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6" d="100"/>
          <a:sy n="76" d="100"/>
        </p:scale>
        <p:origin x="62" y="1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97220-0FA9-3ABC-F18A-05A69DFD33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A1164F-2ED2-E307-8901-F01FFCA47B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B63FD0-E2CF-E258-029B-C80941005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1714E5-51DF-9D26-4E2F-FB8966C01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6E70D4-9B2A-3EA4-BE2D-17B16ACD8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436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1FFC19-F4A8-F674-48E2-5AE9952AD7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0D42E8-2BBE-2498-BC4E-ECD6ABE081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CEE31D-0C03-7AFB-0324-D5A0970FF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2F2953-286D-8291-6158-F7DF859EE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442E58-8665-D50E-227E-AF5E6BD9A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26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34EC0C-0489-94C4-1F9E-B3D4425DAF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958EBC-39AB-7719-7E11-436981E9C0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A19EBC-6139-0AFD-89F7-BB5461E35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9BB475-CDCB-5BBB-91AE-04F92DD83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3B1824-BC3B-DED5-FE32-FC29BB19C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52957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474C81-A460-5198-2071-F0F98EE6A7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BF52D8-C3EE-7C96-474C-6A426CAECB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067C7-AE57-AE65-D57D-CC56FC0AE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97D5B5-895C-1896-A015-BC0AD6810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41DFB9-0CC5-11EE-DDE4-887C344F6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0171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53EEF1-B7D2-19E4-D741-FFF912AD6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58259E-CF9C-9A46-FBA1-2D0CB3BED1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9AC4AA-BA12-BFF3-B72B-B47D7E388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2AE88C-25A6-0CB5-9819-20EE3835F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6D8065-2D4F-D4A9-2511-C1DA7A6D6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782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6045A2-3E49-C615-22CA-D05D6C942B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BC705B-3643-038F-8DCD-DFE3887A83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5B7EDC-CF07-5E33-83B3-9089950A14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7EE648-D6E8-B29D-B6BF-809634B66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9EE7C0-6686-C05E-3D7A-4FD181D8A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17B832-0E67-0BE8-8AA5-077CF2CA6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0015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20020E-4880-B2B8-5BF6-BE88733C3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9E44E5-73F2-F88B-530F-FBB0D4EC90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1D0D69-2F3F-5BC4-DA0F-ABC1D19E19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6E0E0F1-4304-6CC6-5A4E-587339821D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6B274D-544A-A554-D2EA-11B206D2AB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CE8CE3A-14B1-DED7-8249-94640B377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F5BEE4-1AB2-1550-5E7E-33F708F47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F0615B-DDCA-E493-8CBA-D26F55151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7591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80639D-6F64-031B-3291-30FC7B50FE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10CC73-04FA-D1B2-C822-DA91662757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CA81B2-AEF3-AF2B-3331-EB6DD97F88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9B0FC4-F182-42AB-91A3-FF04B7778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7790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123C9F-087D-29E8-82DE-0309183A9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15C2745-1E96-7717-3995-5C45D5ED85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E88E46-101C-44EF-FB79-03A52ADB9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80314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C4A371-2B95-34B0-F4BD-B281B35246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B1AEAE-1F93-FEFD-1833-FE60C3A2D8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F53C58-1000-CC21-B18C-3B0C30E149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8305A2-0052-97A5-D004-0FBFD3FCF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8798DC-861E-9B1A-0B6A-FD9A6479B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D2FDFD-99A1-8070-BE62-B8E7C09BD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664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D8C37-8DA0-5C0B-EBDB-314A64BCAD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F6563D-42AD-4FFF-13EB-D84327AC0B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4AA8A5-9769-708B-19C0-C401432A07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2F3C88-A073-8935-9CCC-DA4F7241B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811EF0-6576-97CC-27D6-69AF2824B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0F47DC-AA21-D9DD-598A-AAD494D26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3719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1252FF-50A2-D0B9-9808-81062AFAD2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2EC7DB-B435-E38A-102F-E2B7DE140E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656EBB-5FB3-1636-A73B-C31D652330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B586A6-B21E-40EB-9495-BB0D925218C9}" type="datetimeFigureOut">
              <a:rPr lang="en-GB" smtClean="0"/>
              <a:t>21/03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07F1C1-2673-9B62-6476-445D904BFD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49EC3C-75AB-9558-DEF9-360434802A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4697A4-37CB-4352-B46B-C6A1FC3673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6973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81" name="Group 2780">
            <a:extLst>
              <a:ext uri="{FF2B5EF4-FFF2-40B4-BE49-F238E27FC236}">
                <a16:creationId xmlns:a16="http://schemas.microsoft.com/office/drawing/2014/main" id="{4991C4F9-EA0D-6EFE-A510-B0AEA4E1F380}"/>
              </a:ext>
            </a:extLst>
          </p:cNvPr>
          <p:cNvGrpSpPr/>
          <p:nvPr/>
        </p:nvGrpSpPr>
        <p:grpSpPr>
          <a:xfrm>
            <a:off x="1175302" y="385080"/>
            <a:ext cx="9577305" cy="5321554"/>
            <a:chOff x="1175302" y="385080"/>
            <a:chExt cx="9577305" cy="5321554"/>
          </a:xfrm>
        </p:grpSpPr>
        <p:sp>
          <p:nvSpPr>
            <p:cNvPr id="2782" name="Freeform: Shape 2781">
              <a:extLst>
                <a:ext uri="{FF2B5EF4-FFF2-40B4-BE49-F238E27FC236}">
                  <a16:creationId xmlns:a16="http://schemas.microsoft.com/office/drawing/2014/main" id="{07A34E5B-AADB-1EAE-477B-2715BD3290A7}"/>
                </a:ext>
              </a:extLst>
            </p:cNvPr>
            <p:cNvSpPr/>
            <p:nvPr/>
          </p:nvSpPr>
          <p:spPr>
            <a:xfrm>
              <a:off x="1534338" y="385080"/>
              <a:ext cx="9218269" cy="4454747"/>
            </a:xfrm>
            <a:custGeom>
              <a:avLst/>
              <a:gdLst>
                <a:gd name="connsiteX0" fmla="*/ 0 w 9218269"/>
                <a:gd name="connsiteY0" fmla="*/ 0 h 4454747"/>
                <a:gd name="connsiteX1" fmla="*/ 9218269 w 9218269"/>
                <a:gd name="connsiteY1" fmla="*/ 0 h 4454747"/>
                <a:gd name="connsiteX2" fmla="*/ 9218269 w 9218269"/>
                <a:gd name="connsiteY2" fmla="*/ 4454748 h 4454747"/>
                <a:gd name="connsiteX3" fmla="*/ 0 w 9218269"/>
                <a:gd name="connsiteY3" fmla="*/ 4454748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218269" h="4454747">
                  <a:moveTo>
                    <a:pt x="0" y="0"/>
                  </a:moveTo>
                  <a:lnTo>
                    <a:pt x="9218269" y="0"/>
                  </a:lnTo>
                  <a:lnTo>
                    <a:pt x="9218269" y="4454748"/>
                  </a:lnTo>
                  <a:lnTo>
                    <a:pt x="0" y="4454748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83" name="Freeform: Shape 2782">
              <a:extLst>
                <a:ext uri="{FF2B5EF4-FFF2-40B4-BE49-F238E27FC236}">
                  <a16:creationId xmlns:a16="http://schemas.microsoft.com/office/drawing/2014/main" id="{1DC4D2D7-2404-C76B-96EC-26094886DFC1}"/>
                </a:ext>
              </a:extLst>
            </p:cNvPr>
            <p:cNvSpPr/>
            <p:nvPr/>
          </p:nvSpPr>
          <p:spPr>
            <a:xfrm>
              <a:off x="1534338" y="4131147"/>
              <a:ext cx="9218269" cy="9677"/>
            </a:xfrm>
            <a:custGeom>
              <a:avLst/>
              <a:gdLst>
                <a:gd name="connsiteX0" fmla="*/ 0 w 9218269"/>
                <a:gd name="connsiteY0" fmla="*/ 0 h 9677"/>
                <a:gd name="connsiteX1" fmla="*/ 9218269 w 9218269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18269" h="9677">
                  <a:moveTo>
                    <a:pt x="0" y="0"/>
                  </a:moveTo>
                  <a:lnTo>
                    <a:pt x="9218269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84" name="Freeform: Shape 2783">
              <a:extLst>
                <a:ext uri="{FF2B5EF4-FFF2-40B4-BE49-F238E27FC236}">
                  <a16:creationId xmlns:a16="http://schemas.microsoft.com/office/drawing/2014/main" id="{3D1643E2-D980-B000-5AB2-6A9886DD4C2E}"/>
                </a:ext>
              </a:extLst>
            </p:cNvPr>
            <p:cNvSpPr/>
            <p:nvPr/>
          </p:nvSpPr>
          <p:spPr>
            <a:xfrm>
              <a:off x="1534338" y="3118664"/>
              <a:ext cx="9218269" cy="9677"/>
            </a:xfrm>
            <a:custGeom>
              <a:avLst/>
              <a:gdLst>
                <a:gd name="connsiteX0" fmla="*/ 0 w 9218269"/>
                <a:gd name="connsiteY0" fmla="*/ 0 h 9677"/>
                <a:gd name="connsiteX1" fmla="*/ 9218269 w 9218269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18269" h="9677">
                  <a:moveTo>
                    <a:pt x="0" y="0"/>
                  </a:moveTo>
                  <a:lnTo>
                    <a:pt x="9218269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85" name="Freeform: Shape 2784">
              <a:extLst>
                <a:ext uri="{FF2B5EF4-FFF2-40B4-BE49-F238E27FC236}">
                  <a16:creationId xmlns:a16="http://schemas.microsoft.com/office/drawing/2014/main" id="{BC3CA21C-D395-C0E1-A089-BA893192A86A}"/>
                </a:ext>
              </a:extLst>
            </p:cNvPr>
            <p:cNvSpPr/>
            <p:nvPr/>
          </p:nvSpPr>
          <p:spPr>
            <a:xfrm>
              <a:off x="1534338" y="2106211"/>
              <a:ext cx="9218269" cy="9677"/>
            </a:xfrm>
            <a:custGeom>
              <a:avLst/>
              <a:gdLst>
                <a:gd name="connsiteX0" fmla="*/ 0 w 9218269"/>
                <a:gd name="connsiteY0" fmla="*/ 0 h 9677"/>
                <a:gd name="connsiteX1" fmla="*/ 9218269 w 9218269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18269" h="9677">
                  <a:moveTo>
                    <a:pt x="0" y="0"/>
                  </a:moveTo>
                  <a:lnTo>
                    <a:pt x="9218269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86" name="Freeform: Shape 2785">
              <a:extLst>
                <a:ext uri="{FF2B5EF4-FFF2-40B4-BE49-F238E27FC236}">
                  <a16:creationId xmlns:a16="http://schemas.microsoft.com/office/drawing/2014/main" id="{7D6EB81E-0859-0BE6-4987-5EA166650F5F}"/>
                </a:ext>
              </a:extLst>
            </p:cNvPr>
            <p:cNvSpPr/>
            <p:nvPr/>
          </p:nvSpPr>
          <p:spPr>
            <a:xfrm>
              <a:off x="1534338" y="1093766"/>
              <a:ext cx="9218269" cy="9677"/>
            </a:xfrm>
            <a:custGeom>
              <a:avLst/>
              <a:gdLst>
                <a:gd name="connsiteX0" fmla="*/ 0 w 9218269"/>
                <a:gd name="connsiteY0" fmla="*/ 0 h 9677"/>
                <a:gd name="connsiteX1" fmla="*/ 9218269 w 9218269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18269" h="9677">
                  <a:moveTo>
                    <a:pt x="0" y="0"/>
                  </a:moveTo>
                  <a:lnTo>
                    <a:pt x="9218269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87" name="Freeform: Shape 2786">
              <a:extLst>
                <a:ext uri="{FF2B5EF4-FFF2-40B4-BE49-F238E27FC236}">
                  <a16:creationId xmlns:a16="http://schemas.microsoft.com/office/drawing/2014/main" id="{FB120E3F-D330-B564-F8D3-AA830F9BFEF1}"/>
                </a:ext>
              </a:extLst>
            </p:cNvPr>
            <p:cNvSpPr/>
            <p:nvPr/>
          </p:nvSpPr>
          <p:spPr>
            <a:xfrm>
              <a:off x="187807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88" name="Freeform: Shape 2787">
              <a:extLst>
                <a:ext uri="{FF2B5EF4-FFF2-40B4-BE49-F238E27FC236}">
                  <a16:creationId xmlns:a16="http://schemas.microsoft.com/office/drawing/2014/main" id="{68A5E196-08D8-3455-ECC6-BE08396E4317}"/>
                </a:ext>
              </a:extLst>
            </p:cNvPr>
            <p:cNvSpPr/>
            <p:nvPr/>
          </p:nvSpPr>
          <p:spPr>
            <a:xfrm>
              <a:off x="191988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89" name="Freeform: Shape 2788">
              <a:extLst>
                <a:ext uri="{FF2B5EF4-FFF2-40B4-BE49-F238E27FC236}">
                  <a16:creationId xmlns:a16="http://schemas.microsoft.com/office/drawing/2014/main" id="{748D402B-AFC6-0A69-20EB-127728FA067D}"/>
                </a:ext>
              </a:extLst>
            </p:cNvPr>
            <p:cNvSpPr/>
            <p:nvPr/>
          </p:nvSpPr>
          <p:spPr>
            <a:xfrm>
              <a:off x="200352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90" name="Freeform: Shape 2789">
              <a:extLst>
                <a:ext uri="{FF2B5EF4-FFF2-40B4-BE49-F238E27FC236}">
                  <a16:creationId xmlns:a16="http://schemas.microsoft.com/office/drawing/2014/main" id="{83F12D9B-7EBE-ED49-F1F6-04D63D7AFAD7}"/>
                </a:ext>
              </a:extLst>
            </p:cNvPr>
            <p:cNvSpPr/>
            <p:nvPr/>
          </p:nvSpPr>
          <p:spPr>
            <a:xfrm>
              <a:off x="208715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91" name="Freeform: Shape 2790">
              <a:extLst>
                <a:ext uri="{FF2B5EF4-FFF2-40B4-BE49-F238E27FC236}">
                  <a16:creationId xmlns:a16="http://schemas.microsoft.com/office/drawing/2014/main" id="{E23C7C91-DA13-CD41-074C-838DF916E53C}"/>
                </a:ext>
              </a:extLst>
            </p:cNvPr>
            <p:cNvSpPr/>
            <p:nvPr/>
          </p:nvSpPr>
          <p:spPr>
            <a:xfrm>
              <a:off x="217079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92" name="Freeform: Shape 2791">
              <a:extLst>
                <a:ext uri="{FF2B5EF4-FFF2-40B4-BE49-F238E27FC236}">
                  <a16:creationId xmlns:a16="http://schemas.microsoft.com/office/drawing/2014/main" id="{3F36851E-A160-562C-2A87-2AA24A02E377}"/>
                </a:ext>
              </a:extLst>
            </p:cNvPr>
            <p:cNvSpPr/>
            <p:nvPr/>
          </p:nvSpPr>
          <p:spPr>
            <a:xfrm>
              <a:off x="225443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93" name="Freeform: Shape 2792">
              <a:extLst>
                <a:ext uri="{FF2B5EF4-FFF2-40B4-BE49-F238E27FC236}">
                  <a16:creationId xmlns:a16="http://schemas.microsoft.com/office/drawing/2014/main" id="{08B7BCDE-27DF-37DC-905C-B569357EA358}"/>
                </a:ext>
              </a:extLst>
            </p:cNvPr>
            <p:cNvSpPr/>
            <p:nvPr/>
          </p:nvSpPr>
          <p:spPr>
            <a:xfrm>
              <a:off x="233806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94" name="Freeform: Shape 2793">
              <a:extLst>
                <a:ext uri="{FF2B5EF4-FFF2-40B4-BE49-F238E27FC236}">
                  <a16:creationId xmlns:a16="http://schemas.microsoft.com/office/drawing/2014/main" id="{B9F71CDE-5FE4-DB82-AB13-2B1A88ECE4DD}"/>
                </a:ext>
              </a:extLst>
            </p:cNvPr>
            <p:cNvSpPr/>
            <p:nvPr/>
          </p:nvSpPr>
          <p:spPr>
            <a:xfrm>
              <a:off x="242170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95" name="Freeform: Shape 2794">
              <a:extLst>
                <a:ext uri="{FF2B5EF4-FFF2-40B4-BE49-F238E27FC236}">
                  <a16:creationId xmlns:a16="http://schemas.microsoft.com/office/drawing/2014/main" id="{0CA32094-B2BD-00BA-4F06-6C12598238AB}"/>
                </a:ext>
              </a:extLst>
            </p:cNvPr>
            <p:cNvSpPr/>
            <p:nvPr/>
          </p:nvSpPr>
          <p:spPr>
            <a:xfrm>
              <a:off x="250534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96" name="Freeform: Shape 2795">
              <a:extLst>
                <a:ext uri="{FF2B5EF4-FFF2-40B4-BE49-F238E27FC236}">
                  <a16:creationId xmlns:a16="http://schemas.microsoft.com/office/drawing/2014/main" id="{7F1DE9D9-A312-AF69-EDDD-581650D395A8}"/>
                </a:ext>
              </a:extLst>
            </p:cNvPr>
            <p:cNvSpPr/>
            <p:nvPr/>
          </p:nvSpPr>
          <p:spPr>
            <a:xfrm>
              <a:off x="258897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97" name="Freeform: Shape 2796">
              <a:extLst>
                <a:ext uri="{FF2B5EF4-FFF2-40B4-BE49-F238E27FC236}">
                  <a16:creationId xmlns:a16="http://schemas.microsoft.com/office/drawing/2014/main" id="{296EC840-9BD6-F679-841B-EE74EE729232}"/>
                </a:ext>
              </a:extLst>
            </p:cNvPr>
            <p:cNvSpPr/>
            <p:nvPr/>
          </p:nvSpPr>
          <p:spPr>
            <a:xfrm>
              <a:off x="267260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98" name="Freeform: Shape 2797">
              <a:extLst>
                <a:ext uri="{FF2B5EF4-FFF2-40B4-BE49-F238E27FC236}">
                  <a16:creationId xmlns:a16="http://schemas.microsoft.com/office/drawing/2014/main" id="{23E06BEB-868B-AF42-1607-C431F6A0B7F5}"/>
                </a:ext>
              </a:extLst>
            </p:cNvPr>
            <p:cNvSpPr/>
            <p:nvPr/>
          </p:nvSpPr>
          <p:spPr>
            <a:xfrm>
              <a:off x="275624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799" name="Freeform: Shape 2798">
              <a:extLst>
                <a:ext uri="{FF2B5EF4-FFF2-40B4-BE49-F238E27FC236}">
                  <a16:creationId xmlns:a16="http://schemas.microsoft.com/office/drawing/2014/main" id="{EC9F676B-73D8-7560-9E4A-3B51B59E0B0D}"/>
                </a:ext>
              </a:extLst>
            </p:cNvPr>
            <p:cNvSpPr/>
            <p:nvPr/>
          </p:nvSpPr>
          <p:spPr>
            <a:xfrm>
              <a:off x="283987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00" name="Freeform: Shape 2799">
              <a:extLst>
                <a:ext uri="{FF2B5EF4-FFF2-40B4-BE49-F238E27FC236}">
                  <a16:creationId xmlns:a16="http://schemas.microsoft.com/office/drawing/2014/main" id="{25461CFB-ACC0-B444-933D-5ED1D3E91B3A}"/>
                </a:ext>
              </a:extLst>
            </p:cNvPr>
            <p:cNvSpPr/>
            <p:nvPr/>
          </p:nvSpPr>
          <p:spPr>
            <a:xfrm>
              <a:off x="292351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01" name="Freeform: Shape 2800">
              <a:extLst>
                <a:ext uri="{FF2B5EF4-FFF2-40B4-BE49-F238E27FC236}">
                  <a16:creationId xmlns:a16="http://schemas.microsoft.com/office/drawing/2014/main" id="{EED4C595-8DB8-69EE-271D-DB04464896B2}"/>
                </a:ext>
              </a:extLst>
            </p:cNvPr>
            <p:cNvSpPr/>
            <p:nvPr/>
          </p:nvSpPr>
          <p:spPr>
            <a:xfrm>
              <a:off x="300714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02" name="Freeform: Shape 2801">
              <a:extLst>
                <a:ext uri="{FF2B5EF4-FFF2-40B4-BE49-F238E27FC236}">
                  <a16:creationId xmlns:a16="http://schemas.microsoft.com/office/drawing/2014/main" id="{5E19AA4F-8379-8CE7-2A72-A6A35655211D}"/>
                </a:ext>
              </a:extLst>
            </p:cNvPr>
            <p:cNvSpPr/>
            <p:nvPr/>
          </p:nvSpPr>
          <p:spPr>
            <a:xfrm>
              <a:off x="309078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03" name="Freeform: Shape 2802">
              <a:extLst>
                <a:ext uri="{FF2B5EF4-FFF2-40B4-BE49-F238E27FC236}">
                  <a16:creationId xmlns:a16="http://schemas.microsoft.com/office/drawing/2014/main" id="{81398B58-BF73-EF3A-BD29-A2DF7273B905}"/>
                </a:ext>
              </a:extLst>
            </p:cNvPr>
            <p:cNvSpPr/>
            <p:nvPr/>
          </p:nvSpPr>
          <p:spPr>
            <a:xfrm>
              <a:off x="317442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04" name="Freeform: Shape 2803">
              <a:extLst>
                <a:ext uri="{FF2B5EF4-FFF2-40B4-BE49-F238E27FC236}">
                  <a16:creationId xmlns:a16="http://schemas.microsoft.com/office/drawing/2014/main" id="{6A364E58-E995-415D-101B-A39749E519B6}"/>
                </a:ext>
              </a:extLst>
            </p:cNvPr>
            <p:cNvSpPr/>
            <p:nvPr/>
          </p:nvSpPr>
          <p:spPr>
            <a:xfrm>
              <a:off x="325805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05" name="Freeform: Shape 2804">
              <a:extLst>
                <a:ext uri="{FF2B5EF4-FFF2-40B4-BE49-F238E27FC236}">
                  <a16:creationId xmlns:a16="http://schemas.microsoft.com/office/drawing/2014/main" id="{BB265D83-87D0-C151-16CA-9C12E474C996}"/>
                </a:ext>
              </a:extLst>
            </p:cNvPr>
            <p:cNvSpPr/>
            <p:nvPr/>
          </p:nvSpPr>
          <p:spPr>
            <a:xfrm>
              <a:off x="334169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06" name="Freeform: Shape 2805">
              <a:extLst>
                <a:ext uri="{FF2B5EF4-FFF2-40B4-BE49-F238E27FC236}">
                  <a16:creationId xmlns:a16="http://schemas.microsoft.com/office/drawing/2014/main" id="{98C30E2D-85FC-A58F-80E8-71F913752596}"/>
                </a:ext>
              </a:extLst>
            </p:cNvPr>
            <p:cNvSpPr/>
            <p:nvPr/>
          </p:nvSpPr>
          <p:spPr>
            <a:xfrm>
              <a:off x="342533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07" name="Freeform: Shape 2806">
              <a:extLst>
                <a:ext uri="{FF2B5EF4-FFF2-40B4-BE49-F238E27FC236}">
                  <a16:creationId xmlns:a16="http://schemas.microsoft.com/office/drawing/2014/main" id="{F53940DA-FBD5-7E18-7B94-940182BBDF33}"/>
                </a:ext>
              </a:extLst>
            </p:cNvPr>
            <p:cNvSpPr/>
            <p:nvPr/>
          </p:nvSpPr>
          <p:spPr>
            <a:xfrm>
              <a:off x="350896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08" name="Freeform: Shape 2807">
              <a:extLst>
                <a:ext uri="{FF2B5EF4-FFF2-40B4-BE49-F238E27FC236}">
                  <a16:creationId xmlns:a16="http://schemas.microsoft.com/office/drawing/2014/main" id="{748C8187-EE51-3023-198B-B9E0C8CAEE49}"/>
                </a:ext>
              </a:extLst>
            </p:cNvPr>
            <p:cNvSpPr/>
            <p:nvPr/>
          </p:nvSpPr>
          <p:spPr>
            <a:xfrm>
              <a:off x="359260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09" name="Freeform: Shape 2808">
              <a:extLst>
                <a:ext uri="{FF2B5EF4-FFF2-40B4-BE49-F238E27FC236}">
                  <a16:creationId xmlns:a16="http://schemas.microsoft.com/office/drawing/2014/main" id="{FB6DD6EA-C80B-D698-D6BF-401D2AD8DB86}"/>
                </a:ext>
              </a:extLst>
            </p:cNvPr>
            <p:cNvSpPr/>
            <p:nvPr/>
          </p:nvSpPr>
          <p:spPr>
            <a:xfrm>
              <a:off x="367623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10" name="Freeform: Shape 2809">
              <a:extLst>
                <a:ext uri="{FF2B5EF4-FFF2-40B4-BE49-F238E27FC236}">
                  <a16:creationId xmlns:a16="http://schemas.microsoft.com/office/drawing/2014/main" id="{E0AA2B1E-7D79-7AEB-654F-CF401AD77E38}"/>
                </a:ext>
              </a:extLst>
            </p:cNvPr>
            <p:cNvSpPr/>
            <p:nvPr/>
          </p:nvSpPr>
          <p:spPr>
            <a:xfrm>
              <a:off x="375987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11" name="Freeform: Shape 2810">
              <a:extLst>
                <a:ext uri="{FF2B5EF4-FFF2-40B4-BE49-F238E27FC236}">
                  <a16:creationId xmlns:a16="http://schemas.microsoft.com/office/drawing/2014/main" id="{A5909BCD-D894-AA34-4585-DD4DE4F0C928}"/>
                </a:ext>
              </a:extLst>
            </p:cNvPr>
            <p:cNvSpPr/>
            <p:nvPr/>
          </p:nvSpPr>
          <p:spPr>
            <a:xfrm>
              <a:off x="384351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12" name="Freeform: Shape 2811">
              <a:extLst>
                <a:ext uri="{FF2B5EF4-FFF2-40B4-BE49-F238E27FC236}">
                  <a16:creationId xmlns:a16="http://schemas.microsoft.com/office/drawing/2014/main" id="{1DAF74A0-BFD9-2437-DF7D-9D80921F7A62}"/>
                </a:ext>
              </a:extLst>
            </p:cNvPr>
            <p:cNvSpPr/>
            <p:nvPr/>
          </p:nvSpPr>
          <p:spPr>
            <a:xfrm>
              <a:off x="392714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13" name="Freeform: Shape 2812">
              <a:extLst>
                <a:ext uri="{FF2B5EF4-FFF2-40B4-BE49-F238E27FC236}">
                  <a16:creationId xmlns:a16="http://schemas.microsoft.com/office/drawing/2014/main" id="{166F19C4-B578-8F48-67A8-BFC3E844F730}"/>
                </a:ext>
              </a:extLst>
            </p:cNvPr>
            <p:cNvSpPr/>
            <p:nvPr/>
          </p:nvSpPr>
          <p:spPr>
            <a:xfrm>
              <a:off x="401078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14" name="Freeform: Shape 2813">
              <a:extLst>
                <a:ext uri="{FF2B5EF4-FFF2-40B4-BE49-F238E27FC236}">
                  <a16:creationId xmlns:a16="http://schemas.microsoft.com/office/drawing/2014/main" id="{DF9B23F8-10C6-34C4-72C2-ADE4A8BD8759}"/>
                </a:ext>
              </a:extLst>
            </p:cNvPr>
            <p:cNvSpPr/>
            <p:nvPr/>
          </p:nvSpPr>
          <p:spPr>
            <a:xfrm>
              <a:off x="409442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15" name="Freeform: Shape 2814">
              <a:extLst>
                <a:ext uri="{FF2B5EF4-FFF2-40B4-BE49-F238E27FC236}">
                  <a16:creationId xmlns:a16="http://schemas.microsoft.com/office/drawing/2014/main" id="{FCAC849B-A6C0-61D0-F522-A4FB1DFD6A49}"/>
                </a:ext>
              </a:extLst>
            </p:cNvPr>
            <p:cNvSpPr/>
            <p:nvPr/>
          </p:nvSpPr>
          <p:spPr>
            <a:xfrm>
              <a:off x="417805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16" name="Freeform: Shape 2815">
              <a:extLst>
                <a:ext uri="{FF2B5EF4-FFF2-40B4-BE49-F238E27FC236}">
                  <a16:creationId xmlns:a16="http://schemas.microsoft.com/office/drawing/2014/main" id="{55794D74-44B5-616A-E749-0F073BD0B41C}"/>
                </a:ext>
              </a:extLst>
            </p:cNvPr>
            <p:cNvSpPr/>
            <p:nvPr/>
          </p:nvSpPr>
          <p:spPr>
            <a:xfrm>
              <a:off x="426168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17" name="Freeform: Shape 2816">
              <a:extLst>
                <a:ext uri="{FF2B5EF4-FFF2-40B4-BE49-F238E27FC236}">
                  <a16:creationId xmlns:a16="http://schemas.microsoft.com/office/drawing/2014/main" id="{510604C1-B6A4-3377-DC83-B78DB44C21F2}"/>
                </a:ext>
              </a:extLst>
            </p:cNvPr>
            <p:cNvSpPr/>
            <p:nvPr/>
          </p:nvSpPr>
          <p:spPr>
            <a:xfrm>
              <a:off x="434531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18" name="Freeform: Shape 2817">
              <a:extLst>
                <a:ext uri="{FF2B5EF4-FFF2-40B4-BE49-F238E27FC236}">
                  <a16:creationId xmlns:a16="http://schemas.microsoft.com/office/drawing/2014/main" id="{9FA8E3D1-B9AD-D80C-7CDF-244479F7E932}"/>
                </a:ext>
              </a:extLst>
            </p:cNvPr>
            <p:cNvSpPr/>
            <p:nvPr/>
          </p:nvSpPr>
          <p:spPr>
            <a:xfrm>
              <a:off x="442895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19" name="Freeform: Shape 2818">
              <a:extLst>
                <a:ext uri="{FF2B5EF4-FFF2-40B4-BE49-F238E27FC236}">
                  <a16:creationId xmlns:a16="http://schemas.microsoft.com/office/drawing/2014/main" id="{DB764F96-F8C5-0B37-99D8-3FF6BEFD8878}"/>
                </a:ext>
              </a:extLst>
            </p:cNvPr>
            <p:cNvSpPr/>
            <p:nvPr/>
          </p:nvSpPr>
          <p:spPr>
            <a:xfrm>
              <a:off x="451259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20" name="Freeform: Shape 2819">
              <a:extLst>
                <a:ext uri="{FF2B5EF4-FFF2-40B4-BE49-F238E27FC236}">
                  <a16:creationId xmlns:a16="http://schemas.microsoft.com/office/drawing/2014/main" id="{325EB1DF-4348-09DD-9D13-DC01CC1B1324}"/>
                </a:ext>
              </a:extLst>
            </p:cNvPr>
            <p:cNvSpPr/>
            <p:nvPr/>
          </p:nvSpPr>
          <p:spPr>
            <a:xfrm>
              <a:off x="459622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21" name="Freeform: Shape 2820">
              <a:extLst>
                <a:ext uri="{FF2B5EF4-FFF2-40B4-BE49-F238E27FC236}">
                  <a16:creationId xmlns:a16="http://schemas.microsoft.com/office/drawing/2014/main" id="{732C92B5-8E0C-1D9A-FCF0-465D3F640124}"/>
                </a:ext>
              </a:extLst>
            </p:cNvPr>
            <p:cNvSpPr/>
            <p:nvPr/>
          </p:nvSpPr>
          <p:spPr>
            <a:xfrm>
              <a:off x="467986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22" name="Freeform: Shape 2821">
              <a:extLst>
                <a:ext uri="{FF2B5EF4-FFF2-40B4-BE49-F238E27FC236}">
                  <a16:creationId xmlns:a16="http://schemas.microsoft.com/office/drawing/2014/main" id="{66AA2867-D37D-4095-4B20-0DBF349070C1}"/>
                </a:ext>
              </a:extLst>
            </p:cNvPr>
            <p:cNvSpPr/>
            <p:nvPr/>
          </p:nvSpPr>
          <p:spPr>
            <a:xfrm>
              <a:off x="476350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23" name="Freeform: Shape 2822">
              <a:extLst>
                <a:ext uri="{FF2B5EF4-FFF2-40B4-BE49-F238E27FC236}">
                  <a16:creationId xmlns:a16="http://schemas.microsoft.com/office/drawing/2014/main" id="{5A9024CA-0976-3AD8-0F27-F851AE04A601}"/>
                </a:ext>
              </a:extLst>
            </p:cNvPr>
            <p:cNvSpPr/>
            <p:nvPr/>
          </p:nvSpPr>
          <p:spPr>
            <a:xfrm>
              <a:off x="484713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24" name="Freeform: Shape 2823">
              <a:extLst>
                <a:ext uri="{FF2B5EF4-FFF2-40B4-BE49-F238E27FC236}">
                  <a16:creationId xmlns:a16="http://schemas.microsoft.com/office/drawing/2014/main" id="{F211389D-8D21-35AF-6AD4-11F059D9C120}"/>
                </a:ext>
              </a:extLst>
            </p:cNvPr>
            <p:cNvSpPr/>
            <p:nvPr/>
          </p:nvSpPr>
          <p:spPr>
            <a:xfrm>
              <a:off x="493077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25" name="Freeform: Shape 2824">
              <a:extLst>
                <a:ext uri="{FF2B5EF4-FFF2-40B4-BE49-F238E27FC236}">
                  <a16:creationId xmlns:a16="http://schemas.microsoft.com/office/drawing/2014/main" id="{002B74CF-5870-E6B8-C669-A31321827693}"/>
                </a:ext>
              </a:extLst>
            </p:cNvPr>
            <p:cNvSpPr/>
            <p:nvPr/>
          </p:nvSpPr>
          <p:spPr>
            <a:xfrm>
              <a:off x="501440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26" name="Freeform: Shape 2825">
              <a:extLst>
                <a:ext uri="{FF2B5EF4-FFF2-40B4-BE49-F238E27FC236}">
                  <a16:creationId xmlns:a16="http://schemas.microsoft.com/office/drawing/2014/main" id="{48267DBA-D197-3D3F-050A-393928512858}"/>
                </a:ext>
              </a:extLst>
            </p:cNvPr>
            <p:cNvSpPr/>
            <p:nvPr/>
          </p:nvSpPr>
          <p:spPr>
            <a:xfrm>
              <a:off x="509804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27" name="Freeform: Shape 2826">
              <a:extLst>
                <a:ext uri="{FF2B5EF4-FFF2-40B4-BE49-F238E27FC236}">
                  <a16:creationId xmlns:a16="http://schemas.microsoft.com/office/drawing/2014/main" id="{457E4A2B-6758-F937-AF8B-62F75246CA76}"/>
                </a:ext>
              </a:extLst>
            </p:cNvPr>
            <p:cNvSpPr/>
            <p:nvPr/>
          </p:nvSpPr>
          <p:spPr>
            <a:xfrm>
              <a:off x="518168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28" name="Freeform: Shape 2827">
              <a:extLst>
                <a:ext uri="{FF2B5EF4-FFF2-40B4-BE49-F238E27FC236}">
                  <a16:creationId xmlns:a16="http://schemas.microsoft.com/office/drawing/2014/main" id="{41AD0B3D-0A4F-F33C-D3EE-5705DDC795E4}"/>
                </a:ext>
              </a:extLst>
            </p:cNvPr>
            <p:cNvSpPr/>
            <p:nvPr/>
          </p:nvSpPr>
          <p:spPr>
            <a:xfrm>
              <a:off x="526531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29" name="Freeform: Shape 2828">
              <a:extLst>
                <a:ext uri="{FF2B5EF4-FFF2-40B4-BE49-F238E27FC236}">
                  <a16:creationId xmlns:a16="http://schemas.microsoft.com/office/drawing/2014/main" id="{0AED956C-5EE6-CF6C-0293-584260F8AED9}"/>
                </a:ext>
              </a:extLst>
            </p:cNvPr>
            <p:cNvSpPr/>
            <p:nvPr/>
          </p:nvSpPr>
          <p:spPr>
            <a:xfrm>
              <a:off x="534895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30" name="Freeform: Shape 2829">
              <a:extLst>
                <a:ext uri="{FF2B5EF4-FFF2-40B4-BE49-F238E27FC236}">
                  <a16:creationId xmlns:a16="http://schemas.microsoft.com/office/drawing/2014/main" id="{E16E46B0-9E19-5170-3A6F-3B489874B4D2}"/>
                </a:ext>
              </a:extLst>
            </p:cNvPr>
            <p:cNvSpPr/>
            <p:nvPr/>
          </p:nvSpPr>
          <p:spPr>
            <a:xfrm>
              <a:off x="543259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31" name="Freeform: Shape 2830">
              <a:extLst>
                <a:ext uri="{FF2B5EF4-FFF2-40B4-BE49-F238E27FC236}">
                  <a16:creationId xmlns:a16="http://schemas.microsoft.com/office/drawing/2014/main" id="{6426BD21-4CC7-1106-BB18-BB8686B140BF}"/>
                </a:ext>
              </a:extLst>
            </p:cNvPr>
            <p:cNvSpPr/>
            <p:nvPr/>
          </p:nvSpPr>
          <p:spPr>
            <a:xfrm>
              <a:off x="551622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32" name="Freeform: Shape 2831">
              <a:extLst>
                <a:ext uri="{FF2B5EF4-FFF2-40B4-BE49-F238E27FC236}">
                  <a16:creationId xmlns:a16="http://schemas.microsoft.com/office/drawing/2014/main" id="{56507891-C20E-0992-4F08-38719510DADF}"/>
                </a:ext>
              </a:extLst>
            </p:cNvPr>
            <p:cNvSpPr/>
            <p:nvPr/>
          </p:nvSpPr>
          <p:spPr>
            <a:xfrm>
              <a:off x="559986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33" name="Freeform: Shape 2832">
              <a:extLst>
                <a:ext uri="{FF2B5EF4-FFF2-40B4-BE49-F238E27FC236}">
                  <a16:creationId xmlns:a16="http://schemas.microsoft.com/office/drawing/2014/main" id="{76125B73-998D-AD78-BBFB-8E8112C17CB6}"/>
                </a:ext>
              </a:extLst>
            </p:cNvPr>
            <p:cNvSpPr/>
            <p:nvPr/>
          </p:nvSpPr>
          <p:spPr>
            <a:xfrm>
              <a:off x="568349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34" name="Freeform: Shape 2833">
              <a:extLst>
                <a:ext uri="{FF2B5EF4-FFF2-40B4-BE49-F238E27FC236}">
                  <a16:creationId xmlns:a16="http://schemas.microsoft.com/office/drawing/2014/main" id="{2A6FE023-E87C-6E01-2FDD-4FF98AF5DE57}"/>
                </a:ext>
              </a:extLst>
            </p:cNvPr>
            <p:cNvSpPr/>
            <p:nvPr/>
          </p:nvSpPr>
          <p:spPr>
            <a:xfrm>
              <a:off x="576712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35" name="Freeform: Shape 2834">
              <a:extLst>
                <a:ext uri="{FF2B5EF4-FFF2-40B4-BE49-F238E27FC236}">
                  <a16:creationId xmlns:a16="http://schemas.microsoft.com/office/drawing/2014/main" id="{7E997A36-1C0A-C5E7-64F2-7D3CB2464354}"/>
                </a:ext>
              </a:extLst>
            </p:cNvPr>
            <p:cNvSpPr/>
            <p:nvPr/>
          </p:nvSpPr>
          <p:spPr>
            <a:xfrm>
              <a:off x="585076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36" name="Freeform: Shape 2835">
              <a:extLst>
                <a:ext uri="{FF2B5EF4-FFF2-40B4-BE49-F238E27FC236}">
                  <a16:creationId xmlns:a16="http://schemas.microsoft.com/office/drawing/2014/main" id="{A36E93F4-39E6-E599-412B-5E089D658D9E}"/>
                </a:ext>
              </a:extLst>
            </p:cNvPr>
            <p:cNvSpPr/>
            <p:nvPr/>
          </p:nvSpPr>
          <p:spPr>
            <a:xfrm>
              <a:off x="593439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37" name="Freeform: Shape 2836">
              <a:extLst>
                <a:ext uri="{FF2B5EF4-FFF2-40B4-BE49-F238E27FC236}">
                  <a16:creationId xmlns:a16="http://schemas.microsoft.com/office/drawing/2014/main" id="{3E07E34E-C52A-C44C-C001-32F722E71C64}"/>
                </a:ext>
              </a:extLst>
            </p:cNvPr>
            <p:cNvSpPr/>
            <p:nvPr/>
          </p:nvSpPr>
          <p:spPr>
            <a:xfrm>
              <a:off x="601803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38" name="Freeform: Shape 2837">
              <a:extLst>
                <a:ext uri="{FF2B5EF4-FFF2-40B4-BE49-F238E27FC236}">
                  <a16:creationId xmlns:a16="http://schemas.microsoft.com/office/drawing/2014/main" id="{2BE5D9B7-E17F-74C2-2FFA-A856070E9544}"/>
                </a:ext>
              </a:extLst>
            </p:cNvPr>
            <p:cNvSpPr/>
            <p:nvPr/>
          </p:nvSpPr>
          <p:spPr>
            <a:xfrm>
              <a:off x="610167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39" name="Freeform: Shape 2838">
              <a:extLst>
                <a:ext uri="{FF2B5EF4-FFF2-40B4-BE49-F238E27FC236}">
                  <a16:creationId xmlns:a16="http://schemas.microsoft.com/office/drawing/2014/main" id="{DD1D764C-ADD6-4BC5-1DD5-50B1F5A68F33}"/>
                </a:ext>
              </a:extLst>
            </p:cNvPr>
            <p:cNvSpPr/>
            <p:nvPr/>
          </p:nvSpPr>
          <p:spPr>
            <a:xfrm>
              <a:off x="618530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40" name="Freeform: Shape 2839">
              <a:extLst>
                <a:ext uri="{FF2B5EF4-FFF2-40B4-BE49-F238E27FC236}">
                  <a16:creationId xmlns:a16="http://schemas.microsoft.com/office/drawing/2014/main" id="{4707D0DA-615A-EAC5-496A-8DC05A0D911D}"/>
                </a:ext>
              </a:extLst>
            </p:cNvPr>
            <p:cNvSpPr/>
            <p:nvPr/>
          </p:nvSpPr>
          <p:spPr>
            <a:xfrm>
              <a:off x="626894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41" name="Freeform: Shape 2840">
              <a:extLst>
                <a:ext uri="{FF2B5EF4-FFF2-40B4-BE49-F238E27FC236}">
                  <a16:creationId xmlns:a16="http://schemas.microsoft.com/office/drawing/2014/main" id="{48BDCE3A-4FA0-D929-75FC-E707EF5D86F7}"/>
                </a:ext>
              </a:extLst>
            </p:cNvPr>
            <p:cNvSpPr/>
            <p:nvPr/>
          </p:nvSpPr>
          <p:spPr>
            <a:xfrm>
              <a:off x="635257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42" name="Freeform: Shape 2841">
              <a:extLst>
                <a:ext uri="{FF2B5EF4-FFF2-40B4-BE49-F238E27FC236}">
                  <a16:creationId xmlns:a16="http://schemas.microsoft.com/office/drawing/2014/main" id="{B21ABFBE-4D82-1A52-C873-7DC079C04DE2}"/>
                </a:ext>
              </a:extLst>
            </p:cNvPr>
            <p:cNvSpPr/>
            <p:nvPr/>
          </p:nvSpPr>
          <p:spPr>
            <a:xfrm>
              <a:off x="643621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43" name="Freeform: Shape 2842">
              <a:extLst>
                <a:ext uri="{FF2B5EF4-FFF2-40B4-BE49-F238E27FC236}">
                  <a16:creationId xmlns:a16="http://schemas.microsoft.com/office/drawing/2014/main" id="{BDCD61A0-752A-91A6-5E38-7814CBFF9018}"/>
                </a:ext>
              </a:extLst>
            </p:cNvPr>
            <p:cNvSpPr/>
            <p:nvPr/>
          </p:nvSpPr>
          <p:spPr>
            <a:xfrm>
              <a:off x="651985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44" name="Freeform: Shape 2843">
              <a:extLst>
                <a:ext uri="{FF2B5EF4-FFF2-40B4-BE49-F238E27FC236}">
                  <a16:creationId xmlns:a16="http://schemas.microsoft.com/office/drawing/2014/main" id="{78A01F18-910F-7D0F-4722-7D2AADEB0667}"/>
                </a:ext>
              </a:extLst>
            </p:cNvPr>
            <p:cNvSpPr/>
            <p:nvPr/>
          </p:nvSpPr>
          <p:spPr>
            <a:xfrm>
              <a:off x="660348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45" name="Freeform: Shape 2844">
              <a:extLst>
                <a:ext uri="{FF2B5EF4-FFF2-40B4-BE49-F238E27FC236}">
                  <a16:creationId xmlns:a16="http://schemas.microsoft.com/office/drawing/2014/main" id="{BAB11111-C9FA-C701-3FC8-DD0F25C2B548}"/>
                </a:ext>
              </a:extLst>
            </p:cNvPr>
            <p:cNvSpPr/>
            <p:nvPr/>
          </p:nvSpPr>
          <p:spPr>
            <a:xfrm>
              <a:off x="668712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46" name="Freeform: Shape 2845">
              <a:extLst>
                <a:ext uri="{FF2B5EF4-FFF2-40B4-BE49-F238E27FC236}">
                  <a16:creationId xmlns:a16="http://schemas.microsoft.com/office/drawing/2014/main" id="{8588AE5B-99DE-8441-D94A-FAD239352EB6}"/>
                </a:ext>
              </a:extLst>
            </p:cNvPr>
            <p:cNvSpPr/>
            <p:nvPr/>
          </p:nvSpPr>
          <p:spPr>
            <a:xfrm>
              <a:off x="677076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47" name="Freeform: Shape 2846">
              <a:extLst>
                <a:ext uri="{FF2B5EF4-FFF2-40B4-BE49-F238E27FC236}">
                  <a16:creationId xmlns:a16="http://schemas.microsoft.com/office/drawing/2014/main" id="{6A795F4E-6929-E3A5-CF42-8E7BADE4C5A9}"/>
                </a:ext>
              </a:extLst>
            </p:cNvPr>
            <p:cNvSpPr/>
            <p:nvPr/>
          </p:nvSpPr>
          <p:spPr>
            <a:xfrm>
              <a:off x="685439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48" name="Freeform: Shape 2847">
              <a:extLst>
                <a:ext uri="{FF2B5EF4-FFF2-40B4-BE49-F238E27FC236}">
                  <a16:creationId xmlns:a16="http://schemas.microsoft.com/office/drawing/2014/main" id="{FD8E6B2D-5D92-F539-35BB-B17ADD8F0D3E}"/>
                </a:ext>
              </a:extLst>
            </p:cNvPr>
            <p:cNvSpPr/>
            <p:nvPr/>
          </p:nvSpPr>
          <p:spPr>
            <a:xfrm>
              <a:off x="693803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49" name="Freeform: Shape 2848">
              <a:extLst>
                <a:ext uri="{FF2B5EF4-FFF2-40B4-BE49-F238E27FC236}">
                  <a16:creationId xmlns:a16="http://schemas.microsoft.com/office/drawing/2014/main" id="{2A7DA70F-47BB-7626-8095-A85960F43CEC}"/>
                </a:ext>
              </a:extLst>
            </p:cNvPr>
            <p:cNvSpPr/>
            <p:nvPr/>
          </p:nvSpPr>
          <p:spPr>
            <a:xfrm>
              <a:off x="702166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50" name="Freeform: Shape 2849">
              <a:extLst>
                <a:ext uri="{FF2B5EF4-FFF2-40B4-BE49-F238E27FC236}">
                  <a16:creationId xmlns:a16="http://schemas.microsoft.com/office/drawing/2014/main" id="{94477047-7966-7431-F6CD-385750485FC9}"/>
                </a:ext>
              </a:extLst>
            </p:cNvPr>
            <p:cNvSpPr/>
            <p:nvPr/>
          </p:nvSpPr>
          <p:spPr>
            <a:xfrm>
              <a:off x="710530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51" name="Freeform: Shape 2850">
              <a:extLst>
                <a:ext uri="{FF2B5EF4-FFF2-40B4-BE49-F238E27FC236}">
                  <a16:creationId xmlns:a16="http://schemas.microsoft.com/office/drawing/2014/main" id="{9DB45384-1602-9EDA-83CD-C082DC18800C}"/>
                </a:ext>
              </a:extLst>
            </p:cNvPr>
            <p:cNvSpPr/>
            <p:nvPr/>
          </p:nvSpPr>
          <p:spPr>
            <a:xfrm>
              <a:off x="718894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52" name="Freeform: Shape 2851">
              <a:extLst>
                <a:ext uri="{FF2B5EF4-FFF2-40B4-BE49-F238E27FC236}">
                  <a16:creationId xmlns:a16="http://schemas.microsoft.com/office/drawing/2014/main" id="{62DFC8EA-7EB1-ED46-F2C1-A870784C9035}"/>
                </a:ext>
              </a:extLst>
            </p:cNvPr>
            <p:cNvSpPr/>
            <p:nvPr/>
          </p:nvSpPr>
          <p:spPr>
            <a:xfrm>
              <a:off x="727253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53" name="Freeform: Shape 2852">
              <a:extLst>
                <a:ext uri="{FF2B5EF4-FFF2-40B4-BE49-F238E27FC236}">
                  <a16:creationId xmlns:a16="http://schemas.microsoft.com/office/drawing/2014/main" id="{DBC6D710-21FC-B00B-8EAD-771B4CED168E}"/>
                </a:ext>
              </a:extLst>
            </p:cNvPr>
            <p:cNvSpPr/>
            <p:nvPr/>
          </p:nvSpPr>
          <p:spPr>
            <a:xfrm>
              <a:off x="735617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54" name="Freeform: Shape 2853">
              <a:extLst>
                <a:ext uri="{FF2B5EF4-FFF2-40B4-BE49-F238E27FC236}">
                  <a16:creationId xmlns:a16="http://schemas.microsoft.com/office/drawing/2014/main" id="{FBEC74D6-495F-38B5-E963-53C6CD4014E4}"/>
                </a:ext>
              </a:extLst>
            </p:cNvPr>
            <p:cNvSpPr/>
            <p:nvPr/>
          </p:nvSpPr>
          <p:spPr>
            <a:xfrm>
              <a:off x="743980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55" name="Freeform: Shape 2854">
              <a:extLst>
                <a:ext uri="{FF2B5EF4-FFF2-40B4-BE49-F238E27FC236}">
                  <a16:creationId xmlns:a16="http://schemas.microsoft.com/office/drawing/2014/main" id="{64A0A207-7331-4723-132A-C7B3C8152A2C}"/>
                </a:ext>
              </a:extLst>
            </p:cNvPr>
            <p:cNvSpPr/>
            <p:nvPr/>
          </p:nvSpPr>
          <p:spPr>
            <a:xfrm>
              <a:off x="752343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56" name="Freeform: Shape 2855">
              <a:extLst>
                <a:ext uri="{FF2B5EF4-FFF2-40B4-BE49-F238E27FC236}">
                  <a16:creationId xmlns:a16="http://schemas.microsoft.com/office/drawing/2014/main" id="{E38235F0-48DB-4540-1A45-3940D961C06B}"/>
                </a:ext>
              </a:extLst>
            </p:cNvPr>
            <p:cNvSpPr/>
            <p:nvPr/>
          </p:nvSpPr>
          <p:spPr>
            <a:xfrm>
              <a:off x="760707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57" name="Freeform: Shape 2856">
              <a:extLst>
                <a:ext uri="{FF2B5EF4-FFF2-40B4-BE49-F238E27FC236}">
                  <a16:creationId xmlns:a16="http://schemas.microsoft.com/office/drawing/2014/main" id="{9C7C52A1-8BA9-EA2A-81B0-B79120DF8557}"/>
                </a:ext>
              </a:extLst>
            </p:cNvPr>
            <p:cNvSpPr/>
            <p:nvPr/>
          </p:nvSpPr>
          <p:spPr>
            <a:xfrm>
              <a:off x="769071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58" name="Freeform: Shape 2857">
              <a:extLst>
                <a:ext uri="{FF2B5EF4-FFF2-40B4-BE49-F238E27FC236}">
                  <a16:creationId xmlns:a16="http://schemas.microsoft.com/office/drawing/2014/main" id="{99C6F345-33B2-B780-CD9E-4F69B3F31D19}"/>
                </a:ext>
              </a:extLst>
            </p:cNvPr>
            <p:cNvSpPr/>
            <p:nvPr/>
          </p:nvSpPr>
          <p:spPr>
            <a:xfrm>
              <a:off x="777434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59" name="Freeform: Shape 2858">
              <a:extLst>
                <a:ext uri="{FF2B5EF4-FFF2-40B4-BE49-F238E27FC236}">
                  <a16:creationId xmlns:a16="http://schemas.microsoft.com/office/drawing/2014/main" id="{B0BED20B-EF15-0C2C-C8FC-B4348A088378}"/>
                </a:ext>
              </a:extLst>
            </p:cNvPr>
            <p:cNvSpPr/>
            <p:nvPr/>
          </p:nvSpPr>
          <p:spPr>
            <a:xfrm>
              <a:off x="785798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60" name="Freeform: Shape 2859">
              <a:extLst>
                <a:ext uri="{FF2B5EF4-FFF2-40B4-BE49-F238E27FC236}">
                  <a16:creationId xmlns:a16="http://schemas.microsoft.com/office/drawing/2014/main" id="{BF8E7143-24FF-9EB9-DAA8-2FD55A329E0C}"/>
                </a:ext>
              </a:extLst>
            </p:cNvPr>
            <p:cNvSpPr/>
            <p:nvPr/>
          </p:nvSpPr>
          <p:spPr>
            <a:xfrm>
              <a:off x="794161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61" name="Freeform: Shape 2860">
              <a:extLst>
                <a:ext uri="{FF2B5EF4-FFF2-40B4-BE49-F238E27FC236}">
                  <a16:creationId xmlns:a16="http://schemas.microsoft.com/office/drawing/2014/main" id="{9C3A555C-5CA8-91C9-057C-7CB4928113A8}"/>
                </a:ext>
              </a:extLst>
            </p:cNvPr>
            <p:cNvSpPr/>
            <p:nvPr/>
          </p:nvSpPr>
          <p:spPr>
            <a:xfrm>
              <a:off x="802525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62" name="Freeform: Shape 2861">
              <a:extLst>
                <a:ext uri="{FF2B5EF4-FFF2-40B4-BE49-F238E27FC236}">
                  <a16:creationId xmlns:a16="http://schemas.microsoft.com/office/drawing/2014/main" id="{7C9E647A-33E1-08F3-9B67-91600B864BCF}"/>
                </a:ext>
              </a:extLst>
            </p:cNvPr>
            <p:cNvSpPr/>
            <p:nvPr/>
          </p:nvSpPr>
          <p:spPr>
            <a:xfrm>
              <a:off x="810889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63" name="Freeform: Shape 2862">
              <a:extLst>
                <a:ext uri="{FF2B5EF4-FFF2-40B4-BE49-F238E27FC236}">
                  <a16:creationId xmlns:a16="http://schemas.microsoft.com/office/drawing/2014/main" id="{8EB20A18-3867-C382-E279-D46491384405}"/>
                </a:ext>
              </a:extLst>
            </p:cNvPr>
            <p:cNvSpPr/>
            <p:nvPr/>
          </p:nvSpPr>
          <p:spPr>
            <a:xfrm>
              <a:off x="819252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64" name="Freeform: Shape 2863">
              <a:extLst>
                <a:ext uri="{FF2B5EF4-FFF2-40B4-BE49-F238E27FC236}">
                  <a16:creationId xmlns:a16="http://schemas.microsoft.com/office/drawing/2014/main" id="{46230221-8D35-30D8-AA9C-65C760DDE1D5}"/>
                </a:ext>
              </a:extLst>
            </p:cNvPr>
            <p:cNvSpPr/>
            <p:nvPr/>
          </p:nvSpPr>
          <p:spPr>
            <a:xfrm>
              <a:off x="827616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65" name="Freeform: Shape 2864">
              <a:extLst>
                <a:ext uri="{FF2B5EF4-FFF2-40B4-BE49-F238E27FC236}">
                  <a16:creationId xmlns:a16="http://schemas.microsoft.com/office/drawing/2014/main" id="{37D02324-3311-5B35-6135-3C4A08E071AE}"/>
                </a:ext>
              </a:extLst>
            </p:cNvPr>
            <p:cNvSpPr/>
            <p:nvPr/>
          </p:nvSpPr>
          <p:spPr>
            <a:xfrm>
              <a:off x="835979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66" name="Freeform: Shape 2865">
              <a:extLst>
                <a:ext uri="{FF2B5EF4-FFF2-40B4-BE49-F238E27FC236}">
                  <a16:creationId xmlns:a16="http://schemas.microsoft.com/office/drawing/2014/main" id="{C2A56A3F-7117-39DB-1A6D-C962B3D239DE}"/>
                </a:ext>
              </a:extLst>
            </p:cNvPr>
            <p:cNvSpPr/>
            <p:nvPr/>
          </p:nvSpPr>
          <p:spPr>
            <a:xfrm>
              <a:off x="844343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67" name="Freeform: Shape 2866">
              <a:extLst>
                <a:ext uri="{FF2B5EF4-FFF2-40B4-BE49-F238E27FC236}">
                  <a16:creationId xmlns:a16="http://schemas.microsoft.com/office/drawing/2014/main" id="{FFD96126-F47D-6D68-28B4-8B55119D71C4}"/>
                </a:ext>
              </a:extLst>
            </p:cNvPr>
            <p:cNvSpPr/>
            <p:nvPr/>
          </p:nvSpPr>
          <p:spPr>
            <a:xfrm>
              <a:off x="852707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68" name="Freeform: Shape 2867">
              <a:extLst>
                <a:ext uri="{FF2B5EF4-FFF2-40B4-BE49-F238E27FC236}">
                  <a16:creationId xmlns:a16="http://schemas.microsoft.com/office/drawing/2014/main" id="{C48088EE-2CB5-739D-72CA-91A0CA61EC23}"/>
                </a:ext>
              </a:extLst>
            </p:cNvPr>
            <p:cNvSpPr/>
            <p:nvPr/>
          </p:nvSpPr>
          <p:spPr>
            <a:xfrm>
              <a:off x="861070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69" name="Freeform: Shape 2868">
              <a:extLst>
                <a:ext uri="{FF2B5EF4-FFF2-40B4-BE49-F238E27FC236}">
                  <a16:creationId xmlns:a16="http://schemas.microsoft.com/office/drawing/2014/main" id="{D7EB64FF-821B-C21E-7A45-C363EB0C8E8F}"/>
                </a:ext>
              </a:extLst>
            </p:cNvPr>
            <p:cNvSpPr/>
            <p:nvPr/>
          </p:nvSpPr>
          <p:spPr>
            <a:xfrm>
              <a:off x="869434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70" name="Freeform: Shape 2869">
              <a:extLst>
                <a:ext uri="{FF2B5EF4-FFF2-40B4-BE49-F238E27FC236}">
                  <a16:creationId xmlns:a16="http://schemas.microsoft.com/office/drawing/2014/main" id="{61A0D68A-8E3E-D547-03AF-78C99FDFC71A}"/>
                </a:ext>
              </a:extLst>
            </p:cNvPr>
            <p:cNvSpPr/>
            <p:nvPr/>
          </p:nvSpPr>
          <p:spPr>
            <a:xfrm>
              <a:off x="877798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71" name="Freeform: Shape 2870">
              <a:extLst>
                <a:ext uri="{FF2B5EF4-FFF2-40B4-BE49-F238E27FC236}">
                  <a16:creationId xmlns:a16="http://schemas.microsoft.com/office/drawing/2014/main" id="{55B51EDC-AE66-2A5C-A378-D14AB0C121DF}"/>
                </a:ext>
              </a:extLst>
            </p:cNvPr>
            <p:cNvSpPr/>
            <p:nvPr/>
          </p:nvSpPr>
          <p:spPr>
            <a:xfrm>
              <a:off x="886161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72" name="Freeform: Shape 2871">
              <a:extLst>
                <a:ext uri="{FF2B5EF4-FFF2-40B4-BE49-F238E27FC236}">
                  <a16:creationId xmlns:a16="http://schemas.microsoft.com/office/drawing/2014/main" id="{D1634B99-0F65-ADFF-3BC7-B7CC9404EB48}"/>
                </a:ext>
              </a:extLst>
            </p:cNvPr>
            <p:cNvSpPr/>
            <p:nvPr/>
          </p:nvSpPr>
          <p:spPr>
            <a:xfrm>
              <a:off x="894524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73" name="Freeform: Shape 2872">
              <a:extLst>
                <a:ext uri="{FF2B5EF4-FFF2-40B4-BE49-F238E27FC236}">
                  <a16:creationId xmlns:a16="http://schemas.microsoft.com/office/drawing/2014/main" id="{4BBC9CB2-A8F4-ABC6-FABB-AA6AC3D94A58}"/>
                </a:ext>
              </a:extLst>
            </p:cNvPr>
            <p:cNvSpPr/>
            <p:nvPr/>
          </p:nvSpPr>
          <p:spPr>
            <a:xfrm>
              <a:off x="902888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74" name="Freeform: Shape 2873">
              <a:extLst>
                <a:ext uri="{FF2B5EF4-FFF2-40B4-BE49-F238E27FC236}">
                  <a16:creationId xmlns:a16="http://schemas.microsoft.com/office/drawing/2014/main" id="{A62514AF-FB71-7696-9232-944E8CAF2299}"/>
                </a:ext>
              </a:extLst>
            </p:cNvPr>
            <p:cNvSpPr/>
            <p:nvPr/>
          </p:nvSpPr>
          <p:spPr>
            <a:xfrm>
              <a:off x="911251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75" name="Freeform: Shape 2874">
              <a:extLst>
                <a:ext uri="{FF2B5EF4-FFF2-40B4-BE49-F238E27FC236}">
                  <a16:creationId xmlns:a16="http://schemas.microsoft.com/office/drawing/2014/main" id="{03DA84AA-C333-76AF-6DFA-FD8673EE0D85}"/>
                </a:ext>
              </a:extLst>
            </p:cNvPr>
            <p:cNvSpPr/>
            <p:nvPr/>
          </p:nvSpPr>
          <p:spPr>
            <a:xfrm>
              <a:off x="919615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76" name="Freeform: Shape 2875">
              <a:extLst>
                <a:ext uri="{FF2B5EF4-FFF2-40B4-BE49-F238E27FC236}">
                  <a16:creationId xmlns:a16="http://schemas.microsoft.com/office/drawing/2014/main" id="{C57AB7BB-892E-DF06-2D49-137C7F9EB96F}"/>
                </a:ext>
              </a:extLst>
            </p:cNvPr>
            <p:cNvSpPr/>
            <p:nvPr/>
          </p:nvSpPr>
          <p:spPr>
            <a:xfrm>
              <a:off x="927978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77" name="Freeform: Shape 2876">
              <a:extLst>
                <a:ext uri="{FF2B5EF4-FFF2-40B4-BE49-F238E27FC236}">
                  <a16:creationId xmlns:a16="http://schemas.microsoft.com/office/drawing/2014/main" id="{6AC4CB36-5B35-1A1C-4695-3B6E44150993}"/>
                </a:ext>
              </a:extLst>
            </p:cNvPr>
            <p:cNvSpPr/>
            <p:nvPr/>
          </p:nvSpPr>
          <p:spPr>
            <a:xfrm>
              <a:off x="936342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78" name="Freeform: Shape 2877">
              <a:extLst>
                <a:ext uri="{FF2B5EF4-FFF2-40B4-BE49-F238E27FC236}">
                  <a16:creationId xmlns:a16="http://schemas.microsoft.com/office/drawing/2014/main" id="{3EA4A152-A7F7-4B90-D885-1F5E9A240FF4}"/>
                </a:ext>
              </a:extLst>
            </p:cNvPr>
            <p:cNvSpPr/>
            <p:nvPr/>
          </p:nvSpPr>
          <p:spPr>
            <a:xfrm>
              <a:off x="944706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79" name="Freeform: Shape 2878">
              <a:extLst>
                <a:ext uri="{FF2B5EF4-FFF2-40B4-BE49-F238E27FC236}">
                  <a16:creationId xmlns:a16="http://schemas.microsoft.com/office/drawing/2014/main" id="{D96EB825-79D1-3CBB-ECBB-F84B68A70C09}"/>
                </a:ext>
              </a:extLst>
            </p:cNvPr>
            <p:cNvSpPr/>
            <p:nvPr/>
          </p:nvSpPr>
          <p:spPr>
            <a:xfrm>
              <a:off x="953069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80" name="Freeform: Shape 2879">
              <a:extLst>
                <a:ext uri="{FF2B5EF4-FFF2-40B4-BE49-F238E27FC236}">
                  <a16:creationId xmlns:a16="http://schemas.microsoft.com/office/drawing/2014/main" id="{A936EBD0-03EA-FDC2-5192-028B8AAA346D}"/>
                </a:ext>
              </a:extLst>
            </p:cNvPr>
            <p:cNvSpPr/>
            <p:nvPr/>
          </p:nvSpPr>
          <p:spPr>
            <a:xfrm>
              <a:off x="961433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81" name="Freeform: Shape 2880">
              <a:extLst>
                <a:ext uri="{FF2B5EF4-FFF2-40B4-BE49-F238E27FC236}">
                  <a16:creationId xmlns:a16="http://schemas.microsoft.com/office/drawing/2014/main" id="{EB3279BD-1EB1-4FA3-82CE-E963814623C5}"/>
                </a:ext>
              </a:extLst>
            </p:cNvPr>
            <p:cNvSpPr/>
            <p:nvPr/>
          </p:nvSpPr>
          <p:spPr>
            <a:xfrm>
              <a:off x="969796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82" name="Freeform: Shape 2881">
              <a:extLst>
                <a:ext uri="{FF2B5EF4-FFF2-40B4-BE49-F238E27FC236}">
                  <a16:creationId xmlns:a16="http://schemas.microsoft.com/office/drawing/2014/main" id="{4F0F7A87-0032-3464-CA97-BE0947C6366D}"/>
                </a:ext>
              </a:extLst>
            </p:cNvPr>
            <p:cNvSpPr/>
            <p:nvPr/>
          </p:nvSpPr>
          <p:spPr>
            <a:xfrm>
              <a:off x="978160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83" name="Freeform: Shape 2882">
              <a:extLst>
                <a:ext uri="{FF2B5EF4-FFF2-40B4-BE49-F238E27FC236}">
                  <a16:creationId xmlns:a16="http://schemas.microsoft.com/office/drawing/2014/main" id="{71CCA146-911D-0F1A-E6F7-43B62B9498B1}"/>
                </a:ext>
              </a:extLst>
            </p:cNvPr>
            <p:cNvSpPr/>
            <p:nvPr/>
          </p:nvSpPr>
          <p:spPr>
            <a:xfrm>
              <a:off x="986524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84" name="Freeform: Shape 2883">
              <a:extLst>
                <a:ext uri="{FF2B5EF4-FFF2-40B4-BE49-F238E27FC236}">
                  <a16:creationId xmlns:a16="http://schemas.microsoft.com/office/drawing/2014/main" id="{9E53FB3E-2207-FEE6-7E82-001FDEC02A39}"/>
                </a:ext>
              </a:extLst>
            </p:cNvPr>
            <p:cNvSpPr/>
            <p:nvPr/>
          </p:nvSpPr>
          <p:spPr>
            <a:xfrm>
              <a:off x="994887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85" name="Freeform: Shape 2884">
              <a:extLst>
                <a:ext uri="{FF2B5EF4-FFF2-40B4-BE49-F238E27FC236}">
                  <a16:creationId xmlns:a16="http://schemas.microsoft.com/office/drawing/2014/main" id="{6C0F84B5-BA59-ECD0-3E13-3E2C97BE8AF0}"/>
                </a:ext>
              </a:extLst>
            </p:cNvPr>
            <p:cNvSpPr/>
            <p:nvPr/>
          </p:nvSpPr>
          <p:spPr>
            <a:xfrm>
              <a:off x="1003251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86" name="Freeform: Shape 2885">
              <a:extLst>
                <a:ext uri="{FF2B5EF4-FFF2-40B4-BE49-F238E27FC236}">
                  <a16:creationId xmlns:a16="http://schemas.microsoft.com/office/drawing/2014/main" id="{5DC3A03E-1030-CDE9-AF6D-DD35CA1CEEC8}"/>
                </a:ext>
              </a:extLst>
            </p:cNvPr>
            <p:cNvSpPr/>
            <p:nvPr/>
          </p:nvSpPr>
          <p:spPr>
            <a:xfrm>
              <a:off x="1011615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87" name="Freeform: Shape 2886">
              <a:extLst>
                <a:ext uri="{FF2B5EF4-FFF2-40B4-BE49-F238E27FC236}">
                  <a16:creationId xmlns:a16="http://schemas.microsoft.com/office/drawing/2014/main" id="{8E41F56A-20B2-A3AA-1823-98BDF87AA927}"/>
                </a:ext>
              </a:extLst>
            </p:cNvPr>
            <p:cNvSpPr/>
            <p:nvPr/>
          </p:nvSpPr>
          <p:spPr>
            <a:xfrm>
              <a:off x="1019978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88" name="Freeform: Shape 2887">
              <a:extLst>
                <a:ext uri="{FF2B5EF4-FFF2-40B4-BE49-F238E27FC236}">
                  <a16:creationId xmlns:a16="http://schemas.microsoft.com/office/drawing/2014/main" id="{5B171E3F-A501-D6C7-3158-FAC3DE2C76A4}"/>
                </a:ext>
              </a:extLst>
            </p:cNvPr>
            <p:cNvSpPr/>
            <p:nvPr/>
          </p:nvSpPr>
          <p:spPr>
            <a:xfrm>
              <a:off x="1028342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89" name="Freeform: Shape 2888">
              <a:extLst>
                <a:ext uri="{FF2B5EF4-FFF2-40B4-BE49-F238E27FC236}">
                  <a16:creationId xmlns:a16="http://schemas.microsoft.com/office/drawing/2014/main" id="{39EFFC6A-7036-A4DD-D3C4-1612AABF4180}"/>
                </a:ext>
              </a:extLst>
            </p:cNvPr>
            <p:cNvSpPr/>
            <p:nvPr/>
          </p:nvSpPr>
          <p:spPr>
            <a:xfrm>
              <a:off x="1036705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90" name="Freeform: Shape 2889">
              <a:extLst>
                <a:ext uri="{FF2B5EF4-FFF2-40B4-BE49-F238E27FC236}">
                  <a16:creationId xmlns:a16="http://schemas.microsoft.com/office/drawing/2014/main" id="{E2F19848-8391-521D-B539-475F2687E2CB}"/>
                </a:ext>
              </a:extLst>
            </p:cNvPr>
            <p:cNvSpPr/>
            <p:nvPr/>
          </p:nvSpPr>
          <p:spPr>
            <a:xfrm>
              <a:off x="1040887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6884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91" name="Freeform: Shape 2890">
              <a:extLst>
                <a:ext uri="{FF2B5EF4-FFF2-40B4-BE49-F238E27FC236}">
                  <a16:creationId xmlns:a16="http://schemas.microsoft.com/office/drawing/2014/main" id="{712E2D5C-103E-3B5E-7D81-5A90202FA7DC}"/>
                </a:ext>
              </a:extLst>
            </p:cNvPr>
            <p:cNvSpPr/>
            <p:nvPr/>
          </p:nvSpPr>
          <p:spPr>
            <a:xfrm>
              <a:off x="1534338" y="4637345"/>
              <a:ext cx="9218269" cy="9677"/>
            </a:xfrm>
            <a:custGeom>
              <a:avLst/>
              <a:gdLst>
                <a:gd name="connsiteX0" fmla="*/ 0 w 9218269"/>
                <a:gd name="connsiteY0" fmla="*/ 0 h 9677"/>
                <a:gd name="connsiteX1" fmla="*/ 9218269 w 9218269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18269" h="9677">
                  <a:moveTo>
                    <a:pt x="0" y="0"/>
                  </a:moveTo>
                  <a:lnTo>
                    <a:pt x="9218269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92" name="Freeform: Shape 2891">
              <a:extLst>
                <a:ext uri="{FF2B5EF4-FFF2-40B4-BE49-F238E27FC236}">
                  <a16:creationId xmlns:a16="http://schemas.microsoft.com/office/drawing/2014/main" id="{F13BBF99-F9B7-08BD-1696-C13561ED4B4E}"/>
                </a:ext>
              </a:extLst>
            </p:cNvPr>
            <p:cNvSpPr/>
            <p:nvPr/>
          </p:nvSpPr>
          <p:spPr>
            <a:xfrm>
              <a:off x="1534338" y="3624901"/>
              <a:ext cx="9218269" cy="9677"/>
            </a:xfrm>
            <a:custGeom>
              <a:avLst/>
              <a:gdLst>
                <a:gd name="connsiteX0" fmla="*/ 0 w 9218269"/>
                <a:gd name="connsiteY0" fmla="*/ 0 h 9677"/>
                <a:gd name="connsiteX1" fmla="*/ 9218269 w 9218269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18269" h="9677">
                  <a:moveTo>
                    <a:pt x="0" y="0"/>
                  </a:moveTo>
                  <a:lnTo>
                    <a:pt x="9218269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93" name="Freeform: Shape 2892">
              <a:extLst>
                <a:ext uri="{FF2B5EF4-FFF2-40B4-BE49-F238E27FC236}">
                  <a16:creationId xmlns:a16="http://schemas.microsoft.com/office/drawing/2014/main" id="{54076F71-F2A2-FA96-D4A6-A0658C9E8E58}"/>
                </a:ext>
              </a:extLst>
            </p:cNvPr>
            <p:cNvSpPr/>
            <p:nvPr/>
          </p:nvSpPr>
          <p:spPr>
            <a:xfrm>
              <a:off x="1534338" y="2612457"/>
              <a:ext cx="9218269" cy="9677"/>
            </a:xfrm>
            <a:custGeom>
              <a:avLst/>
              <a:gdLst>
                <a:gd name="connsiteX0" fmla="*/ 0 w 9218269"/>
                <a:gd name="connsiteY0" fmla="*/ 0 h 9677"/>
                <a:gd name="connsiteX1" fmla="*/ 9218269 w 9218269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18269" h="9677">
                  <a:moveTo>
                    <a:pt x="0" y="0"/>
                  </a:moveTo>
                  <a:lnTo>
                    <a:pt x="9218269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94" name="Freeform: Shape 2893">
              <a:extLst>
                <a:ext uri="{FF2B5EF4-FFF2-40B4-BE49-F238E27FC236}">
                  <a16:creationId xmlns:a16="http://schemas.microsoft.com/office/drawing/2014/main" id="{E3399A91-B359-5A74-E1E8-099D8FE7E081}"/>
                </a:ext>
              </a:extLst>
            </p:cNvPr>
            <p:cNvSpPr/>
            <p:nvPr/>
          </p:nvSpPr>
          <p:spPr>
            <a:xfrm>
              <a:off x="1534338" y="1600013"/>
              <a:ext cx="9218269" cy="9677"/>
            </a:xfrm>
            <a:custGeom>
              <a:avLst/>
              <a:gdLst>
                <a:gd name="connsiteX0" fmla="*/ 0 w 9218269"/>
                <a:gd name="connsiteY0" fmla="*/ 0 h 9677"/>
                <a:gd name="connsiteX1" fmla="*/ 9218269 w 9218269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18269" h="9677">
                  <a:moveTo>
                    <a:pt x="0" y="0"/>
                  </a:moveTo>
                  <a:lnTo>
                    <a:pt x="9218269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95" name="Freeform: Shape 2894">
              <a:extLst>
                <a:ext uri="{FF2B5EF4-FFF2-40B4-BE49-F238E27FC236}">
                  <a16:creationId xmlns:a16="http://schemas.microsoft.com/office/drawing/2014/main" id="{CB24ED8F-3DA4-137E-7DD7-C9C0A051B7C6}"/>
                </a:ext>
              </a:extLst>
            </p:cNvPr>
            <p:cNvSpPr/>
            <p:nvPr/>
          </p:nvSpPr>
          <p:spPr>
            <a:xfrm>
              <a:off x="1534338" y="587562"/>
              <a:ext cx="9218269" cy="9677"/>
            </a:xfrm>
            <a:custGeom>
              <a:avLst/>
              <a:gdLst>
                <a:gd name="connsiteX0" fmla="*/ 0 w 9218269"/>
                <a:gd name="connsiteY0" fmla="*/ 0 h 9677"/>
                <a:gd name="connsiteX1" fmla="*/ 9218269 w 9218269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218269" h="9677">
                  <a:moveTo>
                    <a:pt x="0" y="0"/>
                  </a:moveTo>
                  <a:lnTo>
                    <a:pt x="9218269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96" name="Freeform: Shape 2895">
              <a:extLst>
                <a:ext uri="{FF2B5EF4-FFF2-40B4-BE49-F238E27FC236}">
                  <a16:creationId xmlns:a16="http://schemas.microsoft.com/office/drawing/2014/main" id="{7A9B8C47-9ADA-3FD8-E204-D52F1F5923E8}"/>
                </a:ext>
              </a:extLst>
            </p:cNvPr>
            <p:cNvSpPr/>
            <p:nvPr/>
          </p:nvSpPr>
          <p:spPr>
            <a:xfrm>
              <a:off x="196170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97" name="Freeform: Shape 2896">
              <a:extLst>
                <a:ext uri="{FF2B5EF4-FFF2-40B4-BE49-F238E27FC236}">
                  <a16:creationId xmlns:a16="http://schemas.microsoft.com/office/drawing/2014/main" id="{D40B0C6F-0F11-009C-F437-E5EDCFB2F90D}"/>
                </a:ext>
              </a:extLst>
            </p:cNvPr>
            <p:cNvSpPr/>
            <p:nvPr/>
          </p:nvSpPr>
          <p:spPr>
            <a:xfrm>
              <a:off x="204534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98" name="Freeform: Shape 2897">
              <a:extLst>
                <a:ext uri="{FF2B5EF4-FFF2-40B4-BE49-F238E27FC236}">
                  <a16:creationId xmlns:a16="http://schemas.microsoft.com/office/drawing/2014/main" id="{49594CB4-FFD1-C295-CF4C-1E328320E3D8}"/>
                </a:ext>
              </a:extLst>
            </p:cNvPr>
            <p:cNvSpPr/>
            <p:nvPr/>
          </p:nvSpPr>
          <p:spPr>
            <a:xfrm>
              <a:off x="212897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899" name="Freeform: Shape 2898">
              <a:extLst>
                <a:ext uri="{FF2B5EF4-FFF2-40B4-BE49-F238E27FC236}">
                  <a16:creationId xmlns:a16="http://schemas.microsoft.com/office/drawing/2014/main" id="{318929CC-7850-CF90-BB10-1A8245B7F3CC}"/>
                </a:ext>
              </a:extLst>
            </p:cNvPr>
            <p:cNvSpPr/>
            <p:nvPr/>
          </p:nvSpPr>
          <p:spPr>
            <a:xfrm>
              <a:off x="221260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00" name="Freeform: Shape 2899">
              <a:extLst>
                <a:ext uri="{FF2B5EF4-FFF2-40B4-BE49-F238E27FC236}">
                  <a16:creationId xmlns:a16="http://schemas.microsoft.com/office/drawing/2014/main" id="{A2433D39-BA42-CB4B-EFCB-D38DE1C8708A}"/>
                </a:ext>
              </a:extLst>
            </p:cNvPr>
            <p:cNvSpPr/>
            <p:nvPr/>
          </p:nvSpPr>
          <p:spPr>
            <a:xfrm>
              <a:off x="229624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01" name="Freeform: Shape 2900">
              <a:extLst>
                <a:ext uri="{FF2B5EF4-FFF2-40B4-BE49-F238E27FC236}">
                  <a16:creationId xmlns:a16="http://schemas.microsoft.com/office/drawing/2014/main" id="{A30448FF-6832-17C2-5E8E-FDA7E25479AF}"/>
                </a:ext>
              </a:extLst>
            </p:cNvPr>
            <p:cNvSpPr/>
            <p:nvPr/>
          </p:nvSpPr>
          <p:spPr>
            <a:xfrm>
              <a:off x="237988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02" name="Freeform: Shape 2901">
              <a:extLst>
                <a:ext uri="{FF2B5EF4-FFF2-40B4-BE49-F238E27FC236}">
                  <a16:creationId xmlns:a16="http://schemas.microsoft.com/office/drawing/2014/main" id="{11125203-1DDE-43BC-DEAC-A24E8F2ECF5F}"/>
                </a:ext>
              </a:extLst>
            </p:cNvPr>
            <p:cNvSpPr/>
            <p:nvPr/>
          </p:nvSpPr>
          <p:spPr>
            <a:xfrm>
              <a:off x="246351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03" name="Freeform: Shape 2902">
              <a:extLst>
                <a:ext uri="{FF2B5EF4-FFF2-40B4-BE49-F238E27FC236}">
                  <a16:creationId xmlns:a16="http://schemas.microsoft.com/office/drawing/2014/main" id="{12D78B22-513A-798E-BB90-7F4C9F0C12FB}"/>
                </a:ext>
              </a:extLst>
            </p:cNvPr>
            <p:cNvSpPr/>
            <p:nvPr/>
          </p:nvSpPr>
          <p:spPr>
            <a:xfrm>
              <a:off x="254715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04" name="Freeform: Shape 2903">
              <a:extLst>
                <a:ext uri="{FF2B5EF4-FFF2-40B4-BE49-F238E27FC236}">
                  <a16:creationId xmlns:a16="http://schemas.microsoft.com/office/drawing/2014/main" id="{800FEF89-99DD-619C-064F-78C216E6E9B9}"/>
                </a:ext>
              </a:extLst>
            </p:cNvPr>
            <p:cNvSpPr/>
            <p:nvPr/>
          </p:nvSpPr>
          <p:spPr>
            <a:xfrm>
              <a:off x="263079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05" name="Freeform: Shape 2904">
              <a:extLst>
                <a:ext uri="{FF2B5EF4-FFF2-40B4-BE49-F238E27FC236}">
                  <a16:creationId xmlns:a16="http://schemas.microsoft.com/office/drawing/2014/main" id="{9E9CCDF0-33C4-7766-4FD2-B61F0E8A5D43}"/>
                </a:ext>
              </a:extLst>
            </p:cNvPr>
            <p:cNvSpPr/>
            <p:nvPr/>
          </p:nvSpPr>
          <p:spPr>
            <a:xfrm>
              <a:off x="271442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06" name="Freeform: Shape 2905">
              <a:extLst>
                <a:ext uri="{FF2B5EF4-FFF2-40B4-BE49-F238E27FC236}">
                  <a16:creationId xmlns:a16="http://schemas.microsoft.com/office/drawing/2014/main" id="{76F9EDF9-8433-4D6E-550A-24889A7CC412}"/>
                </a:ext>
              </a:extLst>
            </p:cNvPr>
            <p:cNvSpPr/>
            <p:nvPr/>
          </p:nvSpPr>
          <p:spPr>
            <a:xfrm>
              <a:off x="279806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07" name="Freeform: Shape 2906">
              <a:extLst>
                <a:ext uri="{FF2B5EF4-FFF2-40B4-BE49-F238E27FC236}">
                  <a16:creationId xmlns:a16="http://schemas.microsoft.com/office/drawing/2014/main" id="{CCFEA3FF-9C76-075A-463F-B432222C9027}"/>
                </a:ext>
              </a:extLst>
            </p:cNvPr>
            <p:cNvSpPr/>
            <p:nvPr/>
          </p:nvSpPr>
          <p:spPr>
            <a:xfrm>
              <a:off x="288169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08" name="Freeform: Shape 2907">
              <a:extLst>
                <a:ext uri="{FF2B5EF4-FFF2-40B4-BE49-F238E27FC236}">
                  <a16:creationId xmlns:a16="http://schemas.microsoft.com/office/drawing/2014/main" id="{5AE15AF7-2C01-A0FC-1393-FAD113C95414}"/>
                </a:ext>
              </a:extLst>
            </p:cNvPr>
            <p:cNvSpPr/>
            <p:nvPr/>
          </p:nvSpPr>
          <p:spPr>
            <a:xfrm>
              <a:off x="296533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09" name="Freeform: Shape 2908">
              <a:extLst>
                <a:ext uri="{FF2B5EF4-FFF2-40B4-BE49-F238E27FC236}">
                  <a16:creationId xmlns:a16="http://schemas.microsoft.com/office/drawing/2014/main" id="{150897EB-97F1-B4A2-E69A-149D9EBDA4E2}"/>
                </a:ext>
              </a:extLst>
            </p:cNvPr>
            <p:cNvSpPr/>
            <p:nvPr/>
          </p:nvSpPr>
          <p:spPr>
            <a:xfrm>
              <a:off x="304897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10" name="Freeform: Shape 2909">
              <a:extLst>
                <a:ext uri="{FF2B5EF4-FFF2-40B4-BE49-F238E27FC236}">
                  <a16:creationId xmlns:a16="http://schemas.microsoft.com/office/drawing/2014/main" id="{BEDCD94D-7934-8C38-289A-646BCB47945E}"/>
                </a:ext>
              </a:extLst>
            </p:cNvPr>
            <p:cNvSpPr/>
            <p:nvPr/>
          </p:nvSpPr>
          <p:spPr>
            <a:xfrm>
              <a:off x="313260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11" name="Freeform: Shape 2910">
              <a:extLst>
                <a:ext uri="{FF2B5EF4-FFF2-40B4-BE49-F238E27FC236}">
                  <a16:creationId xmlns:a16="http://schemas.microsoft.com/office/drawing/2014/main" id="{B98C9175-2993-126B-DA79-4F6014090752}"/>
                </a:ext>
              </a:extLst>
            </p:cNvPr>
            <p:cNvSpPr/>
            <p:nvPr/>
          </p:nvSpPr>
          <p:spPr>
            <a:xfrm>
              <a:off x="321624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12" name="Freeform: Shape 2911">
              <a:extLst>
                <a:ext uri="{FF2B5EF4-FFF2-40B4-BE49-F238E27FC236}">
                  <a16:creationId xmlns:a16="http://schemas.microsoft.com/office/drawing/2014/main" id="{26A617C6-0E56-A39B-CB26-FA4281BC5815}"/>
                </a:ext>
              </a:extLst>
            </p:cNvPr>
            <p:cNvSpPr/>
            <p:nvPr/>
          </p:nvSpPr>
          <p:spPr>
            <a:xfrm>
              <a:off x="329988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13" name="Freeform: Shape 2912">
              <a:extLst>
                <a:ext uri="{FF2B5EF4-FFF2-40B4-BE49-F238E27FC236}">
                  <a16:creationId xmlns:a16="http://schemas.microsoft.com/office/drawing/2014/main" id="{4C5F327E-8F0C-EF5F-9FC8-E78534A89902}"/>
                </a:ext>
              </a:extLst>
            </p:cNvPr>
            <p:cNvSpPr/>
            <p:nvPr/>
          </p:nvSpPr>
          <p:spPr>
            <a:xfrm>
              <a:off x="338351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14" name="Freeform: Shape 2913">
              <a:extLst>
                <a:ext uri="{FF2B5EF4-FFF2-40B4-BE49-F238E27FC236}">
                  <a16:creationId xmlns:a16="http://schemas.microsoft.com/office/drawing/2014/main" id="{4CD146FE-8CAA-8C37-341C-E1BAFDE50A6B}"/>
                </a:ext>
              </a:extLst>
            </p:cNvPr>
            <p:cNvSpPr/>
            <p:nvPr/>
          </p:nvSpPr>
          <p:spPr>
            <a:xfrm>
              <a:off x="346714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15" name="Freeform: Shape 2914">
              <a:extLst>
                <a:ext uri="{FF2B5EF4-FFF2-40B4-BE49-F238E27FC236}">
                  <a16:creationId xmlns:a16="http://schemas.microsoft.com/office/drawing/2014/main" id="{E2294EA7-CFE2-5614-0632-44FF341EDF83}"/>
                </a:ext>
              </a:extLst>
            </p:cNvPr>
            <p:cNvSpPr/>
            <p:nvPr/>
          </p:nvSpPr>
          <p:spPr>
            <a:xfrm>
              <a:off x="355077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16" name="Freeform: Shape 2915">
              <a:extLst>
                <a:ext uri="{FF2B5EF4-FFF2-40B4-BE49-F238E27FC236}">
                  <a16:creationId xmlns:a16="http://schemas.microsoft.com/office/drawing/2014/main" id="{6190B4BE-2048-23CC-5850-9B6164D9B962}"/>
                </a:ext>
              </a:extLst>
            </p:cNvPr>
            <p:cNvSpPr/>
            <p:nvPr/>
          </p:nvSpPr>
          <p:spPr>
            <a:xfrm>
              <a:off x="363441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17" name="Freeform: Shape 2916">
              <a:extLst>
                <a:ext uri="{FF2B5EF4-FFF2-40B4-BE49-F238E27FC236}">
                  <a16:creationId xmlns:a16="http://schemas.microsoft.com/office/drawing/2014/main" id="{8463AE67-555E-168A-8058-A4E8514B6CF8}"/>
                </a:ext>
              </a:extLst>
            </p:cNvPr>
            <p:cNvSpPr/>
            <p:nvPr/>
          </p:nvSpPr>
          <p:spPr>
            <a:xfrm>
              <a:off x="371805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18" name="Freeform: Shape 2917">
              <a:extLst>
                <a:ext uri="{FF2B5EF4-FFF2-40B4-BE49-F238E27FC236}">
                  <a16:creationId xmlns:a16="http://schemas.microsoft.com/office/drawing/2014/main" id="{F206E85E-A9D0-F569-55F3-CDE8EAEFFC2E}"/>
                </a:ext>
              </a:extLst>
            </p:cNvPr>
            <p:cNvSpPr/>
            <p:nvPr/>
          </p:nvSpPr>
          <p:spPr>
            <a:xfrm>
              <a:off x="380168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19" name="Freeform: Shape 2918">
              <a:extLst>
                <a:ext uri="{FF2B5EF4-FFF2-40B4-BE49-F238E27FC236}">
                  <a16:creationId xmlns:a16="http://schemas.microsoft.com/office/drawing/2014/main" id="{7ED8145E-F7CE-16B7-6CDB-BF2CAC796BAA}"/>
                </a:ext>
              </a:extLst>
            </p:cNvPr>
            <p:cNvSpPr/>
            <p:nvPr/>
          </p:nvSpPr>
          <p:spPr>
            <a:xfrm>
              <a:off x="388532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20" name="Freeform: Shape 2919">
              <a:extLst>
                <a:ext uri="{FF2B5EF4-FFF2-40B4-BE49-F238E27FC236}">
                  <a16:creationId xmlns:a16="http://schemas.microsoft.com/office/drawing/2014/main" id="{59BDD452-74A4-C8EC-9FB4-B6D2E09EC849}"/>
                </a:ext>
              </a:extLst>
            </p:cNvPr>
            <p:cNvSpPr/>
            <p:nvPr/>
          </p:nvSpPr>
          <p:spPr>
            <a:xfrm>
              <a:off x="396896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21" name="Freeform: Shape 2920">
              <a:extLst>
                <a:ext uri="{FF2B5EF4-FFF2-40B4-BE49-F238E27FC236}">
                  <a16:creationId xmlns:a16="http://schemas.microsoft.com/office/drawing/2014/main" id="{D8579BC0-4D8C-216A-1516-50DE622753B3}"/>
                </a:ext>
              </a:extLst>
            </p:cNvPr>
            <p:cNvSpPr/>
            <p:nvPr/>
          </p:nvSpPr>
          <p:spPr>
            <a:xfrm>
              <a:off x="405259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22" name="Freeform: Shape 2921">
              <a:extLst>
                <a:ext uri="{FF2B5EF4-FFF2-40B4-BE49-F238E27FC236}">
                  <a16:creationId xmlns:a16="http://schemas.microsoft.com/office/drawing/2014/main" id="{E0F88985-FEB5-6331-8F20-1CE8878A42D6}"/>
                </a:ext>
              </a:extLst>
            </p:cNvPr>
            <p:cNvSpPr/>
            <p:nvPr/>
          </p:nvSpPr>
          <p:spPr>
            <a:xfrm>
              <a:off x="413623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23" name="Freeform: Shape 2922">
              <a:extLst>
                <a:ext uri="{FF2B5EF4-FFF2-40B4-BE49-F238E27FC236}">
                  <a16:creationId xmlns:a16="http://schemas.microsoft.com/office/drawing/2014/main" id="{6AD53479-A88F-0614-0DAD-1D17E78D91D5}"/>
                </a:ext>
              </a:extLst>
            </p:cNvPr>
            <p:cNvSpPr/>
            <p:nvPr/>
          </p:nvSpPr>
          <p:spPr>
            <a:xfrm>
              <a:off x="421986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24" name="Freeform: Shape 2923">
              <a:extLst>
                <a:ext uri="{FF2B5EF4-FFF2-40B4-BE49-F238E27FC236}">
                  <a16:creationId xmlns:a16="http://schemas.microsoft.com/office/drawing/2014/main" id="{106BB124-64AE-8D51-8E03-51A1ADF7B479}"/>
                </a:ext>
              </a:extLst>
            </p:cNvPr>
            <p:cNvSpPr/>
            <p:nvPr/>
          </p:nvSpPr>
          <p:spPr>
            <a:xfrm>
              <a:off x="430350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25" name="Freeform: Shape 2924">
              <a:extLst>
                <a:ext uri="{FF2B5EF4-FFF2-40B4-BE49-F238E27FC236}">
                  <a16:creationId xmlns:a16="http://schemas.microsoft.com/office/drawing/2014/main" id="{4F33592E-4116-9E6A-D13F-686BC108D502}"/>
                </a:ext>
              </a:extLst>
            </p:cNvPr>
            <p:cNvSpPr/>
            <p:nvPr/>
          </p:nvSpPr>
          <p:spPr>
            <a:xfrm>
              <a:off x="438714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26" name="Freeform: Shape 2925">
              <a:extLst>
                <a:ext uri="{FF2B5EF4-FFF2-40B4-BE49-F238E27FC236}">
                  <a16:creationId xmlns:a16="http://schemas.microsoft.com/office/drawing/2014/main" id="{B32E7F2F-0DB0-E7AC-589B-9C17852560FC}"/>
                </a:ext>
              </a:extLst>
            </p:cNvPr>
            <p:cNvSpPr/>
            <p:nvPr/>
          </p:nvSpPr>
          <p:spPr>
            <a:xfrm>
              <a:off x="447077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27" name="Freeform: Shape 2926">
              <a:extLst>
                <a:ext uri="{FF2B5EF4-FFF2-40B4-BE49-F238E27FC236}">
                  <a16:creationId xmlns:a16="http://schemas.microsoft.com/office/drawing/2014/main" id="{C125E429-C97A-FF38-1B79-BB780C75DD05}"/>
                </a:ext>
              </a:extLst>
            </p:cNvPr>
            <p:cNvSpPr/>
            <p:nvPr/>
          </p:nvSpPr>
          <p:spPr>
            <a:xfrm>
              <a:off x="455441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28" name="Freeform: Shape 2927">
              <a:extLst>
                <a:ext uri="{FF2B5EF4-FFF2-40B4-BE49-F238E27FC236}">
                  <a16:creationId xmlns:a16="http://schemas.microsoft.com/office/drawing/2014/main" id="{388C22BE-CB85-010B-1397-CF4E638D7516}"/>
                </a:ext>
              </a:extLst>
            </p:cNvPr>
            <p:cNvSpPr/>
            <p:nvPr/>
          </p:nvSpPr>
          <p:spPr>
            <a:xfrm>
              <a:off x="463805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29" name="Freeform: Shape 2928">
              <a:extLst>
                <a:ext uri="{FF2B5EF4-FFF2-40B4-BE49-F238E27FC236}">
                  <a16:creationId xmlns:a16="http://schemas.microsoft.com/office/drawing/2014/main" id="{01C78D72-E6B0-D3E9-3709-F978F648E7A3}"/>
                </a:ext>
              </a:extLst>
            </p:cNvPr>
            <p:cNvSpPr/>
            <p:nvPr/>
          </p:nvSpPr>
          <p:spPr>
            <a:xfrm>
              <a:off x="472168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30" name="Freeform: Shape 2929">
              <a:extLst>
                <a:ext uri="{FF2B5EF4-FFF2-40B4-BE49-F238E27FC236}">
                  <a16:creationId xmlns:a16="http://schemas.microsoft.com/office/drawing/2014/main" id="{5D490BD5-3445-01E9-9E49-CAEE663B7432}"/>
                </a:ext>
              </a:extLst>
            </p:cNvPr>
            <p:cNvSpPr/>
            <p:nvPr/>
          </p:nvSpPr>
          <p:spPr>
            <a:xfrm>
              <a:off x="480532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31" name="Freeform: Shape 2930">
              <a:extLst>
                <a:ext uri="{FF2B5EF4-FFF2-40B4-BE49-F238E27FC236}">
                  <a16:creationId xmlns:a16="http://schemas.microsoft.com/office/drawing/2014/main" id="{9F0CA887-1E20-28B9-1BFA-A2707AFA44DE}"/>
                </a:ext>
              </a:extLst>
            </p:cNvPr>
            <p:cNvSpPr/>
            <p:nvPr/>
          </p:nvSpPr>
          <p:spPr>
            <a:xfrm>
              <a:off x="488895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32" name="Freeform: Shape 2931">
              <a:extLst>
                <a:ext uri="{FF2B5EF4-FFF2-40B4-BE49-F238E27FC236}">
                  <a16:creationId xmlns:a16="http://schemas.microsoft.com/office/drawing/2014/main" id="{A0B07BAD-A7DD-8C8D-6A89-5EEC0CE61F44}"/>
                </a:ext>
              </a:extLst>
            </p:cNvPr>
            <p:cNvSpPr/>
            <p:nvPr/>
          </p:nvSpPr>
          <p:spPr>
            <a:xfrm>
              <a:off x="497258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33" name="Freeform: Shape 2932">
              <a:extLst>
                <a:ext uri="{FF2B5EF4-FFF2-40B4-BE49-F238E27FC236}">
                  <a16:creationId xmlns:a16="http://schemas.microsoft.com/office/drawing/2014/main" id="{E47E6121-E4E1-B785-866E-97D4EE52FD7E}"/>
                </a:ext>
              </a:extLst>
            </p:cNvPr>
            <p:cNvSpPr/>
            <p:nvPr/>
          </p:nvSpPr>
          <p:spPr>
            <a:xfrm>
              <a:off x="505622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34" name="Freeform: Shape 2933">
              <a:extLst>
                <a:ext uri="{FF2B5EF4-FFF2-40B4-BE49-F238E27FC236}">
                  <a16:creationId xmlns:a16="http://schemas.microsoft.com/office/drawing/2014/main" id="{39BD6D2C-7506-5A20-F70B-A5CC9CD9F387}"/>
                </a:ext>
              </a:extLst>
            </p:cNvPr>
            <p:cNvSpPr/>
            <p:nvPr/>
          </p:nvSpPr>
          <p:spPr>
            <a:xfrm>
              <a:off x="513985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35" name="Freeform: Shape 2934">
              <a:extLst>
                <a:ext uri="{FF2B5EF4-FFF2-40B4-BE49-F238E27FC236}">
                  <a16:creationId xmlns:a16="http://schemas.microsoft.com/office/drawing/2014/main" id="{94B60CAB-C984-B694-FD86-7C1FE34D9A62}"/>
                </a:ext>
              </a:extLst>
            </p:cNvPr>
            <p:cNvSpPr/>
            <p:nvPr/>
          </p:nvSpPr>
          <p:spPr>
            <a:xfrm>
              <a:off x="522349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36" name="Freeform: Shape 2935">
              <a:extLst>
                <a:ext uri="{FF2B5EF4-FFF2-40B4-BE49-F238E27FC236}">
                  <a16:creationId xmlns:a16="http://schemas.microsoft.com/office/drawing/2014/main" id="{1D964DFC-25F3-E0D7-E6AB-29930B4618B2}"/>
                </a:ext>
              </a:extLst>
            </p:cNvPr>
            <p:cNvSpPr/>
            <p:nvPr/>
          </p:nvSpPr>
          <p:spPr>
            <a:xfrm>
              <a:off x="530713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37" name="Freeform: Shape 2936">
              <a:extLst>
                <a:ext uri="{FF2B5EF4-FFF2-40B4-BE49-F238E27FC236}">
                  <a16:creationId xmlns:a16="http://schemas.microsoft.com/office/drawing/2014/main" id="{2C41CC31-9972-094E-6311-B608914B7A76}"/>
                </a:ext>
              </a:extLst>
            </p:cNvPr>
            <p:cNvSpPr/>
            <p:nvPr/>
          </p:nvSpPr>
          <p:spPr>
            <a:xfrm>
              <a:off x="539076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38" name="Freeform: Shape 2937">
              <a:extLst>
                <a:ext uri="{FF2B5EF4-FFF2-40B4-BE49-F238E27FC236}">
                  <a16:creationId xmlns:a16="http://schemas.microsoft.com/office/drawing/2014/main" id="{77F72514-4F22-9EAF-EE99-E1D730307264}"/>
                </a:ext>
              </a:extLst>
            </p:cNvPr>
            <p:cNvSpPr/>
            <p:nvPr/>
          </p:nvSpPr>
          <p:spPr>
            <a:xfrm>
              <a:off x="547440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39" name="Freeform: Shape 2938">
              <a:extLst>
                <a:ext uri="{FF2B5EF4-FFF2-40B4-BE49-F238E27FC236}">
                  <a16:creationId xmlns:a16="http://schemas.microsoft.com/office/drawing/2014/main" id="{DC7D6626-4219-5613-2C2B-99DF5FD12EDD}"/>
                </a:ext>
              </a:extLst>
            </p:cNvPr>
            <p:cNvSpPr/>
            <p:nvPr/>
          </p:nvSpPr>
          <p:spPr>
            <a:xfrm>
              <a:off x="555803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40" name="Freeform: Shape 2939">
              <a:extLst>
                <a:ext uri="{FF2B5EF4-FFF2-40B4-BE49-F238E27FC236}">
                  <a16:creationId xmlns:a16="http://schemas.microsoft.com/office/drawing/2014/main" id="{58F0AEB0-A782-C0A6-CCE6-8CE34018E693}"/>
                </a:ext>
              </a:extLst>
            </p:cNvPr>
            <p:cNvSpPr/>
            <p:nvPr/>
          </p:nvSpPr>
          <p:spPr>
            <a:xfrm>
              <a:off x="564167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41" name="Freeform: Shape 2940">
              <a:extLst>
                <a:ext uri="{FF2B5EF4-FFF2-40B4-BE49-F238E27FC236}">
                  <a16:creationId xmlns:a16="http://schemas.microsoft.com/office/drawing/2014/main" id="{6783C054-6E96-DABF-788B-DEA889FC40A5}"/>
                </a:ext>
              </a:extLst>
            </p:cNvPr>
            <p:cNvSpPr/>
            <p:nvPr/>
          </p:nvSpPr>
          <p:spPr>
            <a:xfrm>
              <a:off x="572531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42" name="Freeform: Shape 2941">
              <a:extLst>
                <a:ext uri="{FF2B5EF4-FFF2-40B4-BE49-F238E27FC236}">
                  <a16:creationId xmlns:a16="http://schemas.microsoft.com/office/drawing/2014/main" id="{CF27D965-1B51-DEE8-4332-ED88368E94FA}"/>
                </a:ext>
              </a:extLst>
            </p:cNvPr>
            <p:cNvSpPr/>
            <p:nvPr/>
          </p:nvSpPr>
          <p:spPr>
            <a:xfrm>
              <a:off x="580894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43" name="Freeform: Shape 2942">
              <a:extLst>
                <a:ext uri="{FF2B5EF4-FFF2-40B4-BE49-F238E27FC236}">
                  <a16:creationId xmlns:a16="http://schemas.microsoft.com/office/drawing/2014/main" id="{E0E19233-A52E-70BC-7563-79D79702DEFE}"/>
                </a:ext>
              </a:extLst>
            </p:cNvPr>
            <p:cNvSpPr/>
            <p:nvPr/>
          </p:nvSpPr>
          <p:spPr>
            <a:xfrm>
              <a:off x="589258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44" name="Freeform: Shape 2943">
              <a:extLst>
                <a:ext uri="{FF2B5EF4-FFF2-40B4-BE49-F238E27FC236}">
                  <a16:creationId xmlns:a16="http://schemas.microsoft.com/office/drawing/2014/main" id="{8E512D19-40DB-9A51-9659-E5CF13ECB51A}"/>
                </a:ext>
              </a:extLst>
            </p:cNvPr>
            <p:cNvSpPr/>
            <p:nvPr/>
          </p:nvSpPr>
          <p:spPr>
            <a:xfrm>
              <a:off x="597622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45" name="Freeform: Shape 2944">
              <a:extLst>
                <a:ext uri="{FF2B5EF4-FFF2-40B4-BE49-F238E27FC236}">
                  <a16:creationId xmlns:a16="http://schemas.microsoft.com/office/drawing/2014/main" id="{F993CE0B-C690-7D34-FE7F-A281ABF21D17}"/>
                </a:ext>
              </a:extLst>
            </p:cNvPr>
            <p:cNvSpPr/>
            <p:nvPr/>
          </p:nvSpPr>
          <p:spPr>
            <a:xfrm>
              <a:off x="605985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46" name="Freeform: Shape 2945">
              <a:extLst>
                <a:ext uri="{FF2B5EF4-FFF2-40B4-BE49-F238E27FC236}">
                  <a16:creationId xmlns:a16="http://schemas.microsoft.com/office/drawing/2014/main" id="{C1BD7E5D-4388-B8A8-08CB-DD525ADC2AB1}"/>
                </a:ext>
              </a:extLst>
            </p:cNvPr>
            <p:cNvSpPr/>
            <p:nvPr/>
          </p:nvSpPr>
          <p:spPr>
            <a:xfrm>
              <a:off x="614349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47" name="Freeform: Shape 2946">
              <a:extLst>
                <a:ext uri="{FF2B5EF4-FFF2-40B4-BE49-F238E27FC236}">
                  <a16:creationId xmlns:a16="http://schemas.microsoft.com/office/drawing/2014/main" id="{CF9126A3-FE7E-4BE1-5B51-5FD60EF0A7D8}"/>
                </a:ext>
              </a:extLst>
            </p:cNvPr>
            <p:cNvSpPr/>
            <p:nvPr/>
          </p:nvSpPr>
          <p:spPr>
            <a:xfrm>
              <a:off x="622712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48" name="Freeform: Shape 2947">
              <a:extLst>
                <a:ext uri="{FF2B5EF4-FFF2-40B4-BE49-F238E27FC236}">
                  <a16:creationId xmlns:a16="http://schemas.microsoft.com/office/drawing/2014/main" id="{E0EB75AB-10EA-403D-5EC1-DD934F672981}"/>
                </a:ext>
              </a:extLst>
            </p:cNvPr>
            <p:cNvSpPr/>
            <p:nvPr/>
          </p:nvSpPr>
          <p:spPr>
            <a:xfrm>
              <a:off x="631076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49" name="Freeform: Shape 2948">
              <a:extLst>
                <a:ext uri="{FF2B5EF4-FFF2-40B4-BE49-F238E27FC236}">
                  <a16:creationId xmlns:a16="http://schemas.microsoft.com/office/drawing/2014/main" id="{83BE1F1A-E858-CDAC-E779-0405915C6130}"/>
                </a:ext>
              </a:extLst>
            </p:cNvPr>
            <p:cNvSpPr/>
            <p:nvPr/>
          </p:nvSpPr>
          <p:spPr>
            <a:xfrm>
              <a:off x="639440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50" name="Freeform: Shape 2949">
              <a:extLst>
                <a:ext uri="{FF2B5EF4-FFF2-40B4-BE49-F238E27FC236}">
                  <a16:creationId xmlns:a16="http://schemas.microsoft.com/office/drawing/2014/main" id="{166D2FEB-9FB0-4FE1-0F1E-E4756C889852}"/>
                </a:ext>
              </a:extLst>
            </p:cNvPr>
            <p:cNvSpPr/>
            <p:nvPr/>
          </p:nvSpPr>
          <p:spPr>
            <a:xfrm>
              <a:off x="647802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51" name="Freeform: Shape 2950">
              <a:extLst>
                <a:ext uri="{FF2B5EF4-FFF2-40B4-BE49-F238E27FC236}">
                  <a16:creationId xmlns:a16="http://schemas.microsoft.com/office/drawing/2014/main" id="{4E23CAB9-4693-E9E8-5E2C-81A06B047A95}"/>
                </a:ext>
              </a:extLst>
            </p:cNvPr>
            <p:cNvSpPr/>
            <p:nvPr/>
          </p:nvSpPr>
          <p:spPr>
            <a:xfrm>
              <a:off x="656166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52" name="Freeform: Shape 2951">
              <a:extLst>
                <a:ext uri="{FF2B5EF4-FFF2-40B4-BE49-F238E27FC236}">
                  <a16:creationId xmlns:a16="http://schemas.microsoft.com/office/drawing/2014/main" id="{C66DDA64-82DE-F41C-9AF9-8C14F6A36CD4}"/>
                </a:ext>
              </a:extLst>
            </p:cNvPr>
            <p:cNvSpPr/>
            <p:nvPr/>
          </p:nvSpPr>
          <p:spPr>
            <a:xfrm>
              <a:off x="664530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53" name="Freeform: Shape 2952">
              <a:extLst>
                <a:ext uri="{FF2B5EF4-FFF2-40B4-BE49-F238E27FC236}">
                  <a16:creationId xmlns:a16="http://schemas.microsoft.com/office/drawing/2014/main" id="{6819721D-CE1B-1C67-0B38-294E4C7EE057}"/>
                </a:ext>
              </a:extLst>
            </p:cNvPr>
            <p:cNvSpPr/>
            <p:nvPr/>
          </p:nvSpPr>
          <p:spPr>
            <a:xfrm>
              <a:off x="672893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54" name="Freeform: Shape 2953">
              <a:extLst>
                <a:ext uri="{FF2B5EF4-FFF2-40B4-BE49-F238E27FC236}">
                  <a16:creationId xmlns:a16="http://schemas.microsoft.com/office/drawing/2014/main" id="{BE1F8794-C74F-8A12-260C-5F1495178D41}"/>
                </a:ext>
              </a:extLst>
            </p:cNvPr>
            <p:cNvSpPr/>
            <p:nvPr/>
          </p:nvSpPr>
          <p:spPr>
            <a:xfrm>
              <a:off x="681257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55" name="Freeform: Shape 2954">
              <a:extLst>
                <a:ext uri="{FF2B5EF4-FFF2-40B4-BE49-F238E27FC236}">
                  <a16:creationId xmlns:a16="http://schemas.microsoft.com/office/drawing/2014/main" id="{9959A0D0-C653-27CA-4F2F-31CE5651F356}"/>
                </a:ext>
              </a:extLst>
            </p:cNvPr>
            <p:cNvSpPr/>
            <p:nvPr/>
          </p:nvSpPr>
          <p:spPr>
            <a:xfrm>
              <a:off x="689620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56" name="Freeform: Shape 2955">
              <a:extLst>
                <a:ext uri="{FF2B5EF4-FFF2-40B4-BE49-F238E27FC236}">
                  <a16:creationId xmlns:a16="http://schemas.microsoft.com/office/drawing/2014/main" id="{088C4BC4-E355-3683-5DF1-94A2E6C90832}"/>
                </a:ext>
              </a:extLst>
            </p:cNvPr>
            <p:cNvSpPr/>
            <p:nvPr/>
          </p:nvSpPr>
          <p:spPr>
            <a:xfrm>
              <a:off x="697984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57" name="Freeform: Shape 2956">
              <a:extLst>
                <a:ext uri="{FF2B5EF4-FFF2-40B4-BE49-F238E27FC236}">
                  <a16:creationId xmlns:a16="http://schemas.microsoft.com/office/drawing/2014/main" id="{64720D40-86C0-8485-3BCC-94CBD589BCE5}"/>
                </a:ext>
              </a:extLst>
            </p:cNvPr>
            <p:cNvSpPr/>
            <p:nvPr/>
          </p:nvSpPr>
          <p:spPr>
            <a:xfrm>
              <a:off x="706348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58" name="Freeform: Shape 2957">
              <a:extLst>
                <a:ext uri="{FF2B5EF4-FFF2-40B4-BE49-F238E27FC236}">
                  <a16:creationId xmlns:a16="http://schemas.microsoft.com/office/drawing/2014/main" id="{CB2C9FF2-3906-D15F-F162-FBA7569388DE}"/>
                </a:ext>
              </a:extLst>
            </p:cNvPr>
            <p:cNvSpPr/>
            <p:nvPr/>
          </p:nvSpPr>
          <p:spPr>
            <a:xfrm>
              <a:off x="714711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59" name="Freeform: Shape 2958">
              <a:extLst>
                <a:ext uri="{FF2B5EF4-FFF2-40B4-BE49-F238E27FC236}">
                  <a16:creationId xmlns:a16="http://schemas.microsoft.com/office/drawing/2014/main" id="{E428D839-0E3E-F33E-D4D6-A31CFC25F1F3}"/>
                </a:ext>
              </a:extLst>
            </p:cNvPr>
            <p:cNvSpPr/>
            <p:nvPr/>
          </p:nvSpPr>
          <p:spPr>
            <a:xfrm>
              <a:off x="723075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60" name="Freeform: Shape 2959">
              <a:extLst>
                <a:ext uri="{FF2B5EF4-FFF2-40B4-BE49-F238E27FC236}">
                  <a16:creationId xmlns:a16="http://schemas.microsoft.com/office/drawing/2014/main" id="{5DE0E495-C90E-AC09-7E8A-7AEDD80CFFA3}"/>
                </a:ext>
              </a:extLst>
            </p:cNvPr>
            <p:cNvSpPr/>
            <p:nvPr/>
          </p:nvSpPr>
          <p:spPr>
            <a:xfrm>
              <a:off x="731435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61" name="Freeform: Shape 2960">
              <a:extLst>
                <a:ext uri="{FF2B5EF4-FFF2-40B4-BE49-F238E27FC236}">
                  <a16:creationId xmlns:a16="http://schemas.microsoft.com/office/drawing/2014/main" id="{4E3F28AD-DA54-83A3-6621-21BCFF7847B2}"/>
                </a:ext>
              </a:extLst>
            </p:cNvPr>
            <p:cNvSpPr/>
            <p:nvPr/>
          </p:nvSpPr>
          <p:spPr>
            <a:xfrm>
              <a:off x="739798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62" name="Freeform: Shape 2961">
              <a:extLst>
                <a:ext uri="{FF2B5EF4-FFF2-40B4-BE49-F238E27FC236}">
                  <a16:creationId xmlns:a16="http://schemas.microsoft.com/office/drawing/2014/main" id="{AEC98EEE-1135-F3C5-FA33-D8B4D2253149}"/>
                </a:ext>
              </a:extLst>
            </p:cNvPr>
            <p:cNvSpPr/>
            <p:nvPr/>
          </p:nvSpPr>
          <p:spPr>
            <a:xfrm>
              <a:off x="748162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63" name="Freeform: Shape 2962">
              <a:extLst>
                <a:ext uri="{FF2B5EF4-FFF2-40B4-BE49-F238E27FC236}">
                  <a16:creationId xmlns:a16="http://schemas.microsoft.com/office/drawing/2014/main" id="{33E8CE88-B0E1-4F07-A062-D82C8637B789}"/>
                </a:ext>
              </a:extLst>
            </p:cNvPr>
            <p:cNvSpPr/>
            <p:nvPr/>
          </p:nvSpPr>
          <p:spPr>
            <a:xfrm>
              <a:off x="756526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64" name="Freeform: Shape 2963">
              <a:extLst>
                <a:ext uri="{FF2B5EF4-FFF2-40B4-BE49-F238E27FC236}">
                  <a16:creationId xmlns:a16="http://schemas.microsoft.com/office/drawing/2014/main" id="{ACC780BC-4D9A-A8EE-8F50-1B2FB7E2D915}"/>
                </a:ext>
              </a:extLst>
            </p:cNvPr>
            <p:cNvSpPr/>
            <p:nvPr/>
          </p:nvSpPr>
          <p:spPr>
            <a:xfrm>
              <a:off x="764889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65" name="Freeform: Shape 2964">
              <a:extLst>
                <a:ext uri="{FF2B5EF4-FFF2-40B4-BE49-F238E27FC236}">
                  <a16:creationId xmlns:a16="http://schemas.microsoft.com/office/drawing/2014/main" id="{6027CCE7-B701-DA4D-6DD3-9CF8B9C3D3F5}"/>
                </a:ext>
              </a:extLst>
            </p:cNvPr>
            <p:cNvSpPr/>
            <p:nvPr/>
          </p:nvSpPr>
          <p:spPr>
            <a:xfrm>
              <a:off x="773253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66" name="Freeform: Shape 2965">
              <a:extLst>
                <a:ext uri="{FF2B5EF4-FFF2-40B4-BE49-F238E27FC236}">
                  <a16:creationId xmlns:a16="http://schemas.microsoft.com/office/drawing/2014/main" id="{78870FE3-660A-DD25-CF90-CC9B3A96F100}"/>
                </a:ext>
              </a:extLst>
            </p:cNvPr>
            <p:cNvSpPr/>
            <p:nvPr/>
          </p:nvSpPr>
          <p:spPr>
            <a:xfrm>
              <a:off x="781616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67" name="Freeform: Shape 2966">
              <a:extLst>
                <a:ext uri="{FF2B5EF4-FFF2-40B4-BE49-F238E27FC236}">
                  <a16:creationId xmlns:a16="http://schemas.microsoft.com/office/drawing/2014/main" id="{BBB79854-B2CC-D283-6B65-3514C65F93AF}"/>
                </a:ext>
              </a:extLst>
            </p:cNvPr>
            <p:cNvSpPr/>
            <p:nvPr/>
          </p:nvSpPr>
          <p:spPr>
            <a:xfrm>
              <a:off x="789980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68" name="Freeform: Shape 2967">
              <a:extLst>
                <a:ext uri="{FF2B5EF4-FFF2-40B4-BE49-F238E27FC236}">
                  <a16:creationId xmlns:a16="http://schemas.microsoft.com/office/drawing/2014/main" id="{0573AA6F-B844-D365-5FB0-E7307335346F}"/>
                </a:ext>
              </a:extLst>
            </p:cNvPr>
            <p:cNvSpPr/>
            <p:nvPr/>
          </p:nvSpPr>
          <p:spPr>
            <a:xfrm>
              <a:off x="798344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69" name="Freeform: Shape 2968">
              <a:extLst>
                <a:ext uri="{FF2B5EF4-FFF2-40B4-BE49-F238E27FC236}">
                  <a16:creationId xmlns:a16="http://schemas.microsoft.com/office/drawing/2014/main" id="{992325BF-6DB4-51E0-C423-4E2C2F17BD80}"/>
                </a:ext>
              </a:extLst>
            </p:cNvPr>
            <p:cNvSpPr/>
            <p:nvPr/>
          </p:nvSpPr>
          <p:spPr>
            <a:xfrm>
              <a:off x="806707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70" name="Freeform: Shape 2969">
              <a:extLst>
                <a:ext uri="{FF2B5EF4-FFF2-40B4-BE49-F238E27FC236}">
                  <a16:creationId xmlns:a16="http://schemas.microsoft.com/office/drawing/2014/main" id="{9C12F982-5232-FA21-FE6A-926096309845}"/>
                </a:ext>
              </a:extLst>
            </p:cNvPr>
            <p:cNvSpPr/>
            <p:nvPr/>
          </p:nvSpPr>
          <p:spPr>
            <a:xfrm>
              <a:off x="815070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71" name="Freeform: Shape 2970">
              <a:extLst>
                <a:ext uri="{FF2B5EF4-FFF2-40B4-BE49-F238E27FC236}">
                  <a16:creationId xmlns:a16="http://schemas.microsoft.com/office/drawing/2014/main" id="{FBE618C9-F8C1-91A8-8D41-6F4E429FDDA9}"/>
                </a:ext>
              </a:extLst>
            </p:cNvPr>
            <p:cNvSpPr/>
            <p:nvPr/>
          </p:nvSpPr>
          <p:spPr>
            <a:xfrm>
              <a:off x="823434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72" name="Freeform: Shape 2971">
              <a:extLst>
                <a:ext uri="{FF2B5EF4-FFF2-40B4-BE49-F238E27FC236}">
                  <a16:creationId xmlns:a16="http://schemas.microsoft.com/office/drawing/2014/main" id="{55E2D214-EE26-DEA9-9B83-C290D7921EA1}"/>
                </a:ext>
              </a:extLst>
            </p:cNvPr>
            <p:cNvSpPr/>
            <p:nvPr/>
          </p:nvSpPr>
          <p:spPr>
            <a:xfrm>
              <a:off x="831797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73" name="Freeform: Shape 2972">
              <a:extLst>
                <a:ext uri="{FF2B5EF4-FFF2-40B4-BE49-F238E27FC236}">
                  <a16:creationId xmlns:a16="http://schemas.microsoft.com/office/drawing/2014/main" id="{7E3123FC-7BDA-AD7B-7EF0-7620C8E30F50}"/>
                </a:ext>
              </a:extLst>
            </p:cNvPr>
            <p:cNvSpPr/>
            <p:nvPr/>
          </p:nvSpPr>
          <p:spPr>
            <a:xfrm>
              <a:off x="840161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74" name="Freeform: Shape 2973">
              <a:extLst>
                <a:ext uri="{FF2B5EF4-FFF2-40B4-BE49-F238E27FC236}">
                  <a16:creationId xmlns:a16="http://schemas.microsoft.com/office/drawing/2014/main" id="{012964B6-0B3D-819A-4098-7FC8B2AC7405}"/>
                </a:ext>
              </a:extLst>
            </p:cNvPr>
            <p:cNvSpPr/>
            <p:nvPr/>
          </p:nvSpPr>
          <p:spPr>
            <a:xfrm>
              <a:off x="848524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75" name="Freeform: Shape 2974">
              <a:extLst>
                <a:ext uri="{FF2B5EF4-FFF2-40B4-BE49-F238E27FC236}">
                  <a16:creationId xmlns:a16="http://schemas.microsoft.com/office/drawing/2014/main" id="{04CA7E7D-3514-D66D-1395-88F782F60C44}"/>
                </a:ext>
              </a:extLst>
            </p:cNvPr>
            <p:cNvSpPr/>
            <p:nvPr/>
          </p:nvSpPr>
          <p:spPr>
            <a:xfrm>
              <a:off x="856888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76" name="Freeform: Shape 2975">
              <a:extLst>
                <a:ext uri="{FF2B5EF4-FFF2-40B4-BE49-F238E27FC236}">
                  <a16:creationId xmlns:a16="http://schemas.microsoft.com/office/drawing/2014/main" id="{37CB1F2B-246D-38A4-C3A5-5E13F4281DDE}"/>
                </a:ext>
              </a:extLst>
            </p:cNvPr>
            <p:cNvSpPr/>
            <p:nvPr/>
          </p:nvSpPr>
          <p:spPr>
            <a:xfrm>
              <a:off x="865252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77" name="Freeform: Shape 2976">
              <a:extLst>
                <a:ext uri="{FF2B5EF4-FFF2-40B4-BE49-F238E27FC236}">
                  <a16:creationId xmlns:a16="http://schemas.microsoft.com/office/drawing/2014/main" id="{91C3A35B-9B6A-F727-A618-FB564F24D7DB}"/>
                </a:ext>
              </a:extLst>
            </p:cNvPr>
            <p:cNvSpPr/>
            <p:nvPr/>
          </p:nvSpPr>
          <p:spPr>
            <a:xfrm>
              <a:off x="873615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78" name="Freeform: Shape 2977">
              <a:extLst>
                <a:ext uri="{FF2B5EF4-FFF2-40B4-BE49-F238E27FC236}">
                  <a16:creationId xmlns:a16="http://schemas.microsoft.com/office/drawing/2014/main" id="{8E5B6015-05FC-9D8B-137C-D42D485DEBB4}"/>
                </a:ext>
              </a:extLst>
            </p:cNvPr>
            <p:cNvSpPr/>
            <p:nvPr/>
          </p:nvSpPr>
          <p:spPr>
            <a:xfrm>
              <a:off x="881979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79" name="Freeform: Shape 2978">
              <a:extLst>
                <a:ext uri="{FF2B5EF4-FFF2-40B4-BE49-F238E27FC236}">
                  <a16:creationId xmlns:a16="http://schemas.microsoft.com/office/drawing/2014/main" id="{66E0C7ED-9DF2-44A8-F9C4-D4104A6C2DE1}"/>
                </a:ext>
              </a:extLst>
            </p:cNvPr>
            <p:cNvSpPr/>
            <p:nvPr/>
          </p:nvSpPr>
          <p:spPr>
            <a:xfrm>
              <a:off x="890343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80" name="Freeform: Shape 2979">
              <a:extLst>
                <a:ext uri="{FF2B5EF4-FFF2-40B4-BE49-F238E27FC236}">
                  <a16:creationId xmlns:a16="http://schemas.microsoft.com/office/drawing/2014/main" id="{5D1D7322-004B-24DB-037F-09BBE7FD7197}"/>
                </a:ext>
              </a:extLst>
            </p:cNvPr>
            <p:cNvSpPr/>
            <p:nvPr/>
          </p:nvSpPr>
          <p:spPr>
            <a:xfrm>
              <a:off x="8987064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81" name="Freeform: Shape 2980">
              <a:extLst>
                <a:ext uri="{FF2B5EF4-FFF2-40B4-BE49-F238E27FC236}">
                  <a16:creationId xmlns:a16="http://schemas.microsoft.com/office/drawing/2014/main" id="{41418492-4EF8-F953-4EE0-DB62C12D8590}"/>
                </a:ext>
              </a:extLst>
            </p:cNvPr>
            <p:cNvSpPr/>
            <p:nvPr/>
          </p:nvSpPr>
          <p:spPr>
            <a:xfrm>
              <a:off x="907070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82" name="Freeform: Shape 2981">
              <a:extLst>
                <a:ext uri="{FF2B5EF4-FFF2-40B4-BE49-F238E27FC236}">
                  <a16:creationId xmlns:a16="http://schemas.microsoft.com/office/drawing/2014/main" id="{6C5C4744-925F-4A15-9D2B-DF787A69C867}"/>
                </a:ext>
              </a:extLst>
            </p:cNvPr>
            <p:cNvSpPr/>
            <p:nvPr/>
          </p:nvSpPr>
          <p:spPr>
            <a:xfrm>
              <a:off x="9154333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83" name="Freeform: Shape 2982">
              <a:extLst>
                <a:ext uri="{FF2B5EF4-FFF2-40B4-BE49-F238E27FC236}">
                  <a16:creationId xmlns:a16="http://schemas.microsoft.com/office/drawing/2014/main" id="{4268A6E2-B657-7D36-65A2-B1E5FF7EB35C}"/>
                </a:ext>
              </a:extLst>
            </p:cNvPr>
            <p:cNvSpPr/>
            <p:nvPr/>
          </p:nvSpPr>
          <p:spPr>
            <a:xfrm>
              <a:off x="9237972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84" name="Freeform: Shape 2983">
              <a:extLst>
                <a:ext uri="{FF2B5EF4-FFF2-40B4-BE49-F238E27FC236}">
                  <a16:creationId xmlns:a16="http://schemas.microsoft.com/office/drawing/2014/main" id="{024D420F-2462-9304-CEB7-A77DC68D03DF}"/>
                </a:ext>
              </a:extLst>
            </p:cNvPr>
            <p:cNvSpPr/>
            <p:nvPr/>
          </p:nvSpPr>
          <p:spPr>
            <a:xfrm>
              <a:off x="932161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85" name="Freeform: Shape 2984">
              <a:extLst>
                <a:ext uri="{FF2B5EF4-FFF2-40B4-BE49-F238E27FC236}">
                  <a16:creationId xmlns:a16="http://schemas.microsoft.com/office/drawing/2014/main" id="{7E9711B7-B4D2-2644-B00D-89B69F288CA5}"/>
                </a:ext>
              </a:extLst>
            </p:cNvPr>
            <p:cNvSpPr/>
            <p:nvPr/>
          </p:nvSpPr>
          <p:spPr>
            <a:xfrm>
              <a:off x="9405241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86" name="Freeform: Shape 2985">
              <a:extLst>
                <a:ext uri="{FF2B5EF4-FFF2-40B4-BE49-F238E27FC236}">
                  <a16:creationId xmlns:a16="http://schemas.microsoft.com/office/drawing/2014/main" id="{6CB20305-D1BB-AE1A-B866-759E6B623DA6}"/>
                </a:ext>
              </a:extLst>
            </p:cNvPr>
            <p:cNvSpPr/>
            <p:nvPr/>
          </p:nvSpPr>
          <p:spPr>
            <a:xfrm>
              <a:off x="948888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87" name="Freeform: Shape 2986">
              <a:extLst>
                <a:ext uri="{FF2B5EF4-FFF2-40B4-BE49-F238E27FC236}">
                  <a16:creationId xmlns:a16="http://schemas.microsoft.com/office/drawing/2014/main" id="{AA70C444-B58A-29F1-E23D-F4B9093EE979}"/>
                </a:ext>
              </a:extLst>
            </p:cNvPr>
            <p:cNvSpPr/>
            <p:nvPr/>
          </p:nvSpPr>
          <p:spPr>
            <a:xfrm>
              <a:off x="9572520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88" name="Freeform: Shape 2987">
              <a:extLst>
                <a:ext uri="{FF2B5EF4-FFF2-40B4-BE49-F238E27FC236}">
                  <a16:creationId xmlns:a16="http://schemas.microsoft.com/office/drawing/2014/main" id="{8A56D2A8-413F-81A1-D8E6-194909B2E101}"/>
                </a:ext>
              </a:extLst>
            </p:cNvPr>
            <p:cNvSpPr/>
            <p:nvPr/>
          </p:nvSpPr>
          <p:spPr>
            <a:xfrm>
              <a:off x="965614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89" name="Freeform: Shape 2988">
              <a:extLst>
                <a:ext uri="{FF2B5EF4-FFF2-40B4-BE49-F238E27FC236}">
                  <a16:creationId xmlns:a16="http://schemas.microsoft.com/office/drawing/2014/main" id="{FD6320D8-8309-FD9C-CF8C-746DFCC1ABF1}"/>
                </a:ext>
              </a:extLst>
            </p:cNvPr>
            <p:cNvSpPr/>
            <p:nvPr/>
          </p:nvSpPr>
          <p:spPr>
            <a:xfrm>
              <a:off x="9739789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90" name="Freeform: Shape 2989">
              <a:extLst>
                <a:ext uri="{FF2B5EF4-FFF2-40B4-BE49-F238E27FC236}">
                  <a16:creationId xmlns:a16="http://schemas.microsoft.com/office/drawing/2014/main" id="{A5D998CF-834F-AAF6-9E07-31906F300992}"/>
                </a:ext>
              </a:extLst>
            </p:cNvPr>
            <p:cNvSpPr/>
            <p:nvPr/>
          </p:nvSpPr>
          <p:spPr>
            <a:xfrm>
              <a:off x="982341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91" name="Freeform: Shape 2990">
              <a:extLst>
                <a:ext uri="{FF2B5EF4-FFF2-40B4-BE49-F238E27FC236}">
                  <a16:creationId xmlns:a16="http://schemas.microsoft.com/office/drawing/2014/main" id="{2360D227-3522-991F-80BB-7A35BD1978AC}"/>
                </a:ext>
              </a:extLst>
            </p:cNvPr>
            <p:cNvSpPr/>
            <p:nvPr/>
          </p:nvSpPr>
          <p:spPr>
            <a:xfrm>
              <a:off x="9907058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92" name="Freeform: Shape 2991">
              <a:extLst>
                <a:ext uri="{FF2B5EF4-FFF2-40B4-BE49-F238E27FC236}">
                  <a16:creationId xmlns:a16="http://schemas.microsoft.com/office/drawing/2014/main" id="{B10D09C0-E99E-6518-11D3-3C4FE1BD1908}"/>
                </a:ext>
              </a:extLst>
            </p:cNvPr>
            <p:cNvSpPr/>
            <p:nvPr/>
          </p:nvSpPr>
          <p:spPr>
            <a:xfrm>
              <a:off x="999069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93" name="Freeform: Shape 2992">
              <a:extLst>
                <a:ext uri="{FF2B5EF4-FFF2-40B4-BE49-F238E27FC236}">
                  <a16:creationId xmlns:a16="http://schemas.microsoft.com/office/drawing/2014/main" id="{B997BE57-4B2D-0B6F-975A-7F2C96E62F44}"/>
                </a:ext>
              </a:extLst>
            </p:cNvPr>
            <p:cNvSpPr/>
            <p:nvPr/>
          </p:nvSpPr>
          <p:spPr>
            <a:xfrm>
              <a:off x="10074327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94" name="Freeform: Shape 2993">
              <a:extLst>
                <a:ext uri="{FF2B5EF4-FFF2-40B4-BE49-F238E27FC236}">
                  <a16:creationId xmlns:a16="http://schemas.microsoft.com/office/drawing/2014/main" id="{E5530507-EB5D-08EC-8726-F79D4185BEE0}"/>
                </a:ext>
              </a:extLst>
            </p:cNvPr>
            <p:cNvSpPr/>
            <p:nvPr/>
          </p:nvSpPr>
          <p:spPr>
            <a:xfrm>
              <a:off x="10157966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95" name="Freeform: Shape 2994">
              <a:extLst>
                <a:ext uri="{FF2B5EF4-FFF2-40B4-BE49-F238E27FC236}">
                  <a16:creationId xmlns:a16="http://schemas.microsoft.com/office/drawing/2014/main" id="{243F632C-20E3-6C88-5F36-9155AE85DCEB}"/>
                </a:ext>
              </a:extLst>
            </p:cNvPr>
            <p:cNvSpPr/>
            <p:nvPr/>
          </p:nvSpPr>
          <p:spPr>
            <a:xfrm>
              <a:off x="1024160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96" name="Freeform: Shape 2995">
              <a:extLst>
                <a:ext uri="{FF2B5EF4-FFF2-40B4-BE49-F238E27FC236}">
                  <a16:creationId xmlns:a16="http://schemas.microsoft.com/office/drawing/2014/main" id="{17F8A0AD-9E15-33F5-3DFA-2B9BFCEC0FEF}"/>
                </a:ext>
              </a:extLst>
            </p:cNvPr>
            <p:cNvSpPr/>
            <p:nvPr/>
          </p:nvSpPr>
          <p:spPr>
            <a:xfrm>
              <a:off x="10325235" y="385080"/>
              <a:ext cx="9679" cy="4454747"/>
            </a:xfrm>
            <a:custGeom>
              <a:avLst/>
              <a:gdLst>
                <a:gd name="connsiteX0" fmla="*/ 0 w 9679"/>
                <a:gd name="connsiteY0" fmla="*/ 4454748 h 4454747"/>
                <a:gd name="connsiteX1" fmla="*/ 0 w 9679"/>
                <a:gd name="connsiteY1" fmla="*/ 0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679" h="4454747">
                  <a:moveTo>
                    <a:pt x="0" y="4454748"/>
                  </a:moveTo>
                  <a:lnTo>
                    <a:pt x="0" y="0"/>
                  </a:lnTo>
                </a:path>
              </a:pathLst>
            </a:custGeom>
            <a:noFill/>
            <a:ln w="13767" cap="flat">
              <a:solidFill>
                <a:srgbClr val="EBEBEB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97" name="Freeform: Shape 2996">
              <a:extLst>
                <a:ext uri="{FF2B5EF4-FFF2-40B4-BE49-F238E27FC236}">
                  <a16:creationId xmlns:a16="http://schemas.microsoft.com/office/drawing/2014/main" id="{5DCF2B18-EEEF-E5A6-67D1-AA7667CACC97}"/>
                </a:ext>
              </a:extLst>
            </p:cNvPr>
            <p:cNvSpPr/>
            <p:nvPr/>
          </p:nvSpPr>
          <p:spPr>
            <a:xfrm>
              <a:off x="1961705" y="587562"/>
              <a:ext cx="8363529" cy="2216296"/>
            </a:xfrm>
            <a:custGeom>
              <a:avLst/>
              <a:gdLst>
                <a:gd name="connsiteX0" fmla="*/ 0 w 8363529"/>
                <a:gd name="connsiteY0" fmla="*/ 0 h 2216296"/>
                <a:gd name="connsiteX1" fmla="*/ 8363530 w 8363529"/>
                <a:gd name="connsiteY1" fmla="*/ 0 h 2216296"/>
                <a:gd name="connsiteX2" fmla="*/ 8363530 w 8363529"/>
                <a:gd name="connsiteY2" fmla="*/ 1394616 h 2216296"/>
                <a:gd name="connsiteX3" fmla="*/ 8355177 w 8363529"/>
                <a:gd name="connsiteY3" fmla="*/ 1355788 h 2216296"/>
                <a:gd name="connsiteX4" fmla="*/ 8288254 w 8363529"/>
                <a:gd name="connsiteY4" fmla="*/ 1048395 h 2216296"/>
                <a:gd name="connsiteX5" fmla="*/ 8279900 w 8363529"/>
                <a:gd name="connsiteY5" fmla="*/ 1010331 h 2216296"/>
                <a:gd name="connsiteX6" fmla="*/ 8271537 w 8363529"/>
                <a:gd name="connsiteY6" fmla="*/ 1007873 h 2216296"/>
                <a:gd name="connsiteX7" fmla="*/ 8204614 w 8363529"/>
                <a:gd name="connsiteY7" fmla="*/ 992785 h 2216296"/>
                <a:gd name="connsiteX8" fmla="*/ 8196261 w 8363529"/>
                <a:gd name="connsiteY8" fmla="*/ 991353 h 2216296"/>
                <a:gd name="connsiteX9" fmla="*/ 8187908 w 8363529"/>
                <a:gd name="connsiteY9" fmla="*/ 1011048 h 2216296"/>
                <a:gd name="connsiteX10" fmla="*/ 8120985 w 8363529"/>
                <a:gd name="connsiteY10" fmla="*/ 1245023 h 2216296"/>
                <a:gd name="connsiteX11" fmla="*/ 8112622 w 8363529"/>
                <a:gd name="connsiteY11" fmla="*/ 1289251 h 2216296"/>
                <a:gd name="connsiteX12" fmla="*/ 8104268 w 8363529"/>
                <a:gd name="connsiteY12" fmla="*/ 1303236 h 2216296"/>
                <a:gd name="connsiteX13" fmla="*/ 8037346 w 8363529"/>
                <a:gd name="connsiteY13" fmla="*/ 1400926 h 2216296"/>
                <a:gd name="connsiteX14" fmla="*/ 8028992 w 8363529"/>
                <a:gd name="connsiteY14" fmla="*/ 1411552 h 2216296"/>
                <a:gd name="connsiteX15" fmla="*/ 8020629 w 8363529"/>
                <a:gd name="connsiteY15" fmla="*/ 1391557 h 2216296"/>
                <a:gd name="connsiteX16" fmla="*/ 7953706 w 8363529"/>
                <a:gd name="connsiteY16" fmla="*/ 1223702 h 2216296"/>
                <a:gd name="connsiteX17" fmla="*/ 7945353 w 8363529"/>
                <a:gd name="connsiteY17" fmla="*/ 1201695 h 2216296"/>
                <a:gd name="connsiteX18" fmla="*/ 7937000 w 8363529"/>
                <a:gd name="connsiteY18" fmla="*/ 1185484 h 2216296"/>
                <a:gd name="connsiteX19" fmla="*/ 7870077 w 8363529"/>
                <a:gd name="connsiteY19" fmla="*/ 1094104 h 2216296"/>
                <a:gd name="connsiteX20" fmla="*/ 7861713 w 8363529"/>
                <a:gd name="connsiteY20" fmla="*/ 1085975 h 2216296"/>
                <a:gd name="connsiteX21" fmla="*/ 7853360 w 8363529"/>
                <a:gd name="connsiteY21" fmla="*/ 1093804 h 2216296"/>
                <a:gd name="connsiteX22" fmla="*/ 7786437 w 8363529"/>
                <a:gd name="connsiteY22" fmla="*/ 1193836 h 2216296"/>
                <a:gd name="connsiteX23" fmla="*/ 7778084 w 8363529"/>
                <a:gd name="connsiteY23" fmla="*/ 1214324 h 2216296"/>
                <a:gd name="connsiteX24" fmla="*/ 7769731 w 8363529"/>
                <a:gd name="connsiteY24" fmla="*/ 1224796 h 2216296"/>
                <a:gd name="connsiteX25" fmla="*/ 7702798 w 8363529"/>
                <a:gd name="connsiteY25" fmla="*/ 1292581 h 2216296"/>
                <a:gd name="connsiteX26" fmla="*/ 7694444 w 8363529"/>
                <a:gd name="connsiteY26" fmla="*/ 1299462 h 2216296"/>
                <a:gd name="connsiteX27" fmla="*/ 7686091 w 8363529"/>
                <a:gd name="connsiteY27" fmla="*/ 1290122 h 2216296"/>
                <a:gd name="connsiteX28" fmla="*/ 7619168 w 8363529"/>
                <a:gd name="connsiteY28" fmla="*/ 1221505 h 2216296"/>
                <a:gd name="connsiteX29" fmla="*/ 7610815 w 8363529"/>
                <a:gd name="connsiteY29" fmla="*/ 1213608 h 2216296"/>
                <a:gd name="connsiteX30" fmla="*/ 7602452 w 8363529"/>
                <a:gd name="connsiteY30" fmla="*/ 1207637 h 2216296"/>
                <a:gd name="connsiteX31" fmla="*/ 7535528 w 8363529"/>
                <a:gd name="connsiteY31" fmla="*/ 1150701 h 2216296"/>
                <a:gd name="connsiteX32" fmla="*/ 7527175 w 8363529"/>
                <a:gd name="connsiteY32" fmla="*/ 1142233 h 2216296"/>
                <a:gd name="connsiteX33" fmla="*/ 7518822 w 8363529"/>
                <a:gd name="connsiteY33" fmla="*/ 1124387 h 2216296"/>
                <a:gd name="connsiteX34" fmla="*/ 7451899 w 8363529"/>
                <a:gd name="connsiteY34" fmla="*/ 1006092 h 2216296"/>
                <a:gd name="connsiteX35" fmla="*/ 7443536 w 8363529"/>
                <a:gd name="connsiteY35" fmla="*/ 993811 h 2216296"/>
                <a:gd name="connsiteX36" fmla="*/ 7435183 w 8363529"/>
                <a:gd name="connsiteY36" fmla="*/ 1014299 h 2216296"/>
                <a:gd name="connsiteX37" fmla="*/ 7368260 w 8363529"/>
                <a:gd name="connsiteY37" fmla="*/ 1210095 h 2216296"/>
                <a:gd name="connsiteX38" fmla="*/ 7359906 w 8363529"/>
                <a:gd name="connsiteY38" fmla="*/ 1239429 h 2216296"/>
                <a:gd name="connsiteX39" fmla="*/ 7351543 w 8363529"/>
                <a:gd name="connsiteY39" fmla="*/ 1243320 h 2216296"/>
                <a:gd name="connsiteX40" fmla="*/ 7284620 w 8363529"/>
                <a:gd name="connsiteY40" fmla="*/ 1272692 h 2216296"/>
                <a:gd name="connsiteX41" fmla="*/ 7276267 w 8363529"/>
                <a:gd name="connsiteY41" fmla="*/ 1276176 h 2216296"/>
                <a:gd name="connsiteX42" fmla="*/ 7267914 w 8363529"/>
                <a:gd name="connsiteY42" fmla="*/ 1252998 h 2216296"/>
                <a:gd name="connsiteX43" fmla="*/ 7200991 w 8363529"/>
                <a:gd name="connsiteY43" fmla="*/ 1052634 h 2216296"/>
                <a:gd name="connsiteX44" fmla="*/ 7192628 w 8363529"/>
                <a:gd name="connsiteY44" fmla="*/ 1025526 h 2216296"/>
                <a:gd name="connsiteX45" fmla="*/ 7184274 w 8363529"/>
                <a:gd name="connsiteY45" fmla="*/ 1046469 h 2216296"/>
                <a:gd name="connsiteX46" fmla="*/ 7117351 w 8363529"/>
                <a:gd name="connsiteY46" fmla="*/ 1207521 h 2216296"/>
                <a:gd name="connsiteX47" fmla="*/ 7108998 w 8363529"/>
                <a:gd name="connsiteY47" fmla="*/ 1226877 h 2216296"/>
                <a:gd name="connsiteX48" fmla="*/ 7100645 w 8363529"/>
                <a:gd name="connsiteY48" fmla="*/ 1167599 h 2216296"/>
                <a:gd name="connsiteX49" fmla="*/ 7033712 w 8363529"/>
                <a:gd name="connsiteY49" fmla="*/ 724298 h 2216296"/>
                <a:gd name="connsiteX50" fmla="*/ 7025359 w 8363529"/>
                <a:gd name="connsiteY50" fmla="*/ 672470 h 2216296"/>
                <a:gd name="connsiteX51" fmla="*/ 7017006 w 8363529"/>
                <a:gd name="connsiteY51" fmla="*/ 681618 h 2216296"/>
                <a:gd name="connsiteX52" fmla="*/ 6950083 w 8363529"/>
                <a:gd name="connsiteY52" fmla="*/ 741506 h 2216296"/>
                <a:gd name="connsiteX53" fmla="*/ 6941729 w 8363529"/>
                <a:gd name="connsiteY53" fmla="*/ 747661 h 2216296"/>
                <a:gd name="connsiteX54" fmla="*/ 6933366 w 8363529"/>
                <a:gd name="connsiteY54" fmla="*/ 821949 h 2216296"/>
                <a:gd name="connsiteX55" fmla="*/ 6866443 w 8363529"/>
                <a:gd name="connsiteY55" fmla="*/ 1689794 h 2216296"/>
                <a:gd name="connsiteX56" fmla="*/ 6858090 w 8363529"/>
                <a:gd name="connsiteY56" fmla="*/ 1850846 h 2216296"/>
                <a:gd name="connsiteX57" fmla="*/ 6849737 w 8363529"/>
                <a:gd name="connsiteY57" fmla="*/ 1841768 h 2216296"/>
                <a:gd name="connsiteX58" fmla="*/ 6782814 w 8363529"/>
                <a:gd name="connsiteY58" fmla="*/ 1779655 h 2216296"/>
                <a:gd name="connsiteX59" fmla="*/ 6774451 w 8363529"/>
                <a:gd name="connsiteY59" fmla="*/ 1772967 h 2216296"/>
                <a:gd name="connsiteX60" fmla="*/ 6766097 w 8363529"/>
                <a:gd name="connsiteY60" fmla="*/ 1692892 h 2216296"/>
                <a:gd name="connsiteX61" fmla="*/ 6699174 w 8363529"/>
                <a:gd name="connsiteY61" fmla="*/ 1184342 h 2216296"/>
                <a:gd name="connsiteX62" fmla="*/ 6690821 w 8363529"/>
                <a:gd name="connsiteY62" fmla="*/ 1133571 h 2216296"/>
                <a:gd name="connsiteX63" fmla="*/ 6682458 w 8363529"/>
                <a:gd name="connsiteY63" fmla="*/ 1207821 h 2216296"/>
                <a:gd name="connsiteX64" fmla="*/ 6615535 w 8363529"/>
                <a:gd name="connsiteY64" fmla="*/ 2047648 h 2216296"/>
                <a:gd name="connsiteX65" fmla="*/ 6607182 w 8363529"/>
                <a:gd name="connsiteY65" fmla="*/ 2198228 h 2216296"/>
                <a:gd name="connsiteX66" fmla="*/ 6598829 w 8363529"/>
                <a:gd name="connsiteY66" fmla="*/ 2076276 h 2216296"/>
                <a:gd name="connsiteX67" fmla="*/ 6531944 w 8363529"/>
                <a:gd name="connsiteY67" fmla="*/ 1204308 h 2216296"/>
                <a:gd name="connsiteX68" fmla="*/ 6523542 w 8363529"/>
                <a:gd name="connsiteY68" fmla="*/ 1106773 h 2216296"/>
                <a:gd name="connsiteX69" fmla="*/ 6515189 w 8363529"/>
                <a:gd name="connsiteY69" fmla="*/ 1143443 h 2216296"/>
                <a:gd name="connsiteX70" fmla="*/ 6448305 w 8363529"/>
                <a:gd name="connsiteY70" fmla="*/ 1403994 h 2216296"/>
                <a:gd name="connsiteX71" fmla="*/ 6439913 w 8363529"/>
                <a:gd name="connsiteY71" fmla="*/ 1432989 h 2216296"/>
                <a:gd name="connsiteX72" fmla="*/ 6431560 w 8363529"/>
                <a:gd name="connsiteY72" fmla="*/ 1441080 h 2216296"/>
                <a:gd name="connsiteX73" fmla="*/ 6364665 w 8363529"/>
                <a:gd name="connsiteY73" fmla="*/ 1511807 h 2216296"/>
                <a:gd name="connsiteX74" fmla="*/ 6356273 w 8363529"/>
                <a:gd name="connsiteY74" fmla="*/ 1521446 h 2216296"/>
                <a:gd name="connsiteX75" fmla="*/ 6347920 w 8363529"/>
                <a:gd name="connsiteY75" fmla="*/ 1498354 h 2216296"/>
                <a:gd name="connsiteX76" fmla="*/ 6281036 w 8363529"/>
                <a:gd name="connsiteY76" fmla="*/ 1281277 h 2216296"/>
                <a:gd name="connsiteX77" fmla="*/ 6272644 w 8363529"/>
                <a:gd name="connsiteY77" fmla="*/ 1249330 h 2216296"/>
                <a:gd name="connsiteX78" fmla="*/ 6264280 w 8363529"/>
                <a:gd name="connsiteY78" fmla="*/ 1262908 h 2216296"/>
                <a:gd name="connsiteX79" fmla="*/ 6197396 w 8363529"/>
                <a:gd name="connsiteY79" fmla="*/ 1347552 h 2216296"/>
                <a:gd name="connsiteX80" fmla="*/ 6189004 w 8363529"/>
                <a:gd name="connsiteY80" fmla="*/ 1355865 h 2216296"/>
                <a:gd name="connsiteX81" fmla="*/ 6180651 w 8363529"/>
                <a:gd name="connsiteY81" fmla="*/ 1321731 h 2216296"/>
                <a:gd name="connsiteX82" fmla="*/ 6113767 w 8363529"/>
                <a:gd name="connsiteY82" fmla="*/ 1005986 h 2216296"/>
                <a:gd name="connsiteX83" fmla="*/ 6105365 w 8363529"/>
                <a:gd name="connsiteY83" fmla="*/ 960199 h 2216296"/>
                <a:gd name="connsiteX84" fmla="*/ 6097011 w 8363529"/>
                <a:gd name="connsiteY84" fmla="*/ 990937 h 2216296"/>
                <a:gd name="connsiteX85" fmla="*/ 6030127 w 8363529"/>
                <a:gd name="connsiteY85" fmla="*/ 1207182 h 2216296"/>
                <a:gd name="connsiteX86" fmla="*/ 6021735 w 8363529"/>
                <a:gd name="connsiteY86" fmla="*/ 1231038 h 2216296"/>
                <a:gd name="connsiteX87" fmla="*/ 6013372 w 8363529"/>
                <a:gd name="connsiteY87" fmla="*/ 1291971 h 2216296"/>
                <a:gd name="connsiteX88" fmla="*/ 5946488 w 8363529"/>
                <a:gd name="connsiteY88" fmla="*/ 2047726 h 2216296"/>
                <a:gd name="connsiteX89" fmla="*/ 5938096 w 8363529"/>
                <a:gd name="connsiteY89" fmla="*/ 2197628 h 2216296"/>
                <a:gd name="connsiteX90" fmla="*/ 5929743 w 8363529"/>
                <a:gd name="connsiteY90" fmla="*/ 2006865 h 2216296"/>
                <a:gd name="connsiteX91" fmla="*/ 5862858 w 8363529"/>
                <a:gd name="connsiteY91" fmla="*/ 1097279 h 2216296"/>
                <a:gd name="connsiteX92" fmla="*/ 5854457 w 8363529"/>
                <a:gd name="connsiteY92" fmla="*/ 1027529 h 2216296"/>
                <a:gd name="connsiteX93" fmla="*/ 5846103 w 8363529"/>
                <a:gd name="connsiteY93" fmla="*/ 1114215 h 2216296"/>
                <a:gd name="connsiteX94" fmla="*/ 5779219 w 8363529"/>
                <a:gd name="connsiteY94" fmla="*/ 2055061 h 2216296"/>
                <a:gd name="connsiteX95" fmla="*/ 5770827 w 8363529"/>
                <a:gd name="connsiteY95" fmla="*/ 2216297 h 2216296"/>
                <a:gd name="connsiteX96" fmla="*/ 5762474 w 8363529"/>
                <a:gd name="connsiteY96" fmla="*/ 2024440 h 2216296"/>
                <a:gd name="connsiteX97" fmla="*/ 5695580 w 8363529"/>
                <a:gd name="connsiteY97" fmla="*/ 958351 h 2216296"/>
                <a:gd name="connsiteX98" fmla="*/ 5687188 w 8363529"/>
                <a:gd name="connsiteY98" fmla="*/ 864445 h 2216296"/>
                <a:gd name="connsiteX99" fmla="*/ 5678835 w 8363529"/>
                <a:gd name="connsiteY99" fmla="*/ 892115 h 2216296"/>
                <a:gd name="connsiteX100" fmla="*/ 5611950 w 8363529"/>
                <a:gd name="connsiteY100" fmla="*/ 1114447 h 2216296"/>
                <a:gd name="connsiteX101" fmla="*/ 5603558 w 8363529"/>
                <a:gd name="connsiteY101" fmla="*/ 1142349 h 2216296"/>
                <a:gd name="connsiteX102" fmla="*/ 5595195 w 8363529"/>
                <a:gd name="connsiteY102" fmla="*/ 1197765 h 2216296"/>
                <a:gd name="connsiteX103" fmla="*/ 5528311 w 8363529"/>
                <a:gd name="connsiteY103" fmla="*/ 1828538 h 2216296"/>
                <a:gd name="connsiteX104" fmla="*/ 5519919 w 8363529"/>
                <a:gd name="connsiteY104" fmla="*/ 1942439 h 2216296"/>
                <a:gd name="connsiteX105" fmla="*/ 5511566 w 8363529"/>
                <a:gd name="connsiteY105" fmla="*/ 1902556 h 2216296"/>
                <a:gd name="connsiteX106" fmla="*/ 5444672 w 8363529"/>
                <a:gd name="connsiteY106" fmla="*/ 1191000 h 2216296"/>
                <a:gd name="connsiteX107" fmla="*/ 5436280 w 8363529"/>
                <a:gd name="connsiteY107" fmla="*/ 975287 h 2216296"/>
                <a:gd name="connsiteX108" fmla="*/ 5427926 w 8363529"/>
                <a:gd name="connsiteY108" fmla="*/ 1120873 h 2216296"/>
                <a:gd name="connsiteX109" fmla="*/ 5361042 w 8363529"/>
                <a:gd name="connsiteY109" fmla="*/ 1543570 h 2216296"/>
                <a:gd name="connsiteX110" fmla="*/ 5352650 w 8363529"/>
                <a:gd name="connsiteY110" fmla="*/ 1564958 h 2216296"/>
                <a:gd name="connsiteX111" fmla="*/ 5344287 w 8363529"/>
                <a:gd name="connsiteY111" fmla="*/ 1446857 h 2216296"/>
                <a:gd name="connsiteX112" fmla="*/ 5277403 w 8363529"/>
                <a:gd name="connsiteY112" fmla="*/ 631717 h 2216296"/>
                <a:gd name="connsiteX113" fmla="*/ 5269049 w 8363529"/>
                <a:gd name="connsiteY113" fmla="*/ 543631 h 2216296"/>
                <a:gd name="connsiteX114" fmla="*/ 5260657 w 8363529"/>
                <a:gd name="connsiteY114" fmla="*/ 607294 h 2216296"/>
                <a:gd name="connsiteX115" fmla="*/ 5193773 w 8363529"/>
                <a:gd name="connsiteY115" fmla="*/ 1075881 h 2216296"/>
                <a:gd name="connsiteX116" fmla="*/ 5185410 w 8363529"/>
                <a:gd name="connsiteY116" fmla="*/ 1129864 h 2216296"/>
                <a:gd name="connsiteX117" fmla="*/ 5177018 w 8363529"/>
                <a:gd name="connsiteY117" fmla="*/ 1158753 h 2216296"/>
                <a:gd name="connsiteX118" fmla="*/ 5110134 w 8363529"/>
                <a:gd name="connsiteY118" fmla="*/ 1474914 h 2216296"/>
                <a:gd name="connsiteX119" fmla="*/ 5101780 w 8363529"/>
                <a:gd name="connsiteY119" fmla="*/ 1529575 h 2216296"/>
                <a:gd name="connsiteX120" fmla="*/ 5093388 w 8363529"/>
                <a:gd name="connsiteY120" fmla="*/ 1517816 h 2216296"/>
                <a:gd name="connsiteX121" fmla="*/ 5026494 w 8363529"/>
                <a:gd name="connsiteY121" fmla="*/ 1438922 h 2216296"/>
                <a:gd name="connsiteX122" fmla="*/ 5018141 w 8363529"/>
                <a:gd name="connsiteY122" fmla="*/ 1430608 h 2216296"/>
                <a:gd name="connsiteX123" fmla="*/ 5009749 w 8363529"/>
                <a:gd name="connsiteY123" fmla="*/ 1440770 h 2216296"/>
                <a:gd name="connsiteX124" fmla="*/ 4942864 w 8363529"/>
                <a:gd name="connsiteY124" fmla="*/ 1512755 h 2216296"/>
                <a:gd name="connsiteX125" fmla="*/ 4934501 w 8363529"/>
                <a:gd name="connsiteY125" fmla="*/ 1520730 h 2216296"/>
                <a:gd name="connsiteX126" fmla="*/ 4926109 w 8363529"/>
                <a:gd name="connsiteY126" fmla="*/ 1537211 h 2216296"/>
                <a:gd name="connsiteX127" fmla="*/ 4859225 w 8363529"/>
                <a:gd name="connsiteY127" fmla="*/ 1735194 h 2216296"/>
                <a:gd name="connsiteX128" fmla="*/ 4850872 w 8363529"/>
                <a:gd name="connsiteY128" fmla="*/ 1773035 h 2216296"/>
                <a:gd name="connsiteX129" fmla="*/ 4842480 w 8363529"/>
                <a:gd name="connsiteY129" fmla="*/ 1700944 h 2216296"/>
                <a:gd name="connsiteX130" fmla="*/ 4775595 w 8363529"/>
                <a:gd name="connsiteY130" fmla="*/ 1263701 h 2216296"/>
                <a:gd name="connsiteX131" fmla="*/ 4767232 w 8363529"/>
                <a:gd name="connsiteY131" fmla="*/ 1221922 h 2216296"/>
                <a:gd name="connsiteX132" fmla="*/ 4758840 w 8363529"/>
                <a:gd name="connsiteY132" fmla="*/ 1207559 h 2216296"/>
                <a:gd name="connsiteX133" fmla="*/ 4691956 w 8363529"/>
                <a:gd name="connsiteY133" fmla="*/ 1079094 h 2216296"/>
                <a:gd name="connsiteX134" fmla="*/ 4683603 w 8363529"/>
                <a:gd name="connsiteY134" fmla="*/ 1061102 h 2216296"/>
                <a:gd name="connsiteX135" fmla="*/ 4675201 w 8363529"/>
                <a:gd name="connsiteY135" fmla="*/ 1078416 h 2216296"/>
                <a:gd name="connsiteX136" fmla="*/ 4608317 w 8363529"/>
                <a:gd name="connsiteY136" fmla="*/ 1219996 h 2216296"/>
                <a:gd name="connsiteX137" fmla="*/ 4599964 w 8363529"/>
                <a:gd name="connsiteY137" fmla="*/ 1238064 h 2216296"/>
                <a:gd name="connsiteX138" fmla="*/ 4591572 w 8363529"/>
                <a:gd name="connsiteY138" fmla="*/ 1186839 h 2216296"/>
                <a:gd name="connsiteX139" fmla="*/ 4524687 w 8363529"/>
                <a:gd name="connsiteY139" fmla="*/ 819414 h 2216296"/>
                <a:gd name="connsiteX140" fmla="*/ 4516324 w 8363529"/>
                <a:gd name="connsiteY140" fmla="*/ 778176 h 2216296"/>
                <a:gd name="connsiteX141" fmla="*/ 4507932 w 8363529"/>
                <a:gd name="connsiteY141" fmla="*/ 793138 h 2216296"/>
                <a:gd name="connsiteX142" fmla="*/ 4441048 w 8363529"/>
                <a:gd name="connsiteY142" fmla="*/ 906293 h 2216296"/>
                <a:gd name="connsiteX143" fmla="*/ 4432695 w 8363529"/>
                <a:gd name="connsiteY143" fmla="*/ 919678 h 2216296"/>
                <a:gd name="connsiteX144" fmla="*/ 4424303 w 8363529"/>
                <a:gd name="connsiteY144" fmla="*/ 952263 h 2216296"/>
                <a:gd name="connsiteX145" fmla="*/ 4357409 w 8363529"/>
                <a:gd name="connsiteY145" fmla="*/ 1215079 h 2216296"/>
                <a:gd name="connsiteX146" fmla="*/ 4349055 w 8363529"/>
                <a:gd name="connsiteY146" fmla="*/ 1248197 h 2216296"/>
                <a:gd name="connsiteX147" fmla="*/ 4340664 w 8363529"/>
                <a:gd name="connsiteY147" fmla="*/ 1282564 h 2216296"/>
                <a:gd name="connsiteX148" fmla="*/ 4273779 w 8363529"/>
                <a:gd name="connsiteY148" fmla="*/ 1580046 h 2216296"/>
                <a:gd name="connsiteX149" fmla="*/ 4265416 w 8363529"/>
                <a:gd name="connsiteY149" fmla="*/ 1620307 h 2216296"/>
                <a:gd name="connsiteX150" fmla="*/ 4257024 w 8363529"/>
                <a:gd name="connsiteY150" fmla="*/ 1565761 h 2216296"/>
                <a:gd name="connsiteX151" fmla="*/ 4190140 w 8363529"/>
                <a:gd name="connsiteY151" fmla="*/ 1217915 h 2216296"/>
                <a:gd name="connsiteX152" fmla="*/ 4181787 w 8363529"/>
                <a:gd name="connsiteY152" fmla="*/ 1183064 h 2216296"/>
                <a:gd name="connsiteX153" fmla="*/ 4173394 w 8363529"/>
                <a:gd name="connsiteY153" fmla="*/ 1196217 h 2216296"/>
                <a:gd name="connsiteX154" fmla="*/ 4106500 w 8363529"/>
                <a:gd name="connsiteY154" fmla="*/ 1357297 h 2216296"/>
                <a:gd name="connsiteX155" fmla="*/ 4098147 w 8363529"/>
                <a:gd name="connsiteY155" fmla="*/ 1388789 h 2216296"/>
                <a:gd name="connsiteX156" fmla="*/ 4089755 w 8363529"/>
                <a:gd name="connsiteY156" fmla="*/ 1288690 h 2216296"/>
                <a:gd name="connsiteX157" fmla="*/ 4022871 w 8363529"/>
                <a:gd name="connsiteY157" fmla="*/ 767288 h 2216296"/>
                <a:gd name="connsiteX158" fmla="*/ 4014517 w 8363529"/>
                <a:gd name="connsiteY158" fmla="*/ 723998 h 2216296"/>
                <a:gd name="connsiteX159" fmla="*/ 4006154 w 8363529"/>
                <a:gd name="connsiteY159" fmla="*/ 726602 h 2216296"/>
                <a:gd name="connsiteX160" fmla="*/ 3939231 w 8363529"/>
                <a:gd name="connsiteY160" fmla="*/ 750351 h 2216296"/>
                <a:gd name="connsiteX161" fmla="*/ 3930878 w 8363529"/>
                <a:gd name="connsiteY161" fmla="*/ 753710 h 2216296"/>
                <a:gd name="connsiteX162" fmla="*/ 3922525 w 8363529"/>
                <a:gd name="connsiteY162" fmla="*/ 781011 h 2216296"/>
                <a:gd name="connsiteX163" fmla="*/ 3855602 w 8363529"/>
                <a:gd name="connsiteY163" fmla="*/ 1023900 h 2216296"/>
                <a:gd name="connsiteX164" fmla="*/ 3847239 w 8363529"/>
                <a:gd name="connsiteY164" fmla="*/ 1057696 h 2216296"/>
                <a:gd name="connsiteX165" fmla="*/ 3838885 w 8363529"/>
                <a:gd name="connsiteY165" fmla="*/ 1036830 h 2216296"/>
                <a:gd name="connsiteX166" fmla="*/ 3771962 w 8363529"/>
                <a:gd name="connsiteY166" fmla="*/ 884517 h 2216296"/>
                <a:gd name="connsiteX167" fmla="*/ 3763609 w 8363529"/>
                <a:gd name="connsiteY167" fmla="*/ 867126 h 2216296"/>
                <a:gd name="connsiteX168" fmla="*/ 3755246 w 8363529"/>
                <a:gd name="connsiteY168" fmla="*/ 878585 h 2216296"/>
                <a:gd name="connsiteX169" fmla="*/ 3688323 w 8363529"/>
                <a:gd name="connsiteY169" fmla="*/ 982885 h 2216296"/>
                <a:gd name="connsiteX170" fmla="*/ 3679970 w 8363529"/>
                <a:gd name="connsiteY170" fmla="*/ 997779 h 2216296"/>
                <a:gd name="connsiteX171" fmla="*/ 3671616 w 8363529"/>
                <a:gd name="connsiteY171" fmla="*/ 969994 h 2216296"/>
                <a:gd name="connsiteX172" fmla="*/ 3604693 w 8363529"/>
                <a:gd name="connsiteY172" fmla="*/ 803348 h 2216296"/>
                <a:gd name="connsiteX173" fmla="*/ 3596330 w 8363529"/>
                <a:gd name="connsiteY173" fmla="*/ 787583 h 2216296"/>
                <a:gd name="connsiteX174" fmla="*/ 3587977 w 8363529"/>
                <a:gd name="connsiteY174" fmla="*/ 803232 h 2216296"/>
                <a:gd name="connsiteX175" fmla="*/ 3521054 w 8363529"/>
                <a:gd name="connsiteY175" fmla="*/ 947308 h 2216296"/>
                <a:gd name="connsiteX176" fmla="*/ 3512701 w 8363529"/>
                <a:gd name="connsiteY176" fmla="*/ 968106 h 2216296"/>
                <a:gd name="connsiteX177" fmla="*/ 3504347 w 8363529"/>
                <a:gd name="connsiteY177" fmla="*/ 967497 h 2216296"/>
                <a:gd name="connsiteX178" fmla="*/ 3437424 w 8363529"/>
                <a:gd name="connsiteY178" fmla="*/ 963306 h 2216296"/>
                <a:gd name="connsiteX179" fmla="*/ 3429061 w 8363529"/>
                <a:gd name="connsiteY179" fmla="*/ 962851 h 2216296"/>
                <a:gd name="connsiteX180" fmla="*/ 3420708 w 8363529"/>
                <a:gd name="connsiteY180" fmla="*/ 967342 h 2216296"/>
                <a:gd name="connsiteX181" fmla="*/ 3353785 w 8363529"/>
                <a:gd name="connsiteY181" fmla="*/ 1055692 h 2216296"/>
                <a:gd name="connsiteX182" fmla="*/ 3345432 w 8363529"/>
                <a:gd name="connsiteY182" fmla="*/ 1085791 h 2216296"/>
                <a:gd name="connsiteX183" fmla="*/ 3337069 w 8363529"/>
                <a:gd name="connsiteY183" fmla="*/ 1092517 h 2216296"/>
                <a:gd name="connsiteX184" fmla="*/ 3270146 w 8363529"/>
                <a:gd name="connsiteY184" fmla="*/ 1115996 h 2216296"/>
                <a:gd name="connsiteX185" fmla="*/ 3261792 w 8363529"/>
                <a:gd name="connsiteY185" fmla="*/ 1117389 h 2216296"/>
                <a:gd name="connsiteX186" fmla="*/ 3253439 w 8363529"/>
                <a:gd name="connsiteY186" fmla="*/ 1168392 h 2216296"/>
                <a:gd name="connsiteX187" fmla="*/ 3186516 w 8363529"/>
                <a:gd name="connsiteY187" fmla="*/ 1492828 h 2216296"/>
                <a:gd name="connsiteX188" fmla="*/ 3178153 w 8363529"/>
                <a:gd name="connsiteY188" fmla="*/ 1525269 h 2216296"/>
                <a:gd name="connsiteX189" fmla="*/ 3169800 w 8363529"/>
                <a:gd name="connsiteY189" fmla="*/ 1489431 h 2216296"/>
                <a:gd name="connsiteX190" fmla="*/ 3102877 w 8363529"/>
                <a:gd name="connsiteY190" fmla="*/ 1092101 h 2216296"/>
                <a:gd name="connsiteX191" fmla="*/ 3094523 w 8363529"/>
                <a:gd name="connsiteY191" fmla="*/ 1022390 h 2216296"/>
                <a:gd name="connsiteX192" fmla="*/ 3086161 w 8363529"/>
                <a:gd name="connsiteY192" fmla="*/ 1109792 h 2216296"/>
                <a:gd name="connsiteX193" fmla="*/ 3019238 w 8363529"/>
                <a:gd name="connsiteY193" fmla="*/ 1658602 h 2216296"/>
                <a:gd name="connsiteX194" fmla="*/ 3010884 w 8363529"/>
                <a:gd name="connsiteY194" fmla="*/ 1712818 h 2216296"/>
                <a:gd name="connsiteX195" fmla="*/ 3002531 w 8363529"/>
                <a:gd name="connsiteY195" fmla="*/ 1649302 h 2216296"/>
                <a:gd name="connsiteX196" fmla="*/ 2935608 w 8363529"/>
                <a:gd name="connsiteY196" fmla="*/ 1119664 h 2216296"/>
                <a:gd name="connsiteX197" fmla="*/ 2927245 w 8363529"/>
                <a:gd name="connsiteY197" fmla="*/ 1050669 h 2216296"/>
                <a:gd name="connsiteX198" fmla="*/ 2918892 w 8363529"/>
                <a:gd name="connsiteY198" fmla="*/ 1093127 h 2216296"/>
                <a:gd name="connsiteX199" fmla="*/ 2851968 w 8363529"/>
                <a:gd name="connsiteY199" fmla="*/ 1423572 h 2216296"/>
                <a:gd name="connsiteX200" fmla="*/ 2843615 w 8363529"/>
                <a:gd name="connsiteY200" fmla="*/ 1463755 h 2216296"/>
                <a:gd name="connsiteX201" fmla="*/ 2835262 w 8363529"/>
                <a:gd name="connsiteY201" fmla="*/ 1457745 h 2216296"/>
                <a:gd name="connsiteX202" fmla="*/ 2768329 w 8363529"/>
                <a:gd name="connsiteY202" fmla="*/ 1394199 h 2216296"/>
                <a:gd name="connsiteX203" fmla="*/ 2759976 w 8363529"/>
                <a:gd name="connsiteY203" fmla="*/ 1383612 h 2216296"/>
                <a:gd name="connsiteX204" fmla="*/ 2751623 w 8363529"/>
                <a:gd name="connsiteY204" fmla="*/ 1418278 h 2216296"/>
                <a:gd name="connsiteX205" fmla="*/ 2684699 w 8363529"/>
                <a:gd name="connsiteY205" fmla="*/ 1652254 h 2216296"/>
                <a:gd name="connsiteX206" fmla="*/ 2676346 w 8363529"/>
                <a:gd name="connsiteY206" fmla="*/ 1677020 h 2216296"/>
                <a:gd name="connsiteX207" fmla="*/ 2667983 w 8363529"/>
                <a:gd name="connsiteY207" fmla="*/ 1635695 h 2216296"/>
                <a:gd name="connsiteX208" fmla="*/ 2601060 w 8363529"/>
                <a:gd name="connsiteY208" fmla="*/ 1309294 h 2216296"/>
                <a:gd name="connsiteX209" fmla="*/ 2592707 w 8363529"/>
                <a:gd name="connsiteY209" fmla="*/ 1268986 h 2216296"/>
                <a:gd name="connsiteX210" fmla="*/ 2584354 w 8363529"/>
                <a:gd name="connsiteY210" fmla="*/ 1252426 h 2216296"/>
                <a:gd name="connsiteX211" fmla="*/ 2517430 w 8363529"/>
                <a:gd name="connsiteY211" fmla="*/ 1139542 h 2216296"/>
                <a:gd name="connsiteX212" fmla="*/ 2509068 w 8363529"/>
                <a:gd name="connsiteY212" fmla="*/ 1127484 h 2216296"/>
                <a:gd name="connsiteX213" fmla="*/ 2500714 w 8363529"/>
                <a:gd name="connsiteY213" fmla="*/ 1135497 h 2216296"/>
                <a:gd name="connsiteX214" fmla="*/ 2433791 w 8363529"/>
                <a:gd name="connsiteY214" fmla="*/ 1203282 h 2216296"/>
                <a:gd name="connsiteX215" fmla="*/ 2425438 w 8363529"/>
                <a:gd name="connsiteY215" fmla="*/ 1212244 h 2216296"/>
                <a:gd name="connsiteX216" fmla="*/ 2417075 w 8363529"/>
                <a:gd name="connsiteY216" fmla="*/ 1212543 h 2216296"/>
                <a:gd name="connsiteX217" fmla="*/ 2350152 w 8363529"/>
                <a:gd name="connsiteY217" fmla="*/ 1215195 h 2216296"/>
                <a:gd name="connsiteX218" fmla="*/ 2341799 w 8363529"/>
                <a:gd name="connsiteY218" fmla="*/ 1215534 h 2216296"/>
                <a:gd name="connsiteX219" fmla="*/ 2333445 w 8363529"/>
                <a:gd name="connsiteY219" fmla="*/ 1232016 h 2216296"/>
                <a:gd name="connsiteX220" fmla="*/ 2266522 w 8363529"/>
                <a:gd name="connsiteY220" fmla="*/ 1393106 h 2216296"/>
                <a:gd name="connsiteX221" fmla="*/ 2258159 w 8363529"/>
                <a:gd name="connsiteY221" fmla="*/ 1417862 h 2216296"/>
                <a:gd name="connsiteX222" fmla="*/ 2249806 w 8363529"/>
                <a:gd name="connsiteY222" fmla="*/ 1325050 h 2216296"/>
                <a:gd name="connsiteX223" fmla="*/ 2182883 w 8363529"/>
                <a:gd name="connsiteY223" fmla="*/ 704944 h 2216296"/>
                <a:gd name="connsiteX224" fmla="*/ 2174530 w 8363529"/>
                <a:gd name="connsiteY224" fmla="*/ 639995 h 2216296"/>
                <a:gd name="connsiteX225" fmla="*/ 2166176 w 8363529"/>
                <a:gd name="connsiteY225" fmla="*/ 682336 h 2216296"/>
                <a:gd name="connsiteX226" fmla="*/ 2099253 w 8363529"/>
                <a:gd name="connsiteY226" fmla="*/ 1075426 h 2216296"/>
                <a:gd name="connsiteX227" fmla="*/ 2090890 w 8363529"/>
                <a:gd name="connsiteY227" fmla="*/ 1132594 h 2216296"/>
                <a:gd name="connsiteX228" fmla="*/ 2082537 w 8363529"/>
                <a:gd name="connsiteY228" fmla="*/ 1119625 h 2216296"/>
                <a:gd name="connsiteX229" fmla="*/ 2015614 w 8363529"/>
                <a:gd name="connsiteY229" fmla="*/ 1040536 h 2216296"/>
                <a:gd name="connsiteX230" fmla="*/ 2007260 w 8363529"/>
                <a:gd name="connsiteY230" fmla="*/ 1032901 h 2216296"/>
                <a:gd name="connsiteX231" fmla="*/ 1998898 w 8363529"/>
                <a:gd name="connsiteY231" fmla="*/ 1056834 h 2216296"/>
                <a:gd name="connsiteX232" fmla="*/ 1931975 w 8363529"/>
                <a:gd name="connsiteY232" fmla="*/ 1301804 h 2216296"/>
                <a:gd name="connsiteX233" fmla="*/ 1923621 w 8363529"/>
                <a:gd name="connsiteY233" fmla="*/ 1341271 h 2216296"/>
                <a:gd name="connsiteX234" fmla="*/ 1915268 w 8363529"/>
                <a:gd name="connsiteY234" fmla="*/ 1332425 h 2216296"/>
                <a:gd name="connsiteX235" fmla="*/ 1848345 w 8363529"/>
                <a:gd name="connsiteY235" fmla="*/ 1261127 h 2216296"/>
                <a:gd name="connsiteX236" fmla="*/ 1839982 w 8363529"/>
                <a:gd name="connsiteY236" fmla="*/ 1252165 h 2216296"/>
                <a:gd name="connsiteX237" fmla="*/ 1831629 w 8363529"/>
                <a:gd name="connsiteY237" fmla="*/ 1255078 h 2216296"/>
                <a:gd name="connsiteX238" fmla="*/ 1764706 w 8363529"/>
                <a:gd name="connsiteY238" fmla="*/ 1276931 h 2216296"/>
                <a:gd name="connsiteX239" fmla="*/ 1756352 w 8363529"/>
                <a:gd name="connsiteY239" fmla="*/ 1279496 h 2216296"/>
                <a:gd name="connsiteX240" fmla="*/ 1747989 w 8363529"/>
                <a:gd name="connsiteY240" fmla="*/ 1301010 h 2216296"/>
                <a:gd name="connsiteX241" fmla="*/ 1681066 w 8363529"/>
                <a:gd name="connsiteY241" fmla="*/ 1443161 h 2216296"/>
                <a:gd name="connsiteX242" fmla="*/ 1672713 w 8363529"/>
                <a:gd name="connsiteY242" fmla="*/ 1457861 h 2216296"/>
                <a:gd name="connsiteX243" fmla="*/ 1664360 w 8363529"/>
                <a:gd name="connsiteY243" fmla="*/ 1476646 h 2216296"/>
                <a:gd name="connsiteX244" fmla="*/ 1597437 w 8363529"/>
                <a:gd name="connsiteY244" fmla="*/ 1699773 h 2216296"/>
                <a:gd name="connsiteX245" fmla="*/ 1589074 w 8363529"/>
                <a:gd name="connsiteY245" fmla="*/ 1741930 h 2216296"/>
                <a:gd name="connsiteX246" fmla="*/ 1580720 w 8363529"/>
                <a:gd name="connsiteY246" fmla="*/ 1732929 h 2216296"/>
                <a:gd name="connsiteX247" fmla="*/ 1513797 w 8363529"/>
                <a:gd name="connsiteY247" fmla="*/ 1676749 h 2216296"/>
                <a:gd name="connsiteX248" fmla="*/ 1505444 w 8363529"/>
                <a:gd name="connsiteY248" fmla="*/ 1671232 h 2216296"/>
                <a:gd name="connsiteX249" fmla="*/ 1497091 w 8363529"/>
                <a:gd name="connsiteY249" fmla="*/ 1650705 h 2216296"/>
                <a:gd name="connsiteX250" fmla="*/ 1430158 w 8363529"/>
                <a:gd name="connsiteY250" fmla="*/ 1513055 h 2216296"/>
                <a:gd name="connsiteX251" fmla="*/ 1421805 w 8363529"/>
                <a:gd name="connsiteY251" fmla="*/ 1498577 h 2216296"/>
                <a:gd name="connsiteX252" fmla="*/ 1413451 w 8363529"/>
                <a:gd name="connsiteY252" fmla="*/ 1495973 h 2216296"/>
                <a:gd name="connsiteX253" fmla="*/ 1346528 w 8363529"/>
                <a:gd name="connsiteY253" fmla="*/ 1464820 h 2216296"/>
                <a:gd name="connsiteX254" fmla="*/ 1338175 w 8363529"/>
                <a:gd name="connsiteY254" fmla="*/ 1458887 h 2216296"/>
                <a:gd name="connsiteX255" fmla="*/ 1329812 w 8363529"/>
                <a:gd name="connsiteY255" fmla="*/ 1363840 h 2216296"/>
                <a:gd name="connsiteX256" fmla="*/ 1262889 w 8363529"/>
                <a:gd name="connsiteY256" fmla="*/ 894989 h 2216296"/>
                <a:gd name="connsiteX257" fmla="*/ 1254536 w 8363529"/>
                <a:gd name="connsiteY257" fmla="*/ 857942 h 2216296"/>
                <a:gd name="connsiteX258" fmla="*/ 1246182 w 8363529"/>
                <a:gd name="connsiteY258" fmla="*/ 874007 h 2216296"/>
                <a:gd name="connsiteX259" fmla="*/ 1179259 w 8363529"/>
                <a:gd name="connsiteY259" fmla="*/ 1026136 h 2216296"/>
                <a:gd name="connsiteX260" fmla="*/ 1170896 w 8363529"/>
                <a:gd name="connsiteY260" fmla="*/ 1048705 h 2216296"/>
                <a:gd name="connsiteX261" fmla="*/ 1162543 w 8363529"/>
                <a:gd name="connsiteY261" fmla="*/ 1078716 h 2216296"/>
                <a:gd name="connsiteX262" fmla="*/ 1095620 w 8363529"/>
                <a:gd name="connsiteY262" fmla="*/ 1305655 h 2216296"/>
                <a:gd name="connsiteX263" fmla="*/ 1087267 w 8363529"/>
                <a:gd name="connsiteY263" fmla="*/ 1332464 h 2216296"/>
                <a:gd name="connsiteX264" fmla="*/ 1078904 w 8363529"/>
                <a:gd name="connsiteY264" fmla="*/ 1303584 h 2216296"/>
                <a:gd name="connsiteX265" fmla="*/ 1011981 w 8363529"/>
                <a:gd name="connsiteY265" fmla="*/ 1112173 h 2216296"/>
                <a:gd name="connsiteX266" fmla="*/ 1003627 w 8363529"/>
                <a:gd name="connsiteY266" fmla="*/ 1092294 h 2216296"/>
                <a:gd name="connsiteX267" fmla="*/ 995274 w 8363529"/>
                <a:gd name="connsiteY267" fmla="*/ 1078987 h 2216296"/>
                <a:gd name="connsiteX268" fmla="*/ 928351 w 8363529"/>
                <a:gd name="connsiteY268" fmla="*/ 941143 h 2216296"/>
                <a:gd name="connsiteX269" fmla="*/ 919988 w 8363529"/>
                <a:gd name="connsiteY269" fmla="*/ 918691 h 2216296"/>
                <a:gd name="connsiteX270" fmla="*/ 911635 w 8363529"/>
                <a:gd name="connsiteY270" fmla="*/ 922658 h 2216296"/>
                <a:gd name="connsiteX271" fmla="*/ 844712 w 8363529"/>
                <a:gd name="connsiteY271" fmla="*/ 948479 h 2216296"/>
                <a:gd name="connsiteX272" fmla="*/ 836358 w 8363529"/>
                <a:gd name="connsiteY272" fmla="*/ 951131 h 2216296"/>
                <a:gd name="connsiteX273" fmla="*/ 828005 w 8363529"/>
                <a:gd name="connsiteY273" fmla="*/ 966780 h 2216296"/>
                <a:gd name="connsiteX274" fmla="*/ 761082 w 8363529"/>
                <a:gd name="connsiteY274" fmla="*/ 1126351 h 2216296"/>
                <a:gd name="connsiteX275" fmla="*/ 752719 w 8363529"/>
                <a:gd name="connsiteY275" fmla="*/ 1151911 h 2216296"/>
                <a:gd name="connsiteX276" fmla="*/ 744366 w 8363529"/>
                <a:gd name="connsiteY276" fmla="*/ 1134326 h 2216296"/>
                <a:gd name="connsiteX277" fmla="*/ 677443 w 8363529"/>
                <a:gd name="connsiteY277" fmla="*/ 966548 h 2216296"/>
                <a:gd name="connsiteX278" fmla="*/ 669089 w 8363529"/>
                <a:gd name="connsiteY278" fmla="*/ 941414 h 2216296"/>
                <a:gd name="connsiteX279" fmla="*/ 660727 w 8363529"/>
                <a:gd name="connsiteY279" fmla="*/ 985304 h 2216296"/>
                <a:gd name="connsiteX280" fmla="*/ 593803 w 8363529"/>
                <a:gd name="connsiteY280" fmla="*/ 1224612 h 2216296"/>
                <a:gd name="connsiteX281" fmla="*/ 585450 w 8363529"/>
                <a:gd name="connsiteY281" fmla="*/ 1245323 h 2216296"/>
                <a:gd name="connsiteX282" fmla="*/ 577097 w 8363529"/>
                <a:gd name="connsiteY282" fmla="*/ 1247026 h 2216296"/>
                <a:gd name="connsiteX283" fmla="*/ 510174 w 8363529"/>
                <a:gd name="connsiteY283" fmla="*/ 1268647 h 2216296"/>
                <a:gd name="connsiteX284" fmla="*/ 501811 w 8363529"/>
                <a:gd name="connsiteY284" fmla="*/ 1273070 h 2216296"/>
                <a:gd name="connsiteX285" fmla="*/ 493458 w 8363529"/>
                <a:gd name="connsiteY285" fmla="*/ 1185174 h 2216296"/>
                <a:gd name="connsiteX286" fmla="*/ 426534 w 8363529"/>
                <a:gd name="connsiteY286" fmla="*/ 791589 h 2216296"/>
                <a:gd name="connsiteX287" fmla="*/ 418181 w 8363529"/>
                <a:gd name="connsiteY287" fmla="*/ 763049 h 2216296"/>
                <a:gd name="connsiteX288" fmla="*/ 409818 w 8363529"/>
                <a:gd name="connsiteY288" fmla="*/ 816278 h 2216296"/>
                <a:gd name="connsiteX289" fmla="*/ 342895 w 8363529"/>
                <a:gd name="connsiteY289" fmla="*/ 1395371 h 2216296"/>
                <a:gd name="connsiteX290" fmla="*/ 334542 w 8363529"/>
                <a:gd name="connsiteY290" fmla="*/ 1494870 h 2216296"/>
                <a:gd name="connsiteX291" fmla="*/ 326189 w 8363529"/>
                <a:gd name="connsiteY291" fmla="*/ 1520013 h 2216296"/>
                <a:gd name="connsiteX292" fmla="*/ 259304 w 8363529"/>
                <a:gd name="connsiteY292" fmla="*/ 1752285 h 2216296"/>
                <a:gd name="connsiteX293" fmla="*/ 250903 w 8363529"/>
                <a:gd name="connsiteY293" fmla="*/ 1785897 h 2216296"/>
                <a:gd name="connsiteX294" fmla="*/ 242549 w 8363529"/>
                <a:gd name="connsiteY294" fmla="*/ 1649224 h 2216296"/>
                <a:gd name="connsiteX295" fmla="*/ 175665 w 8363529"/>
                <a:gd name="connsiteY295" fmla="*/ 885079 h 2216296"/>
                <a:gd name="connsiteX296" fmla="*/ 167273 w 8363529"/>
                <a:gd name="connsiteY296" fmla="*/ 817410 h 2216296"/>
                <a:gd name="connsiteX297" fmla="*/ 158920 w 8363529"/>
                <a:gd name="connsiteY297" fmla="*/ 846938 h 2216296"/>
                <a:gd name="connsiteX298" fmla="*/ 92029 w 8363529"/>
                <a:gd name="connsiteY298" fmla="*/ 1119054 h 2216296"/>
                <a:gd name="connsiteX299" fmla="*/ 83635 w 8363529"/>
                <a:gd name="connsiteY299" fmla="*/ 1158337 h 2216296"/>
                <a:gd name="connsiteX300" fmla="*/ 75279 w 8363529"/>
                <a:gd name="connsiteY300" fmla="*/ 1139997 h 2216296"/>
                <a:gd name="connsiteX301" fmla="*/ 8394 w 8363529"/>
                <a:gd name="connsiteY301" fmla="*/ 995060 h 2216296"/>
                <a:gd name="connsiteX302" fmla="*/ 0 w 8363529"/>
                <a:gd name="connsiteY302" fmla="*/ 977175 h 22162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</a:cxnLst>
              <a:rect l="l" t="t" r="r" b="b"/>
              <a:pathLst>
                <a:path w="8363529" h="2216296">
                  <a:moveTo>
                    <a:pt x="0" y="0"/>
                  </a:moveTo>
                  <a:lnTo>
                    <a:pt x="8363530" y="0"/>
                  </a:lnTo>
                  <a:lnTo>
                    <a:pt x="8363530" y="1394616"/>
                  </a:lnTo>
                  <a:lnTo>
                    <a:pt x="8355177" y="1355788"/>
                  </a:lnTo>
                  <a:lnTo>
                    <a:pt x="8288254" y="1048395"/>
                  </a:lnTo>
                  <a:lnTo>
                    <a:pt x="8279900" y="1010331"/>
                  </a:lnTo>
                  <a:lnTo>
                    <a:pt x="8271537" y="1007873"/>
                  </a:lnTo>
                  <a:lnTo>
                    <a:pt x="8204614" y="992785"/>
                  </a:lnTo>
                  <a:lnTo>
                    <a:pt x="8196261" y="991353"/>
                  </a:lnTo>
                  <a:lnTo>
                    <a:pt x="8187908" y="1011048"/>
                  </a:lnTo>
                  <a:lnTo>
                    <a:pt x="8120985" y="1245023"/>
                  </a:lnTo>
                  <a:lnTo>
                    <a:pt x="8112622" y="1289251"/>
                  </a:lnTo>
                  <a:lnTo>
                    <a:pt x="8104268" y="1303236"/>
                  </a:lnTo>
                  <a:lnTo>
                    <a:pt x="8037346" y="1400926"/>
                  </a:lnTo>
                  <a:lnTo>
                    <a:pt x="8028992" y="1411552"/>
                  </a:lnTo>
                  <a:lnTo>
                    <a:pt x="8020629" y="1391557"/>
                  </a:lnTo>
                  <a:lnTo>
                    <a:pt x="7953706" y="1223702"/>
                  </a:lnTo>
                  <a:lnTo>
                    <a:pt x="7945353" y="1201695"/>
                  </a:lnTo>
                  <a:lnTo>
                    <a:pt x="7937000" y="1185484"/>
                  </a:lnTo>
                  <a:lnTo>
                    <a:pt x="7870077" y="1094104"/>
                  </a:lnTo>
                  <a:lnTo>
                    <a:pt x="7861713" y="1085975"/>
                  </a:lnTo>
                  <a:lnTo>
                    <a:pt x="7853360" y="1093804"/>
                  </a:lnTo>
                  <a:lnTo>
                    <a:pt x="7786437" y="1193836"/>
                  </a:lnTo>
                  <a:lnTo>
                    <a:pt x="7778084" y="1214324"/>
                  </a:lnTo>
                  <a:lnTo>
                    <a:pt x="7769731" y="1224796"/>
                  </a:lnTo>
                  <a:lnTo>
                    <a:pt x="7702798" y="1292581"/>
                  </a:lnTo>
                  <a:lnTo>
                    <a:pt x="7694444" y="1299462"/>
                  </a:lnTo>
                  <a:lnTo>
                    <a:pt x="7686091" y="1290122"/>
                  </a:lnTo>
                  <a:lnTo>
                    <a:pt x="7619168" y="1221505"/>
                  </a:lnTo>
                  <a:lnTo>
                    <a:pt x="7610815" y="1213608"/>
                  </a:lnTo>
                  <a:lnTo>
                    <a:pt x="7602452" y="1207637"/>
                  </a:lnTo>
                  <a:lnTo>
                    <a:pt x="7535528" y="1150701"/>
                  </a:lnTo>
                  <a:lnTo>
                    <a:pt x="7527175" y="1142233"/>
                  </a:lnTo>
                  <a:lnTo>
                    <a:pt x="7518822" y="1124387"/>
                  </a:lnTo>
                  <a:lnTo>
                    <a:pt x="7451899" y="1006092"/>
                  </a:lnTo>
                  <a:lnTo>
                    <a:pt x="7443536" y="993811"/>
                  </a:lnTo>
                  <a:lnTo>
                    <a:pt x="7435183" y="1014299"/>
                  </a:lnTo>
                  <a:lnTo>
                    <a:pt x="7368260" y="1210095"/>
                  </a:lnTo>
                  <a:lnTo>
                    <a:pt x="7359906" y="1239429"/>
                  </a:lnTo>
                  <a:lnTo>
                    <a:pt x="7351543" y="1243320"/>
                  </a:lnTo>
                  <a:lnTo>
                    <a:pt x="7284620" y="1272692"/>
                  </a:lnTo>
                  <a:lnTo>
                    <a:pt x="7276267" y="1276176"/>
                  </a:lnTo>
                  <a:lnTo>
                    <a:pt x="7267914" y="1252998"/>
                  </a:lnTo>
                  <a:lnTo>
                    <a:pt x="7200991" y="1052634"/>
                  </a:lnTo>
                  <a:lnTo>
                    <a:pt x="7192628" y="1025526"/>
                  </a:lnTo>
                  <a:lnTo>
                    <a:pt x="7184274" y="1046469"/>
                  </a:lnTo>
                  <a:lnTo>
                    <a:pt x="7117351" y="1207521"/>
                  </a:lnTo>
                  <a:lnTo>
                    <a:pt x="7108998" y="1226877"/>
                  </a:lnTo>
                  <a:lnTo>
                    <a:pt x="7100645" y="1167599"/>
                  </a:lnTo>
                  <a:lnTo>
                    <a:pt x="7033712" y="724298"/>
                  </a:lnTo>
                  <a:lnTo>
                    <a:pt x="7025359" y="672470"/>
                  </a:lnTo>
                  <a:lnTo>
                    <a:pt x="7017006" y="681618"/>
                  </a:lnTo>
                  <a:lnTo>
                    <a:pt x="6950083" y="741506"/>
                  </a:lnTo>
                  <a:lnTo>
                    <a:pt x="6941729" y="747661"/>
                  </a:lnTo>
                  <a:lnTo>
                    <a:pt x="6933366" y="821949"/>
                  </a:lnTo>
                  <a:lnTo>
                    <a:pt x="6866443" y="1689794"/>
                  </a:lnTo>
                  <a:lnTo>
                    <a:pt x="6858090" y="1850846"/>
                  </a:lnTo>
                  <a:lnTo>
                    <a:pt x="6849737" y="1841768"/>
                  </a:lnTo>
                  <a:lnTo>
                    <a:pt x="6782814" y="1779655"/>
                  </a:lnTo>
                  <a:lnTo>
                    <a:pt x="6774451" y="1772967"/>
                  </a:lnTo>
                  <a:lnTo>
                    <a:pt x="6766097" y="1692892"/>
                  </a:lnTo>
                  <a:lnTo>
                    <a:pt x="6699174" y="1184342"/>
                  </a:lnTo>
                  <a:lnTo>
                    <a:pt x="6690821" y="1133571"/>
                  </a:lnTo>
                  <a:lnTo>
                    <a:pt x="6682458" y="1207821"/>
                  </a:lnTo>
                  <a:lnTo>
                    <a:pt x="6615535" y="2047648"/>
                  </a:lnTo>
                  <a:lnTo>
                    <a:pt x="6607182" y="2198228"/>
                  </a:lnTo>
                  <a:lnTo>
                    <a:pt x="6598829" y="2076276"/>
                  </a:lnTo>
                  <a:lnTo>
                    <a:pt x="6531944" y="1204308"/>
                  </a:lnTo>
                  <a:lnTo>
                    <a:pt x="6523542" y="1106773"/>
                  </a:lnTo>
                  <a:lnTo>
                    <a:pt x="6515189" y="1143443"/>
                  </a:lnTo>
                  <a:lnTo>
                    <a:pt x="6448305" y="1403994"/>
                  </a:lnTo>
                  <a:lnTo>
                    <a:pt x="6439913" y="1432989"/>
                  </a:lnTo>
                  <a:lnTo>
                    <a:pt x="6431560" y="1441080"/>
                  </a:lnTo>
                  <a:lnTo>
                    <a:pt x="6364665" y="1511807"/>
                  </a:lnTo>
                  <a:lnTo>
                    <a:pt x="6356273" y="1521446"/>
                  </a:lnTo>
                  <a:lnTo>
                    <a:pt x="6347920" y="1498354"/>
                  </a:lnTo>
                  <a:lnTo>
                    <a:pt x="6281036" y="1281277"/>
                  </a:lnTo>
                  <a:lnTo>
                    <a:pt x="6272644" y="1249330"/>
                  </a:lnTo>
                  <a:lnTo>
                    <a:pt x="6264280" y="1262908"/>
                  </a:lnTo>
                  <a:lnTo>
                    <a:pt x="6197396" y="1347552"/>
                  </a:lnTo>
                  <a:lnTo>
                    <a:pt x="6189004" y="1355865"/>
                  </a:lnTo>
                  <a:lnTo>
                    <a:pt x="6180651" y="1321731"/>
                  </a:lnTo>
                  <a:lnTo>
                    <a:pt x="6113767" y="1005986"/>
                  </a:lnTo>
                  <a:lnTo>
                    <a:pt x="6105365" y="960199"/>
                  </a:lnTo>
                  <a:lnTo>
                    <a:pt x="6097011" y="990937"/>
                  </a:lnTo>
                  <a:lnTo>
                    <a:pt x="6030127" y="1207182"/>
                  </a:lnTo>
                  <a:lnTo>
                    <a:pt x="6021735" y="1231038"/>
                  </a:lnTo>
                  <a:lnTo>
                    <a:pt x="6013372" y="1291971"/>
                  </a:lnTo>
                  <a:lnTo>
                    <a:pt x="5946488" y="2047726"/>
                  </a:lnTo>
                  <a:lnTo>
                    <a:pt x="5938096" y="2197628"/>
                  </a:lnTo>
                  <a:lnTo>
                    <a:pt x="5929743" y="2006865"/>
                  </a:lnTo>
                  <a:lnTo>
                    <a:pt x="5862858" y="1097279"/>
                  </a:lnTo>
                  <a:lnTo>
                    <a:pt x="5854457" y="1027529"/>
                  </a:lnTo>
                  <a:lnTo>
                    <a:pt x="5846103" y="1114215"/>
                  </a:lnTo>
                  <a:lnTo>
                    <a:pt x="5779219" y="2055061"/>
                  </a:lnTo>
                  <a:lnTo>
                    <a:pt x="5770827" y="2216297"/>
                  </a:lnTo>
                  <a:lnTo>
                    <a:pt x="5762474" y="2024440"/>
                  </a:lnTo>
                  <a:lnTo>
                    <a:pt x="5695580" y="958351"/>
                  </a:lnTo>
                  <a:lnTo>
                    <a:pt x="5687188" y="864445"/>
                  </a:lnTo>
                  <a:lnTo>
                    <a:pt x="5678835" y="892115"/>
                  </a:lnTo>
                  <a:lnTo>
                    <a:pt x="5611950" y="1114447"/>
                  </a:lnTo>
                  <a:lnTo>
                    <a:pt x="5603558" y="1142349"/>
                  </a:lnTo>
                  <a:lnTo>
                    <a:pt x="5595195" y="1197765"/>
                  </a:lnTo>
                  <a:lnTo>
                    <a:pt x="5528311" y="1828538"/>
                  </a:lnTo>
                  <a:lnTo>
                    <a:pt x="5519919" y="1942439"/>
                  </a:lnTo>
                  <a:lnTo>
                    <a:pt x="5511566" y="1902556"/>
                  </a:lnTo>
                  <a:lnTo>
                    <a:pt x="5444672" y="1191000"/>
                  </a:lnTo>
                  <a:lnTo>
                    <a:pt x="5436280" y="975287"/>
                  </a:lnTo>
                  <a:lnTo>
                    <a:pt x="5427926" y="1120873"/>
                  </a:lnTo>
                  <a:lnTo>
                    <a:pt x="5361042" y="1543570"/>
                  </a:lnTo>
                  <a:lnTo>
                    <a:pt x="5352650" y="1564958"/>
                  </a:lnTo>
                  <a:lnTo>
                    <a:pt x="5344287" y="1446857"/>
                  </a:lnTo>
                  <a:lnTo>
                    <a:pt x="5277403" y="631717"/>
                  </a:lnTo>
                  <a:lnTo>
                    <a:pt x="5269049" y="543631"/>
                  </a:lnTo>
                  <a:lnTo>
                    <a:pt x="5260657" y="607294"/>
                  </a:lnTo>
                  <a:lnTo>
                    <a:pt x="5193773" y="1075881"/>
                  </a:lnTo>
                  <a:lnTo>
                    <a:pt x="5185410" y="1129864"/>
                  </a:lnTo>
                  <a:lnTo>
                    <a:pt x="5177018" y="1158753"/>
                  </a:lnTo>
                  <a:lnTo>
                    <a:pt x="5110134" y="1474914"/>
                  </a:lnTo>
                  <a:lnTo>
                    <a:pt x="5101780" y="1529575"/>
                  </a:lnTo>
                  <a:lnTo>
                    <a:pt x="5093388" y="1517816"/>
                  </a:lnTo>
                  <a:lnTo>
                    <a:pt x="5026494" y="1438922"/>
                  </a:lnTo>
                  <a:lnTo>
                    <a:pt x="5018141" y="1430608"/>
                  </a:lnTo>
                  <a:lnTo>
                    <a:pt x="5009749" y="1440770"/>
                  </a:lnTo>
                  <a:lnTo>
                    <a:pt x="4942864" y="1512755"/>
                  </a:lnTo>
                  <a:lnTo>
                    <a:pt x="4934501" y="1520730"/>
                  </a:lnTo>
                  <a:lnTo>
                    <a:pt x="4926109" y="1537211"/>
                  </a:lnTo>
                  <a:lnTo>
                    <a:pt x="4859225" y="1735194"/>
                  </a:lnTo>
                  <a:lnTo>
                    <a:pt x="4850872" y="1773035"/>
                  </a:lnTo>
                  <a:lnTo>
                    <a:pt x="4842480" y="1700944"/>
                  </a:lnTo>
                  <a:lnTo>
                    <a:pt x="4775595" y="1263701"/>
                  </a:lnTo>
                  <a:lnTo>
                    <a:pt x="4767232" y="1221922"/>
                  </a:lnTo>
                  <a:lnTo>
                    <a:pt x="4758840" y="1207559"/>
                  </a:lnTo>
                  <a:lnTo>
                    <a:pt x="4691956" y="1079094"/>
                  </a:lnTo>
                  <a:lnTo>
                    <a:pt x="4683603" y="1061102"/>
                  </a:lnTo>
                  <a:lnTo>
                    <a:pt x="4675201" y="1078416"/>
                  </a:lnTo>
                  <a:lnTo>
                    <a:pt x="4608317" y="1219996"/>
                  </a:lnTo>
                  <a:lnTo>
                    <a:pt x="4599964" y="1238064"/>
                  </a:lnTo>
                  <a:lnTo>
                    <a:pt x="4591572" y="1186839"/>
                  </a:lnTo>
                  <a:lnTo>
                    <a:pt x="4524687" y="819414"/>
                  </a:lnTo>
                  <a:lnTo>
                    <a:pt x="4516324" y="778176"/>
                  </a:lnTo>
                  <a:lnTo>
                    <a:pt x="4507932" y="793138"/>
                  </a:lnTo>
                  <a:lnTo>
                    <a:pt x="4441048" y="906293"/>
                  </a:lnTo>
                  <a:lnTo>
                    <a:pt x="4432695" y="919678"/>
                  </a:lnTo>
                  <a:lnTo>
                    <a:pt x="4424303" y="952263"/>
                  </a:lnTo>
                  <a:lnTo>
                    <a:pt x="4357409" y="1215079"/>
                  </a:lnTo>
                  <a:lnTo>
                    <a:pt x="4349055" y="1248197"/>
                  </a:lnTo>
                  <a:lnTo>
                    <a:pt x="4340664" y="1282564"/>
                  </a:lnTo>
                  <a:lnTo>
                    <a:pt x="4273779" y="1580046"/>
                  </a:lnTo>
                  <a:lnTo>
                    <a:pt x="4265416" y="1620307"/>
                  </a:lnTo>
                  <a:lnTo>
                    <a:pt x="4257024" y="1565761"/>
                  </a:lnTo>
                  <a:lnTo>
                    <a:pt x="4190140" y="1217915"/>
                  </a:lnTo>
                  <a:lnTo>
                    <a:pt x="4181787" y="1183064"/>
                  </a:lnTo>
                  <a:lnTo>
                    <a:pt x="4173394" y="1196217"/>
                  </a:lnTo>
                  <a:lnTo>
                    <a:pt x="4106500" y="1357297"/>
                  </a:lnTo>
                  <a:lnTo>
                    <a:pt x="4098147" y="1388789"/>
                  </a:lnTo>
                  <a:lnTo>
                    <a:pt x="4089755" y="1288690"/>
                  </a:lnTo>
                  <a:lnTo>
                    <a:pt x="4022871" y="767288"/>
                  </a:lnTo>
                  <a:lnTo>
                    <a:pt x="4014517" y="723998"/>
                  </a:lnTo>
                  <a:lnTo>
                    <a:pt x="4006154" y="726602"/>
                  </a:lnTo>
                  <a:lnTo>
                    <a:pt x="3939231" y="750351"/>
                  </a:lnTo>
                  <a:lnTo>
                    <a:pt x="3930878" y="753710"/>
                  </a:lnTo>
                  <a:lnTo>
                    <a:pt x="3922525" y="781011"/>
                  </a:lnTo>
                  <a:lnTo>
                    <a:pt x="3855602" y="1023900"/>
                  </a:lnTo>
                  <a:lnTo>
                    <a:pt x="3847239" y="1057696"/>
                  </a:lnTo>
                  <a:lnTo>
                    <a:pt x="3838885" y="1036830"/>
                  </a:lnTo>
                  <a:lnTo>
                    <a:pt x="3771962" y="884517"/>
                  </a:lnTo>
                  <a:lnTo>
                    <a:pt x="3763609" y="867126"/>
                  </a:lnTo>
                  <a:lnTo>
                    <a:pt x="3755246" y="878585"/>
                  </a:lnTo>
                  <a:lnTo>
                    <a:pt x="3688323" y="982885"/>
                  </a:lnTo>
                  <a:lnTo>
                    <a:pt x="3679970" y="997779"/>
                  </a:lnTo>
                  <a:lnTo>
                    <a:pt x="3671616" y="969994"/>
                  </a:lnTo>
                  <a:lnTo>
                    <a:pt x="3604693" y="803348"/>
                  </a:lnTo>
                  <a:lnTo>
                    <a:pt x="3596330" y="787583"/>
                  </a:lnTo>
                  <a:lnTo>
                    <a:pt x="3587977" y="803232"/>
                  </a:lnTo>
                  <a:lnTo>
                    <a:pt x="3521054" y="947308"/>
                  </a:lnTo>
                  <a:lnTo>
                    <a:pt x="3512701" y="968106"/>
                  </a:lnTo>
                  <a:lnTo>
                    <a:pt x="3504347" y="967497"/>
                  </a:lnTo>
                  <a:lnTo>
                    <a:pt x="3437424" y="963306"/>
                  </a:lnTo>
                  <a:lnTo>
                    <a:pt x="3429061" y="962851"/>
                  </a:lnTo>
                  <a:lnTo>
                    <a:pt x="3420708" y="967342"/>
                  </a:lnTo>
                  <a:lnTo>
                    <a:pt x="3353785" y="1055692"/>
                  </a:lnTo>
                  <a:lnTo>
                    <a:pt x="3345432" y="1085791"/>
                  </a:lnTo>
                  <a:lnTo>
                    <a:pt x="3337069" y="1092517"/>
                  </a:lnTo>
                  <a:lnTo>
                    <a:pt x="3270146" y="1115996"/>
                  </a:lnTo>
                  <a:lnTo>
                    <a:pt x="3261792" y="1117389"/>
                  </a:lnTo>
                  <a:lnTo>
                    <a:pt x="3253439" y="1168392"/>
                  </a:lnTo>
                  <a:lnTo>
                    <a:pt x="3186516" y="1492828"/>
                  </a:lnTo>
                  <a:lnTo>
                    <a:pt x="3178153" y="1525269"/>
                  </a:lnTo>
                  <a:lnTo>
                    <a:pt x="3169800" y="1489431"/>
                  </a:lnTo>
                  <a:lnTo>
                    <a:pt x="3102877" y="1092101"/>
                  </a:lnTo>
                  <a:lnTo>
                    <a:pt x="3094523" y="1022390"/>
                  </a:lnTo>
                  <a:lnTo>
                    <a:pt x="3086161" y="1109792"/>
                  </a:lnTo>
                  <a:lnTo>
                    <a:pt x="3019238" y="1658602"/>
                  </a:lnTo>
                  <a:lnTo>
                    <a:pt x="3010884" y="1712818"/>
                  </a:lnTo>
                  <a:lnTo>
                    <a:pt x="3002531" y="1649302"/>
                  </a:lnTo>
                  <a:lnTo>
                    <a:pt x="2935608" y="1119664"/>
                  </a:lnTo>
                  <a:lnTo>
                    <a:pt x="2927245" y="1050669"/>
                  </a:lnTo>
                  <a:lnTo>
                    <a:pt x="2918892" y="1093127"/>
                  </a:lnTo>
                  <a:lnTo>
                    <a:pt x="2851968" y="1423572"/>
                  </a:lnTo>
                  <a:lnTo>
                    <a:pt x="2843615" y="1463755"/>
                  </a:lnTo>
                  <a:lnTo>
                    <a:pt x="2835262" y="1457745"/>
                  </a:lnTo>
                  <a:lnTo>
                    <a:pt x="2768329" y="1394199"/>
                  </a:lnTo>
                  <a:lnTo>
                    <a:pt x="2759976" y="1383612"/>
                  </a:lnTo>
                  <a:lnTo>
                    <a:pt x="2751623" y="1418278"/>
                  </a:lnTo>
                  <a:lnTo>
                    <a:pt x="2684699" y="1652254"/>
                  </a:lnTo>
                  <a:lnTo>
                    <a:pt x="2676346" y="1677020"/>
                  </a:lnTo>
                  <a:lnTo>
                    <a:pt x="2667983" y="1635695"/>
                  </a:lnTo>
                  <a:lnTo>
                    <a:pt x="2601060" y="1309294"/>
                  </a:lnTo>
                  <a:lnTo>
                    <a:pt x="2592707" y="1268986"/>
                  </a:lnTo>
                  <a:lnTo>
                    <a:pt x="2584354" y="1252426"/>
                  </a:lnTo>
                  <a:lnTo>
                    <a:pt x="2517430" y="1139542"/>
                  </a:lnTo>
                  <a:lnTo>
                    <a:pt x="2509068" y="1127484"/>
                  </a:lnTo>
                  <a:lnTo>
                    <a:pt x="2500714" y="1135497"/>
                  </a:lnTo>
                  <a:lnTo>
                    <a:pt x="2433791" y="1203282"/>
                  </a:lnTo>
                  <a:lnTo>
                    <a:pt x="2425438" y="1212244"/>
                  </a:lnTo>
                  <a:lnTo>
                    <a:pt x="2417075" y="1212543"/>
                  </a:lnTo>
                  <a:lnTo>
                    <a:pt x="2350152" y="1215195"/>
                  </a:lnTo>
                  <a:lnTo>
                    <a:pt x="2341799" y="1215534"/>
                  </a:lnTo>
                  <a:lnTo>
                    <a:pt x="2333445" y="1232016"/>
                  </a:lnTo>
                  <a:lnTo>
                    <a:pt x="2266522" y="1393106"/>
                  </a:lnTo>
                  <a:lnTo>
                    <a:pt x="2258159" y="1417862"/>
                  </a:lnTo>
                  <a:lnTo>
                    <a:pt x="2249806" y="1325050"/>
                  </a:lnTo>
                  <a:lnTo>
                    <a:pt x="2182883" y="704944"/>
                  </a:lnTo>
                  <a:lnTo>
                    <a:pt x="2174530" y="639995"/>
                  </a:lnTo>
                  <a:lnTo>
                    <a:pt x="2166176" y="682336"/>
                  </a:lnTo>
                  <a:lnTo>
                    <a:pt x="2099253" y="1075426"/>
                  </a:lnTo>
                  <a:lnTo>
                    <a:pt x="2090890" y="1132594"/>
                  </a:lnTo>
                  <a:lnTo>
                    <a:pt x="2082537" y="1119625"/>
                  </a:lnTo>
                  <a:lnTo>
                    <a:pt x="2015614" y="1040536"/>
                  </a:lnTo>
                  <a:lnTo>
                    <a:pt x="2007260" y="1032901"/>
                  </a:lnTo>
                  <a:lnTo>
                    <a:pt x="1998898" y="1056834"/>
                  </a:lnTo>
                  <a:lnTo>
                    <a:pt x="1931975" y="1301804"/>
                  </a:lnTo>
                  <a:lnTo>
                    <a:pt x="1923621" y="1341271"/>
                  </a:lnTo>
                  <a:lnTo>
                    <a:pt x="1915268" y="1332425"/>
                  </a:lnTo>
                  <a:lnTo>
                    <a:pt x="1848345" y="1261127"/>
                  </a:lnTo>
                  <a:lnTo>
                    <a:pt x="1839982" y="1252165"/>
                  </a:lnTo>
                  <a:lnTo>
                    <a:pt x="1831629" y="1255078"/>
                  </a:lnTo>
                  <a:lnTo>
                    <a:pt x="1764706" y="1276931"/>
                  </a:lnTo>
                  <a:lnTo>
                    <a:pt x="1756352" y="1279496"/>
                  </a:lnTo>
                  <a:lnTo>
                    <a:pt x="1747989" y="1301010"/>
                  </a:lnTo>
                  <a:lnTo>
                    <a:pt x="1681066" y="1443161"/>
                  </a:lnTo>
                  <a:lnTo>
                    <a:pt x="1672713" y="1457861"/>
                  </a:lnTo>
                  <a:lnTo>
                    <a:pt x="1664360" y="1476646"/>
                  </a:lnTo>
                  <a:lnTo>
                    <a:pt x="1597437" y="1699773"/>
                  </a:lnTo>
                  <a:lnTo>
                    <a:pt x="1589074" y="1741930"/>
                  </a:lnTo>
                  <a:lnTo>
                    <a:pt x="1580720" y="1732929"/>
                  </a:lnTo>
                  <a:lnTo>
                    <a:pt x="1513797" y="1676749"/>
                  </a:lnTo>
                  <a:lnTo>
                    <a:pt x="1505444" y="1671232"/>
                  </a:lnTo>
                  <a:lnTo>
                    <a:pt x="1497091" y="1650705"/>
                  </a:lnTo>
                  <a:lnTo>
                    <a:pt x="1430158" y="1513055"/>
                  </a:lnTo>
                  <a:lnTo>
                    <a:pt x="1421805" y="1498577"/>
                  </a:lnTo>
                  <a:lnTo>
                    <a:pt x="1413451" y="1495973"/>
                  </a:lnTo>
                  <a:lnTo>
                    <a:pt x="1346528" y="1464820"/>
                  </a:lnTo>
                  <a:lnTo>
                    <a:pt x="1338175" y="1458887"/>
                  </a:lnTo>
                  <a:lnTo>
                    <a:pt x="1329812" y="1363840"/>
                  </a:lnTo>
                  <a:lnTo>
                    <a:pt x="1262889" y="894989"/>
                  </a:lnTo>
                  <a:lnTo>
                    <a:pt x="1254536" y="857942"/>
                  </a:lnTo>
                  <a:lnTo>
                    <a:pt x="1246182" y="874007"/>
                  </a:lnTo>
                  <a:lnTo>
                    <a:pt x="1179259" y="1026136"/>
                  </a:lnTo>
                  <a:lnTo>
                    <a:pt x="1170896" y="1048705"/>
                  </a:lnTo>
                  <a:lnTo>
                    <a:pt x="1162543" y="1078716"/>
                  </a:lnTo>
                  <a:lnTo>
                    <a:pt x="1095620" y="1305655"/>
                  </a:lnTo>
                  <a:lnTo>
                    <a:pt x="1087267" y="1332464"/>
                  </a:lnTo>
                  <a:lnTo>
                    <a:pt x="1078904" y="1303584"/>
                  </a:lnTo>
                  <a:lnTo>
                    <a:pt x="1011981" y="1112173"/>
                  </a:lnTo>
                  <a:lnTo>
                    <a:pt x="1003627" y="1092294"/>
                  </a:lnTo>
                  <a:lnTo>
                    <a:pt x="995274" y="1078987"/>
                  </a:lnTo>
                  <a:lnTo>
                    <a:pt x="928351" y="941143"/>
                  </a:lnTo>
                  <a:lnTo>
                    <a:pt x="919988" y="918691"/>
                  </a:lnTo>
                  <a:lnTo>
                    <a:pt x="911635" y="922658"/>
                  </a:lnTo>
                  <a:lnTo>
                    <a:pt x="844712" y="948479"/>
                  </a:lnTo>
                  <a:lnTo>
                    <a:pt x="836358" y="951131"/>
                  </a:lnTo>
                  <a:lnTo>
                    <a:pt x="828005" y="966780"/>
                  </a:lnTo>
                  <a:lnTo>
                    <a:pt x="761082" y="1126351"/>
                  </a:lnTo>
                  <a:lnTo>
                    <a:pt x="752719" y="1151911"/>
                  </a:lnTo>
                  <a:lnTo>
                    <a:pt x="744366" y="1134326"/>
                  </a:lnTo>
                  <a:lnTo>
                    <a:pt x="677443" y="966548"/>
                  </a:lnTo>
                  <a:lnTo>
                    <a:pt x="669089" y="941414"/>
                  </a:lnTo>
                  <a:lnTo>
                    <a:pt x="660727" y="985304"/>
                  </a:lnTo>
                  <a:lnTo>
                    <a:pt x="593803" y="1224612"/>
                  </a:lnTo>
                  <a:lnTo>
                    <a:pt x="585450" y="1245323"/>
                  </a:lnTo>
                  <a:lnTo>
                    <a:pt x="577097" y="1247026"/>
                  </a:lnTo>
                  <a:lnTo>
                    <a:pt x="510174" y="1268647"/>
                  </a:lnTo>
                  <a:lnTo>
                    <a:pt x="501811" y="1273070"/>
                  </a:lnTo>
                  <a:lnTo>
                    <a:pt x="493458" y="1185174"/>
                  </a:lnTo>
                  <a:lnTo>
                    <a:pt x="426534" y="791589"/>
                  </a:lnTo>
                  <a:lnTo>
                    <a:pt x="418181" y="763049"/>
                  </a:lnTo>
                  <a:lnTo>
                    <a:pt x="409818" y="816278"/>
                  </a:lnTo>
                  <a:lnTo>
                    <a:pt x="342895" y="1395371"/>
                  </a:lnTo>
                  <a:lnTo>
                    <a:pt x="334542" y="1494870"/>
                  </a:lnTo>
                  <a:lnTo>
                    <a:pt x="326189" y="1520013"/>
                  </a:lnTo>
                  <a:lnTo>
                    <a:pt x="259304" y="1752285"/>
                  </a:lnTo>
                  <a:lnTo>
                    <a:pt x="250903" y="1785897"/>
                  </a:lnTo>
                  <a:lnTo>
                    <a:pt x="242549" y="1649224"/>
                  </a:lnTo>
                  <a:lnTo>
                    <a:pt x="175665" y="885079"/>
                  </a:lnTo>
                  <a:lnTo>
                    <a:pt x="167273" y="817410"/>
                  </a:lnTo>
                  <a:lnTo>
                    <a:pt x="158920" y="846938"/>
                  </a:lnTo>
                  <a:lnTo>
                    <a:pt x="92029" y="1119054"/>
                  </a:lnTo>
                  <a:lnTo>
                    <a:pt x="83635" y="1158337"/>
                  </a:lnTo>
                  <a:lnTo>
                    <a:pt x="75279" y="1139997"/>
                  </a:lnTo>
                  <a:lnTo>
                    <a:pt x="8394" y="995060"/>
                  </a:lnTo>
                  <a:lnTo>
                    <a:pt x="0" y="977175"/>
                  </a:lnTo>
                  <a:close/>
                </a:path>
              </a:pathLst>
            </a:custGeom>
            <a:solidFill>
              <a:srgbClr val="8DD3C7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98" name="Freeform: Shape 2997">
              <a:extLst>
                <a:ext uri="{FF2B5EF4-FFF2-40B4-BE49-F238E27FC236}">
                  <a16:creationId xmlns:a16="http://schemas.microsoft.com/office/drawing/2014/main" id="{FEA8C733-07B4-DE1D-770D-0503E8A2FE4C}"/>
                </a:ext>
              </a:extLst>
            </p:cNvPr>
            <p:cNvSpPr/>
            <p:nvPr/>
          </p:nvSpPr>
          <p:spPr>
            <a:xfrm>
              <a:off x="1961705" y="1131193"/>
              <a:ext cx="8363529" cy="2372732"/>
            </a:xfrm>
            <a:custGeom>
              <a:avLst/>
              <a:gdLst>
                <a:gd name="connsiteX0" fmla="*/ 0 w 8363529"/>
                <a:gd name="connsiteY0" fmla="*/ 433543 h 2372732"/>
                <a:gd name="connsiteX1" fmla="*/ 8394 w 8363529"/>
                <a:gd name="connsiteY1" fmla="*/ 451428 h 2372732"/>
                <a:gd name="connsiteX2" fmla="*/ 75279 w 8363529"/>
                <a:gd name="connsiteY2" fmla="*/ 596366 h 2372732"/>
                <a:gd name="connsiteX3" fmla="*/ 83635 w 8363529"/>
                <a:gd name="connsiteY3" fmla="*/ 614706 h 2372732"/>
                <a:gd name="connsiteX4" fmla="*/ 92029 w 8363529"/>
                <a:gd name="connsiteY4" fmla="*/ 575423 h 2372732"/>
                <a:gd name="connsiteX5" fmla="*/ 158920 w 8363529"/>
                <a:gd name="connsiteY5" fmla="*/ 303306 h 2372732"/>
                <a:gd name="connsiteX6" fmla="*/ 167273 w 8363529"/>
                <a:gd name="connsiteY6" fmla="*/ 273779 h 2372732"/>
                <a:gd name="connsiteX7" fmla="*/ 175665 w 8363529"/>
                <a:gd name="connsiteY7" fmla="*/ 341447 h 2372732"/>
                <a:gd name="connsiteX8" fmla="*/ 242549 w 8363529"/>
                <a:gd name="connsiteY8" fmla="*/ 1105593 h 2372732"/>
                <a:gd name="connsiteX9" fmla="*/ 250903 w 8363529"/>
                <a:gd name="connsiteY9" fmla="*/ 1242266 h 2372732"/>
                <a:gd name="connsiteX10" fmla="*/ 259304 w 8363529"/>
                <a:gd name="connsiteY10" fmla="*/ 1208654 h 2372732"/>
                <a:gd name="connsiteX11" fmla="*/ 326189 w 8363529"/>
                <a:gd name="connsiteY11" fmla="*/ 976382 h 2372732"/>
                <a:gd name="connsiteX12" fmla="*/ 334542 w 8363529"/>
                <a:gd name="connsiteY12" fmla="*/ 951239 h 2372732"/>
                <a:gd name="connsiteX13" fmla="*/ 342895 w 8363529"/>
                <a:gd name="connsiteY13" fmla="*/ 851739 h 2372732"/>
                <a:gd name="connsiteX14" fmla="*/ 409818 w 8363529"/>
                <a:gd name="connsiteY14" fmla="*/ 272647 h 2372732"/>
                <a:gd name="connsiteX15" fmla="*/ 418181 w 8363529"/>
                <a:gd name="connsiteY15" fmla="*/ 219418 h 2372732"/>
                <a:gd name="connsiteX16" fmla="*/ 426534 w 8363529"/>
                <a:gd name="connsiteY16" fmla="*/ 247958 h 2372732"/>
                <a:gd name="connsiteX17" fmla="*/ 493458 w 8363529"/>
                <a:gd name="connsiteY17" fmla="*/ 641543 h 2372732"/>
                <a:gd name="connsiteX18" fmla="*/ 501811 w 8363529"/>
                <a:gd name="connsiteY18" fmla="*/ 729438 h 2372732"/>
                <a:gd name="connsiteX19" fmla="*/ 510174 w 8363529"/>
                <a:gd name="connsiteY19" fmla="*/ 725015 h 2372732"/>
                <a:gd name="connsiteX20" fmla="*/ 577097 w 8363529"/>
                <a:gd name="connsiteY20" fmla="*/ 703395 h 2372732"/>
                <a:gd name="connsiteX21" fmla="*/ 585450 w 8363529"/>
                <a:gd name="connsiteY21" fmla="*/ 701691 h 2372732"/>
                <a:gd name="connsiteX22" fmla="*/ 593803 w 8363529"/>
                <a:gd name="connsiteY22" fmla="*/ 680981 h 2372732"/>
                <a:gd name="connsiteX23" fmla="*/ 660727 w 8363529"/>
                <a:gd name="connsiteY23" fmla="*/ 441673 h 2372732"/>
                <a:gd name="connsiteX24" fmla="*/ 669089 w 8363529"/>
                <a:gd name="connsiteY24" fmla="*/ 397783 h 2372732"/>
                <a:gd name="connsiteX25" fmla="*/ 677443 w 8363529"/>
                <a:gd name="connsiteY25" fmla="*/ 422917 h 2372732"/>
                <a:gd name="connsiteX26" fmla="*/ 744366 w 8363529"/>
                <a:gd name="connsiteY26" fmla="*/ 590694 h 2372732"/>
                <a:gd name="connsiteX27" fmla="*/ 752719 w 8363529"/>
                <a:gd name="connsiteY27" fmla="*/ 608279 h 2372732"/>
                <a:gd name="connsiteX28" fmla="*/ 761082 w 8363529"/>
                <a:gd name="connsiteY28" fmla="*/ 582720 h 2372732"/>
                <a:gd name="connsiteX29" fmla="*/ 828005 w 8363529"/>
                <a:gd name="connsiteY29" fmla="*/ 423149 h 2372732"/>
                <a:gd name="connsiteX30" fmla="*/ 836358 w 8363529"/>
                <a:gd name="connsiteY30" fmla="*/ 407500 h 2372732"/>
                <a:gd name="connsiteX31" fmla="*/ 844712 w 8363529"/>
                <a:gd name="connsiteY31" fmla="*/ 404848 h 2372732"/>
                <a:gd name="connsiteX32" fmla="*/ 911635 w 8363529"/>
                <a:gd name="connsiteY32" fmla="*/ 379027 h 2372732"/>
                <a:gd name="connsiteX33" fmla="*/ 919988 w 8363529"/>
                <a:gd name="connsiteY33" fmla="*/ 375059 h 2372732"/>
                <a:gd name="connsiteX34" fmla="*/ 928351 w 8363529"/>
                <a:gd name="connsiteY34" fmla="*/ 397512 h 2372732"/>
                <a:gd name="connsiteX35" fmla="*/ 995274 w 8363529"/>
                <a:gd name="connsiteY35" fmla="*/ 535356 h 2372732"/>
                <a:gd name="connsiteX36" fmla="*/ 1003627 w 8363529"/>
                <a:gd name="connsiteY36" fmla="*/ 548663 h 2372732"/>
                <a:gd name="connsiteX37" fmla="*/ 1011981 w 8363529"/>
                <a:gd name="connsiteY37" fmla="*/ 568542 h 2372732"/>
                <a:gd name="connsiteX38" fmla="*/ 1078904 w 8363529"/>
                <a:gd name="connsiteY38" fmla="*/ 759953 h 2372732"/>
                <a:gd name="connsiteX39" fmla="*/ 1087267 w 8363529"/>
                <a:gd name="connsiteY39" fmla="*/ 788832 h 2372732"/>
                <a:gd name="connsiteX40" fmla="*/ 1095620 w 8363529"/>
                <a:gd name="connsiteY40" fmla="*/ 762024 h 2372732"/>
                <a:gd name="connsiteX41" fmla="*/ 1162543 w 8363529"/>
                <a:gd name="connsiteY41" fmla="*/ 535085 h 2372732"/>
                <a:gd name="connsiteX42" fmla="*/ 1170896 w 8363529"/>
                <a:gd name="connsiteY42" fmla="*/ 505073 h 2372732"/>
                <a:gd name="connsiteX43" fmla="*/ 1179259 w 8363529"/>
                <a:gd name="connsiteY43" fmla="*/ 482504 h 2372732"/>
                <a:gd name="connsiteX44" fmla="*/ 1246182 w 8363529"/>
                <a:gd name="connsiteY44" fmla="*/ 330376 h 2372732"/>
                <a:gd name="connsiteX45" fmla="*/ 1254536 w 8363529"/>
                <a:gd name="connsiteY45" fmla="*/ 314310 h 2372732"/>
                <a:gd name="connsiteX46" fmla="*/ 1262889 w 8363529"/>
                <a:gd name="connsiteY46" fmla="*/ 351358 h 2372732"/>
                <a:gd name="connsiteX47" fmla="*/ 1329812 w 8363529"/>
                <a:gd name="connsiteY47" fmla="*/ 820208 h 2372732"/>
                <a:gd name="connsiteX48" fmla="*/ 1338175 w 8363529"/>
                <a:gd name="connsiteY48" fmla="*/ 915256 h 2372732"/>
                <a:gd name="connsiteX49" fmla="*/ 1346528 w 8363529"/>
                <a:gd name="connsiteY49" fmla="*/ 921188 h 2372732"/>
                <a:gd name="connsiteX50" fmla="*/ 1413451 w 8363529"/>
                <a:gd name="connsiteY50" fmla="*/ 952342 h 2372732"/>
                <a:gd name="connsiteX51" fmla="*/ 1421805 w 8363529"/>
                <a:gd name="connsiteY51" fmla="*/ 954945 h 2372732"/>
                <a:gd name="connsiteX52" fmla="*/ 1430158 w 8363529"/>
                <a:gd name="connsiteY52" fmla="*/ 969424 h 2372732"/>
                <a:gd name="connsiteX53" fmla="*/ 1497091 w 8363529"/>
                <a:gd name="connsiteY53" fmla="*/ 1107074 h 2372732"/>
                <a:gd name="connsiteX54" fmla="*/ 1505444 w 8363529"/>
                <a:gd name="connsiteY54" fmla="*/ 1127601 h 2372732"/>
                <a:gd name="connsiteX55" fmla="*/ 1513797 w 8363529"/>
                <a:gd name="connsiteY55" fmla="*/ 1133117 h 2372732"/>
                <a:gd name="connsiteX56" fmla="*/ 1580720 w 8363529"/>
                <a:gd name="connsiteY56" fmla="*/ 1189298 h 2372732"/>
                <a:gd name="connsiteX57" fmla="*/ 1589074 w 8363529"/>
                <a:gd name="connsiteY57" fmla="*/ 1198299 h 2372732"/>
                <a:gd name="connsiteX58" fmla="*/ 1597437 w 8363529"/>
                <a:gd name="connsiteY58" fmla="*/ 1156141 h 2372732"/>
                <a:gd name="connsiteX59" fmla="*/ 1664360 w 8363529"/>
                <a:gd name="connsiteY59" fmla="*/ 933015 h 2372732"/>
                <a:gd name="connsiteX60" fmla="*/ 1672713 w 8363529"/>
                <a:gd name="connsiteY60" fmla="*/ 914230 h 2372732"/>
                <a:gd name="connsiteX61" fmla="*/ 1681066 w 8363529"/>
                <a:gd name="connsiteY61" fmla="*/ 899529 h 2372732"/>
                <a:gd name="connsiteX62" fmla="*/ 1747989 w 8363529"/>
                <a:gd name="connsiteY62" fmla="*/ 757379 h 2372732"/>
                <a:gd name="connsiteX63" fmla="*/ 1756352 w 8363529"/>
                <a:gd name="connsiteY63" fmla="*/ 735864 h 2372732"/>
                <a:gd name="connsiteX64" fmla="*/ 1764706 w 8363529"/>
                <a:gd name="connsiteY64" fmla="*/ 733300 h 2372732"/>
                <a:gd name="connsiteX65" fmla="*/ 1831629 w 8363529"/>
                <a:gd name="connsiteY65" fmla="*/ 711447 h 2372732"/>
                <a:gd name="connsiteX66" fmla="*/ 1839982 w 8363529"/>
                <a:gd name="connsiteY66" fmla="*/ 708534 h 2372732"/>
                <a:gd name="connsiteX67" fmla="*/ 1848345 w 8363529"/>
                <a:gd name="connsiteY67" fmla="*/ 717496 h 2372732"/>
                <a:gd name="connsiteX68" fmla="*/ 1915268 w 8363529"/>
                <a:gd name="connsiteY68" fmla="*/ 788793 h 2372732"/>
                <a:gd name="connsiteX69" fmla="*/ 1923621 w 8363529"/>
                <a:gd name="connsiteY69" fmla="*/ 797639 h 2372732"/>
                <a:gd name="connsiteX70" fmla="*/ 1931975 w 8363529"/>
                <a:gd name="connsiteY70" fmla="*/ 758172 h 2372732"/>
                <a:gd name="connsiteX71" fmla="*/ 1998898 w 8363529"/>
                <a:gd name="connsiteY71" fmla="*/ 513203 h 2372732"/>
                <a:gd name="connsiteX72" fmla="*/ 2007260 w 8363529"/>
                <a:gd name="connsiteY72" fmla="*/ 489269 h 2372732"/>
                <a:gd name="connsiteX73" fmla="*/ 2015614 w 8363529"/>
                <a:gd name="connsiteY73" fmla="*/ 496905 h 2372732"/>
                <a:gd name="connsiteX74" fmla="*/ 2082537 w 8363529"/>
                <a:gd name="connsiteY74" fmla="*/ 575994 h 2372732"/>
                <a:gd name="connsiteX75" fmla="*/ 2090890 w 8363529"/>
                <a:gd name="connsiteY75" fmla="*/ 588962 h 2372732"/>
                <a:gd name="connsiteX76" fmla="*/ 2099253 w 8363529"/>
                <a:gd name="connsiteY76" fmla="*/ 531794 h 2372732"/>
                <a:gd name="connsiteX77" fmla="*/ 2166176 w 8363529"/>
                <a:gd name="connsiteY77" fmla="*/ 138705 h 2372732"/>
                <a:gd name="connsiteX78" fmla="*/ 2174530 w 8363529"/>
                <a:gd name="connsiteY78" fmla="*/ 96364 h 2372732"/>
                <a:gd name="connsiteX79" fmla="*/ 2182883 w 8363529"/>
                <a:gd name="connsiteY79" fmla="*/ 161313 h 2372732"/>
                <a:gd name="connsiteX80" fmla="*/ 2249806 w 8363529"/>
                <a:gd name="connsiteY80" fmla="*/ 781419 h 2372732"/>
                <a:gd name="connsiteX81" fmla="*/ 2258159 w 8363529"/>
                <a:gd name="connsiteY81" fmla="*/ 874231 h 2372732"/>
                <a:gd name="connsiteX82" fmla="*/ 2266522 w 8363529"/>
                <a:gd name="connsiteY82" fmla="*/ 849474 h 2372732"/>
                <a:gd name="connsiteX83" fmla="*/ 2333445 w 8363529"/>
                <a:gd name="connsiteY83" fmla="*/ 688384 h 2372732"/>
                <a:gd name="connsiteX84" fmla="*/ 2341799 w 8363529"/>
                <a:gd name="connsiteY84" fmla="*/ 671903 h 2372732"/>
                <a:gd name="connsiteX85" fmla="*/ 2350152 w 8363529"/>
                <a:gd name="connsiteY85" fmla="*/ 671564 h 2372732"/>
                <a:gd name="connsiteX86" fmla="*/ 2417075 w 8363529"/>
                <a:gd name="connsiteY86" fmla="*/ 668912 h 2372732"/>
                <a:gd name="connsiteX87" fmla="*/ 2425438 w 8363529"/>
                <a:gd name="connsiteY87" fmla="*/ 668612 h 2372732"/>
                <a:gd name="connsiteX88" fmla="*/ 2433791 w 8363529"/>
                <a:gd name="connsiteY88" fmla="*/ 659650 h 2372732"/>
                <a:gd name="connsiteX89" fmla="*/ 2500714 w 8363529"/>
                <a:gd name="connsiteY89" fmla="*/ 591866 h 2372732"/>
                <a:gd name="connsiteX90" fmla="*/ 2509068 w 8363529"/>
                <a:gd name="connsiteY90" fmla="*/ 583852 h 2372732"/>
                <a:gd name="connsiteX91" fmla="*/ 2517430 w 8363529"/>
                <a:gd name="connsiteY91" fmla="*/ 595911 h 2372732"/>
                <a:gd name="connsiteX92" fmla="*/ 2584354 w 8363529"/>
                <a:gd name="connsiteY92" fmla="*/ 708795 h 2372732"/>
                <a:gd name="connsiteX93" fmla="*/ 2592707 w 8363529"/>
                <a:gd name="connsiteY93" fmla="*/ 725354 h 2372732"/>
                <a:gd name="connsiteX94" fmla="*/ 2601060 w 8363529"/>
                <a:gd name="connsiteY94" fmla="*/ 765663 h 2372732"/>
                <a:gd name="connsiteX95" fmla="*/ 2667983 w 8363529"/>
                <a:gd name="connsiteY95" fmla="*/ 1092063 h 2372732"/>
                <a:gd name="connsiteX96" fmla="*/ 2676346 w 8363529"/>
                <a:gd name="connsiteY96" fmla="*/ 1133388 h 2372732"/>
                <a:gd name="connsiteX97" fmla="*/ 2684699 w 8363529"/>
                <a:gd name="connsiteY97" fmla="*/ 1108622 h 2372732"/>
                <a:gd name="connsiteX98" fmla="*/ 2751623 w 8363529"/>
                <a:gd name="connsiteY98" fmla="*/ 874647 h 2372732"/>
                <a:gd name="connsiteX99" fmla="*/ 2759976 w 8363529"/>
                <a:gd name="connsiteY99" fmla="*/ 839980 h 2372732"/>
                <a:gd name="connsiteX100" fmla="*/ 2768329 w 8363529"/>
                <a:gd name="connsiteY100" fmla="*/ 850568 h 2372732"/>
                <a:gd name="connsiteX101" fmla="*/ 2835262 w 8363529"/>
                <a:gd name="connsiteY101" fmla="*/ 914114 h 2372732"/>
                <a:gd name="connsiteX102" fmla="*/ 2843615 w 8363529"/>
                <a:gd name="connsiteY102" fmla="*/ 920124 h 2372732"/>
                <a:gd name="connsiteX103" fmla="*/ 2851968 w 8363529"/>
                <a:gd name="connsiteY103" fmla="*/ 879941 h 2372732"/>
                <a:gd name="connsiteX104" fmla="*/ 2918892 w 8363529"/>
                <a:gd name="connsiteY104" fmla="*/ 549495 h 2372732"/>
                <a:gd name="connsiteX105" fmla="*/ 2927245 w 8363529"/>
                <a:gd name="connsiteY105" fmla="*/ 507038 h 2372732"/>
                <a:gd name="connsiteX106" fmla="*/ 2935608 w 8363529"/>
                <a:gd name="connsiteY106" fmla="*/ 576032 h 2372732"/>
                <a:gd name="connsiteX107" fmla="*/ 3002531 w 8363529"/>
                <a:gd name="connsiteY107" fmla="*/ 1105670 h 2372732"/>
                <a:gd name="connsiteX108" fmla="*/ 3010884 w 8363529"/>
                <a:gd name="connsiteY108" fmla="*/ 1169187 h 2372732"/>
                <a:gd name="connsiteX109" fmla="*/ 3019238 w 8363529"/>
                <a:gd name="connsiteY109" fmla="*/ 1114971 h 2372732"/>
                <a:gd name="connsiteX110" fmla="*/ 3086161 w 8363529"/>
                <a:gd name="connsiteY110" fmla="*/ 566161 h 2372732"/>
                <a:gd name="connsiteX111" fmla="*/ 3094523 w 8363529"/>
                <a:gd name="connsiteY111" fmla="*/ 478759 h 2372732"/>
                <a:gd name="connsiteX112" fmla="*/ 3102877 w 8363529"/>
                <a:gd name="connsiteY112" fmla="*/ 548469 h 2372732"/>
                <a:gd name="connsiteX113" fmla="*/ 3169800 w 8363529"/>
                <a:gd name="connsiteY113" fmla="*/ 945799 h 2372732"/>
                <a:gd name="connsiteX114" fmla="*/ 3178153 w 8363529"/>
                <a:gd name="connsiteY114" fmla="*/ 981637 h 2372732"/>
                <a:gd name="connsiteX115" fmla="*/ 3186516 w 8363529"/>
                <a:gd name="connsiteY115" fmla="*/ 949196 h 2372732"/>
                <a:gd name="connsiteX116" fmla="*/ 3253439 w 8363529"/>
                <a:gd name="connsiteY116" fmla="*/ 624761 h 2372732"/>
                <a:gd name="connsiteX117" fmla="*/ 3261792 w 8363529"/>
                <a:gd name="connsiteY117" fmla="*/ 573758 h 2372732"/>
                <a:gd name="connsiteX118" fmla="*/ 3270146 w 8363529"/>
                <a:gd name="connsiteY118" fmla="*/ 572364 h 2372732"/>
                <a:gd name="connsiteX119" fmla="*/ 3337069 w 8363529"/>
                <a:gd name="connsiteY119" fmla="*/ 548886 h 2372732"/>
                <a:gd name="connsiteX120" fmla="*/ 3345432 w 8363529"/>
                <a:gd name="connsiteY120" fmla="*/ 542159 h 2372732"/>
                <a:gd name="connsiteX121" fmla="*/ 3353785 w 8363529"/>
                <a:gd name="connsiteY121" fmla="*/ 512061 h 2372732"/>
                <a:gd name="connsiteX122" fmla="*/ 3420708 w 8363529"/>
                <a:gd name="connsiteY122" fmla="*/ 423710 h 2372732"/>
                <a:gd name="connsiteX123" fmla="*/ 3429061 w 8363529"/>
                <a:gd name="connsiteY123" fmla="*/ 419220 h 2372732"/>
                <a:gd name="connsiteX124" fmla="*/ 3437424 w 8363529"/>
                <a:gd name="connsiteY124" fmla="*/ 419675 h 2372732"/>
                <a:gd name="connsiteX125" fmla="*/ 3504347 w 8363529"/>
                <a:gd name="connsiteY125" fmla="*/ 423865 h 2372732"/>
                <a:gd name="connsiteX126" fmla="*/ 3512701 w 8363529"/>
                <a:gd name="connsiteY126" fmla="*/ 424475 h 2372732"/>
                <a:gd name="connsiteX127" fmla="*/ 3521054 w 8363529"/>
                <a:gd name="connsiteY127" fmla="*/ 403677 h 2372732"/>
                <a:gd name="connsiteX128" fmla="*/ 3587977 w 8363529"/>
                <a:gd name="connsiteY128" fmla="*/ 259601 h 2372732"/>
                <a:gd name="connsiteX129" fmla="*/ 3596330 w 8363529"/>
                <a:gd name="connsiteY129" fmla="*/ 243951 h 2372732"/>
                <a:gd name="connsiteX130" fmla="*/ 3604693 w 8363529"/>
                <a:gd name="connsiteY130" fmla="*/ 259717 h 2372732"/>
                <a:gd name="connsiteX131" fmla="*/ 3671616 w 8363529"/>
                <a:gd name="connsiteY131" fmla="*/ 426362 h 2372732"/>
                <a:gd name="connsiteX132" fmla="*/ 3679970 w 8363529"/>
                <a:gd name="connsiteY132" fmla="*/ 454148 h 2372732"/>
                <a:gd name="connsiteX133" fmla="*/ 3688323 w 8363529"/>
                <a:gd name="connsiteY133" fmla="*/ 439253 h 2372732"/>
                <a:gd name="connsiteX134" fmla="*/ 3755246 w 8363529"/>
                <a:gd name="connsiteY134" fmla="*/ 334953 h 2372732"/>
                <a:gd name="connsiteX135" fmla="*/ 3763609 w 8363529"/>
                <a:gd name="connsiteY135" fmla="*/ 323495 h 2372732"/>
                <a:gd name="connsiteX136" fmla="*/ 3771962 w 8363529"/>
                <a:gd name="connsiteY136" fmla="*/ 340886 h 2372732"/>
                <a:gd name="connsiteX137" fmla="*/ 3838885 w 8363529"/>
                <a:gd name="connsiteY137" fmla="*/ 493198 h 2372732"/>
                <a:gd name="connsiteX138" fmla="*/ 3847239 w 8363529"/>
                <a:gd name="connsiteY138" fmla="*/ 514064 h 2372732"/>
                <a:gd name="connsiteX139" fmla="*/ 3855602 w 8363529"/>
                <a:gd name="connsiteY139" fmla="*/ 480269 h 2372732"/>
                <a:gd name="connsiteX140" fmla="*/ 3922525 w 8363529"/>
                <a:gd name="connsiteY140" fmla="*/ 237380 h 2372732"/>
                <a:gd name="connsiteX141" fmla="*/ 3930878 w 8363529"/>
                <a:gd name="connsiteY141" fmla="*/ 210078 h 2372732"/>
                <a:gd name="connsiteX142" fmla="*/ 3939231 w 8363529"/>
                <a:gd name="connsiteY142" fmla="*/ 206720 h 2372732"/>
                <a:gd name="connsiteX143" fmla="*/ 4006154 w 8363529"/>
                <a:gd name="connsiteY143" fmla="*/ 182970 h 2372732"/>
                <a:gd name="connsiteX144" fmla="*/ 4014517 w 8363529"/>
                <a:gd name="connsiteY144" fmla="*/ 180367 h 2372732"/>
                <a:gd name="connsiteX145" fmla="*/ 4022871 w 8363529"/>
                <a:gd name="connsiteY145" fmla="*/ 223656 h 2372732"/>
                <a:gd name="connsiteX146" fmla="*/ 4089755 w 8363529"/>
                <a:gd name="connsiteY146" fmla="*/ 745059 h 2372732"/>
                <a:gd name="connsiteX147" fmla="*/ 4098147 w 8363529"/>
                <a:gd name="connsiteY147" fmla="*/ 845158 h 2372732"/>
                <a:gd name="connsiteX148" fmla="*/ 4106500 w 8363529"/>
                <a:gd name="connsiteY148" fmla="*/ 813666 h 2372732"/>
                <a:gd name="connsiteX149" fmla="*/ 4173394 w 8363529"/>
                <a:gd name="connsiteY149" fmla="*/ 652585 h 2372732"/>
                <a:gd name="connsiteX150" fmla="*/ 4181787 w 8363529"/>
                <a:gd name="connsiteY150" fmla="*/ 639433 h 2372732"/>
                <a:gd name="connsiteX151" fmla="*/ 4190140 w 8363529"/>
                <a:gd name="connsiteY151" fmla="*/ 674283 h 2372732"/>
                <a:gd name="connsiteX152" fmla="*/ 4257024 w 8363529"/>
                <a:gd name="connsiteY152" fmla="*/ 1022130 h 2372732"/>
                <a:gd name="connsiteX153" fmla="*/ 4265416 w 8363529"/>
                <a:gd name="connsiteY153" fmla="*/ 1076675 h 2372732"/>
                <a:gd name="connsiteX154" fmla="*/ 4273779 w 8363529"/>
                <a:gd name="connsiteY154" fmla="*/ 1036415 h 2372732"/>
                <a:gd name="connsiteX155" fmla="*/ 4340664 w 8363529"/>
                <a:gd name="connsiteY155" fmla="*/ 738932 h 2372732"/>
                <a:gd name="connsiteX156" fmla="*/ 4349055 w 8363529"/>
                <a:gd name="connsiteY156" fmla="*/ 704566 h 2372732"/>
                <a:gd name="connsiteX157" fmla="*/ 4357409 w 8363529"/>
                <a:gd name="connsiteY157" fmla="*/ 671448 h 2372732"/>
                <a:gd name="connsiteX158" fmla="*/ 4424303 w 8363529"/>
                <a:gd name="connsiteY158" fmla="*/ 408632 h 2372732"/>
                <a:gd name="connsiteX159" fmla="*/ 4432695 w 8363529"/>
                <a:gd name="connsiteY159" fmla="*/ 376046 h 2372732"/>
                <a:gd name="connsiteX160" fmla="*/ 4441048 w 8363529"/>
                <a:gd name="connsiteY160" fmla="*/ 362662 h 2372732"/>
                <a:gd name="connsiteX161" fmla="*/ 4507932 w 8363529"/>
                <a:gd name="connsiteY161" fmla="*/ 249506 h 2372732"/>
                <a:gd name="connsiteX162" fmla="*/ 4516324 w 8363529"/>
                <a:gd name="connsiteY162" fmla="*/ 234544 h 2372732"/>
                <a:gd name="connsiteX163" fmla="*/ 4524687 w 8363529"/>
                <a:gd name="connsiteY163" fmla="*/ 275782 h 2372732"/>
                <a:gd name="connsiteX164" fmla="*/ 4591572 w 8363529"/>
                <a:gd name="connsiteY164" fmla="*/ 643207 h 2372732"/>
                <a:gd name="connsiteX165" fmla="*/ 4599964 w 8363529"/>
                <a:gd name="connsiteY165" fmla="*/ 694433 h 2372732"/>
                <a:gd name="connsiteX166" fmla="*/ 4608317 w 8363529"/>
                <a:gd name="connsiteY166" fmla="*/ 676364 h 2372732"/>
                <a:gd name="connsiteX167" fmla="*/ 4675201 w 8363529"/>
                <a:gd name="connsiteY167" fmla="*/ 534785 h 2372732"/>
                <a:gd name="connsiteX168" fmla="*/ 4683603 w 8363529"/>
                <a:gd name="connsiteY168" fmla="*/ 517471 h 2372732"/>
                <a:gd name="connsiteX169" fmla="*/ 4691956 w 8363529"/>
                <a:gd name="connsiteY169" fmla="*/ 535462 h 2372732"/>
                <a:gd name="connsiteX170" fmla="*/ 4758840 w 8363529"/>
                <a:gd name="connsiteY170" fmla="*/ 663928 h 2372732"/>
                <a:gd name="connsiteX171" fmla="*/ 4767232 w 8363529"/>
                <a:gd name="connsiteY171" fmla="*/ 678290 h 2372732"/>
                <a:gd name="connsiteX172" fmla="*/ 4775595 w 8363529"/>
                <a:gd name="connsiteY172" fmla="*/ 720070 h 2372732"/>
                <a:gd name="connsiteX173" fmla="*/ 4842480 w 8363529"/>
                <a:gd name="connsiteY173" fmla="*/ 1157312 h 2372732"/>
                <a:gd name="connsiteX174" fmla="*/ 4850872 w 8363529"/>
                <a:gd name="connsiteY174" fmla="*/ 1229403 h 2372732"/>
                <a:gd name="connsiteX175" fmla="*/ 4859225 w 8363529"/>
                <a:gd name="connsiteY175" fmla="*/ 1191563 h 2372732"/>
                <a:gd name="connsiteX176" fmla="*/ 4926109 w 8363529"/>
                <a:gd name="connsiteY176" fmla="*/ 993580 h 2372732"/>
                <a:gd name="connsiteX177" fmla="*/ 4934501 w 8363529"/>
                <a:gd name="connsiteY177" fmla="*/ 977098 h 2372732"/>
                <a:gd name="connsiteX178" fmla="*/ 4942864 w 8363529"/>
                <a:gd name="connsiteY178" fmla="*/ 969123 h 2372732"/>
                <a:gd name="connsiteX179" fmla="*/ 5009749 w 8363529"/>
                <a:gd name="connsiteY179" fmla="*/ 897139 h 2372732"/>
                <a:gd name="connsiteX180" fmla="*/ 5018141 w 8363529"/>
                <a:gd name="connsiteY180" fmla="*/ 886977 h 2372732"/>
                <a:gd name="connsiteX181" fmla="*/ 5026494 w 8363529"/>
                <a:gd name="connsiteY181" fmla="*/ 895290 h 2372732"/>
                <a:gd name="connsiteX182" fmla="*/ 5093388 w 8363529"/>
                <a:gd name="connsiteY182" fmla="*/ 974185 h 2372732"/>
                <a:gd name="connsiteX183" fmla="*/ 5101780 w 8363529"/>
                <a:gd name="connsiteY183" fmla="*/ 985944 h 2372732"/>
                <a:gd name="connsiteX184" fmla="*/ 5110134 w 8363529"/>
                <a:gd name="connsiteY184" fmla="*/ 931282 h 2372732"/>
                <a:gd name="connsiteX185" fmla="*/ 5177018 w 8363529"/>
                <a:gd name="connsiteY185" fmla="*/ 615122 h 2372732"/>
                <a:gd name="connsiteX186" fmla="*/ 5185410 w 8363529"/>
                <a:gd name="connsiteY186" fmla="*/ 586233 h 2372732"/>
                <a:gd name="connsiteX187" fmla="*/ 5193773 w 8363529"/>
                <a:gd name="connsiteY187" fmla="*/ 532249 h 2372732"/>
                <a:gd name="connsiteX188" fmla="*/ 5260657 w 8363529"/>
                <a:gd name="connsiteY188" fmla="*/ 63663 h 2372732"/>
                <a:gd name="connsiteX189" fmla="*/ 5269049 w 8363529"/>
                <a:gd name="connsiteY189" fmla="*/ 0 h 2372732"/>
                <a:gd name="connsiteX190" fmla="*/ 5277403 w 8363529"/>
                <a:gd name="connsiteY190" fmla="*/ 88085 h 2372732"/>
                <a:gd name="connsiteX191" fmla="*/ 5344287 w 8363529"/>
                <a:gd name="connsiteY191" fmla="*/ 903226 h 2372732"/>
                <a:gd name="connsiteX192" fmla="*/ 5352650 w 8363529"/>
                <a:gd name="connsiteY192" fmla="*/ 1021327 h 2372732"/>
                <a:gd name="connsiteX193" fmla="*/ 5361042 w 8363529"/>
                <a:gd name="connsiteY193" fmla="*/ 999938 h 2372732"/>
                <a:gd name="connsiteX194" fmla="*/ 5427926 w 8363529"/>
                <a:gd name="connsiteY194" fmla="*/ 577242 h 2372732"/>
                <a:gd name="connsiteX195" fmla="*/ 5436280 w 8363529"/>
                <a:gd name="connsiteY195" fmla="*/ 431656 h 2372732"/>
                <a:gd name="connsiteX196" fmla="*/ 5444672 w 8363529"/>
                <a:gd name="connsiteY196" fmla="*/ 647369 h 2372732"/>
                <a:gd name="connsiteX197" fmla="*/ 5511566 w 8363529"/>
                <a:gd name="connsiteY197" fmla="*/ 1358924 h 2372732"/>
                <a:gd name="connsiteX198" fmla="*/ 5519919 w 8363529"/>
                <a:gd name="connsiteY198" fmla="*/ 1398807 h 2372732"/>
                <a:gd name="connsiteX199" fmla="*/ 5528311 w 8363529"/>
                <a:gd name="connsiteY199" fmla="*/ 1284907 h 2372732"/>
                <a:gd name="connsiteX200" fmla="*/ 5595195 w 8363529"/>
                <a:gd name="connsiteY200" fmla="*/ 654134 h 2372732"/>
                <a:gd name="connsiteX201" fmla="*/ 5603558 w 8363529"/>
                <a:gd name="connsiteY201" fmla="*/ 598718 h 2372732"/>
                <a:gd name="connsiteX202" fmla="*/ 5611950 w 8363529"/>
                <a:gd name="connsiteY202" fmla="*/ 570816 h 2372732"/>
                <a:gd name="connsiteX203" fmla="*/ 5678835 w 8363529"/>
                <a:gd name="connsiteY203" fmla="*/ 348483 h 2372732"/>
                <a:gd name="connsiteX204" fmla="*/ 5687188 w 8363529"/>
                <a:gd name="connsiteY204" fmla="*/ 320814 h 2372732"/>
                <a:gd name="connsiteX205" fmla="*/ 5695580 w 8363529"/>
                <a:gd name="connsiteY205" fmla="*/ 414720 h 2372732"/>
                <a:gd name="connsiteX206" fmla="*/ 5762474 w 8363529"/>
                <a:gd name="connsiteY206" fmla="*/ 1480809 h 2372732"/>
                <a:gd name="connsiteX207" fmla="*/ 5770827 w 8363529"/>
                <a:gd name="connsiteY207" fmla="*/ 1672665 h 2372732"/>
                <a:gd name="connsiteX208" fmla="*/ 5779219 w 8363529"/>
                <a:gd name="connsiteY208" fmla="*/ 1511430 h 2372732"/>
                <a:gd name="connsiteX209" fmla="*/ 5846103 w 8363529"/>
                <a:gd name="connsiteY209" fmla="*/ 570584 h 2372732"/>
                <a:gd name="connsiteX210" fmla="*/ 5854457 w 8363529"/>
                <a:gd name="connsiteY210" fmla="*/ 483898 h 2372732"/>
                <a:gd name="connsiteX211" fmla="*/ 5862858 w 8363529"/>
                <a:gd name="connsiteY211" fmla="*/ 553647 h 2372732"/>
                <a:gd name="connsiteX212" fmla="*/ 5929743 w 8363529"/>
                <a:gd name="connsiteY212" fmla="*/ 1463234 h 2372732"/>
                <a:gd name="connsiteX213" fmla="*/ 5938096 w 8363529"/>
                <a:gd name="connsiteY213" fmla="*/ 1653997 h 2372732"/>
                <a:gd name="connsiteX214" fmla="*/ 5946488 w 8363529"/>
                <a:gd name="connsiteY214" fmla="*/ 1504094 h 2372732"/>
                <a:gd name="connsiteX215" fmla="*/ 6013372 w 8363529"/>
                <a:gd name="connsiteY215" fmla="*/ 748339 h 2372732"/>
                <a:gd name="connsiteX216" fmla="*/ 6021735 w 8363529"/>
                <a:gd name="connsiteY216" fmla="*/ 687407 h 2372732"/>
                <a:gd name="connsiteX217" fmla="*/ 6030127 w 8363529"/>
                <a:gd name="connsiteY217" fmla="*/ 663550 h 2372732"/>
                <a:gd name="connsiteX218" fmla="*/ 6097011 w 8363529"/>
                <a:gd name="connsiteY218" fmla="*/ 447305 h 2372732"/>
                <a:gd name="connsiteX219" fmla="*/ 6105365 w 8363529"/>
                <a:gd name="connsiteY219" fmla="*/ 416568 h 2372732"/>
                <a:gd name="connsiteX220" fmla="*/ 6113767 w 8363529"/>
                <a:gd name="connsiteY220" fmla="*/ 462355 h 2372732"/>
                <a:gd name="connsiteX221" fmla="*/ 6180651 w 8363529"/>
                <a:gd name="connsiteY221" fmla="*/ 778099 h 2372732"/>
                <a:gd name="connsiteX222" fmla="*/ 6189004 w 8363529"/>
                <a:gd name="connsiteY222" fmla="*/ 812233 h 2372732"/>
                <a:gd name="connsiteX223" fmla="*/ 6197396 w 8363529"/>
                <a:gd name="connsiteY223" fmla="*/ 803920 h 2372732"/>
                <a:gd name="connsiteX224" fmla="*/ 6264280 w 8363529"/>
                <a:gd name="connsiteY224" fmla="*/ 719276 h 2372732"/>
                <a:gd name="connsiteX225" fmla="*/ 6272644 w 8363529"/>
                <a:gd name="connsiteY225" fmla="*/ 705698 h 2372732"/>
                <a:gd name="connsiteX226" fmla="*/ 6281036 w 8363529"/>
                <a:gd name="connsiteY226" fmla="*/ 737645 h 2372732"/>
                <a:gd name="connsiteX227" fmla="*/ 6347920 w 8363529"/>
                <a:gd name="connsiteY227" fmla="*/ 954723 h 2372732"/>
                <a:gd name="connsiteX228" fmla="*/ 6356273 w 8363529"/>
                <a:gd name="connsiteY228" fmla="*/ 977814 h 2372732"/>
                <a:gd name="connsiteX229" fmla="*/ 6364665 w 8363529"/>
                <a:gd name="connsiteY229" fmla="*/ 968175 h 2372732"/>
                <a:gd name="connsiteX230" fmla="*/ 6431560 w 8363529"/>
                <a:gd name="connsiteY230" fmla="*/ 897448 h 2372732"/>
                <a:gd name="connsiteX231" fmla="*/ 6439913 w 8363529"/>
                <a:gd name="connsiteY231" fmla="*/ 889357 h 2372732"/>
                <a:gd name="connsiteX232" fmla="*/ 6448305 w 8363529"/>
                <a:gd name="connsiteY232" fmla="*/ 860362 h 2372732"/>
                <a:gd name="connsiteX233" fmla="*/ 6515189 w 8363529"/>
                <a:gd name="connsiteY233" fmla="*/ 599811 h 2372732"/>
                <a:gd name="connsiteX234" fmla="*/ 6523542 w 8363529"/>
                <a:gd name="connsiteY234" fmla="*/ 563141 h 2372732"/>
                <a:gd name="connsiteX235" fmla="*/ 6531944 w 8363529"/>
                <a:gd name="connsiteY235" fmla="*/ 660676 h 2372732"/>
                <a:gd name="connsiteX236" fmla="*/ 6598829 w 8363529"/>
                <a:gd name="connsiteY236" fmla="*/ 1532644 h 2372732"/>
                <a:gd name="connsiteX237" fmla="*/ 6607182 w 8363529"/>
                <a:gd name="connsiteY237" fmla="*/ 1654597 h 2372732"/>
                <a:gd name="connsiteX238" fmla="*/ 6615535 w 8363529"/>
                <a:gd name="connsiteY238" fmla="*/ 1504017 h 2372732"/>
                <a:gd name="connsiteX239" fmla="*/ 6682458 w 8363529"/>
                <a:gd name="connsiteY239" fmla="*/ 664189 h 2372732"/>
                <a:gd name="connsiteX240" fmla="*/ 6690821 w 8363529"/>
                <a:gd name="connsiteY240" fmla="*/ 589940 h 2372732"/>
                <a:gd name="connsiteX241" fmla="*/ 6699174 w 8363529"/>
                <a:gd name="connsiteY241" fmla="*/ 640710 h 2372732"/>
                <a:gd name="connsiteX242" fmla="*/ 6766097 w 8363529"/>
                <a:gd name="connsiteY242" fmla="*/ 1149260 h 2372732"/>
                <a:gd name="connsiteX243" fmla="*/ 6774451 w 8363529"/>
                <a:gd name="connsiteY243" fmla="*/ 1229336 h 2372732"/>
                <a:gd name="connsiteX244" fmla="*/ 6782814 w 8363529"/>
                <a:gd name="connsiteY244" fmla="*/ 1236023 h 2372732"/>
                <a:gd name="connsiteX245" fmla="*/ 6849737 w 8363529"/>
                <a:gd name="connsiteY245" fmla="*/ 1298137 h 2372732"/>
                <a:gd name="connsiteX246" fmla="*/ 6858090 w 8363529"/>
                <a:gd name="connsiteY246" fmla="*/ 1307215 h 2372732"/>
                <a:gd name="connsiteX247" fmla="*/ 6866443 w 8363529"/>
                <a:gd name="connsiteY247" fmla="*/ 1146163 h 2372732"/>
                <a:gd name="connsiteX248" fmla="*/ 6933366 w 8363529"/>
                <a:gd name="connsiteY248" fmla="*/ 278318 h 2372732"/>
                <a:gd name="connsiteX249" fmla="*/ 6941729 w 8363529"/>
                <a:gd name="connsiteY249" fmla="*/ 204030 h 2372732"/>
                <a:gd name="connsiteX250" fmla="*/ 6950083 w 8363529"/>
                <a:gd name="connsiteY250" fmla="*/ 197874 h 2372732"/>
                <a:gd name="connsiteX251" fmla="*/ 7017006 w 8363529"/>
                <a:gd name="connsiteY251" fmla="*/ 137987 h 2372732"/>
                <a:gd name="connsiteX252" fmla="*/ 7025359 w 8363529"/>
                <a:gd name="connsiteY252" fmla="*/ 128838 h 2372732"/>
                <a:gd name="connsiteX253" fmla="*/ 7033712 w 8363529"/>
                <a:gd name="connsiteY253" fmla="*/ 180667 h 2372732"/>
                <a:gd name="connsiteX254" fmla="*/ 7100645 w 8363529"/>
                <a:gd name="connsiteY254" fmla="*/ 623967 h 2372732"/>
                <a:gd name="connsiteX255" fmla="*/ 7108998 w 8363529"/>
                <a:gd name="connsiteY255" fmla="*/ 683245 h 2372732"/>
                <a:gd name="connsiteX256" fmla="*/ 7117351 w 8363529"/>
                <a:gd name="connsiteY256" fmla="*/ 663889 h 2372732"/>
                <a:gd name="connsiteX257" fmla="*/ 7184274 w 8363529"/>
                <a:gd name="connsiteY257" fmla="*/ 502838 h 2372732"/>
                <a:gd name="connsiteX258" fmla="*/ 7192628 w 8363529"/>
                <a:gd name="connsiteY258" fmla="*/ 481895 h 2372732"/>
                <a:gd name="connsiteX259" fmla="*/ 7200991 w 8363529"/>
                <a:gd name="connsiteY259" fmla="*/ 509003 h 2372732"/>
                <a:gd name="connsiteX260" fmla="*/ 7267914 w 8363529"/>
                <a:gd name="connsiteY260" fmla="*/ 709366 h 2372732"/>
                <a:gd name="connsiteX261" fmla="*/ 7276267 w 8363529"/>
                <a:gd name="connsiteY261" fmla="*/ 732545 h 2372732"/>
                <a:gd name="connsiteX262" fmla="*/ 7284620 w 8363529"/>
                <a:gd name="connsiteY262" fmla="*/ 729061 h 2372732"/>
                <a:gd name="connsiteX263" fmla="*/ 7351543 w 8363529"/>
                <a:gd name="connsiteY263" fmla="*/ 699688 h 2372732"/>
                <a:gd name="connsiteX264" fmla="*/ 7359906 w 8363529"/>
                <a:gd name="connsiteY264" fmla="*/ 695797 h 2372732"/>
                <a:gd name="connsiteX265" fmla="*/ 7368260 w 8363529"/>
                <a:gd name="connsiteY265" fmla="*/ 666464 h 2372732"/>
                <a:gd name="connsiteX266" fmla="*/ 7435183 w 8363529"/>
                <a:gd name="connsiteY266" fmla="*/ 470668 h 2372732"/>
                <a:gd name="connsiteX267" fmla="*/ 7443536 w 8363529"/>
                <a:gd name="connsiteY267" fmla="*/ 450180 h 2372732"/>
                <a:gd name="connsiteX268" fmla="*/ 7451899 w 8363529"/>
                <a:gd name="connsiteY268" fmla="*/ 462461 h 2372732"/>
                <a:gd name="connsiteX269" fmla="*/ 7518822 w 8363529"/>
                <a:gd name="connsiteY269" fmla="*/ 580755 h 2372732"/>
                <a:gd name="connsiteX270" fmla="*/ 7527175 w 8363529"/>
                <a:gd name="connsiteY270" fmla="*/ 598601 h 2372732"/>
                <a:gd name="connsiteX271" fmla="*/ 7535528 w 8363529"/>
                <a:gd name="connsiteY271" fmla="*/ 607070 h 2372732"/>
                <a:gd name="connsiteX272" fmla="*/ 7602452 w 8363529"/>
                <a:gd name="connsiteY272" fmla="*/ 664005 h 2372732"/>
                <a:gd name="connsiteX273" fmla="*/ 7610815 w 8363529"/>
                <a:gd name="connsiteY273" fmla="*/ 669977 h 2372732"/>
                <a:gd name="connsiteX274" fmla="*/ 7619168 w 8363529"/>
                <a:gd name="connsiteY274" fmla="*/ 677874 h 2372732"/>
                <a:gd name="connsiteX275" fmla="*/ 7686091 w 8363529"/>
                <a:gd name="connsiteY275" fmla="*/ 746491 h 2372732"/>
                <a:gd name="connsiteX276" fmla="*/ 7694444 w 8363529"/>
                <a:gd name="connsiteY276" fmla="*/ 755830 h 2372732"/>
                <a:gd name="connsiteX277" fmla="*/ 7702798 w 8363529"/>
                <a:gd name="connsiteY277" fmla="*/ 748949 h 2372732"/>
                <a:gd name="connsiteX278" fmla="*/ 7769731 w 8363529"/>
                <a:gd name="connsiteY278" fmla="*/ 681164 h 2372732"/>
                <a:gd name="connsiteX279" fmla="*/ 7778084 w 8363529"/>
                <a:gd name="connsiteY279" fmla="*/ 670693 h 2372732"/>
                <a:gd name="connsiteX280" fmla="*/ 7786437 w 8363529"/>
                <a:gd name="connsiteY280" fmla="*/ 650204 h 2372732"/>
                <a:gd name="connsiteX281" fmla="*/ 7853360 w 8363529"/>
                <a:gd name="connsiteY281" fmla="*/ 550173 h 2372732"/>
                <a:gd name="connsiteX282" fmla="*/ 7861713 w 8363529"/>
                <a:gd name="connsiteY282" fmla="*/ 542343 h 2372732"/>
                <a:gd name="connsiteX283" fmla="*/ 7870077 w 8363529"/>
                <a:gd name="connsiteY283" fmla="*/ 550473 h 2372732"/>
                <a:gd name="connsiteX284" fmla="*/ 7937000 w 8363529"/>
                <a:gd name="connsiteY284" fmla="*/ 641852 h 2372732"/>
                <a:gd name="connsiteX285" fmla="*/ 7945353 w 8363529"/>
                <a:gd name="connsiteY285" fmla="*/ 658063 h 2372732"/>
                <a:gd name="connsiteX286" fmla="*/ 7953706 w 8363529"/>
                <a:gd name="connsiteY286" fmla="*/ 680071 h 2372732"/>
                <a:gd name="connsiteX287" fmla="*/ 8020629 w 8363529"/>
                <a:gd name="connsiteY287" fmla="*/ 847926 h 2372732"/>
                <a:gd name="connsiteX288" fmla="*/ 8028992 w 8363529"/>
                <a:gd name="connsiteY288" fmla="*/ 867921 h 2372732"/>
                <a:gd name="connsiteX289" fmla="*/ 8037346 w 8363529"/>
                <a:gd name="connsiteY289" fmla="*/ 857294 h 2372732"/>
                <a:gd name="connsiteX290" fmla="*/ 8104268 w 8363529"/>
                <a:gd name="connsiteY290" fmla="*/ 759605 h 2372732"/>
                <a:gd name="connsiteX291" fmla="*/ 8112622 w 8363529"/>
                <a:gd name="connsiteY291" fmla="*/ 745620 h 2372732"/>
                <a:gd name="connsiteX292" fmla="*/ 8120985 w 8363529"/>
                <a:gd name="connsiteY292" fmla="*/ 701391 h 2372732"/>
                <a:gd name="connsiteX293" fmla="*/ 8187908 w 8363529"/>
                <a:gd name="connsiteY293" fmla="*/ 467416 h 2372732"/>
                <a:gd name="connsiteX294" fmla="*/ 8196261 w 8363529"/>
                <a:gd name="connsiteY294" fmla="*/ 447721 h 2372732"/>
                <a:gd name="connsiteX295" fmla="*/ 8204614 w 8363529"/>
                <a:gd name="connsiteY295" fmla="*/ 449154 h 2372732"/>
                <a:gd name="connsiteX296" fmla="*/ 8271537 w 8363529"/>
                <a:gd name="connsiteY296" fmla="*/ 464242 h 2372732"/>
                <a:gd name="connsiteX297" fmla="*/ 8279900 w 8363529"/>
                <a:gd name="connsiteY297" fmla="*/ 466700 h 2372732"/>
                <a:gd name="connsiteX298" fmla="*/ 8288254 w 8363529"/>
                <a:gd name="connsiteY298" fmla="*/ 504764 h 2372732"/>
                <a:gd name="connsiteX299" fmla="*/ 8355177 w 8363529"/>
                <a:gd name="connsiteY299" fmla="*/ 812156 h 2372732"/>
                <a:gd name="connsiteX300" fmla="*/ 8363530 w 8363529"/>
                <a:gd name="connsiteY300" fmla="*/ 850984 h 2372732"/>
                <a:gd name="connsiteX301" fmla="*/ 8363530 w 8363529"/>
                <a:gd name="connsiteY301" fmla="*/ 1916890 h 2372732"/>
                <a:gd name="connsiteX302" fmla="*/ 8355177 w 8363529"/>
                <a:gd name="connsiteY302" fmla="*/ 1853489 h 2372732"/>
                <a:gd name="connsiteX303" fmla="*/ 8288254 w 8363529"/>
                <a:gd name="connsiteY303" fmla="*/ 1351327 h 2372732"/>
                <a:gd name="connsiteX304" fmla="*/ 8279900 w 8363529"/>
                <a:gd name="connsiteY304" fmla="*/ 1289214 h 2372732"/>
                <a:gd name="connsiteX305" fmla="*/ 8271537 w 8363529"/>
                <a:gd name="connsiteY305" fmla="*/ 1428296 h 2372732"/>
                <a:gd name="connsiteX306" fmla="*/ 8204614 w 8363529"/>
                <a:gd name="connsiteY306" fmla="*/ 2275914 h 2372732"/>
                <a:gd name="connsiteX307" fmla="*/ 8196261 w 8363529"/>
                <a:gd name="connsiteY307" fmla="*/ 2357277 h 2372732"/>
                <a:gd name="connsiteX308" fmla="*/ 8187908 w 8363529"/>
                <a:gd name="connsiteY308" fmla="*/ 2304610 h 2372732"/>
                <a:gd name="connsiteX309" fmla="*/ 8120985 w 8363529"/>
                <a:gd name="connsiteY309" fmla="*/ 1679285 h 2372732"/>
                <a:gd name="connsiteX310" fmla="*/ 8112622 w 8363529"/>
                <a:gd name="connsiteY310" fmla="*/ 1561107 h 2372732"/>
                <a:gd name="connsiteX311" fmla="*/ 8104268 w 8363529"/>
                <a:gd name="connsiteY311" fmla="*/ 1603942 h 2372732"/>
                <a:gd name="connsiteX312" fmla="*/ 8037346 w 8363529"/>
                <a:gd name="connsiteY312" fmla="*/ 1902179 h 2372732"/>
                <a:gd name="connsiteX313" fmla="*/ 8028992 w 8363529"/>
                <a:gd name="connsiteY313" fmla="*/ 1934688 h 2372732"/>
                <a:gd name="connsiteX314" fmla="*/ 8020629 w 8363529"/>
                <a:gd name="connsiteY314" fmla="*/ 1933332 h 2372732"/>
                <a:gd name="connsiteX315" fmla="*/ 7953706 w 8363529"/>
                <a:gd name="connsiteY315" fmla="*/ 1921796 h 2372732"/>
                <a:gd name="connsiteX316" fmla="*/ 7945353 w 8363529"/>
                <a:gd name="connsiteY316" fmla="*/ 1920287 h 2372732"/>
                <a:gd name="connsiteX317" fmla="*/ 7937000 w 8363529"/>
                <a:gd name="connsiteY317" fmla="*/ 1928455 h 2372732"/>
                <a:gd name="connsiteX318" fmla="*/ 7870077 w 8363529"/>
                <a:gd name="connsiteY318" fmla="*/ 1974648 h 2372732"/>
                <a:gd name="connsiteX319" fmla="*/ 7861713 w 8363529"/>
                <a:gd name="connsiteY319" fmla="*/ 1978771 h 2372732"/>
                <a:gd name="connsiteX320" fmla="*/ 7853360 w 8363529"/>
                <a:gd name="connsiteY320" fmla="*/ 1942294 h 2372732"/>
                <a:gd name="connsiteX321" fmla="*/ 7786437 w 8363529"/>
                <a:gd name="connsiteY321" fmla="*/ 1476879 h 2372732"/>
                <a:gd name="connsiteX322" fmla="*/ 7778084 w 8363529"/>
                <a:gd name="connsiteY322" fmla="*/ 1381648 h 2372732"/>
                <a:gd name="connsiteX323" fmla="*/ 7769731 w 8363529"/>
                <a:gd name="connsiteY323" fmla="*/ 1459750 h 2372732"/>
                <a:gd name="connsiteX324" fmla="*/ 7702798 w 8363529"/>
                <a:gd name="connsiteY324" fmla="*/ 1964108 h 2372732"/>
                <a:gd name="connsiteX325" fmla="*/ 7694444 w 8363529"/>
                <a:gd name="connsiteY325" fmla="*/ 2015257 h 2372732"/>
                <a:gd name="connsiteX326" fmla="*/ 7686091 w 8363529"/>
                <a:gd name="connsiteY326" fmla="*/ 1907173 h 2372732"/>
                <a:gd name="connsiteX327" fmla="*/ 7619168 w 8363529"/>
                <a:gd name="connsiteY327" fmla="*/ 1110926 h 2372732"/>
                <a:gd name="connsiteX328" fmla="*/ 7610815 w 8363529"/>
                <a:gd name="connsiteY328" fmla="*/ 1019217 h 2372732"/>
                <a:gd name="connsiteX329" fmla="*/ 7602452 w 8363529"/>
                <a:gd name="connsiteY329" fmla="*/ 1092673 h 2372732"/>
                <a:gd name="connsiteX330" fmla="*/ 7535528 w 8363529"/>
                <a:gd name="connsiteY330" fmla="*/ 1791598 h 2372732"/>
                <a:gd name="connsiteX331" fmla="*/ 7527175 w 8363529"/>
                <a:gd name="connsiteY331" fmla="*/ 1895830 h 2372732"/>
                <a:gd name="connsiteX332" fmla="*/ 7518822 w 8363529"/>
                <a:gd name="connsiteY332" fmla="*/ 1856741 h 2372732"/>
                <a:gd name="connsiteX333" fmla="*/ 7451899 w 8363529"/>
                <a:gd name="connsiteY333" fmla="*/ 1597622 h 2372732"/>
                <a:gd name="connsiteX334" fmla="*/ 7443536 w 8363529"/>
                <a:gd name="connsiteY334" fmla="*/ 1570708 h 2372732"/>
                <a:gd name="connsiteX335" fmla="*/ 7435183 w 8363529"/>
                <a:gd name="connsiteY335" fmla="*/ 1574182 h 2372732"/>
                <a:gd name="connsiteX336" fmla="*/ 7368260 w 8363529"/>
                <a:gd name="connsiteY336" fmla="*/ 1607455 h 2372732"/>
                <a:gd name="connsiteX337" fmla="*/ 7359906 w 8363529"/>
                <a:gd name="connsiteY337" fmla="*/ 1612410 h 2372732"/>
                <a:gd name="connsiteX338" fmla="*/ 7351543 w 8363529"/>
                <a:gd name="connsiteY338" fmla="*/ 1607871 h 2372732"/>
                <a:gd name="connsiteX339" fmla="*/ 7284620 w 8363529"/>
                <a:gd name="connsiteY339" fmla="*/ 1573543 h 2372732"/>
                <a:gd name="connsiteX340" fmla="*/ 7276267 w 8363529"/>
                <a:gd name="connsiteY340" fmla="*/ 1569498 h 2372732"/>
                <a:gd name="connsiteX341" fmla="*/ 7267914 w 8363529"/>
                <a:gd name="connsiteY341" fmla="*/ 1536002 h 2372732"/>
                <a:gd name="connsiteX342" fmla="*/ 7200991 w 8363529"/>
                <a:gd name="connsiteY342" fmla="*/ 1246611 h 2372732"/>
                <a:gd name="connsiteX343" fmla="*/ 7192628 w 8363529"/>
                <a:gd name="connsiteY343" fmla="*/ 1207483 h 2372732"/>
                <a:gd name="connsiteX344" fmla="*/ 7184274 w 8363529"/>
                <a:gd name="connsiteY344" fmla="*/ 1168500 h 2372732"/>
                <a:gd name="connsiteX345" fmla="*/ 7117351 w 8363529"/>
                <a:gd name="connsiteY345" fmla="*/ 868830 h 2372732"/>
                <a:gd name="connsiteX346" fmla="*/ 7108998 w 8363529"/>
                <a:gd name="connsiteY346" fmla="*/ 832838 h 2372732"/>
                <a:gd name="connsiteX347" fmla="*/ 7100645 w 8363529"/>
                <a:gd name="connsiteY347" fmla="*/ 807617 h 2372732"/>
                <a:gd name="connsiteX348" fmla="*/ 7033712 w 8363529"/>
                <a:gd name="connsiteY348" fmla="*/ 619167 h 2372732"/>
                <a:gd name="connsiteX349" fmla="*/ 7025359 w 8363529"/>
                <a:gd name="connsiteY349" fmla="*/ 597121 h 2372732"/>
                <a:gd name="connsiteX350" fmla="*/ 7017006 w 8363529"/>
                <a:gd name="connsiteY350" fmla="*/ 721957 h 2372732"/>
                <a:gd name="connsiteX351" fmla="*/ 6950083 w 8363529"/>
                <a:gd name="connsiteY351" fmla="*/ 1538499 h 2372732"/>
                <a:gd name="connsiteX352" fmla="*/ 6941729 w 8363529"/>
                <a:gd name="connsiteY352" fmla="*/ 1622311 h 2372732"/>
                <a:gd name="connsiteX353" fmla="*/ 6933366 w 8363529"/>
                <a:gd name="connsiteY353" fmla="*/ 1614830 h 2372732"/>
                <a:gd name="connsiteX354" fmla="*/ 6866443 w 8363529"/>
                <a:gd name="connsiteY354" fmla="*/ 1527234 h 2372732"/>
                <a:gd name="connsiteX355" fmla="*/ 6858090 w 8363529"/>
                <a:gd name="connsiteY355" fmla="*/ 1510975 h 2372732"/>
                <a:gd name="connsiteX356" fmla="*/ 6849737 w 8363529"/>
                <a:gd name="connsiteY356" fmla="*/ 1519482 h 2372732"/>
                <a:gd name="connsiteX357" fmla="*/ 6782814 w 8363529"/>
                <a:gd name="connsiteY357" fmla="*/ 1577850 h 2372732"/>
                <a:gd name="connsiteX358" fmla="*/ 6774451 w 8363529"/>
                <a:gd name="connsiteY358" fmla="*/ 1584131 h 2372732"/>
                <a:gd name="connsiteX359" fmla="*/ 6766097 w 8363529"/>
                <a:gd name="connsiteY359" fmla="*/ 1657471 h 2372732"/>
                <a:gd name="connsiteX360" fmla="*/ 6699174 w 8363529"/>
                <a:gd name="connsiteY360" fmla="*/ 2123224 h 2372732"/>
                <a:gd name="connsiteX361" fmla="*/ 6690821 w 8363529"/>
                <a:gd name="connsiteY361" fmla="*/ 2169689 h 2372732"/>
                <a:gd name="connsiteX362" fmla="*/ 6682458 w 8363529"/>
                <a:gd name="connsiteY362" fmla="*/ 2143829 h 2372732"/>
                <a:gd name="connsiteX363" fmla="*/ 6615535 w 8363529"/>
                <a:gd name="connsiteY363" fmla="*/ 1851254 h 2372732"/>
                <a:gd name="connsiteX364" fmla="*/ 6607182 w 8363529"/>
                <a:gd name="connsiteY364" fmla="*/ 1798818 h 2372732"/>
                <a:gd name="connsiteX365" fmla="*/ 6598829 w 8363529"/>
                <a:gd name="connsiteY365" fmla="*/ 1855299 h 2372732"/>
                <a:gd name="connsiteX366" fmla="*/ 6531944 w 8363529"/>
                <a:gd name="connsiteY366" fmla="*/ 2259133 h 2372732"/>
                <a:gd name="connsiteX367" fmla="*/ 6523542 w 8363529"/>
                <a:gd name="connsiteY367" fmla="*/ 2304309 h 2372732"/>
                <a:gd name="connsiteX368" fmla="*/ 6515189 w 8363529"/>
                <a:gd name="connsiteY368" fmla="*/ 2292096 h 2372732"/>
                <a:gd name="connsiteX369" fmla="*/ 6448305 w 8363529"/>
                <a:gd name="connsiteY369" fmla="*/ 2205410 h 2372732"/>
                <a:gd name="connsiteX370" fmla="*/ 6439913 w 8363529"/>
                <a:gd name="connsiteY370" fmla="*/ 2195771 h 2372732"/>
                <a:gd name="connsiteX371" fmla="*/ 6431560 w 8363529"/>
                <a:gd name="connsiteY371" fmla="*/ 2116043 h 2372732"/>
                <a:gd name="connsiteX372" fmla="*/ 6364665 w 8363529"/>
                <a:gd name="connsiteY372" fmla="*/ 1419450 h 2372732"/>
                <a:gd name="connsiteX373" fmla="*/ 6356273 w 8363529"/>
                <a:gd name="connsiteY373" fmla="*/ 1324258 h 2372732"/>
                <a:gd name="connsiteX374" fmla="*/ 6347920 w 8363529"/>
                <a:gd name="connsiteY374" fmla="*/ 1396959 h 2372732"/>
                <a:gd name="connsiteX375" fmla="*/ 6281036 w 8363529"/>
                <a:gd name="connsiteY375" fmla="*/ 2079712 h 2372732"/>
                <a:gd name="connsiteX376" fmla="*/ 6272644 w 8363529"/>
                <a:gd name="connsiteY376" fmla="*/ 2180237 h 2372732"/>
                <a:gd name="connsiteX377" fmla="*/ 6264280 w 8363529"/>
                <a:gd name="connsiteY377" fmla="*/ 2065534 h 2372732"/>
                <a:gd name="connsiteX378" fmla="*/ 6197396 w 8363529"/>
                <a:gd name="connsiteY378" fmla="*/ 1350495 h 2372732"/>
                <a:gd name="connsiteX379" fmla="*/ 6189004 w 8363529"/>
                <a:gd name="connsiteY379" fmla="*/ 1280368 h 2372732"/>
                <a:gd name="connsiteX380" fmla="*/ 6180651 w 8363529"/>
                <a:gd name="connsiteY380" fmla="*/ 1236972 h 2372732"/>
                <a:gd name="connsiteX381" fmla="*/ 6113767 w 8363529"/>
                <a:gd name="connsiteY381" fmla="*/ 834996 h 2372732"/>
                <a:gd name="connsiteX382" fmla="*/ 6105365 w 8363529"/>
                <a:gd name="connsiteY382" fmla="*/ 776735 h 2372732"/>
                <a:gd name="connsiteX383" fmla="*/ 6097011 w 8363529"/>
                <a:gd name="connsiteY383" fmla="*/ 882699 h 2372732"/>
                <a:gd name="connsiteX384" fmla="*/ 6030127 w 8363529"/>
                <a:gd name="connsiteY384" fmla="*/ 1628853 h 2372732"/>
                <a:gd name="connsiteX385" fmla="*/ 6021735 w 8363529"/>
                <a:gd name="connsiteY385" fmla="*/ 1711116 h 2372732"/>
                <a:gd name="connsiteX386" fmla="*/ 6013372 w 8363529"/>
                <a:gd name="connsiteY386" fmla="*/ 1752818 h 2372732"/>
                <a:gd name="connsiteX387" fmla="*/ 5946488 w 8363529"/>
                <a:gd name="connsiteY387" fmla="*/ 2270136 h 2372732"/>
                <a:gd name="connsiteX388" fmla="*/ 5938096 w 8363529"/>
                <a:gd name="connsiteY388" fmla="*/ 2372733 h 2372732"/>
                <a:gd name="connsiteX389" fmla="*/ 5929743 w 8363529"/>
                <a:gd name="connsiteY389" fmla="*/ 2265336 h 2372732"/>
                <a:gd name="connsiteX390" fmla="*/ 5862858 w 8363529"/>
                <a:gd name="connsiteY390" fmla="*/ 1753196 h 2372732"/>
                <a:gd name="connsiteX391" fmla="*/ 5854457 w 8363529"/>
                <a:gd name="connsiteY391" fmla="*/ 1713913 h 2372732"/>
                <a:gd name="connsiteX392" fmla="*/ 5846103 w 8363529"/>
                <a:gd name="connsiteY392" fmla="*/ 1749218 h 2372732"/>
                <a:gd name="connsiteX393" fmla="*/ 5779219 w 8363529"/>
                <a:gd name="connsiteY393" fmla="*/ 2132109 h 2372732"/>
                <a:gd name="connsiteX394" fmla="*/ 5770827 w 8363529"/>
                <a:gd name="connsiteY394" fmla="*/ 2197735 h 2372732"/>
                <a:gd name="connsiteX395" fmla="*/ 5762474 w 8363529"/>
                <a:gd name="connsiteY395" fmla="*/ 2080090 h 2372732"/>
                <a:gd name="connsiteX396" fmla="*/ 5695580 w 8363529"/>
                <a:gd name="connsiteY396" fmla="*/ 1426331 h 2372732"/>
                <a:gd name="connsiteX397" fmla="*/ 5687188 w 8363529"/>
                <a:gd name="connsiteY397" fmla="*/ 1368757 h 2372732"/>
                <a:gd name="connsiteX398" fmla="*/ 5678835 w 8363529"/>
                <a:gd name="connsiteY398" fmla="*/ 1417640 h 2372732"/>
                <a:gd name="connsiteX399" fmla="*/ 5611950 w 8363529"/>
                <a:gd name="connsiteY399" fmla="*/ 1810354 h 2372732"/>
                <a:gd name="connsiteX400" fmla="*/ 5603558 w 8363529"/>
                <a:gd name="connsiteY400" fmla="*/ 1859654 h 2372732"/>
                <a:gd name="connsiteX401" fmla="*/ 5595195 w 8363529"/>
                <a:gd name="connsiteY401" fmla="*/ 1882223 h 2372732"/>
                <a:gd name="connsiteX402" fmla="*/ 5528311 w 8363529"/>
                <a:gd name="connsiteY402" fmla="*/ 2139135 h 2372732"/>
                <a:gd name="connsiteX403" fmla="*/ 5519919 w 8363529"/>
                <a:gd name="connsiteY403" fmla="*/ 2185522 h 2372732"/>
                <a:gd name="connsiteX404" fmla="*/ 5511566 w 8363529"/>
                <a:gd name="connsiteY404" fmla="*/ 2173695 h 2372732"/>
                <a:gd name="connsiteX405" fmla="*/ 5444672 w 8363529"/>
                <a:gd name="connsiteY405" fmla="*/ 1962212 h 2372732"/>
                <a:gd name="connsiteX406" fmla="*/ 5436280 w 8363529"/>
                <a:gd name="connsiteY406" fmla="*/ 1898095 h 2372732"/>
                <a:gd name="connsiteX407" fmla="*/ 5427926 w 8363529"/>
                <a:gd name="connsiteY407" fmla="*/ 1821387 h 2372732"/>
                <a:gd name="connsiteX408" fmla="*/ 5361042 w 8363529"/>
                <a:gd name="connsiteY408" fmla="*/ 1598793 h 2372732"/>
                <a:gd name="connsiteX409" fmla="*/ 5352650 w 8363529"/>
                <a:gd name="connsiteY409" fmla="*/ 1587528 h 2372732"/>
                <a:gd name="connsiteX410" fmla="*/ 5344287 w 8363529"/>
                <a:gd name="connsiteY410" fmla="*/ 1491396 h 2372732"/>
                <a:gd name="connsiteX411" fmla="*/ 5277403 w 8363529"/>
                <a:gd name="connsiteY411" fmla="*/ 828299 h 2372732"/>
                <a:gd name="connsiteX412" fmla="*/ 5269049 w 8363529"/>
                <a:gd name="connsiteY412" fmla="*/ 756624 h 2372732"/>
                <a:gd name="connsiteX413" fmla="*/ 5260657 w 8363529"/>
                <a:gd name="connsiteY413" fmla="*/ 866827 h 2372732"/>
                <a:gd name="connsiteX414" fmla="*/ 5193773 w 8363529"/>
                <a:gd name="connsiteY414" fmla="*/ 1678453 h 2372732"/>
                <a:gd name="connsiteX415" fmla="*/ 5185410 w 8363529"/>
                <a:gd name="connsiteY415" fmla="*/ 1771865 h 2372732"/>
                <a:gd name="connsiteX416" fmla="*/ 5177018 w 8363529"/>
                <a:gd name="connsiteY416" fmla="*/ 1752432 h 2372732"/>
                <a:gd name="connsiteX417" fmla="*/ 5110134 w 8363529"/>
                <a:gd name="connsiteY417" fmla="*/ 1539370 h 2372732"/>
                <a:gd name="connsiteX418" fmla="*/ 5101780 w 8363529"/>
                <a:gd name="connsiteY418" fmla="*/ 1502507 h 2372732"/>
                <a:gd name="connsiteX419" fmla="*/ 5093388 w 8363529"/>
                <a:gd name="connsiteY419" fmla="*/ 1564282 h 2372732"/>
                <a:gd name="connsiteX420" fmla="*/ 5026494 w 8363529"/>
                <a:gd name="connsiteY420" fmla="*/ 1979003 h 2372732"/>
                <a:gd name="connsiteX421" fmla="*/ 5018141 w 8363529"/>
                <a:gd name="connsiteY421" fmla="*/ 2022660 h 2372732"/>
                <a:gd name="connsiteX422" fmla="*/ 5009749 w 8363529"/>
                <a:gd name="connsiteY422" fmla="*/ 2036916 h 2372732"/>
                <a:gd name="connsiteX423" fmla="*/ 4942864 w 8363529"/>
                <a:gd name="connsiteY423" fmla="*/ 2137858 h 2372732"/>
                <a:gd name="connsiteX424" fmla="*/ 4934501 w 8363529"/>
                <a:gd name="connsiteY424" fmla="*/ 2149045 h 2372732"/>
                <a:gd name="connsiteX425" fmla="*/ 4926109 w 8363529"/>
                <a:gd name="connsiteY425" fmla="*/ 2127947 h 2372732"/>
                <a:gd name="connsiteX426" fmla="*/ 4859225 w 8363529"/>
                <a:gd name="connsiteY426" fmla="*/ 1874926 h 2372732"/>
                <a:gd name="connsiteX427" fmla="*/ 4850872 w 8363529"/>
                <a:gd name="connsiteY427" fmla="*/ 1826497 h 2372732"/>
                <a:gd name="connsiteX428" fmla="*/ 4842480 w 8363529"/>
                <a:gd name="connsiteY428" fmla="*/ 1709674 h 2372732"/>
                <a:gd name="connsiteX429" fmla="*/ 4775595 w 8363529"/>
                <a:gd name="connsiteY429" fmla="*/ 1001332 h 2372732"/>
                <a:gd name="connsiteX430" fmla="*/ 4767232 w 8363529"/>
                <a:gd name="connsiteY430" fmla="*/ 933625 h 2372732"/>
                <a:gd name="connsiteX431" fmla="*/ 4758840 w 8363529"/>
                <a:gd name="connsiteY431" fmla="*/ 980466 h 2372732"/>
                <a:gd name="connsiteX432" fmla="*/ 4691956 w 8363529"/>
                <a:gd name="connsiteY432" fmla="*/ 1399949 h 2372732"/>
                <a:gd name="connsiteX433" fmla="*/ 4683603 w 8363529"/>
                <a:gd name="connsiteY433" fmla="*/ 1458695 h 2372732"/>
                <a:gd name="connsiteX434" fmla="*/ 4675201 w 8363529"/>
                <a:gd name="connsiteY434" fmla="*/ 1444594 h 2372732"/>
                <a:gd name="connsiteX435" fmla="*/ 4608317 w 8363529"/>
                <a:gd name="connsiteY435" fmla="*/ 1329097 h 2372732"/>
                <a:gd name="connsiteX436" fmla="*/ 4599964 w 8363529"/>
                <a:gd name="connsiteY436" fmla="*/ 1314318 h 2372732"/>
                <a:gd name="connsiteX437" fmla="*/ 4591572 w 8363529"/>
                <a:gd name="connsiteY437" fmla="*/ 1332232 h 2372732"/>
                <a:gd name="connsiteX438" fmla="*/ 4524687 w 8363529"/>
                <a:gd name="connsiteY438" fmla="*/ 1460543 h 2372732"/>
                <a:gd name="connsiteX439" fmla="*/ 4516324 w 8363529"/>
                <a:gd name="connsiteY439" fmla="*/ 1474954 h 2372732"/>
                <a:gd name="connsiteX440" fmla="*/ 4507932 w 8363529"/>
                <a:gd name="connsiteY440" fmla="*/ 1508633 h 2372732"/>
                <a:gd name="connsiteX441" fmla="*/ 4441048 w 8363529"/>
                <a:gd name="connsiteY441" fmla="*/ 1763735 h 2372732"/>
                <a:gd name="connsiteX442" fmla="*/ 4432695 w 8363529"/>
                <a:gd name="connsiteY442" fmla="*/ 1793911 h 2372732"/>
                <a:gd name="connsiteX443" fmla="*/ 4424303 w 8363529"/>
                <a:gd name="connsiteY443" fmla="*/ 1727791 h 2372732"/>
                <a:gd name="connsiteX444" fmla="*/ 4357409 w 8363529"/>
                <a:gd name="connsiteY444" fmla="*/ 1194359 h 2372732"/>
                <a:gd name="connsiteX445" fmla="*/ 4349055 w 8363529"/>
                <a:gd name="connsiteY445" fmla="*/ 1127107 h 2372732"/>
                <a:gd name="connsiteX446" fmla="*/ 4340664 w 8363529"/>
                <a:gd name="connsiteY446" fmla="*/ 1211112 h 2372732"/>
                <a:gd name="connsiteX447" fmla="*/ 4273779 w 8363529"/>
                <a:gd name="connsiteY447" fmla="*/ 1938433 h 2372732"/>
                <a:gd name="connsiteX448" fmla="*/ 4265416 w 8363529"/>
                <a:gd name="connsiteY448" fmla="*/ 2036916 h 2372732"/>
                <a:gd name="connsiteX449" fmla="*/ 4257024 w 8363529"/>
                <a:gd name="connsiteY449" fmla="*/ 1993820 h 2372732"/>
                <a:gd name="connsiteX450" fmla="*/ 4190140 w 8363529"/>
                <a:gd name="connsiteY450" fmla="*/ 1719207 h 2372732"/>
                <a:gd name="connsiteX451" fmla="*/ 4181787 w 8363529"/>
                <a:gd name="connsiteY451" fmla="*/ 1691721 h 2372732"/>
                <a:gd name="connsiteX452" fmla="*/ 4173394 w 8363529"/>
                <a:gd name="connsiteY452" fmla="*/ 1721394 h 2372732"/>
                <a:gd name="connsiteX453" fmla="*/ 4106500 w 8363529"/>
                <a:gd name="connsiteY453" fmla="*/ 2084735 h 2372732"/>
                <a:gd name="connsiteX454" fmla="*/ 4098147 w 8363529"/>
                <a:gd name="connsiteY454" fmla="*/ 2155772 h 2372732"/>
                <a:gd name="connsiteX455" fmla="*/ 4089755 w 8363529"/>
                <a:gd name="connsiteY455" fmla="*/ 2066628 h 2372732"/>
                <a:gd name="connsiteX456" fmla="*/ 4022871 w 8363529"/>
                <a:gd name="connsiteY456" fmla="*/ 1602316 h 2372732"/>
                <a:gd name="connsiteX457" fmla="*/ 4014517 w 8363529"/>
                <a:gd name="connsiteY457" fmla="*/ 1563749 h 2372732"/>
                <a:gd name="connsiteX458" fmla="*/ 4006154 w 8363529"/>
                <a:gd name="connsiteY458" fmla="*/ 1539903 h 2372732"/>
                <a:gd name="connsiteX459" fmla="*/ 3939231 w 8363529"/>
                <a:gd name="connsiteY459" fmla="*/ 1323425 h 2372732"/>
                <a:gd name="connsiteX460" fmla="*/ 3930878 w 8363529"/>
                <a:gd name="connsiteY460" fmla="*/ 1292698 h 2372732"/>
                <a:gd name="connsiteX461" fmla="*/ 3922525 w 8363529"/>
                <a:gd name="connsiteY461" fmla="*/ 1337526 h 2372732"/>
                <a:gd name="connsiteX462" fmla="*/ 3855602 w 8363529"/>
                <a:gd name="connsiteY462" fmla="*/ 1736289 h 2372732"/>
                <a:gd name="connsiteX463" fmla="*/ 3847239 w 8363529"/>
                <a:gd name="connsiteY463" fmla="*/ 1791753 h 2372732"/>
                <a:gd name="connsiteX464" fmla="*/ 3838885 w 8363529"/>
                <a:gd name="connsiteY464" fmla="*/ 1672365 h 2372732"/>
                <a:gd name="connsiteX465" fmla="*/ 3771962 w 8363529"/>
                <a:gd name="connsiteY465" fmla="*/ 800775 h 2372732"/>
                <a:gd name="connsiteX466" fmla="*/ 3763609 w 8363529"/>
                <a:gd name="connsiteY466" fmla="*/ 701275 h 2372732"/>
                <a:gd name="connsiteX467" fmla="*/ 3755246 w 8363529"/>
                <a:gd name="connsiteY467" fmla="*/ 799759 h 2372732"/>
                <a:gd name="connsiteX468" fmla="*/ 3688323 w 8363529"/>
                <a:gd name="connsiteY468" fmla="*/ 1696860 h 2372732"/>
                <a:gd name="connsiteX469" fmla="*/ 3679970 w 8363529"/>
                <a:gd name="connsiteY469" fmla="*/ 1824794 h 2372732"/>
                <a:gd name="connsiteX470" fmla="*/ 3671616 w 8363529"/>
                <a:gd name="connsiteY470" fmla="*/ 1760677 h 2372732"/>
                <a:gd name="connsiteX471" fmla="*/ 3604693 w 8363529"/>
                <a:gd name="connsiteY471" fmla="*/ 1376277 h 2372732"/>
                <a:gd name="connsiteX472" fmla="*/ 3596330 w 8363529"/>
                <a:gd name="connsiteY472" fmla="*/ 1339946 h 2372732"/>
                <a:gd name="connsiteX473" fmla="*/ 3587977 w 8363529"/>
                <a:gd name="connsiteY473" fmla="*/ 1335600 h 2372732"/>
                <a:gd name="connsiteX474" fmla="*/ 3521054 w 8363529"/>
                <a:gd name="connsiteY474" fmla="*/ 1295562 h 2372732"/>
                <a:gd name="connsiteX475" fmla="*/ 3512701 w 8363529"/>
                <a:gd name="connsiteY475" fmla="*/ 1289784 h 2372732"/>
                <a:gd name="connsiteX476" fmla="*/ 3504347 w 8363529"/>
                <a:gd name="connsiteY476" fmla="*/ 1233826 h 2372732"/>
                <a:gd name="connsiteX477" fmla="*/ 3437424 w 8363529"/>
                <a:gd name="connsiteY477" fmla="*/ 843987 h 2372732"/>
                <a:gd name="connsiteX478" fmla="*/ 3429061 w 8363529"/>
                <a:gd name="connsiteY478" fmla="*/ 801501 h 2372732"/>
                <a:gd name="connsiteX479" fmla="*/ 3420708 w 8363529"/>
                <a:gd name="connsiteY479" fmla="*/ 791968 h 2372732"/>
                <a:gd name="connsiteX480" fmla="*/ 3353785 w 8363529"/>
                <a:gd name="connsiteY480" fmla="*/ 605705 h 2372732"/>
                <a:gd name="connsiteX481" fmla="*/ 3345432 w 8363529"/>
                <a:gd name="connsiteY481" fmla="*/ 542159 h 2372732"/>
                <a:gd name="connsiteX482" fmla="*/ 3337069 w 8363529"/>
                <a:gd name="connsiteY482" fmla="*/ 866140 h 2372732"/>
                <a:gd name="connsiteX483" fmla="*/ 3270146 w 8363529"/>
                <a:gd name="connsiteY483" fmla="*/ 2000430 h 2372732"/>
                <a:gd name="connsiteX484" fmla="*/ 3261792 w 8363529"/>
                <a:gd name="connsiteY484" fmla="*/ 2067160 h 2372732"/>
                <a:gd name="connsiteX485" fmla="*/ 3253439 w 8363529"/>
                <a:gd name="connsiteY485" fmla="*/ 2046439 h 2372732"/>
                <a:gd name="connsiteX486" fmla="*/ 3186516 w 8363529"/>
                <a:gd name="connsiteY486" fmla="*/ 1914615 h 2372732"/>
                <a:gd name="connsiteX487" fmla="*/ 3178153 w 8363529"/>
                <a:gd name="connsiteY487" fmla="*/ 1901424 h 2372732"/>
                <a:gd name="connsiteX488" fmla="*/ 3169800 w 8363529"/>
                <a:gd name="connsiteY488" fmla="*/ 1875110 h 2372732"/>
                <a:gd name="connsiteX489" fmla="*/ 3102877 w 8363529"/>
                <a:gd name="connsiteY489" fmla="*/ 1583337 h 2372732"/>
                <a:gd name="connsiteX490" fmla="*/ 3094523 w 8363529"/>
                <a:gd name="connsiteY490" fmla="*/ 1532151 h 2372732"/>
                <a:gd name="connsiteX491" fmla="*/ 3086161 w 8363529"/>
                <a:gd name="connsiteY491" fmla="*/ 1547161 h 2372732"/>
                <a:gd name="connsiteX492" fmla="*/ 3019238 w 8363529"/>
                <a:gd name="connsiteY492" fmla="*/ 1641328 h 2372732"/>
                <a:gd name="connsiteX493" fmla="*/ 3010884 w 8363529"/>
                <a:gd name="connsiteY493" fmla="*/ 1650629 h 2372732"/>
                <a:gd name="connsiteX494" fmla="*/ 3002531 w 8363529"/>
                <a:gd name="connsiteY494" fmla="*/ 1670585 h 2372732"/>
                <a:gd name="connsiteX495" fmla="*/ 2935608 w 8363529"/>
                <a:gd name="connsiteY495" fmla="*/ 1837191 h 2372732"/>
                <a:gd name="connsiteX496" fmla="*/ 2927245 w 8363529"/>
                <a:gd name="connsiteY496" fmla="*/ 1858889 h 2372732"/>
                <a:gd name="connsiteX497" fmla="*/ 2918892 w 8363529"/>
                <a:gd name="connsiteY497" fmla="*/ 1847324 h 2372732"/>
                <a:gd name="connsiteX498" fmla="*/ 2851968 w 8363529"/>
                <a:gd name="connsiteY498" fmla="*/ 1757164 h 2372732"/>
                <a:gd name="connsiteX499" fmla="*/ 2843615 w 8363529"/>
                <a:gd name="connsiteY499" fmla="*/ 1746199 h 2372732"/>
                <a:gd name="connsiteX500" fmla="*/ 2835262 w 8363529"/>
                <a:gd name="connsiteY500" fmla="*/ 1751299 h 2372732"/>
                <a:gd name="connsiteX501" fmla="*/ 2768329 w 8363529"/>
                <a:gd name="connsiteY501" fmla="*/ 1804799 h 2372732"/>
                <a:gd name="connsiteX502" fmla="*/ 2759976 w 8363529"/>
                <a:gd name="connsiteY502" fmla="*/ 1813683 h 2372732"/>
                <a:gd name="connsiteX503" fmla="*/ 2751623 w 8363529"/>
                <a:gd name="connsiteY503" fmla="*/ 1791453 h 2372732"/>
                <a:gd name="connsiteX504" fmla="*/ 2684699 w 8363529"/>
                <a:gd name="connsiteY504" fmla="*/ 1641251 h 2372732"/>
                <a:gd name="connsiteX505" fmla="*/ 2676346 w 8363529"/>
                <a:gd name="connsiteY505" fmla="*/ 1625340 h 2372732"/>
                <a:gd name="connsiteX506" fmla="*/ 2667983 w 8363529"/>
                <a:gd name="connsiteY506" fmla="*/ 1596945 h 2372732"/>
                <a:gd name="connsiteX507" fmla="*/ 2601060 w 8363529"/>
                <a:gd name="connsiteY507" fmla="*/ 1372464 h 2372732"/>
                <a:gd name="connsiteX508" fmla="*/ 2592707 w 8363529"/>
                <a:gd name="connsiteY508" fmla="*/ 1344746 h 2372732"/>
                <a:gd name="connsiteX509" fmla="*/ 2584354 w 8363529"/>
                <a:gd name="connsiteY509" fmla="*/ 1340439 h 2372732"/>
                <a:gd name="connsiteX510" fmla="*/ 2517430 w 8363529"/>
                <a:gd name="connsiteY510" fmla="*/ 1311066 h 2372732"/>
                <a:gd name="connsiteX511" fmla="*/ 2509068 w 8363529"/>
                <a:gd name="connsiteY511" fmla="*/ 1307892 h 2372732"/>
                <a:gd name="connsiteX512" fmla="*/ 2500714 w 8363529"/>
                <a:gd name="connsiteY512" fmla="*/ 1357869 h 2372732"/>
                <a:gd name="connsiteX513" fmla="*/ 2433791 w 8363529"/>
                <a:gd name="connsiteY513" fmla="*/ 1780827 h 2372732"/>
                <a:gd name="connsiteX514" fmla="*/ 2425438 w 8363529"/>
                <a:gd name="connsiteY514" fmla="*/ 1836775 h 2372732"/>
                <a:gd name="connsiteX515" fmla="*/ 2417075 w 8363529"/>
                <a:gd name="connsiteY515" fmla="*/ 1854283 h 2372732"/>
                <a:gd name="connsiteX516" fmla="*/ 2350152 w 8363529"/>
                <a:gd name="connsiteY516" fmla="*/ 2001611 h 2372732"/>
                <a:gd name="connsiteX517" fmla="*/ 2341799 w 8363529"/>
                <a:gd name="connsiteY517" fmla="*/ 2020996 h 2372732"/>
                <a:gd name="connsiteX518" fmla="*/ 2333445 w 8363529"/>
                <a:gd name="connsiteY518" fmla="*/ 1975596 h 2372732"/>
                <a:gd name="connsiteX519" fmla="*/ 2266522 w 8363529"/>
                <a:gd name="connsiteY519" fmla="*/ 1530825 h 2372732"/>
                <a:gd name="connsiteX520" fmla="*/ 2258159 w 8363529"/>
                <a:gd name="connsiteY520" fmla="*/ 1462440 h 2372732"/>
                <a:gd name="connsiteX521" fmla="*/ 2249806 w 8363529"/>
                <a:gd name="connsiteY521" fmla="*/ 1408756 h 2372732"/>
                <a:gd name="connsiteX522" fmla="*/ 2182883 w 8363529"/>
                <a:gd name="connsiteY522" fmla="*/ 1050061 h 2372732"/>
                <a:gd name="connsiteX523" fmla="*/ 2174530 w 8363529"/>
                <a:gd name="connsiteY523" fmla="*/ 1012481 h 2372732"/>
                <a:gd name="connsiteX524" fmla="*/ 2166176 w 8363529"/>
                <a:gd name="connsiteY524" fmla="*/ 1030482 h 2372732"/>
                <a:gd name="connsiteX525" fmla="*/ 2099253 w 8363529"/>
                <a:gd name="connsiteY525" fmla="*/ 1197127 h 2372732"/>
                <a:gd name="connsiteX526" fmla="*/ 2090890 w 8363529"/>
                <a:gd name="connsiteY526" fmla="*/ 1221351 h 2372732"/>
                <a:gd name="connsiteX527" fmla="*/ 2082537 w 8363529"/>
                <a:gd name="connsiteY527" fmla="*/ 1298059 h 2372732"/>
                <a:gd name="connsiteX528" fmla="*/ 2015614 w 8363529"/>
                <a:gd name="connsiteY528" fmla="*/ 1766610 h 2372732"/>
                <a:gd name="connsiteX529" fmla="*/ 2007260 w 8363529"/>
                <a:gd name="connsiteY529" fmla="*/ 1811680 h 2372732"/>
                <a:gd name="connsiteX530" fmla="*/ 1998898 w 8363529"/>
                <a:gd name="connsiteY530" fmla="*/ 1803551 h 2372732"/>
                <a:gd name="connsiteX531" fmla="*/ 1931975 w 8363529"/>
                <a:gd name="connsiteY531" fmla="*/ 1720078 h 2372732"/>
                <a:gd name="connsiteX532" fmla="*/ 1923621 w 8363529"/>
                <a:gd name="connsiteY532" fmla="*/ 1706616 h 2372732"/>
                <a:gd name="connsiteX533" fmla="*/ 1915268 w 8363529"/>
                <a:gd name="connsiteY533" fmla="*/ 1692360 h 2372732"/>
                <a:gd name="connsiteX534" fmla="*/ 1848345 w 8363529"/>
                <a:gd name="connsiteY534" fmla="*/ 1577289 h 2372732"/>
                <a:gd name="connsiteX535" fmla="*/ 1839982 w 8363529"/>
                <a:gd name="connsiteY535" fmla="*/ 1562772 h 2372732"/>
                <a:gd name="connsiteX536" fmla="*/ 1831629 w 8363529"/>
                <a:gd name="connsiteY536" fmla="*/ 1582921 h 2372732"/>
                <a:gd name="connsiteX537" fmla="*/ 1764706 w 8363529"/>
                <a:gd name="connsiteY537" fmla="*/ 1734179 h 2372732"/>
                <a:gd name="connsiteX538" fmla="*/ 1756352 w 8363529"/>
                <a:gd name="connsiteY538" fmla="*/ 1751947 h 2372732"/>
                <a:gd name="connsiteX539" fmla="*/ 1747989 w 8363529"/>
                <a:gd name="connsiteY539" fmla="*/ 1770162 h 2372732"/>
                <a:gd name="connsiteX540" fmla="*/ 1681066 w 8363529"/>
                <a:gd name="connsiteY540" fmla="*/ 1890382 h 2372732"/>
                <a:gd name="connsiteX541" fmla="*/ 1672713 w 8363529"/>
                <a:gd name="connsiteY541" fmla="*/ 1902827 h 2372732"/>
                <a:gd name="connsiteX542" fmla="*/ 1664360 w 8363529"/>
                <a:gd name="connsiteY542" fmla="*/ 1915941 h 2372732"/>
                <a:gd name="connsiteX543" fmla="*/ 1597437 w 8363529"/>
                <a:gd name="connsiteY543" fmla="*/ 2071805 h 2372732"/>
                <a:gd name="connsiteX544" fmla="*/ 1589074 w 8363529"/>
                <a:gd name="connsiteY544" fmla="*/ 2101294 h 2372732"/>
                <a:gd name="connsiteX545" fmla="*/ 1580720 w 8363529"/>
                <a:gd name="connsiteY545" fmla="*/ 2069618 h 2372732"/>
                <a:gd name="connsiteX546" fmla="*/ 1513797 w 8363529"/>
                <a:gd name="connsiteY546" fmla="*/ 1871751 h 2372732"/>
                <a:gd name="connsiteX547" fmla="*/ 1505444 w 8363529"/>
                <a:gd name="connsiteY547" fmla="*/ 1852318 h 2372732"/>
                <a:gd name="connsiteX548" fmla="*/ 1497091 w 8363529"/>
                <a:gd name="connsiteY548" fmla="*/ 1844227 h 2372732"/>
                <a:gd name="connsiteX549" fmla="*/ 1430158 w 8363529"/>
                <a:gd name="connsiteY549" fmla="*/ 1790011 h 2372732"/>
                <a:gd name="connsiteX550" fmla="*/ 1421805 w 8363529"/>
                <a:gd name="connsiteY550" fmla="*/ 1784340 h 2372732"/>
                <a:gd name="connsiteX551" fmla="*/ 1413451 w 8363529"/>
                <a:gd name="connsiteY551" fmla="*/ 1762003 h 2372732"/>
                <a:gd name="connsiteX552" fmla="*/ 1346528 w 8363529"/>
                <a:gd name="connsiteY552" fmla="*/ 1495481 h 2372732"/>
                <a:gd name="connsiteX553" fmla="*/ 1338175 w 8363529"/>
                <a:gd name="connsiteY553" fmla="*/ 1444778 h 2372732"/>
                <a:gd name="connsiteX554" fmla="*/ 1329812 w 8363529"/>
                <a:gd name="connsiteY554" fmla="*/ 1402059 h 2372732"/>
                <a:gd name="connsiteX555" fmla="*/ 1262889 w 8363529"/>
                <a:gd name="connsiteY555" fmla="*/ 1191456 h 2372732"/>
                <a:gd name="connsiteX556" fmla="*/ 1254536 w 8363529"/>
                <a:gd name="connsiteY556" fmla="*/ 1174820 h 2372732"/>
                <a:gd name="connsiteX557" fmla="*/ 1246182 w 8363529"/>
                <a:gd name="connsiteY557" fmla="*/ 1205518 h 2372732"/>
                <a:gd name="connsiteX558" fmla="*/ 1179259 w 8363529"/>
                <a:gd name="connsiteY558" fmla="*/ 1495936 h 2372732"/>
                <a:gd name="connsiteX559" fmla="*/ 1170896 w 8363529"/>
                <a:gd name="connsiteY559" fmla="*/ 1538993 h 2372732"/>
                <a:gd name="connsiteX560" fmla="*/ 1162543 w 8363529"/>
                <a:gd name="connsiteY560" fmla="*/ 1533322 h 2372732"/>
                <a:gd name="connsiteX561" fmla="*/ 1095620 w 8363529"/>
                <a:gd name="connsiteY561" fmla="*/ 1490525 h 2372732"/>
                <a:gd name="connsiteX562" fmla="*/ 1087267 w 8363529"/>
                <a:gd name="connsiteY562" fmla="*/ 1485454 h 2372732"/>
                <a:gd name="connsiteX563" fmla="*/ 1078904 w 8363529"/>
                <a:gd name="connsiteY563" fmla="*/ 1511391 h 2372732"/>
                <a:gd name="connsiteX564" fmla="*/ 1011981 w 8363529"/>
                <a:gd name="connsiteY564" fmla="*/ 1683176 h 2372732"/>
                <a:gd name="connsiteX565" fmla="*/ 1003627 w 8363529"/>
                <a:gd name="connsiteY565" fmla="*/ 1701061 h 2372732"/>
                <a:gd name="connsiteX566" fmla="*/ 995274 w 8363529"/>
                <a:gd name="connsiteY566" fmla="*/ 1663220 h 2372732"/>
                <a:gd name="connsiteX567" fmla="*/ 928351 w 8363529"/>
                <a:gd name="connsiteY567" fmla="*/ 1271406 h 2372732"/>
                <a:gd name="connsiteX568" fmla="*/ 919988 w 8363529"/>
                <a:gd name="connsiteY568" fmla="*/ 1207560 h 2372732"/>
                <a:gd name="connsiteX569" fmla="*/ 911635 w 8363529"/>
                <a:gd name="connsiteY569" fmla="*/ 1284636 h 2372732"/>
                <a:gd name="connsiteX570" fmla="*/ 844712 w 8363529"/>
                <a:gd name="connsiteY570" fmla="*/ 1784679 h 2372732"/>
                <a:gd name="connsiteX571" fmla="*/ 836358 w 8363529"/>
                <a:gd name="connsiteY571" fmla="*/ 1835604 h 2372732"/>
                <a:gd name="connsiteX572" fmla="*/ 828005 w 8363529"/>
                <a:gd name="connsiteY572" fmla="*/ 1838324 h 2372732"/>
                <a:gd name="connsiteX573" fmla="*/ 761082 w 8363529"/>
                <a:gd name="connsiteY573" fmla="*/ 1866119 h 2372732"/>
                <a:gd name="connsiteX574" fmla="*/ 752719 w 8363529"/>
                <a:gd name="connsiteY574" fmla="*/ 1870542 h 2372732"/>
                <a:gd name="connsiteX575" fmla="*/ 744366 w 8363529"/>
                <a:gd name="connsiteY575" fmla="*/ 1812542 h 2372732"/>
                <a:gd name="connsiteX576" fmla="*/ 677443 w 8363529"/>
                <a:gd name="connsiteY576" fmla="*/ 1258409 h 2372732"/>
                <a:gd name="connsiteX577" fmla="*/ 669089 w 8363529"/>
                <a:gd name="connsiteY577" fmla="*/ 1175381 h 2372732"/>
                <a:gd name="connsiteX578" fmla="*/ 660727 w 8363529"/>
                <a:gd name="connsiteY578" fmla="*/ 1181207 h 2372732"/>
                <a:gd name="connsiteX579" fmla="*/ 593803 w 8363529"/>
                <a:gd name="connsiteY579" fmla="*/ 1212854 h 2372732"/>
                <a:gd name="connsiteX580" fmla="*/ 585450 w 8363529"/>
                <a:gd name="connsiteY580" fmla="*/ 1215574 h 2372732"/>
                <a:gd name="connsiteX581" fmla="*/ 577097 w 8363529"/>
                <a:gd name="connsiteY581" fmla="*/ 1249785 h 2372732"/>
                <a:gd name="connsiteX582" fmla="*/ 510174 w 8363529"/>
                <a:gd name="connsiteY582" fmla="*/ 1688392 h 2372732"/>
                <a:gd name="connsiteX583" fmla="*/ 501811 w 8363529"/>
                <a:gd name="connsiteY583" fmla="*/ 1778601 h 2372732"/>
                <a:gd name="connsiteX584" fmla="*/ 493458 w 8363529"/>
                <a:gd name="connsiteY584" fmla="*/ 1699967 h 2372732"/>
                <a:gd name="connsiteX585" fmla="*/ 426534 w 8363529"/>
                <a:gd name="connsiteY585" fmla="*/ 1347930 h 2372732"/>
                <a:gd name="connsiteX586" fmla="*/ 418181 w 8363529"/>
                <a:gd name="connsiteY586" fmla="*/ 1322409 h 2372732"/>
                <a:gd name="connsiteX587" fmla="*/ 409818 w 8363529"/>
                <a:gd name="connsiteY587" fmla="*/ 1369628 h 2372732"/>
                <a:gd name="connsiteX588" fmla="*/ 342895 w 8363529"/>
                <a:gd name="connsiteY588" fmla="*/ 1883317 h 2372732"/>
                <a:gd name="connsiteX589" fmla="*/ 334542 w 8363529"/>
                <a:gd name="connsiteY589" fmla="*/ 1971551 h 2372732"/>
                <a:gd name="connsiteX590" fmla="*/ 326189 w 8363529"/>
                <a:gd name="connsiteY590" fmla="*/ 1993288 h 2372732"/>
                <a:gd name="connsiteX591" fmla="*/ 259304 w 8363529"/>
                <a:gd name="connsiteY591" fmla="*/ 2194029 h 2372732"/>
                <a:gd name="connsiteX592" fmla="*/ 250903 w 8363529"/>
                <a:gd name="connsiteY592" fmla="*/ 2223101 h 2372732"/>
                <a:gd name="connsiteX593" fmla="*/ 242549 w 8363529"/>
                <a:gd name="connsiteY593" fmla="*/ 2168517 h 2372732"/>
                <a:gd name="connsiteX594" fmla="*/ 175665 w 8363529"/>
                <a:gd name="connsiteY594" fmla="*/ 1863390 h 2372732"/>
                <a:gd name="connsiteX595" fmla="*/ 167273 w 8363529"/>
                <a:gd name="connsiteY595" fmla="*/ 1836359 h 2372732"/>
                <a:gd name="connsiteX596" fmla="*/ 158920 w 8363529"/>
                <a:gd name="connsiteY596" fmla="*/ 1784533 h 2372732"/>
                <a:gd name="connsiteX597" fmla="*/ 92029 w 8363529"/>
                <a:gd name="connsiteY597" fmla="*/ 1306827 h 2372732"/>
                <a:gd name="connsiteX598" fmla="*/ 83635 w 8363529"/>
                <a:gd name="connsiteY598" fmla="*/ 1237872 h 2372732"/>
                <a:gd name="connsiteX599" fmla="*/ 75279 w 8363529"/>
                <a:gd name="connsiteY599" fmla="*/ 1302598 h 2372732"/>
                <a:gd name="connsiteX600" fmla="*/ 8394 w 8363529"/>
                <a:gd name="connsiteY600" fmla="*/ 1813945 h 2372732"/>
                <a:gd name="connsiteX601" fmla="*/ 0 w 8363529"/>
                <a:gd name="connsiteY601" fmla="*/ 1877036 h 23727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  <a:cxn ang="0">
                  <a:pos x="connsiteX466" y="connsiteY466"/>
                </a:cxn>
                <a:cxn ang="0">
                  <a:pos x="connsiteX467" y="connsiteY467"/>
                </a:cxn>
                <a:cxn ang="0">
                  <a:pos x="connsiteX468" y="connsiteY468"/>
                </a:cxn>
                <a:cxn ang="0">
                  <a:pos x="connsiteX469" y="connsiteY469"/>
                </a:cxn>
                <a:cxn ang="0">
                  <a:pos x="connsiteX470" y="connsiteY470"/>
                </a:cxn>
                <a:cxn ang="0">
                  <a:pos x="connsiteX471" y="connsiteY471"/>
                </a:cxn>
                <a:cxn ang="0">
                  <a:pos x="connsiteX472" y="connsiteY472"/>
                </a:cxn>
                <a:cxn ang="0">
                  <a:pos x="connsiteX473" y="connsiteY473"/>
                </a:cxn>
                <a:cxn ang="0">
                  <a:pos x="connsiteX474" y="connsiteY474"/>
                </a:cxn>
                <a:cxn ang="0">
                  <a:pos x="connsiteX475" y="connsiteY475"/>
                </a:cxn>
                <a:cxn ang="0">
                  <a:pos x="connsiteX476" y="connsiteY476"/>
                </a:cxn>
                <a:cxn ang="0">
                  <a:pos x="connsiteX477" y="connsiteY477"/>
                </a:cxn>
                <a:cxn ang="0">
                  <a:pos x="connsiteX478" y="connsiteY478"/>
                </a:cxn>
                <a:cxn ang="0">
                  <a:pos x="connsiteX479" y="connsiteY479"/>
                </a:cxn>
                <a:cxn ang="0">
                  <a:pos x="connsiteX480" y="connsiteY480"/>
                </a:cxn>
                <a:cxn ang="0">
                  <a:pos x="connsiteX481" y="connsiteY481"/>
                </a:cxn>
                <a:cxn ang="0">
                  <a:pos x="connsiteX482" y="connsiteY482"/>
                </a:cxn>
                <a:cxn ang="0">
                  <a:pos x="connsiteX483" y="connsiteY483"/>
                </a:cxn>
                <a:cxn ang="0">
                  <a:pos x="connsiteX484" y="connsiteY484"/>
                </a:cxn>
                <a:cxn ang="0">
                  <a:pos x="connsiteX485" y="connsiteY485"/>
                </a:cxn>
                <a:cxn ang="0">
                  <a:pos x="connsiteX486" y="connsiteY486"/>
                </a:cxn>
                <a:cxn ang="0">
                  <a:pos x="connsiteX487" y="connsiteY487"/>
                </a:cxn>
                <a:cxn ang="0">
                  <a:pos x="connsiteX488" y="connsiteY488"/>
                </a:cxn>
                <a:cxn ang="0">
                  <a:pos x="connsiteX489" y="connsiteY489"/>
                </a:cxn>
                <a:cxn ang="0">
                  <a:pos x="connsiteX490" y="connsiteY490"/>
                </a:cxn>
                <a:cxn ang="0">
                  <a:pos x="connsiteX491" y="connsiteY491"/>
                </a:cxn>
                <a:cxn ang="0">
                  <a:pos x="connsiteX492" y="connsiteY492"/>
                </a:cxn>
                <a:cxn ang="0">
                  <a:pos x="connsiteX493" y="connsiteY493"/>
                </a:cxn>
                <a:cxn ang="0">
                  <a:pos x="connsiteX494" y="connsiteY494"/>
                </a:cxn>
                <a:cxn ang="0">
                  <a:pos x="connsiteX495" y="connsiteY495"/>
                </a:cxn>
                <a:cxn ang="0">
                  <a:pos x="connsiteX496" y="connsiteY496"/>
                </a:cxn>
                <a:cxn ang="0">
                  <a:pos x="connsiteX497" y="connsiteY497"/>
                </a:cxn>
                <a:cxn ang="0">
                  <a:pos x="connsiteX498" y="connsiteY498"/>
                </a:cxn>
                <a:cxn ang="0">
                  <a:pos x="connsiteX499" y="connsiteY499"/>
                </a:cxn>
                <a:cxn ang="0">
                  <a:pos x="connsiteX500" y="connsiteY500"/>
                </a:cxn>
                <a:cxn ang="0">
                  <a:pos x="connsiteX501" y="connsiteY501"/>
                </a:cxn>
                <a:cxn ang="0">
                  <a:pos x="connsiteX502" y="connsiteY502"/>
                </a:cxn>
                <a:cxn ang="0">
                  <a:pos x="connsiteX503" y="connsiteY503"/>
                </a:cxn>
                <a:cxn ang="0">
                  <a:pos x="connsiteX504" y="connsiteY504"/>
                </a:cxn>
                <a:cxn ang="0">
                  <a:pos x="connsiteX505" y="connsiteY505"/>
                </a:cxn>
                <a:cxn ang="0">
                  <a:pos x="connsiteX506" y="connsiteY506"/>
                </a:cxn>
                <a:cxn ang="0">
                  <a:pos x="connsiteX507" y="connsiteY507"/>
                </a:cxn>
                <a:cxn ang="0">
                  <a:pos x="connsiteX508" y="connsiteY508"/>
                </a:cxn>
                <a:cxn ang="0">
                  <a:pos x="connsiteX509" y="connsiteY509"/>
                </a:cxn>
                <a:cxn ang="0">
                  <a:pos x="connsiteX510" y="connsiteY510"/>
                </a:cxn>
                <a:cxn ang="0">
                  <a:pos x="connsiteX511" y="connsiteY511"/>
                </a:cxn>
                <a:cxn ang="0">
                  <a:pos x="connsiteX512" y="connsiteY512"/>
                </a:cxn>
                <a:cxn ang="0">
                  <a:pos x="connsiteX513" y="connsiteY513"/>
                </a:cxn>
                <a:cxn ang="0">
                  <a:pos x="connsiteX514" y="connsiteY514"/>
                </a:cxn>
                <a:cxn ang="0">
                  <a:pos x="connsiteX515" y="connsiteY515"/>
                </a:cxn>
                <a:cxn ang="0">
                  <a:pos x="connsiteX516" y="connsiteY516"/>
                </a:cxn>
                <a:cxn ang="0">
                  <a:pos x="connsiteX517" y="connsiteY517"/>
                </a:cxn>
                <a:cxn ang="0">
                  <a:pos x="connsiteX518" y="connsiteY518"/>
                </a:cxn>
                <a:cxn ang="0">
                  <a:pos x="connsiteX519" y="connsiteY519"/>
                </a:cxn>
                <a:cxn ang="0">
                  <a:pos x="connsiteX520" y="connsiteY520"/>
                </a:cxn>
                <a:cxn ang="0">
                  <a:pos x="connsiteX521" y="connsiteY521"/>
                </a:cxn>
                <a:cxn ang="0">
                  <a:pos x="connsiteX522" y="connsiteY522"/>
                </a:cxn>
                <a:cxn ang="0">
                  <a:pos x="connsiteX523" y="connsiteY523"/>
                </a:cxn>
                <a:cxn ang="0">
                  <a:pos x="connsiteX524" y="connsiteY524"/>
                </a:cxn>
                <a:cxn ang="0">
                  <a:pos x="connsiteX525" y="connsiteY525"/>
                </a:cxn>
                <a:cxn ang="0">
                  <a:pos x="connsiteX526" y="connsiteY526"/>
                </a:cxn>
                <a:cxn ang="0">
                  <a:pos x="connsiteX527" y="connsiteY527"/>
                </a:cxn>
                <a:cxn ang="0">
                  <a:pos x="connsiteX528" y="connsiteY528"/>
                </a:cxn>
                <a:cxn ang="0">
                  <a:pos x="connsiteX529" y="connsiteY529"/>
                </a:cxn>
                <a:cxn ang="0">
                  <a:pos x="connsiteX530" y="connsiteY530"/>
                </a:cxn>
                <a:cxn ang="0">
                  <a:pos x="connsiteX531" y="connsiteY531"/>
                </a:cxn>
                <a:cxn ang="0">
                  <a:pos x="connsiteX532" y="connsiteY532"/>
                </a:cxn>
                <a:cxn ang="0">
                  <a:pos x="connsiteX533" y="connsiteY533"/>
                </a:cxn>
                <a:cxn ang="0">
                  <a:pos x="connsiteX534" y="connsiteY534"/>
                </a:cxn>
                <a:cxn ang="0">
                  <a:pos x="connsiteX535" y="connsiteY535"/>
                </a:cxn>
                <a:cxn ang="0">
                  <a:pos x="connsiteX536" y="connsiteY536"/>
                </a:cxn>
                <a:cxn ang="0">
                  <a:pos x="connsiteX537" y="connsiteY537"/>
                </a:cxn>
                <a:cxn ang="0">
                  <a:pos x="connsiteX538" y="connsiteY538"/>
                </a:cxn>
                <a:cxn ang="0">
                  <a:pos x="connsiteX539" y="connsiteY539"/>
                </a:cxn>
                <a:cxn ang="0">
                  <a:pos x="connsiteX540" y="connsiteY540"/>
                </a:cxn>
                <a:cxn ang="0">
                  <a:pos x="connsiteX541" y="connsiteY541"/>
                </a:cxn>
                <a:cxn ang="0">
                  <a:pos x="connsiteX542" y="connsiteY542"/>
                </a:cxn>
                <a:cxn ang="0">
                  <a:pos x="connsiteX543" y="connsiteY543"/>
                </a:cxn>
                <a:cxn ang="0">
                  <a:pos x="connsiteX544" y="connsiteY544"/>
                </a:cxn>
                <a:cxn ang="0">
                  <a:pos x="connsiteX545" y="connsiteY545"/>
                </a:cxn>
                <a:cxn ang="0">
                  <a:pos x="connsiteX546" y="connsiteY546"/>
                </a:cxn>
                <a:cxn ang="0">
                  <a:pos x="connsiteX547" y="connsiteY547"/>
                </a:cxn>
                <a:cxn ang="0">
                  <a:pos x="connsiteX548" y="connsiteY548"/>
                </a:cxn>
                <a:cxn ang="0">
                  <a:pos x="connsiteX549" y="connsiteY549"/>
                </a:cxn>
                <a:cxn ang="0">
                  <a:pos x="connsiteX550" y="connsiteY550"/>
                </a:cxn>
                <a:cxn ang="0">
                  <a:pos x="connsiteX551" y="connsiteY551"/>
                </a:cxn>
                <a:cxn ang="0">
                  <a:pos x="connsiteX552" y="connsiteY552"/>
                </a:cxn>
                <a:cxn ang="0">
                  <a:pos x="connsiteX553" y="connsiteY553"/>
                </a:cxn>
                <a:cxn ang="0">
                  <a:pos x="connsiteX554" y="connsiteY554"/>
                </a:cxn>
                <a:cxn ang="0">
                  <a:pos x="connsiteX555" y="connsiteY555"/>
                </a:cxn>
                <a:cxn ang="0">
                  <a:pos x="connsiteX556" y="connsiteY556"/>
                </a:cxn>
                <a:cxn ang="0">
                  <a:pos x="connsiteX557" y="connsiteY557"/>
                </a:cxn>
                <a:cxn ang="0">
                  <a:pos x="connsiteX558" y="connsiteY558"/>
                </a:cxn>
                <a:cxn ang="0">
                  <a:pos x="connsiteX559" y="connsiteY559"/>
                </a:cxn>
                <a:cxn ang="0">
                  <a:pos x="connsiteX560" y="connsiteY560"/>
                </a:cxn>
                <a:cxn ang="0">
                  <a:pos x="connsiteX561" y="connsiteY561"/>
                </a:cxn>
                <a:cxn ang="0">
                  <a:pos x="connsiteX562" y="connsiteY562"/>
                </a:cxn>
                <a:cxn ang="0">
                  <a:pos x="connsiteX563" y="connsiteY563"/>
                </a:cxn>
                <a:cxn ang="0">
                  <a:pos x="connsiteX564" y="connsiteY564"/>
                </a:cxn>
                <a:cxn ang="0">
                  <a:pos x="connsiteX565" y="connsiteY565"/>
                </a:cxn>
                <a:cxn ang="0">
                  <a:pos x="connsiteX566" y="connsiteY566"/>
                </a:cxn>
                <a:cxn ang="0">
                  <a:pos x="connsiteX567" y="connsiteY567"/>
                </a:cxn>
                <a:cxn ang="0">
                  <a:pos x="connsiteX568" y="connsiteY568"/>
                </a:cxn>
                <a:cxn ang="0">
                  <a:pos x="connsiteX569" y="connsiteY569"/>
                </a:cxn>
                <a:cxn ang="0">
                  <a:pos x="connsiteX570" y="connsiteY570"/>
                </a:cxn>
                <a:cxn ang="0">
                  <a:pos x="connsiteX571" y="connsiteY571"/>
                </a:cxn>
                <a:cxn ang="0">
                  <a:pos x="connsiteX572" y="connsiteY572"/>
                </a:cxn>
                <a:cxn ang="0">
                  <a:pos x="connsiteX573" y="connsiteY573"/>
                </a:cxn>
                <a:cxn ang="0">
                  <a:pos x="connsiteX574" y="connsiteY574"/>
                </a:cxn>
                <a:cxn ang="0">
                  <a:pos x="connsiteX575" y="connsiteY575"/>
                </a:cxn>
                <a:cxn ang="0">
                  <a:pos x="connsiteX576" y="connsiteY576"/>
                </a:cxn>
                <a:cxn ang="0">
                  <a:pos x="connsiteX577" y="connsiteY577"/>
                </a:cxn>
                <a:cxn ang="0">
                  <a:pos x="connsiteX578" y="connsiteY578"/>
                </a:cxn>
                <a:cxn ang="0">
                  <a:pos x="connsiteX579" y="connsiteY579"/>
                </a:cxn>
                <a:cxn ang="0">
                  <a:pos x="connsiteX580" y="connsiteY580"/>
                </a:cxn>
                <a:cxn ang="0">
                  <a:pos x="connsiteX581" y="connsiteY581"/>
                </a:cxn>
                <a:cxn ang="0">
                  <a:pos x="connsiteX582" y="connsiteY582"/>
                </a:cxn>
                <a:cxn ang="0">
                  <a:pos x="connsiteX583" y="connsiteY583"/>
                </a:cxn>
                <a:cxn ang="0">
                  <a:pos x="connsiteX584" y="connsiteY584"/>
                </a:cxn>
                <a:cxn ang="0">
                  <a:pos x="connsiteX585" y="connsiteY585"/>
                </a:cxn>
                <a:cxn ang="0">
                  <a:pos x="connsiteX586" y="connsiteY586"/>
                </a:cxn>
                <a:cxn ang="0">
                  <a:pos x="connsiteX587" y="connsiteY587"/>
                </a:cxn>
                <a:cxn ang="0">
                  <a:pos x="connsiteX588" y="connsiteY588"/>
                </a:cxn>
                <a:cxn ang="0">
                  <a:pos x="connsiteX589" y="connsiteY589"/>
                </a:cxn>
                <a:cxn ang="0">
                  <a:pos x="connsiteX590" y="connsiteY590"/>
                </a:cxn>
                <a:cxn ang="0">
                  <a:pos x="connsiteX591" y="connsiteY591"/>
                </a:cxn>
                <a:cxn ang="0">
                  <a:pos x="connsiteX592" y="connsiteY592"/>
                </a:cxn>
                <a:cxn ang="0">
                  <a:pos x="connsiteX593" y="connsiteY593"/>
                </a:cxn>
                <a:cxn ang="0">
                  <a:pos x="connsiteX594" y="connsiteY594"/>
                </a:cxn>
                <a:cxn ang="0">
                  <a:pos x="connsiteX595" y="connsiteY595"/>
                </a:cxn>
                <a:cxn ang="0">
                  <a:pos x="connsiteX596" y="connsiteY596"/>
                </a:cxn>
                <a:cxn ang="0">
                  <a:pos x="connsiteX597" y="connsiteY597"/>
                </a:cxn>
                <a:cxn ang="0">
                  <a:pos x="connsiteX598" y="connsiteY598"/>
                </a:cxn>
                <a:cxn ang="0">
                  <a:pos x="connsiteX599" y="connsiteY599"/>
                </a:cxn>
                <a:cxn ang="0">
                  <a:pos x="connsiteX600" y="connsiteY600"/>
                </a:cxn>
                <a:cxn ang="0">
                  <a:pos x="connsiteX601" y="connsiteY601"/>
                </a:cxn>
              </a:cxnLst>
              <a:rect l="l" t="t" r="r" b="b"/>
              <a:pathLst>
                <a:path w="8363529" h="2372732">
                  <a:moveTo>
                    <a:pt x="0" y="433543"/>
                  </a:moveTo>
                  <a:lnTo>
                    <a:pt x="8394" y="451428"/>
                  </a:lnTo>
                  <a:lnTo>
                    <a:pt x="75279" y="596366"/>
                  </a:lnTo>
                  <a:lnTo>
                    <a:pt x="83635" y="614706"/>
                  </a:lnTo>
                  <a:lnTo>
                    <a:pt x="92029" y="575423"/>
                  </a:lnTo>
                  <a:lnTo>
                    <a:pt x="158920" y="303306"/>
                  </a:lnTo>
                  <a:lnTo>
                    <a:pt x="167273" y="273779"/>
                  </a:lnTo>
                  <a:lnTo>
                    <a:pt x="175665" y="341447"/>
                  </a:lnTo>
                  <a:lnTo>
                    <a:pt x="242549" y="1105593"/>
                  </a:lnTo>
                  <a:lnTo>
                    <a:pt x="250903" y="1242266"/>
                  </a:lnTo>
                  <a:lnTo>
                    <a:pt x="259304" y="1208654"/>
                  </a:lnTo>
                  <a:lnTo>
                    <a:pt x="326189" y="976382"/>
                  </a:lnTo>
                  <a:lnTo>
                    <a:pt x="334542" y="951239"/>
                  </a:lnTo>
                  <a:lnTo>
                    <a:pt x="342895" y="851739"/>
                  </a:lnTo>
                  <a:lnTo>
                    <a:pt x="409818" y="272647"/>
                  </a:lnTo>
                  <a:lnTo>
                    <a:pt x="418181" y="219418"/>
                  </a:lnTo>
                  <a:lnTo>
                    <a:pt x="426534" y="247958"/>
                  </a:lnTo>
                  <a:lnTo>
                    <a:pt x="493458" y="641543"/>
                  </a:lnTo>
                  <a:lnTo>
                    <a:pt x="501811" y="729438"/>
                  </a:lnTo>
                  <a:lnTo>
                    <a:pt x="510174" y="725015"/>
                  </a:lnTo>
                  <a:lnTo>
                    <a:pt x="577097" y="703395"/>
                  </a:lnTo>
                  <a:lnTo>
                    <a:pt x="585450" y="701691"/>
                  </a:lnTo>
                  <a:lnTo>
                    <a:pt x="593803" y="680981"/>
                  </a:lnTo>
                  <a:lnTo>
                    <a:pt x="660727" y="441673"/>
                  </a:lnTo>
                  <a:lnTo>
                    <a:pt x="669089" y="397783"/>
                  </a:lnTo>
                  <a:lnTo>
                    <a:pt x="677443" y="422917"/>
                  </a:lnTo>
                  <a:lnTo>
                    <a:pt x="744366" y="590694"/>
                  </a:lnTo>
                  <a:lnTo>
                    <a:pt x="752719" y="608279"/>
                  </a:lnTo>
                  <a:lnTo>
                    <a:pt x="761082" y="582720"/>
                  </a:lnTo>
                  <a:lnTo>
                    <a:pt x="828005" y="423149"/>
                  </a:lnTo>
                  <a:lnTo>
                    <a:pt x="836358" y="407500"/>
                  </a:lnTo>
                  <a:lnTo>
                    <a:pt x="844712" y="404848"/>
                  </a:lnTo>
                  <a:lnTo>
                    <a:pt x="911635" y="379027"/>
                  </a:lnTo>
                  <a:lnTo>
                    <a:pt x="919988" y="375059"/>
                  </a:lnTo>
                  <a:lnTo>
                    <a:pt x="928351" y="397512"/>
                  </a:lnTo>
                  <a:lnTo>
                    <a:pt x="995274" y="535356"/>
                  </a:lnTo>
                  <a:lnTo>
                    <a:pt x="1003627" y="548663"/>
                  </a:lnTo>
                  <a:lnTo>
                    <a:pt x="1011981" y="568542"/>
                  </a:lnTo>
                  <a:lnTo>
                    <a:pt x="1078904" y="759953"/>
                  </a:lnTo>
                  <a:lnTo>
                    <a:pt x="1087267" y="788832"/>
                  </a:lnTo>
                  <a:lnTo>
                    <a:pt x="1095620" y="762024"/>
                  </a:lnTo>
                  <a:lnTo>
                    <a:pt x="1162543" y="535085"/>
                  </a:lnTo>
                  <a:lnTo>
                    <a:pt x="1170896" y="505073"/>
                  </a:lnTo>
                  <a:lnTo>
                    <a:pt x="1179259" y="482504"/>
                  </a:lnTo>
                  <a:lnTo>
                    <a:pt x="1246182" y="330376"/>
                  </a:lnTo>
                  <a:lnTo>
                    <a:pt x="1254536" y="314310"/>
                  </a:lnTo>
                  <a:lnTo>
                    <a:pt x="1262889" y="351358"/>
                  </a:lnTo>
                  <a:lnTo>
                    <a:pt x="1329812" y="820208"/>
                  </a:lnTo>
                  <a:lnTo>
                    <a:pt x="1338175" y="915256"/>
                  </a:lnTo>
                  <a:lnTo>
                    <a:pt x="1346528" y="921188"/>
                  </a:lnTo>
                  <a:lnTo>
                    <a:pt x="1413451" y="952342"/>
                  </a:lnTo>
                  <a:lnTo>
                    <a:pt x="1421805" y="954945"/>
                  </a:lnTo>
                  <a:lnTo>
                    <a:pt x="1430158" y="969424"/>
                  </a:lnTo>
                  <a:lnTo>
                    <a:pt x="1497091" y="1107074"/>
                  </a:lnTo>
                  <a:lnTo>
                    <a:pt x="1505444" y="1127601"/>
                  </a:lnTo>
                  <a:lnTo>
                    <a:pt x="1513797" y="1133117"/>
                  </a:lnTo>
                  <a:lnTo>
                    <a:pt x="1580720" y="1189298"/>
                  </a:lnTo>
                  <a:lnTo>
                    <a:pt x="1589074" y="1198299"/>
                  </a:lnTo>
                  <a:lnTo>
                    <a:pt x="1597437" y="1156141"/>
                  </a:lnTo>
                  <a:lnTo>
                    <a:pt x="1664360" y="933015"/>
                  </a:lnTo>
                  <a:lnTo>
                    <a:pt x="1672713" y="914230"/>
                  </a:lnTo>
                  <a:lnTo>
                    <a:pt x="1681066" y="899529"/>
                  </a:lnTo>
                  <a:lnTo>
                    <a:pt x="1747989" y="757379"/>
                  </a:lnTo>
                  <a:lnTo>
                    <a:pt x="1756352" y="735864"/>
                  </a:lnTo>
                  <a:lnTo>
                    <a:pt x="1764706" y="733300"/>
                  </a:lnTo>
                  <a:lnTo>
                    <a:pt x="1831629" y="711447"/>
                  </a:lnTo>
                  <a:lnTo>
                    <a:pt x="1839982" y="708534"/>
                  </a:lnTo>
                  <a:lnTo>
                    <a:pt x="1848345" y="717496"/>
                  </a:lnTo>
                  <a:lnTo>
                    <a:pt x="1915268" y="788793"/>
                  </a:lnTo>
                  <a:lnTo>
                    <a:pt x="1923621" y="797639"/>
                  </a:lnTo>
                  <a:lnTo>
                    <a:pt x="1931975" y="758172"/>
                  </a:lnTo>
                  <a:lnTo>
                    <a:pt x="1998898" y="513203"/>
                  </a:lnTo>
                  <a:lnTo>
                    <a:pt x="2007260" y="489269"/>
                  </a:lnTo>
                  <a:lnTo>
                    <a:pt x="2015614" y="496905"/>
                  </a:lnTo>
                  <a:lnTo>
                    <a:pt x="2082537" y="575994"/>
                  </a:lnTo>
                  <a:lnTo>
                    <a:pt x="2090890" y="588962"/>
                  </a:lnTo>
                  <a:lnTo>
                    <a:pt x="2099253" y="531794"/>
                  </a:lnTo>
                  <a:lnTo>
                    <a:pt x="2166176" y="138705"/>
                  </a:lnTo>
                  <a:lnTo>
                    <a:pt x="2174530" y="96364"/>
                  </a:lnTo>
                  <a:lnTo>
                    <a:pt x="2182883" y="161313"/>
                  </a:lnTo>
                  <a:lnTo>
                    <a:pt x="2249806" y="781419"/>
                  </a:lnTo>
                  <a:lnTo>
                    <a:pt x="2258159" y="874231"/>
                  </a:lnTo>
                  <a:lnTo>
                    <a:pt x="2266522" y="849474"/>
                  </a:lnTo>
                  <a:lnTo>
                    <a:pt x="2333445" y="688384"/>
                  </a:lnTo>
                  <a:lnTo>
                    <a:pt x="2341799" y="671903"/>
                  </a:lnTo>
                  <a:lnTo>
                    <a:pt x="2350152" y="671564"/>
                  </a:lnTo>
                  <a:lnTo>
                    <a:pt x="2417075" y="668912"/>
                  </a:lnTo>
                  <a:lnTo>
                    <a:pt x="2425438" y="668612"/>
                  </a:lnTo>
                  <a:lnTo>
                    <a:pt x="2433791" y="659650"/>
                  </a:lnTo>
                  <a:lnTo>
                    <a:pt x="2500714" y="591866"/>
                  </a:lnTo>
                  <a:lnTo>
                    <a:pt x="2509068" y="583852"/>
                  </a:lnTo>
                  <a:lnTo>
                    <a:pt x="2517430" y="595911"/>
                  </a:lnTo>
                  <a:lnTo>
                    <a:pt x="2584354" y="708795"/>
                  </a:lnTo>
                  <a:lnTo>
                    <a:pt x="2592707" y="725354"/>
                  </a:lnTo>
                  <a:lnTo>
                    <a:pt x="2601060" y="765663"/>
                  </a:lnTo>
                  <a:lnTo>
                    <a:pt x="2667983" y="1092063"/>
                  </a:lnTo>
                  <a:lnTo>
                    <a:pt x="2676346" y="1133388"/>
                  </a:lnTo>
                  <a:lnTo>
                    <a:pt x="2684699" y="1108622"/>
                  </a:lnTo>
                  <a:lnTo>
                    <a:pt x="2751623" y="874647"/>
                  </a:lnTo>
                  <a:lnTo>
                    <a:pt x="2759976" y="839980"/>
                  </a:lnTo>
                  <a:lnTo>
                    <a:pt x="2768329" y="850568"/>
                  </a:lnTo>
                  <a:lnTo>
                    <a:pt x="2835262" y="914114"/>
                  </a:lnTo>
                  <a:lnTo>
                    <a:pt x="2843615" y="920124"/>
                  </a:lnTo>
                  <a:lnTo>
                    <a:pt x="2851968" y="879941"/>
                  </a:lnTo>
                  <a:lnTo>
                    <a:pt x="2918892" y="549495"/>
                  </a:lnTo>
                  <a:lnTo>
                    <a:pt x="2927245" y="507038"/>
                  </a:lnTo>
                  <a:lnTo>
                    <a:pt x="2935608" y="576032"/>
                  </a:lnTo>
                  <a:lnTo>
                    <a:pt x="3002531" y="1105670"/>
                  </a:lnTo>
                  <a:lnTo>
                    <a:pt x="3010884" y="1169187"/>
                  </a:lnTo>
                  <a:lnTo>
                    <a:pt x="3019238" y="1114971"/>
                  </a:lnTo>
                  <a:lnTo>
                    <a:pt x="3086161" y="566161"/>
                  </a:lnTo>
                  <a:lnTo>
                    <a:pt x="3094523" y="478759"/>
                  </a:lnTo>
                  <a:lnTo>
                    <a:pt x="3102877" y="548469"/>
                  </a:lnTo>
                  <a:lnTo>
                    <a:pt x="3169800" y="945799"/>
                  </a:lnTo>
                  <a:lnTo>
                    <a:pt x="3178153" y="981637"/>
                  </a:lnTo>
                  <a:lnTo>
                    <a:pt x="3186516" y="949196"/>
                  </a:lnTo>
                  <a:lnTo>
                    <a:pt x="3253439" y="624761"/>
                  </a:lnTo>
                  <a:lnTo>
                    <a:pt x="3261792" y="573758"/>
                  </a:lnTo>
                  <a:lnTo>
                    <a:pt x="3270146" y="572364"/>
                  </a:lnTo>
                  <a:lnTo>
                    <a:pt x="3337069" y="548886"/>
                  </a:lnTo>
                  <a:lnTo>
                    <a:pt x="3345432" y="542159"/>
                  </a:lnTo>
                  <a:lnTo>
                    <a:pt x="3353785" y="512061"/>
                  </a:lnTo>
                  <a:lnTo>
                    <a:pt x="3420708" y="423710"/>
                  </a:lnTo>
                  <a:lnTo>
                    <a:pt x="3429061" y="419220"/>
                  </a:lnTo>
                  <a:lnTo>
                    <a:pt x="3437424" y="419675"/>
                  </a:lnTo>
                  <a:lnTo>
                    <a:pt x="3504347" y="423865"/>
                  </a:lnTo>
                  <a:lnTo>
                    <a:pt x="3512701" y="424475"/>
                  </a:lnTo>
                  <a:lnTo>
                    <a:pt x="3521054" y="403677"/>
                  </a:lnTo>
                  <a:lnTo>
                    <a:pt x="3587977" y="259601"/>
                  </a:lnTo>
                  <a:lnTo>
                    <a:pt x="3596330" y="243951"/>
                  </a:lnTo>
                  <a:lnTo>
                    <a:pt x="3604693" y="259717"/>
                  </a:lnTo>
                  <a:lnTo>
                    <a:pt x="3671616" y="426362"/>
                  </a:lnTo>
                  <a:lnTo>
                    <a:pt x="3679970" y="454148"/>
                  </a:lnTo>
                  <a:lnTo>
                    <a:pt x="3688323" y="439253"/>
                  </a:lnTo>
                  <a:lnTo>
                    <a:pt x="3755246" y="334953"/>
                  </a:lnTo>
                  <a:lnTo>
                    <a:pt x="3763609" y="323495"/>
                  </a:lnTo>
                  <a:lnTo>
                    <a:pt x="3771962" y="340886"/>
                  </a:lnTo>
                  <a:lnTo>
                    <a:pt x="3838885" y="493198"/>
                  </a:lnTo>
                  <a:lnTo>
                    <a:pt x="3847239" y="514064"/>
                  </a:lnTo>
                  <a:lnTo>
                    <a:pt x="3855602" y="480269"/>
                  </a:lnTo>
                  <a:lnTo>
                    <a:pt x="3922525" y="237380"/>
                  </a:lnTo>
                  <a:lnTo>
                    <a:pt x="3930878" y="210078"/>
                  </a:lnTo>
                  <a:lnTo>
                    <a:pt x="3939231" y="206720"/>
                  </a:lnTo>
                  <a:lnTo>
                    <a:pt x="4006154" y="182970"/>
                  </a:lnTo>
                  <a:lnTo>
                    <a:pt x="4014517" y="180367"/>
                  </a:lnTo>
                  <a:lnTo>
                    <a:pt x="4022871" y="223656"/>
                  </a:lnTo>
                  <a:lnTo>
                    <a:pt x="4089755" y="745059"/>
                  </a:lnTo>
                  <a:lnTo>
                    <a:pt x="4098147" y="845158"/>
                  </a:lnTo>
                  <a:lnTo>
                    <a:pt x="4106500" y="813666"/>
                  </a:lnTo>
                  <a:lnTo>
                    <a:pt x="4173394" y="652585"/>
                  </a:lnTo>
                  <a:lnTo>
                    <a:pt x="4181787" y="639433"/>
                  </a:lnTo>
                  <a:lnTo>
                    <a:pt x="4190140" y="674283"/>
                  </a:lnTo>
                  <a:lnTo>
                    <a:pt x="4257024" y="1022130"/>
                  </a:lnTo>
                  <a:lnTo>
                    <a:pt x="4265416" y="1076675"/>
                  </a:lnTo>
                  <a:lnTo>
                    <a:pt x="4273779" y="1036415"/>
                  </a:lnTo>
                  <a:lnTo>
                    <a:pt x="4340664" y="738932"/>
                  </a:lnTo>
                  <a:lnTo>
                    <a:pt x="4349055" y="704566"/>
                  </a:lnTo>
                  <a:lnTo>
                    <a:pt x="4357409" y="671448"/>
                  </a:lnTo>
                  <a:lnTo>
                    <a:pt x="4424303" y="408632"/>
                  </a:lnTo>
                  <a:lnTo>
                    <a:pt x="4432695" y="376046"/>
                  </a:lnTo>
                  <a:lnTo>
                    <a:pt x="4441048" y="362662"/>
                  </a:lnTo>
                  <a:lnTo>
                    <a:pt x="4507932" y="249506"/>
                  </a:lnTo>
                  <a:lnTo>
                    <a:pt x="4516324" y="234544"/>
                  </a:lnTo>
                  <a:lnTo>
                    <a:pt x="4524687" y="275782"/>
                  </a:lnTo>
                  <a:lnTo>
                    <a:pt x="4591572" y="643207"/>
                  </a:lnTo>
                  <a:lnTo>
                    <a:pt x="4599964" y="694433"/>
                  </a:lnTo>
                  <a:lnTo>
                    <a:pt x="4608317" y="676364"/>
                  </a:lnTo>
                  <a:lnTo>
                    <a:pt x="4675201" y="534785"/>
                  </a:lnTo>
                  <a:lnTo>
                    <a:pt x="4683603" y="517471"/>
                  </a:lnTo>
                  <a:lnTo>
                    <a:pt x="4691956" y="535462"/>
                  </a:lnTo>
                  <a:lnTo>
                    <a:pt x="4758840" y="663928"/>
                  </a:lnTo>
                  <a:lnTo>
                    <a:pt x="4767232" y="678290"/>
                  </a:lnTo>
                  <a:lnTo>
                    <a:pt x="4775595" y="720070"/>
                  </a:lnTo>
                  <a:lnTo>
                    <a:pt x="4842480" y="1157312"/>
                  </a:lnTo>
                  <a:lnTo>
                    <a:pt x="4850872" y="1229403"/>
                  </a:lnTo>
                  <a:lnTo>
                    <a:pt x="4859225" y="1191563"/>
                  </a:lnTo>
                  <a:lnTo>
                    <a:pt x="4926109" y="993580"/>
                  </a:lnTo>
                  <a:lnTo>
                    <a:pt x="4934501" y="977098"/>
                  </a:lnTo>
                  <a:lnTo>
                    <a:pt x="4942864" y="969123"/>
                  </a:lnTo>
                  <a:lnTo>
                    <a:pt x="5009749" y="897139"/>
                  </a:lnTo>
                  <a:lnTo>
                    <a:pt x="5018141" y="886977"/>
                  </a:lnTo>
                  <a:lnTo>
                    <a:pt x="5026494" y="895290"/>
                  </a:lnTo>
                  <a:lnTo>
                    <a:pt x="5093388" y="974185"/>
                  </a:lnTo>
                  <a:lnTo>
                    <a:pt x="5101780" y="985944"/>
                  </a:lnTo>
                  <a:lnTo>
                    <a:pt x="5110134" y="931282"/>
                  </a:lnTo>
                  <a:lnTo>
                    <a:pt x="5177018" y="615122"/>
                  </a:lnTo>
                  <a:lnTo>
                    <a:pt x="5185410" y="586233"/>
                  </a:lnTo>
                  <a:lnTo>
                    <a:pt x="5193773" y="532249"/>
                  </a:lnTo>
                  <a:lnTo>
                    <a:pt x="5260657" y="63663"/>
                  </a:lnTo>
                  <a:lnTo>
                    <a:pt x="5269049" y="0"/>
                  </a:lnTo>
                  <a:lnTo>
                    <a:pt x="5277403" y="88085"/>
                  </a:lnTo>
                  <a:lnTo>
                    <a:pt x="5344287" y="903226"/>
                  </a:lnTo>
                  <a:lnTo>
                    <a:pt x="5352650" y="1021327"/>
                  </a:lnTo>
                  <a:lnTo>
                    <a:pt x="5361042" y="999938"/>
                  </a:lnTo>
                  <a:lnTo>
                    <a:pt x="5427926" y="577242"/>
                  </a:lnTo>
                  <a:lnTo>
                    <a:pt x="5436280" y="431656"/>
                  </a:lnTo>
                  <a:lnTo>
                    <a:pt x="5444672" y="647369"/>
                  </a:lnTo>
                  <a:lnTo>
                    <a:pt x="5511566" y="1358924"/>
                  </a:lnTo>
                  <a:lnTo>
                    <a:pt x="5519919" y="1398807"/>
                  </a:lnTo>
                  <a:lnTo>
                    <a:pt x="5528311" y="1284907"/>
                  </a:lnTo>
                  <a:lnTo>
                    <a:pt x="5595195" y="654134"/>
                  </a:lnTo>
                  <a:lnTo>
                    <a:pt x="5603558" y="598718"/>
                  </a:lnTo>
                  <a:lnTo>
                    <a:pt x="5611950" y="570816"/>
                  </a:lnTo>
                  <a:lnTo>
                    <a:pt x="5678835" y="348483"/>
                  </a:lnTo>
                  <a:lnTo>
                    <a:pt x="5687188" y="320814"/>
                  </a:lnTo>
                  <a:lnTo>
                    <a:pt x="5695580" y="414720"/>
                  </a:lnTo>
                  <a:lnTo>
                    <a:pt x="5762474" y="1480809"/>
                  </a:lnTo>
                  <a:lnTo>
                    <a:pt x="5770827" y="1672665"/>
                  </a:lnTo>
                  <a:lnTo>
                    <a:pt x="5779219" y="1511430"/>
                  </a:lnTo>
                  <a:lnTo>
                    <a:pt x="5846103" y="570584"/>
                  </a:lnTo>
                  <a:lnTo>
                    <a:pt x="5854457" y="483898"/>
                  </a:lnTo>
                  <a:lnTo>
                    <a:pt x="5862858" y="553647"/>
                  </a:lnTo>
                  <a:lnTo>
                    <a:pt x="5929743" y="1463234"/>
                  </a:lnTo>
                  <a:lnTo>
                    <a:pt x="5938096" y="1653997"/>
                  </a:lnTo>
                  <a:lnTo>
                    <a:pt x="5946488" y="1504094"/>
                  </a:lnTo>
                  <a:lnTo>
                    <a:pt x="6013372" y="748339"/>
                  </a:lnTo>
                  <a:lnTo>
                    <a:pt x="6021735" y="687407"/>
                  </a:lnTo>
                  <a:lnTo>
                    <a:pt x="6030127" y="663550"/>
                  </a:lnTo>
                  <a:lnTo>
                    <a:pt x="6097011" y="447305"/>
                  </a:lnTo>
                  <a:lnTo>
                    <a:pt x="6105365" y="416568"/>
                  </a:lnTo>
                  <a:lnTo>
                    <a:pt x="6113767" y="462355"/>
                  </a:lnTo>
                  <a:lnTo>
                    <a:pt x="6180651" y="778099"/>
                  </a:lnTo>
                  <a:lnTo>
                    <a:pt x="6189004" y="812233"/>
                  </a:lnTo>
                  <a:lnTo>
                    <a:pt x="6197396" y="803920"/>
                  </a:lnTo>
                  <a:lnTo>
                    <a:pt x="6264280" y="719276"/>
                  </a:lnTo>
                  <a:lnTo>
                    <a:pt x="6272644" y="705698"/>
                  </a:lnTo>
                  <a:lnTo>
                    <a:pt x="6281036" y="737645"/>
                  </a:lnTo>
                  <a:lnTo>
                    <a:pt x="6347920" y="954723"/>
                  </a:lnTo>
                  <a:lnTo>
                    <a:pt x="6356273" y="977814"/>
                  </a:lnTo>
                  <a:lnTo>
                    <a:pt x="6364665" y="968175"/>
                  </a:lnTo>
                  <a:lnTo>
                    <a:pt x="6431560" y="897448"/>
                  </a:lnTo>
                  <a:lnTo>
                    <a:pt x="6439913" y="889357"/>
                  </a:lnTo>
                  <a:lnTo>
                    <a:pt x="6448305" y="860362"/>
                  </a:lnTo>
                  <a:lnTo>
                    <a:pt x="6515189" y="599811"/>
                  </a:lnTo>
                  <a:lnTo>
                    <a:pt x="6523542" y="563141"/>
                  </a:lnTo>
                  <a:lnTo>
                    <a:pt x="6531944" y="660676"/>
                  </a:lnTo>
                  <a:lnTo>
                    <a:pt x="6598829" y="1532644"/>
                  </a:lnTo>
                  <a:lnTo>
                    <a:pt x="6607182" y="1654597"/>
                  </a:lnTo>
                  <a:lnTo>
                    <a:pt x="6615535" y="1504017"/>
                  </a:lnTo>
                  <a:lnTo>
                    <a:pt x="6682458" y="664189"/>
                  </a:lnTo>
                  <a:lnTo>
                    <a:pt x="6690821" y="589940"/>
                  </a:lnTo>
                  <a:lnTo>
                    <a:pt x="6699174" y="640710"/>
                  </a:lnTo>
                  <a:lnTo>
                    <a:pt x="6766097" y="1149260"/>
                  </a:lnTo>
                  <a:lnTo>
                    <a:pt x="6774451" y="1229336"/>
                  </a:lnTo>
                  <a:lnTo>
                    <a:pt x="6782814" y="1236023"/>
                  </a:lnTo>
                  <a:lnTo>
                    <a:pt x="6849737" y="1298137"/>
                  </a:lnTo>
                  <a:lnTo>
                    <a:pt x="6858090" y="1307215"/>
                  </a:lnTo>
                  <a:lnTo>
                    <a:pt x="6866443" y="1146163"/>
                  </a:lnTo>
                  <a:lnTo>
                    <a:pt x="6933366" y="278318"/>
                  </a:lnTo>
                  <a:lnTo>
                    <a:pt x="6941729" y="204030"/>
                  </a:lnTo>
                  <a:lnTo>
                    <a:pt x="6950083" y="197874"/>
                  </a:lnTo>
                  <a:lnTo>
                    <a:pt x="7017006" y="137987"/>
                  </a:lnTo>
                  <a:lnTo>
                    <a:pt x="7025359" y="128838"/>
                  </a:lnTo>
                  <a:lnTo>
                    <a:pt x="7033712" y="180667"/>
                  </a:lnTo>
                  <a:lnTo>
                    <a:pt x="7100645" y="623967"/>
                  </a:lnTo>
                  <a:lnTo>
                    <a:pt x="7108998" y="683245"/>
                  </a:lnTo>
                  <a:lnTo>
                    <a:pt x="7117351" y="663889"/>
                  </a:lnTo>
                  <a:lnTo>
                    <a:pt x="7184274" y="502838"/>
                  </a:lnTo>
                  <a:lnTo>
                    <a:pt x="7192628" y="481895"/>
                  </a:lnTo>
                  <a:lnTo>
                    <a:pt x="7200991" y="509003"/>
                  </a:lnTo>
                  <a:lnTo>
                    <a:pt x="7267914" y="709366"/>
                  </a:lnTo>
                  <a:lnTo>
                    <a:pt x="7276267" y="732545"/>
                  </a:lnTo>
                  <a:lnTo>
                    <a:pt x="7284620" y="729061"/>
                  </a:lnTo>
                  <a:lnTo>
                    <a:pt x="7351543" y="699688"/>
                  </a:lnTo>
                  <a:lnTo>
                    <a:pt x="7359906" y="695797"/>
                  </a:lnTo>
                  <a:lnTo>
                    <a:pt x="7368260" y="666464"/>
                  </a:lnTo>
                  <a:lnTo>
                    <a:pt x="7435183" y="470668"/>
                  </a:lnTo>
                  <a:lnTo>
                    <a:pt x="7443536" y="450180"/>
                  </a:lnTo>
                  <a:lnTo>
                    <a:pt x="7451899" y="462461"/>
                  </a:lnTo>
                  <a:lnTo>
                    <a:pt x="7518822" y="580755"/>
                  </a:lnTo>
                  <a:lnTo>
                    <a:pt x="7527175" y="598601"/>
                  </a:lnTo>
                  <a:lnTo>
                    <a:pt x="7535528" y="607070"/>
                  </a:lnTo>
                  <a:lnTo>
                    <a:pt x="7602452" y="664005"/>
                  </a:lnTo>
                  <a:lnTo>
                    <a:pt x="7610815" y="669977"/>
                  </a:lnTo>
                  <a:lnTo>
                    <a:pt x="7619168" y="677874"/>
                  </a:lnTo>
                  <a:lnTo>
                    <a:pt x="7686091" y="746491"/>
                  </a:lnTo>
                  <a:lnTo>
                    <a:pt x="7694444" y="755830"/>
                  </a:lnTo>
                  <a:lnTo>
                    <a:pt x="7702798" y="748949"/>
                  </a:lnTo>
                  <a:lnTo>
                    <a:pt x="7769731" y="681164"/>
                  </a:lnTo>
                  <a:lnTo>
                    <a:pt x="7778084" y="670693"/>
                  </a:lnTo>
                  <a:lnTo>
                    <a:pt x="7786437" y="650204"/>
                  </a:lnTo>
                  <a:lnTo>
                    <a:pt x="7853360" y="550173"/>
                  </a:lnTo>
                  <a:lnTo>
                    <a:pt x="7861713" y="542343"/>
                  </a:lnTo>
                  <a:lnTo>
                    <a:pt x="7870077" y="550473"/>
                  </a:lnTo>
                  <a:lnTo>
                    <a:pt x="7937000" y="641852"/>
                  </a:lnTo>
                  <a:lnTo>
                    <a:pt x="7945353" y="658063"/>
                  </a:lnTo>
                  <a:lnTo>
                    <a:pt x="7953706" y="680071"/>
                  </a:lnTo>
                  <a:lnTo>
                    <a:pt x="8020629" y="847926"/>
                  </a:lnTo>
                  <a:lnTo>
                    <a:pt x="8028992" y="867921"/>
                  </a:lnTo>
                  <a:lnTo>
                    <a:pt x="8037346" y="857294"/>
                  </a:lnTo>
                  <a:lnTo>
                    <a:pt x="8104268" y="759605"/>
                  </a:lnTo>
                  <a:lnTo>
                    <a:pt x="8112622" y="745620"/>
                  </a:lnTo>
                  <a:lnTo>
                    <a:pt x="8120985" y="701391"/>
                  </a:lnTo>
                  <a:lnTo>
                    <a:pt x="8187908" y="467416"/>
                  </a:lnTo>
                  <a:lnTo>
                    <a:pt x="8196261" y="447721"/>
                  </a:lnTo>
                  <a:lnTo>
                    <a:pt x="8204614" y="449154"/>
                  </a:lnTo>
                  <a:lnTo>
                    <a:pt x="8271537" y="464242"/>
                  </a:lnTo>
                  <a:lnTo>
                    <a:pt x="8279900" y="466700"/>
                  </a:lnTo>
                  <a:lnTo>
                    <a:pt x="8288254" y="504764"/>
                  </a:lnTo>
                  <a:lnTo>
                    <a:pt x="8355177" y="812156"/>
                  </a:lnTo>
                  <a:lnTo>
                    <a:pt x="8363530" y="850984"/>
                  </a:lnTo>
                  <a:lnTo>
                    <a:pt x="8363530" y="1916890"/>
                  </a:lnTo>
                  <a:lnTo>
                    <a:pt x="8355177" y="1853489"/>
                  </a:lnTo>
                  <a:lnTo>
                    <a:pt x="8288254" y="1351327"/>
                  </a:lnTo>
                  <a:lnTo>
                    <a:pt x="8279900" y="1289214"/>
                  </a:lnTo>
                  <a:lnTo>
                    <a:pt x="8271537" y="1428296"/>
                  </a:lnTo>
                  <a:lnTo>
                    <a:pt x="8204614" y="2275914"/>
                  </a:lnTo>
                  <a:lnTo>
                    <a:pt x="8196261" y="2357277"/>
                  </a:lnTo>
                  <a:lnTo>
                    <a:pt x="8187908" y="2304610"/>
                  </a:lnTo>
                  <a:lnTo>
                    <a:pt x="8120985" y="1679285"/>
                  </a:lnTo>
                  <a:lnTo>
                    <a:pt x="8112622" y="1561107"/>
                  </a:lnTo>
                  <a:lnTo>
                    <a:pt x="8104268" y="1603942"/>
                  </a:lnTo>
                  <a:lnTo>
                    <a:pt x="8037346" y="1902179"/>
                  </a:lnTo>
                  <a:lnTo>
                    <a:pt x="8028992" y="1934688"/>
                  </a:lnTo>
                  <a:lnTo>
                    <a:pt x="8020629" y="1933332"/>
                  </a:lnTo>
                  <a:lnTo>
                    <a:pt x="7953706" y="1921796"/>
                  </a:lnTo>
                  <a:lnTo>
                    <a:pt x="7945353" y="1920287"/>
                  </a:lnTo>
                  <a:lnTo>
                    <a:pt x="7937000" y="1928455"/>
                  </a:lnTo>
                  <a:lnTo>
                    <a:pt x="7870077" y="1974648"/>
                  </a:lnTo>
                  <a:lnTo>
                    <a:pt x="7861713" y="1978771"/>
                  </a:lnTo>
                  <a:lnTo>
                    <a:pt x="7853360" y="1942294"/>
                  </a:lnTo>
                  <a:lnTo>
                    <a:pt x="7786437" y="1476879"/>
                  </a:lnTo>
                  <a:lnTo>
                    <a:pt x="7778084" y="1381648"/>
                  </a:lnTo>
                  <a:lnTo>
                    <a:pt x="7769731" y="1459750"/>
                  </a:lnTo>
                  <a:lnTo>
                    <a:pt x="7702798" y="1964108"/>
                  </a:lnTo>
                  <a:lnTo>
                    <a:pt x="7694444" y="2015257"/>
                  </a:lnTo>
                  <a:lnTo>
                    <a:pt x="7686091" y="1907173"/>
                  </a:lnTo>
                  <a:lnTo>
                    <a:pt x="7619168" y="1110926"/>
                  </a:lnTo>
                  <a:lnTo>
                    <a:pt x="7610815" y="1019217"/>
                  </a:lnTo>
                  <a:lnTo>
                    <a:pt x="7602452" y="1092673"/>
                  </a:lnTo>
                  <a:lnTo>
                    <a:pt x="7535528" y="1791598"/>
                  </a:lnTo>
                  <a:lnTo>
                    <a:pt x="7527175" y="1895830"/>
                  </a:lnTo>
                  <a:lnTo>
                    <a:pt x="7518822" y="1856741"/>
                  </a:lnTo>
                  <a:lnTo>
                    <a:pt x="7451899" y="1597622"/>
                  </a:lnTo>
                  <a:lnTo>
                    <a:pt x="7443536" y="1570708"/>
                  </a:lnTo>
                  <a:lnTo>
                    <a:pt x="7435183" y="1574182"/>
                  </a:lnTo>
                  <a:lnTo>
                    <a:pt x="7368260" y="1607455"/>
                  </a:lnTo>
                  <a:lnTo>
                    <a:pt x="7359906" y="1612410"/>
                  </a:lnTo>
                  <a:lnTo>
                    <a:pt x="7351543" y="1607871"/>
                  </a:lnTo>
                  <a:lnTo>
                    <a:pt x="7284620" y="1573543"/>
                  </a:lnTo>
                  <a:lnTo>
                    <a:pt x="7276267" y="1569498"/>
                  </a:lnTo>
                  <a:lnTo>
                    <a:pt x="7267914" y="1536002"/>
                  </a:lnTo>
                  <a:lnTo>
                    <a:pt x="7200991" y="1246611"/>
                  </a:lnTo>
                  <a:lnTo>
                    <a:pt x="7192628" y="1207483"/>
                  </a:lnTo>
                  <a:lnTo>
                    <a:pt x="7184274" y="1168500"/>
                  </a:lnTo>
                  <a:lnTo>
                    <a:pt x="7117351" y="868830"/>
                  </a:lnTo>
                  <a:lnTo>
                    <a:pt x="7108998" y="832838"/>
                  </a:lnTo>
                  <a:lnTo>
                    <a:pt x="7100645" y="807617"/>
                  </a:lnTo>
                  <a:lnTo>
                    <a:pt x="7033712" y="619167"/>
                  </a:lnTo>
                  <a:lnTo>
                    <a:pt x="7025359" y="597121"/>
                  </a:lnTo>
                  <a:lnTo>
                    <a:pt x="7017006" y="721957"/>
                  </a:lnTo>
                  <a:lnTo>
                    <a:pt x="6950083" y="1538499"/>
                  </a:lnTo>
                  <a:lnTo>
                    <a:pt x="6941729" y="1622311"/>
                  </a:lnTo>
                  <a:lnTo>
                    <a:pt x="6933366" y="1614830"/>
                  </a:lnTo>
                  <a:lnTo>
                    <a:pt x="6866443" y="1527234"/>
                  </a:lnTo>
                  <a:lnTo>
                    <a:pt x="6858090" y="1510975"/>
                  </a:lnTo>
                  <a:lnTo>
                    <a:pt x="6849737" y="1519482"/>
                  </a:lnTo>
                  <a:lnTo>
                    <a:pt x="6782814" y="1577850"/>
                  </a:lnTo>
                  <a:lnTo>
                    <a:pt x="6774451" y="1584131"/>
                  </a:lnTo>
                  <a:lnTo>
                    <a:pt x="6766097" y="1657471"/>
                  </a:lnTo>
                  <a:lnTo>
                    <a:pt x="6699174" y="2123224"/>
                  </a:lnTo>
                  <a:lnTo>
                    <a:pt x="6690821" y="2169689"/>
                  </a:lnTo>
                  <a:lnTo>
                    <a:pt x="6682458" y="2143829"/>
                  </a:lnTo>
                  <a:lnTo>
                    <a:pt x="6615535" y="1851254"/>
                  </a:lnTo>
                  <a:lnTo>
                    <a:pt x="6607182" y="1798818"/>
                  </a:lnTo>
                  <a:lnTo>
                    <a:pt x="6598829" y="1855299"/>
                  </a:lnTo>
                  <a:lnTo>
                    <a:pt x="6531944" y="2259133"/>
                  </a:lnTo>
                  <a:lnTo>
                    <a:pt x="6523542" y="2304309"/>
                  </a:lnTo>
                  <a:lnTo>
                    <a:pt x="6515189" y="2292096"/>
                  </a:lnTo>
                  <a:lnTo>
                    <a:pt x="6448305" y="2205410"/>
                  </a:lnTo>
                  <a:lnTo>
                    <a:pt x="6439913" y="2195771"/>
                  </a:lnTo>
                  <a:lnTo>
                    <a:pt x="6431560" y="2116043"/>
                  </a:lnTo>
                  <a:lnTo>
                    <a:pt x="6364665" y="1419450"/>
                  </a:lnTo>
                  <a:lnTo>
                    <a:pt x="6356273" y="1324258"/>
                  </a:lnTo>
                  <a:lnTo>
                    <a:pt x="6347920" y="1396959"/>
                  </a:lnTo>
                  <a:lnTo>
                    <a:pt x="6281036" y="2079712"/>
                  </a:lnTo>
                  <a:lnTo>
                    <a:pt x="6272644" y="2180237"/>
                  </a:lnTo>
                  <a:lnTo>
                    <a:pt x="6264280" y="2065534"/>
                  </a:lnTo>
                  <a:lnTo>
                    <a:pt x="6197396" y="1350495"/>
                  </a:lnTo>
                  <a:lnTo>
                    <a:pt x="6189004" y="1280368"/>
                  </a:lnTo>
                  <a:lnTo>
                    <a:pt x="6180651" y="1236972"/>
                  </a:lnTo>
                  <a:lnTo>
                    <a:pt x="6113767" y="834996"/>
                  </a:lnTo>
                  <a:lnTo>
                    <a:pt x="6105365" y="776735"/>
                  </a:lnTo>
                  <a:lnTo>
                    <a:pt x="6097011" y="882699"/>
                  </a:lnTo>
                  <a:lnTo>
                    <a:pt x="6030127" y="1628853"/>
                  </a:lnTo>
                  <a:lnTo>
                    <a:pt x="6021735" y="1711116"/>
                  </a:lnTo>
                  <a:lnTo>
                    <a:pt x="6013372" y="1752818"/>
                  </a:lnTo>
                  <a:lnTo>
                    <a:pt x="5946488" y="2270136"/>
                  </a:lnTo>
                  <a:lnTo>
                    <a:pt x="5938096" y="2372733"/>
                  </a:lnTo>
                  <a:lnTo>
                    <a:pt x="5929743" y="2265336"/>
                  </a:lnTo>
                  <a:lnTo>
                    <a:pt x="5862858" y="1753196"/>
                  </a:lnTo>
                  <a:lnTo>
                    <a:pt x="5854457" y="1713913"/>
                  </a:lnTo>
                  <a:lnTo>
                    <a:pt x="5846103" y="1749218"/>
                  </a:lnTo>
                  <a:lnTo>
                    <a:pt x="5779219" y="2132109"/>
                  </a:lnTo>
                  <a:lnTo>
                    <a:pt x="5770827" y="2197735"/>
                  </a:lnTo>
                  <a:lnTo>
                    <a:pt x="5762474" y="2080090"/>
                  </a:lnTo>
                  <a:lnTo>
                    <a:pt x="5695580" y="1426331"/>
                  </a:lnTo>
                  <a:lnTo>
                    <a:pt x="5687188" y="1368757"/>
                  </a:lnTo>
                  <a:lnTo>
                    <a:pt x="5678835" y="1417640"/>
                  </a:lnTo>
                  <a:lnTo>
                    <a:pt x="5611950" y="1810354"/>
                  </a:lnTo>
                  <a:lnTo>
                    <a:pt x="5603558" y="1859654"/>
                  </a:lnTo>
                  <a:lnTo>
                    <a:pt x="5595195" y="1882223"/>
                  </a:lnTo>
                  <a:lnTo>
                    <a:pt x="5528311" y="2139135"/>
                  </a:lnTo>
                  <a:lnTo>
                    <a:pt x="5519919" y="2185522"/>
                  </a:lnTo>
                  <a:lnTo>
                    <a:pt x="5511566" y="2173695"/>
                  </a:lnTo>
                  <a:lnTo>
                    <a:pt x="5444672" y="1962212"/>
                  </a:lnTo>
                  <a:lnTo>
                    <a:pt x="5436280" y="1898095"/>
                  </a:lnTo>
                  <a:lnTo>
                    <a:pt x="5427926" y="1821387"/>
                  </a:lnTo>
                  <a:lnTo>
                    <a:pt x="5361042" y="1598793"/>
                  </a:lnTo>
                  <a:lnTo>
                    <a:pt x="5352650" y="1587528"/>
                  </a:lnTo>
                  <a:lnTo>
                    <a:pt x="5344287" y="1491396"/>
                  </a:lnTo>
                  <a:lnTo>
                    <a:pt x="5277403" y="828299"/>
                  </a:lnTo>
                  <a:lnTo>
                    <a:pt x="5269049" y="756624"/>
                  </a:lnTo>
                  <a:lnTo>
                    <a:pt x="5260657" y="866827"/>
                  </a:lnTo>
                  <a:lnTo>
                    <a:pt x="5193773" y="1678453"/>
                  </a:lnTo>
                  <a:lnTo>
                    <a:pt x="5185410" y="1771865"/>
                  </a:lnTo>
                  <a:lnTo>
                    <a:pt x="5177018" y="1752432"/>
                  </a:lnTo>
                  <a:lnTo>
                    <a:pt x="5110134" y="1539370"/>
                  </a:lnTo>
                  <a:lnTo>
                    <a:pt x="5101780" y="1502507"/>
                  </a:lnTo>
                  <a:lnTo>
                    <a:pt x="5093388" y="1564282"/>
                  </a:lnTo>
                  <a:lnTo>
                    <a:pt x="5026494" y="1979003"/>
                  </a:lnTo>
                  <a:lnTo>
                    <a:pt x="5018141" y="2022660"/>
                  </a:lnTo>
                  <a:lnTo>
                    <a:pt x="5009749" y="2036916"/>
                  </a:lnTo>
                  <a:lnTo>
                    <a:pt x="4942864" y="2137858"/>
                  </a:lnTo>
                  <a:lnTo>
                    <a:pt x="4934501" y="2149045"/>
                  </a:lnTo>
                  <a:lnTo>
                    <a:pt x="4926109" y="2127947"/>
                  </a:lnTo>
                  <a:lnTo>
                    <a:pt x="4859225" y="1874926"/>
                  </a:lnTo>
                  <a:lnTo>
                    <a:pt x="4850872" y="1826497"/>
                  </a:lnTo>
                  <a:lnTo>
                    <a:pt x="4842480" y="1709674"/>
                  </a:lnTo>
                  <a:lnTo>
                    <a:pt x="4775595" y="1001332"/>
                  </a:lnTo>
                  <a:lnTo>
                    <a:pt x="4767232" y="933625"/>
                  </a:lnTo>
                  <a:lnTo>
                    <a:pt x="4758840" y="980466"/>
                  </a:lnTo>
                  <a:lnTo>
                    <a:pt x="4691956" y="1399949"/>
                  </a:lnTo>
                  <a:lnTo>
                    <a:pt x="4683603" y="1458695"/>
                  </a:lnTo>
                  <a:lnTo>
                    <a:pt x="4675201" y="1444594"/>
                  </a:lnTo>
                  <a:lnTo>
                    <a:pt x="4608317" y="1329097"/>
                  </a:lnTo>
                  <a:lnTo>
                    <a:pt x="4599964" y="1314318"/>
                  </a:lnTo>
                  <a:lnTo>
                    <a:pt x="4591572" y="1332232"/>
                  </a:lnTo>
                  <a:lnTo>
                    <a:pt x="4524687" y="1460543"/>
                  </a:lnTo>
                  <a:lnTo>
                    <a:pt x="4516324" y="1474954"/>
                  </a:lnTo>
                  <a:lnTo>
                    <a:pt x="4507932" y="1508633"/>
                  </a:lnTo>
                  <a:lnTo>
                    <a:pt x="4441048" y="1763735"/>
                  </a:lnTo>
                  <a:lnTo>
                    <a:pt x="4432695" y="1793911"/>
                  </a:lnTo>
                  <a:lnTo>
                    <a:pt x="4424303" y="1727791"/>
                  </a:lnTo>
                  <a:lnTo>
                    <a:pt x="4357409" y="1194359"/>
                  </a:lnTo>
                  <a:lnTo>
                    <a:pt x="4349055" y="1127107"/>
                  </a:lnTo>
                  <a:lnTo>
                    <a:pt x="4340664" y="1211112"/>
                  </a:lnTo>
                  <a:lnTo>
                    <a:pt x="4273779" y="1938433"/>
                  </a:lnTo>
                  <a:lnTo>
                    <a:pt x="4265416" y="2036916"/>
                  </a:lnTo>
                  <a:lnTo>
                    <a:pt x="4257024" y="1993820"/>
                  </a:lnTo>
                  <a:lnTo>
                    <a:pt x="4190140" y="1719207"/>
                  </a:lnTo>
                  <a:lnTo>
                    <a:pt x="4181787" y="1691721"/>
                  </a:lnTo>
                  <a:lnTo>
                    <a:pt x="4173394" y="1721394"/>
                  </a:lnTo>
                  <a:lnTo>
                    <a:pt x="4106500" y="2084735"/>
                  </a:lnTo>
                  <a:lnTo>
                    <a:pt x="4098147" y="2155772"/>
                  </a:lnTo>
                  <a:lnTo>
                    <a:pt x="4089755" y="2066628"/>
                  </a:lnTo>
                  <a:lnTo>
                    <a:pt x="4022871" y="1602316"/>
                  </a:lnTo>
                  <a:lnTo>
                    <a:pt x="4014517" y="1563749"/>
                  </a:lnTo>
                  <a:lnTo>
                    <a:pt x="4006154" y="1539903"/>
                  </a:lnTo>
                  <a:lnTo>
                    <a:pt x="3939231" y="1323425"/>
                  </a:lnTo>
                  <a:lnTo>
                    <a:pt x="3930878" y="1292698"/>
                  </a:lnTo>
                  <a:lnTo>
                    <a:pt x="3922525" y="1337526"/>
                  </a:lnTo>
                  <a:lnTo>
                    <a:pt x="3855602" y="1736289"/>
                  </a:lnTo>
                  <a:lnTo>
                    <a:pt x="3847239" y="1791753"/>
                  </a:lnTo>
                  <a:lnTo>
                    <a:pt x="3838885" y="1672365"/>
                  </a:lnTo>
                  <a:lnTo>
                    <a:pt x="3771962" y="800775"/>
                  </a:lnTo>
                  <a:lnTo>
                    <a:pt x="3763609" y="701275"/>
                  </a:lnTo>
                  <a:lnTo>
                    <a:pt x="3755246" y="799759"/>
                  </a:lnTo>
                  <a:lnTo>
                    <a:pt x="3688323" y="1696860"/>
                  </a:lnTo>
                  <a:lnTo>
                    <a:pt x="3679970" y="1824794"/>
                  </a:lnTo>
                  <a:lnTo>
                    <a:pt x="3671616" y="1760677"/>
                  </a:lnTo>
                  <a:lnTo>
                    <a:pt x="3604693" y="1376277"/>
                  </a:lnTo>
                  <a:lnTo>
                    <a:pt x="3596330" y="1339946"/>
                  </a:lnTo>
                  <a:lnTo>
                    <a:pt x="3587977" y="1335600"/>
                  </a:lnTo>
                  <a:lnTo>
                    <a:pt x="3521054" y="1295562"/>
                  </a:lnTo>
                  <a:lnTo>
                    <a:pt x="3512701" y="1289784"/>
                  </a:lnTo>
                  <a:lnTo>
                    <a:pt x="3504347" y="1233826"/>
                  </a:lnTo>
                  <a:lnTo>
                    <a:pt x="3437424" y="843987"/>
                  </a:lnTo>
                  <a:lnTo>
                    <a:pt x="3429061" y="801501"/>
                  </a:lnTo>
                  <a:lnTo>
                    <a:pt x="3420708" y="791968"/>
                  </a:lnTo>
                  <a:lnTo>
                    <a:pt x="3353785" y="605705"/>
                  </a:lnTo>
                  <a:lnTo>
                    <a:pt x="3345432" y="542159"/>
                  </a:lnTo>
                  <a:lnTo>
                    <a:pt x="3337069" y="866140"/>
                  </a:lnTo>
                  <a:lnTo>
                    <a:pt x="3270146" y="2000430"/>
                  </a:lnTo>
                  <a:lnTo>
                    <a:pt x="3261792" y="2067160"/>
                  </a:lnTo>
                  <a:lnTo>
                    <a:pt x="3253439" y="2046439"/>
                  </a:lnTo>
                  <a:lnTo>
                    <a:pt x="3186516" y="1914615"/>
                  </a:lnTo>
                  <a:lnTo>
                    <a:pt x="3178153" y="1901424"/>
                  </a:lnTo>
                  <a:lnTo>
                    <a:pt x="3169800" y="1875110"/>
                  </a:lnTo>
                  <a:lnTo>
                    <a:pt x="3102877" y="1583337"/>
                  </a:lnTo>
                  <a:lnTo>
                    <a:pt x="3094523" y="1532151"/>
                  </a:lnTo>
                  <a:lnTo>
                    <a:pt x="3086161" y="1547161"/>
                  </a:lnTo>
                  <a:lnTo>
                    <a:pt x="3019238" y="1641328"/>
                  </a:lnTo>
                  <a:lnTo>
                    <a:pt x="3010884" y="1650629"/>
                  </a:lnTo>
                  <a:lnTo>
                    <a:pt x="3002531" y="1670585"/>
                  </a:lnTo>
                  <a:lnTo>
                    <a:pt x="2935608" y="1837191"/>
                  </a:lnTo>
                  <a:lnTo>
                    <a:pt x="2927245" y="1858889"/>
                  </a:lnTo>
                  <a:lnTo>
                    <a:pt x="2918892" y="1847324"/>
                  </a:lnTo>
                  <a:lnTo>
                    <a:pt x="2851968" y="1757164"/>
                  </a:lnTo>
                  <a:lnTo>
                    <a:pt x="2843615" y="1746199"/>
                  </a:lnTo>
                  <a:lnTo>
                    <a:pt x="2835262" y="1751299"/>
                  </a:lnTo>
                  <a:lnTo>
                    <a:pt x="2768329" y="1804799"/>
                  </a:lnTo>
                  <a:lnTo>
                    <a:pt x="2759976" y="1813683"/>
                  </a:lnTo>
                  <a:lnTo>
                    <a:pt x="2751623" y="1791453"/>
                  </a:lnTo>
                  <a:lnTo>
                    <a:pt x="2684699" y="1641251"/>
                  </a:lnTo>
                  <a:lnTo>
                    <a:pt x="2676346" y="1625340"/>
                  </a:lnTo>
                  <a:lnTo>
                    <a:pt x="2667983" y="1596945"/>
                  </a:lnTo>
                  <a:lnTo>
                    <a:pt x="2601060" y="1372464"/>
                  </a:lnTo>
                  <a:lnTo>
                    <a:pt x="2592707" y="1344746"/>
                  </a:lnTo>
                  <a:lnTo>
                    <a:pt x="2584354" y="1340439"/>
                  </a:lnTo>
                  <a:lnTo>
                    <a:pt x="2517430" y="1311066"/>
                  </a:lnTo>
                  <a:lnTo>
                    <a:pt x="2509068" y="1307892"/>
                  </a:lnTo>
                  <a:lnTo>
                    <a:pt x="2500714" y="1357869"/>
                  </a:lnTo>
                  <a:lnTo>
                    <a:pt x="2433791" y="1780827"/>
                  </a:lnTo>
                  <a:lnTo>
                    <a:pt x="2425438" y="1836775"/>
                  </a:lnTo>
                  <a:lnTo>
                    <a:pt x="2417075" y="1854283"/>
                  </a:lnTo>
                  <a:lnTo>
                    <a:pt x="2350152" y="2001611"/>
                  </a:lnTo>
                  <a:lnTo>
                    <a:pt x="2341799" y="2020996"/>
                  </a:lnTo>
                  <a:lnTo>
                    <a:pt x="2333445" y="1975596"/>
                  </a:lnTo>
                  <a:lnTo>
                    <a:pt x="2266522" y="1530825"/>
                  </a:lnTo>
                  <a:lnTo>
                    <a:pt x="2258159" y="1462440"/>
                  </a:lnTo>
                  <a:lnTo>
                    <a:pt x="2249806" y="1408756"/>
                  </a:lnTo>
                  <a:lnTo>
                    <a:pt x="2182883" y="1050061"/>
                  </a:lnTo>
                  <a:lnTo>
                    <a:pt x="2174530" y="1012481"/>
                  </a:lnTo>
                  <a:lnTo>
                    <a:pt x="2166176" y="1030482"/>
                  </a:lnTo>
                  <a:lnTo>
                    <a:pt x="2099253" y="1197127"/>
                  </a:lnTo>
                  <a:lnTo>
                    <a:pt x="2090890" y="1221351"/>
                  </a:lnTo>
                  <a:lnTo>
                    <a:pt x="2082537" y="1298059"/>
                  </a:lnTo>
                  <a:lnTo>
                    <a:pt x="2015614" y="1766610"/>
                  </a:lnTo>
                  <a:lnTo>
                    <a:pt x="2007260" y="1811680"/>
                  </a:lnTo>
                  <a:lnTo>
                    <a:pt x="1998898" y="1803551"/>
                  </a:lnTo>
                  <a:lnTo>
                    <a:pt x="1931975" y="1720078"/>
                  </a:lnTo>
                  <a:lnTo>
                    <a:pt x="1923621" y="1706616"/>
                  </a:lnTo>
                  <a:lnTo>
                    <a:pt x="1915268" y="1692360"/>
                  </a:lnTo>
                  <a:lnTo>
                    <a:pt x="1848345" y="1577289"/>
                  </a:lnTo>
                  <a:lnTo>
                    <a:pt x="1839982" y="1562772"/>
                  </a:lnTo>
                  <a:lnTo>
                    <a:pt x="1831629" y="1582921"/>
                  </a:lnTo>
                  <a:lnTo>
                    <a:pt x="1764706" y="1734179"/>
                  </a:lnTo>
                  <a:lnTo>
                    <a:pt x="1756352" y="1751947"/>
                  </a:lnTo>
                  <a:lnTo>
                    <a:pt x="1747989" y="1770162"/>
                  </a:lnTo>
                  <a:lnTo>
                    <a:pt x="1681066" y="1890382"/>
                  </a:lnTo>
                  <a:lnTo>
                    <a:pt x="1672713" y="1902827"/>
                  </a:lnTo>
                  <a:lnTo>
                    <a:pt x="1664360" y="1915941"/>
                  </a:lnTo>
                  <a:lnTo>
                    <a:pt x="1597437" y="2071805"/>
                  </a:lnTo>
                  <a:lnTo>
                    <a:pt x="1589074" y="2101294"/>
                  </a:lnTo>
                  <a:lnTo>
                    <a:pt x="1580720" y="2069618"/>
                  </a:lnTo>
                  <a:lnTo>
                    <a:pt x="1513797" y="1871751"/>
                  </a:lnTo>
                  <a:lnTo>
                    <a:pt x="1505444" y="1852318"/>
                  </a:lnTo>
                  <a:lnTo>
                    <a:pt x="1497091" y="1844227"/>
                  </a:lnTo>
                  <a:lnTo>
                    <a:pt x="1430158" y="1790011"/>
                  </a:lnTo>
                  <a:lnTo>
                    <a:pt x="1421805" y="1784340"/>
                  </a:lnTo>
                  <a:lnTo>
                    <a:pt x="1413451" y="1762003"/>
                  </a:lnTo>
                  <a:lnTo>
                    <a:pt x="1346528" y="1495481"/>
                  </a:lnTo>
                  <a:lnTo>
                    <a:pt x="1338175" y="1444778"/>
                  </a:lnTo>
                  <a:lnTo>
                    <a:pt x="1329812" y="1402059"/>
                  </a:lnTo>
                  <a:lnTo>
                    <a:pt x="1262889" y="1191456"/>
                  </a:lnTo>
                  <a:lnTo>
                    <a:pt x="1254536" y="1174820"/>
                  </a:lnTo>
                  <a:lnTo>
                    <a:pt x="1246182" y="1205518"/>
                  </a:lnTo>
                  <a:lnTo>
                    <a:pt x="1179259" y="1495936"/>
                  </a:lnTo>
                  <a:lnTo>
                    <a:pt x="1170896" y="1538993"/>
                  </a:lnTo>
                  <a:lnTo>
                    <a:pt x="1162543" y="1533322"/>
                  </a:lnTo>
                  <a:lnTo>
                    <a:pt x="1095620" y="1490525"/>
                  </a:lnTo>
                  <a:lnTo>
                    <a:pt x="1087267" y="1485454"/>
                  </a:lnTo>
                  <a:lnTo>
                    <a:pt x="1078904" y="1511391"/>
                  </a:lnTo>
                  <a:lnTo>
                    <a:pt x="1011981" y="1683176"/>
                  </a:lnTo>
                  <a:lnTo>
                    <a:pt x="1003627" y="1701061"/>
                  </a:lnTo>
                  <a:lnTo>
                    <a:pt x="995274" y="1663220"/>
                  </a:lnTo>
                  <a:lnTo>
                    <a:pt x="928351" y="1271406"/>
                  </a:lnTo>
                  <a:lnTo>
                    <a:pt x="919988" y="1207560"/>
                  </a:lnTo>
                  <a:lnTo>
                    <a:pt x="911635" y="1284636"/>
                  </a:lnTo>
                  <a:lnTo>
                    <a:pt x="844712" y="1784679"/>
                  </a:lnTo>
                  <a:lnTo>
                    <a:pt x="836358" y="1835604"/>
                  </a:lnTo>
                  <a:lnTo>
                    <a:pt x="828005" y="1838324"/>
                  </a:lnTo>
                  <a:lnTo>
                    <a:pt x="761082" y="1866119"/>
                  </a:lnTo>
                  <a:lnTo>
                    <a:pt x="752719" y="1870542"/>
                  </a:lnTo>
                  <a:lnTo>
                    <a:pt x="744366" y="1812542"/>
                  </a:lnTo>
                  <a:lnTo>
                    <a:pt x="677443" y="1258409"/>
                  </a:lnTo>
                  <a:lnTo>
                    <a:pt x="669089" y="1175381"/>
                  </a:lnTo>
                  <a:lnTo>
                    <a:pt x="660727" y="1181207"/>
                  </a:lnTo>
                  <a:lnTo>
                    <a:pt x="593803" y="1212854"/>
                  </a:lnTo>
                  <a:lnTo>
                    <a:pt x="585450" y="1215574"/>
                  </a:lnTo>
                  <a:lnTo>
                    <a:pt x="577097" y="1249785"/>
                  </a:lnTo>
                  <a:lnTo>
                    <a:pt x="510174" y="1688392"/>
                  </a:lnTo>
                  <a:lnTo>
                    <a:pt x="501811" y="1778601"/>
                  </a:lnTo>
                  <a:lnTo>
                    <a:pt x="493458" y="1699967"/>
                  </a:lnTo>
                  <a:lnTo>
                    <a:pt x="426534" y="1347930"/>
                  </a:lnTo>
                  <a:lnTo>
                    <a:pt x="418181" y="1322409"/>
                  </a:lnTo>
                  <a:lnTo>
                    <a:pt x="409818" y="1369628"/>
                  </a:lnTo>
                  <a:lnTo>
                    <a:pt x="342895" y="1883317"/>
                  </a:lnTo>
                  <a:lnTo>
                    <a:pt x="334542" y="1971551"/>
                  </a:lnTo>
                  <a:lnTo>
                    <a:pt x="326189" y="1993288"/>
                  </a:lnTo>
                  <a:lnTo>
                    <a:pt x="259304" y="2194029"/>
                  </a:lnTo>
                  <a:lnTo>
                    <a:pt x="250903" y="2223101"/>
                  </a:lnTo>
                  <a:lnTo>
                    <a:pt x="242549" y="2168517"/>
                  </a:lnTo>
                  <a:lnTo>
                    <a:pt x="175665" y="1863390"/>
                  </a:lnTo>
                  <a:lnTo>
                    <a:pt x="167273" y="1836359"/>
                  </a:lnTo>
                  <a:lnTo>
                    <a:pt x="158920" y="1784533"/>
                  </a:lnTo>
                  <a:lnTo>
                    <a:pt x="92029" y="1306827"/>
                  </a:lnTo>
                  <a:lnTo>
                    <a:pt x="83635" y="1237872"/>
                  </a:lnTo>
                  <a:lnTo>
                    <a:pt x="75279" y="1302598"/>
                  </a:lnTo>
                  <a:lnTo>
                    <a:pt x="8394" y="1813945"/>
                  </a:lnTo>
                  <a:lnTo>
                    <a:pt x="0" y="1877036"/>
                  </a:lnTo>
                  <a:close/>
                </a:path>
              </a:pathLst>
            </a:custGeom>
            <a:solidFill>
              <a:srgbClr val="FFFFB3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2999" name="Freeform: Shape 2998">
              <a:extLst>
                <a:ext uri="{FF2B5EF4-FFF2-40B4-BE49-F238E27FC236}">
                  <a16:creationId xmlns:a16="http://schemas.microsoft.com/office/drawing/2014/main" id="{FD68D124-F4F0-9242-C360-EFC79DF67B1A}"/>
                </a:ext>
              </a:extLst>
            </p:cNvPr>
            <p:cNvSpPr/>
            <p:nvPr/>
          </p:nvSpPr>
          <p:spPr>
            <a:xfrm>
              <a:off x="1961705" y="1673353"/>
              <a:ext cx="8363529" cy="2481118"/>
            </a:xfrm>
            <a:custGeom>
              <a:avLst/>
              <a:gdLst>
                <a:gd name="connsiteX0" fmla="*/ 0 w 8363529"/>
                <a:gd name="connsiteY0" fmla="*/ 1334876 h 2481118"/>
                <a:gd name="connsiteX1" fmla="*/ 8394 w 8363529"/>
                <a:gd name="connsiteY1" fmla="*/ 1271785 h 2481118"/>
                <a:gd name="connsiteX2" fmla="*/ 75279 w 8363529"/>
                <a:gd name="connsiteY2" fmla="*/ 760439 h 2481118"/>
                <a:gd name="connsiteX3" fmla="*/ 83635 w 8363529"/>
                <a:gd name="connsiteY3" fmla="*/ 695712 h 2481118"/>
                <a:gd name="connsiteX4" fmla="*/ 92029 w 8363529"/>
                <a:gd name="connsiteY4" fmla="*/ 764668 h 2481118"/>
                <a:gd name="connsiteX5" fmla="*/ 158920 w 8363529"/>
                <a:gd name="connsiteY5" fmla="*/ 1242374 h 2481118"/>
                <a:gd name="connsiteX6" fmla="*/ 167273 w 8363529"/>
                <a:gd name="connsiteY6" fmla="*/ 1294200 h 2481118"/>
                <a:gd name="connsiteX7" fmla="*/ 175665 w 8363529"/>
                <a:gd name="connsiteY7" fmla="*/ 1321230 h 2481118"/>
                <a:gd name="connsiteX8" fmla="*/ 242549 w 8363529"/>
                <a:gd name="connsiteY8" fmla="*/ 1626358 h 2481118"/>
                <a:gd name="connsiteX9" fmla="*/ 250903 w 8363529"/>
                <a:gd name="connsiteY9" fmla="*/ 1680942 h 2481118"/>
                <a:gd name="connsiteX10" fmla="*/ 259304 w 8363529"/>
                <a:gd name="connsiteY10" fmla="*/ 1651869 h 2481118"/>
                <a:gd name="connsiteX11" fmla="*/ 326189 w 8363529"/>
                <a:gd name="connsiteY11" fmla="*/ 1451128 h 2481118"/>
                <a:gd name="connsiteX12" fmla="*/ 334542 w 8363529"/>
                <a:gd name="connsiteY12" fmla="*/ 1429392 h 2481118"/>
                <a:gd name="connsiteX13" fmla="*/ 342895 w 8363529"/>
                <a:gd name="connsiteY13" fmla="*/ 1341157 h 2481118"/>
                <a:gd name="connsiteX14" fmla="*/ 409818 w 8363529"/>
                <a:gd name="connsiteY14" fmla="*/ 827469 h 2481118"/>
                <a:gd name="connsiteX15" fmla="*/ 418181 w 8363529"/>
                <a:gd name="connsiteY15" fmla="*/ 780250 h 2481118"/>
                <a:gd name="connsiteX16" fmla="*/ 426534 w 8363529"/>
                <a:gd name="connsiteY16" fmla="*/ 805771 h 2481118"/>
                <a:gd name="connsiteX17" fmla="*/ 493458 w 8363529"/>
                <a:gd name="connsiteY17" fmla="*/ 1157808 h 2481118"/>
                <a:gd name="connsiteX18" fmla="*/ 501811 w 8363529"/>
                <a:gd name="connsiteY18" fmla="*/ 1236441 h 2481118"/>
                <a:gd name="connsiteX19" fmla="*/ 510174 w 8363529"/>
                <a:gd name="connsiteY19" fmla="*/ 1146233 h 2481118"/>
                <a:gd name="connsiteX20" fmla="*/ 577097 w 8363529"/>
                <a:gd name="connsiteY20" fmla="*/ 707626 h 2481118"/>
                <a:gd name="connsiteX21" fmla="*/ 585450 w 8363529"/>
                <a:gd name="connsiteY21" fmla="*/ 673414 h 2481118"/>
                <a:gd name="connsiteX22" fmla="*/ 593803 w 8363529"/>
                <a:gd name="connsiteY22" fmla="*/ 670695 h 2481118"/>
                <a:gd name="connsiteX23" fmla="*/ 660727 w 8363529"/>
                <a:gd name="connsiteY23" fmla="*/ 639048 h 2481118"/>
                <a:gd name="connsiteX24" fmla="*/ 669089 w 8363529"/>
                <a:gd name="connsiteY24" fmla="*/ 633222 h 2481118"/>
                <a:gd name="connsiteX25" fmla="*/ 677443 w 8363529"/>
                <a:gd name="connsiteY25" fmla="*/ 716249 h 2481118"/>
                <a:gd name="connsiteX26" fmla="*/ 744366 w 8363529"/>
                <a:gd name="connsiteY26" fmla="*/ 1270382 h 2481118"/>
                <a:gd name="connsiteX27" fmla="*/ 752719 w 8363529"/>
                <a:gd name="connsiteY27" fmla="*/ 1328382 h 2481118"/>
                <a:gd name="connsiteX28" fmla="*/ 761082 w 8363529"/>
                <a:gd name="connsiteY28" fmla="*/ 1323959 h 2481118"/>
                <a:gd name="connsiteX29" fmla="*/ 828005 w 8363529"/>
                <a:gd name="connsiteY29" fmla="*/ 1296164 h 2481118"/>
                <a:gd name="connsiteX30" fmla="*/ 836358 w 8363529"/>
                <a:gd name="connsiteY30" fmla="*/ 1293445 h 2481118"/>
                <a:gd name="connsiteX31" fmla="*/ 844712 w 8363529"/>
                <a:gd name="connsiteY31" fmla="*/ 1242519 h 2481118"/>
                <a:gd name="connsiteX32" fmla="*/ 911635 w 8363529"/>
                <a:gd name="connsiteY32" fmla="*/ 742476 h 2481118"/>
                <a:gd name="connsiteX33" fmla="*/ 919988 w 8363529"/>
                <a:gd name="connsiteY33" fmla="*/ 665401 h 2481118"/>
                <a:gd name="connsiteX34" fmla="*/ 928351 w 8363529"/>
                <a:gd name="connsiteY34" fmla="*/ 729247 h 2481118"/>
                <a:gd name="connsiteX35" fmla="*/ 995274 w 8363529"/>
                <a:gd name="connsiteY35" fmla="*/ 1121060 h 2481118"/>
                <a:gd name="connsiteX36" fmla="*/ 1003627 w 8363529"/>
                <a:gd name="connsiteY36" fmla="*/ 1158901 h 2481118"/>
                <a:gd name="connsiteX37" fmla="*/ 1011981 w 8363529"/>
                <a:gd name="connsiteY37" fmla="*/ 1141016 h 2481118"/>
                <a:gd name="connsiteX38" fmla="*/ 1078904 w 8363529"/>
                <a:gd name="connsiteY38" fmla="*/ 969232 h 2481118"/>
                <a:gd name="connsiteX39" fmla="*/ 1087267 w 8363529"/>
                <a:gd name="connsiteY39" fmla="*/ 943295 h 2481118"/>
                <a:gd name="connsiteX40" fmla="*/ 1095620 w 8363529"/>
                <a:gd name="connsiteY40" fmla="*/ 948366 h 2481118"/>
                <a:gd name="connsiteX41" fmla="*/ 1162543 w 8363529"/>
                <a:gd name="connsiteY41" fmla="*/ 991162 h 2481118"/>
                <a:gd name="connsiteX42" fmla="*/ 1170896 w 8363529"/>
                <a:gd name="connsiteY42" fmla="*/ 996834 h 2481118"/>
                <a:gd name="connsiteX43" fmla="*/ 1179259 w 8363529"/>
                <a:gd name="connsiteY43" fmla="*/ 953776 h 2481118"/>
                <a:gd name="connsiteX44" fmla="*/ 1246182 w 8363529"/>
                <a:gd name="connsiteY44" fmla="*/ 663359 h 2481118"/>
                <a:gd name="connsiteX45" fmla="*/ 1254536 w 8363529"/>
                <a:gd name="connsiteY45" fmla="*/ 632660 h 2481118"/>
                <a:gd name="connsiteX46" fmla="*/ 1262889 w 8363529"/>
                <a:gd name="connsiteY46" fmla="*/ 649297 h 2481118"/>
                <a:gd name="connsiteX47" fmla="*/ 1329812 w 8363529"/>
                <a:gd name="connsiteY47" fmla="*/ 859900 h 2481118"/>
                <a:gd name="connsiteX48" fmla="*/ 1338175 w 8363529"/>
                <a:gd name="connsiteY48" fmla="*/ 902618 h 2481118"/>
                <a:gd name="connsiteX49" fmla="*/ 1346528 w 8363529"/>
                <a:gd name="connsiteY49" fmla="*/ 953321 h 2481118"/>
                <a:gd name="connsiteX50" fmla="*/ 1413451 w 8363529"/>
                <a:gd name="connsiteY50" fmla="*/ 1219844 h 2481118"/>
                <a:gd name="connsiteX51" fmla="*/ 1421805 w 8363529"/>
                <a:gd name="connsiteY51" fmla="*/ 1242181 h 2481118"/>
                <a:gd name="connsiteX52" fmla="*/ 1430158 w 8363529"/>
                <a:gd name="connsiteY52" fmla="*/ 1247852 h 2481118"/>
                <a:gd name="connsiteX53" fmla="*/ 1497091 w 8363529"/>
                <a:gd name="connsiteY53" fmla="*/ 1302068 h 2481118"/>
                <a:gd name="connsiteX54" fmla="*/ 1505444 w 8363529"/>
                <a:gd name="connsiteY54" fmla="*/ 1310159 h 2481118"/>
                <a:gd name="connsiteX55" fmla="*/ 1513797 w 8363529"/>
                <a:gd name="connsiteY55" fmla="*/ 1329592 h 2481118"/>
                <a:gd name="connsiteX56" fmla="*/ 1580720 w 8363529"/>
                <a:gd name="connsiteY56" fmla="*/ 1527459 h 2481118"/>
                <a:gd name="connsiteX57" fmla="*/ 1589074 w 8363529"/>
                <a:gd name="connsiteY57" fmla="*/ 1559135 h 2481118"/>
                <a:gd name="connsiteX58" fmla="*/ 1597437 w 8363529"/>
                <a:gd name="connsiteY58" fmla="*/ 1529646 h 2481118"/>
                <a:gd name="connsiteX59" fmla="*/ 1664360 w 8363529"/>
                <a:gd name="connsiteY59" fmla="*/ 1373782 h 2481118"/>
                <a:gd name="connsiteX60" fmla="*/ 1672713 w 8363529"/>
                <a:gd name="connsiteY60" fmla="*/ 1360668 h 2481118"/>
                <a:gd name="connsiteX61" fmla="*/ 1681066 w 8363529"/>
                <a:gd name="connsiteY61" fmla="*/ 1348222 h 2481118"/>
                <a:gd name="connsiteX62" fmla="*/ 1747989 w 8363529"/>
                <a:gd name="connsiteY62" fmla="*/ 1228002 h 2481118"/>
                <a:gd name="connsiteX63" fmla="*/ 1756352 w 8363529"/>
                <a:gd name="connsiteY63" fmla="*/ 1209788 h 2481118"/>
                <a:gd name="connsiteX64" fmla="*/ 1764706 w 8363529"/>
                <a:gd name="connsiteY64" fmla="*/ 1192019 h 2481118"/>
                <a:gd name="connsiteX65" fmla="*/ 1831629 w 8363529"/>
                <a:gd name="connsiteY65" fmla="*/ 1040762 h 2481118"/>
                <a:gd name="connsiteX66" fmla="*/ 1839982 w 8363529"/>
                <a:gd name="connsiteY66" fmla="*/ 1020612 h 2481118"/>
                <a:gd name="connsiteX67" fmla="*/ 1848345 w 8363529"/>
                <a:gd name="connsiteY67" fmla="*/ 1035129 h 2481118"/>
                <a:gd name="connsiteX68" fmla="*/ 1915268 w 8363529"/>
                <a:gd name="connsiteY68" fmla="*/ 1150201 h 2481118"/>
                <a:gd name="connsiteX69" fmla="*/ 1923621 w 8363529"/>
                <a:gd name="connsiteY69" fmla="*/ 1164457 h 2481118"/>
                <a:gd name="connsiteX70" fmla="*/ 1931975 w 8363529"/>
                <a:gd name="connsiteY70" fmla="*/ 1177919 h 2481118"/>
                <a:gd name="connsiteX71" fmla="*/ 1998898 w 8363529"/>
                <a:gd name="connsiteY71" fmla="*/ 1261391 h 2481118"/>
                <a:gd name="connsiteX72" fmla="*/ 2007260 w 8363529"/>
                <a:gd name="connsiteY72" fmla="*/ 1269521 h 2481118"/>
                <a:gd name="connsiteX73" fmla="*/ 2015614 w 8363529"/>
                <a:gd name="connsiteY73" fmla="*/ 1224450 h 2481118"/>
                <a:gd name="connsiteX74" fmla="*/ 2082537 w 8363529"/>
                <a:gd name="connsiteY74" fmla="*/ 755900 h 2481118"/>
                <a:gd name="connsiteX75" fmla="*/ 2090890 w 8363529"/>
                <a:gd name="connsiteY75" fmla="*/ 679192 h 2481118"/>
                <a:gd name="connsiteX76" fmla="*/ 2099253 w 8363529"/>
                <a:gd name="connsiteY76" fmla="*/ 654968 h 2481118"/>
                <a:gd name="connsiteX77" fmla="*/ 2166176 w 8363529"/>
                <a:gd name="connsiteY77" fmla="*/ 488323 h 2481118"/>
                <a:gd name="connsiteX78" fmla="*/ 2174530 w 8363529"/>
                <a:gd name="connsiteY78" fmla="*/ 470322 h 2481118"/>
                <a:gd name="connsiteX79" fmla="*/ 2182883 w 8363529"/>
                <a:gd name="connsiteY79" fmla="*/ 507901 h 2481118"/>
                <a:gd name="connsiteX80" fmla="*/ 2249806 w 8363529"/>
                <a:gd name="connsiteY80" fmla="*/ 866597 h 2481118"/>
                <a:gd name="connsiteX81" fmla="*/ 2258159 w 8363529"/>
                <a:gd name="connsiteY81" fmla="*/ 920281 h 2481118"/>
                <a:gd name="connsiteX82" fmla="*/ 2266522 w 8363529"/>
                <a:gd name="connsiteY82" fmla="*/ 988665 h 2481118"/>
                <a:gd name="connsiteX83" fmla="*/ 2333445 w 8363529"/>
                <a:gd name="connsiteY83" fmla="*/ 1433437 h 2481118"/>
                <a:gd name="connsiteX84" fmla="*/ 2341799 w 8363529"/>
                <a:gd name="connsiteY84" fmla="*/ 1478837 h 2481118"/>
                <a:gd name="connsiteX85" fmla="*/ 2350152 w 8363529"/>
                <a:gd name="connsiteY85" fmla="*/ 1459451 h 2481118"/>
                <a:gd name="connsiteX86" fmla="*/ 2417075 w 8363529"/>
                <a:gd name="connsiteY86" fmla="*/ 1312123 h 2481118"/>
                <a:gd name="connsiteX87" fmla="*/ 2425438 w 8363529"/>
                <a:gd name="connsiteY87" fmla="*/ 1294616 h 2481118"/>
                <a:gd name="connsiteX88" fmla="*/ 2433791 w 8363529"/>
                <a:gd name="connsiteY88" fmla="*/ 1238667 h 2481118"/>
                <a:gd name="connsiteX89" fmla="*/ 2500714 w 8363529"/>
                <a:gd name="connsiteY89" fmla="*/ 815710 h 2481118"/>
                <a:gd name="connsiteX90" fmla="*/ 2509068 w 8363529"/>
                <a:gd name="connsiteY90" fmla="*/ 765733 h 2481118"/>
                <a:gd name="connsiteX91" fmla="*/ 2517430 w 8363529"/>
                <a:gd name="connsiteY91" fmla="*/ 768907 h 2481118"/>
                <a:gd name="connsiteX92" fmla="*/ 2584354 w 8363529"/>
                <a:gd name="connsiteY92" fmla="*/ 798280 h 2481118"/>
                <a:gd name="connsiteX93" fmla="*/ 2592707 w 8363529"/>
                <a:gd name="connsiteY93" fmla="*/ 802587 h 2481118"/>
                <a:gd name="connsiteX94" fmla="*/ 2601060 w 8363529"/>
                <a:gd name="connsiteY94" fmla="*/ 830304 h 2481118"/>
                <a:gd name="connsiteX95" fmla="*/ 2667983 w 8363529"/>
                <a:gd name="connsiteY95" fmla="*/ 1054785 h 2481118"/>
                <a:gd name="connsiteX96" fmla="*/ 2676346 w 8363529"/>
                <a:gd name="connsiteY96" fmla="*/ 1083181 h 2481118"/>
                <a:gd name="connsiteX97" fmla="*/ 2684699 w 8363529"/>
                <a:gd name="connsiteY97" fmla="*/ 1099091 h 2481118"/>
                <a:gd name="connsiteX98" fmla="*/ 2751623 w 8363529"/>
                <a:gd name="connsiteY98" fmla="*/ 1249294 h 2481118"/>
                <a:gd name="connsiteX99" fmla="*/ 2759976 w 8363529"/>
                <a:gd name="connsiteY99" fmla="*/ 1271524 h 2481118"/>
                <a:gd name="connsiteX100" fmla="*/ 2768329 w 8363529"/>
                <a:gd name="connsiteY100" fmla="*/ 1262640 h 2481118"/>
                <a:gd name="connsiteX101" fmla="*/ 2835262 w 8363529"/>
                <a:gd name="connsiteY101" fmla="*/ 1209140 h 2481118"/>
                <a:gd name="connsiteX102" fmla="*/ 2843615 w 8363529"/>
                <a:gd name="connsiteY102" fmla="*/ 1204039 h 2481118"/>
                <a:gd name="connsiteX103" fmla="*/ 2851968 w 8363529"/>
                <a:gd name="connsiteY103" fmla="*/ 1215005 h 2481118"/>
                <a:gd name="connsiteX104" fmla="*/ 2918892 w 8363529"/>
                <a:gd name="connsiteY104" fmla="*/ 1305165 h 2481118"/>
                <a:gd name="connsiteX105" fmla="*/ 2927245 w 8363529"/>
                <a:gd name="connsiteY105" fmla="*/ 1316730 h 2481118"/>
                <a:gd name="connsiteX106" fmla="*/ 2935608 w 8363529"/>
                <a:gd name="connsiteY106" fmla="*/ 1295032 h 2481118"/>
                <a:gd name="connsiteX107" fmla="*/ 3002531 w 8363529"/>
                <a:gd name="connsiteY107" fmla="*/ 1128425 h 2481118"/>
                <a:gd name="connsiteX108" fmla="*/ 3010884 w 8363529"/>
                <a:gd name="connsiteY108" fmla="*/ 1108469 h 2481118"/>
                <a:gd name="connsiteX109" fmla="*/ 3019238 w 8363529"/>
                <a:gd name="connsiteY109" fmla="*/ 1099169 h 2481118"/>
                <a:gd name="connsiteX110" fmla="*/ 3086161 w 8363529"/>
                <a:gd name="connsiteY110" fmla="*/ 1005002 h 2481118"/>
                <a:gd name="connsiteX111" fmla="*/ 3094523 w 8363529"/>
                <a:gd name="connsiteY111" fmla="*/ 989991 h 2481118"/>
                <a:gd name="connsiteX112" fmla="*/ 3102877 w 8363529"/>
                <a:gd name="connsiteY112" fmla="*/ 1041178 h 2481118"/>
                <a:gd name="connsiteX113" fmla="*/ 3169800 w 8363529"/>
                <a:gd name="connsiteY113" fmla="*/ 1332950 h 2481118"/>
                <a:gd name="connsiteX114" fmla="*/ 3178153 w 8363529"/>
                <a:gd name="connsiteY114" fmla="*/ 1359265 h 2481118"/>
                <a:gd name="connsiteX115" fmla="*/ 3186516 w 8363529"/>
                <a:gd name="connsiteY115" fmla="*/ 1372456 h 2481118"/>
                <a:gd name="connsiteX116" fmla="*/ 3253439 w 8363529"/>
                <a:gd name="connsiteY116" fmla="*/ 1504280 h 2481118"/>
                <a:gd name="connsiteX117" fmla="*/ 3261792 w 8363529"/>
                <a:gd name="connsiteY117" fmla="*/ 1525001 h 2481118"/>
                <a:gd name="connsiteX118" fmla="*/ 3270146 w 8363529"/>
                <a:gd name="connsiteY118" fmla="*/ 1458271 h 2481118"/>
                <a:gd name="connsiteX119" fmla="*/ 3337069 w 8363529"/>
                <a:gd name="connsiteY119" fmla="*/ 323981 h 2481118"/>
                <a:gd name="connsiteX120" fmla="*/ 3345432 w 8363529"/>
                <a:gd name="connsiteY120" fmla="*/ 0 h 2481118"/>
                <a:gd name="connsiteX121" fmla="*/ 3353785 w 8363529"/>
                <a:gd name="connsiteY121" fmla="*/ 63546 h 2481118"/>
                <a:gd name="connsiteX122" fmla="*/ 3420708 w 8363529"/>
                <a:gd name="connsiteY122" fmla="*/ 249809 h 2481118"/>
                <a:gd name="connsiteX123" fmla="*/ 3429061 w 8363529"/>
                <a:gd name="connsiteY123" fmla="*/ 259341 h 2481118"/>
                <a:gd name="connsiteX124" fmla="*/ 3437424 w 8363529"/>
                <a:gd name="connsiteY124" fmla="*/ 301828 h 2481118"/>
                <a:gd name="connsiteX125" fmla="*/ 3504347 w 8363529"/>
                <a:gd name="connsiteY125" fmla="*/ 691667 h 2481118"/>
                <a:gd name="connsiteX126" fmla="*/ 3512701 w 8363529"/>
                <a:gd name="connsiteY126" fmla="*/ 747625 h 2481118"/>
                <a:gd name="connsiteX127" fmla="*/ 3521054 w 8363529"/>
                <a:gd name="connsiteY127" fmla="*/ 753403 h 2481118"/>
                <a:gd name="connsiteX128" fmla="*/ 3587977 w 8363529"/>
                <a:gd name="connsiteY128" fmla="*/ 793441 h 2481118"/>
                <a:gd name="connsiteX129" fmla="*/ 3596330 w 8363529"/>
                <a:gd name="connsiteY129" fmla="*/ 797786 h 2481118"/>
                <a:gd name="connsiteX130" fmla="*/ 3604693 w 8363529"/>
                <a:gd name="connsiteY130" fmla="*/ 834118 h 2481118"/>
                <a:gd name="connsiteX131" fmla="*/ 3671616 w 8363529"/>
                <a:gd name="connsiteY131" fmla="*/ 1218518 h 2481118"/>
                <a:gd name="connsiteX132" fmla="*/ 3679970 w 8363529"/>
                <a:gd name="connsiteY132" fmla="*/ 1282635 h 2481118"/>
                <a:gd name="connsiteX133" fmla="*/ 3688323 w 8363529"/>
                <a:gd name="connsiteY133" fmla="*/ 1154701 h 2481118"/>
                <a:gd name="connsiteX134" fmla="*/ 3755246 w 8363529"/>
                <a:gd name="connsiteY134" fmla="*/ 257599 h 2481118"/>
                <a:gd name="connsiteX135" fmla="*/ 3763609 w 8363529"/>
                <a:gd name="connsiteY135" fmla="*/ 159116 h 2481118"/>
                <a:gd name="connsiteX136" fmla="*/ 3771962 w 8363529"/>
                <a:gd name="connsiteY136" fmla="*/ 258615 h 2481118"/>
                <a:gd name="connsiteX137" fmla="*/ 3838885 w 8363529"/>
                <a:gd name="connsiteY137" fmla="*/ 1130206 h 2481118"/>
                <a:gd name="connsiteX138" fmla="*/ 3847239 w 8363529"/>
                <a:gd name="connsiteY138" fmla="*/ 1249594 h 2481118"/>
                <a:gd name="connsiteX139" fmla="*/ 3855602 w 8363529"/>
                <a:gd name="connsiteY139" fmla="*/ 1194129 h 2481118"/>
                <a:gd name="connsiteX140" fmla="*/ 3922525 w 8363529"/>
                <a:gd name="connsiteY140" fmla="*/ 795367 h 2481118"/>
                <a:gd name="connsiteX141" fmla="*/ 3930878 w 8363529"/>
                <a:gd name="connsiteY141" fmla="*/ 750538 h 2481118"/>
                <a:gd name="connsiteX142" fmla="*/ 3939231 w 8363529"/>
                <a:gd name="connsiteY142" fmla="*/ 781266 h 2481118"/>
                <a:gd name="connsiteX143" fmla="*/ 4006154 w 8363529"/>
                <a:gd name="connsiteY143" fmla="*/ 997743 h 2481118"/>
                <a:gd name="connsiteX144" fmla="*/ 4014517 w 8363529"/>
                <a:gd name="connsiteY144" fmla="*/ 1021590 h 2481118"/>
                <a:gd name="connsiteX145" fmla="*/ 4022871 w 8363529"/>
                <a:gd name="connsiteY145" fmla="*/ 1060157 h 2481118"/>
                <a:gd name="connsiteX146" fmla="*/ 4089755 w 8363529"/>
                <a:gd name="connsiteY146" fmla="*/ 1524468 h 2481118"/>
                <a:gd name="connsiteX147" fmla="*/ 4098147 w 8363529"/>
                <a:gd name="connsiteY147" fmla="*/ 1613612 h 2481118"/>
                <a:gd name="connsiteX148" fmla="*/ 4106500 w 8363529"/>
                <a:gd name="connsiteY148" fmla="*/ 1542576 h 2481118"/>
                <a:gd name="connsiteX149" fmla="*/ 4173394 w 8363529"/>
                <a:gd name="connsiteY149" fmla="*/ 1179235 h 2481118"/>
                <a:gd name="connsiteX150" fmla="*/ 4181787 w 8363529"/>
                <a:gd name="connsiteY150" fmla="*/ 1149562 h 2481118"/>
                <a:gd name="connsiteX151" fmla="*/ 4190140 w 8363529"/>
                <a:gd name="connsiteY151" fmla="*/ 1177048 h 2481118"/>
                <a:gd name="connsiteX152" fmla="*/ 4257024 w 8363529"/>
                <a:gd name="connsiteY152" fmla="*/ 1451661 h 2481118"/>
                <a:gd name="connsiteX153" fmla="*/ 4265416 w 8363529"/>
                <a:gd name="connsiteY153" fmla="*/ 1494757 h 2481118"/>
                <a:gd name="connsiteX154" fmla="*/ 4273779 w 8363529"/>
                <a:gd name="connsiteY154" fmla="*/ 1396274 h 2481118"/>
                <a:gd name="connsiteX155" fmla="*/ 4340664 w 8363529"/>
                <a:gd name="connsiteY155" fmla="*/ 668953 h 2481118"/>
                <a:gd name="connsiteX156" fmla="*/ 4349055 w 8363529"/>
                <a:gd name="connsiteY156" fmla="*/ 584948 h 2481118"/>
                <a:gd name="connsiteX157" fmla="*/ 4357409 w 8363529"/>
                <a:gd name="connsiteY157" fmla="*/ 652200 h 2481118"/>
                <a:gd name="connsiteX158" fmla="*/ 4424303 w 8363529"/>
                <a:gd name="connsiteY158" fmla="*/ 1185632 h 2481118"/>
                <a:gd name="connsiteX159" fmla="*/ 4432695 w 8363529"/>
                <a:gd name="connsiteY159" fmla="*/ 1251752 h 2481118"/>
                <a:gd name="connsiteX160" fmla="*/ 4441048 w 8363529"/>
                <a:gd name="connsiteY160" fmla="*/ 1221576 h 2481118"/>
                <a:gd name="connsiteX161" fmla="*/ 4507932 w 8363529"/>
                <a:gd name="connsiteY161" fmla="*/ 966474 h 2481118"/>
                <a:gd name="connsiteX162" fmla="*/ 4516324 w 8363529"/>
                <a:gd name="connsiteY162" fmla="*/ 932794 h 2481118"/>
                <a:gd name="connsiteX163" fmla="*/ 4524687 w 8363529"/>
                <a:gd name="connsiteY163" fmla="*/ 918384 h 2481118"/>
                <a:gd name="connsiteX164" fmla="*/ 4591572 w 8363529"/>
                <a:gd name="connsiteY164" fmla="*/ 790073 h 2481118"/>
                <a:gd name="connsiteX165" fmla="*/ 4599964 w 8363529"/>
                <a:gd name="connsiteY165" fmla="*/ 772159 h 2481118"/>
                <a:gd name="connsiteX166" fmla="*/ 4608317 w 8363529"/>
                <a:gd name="connsiteY166" fmla="*/ 786937 h 2481118"/>
                <a:gd name="connsiteX167" fmla="*/ 4675201 w 8363529"/>
                <a:gd name="connsiteY167" fmla="*/ 902434 h 2481118"/>
                <a:gd name="connsiteX168" fmla="*/ 4683603 w 8363529"/>
                <a:gd name="connsiteY168" fmla="*/ 916535 h 2481118"/>
                <a:gd name="connsiteX169" fmla="*/ 4691956 w 8363529"/>
                <a:gd name="connsiteY169" fmla="*/ 857790 h 2481118"/>
                <a:gd name="connsiteX170" fmla="*/ 4758840 w 8363529"/>
                <a:gd name="connsiteY170" fmla="*/ 438307 h 2481118"/>
                <a:gd name="connsiteX171" fmla="*/ 4767232 w 8363529"/>
                <a:gd name="connsiteY171" fmla="*/ 391465 h 2481118"/>
                <a:gd name="connsiteX172" fmla="*/ 4775595 w 8363529"/>
                <a:gd name="connsiteY172" fmla="*/ 459173 h 2481118"/>
                <a:gd name="connsiteX173" fmla="*/ 4842480 w 8363529"/>
                <a:gd name="connsiteY173" fmla="*/ 1167515 h 2481118"/>
                <a:gd name="connsiteX174" fmla="*/ 4850872 w 8363529"/>
                <a:gd name="connsiteY174" fmla="*/ 1284338 h 2481118"/>
                <a:gd name="connsiteX175" fmla="*/ 4859225 w 8363529"/>
                <a:gd name="connsiteY175" fmla="*/ 1332766 h 2481118"/>
                <a:gd name="connsiteX176" fmla="*/ 4926109 w 8363529"/>
                <a:gd name="connsiteY176" fmla="*/ 1585788 h 2481118"/>
                <a:gd name="connsiteX177" fmla="*/ 4934501 w 8363529"/>
                <a:gd name="connsiteY177" fmla="*/ 1606886 h 2481118"/>
                <a:gd name="connsiteX178" fmla="*/ 4942864 w 8363529"/>
                <a:gd name="connsiteY178" fmla="*/ 1595698 h 2481118"/>
                <a:gd name="connsiteX179" fmla="*/ 5009749 w 8363529"/>
                <a:gd name="connsiteY179" fmla="*/ 1494757 h 2481118"/>
                <a:gd name="connsiteX180" fmla="*/ 5018141 w 8363529"/>
                <a:gd name="connsiteY180" fmla="*/ 1480501 h 2481118"/>
                <a:gd name="connsiteX181" fmla="*/ 5026494 w 8363529"/>
                <a:gd name="connsiteY181" fmla="*/ 1436844 h 2481118"/>
                <a:gd name="connsiteX182" fmla="*/ 5093388 w 8363529"/>
                <a:gd name="connsiteY182" fmla="*/ 1022122 h 2481118"/>
                <a:gd name="connsiteX183" fmla="*/ 5101780 w 8363529"/>
                <a:gd name="connsiteY183" fmla="*/ 960348 h 2481118"/>
                <a:gd name="connsiteX184" fmla="*/ 5110134 w 8363529"/>
                <a:gd name="connsiteY184" fmla="*/ 997211 h 2481118"/>
                <a:gd name="connsiteX185" fmla="*/ 5177018 w 8363529"/>
                <a:gd name="connsiteY185" fmla="*/ 1210272 h 2481118"/>
                <a:gd name="connsiteX186" fmla="*/ 5185410 w 8363529"/>
                <a:gd name="connsiteY186" fmla="*/ 1229706 h 2481118"/>
                <a:gd name="connsiteX187" fmla="*/ 5193773 w 8363529"/>
                <a:gd name="connsiteY187" fmla="*/ 1136294 h 2481118"/>
                <a:gd name="connsiteX188" fmla="*/ 5260657 w 8363529"/>
                <a:gd name="connsiteY188" fmla="*/ 324668 h 2481118"/>
                <a:gd name="connsiteX189" fmla="*/ 5269049 w 8363529"/>
                <a:gd name="connsiteY189" fmla="*/ 214464 h 2481118"/>
                <a:gd name="connsiteX190" fmla="*/ 5277403 w 8363529"/>
                <a:gd name="connsiteY190" fmla="*/ 286140 h 2481118"/>
                <a:gd name="connsiteX191" fmla="*/ 5344287 w 8363529"/>
                <a:gd name="connsiteY191" fmla="*/ 949237 h 2481118"/>
                <a:gd name="connsiteX192" fmla="*/ 5352650 w 8363529"/>
                <a:gd name="connsiteY192" fmla="*/ 1045369 h 2481118"/>
                <a:gd name="connsiteX193" fmla="*/ 5361042 w 8363529"/>
                <a:gd name="connsiteY193" fmla="*/ 1056634 h 2481118"/>
                <a:gd name="connsiteX194" fmla="*/ 5427926 w 8363529"/>
                <a:gd name="connsiteY194" fmla="*/ 1279228 h 2481118"/>
                <a:gd name="connsiteX195" fmla="*/ 5436280 w 8363529"/>
                <a:gd name="connsiteY195" fmla="*/ 1355936 h 2481118"/>
                <a:gd name="connsiteX196" fmla="*/ 5444672 w 8363529"/>
                <a:gd name="connsiteY196" fmla="*/ 1420052 h 2481118"/>
                <a:gd name="connsiteX197" fmla="*/ 5511566 w 8363529"/>
                <a:gd name="connsiteY197" fmla="*/ 1631536 h 2481118"/>
                <a:gd name="connsiteX198" fmla="*/ 5519919 w 8363529"/>
                <a:gd name="connsiteY198" fmla="*/ 1643363 h 2481118"/>
                <a:gd name="connsiteX199" fmla="*/ 5528311 w 8363529"/>
                <a:gd name="connsiteY199" fmla="*/ 1596976 h 2481118"/>
                <a:gd name="connsiteX200" fmla="*/ 5595195 w 8363529"/>
                <a:gd name="connsiteY200" fmla="*/ 1340064 h 2481118"/>
                <a:gd name="connsiteX201" fmla="*/ 5603558 w 8363529"/>
                <a:gd name="connsiteY201" fmla="*/ 1317495 h 2481118"/>
                <a:gd name="connsiteX202" fmla="*/ 5611950 w 8363529"/>
                <a:gd name="connsiteY202" fmla="*/ 1268195 h 2481118"/>
                <a:gd name="connsiteX203" fmla="*/ 5678835 w 8363529"/>
                <a:gd name="connsiteY203" fmla="*/ 875481 h 2481118"/>
                <a:gd name="connsiteX204" fmla="*/ 5687188 w 8363529"/>
                <a:gd name="connsiteY204" fmla="*/ 826598 h 2481118"/>
                <a:gd name="connsiteX205" fmla="*/ 5695580 w 8363529"/>
                <a:gd name="connsiteY205" fmla="*/ 884172 h 2481118"/>
                <a:gd name="connsiteX206" fmla="*/ 5762474 w 8363529"/>
                <a:gd name="connsiteY206" fmla="*/ 1537930 h 2481118"/>
                <a:gd name="connsiteX207" fmla="*/ 5770827 w 8363529"/>
                <a:gd name="connsiteY207" fmla="*/ 1655576 h 2481118"/>
                <a:gd name="connsiteX208" fmla="*/ 5779219 w 8363529"/>
                <a:gd name="connsiteY208" fmla="*/ 1589950 h 2481118"/>
                <a:gd name="connsiteX209" fmla="*/ 5846103 w 8363529"/>
                <a:gd name="connsiteY209" fmla="*/ 1207059 h 2481118"/>
                <a:gd name="connsiteX210" fmla="*/ 5854457 w 8363529"/>
                <a:gd name="connsiteY210" fmla="*/ 1171754 h 2481118"/>
                <a:gd name="connsiteX211" fmla="*/ 5862858 w 8363529"/>
                <a:gd name="connsiteY211" fmla="*/ 1211037 h 2481118"/>
                <a:gd name="connsiteX212" fmla="*/ 5929743 w 8363529"/>
                <a:gd name="connsiteY212" fmla="*/ 1723177 h 2481118"/>
                <a:gd name="connsiteX213" fmla="*/ 5938096 w 8363529"/>
                <a:gd name="connsiteY213" fmla="*/ 1830574 h 2481118"/>
                <a:gd name="connsiteX214" fmla="*/ 5946488 w 8363529"/>
                <a:gd name="connsiteY214" fmla="*/ 1727977 h 2481118"/>
                <a:gd name="connsiteX215" fmla="*/ 6013372 w 8363529"/>
                <a:gd name="connsiteY215" fmla="*/ 1210659 h 2481118"/>
                <a:gd name="connsiteX216" fmla="*/ 6021735 w 8363529"/>
                <a:gd name="connsiteY216" fmla="*/ 1168957 h 2481118"/>
                <a:gd name="connsiteX217" fmla="*/ 6030127 w 8363529"/>
                <a:gd name="connsiteY217" fmla="*/ 1086694 h 2481118"/>
                <a:gd name="connsiteX218" fmla="*/ 6097011 w 8363529"/>
                <a:gd name="connsiteY218" fmla="*/ 340540 h 2481118"/>
                <a:gd name="connsiteX219" fmla="*/ 6105365 w 8363529"/>
                <a:gd name="connsiteY219" fmla="*/ 234575 h 2481118"/>
                <a:gd name="connsiteX220" fmla="*/ 6113767 w 8363529"/>
                <a:gd name="connsiteY220" fmla="*/ 292837 h 2481118"/>
                <a:gd name="connsiteX221" fmla="*/ 6180651 w 8363529"/>
                <a:gd name="connsiteY221" fmla="*/ 694812 h 2481118"/>
                <a:gd name="connsiteX222" fmla="*/ 6189004 w 8363529"/>
                <a:gd name="connsiteY222" fmla="*/ 738209 h 2481118"/>
                <a:gd name="connsiteX223" fmla="*/ 6197396 w 8363529"/>
                <a:gd name="connsiteY223" fmla="*/ 808335 h 2481118"/>
                <a:gd name="connsiteX224" fmla="*/ 6264280 w 8363529"/>
                <a:gd name="connsiteY224" fmla="*/ 1523375 h 2481118"/>
                <a:gd name="connsiteX225" fmla="*/ 6272644 w 8363529"/>
                <a:gd name="connsiteY225" fmla="*/ 1638078 h 2481118"/>
                <a:gd name="connsiteX226" fmla="*/ 6281036 w 8363529"/>
                <a:gd name="connsiteY226" fmla="*/ 1537553 h 2481118"/>
                <a:gd name="connsiteX227" fmla="*/ 6347920 w 8363529"/>
                <a:gd name="connsiteY227" fmla="*/ 854799 h 2481118"/>
                <a:gd name="connsiteX228" fmla="*/ 6356273 w 8363529"/>
                <a:gd name="connsiteY228" fmla="*/ 782098 h 2481118"/>
                <a:gd name="connsiteX229" fmla="*/ 6364665 w 8363529"/>
                <a:gd name="connsiteY229" fmla="*/ 877291 h 2481118"/>
                <a:gd name="connsiteX230" fmla="*/ 6431560 w 8363529"/>
                <a:gd name="connsiteY230" fmla="*/ 1573884 h 2481118"/>
                <a:gd name="connsiteX231" fmla="*/ 6439913 w 8363529"/>
                <a:gd name="connsiteY231" fmla="*/ 1653611 h 2481118"/>
                <a:gd name="connsiteX232" fmla="*/ 6448305 w 8363529"/>
                <a:gd name="connsiteY232" fmla="*/ 1663251 h 2481118"/>
                <a:gd name="connsiteX233" fmla="*/ 6515189 w 8363529"/>
                <a:gd name="connsiteY233" fmla="*/ 1749937 h 2481118"/>
                <a:gd name="connsiteX234" fmla="*/ 6523542 w 8363529"/>
                <a:gd name="connsiteY234" fmla="*/ 1762150 h 2481118"/>
                <a:gd name="connsiteX235" fmla="*/ 6531944 w 8363529"/>
                <a:gd name="connsiteY235" fmla="*/ 1716973 h 2481118"/>
                <a:gd name="connsiteX236" fmla="*/ 6598829 w 8363529"/>
                <a:gd name="connsiteY236" fmla="*/ 1313140 h 2481118"/>
                <a:gd name="connsiteX237" fmla="*/ 6607182 w 8363529"/>
                <a:gd name="connsiteY237" fmla="*/ 1256659 h 2481118"/>
                <a:gd name="connsiteX238" fmla="*/ 6615535 w 8363529"/>
                <a:gd name="connsiteY238" fmla="*/ 1309094 h 2481118"/>
                <a:gd name="connsiteX239" fmla="*/ 6682458 w 8363529"/>
                <a:gd name="connsiteY239" fmla="*/ 1601670 h 2481118"/>
                <a:gd name="connsiteX240" fmla="*/ 6690821 w 8363529"/>
                <a:gd name="connsiteY240" fmla="*/ 1627529 h 2481118"/>
                <a:gd name="connsiteX241" fmla="*/ 6699174 w 8363529"/>
                <a:gd name="connsiteY241" fmla="*/ 1581065 h 2481118"/>
                <a:gd name="connsiteX242" fmla="*/ 6766097 w 8363529"/>
                <a:gd name="connsiteY242" fmla="*/ 1115312 h 2481118"/>
                <a:gd name="connsiteX243" fmla="*/ 6774451 w 8363529"/>
                <a:gd name="connsiteY243" fmla="*/ 1041972 h 2481118"/>
                <a:gd name="connsiteX244" fmla="*/ 6782814 w 8363529"/>
                <a:gd name="connsiteY244" fmla="*/ 1035691 h 2481118"/>
                <a:gd name="connsiteX245" fmla="*/ 6849737 w 8363529"/>
                <a:gd name="connsiteY245" fmla="*/ 977323 h 2481118"/>
                <a:gd name="connsiteX246" fmla="*/ 6858090 w 8363529"/>
                <a:gd name="connsiteY246" fmla="*/ 968816 h 2481118"/>
                <a:gd name="connsiteX247" fmla="*/ 6866443 w 8363529"/>
                <a:gd name="connsiteY247" fmla="*/ 985075 h 2481118"/>
                <a:gd name="connsiteX248" fmla="*/ 6933366 w 8363529"/>
                <a:gd name="connsiteY248" fmla="*/ 1072670 h 2481118"/>
                <a:gd name="connsiteX249" fmla="*/ 6941729 w 8363529"/>
                <a:gd name="connsiteY249" fmla="*/ 1080152 h 2481118"/>
                <a:gd name="connsiteX250" fmla="*/ 6950083 w 8363529"/>
                <a:gd name="connsiteY250" fmla="*/ 996340 h 2481118"/>
                <a:gd name="connsiteX251" fmla="*/ 7017006 w 8363529"/>
                <a:gd name="connsiteY251" fmla="*/ 179798 h 2481118"/>
                <a:gd name="connsiteX252" fmla="*/ 7025359 w 8363529"/>
                <a:gd name="connsiteY252" fmla="*/ 54961 h 2481118"/>
                <a:gd name="connsiteX253" fmla="*/ 7033712 w 8363529"/>
                <a:gd name="connsiteY253" fmla="*/ 77008 h 2481118"/>
                <a:gd name="connsiteX254" fmla="*/ 7100645 w 8363529"/>
                <a:gd name="connsiteY254" fmla="*/ 265458 h 2481118"/>
                <a:gd name="connsiteX255" fmla="*/ 7108998 w 8363529"/>
                <a:gd name="connsiteY255" fmla="*/ 290679 h 2481118"/>
                <a:gd name="connsiteX256" fmla="*/ 7117351 w 8363529"/>
                <a:gd name="connsiteY256" fmla="*/ 326671 h 2481118"/>
                <a:gd name="connsiteX257" fmla="*/ 7184274 w 8363529"/>
                <a:gd name="connsiteY257" fmla="*/ 626341 h 2481118"/>
                <a:gd name="connsiteX258" fmla="*/ 7192628 w 8363529"/>
                <a:gd name="connsiteY258" fmla="*/ 665324 h 2481118"/>
                <a:gd name="connsiteX259" fmla="*/ 7200991 w 8363529"/>
                <a:gd name="connsiteY259" fmla="*/ 704452 h 2481118"/>
                <a:gd name="connsiteX260" fmla="*/ 7267914 w 8363529"/>
                <a:gd name="connsiteY260" fmla="*/ 993843 h 2481118"/>
                <a:gd name="connsiteX261" fmla="*/ 7276267 w 8363529"/>
                <a:gd name="connsiteY261" fmla="*/ 1027339 h 2481118"/>
                <a:gd name="connsiteX262" fmla="*/ 7284620 w 8363529"/>
                <a:gd name="connsiteY262" fmla="*/ 1031384 h 2481118"/>
                <a:gd name="connsiteX263" fmla="*/ 7351543 w 8363529"/>
                <a:gd name="connsiteY263" fmla="*/ 1065712 h 2481118"/>
                <a:gd name="connsiteX264" fmla="*/ 7359906 w 8363529"/>
                <a:gd name="connsiteY264" fmla="*/ 1070251 h 2481118"/>
                <a:gd name="connsiteX265" fmla="*/ 7368260 w 8363529"/>
                <a:gd name="connsiteY265" fmla="*/ 1065296 h 2481118"/>
                <a:gd name="connsiteX266" fmla="*/ 7435183 w 8363529"/>
                <a:gd name="connsiteY266" fmla="*/ 1032023 h 2481118"/>
                <a:gd name="connsiteX267" fmla="*/ 7443536 w 8363529"/>
                <a:gd name="connsiteY267" fmla="*/ 1028548 h 2481118"/>
                <a:gd name="connsiteX268" fmla="*/ 7451899 w 8363529"/>
                <a:gd name="connsiteY268" fmla="*/ 1055463 h 2481118"/>
                <a:gd name="connsiteX269" fmla="*/ 7518822 w 8363529"/>
                <a:gd name="connsiteY269" fmla="*/ 1314582 h 2481118"/>
                <a:gd name="connsiteX270" fmla="*/ 7527175 w 8363529"/>
                <a:gd name="connsiteY270" fmla="*/ 1353671 h 2481118"/>
                <a:gd name="connsiteX271" fmla="*/ 7535528 w 8363529"/>
                <a:gd name="connsiteY271" fmla="*/ 1249439 h 2481118"/>
                <a:gd name="connsiteX272" fmla="*/ 7602452 w 8363529"/>
                <a:gd name="connsiteY272" fmla="*/ 550514 h 2481118"/>
                <a:gd name="connsiteX273" fmla="*/ 7610815 w 8363529"/>
                <a:gd name="connsiteY273" fmla="*/ 477057 h 2481118"/>
                <a:gd name="connsiteX274" fmla="*/ 7619168 w 8363529"/>
                <a:gd name="connsiteY274" fmla="*/ 568766 h 2481118"/>
                <a:gd name="connsiteX275" fmla="*/ 7686091 w 8363529"/>
                <a:gd name="connsiteY275" fmla="*/ 1365014 h 2481118"/>
                <a:gd name="connsiteX276" fmla="*/ 7694444 w 8363529"/>
                <a:gd name="connsiteY276" fmla="*/ 1473097 h 2481118"/>
                <a:gd name="connsiteX277" fmla="*/ 7702798 w 8363529"/>
                <a:gd name="connsiteY277" fmla="*/ 1421949 h 2481118"/>
                <a:gd name="connsiteX278" fmla="*/ 7769731 w 8363529"/>
                <a:gd name="connsiteY278" fmla="*/ 917590 h 2481118"/>
                <a:gd name="connsiteX279" fmla="*/ 7778084 w 8363529"/>
                <a:gd name="connsiteY279" fmla="*/ 839489 h 2481118"/>
                <a:gd name="connsiteX280" fmla="*/ 7786437 w 8363529"/>
                <a:gd name="connsiteY280" fmla="*/ 934720 h 2481118"/>
                <a:gd name="connsiteX281" fmla="*/ 7853360 w 8363529"/>
                <a:gd name="connsiteY281" fmla="*/ 1400135 h 2481118"/>
                <a:gd name="connsiteX282" fmla="*/ 7861713 w 8363529"/>
                <a:gd name="connsiteY282" fmla="*/ 1436611 h 2481118"/>
                <a:gd name="connsiteX283" fmla="*/ 7870077 w 8363529"/>
                <a:gd name="connsiteY283" fmla="*/ 1432489 h 2481118"/>
                <a:gd name="connsiteX284" fmla="*/ 7937000 w 8363529"/>
                <a:gd name="connsiteY284" fmla="*/ 1386296 h 2481118"/>
                <a:gd name="connsiteX285" fmla="*/ 7945353 w 8363529"/>
                <a:gd name="connsiteY285" fmla="*/ 1378127 h 2481118"/>
                <a:gd name="connsiteX286" fmla="*/ 7953706 w 8363529"/>
                <a:gd name="connsiteY286" fmla="*/ 1379637 h 2481118"/>
                <a:gd name="connsiteX287" fmla="*/ 8020629 w 8363529"/>
                <a:gd name="connsiteY287" fmla="*/ 1391173 h 2481118"/>
                <a:gd name="connsiteX288" fmla="*/ 8028992 w 8363529"/>
                <a:gd name="connsiteY288" fmla="*/ 1392528 h 2481118"/>
                <a:gd name="connsiteX289" fmla="*/ 8037346 w 8363529"/>
                <a:gd name="connsiteY289" fmla="*/ 1360020 h 2481118"/>
                <a:gd name="connsiteX290" fmla="*/ 8104268 w 8363529"/>
                <a:gd name="connsiteY290" fmla="*/ 1061783 h 2481118"/>
                <a:gd name="connsiteX291" fmla="*/ 8112622 w 8363529"/>
                <a:gd name="connsiteY291" fmla="*/ 1018948 h 2481118"/>
                <a:gd name="connsiteX292" fmla="*/ 8120985 w 8363529"/>
                <a:gd name="connsiteY292" fmla="*/ 1137126 h 2481118"/>
                <a:gd name="connsiteX293" fmla="*/ 8187908 w 8363529"/>
                <a:gd name="connsiteY293" fmla="*/ 1762450 h 2481118"/>
                <a:gd name="connsiteX294" fmla="*/ 8196261 w 8363529"/>
                <a:gd name="connsiteY294" fmla="*/ 1815118 h 2481118"/>
                <a:gd name="connsiteX295" fmla="*/ 8204614 w 8363529"/>
                <a:gd name="connsiteY295" fmla="*/ 1733755 h 2481118"/>
                <a:gd name="connsiteX296" fmla="*/ 8271537 w 8363529"/>
                <a:gd name="connsiteY296" fmla="*/ 886137 h 2481118"/>
                <a:gd name="connsiteX297" fmla="*/ 8279900 w 8363529"/>
                <a:gd name="connsiteY297" fmla="*/ 747054 h 2481118"/>
                <a:gd name="connsiteX298" fmla="*/ 8288254 w 8363529"/>
                <a:gd name="connsiteY298" fmla="*/ 809168 h 2481118"/>
                <a:gd name="connsiteX299" fmla="*/ 8355177 w 8363529"/>
                <a:gd name="connsiteY299" fmla="*/ 1311330 h 2481118"/>
                <a:gd name="connsiteX300" fmla="*/ 8363530 w 8363529"/>
                <a:gd name="connsiteY300" fmla="*/ 1374730 h 2481118"/>
                <a:gd name="connsiteX301" fmla="*/ 8363530 w 8363529"/>
                <a:gd name="connsiteY301" fmla="*/ 1829025 h 2481118"/>
                <a:gd name="connsiteX302" fmla="*/ 8355177 w 8363529"/>
                <a:gd name="connsiteY302" fmla="*/ 1759615 h 2481118"/>
                <a:gd name="connsiteX303" fmla="*/ 8288254 w 8363529"/>
                <a:gd name="connsiteY303" fmla="*/ 1209972 h 2481118"/>
                <a:gd name="connsiteX304" fmla="*/ 8279900 w 8363529"/>
                <a:gd name="connsiteY304" fmla="*/ 1141965 h 2481118"/>
                <a:gd name="connsiteX305" fmla="*/ 8271537 w 8363529"/>
                <a:gd name="connsiteY305" fmla="*/ 1269589 h 2481118"/>
                <a:gd name="connsiteX306" fmla="*/ 8204614 w 8363529"/>
                <a:gd name="connsiteY306" fmla="*/ 2047390 h 2481118"/>
                <a:gd name="connsiteX307" fmla="*/ 8196261 w 8363529"/>
                <a:gd name="connsiteY307" fmla="*/ 2122007 h 2481118"/>
                <a:gd name="connsiteX308" fmla="*/ 8187908 w 8363529"/>
                <a:gd name="connsiteY308" fmla="*/ 2112107 h 2481118"/>
                <a:gd name="connsiteX309" fmla="*/ 8120985 w 8363529"/>
                <a:gd name="connsiteY309" fmla="*/ 1994267 h 2481118"/>
                <a:gd name="connsiteX310" fmla="*/ 8112622 w 8363529"/>
                <a:gd name="connsiteY310" fmla="*/ 1971998 h 2481118"/>
                <a:gd name="connsiteX311" fmla="*/ 8104268 w 8363529"/>
                <a:gd name="connsiteY311" fmla="*/ 1980399 h 2481118"/>
                <a:gd name="connsiteX312" fmla="*/ 8037346 w 8363529"/>
                <a:gd name="connsiteY312" fmla="*/ 2038921 h 2481118"/>
                <a:gd name="connsiteX313" fmla="*/ 8028992 w 8363529"/>
                <a:gd name="connsiteY313" fmla="*/ 2045309 h 2481118"/>
                <a:gd name="connsiteX314" fmla="*/ 8020629 w 8363529"/>
                <a:gd name="connsiteY314" fmla="*/ 2025121 h 2481118"/>
                <a:gd name="connsiteX315" fmla="*/ 7953706 w 8363529"/>
                <a:gd name="connsiteY315" fmla="*/ 1855756 h 2481118"/>
                <a:gd name="connsiteX316" fmla="*/ 7945353 w 8363529"/>
                <a:gd name="connsiteY316" fmla="*/ 1833564 h 2481118"/>
                <a:gd name="connsiteX317" fmla="*/ 7937000 w 8363529"/>
                <a:gd name="connsiteY317" fmla="*/ 1851826 h 2481118"/>
                <a:gd name="connsiteX318" fmla="*/ 7870077 w 8363529"/>
                <a:gd name="connsiteY318" fmla="*/ 1954723 h 2481118"/>
                <a:gd name="connsiteX319" fmla="*/ 7861713 w 8363529"/>
                <a:gd name="connsiteY319" fmla="*/ 1963917 h 2481118"/>
                <a:gd name="connsiteX320" fmla="*/ 7853360 w 8363529"/>
                <a:gd name="connsiteY320" fmla="*/ 1912314 h 2481118"/>
                <a:gd name="connsiteX321" fmla="*/ 7786437 w 8363529"/>
                <a:gd name="connsiteY321" fmla="*/ 1253794 h 2481118"/>
                <a:gd name="connsiteX322" fmla="*/ 7778084 w 8363529"/>
                <a:gd name="connsiteY322" fmla="*/ 1119057 h 2481118"/>
                <a:gd name="connsiteX323" fmla="*/ 7769731 w 8363529"/>
                <a:gd name="connsiteY323" fmla="*/ 1218363 h 2481118"/>
                <a:gd name="connsiteX324" fmla="*/ 7702798 w 8363529"/>
                <a:gd name="connsiteY324" fmla="*/ 1859878 h 2481118"/>
                <a:gd name="connsiteX325" fmla="*/ 7694444 w 8363529"/>
                <a:gd name="connsiteY325" fmla="*/ 1924934 h 2481118"/>
                <a:gd name="connsiteX326" fmla="*/ 7686091 w 8363529"/>
                <a:gd name="connsiteY326" fmla="*/ 1818892 h 2481118"/>
                <a:gd name="connsiteX327" fmla="*/ 7619168 w 8363529"/>
                <a:gd name="connsiteY327" fmla="*/ 1037549 h 2481118"/>
                <a:gd name="connsiteX328" fmla="*/ 7610815 w 8363529"/>
                <a:gd name="connsiteY328" fmla="*/ 947534 h 2481118"/>
                <a:gd name="connsiteX329" fmla="*/ 7602452 w 8363529"/>
                <a:gd name="connsiteY329" fmla="*/ 1010441 h 2481118"/>
                <a:gd name="connsiteX330" fmla="*/ 7535528 w 8363529"/>
                <a:gd name="connsiteY330" fmla="*/ 1609112 h 2481118"/>
                <a:gd name="connsiteX331" fmla="*/ 7527175 w 8363529"/>
                <a:gd name="connsiteY331" fmla="*/ 1698411 h 2481118"/>
                <a:gd name="connsiteX332" fmla="*/ 7518822 w 8363529"/>
                <a:gd name="connsiteY332" fmla="*/ 1670471 h 2481118"/>
                <a:gd name="connsiteX333" fmla="*/ 7451899 w 8363529"/>
                <a:gd name="connsiteY333" fmla="*/ 1485534 h 2481118"/>
                <a:gd name="connsiteX334" fmla="*/ 7443536 w 8363529"/>
                <a:gd name="connsiteY334" fmla="*/ 1466294 h 2481118"/>
                <a:gd name="connsiteX335" fmla="*/ 7435183 w 8363529"/>
                <a:gd name="connsiteY335" fmla="*/ 1490518 h 2481118"/>
                <a:gd name="connsiteX336" fmla="*/ 7368260 w 8363529"/>
                <a:gd name="connsiteY336" fmla="*/ 1722151 h 2481118"/>
                <a:gd name="connsiteX337" fmla="*/ 7359906 w 8363529"/>
                <a:gd name="connsiteY337" fmla="*/ 1756818 h 2481118"/>
                <a:gd name="connsiteX338" fmla="*/ 7351543 w 8363529"/>
                <a:gd name="connsiteY338" fmla="*/ 1721890 h 2481118"/>
                <a:gd name="connsiteX339" fmla="*/ 7284620 w 8363529"/>
                <a:gd name="connsiteY339" fmla="*/ 1457477 h 2481118"/>
                <a:gd name="connsiteX340" fmla="*/ 7276267 w 8363529"/>
                <a:gd name="connsiteY340" fmla="*/ 1426217 h 2481118"/>
                <a:gd name="connsiteX341" fmla="*/ 7267914 w 8363529"/>
                <a:gd name="connsiteY341" fmla="*/ 1442854 h 2481118"/>
                <a:gd name="connsiteX342" fmla="*/ 7200991 w 8363529"/>
                <a:gd name="connsiteY342" fmla="*/ 1586659 h 2481118"/>
                <a:gd name="connsiteX343" fmla="*/ 7192628 w 8363529"/>
                <a:gd name="connsiteY343" fmla="*/ 1606131 h 2481118"/>
                <a:gd name="connsiteX344" fmla="*/ 7184274 w 8363529"/>
                <a:gd name="connsiteY344" fmla="*/ 1581220 h 2481118"/>
                <a:gd name="connsiteX345" fmla="*/ 7117351 w 8363529"/>
                <a:gd name="connsiteY345" fmla="*/ 1389925 h 2481118"/>
                <a:gd name="connsiteX346" fmla="*/ 7108998 w 8363529"/>
                <a:gd name="connsiteY346" fmla="*/ 1366901 h 2481118"/>
                <a:gd name="connsiteX347" fmla="*/ 7100645 w 8363529"/>
                <a:gd name="connsiteY347" fmla="*/ 1486027 h 2481118"/>
                <a:gd name="connsiteX348" fmla="*/ 7033712 w 8363529"/>
                <a:gd name="connsiteY348" fmla="*/ 2376964 h 2481118"/>
                <a:gd name="connsiteX349" fmla="*/ 7025359 w 8363529"/>
                <a:gd name="connsiteY349" fmla="*/ 2481119 h 2481118"/>
                <a:gd name="connsiteX350" fmla="*/ 7017006 w 8363529"/>
                <a:gd name="connsiteY350" fmla="*/ 2384261 h 2481118"/>
                <a:gd name="connsiteX351" fmla="*/ 6950083 w 8363529"/>
                <a:gd name="connsiteY351" fmla="*/ 1750546 h 2481118"/>
                <a:gd name="connsiteX352" fmla="*/ 6941729 w 8363529"/>
                <a:gd name="connsiteY352" fmla="*/ 1685520 h 2481118"/>
                <a:gd name="connsiteX353" fmla="*/ 6933366 w 8363529"/>
                <a:gd name="connsiteY353" fmla="*/ 1701208 h 2481118"/>
                <a:gd name="connsiteX354" fmla="*/ 6866443 w 8363529"/>
                <a:gd name="connsiteY354" fmla="*/ 1884674 h 2481118"/>
                <a:gd name="connsiteX355" fmla="*/ 6858090 w 8363529"/>
                <a:gd name="connsiteY355" fmla="*/ 1918701 h 2481118"/>
                <a:gd name="connsiteX356" fmla="*/ 6849737 w 8363529"/>
                <a:gd name="connsiteY356" fmla="*/ 1900139 h 2481118"/>
                <a:gd name="connsiteX357" fmla="*/ 6782814 w 8363529"/>
                <a:gd name="connsiteY357" fmla="*/ 1772583 h 2481118"/>
                <a:gd name="connsiteX358" fmla="*/ 6774451 w 8363529"/>
                <a:gd name="connsiteY358" fmla="*/ 1758860 h 2481118"/>
                <a:gd name="connsiteX359" fmla="*/ 6766097 w 8363529"/>
                <a:gd name="connsiteY359" fmla="*/ 1813037 h 2481118"/>
                <a:gd name="connsiteX360" fmla="*/ 6699174 w 8363529"/>
                <a:gd name="connsiteY360" fmla="*/ 2157061 h 2481118"/>
                <a:gd name="connsiteX361" fmla="*/ 6690821 w 8363529"/>
                <a:gd name="connsiteY361" fmla="*/ 2191418 h 2481118"/>
                <a:gd name="connsiteX362" fmla="*/ 6682458 w 8363529"/>
                <a:gd name="connsiteY362" fmla="*/ 2176562 h 2481118"/>
                <a:gd name="connsiteX363" fmla="*/ 6615535 w 8363529"/>
                <a:gd name="connsiteY363" fmla="*/ 2008784 h 2481118"/>
                <a:gd name="connsiteX364" fmla="*/ 6607182 w 8363529"/>
                <a:gd name="connsiteY364" fmla="*/ 1978695 h 2481118"/>
                <a:gd name="connsiteX365" fmla="*/ 6598829 w 8363529"/>
                <a:gd name="connsiteY365" fmla="*/ 1997519 h 2481118"/>
                <a:gd name="connsiteX366" fmla="*/ 6531944 w 8363529"/>
                <a:gd name="connsiteY366" fmla="*/ 2132072 h 2481118"/>
                <a:gd name="connsiteX367" fmla="*/ 6523542 w 8363529"/>
                <a:gd name="connsiteY367" fmla="*/ 2147112 h 2481118"/>
                <a:gd name="connsiteX368" fmla="*/ 6515189 w 8363529"/>
                <a:gd name="connsiteY368" fmla="*/ 2134714 h 2481118"/>
                <a:gd name="connsiteX369" fmla="*/ 6448305 w 8363529"/>
                <a:gd name="connsiteY369" fmla="*/ 2046587 h 2481118"/>
                <a:gd name="connsiteX370" fmla="*/ 6439913 w 8363529"/>
                <a:gd name="connsiteY370" fmla="*/ 2036763 h 2481118"/>
                <a:gd name="connsiteX371" fmla="*/ 6431560 w 8363529"/>
                <a:gd name="connsiteY371" fmla="*/ 1979528 h 2481118"/>
                <a:gd name="connsiteX372" fmla="*/ 6364665 w 8363529"/>
                <a:gd name="connsiteY372" fmla="*/ 1479408 h 2481118"/>
                <a:gd name="connsiteX373" fmla="*/ 6356273 w 8363529"/>
                <a:gd name="connsiteY373" fmla="*/ 1411061 h 2481118"/>
                <a:gd name="connsiteX374" fmla="*/ 6347920 w 8363529"/>
                <a:gd name="connsiteY374" fmla="*/ 1478537 h 2481118"/>
                <a:gd name="connsiteX375" fmla="*/ 6281036 w 8363529"/>
                <a:gd name="connsiteY375" fmla="*/ 2112300 h 2481118"/>
                <a:gd name="connsiteX376" fmla="*/ 6272644 w 8363529"/>
                <a:gd name="connsiteY376" fmla="*/ 2205635 h 2481118"/>
                <a:gd name="connsiteX377" fmla="*/ 6264280 w 8363529"/>
                <a:gd name="connsiteY377" fmla="*/ 2160274 h 2481118"/>
                <a:gd name="connsiteX378" fmla="*/ 6197396 w 8363529"/>
                <a:gd name="connsiteY378" fmla="*/ 1877570 h 2481118"/>
                <a:gd name="connsiteX379" fmla="*/ 6189004 w 8363529"/>
                <a:gd name="connsiteY379" fmla="*/ 1849852 h 2481118"/>
                <a:gd name="connsiteX380" fmla="*/ 6180651 w 8363529"/>
                <a:gd name="connsiteY380" fmla="*/ 1863614 h 2481118"/>
                <a:gd name="connsiteX381" fmla="*/ 6113767 w 8363529"/>
                <a:gd name="connsiteY381" fmla="*/ 1990870 h 2481118"/>
                <a:gd name="connsiteX382" fmla="*/ 6105365 w 8363529"/>
                <a:gd name="connsiteY382" fmla="*/ 2009316 h 2481118"/>
                <a:gd name="connsiteX383" fmla="*/ 6097011 w 8363529"/>
                <a:gd name="connsiteY383" fmla="*/ 1992719 h 2481118"/>
                <a:gd name="connsiteX384" fmla="*/ 6030127 w 8363529"/>
                <a:gd name="connsiteY384" fmla="*/ 1875789 h 2481118"/>
                <a:gd name="connsiteX385" fmla="*/ 6021735 w 8363529"/>
                <a:gd name="connsiteY385" fmla="*/ 1862898 h 2481118"/>
                <a:gd name="connsiteX386" fmla="*/ 6013372 w 8363529"/>
                <a:gd name="connsiteY386" fmla="*/ 1898929 h 2481118"/>
                <a:gd name="connsiteX387" fmla="*/ 5946488 w 8363529"/>
                <a:gd name="connsiteY387" fmla="*/ 2345782 h 2481118"/>
                <a:gd name="connsiteX388" fmla="*/ 5938096 w 8363529"/>
                <a:gd name="connsiteY388" fmla="*/ 2434355 h 2481118"/>
                <a:gd name="connsiteX389" fmla="*/ 5929743 w 8363529"/>
                <a:gd name="connsiteY389" fmla="*/ 2365167 h 2481118"/>
                <a:gd name="connsiteX390" fmla="*/ 5862858 w 8363529"/>
                <a:gd name="connsiteY390" fmla="*/ 2035215 h 2481118"/>
                <a:gd name="connsiteX391" fmla="*/ 5854457 w 8363529"/>
                <a:gd name="connsiteY391" fmla="*/ 2009917 h 2481118"/>
                <a:gd name="connsiteX392" fmla="*/ 5846103 w 8363529"/>
                <a:gd name="connsiteY392" fmla="*/ 2018278 h 2481118"/>
                <a:gd name="connsiteX393" fmla="*/ 5779219 w 8363529"/>
                <a:gd name="connsiteY393" fmla="*/ 2109010 h 2481118"/>
                <a:gd name="connsiteX394" fmla="*/ 5770827 w 8363529"/>
                <a:gd name="connsiteY394" fmla="*/ 2124543 h 2481118"/>
                <a:gd name="connsiteX395" fmla="*/ 5762474 w 8363529"/>
                <a:gd name="connsiteY395" fmla="*/ 1983873 h 2481118"/>
                <a:gd name="connsiteX396" fmla="*/ 5695580 w 8363529"/>
                <a:gd name="connsiteY396" fmla="*/ 1202075 h 2481118"/>
                <a:gd name="connsiteX397" fmla="*/ 5687188 w 8363529"/>
                <a:gd name="connsiteY397" fmla="*/ 1133235 h 2481118"/>
                <a:gd name="connsiteX398" fmla="*/ 5678835 w 8363529"/>
                <a:gd name="connsiteY398" fmla="*/ 1203052 h 2481118"/>
                <a:gd name="connsiteX399" fmla="*/ 5611950 w 8363529"/>
                <a:gd name="connsiteY399" fmla="*/ 1764337 h 2481118"/>
                <a:gd name="connsiteX400" fmla="*/ 5603558 w 8363529"/>
                <a:gd name="connsiteY400" fmla="*/ 1834812 h 2481118"/>
                <a:gd name="connsiteX401" fmla="*/ 5595195 w 8363529"/>
                <a:gd name="connsiteY401" fmla="*/ 1879302 h 2481118"/>
                <a:gd name="connsiteX402" fmla="*/ 5528311 w 8363529"/>
                <a:gd name="connsiteY402" fmla="*/ 2385965 h 2481118"/>
                <a:gd name="connsiteX403" fmla="*/ 5519919 w 8363529"/>
                <a:gd name="connsiteY403" fmla="*/ 2477451 h 2481118"/>
                <a:gd name="connsiteX404" fmla="*/ 5511566 w 8363529"/>
                <a:gd name="connsiteY404" fmla="*/ 2462440 h 2481118"/>
                <a:gd name="connsiteX405" fmla="*/ 5444672 w 8363529"/>
                <a:gd name="connsiteY405" fmla="*/ 2194786 h 2481118"/>
                <a:gd name="connsiteX406" fmla="*/ 5436280 w 8363529"/>
                <a:gd name="connsiteY406" fmla="*/ 2113616 h 2481118"/>
                <a:gd name="connsiteX407" fmla="*/ 5427926 w 8363529"/>
                <a:gd name="connsiteY407" fmla="*/ 2045870 h 2481118"/>
                <a:gd name="connsiteX408" fmla="*/ 5361042 w 8363529"/>
                <a:gd name="connsiteY408" fmla="*/ 1849252 h 2481118"/>
                <a:gd name="connsiteX409" fmla="*/ 5352650 w 8363529"/>
                <a:gd name="connsiteY409" fmla="*/ 1839313 h 2481118"/>
                <a:gd name="connsiteX410" fmla="*/ 5344287 w 8363529"/>
                <a:gd name="connsiteY410" fmla="*/ 1867282 h 2481118"/>
                <a:gd name="connsiteX411" fmla="*/ 5277403 w 8363529"/>
                <a:gd name="connsiteY411" fmla="*/ 2060310 h 2481118"/>
                <a:gd name="connsiteX412" fmla="*/ 5269049 w 8363529"/>
                <a:gd name="connsiteY412" fmla="*/ 2081147 h 2481118"/>
                <a:gd name="connsiteX413" fmla="*/ 5260657 w 8363529"/>
                <a:gd name="connsiteY413" fmla="*/ 2033057 h 2481118"/>
                <a:gd name="connsiteX414" fmla="*/ 5193773 w 8363529"/>
                <a:gd name="connsiteY414" fmla="*/ 1678900 h 2481118"/>
                <a:gd name="connsiteX415" fmla="*/ 5185410 w 8363529"/>
                <a:gd name="connsiteY415" fmla="*/ 1638146 h 2481118"/>
                <a:gd name="connsiteX416" fmla="*/ 5177018 w 8363529"/>
                <a:gd name="connsiteY416" fmla="*/ 1650698 h 2481118"/>
                <a:gd name="connsiteX417" fmla="*/ 5110134 w 8363529"/>
                <a:gd name="connsiteY417" fmla="*/ 1787971 h 2481118"/>
                <a:gd name="connsiteX418" fmla="*/ 5101780 w 8363529"/>
                <a:gd name="connsiteY418" fmla="*/ 1811750 h 2481118"/>
                <a:gd name="connsiteX419" fmla="*/ 5093388 w 8363529"/>
                <a:gd name="connsiteY419" fmla="*/ 1824796 h 2481118"/>
                <a:gd name="connsiteX420" fmla="*/ 5026494 w 8363529"/>
                <a:gd name="connsiteY420" fmla="*/ 1912343 h 2481118"/>
                <a:gd name="connsiteX421" fmla="*/ 5018141 w 8363529"/>
                <a:gd name="connsiteY421" fmla="*/ 1921576 h 2481118"/>
                <a:gd name="connsiteX422" fmla="*/ 5009749 w 8363529"/>
                <a:gd name="connsiteY422" fmla="*/ 1936122 h 2481118"/>
                <a:gd name="connsiteX423" fmla="*/ 4942864 w 8363529"/>
                <a:gd name="connsiteY423" fmla="*/ 2039183 h 2481118"/>
                <a:gd name="connsiteX424" fmla="*/ 4934501 w 8363529"/>
                <a:gd name="connsiteY424" fmla="*/ 2050603 h 2481118"/>
                <a:gd name="connsiteX425" fmla="*/ 4926109 w 8363529"/>
                <a:gd name="connsiteY425" fmla="*/ 2022392 h 2481118"/>
                <a:gd name="connsiteX426" fmla="*/ 4859225 w 8363529"/>
                <a:gd name="connsiteY426" fmla="*/ 1683478 h 2481118"/>
                <a:gd name="connsiteX427" fmla="*/ 4850872 w 8363529"/>
                <a:gd name="connsiteY427" fmla="*/ 1618683 h 2481118"/>
                <a:gd name="connsiteX428" fmla="*/ 4842480 w 8363529"/>
                <a:gd name="connsiteY428" fmla="*/ 1584694 h 2481118"/>
                <a:gd name="connsiteX429" fmla="*/ 4775595 w 8363529"/>
                <a:gd name="connsiteY429" fmla="*/ 1378737 h 2481118"/>
                <a:gd name="connsiteX430" fmla="*/ 4767232 w 8363529"/>
                <a:gd name="connsiteY430" fmla="*/ 1359042 h 2481118"/>
                <a:gd name="connsiteX431" fmla="*/ 4758840 w 8363529"/>
                <a:gd name="connsiteY431" fmla="*/ 1370153 h 2481118"/>
                <a:gd name="connsiteX432" fmla="*/ 4691956 w 8363529"/>
                <a:gd name="connsiteY432" fmla="*/ 1469507 h 2481118"/>
                <a:gd name="connsiteX433" fmla="*/ 4683603 w 8363529"/>
                <a:gd name="connsiteY433" fmla="*/ 1483414 h 2481118"/>
                <a:gd name="connsiteX434" fmla="*/ 4675201 w 8363529"/>
                <a:gd name="connsiteY434" fmla="*/ 1525155 h 2481118"/>
                <a:gd name="connsiteX435" fmla="*/ 4608317 w 8363529"/>
                <a:gd name="connsiteY435" fmla="*/ 1866343 h 2481118"/>
                <a:gd name="connsiteX436" fmla="*/ 4599964 w 8363529"/>
                <a:gd name="connsiteY436" fmla="*/ 1909924 h 2481118"/>
                <a:gd name="connsiteX437" fmla="*/ 4591572 w 8363529"/>
                <a:gd name="connsiteY437" fmla="*/ 1873108 h 2481118"/>
                <a:gd name="connsiteX438" fmla="*/ 4524687 w 8363529"/>
                <a:gd name="connsiteY438" fmla="*/ 1609073 h 2481118"/>
                <a:gd name="connsiteX439" fmla="*/ 4516324 w 8363529"/>
                <a:gd name="connsiteY439" fmla="*/ 1579478 h 2481118"/>
                <a:gd name="connsiteX440" fmla="*/ 4507932 w 8363529"/>
                <a:gd name="connsiteY440" fmla="*/ 1610477 h 2481118"/>
                <a:gd name="connsiteX441" fmla="*/ 4441048 w 8363529"/>
                <a:gd name="connsiteY441" fmla="*/ 1845129 h 2481118"/>
                <a:gd name="connsiteX442" fmla="*/ 4432695 w 8363529"/>
                <a:gd name="connsiteY442" fmla="*/ 1872915 h 2481118"/>
                <a:gd name="connsiteX443" fmla="*/ 4424303 w 8363529"/>
                <a:gd name="connsiteY443" fmla="*/ 1785890 h 2481118"/>
                <a:gd name="connsiteX444" fmla="*/ 4357409 w 8363529"/>
                <a:gd name="connsiteY444" fmla="*/ 1083819 h 2481118"/>
                <a:gd name="connsiteX445" fmla="*/ 4349055 w 8363529"/>
                <a:gd name="connsiteY445" fmla="*/ 995285 h 2481118"/>
                <a:gd name="connsiteX446" fmla="*/ 4340664 w 8363529"/>
                <a:gd name="connsiteY446" fmla="*/ 1085639 h 2481118"/>
                <a:gd name="connsiteX447" fmla="*/ 4273779 w 8363529"/>
                <a:gd name="connsiteY447" fmla="*/ 1867998 h 2481118"/>
                <a:gd name="connsiteX448" fmla="*/ 4265416 w 8363529"/>
                <a:gd name="connsiteY448" fmla="*/ 1973895 h 2481118"/>
                <a:gd name="connsiteX449" fmla="*/ 4257024 w 8363529"/>
                <a:gd name="connsiteY449" fmla="*/ 1905433 h 2481118"/>
                <a:gd name="connsiteX450" fmla="*/ 4190140 w 8363529"/>
                <a:gd name="connsiteY450" fmla="*/ 1469129 h 2481118"/>
                <a:gd name="connsiteX451" fmla="*/ 4181787 w 8363529"/>
                <a:gd name="connsiteY451" fmla="*/ 1425424 h 2481118"/>
                <a:gd name="connsiteX452" fmla="*/ 4173394 w 8363529"/>
                <a:gd name="connsiteY452" fmla="*/ 1474152 h 2481118"/>
                <a:gd name="connsiteX453" fmla="*/ 4106500 w 8363529"/>
                <a:gd name="connsiteY453" fmla="*/ 2070936 h 2481118"/>
                <a:gd name="connsiteX454" fmla="*/ 4098147 w 8363529"/>
                <a:gd name="connsiteY454" fmla="*/ 2187566 h 2481118"/>
                <a:gd name="connsiteX455" fmla="*/ 4089755 w 8363529"/>
                <a:gd name="connsiteY455" fmla="*/ 2145525 h 2481118"/>
                <a:gd name="connsiteX456" fmla="*/ 4022871 w 8363529"/>
                <a:gd name="connsiteY456" fmla="*/ 1926483 h 2481118"/>
                <a:gd name="connsiteX457" fmla="*/ 4014517 w 8363529"/>
                <a:gd name="connsiteY457" fmla="*/ 1908298 h 2481118"/>
                <a:gd name="connsiteX458" fmla="*/ 4006154 w 8363529"/>
                <a:gd name="connsiteY458" fmla="*/ 1892387 h 2481118"/>
                <a:gd name="connsiteX459" fmla="*/ 3939231 w 8363529"/>
                <a:gd name="connsiteY459" fmla="*/ 1747788 h 2481118"/>
                <a:gd name="connsiteX460" fmla="*/ 3930878 w 8363529"/>
                <a:gd name="connsiteY460" fmla="*/ 1727213 h 2481118"/>
                <a:gd name="connsiteX461" fmla="*/ 3922525 w 8363529"/>
                <a:gd name="connsiteY461" fmla="*/ 1729603 h 2481118"/>
                <a:gd name="connsiteX462" fmla="*/ 3855602 w 8363529"/>
                <a:gd name="connsiteY462" fmla="*/ 1750691 h 2481118"/>
                <a:gd name="connsiteX463" fmla="*/ 3847239 w 8363529"/>
                <a:gd name="connsiteY463" fmla="*/ 1753643 h 2481118"/>
                <a:gd name="connsiteX464" fmla="*/ 3838885 w 8363529"/>
                <a:gd name="connsiteY464" fmla="*/ 1740559 h 2481118"/>
                <a:gd name="connsiteX465" fmla="*/ 3771962 w 8363529"/>
                <a:gd name="connsiteY465" fmla="*/ 1644988 h 2481118"/>
                <a:gd name="connsiteX466" fmla="*/ 3763609 w 8363529"/>
                <a:gd name="connsiteY466" fmla="*/ 1634101 h 2481118"/>
                <a:gd name="connsiteX467" fmla="*/ 3755246 w 8363529"/>
                <a:gd name="connsiteY467" fmla="*/ 1643672 h 2481118"/>
                <a:gd name="connsiteX468" fmla="*/ 3688323 w 8363529"/>
                <a:gd name="connsiteY468" fmla="*/ 1730851 h 2481118"/>
                <a:gd name="connsiteX469" fmla="*/ 3679970 w 8363529"/>
                <a:gd name="connsiteY469" fmla="*/ 1743288 h 2481118"/>
                <a:gd name="connsiteX470" fmla="*/ 3671616 w 8363529"/>
                <a:gd name="connsiteY470" fmla="*/ 1665748 h 2481118"/>
                <a:gd name="connsiteX471" fmla="*/ 3604693 w 8363529"/>
                <a:gd name="connsiteY471" fmla="*/ 1200981 h 2481118"/>
                <a:gd name="connsiteX472" fmla="*/ 3596330 w 8363529"/>
                <a:gd name="connsiteY472" fmla="*/ 1157043 h 2481118"/>
                <a:gd name="connsiteX473" fmla="*/ 3587977 w 8363529"/>
                <a:gd name="connsiteY473" fmla="*/ 1167863 h 2481118"/>
                <a:gd name="connsiteX474" fmla="*/ 3521054 w 8363529"/>
                <a:gd name="connsiteY474" fmla="*/ 1267663 h 2481118"/>
                <a:gd name="connsiteX475" fmla="*/ 3512701 w 8363529"/>
                <a:gd name="connsiteY475" fmla="*/ 1282064 h 2481118"/>
                <a:gd name="connsiteX476" fmla="*/ 3504347 w 8363529"/>
                <a:gd name="connsiteY476" fmla="*/ 1248423 h 2481118"/>
                <a:gd name="connsiteX477" fmla="*/ 3437424 w 8363529"/>
                <a:gd name="connsiteY477" fmla="*/ 1013809 h 2481118"/>
                <a:gd name="connsiteX478" fmla="*/ 3429061 w 8363529"/>
                <a:gd name="connsiteY478" fmla="*/ 988211 h 2481118"/>
                <a:gd name="connsiteX479" fmla="*/ 3420708 w 8363529"/>
                <a:gd name="connsiteY479" fmla="*/ 1034258 h 2481118"/>
                <a:gd name="connsiteX480" fmla="*/ 3353785 w 8363529"/>
                <a:gd name="connsiteY480" fmla="*/ 1936315 h 2481118"/>
                <a:gd name="connsiteX481" fmla="*/ 3345432 w 8363529"/>
                <a:gd name="connsiteY481" fmla="*/ 2243969 h 2481118"/>
                <a:gd name="connsiteX482" fmla="*/ 3337069 w 8363529"/>
                <a:gd name="connsiteY482" fmla="*/ 2234175 h 2481118"/>
                <a:gd name="connsiteX483" fmla="*/ 3270146 w 8363529"/>
                <a:gd name="connsiteY483" fmla="*/ 2199847 h 2481118"/>
                <a:gd name="connsiteX484" fmla="*/ 3261792 w 8363529"/>
                <a:gd name="connsiteY484" fmla="*/ 2197844 h 2481118"/>
                <a:gd name="connsiteX485" fmla="*/ 3253439 w 8363529"/>
                <a:gd name="connsiteY485" fmla="*/ 2140153 h 2481118"/>
                <a:gd name="connsiteX486" fmla="*/ 3186516 w 8363529"/>
                <a:gd name="connsiteY486" fmla="*/ 1773454 h 2481118"/>
                <a:gd name="connsiteX487" fmla="*/ 3178153 w 8363529"/>
                <a:gd name="connsiteY487" fmla="*/ 1736823 h 2481118"/>
                <a:gd name="connsiteX488" fmla="*/ 3169800 w 8363529"/>
                <a:gd name="connsiteY488" fmla="*/ 1725441 h 2481118"/>
                <a:gd name="connsiteX489" fmla="*/ 3102877 w 8363529"/>
                <a:gd name="connsiteY489" fmla="*/ 1599589 h 2481118"/>
                <a:gd name="connsiteX490" fmla="*/ 3094523 w 8363529"/>
                <a:gd name="connsiteY490" fmla="*/ 1577513 h 2481118"/>
                <a:gd name="connsiteX491" fmla="*/ 3086161 w 8363529"/>
                <a:gd name="connsiteY491" fmla="*/ 1577281 h 2481118"/>
                <a:gd name="connsiteX492" fmla="*/ 3019238 w 8363529"/>
                <a:gd name="connsiteY492" fmla="*/ 1576071 h 2481118"/>
                <a:gd name="connsiteX493" fmla="*/ 3010884 w 8363529"/>
                <a:gd name="connsiteY493" fmla="*/ 1575965 h 2481118"/>
                <a:gd name="connsiteX494" fmla="*/ 3002531 w 8363529"/>
                <a:gd name="connsiteY494" fmla="*/ 1566325 h 2481118"/>
                <a:gd name="connsiteX495" fmla="*/ 2935608 w 8363529"/>
                <a:gd name="connsiteY495" fmla="*/ 1485872 h 2481118"/>
                <a:gd name="connsiteX496" fmla="*/ 2927245 w 8363529"/>
                <a:gd name="connsiteY496" fmla="*/ 1475362 h 2481118"/>
                <a:gd name="connsiteX497" fmla="*/ 2918892 w 8363529"/>
                <a:gd name="connsiteY497" fmla="*/ 1499334 h 2481118"/>
                <a:gd name="connsiteX498" fmla="*/ 2851968 w 8363529"/>
                <a:gd name="connsiteY498" fmla="*/ 1685859 h 2481118"/>
                <a:gd name="connsiteX499" fmla="*/ 2843615 w 8363529"/>
                <a:gd name="connsiteY499" fmla="*/ 1708544 h 2481118"/>
                <a:gd name="connsiteX500" fmla="*/ 2835262 w 8363529"/>
                <a:gd name="connsiteY500" fmla="*/ 1709792 h 2481118"/>
                <a:gd name="connsiteX501" fmla="*/ 2768329 w 8363529"/>
                <a:gd name="connsiteY501" fmla="*/ 1722722 h 2481118"/>
                <a:gd name="connsiteX502" fmla="*/ 2759976 w 8363529"/>
                <a:gd name="connsiteY502" fmla="*/ 1724871 h 2481118"/>
                <a:gd name="connsiteX503" fmla="*/ 2751623 w 8363529"/>
                <a:gd name="connsiteY503" fmla="*/ 1730813 h 2481118"/>
                <a:gd name="connsiteX504" fmla="*/ 2684699 w 8363529"/>
                <a:gd name="connsiteY504" fmla="*/ 1770802 h 2481118"/>
                <a:gd name="connsiteX505" fmla="*/ 2676346 w 8363529"/>
                <a:gd name="connsiteY505" fmla="*/ 1775041 h 2481118"/>
                <a:gd name="connsiteX506" fmla="*/ 2667983 w 8363529"/>
                <a:gd name="connsiteY506" fmla="*/ 1800485 h 2481118"/>
                <a:gd name="connsiteX507" fmla="*/ 2601060 w 8363529"/>
                <a:gd name="connsiteY507" fmla="*/ 2001681 h 2481118"/>
                <a:gd name="connsiteX508" fmla="*/ 2592707 w 8363529"/>
                <a:gd name="connsiteY508" fmla="*/ 2026514 h 2481118"/>
                <a:gd name="connsiteX509" fmla="*/ 2584354 w 8363529"/>
                <a:gd name="connsiteY509" fmla="*/ 1916350 h 2481118"/>
                <a:gd name="connsiteX510" fmla="*/ 2517430 w 8363529"/>
                <a:gd name="connsiteY510" fmla="*/ 1165134 h 2481118"/>
                <a:gd name="connsiteX511" fmla="*/ 2509068 w 8363529"/>
                <a:gd name="connsiteY511" fmla="*/ 1084874 h 2481118"/>
                <a:gd name="connsiteX512" fmla="*/ 2500714 w 8363529"/>
                <a:gd name="connsiteY512" fmla="*/ 1160566 h 2481118"/>
                <a:gd name="connsiteX513" fmla="*/ 2433791 w 8363529"/>
                <a:gd name="connsiteY513" fmla="*/ 1801356 h 2481118"/>
                <a:gd name="connsiteX514" fmla="*/ 2425438 w 8363529"/>
                <a:gd name="connsiteY514" fmla="*/ 1886145 h 2481118"/>
                <a:gd name="connsiteX515" fmla="*/ 2417075 w 8363529"/>
                <a:gd name="connsiteY515" fmla="*/ 1892387 h 2481118"/>
                <a:gd name="connsiteX516" fmla="*/ 2350152 w 8363529"/>
                <a:gd name="connsiteY516" fmla="*/ 1945006 h 2481118"/>
                <a:gd name="connsiteX517" fmla="*/ 2341799 w 8363529"/>
                <a:gd name="connsiteY517" fmla="*/ 1951926 h 2481118"/>
                <a:gd name="connsiteX518" fmla="*/ 2333445 w 8363529"/>
                <a:gd name="connsiteY518" fmla="*/ 1951287 h 2481118"/>
                <a:gd name="connsiteX519" fmla="*/ 2266522 w 8363529"/>
                <a:gd name="connsiteY519" fmla="*/ 1944938 h 2481118"/>
                <a:gd name="connsiteX520" fmla="*/ 2258159 w 8363529"/>
                <a:gd name="connsiteY520" fmla="*/ 1943951 h 2481118"/>
                <a:gd name="connsiteX521" fmla="*/ 2249806 w 8363529"/>
                <a:gd name="connsiteY521" fmla="*/ 1896171 h 2481118"/>
                <a:gd name="connsiteX522" fmla="*/ 2182883 w 8363529"/>
                <a:gd name="connsiteY522" fmla="*/ 1577020 h 2481118"/>
                <a:gd name="connsiteX523" fmla="*/ 2174530 w 8363529"/>
                <a:gd name="connsiteY523" fmla="*/ 1543563 h 2481118"/>
                <a:gd name="connsiteX524" fmla="*/ 2166176 w 8363529"/>
                <a:gd name="connsiteY524" fmla="*/ 1515816 h 2481118"/>
                <a:gd name="connsiteX525" fmla="*/ 2099253 w 8363529"/>
                <a:gd name="connsiteY525" fmla="*/ 1258178 h 2481118"/>
                <a:gd name="connsiteX526" fmla="*/ 2090890 w 8363529"/>
                <a:gd name="connsiteY526" fmla="*/ 1220744 h 2481118"/>
                <a:gd name="connsiteX527" fmla="*/ 2082537 w 8363529"/>
                <a:gd name="connsiteY527" fmla="*/ 1300897 h 2481118"/>
                <a:gd name="connsiteX528" fmla="*/ 2015614 w 8363529"/>
                <a:gd name="connsiteY528" fmla="*/ 1790575 h 2481118"/>
                <a:gd name="connsiteX529" fmla="*/ 2007260 w 8363529"/>
                <a:gd name="connsiteY529" fmla="*/ 1837716 h 2481118"/>
                <a:gd name="connsiteX530" fmla="*/ 1998898 w 8363529"/>
                <a:gd name="connsiteY530" fmla="*/ 1826490 h 2481118"/>
                <a:gd name="connsiteX531" fmla="*/ 1931975 w 8363529"/>
                <a:gd name="connsiteY531" fmla="*/ 1711718 h 2481118"/>
                <a:gd name="connsiteX532" fmla="*/ 1923621 w 8363529"/>
                <a:gd name="connsiteY532" fmla="*/ 1693233 h 2481118"/>
                <a:gd name="connsiteX533" fmla="*/ 1915268 w 8363529"/>
                <a:gd name="connsiteY533" fmla="*/ 1692439 h 2481118"/>
                <a:gd name="connsiteX534" fmla="*/ 1848345 w 8363529"/>
                <a:gd name="connsiteY534" fmla="*/ 1685975 h 2481118"/>
                <a:gd name="connsiteX535" fmla="*/ 1839982 w 8363529"/>
                <a:gd name="connsiteY535" fmla="*/ 1685181 h 2481118"/>
                <a:gd name="connsiteX536" fmla="*/ 1831629 w 8363529"/>
                <a:gd name="connsiteY536" fmla="*/ 1694104 h 2481118"/>
                <a:gd name="connsiteX537" fmla="*/ 1764706 w 8363529"/>
                <a:gd name="connsiteY537" fmla="*/ 1761202 h 2481118"/>
                <a:gd name="connsiteX538" fmla="*/ 1756352 w 8363529"/>
                <a:gd name="connsiteY538" fmla="*/ 1769070 h 2481118"/>
                <a:gd name="connsiteX539" fmla="*/ 1747989 w 8363529"/>
                <a:gd name="connsiteY539" fmla="*/ 1775457 h 2481118"/>
                <a:gd name="connsiteX540" fmla="*/ 1681066 w 8363529"/>
                <a:gd name="connsiteY540" fmla="*/ 1817683 h 2481118"/>
                <a:gd name="connsiteX541" fmla="*/ 1672713 w 8363529"/>
                <a:gd name="connsiteY541" fmla="*/ 1822067 h 2481118"/>
                <a:gd name="connsiteX542" fmla="*/ 1664360 w 8363529"/>
                <a:gd name="connsiteY542" fmla="*/ 1840861 h 2481118"/>
                <a:gd name="connsiteX543" fmla="*/ 1597437 w 8363529"/>
                <a:gd name="connsiteY543" fmla="*/ 2063910 h 2481118"/>
                <a:gd name="connsiteX544" fmla="*/ 1589074 w 8363529"/>
                <a:gd name="connsiteY544" fmla="*/ 2106058 h 2481118"/>
                <a:gd name="connsiteX545" fmla="*/ 1580720 w 8363529"/>
                <a:gd name="connsiteY545" fmla="*/ 2098383 h 2481118"/>
                <a:gd name="connsiteX546" fmla="*/ 1513797 w 8363529"/>
                <a:gd name="connsiteY546" fmla="*/ 2050254 h 2481118"/>
                <a:gd name="connsiteX547" fmla="*/ 1505444 w 8363529"/>
                <a:gd name="connsiteY547" fmla="*/ 2045532 h 2481118"/>
                <a:gd name="connsiteX548" fmla="*/ 1497091 w 8363529"/>
                <a:gd name="connsiteY548" fmla="*/ 2025643 h 2481118"/>
                <a:gd name="connsiteX549" fmla="*/ 1430158 w 8363529"/>
                <a:gd name="connsiteY549" fmla="*/ 1892310 h 2481118"/>
                <a:gd name="connsiteX550" fmla="*/ 1421805 w 8363529"/>
                <a:gd name="connsiteY550" fmla="*/ 1878286 h 2481118"/>
                <a:gd name="connsiteX551" fmla="*/ 1413451 w 8363529"/>
                <a:gd name="connsiteY551" fmla="*/ 1879002 h 2481118"/>
                <a:gd name="connsiteX552" fmla="*/ 1346528 w 8363529"/>
                <a:gd name="connsiteY552" fmla="*/ 1887771 h 2481118"/>
                <a:gd name="connsiteX553" fmla="*/ 1338175 w 8363529"/>
                <a:gd name="connsiteY553" fmla="*/ 1889435 h 2481118"/>
                <a:gd name="connsiteX554" fmla="*/ 1329812 w 8363529"/>
                <a:gd name="connsiteY554" fmla="*/ 1774964 h 2481118"/>
                <a:gd name="connsiteX555" fmla="*/ 1262889 w 8363529"/>
                <a:gd name="connsiteY555" fmla="*/ 1210272 h 2481118"/>
                <a:gd name="connsiteX556" fmla="*/ 1254536 w 8363529"/>
                <a:gd name="connsiteY556" fmla="*/ 1165666 h 2481118"/>
                <a:gd name="connsiteX557" fmla="*/ 1246182 w 8363529"/>
                <a:gd name="connsiteY557" fmla="*/ 1185138 h 2481118"/>
                <a:gd name="connsiteX558" fmla="*/ 1179259 w 8363529"/>
                <a:gd name="connsiteY558" fmla="*/ 1369127 h 2481118"/>
                <a:gd name="connsiteX559" fmla="*/ 1170896 w 8363529"/>
                <a:gd name="connsiteY559" fmla="*/ 1396390 h 2481118"/>
                <a:gd name="connsiteX560" fmla="*/ 1162543 w 8363529"/>
                <a:gd name="connsiteY560" fmla="*/ 1472488 h 2481118"/>
                <a:gd name="connsiteX561" fmla="*/ 1095620 w 8363529"/>
                <a:gd name="connsiteY561" fmla="*/ 2047835 h 2481118"/>
                <a:gd name="connsiteX562" fmla="*/ 1087267 w 8363529"/>
                <a:gd name="connsiteY562" fmla="*/ 2115852 h 2481118"/>
                <a:gd name="connsiteX563" fmla="*/ 1078904 w 8363529"/>
                <a:gd name="connsiteY563" fmla="*/ 2055964 h 2481118"/>
                <a:gd name="connsiteX564" fmla="*/ 1011981 w 8363529"/>
                <a:gd name="connsiteY564" fmla="*/ 1659167 h 2481118"/>
                <a:gd name="connsiteX565" fmla="*/ 1003627 w 8363529"/>
                <a:gd name="connsiteY565" fmla="*/ 1617929 h 2481118"/>
                <a:gd name="connsiteX566" fmla="*/ 995274 w 8363529"/>
                <a:gd name="connsiteY566" fmla="*/ 1600499 h 2481118"/>
                <a:gd name="connsiteX567" fmla="*/ 928351 w 8363529"/>
                <a:gd name="connsiteY567" fmla="*/ 1419936 h 2481118"/>
                <a:gd name="connsiteX568" fmla="*/ 919988 w 8363529"/>
                <a:gd name="connsiteY568" fmla="*/ 1390496 h 2481118"/>
                <a:gd name="connsiteX569" fmla="*/ 911635 w 8363529"/>
                <a:gd name="connsiteY569" fmla="*/ 1448564 h 2481118"/>
                <a:gd name="connsiteX570" fmla="*/ 844712 w 8363529"/>
                <a:gd name="connsiteY570" fmla="*/ 1825280 h 2481118"/>
                <a:gd name="connsiteX571" fmla="*/ 836358 w 8363529"/>
                <a:gd name="connsiteY571" fmla="*/ 1863653 h 2481118"/>
                <a:gd name="connsiteX572" fmla="*/ 828005 w 8363529"/>
                <a:gd name="connsiteY572" fmla="*/ 1870234 h 2481118"/>
                <a:gd name="connsiteX573" fmla="*/ 761082 w 8363529"/>
                <a:gd name="connsiteY573" fmla="*/ 1937370 h 2481118"/>
                <a:gd name="connsiteX574" fmla="*/ 752719 w 8363529"/>
                <a:gd name="connsiteY574" fmla="*/ 1948151 h 2481118"/>
                <a:gd name="connsiteX575" fmla="*/ 744366 w 8363529"/>
                <a:gd name="connsiteY575" fmla="*/ 1924479 h 2481118"/>
                <a:gd name="connsiteX576" fmla="*/ 677443 w 8363529"/>
                <a:gd name="connsiteY576" fmla="*/ 1698488 h 2481118"/>
                <a:gd name="connsiteX577" fmla="*/ 669089 w 8363529"/>
                <a:gd name="connsiteY577" fmla="*/ 1664615 h 2481118"/>
                <a:gd name="connsiteX578" fmla="*/ 660727 w 8363529"/>
                <a:gd name="connsiteY578" fmla="*/ 1570023 h 2481118"/>
                <a:gd name="connsiteX579" fmla="*/ 593803 w 8363529"/>
                <a:gd name="connsiteY579" fmla="*/ 1054485 h 2481118"/>
                <a:gd name="connsiteX580" fmla="*/ 585450 w 8363529"/>
                <a:gd name="connsiteY580" fmla="*/ 1009870 h 2481118"/>
                <a:gd name="connsiteX581" fmla="*/ 577097 w 8363529"/>
                <a:gd name="connsiteY581" fmla="*/ 1055463 h 2481118"/>
                <a:gd name="connsiteX582" fmla="*/ 510174 w 8363529"/>
                <a:gd name="connsiteY582" fmla="*/ 1640304 h 2481118"/>
                <a:gd name="connsiteX583" fmla="*/ 501811 w 8363529"/>
                <a:gd name="connsiteY583" fmla="*/ 1760602 h 2481118"/>
                <a:gd name="connsiteX584" fmla="*/ 493458 w 8363529"/>
                <a:gd name="connsiteY584" fmla="*/ 1691607 h 2481118"/>
                <a:gd name="connsiteX585" fmla="*/ 426534 w 8363529"/>
                <a:gd name="connsiteY585" fmla="*/ 1382705 h 2481118"/>
                <a:gd name="connsiteX586" fmla="*/ 418181 w 8363529"/>
                <a:gd name="connsiteY586" fmla="*/ 1360320 h 2481118"/>
                <a:gd name="connsiteX587" fmla="*/ 409818 w 8363529"/>
                <a:gd name="connsiteY587" fmla="*/ 1392567 h 2481118"/>
                <a:gd name="connsiteX588" fmla="*/ 342895 w 8363529"/>
                <a:gd name="connsiteY588" fmla="*/ 1743172 h 2481118"/>
                <a:gd name="connsiteX589" fmla="*/ 334542 w 8363529"/>
                <a:gd name="connsiteY589" fmla="*/ 1803398 h 2481118"/>
                <a:gd name="connsiteX590" fmla="*/ 326189 w 8363529"/>
                <a:gd name="connsiteY590" fmla="*/ 1840823 h 2481118"/>
                <a:gd name="connsiteX591" fmla="*/ 259304 w 8363529"/>
                <a:gd name="connsiteY591" fmla="*/ 2186472 h 2481118"/>
                <a:gd name="connsiteX592" fmla="*/ 250903 w 8363529"/>
                <a:gd name="connsiteY592" fmla="*/ 2236488 h 2481118"/>
                <a:gd name="connsiteX593" fmla="*/ 242549 w 8363529"/>
                <a:gd name="connsiteY593" fmla="*/ 2155619 h 2481118"/>
                <a:gd name="connsiteX594" fmla="*/ 175665 w 8363529"/>
                <a:gd name="connsiteY594" fmla="*/ 1703434 h 2481118"/>
                <a:gd name="connsiteX595" fmla="*/ 167273 w 8363529"/>
                <a:gd name="connsiteY595" fmla="*/ 1663406 h 2481118"/>
                <a:gd name="connsiteX596" fmla="*/ 158920 w 8363529"/>
                <a:gd name="connsiteY596" fmla="*/ 1651347 h 2481118"/>
                <a:gd name="connsiteX597" fmla="*/ 92029 w 8363529"/>
                <a:gd name="connsiteY597" fmla="*/ 1540427 h 2481118"/>
                <a:gd name="connsiteX598" fmla="*/ 83635 w 8363529"/>
                <a:gd name="connsiteY598" fmla="*/ 1524391 h 2481118"/>
                <a:gd name="connsiteX599" fmla="*/ 75279 w 8363529"/>
                <a:gd name="connsiteY599" fmla="*/ 1546776 h 2481118"/>
                <a:gd name="connsiteX600" fmla="*/ 8394 w 8363529"/>
                <a:gd name="connsiteY600" fmla="*/ 1723361 h 2481118"/>
                <a:gd name="connsiteX601" fmla="*/ 0 w 8363529"/>
                <a:gd name="connsiteY601" fmla="*/ 1745136 h 24811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  <a:cxn ang="0">
                  <a:pos x="connsiteX466" y="connsiteY466"/>
                </a:cxn>
                <a:cxn ang="0">
                  <a:pos x="connsiteX467" y="connsiteY467"/>
                </a:cxn>
                <a:cxn ang="0">
                  <a:pos x="connsiteX468" y="connsiteY468"/>
                </a:cxn>
                <a:cxn ang="0">
                  <a:pos x="connsiteX469" y="connsiteY469"/>
                </a:cxn>
                <a:cxn ang="0">
                  <a:pos x="connsiteX470" y="connsiteY470"/>
                </a:cxn>
                <a:cxn ang="0">
                  <a:pos x="connsiteX471" y="connsiteY471"/>
                </a:cxn>
                <a:cxn ang="0">
                  <a:pos x="connsiteX472" y="connsiteY472"/>
                </a:cxn>
                <a:cxn ang="0">
                  <a:pos x="connsiteX473" y="connsiteY473"/>
                </a:cxn>
                <a:cxn ang="0">
                  <a:pos x="connsiteX474" y="connsiteY474"/>
                </a:cxn>
                <a:cxn ang="0">
                  <a:pos x="connsiteX475" y="connsiteY475"/>
                </a:cxn>
                <a:cxn ang="0">
                  <a:pos x="connsiteX476" y="connsiteY476"/>
                </a:cxn>
                <a:cxn ang="0">
                  <a:pos x="connsiteX477" y="connsiteY477"/>
                </a:cxn>
                <a:cxn ang="0">
                  <a:pos x="connsiteX478" y="connsiteY478"/>
                </a:cxn>
                <a:cxn ang="0">
                  <a:pos x="connsiteX479" y="connsiteY479"/>
                </a:cxn>
                <a:cxn ang="0">
                  <a:pos x="connsiteX480" y="connsiteY480"/>
                </a:cxn>
                <a:cxn ang="0">
                  <a:pos x="connsiteX481" y="connsiteY481"/>
                </a:cxn>
                <a:cxn ang="0">
                  <a:pos x="connsiteX482" y="connsiteY482"/>
                </a:cxn>
                <a:cxn ang="0">
                  <a:pos x="connsiteX483" y="connsiteY483"/>
                </a:cxn>
                <a:cxn ang="0">
                  <a:pos x="connsiteX484" y="connsiteY484"/>
                </a:cxn>
                <a:cxn ang="0">
                  <a:pos x="connsiteX485" y="connsiteY485"/>
                </a:cxn>
                <a:cxn ang="0">
                  <a:pos x="connsiteX486" y="connsiteY486"/>
                </a:cxn>
                <a:cxn ang="0">
                  <a:pos x="connsiteX487" y="connsiteY487"/>
                </a:cxn>
                <a:cxn ang="0">
                  <a:pos x="connsiteX488" y="connsiteY488"/>
                </a:cxn>
                <a:cxn ang="0">
                  <a:pos x="connsiteX489" y="connsiteY489"/>
                </a:cxn>
                <a:cxn ang="0">
                  <a:pos x="connsiteX490" y="connsiteY490"/>
                </a:cxn>
                <a:cxn ang="0">
                  <a:pos x="connsiteX491" y="connsiteY491"/>
                </a:cxn>
                <a:cxn ang="0">
                  <a:pos x="connsiteX492" y="connsiteY492"/>
                </a:cxn>
                <a:cxn ang="0">
                  <a:pos x="connsiteX493" y="connsiteY493"/>
                </a:cxn>
                <a:cxn ang="0">
                  <a:pos x="connsiteX494" y="connsiteY494"/>
                </a:cxn>
                <a:cxn ang="0">
                  <a:pos x="connsiteX495" y="connsiteY495"/>
                </a:cxn>
                <a:cxn ang="0">
                  <a:pos x="connsiteX496" y="connsiteY496"/>
                </a:cxn>
                <a:cxn ang="0">
                  <a:pos x="connsiteX497" y="connsiteY497"/>
                </a:cxn>
                <a:cxn ang="0">
                  <a:pos x="connsiteX498" y="connsiteY498"/>
                </a:cxn>
                <a:cxn ang="0">
                  <a:pos x="connsiteX499" y="connsiteY499"/>
                </a:cxn>
                <a:cxn ang="0">
                  <a:pos x="connsiteX500" y="connsiteY500"/>
                </a:cxn>
                <a:cxn ang="0">
                  <a:pos x="connsiteX501" y="connsiteY501"/>
                </a:cxn>
                <a:cxn ang="0">
                  <a:pos x="connsiteX502" y="connsiteY502"/>
                </a:cxn>
                <a:cxn ang="0">
                  <a:pos x="connsiteX503" y="connsiteY503"/>
                </a:cxn>
                <a:cxn ang="0">
                  <a:pos x="connsiteX504" y="connsiteY504"/>
                </a:cxn>
                <a:cxn ang="0">
                  <a:pos x="connsiteX505" y="connsiteY505"/>
                </a:cxn>
                <a:cxn ang="0">
                  <a:pos x="connsiteX506" y="connsiteY506"/>
                </a:cxn>
                <a:cxn ang="0">
                  <a:pos x="connsiteX507" y="connsiteY507"/>
                </a:cxn>
                <a:cxn ang="0">
                  <a:pos x="connsiteX508" y="connsiteY508"/>
                </a:cxn>
                <a:cxn ang="0">
                  <a:pos x="connsiteX509" y="connsiteY509"/>
                </a:cxn>
                <a:cxn ang="0">
                  <a:pos x="connsiteX510" y="connsiteY510"/>
                </a:cxn>
                <a:cxn ang="0">
                  <a:pos x="connsiteX511" y="connsiteY511"/>
                </a:cxn>
                <a:cxn ang="0">
                  <a:pos x="connsiteX512" y="connsiteY512"/>
                </a:cxn>
                <a:cxn ang="0">
                  <a:pos x="connsiteX513" y="connsiteY513"/>
                </a:cxn>
                <a:cxn ang="0">
                  <a:pos x="connsiteX514" y="connsiteY514"/>
                </a:cxn>
                <a:cxn ang="0">
                  <a:pos x="connsiteX515" y="connsiteY515"/>
                </a:cxn>
                <a:cxn ang="0">
                  <a:pos x="connsiteX516" y="connsiteY516"/>
                </a:cxn>
                <a:cxn ang="0">
                  <a:pos x="connsiteX517" y="connsiteY517"/>
                </a:cxn>
                <a:cxn ang="0">
                  <a:pos x="connsiteX518" y="connsiteY518"/>
                </a:cxn>
                <a:cxn ang="0">
                  <a:pos x="connsiteX519" y="connsiteY519"/>
                </a:cxn>
                <a:cxn ang="0">
                  <a:pos x="connsiteX520" y="connsiteY520"/>
                </a:cxn>
                <a:cxn ang="0">
                  <a:pos x="connsiteX521" y="connsiteY521"/>
                </a:cxn>
                <a:cxn ang="0">
                  <a:pos x="connsiteX522" y="connsiteY522"/>
                </a:cxn>
                <a:cxn ang="0">
                  <a:pos x="connsiteX523" y="connsiteY523"/>
                </a:cxn>
                <a:cxn ang="0">
                  <a:pos x="connsiteX524" y="connsiteY524"/>
                </a:cxn>
                <a:cxn ang="0">
                  <a:pos x="connsiteX525" y="connsiteY525"/>
                </a:cxn>
                <a:cxn ang="0">
                  <a:pos x="connsiteX526" y="connsiteY526"/>
                </a:cxn>
                <a:cxn ang="0">
                  <a:pos x="connsiteX527" y="connsiteY527"/>
                </a:cxn>
                <a:cxn ang="0">
                  <a:pos x="connsiteX528" y="connsiteY528"/>
                </a:cxn>
                <a:cxn ang="0">
                  <a:pos x="connsiteX529" y="connsiteY529"/>
                </a:cxn>
                <a:cxn ang="0">
                  <a:pos x="connsiteX530" y="connsiteY530"/>
                </a:cxn>
                <a:cxn ang="0">
                  <a:pos x="connsiteX531" y="connsiteY531"/>
                </a:cxn>
                <a:cxn ang="0">
                  <a:pos x="connsiteX532" y="connsiteY532"/>
                </a:cxn>
                <a:cxn ang="0">
                  <a:pos x="connsiteX533" y="connsiteY533"/>
                </a:cxn>
                <a:cxn ang="0">
                  <a:pos x="connsiteX534" y="connsiteY534"/>
                </a:cxn>
                <a:cxn ang="0">
                  <a:pos x="connsiteX535" y="connsiteY535"/>
                </a:cxn>
                <a:cxn ang="0">
                  <a:pos x="connsiteX536" y="connsiteY536"/>
                </a:cxn>
                <a:cxn ang="0">
                  <a:pos x="connsiteX537" y="connsiteY537"/>
                </a:cxn>
                <a:cxn ang="0">
                  <a:pos x="connsiteX538" y="connsiteY538"/>
                </a:cxn>
                <a:cxn ang="0">
                  <a:pos x="connsiteX539" y="connsiteY539"/>
                </a:cxn>
                <a:cxn ang="0">
                  <a:pos x="connsiteX540" y="connsiteY540"/>
                </a:cxn>
                <a:cxn ang="0">
                  <a:pos x="connsiteX541" y="connsiteY541"/>
                </a:cxn>
                <a:cxn ang="0">
                  <a:pos x="connsiteX542" y="connsiteY542"/>
                </a:cxn>
                <a:cxn ang="0">
                  <a:pos x="connsiteX543" y="connsiteY543"/>
                </a:cxn>
                <a:cxn ang="0">
                  <a:pos x="connsiteX544" y="connsiteY544"/>
                </a:cxn>
                <a:cxn ang="0">
                  <a:pos x="connsiteX545" y="connsiteY545"/>
                </a:cxn>
                <a:cxn ang="0">
                  <a:pos x="connsiteX546" y="connsiteY546"/>
                </a:cxn>
                <a:cxn ang="0">
                  <a:pos x="connsiteX547" y="connsiteY547"/>
                </a:cxn>
                <a:cxn ang="0">
                  <a:pos x="connsiteX548" y="connsiteY548"/>
                </a:cxn>
                <a:cxn ang="0">
                  <a:pos x="connsiteX549" y="connsiteY549"/>
                </a:cxn>
                <a:cxn ang="0">
                  <a:pos x="connsiteX550" y="connsiteY550"/>
                </a:cxn>
                <a:cxn ang="0">
                  <a:pos x="connsiteX551" y="connsiteY551"/>
                </a:cxn>
                <a:cxn ang="0">
                  <a:pos x="connsiteX552" y="connsiteY552"/>
                </a:cxn>
                <a:cxn ang="0">
                  <a:pos x="connsiteX553" y="connsiteY553"/>
                </a:cxn>
                <a:cxn ang="0">
                  <a:pos x="connsiteX554" y="connsiteY554"/>
                </a:cxn>
                <a:cxn ang="0">
                  <a:pos x="connsiteX555" y="connsiteY555"/>
                </a:cxn>
                <a:cxn ang="0">
                  <a:pos x="connsiteX556" y="connsiteY556"/>
                </a:cxn>
                <a:cxn ang="0">
                  <a:pos x="connsiteX557" y="connsiteY557"/>
                </a:cxn>
                <a:cxn ang="0">
                  <a:pos x="connsiteX558" y="connsiteY558"/>
                </a:cxn>
                <a:cxn ang="0">
                  <a:pos x="connsiteX559" y="connsiteY559"/>
                </a:cxn>
                <a:cxn ang="0">
                  <a:pos x="connsiteX560" y="connsiteY560"/>
                </a:cxn>
                <a:cxn ang="0">
                  <a:pos x="connsiteX561" y="connsiteY561"/>
                </a:cxn>
                <a:cxn ang="0">
                  <a:pos x="connsiteX562" y="connsiteY562"/>
                </a:cxn>
                <a:cxn ang="0">
                  <a:pos x="connsiteX563" y="connsiteY563"/>
                </a:cxn>
                <a:cxn ang="0">
                  <a:pos x="connsiteX564" y="connsiteY564"/>
                </a:cxn>
                <a:cxn ang="0">
                  <a:pos x="connsiteX565" y="connsiteY565"/>
                </a:cxn>
                <a:cxn ang="0">
                  <a:pos x="connsiteX566" y="connsiteY566"/>
                </a:cxn>
                <a:cxn ang="0">
                  <a:pos x="connsiteX567" y="connsiteY567"/>
                </a:cxn>
                <a:cxn ang="0">
                  <a:pos x="connsiteX568" y="connsiteY568"/>
                </a:cxn>
                <a:cxn ang="0">
                  <a:pos x="connsiteX569" y="connsiteY569"/>
                </a:cxn>
                <a:cxn ang="0">
                  <a:pos x="connsiteX570" y="connsiteY570"/>
                </a:cxn>
                <a:cxn ang="0">
                  <a:pos x="connsiteX571" y="connsiteY571"/>
                </a:cxn>
                <a:cxn ang="0">
                  <a:pos x="connsiteX572" y="connsiteY572"/>
                </a:cxn>
                <a:cxn ang="0">
                  <a:pos x="connsiteX573" y="connsiteY573"/>
                </a:cxn>
                <a:cxn ang="0">
                  <a:pos x="connsiteX574" y="connsiteY574"/>
                </a:cxn>
                <a:cxn ang="0">
                  <a:pos x="connsiteX575" y="connsiteY575"/>
                </a:cxn>
                <a:cxn ang="0">
                  <a:pos x="connsiteX576" y="connsiteY576"/>
                </a:cxn>
                <a:cxn ang="0">
                  <a:pos x="connsiteX577" y="connsiteY577"/>
                </a:cxn>
                <a:cxn ang="0">
                  <a:pos x="connsiteX578" y="connsiteY578"/>
                </a:cxn>
                <a:cxn ang="0">
                  <a:pos x="connsiteX579" y="connsiteY579"/>
                </a:cxn>
                <a:cxn ang="0">
                  <a:pos x="connsiteX580" y="connsiteY580"/>
                </a:cxn>
                <a:cxn ang="0">
                  <a:pos x="connsiteX581" y="connsiteY581"/>
                </a:cxn>
                <a:cxn ang="0">
                  <a:pos x="connsiteX582" y="connsiteY582"/>
                </a:cxn>
                <a:cxn ang="0">
                  <a:pos x="connsiteX583" y="connsiteY583"/>
                </a:cxn>
                <a:cxn ang="0">
                  <a:pos x="connsiteX584" y="connsiteY584"/>
                </a:cxn>
                <a:cxn ang="0">
                  <a:pos x="connsiteX585" y="connsiteY585"/>
                </a:cxn>
                <a:cxn ang="0">
                  <a:pos x="connsiteX586" y="connsiteY586"/>
                </a:cxn>
                <a:cxn ang="0">
                  <a:pos x="connsiteX587" y="connsiteY587"/>
                </a:cxn>
                <a:cxn ang="0">
                  <a:pos x="connsiteX588" y="connsiteY588"/>
                </a:cxn>
                <a:cxn ang="0">
                  <a:pos x="connsiteX589" y="connsiteY589"/>
                </a:cxn>
                <a:cxn ang="0">
                  <a:pos x="connsiteX590" y="connsiteY590"/>
                </a:cxn>
                <a:cxn ang="0">
                  <a:pos x="connsiteX591" y="connsiteY591"/>
                </a:cxn>
                <a:cxn ang="0">
                  <a:pos x="connsiteX592" y="connsiteY592"/>
                </a:cxn>
                <a:cxn ang="0">
                  <a:pos x="connsiteX593" y="connsiteY593"/>
                </a:cxn>
                <a:cxn ang="0">
                  <a:pos x="connsiteX594" y="connsiteY594"/>
                </a:cxn>
                <a:cxn ang="0">
                  <a:pos x="connsiteX595" y="connsiteY595"/>
                </a:cxn>
                <a:cxn ang="0">
                  <a:pos x="connsiteX596" y="connsiteY596"/>
                </a:cxn>
                <a:cxn ang="0">
                  <a:pos x="connsiteX597" y="connsiteY597"/>
                </a:cxn>
                <a:cxn ang="0">
                  <a:pos x="connsiteX598" y="connsiteY598"/>
                </a:cxn>
                <a:cxn ang="0">
                  <a:pos x="connsiteX599" y="connsiteY599"/>
                </a:cxn>
                <a:cxn ang="0">
                  <a:pos x="connsiteX600" y="connsiteY600"/>
                </a:cxn>
                <a:cxn ang="0">
                  <a:pos x="connsiteX601" y="connsiteY601"/>
                </a:cxn>
              </a:cxnLst>
              <a:rect l="l" t="t" r="r" b="b"/>
              <a:pathLst>
                <a:path w="8363529" h="2481118">
                  <a:moveTo>
                    <a:pt x="0" y="1334876"/>
                  </a:moveTo>
                  <a:lnTo>
                    <a:pt x="8394" y="1271785"/>
                  </a:lnTo>
                  <a:lnTo>
                    <a:pt x="75279" y="760439"/>
                  </a:lnTo>
                  <a:lnTo>
                    <a:pt x="83635" y="695712"/>
                  </a:lnTo>
                  <a:lnTo>
                    <a:pt x="92029" y="764668"/>
                  </a:lnTo>
                  <a:lnTo>
                    <a:pt x="158920" y="1242374"/>
                  </a:lnTo>
                  <a:lnTo>
                    <a:pt x="167273" y="1294200"/>
                  </a:lnTo>
                  <a:lnTo>
                    <a:pt x="175665" y="1321230"/>
                  </a:lnTo>
                  <a:lnTo>
                    <a:pt x="242549" y="1626358"/>
                  </a:lnTo>
                  <a:lnTo>
                    <a:pt x="250903" y="1680942"/>
                  </a:lnTo>
                  <a:lnTo>
                    <a:pt x="259304" y="1651869"/>
                  </a:lnTo>
                  <a:lnTo>
                    <a:pt x="326189" y="1451128"/>
                  </a:lnTo>
                  <a:lnTo>
                    <a:pt x="334542" y="1429392"/>
                  </a:lnTo>
                  <a:lnTo>
                    <a:pt x="342895" y="1341157"/>
                  </a:lnTo>
                  <a:lnTo>
                    <a:pt x="409818" y="827469"/>
                  </a:lnTo>
                  <a:lnTo>
                    <a:pt x="418181" y="780250"/>
                  </a:lnTo>
                  <a:lnTo>
                    <a:pt x="426534" y="805771"/>
                  </a:lnTo>
                  <a:lnTo>
                    <a:pt x="493458" y="1157808"/>
                  </a:lnTo>
                  <a:lnTo>
                    <a:pt x="501811" y="1236441"/>
                  </a:lnTo>
                  <a:lnTo>
                    <a:pt x="510174" y="1146233"/>
                  </a:lnTo>
                  <a:lnTo>
                    <a:pt x="577097" y="707626"/>
                  </a:lnTo>
                  <a:lnTo>
                    <a:pt x="585450" y="673414"/>
                  </a:lnTo>
                  <a:lnTo>
                    <a:pt x="593803" y="670695"/>
                  </a:lnTo>
                  <a:lnTo>
                    <a:pt x="660727" y="639048"/>
                  </a:lnTo>
                  <a:lnTo>
                    <a:pt x="669089" y="633222"/>
                  </a:lnTo>
                  <a:lnTo>
                    <a:pt x="677443" y="716249"/>
                  </a:lnTo>
                  <a:lnTo>
                    <a:pt x="744366" y="1270382"/>
                  </a:lnTo>
                  <a:lnTo>
                    <a:pt x="752719" y="1328382"/>
                  </a:lnTo>
                  <a:lnTo>
                    <a:pt x="761082" y="1323959"/>
                  </a:lnTo>
                  <a:lnTo>
                    <a:pt x="828005" y="1296164"/>
                  </a:lnTo>
                  <a:lnTo>
                    <a:pt x="836358" y="1293445"/>
                  </a:lnTo>
                  <a:lnTo>
                    <a:pt x="844712" y="1242519"/>
                  </a:lnTo>
                  <a:lnTo>
                    <a:pt x="911635" y="742476"/>
                  </a:lnTo>
                  <a:lnTo>
                    <a:pt x="919988" y="665401"/>
                  </a:lnTo>
                  <a:lnTo>
                    <a:pt x="928351" y="729247"/>
                  </a:lnTo>
                  <a:lnTo>
                    <a:pt x="995274" y="1121060"/>
                  </a:lnTo>
                  <a:lnTo>
                    <a:pt x="1003627" y="1158901"/>
                  </a:lnTo>
                  <a:lnTo>
                    <a:pt x="1011981" y="1141016"/>
                  </a:lnTo>
                  <a:lnTo>
                    <a:pt x="1078904" y="969232"/>
                  </a:lnTo>
                  <a:lnTo>
                    <a:pt x="1087267" y="943295"/>
                  </a:lnTo>
                  <a:lnTo>
                    <a:pt x="1095620" y="948366"/>
                  </a:lnTo>
                  <a:lnTo>
                    <a:pt x="1162543" y="991162"/>
                  </a:lnTo>
                  <a:lnTo>
                    <a:pt x="1170896" y="996834"/>
                  </a:lnTo>
                  <a:lnTo>
                    <a:pt x="1179259" y="953776"/>
                  </a:lnTo>
                  <a:lnTo>
                    <a:pt x="1246182" y="663359"/>
                  </a:lnTo>
                  <a:lnTo>
                    <a:pt x="1254536" y="632660"/>
                  </a:lnTo>
                  <a:lnTo>
                    <a:pt x="1262889" y="649297"/>
                  </a:lnTo>
                  <a:lnTo>
                    <a:pt x="1329812" y="859900"/>
                  </a:lnTo>
                  <a:lnTo>
                    <a:pt x="1338175" y="902618"/>
                  </a:lnTo>
                  <a:lnTo>
                    <a:pt x="1346528" y="953321"/>
                  </a:lnTo>
                  <a:lnTo>
                    <a:pt x="1413451" y="1219844"/>
                  </a:lnTo>
                  <a:lnTo>
                    <a:pt x="1421805" y="1242181"/>
                  </a:lnTo>
                  <a:lnTo>
                    <a:pt x="1430158" y="1247852"/>
                  </a:lnTo>
                  <a:lnTo>
                    <a:pt x="1497091" y="1302068"/>
                  </a:lnTo>
                  <a:lnTo>
                    <a:pt x="1505444" y="1310159"/>
                  </a:lnTo>
                  <a:lnTo>
                    <a:pt x="1513797" y="1329592"/>
                  </a:lnTo>
                  <a:lnTo>
                    <a:pt x="1580720" y="1527459"/>
                  </a:lnTo>
                  <a:lnTo>
                    <a:pt x="1589074" y="1559135"/>
                  </a:lnTo>
                  <a:lnTo>
                    <a:pt x="1597437" y="1529646"/>
                  </a:lnTo>
                  <a:lnTo>
                    <a:pt x="1664360" y="1373782"/>
                  </a:lnTo>
                  <a:lnTo>
                    <a:pt x="1672713" y="1360668"/>
                  </a:lnTo>
                  <a:lnTo>
                    <a:pt x="1681066" y="1348222"/>
                  </a:lnTo>
                  <a:lnTo>
                    <a:pt x="1747989" y="1228002"/>
                  </a:lnTo>
                  <a:lnTo>
                    <a:pt x="1756352" y="1209788"/>
                  </a:lnTo>
                  <a:lnTo>
                    <a:pt x="1764706" y="1192019"/>
                  </a:lnTo>
                  <a:lnTo>
                    <a:pt x="1831629" y="1040762"/>
                  </a:lnTo>
                  <a:lnTo>
                    <a:pt x="1839982" y="1020612"/>
                  </a:lnTo>
                  <a:lnTo>
                    <a:pt x="1848345" y="1035129"/>
                  </a:lnTo>
                  <a:lnTo>
                    <a:pt x="1915268" y="1150201"/>
                  </a:lnTo>
                  <a:lnTo>
                    <a:pt x="1923621" y="1164457"/>
                  </a:lnTo>
                  <a:lnTo>
                    <a:pt x="1931975" y="1177919"/>
                  </a:lnTo>
                  <a:lnTo>
                    <a:pt x="1998898" y="1261391"/>
                  </a:lnTo>
                  <a:lnTo>
                    <a:pt x="2007260" y="1269521"/>
                  </a:lnTo>
                  <a:lnTo>
                    <a:pt x="2015614" y="1224450"/>
                  </a:lnTo>
                  <a:lnTo>
                    <a:pt x="2082537" y="755900"/>
                  </a:lnTo>
                  <a:lnTo>
                    <a:pt x="2090890" y="679192"/>
                  </a:lnTo>
                  <a:lnTo>
                    <a:pt x="2099253" y="654968"/>
                  </a:lnTo>
                  <a:lnTo>
                    <a:pt x="2166176" y="488323"/>
                  </a:lnTo>
                  <a:lnTo>
                    <a:pt x="2174530" y="470322"/>
                  </a:lnTo>
                  <a:lnTo>
                    <a:pt x="2182883" y="507901"/>
                  </a:lnTo>
                  <a:lnTo>
                    <a:pt x="2249806" y="866597"/>
                  </a:lnTo>
                  <a:lnTo>
                    <a:pt x="2258159" y="920281"/>
                  </a:lnTo>
                  <a:lnTo>
                    <a:pt x="2266522" y="988665"/>
                  </a:lnTo>
                  <a:lnTo>
                    <a:pt x="2333445" y="1433437"/>
                  </a:lnTo>
                  <a:lnTo>
                    <a:pt x="2341799" y="1478837"/>
                  </a:lnTo>
                  <a:lnTo>
                    <a:pt x="2350152" y="1459451"/>
                  </a:lnTo>
                  <a:lnTo>
                    <a:pt x="2417075" y="1312123"/>
                  </a:lnTo>
                  <a:lnTo>
                    <a:pt x="2425438" y="1294616"/>
                  </a:lnTo>
                  <a:lnTo>
                    <a:pt x="2433791" y="1238667"/>
                  </a:lnTo>
                  <a:lnTo>
                    <a:pt x="2500714" y="815710"/>
                  </a:lnTo>
                  <a:lnTo>
                    <a:pt x="2509068" y="765733"/>
                  </a:lnTo>
                  <a:lnTo>
                    <a:pt x="2517430" y="768907"/>
                  </a:lnTo>
                  <a:lnTo>
                    <a:pt x="2584354" y="798280"/>
                  </a:lnTo>
                  <a:lnTo>
                    <a:pt x="2592707" y="802587"/>
                  </a:lnTo>
                  <a:lnTo>
                    <a:pt x="2601060" y="830304"/>
                  </a:lnTo>
                  <a:lnTo>
                    <a:pt x="2667983" y="1054785"/>
                  </a:lnTo>
                  <a:lnTo>
                    <a:pt x="2676346" y="1083181"/>
                  </a:lnTo>
                  <a:lnTo>
                    <a:pt x="2684699" y="1099091"/>
                  </a:lnTo>
                  <a:lnTo>
                    <a:pt x="2751623" y="1249294"/>
                  </a:lnTo>
                  <a:lnTo>
                    <a:pt x="2759976" y="1271524"/>
                  </a:lnTo>
                  <a:lnTo>
                    <a:pt x="2768329" y="1262640"/>
                  </a:lnTo>
                  <a:lnTo>
                    <a:pt x="2835262" y="1209140"/>
                  </a:lnTo>
                  <a:lnTo>
                    <a:pt x="2843615" y="1204039"/>
                  </a:lnTo>
                  <a:lnTo>
                    <a:pt x="2851968" y="1215005"/>
                  </a:lnTo>
                  <a:lnTo>
                    <a:pt x="2918892" y="1305165"/>
                  </a:lnTo>
                  <a:lnTo>
                    <a:pt x="2927245" y="1316730"/>
                  </a:lnTo>
                  <a:lnTo>
                    <a:pt x="2935608" y="1295032"/>
                  </a:lnTo>
                  <a:lnTo>
                    <a:pt x="3002531" y="1128425"/>
                  </a:lnTo>
                  <a:lnTo>
                    <a:pt x="3010884" y="1108469"/>
                  </a:lnTo>
                  <a:lnTo>
                    <a:pt x="3019238" y="1099169"/>
                  </a:lnTo>
                  <a:lnTo>
                    <a:pt x="3086161" y="1005002"/>
                  </a:lnTo>
                  <a:lnTo>
                    <a:pt x="3094523" y="989991"/>
                  </a:lnTo>
                  <a:lnTo>
                    <a:pt x="3102877" y="1041178"/>
                  </a:lnTo>
                  <a:lnTo>
                    <a:pt x="3169800" y="1332950"/>
                  </a:lnTo>
                  <a:lnTo>
                    <a:pt x="3178153" y="1359265"/>
                  </a:lnTo>
                  <a:lnTo>
                    <a:pt x="3186516" y="1372456"/>
                  </a:lnTo>
                  <a:lnTo>
                    <a:pt x="3253439" y="1504280"/>
                  </a:lnTo>
                  <a:lnTo>
                    <a:pt x="3261792" y="1525001"/>
                  </a:lnTo>
                  <a:lnTo>
                    <a:pt x="3270146" y="1458271"/>
                  </a:lnTo>
                  <a:lnTo>
                    <a:pt x="3337069" y="323981"/>
                  </a:lnTo>
                  <a:lnTo>
                    <a:pt x="3345432" y="0"/>
                  </a:lnTo>
                  <a:lnTo>
                    <a:pt x="3353785" y="63546"/>
                  </a:lnTo>
                  <a:lnTo>
                    <a:pt x="3420708" y="249809"/>
                  </a:lnTo>
                  <a:lnTo>
                    <a:pt x="3429061" y="259341"/>
                  </a:lnTo>
                  <a:lnTo>
                    <a:pt x="3437424" y="301828"/>
                  </a:lnTo>
                  <a:lnTo>
                    <a:pt x="3504347" y="691667"/>
                  </a:lnTo>
                  <a:lnTo>
                    <a:pt x="3512701" y="747625"/>
                  </a:lnTo>
                  <a:lnTo>
                    <a:pt x="3521054" y="753403"/>
                  </a:lnTo>
                  <a:lnTo>
                    <a:pt x="3587977" y="793441"/>
                  </a:lnTo>
                  <a:lnTo>
                    <a:pt x="3596330" y="797786"/>
                  </a:lnTo>
                  <a:lnTo>
                    <a:pt x="3604693" y="834118"/>
                  </a:lnTo>
                  <a:lnTo>
                    <a:pt x="3671616" y="1218518"/>
                  </a:lnTo>
                  <a:lnTo>
                    <a:pt x="3679970" y="1282635"/>
                  </a:lnTo>
                  <a:lnTo>
                    <a:pt x="3688323" y="1154701"/>
                  </a:lnTo>
                  <a:lnTo>
                    <a:pt x="3755246" y="257599"/>
                  </a:lnTo>
                  <a:lnTo>
                    <a:pt x="3763609" y="159116"/>
                  </a:lnTo>
                  <a:lnTo>
                    <a:pt x="3771962" y="258615"/>
                  </a:lnTo>
                  <a:lnTo>
                    <a:pt x="3838885" y="1130206"/>
                  </a:lnTo>
                  <a:lnTo>
                    <a:pt x="3847239" y="1249594"/>
                  </a:lnTo>
                  <a:lnTo>
                    <a:pt x="3855602" y="1194129"/>
                  </a:lnTo>
                  <a:lnTo>
                    <a:pt x="3922525" y="795367"/>
                  </a:lnTo>
                  <a:lnTo>
                    <a:pt x="3930878" y="750538"/>
                  </a:lnTo>
                  <a:lnTo>
                    <a:pt x="3939231" y="781266"/>
                  </a:lnTo>
                  <a:lnTo>
                    <a:pt x="4006154" y="997743"/>
                  </a:lnTo>
                  <a:lnTo>
                    <a:pt x="4014517" y="1021590"/>
                  </a:lnTo>
                  <a:lnTo>
                    <a:pt x="4022871" y="1060157"/>
                  </a:lnTo>
                  <a:lnTo>
                    <a:pt x="4089755" y="1524468"/>
                  </a:lnTo>
                  <a:lnTo>
                    <a:pt x="4098147" y="1613612"/>
                  </a:lnTo>
                  <a:lnTo>
                    <a:pt x="4106500" y="1542576"/>
                  </a:lnTo>
                  <a:lnTo>
                    <a:pt x="4173394" y="1179235"/>
                  </a:lnTo>
                  <a:lnTo>
                    <a:pt x="4181787" y="1149562"/>
                  </a:lnTo>
                  <a:lnTo>
                    <a:pt x="4190140" y="1177048"/>
                  </a:lnTo>
                  <a:lnTo>
                    <a:pt x="4257024" y="1451661"/>
                  </a:lnTo>
                  <a:lnTo>
                    <a:pt x="4265416" y="1494757"/>
                  </a:lnTo>
                  <a:lnTo>
                    <a:pt x="4273779" y="1396274"/>
                  </a:lnTo>
                  <a:lnTo>
                    <a:pt x="4340664" y="668953"/>
                  </a:lnTo>
                  <a:lnTo>
                    <a:pt x="4349055" y="584948"/>
                  </a:lnTo>
                  <a:lnTo>
                    <a:pt x="4357409" y="652200"/>
                  </a:lnTo>
                  <a:lnTo>
                    <a:pt x="4424303" y="1185632"/>
                  </a:lnTo>
                  <a:lnTo>
                    <a:pt x="4432695" y="1251752"/>
                  </a:lnTo>
                  <a:lnTo>
                    <a:pt x="4441048" y="1221576"/>
                  </a:lnTo>
                  <a:lnTo>
                    <a:pt x="4507932" y="966474"/>
                  </a:lnTo>
                  <a:lnTo>
                    <a:pt x="4516324" y="932794"/>
                  </a:lnTo>
                  <a:lnTo>
                    <a:pt x="4524687" y="918384"/>
                  </a:lnTo>
                  <a:lnTo>
                    <a:pt x="4591572" y="790073"/>
                  </a:lnTo>
                  <a:lnTo>
                    <a:pt x="4599964" y="772159"/>
                  </a:lnTo>
                  <a:lnTo>
                    <a:pt x="4608317" y="786937"/>
                  </a:lnTo>
                  <a:lnTo>
                    <a:pt x="4675201" y="902434"/>
                  </a:lnTo>
                  <a:lnTo>
                    <a:pt x="4683603" y="916535"/>
                  </a:lnTo>
                  <a:lnTo>
                    <a:pt x="4691956" y="857790"/>
                  </a:lnTo>
                  <a:lnTo>
                    <a:pt x="4758840" y="438307"/>
                  </a:lnTo>
                  <a:lnTo>
                    <a:pt x="4767232" y="391465"/>
                  </a:lnTo>
                  <a:lnTo>
                    <a:pt x="4775595" y="459173"/>
                  </a:lnTo>
                  <a:lnTo>
                    <a:pt x="4842480" y="1167515"/>
                  </a:lnTo>
                  <a:lnTo>
                    <a:pt x="4850872" y="1284338"/>
                  </a:lnTo>
                  <a:lnTo>
                    <a:pt x="4859225" y="1332766"/>
                  </a:lnTo>
                  <a:lnTo>
                    <a:pt x="4926109" y="1585788"/>
                  </a:lnTo>
                  <a:lnTo>
                    <a:pt x="4934501" y="1606886"/>
                  </a:lnTo>
                  <a:lnTo>
                    <a:pt x="4942864" y="1595698"/>
                  </a:lnTo>
                  <a:lnTo>
                    <a:pt x="5009749" y="1494757"/>
                  </a:lnTo>
                  <a:lnTo>
                    <a:pt x="5018141" y="1480501"/>
                  </a:lnTo>
                  <a:lnTo>
                    <a:pt x="5026494" y="1436844"/>
                  </a:lnTo>
                  <a:lnTo>
                    <a:pt x="5093388" y="1022122"/>
                  </a:lnTo>
                  <a:lnTo>
                    <a:pt x="5101780" y="960348"/>
                  </a:lnTo>
                  <a:lnTo>
                    <a:pt x="5110134" y="997211"/>
                  </a:lnTo>
                  <a:lnTo>
                    <a:pt x="5177018" y="1210272"/>
                  </a:lnTo>
                  <a:lnTo>
                    <a:pt x="5185410" y="1229706"/>
                  </a:lnTo>
                  <a:lnTo>
                    <a:pt x="5193773" y="1136294"/>
                  </a:lnTo>
                  <a:lnTo>
                    <a:pt x="5260657" y="324668"/>
                  </a:lnTo>
                  <a:lnTo>
                    <a:pt x="5269049" y="214464"/>
                  </a:lnTo>
                  <a:lnTo>
                    <a:pt x="5277403" y="286140"/>
                  </a:lnTo>
                  <a:lnTo>
                    <a:pt x="5344287" y="949237"/>
                  </a:lnTo>
                  <a:lnTo>
                    <a:pt x="5352650" y="1045369"/>
                  </a:lnTo>
                  <a:lnTo>
                    <a:pt x="5361042" y="1056634"/>
                  </a:lnTo>
                  <a:lnTo>
                    <a:pt x="5427926" y="1279228"/>
                  </a:lnTo>
                  <a:lnTo>
                    <a:pt x="5436280" y="1355936"/>
                  </a:lnTo>
                  <a:lnTo>
                    <a:pt x="5444672" y="1420052"/>
                  </a:lnTo>
                  <a:lnTo>
                    <a:pt x="5511566" y="1631536"/>
                  </a:lnTo>
                  <a:lnTo>
                    <a:pt x="5519919" y="1643363"/>
                  </a:lnTo>
                  <a:lnTo>
                    <a:pt x="5528311" y="1596976"/>
                  </a:lnTo>
                  <a:lnTo>
                    <a:pt x="5595195" y="1340064"/>
                  </a:lnTo>
                  <a:lnTo>
                    <a:pt x="5603558" y="1317495"/>
                  </a:lnTo>
                  <a:lnTo>
                    <a:pt x="5611950" y="1268195"/>
                  </a:lnTo>
                  <a:lnTo>
                    <a:pt x="5678835" y="875481"/>
                  </a:lnTo>
                  <a:lnTo>
                    <a:pt x="5687188" y="826598"/>
                  </a:lnTo>
                  <a:lnTo>
                    <a:pt x="5695580" y="884172"/>
                  </a:lnTo>
                  <a:lnTo>
                    <a:pt x="5762474" y="1537930"/>
                  </a:lnTo>
                  <a:lnTo>
                    <a:pt x="5770827" y="1655576"/>
                  </a:lnTo>
                  <a:lnTo>
                    <a:pt x="5779219" y="1589950"/>
                  </a:lnTo>
                  <a:lnTo>
                    <a:pt x="5846103" y="1207059"/>
                  </a:lnTo>
                  <a:lnTo>
                    <a:pt x="5854457" y="1171754"/>
                  </a:lnTo>
                  <a:lnTo>
                    <a:pt x="5862858" y="1211037"/>
                  </a:lnTo>
                  <a:lnTo>
                    <a:pt x="5929743" y="1723177"/>
                  </a:lnTo>
                  <a:lnTo>
                    <a:pt x="5938096" y="1830574"/>
                  </a:lnTo>
                  <a:lnTo>
                    <a:pt x="5946488" y="1727977"/>
                  </a:lnTo>
                  <a:lnTo>
                    <a:pt x="6013372" y="1210659"/>
                  </a:lnTo>
                  <a:lnTo>
                    <a:pt x="6021735" y="1168957"/>
                  </a:lnTo>
                  <a:lnTo>
                    <a:pt x="6030127" y="1086694"/>
                  </a:lnTo>
                  <a:lnTo>
                    <a:pt x="6097011" y="340540"/>
                  </a:lnTo>
                  <a:lnTo>
                    <a:pt x="6105365" y="234575"/>
                  </a:lnTo>
                  <a:lnTo>
                    <a:pt x="6113767" y="292837"/>
                  </a:lnTo>
                  <a:lnTo>
                    <a:pt x="6180651" y="694812"/>
                  </a:lnTo>
                  <a:lnTo>
                    <a:pt x="6189004" y="738209"/>
                  </a:lnTo>
                  <a:lnTo>
                    <a:pt x="6197396" y="808335"/>
                  </a:lnTo>
                  <a:lnTo>
                    <a:pt x="6264280" y="1523375"/>
                  </a:lnTo>
                  <a:lnTo>
                    <a:pt x="6272644" y="1638078"/>
                  </a:lnTo>
                  <a:lnTo>
                    <a:pt x="6281036" y="1537553"/>
                  </a:lnTo>
                  <a:lnTo>
                    <a:pt x="6347920" y="854799"/>
                  </a:lnTo>
                  <a:lnTo>
                    <a:pt x="6356273" y="782098"/>
                  </a:lnTo>
                  <a:lnTo>
                    <a:pt x="6364665" y="877291"/>
                  </a:lnTo>
                  <a:lnTo>
                    <a:pt x="6431560" y="1573884"/>
                  </a:lnTo>
                  <a:lnTo>
                    <a:pt x="6439913" y="1653611"/>
                  </a:lnTo>
                  <a:lnTo>
                    <a:pt x="6448305" y="1663251"/>
                  </a:lnTo>
                  <a:lnTo>
                    <a:pt x="6515189" y="1749937"/>
                  </a:lnTo>
                  <a:lnTo>
                    <a:pt x="6523542" y="1762150"/>
                  </a:lnTo>
                  <a:lnTo>
                    <a:pt x="6531944" y="1716973"/>
                  </a:lnTo>
                  <a:lnTo>
                    <a:pt x="6598829" y="1313140"/>
                  </a:lnTo>
                  <a:lnTo>
                    <a:pt x="6607182" y="1256659"/>
                  </a:lnTo>
                  <a:lnTo>
                    <a:pt x="6615535" y="1309094"/>
                  </a:lnTo>
                  <a:lnTo>
                    <a:pt x="6682458" y="1601670"/>
                  </a:lnTo>
                  <a:lnTo>
                    <a:pt x="6690821" y="1627529"/>
                  </a:lnTo>
                  <a:lnTo>
                    <a:pt x="6699174" y="1581065"/>
                  </a:lnTo>
                  <a:lnTo>
                    <a:pt x="6766097" y="1115312"/>
                  </a:lnTo>
                  <a:lnTo>
                    <a:pt x="6774451" y="1041972"/>
                  </a:lnTo>
                  <a:lnTo>
                    <a:pt x="6782814" y="1035691"/>
                  </a:lnTo>
                  <a:lnTo>
                    <a:pt x="6849737" y="977323"/>
                  </a:lnTo>
                  <a:lnTo>
                    <a:pt x="6858090" y="968816"/>
                  </a:lnTo>
                  <a:lnTo>
                    <a:pt x="6866443" y="985075"/>
                  </a:lnTo>
                  <a:lnTo>
                    <a:pt x="6933366" y="1072670"/>
                  </a:lnTo>
                  <a:lnTo>
                    <a:pt x="6941729" y="1080152"/>
                  </a:lnTo>
                  <a:lnTo>
                    <a:pt x="6950083" y="996340"/>
                  </a:lnTo>
                  <a:lnTo>
                    <a:pt x="7017006" y="179798"/>
                  </a:lnTo>
                  <a:lnTo>
                    <a:pt x="7025359" y="54961"/>
                  </a:lnTo>
                  <a:lnTo>
                    <a:pt x="7033712" y="77008"/>
                  </a:lnTo>
                  <a:lnTo>
                    <a:pt x="7100645" y="265458"/>
                  </a:lnTo>
                  <a:lnTo>
                    <a:pt x="7108998" y="290679"/>
                  </a:lnTo>
                  <a:lnTo>
                    <a:pt x="7117351" y="326671"/>
                  </a:lnTo>
                  <a:lnTo>
                    <a:pt x="7184274" y="626341"/>
                  </a:lnTo>
                  <a:lnTo>
                    <a:pt x="7192628" y="665324"/>
                  </a:lnTo>
                  <a:lnTo>
                    <a:pt x="7200991" y="704452"/>
                  </a:lnTo>
                  <a:lnTo>
                    <a:pt x="7267914" y="993843"/>
                  </a:lnTo>
                  <a:lnTo>
                    <a:pt x="7276267" y="1027339"/>
                  </a:lnTo>
                  <a:lnTo>
                    <a:pt x="7284620" y="1031384"/>
                  </a:lnTo>
                  <a:lnTo>
                    <a:pt x="7351543" y="1065712"/>
                  </a:lnTo>
                  <a:lnTo>
                    <a:pt x="7359906" y="1070251"/>
                  </a:lnTo>
                  <a:lnTo>
                    <a:pt x="7368260" y="1065296"/>
                  </a:lnTo>
                  <a:lnTo>
                    <a:pt x="7435183" y="1032023"/>
                  </a:lnTo>
                  <a:lnTo>
                    <a:pt x="7443536" y="1028548"/>
                  </a:lnTo>
                  <a:lnTo>
                    <a:pt x="7451899" y="1055463"/>
                  </a:lnTo>
                  <a:lnTo>
                    <a:pt x="7518822" y="1314582"/>
                  </a:lnTo>
                  <a:lnTo>
                    <a:pt x="7527175" y="1353671"/>
                  </a:lnTo>
                  <a:lnTo>
                    <a:pt x="7535528" y="1249439"/>
                  </a:lnTo>
                  <a:lnTo>
                    <a:pt x="7602452" y="550514"/>
                  </a:lnTo>
                  <a:lnTo>
                    <a:pt x="7610815" y="477057"/>
                  </a:lnTo>
                  <a:lnTo>
                    <a:pt x="7619168" y="568766"/>
                  </a:lnTo>
                  <a:lnTo>
                    <a:pt x="7686091" y="1365014"/>
                  </a:lnTo>
                  <a:lnTo>
                    <a:pt x="7694444" y="1473097"/>
                  </a:lnTo>
                  <a:lnTo>
                    <a:pt x="7702798" y="1421949"/>
                  </a:lnTo>
                  <a:lnTo>
                    <a:pt x="7769731" y="917590"/>
                  </a:lnTo>
                  <a:lnTo>
                    <a:pt x="7778084" y="839489"/>
                  </a:lnTo>
                  <a:lnTo>
                    <a:pt x="7786437" y="934720"/>
                  </a:lnTo>
                  <a:lnTo>
                    <a:pt x="7853360" y="1400135"/>
                  </a:lnTo>
                  <a:lnTo>
                    <a:pt x="7861713" y="1436611"/>
                  </a:lnTo>
                  <a:lnTo>
                    <a:pt x="7870077" y="1432489"/>
                  </a:lnTo>
                  <a:lnTo>
                    <a:pt x="7937000" y="1386296"/>
                  </a:lnTo>
                  <a:lnTo>
                    <a:pt x="7945353" y="1378127"/>
                  </a:lnTo>
                  <a:lnTo>
                    <a:pt x="7953706" y="1379637"/>
                  </a:lnTo>
                  <a:lnTo>
                    <a:pt x="8020629" y="1391173"/>
                  </a:lnTo>
                  <a:lnTo>
                    <a:pt x="8028992" y="1392528"/>
                  </a:lnTo>
                  <a:lnTo>
                    <a:pt x="8037346" y="1360020"/>
                  </a:lnTo>
                  <a:lnTo>
                    <a:pt x="8104268" y="1061783"/>
                  </a:lnTo>
                  <a:lnTo>
                    <a:pt x="8112622" y="1018948"/>
                  </a:lnTo>
                  <a:lnTo>
                    <a:pt x="8120985" y="1137126"/>
                  </a:lnTo>
                  <a:lnTo>
                    <a:pt x="8187908" y="1762450"/>
                  </a:lnTo>
                  <a:lnTo>
                    <a:pt x="8196261" y="1815118"/>
                  </a:lnTo>
                  <a:lnTo>
                    <a:pt x="8204614" y="1733755"/>
                  </a:lnTo>
                  <a:lnTo>
                    <a:pt x="8271537" y="886137"/>
                  </a:lnTo>
                  <a:lnTo>
                    <a:pt x="8279900" y="747054"/>
                  </a:lnTo>
                  <a:lnTo>
                    <a:pt x="8288254" y="809168"/>
                  </a:lnTo>
                  <a:lnTo>
                    <a:pt x="8355177" y="1311330"/>
                  </a:lnTo>
                  <a:lnTo>
                    <a:pt x="8363530" y="1374730"/>
                  </a:lnTo>
                  <a:lnTo>
                    <a:pt x="8363530" y="1829025"/>
                  </a:lnTo>
                  <a:lnTo>
                    <a:pt x="8355177" y="1759615"/>
                  </a:lnTo>
                  <a:lnTo>
                    <a:pt x="8288254" y="1209972"/>
                  </a:lnTo>
                  <a:lnTo>
                    <a:pt x="8279900" y="1141965"/>
                  </a:lnTo>
                  <a:lnTo>
                    <a:pt x="8271537" y="1269589"/>
                  </a:lnTo>
                  <a:lnTo>
                    <a:pt x="8204614" y="2047390"/>
                  </a:lnTo>
                  <a:lnTo>
                    <a:pt x="8196261" y="2122007"/>
                  </a:lnTo>
                  <a:lnTo>
                    <a:pt x="8187908" y="2112107"/>
                  </a:lnTo>
                  <a:lnTo>
                    <a:pt x="8120985" y="1994267"/>
                  </a:lnTo>
                  <a:lnTo>
                    <a:pt x="8112622" y="1971998"/>
                  </a:lnTo>
                  <a:lnTo>
                    <a:pt x="8104268" y="1980399"/>
                  </a:lnTo>
                  <a:lnTo>
                    <a:pt x="8037346" y="2038921"/>
                  </a:lnTo>
                  <a:lnTo>
                    <a:pt x="8028992" y="2045309"/>
                  </a:lnTo>
                  <a:lnTo>
                    <a:pt x="8020629" y="2025121"/>
                  </a:lnTo>
                  <a:lnTo>
                    <a:pt x="7953706" y="1855756"/>
                  </a:lnTo>
                  <a:lnTo>
                    <a:pt x="7945353" y="1833564"/>
                  </a:lnTo>
                  <a:lnTo>
                    <a:pt x="7937000" y="1851826"/>
                  </a:lnTo>
                  <a:lnTo>
                    <a:pt x="7870077" y="1954723"/>
                  </a:lnTo>
                  <a:lnTo>
                    <a:pt x="7861713" y="1963917"/>
                  </a:lnTo>
                  <a:lnTo>
                    <a:pt x="7853360" y="1912314"/>
                  </a:lnTo>
                  <a:lnTo>
                    <a:pt x="7786437" y="1253794"/>
                  </a:lnTo>
                  <a:lnTo>
                    <a:pt x="7778084" y="1119057"/>
                  </a:lnTo>
                  <a:lnTo>
                    <a:pt x="7769731" y="1218363"/>
                  </a:lnTo>
                  <a:lnTo>
                    <a:pt x="7702798" y="1859878"/>
                  </a:lnTo>
                  <a:lnTo>
                    <a:pt x="7694444" y="1924934"/>
                  </a:lnTo>
                  <a:lnTo>
                    <a:pt x="7686091" y="1818892"/>
                  </a:lnTo>
                  <a:lnTo>
                    <a:pt x="7619168" y="1037549"/>
                  </a:lnTo>
                  <a:lnTo>
                    <a:pt x="7610815" y="947534"/>
                  </a:lnTo>
                  <a:lnTo>
                    <a:pt x="7602452" y="1010441"/>
                  </a:lnTo>
                  <a:lnTo>
                    <a:pt x="7535528" y="1609112"/>
                  </a:lnTo>
                  <a:lnTo>
                    <a:pt x="7527175" y="1698411"/>
                  </a:lnTo>
                  <a:lnTo>
                    <a:pt x="7518822" y="1670471"/>
                  </a:lnTo>
                  <a:lnTo>
                    <a:pt x="7451899" y="1485534"/>
                  </a:lnTo>
                  <a:lnTo>
                    <a:pt x="7443536" y="1466294"/>
                  </a:lnTo>
                  <a:lnTo>
                    <a:pt x="7435183" y="1490518"/>
                  </a:lnTo>
                  <a:lnTo>
                    <a:pt x="7368260" y="1722151"/>
                  </a:lnTo>
                  <a:lnTo>
                    <a:pt x="7359906" y="1756818"/>
                  </a:lnTo>
                  <a:lnTo>
                    <a:pt x="7351543" y="1721890"/>
                  </a:lnTo>
                  <a:lnTo>
                    <a:pt x="7284620" y="1457477"/>
                  </a:lnTo>
                  <a:lnTo>
                    <a:pt x="7276267" y="1426217"/>
                  </a:lnTo>
                  <a:lnTo>
                    <a:pt x="7267914" y="1442854"/>
                  </a:lnTo>
                  <a:lnTo>
                    <a:pt x="7200991" y="1586659"/>
                  </a:lnTo>
                  <a:lnTo>
                    <a:pt x="7192628" y="1606131"/>
                  </a:lnTo>
                  <a:lnTo>
                    <a:pt x="7184274" y="1581220"/>
                  </a:lnTo>
                  <a:lnTo>
                    <a:pt x="7117351" y="1389925"/>
                  </a:lnTo>
                  <a:lnTo>
                    <a:pt x="7108998" y="1366901"/>
                  </a:lnTo>
                  <a:lnTo>
                    <a:pt x="7100645" y="1486027"/>
                  </a:lnTo>
                  <a:lnTo>
                    <a:pt x="7033712" y="2376964"/>
                  </a:lnTo>
                  <a:lnTo>
                    <a:pt x="7025359" y="2481119"/>
                  </a:lnTo>
                  <a:lnTo>
                    <a:pt x="7017006" y="2384261"/>
                  </a:lnTo>
                  <a:lnTo>
                    <a:pt x="6950083" y="1750546"/>
                  </a:lnTo>
                  <a:lnTo>
                    <a:pt x="6941729" y="1685520"/>
                  </a:lnTo>
                  <a:lnTo>
                    <a:pt x="6933366" y="1701208"/>
                  </a:lnTo>
                  <a:lnTo>
                    <a:pt x="6866443" y="1884674"/>
                  </a:lnTo>
                  <a:lnTo>
                    <a:pt x="6858090" y="1918701"/>
                  </a:lnTo>
                  <a:lnTo>
                    <a:pt x="6849737" y="1900139"/>
                  </a:lnTo>
                  <a:lnTo>
                    <a:pt x="6782814" y="1772583"/>
                  </a:lnTo>
                  <a:lnTo>
                    <a:pt x="6774451" y="1758860"/>
                  </a:lnTo>
                  <a:lnTo>
                    <a:pt x="6766097" y="1813037"/>
                  </a:lnTo>
                  <a:lnTo>
                    <a:pt x="6699174" y="2157061"/>
                  </a:lnTo>
                  <a:lnTo>
                    <a:pt x="6690821" y="2191418"/>
                  </a:lnTo>
                  <a:lnTo>
                    <a:pt x="6682458" y="2176562"/>
                  </a:lnTo>
                  <a:lnTo>
                    <a:pt x="6615535" y="2008784"/>
                  </a:lnTo>
                  <a:lnTo>
                    <a:pt x="6607182" y="1978695"/>
                  </a:lnTo>
                  <a:lnTo>
                    <a:pt x="6598829" y="1997519"/>
                  </a:lnTo>
                  <a:lnTo>
                    <a:pt x="6531944" y="2132072"/>
                  </a:lnTo>
                  <a:lnTo>
                    <a:pt x="6523542" y="2147112"/>
                  </a:lnTo>
                  <a:lnTo>
                    <a:pt x="6515189" y="2134714"/>
                  </a:lnTo>
                  <a:lnTo>
                    <a:pt x="6448305" y="2046587"/>
                  </a:lnTo>
                  <a:lnTo>
                    <a:pt x="6439913" y="2036763"/>
                  </a:lnTo>
                  <a:lnTo>
                    <a:pt x="6431560" y="1979528"/>
                  </a:lnTo>
                  <a:lnTo>
                    <a:pt x="6364665" y="1479408"/>
                  </a:lnTo>
                  <a:lnTo>
                    <a:pt x="6356273" y="1411061"/>
                  </a:lnTo>
                  <a:lnTo>
                    <a:pt x="6347920" y="1478537"/>
                  </a:lnTo>
                  <a:lnTo>
                    <a:pt x="6281036" y="2112300"/>
                  </a:lnTo>
                  <a:lnTo>
                    <a:pt x="6272644" y="2205635"/>
                  </a:lnTo>
                  <a:lnTo>
                    <a:pt x="6264280" y="2160274"/>
                  </a:lnTo>
                  <a:lnTo>
                    <a:pt x="6197396" y="1877570"/>
                  </a:lnTo>
                  <a:lnTo>
                    <a:pt x="6189004" y="1849852"/>
                  </a:lnTo>
                  <a:lnTo>
                    <a:pt x="6180651" y="1863614"/>
                  </a:lnTo>
                  <a:lnTo>
                    <a:pt x="6113767" y="1990870"/>
                  </a:lnTo>
                  <a:lnTo>
                    <a:pt x="6105365" y="2009316"/>
                  </a:lnTo>
                  <a:lnTo>
                    <a:pt x="6097011" y="1992719"/>
                  </a:lnTo>
                  <a:lnTo>
                    <a:pt x="6030127" y="1875789"/>
                  </a:lnTo>
                  <a:lnTo>
                    <a:pt x="6021735" y="1862898"/>
                  </a:lnTo>
                  <a:lnTo>
                    <a:pt x="6013372" y="1898929"/>
                  </a:lnTo>
                  <a:lnTo>
                    <a:pt x="5946488" y="2345782"/>
                  </a:lnTo>
                  <a:lnTo>
                    <a:pt x="5938096" y="2434355"/>
                  </a:lnTo>
                  <a:lnTo>
                    <a:pt x="5929743" y="2365167"/>
                  </a:lnTo>
                  <a:lnTo>
                    <a:pt x="5862858" y="2035215"/>
                  </a:lnTo>
                  <a:lnTo>
                    <a:pt x="5854457" y="2009917"/>
                  </a:lnTo>
                  <a:lnTo>
                    <a:pt x="5846103" y="2018278"/>
                  </a:lnTo>
                  <a:lnTo>
                    <a:pt x="5779219" y="2109010"/>
                  </a:lnTo>
                  <a:lnTo>
                    <a:pt x="5770827" y="2124543"/>
                  </a:lnTo>
                  <a:lnTo>
                    <a:pt x="5762474" y="1983873"/>
                  </a:lnTo>
                  <a:lnTo>
                    <a:pt x="5695580" y="1202075"/>
                  </a:lnTo>
                  <a:lnTo>
                    <a:pt x="5687188" y="1133235"/>
                  </a:lnTo>
                  <a:lnTo>
                    <a:pt x="5678835" y="1203052"/>
                  </a:lnTo>
                  <a:lnTo>
                    <a:pt x="5611950" y="1764337"/>
                  </a:lnTo>
                  <a:lnTo>
                    <a:pt x="5603558" y="1834812"/>
                  </a:lnTo>
                  <a:lnTo>
                    <a:pt x="5595195" y="1879302"/>
                  </a:lnTo>
                  <a:lnTo>
                    <a:pt x="5528311" y="2385965"/>
                  </a:lnTo>
                  <a:lnTo>
                    <a:pt x="5519919" y="2477451"/>
                  </a:lnTo>
                  <a:lnTo>
                    <a:pt x="5511566" y="2462440"/>
                  </a:lnTo>
                  <a:lnTo>
                    <a:pt x="5444672" y="2194786"/>
                  </a:lnTo>
                  <a:lnTo>
                    <a:pt x="5436280" y="2113616"/>
                  </a:lnTo>
                  <a:lnTo>
                    <a:pt x="5427926" y="2045870"/>
                  </a:lnTo>
                  <a:lnTo>
                    <a:pt x="5361042" y="1849252"/>
                  </a:lnTo>
                  <a:lnTo>
                    <a:pt x="5352650" y="1839313"/>
                  </a:lnTo>
                  <a:lnTo>
                    <a:pt x="5344287" y="1867282"/>
                  </a:lnTo>
                  <a:lnTo>
                    <a:pt x="5277403" y="2060310"/>
                  </a:lnTo>
                  <a:lnTo>
                    <a:pt x="5269049" y="2081147"/>
                  </a:lnTo>
                  <a:lnTo>
                    <a:pt x="5260657" y="2033057"/>
                  </a:lnTo>
                  <a:lnTo>
                    <a:pt x="5193773" y="1678900"/>
                  </a:lnTo>
                  <a:lnTo>
                    <a:pt x="5185410" y="1638146"/>
                  </a:lnTo>
                  <a:lnTo>
                    <a:pt x="5177018" y="1650698"/>
                  </a:lnTo>
                  <a:lnTo>
                    <a:pt x="5110134" y="1787971"/>
                  </a:lnTo>
                  <a:lnTo>
                    <a:pt x="5101780" y="1811750"/>
                  </a:lnTo>
                  <a:lnTo>
                    <a:pt x="5093388" y="1824796"/>
                  </a:lnTo>
                  <a:lnTo>
                    <a:pt x="5026494" y="1912343"/>
                  </a:lnTo>
                  <a:lnTo>
                    <a:pt x="5018141" y="1921576"/>
                  </a:lnTo>
                  <a:lnTo>
                    <a:pt x="5009749" y="1936122"/>
                  </a:lnTo>
                  <a:lnTo>
                    <a:pt x="4942864" y="2039183"/>
                  </a:lnTo>
                  <a:lnTo>
                    <a:pt x="4934501" y="2050603"/>
                  </a:lnTo>
                  <a:lnTo>
                    <a:pt x="4926109" y="2022392"/>
                  </a:lnTo>
                  <a:lnTo>
                    <a:pt x="4859225" y="1683478"/>
                  </a:lnTo>
                  <a:lnTo>
                    <a:pt x="4850872" y="1618683"/>
                  </a:lnTo>
                  <a:lnTo>
                    <a:pt x="4842480" y="1584694"/>
                  </a:lnTo>
                  <a:lnTo>
                    <a:pt x="4775595" y="1378737"/>
                  </a:lnTo>
                  <a:lnTo>
                    <a:pt x="4767232" y="1359042"/>
                  </a:lnTo>
                  <a:lnTo>
                    <a:pt x="4758840" y="1370153"/>
                  </a:lnTo>
                  <a:lnTo>
                    <a:pt x="4691956" y="1469507"/>
                  </a:lnTo>
                  <a:lnTo>
                    <a:pt x="4683603" y="1483414"/>
                  </a:lnTo>
                  <a:lnTo>
                    <a:pt x="4675201" y="1525155"/>
                  </a:lnTo>
                  <a:lnTo>
                    <a:pt x="4608317" y="1866343"/>
                  </a:lnTo>
                  <a:lnTo>
                    <a:pt x="4599964" y="1909924"/>
                  </a:lnTo>
                  <a:lnTo>
                    <a:pt x="4591572" y="1873108"/>
                  </a:lnTo>
                  <a:lnTo>
                    <a:pt x="4524687" y="1609073"/>
                  </a:lnTo>
                  <a:lnTo>
                    <a:pt x="4516324" y="1579478"/>
                  </a:lnTo>
                  <a:lnTo>
                    <a:pt x="4507932" y="1610477"/>
                  </a:lnTo>
                  <a:lnTo>
                    <a:pt x="4441048" y="1845129"/>
                  </a:lnTo>
                  <a:lnTo>
                    <a:pt x="4432695" y="1872915"/>
                  </a:lnTo>
                  <a:lnTo>
                    <a:pt x="4424303" y="1785890"/>
                  </a:lnTo>
                  <a:lnTo>
                    <a:pt x="4357409" y="1083819"/>
                  </a:lnTo>
                  <a:lnTo>
                    <a:pt x="4349055" y="995285"/>
                  </a:lnTo>
                  <a:lnTo>
                    <a:pt x="4340664" y="1085639"/>
                  </a:lnTo>
                  <a:lnTo>
                    <a:pt x="4273779" y="1867998"/>
                  </a:lnTo>
                  <a:lnTo>
                    <a:pt x="4265416" y="1973895"/>
                  </a:lnTo>
                  <a:lnTo>
                    <a:pt x="4257024" y="1905433"/>
                  </a:lnTo>
                  <a:lnTo>
                    <a:pt x="4190140" y="1469129"/>
                  </a:lnTo>
                  <a:lnTo>
                    <a:pt x="4181787" y="1425424"/>
                  </a:lnTo>
                  <a:lnTo>
                    <a:pt x="4173394" y="1474152"/>
                  </a:lnTo>
                  <a:lnTo>
                    <a:pt x="4106500" y="2070936"/>
                  </a:lnTo>
                  <a:lnTo>
                    <a:pt x="4098147" y="2187566"/>
                  </a:lnTo>
                  <a:lnTo>
                    <a:pt x="4089755" y="2145525"/>
                  </a:lnTo>
                  <a:lnTo>
                    <a:pt x="4022871" y="1926483"/>
                  </a:lnTo>
                  <a:lnTo>
                    <a:pt x="4014517" y="1908298"/>
                  </a:lnTo>
                  <a:lnTo>
                    <a:pt x="4006154" y="1892387"/>
                  </a:lnTo>
                  <a:lnTo>
                    <a:pt x="3939231" y="1747788"/>
                  </a:lnTo>
                  <a:lnTo>
                    <a:pt x="3930878" y="1727213"/>
                  </a:lnTo>
                  <a:lnTo>
                    <a:pt x="3922525" y="1729603"/>
                  </a:lnTo>
                  <a:lnTo>
                    <a:pt x="3855602" y="1750691"/>
                  </a:lnTo>
                  <a:lnTo>
                    <a:pt x="3847239" y="1753643"/>
                  </a:lnTo>
                  <a:lnTo>
                    <a:pt x="3838885" y="1740559"/>
                  </a:lnTo>
                  <a:lnTo>
                    <a:pt x="3771962" y="1644988"/>
                  </a:lnTo>
                  <a:lnTo>
                    <a:pt x="3763609" y="1634101"/>
                  </a:lnTo>
                  <a:lnTo>
                    <a:pt x="3755246" y="1643672"/>
                  </a:lnTo>
                  <a:lnTo>
                    <a:pt x="3688323" y="1730851"/>
                  </a:lnTo>
                  <a:lnTo>
                    <a:pt x="3679970" y="1743288"/>
                  </a:lnTo>
                  <a:lnTo>
                    <a:pt x="3671616" y="1665748"/>
                  </a:lnTo>
                  <a:lnTo>
                    <a:pt x="3604693" y="1200981"/>
                  </a:lnTo>
                  <a:lnTo>
                    <a:pt x="3596330" y="1157043"/>
                  </a:lnTo>
                  <a:lnTo>
                    <a:pt x="3587977" y="1167863"/>
                  </a:lnTo>
                  <a:lnTo>
                    <a:pt x="3521054" y="1267663"/>
                  </a:lnTo>
                  <a:lnTo>
                    <a:pt x="3512701" y="1282064"/>
                  </a:lnTo>
                  <a:lnTo>
                    <a:pt x="3504347" y="1248423"/>
                  </a:lnTo>
                  <a:lnTo>
                    <a:pt x="3437424" y="1013809"/>
                  </a:lnTo>
                  <a:lnTo>
                    <a:pt x="3429061" y="988211"/>
                  </a:lnTo>
                  <a:lnTo>
                    <a:pt x="3420708" y="1034258"/>
                  </a:lnTo>
                  <a:lnTo>
                    <a:pt x="3353785" y="1936315"/>
                  </a:lnTo>
                  <a:lnTo>
                    <a:pt x="3345432" y="2243969"/>
                  </a:lnTo>
                  <a:lnTo>
                    <a:pt x="3337069" y="2234175"/>
                  </a:lnTo>
                  <a:lnTo>
                    <a:pt x="3270146" y="2199847"/>
                  </a:lnTo>
                  <a:lnTo>
                    <a:pt x="3261792" y="2197844"/>
                  </a:lnTo>
                  <a:lnTo>
                    <a:pt x="3253439" y="2140153"/>
                  </a:lnTo>
                  <a:lnTo>
                    <a:pt x="3186516" y="1773454"/>
                  </a:lnTo>
                  <a:lnTo>
                    <a:pt x="3178153" y="1736823"/>
                  </a:lnTo>
                  <a:lnTo>
                    <a:pt x="3169800" y="1725441"/>
                  </a:lnTo>
                  <a:lnTo>
                    <a:pt x="3102877" y="1599589"/>
                  </a:lnTo>
                  <a:lnTo>
                    <a:pt x="3094523" y="1577513"/>
                  </a:lnTo>
                  <a:lnTo>
                    <a:pt x="3086161" y="1577281"/>
                  </a:lnTo>
                  <a:lnTo>
                    <a:pt x="3019238" y="1576071"/>
                  </a:lnTo>
                  <a:lnTo>
                    <a:pt x="3010884" y="1575965"/>
                  </a:lnTo>
                  <a:lnTo>
                    <a:pt x="3002531" y="1566325"/>
                  </a:lnTo>
                  <a:lnTo>
                    <a:pt x="2935608" y="1485872"/>
                  </a:lnTo>
                  <a:lnTo>
                    <a:pt x="2927245" y="1475362"/>
                  </a:lnTo>
                  <a:lnTo>
                    <a:pt x="2918892" y="1499334"/>
                  </a:lnTo>
                  <a:lnTo>
                    <a:pt x="2851968" y="1685859"/>
                  </a:lnTo>
                  <a:lnTo>
                    <a:pt x="2843615" y="1708544"/>
                  </a:lnTo>
                  <a:lnTo>
                    <a:pt x="2835262" y="1709792"/>
                  </a:lnTo>
                  <a:lnTo>
                    <a:pt x="2768329" y="1722722"/>
                  </a:lnTo>
                  <a:lnTo>
                    <a:pt x="2759976" y="1724871"/>
                  </a:lnTo>
                  <a:lnTo>
                    <a:pt x="2751623" y="1730813"/>
                  </a:lnTo>
                  <a:lnTo>
                    <a:pt x="2684699" y="1770802"/>
                  </a:lnTo>
                  <a:lnTo>
                    <a:pt x="2676346" y="1775041"/>
                  </a:lnTo>
                  <a:lnTo>
                    <a:pt x="2667983" y="1800485"/>
                  </a:lnTo>
                  <a:lnTo>
                    <a:pt x="2601060" y="2001681"/>
                  </a:lnTo>
                  <a:lnTo>
                    <a:pt x="2592707" y="2026514"/>
                  </a:lnTo>
                  <a:lnTo>
                    <a:pt x="2584354" y="1916350"/>
                  </a:lnTo>
                  <a:lnTo>
                    <a:pt x="2517430" y="1165134"/>
                  </a:lnTo>
                  <a:lnTo>
                    <a:pt x="2509068" y="1084874"/>
                  </a:lnTo>
                  <a:lnTo>
                    <a:pt x="2500714" y="1160566"/>
                  </a:lnTo>
                  <a:lnTo>
                    <a:pt x="2433791" y="1801356"/>
                  </a:lnTo>
                  <a:lnTo>
                    <a:pt x="2425438" y="1886145"/>
                  </a:lnTo>
                  <a:lnTo>
                    <a:pt x="2417075" y="1892387"/>
                  </a:lnTo>
                  <a:lnTo>
                    <a:pt x="2350152" y="1945006"/>
                  </a:lnTo>
                  <a:lnTo>
                    <a:pt x="2341799" y="1951926"/>
                  </a:lnTo>
                  <a:lnTo>
                    <a:pt x="2333445" y="1951287"/>
                  </a:lnTo>
                  <a:lnTo>
                    <a:pt x="2266522" y="1944938"/>
                  </a:lnTo>
                  <a:lnTo>
                    <a:pt x="2258159" y="1943951"/>
                  </a:lnTo>
                  <a:lnTo>
                    <a:pt x="2249806" y="1896171"/>
                  </a:lnTo>
                  <a:lnTo>
                    <a:pt x="2182883" y="1577020"/>
                  </a:lnTo>
                  <a:lnTo>
                    <a:pt x="2174530" y="1543563"/>
                  </a:lnTo>
                  <a:lnTo>
                    <a:pt x="2166176" y="1515816"/>
                  </a:lnTo>
                  <a:lnTo>
                    <a:pt x="2099253" y="1258178"/>
                  </a:lnTo>
                  <a:lnTo>
                    <a:pt x="2090890" y="1220744"/>
                  </a:lnTo>
                  <a:lnTo>
                    <a:pt x="2082537" y="1300897"/>
                  </a:lnTo>
                  <a:lnTo>
                    <a:pt x="2015614" y="1790575"/>
                  </a:lnTo>
                  <a:lnTo>
                    <a:pt x="2007260" y="1837716"/>
                  </a:lnTo>
                  <a:lnTo>
                    <a:pt x="1998898" y="1826490"/>
                  </a:lnTo>
                  <a:lnTo>
                    <a:pt x="1931975" y="1711718"/>
                  </a:lnTo>
                  <a:lnTo>
                    <a:pt x="1923621" y="1693233"/>
                  </a:lnTo>
                  <a:lnTo>
                    <a:pt x="1915268" y="1692439"/>
                  </a:lnTo>
                  <a:lnTo>
                    <a:pt x="1848345" y="1685975"/>
                  </a:lnTo>
                  <a:lnTo>
                    <a:pt x="1839982" y="1685181"/>
                  </a:lnTo>
                  <a:lnTo>
                    <a:pt x="1831629" y="1694104"/>
                  </a:lnTo>
                  <a:lnTo>
                    <a:pt x="1764706" y="1761202"/>
                  </a:lnTo>
                  <a:lnTo>
                    <a:pt x="1756352" y="1769070"/>
                  </a:lnTo>
                  <a:lnTo>
                    <a:pt x="1747989" y="1775457"/>
                  </a:lnTo>
                  <a:lnTo>
                    <a:pt x="1681066" y="1817683"/>
                  </a:lnTo>
                  <a:lnTo>
                    <a:pt x="1672713" y="1822067"/>
                  </a:lnTo>
                  <a:lnTo>
                    <a:pt x="1664360" y="1840861"/>
                  </a:lnTo>
                  <a:lnTo>
                    <a:pt x="1597437" y="2063910"/>
                  </a:lnTo>
                  <a:lnTo>
                    <a:pt x="1589074" y="2106058"/>
                  </a:lnTo>
                  <a:lnTo>
                    <a:pt x="1580720" y="2098383"/>
                  </a:lnTo>
                  <a:lnTo>
                    <a:pt x="1513797" y="2050254"/>
                  </a:lnTo>
                  <a:lnTo>
                    <a:pt x="1505444" y="2045532"/>
                  </a:lnTo>
                  <a:lnTo>
                    <a:pt x="1497091" y="2025643"/>
                  </a:lnTo>
                  <a:lnTo>
                    <a:pt x="1430158" y="1892310"/>
                  </a:lnTo>
                  <a:lnTo>
                    <a:pt x="1421805" y="1878286"/>
                  </a:lnTo>
                  <a:lnTo>
                    <a:pt x="1413451" y="1879002"/>
                  </a:lnTo>
                  <a:lnTo>
                    <a:pt x="1346528" y="1887771"/>
                  </a:lnTo>
                  <a:lnTo>
                    <a:pt x="1338175" y="1889435"/>
                  </a:lnTo>
                  <a:lnTo>
                    <a:pt x="1329812" y="1774964"/>
                  </a:lnTo>
                  <a:lnTo>
                    <a:pt x="1262889" y="1210272"/>
                  </a:lnTo>
                  <a:lnTo>
                    <a:pt x="1254536" y="1165666"/>
                  </a:lnTo>
                  <a:lnTo>
                    <a:pt x="1246182" y="1185138"/>
                  </a:lnTo>
                  <a:lnTo>
                    <a:pt x="1179259" y="1369127"/>
                  </a:lnTo>
                  <a:lnTo>
                    <a:pt x="1170896" y="1396390"/>
                  </a:lnTo>
                  <a:lnTo>
                    <a:pt x="1162543" y="1472488"/>
                  </a:lnTo>
                  <a:lnTo>
                    <a:pt x="1095620" y="2047835"/>
                  </a:lnTo>
                  <a:lnTo>
                    <a:pt x="1087267" y="2115852"/>
                  </a:lnTo>
                  <a:lnTo>
                    <a:pt x="1078904" y="2055964"/>
                  </a:lnTo>
                  <a:lnTo>
                    <a:pt x="1011981" y="1659167"/>
                  </a:lnTo>
                  <a:lnTo>
                    <a:pt x="1003627" y="1617929"/>
                  </a:lnTo>
                  <a:lnTo>
                    <a:pt x="995274" y="1600499"/>
                  </a:lnTo>
                  <a:lnTo>
                    <a:pt x="928351" y="1419936"/>
                  </a:lnTo>
                  <a:lnTo>
                    <a:pt x="919988" y="1390496"/>
                  </a:lnTo>
                  <a:lnTo>
                    <a:pt x="911635" y="1448564"/>
                  </a:lnTo>
                  <a:lnTo>
                    <a:pt x="844712" y="1825280"/>
                  </a:lnTo>
                  <a:lnTo>
                    <a:pt x="836358" y="1863653"/>
                  </a:lnTo>
                  <a:lnTo>
                    <a:pt x="828005" y="1870234"/>
                  </a:lnTo>
                  <a:lnTo>
                    <a:pt x="761082" y="1937370"/>
                  </a:lnTo>
                  <a:lnTo>
                    <a:pt x="752719" y="1948151"/>
                  </a:lnTo>
                  <a:lnTo>
                    <a:pt x="744366" y="1924479"/>
                  </a:lnTo>
                  <a:lnTo>
                    <a:pt x="677443" y="1698488"/>
                  </a:lnTo>
                  <a:lnTo>
                    <a:pt x="669089" y="1664615"/>
                  </a:lnTo>
                  <a:lnTo>
                    <a:pt x="660727" y="1570023"/>
                  </a:lnTo>
                  <a:lnTo>
                    <a:pt x="593803" y="1054485"/>
                  </a:lnTo>
                  <a:lnTo>
                    <a:pt x="585450" y="1009870"/>
                  </a:lnTo>
                  <a:lnTo>
                    <a:pt x="577097" y="1055463"/>
                  </a:lnTo>
                  <a:lnTo>
                    <a:pt x="510174" y="1640304"/>
                  </a:lnTo>
                  <a:lnTo>
                    <a:pt x="501811" y="1760602"/>
                  </a:lnTo>
                  <a:lnTo>
                    <a:pt x="493458" y="1691607"/>
                  </a:lnTo>
                  <a:lnTo>
                    <a:pt x="426534" y="1382705"/>
                  </a:lnTo>
                  <a:lnTo>
                    <a:pt x="418181" y="1360320"/>
                  </a:lnTo>
                  <a:lnTo>
                    <a:pt x="409818" y="1392567"/>
                  </a:lnTo>
                  <a:lnTo>
                    <a:pt x="342895" y="1743172"/>
                  </a:lnTo>
                  <a:lnTo>
                    <a:pt x="334542" y="1803398"/>
                  </a:lnTo>
                  <a:lnTo>
                    <a:pt x="326189" y="1840823"/>
                  </a:lnTo>
                  <a:lnTo>
                    <a:pt x="259304" y="2186472"/>
                  </a:lnTo>
                  <a:lnTo>
                    <a:pt x="250903" y="2236488"/>
                  </a:lnTo>
                  <a:lnTo>
                    <a:pt x="242549" y="2155619"/>
                  </a:lnTo>
                  <a:lnTo>
                    <a:pt x="175665" y="1703434"/>
                  </a:lnTo>
                  <a:lnTo>
                    <a:pt x="167273" y="1663406"/>
                  </a:lnTo>
                  <a:lnTo>
                    <a:pt x="158920" y="1651347"/>
                  </a:lnTo>
                  <a:lnTo>
                    <a:pt x="92029" y="1540427"/>
                  </a:lnTo>
                  <a:lnTo>
                    <a:pt x="83635" y="1524391"/>
                  </a:lnTo>
                  <a:lnTo>
                    <a:pt x="75279" y="1546776"/>
                  </a:lnTo>
                  <a:lnTo>
                    <a:pt x="8394" y="1723361"/>
                  </a:lnTo>
                  <a:lnTo>
                    <a:pt x="0" y="1745136"/>
                  </a:lnTo>
                  <a:close/>
                </a:path>
              </a:pathLst>
            </a:custGeom>
            <a:solidFill>
              <a:srgbClr val="BEBADA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00" name="Freeform: Shape 2999">
              <a:extLst>
                <a:ext uri="{FF2B5EF4-FFF2-40B4-BE49-F238E27FC236}">
                  <a16:creationId xmlns:a16="http://schemas.microsoft.com/office/drawing/2014/main" id="{08D9B8FF-2F74-FC5E-3B73-A2ECF97C9011}"/>
                </a:ext>
              </a:extLst>
            </p:cNvPr>
            <p:cNvSpPr/>
            <p:nvPr/>
          </p:nvSpPr>
          <p:spPr>
            <a:xfrm>
              <a:off x="1961705" y="2620886"/>
              <a:ext cx="8363529" cy="1600305"/>
            </a:xfrm>
            <a:custGeom>
              <a:avLst/>
              <a:gdLst>
                <a:gd name="connsiteX0" fmla="*/ 0 w 8363529"/>
                <a:gd name="connsiteY0" fmla="*/ 797602 h 1600305"/>
                <a:gd name="connsiteX1" fmla="*/ 8394 w 8363529"/>
                <a:gd name="connsiteY1" fmla="*/ 775827 h 1600305"/>
                <a:gd name="connsiteX2" fmla="*/ 75279 w 8363529"/>
                <a:gd name="connsiteY2" fmla="*/ 599242 h 1600305"/>
                <a:gd name="connsiteX3" fmla="*/ 83635 w 8363529"/>
                <a:gd name="connsiteY3" fmla="*/ 576857 h 1600305"/>
                <a:gd name="connsiteX4" fmla="*/ 92029 w 8363529"/>
                <a:gd name="connsiteY4" fmla="*/ 592893 h 1600305"/>
                <a:gd name="connsiteX5" fmla="*/ 158920 w 8363529"/>
                <a:gd name="connsiteY5" fmla="*/ 703813 h 1600305"/>
                <a:gd name="connsiteX6" fmla="*/ 167273 w 8363529"/>
                <a:gd name="connsiteY6" fmla="*/ 715872 h 1600305"/>
                <a:gd name="connsiteX7" fmla="*/ 175665 w 8363529"/>
                <a:gd name="connsiteY7" fmla="*/ 755900 h 1600305"/>
                <a:gd name="connsiteX8" fmla="*/ 242549 w 8363529"/>
                <a:gd name="connsiteY8" fmla="*/ 1208085 h 1600305"/>
                <a:gd name="connsiteX9" fmla="*/ 250903 w 8363529"/>
                <a:gd name="connsiteY9" fmla="*/ 1288954 h 1600305"/>
                <a:gd name="connsiteX10" fmla="*/ 259304 w 8363529"/>
                <a:gd name="connsiteY10" fmla="*/ 1238938 h 1600305"/>
                <a:gd name="connsiteX11" fmla="*/ 326189 w 8363529"/>
                <a:gd name="connsiteY11" fmla="*/ 893289 h 1600305"/>
                <a:gd name="connsiteX12" fmla="*/ 334542 w 8363529"/>
                <a:gd name="connsiteY12" fmla="*/ 855864 h 1600305"/>
                <a:gd name="connsiteX13" fmla="*/ 342895 w 8363529"/>
                <a:gd name="connsiteY13" fmla="*/ 795638 h 1600305"/>
                <a:gd name="connsiteX14" fmla="*/ 409818 w 8363529"/>
                <a:gd name="connsiteY14" fmla="*/ 445033 h 1600305"/>
                <a:gd name="connsiteX15" fmla="*/ 418181 w 8363529"/>
                <a:gd name="connsiteY15" fmla="*/ 412786 h 1600305"/>
                <a:gd name="connsiteX16" fmla="*/ 426534 w 8363529"/>
                <a:gd name="connsiteY16" fmla="*/ 435171 h 1600305"/>
                <a:gd name="connsiteX17" fmla="*/ 493458 w 8363529"/>
                <a:gd name="connsiteY17" fmla="*/ 744073 h 1600305"/>
                <a:gd name="connsiteX18" fmla="*/ 501811 w 8363529"/>
                <a:gd name="connsiteY18" fmla="*/ 813068 h 1600305"/>
                <a:gd name="connsiteX19" fmla="*/ 510174 w 8363529"/>
                <a:gd name="connsiteY19" fmla="*/ 692770 h 1600305"/>
                <a:gd name="connsiteX20" fmla="*/ 577097 w 8363529"/>
                <a:gd name="connsiteY20" fmla="*/ 107929 h 1600305"/>
                <a:gd name="connsiteX21" fmla="*/ 585450 w 8363529"/>
                <a:gd name="connsiteY21" fmla="*/ 62336 h 1600305"/>
                <a:gd name="connsiteX22" fmla="*/ 593803 w 8363529"/>
                <a:gd name="connsiteY22" fmla="*/ 106951 h 1600305"/>
                <a:gd name="connsiteX23" fmla="*/ 660727 w 8363529"/>
                <a:gd name="connsiteY23" fmla="*/ 622489 h 1600305"/>
                <a:gd name="connsiteX24" fmla="*/ 669089 w 8363529"/>
                <a:gd name="connsiteY24" fmla="*/ 717081 h 1600305"/>
                <a:gd name="connsiteX25" fmla="*/ 677443 w 8363529"/>
                <a:gd name="connsiteY25" fmla="*/ 750954 h 1600305"/>
                <a:gd name="connsiteX26" fmla="*/ 744366 w 8363529"/>
                <a:gd name="connsiteY26" fmla="*/ 976945 h 1600305"/>
                <a:gd name="connsiteX27" fmla="*/ 752719 w 8363529"/>
                <a:gd name="connsiteY27" fmla="*/ 1000618 h 1600305"/>
                <a:gd name="connsiteX28" fmla="*/ 761082 w 8363529"/>
                <a:gd name="connsiteY28" fmla="*/ 989836 h 1600305"/>
                <a:gd name="connsiteX29" fmla="*/ 828005 w 8363529"/>
                <a:gd name="connsiteY29" fmla="*/ 922700 h 1600305"/>
                <a:gd name="connsiteX30" fmla="*/ 836358 w 8363529"/>
                <a:gd name="connsiteY30" fmla="*/ 916119 h 1600305"/>
                <a:gd name="connsiteX31" fmla="*/ 844712 w 8363529"/>
                <a:gd name="connsiteY31" fmla="*/ 877746 h 1600305"/>
                <a:gd name="connsiteX32" fmla="*/ 911635 w 8363529"/>
                <a:gd name="connsiteY32" fmla="*/ 501030 h 1600305"/>
                <a:gd name="connsiteX33" fmla="*/ 919988 w 8363529"/>
                <a:gd name="connsiteY33" fmla="*/ 442962 h 1600305"/>
                <a:gd name="connsiteX34" fmla="*/ 928351 w 8363529"/>
                <a:gd name="connsiteY34" fmla="*/ 472402 h 1600305"/>
                <a:gd name="connsiteX35" fmla="*/ 995274 w 8363529"/>
                <a:gd name="connsiteY35" fmla="*/ 652965 h 1600305"/>
                <a:gd name="connsiteX36" fmla="*/ 1003627 w 8363529"/>
                <a:gd name="connsiteY36" fmla="*/ 670395 h 1600305"/>
                <a:gd name="connsiteX37" fmla="*/ 1011981 w 8363529"/>
                <a:gd name="connsiteY37" fmla="*/ 711633 h 1600305"/>
                <a:gd name="connsiteX38" fmla="*/ 1078904 w 8363529"/>
                <a:gd name="connsiteY38" fmla="*/ 1108431 h 1600305"/>
                <a:gd name="connsiteX39" fmla="*/ 1087267 w 8363529"/>
                <a:gd name="connsiteY39" fmla="*/ 1168318 h 1600305"/>
                <a:gd name="connsiteX40" fmla="*/ 1095620 w 8363529"/>
                <a:gd name="connsiteY40" fmla="*/ 1100301 h 1600305"/>
                <a:gd name="connsiteX41" fmla="*/ 1162543 w 8363529"/>
                <a:gd name="connsiteY41" fmla="*/ 524954 h 1600305"/>
                <a:gd name="connsiteX42" fmla="*/ 1170896 w 8363529"/>
                <a:gd name="connsiteY42" fmla="*/ 448856 h 1600305"/>
                <a:gd name="connsiteX43" fmla="*/ 1179259 w 8363529"/>
                <a:gd name="connsiteY43" fmla="*/ 421593 h 1600305"/>
                <a:gd name="connsiteX44" fmla="*/ 1246182 w 8363529"/>
                <a:gd name="connsiteY44" fmla="*/ 237604 h 1600305"/>
                <a:gd name="connsiteX45" fmla="*/ 1254536 w 8363529"/>
                <a:gd name="connsiteY45" fmla="*/ 218132 h 1600305"/>
                <a:gd name="connsiteX46" fmla="*/ 1262889 w 8363529"/>
                <a:gd name="connsiteY46" fmla="*/ 262738 h 1600305"/>
                <a:gd name="connsiteX47" fmla="*/ 1329812 w 8363529"/>
                <a:gd name="connsiteY47" fmla="*/ 827430 h 1600305"/>
                <a:gd name="connsiteX48" fmla="*/ 1338175 w 8363529"/>
                <a:gd name="connsiteY48" fmla="*/ 941901 h 1600305"/>
                <a:gd name="connsiteX49" fmla="*/ 1346528 w 8363529"/>
                <a:gd name="connsiteY49" fmla="*/ 940237 h 1600305"/>
                <a:gd name="connsiteX50" fmla="*/ 1413451 w 8363529"/>
                <a:gd name="connsiteY50" fmla="*/ 931468 h 1600305"/>
                <a:gd name="connsiteX51" fmla="*/ 1421805 w 8363529"/>
                <a:gd name="connsiteY51" fmla="*/ 930752 h 1600305"/>
                <a:gd name="connsiteX52" fmla="*/ 1430158 w 8363529"/>
                <a:gd name="connsiteY52" fmla="*/ 944776 h 1600305"/>
                <a:gd name="connsiteX53" fmla="*/ 1497091 w 8363529"/>
                <a:gd name="connsiteY53" fmla="*/ 1078109 h 1600305"/>
                <a:gd name="connsiteX54" fmla="*/ 1505444 w 8363529"/>
                <a:gd name="connsiteY54" fmla="*/ 1097998 h 1600305"/>
                <a:gd name="connsiteX55" fmla="*/ 1513797 w 8363529"/>
                <a:gd name="connsiteY55" fmla="*/ 1102721 h 1600305"/>
                <a:gd name="connsiteX56" fmla="*/ 1580720 w 8363529"/>
                <a:gd name="connsiteY56" fmla="*/ 1150849 h 1600305"/>
                <a:gd name="connsiteX57" fmla="*/ 1589074 w 8363529"/>
                <a:gd name="connsiteY57" fmla="*/ 1158524 h 1600305"/>
                <a:gd name="connsiteX58" fmla="*/ 1597437 w 8363529"/>
                <a:gd name="connsiteY58" fmla="*/ 1116376 h 1600305"/>
                <a:gd name="connsiteX59" fmla="*/ 1664360 w 8363529"/>
                <a:gd name="connsiteY59" fmla="*/ 893327 h 1600305"/>
                <a:gd name="connsiteX60" fmla="*/ 1672713 w 8363529"/>
                <a:gd name="connsiteY60" fmla="*/ 874533 h 1600305"/>
                <a:gd name="connsiteX61" fmla="*/ 1681066 w 8363529"/>
                <a:gd name="connsiteY61" fmla="*/ 870149 h 1600305"/>
                <a:gd name="connsiteX62" fmla="*/ 1747989 w 8363529"/>
                <a:gd name="connsiteY62" fmla="*/ 827923 h 1600305"/>
                <a:gd name="connsiteX63" fmla="*/ 1756352 w 8363529"/>
                <a:gd name="connsiteY63" fmla="*/ 821536 h 1600305"/>
                <a:gd name="connsiteX64" fmla="*/ 1764706 w 8363529"/>
                <a:gd name="connsiteY64" fmla="*/ 813668 h 1600305"/>
                <a:gd name="connsiteX65" fmla="*/ 1831629 w 8363529"/>
                <a:gd name="connsiteY65" fmla="*/ 746570 h 1600305"/>
                <a:gd name="connsiteX66" fmla="*/ 1839982 w 8363529"/>
                <a:gd name="connsiteY66" fmla="*/ 737647 h 1600305"/>
                <a:gd name="connsiteX67" fmla="*/ 1848345 w 8363529"/>
                <a:gd name="connsiteY67" fmla="*/ 738441 h 1600305"/>
                <a:gd name="connsiteX68" fmla="*/ 1915268 w 8363529"/>
                <a:gd name="connsiteY68" fmla="*/ 744906 h 1600305"/>
                <a:gd name="connsiteX69" fmla="*/ 1923621 w 8363529"/>
                <a:gd name="connsiteY69" fmla="*/ 745699 h 1600305"/>
                <a:gd name="connsiteX70" fmla="*/ 1931975 w 8363529"/>
                <a:gd name="connsiteY70" fmla="*/ 764184 h 1600305"/>
                <a:gd name="connsiteX71" fmla="*/ 1998898 w 8363529"/>
                <a:gd name="connsiteY71" fmla="*/ 878956 h 1600305"/>
                <a:gd name="connsiteX72" fmla="*/ 2007260 w 8363529"/>
                <a:gd name="connsiteY72" fmla="*/ 890182 h 1600305"/>
                <a:gd name="connsiteX73" fmla="*/ 2015614 w 8363529"/>
                <a:gd name="connsiteY73" fmla="*/ 843041 h 1600305"/>
                <a:gd name="connsiteX74" fmla="*/ 2082537 w 8363529"/>
                <a:gd name="connsiteY74" fmla="*/ 353363 h 1600305"/>
                <a:gd name="connsiteX75" fmla="*/ 2090890 w 8363529"/>
                <a:gd name="connsiteY75" fmla="*/ 273210 h 1600305"/>
                <a:gd name="connsiteX76" fmla="*/ 2099253 w 8363529"/>
                <a:gd name="connsiteY76" fmla="*/ 310644 h 1600305"/>
                <a:gd name="connsiteX77" fmla="*/ 2166176 w 8363529"/>
                <a:gd name="connsiteY77" fmla="*/ 568282 h 1600305"/>
                <a:gd name="connsiteX78" fmla="*/ 2174530 w 8363529"/>
                <a:gd name="connsiteY78" fmla="*/ 596029 h 1600305"/>
                <a:gd name="connsiteX79" fmla="*/ 2182883 w 8363529"/>
                <a:gd name="connsiteY79" fmla="*/ 629486 h 1600305"/>
                <a:gd name="connsiteX80" fmla="*/ 2249806 w 8363529"/>
                <a:gd name="connsiteY80" fmla="*/ 948637 h 1600305"/>
                <a:gd name="connsiteX81" fmla="*/ 2258159 w 8363529"/>
                <a:gd name="connsiteY81" fmla="*/ 996417 h 1600305"/>
                <a:gd name="connsiteX82" fmla="*/ 2266522 w 8363529"/>
                <a:gd name="connsiteY82" fmla="*/ 997404 h 1600305"/>
                <a:gd name="connsiteX83" fmla="*/ 2333445 w 8363529"/>
                <a:gd name="connsiteY83" fmla="*/ 1003753 h 1600305"/>
                <a:gd name="connsiteX84" fmla="*/ 2341799 w 8363529"/>
                <a:gd name="connsiteY84" fmla="*/ 1004392 h 1600305"/>
                <a:gd name="connsiteX85" fmla="*/ 2350152 w 8363529"/>
                <a:gd name="connsiteY85" fmla="*/ 997472 h 1600305"/>
                <a:gd name="connsiteX86" fmla="*/ 2417075 w 8363529"/>
                <a:gd name="connsiteY86" fmla="*/ 944853 h 1600305"/>
                <a:gd name="connsiteX87" fmla="*/ 2425438 w 8363529"/>
                <a:gd name="connsiteY87" fmla="*/ 938611 h 1600305"/>
                <a:gd name="connsiteX88" fmla="*/ 2433791 w 8363529"/>
                <a:gd name="connsiteY88" fmla="*/ 853822 h 1600305"/>
                <a:gd name="connsiteX89" fmla="*/ 2500714 w 8363529"/>
                <a:gd name="connsiteY89" fmla="*/ 213032 h 1600305"/>
                <a:gd name="connsiteX90" fmla="*/ 2509068 w 8363529"/>
                <a:gd name="connsiteY90" fmla="*/ 137340 h 1600305"/>
                <a:gd name="connsiteX91" fmla="*/ 2517430 w 8363529"/>
                <a:gd name="connsiteY91" fmla="*/ 217600 h 1600305"/>
                <a:gd name="connsiteX92" fmla="*/ 2584354 w 8363529"/>
                <a:gd name="connsiteY92" fmla="*/ 968816 h 1600305"/>
                <a:gd name="connsiteX93" fmla="*/ 2592707 w 8363529"/>
                <a:gd name="connsiteY93" fmla="*/ 1078980 h 1600305"/>
                <a:gd name="connsiteX94" fmla="*/ 2601060 w 8363529"/>
                <a:gd name="connsiteY94" fmla="*/ 1054147 h 1600305"/>
                <a:gd name="connsiteX95" fmla="*/ 2667983 w 8363529"/>
                <a:gd name="connsiteY95" fmla="*/ 852951 h 1600305"/>
                <a:gd name="connsiteX96" fmla="*/ 2676346 w 8363529"/>
                <a:gd name="connsiteY96" fmla="*/ 827507 h 1600305"/>
                <a:gd name="connsiteX97" fmla="*/ 2684699 w 8363529"/>
                <a:gd name="connsiteY97" fmla="*/ 823268 h 1600305"/>
                <a:gd name="connsiteX98" fmla="*/ 2751623 w 8363529"/>
                <a:gd name="connsiteY98" fmla="*/ 783279 h 1600305"/>
                <a:gd name="connsiteX99" fmla="*/ 2759976 w 8363529"/>
                <a:gd name="connsiteY99" fmla="*/ 777337 h 1600305"/>
                <a:gd name="connsiteX100" fmla="*/ 2768329 w 8363529"/>
                <a:gd name="connsiteY100" fmla="*/ 775188 h 1600305"/>
                <a:gd name="connsiteX101" fmla="*/ 2835262 w 8363529"/>
                <a:gd name="connsiteY101" fmla="*/ 762258 h 1600305"/>
                <a:gd name="connsiteX102" fmla="*/ 2843615 w 8363529"/>
                <a:gd name="connsiteY102" fmla="*/ 761010 h 1600305"/>
                <a:gd name="connsiteX103" fmla="*/ 2851968 w 8363529"/>
                <a:gd name="connsiteY103" fmla="*/ 738325 h 1600305"/>
                <a:gd name="connsiteX104" fmla="*/ 2918892 w 8363529"/>
                <a:gd name="connsiteY104" fmla="*/ 551801 h 1600305"/>
                <a:gd name="connsiteX105" fmla="*/ 2927245 w 8363529"/>
                <a:gd name="connsiteY105" fmla="*/ 527828 h 1600305"/>
                <a:gd name="connsiteX106" fmla="*/ 2935608 w 8363529"/>
                <a:gd name="connsiteY106" fmla="*/ 538339 h 1600305"/>
                <a:gd name="connsiteX107" fmla="*/ 3002531 w 8363529"/>
                <a:gd name="connsiteY107" fmla="*/ 618792 h 1600305"/>
                <a:gd name="connsiteX108" fmla="*/ 3010884 w 8363529"/>
                <a:gd name="connsiteY108" fmla="*/ 628431 h 1600305"/>
                <a:gd name="connsiteX109" fmla="*/ 3019238 w 8363529"/>
                <a:gd name="connsiteY109" fmla="*/ 628538 h 1600305"/>
                <a:gd name="connsiteX110" fmla="*/ 3086161 w 8363529"/>
                <a:gd name="connsiteY110" fmla="*/ 629747 h 1600305"/>
                <a:gd name="connsiteX111" fmla="*/ 3094523 w 8363529"/>
                <a:gd name="connsiteY111" fmla="*/ 629979 h 1600305"/>
                <a:gd name="connsiteX112" fmla="*/ 3102877 w 8363529"/>
                <a:gd name="connsiteY112" fmla="*/ 652055 h 1600305"/>
                <a:gd name="connsiteX113" fmla="*/ 3169800 w 8363529"/>
                <a:gd name="connsiteY113" fmla="*/ 777908 h 1600305"/>
                <a:gd name="connsiteX114" fmla="*/ 3178153 w 8363529"/>
                <a:gd name="connsiteY114" fmla="*/ 789289 h 1600305"/>
                <a:gd name="connsiteX115" fmla="*/ 3186516 w 8363529"/>
                <a:gd name="connsiteY115" fmla="*/ 825920 h 1600305"/>
                <a:gd name="connsiteX116" fmla="*/ 3253439 w 8363529"/>
                <a:gd name="connsiteY116" fmla="*/ 1192620 h 1600305"/>
                <a:gd name="connsiteX117" fmla="*/ 3261792 w 8363529"/>
                <a:gd name="connsiteY117" fmla="*/ 1250310 h 1600305"/>
                <a:gd name="connsiteX118" fmla="*/ 3270146 w 8363529"/>
                <a:gd name="connsiteY118" fmla="*/ 1252313 h 1600305"/>
                <a:gd name="connsiteX119" fmla="*/ 3337069 w 8363529"/>
                <a:gd name="connsiteY119" fmla="*/ 1286641 h 1600305"/>
                <a:gd name="connsiteX120" fmla="*/ 3345432 w 8363529"/>
                <a:gd name="connsiteY120" fmla="*/ 1296435 h 1600305"/>
                <a:gd name="connsiteX121" fmla="*/ 3353785 w 8363529"/>
                <a:gd name="connsiteY121" fmla="*/ 988781 h 1600305"/>
                <a:gd name="connsiteX122" fmla="*/ 3420708 w 8363529"/>
                <a:gd name="connsiteY122" fmla="*/ 86725 h 1600305"/>
                <a:gd name="connsiteX123" fmla="*/ 3429061 w 8363529"/>
                <a:gd name="connsiteY123" fmla="*/ 40677 h 1600305"/>
                <a:gd name="connsiteX124" fmla="*/ 3437424 w 8363529"/>
                <a:gd name="connsiteY124" fmla="*/ 66275 h 1600305"/>
                <a:gd name="connsiteX125" fmla="*/ 3504347 w 8363529"/>
                <a:gd name="connsiteY125" fmla="*/ 300889 h 1600305"/>
                <a:gd name="connsiteX126" fmla="*/ 3512701 w 8363529"/>
                <a:gd name="connsiteY126" fmla="*/ 334530 h 1600305"/>
                <a:gd name="connsiteX127" fmla="*/ 3521054 w 8363529"/>
                <a:gd name="connsiteY127" fmla="*/ 320129 h 1600305"/>
                <a:gd name="connsiteX128" fmla="*/ 3587977 w 8363529"/>
                <a:gd name="connsiteY128" fmla="*/ 220329 h 1600305"/>
                <a:gd name="connsiteX129" fmla="*/ 3596330 w 8363529"/>
                <a:gd name="connsiteY129" fmla="*/ 209509 h 1600305"/>
                <a:gd name="connsiteX130" fmla="*/ 3604693 w 8363529"/>
                <a:gd name="connsiteY130" fmla="*/ 253447 h 1600305"/>
                <a:gd name="connsiteX131" fmla="*/ 3671616 w 8363529"/>
                <a:gd name="connsiteY131" fmla="*/ 718214 h 1600305"/>
                <a:gd name="connsiteX132" fmla="*/ 3679970 w 8363529"/>
                <a:gd name="connsiteY132" fmla="*/ 795754 h 1600305"/>
                <a:gd name="connsiteX133" fmla="*/ 3688323 w 8363529"/>
                <a:gd name="connsiteY133" fmla="*/ 783318 h 1600305"/>
                <a:gd name="connsiteX134" fmla="*/ 3755246 w 8363529"/>
                <a:gd name="connsiteY134" fmla="*/ 696138 h 1600305"/>
                <a:gd name="connsiteX135" fmla="*/ 3763609 w 8363529"/>
                <a:gd name="connsiteY135" fmla="*/ 686567 h 1600305"/>
                <a:gd name="connsiteX136" fmla="*/ 3771962 w 8363529"/>
                <a:gd name="connsiteY136" fmla="*/ 697455 h 1600305"/>
                <a:gd name="connsiteX137" fmla="*/ 3838885 w 8363529"/>
                <a:gd name="connsiteY137" fmla="*/ 793025 h 1600305"/>
                <a:gd name="connsiteX138" fmla="*/ 3847239 w 8363529"/>
                <a:gd name="connsiteY138" fmla="*/ 806109 h 1600305"/>
                <a:gd name="connsiteX139" fmla="*/ 3855602 w 8363529"/>
                <a:gd name="connsiteY139" fmla="*/ 803158 h 1600305"/>
                <a:gd name="connsiteX140" fmla="*/ 3922525 w 8363529"/>
                <a:gd name="connsiteY140" fmla="*/ 782069 h 1600305"/>
                <a:gd name="connsiteX141" fmla="*/ 3930878 w 8363529"/>
                <a:gd name="connsiteY141" fmla="*/ 779679 h 1600305"/>
                <a:gd name="connsiteX142" fmla="*/ 3939231 w 8363529"/>
                <a:gd name="connsiteY142" fmla="*/ 800254 h 1600305"/>
                <a:gd name="connsiteX143" fmla="*/ 4006154 w 8363529"/>
                <a:gd name="connsiteY143" fmla="*/ 944853 h 1600305"/>
                <a:gd name="connsiteX144" fmla="*/ 4014517 w 8363529"/>
                <a:gd name="connsiteY144" fmla="*/ 960764 h 1600305"/>
                <a:gd name="connsiteX145" fmla="*/ 4022871 w 8363529"/>
                <a:gd name="connsiteY145" fmla="*/ 978949 h 1600305"/>
                <a:gd name="connsiteX146" fmla="*/ 4089755 w 8363529"/>
                <a:gd name="connsiteY146" fmla="*/ 1197991 h 1600305"/>
                <a:gd name="connsiteX147" fmla="*/ 4098147 w 8363529"/>
                <a:gd name="connsiteY147" fmla="*/ 1240032 h 1600305"/>
                <a:gd name="connsiteX148" fmla="*/ 4106500 w 8363529"/>
                <a:gd name="connsiteY148" fmla="*/ 1123402 h 1600305"/>
                <a:gd name="connsiteX149" fmla="*/ 4173394 w 8363529"/>
                <a:gd name="connsiteY149" fmla="*/ 526618 h 1600305"/>
                <a:gd name="connsiteX150" fmla="*/ 4181787 w 8363529"/>
                <a:gd name="connsiteY150" fmla="*/ 477890 h 1600305"/>
                <a:gd name="connsiteX151" fmla="*/ 4190140 w 8363529"/>
                <a:gd name="connsiteY151" fmla="*/ 521595 h 1600305"/>
                <a:gd name="connsiteX152" fmla="*/ 4257024 w 8363529"/>
                <a:gd name="connsiteY152" fmla="*/ 957899 h 1600305"/>
                <a:gd name="connsiteX153" fmla="*/ 4265416 w 8363529"/>
                <a:gd name="connsiteY153" fmla="*/ 1026361 h 1600305"/>
                <a:gd name="connsiteX154" fmla="*/ 4273779 w 8363529"/>
                <a:gd name="connsiteY154" fmla="*/ 920465 h 1600305"/>
                <a:gd name="connsiteX155" fmla="*/ 4340664 w 8363529"/>
                <a:gd name="connsiteY155" fmla="*/ 138105 h 1600305"/>
                <a:gd name="connsiteX156" fmla="*/ 4349055 w 8363529"/>
                <a:gd name="connsiteY156" fmla="*/ 47751 h 1600305"/>
                <a:gd name="connsiteX157" fmla="*/ 4357409 w 8363529"/>
                <a:gd name="connsiteY157" fmla="*/ 136286 h 1600305"/>
                <a:gd name="connsiteX158" fmla="*/ 4424303 w 8363529"/>
                <a:gd name="connsiteY158" fmla="*/ 838356 h 1600305"/>
                <a:gd name="connsiteX159" fmla="*/ 4432695 w 8363529"/>
                <a:gd name="connsiteY159" fmla="*/ 925381 h 1600305"/>
                <a:gd name="connsiteX160" fmla="*/ 4441048 w 8363529"/>
                <a:gd name="connsiteY160" fmla="*/ 897595 h 1600305"/>
                <a:gd name="connsiteX161" fmla="*/ 4507932 w 8363529"/>
                <a:gd name="connsiteY161" fmla="*/ 662943 h 1600305"/>
                <a:gd name="connsiteX162" fmla="*/ 4516324 w 8363529"/>
                <a:gd name="connsiteY162" fmla="*/ 631944 h 1600305"/>
                <a:gd name="connsiteX163" fmla="*/ 4524687 w 8363529"/>
                <a:gd name="connsiteY163" fmla="*/ 661540 h 1600305"/>
                <a:gd name="connsiteX164" fmla="*/ 4591572 w 8363529"/>
                <a:gd name="connsiteY164" fmla="*/ 925574 h 1600305"/>
                <a:gd name="connsiteX165" fmla="*/ 4599964 w 8363529"/>
                <a:gd name="connsiteY165" fmla="*/ 962390 h 1600305"/>
                <a:gd name="connsiteX166" fmla="*/ 4608317 w 8363529"/>
                <a:gd name="connsiteY166" fmla="*/ 918809 h 1600305"/>
                <a:gd name="connsiteX167" fmla="*/ 4675201 w 8363529"/>
                <a:gd name="connsiteY167" fmla="*/ 577621 h 1600305"/>
                <a:gd name="connsiteX168" fmla="*/ 4683603 w 8363529"/>
                <a:gd name="connsiteY168" fmla="*/ 535880 h 1600305"/>
                <a:gd name="connsiteX169" fmla="*/ 4691956 w 8363529"/>
                <a:gd name="connsiteY169" fmla="*/ 521973 h 1600305"/>
                <a:gd name="connsiteX170" fmla="*/ 4758840 w 8363529"/>
                <a:gd name="connsiteY170" fmla="*/ 422619 h 1600305"/>
                <a:gd name="connsiteX171" fmla="*/ 4767232 w 8363529"/>
                <a:gd name="connsiteY171" fmla="*/ 411508 h 1600305"/>
                <a:gd name="connsiteX172" fmla="*/ 4775595 w 8363529"/>
                <a:gd name="connsiteY172" fmla="*/ 431203 h 1600305"/>
                <a:gd name="connsiteX173" fmla="*/ 4842480 w 8363529"/>
                <a:gd name="connsiteY173" fmla="*/ 637161 h 1600305"/>
                <a:gd name="connsiteX174" fmla="*/ 4850872 w 8363529"/>
                <a:gd name="connsiteY174" fmla="*/ 671150 h 1600305"/>
                <a:gd name="connsiteX175" fmla="*/ 4859225 w 8363529"/>
                <a:gd name="connsiteY175" fmla="*/ 735944 h 1600305"/>
                <a:gd name="connsiteX176" fmla="*/ 4926109 w 8363529"/>
                <a:gd name="connsiteY176" fmla="*/ 1074858 h 1600305"/>
                <a:gd name="connsiteX177" fmla="*/ 4934501 w 8363529"/>
                <a:gd name="connsiteY177" fmla="*/ 1103069 h 1600305"/>
                <a:gd name="connsiteX178" fmla="*/ 4942864 w 8363529"/>
                <a:gd name="connsiteY178" fmla="*/ 1091649 h 1600305"/>
                <a:gd name="connsiteX179" fmla="*/ 5009749 w 8363529"/>
                <a:gd name="connsiteY179" fmla="*/ 988588 h 1600305"/>
                <a:gd name="connsiteX180" fmla="*/ 5018141 w 8363529"/>
                <a:gd name="connsiteY180" fmla="*/ 974042 h 1600305"/>
                <a:gd name="connsiteX181" fmla="*/ 5026494 w 8363529"/>
                <a:gd name="connsiteY181" fmla="*/ 964809 h 1600305"/>
                <a:gd name="connsiteX182" fmla="*/ 5093388 w 8363529"/>
                <a:gd name="connsiteY182" fmla="*/ 877262 h 1600305"/>
                <a:gd name="connsiteX183" fmla="*/ 5101780 w 8363529"/>
                <a:gd name="connsiteY183" fmla="*/ 864216 h 1600305"/>
                <a:gd name="connsiteX184" fmla="*/ 5110134 w 8363529"/>
                <a:gd name="connsiteY184" fmla="*/ 840437 h 1600305"/>
                <a:gd name="connsiteX185" fmla="*/ 5177018 w 8363529"/>
                <a:gd name="connsiteY185" fmla="*/ 703165 h 1600305"/>
                <a:gd name="connsiteX186" fmla="*/ 5185410 w 8363529"/>
                <a:gd name="connsiteY186" fmla="*/ 690612 h 1600305"/>
                <a:gd name="connsiteX187" fmla="*/ 5193773 w 8363529"/>
                <a:gd name="connsiteY187" fmla="*/ 731366 h 1600305"/>
                <a:gd name="connsiteX188" fmla="*/ 5260657 w 8363529"/>
                <a:gd name="connsiteY188" fmla="*/ 1085523 h 1600305"/>
                <a:gd name="connsiteX189" fmla="*/ 5269049 w 8363529"/>
                <a:gd name="connsiteY189" fmla="*/ 1133613 h 1600305"/>
                <a:gd name="connsiteX190" fmla="*/ 5277403 w 8363529"/>
                <a:gd name="connsiteY190" fmla="*/ 1112776 h 1600305"/>
                <a:gd name="connsiteX191" fmla="*/ 5344287 w 8363529"/>
                <a:gd name="connsiteY191" fmla="*/ 919748 h 1600305"/>
                <a:gd name="connsiteX192" fmla="*/ 5352650 w 8363529"/>
                <a:gd name="connsiteY192" fmla="*/ 891779 h 1600305"/>
                <a:gd name="connsiteX193" fmla="*/ 5361042 w 8363529"/>
                <a:gd name="connsiteY193" fmla="*/ 901718 h 1600305"/>
                <a:gd name="connsiteX194" fmla="*/ 5427926 w 8363529"/>
                <a:gd name="connsiteY194" fmla="*/ 1098336 h 1600305"/>
                <a:gd name="connsiteX195" fmla="*/ 5436280 w 8363529"/>
                <a:gd name="connsiteY195" fmla="*/ 1166082 h 1600305"/>
                <a:gd name="connsiteX196" fmla="*/ 5444672 w 8363529"/>
                <a:gd name="connsiteY196" fmla="*/ 1247252 h 1600305"/>
                <a:gd name="connsiteX197" fmla="*/ 5511566 w 8363529"/>
                <a:gd name="connsiteY197" fmla="*/ 1514906 h 1600305"/>
                <a:gd name="connsiteX198" fmla="*/ 5519919 w 8363529"/>
                <a:gd name="connsiteY198" fmla="*/ 1529917 h 1600305"/>
                <a:gd name="connsiteX199" fmla="*/ 5528311 w 8363529"/>
                <a:gd name="connsiteY199" fmla="*/ 1438431 h 1600305"/>
                <a:gd name="connsiteX200" fmla="*/ 5595195 w 8363529"/>
                <a:gd name="connsiteY200" fmla="*/ 931768 h 1600305"/>
                <a:gd name="connsiteX201" fmla="*/ 5603558 w 8363529"/>
                <a:gd name="connsiteY201" fmla="*/ 887279 h 1600305"/>
                <a:gd name="connsiteX202" fmla="*/ 5611950 w 8363529"/>
                <a:gd name="connsiteY202" fmla="*/ 816804 h 1600305"/>
                <a:gd name="connsiteX203" fmla="*/ 5678835 w 8363529"/>
                <a:gd name="connsiteY203" fmla="*/ 255519 h 1600305"/>
                <a:gd name="connsiteX204" fmla="*/ 5687188 w 8363529"/>
                <a:gd name="connsiteY204" fmla="*/ 185701 h 1600305"/>
                <a:gd name="connsiteX205" fmla="*/ 5695580 w 8363529"/>
                <a:gd name="connsiteY205" fmla="*/ 254541 h 1600305"/>
                <a:gd name="connsiteX206" fmla="*/ 5762474 w 8363529"/>
                <a:gd name="connsiteY206" fmla="*/ 1036339 h 1600305"/>
                <a:gd name="connsiteX207" fmla="*/ 5770827 w 8363529"/>
                <a:gd name="connsiteY207" fmla="*/ 1177009 h 1600305"/>
                <a:gd name="connsiteX208" fmla="*/ 5779219 w 8363529"/>
                <a:gd name="connsiteY208" fmla="*/ 1161476 h 1600305"/>
                <a:gd name="connsiteX209" fmla="*/ 5846103 w 8363529"/>
                <a:gd name="connsiteY209" fmla="*/ 1070744 h 1600305"/>
                <a:gd name="connsiteX210" fmla="*/ 5854457 w 8363529"/>
                <a:gd name="connsiteY210" fmla="*/ 1062383 h 1600305"/>
                <a:gd name="connsiteX211" fmla="*/ 5862858 w 8363529"/>
                <a:gd name="connsiteY211" fmla="*/ 1087681 h 1600305"/>
                <a:gd name="connsiteX212" fmla="*/ 5929743 w 8363529"/>
                <a:gd name="connsiteY212" fmla="*/ 1417633 h 1600305"/>
                <a:gd name="connsiteX213" fmla="*/ 5938096 w 8363529"/>
                <a:gd name="connsiteY213" fmla="*/ 1486821 h 1600305"/>
                <a:gd name="connsiteX214" fmla="*/ 5946488 w 8363529"/>
                <a:gd name="connsiteY214" fmla="*/ 1398248 h 1600305"/>
                <a:gd name="connsiteX215" fmla="*/ 6013372 w 8363529"/>
                <a:gd name="connsiteY215" fmla="*/ 951395 h 1600305"/>
                <a:gd name="connsiteX216" fmla="*/ 6021735 w 8363529"/>
                <a:gd name="connsiteY216" fmla="*/ 915364 h 1600305"/>
                <a:gd name="connsiteX217" fmla="*/ 6030127 w 8363529"/>
                <a:gd name="connsiteY217" fmla="*/ 928255 h 1600305"/>
                <a:gd name="connsiteX218" fmla="*/ 6097011 w 8363529"/>
                <a:gd name="connsiteY218" fmla="*/ 1045185 h 1600305"/>
                <a:gd name="connsiteX219" fmla="*/ 6105365 w 8363529"/>
                <a:gd name="connsiteY219" fmla="*/ 1061783 h 1600305"/>
                <a:gd name="connsiteX220" fmla="*/ 6113767 w 8363529"/>
                <a:gd name="connsiteY220" fmla="*/ 1043336 h 1600305"/>
                <a:gd name="connsiteX221" fmla="*/ 6180651 w 8363529"/>
                <a:gd name="connsiteY221" fmla="*/ 916080 h 1600305"/>
                <a:gd name="connsiteX222" fmla="*/ 6189004 w 8363529"/>
                <a:gd name="connsiteY222" fmla="*/ 902318 h 1600305"/>
                <a:gd name="connsiteX223" fmla="*/ 6197396 w 8363529"/>
                <a:gd name="connsiteY223" fmla="*/ 930036 h 1600305"/>
                <a:gd name="connsiteX224" fmla="*/ 6264280 w 8363529"/>
                <a:gd name="connsiteY224" fmla="*/ 1212740 h 1600305"/>
                <a:gd name="connsiteX225" fmla="*/ 6272644 w 8363529"/>
                <a:gd name="connsiteY225" fmla="*/ 1258101 h 1600305"/>
                <a:gd name="connsiteX226" fmla="*/ 6281036 w 8363529"/>
                <a:gd name="connsiteY226" fmla="*/ 1164766 h 1600305"/>
                <a:gd name="connsiteX227" fmla="*/ 6347920 w 8363529"/>
                <a:gd name="connsiteY227" fmla="*/ 531003 h 1600305"/>
                <a:gd name="connsiteX228" fmla="*/ 6356273 w 8363529"/>
                <a:gd name="connsiteY228" fmla="*/ 463527 h 1600305"/>
                <a:gd name="connsiteX229" fmla="*/ 6364665 w 8363529"/>
                <a:gd name="connsiteY229" fmla="*/ 531874 h 1600305"/>
                <a:gd name="connsiteX230" fmla="*/ 6431560 w 8363529"/>
                <a:gd name="connsiteY230" fmla="*/ 1031994 h 1600305"/>
                <a:gd name="connsiteX231" fmla="*/ 6439913 w 8363529"/>
                <a:gd name="connsiteY231" fmla="*/ 1089229 h 1600305"/>
                <a:gd name="connsiteX232" fmla="*/ 6448305 w 8363529"/>
                <a:gd name="connsiteY232" fmla="*/ 1099053 h 1600305"/>
                <a:gd name="connsiteX233" fmla="*/ 6515189 w 8363529"/>
                <a:gd name="connsiteY233" fmla="*/ 1187180 h 1600305"/>
                <a:gd name="connsiteX234" fmla="*/ 6523542 w 8363529"/>
                <a:gd name="connsiteY234" fmla="*/ 1199578 h 1600305"/>
                <a:gd name="connsiteX235" fmla="*/ 6531944 w 8363529"/>
                <a:gd name="connsiteY235" fmla="*/ 1184538 h 1600305"/>
                <a:gd name="connsiteX236" fmla="*/ 6598829 w 8363529"/>
                <a:gd name="connsiteY236" fmla="*/ 1049985 h 1600305"/>
                <a:gd name="connsiteX237" fmla="*/ 6607182 w 8363529"/>
                <a:gd name="connsiteY237" fmla="*/ 1031161 h 1600305"/>
                <a:gd name="connsiteX238" fmla="*/ 6615535 w 8363529"/>
                <a:gd name="connsiteY238" fmla="*/ 1061250 h 1600305"/>
                <a:gd name="connsiteX239" fmla="*/ 6682458 w 8363529"/>
                <a:gd name="connsiteY239" fmla="*/ 1229028 h 1600305"/>
                <a:gd name="connsiteX240" fmla="*/ 6690821 w 8363529"/>
                <a:gd name="connsiteY240" fmla="*/ 1243884 h 1600305"/>
                <a:gd name="connsiteX241" fmla="*/ 6699174 w 8363529"/>
                <a:gd name="connsiteY241" fmla="*/ 1209527 h 1600305"/>
                <a:gd name="connsiteX242" fmla="*/ 6766097 w 8363529"/>
                <a:gd name="connsiteY242" fmla="*/ 865503 h 1600305"/>
                <a:gd name="connsiteX243" fmla="*/ 6774451 w 8363529"/>
                <a:gd name="connsiteY243" fmla="*/ 811326 h 1600305"/>
                <a:gd name="connsiteX244" fmla="*/ 6782814 w 8363529"/>
                <a:gd name="connsiteY244" fmla="*/ 825049 h 1600305"/>
                <a:gd name="connsiteX245" fmla="*/ 6849737 w 8363529"/>
                <a:gd name="connsiteY245" fmla="*/ 952605 h 1600305"/>
                <a:gd name="connsiteX246" fmla="*/ 6858090 w 8363529"/>
                <a:gd name="connsiteY246" fmla="*/ 971167 h 1600305"/>
                <a:gd name="connsiteX247" fmla="*/ 6866443 w 8363529"/>
                <a:gd name="connsiteY247" fmla="*/ 937140 h 1600305"/>
                <a:gd name="connsiteX248" fmla="*/ 6933366 w 8363529"/>
                <a:gd name="connsiteY248" fmla="*/ 753674 h 1600305"/>
                <a:gd name="connsiteX249" fmla="*/ 6941729 w 8363529"/>
                <a:gd name="connsiteY249" fmla="*/ 737986 h 1600305"/>
                <a:gd name="connsiteX250" fmla="*/ 6950083 w 8363529"/>
                <a:gd name="connsiteY250" fmla="*/ 803012 h 1600305"/>
                <a:gd name="connsiteX251" fmla="*/ 7017006 w 8363529"/>
                <a:gd name="connsiteY251" fmla="*/ 1436728 h 1600305"/>
                <a:gd name="connsiteX252" fmla="*/ 7025359 w 8363529"/>
                <a:gd name="connsiteY252" fmla="*/ 1533585 h 1600305"/>
                <a:gd name="connsiteX253" fmla="*/ 7033712 w 8363529"/>
                <a:gd name="connsiteY253" fmla="*/ 1429430 h 1600305"/>
                <a:gd name="connsiteX254" fmla="*/ 7100645 w 8363529"/>
                <a:gd name="connsiteY254" fmla="*/ 538493 h 1600305"/>
                <a:gd name="connsiteX255" fmla="*/ 7108998 w 8363529"/>
                <a:gd name="connsiteY255" fmla="*/ 419367 h 1600305"/>
                <a:gd name="connsiteX256" fmla="*/ 7117351 w 8363529"/>
                <a:gd name="connsiteY256" fmla="*/ 442391 h 1600305"/>
                <a:gd name="connsiteX257" fmla="*/ 7184274 w 8363529"/>
                <a:gd name="connsiteY257" fmla="*/ 633686 h 1600305"/>
                <a:gd name="connsiteX258" fmla="*/ 7192628 w 8363529"/>
                <a:gd name="connsiteY258" fmla="*/ 658597 h 1600305"/>
                <a:gd name="connsiteX259" fmla="*/ 7200991 w 8363529"/>
                <a:gd name="connsiteY259" fmla="*/ 639125 h 1600305"/>
                <a:gd name="connsiteX260" fmla="*/ 7267914 w 8363529"/>
                <a:gd name="connsiteY260" fmla="*/ 495320 h 1600305"/>
                <a:gd name="connsiteX261" fmla="*/ 7276267 w 8363529"/>
                <a:gd name="connsiteY261" fmla="*/ 478683 h 1600305"/>
                <a:gd name="connsiteX262" fmla="*/ 7284620 w 8363529"/>
                <a:gd name="connsiteY262" fmla="*/ 509943 h 1600305"/>
                <a:gd name="connsiteX263" fmla="*/ 7351543 w 8363529"/>
                <a:gd name="connsiteY263" fmla="*/ 774356 h 1600305"/>
                <a:gd name="connsiteX264" fmla="*/ 7359906 w 8363529"/>
                <a:gd name="connsiteY264" fmla="*/ 809284 h 1600305"/>
                <a:gd name="connsiteX265" fmla="*/ 7368260 w 8363529"/>
                <a:gd name="connsiteY265" fmla="*/ 774617 h 1600305"/>
                <a:gd name="connsiteX266" fmla="*/ 7435183 w 8363529"/>
                <a:gd name="connsiteY266" fmla="*/ 542984 h 1600305"/>
                <a:gd name="connsiteX267" fmla="*/ 7443536 w 8363529"/>
                <a:gd name="connsiteY267" fmla="*/ 518760 h 1600305"/>
                <a:gd name="connsiteX268" fmla="*/ 7451899 w 8363529"/>
                <a:gd name="connsiteY268" fmla="*/ 538000 h 1600305"/>
                <a:gd name="connsiteX269" fmla="*/ 7518822 w 8363529"/>
                <a:gd name="connsiteY269" fmla="*/ 722937 h 1600305"/>
                <a:gd name="connsiteX270" fmla="*/ 7527175 w 8363529"/>
                <a:gd name="connsiteY270" fmla="*/ 750877 h 1600305"/>
                <a:gd name="connsiteX271" fmla="*/ 7535528 w 8363529"/>
                <a:gd name="connsiteY271" fmla="*/ 661578 h 1600305"/>
                <a:gd name="connsiteX272" fmla="*/ 7602452 w 8363529"/>
                <a:gd name="connsiteY272" fmla="*/ 62907 h 1600305"/>
                <a:gd name="connsiteX273" fmla="*/ 7610815 w 8363529"/>
                <a:gd name="connsiteY273" fmla="*/ 0 h 1600305"/>
                <a:gd name="connsiteX274" fmla="*/ 7619168 w 8363529"/>
                <a:gd name="connsiteY274" fmla="*/ 90015 h 1600305"/>
                <a:gd name="connsiteX275" fmla="*/ 7686091 w 8363529"/>
                <a:gd name="connsiteY275" fmla="*/ 871358 h 1600305"/>
                <a:gd name="connsiteX276" fmla="*/ 7694444 w 8363529"/>
                <a:gd name="connsiteY276" fmla="*/ 977400 h 1600305"/>
                <a:gd name="connsiteX277" fmla="*/ 7702798 w 8363529"/>
                <a:gd name="connsiteY277" fmla="*/ 912345 h 1600305"/>
                <a:gd name="connsiteX278" fmla="*/ 7769731 w 8363529"/>
                <a:gd name="connsiteY278" fmla="*/ 270829 h 1600305"/>
                <a:gd name="connsiteX279" fmla="*/ 7778084 w 8363529"/>
                <a:gd name="connsiteY279" fmla="*/ 171523 h 1600305"/>
                <a:gd name="connsiteX280" fmla="*/ 7786437 w 8363529"/>
                <a:gd name="connsiteY280" fmla="*/ 306260 h 1600305"/>
                <a:gd name="connsiteX281" fmla="*/ 7853360 w 8363529"/>
                <a:gd name="connsiteY281" fmla="*/ 964780 h 1600305"/>
                <a:gd name="connsiteX282" fmla="*/ 7861713 w 8363529"/>
                <a:gd name="connsiteY282" fmla="*/ 1016383 h 1600305"/>
                <a:gd name="connsiteX283" fmla="*/ 7870077 w 8363529"/>
                <a:gd name="connsiteY283" fmla="*/ 1007189 h 1600305"/>
                <a:gd name="connsiteX284" fmla="*/ 7937000 w 8363529"/>
                <a:gd name="connsiteY284" fmla="*/ 904292 h 1600305"/>
                <a:gd name="connsiteX285" fmla="*/ 7945353 w 8363529"/>
                <a:gd name="connsiteY285" fmla="*/ 886030 h 1600305"/>
                <a:gd name="connsiteX286" fmla="*/ 7953706 w 8363529"/>
                <a:gd name="connsiteY286" fmla="*/ 908222 h 1600305"/>
                <a:gd name="connsiteX287" fmla="*/ 8020629 w 8363529"/>
                <a:gd name="connsiteY287" fmla="*/ 1077587 h 1600305"/>
                <a:gd name="connsiteX288" fmla="*/ 8028992 w 8363529"/>
                <a:gd name="connsiteY288" fmla="*/ 1097775 h 1600305"/>
                <a:gd name="connsiteX289" fmla="*/ 8037346 w 8363529"/>
                <a:gd name="connsiteY289" fmla="*/ 1091387 h 1600305"/>
                <a:gd name="connsiteX290" fmla="*/ 8104268 w 8363529"/>
                <a:gd name="connsiteY290" fmla="*/ 1032865 h 1600305"/>
                <a:gd name="connsiteX291" fmla="*/ 8112622 w 8363529"/>
                <a:gd name="connsiteY291" fmla="*/ 1024464 h 1600305"/>
                <a:gd name="connsiteX292" fmla="*/ 8120985 w 8363529"/>
                <a:gd name="connsiteY292" fmla="*/ 1046733 h 1600305"/>
                <a:gd name="connsiteX293" fmla="*/ 8187908 w 8363529"/>
                <a:gd name="connsiteY293" fmla="*/ 1164573 h 1600305"/>
                <a:gd name="connsiteX294" fmla="*/ 8196261 w 8363529"/>
                <a:gd name="connsiteY294" fmla="*/ 1174473 h 1600305"/>
                <a:gd name="connsiteX295" fmla="*/ 8204614 w 8363529"/>
                <a:gd name="connsiteY295" fmla="*/ 1099856 h 1600305"/>
                <a:gd name="connsiteX296" fmla="*/ 8271537 w 8363529"/>
                <a:gd name="connsiteY296" fmla="*/ 322055 h 1600305"/>
                <a:gd name="connsiteX297" fmla="*/ 8279900 w 8363529"/>
                <a:gd name="connsiteY297" fmla="*/ 194431 h 1600305"/>
                <a:gd name="connsiteX298" fmla="*/ 8288254 w 8363529"/>
                <a:gd name="connsiteY298" fmla="*/ 262438 h 1600305"/>
                <a:gd name="connsiteX299" fmla="*/ 8355177 w 8363529"/>
                <a:gd name="connsiteY299" fmla="*/ 812081 h 1600305"/>
                <a:gd name="connsiteX300" fmla="*/ 8363530 w 8363529"/>
                <a:gd name="connsiteY300" fmla="*/ 881491 h 1600305"/>
                <a:gd name="connsiteX301" fmla="*/ 8363530 w 8363529"/>
                <a:gd name="connsiteY301" fmla="*/ 1240564 h 1600305"/>
                <a:gd name="connsiteX302" fmla="*/ 8355177 w 8363529"/>
                <a:gd name="connsiteY302" fmla="*/ 1156298 h 1600305"/>
                <a:gd name="connsiteX303" fmla="*/ 8288254 w 8363529"/>
                <a:gd name="connsiteY303" fmla="*/ 488894 h 1600305"/>
                <a:gd name="connsiteX304" fmla="*/ 8279900 w 8363529"/>
                <a:gd name="connsiteY304" fmla="*/ 406321 h 1600305"/>
                <a:gd name="connsiteX305" fmla="*/ 8271537 w 8363529"/>
                <a:gd name="connsiteY305" fmla="*/ 532629 h 1600305"/>
                <a:gd name="connsiteX306" fmla="*/ 8204614 w 8363529"/>
                <a:gd name="connsiteY306" fmla="*/ 1302445 h 1600305"/>
                <a:gd name="connsiteX307" fmla="*/ 8196261 w 8363529"/>
                <a:gd name="connsiteY307" fmla="*/ 1376317 h 1600305"/>
                <a:gd name="connsiteX308" fmla="*/ 8187908 w 8363529"/>
                <a:gd name="connsiteY308" fmla="*/ 1359342 h 1600305"/>
                <a:gd name="connsiteX309" fmla="*/ 8120985 w 8363529"/>
                <a:gd name="connsiteY309" fmla="*/ 1157885 h 1600305"/>
                <a:gd name="connsiteX310" fmla="*/ 8112622 w 8363529"/>
                <a:gd name="connsiteY310" fmla="*/ 1119812 h 1600305"/>
                <a:gd name="connsiteX311" fmla="*/ 8104268 w 8363529"/>
                <a:gd name="connsiteY311" fmla="*/ 1135277 h 1600305"/>
                <a:gd name="connsiteX312" fmla="*/ 8037346 w 8363529"/>
                <a:gd name="connsiteY312" fmla="*/ 1242713 h 1600305"/>
                <a:gd name="connsiteX313" fmla="*/ 8028992 w 8363529"/>
                <a:gd name="connsiteY313" fmla="*/ 1254433 h 1600305"/>
                <a:gd name="connsiteX314" fmla="*/ 8020629 w 8363529"/>
                <a:gd name="connsiteY314" fmla="*/ 1235232 h 1600305"/>
                <a:gd name="connsiteX315" fmla="*/ 7953706 w 8363529"/>
                <a:gd name="connsiteY315" fmla="*/ 1073957 h 1600305"/>
                <a:gd name="connsiteX316" fmla="*/ 7945353 w 8363529"/>
                <a:gd name="connsiteY316" fmla="*/ 1052821 h 1600305"/>
                <a:gd name="connsiteX317" fmla="*/ 7937000 w 8363529"/>
                <a:gd name="connsiteY317" fmla="*/ 1074258 h 1600305"/>
                <a:gd name="connsiteX318" fmla="*/ 7870077 w 8363529"/>
                <a:gd name="connsiteY318" fmla="*/ 1195078 h 1600305"/>
                <a:gd name="connsiteX319" fmla="*/ 7861713 w 8363529"/>
                <a:gd name="connsiteY319" fmla="*/ 1205859 h 1600305"/>
                <a:gd name="connsiteX320" fmla="*/ 7853360 w 8363529"/>
                <a:gd name="connsiteY320" fmla="*/ 1169334 h 1600305"/>
                <a:gd name="connsiteX321" fmla="*/ 7786437 w 8363529"/>
                <a:gd name="connsiteY321" fmla="*/ 703397 h 1600305"/>
                <a:gd name="connsiteX322" fmla="*/ 7778084 w 8363529"/>
                <a:gd name="connsiteY322" fmla="*/ 608049 h 1600305"/>
                <a:gd name="connsiteX323" fmla="*/ 7769731 w 8363529"/>
                <a:gd name="connsiteY323" fmla="*/ 678031 h 1600305"/>
                <a:gd name="connsiteX324" fmla="*/ 7702798 w 8363529"/>
                <a:gd name="connsiteY324" fmla="*/ 1130022 h 1600305"/>
                <a:gd name="connsiteX325" fmla="*/ 7694444 w 8363529"/>
                <a:gd name="connsiteY325" fmla="*/ 1175876 h 1600305"/>
                <a:gd name="connsiteX326" fmla="*/ 7686091 w 8363529"/>
                <a:gd name="connsiteY326" fmla="*/ 1084429 h 1600305"/>
                <a:gd name="connsiteX327" fmla="*/ 7619168 w 8363529"/>
                <a:gd name="connsiteY327" fmla="*/ 410860 h 1600305"/>
                <a:gd name="connsiteX328" fmla="*/ 7610815 w 8363529"/>
                <a:gd name="connsiteY328" fmla="*/ 333252 h 1600305"/>
                <a:gd name="connsiteX329" fmla="*/ 7602452 w 8363529"/>
                <a:gd name="connsiteY329" fmla="*/ 398385 h 1600305"/>
                <a:gd name="connsiteX330" fmla="*/ 7535528 w 8363529"/>
                <a:gd name="connsiteY330" fmla="*/ 1018038 h 1600305"/>
                <a:gd name="connsiteX331" fmla="*/ 7527175 w 8363529"/>
                <a:gd name="connsiteY331" fmla="*/ 1110434 h 1600305"/>
                <a:gd name="connsiteX332" fmla="*/ 7518822 w 8363529"/>
                <a:gd name="connsiteY332" fmla="*/ 1056450 h 1600305"/>
                <a:gd name="connsiteX333" fmla="*/ 7451899 w 8363529"/>
                <a:gd name="connsiteY333" fmla="*/ 698742 h 1600305"/>
                <a:gd name="connsiteX334" fmla="*/ 7443536 w 8363529"/>
                <a:gd name="connsiteY334" fmla="*/ 661578 h 1600305"/>
                <a:gd name="connsiteX335" fmla="*/ 7435183 w 8363529"/>
                <a:gd name="connsiteY335" fmla="*/ 685512 h 1600305"/>
                <a:gd name="connsiteX336" fmla="*/ 7368260 w 8363529"/>
                <a:gd name="connsiteY336" fmla="*/ 914116 h 1600305"/>
                <a:gd name="connsiteX337" fmla="*/ 7359906 w 8363529"/>
                <a:gd name="connsiteY337" fmla="*/ 948366 h 1600305"/>
                <a:gd name="connsiteX338" fmla="*/ 7351543 w 8363529"/>
                <a:gd name="connsiteY338" fmla="*/ 977323 h 1600305"/>
                <a:gd name="connsiteX339" fmla="*/ 7284620 w 8363529"/>
                <a:gd name="connsiteY339" fmla="*/ 1196220 h 1600305"/>
                <a:gd name="connsiteX340" fmla="*/ 7276267 w 8363529"/>
                <a:gd name="connsiteY340" fmla="*/ 1222070 h 1600305"/>
                <a:gd name="connsiteX341" fmla="*/ 7267914 w 8363529"/>
                <a:gd name="connsiteY341" fmla="*/ 1169983 h 1600305"/>
                <a:gd name="connsiteX342" fmla="*/ 7200991 w 8363529"/>
                <a:gd name="connsiteY342" fmla="*/ 719501 h 1600305"/>
                <a:gd name="connsiteX343" fmla="*/ 7192628 w 8363529"/>
                <a:gd name="connsiteY343" fmla="*/ 658597 h 1600305"/>
                <a:gd name="connsiteX344" fmla="*/ 7184274 w 8363529"/>
                <a:gd name="connsiteY344" fmla="*/ 661123 h 1600305"/>
                <a:gd name="connsiteX345" fmla="*/ 7117351 w 8363529"/>
                <a:gd name="connsiteY345" fmla="*/ 680789 h 1600305"/>
                <a:gd name="connsiteX346" fmla="*/ 7108998 w 8363529"/>
                <a:gd name="connsiteY346" fmla="*/ 683170 h 1600305"/>
                <a:gd name="connsiteX347" fmla="*/ 7100645 w 8363529"/>
                <a:gd name="connsiteY347" fmla="*/ 781198 h 1600305"/>
                <a:gd name="connsiteX348" fmla="*/ 7033712 w 8363529"/>
                <a:gd name="connsiteY348" fmla="*/ 1514568 h 1600305"/>
                <a:gd name="connsiteX349" fmla="*/ 7025359 w 8363529"/>
                <a:gd name="connsiteY349" fmla="*/ 1600305 h 1600305"/>
                <a:gd name="connsiteX350" fmla="*/ 7017006 w 8363529"/>
                <a:gd name="connsiteY350" fmla="*/ 1502286 h 1600305"/>
                <a:gd name="connsiteX351" fmla="*/ 6950083 w 8363529"/>
                <a:gd name="connsiteY351" fmla="*/ 861003 h 1600305"/>
                <a:gd name="connsiteX352" fmla="*/ 6941729 w 8363529"/>
                <a:gd name="connsiteY352" fmla="*/ 795183 h 1600305"/>
                <a:gd name="connsiteX353" fmla="*/ 6933366 w 8363529"/>
                <a:gd name="connsiteY353" fmla="*/ 828978 h 1600305"/>
                <a:gd name="connsiteX354" fmla="*/ 6866443 w 8363529"/>
                <a:gd name="connsiteY354" fmla="*/ 1223928 h 1600305"/>
                <a:gd name="connsiteX355" fmla="*/ 6858090 w 8363529"/>
                <a:gd name="connsiteY355" fmla="*/ 1297229 h 1600305"/>
                <a:gd name="connsiteX356" fmla="*/ 6849737 w 8363529"/>
                <a:gd name="connsiteY356" fmla="*/ 1283167 h 1600305"/>
                <a:gd name="connsiteX357" fmla="*/ 6782814 w 8363529"/>
                <a:gd name="connsiteY357" fmla="*/ 1186609 h 1600305"/>
                <a:gd name="connsiteX358" fmla="*/ 6774451 w 8363529"/>
                <a:gd name="connsiteY358" fmla="*/ 1176254 h 1600305"/>
                <a:gd name="connsiteX359" fmla="*/ 6766097 w 8363529"/>
                <a:gd name="connsiteY359" fmla="*/ 1203923 h 1600305"/>
                <a:gd name="connsiteX360" fmla="*/ 6699174 w 8363529"/>
                <a:gd name="connsiteY360" fmla="*/ 1379569 h 1600305"/>
                <a:gd name="connsiteX361" fmla="*/ 6690821 w 8363529"/>
                <a:gd name="connsiteY361" fmla="*/ 1397106 h 1600305"/>
                <a:gd name="connsiteX362" fmla="*/ 6682458 w 8363529"/>
                <a:gd name="connsiteY362" fmla="*/ 1379753 h 1600305"/>
                <a:gd name="connsiteX363" fmla="*/ 6615535 w 8363529"/>
                <a:gd name="connsiteY363" fmla="*/ 1183328 h 1600305"/>
                <a:gd name="connsiteX364" fmla="*/ 6607182 w 8363529"/>
                <a:gd name="connsiteY364" fmla="*/ 1148130 h 1600305"/>
                <a:gd name="connsiteX365" fmla="*/ 6598829 w 8363529"/>
                <a:gd name="connsiteY365" fmla="*/ 1183629 h 1600305"/>
                <a:gd name="connsiteX366" fmla="*/ 6531944 w 8363529"/>
                <a:gd name="connsiteY366" fmla="*/ 1437444 h 1600305"/>
                <a:gd name="connsiteX367" fmla="*/ 6523542 w 8363529"/>
                <a:gd name="connsiteY367" fmla="*/ 1465839 h 1600305"/>
                <a:gd name="connsiteX368" fmla="*/ 6515189 w 8363529"/>
                <a:gd name="connsiteY368" fmla="*/ 1455629 h 1600305"/>
                <a:gd name="connsiteX369" fmla="*/ 6448305 w 8363529"/>
                <a:gd name="connsiteY369" fmla="*/ 1383160 h 1600305"/>
                <a:gd name="connsiteX370" fmla="*/ 6439913 w 8363529"/>
                <a:gd name="connsiteY370" fmla="*/ 1375069 h 1600305"/>
                <a:gd name="connsiteX371" fmla="*/ 6431560 w 8363529"/>
                <a:gd name="connsiteY371" fmla="*/ 1308078 h 1600305"/>
                <a:gd name="connsiteX372" fmla="*/ 6364665 w 8363529"/>
                <a:gd name="connsiteY372" fmla="*/ 722598 h 1600305"/>
                <a:gd name="connsiteX373" fmla="*/ 6356273 w 8363529"/>
                <a:gd name="connsiteY373" fmla="*/ 642638 h 1600305"/>
                <a:gd name="connsiteX374" fmla="*/ 6347920 w 8363529"/>
                <a:gd name="connsiteY374" fmla="*/ 706532 h 1600305"/>
                <a:gd name="connsiteX375" fmla="*/ 6281036 w 8363529"/>
                <a:gd name="connsiteY375" fmla="*/ 1306868 h 1600305"/>
                <a:gd name="connsiteX376" fmla="*/ 6272644 w 8363529"/>
                <a:gd name="connsiteY376" fmla="*/ 1395257 h 1600305"/>
                <a:gd name="connsiteX377" fmla="*/ 6264280 w 8363529"/>
                <a:gd name="connsiteY377" fmla="*/ 1346112 h 1600305"/>
                <a:gd name="connsiteX378" fmla="*/ 6197396 w 8363529"/>
                <a:gd name="connsiteY378" fmla="*/ 1039591 h 1600305"/>
                <a:gd name="connsiteX379" fmla="*/ 6189004 w 8363529"/>
                <a:gd name="connsiteY379" fmla="*/ 1009531 h 1600305"/>
                <a:gd name="connsiteX380" fmla="*/ 6180651 w 8363529"/>
                <a:gd name="connsiteY380" fmla="*/ 1018154 h 1600305"/>
                <a:gd name="connsiteX381" fmla="*/ 6113767 w 8363529"/>
                <a:gd name="connsiteY381" fmla="*/ 1097882 h 1600305"/>
                <a:gd name="connsiteX382" fmla="*/ 6105365 w 8363529"/>
                <a:gd name="connsiteY382" fmla="*/ 1109456 h 1600305"/>
                <a:gd name="connsiteX383" fmla="*/ 6097011 w 8363529"/>
                <a:gd name="connsiteY383" fmla="*/ 1135384 h 1600305"/>
                <a:gd name="connsiteX384" fmla="*/ 6030127 w 8363529"/>
                <a:gd name="connsiteY384" fmla="*/ 1318172 h 1600305"/>
                <a:gd name="connsiteX385" fmla="*/ 6021735 w 8363529"/>
                <a:gd name="connsiteY385" fmla="*/ 1338322 h 1600305"/>
                <a:gd name="connsiteX386" fmla="*/ 6013372 w 8363529"/>
                <a:gd name="connsiteY386" fmla="*/ 1348909 h 1600305"/>
                <a:gd name="connsiteX387" fmla="*/ 5946488 w 8363529"/>
                <a:gd name="connsiteY387" fmla="*/ 1480395 h 1600305"/>
                <a:gd name="connsiteX388" fmla="*/ 5938096 w 8363529"/>
                <a:gd name="connsiteY388" fmla="*/ 1506438 h 1600305"/>
                <a:gd name="connsiteX389" fmla="*/ 5929743 w 8363529"/>
                <a:gd name="connsiteY389" fmla="*/ 1456838 h 1600305"/>
                <a:gd name="connsiteX390" fmla="*/ 5862858 w 8363529"/>
                <a:gd name="connsiteY390" fmla="*/ 1220260 h 1600305"/>
                <a:gd name="connsiteX391" fmla="*/ 5854457 w 8363529"/>
                <a:gd name="connsiteY391" fmla="*/ 1202114 h 1600305"/>
                <a:gd name="connsiteX392" fmla="*/ 5846103 w 8363529"/>
                <a:gd name="connsiteY392" fmla="*/ 1216253 h 1600305"/>
                <a:gd name="connsiteX393" fmla="*/ 5779219 w 8363529"/>
                <a:gd name="connsiteY393" fmla="*/ 1369775 h 1600305"/>
                <a:gd name="connsiteX394" fmla="*/ 5770827 w 8363529"/>
                <a:gd name="connsiteY394" fmla="*/ 1396090 h 1600305"/>
                <a:gd name="connsiteX395" fmla="*/ 5762474 w 8363529"/>
                <a:gd name="connsiteY395" fmla="*/ 1279160 h 1600305"/>
                <a:gd name="connsiteX396" fmla="*/ 5695580 w 8363529"/>
                <a:gd name="connsiteY396" fmla="*/ 629370 h 1600305"/>
                <a:gd name="connsiteX397" fmla="*/ 5687188 w 8363529"/>
                <a:gd name="connsiteY397" fmla="*/ 572134 h 1600305"/>
                <a:gd name="connsiteX398" fmla="*/ 5678835 w 8363529"/>
                <a:gd name="connsiteY398" fmla="*/ 619169 h 1600305"/>
                <a:gd name="connsiteX399" fmla="*/ 5611950 w 8363529"/>
                <a:gd name="connsiteY399" fmla="*/ 997095 h 1600305"/>
                <a:gd name="connsiteX400" fmla="*/ 5603558 w 8363529"/>
                <a:gd name="connsiteY400" fmla="*/ 1044546 h 1600305"/>
                <a:gd name="connsiteX401" fmla="*/ 5595195 w 8363529"/>
                <a:gd name="connsiteY401" fmla="*/ 1080722 h 1600305"/>
                <a:gd name="connsiteX402" fmla="*/ 5528311 w 8363529"/>
                <a:gd name="connsiteY402" fmla="*/ 1492676 h 1600305"/>
                <a:gd name="connsiteX403" fmla="*/ 5519919 w 8363529"/>
                <a:gd name="connsiteY403" fmla="*/ 1567042 h 1600305"/>
                <a:gd name="connsiteX404" fmla="*/ 5511566 w 8363529"/>
                <a:gd name="connsiteY404" fmla="*/ 1555099 h 1600305"/>
                <a:gd name="connsiteX405" fmla="*/ 5444672 w 8363529"/>
                <a:gd name="connsiteY405" fmla="*/ 1342028 h 1600305"/>
                <a:gd name="connsiteX406" fmla="*/ 5436280 w 8363529"/>
                <a:gd name="connsiteY406" fmla="*/ 1277457 h 1600305"/>
                <a:gd name="connsiteX407" fmla="*/ 5427926 w 8363529"/>
                <a:gd name="connsiteY407" fmla="*/ 1193036 h 1600305"/>
                <a:gd name="connsiteX408" fmla="*/ 5361042 w 8363529"/>
                <a:gd name="connsiteY408" fmla="*/ 948027 h 1600305"/>
                <a:gd name="connsiteX409" fmla="*/ 5352650 w 8363529"/>
                <a:gd name="connsiteY409" fmla="*/ 935630 h 1600305"/>
                <a:gd name="connsiteX410" fmla="*/ 5344287 w 8363529"/>
                <a:gd name="connsiteY410" fmla="*/ 969309 h 1600305"/>
                <a:gd name="connsiteX411" fmla="*/ 5277403 w 8363529"/>
                <a:gd name="connsiteY411" fmla="*/ 1201736 h 1600305"/>
                <a:gd name="connsiteX412" fmla="*/ 5269049 w 8363529"/>
                <a:gd name="connsiteY412" fmla="*/ 1226879 h 1600305"/>
                <a:gd name="connsiteX413" fmla="*/ 5260657 w 8363529"/>
                <a:gd name="connsiteY413" fmla="*/ 1210011 h 1600305"/>
                <a:gd name="connsiteX414" fmla="*/ 5193773 w 8363529"/>
                <a:gd name="connsiteY414" fmla="*/ 1085900 h 1600305"/>
                <a:gd name="connsiteX415" fmla="*/ 5185410 w 8363529"/>
                <a:gd name="connsiteY415" fmla="*/ 1071615 h 1600305"/>
                <a:gd name="connsiteX416" fmla="*/ 5177018 w 8363529"/>
                <a:gd name="connsiteY416" fmla="*/ 1072554 h 1600305"/>
                <a:gd name="connsiteX417" fmla="*/ 5110134 w 8363529"/>
                <a:gd name="connsiteY417" fmla="*/ 1082726 h 1600305"/>
                <a:gd name="connsiteX418" fmla="*/ 5101780 w 8363529"/>
                <a:gd name="connsiteY418" fmla="*/ 1084468 h 1600305"/>
                <a:gd name="connsiteX419" fmla="*/ 5093388 w 8363529"/>
                <a:gd name="connsiteY419" fmla="*/ 1111044 h 1600305"/>
                <a:gd name="connsiteX420" fmla="*/ 5026494 w 8363529"/>
                <a:gd name="connsiteY420" fmla="*/ 1289370 h 1600305"/>
                <a:gd name="connsiteX421" fmla="*/ 5018141 w 8363529"/>
                <a:gd name="connsiteY421" fmla="*/ 1308117 h 1600305"/>
                <a:gd name="connsiteX422" fmla="*/ 5009749 w 8363529"/>
                <a:gd name="connsiteY422" fmla="*/ 1317040 h 1600305"/>
                <a:gd name="connsiteX423" fmla="*/ 4942864 w 8363529"/>
                <a:gd name="connsiteY423" fmla="*/ 1380208 h 1600305"/>
                <a:gd name="connsiteX424" fmla="*/ 4934501 w 8363529"/>
                <a:gd name="connsiteY424" fmla="*/ 1387205 h 1600305"/>
                <a:gd name="connsiteX425" fmla="*/ 4926109 w 8363529"/>
                <a:gd name="connsiteY425" fmla="*/ 1350119 h 1600305"/>
                <a:gd name="connsiteX426" fmla="*/ 4859225 w 8363529"/>
                <a:gd name="connsiteY426" fmla="*/ 904699 h 1600305"/>
                <a:gd name="connsiteX427" fmla="*/ 4850872 w 8363529"/>
                <a:gd name="connsiteY427" fmla="*/ 819533 h 1600305"/>
                <a:gd name="connsiteX428" fmla="*/ 4842480 w 8363529"/>
                <a:gd name="connsiteY428" fmla="*/ 810339 h 1600305"/>
                <a:gd name="connsiteX429" fmla="*/ 4775595 w 8363529"/>
                <a:gd name="connsiteY429" fmla="*/ 754768 h 1600305"/>
                <a:gd name="connsiteX430" fmla="*/ 4767232 w 8363529"/>
                <a:gd name="connsiteY430" fmla="*/ 749474 h 1600305"/>
                <a:gd name="connsiteX431" fmla="*/ 4758840 w 8363529"/>
                <a:gd name="connsiteY431" fmla="*/ 742293 h 1600305"/>
                <a:gd name="connsiteX432" fmla="*/ 4691956 w 8363529"/>
                <a:gd name="connsiteY432" fmla="*/ 677953 h 1600305"/>
                <a:gd name="connsiteX433" fmla="*/ 4683603 w 8363529"/>
                <a:gd name="connsiteY433" fmla="*/ 668914 h 1600305"/>
                <a:gd name="connsiteX434" fmla="*/ 4675201 w 8363529"/>
                <a:gd name="connsiteY434" fmla="*/ 730466 h 1600305"/>
                <a:gd name="connsiteX435" fmla="*/ 4608317 w 8363529"/>
                <a:gd name="connsiteY435" fmla="*/ 1233867 h 1600305"/>
                <a:gd name="connsiteX436" fmla="*/ 4599964 w 8363529"/>
                <a:gd name="connsiteY436" fmla="*/ 1298177 h 1600305"/>
                <a:gd name="connsiteX437" fmla="*/ 4591572 w 8363529"/>
                <a:gd name="connsiteY437" fmla="*/ 1229860 h 1600305"/>
                <a:gd name="connsiteX438" fmla="*/ 4524687 w 8363529"/>
                <a:gd name="connsiteY438" fmla="*/ 740028 h 1600305"/>
                <a:gd name="connsiteX439" fmla="*/ 4516324 w 8363529"/>
                <a:gd name="connsiteY439" fmla="*/ 685096 h 1600305"/>
                <a:gd name="connsiteX440" fmla="*/ 4507932 w 8363529"/>
                <a:gd name="connsiteY440" fmla="*/ 722482 h 1600305"/>
                <a:gd name="connsiteX441" fmla="*/ 4441048 w 8363529"/>
                <a:gd name="connsiteY441" fmla="*/ 1005563 h 1600305"/>
                <a:gd name="connsiteX442" fmla="*/ 4432695 w 8363529"/>
                <a:gd name="connsiteY442" fmla="*/ 1039059 h 1600305"/>
                <a:gd name="connsiteX443" fmla="*/ 4424303 w 8363529"/>
                <a:gd name="connsiteY443" fmla="*/ 946324 h 1600305"/>
                <a:gd name="connsiteX444" fmla="*/ 4357409 w 8363529"/>
                <a:gd name="connsiteY444" fmla="*/ 198176 h 1600305"/>
                <a:gd name="connsiteX445" fmla="*/ 4349055 w 8363529"/>
                <a:gd name="connsiteY445" fmla="*/ 103845 h 1600305"/>
                <a:gd name="connsiteX446" fmla="*/ 4340664 w 8363529"/>
                <a:gd name="connsiteY446" fmla="*/ 216700 h 1600305"/>
                <a:gd name="connsiteX447" fmla="*/ 4273779 w 8363529"/>
                <a:gd name="connsiteY447" fmla="*/ 1193829 h 1600305"/>
                <a:gd name="connsiteX448" fmla="*/ 4265416 w 8363529"/>
                <a:gd name="connsiteY448" fmla="*/ 1326108 h 1600305"/>
                <a:gd name="connsiteX449" fmla="*/ 4257024 w 8363529"/>
                <a:gd name="connsiteY449" fmla="*/ 1250010 h 1600305"/>
                <a:gd name="connsiteX450" fmla="*/ 4190140 w 8363529"/>
                <a:gd name="connsiteY450" fmla="*/ 765094 h 1600305"/>
                <a:gd name="connsiteX451" fmla="*/ 4181787 w 8363529"/>
                <a:gd name="connsiteY451" fmla="*/ 716510 h 1600305"/>
                <a:gd name="connsiteX452" fmla="*/ 4173394 w 8363529"/>
                <a:gd name="connsiteY452" fmla="*/ 763991 h 1600305"/>
                <a:gd name="connsiteX453" fmla="*/ 4106500 w 8363529"/>
                <a:gd name="connsiteY453" fmla="*/ 1345203 h 1600305"/>
                <a:gd name="connsiteX454" fmla="*/ 4098147 w 8363529"/>
                <a:gd name="connsiteY454" fmla="*/ 1458803 h 1600305"/>
                <a:gd name="connsiteX455" fmla="*/ 4089755 w 8363529"/>
                <a:gd name="connsiteY455" fmla="*/ 1406561 h 1600305"/>
                <a:gd name="connsiteX456" fmla="*/ 4022871 w 8363529"/>
                <a:gd name="connsiteY456" fmla="*/ 1134484 h 1600305"/>
                <a:gd name="connsiteX457" fmla="*/ 4014517 w 8363529"/>
                <a:gd name="connsiteY457" fmla="*/ 1111915 h 1600305"/>
                <a:gd name="connsiteX458" fmla="*/ 4006154 w 8363529"/>
                <a:gd name="connsiteY458" fmla="*/ 1088581 h 1600305"/>
                <a:gd name="connsiteX459" fmla="*/ 3939231 w 8363529"/>
                <a:gd name="connsiteY459" fmla="*/ 876807 h 1600305"/>
                <a:gd name="connsiteX460" fmla="*/ 3930878 w 8363529"/>
                <a:gd name="connsiteY460" fmla="*/ 846709 h 1600305"/>
                <a:gd name="connsiteX461" fmla="*/ 3922525 w 8363529"/>
                <a:gd name="connsiteY461" fmla="*/ 871097 h 1600305"/>
                <a:gd name="connsiteX462" fmla="*/ 3855602 w 8363529"/>
                <a:gd name="connsiteY462" fmla="*/ 1088020 h 1600305"/>
                <a:gd name="connsiteX463" fmla="*/ 3847239 w 8363529"/>
                <a:gd name="connsiteY463" fmla="*/ 1118186 h 1600305"/>
                <a:gd name="connsiteX464" fmla="*/ 3838885 w 8363529"/>
                <a:gd name="connsiteY464" fmla="*/ 1093991 h 1600305"/>
                <a:gd name="connsiteX465" fmla="*/ 3771962 w 8363529"/>
                <a:gd name="connsiteY465" fmla="*/ 917329 h 1600305"/>
                <a:gd name="connsiteX466" fmla="*/ 3763609 w 8363529"/>
                <a:gd name="connsiteY466" fmla="*/ 897141 h 1600305"/>
                <a:gd name="connsiteX467" fmla="*/ 3755246 w 8363529"/>
                <a:gd name="connsiteY467" fmla="*/ 898166 h 1600305"/>
                <a:gd name="connsiteX468" fmla="*/ 3688323 w 8363529"/>
                <a:gd name="connsiteY468" fmla="*/ 907535 h 1600305"/>
                <a:gd name="connsiteX469" fmla="*/ 3679970 w 8363529"/>
                <a:gd name="connsiteY469" fmla="*/ 908861 h 1600305"/>
                <a:gd name="connsiteX470" fmla="*/ 3671616 w 8363529"/>
                <a:gd name="connsiteY470" fmla="*/ 882817 h 1600305"/>
                <a:gd name="connsiteX471" fmla="*/ 3604693 w 8363529"/>
                <a:gd name="connsiteY471" fmla="*/ 726682 h 1600305"/>
                <a:gd name="connsiteX472" fmla="*/ 3596330 w 8363529"/>
                <a:gd name="connsiteY472" fmla="*/ 711933 h 1600305"/>
                <a:gd name="connsiteX473" fmla="*/ 3587977 w 8363529"/>
                <a:gd name="connsiteY473" fmla="*/ 724717 h 1600305"/>
                <a:gd name="connsiteX474" fmla="*/ 3521054 w 8363529"/>
                <a:gd name="connsiteY474" fmla="*/ 842741 h 1600305"/>
                <a:gd name="connsiteX475" fmla="*/ 3512701 w 8363529"/>
                <a:gd name="connsiteY475" fmla="*/ 859793 h 1600305"/>
                <a:gd name="connsiteX476" fmla="*/ 3504347 w 8363529"/>
                <a:gd name="connsiteY476" fmla="*/ 802103 h 1600305"/>
                <a:gd name="connsiteX477" fmla="*/ 3437424 w 8363529"/>
                <a:gd name="connsiteY477" fmla="*/ 400204 h 1600305"/>
                <a:gd name="connsiteX478" fmla="*/ 3429061 w 8363529"/>
                <a:gd name="connsiteY478" fmla="*/ 356344 h 1600305"/>
                <a:gd name="connsiteX479" fmla="*/ 3420708 w 8363529"/>
                <a:gd name="connsiteY479" fmla="*/ 390826 h 1600305"/>
                <a:gd name="connsiteX480" fmla="*/ 3353785 w 8363529"/>
                <a:gd name="connsiteY480" fmla="*/ 1066128 h 1600305"/>
                <a:gd name="connsiteX481" fmla="*/ 3345432 w 8363529"/>
                <a:gd name="connsiteY481" fmla="*/ 1296435 h 1600305"/>
                <a:gd name="connsiteX482" fmla="*/ 3337069 w 8363529"/>
                <a:gd name="connsiteY482" fmla="*/ 1308571 h 1600305"/>
                <a:gd name="connsiteX483" fmla="*/ 3270146 w 8363529"/>
                <a:gd name="connsiteY483" fmla="*/ 1351067 h 1600305"/>
                <a:gd name="connsiteX484" fmla="*/ 3261792 w 8363529"/>
                <a:gd name="connsiteY484" fmla="*/ 1353555 h 1600305"/>
                <a:gd name="connsiteX485" fmla="*/ 3253439 w 8363529"/>
                <a:gd name="connsiteY485" fmla="*/ 1299803 h 1600305"/>
                <a:gd name="connsiteX486" fmla="*/ 3186516 w 8363529"/>
                <a:gd name="connsiteY486" fmla="*/ 957928 h 1600305"/>
                <a:gd name="connsiteX487" fmla="*/ 3178153 w 8363529"/>
                <a:gd name="connsiteY487" fmla="*/ 923755 h 1600305"/>
                <a:gd name="connsiteX488" fmla="*/ 3169800 w 8363529"/>
                <a:gd name="connsiteY488" fmla="*/ 915364 h 1600305"/>
                <a:gd name="connsiteX489" fmla="*/ 3102877 w 8363529"/>
                <a:gd name="connsiteY489" fmla="*/ 822368 h 1600305"/>
                <a:gd name="connsiteX490" fmla="*/ 3094523 w 8363529"/>
                <a:gd name="connsiteY490" fmla="*/ 806071 h 1600305"/>
                <a:gd name="connsiteX491" fmla="*/ 3086161 w 8363529"/>
                <a:gd name="connsiteY491" fmla="*/ 812197 h 1600305"/>
                <a:gd name="connsiteX492" fmla="*/ 3019238 w 8363529"/>
                <a:gd name="connsiteY492" fmla="*/ 850609 h 1600305"/>
                <a:gd name="connsiteX493" fmla="*/ 3010884 w 8363529"/>
                <a:gd name="connsiteY493" fmla="*/ 854422 h 1600305"/>
                <a:gd name="connsiteX494" fmla="*/ 3002531 w 8363529"/>
                <a:gd name="connsiteY494" fmla="*/ 844599 h 1600305"/>
                <a:gd name="connsiteX495" fmla="*/ 2935608 w 8363529"/>
                <a:gd name="connsiteY495" fmla="*/ 762820 h 1600305"/>
                <a:gd name="connsiteX496" fmla="*/ 2927245 w 8363529"/>
                <a:gd name="connsiteY496" fmla="*/ 752164 h 1600305"/>
                <a:gd name="connsiteX497" fmla="*/ 2918892 w 8363529"/>
                <a:gd name="connsiteY497" fmla="*/ 766981 h 1600305"/>
                <a:gd name="connsiteX498" fmla="*/ 2851968 w 8363529"/>
                <a:gd name="connsiteY498" fmla="*/ 882362 h 1600305"/>
                <a:gd name="connsiteX499" fmla="*/ 2843615 w 8363529"/>
                <a:gd name="connsiteY499" fmla="*/ 896386 h 1600305"/>
                <a:gd name="connsiteX500" fmla="*/ 2835262 w 8363529"/>
                <a:gd name="connsiteY500" fmla="*/ 906819 h 1600305"/>
                <a:gd name="connsiteX501" fmla="*/ 2768329 w 8363529"/>
                <a:gd name="connsiteY501" fmla="*/ 1016983 h 1600305"/>
                <a:gd name="connsiteX502" fmla="*/ 2759976 w 8363529"/>
                <a:gd name="connsiteY502" fmla="*/ 1035284 h 1600305"/>
                <a:gd name="connsiteX503" fmla="*/ 2751623 w 8363529"/>
                <a:gd name="connsiteY503" fmla="*/ 1018009 h 1600305"/>
                <a:gd name="connsiteX504" fmla="*/ 2684699 w 8363529"/>
                <a:gd name="connsiteY504" fmla="*/ 901379 h 1600305"/>
                <a:gd name="connsiteX505" fmla="*/ 2676346 w 8363529"/>
                <a:gd name="connsiteY505" fmla="*/ 889050 h 1600305"/>
                <a:gd name="connsiteX506" fmla="*/ 2667983 w 8363529"/>
                <a:gd name="connsiteY506" fmla="*/ 915819 h 1600305"/>
                <a:gd name="connsiteX507" fmla="*/ 2601060 w 8363529"/>
                <a:gd name="connsiteY507" fmla="*/ 1127186 h 1600305"/>
                <a:gd name="connsiteX508" fmla="*/ 2592707 w 8363529"/>
                <a:gd name="connsiteY508" fmla="*/ 1153269 h 1600305"/>
                <a:gd name="connsiteX509" fmla="*/ 2584354 w 8363529"/>
                <a:gd name="connsiteY509" fmla="*/ 1076716 h 1600305"/>
                <a:gd name="connsiteX510" fmla="*/ 2517430 w 8363529"/>
                <a:gd name="connsiteY510" fmla="*/ 554481 h 1600305"/>
                <a:gd name="connsiteX511" fmla="*/ 2509068 w 8363529"/>
                <a:gd name="connsiteY511" fmla="*/ 498678 h 1600305"/>
                <a:gd name="connsiteX512" fmla="*/ 2500714 w 8363529"/>
                <a:gd name="connsiteY512" fmla="*/ 544881 h 1600305"/>
                <a:gd name="connsiteX513" fmla="*/ 2433791 w 8363529"/>
                <a:gd name="connsiteY513" fmla="*/ 936007 h 1600305"/>
                <a:gd name="connsiteX514" fmla="*/ 2425438 w 8363529"/>
                <a:gd name="connsiteY514" fmla="*/ 987794 h 1600305"/>
                <a:gd name="connsiteX515" fmla="*/ 2417075 w 8363529"/>
                <a:gd name="connsiteY515" fmla="*/ 997511 h 1600305"/>
                <a:gd name="connsiteX516" fmla="*/ 2350152 w 8363529"/>
                <a:gd name="connsiteY516" fmla="*/ 1079513 h 1600305"/>
                <a:gd name="connsiteX517" fmla="*/ 2341799 w 8363529"/>
                <a:gd name="connsiteY517" fmla="*/ 1090284 h 1600305"/>
                <a:gd name="connsiteX518" fmla="*/ 2333445 w 8363529"/>
                <a:gd name="connsiteY518" fmla="*/ 1104046 h 1600305"/>
                <a:gd name="connsiteX519" fmla="*/ 2266522 w 8363529"/>
                <a:gd name="connsiteY519" fmla="*/ 1238667 h 1600305"/>
                <a:gd name="connsiteX520" fmla="*/ 2258159 w 8363529"/>
                <a:gd name="connsiteY520" fmla="*/ 1259388 h 1600305"/>
                <a:gd name="connsiteX521" fmla="*/ 2249806 w 8363529"/>
                <a:gd name="connsiteY521" fmla="*/ 1190616 h 1600305"/>
                <a:gd name="connsiteX522" fmla="*/ 2182883 w 8363529"/>
                <a:gd name="connsiteY522" fmla="*/ 731221 h 1600305"/>
                <a:gd name="connsiteX523" fmla="*/ 2174530 w 8363529"/>
                <a:gd name="connsiteY523" fmla="*/ 683092 h 1600305"/>
                <a:gd name="connsiteX524" fmla="*/ 2166176 w 8363529"/>
                <a:gd name="connsiteY524" fmla="*/ 664269 h 1600305"/>
                <a:gd name="connsiteX525" fmla="*/ 2099253 w 8363529"/>
                <a:gd name="connsiteY525" fmla="*/ 489687 h 1600305"/>
                <a:gd name="connsiteX526" fmla="*/ 2090890 w 8363529"/>
                <a:gd name="connsiteY526" fmla="*/ 464282 h 1600305"/>
                <a:gd name="connsiteX527" fmla="*/ 2082537 w 8363529"/>
                <a:gd name="connsiteY527" fmla="*/ 530857 h 1600305"/>
                <a:gd name="connsiteX528" fmla="*/ 2015614 w 8363529"/>
                <a:gd name="connsiteY528" fmla="*/ 937633 h 1600305"/>
                <a:gd name="connsiteX529" fmla="*/ 2007260 w 8363529"/>
                <a:gd name="connsiteY529" fmla="*/ 976761 h 1600305"/>
                <a:gd name="connsiteX530" fmla="*/ 1998898 w 8363529"/>
                <a:gd name="connsiteY530" fmla="*/ 977971 h 1600305"/>
                <a:gd name="connsiteX531" fmla="*/ 1931975 w 8363529"/>
                <a:gd name="connsiteY531" fmla="*/ 990407 h 1600305"/>
                <a:gd name="connsiteX532" fmla="*/ 1923621 w 8363529"/>
                <a:gd name="connsiteY532" fmla="*/ 992411 h 1600305"/>
                <a:gd name="connsiteX533" fmla="*/ 1915268 w 8363529"/>
                <a:gd name="connsiteY533" fmla="*/ 1001256 h 1600305"/>
                <a:gd name="connsiteX534" fmla="*/ 1848345 w 8363529"/>
                <a:gd name="connsiteY534" fmla="*/ 1072516 h 1600305"/>
                <a:gd name="connsiteX535" fmla="*/ 1839982 w 8363529"/>
                <a:gd name="connsiteY535" fmla="*/ 1081516 h 1600305"/>
                <a:gd name="connsiteX536" fmla="*/ 1831629 w 8363529"/>
                <a:gd name="connsiteY536" fmla="*/ 1099091 h 1600305"/>
                <a:gd name="connsiteX537" fmla="*/ 1764706 w 8363529"/>
                <a:gd name="connsiteY537" fmla="*/ 1231225 h 1600305"/>
                <a:gd name="connsiteX538" fmla="*/ 1756352 w 8363529"/>
                <a:gd name="connsiteY538" fmla="*/ 1246719 h 1600305"/>
                <a:gd name="connsiteX539" fmla="*/ 1747989 w 8363529"/>
                <a:gd name="connsiteY539" fmla="*/ 1220599 h 1600305"/>
                <a:gd name="connsiteX540" fmla="*/ 1681066 w 8363529"/>
                <a:gd name="connsiteY540" fmla="*/ 1048020 h 1600305"/>
                <a:gd name="connsiteX541" fmla="*/ 1672713 w 8363529"/>
                <a:gd name="connsiteY541" fmla="*/ 1030136 h 1600305"/>
                <a:gd name="connsiteX542" fmla="*/ 1664360 w 8363529"/>
                <a:gd name="connsiteY542" fmla="*/ 1054785 h 1600305"/>
                <a:gd name="connsiteX543" fmla="*/ 1597437 w 8363529"/>
                <a:gd name="connsiteY543" fmla="*/ 1347438 h 1600305"/>
                <a:gd name="connsiteX544" fmla="*/ 1589074 w 8363529"/>
                <a:gd name="connsiteY544" fmla="*/ 1402738 h 1600305"/>
                <a:gd name="connsiteX545" fmla="*/ 1580720 w 8363529"/>
                <a:gd name="connsiteY545" fmla="*/ 1378853 h 1600305"/>
                <a:gd name="connsiteX546" fmla="*/ 1513797 w 8363529"/>
                <a:gd name="connsiteY546" fmla="*/ 1229560 h 1600305"/>
                <a:gd name="connsiteX547" fmla="*/ 1505444 w 8363529"/>
                <a:gd name="connsiteY547" fmla="*/ 1214889 h 1600305"/>
                <a:gd name="connsiteX548" fmla="*/ 1497091 w 8363529"/>
                <a:gd name="connsiteY548" fmla="*/ 1199878 h 1600305"/>
                <a:gd name="connsiteX549" fmla="*/ 1430158 w 8363529"/>
                <a:gd name="connsiteY549" fmla="*/ 1099401 h 1600305"/>
                <a:gd name="connsiteX550" fmla="*/ 1421805 w 8363529"/>
                <a:gd name="connsiteY550" fmla="*/ 1088852 h 1600305"/>
                <a:gd name="connsiteX551" fmla="*/ 1413451 w 8363529"/>
                <a:gd name="connsiteY551" fmla="*/ 1103330 h 1600305"/>
                <a:gd name="connsiteX552" fmla="*/ 1346528 w 8363529"/>
                <a:gd name="connsiteY552" fmla="*/ 1276440 h 1600305"/>
                <a:gd name="connsiteX553" fmla="*/ 1338175 w 8363529"/>
                <a:gd name="connsiteY553" fmla="*/ 1309365 h 1600305"/>
                <a:gd name="connsiteX554" fmla="*/ 1329812 w 8363529"/>
                <a:gd name="connsiteY554" fmla="*/ 1179922 h 1600305"/>
                <a:gd name="connsiteX555" fmla="*/ 1262889 w 8363529"/>
                <a:gd name="connsiteY555" fmla="*/ 541474 h 1600305"/>
                <a:gd name="connsiteX556" fmla="*/ 1254536 w 8363529"/>
                <a:gd name="connsiteY556" fmla="*/ 491004 h 1600305"/>
                <a:gd name="connsiteX557" fmla="*/ 1246182 w 8363529"/>
                <a:gd name="connsiteY557" fmla="*/ 527151 h 1600305"/>
                <a:gd name="connsiteX558" fmla="*/ 1179259 w 8363529"/>
                <a:gd name="connsiteY558" fmla="*/ 868900 h 1600305"/>
                <a:gd name="connsiteX559" fmla="*/ 1170896 w 8363529"/>
                <a:gd name="connsiteY559" fmla="*/ 919564 h 1600305"/>
                <a:gd name="connsiteX560" fmla="*/ 1162543 w 8363529"/>
                <a:gd name="connsiteY560" fmla="*/ 961412 h 1600305"/>
                <a:gd name="connsiteX561" fmla="*/ 1095620 w 8363529"/>
                <a:gd name="connsiteY561" fmla="*/ 1277718 h 1600305"/>
                <a:gd name="connsiteX562" fmla="*/ 1087267 w 8363529"/>
                <a:gd name="connsiteY562" fmla="*/ 1315075 h 1600305"/>
                <a:gd name="connsiteX563" fmla="*/ 1078904 w 8363529"/>
                <a:gd name="connsiteY563" fmla="*/ 1292051 h 1600305"/>
                <a:gd name="connsiteX564" fmla="*/ 1011981 w 8363529"/>
                <a:gd name="connsiteY564" fmla="*/ 1139207 h 1600305"/>
                <a:gd name="connsiteX565" fmla="*/ 1003627 w 8363529"/>
                <a:gd name="connsiteY565" fmla="*/ 1123325 h 1600305"/>
                <a:gd name="connsiteX566" fmla="*/ 995274 w 8363529"/>
                <a:gd name="connsiteY566" fmla="*/ 1085561 h 1600305"/>
                <a:gd name="connsiteX567" fmla="*/ 928351 w 8363529"/>
                <a:gd name="connsiteY567" fmla="*/ 694358 h 1600305"/>
                <a:gd name="connsiteX568" fmla="*/ 919988 w 8363529"/>
                <a:gd name="connsiteY568" fmla="*/ 630580 h 1600305"/>
                <a:gd name="connsiteX569" fmla="*/ 911635 w 8363529"/>
                <a:gd name="connsiteY569" fmla="*/ 687931 h 1600305"/>
                <a:gd name="connsiteX570" fmla="*/ 844712 w 8363529"/>
                <a:gd name="connsiteY570" fmla="*/ 1059934 h 1600305"/>
                <a:gd name="connsiteX571" fmla="*/ 836358 w 8363529"/>
                <a:gd name="connsiteY571" fmla="*/ 1097814 h 1600305"/>
                <a:gd name="connsiteX572" fmla="*/ 828005 w 8363529"/>
                <a:gd name="connsiteY572" fmla="*/ 1119434 h 1600305"/>
                <a:gd name="connsiteX573" fmla="*/ 761082 w 8363529"/>
                <a:gd name="connsiteY573" fmla="*/ 1339531 h 1600305"/>
                <a:gd name="connsiteX574" fmla="*/ 752719 w 8363529"/>
                <a:gd name="connsiteY574" fmla="*/ 1374769 h 1600305"/>
                <a:gd name="connsiteX575" fmla="*/ 744366 w 8363529"/>
                <a:gd name="connsiteY575" fmla="*/ 1346567 h 1600305"/>
                <a:gd name="connsiteX576" fmla="*/ 677443 w 8363529"/>
                <a:gd name="connsiteY576" fmla="*/ 1077248 h 1600305"/>
                <a:gd name="connsiteX577" fmla="*/ 669089 w 8363529"/>
                <a:gd name="connsiteY577" fmla="*/ 1036871 h 1600305"/>
                <a:gd name="connsiteX578" fmla="*/ 660727 w 8363529"/>
                <a:gd name="connsiteY578" fmla="*/ 972793 h 1600305"/>
                <a:gd name="connsiteX579" fmla="*/ 593803 w 8363529"/>
                <a:gd name="connsiteY579" fmla="*/ 623592 h 1600305"/>
                <a:gd name="connsiteX580" fmla="*/ 585450 w 8363529"/>
                <a:gd name="connsiteY580" fmla="*/ 593348 h 1600305"/>
                <a:gd name="connsiteX581" fmla="*/ 577097 w 8363529"/>
                <a:gd name="connsiteY581" fmla="*/ 617050 h 1600305"/>
                <a:gd name="connsiteX582" fmla="*/ 510174 w 8363529"/>
                <a:gd name="connsiteY582" fmla="*/ 920581 h 1600305"/>
                <a:gd name="connsiteX583" fmla="*/ 501811 w 8363529"/>
                <a:gd name="connsiteY583" fmla="*/ 983033 h 1600305"/>
                <a:gd name="connsiteX584" fmla="*/ 493458 w 8363529"/>
                <a:gd name="connsiteY584" fmla="*/ 932417 h 1600305"/>
                <a:gd name="connsiteX585" fmla="*/ 426534 w 8363529"/>
                <a:gd name="connsiteY585" fmla="*/ 705923 h 1600305"/>
                <a:gd name="connsiteX586" fmla="*/ 418181 w 8363529"/>
                <a:gd name="connsiteY586" fmla="*/ 689480 h 1600305"/>
                <a:gd name="connsiteX587" fmla="*/ 409818 w 8363529"/>
                <a:gd name="connsiteY587" fmla="*/ 709029 h 1600305"/>
                <a:gd name="connsiteX588" fmla="*/ 342895 w 8363529"/>
                <a:gd name="connsiteY588" fmla="*/ 921452 h 1600305"/>
                <a:gd name="connsiteX589" fmla="*/ 334542 w 8363529"/>
                <a:gd name="connsiteY589" fmla="*/ 957928 h 1600305"/>
                <a:gd name="connsiteX590" fmla="*/ 326189 w 8363529"/>
                <a:gd name="connsiteY590" fmla="*/ 995430 h 1600305"/>
                <a:gd name="connsiteX591" fmla="*/ 259304 w 8363529"/>
                <a:gd name="connsiteY591" fmla="*/ 1341806 h 1600305"/>
                <a:gd name="connsiteX592" fmla="*/ 250903 w 8363529"/>
                <a:gd name="connsiteY592" fmla="*/ 1391928 h 1600305"/>
                <a:gd name="connsiteX593" fmla="*/ 242549 w 8363529"/>
                <a:gd name="connsiteY593" fmla="*/ 1353748 h 1600305"/>
                <a:gd name="connsiteX594" fmla="*/ 175665 w 8363529"/>
                <a:gd name="connsiteY594" fmla="*/ 1140455 h 1600305"/>
                <a:gd name="connsiteX595" fmla="*/ 167273 w 8363529"/>
                <a:gd name="connsiteY595" fmla="*/ 1121554 h 1600305"/>
                <a:gd name="connsiteX596" fmla="*/ 158920 w 8363529"/>
                <a:gd name="connsiteY596" fmla="*/ 1084506 h 1600305"/>
                <a:gd name="connsiteX597" fmla="*/ 92029 w 8363529"/>
                <a:gd name="connsiteY597" fmla="*/ 743048 h 1600305"/>
                <a:gd name="connsiteX598" fmla="*/ 83635 w 8363529"/>
                <a:gd name="connsiteY598" fmla="*/ 693796 h 1600305"/>
                <a:gd name="connsiteX599" fmla="*/ 75279 w 8363529"/>
                <a:gd name="connsiteY599" fmla="*/ 717343 h 1600305"/>
                <a:gd name="connsiteX600" fmla="*/ 8394 w 8363529"/>
                <a:gd name="connsiteY600" fmla="*/ 903383 h 1600305"/>
                <a:gd name="connsiteX601" fmla="*/ 0 w 8363529"/>
                <a:gd name="connsiteY601" fmla="*/ 926368 h 16003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  <a:cxn ang="0">
                  <a:pos x="connsiteX466" y="connsiteY466"/>
                </a:cxn>
                <a:cxn ang="0">
                  <a:pos x="connsiteX467" y="connsiteY467"/>
                </a:cxn>
                <a:cxn ang="0">
                  <a:pos x="connsiteX468" y="connsiteY468"/>
                </a:cxn>
                <a:cxn ang="0">
                  <a:pos x="connsiteX469" y="connsiteY469"/>
                </a:cxn>
                <a:cxn ang="0">
                  <a:pos x="connsiteX470" y="connsiteY470"/>
                </a:cxn>
                <a:cxn ang="0">
                  <a:pos x="connsiteX471" y="connsiteY471"/>
                </a:cxn>
                <a:cxn ang="0">
                  <a:pos x="connsiteX472" y="connsiteY472"/>
                </a:cxn>
                <a:cxn ang="0">
                  <a:pos x="connsiteX473" y="connsiteY473"/>
                </a:cxn>
                <a:cxn ang="0">
                  <a:pos x="connsiteX474" y="connsiteY474"/>
                </a:cxn>
                <a:cxn ang="0">
                  <a:pos x="connsiteX475" y="connsiteY475"/>
                </a:cxn>
                <a:cxn ang="0">
                  <a:pos x="connsiteX476" y="connsiteY476"/>
                </a:cxn>
                <a:cxn ang="0">
                  <a:pos x="connsiteX477" y="connsiteY477"/>
                </a:cxn>
                <a:cxn ang="0">
                  <a:pos x="connsiteX478" y="connsiteY478"/>
                </a:cxn>
                <a:cxn ang="0">
                  <a:pos x="connsiteX479" y="connsiteY479"/>
                </a:cxn>
                <a:cxn ang="0">
                  <a:pos x="connsiteX480" y="connsiteY480"/>
                </a:cxn>
                <a:cxn ang="0">
                  <a:pos x="connsiteX481" y="connsiteY481"/>
                </a:cxn>
                <a:cxn ang="0">
                  <a:pos x="connsiteX482" y="connsiteY482"/>
                </a:cxn>
                <a:cxn ang="0">
                  <a:pos x="connsiteX483" y="connsiteY483"/>
                </a:cxn>
                <a:cxn ang="0">
                  <a:pos x="connsiteX484" y="connsiteY484"/>
                </a:cxn>
                <a:cxn ang="0">
                  <a:pos x="connsiteX485" y="connsiteY485"/>
                </a:cxn>
                <a:cxn ang="0">
                  <a:pos x="connsiteX486" y="connsiteY486"/>
                </a:cxn>
                <a:cxn ang="0">
                  <a:pos x="connsiteX487" y="connsiteY487"/>
                </a:cxn>
                <a:cxn ang="0">
                  <a:pos x="connsiteX488" y="connsiteY488"/>
                </a:cxn>
                <a:cxn ang="0">
                  <a:pos x="connsiteX489" y="connsiteY489"/>
                </a:cxn>
                <a:cxn ang="0">
                  <a:pos x="connsiteX490" y="connsiteY490"/>
                </a:cxn>
                <a:cxn ang="0">
                  <a:pos x="connsiteX491" y="connsiteY491"/>
                </a:cxn>
                <a:cxn ang="0">
                  <a:pos x="connsiteX492" y="connsiteY492"/>
                </a:cxn>
                <a:cxn ang="0">
                  <a:pos x="connsiteX493" y="connsiteY493"/>
                </a:cxn>
                <a:cxn ang="0">
                  <a:pos x="connsiteX494" y="connsiteY494"/>
                </a:cxn>
                <a:cxn ang="0">
                  <a:pos x="connsiteX495" y="connsiteY495"/>
                </a:cxn>
                <a:cxn ang="0">
                  <a:pos x="connsiteX496" y="connsiteY496"/>
                </a:cxn>
                <a:cxn ang="0">
                  <a:pos x="connsiteX497" y="connsiteY497"/>
                </a:cxn>
                <a:cxn ang="0">
                  <a:pos x="connsiteX498" y="connsiteY498"/>
                </a:cxn>
                <a:cxn ang="0">
                  <a:pos x="connsiteX499" y="connsiteY499"/>
                </a:cxn>
                <a:cxn ang="0">
                  <a:pos x="connsiteX500" y="connsiteY500"/>
                </a:cxn>
                <a:cxn ang="0">
                  <a:pos x="connsiteX501" y="connsiteY501"/>
                </a:cxn>
                <a:cxn ang="0">
                  <a:pos x="connsiteX502" y="connsiteY502"/>
                </a:cxn>
                <a:cxn ang="0">
                  <a:pos x="connsiteX503" y="connsiteY503"/>
                </a:cxn>
                <a:cxn ang="0">
                  <a:pos x="connsiteX504" y="connsiteY504"/>
                </a:cxn>
                <a:cxn ang="0">
                  <a:pos x="connsiteX505" y="connsiteY505"/>
                </a:cxn>
                <a:cxn ang="0">
                  <a:pos x="connsiteX506" y="connsiteY506"/>
                </a:cxn>
                <a:cxn ang="0">
                  <a:pos x="connsiteX507" y="connsiteY507"/>
                </a:cxn>
                <a:cxn ang="0">
                  <a:pos x="connsiteX508" y="connsiteY508"/>
                </a:cxn>
                <a:cxn ang="0">
                  <a:pos x="connsiteX509" y="connsiteY509"/>
                </a:cxn>
                <a:cxn ang="0">
                  <a:pos x="connsiteX510" y="connsiteY510"/>
                </a:cxn>
                <a:cxn ang="0">
                  <a:pos x="connsiteX511" y="connsiteY511"/>
                </a:cxn>
                <a:cxn ang="0">
                  <a:pos x="connsiteX512" y="connsiteY512"/>
                </a:cxn>
                <a:cxn ang="0">
                  <a:pos x="connsiteX513" y="connsiteY513"/>
                </a:cxn>
                <a:cxn ang="0">
                  <a:pos x="connsiteX514" y="connsiteY514"/>
                </a:cxn>
                <a:cxn ang="0">
                  <a:pos x="connsiteX515" y="connsiteY515"/>
                </a:cxn>
                <a:cxn ang="0">
                  <a:pos x="connsiteX516" y="connsiteY516"/>
                </a:cxn>
                <a:cxn ang="0">
                  <a:pos x="connsiteX517" y="connsiteY517"/>
                </a:cxn>
                <a:cxn ang="0">
                  <a:pos x="connsiteX518" y="connsiteY518"/>
                </a:cxn>
                <a:cxn ang="0">
                  <a:pos x="connsiteX519" y="connsiteY519"/>
                </a:cxn>
                <a:cxn ang="0">
                  <a:pos x="connsiteX520" y="connsiteY520"/>
                </a:cxn>
                <a:cxn ang="0">
                  <a:pos x="connsiteX521" y="connsiteY521"/>
                </a:cxn>
                <a:cxn ang="0">
                  <a:pos x="connsiteX522" y="connsiteY522"/>
                </a:cxn>
                <a:cxn ang="0">
                  <a:pos x="connsiteX523" y="connsiteY523"/>
                </a:cxn>
                <a:cxn ang="0">
                  <a:pos x="connsiteX524" y="connsiteY524"/>
                </a:cxn>
                <a:cxn ang="0">
                  <a:pos x="connsiteX525" y="connsiteY525"/>
                </a:cxn>
                <a:cxn ang="0">
                  <a:pos x="connsiteX526" y="connsiteY526"/>
                </a:cxn>
                <a:cxn ang="0">
                  <a:pos x="connsiteX527" y="connsiteY527"/>
                </a:cxn>
                <a:cxn ang="0">
                  <a:pos x="connsiteX528" y="connsiteY528"/>
                </a:cxn>
                <a:cxn ang="0">
                  <a:pos x="connsiteX529" y="connsiteY529"/>
                </a:cxn>
                <a:cxn ang="0">
                  <a:pos x="connsiteX530" y="connsiteY530"/>
                </a:cxn>
                <a:cxn ang="0">
                  <a:pos x="connsiteX531" y="connsiteY531"/>
                </a:cxn>
                <a:cxn ang="0">
                  <a:pos x="connsiteX532" y="connsiteY532"/>
                </a:cxn>
                <a:cxn ang="0">
                  <a:pos x="connsiteX533" y="connsiteY533"/>
                </a:cxn>
                <a:cxn ang="0">
                  <a:pos x="connsiteX534" y="connsiteY534"/>
                </a:cxn>
                <a:cxn ang="0">
                  <a:pos x="connsiteX535" y="connsiteY535"/>
                </a:cxn>
                <a:cxn ang="0">
                  <a:pos x="connsiteX536" y="connsiteY536"/>
                </a:cxn>
                <a:cxn ang="0">
                  <a:pos x="connsiteX537" y="connsiteY537"/>
                </a:cxn>
                <a:cxn ang="0">
                  <a:pos x="connsiteX538" y="connsiteY538"/>
                </a:cxn>
                <a:cxn ang="0">
                  <a:pos x="connsiteX539" y="connsiteY539"/>
                </a:cxn>
                <a:cxn ang="0">
                  <a:pos x="connsiteX540" y="connsiteY540"/>
                </a:cxn>
                <a:cxn ang="0">
                  <a:pos x="connsiteX541" y="connsiteY541"/>
                </a:cxn>
                <a:cxn ang="0">
                  <a:pos x="connsiteX542" y="connsiteY542"/>
                </a:cxn>
                <a:cxn ang="0">
                  <a:pos x="connsiteX543" y="connsiteY543"/>
                </a:cxn>
                <a:cxn ang="0">
                  <a:pos x="connsiteX544" y="connsiteY544"/>
                </a:cxn>
                <a:cxn ang="0">
                  <a:pos x="connsiteX545" y="connsiteY545"/>
                </a:cxn>
                <a:cxn ang="0">
                  <a:pos x="connsiteX546" y="connsiteY546"/>
                </a:cxn>
                <a:cxn ang="0">
                  <a:pos x="connsiteX547" y="connsiteY547"/>
                </a:cxn>
                <a:cxn ang="0">
                  <a:pos x="connsiteX548" y="connsiteY548"/>
                </a:cxn>
                <a:cxn ang="0">
                  <a:pos x="connsiteX549" y="connsiteY549"/>
                </a:cxn>
                <a:cxn ang="0">
                  <a:pos x="connsiteX550" y="connsiteY550"/>
                </a:cxn>
                <a:cxn ang="0">
                  <a:pos x="connsiteX551" y="connsiteY551"/>
                </a:cxn>
                <a:cxn ang="0">
                  <a:pos x="connsiteX552" y="connsiteY552"/>
                </a:cxn>
                <a:cxn ang="0">
                  <a:pos x="connsiteX553" y="connsiteY553"/>
                </a:cxn>
                <a:cxn ang="0">
                  <a:pos x="connsiteX554" y="connsiteY554"/>
                </a:cxn>
                <a:cxn ang="0">
                  <a:pos x="connsiteX555" y="connsiteY555"/>
                </a:cxn>
                <a:cxn ang="0">
                  <a:pos x="connsiteX556" y="connsiteY556"/>
                </a:cxn>
                <a:cxn ang="0">
                  <a:pos x="connsiteX557" y="connsiteY557"/>
                </a:cxn>
                <a:cxn ang="0">
                  <a:pos x="connsiteX558" y="connsiteY558"/>
                </a:cxn>
                <a:cxn ang="0">
                  <a:pos x="connsiteX559" y="connsiteY559"/>
                </a:cxn>
                <a:cxn ang="0">
                  <a:pos x="connsiteX560" y="connsiteY560"/>
                </a:cxn>
                <a:cxn ang="0">
                  <a:pos x="connsiteX561" y="connsiteY561"/>
                </a:cxn>
                <a:cxn ang="0">
                  <a:pos x="connsiteX562" y="connsiteY562"/>
                </a:cxn>
                <a:cxn ang="0">
                  <a:pos x="connsiteX563" y="connsiteY563"/>
                </a:cxn>
                <a:cxn ang="0">
                  <a:pos x="connsiteX564" y="connsiteY564"/>
                </a:cxn>
                <a:cxn ang="0">
                  <a:pos x="connsiteX565" y="connsiteY565"/>
                </a:cxn>
                <a:cxn ang="0">
                  <a:pos x="connsiteX566" y="connsiteY566"/>
                </a:cxn>
                <a:cxn ang="0">
                  <a:pos x="connsiteX567" y="connsiteY567"/>
                </a:cxn>
                <a:cxn ang="0">
                  <a:pos x="connsiteX568" y="connsiteY568"/>
                </a:cxn>
                <a:cxn ang="0">
                  <a:pos x="connsiteX569" y="connsiteY569"/>
                </a:cxn>
                <a:cxn ang="0">
                  <a:pos x="connsiteX570" y="connsiteY570"/>
                </a:cxn>
                <a:cxn ang="0">
                  <a:pos x="connsiteX571" y="connsiteY571"/>
                </a:cxn>
                <a:cxn ang="0">
                  <a:pos x="connsiteX572" y="connsiteY572"/>
                </a:cxn>
                <a:cxn ang="0">
                  <a:pos x="connsiteX573" y="connsiteY573"/>
                </a:cxn>
                <a:cxn ang="0">
                  <a:pos x="connsiteX574" y="connsiteY574"/>
                </a:cxn>
                <a:cxn ang="0">
                  <a:pos x="connsiteX575" y="connsiteY575"/>
                </a:cxn>
                <a:cxn ang="0">
                  <a:pos x="connsiteX576" y="connsiteY576"/>
                </a:cxn>
                <a:cxn ang="0">
                  <a:pos x="connsiteX577" y="connsiteY577"/>
                </a:cxn>
                <a:cxn ang="0">
                  <a:pos x="connsiteX578" y="connsiteY578"/>
                </a:cxn>
                <a:cxn ang="0">
                  <a:pos x="connsiteX579" y="connsiteY579"/>
                </a:cxn>
                <a:cxn ang="0">
                  <a:pos x="connsiteX580" y="connsiteY580"/>
                </a:cxn>
                <a:cxn ang="0">
                  <a:pos x="connsiteX581" y="connsiteY581"/>
                </a:cxn>
                <a:cxn ang="0">
                  <a:pos x="connsiteX582" y="connsiteY582"/>
                </a:cxn>
                <a:cxn ang="0">
                  <a:pos x="connsiteX583" y="connsiteY583"/>
                </a:cxn>
                <a:cxn ang="0">
                  <a:pos x="connsiteX584" y="connsiteY584"/>
                </a:cxn>
                <a:cxn ang="0">
                  <a:pos x="connsiteX585" y="connsiteY585"/>
                </a:cxn>
                <a:cxn ang="0">
                  <a:pos x="connsiteX586" y="connsiteY586"/>
                </a:cxn>
                <a:cxn ang="0">
                  <a:pos x="connsiteX587" y="connsiteY587"/>
                </a:cxn>
                <a:cxn ang="0">
                  <a:pos x="connsiteX588" y="connsiteY588"/>
                </a:cxn>
                <a:cxn ang="0">
                  <a:pos x="connsiteX589" y="connsiteY589"/>
                </a:cxn>
                <a:cxn ang="0">
                  <a:pos x="connsiteX590" y="connsiteY590"/>
                </a:cxn>
                <a:cxn ang="0">
                  <a:pos x="connsiteX591" y="connsiteY591"/>
                </a:cxn>
                <a:cxn ang="0">
                  <a:pos x="connsiteX592" y="connsiteY592"/>
                </a:cxn>
                <a:cxn ang="0">
                  <a:pos x="connsiteX593" y="connsiteY593"/>
                </a:cxn>
                <a:cxn ang="0">
                  <a:pos x="connsiteX594" y="connsiteY594"/>
                </a:cxn>
                <a:cxn ang="0">
                  <a:pos x="connsiteX595" y="connsiteY595"/>
                </a:cxn>
                <a:cxn ang="0">
                  <a:pos x="connsiteX596" y="connsiteY596"/>
                </a:cxn>
                <a:cxn ang="0">
                  <a:pos x="connsiteX597" y="connsiteY597"/>
                </a:cxn>
                <a:cxn ang="0">
                  <a:pos x="connsiteX598" y="connsiteY598"/>
                </a:cxn>
                <a:cxn ang="0">
                  <a:pos x="connsiteX599" y="connsiteY599"/>
                </a:cxn>
                <a:cxn ang="0">
                  <a:pos x="connsiteX600" y="connsiteY600"/>
                </a:cxn>
                <a:cxn ang="0">
                  <a:pos x="connsiteX601" y="connsiteY601"/>
                </a:cxn>
              </a:cxnLst>
              <a:rect l="l" t="t" r="r" b="b"/>
              <a:pathLst>
                <a:path w="8363529" h="1600305">
                  <a:moveTo>
                    <a:pt x="0" y="797602"/>
                  </a:moveTo>
                  <a:lnTo>
                    <a:pt x="8394" y="775827"/>
                  </a:lnTo>
                  <a:lnTo>
                    <a:pt x="75279" y="599242"/>
                  </a:lnTo>
                  <a:lnTo>
                    <a:pt x="83635" y="576857"/>
                  </a:lnTo>
                  <a:lnTo>
                    <a:pt x="92029" y="592893"/>
                  </a:lnTo>
                  <a:lnTo>
                    <a:pt x="158920" y="703813"/>
                  </a:lnTo>
                  <a:lnTo>
                    <a:pt x="167273" y="715872"/>
                  </a:lnTo>
                  <a:lnTo>
                    <a:pt x="175665" y="755900"/>
                  </a:lnTo>
                  <a:lnTo>
                    <a:pt x="242549" y="1208085"/>
                  </a:lnTo>
                  <a:lnTo>
                    <a:pt x="250903" y="1288954"/>
                  </a:lnTo>
                  <a:lnTo>
                    <a:pt x="259304" y="1238938"/>
                  </a:lnTo>
                  <a:lnTo>
                    <a:pt x="326189" y="893289"/>
                  </a:lnTo>
                  <a:lnTo>
                    <a:pt x="334542" y="855864"/>
                  </a:lnTo>
                  <a:lnTo>
                    <a:pt x="342895" y="795638"/>
                  </a:lnTo>
                  <a:lnTo>
                    <a:pt x="409818" y="445033"/>
                  </a:lnTo>
                  <a:lnTo>
                    <a:pt x="418181" y="412786"/>
                  </a:lnTo>
                  <a:lnTo>
                    <a:pt x="426534" y="435171"/>
                  </a:lnTo>
                  <a:lnTo>
                    <a:pt x="493458" y="744073"/>
                  </a:lnTo>
                  <a:lnTo>
                    <a:pt x="501811" y="813068"/>
                  </a:lnTo>
                  <a:lnTo>
                    <a:pt x="510174" y="692770"/>
                  </a:lnTo>
                  <a:lnTo>
                    <a:pt x="577097" y="107929"/>
                  </a:lnTo>
                  <a:lnTo>
                    <a:pt x="585450" y="62336"/>
                  </a:lnTo>
                  <a:lnTo>
                    <a:pt x="593803" y="106951"/>
                  </a:lnTo>
                  <a:lnTo>
                    <a:pt x="660727" y="622489"/>
                  </a:lnTo>
                  <a:lnTo>
                    <a:pt x="669089" y="717081"/>
                  </a:lnTo>
                  <a:lnTo>
                    <a:pt x="677443" y="750954"/>
                  </a:lnTo>
                  <a:lnTo>
                    <a:pt x="744366" y="976945"/>
                  </a:lnTo>
                  <a:lnTo>
                    <a:pt x="752719" y="1000618"/>
                  </a:lnTo>
                  <a:lnTo>
                    <a:pt x="761082" y="989836"/>
                  </a:lnTo>
                  <a:lnTo>
                    <a:pt x="828005" y="922700"/>
                  </a:lnTo>
                  <a:lnTo>
                    <a:pt x="836358" y="916119"/>
                  </a:lnTo>
                  <a:lnTo>
                    <a:pt x="844712" y="877746"/>
                  </a:lnTo>
                  <a:lnTo>
                    <a:pt x="911635" y="501030"/>
                  </a:lnTo>
                  <a:lnTo>
                    <a:pt x="919988" y="442962"/>
                  </a:lnTo>
                  <a:lnTo>
                    <a:pt x="928351" y="472402"/>
                  </a:lnTo>
                  <a:lnTo>
                    <a:pt x="995274" y="652965"/>
                  </a:lnTo>
                  <a:lnTo>
                    <a:pt x="1003627" y="670395"/>
                  </a:lnTo>
                  <a:lnTo>
                    <a:pt x="1011981" y="711633"/>
                  </a:lnTo>
                  <a:lnTo>
                    <a:pt x="1078904" y="1108431"/>
                  </a:lnTo>
                  <a:lnTo>
                    <a:pt x="1087267" y="1168318"/>
                  </a:lnTo>
                  <a:lnTo>
                    <a:pt x="1095620" y="1100301"/>
                  </a:lnTo>
                  <a:lnTo>
                    <a:pt x="1162543" y="524954"/>
                  </a:lnTo>
                  <a:lnTo>
                    <a:pt x="1170896" y="448856"/>
                  </a:lnTo>
                  <a:lnTo>
                    <a:pt x="1179259" y="421593"/>
                  </a:lnTo>
                  <a:lnTo>
                    <a:pt x="1246182" y="237604"/>
                  </a:lnTo>
                  <a:lnTo>
                    <a:pt x="1254536" y="218132"/>
                  </a:lnTo>
                  <a:lnTo>
                    <a:pt x="1262889" y="262738"/>
                  </a:lnTo>
                  <a:lnTo>
                    <a:pt x="1329812" y="827430"/>
                  </a:lnTo>
                  <a:lnTo>
                    <a:pt x="1338175" y="941901"/>
                  </a:lnTo>
                  <a:lnTo>
                    <a:pt x="1346528" y="940237"/>
                  </a:lnTo>
                  <a:lnTo>
                    <a:pt x="1413451" y="931468"/>
                  </a:lnTo>
                  <a:lnTo>
                    <a:pt x="1421805" y="930752"/>
                  </a:lnTo>
                  <a:lnTo>
                    <a:pt x="1430158" y="944776"/>
                  </a:lnTo>
                  <a:lnTo>
                    <a:pt x="1497091" y="1078109"/>
                  </a:lnTo>
                  <a:lnTo>
                    <a:pt x="1505444" y="1097998"/>
                  </a:lnTo>
                  <a:lnTo>
                    <a:pt x="1513797" y="1102721"/>
                  </a:lnTo>
                  <a:lnTo>
                    <a:pt x="1580720" y="1150849"/>
                  </a:lnTo>
                  <a:lnTo>
                    <a:pt x="1589074" y="1158524"/>
                  </a:lnTo>
                  <a:lnTo>
                    <a:pt x="1597437" y="1116376"/>
                  </a:lnTo>
                  <a:lnTo>
                    <a:pt x="1664360" y="893327"/>
                  </a:lnTo>
                  <a:lnTo>
                    <a:pt x="1672713" y="874533"/>
                  </a:lnTo>
                  <a:lnTo>
                    <a:pt x="1681066" y="870149"/>
                  </a:lnTo>
                  <a:lnTo>
                    <a:pt x="1747989" y="827923"/>
                  </a:lnTo>
                  <a:lnTo>
                    <a:pt x="1756352" y="821536"/>
                  </a:lnTo>
                  <a:lnTo>
                    <a:pt x="1764706" y="813668"/>
                  </a:lnTo>
                  <a:lnTo>
                    <a:pt x="1831629" y="746570"/>
                  </a:lnTo>
                  <a:lnTo>
                    <a:pt x="1839982" y="737647"/>
                  </a:lnTo>
                  <a:lnTo>
                    <a:pt x="1848345" y="738441"/>
                  </a:lnTo>
                  <a:lnTo>
                    <a:pt x="1915268" y="744906"/>
                  </a:lnTo>
                  <a:lnTo>
                    <a:pt x="1923621" y="745699"/>
                  </a:lnTo>
                  <a:lnTo>
                    <a:pt x="1931975" y="764184"/>
                  </a:lnTo>
                  <a:lnTo>
                    <a:pt x="1998898" y="878956"/>
                  </a:lnTo>
                  <a:lnTo>
                    <a:pt x="2007260" y="890182"/>
                  </a:lnTo>
                  <a:lnTo>
                    <a:pt x="2015614" y="843041"/>
                  </a:lnTo>
                  <a:lnTo>
                    <a:pt x="2082537" y="353363"/>
                  </a:lnTo>
                  <a:lnTo>
                    <a:pt x="2090890" y="273210"/>
                  </a:lnTo>
                  <a:lnTo>
                    <a:pt x="2099253" y="310644"/>
                  </a:lnTo>
                  <a:lnTo>
                    <a:pt x="2166176" y="568282"/>
                  </a:lnTo>
                  <a:lnTo>
                    <a:pt x="2174530" y="596029"/>
                  </a:lnTo>
                  <a:lnTo>
                    <a:pt x="2182883" y="629486"/>
                  </a:lnTo>
                  <a:lnTo>
                    <a:pt x="2249806" y="948637"/>
                  </a:lnTo>
                  <a:lnTo>
                    <a:pt x="2258159" y="996417"/>
                  </a:lnTo>
                  <a:lnTo>
                    <a:pt x="2266522" y="997404"/>
                  </a:lnTo>
                  <a:lnTo>
                    <a:pt x="2333445" y="1003753"/>
                  </a:lnTo>
                  <a:lnTo>
                    <a:pt x="2341799" y="1004392"/>
                  </a:lnTo>
                  <a:lnTo>
                    <a:pt x="2350152" y="997472"/>
                  </a:lnTo>
                  <a:lnTo>
                    <a:pt x="2417075" y="944853"/>
                  </a:lnTo>
                  <a:lnTo>
                    <a:pt x="2425438" y="938611"/>
                  </a:lnTo>
                  <a:lnTo>
                    <a:pt x="2433791" y="853822"/>
                  </a:lnTo>
                  <a:lnTo>
                    <a:pt x="2500714" y="213032"/>
                  </a:lnTo>
                  <a:lnTo>
                    <a:pt x="2509068" y="137340"/>
                  </a:lnTo>
                  <a:lnTo>
                    <a:pt x="2517430" y="217600"/>
                  </a:lnTo>
                  <a:lnTo>
                    <a:pt x="2584354" y="968816"/>
                  </a:lnTo>
                  <a:lnTo>
                    <a:pt x="2592707" y="1078980"/>
                  </a:lnTo>
                  <a:lnTo>
                    <a:pt x="2601060" y="1054147"/>
                  </a:lnTo>
                  <a:lnTo>
                    <a:pt x="2667983" y="852951"/>
                  </a:lnTo>
                  <a:lnTo>
                    <a:pt x="2676346" y="827507"/>
                  </a:lnTo>
                  <a:lnTo>
                    <a:pt x="2684699" y="823268"/>
                  </a:lnTo>
                  <a:lnTo>
                    <a:pt x="2751623" y="783279"/>
                  </a:lnTo>
                  <a:lnTo>
                    <a:pt x="2759976" y="777337"/>
                  </a:lnTo>
                  <a:lnTo>
                    <a:pt x="2768329" y="775188"/>
                  </a:lnTo>
                  <a:lnTo>
                    <a:pt x="2835262" y="762258"/>
                  </a:lnTo>
                  <a:lnTo>
                    <a:pt x="2843615" y="761010"/>
                  </a:lnTo>
                  <a:lnTo>
                    <a:pt x="2851968" y="738325"/>
                  </a:lnTo>
                  <a:lnTo>
                    <a:pt x="2918892" y="551801"/>
                  </a:lnTo>
                  <a:lnTo>
                    <a:pt x="2927245" y="527828"/>
                  </a:lnTo>
                  <a:lnTo>
                    <a:pt x="2935608" y="538339"/>
                  </a:lnTo>
                  <a:lnTo>
                    <a:pt x="3002531" y="618792"/>
                  </a:lnTo>
                  <a:lnTo>
                    <a:pt x="3010884" y="628431"/>
                  </a:lnTo>
                  <a:lnTo>
                    <a:pt x="3019238" y="628538"/>
                  </a:lnTo>
                  <a:lnTo>
                    <a:pt x="3086161" y="629747"/>
                  </a:lnTo>
                  <a:lnTo>
                    <a:pt x="3094523" y="629979"/>
                  </a:lnTo>
                  <a:lnTo>
                    <a:pt x="3102877" y="652055"/>
                  </a:lnTo>
                  <a:lnTo>
                    <a:pt x="3169800" y="777908"/>
                  </a:lnTo>
                  <a:lnTo>
                    <a:pt x="3178153" y="789289"/>
                  </a:lnTo>
                  <a:lnTo>
                    <a:pt x="3186516" y="825920"/>
                  </a:lnTo>
                  <a:lnTo>
                    <a:pt x="3253439" y="1192620"/>
                  </a:lnTo>
                  <a:lnTo>
                    <a:pt x="3261792" y="1250310"/>
                  </a:lnTo>
                  <a:lnTo>
                    <a:pt x="3270146" y="1252313"/>
                  </a:lnTo>
                  <a:lnTo>
                    <a:pt x="3337069" y="1286641"/>
                  </a:lnTo>
                  <a:lnTo>
                    <a:pt x="3345432" y="1296435"/>
                  </a:lnTo>
                  <a:lnTo>
                    <a:pt x="3353785" y="988781"/>
                  </a:lnTo>
                  <a:lnTo>
                    <a:pt x="3420708" y="86725"/>
                  </a:lnTo>
                  <a:lnTo>
                    <a:pt x="3429061" y="40677"/>
                  </a:lnTo>
                  <a:lnTo>
                    <a:pt x="3437424" y="66275"/>
                  </a:lnTo>
                  <a:lnTo>
                    <a:pt x="3504347" y="300889"/>
                  </a:lnTo>
                  <a:lnTo>
                    <a:pt x="3512701" y="334530"/>
                  </a:lnTo>
                  <a:lnTo>
                    <a:pt x="3521054" y="320129"/>
                  </a:lnTo>
                  <a:lnTo>
                    <a:pt x="3587977" y="220329"/>
                  </a:lnTo>
                  <a:lnTo>
                    <a:pt x="3596330" y="209509"/>
                  </a:lnTo>
                  <a:lnTo>
                    <a:pt x="3604693" y="253447"/>
                  </a:lnTo>
                  <a:lnTo>
                    <a:pt x="3671616" y="718214"/>
                  </a:lnTo>
                  <a:lnTo>
                    <a:pt x="3679970" y="795754"/>
                  </a:lnTo>
                  <a:lnTo>
                    <a:pt x="3688323" y="783318"/>
                  </a:lnTo>
                  <a:lnTo>
                    <a:pt x="3755246" y="696138"/>
                  </a:lnTo>
                  <a:lnTo>
                    <a:pt x="3763609" y="686567"/>
                  </a:lnTo>
                  <a:lnTo>
                    <a:pt x="3771962" y="697455"/>
                  </a:lnTo>
                  <a:lnTo>
                    <a:pt x="3838885" y="793025"/>
                  </a:lnTo>
                  <a:lnTo>
                    <a:pt x="3847239" y="806109"/>
                  </a:lnTo>
                  <a:lnTo>
                    <a:pt x="3855602" y="803158"/>
                  </a:lnTo>
                  <a:lnTo>
                    <a:pt x="3922525" y="782069"/>
                  </a:lnTo>
                  <a:lnTo>
                    <a:pt x="3930878" y="779679"/>
                  </a:lnTo>
                  <a:lnTo>
                    <a:pt x="3939231" y="800254"/>
                  </a:lnTo>
                  <a:lnTo>
                    <a:pt x="4006154" y="944853"/>
                  </a:lnTo>
                  <a:lnTo>
                    <a:pt x="4014517" y="960764"/>
                  </a:lnTo>
                  <a:lnTo>
                    <a:pt x="4022871" y="978949"/>
                  </a:lnTo>
                  <a:lnTo>
                    <a:pt x="4089755" y="1197991"/>
                  </a:lnTo>
                  <a:lnTo>
                    <a:pt x="4098147" y="1240032"/>
                  </a:lnTo>
                  <a:lnTo>
                    <a:pt x="4106500" y="1123402"/>
                  </a:lnTo>
                  <a:lnTo>
                    <a:pt x="4173394" y="526618"/>
                  </a:lnTo>
                  <a:lnTo>
                    <a:pt x="4181787" y="477890"/>
                  </a:lnTo>
                  <a:lnTo>
                    <a:pt x="4190140" y="521595"/>
                  </a:lnTo>
                  <a:lnTo>
                    <a:pt x="4257024" y="957899"/>
                  </a:lnTo>
                  <a:lnTo>
                    <a:pt x="4265416" y="1026361"/>
                  </a:lnTo>
                  <a:lnTo>
                    <a:pt x="4273779" y="920465"/>
                  </a:lnTo>
                  <a:lnTo>
                    <a:pt x="4340664" y="138105"/>
                  </a:lnTo>
                  <a:lnTo>
                    <a:pt x="4349055" y="47751"/>
                  </a:lnTo>
                  <a:lnTo>
                    <a:pt x="4357409" y="136286"/>
                  </a:lnTo>
                  <a:lnTo>
                    <a:pt x="4424303" y="838356"/>
                  </a:lnTo>
                  <a:lnTo>
                    <a:pt x="4432695" y="925381"/>
                  </a:lnTo>
                  <a:lnTo>
                    <a:pt x="4441048" y="897595"/>
                  </a:lnTo>
                  <a:lnTo>
                    <a:pt x="4507932" y="662943"/>
                  </a:lnTo>
                  <a:lnTo>
                    <a:pt x="4516324" y="631944"/>
                  </a:lnTo>
                  <a:lnTo>
                    <a:pt x="4524687" y="661540"/>
                  </a:lnTo>
                  <a:lnTo>
                    <a:pt x="4591572" y="925574"/>
                  </a:lnTo>
                  <a:lnTo>
                    <a:pt x="4599964" y="962390"/>
                  </a:lnTo>
                  <a:lnTo>
                    <a:pt x="4608317" y="918809"/>
                  </a:lnTo>
                  <a:lnTo>
                    <a:pt x="4675201" y="577621"/>
                  </a:lnTo>
                  <a:lnTo>
                    <a:pt x="4683603" y="535880"/>
                  </a:lnTo>
                  <a:lnTo>
                    <a:pt x="4691956" y="521973"/>
                  </a:lnTo>
                  <a:lnTo>
                    <a:pt x="4758840" y="422619"/>
                  </a:lnTo>
                  <a:lnTo>
                    <a:pt x="4767232" y="411508"/>
                  </a:lnTo>
                  <a:lnTo>
                    <a:pt x="4775595" y="431203"/>
                  </a:lnTo>
                  <a:lnTo>
                    <a:pt x="4842480" y="637161"/>
                  </a:lnTo>
                  <a:lnTo>
                    <a:pt x="4850872" y="671150"/>
                  </a:lnTo>
                  <a:lnTo>
                    <a:pt x="4859225" y="735944"/>
                  </a:lnTo>
                  <a:lnTo>
                    <a:pt x="4926109" y="1074858"/>
                  </a:lnTo>
                  <a:lnTo>
                    <a:pt x="4934501" y="1103069"/>
                  </a:lnTo>
                  <a:lnTo>
                    <a:pt x="4942864" y="1091649"/>
                  </a:lnTo>
                  <a:lnTo>
                    <a:pt x="5009749" y="988588"/>
                  </a:lnTo>
                  <a:lnTo>
                    <a:pt x="5018141" y="974042"/>
                  </a:lnTo>
                  <a:lnTo>
                    <a:pt x="5026494" y="964809"/>
                  </a:lnTo>
                  <a:lnTo>
                    <a:pt x="5093388" y="877262"/>
                  </a:lnTo>
                  <a:lnTo>
                    <a:pt x="5101780" y="864216"/>
                  </a:lnTo>
                  <a:lnTo>
                    <a:pt x="5110134" y="840437"/>
                  </a:lnTo>
                  <a:lnTo>
                    <a:pt x="5177018" y="703165"/>
                  </a:lnTo>
                  <a:lnTo>
                    <a:pt x="5185410" y="690612"/>
                  </a:lnTo>
                  <a:lnTo>
                    <a:pt x="5193773" y="731366"/>
                  </a:lnTo>
                  <a:lnTo>
                    <a:pt x="5260657" y="1085523"/>
                  </a:lnTo>
                  <a:lnTo>
                    <a:pt x="5269049" y="1133613"/>
                  </a:lnTo>
                  <a:lnTo>
                    <a:pt x="5277403" y="1112776"/>
                  </a:lnTo>
                  <a:lnTo>
                    <a:pt x="5344287" y="919748"/>
                  </a:lnTo>
                  <a:lnTo>
                    <a:pt x="5352650" y="891779"/>
                  </a:lnTo>
                  <a:lnTo>
                    <a:pt x="5361042" y="901718"/>
                  </a:lnTo>
                  <a:lnTo>
                    <a:pt x="5427926" y="1098336"/>
                  </a:lnTo>
                  <a:lnTo>
                    <a:pt x="5436280" y="1166082"/>
                  </a:lnTo>
                  <a:lnTo>
                    <a:pt x="5444672" y="1247252"/>
                  </a:lnTo>
                  <a:lnTo>
                    <a:pt x="5511566" y="1514906"/>
                  </a:lnTo>
                  <a:lnTo>
                    <a:pt x="5519919" y="1529917"/>
                  </a:lnTo>
                  <a:lnTo>
                    <a:pt x="5528311" y="1438431"/>
                  </a:lnTo>
                  <a:lnTo>
                    <a:pt x="5595195" y="931768"/>
                  </a:lnTo>
                  <a:lnTo>
                    <a:pt x="5603558" y="887279"/>
                  </a:lnTo>
                  <a:lnTo>
                    <a:pt x="5611950" y="816804"/>
                  </a:lnTo>
                  <a:lnTo>
                    <a:pt x="5678835" y="255519"/>
                  </a:lnTo>
                  <a:lnTo>
                    <a:pt x="5687188" y="185701"/>
                  </a:lnTo>
                  <a:lnTo>
                    <a:pt x="5695580" y="254541"/>
                  </a:lnTo>
                  <a:lnTo>
                    <a:pt x="5762474" y="1036339"/>
                  </a:lnTo>
                  <a:lnTo>
                    <a:pt x="5770827" y="1177009"/>
                  </a:lnTo>
                  <a:lnTo>
                    <a:pt x="5779219" y="1161476"/>
                  </a:lnTo>
                  <a:lnTo>
                    <a:pt x="5846103" y="1070744"/>
                  </a:lnTo>
                  <a:lnTo>
                    <a:pt x="5854457" y="1062383"/>
                  </a:lnTo>
                  <a:lnTo>
                    <a:pt x="5862858" y="1087681"/>
                  </a:lnTo>
                  <a:lnTo>
                    <a:pt x="5929743" y="1417633"/>
                  </a:lnTo>
                  <a:lnTo>
                    <a:pt x="5938096" y="1486821"/>
                  </a:lnTo>
                  <a:lnTo>
                    <a:pt x="5946488" y="1398248"/>
                  </a:lnTo>
                  <a:lnTo>
                    <a:pt x="6013372" y="951395"/>
                  </a:lnTo>
                  <a:lnTo>
                    <a:pt x="6021735" y="915364"/>
                  </a:lnTo>
                  <a:lnTo>
                    <a:pt x="6030127" y="928255"/>
                  </a:lnTo>
                  <a:lnTo>
                    <a:pt x="6097011" y="1045185"/>
                  </a:lnTo>
                  <a:lnTo>
                    <a:pt x="6105365" y="1061783"/>
                  </a:lnTo>
                  <a:lnTo>
                    <a:pt x="6113767" y="1043336"/>
                  </a:lnTo>
                  <a:lnTo>
                    <a:pt x="6180651" y="916080"/>
                  </a:lnTo>
                  <a:lnTo>
                    <a:pt x="6189004" y="902318"/>
                  </a:lnTo>
                  <a:lnTo>
                    <a:pt x="6197396" y="930036"/>
                  </a:lnTo>
                  <a:lnTo>
                    <a:pt x="6264280" y="1212740"/>
                  </a:lnTo>
                  <a:lnTo>
                    <a:pt x="6272644" y="1258101"/>
                  </a:lnTo>
                  <a:lnTo>
                    <a:pt x="6281036" y="1164766"/>
                  </a:lnTo>
                  <a:lnTo>
                    <a:pt x="6347920" y="531003"/>
                  </a:lnTo>
                  <a:lnTo>
                    <a:pt x="6356273" y="463527"/>
                  </a:lnTo>
                  <a:lnTo>
                    <a:pt x="6364665" y="531874"/>
                  </a:lnTo>
                  <a:lnTo>
                    <a:pt x="6431560" y="1031994"/>
                  </a:lnTo>
                  <a:lnTo>
                    <a:pt x="6439913" y="1089229"/>
                  </a:lnTo>
                  <a:lnTo>
                    <a:pt x="6448305" y="1099053"/>
                  </a:lnTo>
                  <a:lnTo>
                    <a:pt x="6515189" y="1187180"/>
                  </a:lnTo>
                  <a:lnTo>
                    <a:pt x="6523542" y="1199578"/>
                  </a:lnTo>
                  <a:lnTo>
                    <a:pt x="6531944" y="1184538"/>
                  </a:lnTo>
                  <a:lnTo>
                    <a:pt x="6598829" y="1049985"/>
                  </a:lnTo>
                  <a:lnTo>
                    <a:pt x="6607182" y="1031161"/>
                  </a:lnTo>
                  <a:lnTo>
                    <a:pt x="6615535" y="1061250"/>
                  </a:lnTo>
                  <a:lnTo>
                    <a:pt x="6682458" y="1229028"/>
                  </a:lnTo>
                  <a:lnTo>
                    <a:pt x="6690821" y="1243884"/>
                  </a:lnTo>
                  <a:lnTo>
                    <a:pt x="6699174" y="1209527"/>
                  </a:lnTo>
                  <a:lnTo>
                    <a:pt x="6766097" y="865503"/>
                  </a:lnTo>
                  <a:lnTo>
                    <a:pt x="6774451" y="811326"/>
                  </a:lnTo>
                  <a:lnTo>
                    <a:pt x="6782814" y="825049"/>
                  </a:lnTo>
                  <a:lnTo>
                    <a:pt x="6849737" y="952605"/>
                  </a:lnTo>
                  <a:lnTo>
                    <a:pt x="6858090" y="971167"/>
                  </a:lnTo>
                  <a:lnTo>
                    <a:pt x="6866443" y="937140"/>
                  </a:lnTo>
                  <a:lnTo>
                    <a:pt x="6933366" y="753674"/>
                  </a:lnTo>
                  <a:lnTo>
                    <a:pt x="6941729" y="737986"/>
                  </a:lnTo>
                  <a:lnTo>
                    <a:pt x="6950083" y="803012"/>
                  </a:lnTo>
                  <a:lnTo>
                    <a:pt x="7017006" y="1436728"/>
                  </a:lnTo>
                  <a:lnTo>
                    <a:pt x="7025359" y="1533585"/>
                  </a:lnTo>
                  <a:lnTo>
                    <a:pt x="7033712" y="1429430"/>
                  </a:lnTo>
                  <a:lnTo>
                    <a:pt x="7100645" y="538493"/>
                  </a:lnTo>
                  <a:lnTo>
                    <a:pt x="7108998" y="419367"/>
                  </a:lnTo>
                  <a:lnTo>
                    <a:pt x="7117351" y="442391"/>
                  </a:lnTo>
                  <a:lnTo>
                    <a:pt x="7184274" y="633686"/>
                  </a:lnTo>
                  <a:lnTo>
                    <a:pt x="7192628" y="658597"/>
                  </a:lnTo>
                  <a:lnTo>
                    <a:pt x="7200991" y="639125"/>
                  </a:lnTo>
                  <a:lnTo>
                    <a:pt x="7267914" y="495320"/>
                  </a:lnTo>
                  <a:lnTo>
                    <a:pt x="7276267" y="478683"/>
                  </a:lnTo>
                  <a:lnTo>
                    <a:pt x="7284620" y="509943"/>
                  </a:lnTo>
                  <a:lnTo>
                    <a:pt x="7351543" y="774356"/>
                  </a:lnTo>
                  <a:lnTo>
                    <a:pt x="7359906" y="809284"/>
                  </a:lnTo>
                  <a:lnTo>
                    <a:pt x="7368260" y="774617"/>
                  </a:lnTo>
                  <a:lnTo>
                    <a:pt x="7435183" y="542984"/>
                  </a:lnTo>
                  <a:lnTo>
                    <a:pt x="7443536" y="518760"/>
                  </a:lnTo>
                  <a:lnTo>
                    <a:pt x="7451899" y="538000"/>
                  </a:lnTo>
                  <a:lnTo>
                    <a:pt x="7518822" y="722937"/>
                  </a:lnTo>
                  <a:lnTo>
                    <a:pt x="7527175" y="750877"/>
                  </a:lnTo>
                  <a:lnTo>
                    <a:pt x="7535528" y="661578"/>
                  </a:lnTo>
                  <a:lnTo>
                    <a:pt x="7602452" y="62907"/>
                  </a:lnTo>
                  <a:lnTo>
                    <a:pt x="7610815" y="0"/>
                  </a:lnTo>
                  <a:lnTo>
                    <a:pt x="7619168" y="90015"/>
                  </a:lnTo>
                  <a:lnTo>
                    <a:pt x="7686091" y="871358"/>
                  </a:lnTo>
                  <a:lnTo>
                    <a:pt x="7694444" y="977400"/>
                  </a:lnTo>
                  <a:lnTo>
                    <a:pt x="7702798" y="912345"/>
                  </a:lnTo>
                  <a:lnTo>
                    <a:pt x="7769731" y="270829"/>
                  </a:lnTo>
                  <a:lnTo>
                    <a:pt x="7778084" y="171523"/>
                  </a:lnTo>
                  <a:lnTo>
                    <a:pt x="7786437" y="306260"/>
                  </a:lnTo>
                  <a:lnTo>
                    <a:pt x="7853360" y="964780"/>
                  </a:lnTo>
                  <a:lnTo>
                    <a:pt x="7861713" y="1016383"/>
                  </a:lnTo>
                  <a:lnTo>
                    <a:pt x="7870077" y="1007189"/>
                  </a:lnTo>
                  <a:lnTo>
                    <a:pt x="7937000" y="904292"/>
                  </a:lnTo>
                  <a:lnTo>
                    <a:pt x="7945353" y="886030"/>
                  </a:lnTo>
                  <a:lnTo>
                    <a:pt x="7953706" y="908222"/>
                  </a:lnTo>
                  <a:lnTo>
                    <a:pt x="8020629" y="1077587"/>
                  </a:lnTo>
                  <a:lnTo>
                    <a:pt x="8028992" y="1097775"/>
                  </a:lnTo>
                  <a:lnTo>
                    <a:pt x="8037346" y="1091387"/>
                  </a:lnTo>
                  <a:lnTo>
                    <a:pt x="8104268" y="1032865"/>
                  </a:lnTo>
                  <a:lnTo>
                    <a:pt x="8112622" y="1024464"/>
                  </a:lnTo>
                  <a:lnTo>
                    <a:pt x="8120985" y="1046733"/>
                  </a:lnTo>
                  <a:lnTo>
                    <a:pt x="8187908" y="1164573"/>
                  </a:lnTo>
                  <a:lnTo>
                    <a:pt x="8196261" y="1174473"/>
                  </a:lnTo>
                  <a:lnTo>
                    <a:pt x="8204614" y="1099856"/>
                  </a:lnTo>
                  <a:lnTo>
                    <a:pt x="8271537" y="322055"/>
                  </a:lnTo>
                  <a:lnTo>
                    <a:pt x="8279900" y="194431"/>
                  </a:lnTo>
                  <a:lnTo>
                    <a:pt x="8288254" y="262438"/>
                  </a:lnTo>
                  <a:lnTo>
                    <a:pt x="8355177" y="812081"/>
                  </a:lnTo>
                  <a:lnTo>
                    <a:pt x="8363530" y="881491"/>
                  </a:lnTo>
                  <a:lnTo>
                    <a:pt x="8363530" y="1240564"/>
                  </a:lnTo>
                  <a:lnTo>
                    <a:pt x="8355177" y="1156298"/>
                  </a:lnTo>
                  <a:lnTo>
                    <a:pt x="8288254" y="488894"/>
                  </a:lnTo>
                  <a:lnTo>
                    <a:pt x="8279900" y="406321"/>
                  </a:lnTo>
                  <a:lnTo>
                    <a:pt x="8271537" y="532629"/>
                  </a:lnTo>
                  <a:lnTo>
                    <a:pt x="8204614" y="1302445"/>
                  </a:lnTo>
                  <a:lnTo>
                    <a:pt x="8196261" y="1376317"/>
                  </a:lnTo>
                  <a:lnTo>
                    <a:pt x="8187908" y="1359342"/>
                  </a:lnTo>
                  <a:lnTo>
                    <a:pt x="8120985" y="1157885"/>
                  </a:lnTo>
                  <a:lnTo>
                    <a:pt x="8112622" y="1119812"/>
                  </a:lnTo>
                  <a:lnTo>
                    <a:pt x="8104268" y="1135277"/>
                  </a:lnTo>
                  <a:lnTo>
                    <a:pt x="8037346" y="1242713"/>
                  </a:lnTo>
                  <a:lnTo>
                    <a:pt x="8028992" y="1254433"/>
                  </a:lnTo>
                  <a:lnTo>
                    <a:pt x="8020629" y="1235232"/>
                  </a:lnTo>
                  <a:lnTo>
                    <a:pt x="7953706" y="1073957"/>
                  </a:lnTo>
                  <a:lnTo>
                    <a:pt x="7945353" y="1052821"/>
                  </a:lnTo>
                  <a:lnTo>
                    <a:pt x="7937000" y="1074258"/>
                  </a:lnTo>
                  <a:lnTo>
                    <a:pt x="7870077" y="1195078"/>
                  </a:lnTo>
                  <a:lnTo>
                    <a:pt x="7861713" y="1205859"/>
                  </a:lnTo>
                  <a:lnTo>
                    <a:pt x="7853360" y="1169334"/>
                  </a:lnTo>
                  <a:lnTo>
                    <a:pt x="7786437" y="703397"/>
                  </a:lnTo>
                  <a:lnTo>
                    <a:pt x="7778084" y="608049"/>
                  </a:lnTo>
                  <a:lnTo>
                    <a:pt x="7769731" y="678031"/>
                  </a:lnTo>
                  <a:lnTo>
                    <a:pt x="7702798" y="1130022"/>
                  </a:lnTo>
                  <a:lnTo>
                    <a:pt x="7694444" y="1175876"/>
                  </a:lnTo>
                  <a:lnTo>
                    <a:pt x="7686091" y="1084429"/>
                  </a:lnTo>
                  <a:lnTo>
                    <a:pt x="7619168" y="410860"/>
                  </a:lnTo>
                  <a:lnTo>
                    <a:pt x="7610815" y="333252"/>
                  </a:lnTo>
                  <a:lnTo>
                    <a:pt x="7602452" y="398385"/>
                  </a:lnTo>
                  <a:lnTo>
                    <a:pt x="7535528" y="1018038"/>
                  </a:lnTo>
                  <a:lnTo>
                    <a:pt x="7527175" y="1110434"/>
                  </a:lnTo>
                  <a:lnTo>
                    <a:pt x="7518822" y="1056450"/>
                  </a:lnTo>
                  <a:lnTo>
                    <a:pt x="7451899" y="698742"/>
                  </a:lnTo>
                  <a:lnTo>
                    <a:pt x="7443536" y="661578"/>
                  </a:lnTo>
                  <a:lnTo>
                    <a:pt x="7435183" y="685512"/>
                  </a:lnTo>
                  <a:lnTo>
                    <a:pt x="7368260" y="914116"/>
                  </a:lnTo>
                  <a:lnTo>
                    <a:pt x="7359906" y="948366"/>
                  </a:lnTo>
                  <a:lnTo>
                    <a:pt x="7351543" y="977323"/>
                  </a:lnTo>
                  <a:lnTo>
                    <a:pt x="7284620" y="1196220"/>
                  </a:lnTo>
                  <a:lnTo>
                    <a:pt x="7276267" y="1222070"/>
                  </a:lnTo>
                  <a:lnTo>
                    <a:pt x="7267914" y="1169983"/>
                  </a:lnTo>
                  <a:lnTo>
                    <a:pt x="7200991" y="719501"/>
                  </a:lnTo>
                  <a:lnTo>
                    <a:pt x="7192628" y="658597"/>
                  </a:lnTo>
                  <a:lnTo>
                    <a:pt x="7184274" y="661123"/>
                  </a:lnTo>
                  <a:lnTo>
                    <a:pt x="7117351" y="680789"/>
                  </a:lnTo>
                  <a:lnTo>
                    <a:pt x="7108998" y="683170"/>
                  </a:lnTo>
                  <a:lnTo>
                    <a:pt x="7100645" y="781198"/>
                  </a:lnTo>
                  <a:lnTo>
                    <a:pt x="7033712" y="1514568"/>
                  </a:lnTo>
                  <a:lnTo>
                    <a:pt x="7025359" y="1600305"/>
                  </a:lnTo>
                  <a:lnTo>
                    <a:pt x="7017006" y="1502286"/>
                  </a:lnTo>
                  <a:lnTo>
                    <a:pt x="6950083" y="861003"/>
                  </a:lnTo>
                  <a:lnTo>
                    <a:pt x="6941729" y="795183"/>
                  </a:lnTo>
                  <a:lnTo>
                    <a:pt x="6933366" y="828978"/>
                  </a:lnTo>
                  <a:lnTo>
                    <a:pt x="6866443" y="1223928"/>
                  </a:lnTo>
                  <a:lnTo>
                    <a:pt x="6858090" y="1297229"/>
                  </a:lnTo>
                  <a:lnTo>
                    <a:pt x="6849737" y="1283167"/>
                  </a:lnTo>
                  <a:lnTo>
                    <a:pt x="6782814" y="1186609"/>
                  </a:lnTo>
                  <a:lnTo>
                    <a:pt x="6774451" y="1176254"/>
                  </a:lnTo>
                  <a:lnTo>
                    <a:pt x="6766097" y="1203923"/>
                  </a:lnTo>
                  <a:lnTo>
                    <a:pt x="6699174" y="1379569"/>
                  </a:lnTo>
                  <a:lnTo>
                    <a:pt x="6690821" y="1397106"/>
                  </a:lnTo>
                  <a:lnTo>
                    <a:pt x="6682458" y="1379753"/>
                  </a:lnTo>
                  <a:lnTo>
                    <a:pt x="6615535" y="1183328"/>
                  </a:lnTo>
                  <a:lnTo>
                    <a:pt x="6607182" y="1148130"/>
                  </a:lnTo>
                  <a:lnTo>
                    <a:pt x="6598829" y="1183629"/>
                  </a:lnTo>
                  <a:lnTo>
                    <a:pt x="6531944" y="1437444"/>
                  </a:lnTo>
                  <a:lnTo>
                    <a:pt x="6523542" y="1465839"/>
                  </a:lnTo>
                  <a:lnTo>
                    <a:pt x="6515189" y="1455629"/>
                  </a:lnTo>
                  <a:lnTo>
                    <a:pt x="6448305" y="1383160"/>
                  </a:lnTo>
                  <a:lnTo>
                    <a:pt x="6439913" y="1375069"/>
                  </a:lnTo>
                  <a:lnTo>
                    <a:pt x="6431560" y="1308078"/>
                  </a:lnTo>
                  <a:lnTo>
                    <a:pt x="6364665" y="722598"/>
                  </a:lnTo>
                  <a:lnTo>
                    <a:pt x="6356273" y="642638"/>
                  </a:lnTo>
                  <a:lnTo>
                    <a:pt x="6347920" y="706532"/>
                  </a:lnTo>
                  <a:lnTo>
                    <a:pt x="6281036" y="1306868"/>
                  </a:lnTo>
                  <a:lnTo>
                    <a:pt x="6272644" y="1395257"/>
                  </a:lnTo>
                  <a:lnTo>
                    <a:pt x="6264280" y="1346112"/>
                  </a:lnTo>
                  <a:lnTo>
                    <a:pt x="6197396" y="1039591"/>
                  </a:lnTo>
                  <a:lnTo>
                    <a:pt x="6189004" y="1009531"/>
                  </a:lnTo>
                  <a:lnTo>
                    <a:pt x="6180651" y="1018154"/>
                  </a:lnTo>
                  <a:lnTo>
                    <a:pt x="6113767" y="1097882"/>
                  </a:lnTo>
                  <a:lnTo>
                    <a:pt x="6105365" y="1109456"/>
                  </a:lnTo>
                  <a:lnTo>
                    <a:pt x="6097011" y="1135384"/>
                  </a:lnTo>
                  <a:lnTo>
                    <a:pt x="6030127" y="1318172"/>
                  </a:lnTo>
                  <a:lnTo>
                    <a:pt x="6021735" y="1338322"/>
                  </a:lnTo>
                  <a:lnTo>
                    <a:pt x="6013372" y="1348909"/>
                  </a:lnTo>
                  <a:lnTo>
                    <a:pt x="5946488" y="1480395"/>
                  </a:lnTo>
                  <a:lnTo>
                    <a:pt x="5938096" y="1506438"/>
                  </a:lnTo>
                  <a:lnTo>
                    <a:pt x="5929743" y="1456838"/>
                  </a:lnTo>
                  <a:lnTo>
                    <a:pt x="5862858" y="1220260"/>
                  </a:lnTo>
                  <a:lnTo>
                    <a:pt x="5854457" y="1202114"/>
                  </a:lnTo>
                  <a:lnTo>
                    <a:pt x="5846103" y="1216253"/>
                  </a:lnTo>
                  <a:lnTo>
                    <a:pt x="5779219" y="1369775"/>
                  </a:lnTo>
                  <a:lnTo>
                    <a:pt x="5770827" y="1396090"/>
                  </a:lnTo>
                  <a:lnTo>
                    <a:pt x="5762474" y="1279160"/>
                  </a:lnTo>
                  <a:lnTo>
                    <a:pt x="5695580" y="629370"/>
                  </a:lnTo>
                  <a:lnTo>
                    <a:pt x="5687188" y="572134"/>
                  </a:lnTo>
                  <a:lnTo>
                    <a:pt x="5678835" y="619169"/>
                  </a:lnTo>
                  <a:lnTo>
                    <a:pt x="5611950" y="997095"/>
                  </a:lnTo>
                  <a:lnTo>
                    <a:pt x="5603558" y="1044546"/>
                  </a:lnTo>
                  <a:lnTo>
                    <a:pt x="5595195" y="1080722"/>
                  </a:lnTo>
                  <a:lnTo>
                    <a:pt x="5528311" y="1492676"/>
                  </a:lnTo>
                  <a:lnTo>
                    <a:pt x="5519919" y="1567042"/>
                  </a:lnTo>
                  <a:lnTo>
                    <a:pt x="5511566" y="1555099"/>
                  </a:lnTo>
                  <a:lnTo>
                    <a:pt x="5444672" y="1342028"/>
                  </a:lnTo>
                  <a:lnTo>
                    <a:pt x="5436280" y="1277457"/>
                  </a:lnTo>
                  <a:lnTo>
                    <a:pt x="5427926" y="1193036"/>
                  </a:lnTo>
                  <a:lnTo>
                    <a:pt x="5361042" y="948027"/>
                  </a:lnTo>
                  <a:lnTo>
                    <a:pt x="5352650" y="935630"/>
                  </a:lnTo>
                  <a:lnTo>
                    <a:pt x="5344287" y="969309"/>
                  </a:lnTo>
                  <a:lnTo>
                    <a:pt x="5277403" y="1201736"/>
                  </a:lnTo>
                  <a:lnTo>
                    <a:pt x="5269049" y="1226879"/>
                  </a:lnTo>
                  <a:lnTo>
                    <a:pt x="5260657" y="1210011"/>
                  </a:lnTo>
                  <a:lnTo>
                    <a:pt x="5193773" y="1085900"/>
                  </a:lnTo>
                  <a:lnTo>
                    <a:pt x="5185410" y="1071615"/>
                  </a:lnTo>
                  <a:lnTo>
                    <a:pt x="5177018" y="1072554"/>
                  </a:lnTo>
                  <a:lnTo>
                    <a:pt x="5110134" y="1082726"/>
                  </a:lnTo>
                  <a:lnTo>
                    <a:pt x="5101780" y="1084468"/>
                  </a:lnTo>
                  <a:lnTo>
                    <a:pt x="5093388" y="1111044"/>
                  </a:lnTo>
                  <a:lnTo>
                    <a:pt x="5026494" y="1289370"/>
                  </a:lnTo>
                  <a:lnTo>
                    <a:pt x="5018141" y="1308117"/>
                  </a:lnTo>
                  <a:lnTo>
                    <a:pt x="5009749" y="1317040"/>
                  </a:lnTo>
                  <a:lnTo>
                    <a:pt x="4942864" y="1380208"/>
                  </a:lnTo>
                  <a:lnTo>
                    <a:pt x="4934501" y="1387205"/>
                  </a:lnTo>
                  <a:lnTo>
                    <a:pt x="4926109" y="1350119"/>
                  </a:lnTo>
                  <a:lnTo>
                    <a:pt x="4859225" y="904699"/>
                  </a:lnTo>
                  <a:lnTo>
                    <a:pt x="4850872" y="819533"/>
                  </a:lnTo>
                  <a:lnTo>
                    <a:pt x="4842480" y="810339"/>
                  </a:lnTo>
                  <a:lnTo>
                    <a:pt x="4775595" y="754768"/>
                  </a:lnTo>
                  <a:lnTo>
                    <a:pt x="4767232" y="749474"/>
                  </a:lnTo>
                  <a:lnTo>
                    <a:pt x="4758840" y="742293"/>
                  </a:lnTo>
                  <a:lnTo>
                    <a:pt x="4691956" y="677953"/>
                  </a:lnTo>
                  <a:lnTo>
                    <a:pt x="4683603" y="668914"/>
                  </a:lnTo>
                  <a:lnTo>
                    <a:pt x="4675201" y="730466"/>
                  </a:lnTo>
                  <a:lnTo>
                    <a:pt x="4608317" y="1233867"/>
                  </a:lnTo>
                  <a:lnTo>
                    <a:pt x="4599964" y="1298177"/>
                  </a:lnTo>
                  <a:lnTo>
                    <a:pt x="4591572" y="1229860"/>
                  </a:lnTo>
                  <a:lnTo>
                    <a:pt x="4524687" y="740028"/>
                  </a:lnTo>
                  <a:lnTo>
                    <a:pt x="4516324" y="685096"/>
                  </a:lnTo>
                  <a:lnTo>
                    <a:pt x="4507932" y="722482"/>
                  </a:lnTo>
                  <a:lnTo>
                    <a:pt x="4441048" y="1005563"/>
                  </a:lnTo>
                  <a:lnTo>
                    <a:pt x="4432695" y="1039059"/>
                  </a:lnTo>
                  <a:lnTo>
                    <a:pt x="4424303" y="946324"/>
                  </a:lnTo>
                  <a:lnTo>
                    <a:pt x="4357409" y="198176"/>
                  </a:lnTo>
                  <a:lnTo>
                    <a:pt x="4349055" y="103845"/>
                  </a:lnTo>
                  <a:lnTo>
                    <a:pt x="4340664" y="216700"/>
                  </a:lnTo>
                  <a:lnTo>
                    <a:pt x="4273779" y="1193829"/>
                  </a:lnTo>
                  <a:lnTo>
                    <a:pt x="4265416" y="1326108"/>
                  </a:lnTo>
                  <a:lnTo>
                    <a:pt x="4257024" y="1250010"/>
                  </a:lnTo>
                  <a:lnTo>
                    <a:pt x="4190140" y="765094"/>
                  </a:lnTo>
                  <a:lnTo>
                    <a:pt x="4181787" y="716510"/>
                  </a:lnTo>
                  <a:lnTo>
                    <a:pt x="4173394" y="763991"/>
                  </a:lnTo>
                  <a:lnTo>
                    <a:pt x="4106500" y="1345203"/>
                  </a:lnTo>
                  <a:lnTo>
                    <a:pt x="4098147" y="1458803"/>
                  </a:lnTo>
                  <a:lnTo>
                    <a:pt x="4089755" y="1406561"/>
                  </a:lnTo>
                  <a:lnTo>
                    <a:pt x="4022871" y="1134484"/>
                  </a:lnTo>
                  <a:lnTo>
                    <a:pt x="4014517" y="1111915"/>
                  </a:lnTo>
                  <a:lnTo>
                    <a:pt x="4006154" y="1088581"/>
                  </a:lnTo>
                  <a:lnTo>
                    <a:pt x="3939231" y="876807"/>
                  </a:lnTo>
                  <a:lnTo>
                    <a:pt x="3930878" y="846709"/>
                  </a:lnTo>
                  <a:lnTo>
                    <a:pt x="3922525" y="871097"/>
                  </a:lnTo>
                  <a:lnTo>
                    <a:pt x="3855602" y="1088020"/>
                  </a:lnTo>
                  <a:lnTo>
                    <a:pt x="3847239" y="1118186"/>
                  </a:lnTo>
                  <a:lnTo>
                    <a:pt x="3838885" y="1093991"/>
                  </a:lnTo>
                  <a:lnTo>
                    <a:pt x="3771962" y="917329"/>
                  </a:lnTo>
                  <a:lnTo>
                    <a:pt x="3763609" y="897141"/>
                  </a:lnTo>
                  <a:lnTo>
                    <a:pt x="3755246" y="898166"/>
                  </a:lnTo>
                  <a:lnTo>
                    <a:pt x="3688323" y="907535"/>
                  </a:lnTo>
                  <a:lnTo>
                    <a:pt x="3679970" y="908861"/>
                  </a:lnTo>
                  <a:lnTo>
                    <a:pt x="3671616" y="882817"/>
                  </a:lnTo>
                  <a:lnTo>
                    <a:pt x="3604693" y="726682"/>
                  </a:lnTo>
                  <a:lnTo>
                    <a:pt x="3596330" y="711933"/>
                  </a:lnTo>
                  <a:lnTo>
                    <a:pt x="3587977" y="724717"/>
                  </a:lnTo>
                  <a:lnTo>
                    <a:pt x="3521054" y="842741"/>
                  </a:lnTo>
                  <a:lnTo>
                    <a:pt x="3512701" y="859793"/>
                  </a:lnTo>
                  <a:lnTo>
                    <a:pt x="3504347" y="802103"/>
                  </a:lnTo>
                  <a:lnTo>
                    <a:pt x="3437424" y="400204"/>
                  </a:lnTo>
                  <a:lnTo>
                    <a:pt x="3429061" y="356344"/>
                  </a:lnTo>
                  <a:lnTo>
                    <a:pt x="3420708" y="390826"/>
                  </a:lnTo>
                  <a:lnTo>
                    <a:pt x="3353785" y="1066128"/>
                  </a:lnTo>
                  <a:lnTo>
                    <a:pt x="3345432" y="1296435"/>
                  </a:lnTo>
                  <a:lnTo>
                    <a:pt x="3337069" y="1308571"/>
                  </a:lnTo>
                  <a:lnTo>
                    <a:pt x="3270146" y="1351067"/>
                  </a:lnTo>
                  <a:lnTo>
                    <a:pt x="3261792" y="1353555"/>
                  </a:lnTo>
                  <a:lnTo>
                    <a:pt x="3253439" y="1299803"/>
                  </a:lnTo>
                  <a:lnTo>
                    <a:pt x="3186516" y="957928"/>
                  </a:lnTo>
                  <a:lnTo>
                    <a:pt x="3178153" y="923755"/>
                  </a:lnTo>
                  <a:lnTo>
                    <a:pt x="3169800" y="915364"/>
                  </a:lnTo>
                  <a:lnTo>
                    <a:pt x="3102877" y="822368"/>
                  </a:lnTo>
                  <a:lnTo>
                    <a:pt x="3094523" y="806071"/>
                  </a:lnTo>
                  <a:lnTo>
                    <a:pt x="3086161" y="812197"/>
                  </a:lnTo>
                  <a:lnTo>
                    <a:pt x="3019238" y="850609"/>
                  </a:lnTo>
                  <a:lnTo>
                    <a:pt x="3010884" y="854422"/>
                  </a:lnTo>
                  <a:lnTo>
                    <a:pt x="3002531" y="844599"/>
                  </a:lnTo>
                  <a:lnTo>
                    <a:pt x="2935608" y="762820"/>
                  </a:lnTo>
                  <a:lnTo>
                    <a:pt x="2927245" y="752164"/>
                  </a:lnTo>
                  <a:lnTo>
                    <a:pt x="2918892" y="766981"/>
                  </a:lnTo>
                  <a:lnTo>
                    <a:pt x="2851968" y="882362"/>
                  </a:lnTo>
                  <a:lnTo>
                    <a:pt x="2843615" y="896386"/>
                  </a:lnTo>
                  <a:lnTo>
                    <a:pt x="2835262" y="906819"/>
                  </a:lnTo>
                  <a:lnTo>
                    <a:pt x="2768329" y="1016983"/>
                  </a:lnTo>
                  <a:lnTo>
                    <a:pt x="2759976" y="1035284"/>
                  </a:lnTo>
                  <a:lnTo>
                    <a:pt x="2751623" y="1018009"/>
                  </a:lnTo>
                  <a:lnTo>
                    <a:pt x="2684699" y="901379"/>
                  </a:lnTo>
                  <a:lnTo>
                    <a:pt x="2676346" y="889050"/>
                  </a:lnTo>
                  <a:lnTo>
                    <a:pt x="2667983" y="915819"/>
                  </a:lnTo>
                  <a:lnTo>
                    <a:pt x="2601060" y="1127186"/>
                  </a:lnTo>
                  <a:lnTo>
                    <a:pt x="2592707" y="1153269"/>
                  </a:lnTo>
                  <a:lnTo>
                    <a:pt x="2584354" y="1076716"/>
                  </a:lnTo>
                  <a:lnTo>
                    <a:pt x="2517430" y="554481"/>
                  </a:lnTo>
                  <a:lnTo>
                    <a:pt x="2509068" y="498678"/>
                  </a:lnTo>
                  <a:lnTo>
                    <a:pt x="2500714" y="544881"/>
                  </a:lnTo>
                  <a:lnTo>
                    <a:pt x="2433791" y="936007"/>
                  </a:lnTo>
                  <a:lnTo>
                    <a:pt x="2425438" y="987794"/>
                  </a:lnTo>
                  <a:lnTo>
                    <a:pt x="2417075" y="997511"/>
                  </a:lnTo>
                  <a:lnTo>
                    <a:pt x="2350152" y="1079513"/>
                  </a:lnTo>
                  <a:lnTo>
                    <a:pt x="2341799" y="1090284"/>
                  </a:lnTo>
                  <a:lnTo>
                    <a:pt x="2333445" y="1104046"/>
                  </a:lnTo>
                  <a:lnTo>
                    <a:pt x="2266522" y="1238667"/>
                  </a:lnTo>
                  <a:lnTo>
                    <a:pt x="2258159" y="1259388"/>
                  </a:lnTo>
                  <a:lnTo>
                    <a:pt x="2249806" y="1190616"/>
                  </a:lnTo>
                  <a:lnTo>
                    <a:pt x="2182883" y="731221"/>
                  </a:lnTo>
                  <a:lnTo>
                    <a:pt x="2174530" y="683092"/>
                  </a:lnTo>
                  <a:lnTo>
                    <a:pt x="2166176" y="664269"/>
                  </a:lnTo>
                  <a:lnTo>
                    <a:pt x="2099253" y="489687"/>
                  </a:lnTo>
                  <a:lnTo>
                    <a:pt x="2090890" y="464282"/>
                  </a:lnTo>
                  <a:lnTo>
                    <a:pt x="2082537" y="530857"/>
                  </a:lnTo>
                  <a:lnTo>
                    <a:pt x="2015614" y="937633"/>
                  </a:lnTo>
                  <a:lnTo>
                    <a:pt x="2007260" y="976761"/>
                  </a:lnTo>
                  <a:lnTo>
                    <a:pt x="1998898" y="977971"/>
                  </a:lnTo>
                  <a:lnTo>
                    <a:pt x="1931975" y="990407"/>
                  </a:lnTo>
                  <a:lnTo>
                    <a:pt x="1923621" y="992411"/>
                  </a:lnTo>
                  <a:lnTo>
                    <a:pt x="1915268" y="1001256"/>
                  </a:lnTo>
                  <a:lnTo>
                    <a:pt x="1848345" y="1072516"/>
                  </a:lnTo>
                  <a:lnTo>
                    <a:pt x="1839982" y="1081516"/>
                  </a:lnTo>
                  <a:lnTo>
                    <a:pt x="1831629" y="1099091"/>
                  </a:lnTo>
                  <a:lnTo>
                    <a:pt x="1764706" y="1231225"/>
                  </a:lnTo>
                  <a:lnTo>
                    <a:pt x="1756352" y="1246719"/>
                  </a:lnTo>
                  <a:lnTo>
                    <a:pt x="1747989" y="1220599"/>
                  </a:lnTo>
                  <a:lnTo>
                    <a:pt x="1681066" y="1048020"/>
                  </a:lnTo>
                  <a:lnTo>
                    <a:pt x="1672713" y="1030136"/>
                  </a:lnTo>
                  <a:lnTo>
                    <a:pt x="1664360" y="1054785"/>
                  </a:lnTo>
                  <a:lnTo>
                    <a:pt x="1597437" y="1347438"/>
                  </a:lnTo>
                  <a:lnTo>
                    <a:pt x="1589074" y="1402738"/>
                  </a:lnTo>
                  <a:lnTo>
                    <a:pt x="1580720" y="1378853"/>
                  </a:lnTo>
                  <a:lnTo>
                    <a:pt x="1513797" y="1229560"/>
                  </a:lnTo>
                  <a:lnTo>
                    <a:pt x="1505444" y="1214889"/>
                  </a:lnTo>
                  <a:lnTo>
                    <a:pt x="1497091" y="1199878"/>
                  </a:lnTo>
                  <a:lnTo>
                    <a:pt x="1430158" y="1099401"/>
                  </a:lnTo>
                  <a:lnTo>
                    <a:pt x="1421805" y="1088852"/>
                  </a:lnTo>
                  <a:lnTo>
                    <a:pt x="1413451" y="1103330"/>
                  </a:lnTo>
                  <a:lnTo>
                    <a:pt x="1346528" y="1276440"/>
                  </a:lnTo>
                  <a:lnTo>
                    <a:pt x="1338175" y="1309365"/>
                  </a:lnTo>
                  <a:lnTo>
                    <a:pt x="1329812" y="1179922"/>
                  </a:lnTo>
                  <a:lnTo>
                    <a:pt x="1262889" y="541474"/>
                  </a:lnTo>
                  <a:lnTo>
                    <a:pt x="1254536" y="491004"/>
                  </a:lnTo>
                  <a:lnTo>
                    <a:pt x="1246182" y="527151"/>
                  </a:lnTo>
                  <a:lnTo>
                    <a:pt x="1179259" y="868900"/>
                  </a:lnTo>
                  <a:lnTo>
                    <a:pt x="1170896" y="919564"/>
                  </a:lnTo>
                  <a:lnTo>
                    <a:pt x="1162543" y="961412"/>
                  </a:lnTo>
                  <a:lnTo>
                    <a:pt x="1095620" y="1277718"/>
                  </a:lnTo>
                  <a:lnTo>
                    <a:pt x="1087267" y="1315075"/>
                  </a:lnTo>
                  <a:lnTo>
                    <a:pt x="1078904" y="1292051"/>
                  </a:lnTo>
                  <a:lnTo>
                    <a:pt x="1011981" y="1139207"/>
                  </a:lnTo>
                  <a:lnTo>
                    <a:pt x="1003627" y="1123325"/>
                  </a:lnTo>
                  <a:lnTo>
                    <a:pt x="995274" y="1085561"/>
                  </a:lnTo>
                  <a:lnTo>
                    <a:pt x="928351" y="694358"/>
                  </a:lnTo>
                  <a:lnTo>
                    <a:pt x="919988" y="630580"/>
                  </a:lnTo>
                  <a:lnTo>
                    <a:pt x="911635" y="687931"/>
                  </a:lnTo>
                  <a:lnTo>
                    <a:pt x="844712" y="1059934"/>
                  </a:lnTo>
                  <a:lnTo>
                    <a:pt x="836358" y="1097814"/>
                  </a:lnTo>
                  <a:lnTo>
                    <a:pt x="828005" y="1119434"/>
                  </a:lnTo>
                  <a:lnTo>
                    <a:pt x="761082" y="1339531"/>
                  </a:lnTo>
                  <a:lnTo>
                    <a:pt x="752719" y="1374769"/>
                  </a:lnTo>
                  <a:lnTo>
                    <a:pt x="744366" y="1346567"/>
                  </a:lnTo>
                  <a:lnTo>
                    <a:pt x="677443" y="1077248"/>
                  </a:lnTo>
                  <a:lnTo>
                    <a:pt x="669089" y="1036871"/>
                  </a:lnTo>
                  <a:lnTo>
                    <a:pt x="660727" y="972793"/>
                  </a:lnTo>
                  <a:lnTo>
                    <a:pt x="593803" y="623592"/>
                  </a:lnTo>
                  <a:lnTo>
                    <a:pt x="585450" y="593348"/>
                  </a:lnTo>
                  <a:lnTo>
                    <a:pt x="577097" y="617050"/>
                  </a:lnTo>
                  <a:lnTo>
                    <a:pt x="510174" y="920581"/>
                  </a:lnTo>
                  <a:lnTo>
                    <a:pt x="501811" y="983033"/>
                  </a:lnTo>
                  <a:lnTo>
                    <a:pt x="493458" y="932417"/>
                  </a:lnTo>
                  <a:lnTo>
                    <a:pt x="426534" y="705923"/>
                  </a:lnTo>
                  <a:lnTo>
                    <a:pt x="418181" y="689480"/>
                  </a:lnTo>
                  <a:lnTo>
                    <a:pt x="409818" y="709029"/>
                  </a:lnTo>
                  <a:lnTo>
                    <a:pt x="342895" y="921452"/>
                  </a:lnTo>
                  <a:lnTo>
                    <a:pt x="334542" y="957928"/>
                  </a:lnTo>
                  <a:lnTo>
                    <a:pt x="326189" y="995430"/>
                  </a:lnTo>
                  <a:lnTo>
                    <a:pt x="259304" y="1341806"/>
                  </a:lnTo>
                  <a:lnTo>
                    <a:pt x="250903" y="1391928"/>
                  </a:lnTo>
                  <a:lnTo>
                    <a:pt x="242549" y="1353748"/>
                  </a:lnTo>
                  <a:lnTo>
                    <a:pt x="175665" y="1140455"/>
                  </a:lnTo>
                  <a:lnTo>
                    <a:pt x="167273" y="1121554"/>
                  </a:lnTo>
                  <a:lnTo>
                    <a:pt x="158920" y="1084506"/>
                  </a:lnTo>
                  <a:lnTo>
                    <a:pt x="92029" y="743048"/>
                  </a:lnTo>
                  <a:lnTo>
                    <a:pt x="83635" y="693796"/>
                  </a:lnTo>
                  <a:lnTo>
                    <a:pt x="75279" y="717343"/>
                  </a:lnTo>
                  <a:lnTo>
                    <a:pt x="8394" y="903383"/>
                  </a:lnTo>
                  <a:lnTo>
                    <a:pt x="0" y="926368"/>
                  </a:lnTo>
                  <a:close/>
                </a:path>
              </a:pathLst>
            </a:custGeom>
            <a:solidFill>
              <a:srgbClr val="FB8072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01" name="Freeform: Shape 3000">
              <a:extLst>
                <a:ext uri="{FF2B5EF4-FFF2-40B4-BE49-F238E27FC236}">
                  <a16:creationId xmlns:a16="http://schemas.microsoft.com/office/drawing/2014/main" id="{6E950564-FE05-4ED9-6066-C6B476D24C1A}"/>
                </a:ext>
              </a:extLst>
            </p:cNvPr>
            <p:cNvSpPr/>
            <p:nvPr/>
          </p:nvSpPr>
          <p:spPr>
            <a:xfrm>
              <a:off x="1961705" y="2724731"/>
              <a:ext cx="8363529" cy="1610902"/>
            </a:xfrm>
            <a:custGeom>
              <a:avLst/>
              <a:gdLst>
                <a:gd name="connsiteX0" fmla="*/ 0 w 8363529"/>
                <a:gd name="connsiteY0" fmla="*/ 822523 h 1610902"/>
                <a:gd name="connsiteX1" fmla="*/ 8394 w 8363529"/>
                <a:gd name="connsiteY1" fmla="*/ 799538 h 1610902"/>
                <a:gd name="connsiteX2" fmla="*/ 75279 w 8363529"/>
                <a:gd name="connsiteY2" fmla="*/ 613498 h 1610902"/>
                <a:gd name="connsiteX3" fmla="*/ 83635 w 8363529"/>
                <a:gd name="connsiteY3" fmla="*/ 589951 h 1610902"/>
                <a:gd name="connsiteX4" fmla="*/ 92029 w 8363529"/>
                <a:gd name="connsiteY4" fmla="*/ 639203 h 1610902"/>
                <a:gd name="connsiteX5" fmla="*/ 158920 w 8363529"/>
                <a:gd name="connsiteY5" fmla="*/ 980662 h 1610902"/>
                <a:gd name="connsiteX6" fmla="*/ 167273 w 8363529"/>
                <a:gd name="connsiteY6" fmla="*/ 1017709 h 1610902"/>
                <a:gd name="connsiteX7" fmla="*/ 175665 w 8363529"/>
                <a:gd name="connsiteY7" fmla="*/ 1036610 h 1610902"/>
                <a:gd name="connsiteX8" fmla="*/ 242549 w 8363529"/>
                <a:gd name="connsiteY8" fmla="*/ 1249903 h 1610902"/>
                <a:gd name="connsiteX9" fmla="*/ 250903 w 8363529"/>
                <a:gd name="connsiteY9" fmla="*/ 1288083 h 1610902"/>
                <a:gd name="connsiteX10" fmla="*/ 259304 w 8363529"/>
                <a:gd name="connsiteY10" fmla="*/ 1237961 h 1610902"/>
                <a:gd name="connsiteX11" fmla="*/ 326189 w 8363529"/>
                <a:gd name="connsiteY11" fmla="*/ 891585 h 1610902"/>
                <a:gd name="connsiteX12" fmla="*/ 334542 w 8363529"/>
                <a:gd name="connsiteY12" fmla="*/ 854083 h 1610902"/>
                <a:gd name="connsiteX13" fmla="*/ 342895 w 8363529"/>
                <a:gd name="connsiteY13" fmla="*/ 817607 h 1610902"/>
                <a:gd name="connsiteX14" fmla="*/ 409818 w 8363529"/>
                <a:gd name="connsiteY14" fmla="*/ 605184 h 1610902"/>
                <a:gd name="connsiteX15" fmla="*/ 418181 w 8363529"/>
                <a:gd name="connsiteY15" fmla="*/ 585635 h 1610902"/>
                <a:gd name="connsiteX16" fmla="*/ 426534 w 8363529"/>
                <a:gd name="connsiteY16" fmla="*/ 602078 h 1610902"/>
                <a:gd name="connsiteX17" fmla="*/ 493458 w 8363529"/>
                <a:gd name="connsiteY17" fmla="*/ 828572 h 1610902"/>
                <a:gd name="connsiteX18" fmla="*/ 501811 w 8363529"/>
                <a:gd name="connsiteY18" fmla="*/ 879188 h 1610902"/>
                <a:gd name="connsiteX19" fmla="*/ 510174 w 8363529"/>
                <a:gd name="connsiteY19" fmla="*/ 816736 h 1610902"/>
                <a:gd name="connsiteX20" fmla="*/ 577097 w 8363529"/>
                <a:gd name="connsiteY20" fmla="*/ 513205 h 1610902"/>
                <a:gd name="connsiteX21" fmla="*/ 585450 w 8363529"/>
                <a:gd name="connsiteY21" fmla="*/ 489503 h 1610902"/>
                <a:gd name="connsiteX22" fmla="*/ 593803 w 8363529"/>
                <a:gd name="connsiteY22" fmla="*/ 519747 h 1610902"/>
                <a:gd name="connsiteX23" fmla="*/ 660727 w 8363529"/>
                <a:gd name="connsiteY23" fmla="*/ 868948 h 1610902"/>
                <a:gd name="connsiteX24" fmla="*/ 669089 w 8363529"/>
                <a:gd name="connsiteY24" fmla="*/ 933027 h 1610902"/>
                <a:gd name="connsiteX25" fmla="*/ 677443 w 8363529"/>
                <a:gd name="connsiteY25" fmla="*/ 973403 h 1610902"/>
                <a:gd name="connsiteX26" fmla="*/ 744366 w 8363529"/>
                <a:gd name="connsiteY26" fmla="*/ 1242722 h 1610902"/>
                <a:gd name="connsiteX27" fmla="*/ 752719 w 8363529"/>
                <a:gd name="connsiteY27" fmla="*/ 1270924 h 1610902"/>
                <a:gd name="connsiteX28" fmla="*/ 761082 w 8363529"/>
                <a:gd name="connsiteY28" fmla="*/ 1235687 h 1610902"/>
                <a:gd name="connsiteX29" fmla="*/ 828005 w 8363529"/>
                <a:gd name="connsiteY29" fmla="*/ 1015590 h 1610902"/>
                <a:gd name="connsiteX30" fmla="*/ 836358 w 8363529"/>
                <a:gd name="connsiteY30" fmla="*/ 993969 h 1610902"/>
                <a:gd name="connsiteX31" fmla="*/ 844712 w 8363529"/>
                <a:gd name="connsiteY31" fmla="*/ 956089 h 1610902"/>
                <a:gd name="connsiteX32" fmla="*/ 911635 w 8363529"/>
                <a:gd name="connsiteY32" fmla="*/ 584086 h 1610902"/>
                <a:gd name="connsiteX33" fmla="*/ 919988 w 8363529"/>
                <a:gd name="connsiteY33" fmla="*/ 526735 h 1610902"/>
                <a:gd name="connsiteX34" fmla="*/ 928351 w 8363529"/>
                <a:gd name="connsiteY34" fmla="*/ 590513 h 1610902"/>
                <a:gd name="connsiteX35" fmla="*/ 995274 w 8363529"/>
                <a:gd name="connsiteY35" fmla="*/ 981717 h 1610902"/>
                <a:gd name="connsiteX36" fmla="*/ 1003627 w 8363529"/>
                <a:gd name="connsiteY36" fmla="*/ 1019480 h 1610902"/>
                <a:gd name="connsiteX37" fmla="*/ 1011981 w 8363529"/>
                <a:gd name="connsiteY37" fmla="*/ 1035362 h 1610902"/>
                <a:gd name="connsiteX38" fmla="*/ 1078904 w 8363529"/>
                <a:gd name="connsiteY38" fmla="*/ 1188206 h 1610902"/>
                <a:gd name="connsiteX39" fmla="*/ 1087267 w 8363529"/>
                <a:gd name="connsiteY39" fmla="*/ 1211230 h 1610902"/>
                <a:gd name="connsiteX40" fmla="*/ 1095620 w 8363529"/>
                <a:gd name="connsiteY40" fmla="*/ 1173873 h 1610902"/>
                <a:gd name="connsiteX41" fmla="*/ 1162543 w 8363529"/>
                <a:gd name="connsiteY41" fmla="*/ 857567 h 1610902"/>
                <a:gd name="connsiteX42" fmla="*/ 1170896 w 8363529"/>
                <a:gd name="connsiteY42" fmla="*/ 815720 h 1610902"/>
                <a:gd name="connsiteX43" fmla="*/ 1179259 w 8363529"/>
                <a:gd name="connsiteY43" fmla="*/ 765055 h 1610902"/>
                <a:gd name="connsiteX44" fmla="*/ 1246182 w 8363529"/>
                <a:gd name="connsiteY44" fmla="*/ 423306 h 1610902"/>
                <a:gd name="connsiteX45" fmla="*/ 1254536 w 8363529"/>
                <a:gd name="connsiteY45" fmla="*/ 387159 h 1610902"/>
                <a:gd name="connsiteX46" fmla="*/ 1262889 w 8363529"/>
                <a:gd name="connsiteY46" fmla="*/ 437629 h 1610902"/>
                <a:gd name="connsiteX47" fmla="*/ 1329812 w 8363529"/>
                <a:gd name="connsiteY47" fmla="*/ 1076077 h 1610902"/>
                <a:gd name="connsiteX48" fmla="*/ 1338175 w 8363529"/>
                <a:gd name="connsiteY48" fmla="*/ 1205520 h 1610902"/>
                <a:gd name="connsiteX49" fmla="*/ 1346528 w 8363529"/>
                <a:gd name="connsiteY49" fmla="*/ 1172596 h 1610902"/>
                <a:gd name="connsiteX50" fmla="*/ 1413451 w 8363529"/>
                <a:gd name="connsiteY50" fmla="*/ 999485 h 1610902"/>
                <a:gd name="connsiteX51" fmla="*/ 1421805 w 8363529"/>
                <a:gd name="connsiteY51" fmla="*/ 985007 h 1610902"/>
                <a:gd name="connsiteX52" fmla="*/ 1430158 w 8363529"/>
                <a:gd name="connsiteY52" fmla="*/ 995556 h 1610902"/>
                <a:gd name="connsiteX53" fmla="*/ 1497091 w 8363529"/>
                <a:gd name="connsiteY53" fmla="*/ 1096033 h 1610902"/>
                <a:gd name="connsiteX54" fmla="*/ 1505444 w 8363529"/>
                <a:gd name="connsiteY54" fmla="*/ 1111044 h 1610902"/>
                <a:gd name="connsiteX55" fmla="*/ 1513797 w 8363529"/>
                <a:gd name="connsiteY55" fmla="*/ 1125715 h 1610902"/>
                <a:gd name="connsiteX56" fmla="*/ 1580720 w 8363529"/>
                <a:gd name="connsiteY56" fmla="*/ 1275008 h 1610902"/>
                <a:gd name="connsiteX57" fmla="*/ 1589074 w 8363529"/>
                <a:gd name="connsiteY57" fmla="*/ 1298894 h 1610902"/>
                <a:gd name="connsiteX58" fmla="*/ 1597437 w 8363529"/>
                <a:gd name="connsiteY58" fmla="*/ 1243593 h 1610902"/>
                <a:gd name="connsiteX59" fmla="*/ 1664360 w 8363529"/>
                <a:gd name="connsiteY59" fmla="*/ 950941 h 1610902"/>
                <a:gd name="connsiteX60" fmla="*/ 1672713 w 8363529"/>
                <a:gd name="connsiteY60" fmla="*/ 926291 h 1610902"/>
                <a:gd name="connsiteX61" fmla="*/ 1681066 w 8363529"/>
                <a:gd name="connsiteY61" fmla="*/ 944176 h 1610902"/>
                <a:gd name="connsiteX62" fmla="*/ 1747989 w 8363529"/>
                <a:gd name="connsiteY62" fmla="*/ 1116754 h 1610902"/>
                <a:gd name="connsiteX63" fmla="*/ 1756352 w 8363529"/>
                <a:gd name="connsiteY63" fmla="*/ 1142875 h 1610902"/>
                <a:gd name="connsiteX64" fmla="*/ 1764706 w 8363529"/>
                <a:gd name="connsiteY64" fmla="*/ 1127380 h 1610902"/>
                <a:gd name="connsiteX65" fmla="*/ 1831629 w 8363529"/>
                <a:gd name="connsiteY65" fmla="*/ 995246 h 1610902"/>
                <a:gd name="connsiteX66" fmla="*/ 1839982 w 8363529"/>
                <a:gd name="connsiteY66" fmla="*/ 977671 h 1610902"/>
                <a:gd name="connsiteX67" fmla="*/ 1848345 w 8363529"/>
                <a:gd name="connsiteY67" fmla="*/ 968671 h 1610902"/>
                <a:gd name="connsiteX68" fmla="*/ 1915268 w 8363529"/>
                <a:gd name="connsiteY68" fmla="*/ 897412 h 1610902"/>
                <a:gd name="connsiteX69" fmla="*/ 1923621 w 8363529"/>
                <a:gd name="connsiteY69" fmla="*/ 888566 h 1610902"/>
                <a:gd name="connsiteX70" fmla="*/ 1931975 w 8363529"/>
                <a:gd name="connsiteY70" fmla="*/ 886562 h 1610902"/>
                <a:gd name="connsiteX71" fmla="*/ 1998898 w 8363529"/>
                <a:gd name="connsiteY71" fmla="*/ 874126 h 1610902"/>
                <a:gd name="connsiteX72" fmla="*/ 2007260 w 8363529"/>
                <a:gd name="connsiteY72" fmla="*/ 872916 h 1610902"/>
                <a:gd name="connsiteX73" fmla="*/ 2015614 w 8363529"/>
                <a:gd name="connsiteY73" fmla="*/ 833788 h 1610902"/>
                <a:gd name="connsiteX74" fmla="*/ 2082537 w 8363529"/>
                <a:gd name="connsiteY74" fmla="*/ 427012 h 1610902"/>
                <a:gd name="connsiteX75" fmla="*/ 2090890 w 8363529"/>
                <a:gd name="connsiteY75" fmla="*/ 360438 h 1610902"/>
                <a:gd name="connsiteX76" fmla="*/ 2099253 w 8363529"/>
                <a:gd name="connsiteY76" fmla="*/ 385842 h 1610902"/>
                <a:gd name="connsiteX77" fmla="*/ 2166176 w 8363529"/>
                <a:gd name="connsiteY77" fmla="*/ 560424 h 1610902"/>
                <a:gd name="connsiteX78" fmla="*/ 2174530 w 8363529"/>
                <a:gd name="connsiteY78" fmla="*/ 579247 h 1610902"/>
                <a:gd name="connsiteX79" fmla="*/ 2182883 w 8363529"/>
                <a:gd name="connsiteY79" fmla="*/ 627376 h 1610902"/>
                <a:gd name="connsiteX80" fmla="*/ 2249806 w 8363529"/>
                <a:gd name="connsiteY80" fmla="*/ 1086771 h 1610902"/>
                <a:gd name="connsiteX81" fmla="*/ 2258159 w 8363529"/>
                <a:gd name="connsiteY81" fmla="*/ 1155543 h 1610902"/>
                <a:gd name="connsiteX82" fmla="*/ 2266522 w 8363529"/>
                <a:gd name="connsiteY82" fmla="*/ 1134823 h 1610902"/>
                <a:gd name="connsiteX83" fmla="*/ 2333445 w 8363529"/>
                <a:gd name="connsiteY83" fmla="*/ 1000202 h 1610902"/>
                <a:gd name="connsiteX84" fmla="*/ 2341799 w 8363529"/>
                <a:gd name="connsiteY84" fmla="*/ 986439 h 1610902"/>
                <a:gd name="connsiteX85" fmla="*/ 2350152 w 8363529"/>
                <a:gd name="connsiteY85" fmla="*/ 975668 h 1610902"/>
                <a:gd name="connsiteX86" fmla="*/ 2417075 w 8363529"/>
                <a:gd name="connsiteY86" fmla="*/ 893666 h 1610902"/>
                <a:gd name="connsiteX87" fmla="*/ 2425438 w 8363529"/>
                <a:gd name="connsiteY87" fmla="*/ 883950 h 1610902"/>
                <a:gd name="connsiteX88" fmla="*/ 2433791 w 8363529"/>
                <a:gd name="connsiteY88" fmla="*/ 832162 h 1610902"/>
                <a:gd name="connsiteX89" fmla="*/ 2500714 w 8363529"/>
                <a:gd name="connsiteY89" fmla="*/ 441036 h 1610902"/>
                <a:gd name="connsiteX90" fmla="*/ 2509068 w 8363529"/>
                <a:gd name="connsiteY90" fmla="*/ 394833 h 1610902"/>
                <a:gd name="connsiteX91" fmla="*/ 2517430 w 8363529"/>
                <a:gd name="connsiteY91" fmla="*/ 450637 h 1610902"/>
                <a:gd name="connsiteX92" fmla="*/ 2584354 w 8363529"/>
                <a:gd name="connsiteY92" fmla="*/ 972871 h 1610902"/>
                <a:gd name="connsiteX93" fmla="*/ 2592707 w 8363529"/>
                <a:gd name="connsiteY93" fmla="*/ 1049424 h 1610902"/>
                <a:gd name="connsiteX94" fmla="*/ 2601060 w 8363529"/>
                <a:gd name="connsiteY94" fmla="*/ 1023342 h 1610902"/>
                <a:gd name="connsiteX95" fmla="*/ 2667983 w 8363529"/>
                <a:gd name="connsiteY95" fmla="*/ 811974 h 1610902"/>
                <a:gd name="connsiteX96" fmla="*/ 2676346 w 8363529"/>
                <a:gd name="connsiteY96" fmla="*/ 785205 h 1610902"/>
                <a:gd name="connsiteX97" fmla="*/ 2684699 w 8363529"/>
                <a:gd name="connsiteY97" fmla="*/ 797535 h 1610902"/>
                <a:gd name="connsiteX98" fmla="*/ 2751623 w 8363529"/>
                <a:gd name="connsiteY98" fmla="*/ 914164 h 1610902"/>
                <a:gd name="connsiteX99" fmla="*/ 2759976 w 8363529"/>
                <a:gd name="connsiteY99" fmla="*/ 931439 h 1610902"/>
                <a:gd name="connsiteX100" fmla="*/ 2768329 w 8363529"/>
                <a:gd name="connsiteY100" fmla="*/ 913138 h 1610902"/>
                <a:gd name="connsiteX101" fmla="*/ 2835262 w 8363529"/>
                <a:gd name="connsiteY101" fmla="*/ 802974 h 1610902"/>
                <a:gd name="connsiteX102" fmla="*/ 2843615 w 8363529"/>
                <a:gd name="connsiteY102" fmla="*/ 792541 h 1610902"/>
                <a:gd name="connsiteX103" fmla="*/ 2851968 w 8363529"/>
                <a:gd name="connsiteY103" fmla="*/ 778517 h 1610902"/>
                <a:gd name="connsiteX104" fmla="*/ 2918892 w 8363529"/>
                <a:gd name="connsiteY104" fmla="*/ 663136 h 1610902"/>
                <a:gd name="connsiteX105" fmla="*/ 2927245 w 8363529"/>
                <a:gd name="connsiteY105" fmla="*/ 648319 h 1610902"/>
                <a:gd name="connsiteX106" fmla="*/ 2935608 w 8363529"/>
                <a:gd name="connsiteY106" fmla="*/ 658975 h 1610902"/>
                <a:gd name="connsiteX107" fmla="*/ 3002531 w 8363529"/>
                <a:gd name="connsiteY107" fmla="*/ 740754 h 1610902"/>
                <a:gd name="connsiteX108" fmla="*/ 3010884 w 8363529"/>
                <a:gd name="connsiteY108" fmla="*/ 750577 h 1610902"/>
                <a:gd name="connsiteX109" fmla="*/ 3019238 w 8363529"/>
                <a:gd name="connsiteY109" fmla="*/ 746764 h 1610902"/>
                <a:gd name="connsiteX110" fmla="*/ 3086161 w 8363529"/>
                <a:gd name="connsiteY110" fmla="*/ 708352 h 1610902"/>
                <a:gd name="connsiteX111" fmla="*/ 3094523 w 8363529"/>
                <a:gd name="connsiteY111" fmla="*/ 702226 h 1610902"/>
                <a:gd name="connsiteX112" fmla="*/ 3102877 w 8363529"/>
                <a:gd name="connsiteY112" fmla="*/ 718523 h 1610902"/>
                <a:gd name="connsiteX113" fmla="*/ 3169800 w 8363529"/>
                <a:gd name="connsiteY113" fmla="*/ 811519 h 1610902"/>
                <a:gd name="connsiteX114" fmla="*/ 3178153 w 8363529"/>
                <a:gd name="connsiteY114" fmla="*/ 819910 h 1610902"/>
                <a:gd name="connsiteX115" fmla="*/ 3186516 w 8363529"/>
                <a:gd name="connsiteY115" fmla="*/ 854083 h 1610902"/>
                <a:gd name="connsiteX116" fmla="*/ 3253439 w 8363529"/>
                <a:gd name="connsiteY116" fmla="*/ 1195958 h 1610902"/>
                <a:gd name="connsiteX117" fmla="*/ 3261792 w 8363529"/>
                <a:gd name="connsiteY117" fmla="*/ 1249710 h 1610902"/>
                <a:gd name="connsiteX118" fmla="*/ 3270146 w 8363529"/>
                <a:gd name="connsiteY118" fmla="*/ 1247223 h 1610902"/>
                <a:gd name="connsiteX119" fmla="*/ 3337069 w 8363529"/>
                <a:gd name="connsiteY119" fmla="*/ 1204727 h 1610902"/>
                <a:gd name="connsiteX120" fmla="*/ 3345432 w 8363529"/>
                <a:gd name="connsiteY120" fmla="*/ 1192590 h 1610902"/>
                <a:gd name="connsiteX121" fmla="*/ 3353785 w 8363529"/>
                <a:gd name="connsiteY121" fmla="*/ 962283 h 1610902"/>
                <a:gd name="connsiteX122" fmla="*/ 3420708 w 8363529"/>
                <a:gd name="connsiteY122" fmla="*/ 286982 h 1610902"/>
                <a:gd name="connsiteX123" fmla="*/ 3429061 w 8363529"/>
                <a:gd name="connsiteY123" fmla="*/ 252499 h 1610902"/>
                <a:gd name="connsiteX124" fmla="*/ 3437424 w 8363529"/>
                <a:gd name="connsiteY124" fmla="*/ 296360 h 1610902"/>
                <a:gd name="connsiteX125" fmla="*/ 3504347 w 8363529"/>
                <a:gd name="connsiteY125" fmla="*/ 698258 h 1610902"/>
                <a:gd name="connsiteX126" fmla="*/ 3512701 w 8363529"/>
                <a:gd name="connsiteY126" fmla="*/ 755948 h 1610902"/>
                <a:gd name="connsiteX127" fmla="*/ 3521054 w 8363529"/>
                <a:gd name="connsiteY127" fmla="*/ 738896 h 1610902"/>
                <a:gd name="connsiteX128" fmla="*/ 3587977 w 8363529"/>
                <a:gd name="connsiteY128" fmla="*/ 620872 h 1610902"/>
                <a:gd name="connsiteX129" fmla="*/ 3596330 w 8363529"/>
                <a:gd name="connsiteY129" fmla="*/ 608088 h 1610902"/>
                <a:gd name="connsiteX130" fmla="*/ 3604693 w 8363529"/>
                <a:gd name="connsiteY130" fmla="*/ 622837 h 1610902"/>
                <a:gd name="connsiteX131" fmla="*/ 3671616 w 8363529"/>
                <a:gd name="connsiteY131" fmla="*/ 778972 h 1610902"/>
                <a:gd name="connsiteX132" fmla="*/ 3679970 w 8363529"/>
                <a:gd name="connsiteY132" fmla="*/ 805016 h 1610902"/>
                <a:gd name="connsiteX133" fmla="*/ 3688323 w 8363529"/>
                <a:gd name="connsiteY133" fmla="*/ 803690 h 1610902"/>
                <a:gd name="connsiteX134" fmla="*/ 3755246 w 8363529"/>
                <a:gd name="connsiteY134" fmla="*/ 794321 h 1610902"/>
                <a:gd name="connsiteX135" fmla="*/ 3763609 w 8363529"/>
                <a:gd name="connsiteY135" fmla="*/ 793296 h 1610902"/>
                <a:gd name="connsiteX136" fmla="*/ 3771962 w 8363529"/>
                <a:gd name="connsiteY136" fmla="*/ 813484 h 1610902"/>
                <a:gd name="connsiteX137" fmla="*/ 3838885 w 8363529"/>
                <a:gd name="connsiteY137" fmla="*/ 990146 h 1610902"/>
                <a:gd name="connsiteX138" fmla="*/ 3847239 w 8363529"/>
                <a:gd name="connsiteY138" fmla="*/ 1014341 h 1610902"/>
                <a:gd name="connsiteX139" fmla="*/ 3855602 w 8363529"/>
                <a:gd name="connsiteY139" fmla="*/ 984175 h 1610902"/>
                <a:gd name="connsiteX140" fmla="*/ 3922525 w 8363529"/>
                <a:gd name="connsiteY140" fmla="*/ 767252 h 1610902"/>
                <a:gd name="connsiteX141" fmla="*/ 3930878 w 8363529"/>
                <a:gd name="connsiteY141" fmla="*/ 742864 h 1610902"/>
                <a:gd name="connsiteX142" fmla="*/ 3939231 w 8363529"/>
                <a:gd name="connsiteY142" fmla="*/ 772962 h 1610902"/>
                <a:gd name="connsiteX143" fmla="*/ 4006154 w 8363529"/>
                <a:gd name="connsiteY143" fmla="*/ 984736 h 1610902"/>
                <a:gd name="connsiteX144" fmla="*/ 4014517 w 8363529"/>
                <a:gd name="connsiteY144" fmla="*/ 1008070 h 1610902"/>
                <a:gd name="connsiteX145" fmla="*/ 4022871 w 8363529"/>
                <a:gd name="connsiteY145" fmla="*/ 1030639 h 1610902"/>
                <a:gd name="connsiteX146" fmla="*/ 4089755 w 8363529"/>
                <a:gd name="connsiteY146" fmla="*/ 1302716 h 1610902"/>
                <a:gd name="connsiteX147" fmla="*/ 4098147 w 8363529"/>
                <a:gd name="connsiteY147" fmla="*/ 1354958 h 1610902"/>
                <a:gd name="connsiteX148" fmla="*/ 4106500 w 8363529"/>
                <a:gd name="connsiteY148" fmla="*/ 1241358 h 1610902"/>
                <a:gd name="connsiteX149" fmla="*/ 4173394 w 8363529"/>
                <a:gd name="connsiteY149" fmla="*/ 660146 h 1610902"/>
                <a:gd name="connsiteX150" fmla="*/ 4181787 w 8363529"/>
                <a:gd name="connsiteY150" fmla="*/ 612666 h 1610902"/>
                <a:gd name="connsiteX151" fmla="*/ 4190140 w 8363529"/>
                <a:gd name="connsiteY151" fmla="*/ 661249 h 1610902"/>
                <a:gd name="connsiteX152" fmla="*/ 4257024 w 8363529"/>
                <a:gd name="connsiteY152" fmla="*/ 1146165 h 1610902"/>
                <a:gd name="connsiteX153" fmla="*/ 4265416 w 8363529"/>
                <a:gd name="connsiteY153" fmla="*/ 1222263 h 1610902"/>
                <a:gd name="connsiteX154" fmla="*/ 4273779 w 8363529"/>
                <a:gd name="connsiteY154" fmla="*/ 1089984 h 1610902"/>
                <a:gd name="connsiteX155" fmla="*/ 4340664 w 8363529"/>
                <a:gd name="connsiteY155" fmla="*/ 112855 h 1610902"/>
                <a:gd name="connsiteX156" fmla="*/ 4349055 w 8363529"/>
                <a:gd name="connsiteY156" fmla="*/ 0 h 1610902"/>
                <a:gd name="connsiteX157" fmla="*/ 4357409 w 8363529"/>
                <a:gd name="connsiteY157" fmla="*/ 94331 h 1610902"/>
                <a:gd name="connsiteX158" fmla="*/ 4424303 w 8363529"/>
                <a:gd name="connsiteY158" fmla="*/ 842479 h 1610902"/>
                <a:gd name="connsiteX159" fmla="*/ 4432695 w 8363529"/>
                <a:gd name="connsiteY159" fmla="*/ 935214 h 1610902"/>
                <a:gd name="connsiteX160" fmla="*/ 4441048 w 8363529"/>
                <a:gd name="connsiteY160" fmla="*/ 901718 h 1610902"/>
                <a:gd name="connsiteX161" fmla="*/ 4507932 w 8363529"/>
                <a:gd name="connsiteY161" fmla="*/ 618637 h 1610902"/>
                <a:gd name="connsiteX162" fmla="*/ 4516324 w 8363529"/>
                <a:gd name="connsiteY162" fmla="*/ 581251 h 1610902"/>
                <a:gd name="connsiteX163" fmla="*/ 4524687 w 8363529"/>
                <a:gd name="connsiteY163" fmla="*/ 636183 h 1610902"/>
                <a:gd name="connsiteX164" fmla="*/ 4591572 w 8363529"/>
                <a:gd name="connsiteY164" fmla="*/ 1126016 h 1610902"/>
                <a:gd name="connsiteX165" fmla="*/ 4599964 w 8363529"/>
                <a:gd name="connsiteY165" fmla="*/ 1194332 h 1610902"/>
                <a:gd name="connsiteX166" fmla="*/ 4608317 w 8363529"/>
                <a:gd name="connsiteY166" fmla="*/ 1130022 h 1610902"/>
                <a:gd name="connsiteX167" fmla="*/ 4675201 w 8363529"/>
                <a:gd name="connsiteY167" fmla="*/ 626621 h 1610902"/>
                <a:gd name="connsiteX168" fmla="*/ 4683603 w 8363529"/>
                <a:gd name="connsiteY168" fmla="*/ 565069 h 1610902"/>
                <a:gd name="connsiteX169" fmla="*/ 4691956 w 8363529"/>
                <a:gd name="connsiteY169" fmla="*/ 574108 h 1610902"/>
                <a:gd name="connsiteX170" fmla="*/ 4758840 w 8363529"/>
                <a:gd name="connsiteY170" fmla="*/ 638448 h 1610902"/>
                <a:gd name="connsiteX171" fmla="*/ 4767232 w 8363529"/>
                <a:gd name="connsiteY171" fmla="*/ 645629 h 1610902"/>
                <a:gd name="connsiteX172" fmla="*/ 4775595 w 8363529"/>
                <a:gd name="connsiteY172" fmla="*/ 650923 h 1610902"/>
                <a:gd name="connsiteX173" fmla="*/ 4842480 w 8363529"/>
                <a:gd name="connsiteY173" fmla="*/ 706494 h 1610902"/>
                <a:gd name="connsiteX174" fmla="*/ 4850872 w 8363529"/>
                <a:gd name="connsiteY174" fmla="*/ 715688 h 1610902"/>
                <a:gd name="connsiteX175" fmla="*/ 4859225 w 8363529"/>
                <a:gd name="connsiteY175" fmla="*/ 800854 h 1610902"/>
                <a:gd name="connsiteX176" fmla="*/ 4926109 w 8363529"/>
                <a:gd name="connsiteY176" fmla="*/ 1246274 h 1610902"/>
                <a:gd name="connsiteX177" fmla="*/ 4934501 w 8363529"/>
                <a:gd name="connsiteY177" fmla="*/ 1283360 h 1610902"/>
                <a:gd name="connsiteX178" fmla="*/ 4942864 w 8363529"/>
                <a:gd name="connsiteY178" fmla="*/ 1276363 h 1610902"/>
                <a:gd name="connsiteX179" fmla="*/ 5009749 w 8363529"/>
                <a:gd name="connsiteY179" fmla="*/ 1213195 h 1610902"/>
                <a:gd name="connsiteX180" fmla="*/ 5018141 w 8363529"/>
                <a:gd name="connsiteY180" fmla="*/ 1204272 h 1610902"/>
                <a:gd name="connsiteX181" fmla="*/ 5026494 w 8363529"/>
                <a:gd name="connsiteY181" fmla="*/ 1185525 h 1610902"/>
                <a:gd name="connsiteX182" fmla="*/ 5093388 w 8363529"/>
                <a:gd name="connsiteY182" fmla="*/ 1007199 h 1610902"/>
                <a:gd name="connsiteX183" fmla="*/ 5101780 w 8363529"/>
                <a:gd name="connsiteY183" fmla="*/ 980623 h 1610902"/>
                <a:gd name="connsiteX184" fmla="*/ 5110134 w 8363529"/>
                <a:gd name="connsiteY184" fmla="*/ 978881 h 1610902"/>
                <a:gd name="connsiteX185" fmla="*/ 5177018 w 8363529"/>
                <a:gd name="connsiteY185" fmla="*/ 968709 h 1610902"/>
                <a:gd name="connsiteX186" fmla="*/ 5185410 w 8363529"/>
                <a:gd name="connsiteY186" fmla="*/ 967770 h 1610902"/>
                <a:gd name="connsiteX187" fmla="*/ 5193773 w 8363529"/>
                <a:gd name="connsiteY187" fmla="*/ 982055 h 1610902"/>
                <a:gd name="connsiteX188" fmla="*/ 5260657 w 8363529"/>
                <a:gd name="connsiteY188" fmla="*/ 1106166 h 1610902"/>
                <a:gd name="connsiteX189" fmla="*/ 5269049 w 8363529"/>
                <a:gd name="connsiteY189" fmla="*/ 1123035 h 1610902"/>
                <a:gd name="connsiteX190" fmla="*/ 5277403 w 8363529"/>
                <a:gd name="connsiteY190" fmla="*/ 1097891 h 1610902"/>
                <a:gd name="connsiteX191" fmla="*/ 5344287 w 8363529"/>
                <a:gd name="connsiteY191" fmla="*/ 865465 h 1610902"/>
                <a:gd name="connsiteX192" fmla="*/ 5352650 w 8363529"/>
                <a:gd name="connsiteY192" fmla="*/ 831785 h 1610902"/>
                <a:gd name="connsiteX193" fmla="*/ 5361042 w 8363529"/>
                <a:gd name="connsiteY193" fmla="*/ 844183 h 1610902"/>
                <a:gd name="connsiteX194" fmla="*/ 5427926 w 8363529"/>
                <a:gd name="connsiteY194" fmla="*/ 1089191 h 1610902"/>
                <a:gd name="connsiteX195" fmla="*/ 5436280 w 8363529"/>
                <a:gd name="connsiteY195" fmla="*/ 1173612 h 1610902"/>
                <a:gd name="connsiteX196" fmla="*/ 5444672 w 8363529"/>
                <a:gd name="connsiteY196" fmla="*/ 1238183 h 1610902"/>
                <a:gd name="connsiteX197" fmla="*/ 5511566 w 8363529"/>
                <a:gd name="connsiteY197" fmla="*/ 1451254 h 1610902"/>
                <a:gd name="connsiteX198" fmla="*/ 5519919 w 8363529"/>
                <a:gd name="connsiteY198" fmla="*/ 1463197 h 1610902"/>
                <a:gd name="connsiteX199" fmla="*/ 5528311 w 8363529"/>
                <a:gd name="connsiteY199" fmla="*/ 1388831 h 1610902"/>
                <a:gd name="connsiteX200" fmla="*/ 5595195 w 8363529"/>
                <a:gd name="connsiteY200" fmla="*/ 976878 h 1610902"/>
                <a:gd name="connsiteX201" fmla="*/ 5603558 w 8363529"/>
                <a:gd name="connsiteY201" fmla="*/ 940701 h 1610902"/>
                <a:gd name="connsiteX202" fmla="*/ 5611950 w 8363529"/>
                <a:gd name="connsiteY202" fmla="*/ 893250 h 1610902"/>
                <a:gd name="connsiteX203" fmla="*/ 5678835 w 8363529"/>
                <a:gd name="connsiteY203" fmla="*/ 515324 h 1610902"/>
                <a:gd name="connsiteX204" fmla="*/ 5687188 w 8363529"/>
                <a:gd name="connsiteY204" fmla="*/ 468289 h 1610902"/>
                <a:gd name="connsiteX205" fmla="*/ 5695580 w 8363529"/>
                <a:gd name="connsiteY205" fmla="*/ 525525 h 1610902"/>
                <a:gd name="connsiteX206" fmla="*/ 5762474 w 8363529"/>
                <a:gd name="connsiteY206" fmla="*/ 1175315 h 1610902"/>
                <a:gd name="connsiteX207" fmla="*/ 5770827 w 8363529"/>
                <a:gd name="connsiteY207" fmla="*/ 1292245 h 1610902"/>
                <a:gd name="connsiteX208" fmla="*/ 5779219 w 8363529"/>
                <a:gd name="connsiteY208" fmla="*/ 1265930 h 1610902"/>
                <a:gd name="connsiteX209" fmla="*/ 5846103 w 8363529"/>
                <a:gd name="connsiteY209" fmla="*/ 1112408 h 1610902"/>
                <a:gd name="connsiteX210" fmla="*/ 5854457 w 8363529"/>
                <a:gd name="connsiteY210" fmla="*/ 1098269 h 1610902"/>
                <a:gd name="connsiteX211" fmla="*/ 5862858 w 8363529"/>
                <a:gd name="connsiteY211" fmla="*/ 1116415 h 1610902"/>
                <a:gd name="connsiteX212" fmla="*/ 5929743 w 8363529"/>
                <a:gd name="connsiteY212" fmla="*/ 1352994 h 1610902"/>
                <a:gd name="connsiteX213" fmla="*/ 5938096 w 8363529"/>
                <a:gd name="connsiteY213" fmla="*/ 1402593 h 1610902"/>
                <a:gd name="connsiteX214" fmla="*/ 5946488 w 8363529"/>
                <a:gd name="connsiteY214" fmla="*/ 1376550 h 1610902"/>
                <a:gd name="connsiteX215" fmla="*/ 6013372 w 8363529"/>
                <a:gd name="connsiteY215" fmla="*/ 1245065 h 1610902"/>
                <a:gd name="connsiteX216" fmla="*/ 6021735 w 8363529"/>
                <a:gd name="connsiteY216" fmla="*/ 1234477 h 1610902"/>
                <a:gd name="connsiteX217" fmla="*/ 6030127 w 8363529"/>
                <a:gd name="connsiteY217" fmla="*/ 1214327 h 1610902"/>
                <a:gd name="connsiteX218" fmla="*/ 6097011 w 8363529"/>
                <a:gd name="connsiteY218" fmla="*/ 1031539 h 1610902"/>
                <a:gd name="connsiteX219" fmla="*/ 6105365 w 8363529"/>
                <a:gd name="connsiteY219" fmla="*/ 1005611 h 1610902"/>
                <a:gd name="connsiteX220" fmla="*/ 6113767 w 8363529"/>
                <a:gd name="connsiteY220" fmla="*/ 994037 h 1610902"/>
                <a:gd name="connsiteX221" fmla="*/ 6180651 w 8363529"/>
                <a:gd name="connsiteY221" fmla="*/ 914309 h 1610902"/>
                <a:gd name="connsiteX222" fmla="*/ 6189004 w 8363529"/>
                <a:gd name="connsiteY222" fmla="*/ 905686 h 1610902"/>
                <a:gd name="connsiteX223" fmla="*/ 6197396 w 8363529"/>
                <a:gd name="connsiteY223" fmla="*/ 935746 h 1610902"/>
                <a:gd name="connsiteX224" fmla="*/ 6264280 w 8363529"/>
                <a:gd name="connsiteY224" fmla="*/ 1242268 h 1610902"/>
                <a:gd name="connsiteX225" fmla="*/ 6272644 w 8363529"/>
                <a:gd name="connsiteY225" fmla="*/ 1291412 h 1610902"/>
                <a:gd name="connsiteX226" fmla="*/ 6281036 w 8363529"/>
                <a:gd name="connsiteY226" fmla="*/ 1203023 h 1610902"/>
                <a:gd name="connsiteX227" fmla="*/ 6347920 w 8363529"/>
                <a:gd name="connsiteY227" fmla="*/ 602688 h 1610902"/>
                <a:gd name="connsiteX228" fmla="*/ 6356273 w 8363529"/>
                <a:gd name="connsiteY228" fmla="*/ 538794 h 1610902"/>
                <a:gd name="connsiteX229" fmla="*/ 6364665 w 8363529"/>
                <a:gd name="connsiteY229" fmla="*/ 618753 h 1610902"/>
                <a:gd name="connsiteX230" fmla="*/ 6431560 w 8363529"/>
                <a:gd name="connsiteY230" fmla="*/ 1204233 h 1610902"/>
                <a:gd name="connsiteX231" fmla="*/ 6439913 w 8363529"/>
                <a:gd name="connsiteY231" fmla="*/ 1271224 h 1610902"/>
                <a:gd name="connsiteX232" fmla="*/ 6448305 w 8363529"/>
                <a:gd name="connsiteY232" fmla="*/ 1279315 h 1610902"/>
                <a:gd name="connsiteX233" fmla="*/ 6515189 w 8363529"/>
                <a:gd name="connsiteY233" fmla="*/ 1351784 h 1610902"/>
                <a:gd name="connsiteX234" fmla="*/ 6523542 w 8363529"/>
                <a:gd name="connsiteY234" fmla="*/ 1361994 h 1610902"/>
                <a:gd name="connsiteX235" fmla="*/ 6531944 w 8363529"/>
                <a:gd name="connsiteY235" fmla="*/ 1333599 h 1610902"/>
                <a:gd name="connsiteX236" fmla="*/ 6598829 w 8363529"/>
                <a:gd name="connsiteY236" fmla="*/ 1079784 h 1610902"/>
                <a:gd name="connsiteX237" fmla="*/ 6607182 w 8363529"/>
                <a:gd name="connsiteY237" fmla="*/ 1044285 h 1610902"/>
                <a:gd name="connsiteX238" fmla="*/ 6615535 w 8363529"/>
                <a:gd name="connsiteY238" fmla="*/ 1079484 h 1610902"/>
                <a:gd name="connsiteX239" fmla="*/ 6682458 w 8363529"/>
                <a:gd name="connsiteY239" fmla="*/ 1275908 h 1610902"/>
                <a:gd name="connsiteX240" fmla="*/ 6690821 w 8363529"/>
                <a:gd name="connsiteY240" fmla="*/ 1293261 h 1610902"/>
                <a:gd name="connsiteX241" fmla="*/ 6699174 w 8363529"/>
                <a:gd name="connsiteY241" fmla="*/ 1275724 h 1610902"/>
                <a:gd name="connsiteX242" fmla="*/ 6766097 w 8363529"/>
                <a:gd name="connsiteY242" fmla="*/ 1100079 h 1610902"/>
                <a:gd name="connsiteX243" fmla="*/ 6774451 w 8363529"/>
                <a:gd name="connsiteY243" fmla="*/ 1072409 h 1610902"/>
                <a:gd name="connsiteX244" fmla="*/ 6782814 w 8363529"/>
                <a:gd name="connsiteY244" fmla="*/ 1082765 h 1610902"/>
                <a:gd name="connsiteX245" fmla="*/ 6849737 w 8363529"/>
                <a:gd name="connsiteY245" fmla="*/ 1179322 h 1610902"/>
                <a:gd name="connsiteX246" fmla="*/ 6858090 w 8363529"/>
                <a:gd name="connsiteY246" fmla="*/ 1193384 h 1610902"/>
                <a:gd name="connsiteX247" fmla="*/ 6866443 w 8363529"/>
                <a:gd name="connsiteY247" fmla="*/ 1120083 h 1610902"/>
                <a:gd name="connsiteX248" fmla="*/ 6933366 w 8363529"/>
                <a:gd name="connsiteY248" fmla="*/ 725134 h 1610902"/>
                <a:gd name="connsiteX249" fmla="*/ 6941729 w 8363529"/>
                <a:gd name="connsiteY249" fmla="*/ 691338 h 1610902"/>
                <a:gd name="connsiteX250" fmla="*/ 6950083 w 8363529"/>
                <a:gd name="connsiteY250" fmla="*/ 757158 h 1610902"/>
                <a:gd name="connsiteX251" fmla="*/ 7017006 w 8363529"/>
                <a:gd name="connsiteY251" fmla="*/ 1398441 h 1610902"/>
                <a:gd name="connsiteX252" fmla="*/ 7025359 w 8363529"/>
                <a:gd name="connsiteY252" fmla="*/ 1496460 h 1610902"/>
                <a:gd name="connsiteX253" fmla="*/ 7033712 w 8363529"/>
                <a:gd name="connsiteY253" fmla="*/ 1410723 h 1610902"/>
                <a:gd name="connsiteX254" fmla="*/ 7100645 w 8363529"/>
                <a:gd name="connsiteY254" fmla="*/ 677353 h 1610902"/>
                <a:gd name="connsiteX255" fmla="*/ 7108998 w 8363529"/>
                <a:gd name="connsiteY255" fmla="*/ 579325 h 1610902"/>
                <a:gd name="connsiteX256" fmla="*/ 7117351 w 8363529"/>
                <a:gd name="connsiteY256" fmla="*/ 576944 h 1610902"/>
                <a:gd name="connsiteX257" fmla="*/ 7184274 w 8363529"/>
                <a:gd name="connsiteY257" fmla="*/ 557279 h 1610902"/>
                <a:gd name="connsiteX258" fmla="*/ 7192628 w 8363529"/>
                <a:gd name="connsiteY258" fmla="*/ 554752 h 1610902"/>
                <a:gd name="connsiteX259" fmla="*/ 7200991 w 8363529"/>
                <a:gd name="connsiteY259" fmla="*/ 615656 h 1610902"/>
                <a:gd name="connsiteX260" fmla="*/ 7267914 w 8363529"/>
                <a:gd name="connsiteY260" fmla="*/ 1066138 h 1610902"/>
                <a:gd name="connsiteX261" fmla="*/ 7276267 w 8363529"/>
                <a:gd name="connsiteY261" fmla="*/ 1118225 h 1610902"/>
                <a:gd name="connsiteX262" fmla="*/ 7284620 w 8363529"/>
                <a:gd name="connsiteY262" fmla="*/ 1092375 h 1610902"/>
                <a:gd name="connsiteX263" fmla="*/ 7351543 w 8363529"/>
                <a:gd name="connsiteY263" fmla="*/ 873478 h 1610902"/>
                <a:gd name="connsiteX264" fmla="*/ 7359906 w 8363529"/>
                <a:gd name="connsiteY264" fmla="*/ 844521 h 1610902"/>
                <a:gd name="connsiteX265" fmla="*/ 7368260 w 8363529"/>
                <a:gd name="connsiteY265" fmla="*/ 810271 h 1610902"/>
                <a:gd name="connsiteX266" fmla="*/ 7435183 w 8363529"/>
                <a:gd name="connsiteY266" fmla="*/ 581667 h 1610902"/>
                <a:gd name="connsiteX267" fmla="*/ 7443536 w 8363529"/>
                <a:gd name="connsiteY267" fmla="*/ 557733 h 1610902"/>
                <a:gd name="connsiteX268" fmla="*/ 7451899 w 8363529"/>
                <a:gd name="connsiteY268" fmla="*/ 594897 h 1610902"/>
                <a:gd name="connsiteX269" fmla="*/ 7518822 w 8363529"/>
                <a:gd name="connsiteY269" fmla="*/ 952605 h 1610902"/>
                <a:gd name="connsiteX270" fmla="*/ 7527175 w 8363529"/>
                <a:gd name="connsiteY270" fmla="*/ 1006589 h 1610902"/>
                <a:gd name="connsiteX271" fmla="*/ 7535528 w 8363529"/>
                <a:gd name="connsiteY271" fmla="*/ 914193 h 1610902"/>
                <a:gd name="connsiteX272" fmla="*/ 7602452 w 8363529"/>
                <a:gd name="connsiteY272" fmla="*/ 294540 h 1610902"/>
                <a:gd name="connsiteX273" fmla="*/ 7610815 w 8363529"/>
                <a:gd name="connsiteY273" fmla="*/ 229407 h 1610902"/>
                <a:gd name="connsiteX274" fmla="*/ 7619168 w 8363529"/>
                <a:gd name="connsiteY274" fmla="*/ 307015 h 1610902"/>
                <a:gd name="connsiteX275" fmla="*/ 7686091 w 8363529"/>
                <a:gd name="connsiteY275" fmla="*/ 980584 h 1610902"/>
                <a:gd name="connsiteX276" fmla="*/ 7694444 w 8363529"/>
                <a:gd name="connsiteY276" fmla="*/ 1072032 h 1610902"/>
                <a:gd name="connsiteX277" fmla="*/ 7702798 w 8363529"/>
                <a:gd name="connsiteY277" fmla="*/ 1026177 h 1610902"/>
                <a:gd name="connsiteX278" fmla="*/ 7769731 w 8363529"/>
                <a:gd name="connsiteY278" fmla="*/ 574186 h 1610902"/>
                <a:gd name="connsiteX279" fmla="*/ 7778084 w 8363529"/>
                <a:gd name="connsiteY279" fmla="*/ 504204 h 1610902"/>
                <a:gd name="connsiteX280" fmla="*/ 7786437 w 8363529"/>
                <a:gd name="connsiteY280" fmla="*/ 599552 h 1610902"/>
                <a:gd name="connsiteX281" fmla="*/ 7853360 w 8363529"/>
                <a:gd name="connsiteY281" fmla="*/ 1065489 h 1610902"/>
                <a:gd name="connsiteX282" fmla="*/ 7861713 w 8363529"/>
                <a:gd name="connsiteY282" fmla="*/ 1102014 h 1610902"/>
                <a:gd name="connsiteX283" fmla="*/ 7870077 w 8363529"/>
                <a:gd name="connsiteY283" fmla="*/ 1091233 h 1610902"/>
                <a:gd name="connsiteX284" fmla="*/ 7937000 w 8363529"/>
                <a:gd name="connsiteY284" fmla="*/ 970413 h 1610902"/>
                <a:gd name="connsiteX285" fmla="*/ 7945353 w 8363529"/>
                <a:gd name="connsiteY285" fmla="*/ 948976 h 1610902"/>
                <a:gd name="connsiteX286" fmla="*/ 7953706 w 8363529"/>
                <a:gd name="connsiteY286" fmla="*/ 970113 h 1610902"/>
                <a:gd name="connsiteX287" fmla="*/ 8020629 w 8363529"/>
                <a:gd name="connsiteY287" fmla="*/ 1131387 h 1610902"/>
                <a:gd name="connsiteX288" fmla="*/ 8028992 w 8363529"/>
                <a:gd name="connsiteY288" fmla="*/ 1150588 h 1610902"/>
                <a:gd name="connsiteX289" fmla="*/ 8037346 w 8363529"/>
                <a:gd name="connsiteY289" fmla="*/ 1138868 h 1610902"/>
                <a:gd name="connsiteX290" fmla="*/ 8104268 w 8363529"/>
                <a:gd name="connsiteY290" fmla="*/ 1031432 h 1610902"/>
                <a:gd name="connsiteX291" fmla="*/ 8112622 w 8363529"/>
                <a:gd name="connsiteY291" fmla="*/ 1015967 h 1610902"/>
                <a:gd name="connsiteX292" fmla="*/ 8120985 w 8363529"/>
                <a:gd name="connsiteY292" fmla="*/ 1054040 h 1610902"/>
                <a:gd name="connsiteX293" fmla="*/ 8187908 w 8363529"/>
                <a:gd name="connsiteY293" fmla="*/ 1255497 h 1610902"/>
                <a:gd name="connsiteX294" fmla="*/ 8196261 w 8363529"/>
                <a:gd name="connsiteY294" fmla="*/ 1272473 h 1610902"/>
                <a:gd name="connsiteX295" fmla="*/ 8204614 w 8363529"/>
                <a:gd name="connsiteY295" fmla="*/ 1198600 h 1610902"/>
                <a:gd name="connsiteX296" fmla="*/ 8271537 w 8363529"/>
                <a:gd name="connsiteY296" fmla="*/ 428784 h 1610902"/>
                <a:gd name="connsiteX297" fmla="*/ 8279900 w 8363529"/>
                <a:gd name="connsiteY297" fmla="*/ 302476 h 1610902"/>
                <a:gd name="connsiteX298" fmla="*/ 8288254 w 8363529"/>
                <a:gd name="connsiteY298" fmla="*/ 385049 h 1610902"/>
                <a:gd name="connsiteX299" fmla="*/ 8355177 w 8363529"/>
                <a:gd name="connsiteY299" fmla="*/ 1052453 h 1610902"/>
                <a:gd name="connsiteX300" fmla="*/ 8363530 w 8363529"/>
                <a:gd name="connsiteY300" fmla="*/ 1136719 h 1610902"/>
                <a:gd name="connsiteX301" fmla="*/ 8363530 w 8363529"/>
                <a:gd name="connsiteY301" fmla="*/ 1172780 h 1610902"/>
                <a:gd name="connsiteX302" fmla="*/ 8355177 w 8363529"/>
                <a:gd name="connsiteY302" fmla="*/ 1087003 h 1610902"/>
                <a:gd name="connsiteX303" fmla="*/ 8288254 w 8363529"/>
                <a:gd name="connsiteY303" fmla="*/ 407579 h 1610902"/>
                <a:gd name="connsiteX304" fmla="*/ 8279900 w 8363529"/>
                <a:gd name="connsiteY304" fmla="*/ 323497 h 1610902"/>
                <a:gd name="connsiteX305" fmla="*/ 8271537 w 8363529"/>
                <a:gd name="connsiteY305" fmla="*/ 467273 h 1610902"/>
                <a:gd name="connsiteX306" fmla="*/ 8204614 w 8363529"/>
                <a:gd name="connsiteY306" fmla="*/ 1343393 h 1610902"/>
                <a:gd name="connsiteX307" fmla="*/ 8196261 w 8363529"/>
                <a:gd name="connsiteY307" fmla="*/ 1427505 h 1610902"/>
                <a:gd name="connsiteX308" fmla="*/ 8187908 w 8363529"/>
                <a:gd name="connsiteY308" fmla="*/ 1420740 h 1610902"/>
                <a:gd name="connsiteX309" fmla="*/ 8120985 w 8363529"/>
                <a:gd name="connsiteY309" fmla="*/ 1340519 h 1610902"/>
                <a:gd name="connsiteX310" fmla="*/ 8112622 w 8363529"/>
                <a:gd name="connsiteY310" fmla="*/ 1325363 h 1610902"/>
                <a:gd name="connsiteX311" fmla="*/ 8104268 w 8363529"/>
                <a:gd name="connsiteY311" fmla="*/ 1324869 h 1610902"/>
                <a:gd name="connsiteX312" fmla="*/ 8037346 w 8363529"/>
                <a:gd name="connsiteY312" fmla="*/ 1321463 h 1610902"/>
                <a:gd name="connsiteX313" fmla="*/ 8028992 w 8363529"/>
                <a:gd name="connsiteY313" fmla="*/ 1321085 h 1610902"/>
                <a:gd name="connsiteX314" fmla="*/ 8020629 w 8363529"/>
                <a:gd name="connsiteY314" fmla="*/ 1287744 h 1610902"/>
                <a:gd name="connsiteX315" fmla="*/ 7953706 w 8363529"/>
                <a:gd name="connsiteY315" fmla="*/ 1007992 h 1610902"/>
                <a:gd name="connsiteX316" fmla="*/ 7945353 w 8363529"/>
                <a:gd name="connsiteY316" fmla="*/ 971322 h 1610902"/>
                <a:gd name="connsiteX317" fmla="*/ 7937000 w 8363529"/>
                <a:gd name="connsiteY317" fmla="*/ 1006928 h 1610902"/>
                <a:gd name="connsiteX318" fmla="*/ 7870077 w 8363529"/>
                <a:gd name="connsiteY318" fmla="*/ 1207562 h 1610902"/>
                <a:gd name="connsiteX319" fmla="*/ 7861713 w 8363529"/>
                <a:gd name="connsiteY319" fmla="*/ 1225476 h 1610902"/>
                <a:gd name="connsiteX320" fmla="*/ 7853360 w 8363529"/>
                <a:gd name="connsiteY320" fmla="*/ 1181925 h 1610902"/>
                <a:gd name="connsiteX321" fmla="*/ 7786437 w 8363529"/>
                <a:gd name="connsiteY321" fmla="*/ 626650 h 1610902"/>
                <a:gd name="connsiteX322" fmla="*/ 7778084 w 8363529"/>
                <a:gd name="connsiteY322" fmla="*/ 513050 h 1610902"/>
                <a:gd name="connsiteX323" fmla="*/ 7769731 w 8363529"/>
                <a:gd name="connsiteY323" fmla="*/ 616033 h 1610902"/>
                <a:gd name="connsiteX324" fmla="*/ 7702798 w 8363529"/>
                <a:gd name="connsiteY324" fmla="*/ 1281096 h 1610902"/>
                <a:gd name="connsiteX325" fmla="*/ 7694444 w 8363529"/>
                <a:gd name="connsiteY325" fmla="*/ 1348532 h 1610902"/>
                <a:gd name="connsiteX326" fmla="*/ 7686091 w 8363529"/>
                <a:gd name="connsiteY326" fmla="*/ 1243555 h 1610902"/>
                <a:gd name="connsiteX327" fmla="*/ 7619168 w 8363529"/>
                <a:gd name="connsiteY327" fmla="*/ 470254 h 1610902"/>
                <a:gd name="connsiteX328" fmla="*/ 7610815 w 8363529"/>
                <a:gd name="connsiteY328" fmla="*/ 381149 h 1610902"/>
                <a:gd name="connsiteX329" fmla="*/ 7602452 w 8363529"/>
                <a:gd name="connsiteY329" fmla="*/ 439787 h 1610902"/>
                <a:gd name="connsiteX330" fmla="*/ 7535528 w 8363529"/>
                <a:gd name="connsiteY330" fmla="*/ 997482 h 1610902"/>
                <a:gd name="connsiteX331" fmla="*/ 7527175 w 8363529"/>
                <a:gd name="connsiteY331" fmla="*/ 1080655 h 1610902"/>
                <a:gd name="connsiteX332" fmla="*/ 7518822 w 8363529"/>
                <a:gd name="connsiteY332" fmla="*/ 1035894 h 1610902"/>
                <a:gd name="connsiteX333" fmla="*/ 7451899 w 8363529"/>
                <a:gd name="connsiteY333" fmla="*/ 739273 h 1610902"/>
                <a:gd name="connsiteX334" fmla="*/ 7443536 w 8363529"/>
                <a:gd name="connsiteY334" fmla="*/ 708429 h 1610902"/>
                <a:gd name="connsiteX335" fmla="*/ 7435183 w 8363529"/>
                <a:gd name="connsiteY335" fmla="*/ 721998 h 1610902"/>
                <a:gd name="connsiteX336" fmla="*/ 7368260 w 8363529"/>
                <a:gd name="connsiteY336" fmla="*/ 851596 h 1610902"/>
                <a:gd name="connsiteX337" fmla="*/ 7359906 w 8363529"/>
                <a:gd name="connsiteY337" fmla="*/ 871020 h 1610902"/>
                <a:gd name="connsiteX338" fmla="*/ 7351543 w 8363529"/>
                <a:gd name="connsiteY338" fmla="*/ 915142 h 1610902"/>
                <a:gd name="connsiteX339" fmla="*/ 7284620 w 8363529"/>
                <a:gd name="connsiteY339" fmla="*/ 1248849 h 1610902"/>
                <a:gd name="connsiteX340" fmla="*/ 7276267 w 8363529"/>
                <a:gd name="connsiteY340" fmla="*/ 1288277 h 1610902"/>
                <a:gd name="connsiteX341" fmla="*/ 7267914 w 8363529"/>
                <a:gd name="connsiteY341" fmla="*/ 1318104 h 1610902"/>
                <a:gd name="connsiteX342" fmla="*/ 7200991 w 8363529"/>
                <a:gd name="connsiteY342" fmla="*/ 1576042 h 1610902"/>
                <a:gd name="connsiteX343" fmla="*/ 7192628 w 8363529"/>
                <a:gd name="connsiteY343" fmla="*/ 1610902 h 1610902"/>
                <a:gd name="connsiteX344" fmla="*/ 7184274 w 8363529"/>
                <a:gd name="connsiteY344" fmla="*/ 1526404 h 1610902"/>
                <a:gd name="connsiteX345" fmla="*/ 7117351 w 8363529"/>
                <a:gd name="connsiteY345" fmla="*/ 876730 h 1610902"/>
                <a:gd name="connsiteX346" fmla="*/ 7108998 w 8363529"/>
                <a:gd name="connsiteY346" fmla="*/ 798667 h 1610902"/>
                <a:gd name="connsiteX347" fmla="*/ 7100645 w 8363529"/>
                <a:gd name="connsiteY347" fmla="*/ 880853 h 1610902"/>
                <a:gd name="connsiteX348" fmla="*/ 7033712 w 8363529"/>
                <a:gd name="connsiteY348" fmla="*/ 1495560 h 1610902"/>
                <a:gd name="connsiteX349" fmla="*/ 7025359 w 8363529"/>
                <a:gd name="connsiteY349" fmla="*/ 1567429 h 1610902"/>
                <a:gd name="connsiteX350" fmla="*/ 7017006 w 8363529"/>
                <a:gd name="connsiteY350" fmla="*/ 1494573 h 1610902"/>
                <a:gd name="connsiteX351" fmla="*/ 6950083 w 8363529"/>
                <a:gd name="connsiteY351" fmla="*/ 1017970 h 1610902"/>
                <a:gd name="connsiteX352" fmla="*/ 6941729 w 8363529"/>
                <a:gd name="connsiteY352" fmla="*/ 969048 h 1610902"/>
                <a:gd name="connsiteX353" fmla="*/ 6933366 w 8363529"/>
                <a:gd name="connsiteY353" fmla="*/ 991172 h 1610902"/>
                <a:gd name="connsiteX354" fmla="*/ 6866443 w 8363529"/>
                <a:gd name="connsiteY354" fmla="*/ 1249487 h 1610902"/>
                <a:gd name="connsiteX355" fmla="*/ 6858090 w 8363529"/>
                <a:gd name="connsiteY355" fmla="*/ 1297422 h 1610902"/>
                <a:gd name="connsiteX356" fmla="*/ 6849737 w 8363529"/>
                <a:gd name="connsiteY356" fmla="*/ 1271602 h 1610902"/>
                <a:gd name="connsiteX357" fmla="*/ 6782814 w 8363529"/>
                <a:gd name="connsiteY357" fmla="*/ 1094301 h 1610902"/>
                <a:gd name="connsiteX358" fmla="*/ 6774451 w 8363529"/>
                <a:gd name="connsiteY358" fmla="*/ 1075245 h 1610902"/>
                <a:gd name="connsiteX359" fmla="*/ 6766097 w 8363529"/>
                <a:gd name="connsiteY359" fmla="*/ 1109495 h 1610902"/>
                <a:gd name="connsiteX360" fmla="*/ 6699174 w 8363529"/>
                <a:gd name="connsiteY360" fmla="*/ 1327173 h 1610902"/>
                <a:gd name="connsiteX361" fmla="*/ 6690821 w 8363529"/>
                <a:gd name="connsiteY361" fmla="*/ 1348909 h 1610902"/>
                <a:gd name="connsiteX362" fmla="*/ 6682458 w 8363529"/>
                <a:gd name="connsiteY362" fmla="*/ 1340712 h 1610902"/>
                <a:gd name="connsiteX363" fmla="*/ 6615535 w 8363529"/>
                <a:gd name="connsiteY363" fmla="*/ 1248200 h 1610902"/>
                <a:gd name="connsiteX364" fmla="*/ 6607182 w 8363529"/>
                <a:gd name="connsiteY364" fmla="*/ 1231602 h 1610902"/>
                <a:gd name="connsiteX365" fmla="*/ 6598829 w 8363529"/>
                <a:gd name="connsiteY365" fmla="*/ 1247639 h 1610902"/>
                <a:gd name="connsiteX366" fmla="*/ 6531944 w 8363529"/>
                <a:gd name="connsiteY366" fmla="*/ 1362149 h 1610902"/>
                <a:gd name="connsiteX367" fmla="*/ 6523542 w 8363529"/>
                <a:gd name="connsiteY367" fmla="*/ 1374963 h 1610902"/>
                <a:gd name="connsiteX368" fmla="*/ 6515189 w 8363529"/>
                <a:gd name="connsiteY368" fmla="*/ 1380895 h 1610902"/>
                <a:gd name="connsiteX369" fmla="*/ 6448305 w 8363529"/>
                <a:gd name="connsiteY369" fmla="*/ 1422936 h 1610902"/>
                <a:gd name="connsiteX370" fmla="*/ 6439913 w 8363529"/>
                <a:gd name="connsiteY370" fmla="*/ 1427621 h 1610902"/>
                <a:gd name="connsiteX371" fmla="*/ 6431560 w 8363529"/>
                <a:gd name="connsiteY371" fmla="*/ 1417943 h 1610902"/>
                <a:gd name="connsiteX372" fmla="*/ 6364665 w 8363529"/>
                <a:gd name="connsiteY372" fmla="*/ 1333638 h 1610902"/>
                <a:gd name="connsiteX373" fmla="*/ 6356273 w 8363529"/>
                <a:gd name="connsiteY373" fmla="*/ 1322111 h 1610902"/>
                <a:gd name="connsiteX374" fmla="*/ 6347920 w 8363529"/>
                <a:gd name="connsiteY374" fmla="*/ 1335186 h 1610902"/>
                <a:gd name="connsiteX375" fmla="*/ 6281036 w 8363529"/>
                <a:gd name="connsiteY375" fmla="*/ 1457980 h 1610902"/>
                <a:gd name="connsiteX376" fmla="*/ 6272644 w 8363529"/>
                <a:gd name="connsiteY376" fmla="*/ 1476049 h 1610902"/>
                <a:gd name="connsiteX377" fmla="*/ 6264280 w 8363529"/>
                <a:gd name="connsiteY377" fmla="*/ 1450799 h 1610902"/>
                <a:gd name="connsiteX378" fmla="*/ 6197396 w 8363529"/>
                <a:gd name="connsiteY378" fmla="*/ 1293338 h 1610902"/>
                <a:gd name="connsiteX379" fmla="*/ 6189004 w 8363529"/>
                <a:gd name="connsiteY379" fmla="*/ 1277882 h 1610902"/>
                <a:gd name="connsiteX380" fmla="*/ 6180651 w 8363529"/>
                <a:gd name="connsiteY380" fmla="*/ 1281541 h 1610902"/>
                <a:gd name="connsiteX381" fmla="*/ 6113767 w 8363529"/>
                <a:gd name="connsiteY381" fmla="*/ 1315346 h 1610902"/>
                <a:gd name="connsiteX382" fmla="*/ 6105365 w 8363529"/>
                <a:gd name="connsiteY382" fmla="*/ 1320253 h 1610902"/>
                <a:gd name="connsiteX383" fmla="*/ 6097011 w 8363529"/>
                <a:gd name="connsiteY383" fmla="*/ 1330695 h 1610902"/>
                <a:gd name="connsiteX384" fmla="*/ 6030127 w 8363529"/>
                <a:gd name="connsiteY384" fmla="*/ 1404335 h 1610902"/>
                <a:gd name="connsiteX385" fmla="*/ 6021735 w 8363529"/>
                <a:gd name="connsiteY385" fmla="*/ 1412465 h 1610902"/>
                <a:gd name="connsiteX386" fmla="*/ 6013372 w 8363529"/>
                <a:gd name="connsiteY386" fmla="*/ 1416017 h 1610902"/>
                <a:gd name="connsiteX387" fmla="*/ 5946488 w 8363529"/>
                <a:gd name="connsiteY387" fmla="*/ 1460323 h 1610902"/>
                <a:gd name="connsiteX388" fmla="*/ 5938096 w 8363529"/>
                <a:gd name="connsiteY388" fmla="*/ 1469130 h 1610902"/>
                <a:gd name="connsiteX389" fmla="*/ 5929743 w 8363529"/>
                <a:gd name="connsiteY389" fmla="*/ 1430911 h 1610902"/>
                <a:gd name="connsiteX390" fmla="*/ 5862858 w 8363529"/>
                <a:gd name="connsiteY390" fmla="*/ 1248616 h 1610902"/>
                <a:gd name="connsiteX391" fmla="*/ 5854457 w 8363529"/>
                <a:gd name="connsiteY391" fmla="*/ 1234670 h 1610902"/>
                <a:gd name="connsiteX392" fmla="*/ 5846103 w 8363529"/>
                <a:gd name="connsiteY392" fmla="*/ 1247368 h 1610902"/>
                <a:gd name="connsiteX393" fmla="*/ 5779219 w 8363529"/>
                <a:gd name="connsiteY393" fmla="*/ 1385163 h 1610902"/>
                <a:gd name="connsiteX394" fmla="*/ 5770827 w 8363529"/>
                <a:gd name="connsiteY394" fmla="*/ 1408797 h 1610902"/>
                <a:gd name="connsiteX395" fmla="*/ 5762474 w 8363529"/>
                <a:gd name="connsiteY395" fmla="*/ 1277950 h 1610902"/>
                <a:gd name="connsiteX396" fmla="*/ 5695580 w 8363529"/>
                <a:gd name="connsiteY396" fmla="*/ 550891 h 1610902"/>
                <a:gd name="connsiteX397" fmla="*/ 5687188 w 8363529"/>
                <a:gd name="connsiteY397" fmla="*/ 486852 h 1610902"/>
                <a:gd name="connsiteX398" fmla="*/ 5678835 w 8363529"/>
                <a:gd name="connsiteY398" fmla="*/ 534903 h 1610902"/>
                <a:gd name="connsiteX399" fmla="*/ 5611950 w 8363529"/>
                <a:gd name="connsiteY399" fmla="*/ 921036 h 1610902"/>
                <a:gd name="connsiteX400" fmla="*/ 5603558 w 8363529"/>
                <a:gd name="connsiteY400" fmla="*/ 969542 h 1610902"/>
                <a:gd name="connsiteX401" fmla="*/ 5595195 w 8363529"/>
                <a:gd name="connsiteY401" fmla="*/ 1012222 h 1610902"/>
                <a:gd name="connsiteX402" fmla="*/ 5528311 w 8363529"/>
                <a:gd name="connsiteY402" fmla="*/ 1498057 h 1610902"/>
                <a:gd name="connsiteX403" fmla="*/ 5519919 w 8363529"/>
                <a:gd name="connsiteY403" fmla="*/ 1585759 h 1610902"/>
                <a:gd name="connsiteX404" fmla="*/ 5511566 w 8363529"/>
                <a:gd name="connsiteY404" fmla="*/ 1582352 h 1610902"/>
                <a:gd name="connsiteX405" fmla="*/ 5444672 w 8363529"/>
                <a:gd name="connsiteY405" fmla="*/ 1521604 h 1610902"/>
                <a:gd name="connsiteX406" fmla="*/ 5436280 w 8363529"/>
                <a:gd name="connsiteY406" fmla="*/ 1503196 h 1610902"/>
                <a:gd name="connsiteX407" fmla="*/ 5427926 w 8363529"/>
                <a:gd name="connsiteY407" fmla="*/ 1380934 h 1610902"/>
                <a:gd name="connsiteX408" fmla="*/ 5361042 w 8363529"/>
                <a:gd name="connsiteY408" fmla="*/ 1026022 h 1610902"/>
                <a:gd name="connsiteX409" fmla="*/ 5352650 w 8363529"/>
                <a:gd name="connsiteY409" fmla="*/ 1008070 h 1610902"/>
                <a:gd name="connsiteX410" fmla="*/ 5344287 w 8363529"/>
                <a:gd name="connsiteY410" fmla="*/ 1032981 h 1610902"/>
                <a:gd name="connsiteX411" fmla="*/ 5277403 w 8363529"/>
                <a:gd name="connsiteY411" fmla="*/ 1205065 h 1610902"/>
                <a:gd name="connsiteX412" fmla="*/ 5269049 w 8363529"/>
                <a:gd name="connsiteY412" fmla="*/ 1223666 h 1610902"/>
                <a:gd name="connsiteX413" fmla="*/ 5260657 w 8363529"/>
                <a:gd name="connsiteY413" fmla="*/ 1203972 h 1610902"/>
                <a:gd name="connsiteX414" fmla="*/ 5193773 w 8363529"/>
                <a:gd name="connsiteY414" fmla="*/ 1059024 h 1610902"/>
                <a:gd name="connsiteX415" fmla="*/ 5185410 w 8363529"/>
                <a:gd name="connsiteY415" fmla="*/ 1042359 h 1610902"/>
                <a:gd name="connsiteX416" fmla="*/ 5177018 w 8363529"/>
                <a:gd name="connsiteY416" fmla="*/ 1042088 h 1610902"/>
                <a:gd name="connsiteX417" fmla="*/ 5110134 w 8363529"/>
                <a:gd name="connsiteY417" fmla="*/ 1039068 h 1610902"/>
                <a:gd name="connsiteX418" fmla="*/ 5101780 w 8363529"/>
                <a:gd name="connsiteY418" fmla="*/ 1038536 h 1610902"/>
                <a:gd name="connsiteX419" fmla="*/ 5093388 w 8363529"/>
                <a:gd name="connsiteY419" fmla="*/ 1080955 h 1610902"/>
                <a:gd name="connsiteX420" fmla="*/ 5026494 w 8363529"/>
                <a:gd name="connsiteY420" fmla="*/ 1365623 h 1610902"/>
                <a:gd name="connsiteX421" fmla="*/ 5018141 w 8363529"/>
                <a:gd name="connsiteY421" fmla="*/ 1395567 h 1610902"/>
                <a:gd name="connsiteX422" fmla="*/ 5009749 w 8363529"/>
                <a:gd name="connsiteY422" fmla="*/ 1399719 h 1610902"/>
                <a:gd name="connsiteX423" fmla="*/ 4942864 w 8363529"/>
                <a:gd name="connsiteY423" fmla="*/ 1429101 h 1610902"/>
                <a:gd name="connsiteX424" fmla="*/ 4934501 w 8363529"/>
                <a:gd name="connsiteY424" fmla="*/ 1432382 h 1610902"/>
                <a:gd name="connsiteX425" fmla="*/ 4926109 w 8363529"/>
                <a:gd name="connsiteY425" fmla="*/ 1414352 h 1610902"/>
                <a:gd name="connsiteX426" fmla="*/ 4859225 w 8363529"/>
                <a:gd name="connsiteY426" fmla="*/ 1198262 h 1610902"/>
                <a:gd name="connsiteX427" fmla="*/ 4850872 w 8363529"/>
                <a:gd name="connsiteY427" fmla="*/ 1156937 h 1610902"/>
                <a:gd name="connsiteX428" fmla="*/ 4842480 w 8363529"/>
                <a:gd name="connsiteY428" fmla="*/ 1114944 h 1610902"/>
                <a:gd name="connsiteX429" fmla="*/ 4775595 w 8363529"/>
                <a:gd name="connsiteY429" fmla="*/ 860442 h 1610902"/>
                <a:gd name="connsiteX430" fmla="*/ 4767232 w 8363529"/>
                <a:gd name="connsiteY430" fmla="*/ 836130 h 1610902"/>
                <a:gd name="connsiteX431" fmla="*/ 4758840 w 8363529"/>
                <a:gd name="connsiteY431" fmla="*/ 841008 h 1610902"/>
                <a:gd name="connsiteX432" fmla="*/ 4691956 w 8363529"/>
                <a:gd name="connsiteY432" fmla="*/ 884520 h 1610902"/>
                <a:gd name="connsiteX433" fmla="*/ 4683603 w 8363529"/>
                <a:gd name="connsiteY433" fmla="*/ 890647 h 1610902"/>
                <a:gd name="connsiteX434" fmla="*/ 4675201 w 8363529"/>
                <a:gd name="connsiteY434" fmla="*/ 945047 h 1610902"/>
                <a:gd name="connsiteX435" fmla="*/ 4608317 w 8363529"/>
                <a:gd name="connsiteY435" fmla="*/ 1390002 h 1610902"/>
                <a:gd name="connsiteX436" fmla="*/ 4599964 w 8363529"/>
                <a:gd name="connsiteY436" fmla="*/ 1446899 h 1610902"/>
                <a:gd name="connsiteX437" fmla="*/ 4591572 w 8363529"/>
                <a:gd name="connsiteY437" fmla="*/ 1445389 h 1610902"/>
                <a:gd name="connsiteX438" fmla="*/ 4524687 w 8363529"/>
                <a:gd name="connsiteY438" fmla="*/ 1434802 h 1610902"/>
                <a:gd name="connsiteX439" fmla="*/ 4516324 w 8363529"/>
                <a:gd name="connsiteY439" fmla="*/ 1433592 h 1610902"/>
                <a:gd name="connsiteX440" fmla="*/ 4507932 w 8363529"/>
                <a:gd name="connsiteY440" fmla="*/ 1400513 h 1610902"/>
                <a:gd name="connsiteX441" fmla="*/ 4441048 w 8363529"/>
                <a:gd name="connsiteY441" fmla="*/ 1150094 h 1610902"/>
                <a:gd name="connsiteX442" fmla="*/ 4432695 w 8363529"/>
                <a:gd name="connsiteY442" fmla="*/ 1120460 h 1610902"/>
                <a:gd name="connsiteX443" fmla="*/ 4424303 w 8363529"/>
                <a:gd name="connsiteY443" fmla="*/ 1042581 h 1610902"/>
                <a:gd name="connsiteX444" fmla="*/ 4357409 w 8363529"/>
                <a:gd name="connsiteY444" fmla="*/ 414305 h 1610902"/>
                <a:gd name="connsiteX445" fmla="*/ 4349055 w 8363529"/>
                <a:gd name="connsiteY445" fmla="*/ 335101 h 1610902"/>
                <a:gd name="connsiteX446" fmla="*/ 4340664 w 8363529"/>
                <a:gd name="connsiteY446" fmla="*/ 433884 h 1610902"/>
                <a:gd name="connsiteX447" fmla="*/ 4273779 w 8363529"/>
                <a:gd name="connsiteY447" fmla="*/ 1289148 h 1610902"/>
                <a:gd name="connsiteX448" fmla="*/ 4265416 w 8363529"/>
                <a:gd name="connsiteY448" fmla="*/ 1404935 h 1610902"/>
                <a:gd name="connsiteX449" fmla="*/ 4257024 w 8363529"/>
                <a:gd name="connsiteY449" fmla="*/ 1306046 h 1610902"/>
                <a:gd name="connsiteX450" fmla="*/ 4190140 w 8363529"/>
                <a:gd name="connsiteY450" fmla="*/ 675805 h 1610902"/>
                <a:gd name="connsiteX451" fmla="*/ 4181787 w 8363529"/>
                <a:gd name="connsiteY451" fmla="*/ 612666 h 1610902"/>
                <a:gd name="connsiteX452" fmla="*/ 4173394 w 8363529"/>
                <a:gd name="connsiteY452" fmla="*/ 670927 h 1610902"/>
                <a:gd name="connsiteX453" fmla="*/ 4106500 w 8363529"/>
                <a:gd name="connsiteY453" fmla="*/ 1383847 h 1610902"/>
                <a:gd name="connsiteX454" fmla="*/ 4098147 w 8363529"/>
                <a:gd name="connsiteY454" fmla="*/ 1523152 h 1610902"/>
                <a:gd name="connsiteX455" fmla="*/ 4089755 w 8363529"/>
                <a:gd name="connsiteY455" fmla="*/ 1475294 h 1610902"/>
                <a:gd name="connsiteX456" fmla="*/ 4022871 w 8363529"/>
                <a:gd name="connsiteY456" fmla="*/ 1225931 h 1610902"/>
                <a:gd name="connsiteX457" fmla="*/ 4014517 w 8363529"/>
                <a:gd name="connsiteY457" fmla="*/ 1205259 h 1610902"/>
                <a:gd name="connsiteX458" fmla="*/ 4006154 w 8363529"/>
                <a:gd name="connsiteY458" fmla="*/ 1234293 h 1610902"/>
                <a:gd name="connsiteX459" fmla="*/ 3939231 w 8363529"/>
                <a:gd name="connsiteY459" fmla="*/ 1497825 h 1610902"/>
                <a:gd name="connsiteX460" fmla="*/ 3930878 w 8363529"/>
                <a:gd name="connsiteY460" fmla="*/ 1535250 h 1610902"/>
                <a:gd name="connsiteX461" fmla="*/ 3922525 w 8363529"/>
                <a:gd name="connsiteY461" fmla="*/ 1512758 h 1610902"/>
                <a:gd name="connsiteX462" fmla="*/ 3855602 w 8363529"/>
                <a:gd name="connsiteY462" fmla="*/ 1312694 h 1610902"/>
                <a:gd name="connsiteX463" fmla="*/ 3847239 w 8363529"/>
                <a:gd name="connsiteY463" fmla="*/ 1284870 h 1610902"/>
                <a:gd name="connsiteX464" fmla="*/ 3838885 w 8363529"/>
                <a:gd name="connsiteY464" fmla="*/ 1281057 h 1610902"/>
                <a:gd name="connsiteX465" fmla="*/ 3771962 w 8363529"/>
                <a:gd name="connsiteY465" fmla="*/ 1253001 h 1610902"/>
                <a:gd name="connsiteX466" fmla="*/ 3763609 w 8363529"/>
                <a:gd name="connsiteY466" fmla="*/ 1249787 h 1610902"/>
                <a:gd name="connsiteX467" fmla="*/ 3755246 w 8363529"/>
                <a:gd name="connsiteY467" fmla="*/ 1219360 h 1610902"/>
                <a:gd name="connsiteX468" fmla="*/ 3688323 w 8363529"/>
                <a:gd name="connsiteY468" fmla="*/ 941950 h 1610902"/>
                <a:gd name="connsiteX469" fmla="*/ 3679970 w 8363529"/>
                <a:gd name="connsiteY469" fmla="*/ 902405 h 1610902"/>
                <a:gd name="connsiteX470" fmla="*/ 3671616 w 8363529"/>
                <a:gd name="connsiteY470" fmla="*/ 864487 h 1610902"/>
                <a:gd name="connsiteX471" fmla="*/ 3604693 w 8363529"/>
                <a:gd name="connsiteY471" fmla="*/ 637093 h 1610902"/>
                <a:gd name="connsiteX472" fmla="*/ 3596330 w 8363529"/>
                <a:gd name="connsiteY472" fmla="*/ 615617 h 1610902"/>
                <a:gd name="connsiteX473" fmla="*/ 3587977 w 8363529"/>
                <a:gd name="connsiteY473" fmla="*/ 651948 h 1610902"/>
                <a:gd name="connsiteX474" fmla="*/ 3521054 w 8363529"/>
                <a:gd name="connsiteY474" fmla="*/ 986594 h 1610902"/>
                <a:gd name="connsiteX475" fmla="*/ 3512701 w 8363529"/>
                <a:gd name="connsiteY475" fmla="*/ 1034868 h 1610902"/>
                <a:gd name="connsiteX476" fmla="*/ 3504347 w 8363529"/>
                <a:gd name="connsiteY476" fmla="*/ 969048 h 1610902"/>
                <a:gd name="connsiteX477" fmla="*/ 3437424 w 8363529"/>
                <a:gd name="connsiteY477" fmla="*/ 510514 h 1610902"/>
                <a:gd name="connsiteX478" fmla="*/ 3429061 w 8363529"/>
                <a:gd name="connsiteY478" fmla="*/ 460499 h 1610902"/>
                <a:gd name="connsiteX479" fmla="*/ 3420708 w 8363529"/>
                <a:gd name="connsiteY479" fmla="*/ 496230 h 1610902"/>
                <a:gd name="connsiteX480" fmla="*/ 3353785 w 8363529"/>
                <a:gd name="connsiteY480" fmla="*/ 1196829 h 1610902"/>
                <a:gd name="connsiteX481" fmla="*/ 3345432 w 8363529"/>
                <a:gd name="connsiteY481" fmla="*/ 1435789 h 1610902"/>
                <a:gd name="connsiteX482" fmla="*/ 3337069 w 8363529"/>
                <a:gd name="connsiteY482" fmla="*/ 1414052 h 1610902"/>
                <a:gd name="connsiteX483" fmla="*/ 3270146 w 8363529"/>
                <a:gd name="connsiteY483" fmla="*/ 1338022 h 1610902"/>
                <a:gd name="connsiteX484" fmla="*/ 3261792 w 8363529"/>
                <a:gd name="connsiteY484" fmla="*/ 1333560 h 1610902"/>
                <a:gd name="connsiteX485" fmla="*/ 3253439 w 8363529"/>
                <a:gd name="connsiteY485" fmla="*/ 1281473 h 1610902"/>
                <a:gd name="connsiteX486" fmla="*/ 3186516 w 8363529"/>
                <a:gd name="connsiteY486" fmla="*/ 950186 h 1610902"/>
                <a:gd name="connsiteX487" fmla="*/ 3178153 w 8363529"/>
                <a:gd name="connsiteY487" fmla="*/ 917068 h 1610902"/>
                <a:gd name="connsiteX488" fmla="*/ 3169800 w 8363529"/>
                <a:gd name="connsiteY488" fmla="*/ 918432 h 1610902"/>
                <a:gd name="connsiteX489" fmla="*/ 3102877 w 8363529"/>
                <a:gd name="connsiteY489" fmla="*/ 933665 h 1610902"/>
                <a:gd name="connsiteX490" fmla="*/ 3094523 w 8363529"/>
                <a:gd name="connsiteY490" fmla="*/ 936346 h 1610902"/>
                <a:gd name="connsiteX491" fmla="*/ 3086161 w 8363529"/>
                <a:gd name="connsiteY491" fmla="*/ 956651 h 1610902"/>
                <a:gd name="connsiteX492" fmla="*/ 3019238 w 8363529"/>
                <a:gd name="connsiteY492" fmla="*/ 1084168 h 1610902"/>
                <a:gd name="connsiteX493" fmla="*/ 3010884 w 8363529"/>
                <a:gd name="connsiteY493" fmla="*/ 1096759 h 1610902"/>
                <a:gd name="connsiteX494" fmla="*/ 3002531 w 8363529"/>
                <a:gd name="connsiteY494" fmla="*/ 1060766 h 1610902"/>
                <a:gd name="connsiteX495" fmla="*/ 2935608 w 8363529"/>
                <a:gd name="connsiteY495" fmla="*/ 760594 h 1610902"/>
                <a:gd name="connsiteX496" fmla="*/ 2927245 w 8363529"/>
                <a:gd name="connsiteY496" fmla="*/ 721466 h 1610902"/>
                <a:gd name="connsiteX497" fmla="*/ 2918892 w 8363529"/>
                <a:gd name="connsiteY497" fmla="*/ 742680 h 1610902"/>
                <a:gd name="connsiteX498" fmla="*/ 2851968 w 8363529"/>
                <a:gd name="connsiteY498" fmla="*/ 907699 h 1610902"/>
                <a:gd name="connsiteX499" fmla="*/ 2843615 w 8363529"/>
                <a:gd name="connsiteY499" fmla="*/ 927771 h 1610902"/>
                <a:gd name="connsiteX500" fmla="*/ 2835262 w 8363529"/>
                <a:gd name="connsiteY500" fmla="*/ 938582 h 1610902"/>
                <a:gd name="connsiteX501" fmla="*/ 2768329 w 8363529"/>
                <a:gd name="connsiteY501" fmla="*/ 1052714 h 1610902"/>
                <a:gd name="connsiteX502" fmla="*/ 2759976 w 8363529"/>
                <a:gd name="connsiteY502" fmla="*/ 1071732 h 1610902"/>
                <a:gd name="connsiteX503" fmla="*/ 2751623 w 8363529"/>
                <a:gd name="connsiteY503" fmla="*/ 1051427 h 1610902"/>
                <a:gd name="connsiteX504" fmla="*/ 2684699 w 8363529"/>
                <a:gd name="connsiteY504" fmla="*/ 914541 h 1610902"/>
                <a:gd name="connsiteX505" fmla="*/ 2676346 w 8363529"/>
                <a:gd name="connsiteY505" fmla="*/ 900054 h 1610902"/>
                <a:gd name="connsiteX506" fmla="*/ 2667983 w 8363529"/>
                <a:gd name="connsiteY506" fmla="*/ 941001 h 1610902"/>
                <a:gd name="connsiteX507" fmla="*/ 2601060 w 8363529"/>
                <a:gd name="connsiteY507" fmla="*/ 1264304 h 1610902"/>
                <a:gd name="connsiteX508" fmla="*/ 2592707 w 8363529"/>
                <a:gd name="connsiteY508" fmla="*/ 1304187 h 1610902"/>
                <a:gd name="connsiteX509" fmla="*/ 2584354 w 8363529"/>
                <a:gd name="connsiteY509" fmla="*/ 1270924 h 1610902"/>
                <a:gd name="connsiteX510" fmla="*/ 2517430 w 8363529"/>
                <a:gd name="connsiteY510" fmla="*/ 1043907 h 1610902"/>
                <a:gd name="connsiteX511" fmla="*/ 2509068 w 8363529"/>
                <a:gd name="connsiteY511" fmla="*/ 1019635 h 1610902"/>
                <a:gd name="connsiteX512" fmla="*/ 2500714 w 8363529"/>
                <a:gd name="connsiteY512" fmla="*/ 1015667 h 1610902"/>
                <a:gd name="connsiteX513" fmla="*/ 2433791 w 8363529"/>
                <a:gd name="connsiteY513" fmla="*/ 981978 h 1610902"/>
                <a:gd name="connsiteX514" fmla="*/ 2425438 w 8363529"/>
                <a:gd name="connsiteY514" fmla="*/ 977516 h 1610902"/>
                <a:gd name="connsiteX515" fmla="*/ 2417075 w 8363529"/>
                <a:gd name="connsiteY515" fmla="*/ 1009241 h 1610902"/>
                <a:gd name="connsiteX516" fmla="*/ 2350152 w 8363529"/>
                <a:gd name="connsiteY516" fmla="*/ 1276402 h 1610902"/>
                <a:gd name="connsiteX517" fmla="*/ 2341799 w 8363529"/>
                <a:gd name="connsiteY517" fmla="*/ 1311562 h 1610902"/>
                <a:gd name="connsiteX518" fmla="*/ 2333445 w 8363529"/>
                <a:gd name="connsiteY518" fmla="*/ 1303549 h 1610902"/>
                <a:gd name="connsiteX519" fmla="*/ 2266522 w 8363529"/>
                <a:gd name="connsiteY519" fmla="*/ 1225031 h 1610902"/>
                <a:gd name="connsiteX520" fmla="*/ 2258159 w 8363529"/>
                <a:gd name="connsiteY520" fmla="*/ 1212963 h 1610902"/>
                <a:gd name="connsiteX521" fmla="*/ 2249806 w 8363529"/>
                <a:gd name="connsiteY521" fmla="*/ 1198600 h 1610902"/>
                <a:gd name="connsiteX522" fmla="*/ 2182883 w 8363529"/>
                <a:gd name="connsiteY522" fmla="*/ 1102653 h 1610902"/>
                <a:gd name="connsiteX523" fmla="*/ 2174530 w 8363529"/>
                <a:gd name="connsiteY523" fmla="*/ 1092597 h 1610902"/>
                <a:gd name="connsiteX524" fmla="*/ 2166176 w 8363529"/>
                <a:gd name="connsiteY524" fmla="*/ 1033920 h 1610902"/>
                <a:gd name="connsiteX525" fmla="*/ 2099253 w 8363529"/>
                <a:gd name="connsiteY525" fmla="*/ 489155 h 1610902"/>
                <a:gd name="connsiteX526" fmla="*/ 2090890 w 8363529"/>
                <a:gd name="connsiteY526" fmla="*/ 409999 h 1610902"/>
                <a:gd name="connsiteX527" fmla="*/ 2082537 w 8363529"/>
                <a:gd name="connsiteY527" fmla="*/ 531080 h 1610902"/>
                <a:gd name="connsiteX528" fmla="*/ 2015614 w 8363529"/>
                <a:gd name="connsiteY528" fmla="*/ 1270963 h 1610902"/>
                <a:gd name="connsiteX529" fmla="*/ 2007260 w 8363529"/>
                <a:gd name="connsiteY529" fmla="*/ 1342183 h 1610902"/>
                <a:gd name="connsiteX530" fmla="*/ 1998898 w 8363529"/>
                <a:gd name="connsiteY530" fmla="*/ 1333938 h 1610902"/>
                <a:gd name="connsiteX531" fmla="*/ 1931975 w 8363529"/>
                <a:gd name="connsiteY531" fmla="*/ 1249710 h 1610902"/>
                <a:gd name="connsiteX532" fmla="*/ 1923621 w 8363529"/>
                <a:gd name="connsiteY532" fmla="*/ 1236141 h 1610902"/>
                <a:gd name="connsiteX533" fmla="*/ 1915268 w 8363529"/>
                <a:gd name="connsiteY533" fmla="*/ 1242190 h 1610902"/>
                <a:gd name="connsiteX534" fmla="*/ 1848345 w 8363529"/>
                <a:gd name="connsiteY534" fmla="*/ 1291035 h 1610902"/>
                <a:gd name="connsiteX535" fmla="*/ 1839982 w 8363529"/>
                <a:gd name="connsiteY535" fmla="*/ 1297200 h 1610902"/>
                <a:gd name="connsiteX536" fmla="*/ 1831629 w 8363529"/>
                <a:gd name="connsiteY536" fmla="*/ 1296629 h 1610902"/>
                <a:gd name="connsiteX537" fmla="*/ 1764706 w 8363529"/>
                <a:gd name="connsiteY537" fmla="*/ 1292399 h 1610902"/>
                <a:gd name="connsiteX538" fmla="*/ 1756352 w 8363529"/>
                <a:gd name="connsiteY538" fmla="*/ 1291906 h 1610902"/>
                <a:gd name="connsiteX539" fmla="*/ 1747989 w 8363529"/>
                <a:gd name="connsiteY539" fmla="*/ 1301052 h 1610902"/>
                <a:gd name="connsiteX540" fmla="*/ 1681066 w 8363529"/>
                <a:gd name="connsiteY540" fmla="*/ 1361462 h 1610902"/>
                <a:gd name="connsiteX541" fmla="*/ 1672713 w 8363529"/>
                <a:gd name="connsiteY541" fmla="*/ 1367743 h 1610902"/>
                <a:gd name="connsiteX542" fmla="*/ 1664360 w 8363529"/>
                <a:gd name="connsiteY542" fmla="*/ 1370501 h 1610902"/>
                <a:gd name="connsiteX543" fmla="*/ 1597437 w 8363529"/>
                <a:gd name="connsiteY543" fmla="*/ 1403387 h 1610902"/>
                <a:gd name="connsiteX544" fmla="*/ 1589074 w 8363529"/>
                <a:gd name="connsiteY544" fmla="*/ 1409629 h 1610902"/>
                <a:gd name="connsiteX545" fmla="*/ 1580720 w 8363529"/>
                <a:gd name="connsiteY545" fmla="*/ 1410645 h 1610902"/>
                <a:gd name="connsiteX546" fmla="*/ 1513797 w 8363529"/>
                <a:gd name="connsiteY546" fmla="*/ 1417033 h 1610902"/>
                <a:gd name="connsiteX547" fmla="*/ 1505444 w 8363529"/>
                <a:gd name="connsiteY547" fmla="*/ 1417681 h 1610902"/>
                <a:gd name="connsiteX548" fmla="*/ 1497091 w 8363529"/>
                <a:gd name="connsiteY548" fmla="*/ 1378737 h 1610902"/>
                <a:gd name="connsiteX549" fmla="*/ 1430158 w 8363529"/>
                <a:gd name="connsiteY549" fmla="*/ 1117741 h 1610902"/>
                <a:gd name="connsiteX550" fmla="*/ 1421805 w 8363529"/>
                <a:gd name="connsiteY550" fmla="*/ 1090333 h 1610902"/>
                <a:gd name="connsiteX551" fmla="*/ 1413451 w 8363529"/>
                <a:gd name="connsiteY551" fmla="*/ 1113802 h 1610902"/>
                <a:gd name="connsiteX552" fmla="*/ 1346528 w 8363529"/>
                <a:gd name="connsiteY552" fmla="*/ 1394280 h 1610902"/>
                <a:gd name="connsiteX553" fmla="*/ 1338175 w 8363529"/>
                <a:gd name="connsiteY553" fmla="*/ 1447654 h 1610902"/>
                <a:gd name="connsiteX554" fmla="*/ 1329812 w 8363529"/>
                <a:gd name="connsiteY554" fmla="*/ 1353681 h 1610902"/>
                <a:gd name="connsiteX555" fmla="*/ 1262889 w 8363529"/>
                <a:gd name="connsiteY555" fmla="*/ 890114 h 1610902"/>
                <a:gd name="connsiteX556" fmla="*/ 1254536 w 8363529"/>
                <a:gd name="connsiteY556" fmla="*/ 853483 h 1610902"/>
                <a:gd name="connsiteX557" fmla="*/ 1246182 w 8363529"/>
                <a:gd name="connsiteY557" fmla="*/ 872994 h 1610902"/>
                <a:gd name="connsiteX558" fmla="*/ 1179259 w 8363529"/>
                <a:gd name="connsiteY558" fmla="*/ 1057215 h 1610902"/>
                <a:gd name="connsiteX559" fmla="*/ 1170896 w 8363529"/>
                <a:gd name="connsiteY559" fmla="*/ 1084507 h 1610902"/>
                <a:gd name="connsiteX560" fmla="*/ 1162543 w 8363529"/>
                <a:gd name="connsiteY560" fmla="*/ 1113734 h 1610902"/>
                <a:gd name="connsiteX561" fmla="*/ 1095620 w 8363529"/>
                <a:gd name="connsiteY561" fmla="*/ 1334809 h 1610902"/>
                <a:gd name="connsiteX562" fmla="*/ 1087267 w 8363529"/>
                <a:gd name="connsiteY562" fmla="*/ 1360939 h 1610902"/>
                <a:gd name="connsiteX563" fmla="*/ 1078904 w 8363529"/>
                <a:gd name="connsiteY563" fmla="*/ 1356323 h 1610902"/>
                <a:gd name="connsiteX564" fmla="*/ 1011981 w 8363529"/>
                <a:gd name="connsiteY564" fmla="*/ 1325585 h 1610902"/>
                <a:gd name="connsiteX565" fmla="*/ 1003627 w 8363529"/>
                <a:gd name="connsiteY565" fmla="*/ 1322411 h 1610902"/>
                <a:gd name="connsiteX566" fmla="*/ 995274 w 8363529"/>
                <a:gd name="connsiteY566" fmla="*/ 1301623 h 1610902"/>
                <a:gd name="connsiteX567" fmla="*/ 928351 w 8363529"/>
                <a:gd name="connsiteY567" fmla="*/ 1086394 h 1610902"/>
                <a:gd name="connsiteX568" fmla="*/ 919988 w 8363529"/>
                <a:gd name="connsiteY568" fmla="*/ 1051311 h 1610902"/>
                <a:gd name="connsiteX569" fmla="*/ 911635 w 8363529"/>
                <a:gd name="connsiteY569" fmla="*/ 1076493 h 1610902"/>
                <a:gd name="connsiteX570" fmla="*/ 844712 w 8363529"/>
                <a:gd name="connsiteY570" fmla="*/ 1239964 h 1610902"/>
                <a:gd name="connsiteX571" fmla="*/ 836358 w 8363529"/>
                <a:gd name="connsiteY571" fmla="*/ 1256591 h 1610902"/>
                <a:gd name="connsiteX572" fmla="*/ 828005 w 8363529"/>
                <a:gd name="connsiteY572" fmla="*/ 1263927 h 1610902"/>
                <a:gd name="connsiteX573" fmla="*/ 761082 w 8363529"/>
                <a:gd name="connsiteY573" fmla="*/ 1338670 h 1610902"/>
                <a:gd name="connsiteX574" fmla="*/ 752719 w 8363529"/>
                <a:gd name="connsiteY574" fmla="*/ 1350651 h 1610902"/>
                <a:gd name="connsiteX575" fmla="*/ 744366 w 8363529"/>
                <a:gd name="connsiteY575" fmla="*/ 1327095 h 1610902"/>
                <a:gd name="connsiteX576" fmla="*/ 677443 w 8363529"/>
                <a:gd name="connsiteY576" fmla="*/ 1102014 h 1610902"/>
                <a:gd name="connsiteX577" fmla="*/ 669089 w 8363529"/>
                <a:gd name="connsiteY577" fmla="*/ 1068286 h 1610902"/>
                <a:gd name="connsiteX578" fmla="*/ 660727 w 8363529"/>
                <a:gd name="connsiteY578" fmla="*/ 1033736 h 1610902"/>
                <a:gd name="connsiteX579" fmla="*/ 593803 w 8363529"/>
                <a:gd name="connsiteY579" fmla="*/ 845392 h 1610902"/>
                <a:gd name="connsiteX580" fmla="*/ 585450 w 8363529"/>
                <a:gd name="connsiteY580" fmla="*/ 829095 h 1610902"/>
                <a:gd name="connsiteX581" fmla="*/ 577097 w 8363529"/>
                <a:gd name="connsiteY581" fmla="*/ 838550 h 1610902"/>
                <a:gd name="connsiteX582" fmla="*/ 510174 w 8363529"/>
                <a:gd name="connsiteY582" fmla="*/ 959680 h 1610902"/>
                <a:gd name="connsiteX583" fmla="*/ 501811 w 8363529"/>
                <a:gd name="connsiteY583" fmla="*/ 984591 h 1610902"/>
                <a:gd name="connsiteX584" fmla="*/ 493458 w 8363529"/>
                <a:gd name="connsiteY584" fmla="*/ 939946 h 1610902"/>
                <a:gd name="connsiteX585" fmla="*/ 426534 w 8363529"/>
                <a:gd name="connsiteY585" fmla="*/ 740144 h 1610902"/>
                <a:gd name="connsiteX586" fmla="*/ 418181 w 8363529"/>
                <a:gd name="connsiteY586" fmla="*/ 725666 h 1610902"/>
                <a:gd name="connsiteX587" fmla="*/ 409818 w 8363529"/>
                <a:gd name="connsiteY587" fmla="*/ 741276 h 1610902"/>
                <a:gd name="connsiteX588" fmla="*/ 342895 w 8363529"/>
                <a:gd name="connsiteY588" fmla="*/ 911212 h 1610902"/>
                <a:gd name="connsiteX589" fmla="*/ 334542 w 8363529"/>
                <a:gd name="connsiteY589" fmla="*/ 940430 h 1610902"/>
                <a:gd name="connsiteX590" fmla="*/ 326189 w 8363529"/>
                <a:gd name="connsiteY590" fmla="*/ 974913 h 1610902"/>
                <a:gd name="connsiteX591" fmla="*/ 259304 w 8363529"/>
                <a:gd name="connsiteY591" fmla="*/ 1293677 h 1610902"/>
                <a:gd name="connsiteX592" fmla="*/ 250903 w 8363529"/>
                <a:gd name="connsiteY592" fmla="*/ 1339802 h 1610902"/>
                <a:gd name="connsiteX593" fmla="*/ 242549 w 8363529"/>
                <a:gd name="connsiteY593" fmla="*/ 1325092 h 1610902"/>
                <a:gd name="connsiteX594" fmla="*/ 175665 w 8363529"/>
                <a:gd name="connsiteY594" fmla="*/ 1242945 h 1610902"/>
                <a:gd name="connsiteX595" fmla="*/ 167273 w 8363529"/>
                <a:gd name="connsiteY595" fmla="*/ 1235648 h 1610902"/>
                <a:gd name="connsiteX596" fmla="*/ 158920 w 8363529"/>
                <a:gd name="connsiteY596" fmla="*/ 1206236 h 1610902"/>
                <a:gd name="connsiteX597" fmla="*/ 92029 w 8363529"/>
                <a:gd name="connsiteY597" fmla="*/ 935214 h 1610902"/>
                <a:gd name="connsiteX598" fmla="*/ 83635 w 8363529"/>
                <a:gd name="connsiteY598" fmla="*/ 896086 h 1610902"/>
                <a:gd name="connsiteX599" fmla="*/ 75279 w 8363529"/>
                <a:gd name="connsiteY599" fmla="*/ 898360 h 1610902"/>
                <a:gd name="connsiteX600" fmla="*/ 8394 w 8363529"/>
                <a:gd name="connsiteY600" fmla="*/ 916197 h 1610902"/>
                <a:gd name="connsiteX601" fmla="*/ 0 w 8363529"/>
                <a:gd name="connsiteY601" fmla="*/ 918393 h 16109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  <a:cxn ang="0">
                  <a:pos x="connsiteX466" y="connsiteY466"/>
                </a:cxn>
                <a:cxn ang="0">
                  <a:pos x="connsiteX467" y="connsiteY467"/>
                </a:cxn>
                <a:cxn ang="0">
                  <a:pos x="connsiteX468" y="connsiteY468"/>
                </a:cxn>
                <a:cxn ang="0">
                  <a:pos x="connsiteX469" y="connsiteY469"/>
                </a:cxn>
                <a:cxn ang="0">
                  <a:pos x="connsiteX470" y="connsiteY470"/>
                </a:cxn>
                <a:cxn ang="0">
                  <a:pos x="connsiteX471" y="connsiteY471"/>
                </a:cxn>
                <a:cxn ang="0">
                  <a:pos x="connsiteX472" y="connsiteY472"/>
                </a:cxn>
                <a:cxn ang="0">
                  <a:pos x="connsiteX473" y="connsiteY473"/>
                </a:cxn>
                <a:cxn ang="0">
                  <a:pos x="connsiteX474" y="connsiteY474"/>
                </a:cxn>
                <a:cxn ang="0">
                  <a:pos x="connsiteX475" y="connsiteY475"/>
                </a:cxn>
                <a:cxn ang="0">
                  <a:pos x="connsiteX476" y="connsiteY476"/>
                </a:cxn>
                <a:cxn ang="0">
                  <a:pos x="connsiteX477" y="connsiteY477"/>
                </a:cxn>
                <a:cxn ang="0">
                  <a:pos x="connsiteX478" y="connsiteY478"/>
                </a:cxn>
                <a:cxn ang="0">
                  <a:pos x="connsiteX479" y="connsiteY479"/>
                </a:cxn>
                <a:cxn ang="0">
                  <a:pos x="connsiteX480" y="connsiteY480"/>
                </a:cxn>
                <a:cxn ang="0">
                  <a:pos x="connsiteX481" y="connsiteY481"/>
                </a:cxn>
                <a:cxn ang="0">
                  <a:pos x="connsiteX482" y="connsiteY482"/>
                </a:cxn>
                <a:cxn ang="0">
                  <a:pos x="connsiteX483" y="connsiteY483"/>
                </a:cxn>
                <a:cxn ang="0">
                  <a:pos x="connsiteX484" y="connsiteY484"/>
                </a:cxn>
                <a:cxn ang="0">
                  <a:pos x="connsiteX485" y="connsiteY485"/>
                </a:cxn>
                <a:cxn ang="0">
                  <a:pos x="connsiteX486" y="connsiteY486"/>
                </a:cxn>
                <a:cxn ang="0">
                  <a:pos x="connsiteX487" y="connsiteY487"/>
                </a:cxn>
                <a:cxn ang="0">
                  <a:pos x="connsiteX488" y="connsiteY488"/>
                </a:cxn>
                <a:cxn ang="0">
                  <a:pos x="connsiteX489" y="connsiteY489"/>
                </a:cxn>
                <a:cxn ang="0">
                  <a:pos x="connsiteX490" y="connsiteY490"/>
                </a:cxn>
                <a:cxn ang="0">
                  <a:pos x="connsiteX491" y="connsiteY491"/>
                </a:cxn>
                <a:cxn ang="0">
                  <a:pos x="connsiteX492" y="connsiteY492"/>
                </a:cxn>
                <a:cxn ang="0">
                  <a:pos x="connsiteX493" y="connsiteY493"/>
                </a:cxn>
                <a:cxn ang="0">
                  <a:pos x="connsiteX494" y="connsiteY494"/>
                </a:cxn>
                <a:cxn ang="0">
                  <a:pos x="connsiteX495" y="connsiteY495"/>
                </a:cxn>
                <a:cxn ang="0">
                  <a:pos x="connsiteX496" y="connsiteY496"/>
                </a:cxn>
                <a:cxn ang="0">
                  <a:pos x="connsiteX497" y="connsiteY497"/>
                </a:cxn>
                <a:cxn ang="0">
                  <a:pos x="connsiteX498" y="connsiteY498"/>
                </a:cxn>
                <a:cxn ang="0">
                  <a:pos x="connsiteX499" y="connsiteY499"/>
                </a:cxn>
                <a:cxn ang="0">
                  <a:pos x="connsiteX500" y="connsiteY500"/>
                </a:cxn>
                <a:cxn ang="0">
                  <a:pos x="connsiteX501" y="connsiteY501"/>
                </a:cxn>
                <a:cxn ang="0">
                  <a:pos x="connsiteX502" y="connsiteY502"/>
                </a:cxn>
                <a:cxn ang="0">
                  <a:pos x="connsiteX503" y="connsiteY503"/>
                </a:cxn>
                <a:cxn ang="0">
                  <a:pos x="connsiteX504" y="connsiteY504"/>
                </a:cxn>
                <a:cxn ang="0">
                  <a:pos x="connsiteX505" y="connsiteY505"/>
                </a:cxn>
                <a:cxn ang="0">
                  <a:pos x="connsiteX506" y="connsiteY506"/>
                </a:cxn>
                <a:cxn ang="0">
                  <a:pos x="connsiteX507" y="connsiteY507"/>
                </a:cxn>
                <a:cxn ang="0">
                  <a:pos x="connsiteX508" y="connsiteY508"/>
                </a:cxn>
                <a:cxn ang="0">
                  <a:pos x="connsiteX509" y="connsiteY509"/>
                </a:cxn>
                <a:cxn ang="0">
                  <a:pos x="connsiteX510" y="connsiteY510"/>
                </a:cxn>
                <a:cxn ang="0">
                  <a:pos x="connsiteX511" y="connsiteY511"/>
                </a:cxn>
                <a:cxn ang="0">
                  <a:pos x="connsiteX512" y="connsiteY512"/>
                </a:cxn>
                <a:cxn ang="0">
                  <a:pos x="connsiteX513" y="connsiteY513"/>
                </a:cxn>
                <a:cxn ang="0">
                  <a:pos x="connsiteX514" y="connsiteY514"/>
                </a:cxn>
                <a:cxn ang="0">
                  <a:pos x="connsiteX515" y="connsiteY515"/>
                </a:cxn>
                <a:cxn ang="0">
                  <a:pos x="connsiteX516" y="connsiteY516"/>
                </a:cxn>
                <a:cxn ang="0">
                  <a:pos x="connsiteX517" y="connsiteY517"/>
                </a:cxn>
                <a:cxn ang="0">
                  <a:pos x="connsiteX518" y="connsiteY518"/>
                </a:cxn>
                <a:cxn ang="0">
                  <a:pos x="connsiteX519" y="connsiteY519"/>
                </a:cxn>
                <a:cxn ang="0">
                  <a:pos x="connsiteX520" y="connsiteY520"/>
                </a:cxn>
                <a:cxn ang="0">
                  <a:pos x="connsiteX521" y="connsiteY521"/>
                </a:cxn>
                <a:cxn ang="0">
                  <a:pos x="connsiteX522" y="connsiteY522"/>
                </a:cxn>
                <a:cxn ang="0">
                  <a:pos x="connsiteX523" y="connsiteY523"/>
                </a:cxn>
                <a:cxn ang="0">
                  <a:pos x="connsiteX524" y="connsiteY524"/>
                </a:cxn>
                <a:cxn ang="0">
                  <a:pos x="connsiteX525" y="connsiteY525"/>
                </a:cxn>
                <a:cxn ang="0">
                  <a:pos x="connsiteX526" y="connsiteY526"/>
                </a:cxn>
                <a:cxn ang="0">
                  <a:pos x="connsiteX527" y="connsiteY527"/>
                </a:cxn>
                <a:cxn ang="0">
                  <a:pos x="connsiteX528" y="connsiteY528"/>
                </a:cxn>
                <a:cxn ang="0">
                  <a:pos x="connsiteX529" y="connsiteY529"/>
                </a:cxn>
                <a:cxn ang="0">
                  <a:pos x="connsiteX530" y="connsiteY530"/>
                </a:cxn>
                <a:cxn ang="0">
                  <a:pos x="connsiteX531" y="connsiteY531"/>
                </a:cxn>
                <a:cxn ang="0">
                  <a:pos x="connsiteX532" y="connsiteY532"/>
                </a:cxn>
                <a:cxn ang="0">
                  <a:pos x="connsiteX533" y="connsiteY533"/>
                </a:cxn>
                <a:cxn ang="0">
                  <a:pos x="connsiteX534" y="connsiteY534"/>
                </a:cxn>
                <a:cxn ang="0">
                  <a:pos x="connsiteX535" y="connsiteY535"/>
                </a:cxn>
                <a:cxn ang="0">
                  <a:pos x="connsiteX536" y="connsiteY536"/>
                </a:cxn>
                <a:cxn ang="0">
                  <a:pos x="connsiteX537" y="connsiteY537"/>
                </a:cxn>
                <a:cxn ang="0">
                  <a:pos x="connsiteX538" y="connsiteY538"/>
                </a:cxn>
                <a:cxn ang="0">
                  <a:pos x="connsiteX539" y="connsiteY539"/>
                </a:cxn>
                <a:cxn ang="0">
                  <a:pos x="connsiteX540" y="connsiteY540"/>
                </a:cxn>
                <a:cxn ang="0">
                  <a:pos x="connsiteX541" y="connsiteY541"/>
                </a:cxn>
                <a:cxn ang="0">
                  <a:pos x="connsiteX542" y="connsiteY542"/>
                </a:cxn>
                <a:cxn ang="0">
                  <a:pos x="connsiteX543" y="connsiteY543"/>
                </a:cxn>
                <a:cxn ang="0">
                  <a:pos x="connsiteX544" y="connsiteY544"/>
                </a:cxn>
                <a:cxn ang="0">
                  <a:pos x="connsiteX545" y="connsiteY545"/>
                </a:cxn>
                <a:cxn ang="0">
                  <a:pos x="connsiteX546" y="connsiteY546"/>
                </a:cxn>
                <a:cxn ang="0">
                  <a:pos x="connsiteX547" y="connsiteY547"/>
                </a:cxn>
                <a:cxn ang="0">
                  <a:pos x="connsiteX548" y="connsiteY548"/>
                </a:cxn>
                <a:cxn ang="0">
                  <a:pos x="connsiteX549" y="connsiteY549"/>
                </a:cxn>
                <a:cxn ang="0">
                  <a:pos x="connsiteX550" y="connsiteY550"/>
                </a:cxn>
                <a:cxn ang="0">
                  <a:pos x="connsiteX551" y="connsiteY551"/>
                </a:cxn>
                <a:cxn ang="0">
                  <a:pos x="connsiteX552" y="connsiteY552"/>
                </a:cxn>
                <a:cxn ang="0">
                  <a:pos x="connsiteX553" y="connsiteY553"/>
                </a:cxn>
                <a:cxn ang="0">
                  <a:pos x="connsiteX554" y="connsiteY554"/>
                </a:cxn>
                <a:cxn ang="0">
                  <a:pos x="connsiteX555" y="connsiteY555"/>
                </a:cxn>
                <a:cxn ang="0">
                  <a:pos x="connsiteX556" y="connsiteY556"/>
                </a:cxn>
                <a:cxn ang="0">
                  <a:pos x="connsiteX557" y="connsiteY557"/>
                </a:cxn>
                <a:cxn ang="0">
                  <a:pos x="connsiteX558" y="connsiteY558"/>
                </a:cxn>
                <a:cxn ang="0">
                  <a:pos x="connsiteX559" y="connsiteY559"/>
                </a:cxn>
                <a:cxn ang="0">
                  <a:pos x="connsiteX560" y="connsiteY560"/>
                </a:cxn>
                <a:cxn ang="0">
                  <a:pos x="connsiteX561" y="connsiteY561"/>
                </a:cxn>
                <a:cxn ang="0">
                  <a:pos x="connsiteX562" y="connsiteY562"/>
                </a:cxn>
                <a:cxn ang="0">
                  <a:pos x="connsiteX563" y="connsiteY563"/>
                </a:cxn>
                <a:cxn ang="0">
                  <a:pos x="connsiteX564" y="connsiteY564"/>
                </a:cxn>
                <a:cxn ang="0">
                  <a:pos x="connsiteX565" y="connsiteY565"/>
                </a:cxn>
                <a:cxn ang="0">
                  <a:pos x="connsiteX566" y="connsiteY566"/>
                </a:cxn>
                <a:cxn ang="0">
                  <a:pos x="connsiteX567" y="connsiteY567"/>
                </a:cxn>
                <a:cxn ang="0">
                  <a:pos x="connsiteX568" y="connsiteY568"/>
                </a:cxn>
                <a:cxn ang="0">
                  <a:pos x="connsiteX569" y="connsiteY569"/>
                </a:cxn>
                <a:cxn ang="0">
                  <a:pos x="connsiteX570" y="connsiteY570"/>
                </a:cxn>
                <a:cxn ang="0">
                  <a:pos x="connsiteX571" y="connsiteY571"/>
                </a:cxn>
                <a:cxn ang="0">
                  <a:pos x="connsiteX572" y="connsiteY572"/>
                </a:cxn>
                <a:cxn ang="0">
                  <a:pos x="connsiteX573" y="connsiteY573"/>
                </a:cxn>
                <a:cxn ang="0">
                  <a:pos x="connsiteX574" y="connsiteY574"/>
                </a:cxn>
                <a:cxn ang="0">
                  <a:pos x="connsiteX575" y="connsiteY575"/>
                </a:cxn>
                <a:cxn ang="0">
                  <a:pos x="connsiteX576" y="connsiteY576"/>
                </a:cxn>
                <a:cxn ang="0">
                  <a:pos x="connsiteX577" y="connsiteY577"/>
                </a:cxn>
                <a:cxn ang="0">
                  <a:pos x="connsiteX578" y="connsiteY578"/>
                </a:cxn>
                <a:cxn ang="0">
                  <a:pos x="connsiteX579" y="connsiteY579"/>
                </a:cxn>
                <a:cxn ang="0">
                  <a:pos x="connsiteX580" y="connsiteY580"/>
                </a:cxn>
                <a:cxn ang="0">
                  <a:pos x="connsiteX581" y="connsiteY581"/>
                </a:cxn>
                <a:cxn ang="0">
                  <a:pos x="connsiteX582" y="connsiteY582"/>
                </a:cxn>
                <a:cxn ang="0">
                  <a:pos x="connsiteX583" y="connsiteY583"/>
                </a:cxn>
                <a:cxn ang="0">
                  <a:pos x="connsiteX584" y="connsiteY584"/>
                </a:cxn>
                <a:cxn ang="0">
                  <a:pos x="connsiteX585" y="connsiteY585"/>
                </a:cxn>
                <a:cxn ang="0">
                  <a:pos x="connsiteX586" y="connsiteY586"/>
                </a:cxn>
                <a:cxn ang="0">
                  <a:pos x="connsiteX587" y="connsiteY587"/>
                </a:cxn>
                <a:cxn ang="0">
                  <a:pos x="connsiteX588" y="connsiteY588"/>
                </a:cxn>
                <a:cxn ang="0">
                  <a:pos x="connsiteX589" y="connsiteY589"/>
                </a:cxn>
                <a:cxn ang="0">
                  <a:pos x="connsiteX590" y="connsiteY590"/>
                </a:cxn>
                <a:cxn ang="0">
                  <a:pos x="connsiteX591" y="connsiteY591"/>
                </a:cxn>
                <a:cxn ang="0">
                  <a:pos x="connsiteX592" y="connsiteY592"/>
                </a:cxn>
                <a:cxn ang="0">
                  <a:pos x="connsiteX593" y="connsiteY593"/>
                </a:cxn>
                <a:cxn ang="0">
                  <a:pos x="connsiteX594" y="connsiteY594"/>
                </a:cxn>
                <a:cxn ang="0">
                  <a:pos x="connsiteX595" y="connsiteY595"/>
                </a:cxn>
                <a:cxn ang="0">
                  <a:pos x="connsiteX596" y="connsiteY596"/>
                </a:cxn>
                <a:cxn ang="0">
                  <a:pos x="connsiteX597" y="connsiteY597"/>
                </a:cxn>
                <a:cxn ang="0">
                  <a:pos x="connsiteX598" y="connsiteY598"/>
                </a:cxn>
                <a:cxn ang="0">
                  <a:pos x="connsiteX599" y="connsiteY599"/>
                </a:cxn>
                <a:cxn ang="0">
                  <a:pos x="connsiteX600" y="connsiteY600"/>
                </a:cxn>
                <a:cxn ang="0">
                  <a:pos x="connsiteX601" y="connsiteY601"/>
                </a:cxn>
              </a:cxnLst>
              <a:rect l="l" t="t" r="r" b="b"/>
              <a:pathLst>
                <a:path w="8363529" h="1610902">
                  <a:moveTo>
                    <a:pt x="0" y="822523"/>
                  </a:moveTo>
                  <a:lnTo>
                    <a:pt x="8394" y="799538"/>
                  </a:lnTo>
                  <a:lnTo>
                    <a:pt x="75279" y="613498"/>
                  </a:lnTo>
                  <a:lnTo>
                    <a:pt x="83635" y="589951"/>
                  </a:lnTo>
                  <a:lnTo>
                    <a:pt x="92029" y="639203"/>
                  </a:lnTo>
                  <a:lnTo>
                    <a:pt x="158920" y="980662"/>
                  </a:lnTo>
                  <a:lnTo>
                    <a:pt x="167273" y="1017709"/>
                  </a:lnTo>
                  <a:lnTo>
                    <a:pt x="175665" y="1036610"/>
                  </a:lnTo>
                  <a:lnTo>
                    <a:pt x="242549" y="1249903"/>
                  </a:lnTo>
                  <a:lnTo>
                    <a:pt x="250903" y="1288083"/>
                  </a:lnTo>
                  <a:lnTo>
                    <a:pt x="259304" y="1237961"/>
                  </a:lnTo>
                  <a:lnTo>
                    <a:pt x="326189" y="891585"/>
                  </a:lnTo>
                  <a:lnTo>
                    <a:pt x="334542" y="854083"/>
                  </a:lnTo>
                  <a:lnTo>
                    <a:pt x="342895" y="817607"/>
                  </a:lnTo>
                  <a:lnTo>
                    <a:pt x="409818" y="605184"/>
                  </a:lnTo>
                  <a:lnTo>
                    <a:pt x="418181" y="585635"/>
                  </a:lnTo>
                  <a:lnTo>
                    <a:pt x="426534" y="602078"/>
                  </a:lnTo>
                  <a:lnTo>
                    <a:pt x="493458" y="828572"/>
                  </a:lnTo>
                  <a:lnTo>
                    <a:pt x="501811" y="879188"/>
                  </a:lnTo>
                  <a:lnTo>
                    <a:pt x="510174" y="816736"/>
                  </a:lnTo>
                  <a:lnTo>
                    <a:pt x="577097" y="513205"/>
                  </a:lnTo>
                  <a:lnTo>
                    <a:pt x="585450" y="489503"/>
                  </a:lnTo>
                  <a:lnTo>
                    <a:pt x="593803" y="519747"/>
                  </a:lnTo>
                  <a:lnTo>
                    <a:pt x="660727" y="868948"/>
                  </a:lnTo>
                  <a:lnTo>
                    <a:pt x="669089" y="933027"/>
                  </a:lnTo>
                  <a:lnTo>
                    <a:pt x="677443" y="973403"/>
                  </a:lnTo>
                  <a:lnTo>
                    <a:pt x="744366" y="1242722"/>
                  </a:lnTo>
                  <a:lnTo>
                    <a:pt x="752719" y="1270924"/>
                  </a:lnTo>
                  <a:lnTo>
                    <a:pt x="761082" y="1235687"/>
                  </a:lnTo>
                  <a:lnTo>
                    <a:pt x="828005" y="1015590"/>
                  </a:lnTo>
                  <a:lnTo>
                    <a:pt x="836358" y="993969"/>
                  </a:lnTo>
                  <a:lnTo>
                    <a:pt x="844712" y="956089"/>
                  </a:lnTo>
                  <a:lnTo>
                    <a:pt x="911635" y="584086"/>
                  </a:lnTo>
                  <a:lnTo>
                    <a:pt x="919988" y="526735"/>
                  </a:lnTo>
                  <a:lnTo>
                    <a:pt x="928351" y="590513"/>
                  </a:lnTo>
                  <a:lnTo>
                    <a:pt x="995274" y="981717"/>
                  </a:lnTo>
                  <a:lnTo>
                    <a:pt x="1003627" y="1019480"/>
                  </a:lnTo>
                  <a:lnTo>
                    <a:pt x="1011981" y="1035362"/>
                  </a:lnTo>
                  <a:lnTo>
                    <a:pt x="1078904" y="1188206"/>
                  </a:lnTo>
                  <a:lnTo>
                    <a:pt x="1087267" y="1211230"/>
                  </a:lnTo>
                  <a:lnTo>
                    <a:pt x="1095620" y="1173873"/>
                  </a:lnTo>
                  <a:lnTo>
                    <a:pt x="1162543" y="857567"/>
                  </a:lnTo>
                  <a:lnTo>
                    <a:pt x="1170896" y="815720"/>
                  </a:lnTo>
                  <a:lnTo>
                    <a:pt x="1179259" y="765055"/>
                  </a:lnTo>
                  <a:lnTo>
                    <a:pt x="1246182" y="423306"/>
                  </a:lnTo>
                  <a:lnTo>
                    <a:pt x="1254536" y="387159"/>
                  </a:lnTo>
                  <a:lnTo>
                    <a:pt x="1262889" y="437629"/>
                  </a:lnTo>
                  <a:lnTo>
                    <a:pt x="1329812" y="1076077"/>
                  </a:lnTo>
                  <a:lnTo>
                    <a:pt x="1338175" y="1205520"/>
                  </a:lnTo>
                  <a:lnTo>
                    <a:pt x="1346528" y="1172596"/>
                  </a:lnTo>
                  <a:lnTo>
                    <a:pt x="1413451" y="999485"/>
                  </a:lnTo>
                  <a:lnTo>
                    <a:pt x="1421805" y="985007"/>
                  </a:lnTo>
                  <a:lnTo>
                    <a:pt x="1430158" y="995556"/>
                  </a:lnTo>
                  <a:lnTo>
                    <a:pt x="1497091" y="1096033"/>
                  </a:lnTo>
                  <a:lnTo>
                    <a:pt x="1505444" y="1111044"/>
                  </a:lnTo>
                  <a:lnTo>
                    <a:pt x="1513797" y="1125715"/>
                  </a:lnTo>
                  <a:lnTo>
                    <a:pt x="1580720" y="1275008"/>
                  </a:lnTo>
                  <a:lnTo>
                    <a:pt x="1589074" y="1298894"/>
                  </a:lnTo>
                  <a:lnTo>
                    <a:pt x="1597437" y="1243593"/>
                  </a:lnTo>
                  <a:lnTo>
                    <a:pt x="1664360" y="950941"/>
                  </a:lnTo>
                  <a:lnTo>
                    <a:pt x="1672713" y="926291"/>
                  </a:lnTo>
                  <a:lnTo>
                    <a:pt x="1681066" y="944176"/>
                  </a:lnTo>
                  <a:lnTo>
                    <a:pt x="1747989" y="1116754"/>
                  </a:lnTo>
                  <a:lnTo>
                    <a:pt x="1756352" y="1142875"/>
                  </a:lnTo>
                  <a:lnTo>
                    <a:pt x="1764706" y="1127380"/>
                  </a:lnTo>
                  <a:lnTo>
                    <a:pt x="1831629" y="995246"/>
                  </a:lnTo>
                  <a:lnTo>
                    <a:pt x="1839982" y="977671"/>
                  </a:lnTo>
                  <a:lnTo>
                    <a:pt x="1848345" y="968671"/>
                  </a:lnTo>
                  <a:lnTo>
                    <a:pt x="1915268" y="897412"/>
                  </a:lnTo>
                  <a:lnTo>
                    <a:pt x="1923621" y="888566"/>
                  </a:lnTo>
                  <a:lnTo>
                    <a:pt x="1931975" y="886562"/>
                  </a:lnTo>
                  <a:lnTo>
                    <a:pt x="1998898" y="874126"/>
                  </a:lnTo>
                  <a:lnTo>
                    <a:pt x="2007260" y="872916"/>
                  </a:lnTo>
                  <a:lnTo>
                    <a:pt x="2015614" y="833788"/>
                  </a:lnTo>
                  <a:lnTo>
                    <a:pt x="2082537" y="427012"/>
                  </a:lnTo>
                  <a:lnTo>
                    <a:pt x="2090890" y="360438"/>
                  </a:lnTo>
                  <a:lnTo>
                    <a:pt x="2099253" y="385842"/>
                  </a:lnTo>
                  <a:lnTo>
                    <a:pt x="2166176" y="560424"/>
                  </a:lnTo>
                  <a:lnTo>
                    <a:pt x="2174530" y="579247"/>
                  </a:lnTo>
                  <a:lnTo>
                    <a:pt x="2182883" y="627376"/>
                  </a:lnTo>
                  <a:lnTo>
                    <a:pt x="2249806" y="1086771"/>
                  </a:lnTo>
                  <a:lnTo>
                    <a:pt x="2258159" y="1155543"/>
                  </a:lnTo>
                  <a:lnTo>
                    <a:pt x="2266522" y="1134823"/>
                  </a:lnTo>
                  <a:lnTo>
                    <a:pt x="2333445" y="1000202"/>
                  </a:lnTo>
                  <a:lnTo>
                    <a:pt x="2341799" y="986439"/>
                  </a:lnTo>
                  <a:lnTo>
                    <a:pt x="2350152" y="975668"/>
                  </a:lnTo>
                  <a:lnTo>
                    <a:pt x="2417075" y="893666"/>
                  </a:lnTo>
                  <a:lnTo>
                    <a:pt x="2425438" y="883950"/>
                  </a:lnTo>
                  <a:lnTo>
                    <a:pt x="2433791" y="832162"/>
                  </a:lnTo>
                  <a:lnTo>
                    <a:pt x="2500714" y="441036"/>
                  </a:lnTo>
                  <a:lnTo>
                    <a:pt x="2509068" y="394833"/>
                  </a:lnTo>
                  <a:lnTo>
                    <a:pt x="2517430" y="450637"/>
                  </a:lnTo>
                  <a:lnTo>
                    <a:pt x="2584354" y="972871"/>
                  </a:lnTo>
                  <a:lnTo>
                    <a:pt x="2592707" y="1049424"/>
                  </a:lnTo>
                  <a:lnTo>
                    <a:pt x="2601060" y="1023342"/>
                  </a:lnTo>
                  <a:lnTo>
                    <a:pt x="2667983" y="811974"/>
                  </a:lnTo>
                  <a:lnTo>
                    <a:pt x="2676346" y="785205"/>
                  </a:lnTo>
                  <a:lnTo>
                    <a:pt x="2684699" y="797535"/>
                  </a:lnTo>
                  <a:lnTo>
                    <a:pt x="2751623" y="914164"/>
                  </a:lnTo>
                  <a:lnTo>
                    <a:pt x="2759976" y="931439"/>
                  </a:lnTo>
                  <a:lnTo>
                    <a:pt x="2768329" y="913138"/>
                  </a:lnTo>
                  <a:lnTo>
                    <a:pt x="2835262" y="802974"/>
                  </a:lnTo>
                  <a:lnTo>
                    <a:pt x="2843615" y="792541"/>
                  </a:lnTo>
                  <a:lnTo>
                    <a:pt x="2851968" y="778517"/>
                  </a:lnTo>
                  <a:lnTo>
                    <a:pt x="2918892" y="663136"/>
                  </a:lnTo>
                  <a:lnTo>
                    <a:pt x="2927245" y="648319"/>
                  </a:lnTo>
                  <a:lnTo>
                    <a:pt x="2935608" y="658975"/>
                  </a:lnTo>
                  <a:lnTo>
                    <a:pt x="3002531" y="740754"/>
                  </a:lnTo>
                  <a:lnTo>
                    <a:pt x="3010884" y="750577"/>
                  </a:lnTo>
                  <a:lnTo>
                    <a:pt x="3019238" y="746764"/>
                  </a:lnTo>
                  <a:lnTo>
                    <a:pt x="3086161" y="708352"/>
                  </a:lnTo>
                  <a:lnTo>
                    <a:pt x="3094523" y="702226"/>
                  </a:lnTo>
                  <a:lnTo>
                    <a:pt x="3102877" y="718523"/>
                  </a:lnTo>
                  <a:lnTo>
                    <a:pt x="3169800" y="811519"/>
                  </a:lnTo>
                  <a:lnTo>
                    <a:pt x="3178153" y="819910"/>
                  </a:lnTo>
                  <a:lnTo>
                    <a:pt x="3186516" y="854083"/>
                  </a:lnTo>
                  <a:lnTo>
                    <a:pt x="3253439" y="1195958"/>
                  </a:lnTo>
                  <a:lnTo>
                    <a:pt x="3261792" y="1249710"/>
                  </a:lnTo>
                  <a:lnTo>
                    <a:pt x="3270146" y="1247223"/>
                  </a:lnTo>
                  <a:lnTo>
                    <a:pt x="3337069" y="1204727"/>
                  </a:lnTo>
                  <a:lnTo>
                    <a:pt x="3345432" y="1192590"/>
                  </a:lnTo>
                  <a:lnTo>
                    <a:pt x="3353785" y="962283"/>
                  </a:lnTo>
                  <a:lnTo>
                    <a:pt x="3420708" y="286982"/>
                  </a:lnTo>
                  <a:lnTo>
                    <a:pt x="3429061" y="252499"/>
                  </a:lnTo>
                  <a:lnTo>
                    <a:pt x="3437424" y="296360"/>
                  </a:lnTo>
                  <a:lnTo>
                    <a:pt x="3504347" y="698258"/>
                  </a:lnTo>
                  <a:lnTo>
                    <a:pt x="3512701" y="755948"/>
                  </a:lnTo>
                  <a:lnTo>
                    <a:pt x="3521054" y="738896"/>
                  </a:lnTo>
                  <a:lnTo>
                    <a:pt x="3587977" y="620872"/>
                  </a:lnTo>
                  <a:lnTo>
                    <a:pt x="3596330" y="608088"/>
                  </a:lnTo>
                  <a:lnTo>
                    <a:pt x="3604693" y="622837"/>
                  </a:lnTo>
                  <a:lnTo>
                    <a:pt x="3671616" y="778972"/>
                  </a:lnTo>
                  <a:lnTo>
                    <a:pt x="3679970" y="805016"/>
                  </a:lnTo>
                  <a:lnTo>
                    <a:pt x="3688323" y="803690"/>
                  </a:lnTo>
                  <a:lnTo>
                    <a:pt x="3755246" y="794321"/>
                  </a:lnTo>
                  <a:lnTo>
                    <a:pt x="3763609" y="793296"/>
                  </a:lnTo>
                  <a:lnTo>
                    <a:pt x="3771962" y="813484"/>
                  </a:lnTo>
                  <a:lnTo>
                    <a:pt x="3838885" y="990146"/>
                  </a:lnTo>
                  <a:lnTo>
                    <a:pt x="3847239" y="1014341"/>
                  </a:lnTo>
                  <a:lnTo>
                    <a:pt x="3855602" y="984175"/>
                  </a:lnTo>
                  <a:lnTo>
                    <a:pt x="3922525" y="767252"/>
                  </a:lnTo>
                  <a:lnTo>
                    <a:pt x="3930878" y="742864"/>
                  </a:lnTo>
                  <a:lnTo>
                    <a:pt x="3939231" y="772962"/>
                  </a:lnTo>
                  <a:lnTo>
                    <a:pt x="4006154" y="984736"/>
                  </a:lnTo>
                  <a:lnTo>
                    <a:pt x="4014517" y="1008070"/>
                  </a:lnTo>
                  <a:lnTo>
                    <a:pt x="4022871" y="1030639"/>
                  </a:lnTo>
                  <a:lnTo>
                    <a:pt x="4089755" y="1302716"/>
                  </a:lnTo>
                  <a:lnTo>
                    <a:pt x="4098147" y="1354958"/>
                  </a:lnTo>
                  <a:lnTo>
                    <a:pt x="4106500" y="1241358"/>
                  </a:lnTo>
                  <a:lnTo>
                    <a:pt x="4173394" y="660146"/>
                  </a:lnTo>
                  <a:lnTo>
                    <a:pt x="4181787" y="612666"/>
                  </a:lnTo>
                  <a:lnTo>
                    <a:pt x="4190140" y="661249"/>
                  </a:lnTo>
                  <a:lnTo>
                    <a:pt x="4257024" y="1146165"/>
                  </a:lnTo>
                  <a:lnTo>
                    <a:pt x="4265416" y="1222263"/>
                  </a:lnTo>
                  <a:lnTo>
                    <a:pt x="4273779" y="1089984"/>
                  </a:lnTo>
                  <a:lnTo>
                    <a:pt x="4340664" y="112855"/>
                  </a:lnTo>
                  <a:lnTo>
                    <a:pt x="4349055" y="0"/>
                  </a:lnTo>
                  <a:lnTo>
                    <a:pt x="4357409" y="94331"/>
                  </a:lnTo>
                  <a:lnTo>
                    <a:pt x="4424303" y="842479"/>
                  </a:lnTo>
                  <a:lnTo>
                    <a:pt x="4432695" y="935214"/>
                  </a:lnTo>
                  <a:lnTo>
                    <a:pt x="4441048" y="901718"/>
                  </a:lnTo>
                  <a:lnTo>
                    <a:pt x="4507932" y="618637"/>
                  </a:lnTo>
                  <a:lnTo>
                    <a:pt x="4516324" y="581251"/>
                  </a:lnTo>
                  <a:lnTo>
                    <a:pt x="4524687" y="636183"/>
                  </a:lnTo>
                  <a:lnTo>
                    <a:pt x="4591572" y="1126016"/>
                  </a:lnTo>
                  <a:lnTo>
                    <a:pt x="4599964" y="1194332"/>
                  </a:lnTo>
                  <a:lnTo>
                    <a:pt x="4608317" y="1130022"/>
                  </a:lnTo>
                  <a:lnTo>
                    <a:pt x="4675201" y="626621"/>
                  </a:lnTo>
                  <a:lnTo>
                    <a:pt x="4683603" y="565069"/>
                  </a:lnTo>
                  <a:lnTo>
                    <a:pt x="4691956" y="574108"/>
                  </a:lnTo>
                  <a:lnTo>
                    <a:pt x="4758840" y="638448"/>
                  </a:lnTo>
                  <a:lnTo>
                    <a:pt x="4767232" y="645629"/>
                  </a:lnTo>
                  <a:lnTo>
                    <a:pt x="4775595" y="650923"/>
                  </a:lnTo>
                  <a:lnTo>
                    <a:pt x="4842480" y="706494"/>
                  </a:lnTo>
                  <a:lnTo>
                    <a:pt x="4850872" y="715688"/>
                  </a:lnTo>
                  <a:lnTo>
                    <a:pt x="4859225" y="800854"/>
                  </a:lnTo>
                  <a:lnTo>
                    <a:pt x="4926109" y="1246274"/>
                  </a:lnTo>
                  <a:lnTo>
                    <a:pt x="4934501" y="1283360"/>
                  </a:lnTo>
                  <a:lnTo>
                    <a:pt x="4942864" y="1276363"/>
                  </a:lnTo>
                  <a:lnTo>
                    <a:pt x="5009749" y="1213195"/>
                  </a:lnTo>
                  <a:lnTo>
                    <a:pt x="5018141" y="1204272"/>
                  </a:lnTo>
                  <a:lnTo>
                    <a:pt x="5026494" y="1185525"/>
                  </a:lnTo>
                  <a:lnTo>
                    <a:pt x="5093388" y="1007199"/>
                  </a:lnTo>
                  <a:lnTo>
                    <a:pt x="5101780" y="980623"/>
                  </a:lnTo>
                  <a:lnTo>
                    <a:pt x="5110134" y="978881"/>
                  </a:lnTo>
                  <a:lnTo>
                    <a:pt x="5177018" y="968709"/>
                  </a:lnTo>
                  <a:lnTo>
                    <a:pt x="5185410" y="967770"/>
                  </a:lnTo>
                  <a:lnTo>
                    <a:pt x="5193773" y="982055"/>
                  </a:lnTo>
                  <a:lnTo>
                    <a:pt x="5260657" y="1106166"/>
                  </a:lnTo>
                  <a:lnTo>
                    <a:pt x="5269049" y="1123035"/>
                  </a:lnTo>
                  <a:lnTo>
                    <a:pt x="5277403" y="1097891"/>
                  </a:lnTo>
                  <a:lnTo>
                    <a:pt x="5344287" y="865465"/>
                  </a:lnTo>
                  <a:lnTo>
                    <a:pt x="5352650" y="831785"/>
                  </a:lnTo>
                  <a:lnTo>
                    <a:pt x="5361042" y="844183"/>
                  </a:lnTo>
                  <a:lnTo>
                    <a:pt x="5427926" y="1089191"/>
                  </a:lnTo>
                  <a:lnTo>
                    <a:pt x="5436280" y="1173612"/>
                  </a:lnTo>
                  <a:lnTo>
                    <a:pt x="5444672" y="1238183"/>
                  </a:lnTo>
                  <a:lnTo>
                    <a:pt x="5511566" y="1451254"/>
                  </a:lnTo>
                  <a:lnTo>
                    <a:pt x="5519919" y="1463197"/>
                  </a:lnTo>
                  <a:lnTo>
                    <a:pt x="5528311" y="1388831"/>
                  </a:lnTo>
                  <a:lnTo>
                    <a:pt x="5595195" y="976878"/>
                  </a:lnTo>
                  <a:lnTo>
                    <a:pt x="5603558" y="940701"/>
                  </a:lnTo>
                  <a:lnTo>
                    <a:pt x="5611950" y="893250"/>
                  </a:lnTo>
                  <a:lnTo>
                    <a:pt x="5678835" y="515324"/>
                  </a:lnTo>
                  <a:lnTo>
                    <a:pt x="5687188" y="468289"/>
                  </a:lnTo>
                  <a:lnTo>
                    <a:pt x="5695580" y="525525"/>
                  </a:lnTo>
                  <a:lnTo>
                    <a:pt x="5762474" y="1175315"/>
                  </a:lnTo>
                  <a:lnTo>
                    <a:pt x="5770827" y="1292245"/>
                  </a:lnTo>
                  <a:lnTo>
                    <a:pt x="5779219" y="1265930"/>
                  </a:lnTo>
                  <a:lnTo>
                    <a:pt x="5846103" y="1112408"/>
                  </a:lnTo>
                  <a:lnTo>
                    <a:pt x="5854457" y="1098269"/>
                  </a:lnTo>
                  <a:lnTo>
                    <a:pt x="5862858" y="1116415"/>
                  </a:lnTo>
                  <a:lnTo>
                    <a:pt x="5929743" y="1352994"/>
                  </a:lnTo>
                  <a:lnTo>
                    <a:pt x="5938096" y="1402593"/>
                  </a:lnTo>
                  <a:lnTo>
                    <a:pt x="5946488" y="1376550"/>
                  </a:lnTo>
                  <a:lnTo>
                    <a:pt x="6013372" y="1245065"/>
                  </a:lnTo>
                  <a:lnTo>
                    <a:pt x="6021735" y="1234477"/>
                  </a:lnTo>
                  <a:lnTo>
                    <a:pt x="6030127" y="1214327"/>
                  </a:lnTo>
                  <a:lnTo>
                    <a:pt x="6097011" y="1031539"/>
                  </a:lnTo>
                  <a:lnTo>
                    <a:pt x="6105365" y="1005611"/>
                  </a:lnTo>
                  <a:lnTo>
                    <a:pt x="6113767" y="994037"/>
                  </a:lnTo>
                  <a:lnTo>
                    <a:pt x="6180651" y="914309"/>
                  </a:lnTo>
                  <a:lnTo>
                    <a:pt x="6189004" y="905686"/>
                  </a:lnTo>
                  <a:lnTo>
                    <a:pt x="6197396" y="935746"/>
                  </a:lnTo>
                  <a:lnTo>
                    <a:pt x="6264280" y="1242268"/>
                  </a:lnTo>
                  <a:lnTo>
                    <a:pt x="6272644" y="1291412"/>
                  </a:lnTo>
                  <a:lnTo>
                    <a:pt x="6281036" y="1203023"/>
                  </a:lnTo>
                  <a:lnTo>
                    <a:pt x="6347920" y="602688"/>
                  </a:lnTo>
                  <a:lnTo>
                    <a:pt x="6356273" y="538794"/>
                  </a:lnTo>
                  <a:lnTo>
                    <a:pt x="6364665" y="618753"/>
                  </a:lnTo>
                  <a:lnTo>
                    <a:pt x="6431560" y="1204233"/>
                  </a:lnTo>
                  <a:lnTo>
                    <a:pt x="6439913" y="1271224"/>
                  </a:lnTo>
                  <a:lnTo>
                    <a:pt x="6448305" y="1279315"/>
                  </a:lnTo>
                  <a:lnTo>
                    <a:pt x="6515189" y="1351784"/>
                  </a:lnTo>
                  <a:lnTo>
                    <a:pt x="6523542" y="1361994"/>
                  </a:lnTo>
                  <a:lnTo>
                    <a:pt x="6531944" y="1333599"/>
                  </a:lnTo>
                  <a:lnTo>
                    <a:pt x="6598829" y="1079784"/>
                  </a:lnTo>
                  <a:lnTo>
                    <a:pt x="6607182" y="1044285"/>
                  </a:lnTo>
                  <a:lnTo>
                    <a:pt x="6615535" y="1079484"/>
                  </a:lnTo>
                  <a:lnTo>
                    <a:pt x="6682458" y="1275908"/>
                  </a:lnTo>
                  <a:lnTo>
                    <a:pt x="6690821" y="1293261"/>
                  </a:lnTo>
                  <a:lnTo>
                    <a:pt x="6699174" y="1275724"/>
                  </a:lnTo>
                  <a:lnTo>
                    <a:pt x="6766097" y="1100079"/>
                  </a:lnTo>
                  <a:lnTo>
                    <a:pt x="6774451" y="1072409"/>
                  </a:lnTo>
                  <a:lnTo>
                    <a:pt x="6782814" y="1082765"/>
                  </a:lnTo>
                  <a:lnTo>
                    <a:pt x="6849737" y="1179322"/>
                  </a:lnTo>
                  <a:lnTo>
                    <a:pt x="6858090" y="1193384"/>
                  </a:lnTo>
                  <a:lnTo>
                    <a:pt x="6866443" y="1120083"/>
                  </a:lnTo>
                  <a:lnTo>
                    <a:pt x="6933366" y="725134"/>
                  </a:lnTo>
                  <a:lnTo>
                    <a:pt x="6941729" y="691338"/>
                  </a:lnTo>
                  <a:lnTo>
                    <a:pt x="6950083" y="757158"/>
                  </a:lnTo>
                  <a:lnTo>
                    <a:pt x="7017006" y="1398441"/>
                  </a:lnTo>
                  <a:lnTo>
                    <a:pt x="7025359" y="1496460"/>
                  </a:lnTo>
                  <a:lnTo>
                    <a:pt x="7033712" y="1410723"/>
                  </a:lnTo>
                  <a:lnTo>
                    <a:pt x="7100645" y="677353"/>
                  </a:lnTo>
                  <a:lnTo>
                    <a:pt x="7108998" y="579325"/>
                  </a:lnTo>
                  <a:lnTo>
                    <a:pt x="7117351" y="576944"/>
                  </a:lnTo>
                  <a:lnTo>
                    <a:pt x="7184274" y="557279"/>
                  </a:lnTo>
                  <a:lnTo>
                    <a:pt x="7192628" y="554752"/>
                  </a:lnTo>
                  <a:lnTo>
                    <a:pt x="7200991" y="615656"/>
                  </a:lnTo>
                  <a:lnTo>
                    <a:pt x="7267914" y="1066138"/>
                  </a:lnTo>
                  <a:lnTo>
                    <a:pt x="7276267" y="1118225"/>
                  </a:lnTo>
                  <a:lnTo>
                    <a:pt x="7284620" y="1092375"/>
                  </a:lnTo>
                  <a:lnTo>
                    <a:pt x="7351543" y="873478"/>
                  </a:lnTo>
                  <a:lnTo>
                    <a:pt x="7359906" y="844521"/>
                  </a:lnTo>
                  <a:lnTo>
                    <a:pt x="7368260" y="810271"/>
                  </a:lnTo>
                  <a:lnTo>
                    <a:pt x="7435183" y="581667"/>
                  </a:lnTo>
                  <a:lnTo>
                    <a:pt x="7443536" y="557733"/>
                  </a:lnTo>
                  <a:lnTo>
                    <a:pt x="7451899" y="594897"/>
                  </a:lnTo>
                  <a:lnTo>
                    <a:pt x="7518822" y="952605"/>
                  </a:lnTo>
                  <a:lnTo>
                    <a:pt x="7527175" y="1006589"/>
                  </a:lnTo>
                  <a:lnTo>
                    <a:pt x="7535528" y="914193"/>
                  </a:lnTo>
                  <a:lnTo>
                    <a:pt x="7602452" y="294540"/>
                  </a:lnTo>
                  <a:lnTo>
                    <a:pt x="7610815" y="229407"/>
                  </a:lnTo>
                  <a:lnTo>
                    <a:pt x="7619168" y="307015"/>
                  </a:lnTo>
                  <a:lnTo>
                    <a:pt x="7686091" y="980584"/>
                  </a:lnTo>
                  <a:lnTo>
                    <a:pt x="7694444" y="1072032"/>
                  </a:lnTo>
                  <a:lnTo>
                    <a:pt x="7702798" y="1026177"/>
                  </a:lnTo>
                  <a:lnTo>
                    <a:pt x="7769731" y="574186"/>
                  </a:lnTo>
                  <a:lnTo>
                    <a:pt x="7778084" y="504204"/>
                  </a:lnTo>
                  <a:lnTo>
                    <a:pt x="7786437" y="599552"/>
                  </a:lnTo>
                  <a:lnTo>
                    <a:pt x="7853360" y="1065489"/>
                  </a:lnTo>
                  <a:lnTo>
                    <a:pt x="7861713" y="1102014"/>
                  </a:lnTo>
                  <a:lnTo>
                    <a:pt x="7870077" y="1091233"/>
                  </a:lnTo>
                  <a:lnTo>
                    <a:pt x="7937000" y="970413"/>
                  </a:lnTo>
                  <a:lnTo>
                    <a:pt x="7945353" y="948976"/>
                  </a:lnTo>
                  <a:lnTo>
                    <a:pt x="7953706" y="970113"/>
                  </a:lnTo>
                  <a:lnTo>
                    <a:pt x="8020629" y="1131387"/>
                  </a:lnTo>
                  <a:lnTo>
                    <a:pt x="8028992" y="1150588"/>
                  </a:lnTo>
                  <a:lnTo>
                    <a:pt x="8037346" y="1138868"/>
                  </a:lnTo>
                  <a:lnTo>
                    <a:pt x="8104268" y="1031432"/>
                  </a:lnTo>
                  <a:lnTo>
                    <a:pt x="8112622" y="1015967"/>
                  </a:lnTo>
                  <a:lnTo>
                    <a:pt x="8120985" y="1054040"/>
                  </a:lnTo>
                  <a:lnTo>
                    <a:pt x="8187908" y="1255497"/>
                  </a:lnTo>
                  <a:lnTo>
                    <a:pt x="8196261" y="1272473"/>
                  </a:lnTo>
                  <a:lnTo>
                    <a:pt x="8204614" y="1198600"/>
                  </a:lnTo>
                  <a:lnTo>
                    <a:pt x="8271537" y="428784"/>
                  </a:lnTo>
                  <a:lnTo>
                    <a:pt x="8279900" y="302476"/>
                  </a:lnTo>
                  <a:lnTo>
                    <a:pt x="8288254" y="385049"/>
                  </a:lnTo>
                  <a:lnTo>
                    <a:pt x="8355177" y="1052453"/>
                  </a:lnTo>
                  <a:lnTo>
                    <a:pt x="8363530" y="1136719"/>
                  </a:lnTo>
                  <a:lnTo>
                    <a:pt x="8363530" y="1172780"/>
                  </a:lnTo>
                  <a:lnTo>
                    <a:pt x="8355177" y="1087003"/>
                  </a:lnTo>
                  <a:lnTo>
                    <a:pt x="8288254" y="407579"/>
                  </a:lnTo>
                  <a:lnTo>
                    <a:pt x="8279900" y="323497"/>
                  </a:lnTo>
                  <a:lnTo>
                    <a:pt x="8271537" y="467273"/>
                  </a:lnTo>
                  <a:lnTo>
                    <a:pt x="8204614" y="1343393"/>
                  </a:lnTo>
                  <a:lnTo>
                    <a:pt x="8196261" y="1427505"/>
                  </a:lnTo>
                  <a:lnTo>
                    <a:pt x="8187908" y="1420740"/>
                  </a:lnTo>
                  <a:lnTo>
                    <a:pt x="8120985" y="1340519"/>
                  </a:lnTo>
                  <a:lnTo>
                    <a:pt x="8112622" y="1325363"/>
                  </a:lnTo>
                  <a:lnTo>
                    <a:pt x="8104268" y="1324869"/>
                  </a:lnTo>
                  <a:lnTo>
                    <a:pt x="8037346" y="1321463"/>
                  </a:lnTo>
                  <a:lnTo>
                    <a:pt x="8028992" y="1321085"/>
                  </a:lnTo>
                  <a:lnTo>
                    <a:pt x="8020629" y="1287744"/>
                  </a:lnTo>
                  <a:lnTo>
                    <a:pt x="7953706" y="1007992"/>
                  </a:lnTo>
                  <a:lnTo>
                    <a:pt x="7945353" y="971322"/>
                  </a:lnTo>
                  <a:lnTo>
                    <a:pt x="7937000" y="1006928"/>
                  </a:lnTo>
                  <a:lnTo>
                    <a:pt x="7870077" y="1207562"/>
                  </a:lnTo>
                  <a:lnTo>
                    <a:pt x="7861713" y="1225476"/>
                  </a:lnTo>
                  <a:lnTo>
                    <a:pt x="7853360" y="1181925"/>
                  </a:lnTo>
                  <a:lnTo>
                    <a:pt x="7786437" y="626650"/>
                  </a:lnTo>
                  <a:lnTo>
                    <a:pt x="7778084" y="513050"/>
                  </a:lnTo>
                  <a:lnTo>
                    <a:pt x="7769731" y="616033"/>
                  </a:lnTo>
                  <a:lnTo>
                    <a:pt x="7702798" y="1281096"/>
                  </a:lnTo>
                  <a:lnTo>
                    <a:pt x="7694444" y="1348532"/>
                  </a:lnTo>
                  <a:lnTo>
                    <a:pt x="7686091" y="1243555"/>
                  </a:lnTo>
                  <a:lnTo>
                    <a:pt x="7619168" y="470254"/>
                  </a:lnTo>
                  <a:lnTo>
                    <a:pt x="7610815" y="381149"/>
                  </a:lnTo>
                  <a:lnTo>
                    <a:pt x="7602452" y="439787"/>
                  </a:lnTo>
                  <a:lnTo>
                    <a:pt x="7535528" y="997482"/>
                  </a:lnTo>
                  <a:lnTo>
                    <a:pt x="7527175" y="1080655"/>
                  </a:lnTo>
                  <a:lnTo>
                    <a:pt x="7518822" y="1035894"/>
                  </a:lnTo>
                  <a:lnTo>
                    <a:pt x="7451899" y="739273"/>
                  </a:lnTo>
                  <a:lnTo>
                    <a:pt x="7443536" y="708429"/>
                  </a:lnTo>
                  <a:lnTo>
                    <a:pt x="7435183" y="721998"/>
                  </a:lnTo>
                  <a:lnTo>
                    <a:pt x="7368260" y="851596"/>
                  </a:lnTo>
                  <a:lnTo>
                    <a:pt x="7359906" y="871020"/>
                  </a:lnTo>
                  <a:lnTo>
                    <a:pt x="7351543" y="915142"/>
                  </a:lnTo>
                  <a:lnTo>
                    <a:pt x="7284620" y="1248849"/>
                  </a:lnTo>
                  <a:lnTo>
                    <a:pt x="7276267" y="1288277"/>
                  </a:lnTo>
                  <a:lnTo>
                    <a:pt x="7267914" y="1318104"/>
                  </a:lnTo>
                  <a:lnTo>
                    <a:pt x="7200991" y="1576042"/>
                  </a:lnTo>
                  <a:lnTo>
                    <a:pt x="7192628" y="1610902"/>
                  </a:lnTo>
                  <a:lnTo>
                    <a:pt x="7184274" y="1526404"/>
                  </a:lnTo>
                  <a:lnTo>
                    <a:pt x="7117351" y="876730"/>
                  </a:lnTo>
                  <a:lnTo>
                    <a:pt x="7108998" y="798667"/>
                  </a:lnTo>
                  <a:lnTo>
                    <a:pt x="7100645" y="880853"/>
                  </a:lnTo>
                  <a:lnTo>
                    <a:pt x="7033712" y="1495560"/>
                  </a:lnTo>
                  <a:lnTo>
                    <a:pt x="7025359" y="1567429"/>
                  </a:lnTo>
                  <a:lnTo>
                    <a:pt x="7017006" y="1494573"/>
                  </a:lnTo>
                  <a:lnTo>
                    <a:pt x="6950083" y="1017970"/>
                  </a:lnTo>
                  <a:lnTo>
                    <a:pt x="6941729" y="969048"/>
                  </a:lnTo>
                  <a:lnTo>
                    <a:pt x="6933366" y="991172"/>
                  </a:lnTo>
                  <a:lnTo>
                    <a:pt x="6866443" y="1249487"/>
                  </a:lnTo>
                  <a:lnTo>
                    <a:pt x="6858090" y="1297422"/>
                  </a:lnTo>
                  <a:lnTo>
                    <a:pt x="6849737" y="1271602"/>
                  </a:lnTo>
                  <a:lnTo>
                    <a:pt x="6782814" y="1094301"/>
                  </a:lnTo>
                  <a:lnTo>
                    <a:pt x="6774451" y="1075245"/>
                  </a:lnTo>
                  <a:lnTo>
                    <a:pt x="6766097" y="1109495"/>
                  </a:lnTo>
                  <a:lnTo>
                    <a:pt x="6699174" y="1327173"/>
                  </a:lnTo>
                  <a:lnTo>
                    <a:pt x="6690821" y="1348909"/>
                  </a:lnTo>
                  <a:lnTo>
                    <a:pt x="6682458" y="1340712"/>
                  </a:lnTo>
                  <a:lnTo>
                    <a:pt x="6615535" y="1248200"/>
                  </a:lnTo>
                  <a:lnTo>
                    <a:pt x="6607182" y="1231602"/>
                  </a:lnTo>
                  <a:lnTo>
                    <a:pt x="6598829" y="1247639"/>
                  </a:lnTo>
                  <a:lnTo>
                    <a:pt x="6531944" y="1362149"/>
                  </a:lnTo>
                  <a:lnTo>
                    <a:pt x="6523542" y="1374963"/>
                  </a:lnTo>
                  <a:lnTo>
                    <a:pt x="6515189" y="1380895"/>
                  </a:lnTo>
                  <a:lnTo>
                    <a:pt x="6448305" y="1422936"/>
                  </a:lnTo>
                  <a:lnTo>
                    <a:pt x="6439913" y="1427621"/>
                  </a:lnTo>
                  <a:lnTo>
                    <a:pt x="6431560" y="1417943"/>
                  </a:lnTo>
                  <a:lnTo>
                    <a:pt x="6364665" y="1333638"/>
                  </a:lnTo>
                  <a:lnTo>
                    <a:pt x="6356273" y="1322111"/>
                  </a:lnTo>
                  <a:lnTo>
                    <a:pt x="6347920" y="1335186"/>
                  </a:lnTo>
                  <a:lnTo>
                    <a:pt x="6281036" y="1457980"/>
                  </a:lnTo>
                  <a:lnTo>
                    <a:pt x="6272644" y="1476049"/>
                  </a:lnTo>
                  <a:lnTo>
                    <a:pt x="6264280" y="1450799"/>
                  </a:lnTo>
                  <a:lnTo>
                    <a:pt x="6197396" y="1293338"/>
                  </a:lnTo>
                  <a:lnTo>
                    <a:pt x="6189004" y="1277882"/>
                  </a:lnTo>
                  <a:lnTo>
                    <a:pt x="6180651" y="1281541"/>
                  </a:lnTo>
                  <a:lnTo>
                    <a:pt x="6113767" y="1315346"/>
                  </a:lnTo>
                  <a:lnTo>
                    <a:pt x="6105365" y="1320253"/>
                  </a:lnTo>
                  <a:lnTo>
                    <a:pt x="6097011" y="1330695"/>
                  </a:lnTo>
                  <a:lnTo>
                    <a:pt x="6030127" y="1404335"/>
                  </a:lnTo>
                  <a:lnTo>
                    <a:pt x="6021735" y="1412465"/>
                  </a:lnTo>
                  <a:lnTo>
                    <a:pt x="6013372" y="1416017"/>
                  </a:lnTo>
                  <a:lnTo>
                    <a:pt x="5946488" y="1460323"/>
                  </a:lnTo>
                  <a:lnTo>
                    <a:pt x="5938096" y="1469130"/>
                  </a:lnTo>
                  <a:lnTo>
                    <a:pt x="5929743" y="1430911"/>
                  </a:lnTo>
                  <a:lnTo>
                    <a:pt x="5862858" y="1248616"/>
                  </a:lnTo>
                  <a:lnTo>
                    <a:pt x="5854457" y="1234670"/>
                  </a:lnTo>
                  <a:lnTo>
                    <a:pt x="5846103" y="1247368"/>
                  </a:lnTo>
                  <a:lnTo>
                    <a:pt x="5779219" y="1385163"/>
                  </a:lnTo>
                  <a:lnTo>
                    <a:pt x="5770827" y="1408797"/>
                  </a:lnTo>
                  <a:lnTo>
                    <a:pt x="5762474" y="1277950"/>
                  </a:lnTo>
                  <a:lnTo>
                    <a:pt x="5695580" y="550891"/>
                  </a:lnTo>
                  <a:lnTo>
                    <a:pt x="5687188" y="486852"/>
                  </a:lnTo>
                  <a:lnTo>
                    <a:pt x="5678835" y="534903"/>
                  </a:lnTo>
                  <a:lnTo>
                    <a:pt x="5611950" y="921036"/>
                  </a:lnTo>
                  <a:lnTo>
                    <a:pt x="5603558" y="969542"/>
                  </a:lnTo>
                  <a:lnTo>
                    <a:pt x="5595195" y="1012222"/>
                  </a:lnTo>
                  <a:lnTo>
                    <a:pt x="5528311" y="1498057"/>
                  </a:lnTo>
                  <a:lnTo>
                    <a:pt x="5519919" y="1585759"/>
                  </a:lnTo>
                  <a:lnTo>
                    <a:pt x="5511566" y="1582352"/>
                  </a:lnTo>
                  <a:lnTo>
                    <a:pt x="5444672" y="1521604"/>
                  </a:lnTo>
                  <a:lnTo>
                    <a:pt x="5436280" y="1503196"/>
                  </a:lnTo>
                  <a:lnTo>
                    <a:pt x="5427926" y="1380934"/>
                  </a:lnTo>
                  <a:lnTo>
                    <a:pt x="5361042" y="1026022"/>
                  </a:lnTo>
                  <a:lnTo>
                    <a:pt x="5352650" y="1008070"/>
                  </a:lnTo>
                  <a:lnTo>
                    <a:pt x="5344287" y="1032981"/>
                  </a:lnTo>
                  <a:lnTo>
                    <a:pt x="5277403" y="1205065"/>
                  </a:lnTo>
                  <a:lnTo>
                    <a:pt x="5269049" y="1223666"/>
                  </a:lnTo>
                  <a:lnTo>
                    <a:pt x="5260657" y="1203972"/>
                  </a:lnTo>
                  <a:lnTo>
                    <a:pt x="5193773" y="1059024"/>
                  </a:lnTo>
                  <a:lnTo>
                    <a:pt x="5185410" y="1042359"/>
                  </a:lnTo>
                  <a:lnTo>
                    <a:pt x="5177018" y="1042088"/>
                  </a:lnTo>
                  <a:lnTo>
                    <a:pt x="5110134" y="1039068"/>
                  </a:lnTo>
                  <a:lnTo>
                    <a:pt x="5101780" y="1038536"/>
                  </a:lnTo>
                  <a:lnTo>
                    <a:pt x="5093388" y="1080955"/>
                  </a:lnTo>
                  <a:lnTo>
                    <a:pt x="5026494" y="1365623"/>
                  </a:lnTo>
                  <a:lnTo>
                    <a:pt x="5018141" y="1395567"/>
                  </a:lnTo>
                  <a:lnTo>
                    <a:pt x="5009749" y="1399719"/>
                  </a:lnTo>
                  <a:lnTo>
                    <a:pt x="4942864" y="1429101"/>
                  </a:lnTo>
                  <a:lnTo>
                    <a:pt x="4934501" y="1432382"/>
                  </a:lnTo>
                  <a:lnTo>
                    <a:pt x="4926109" y="1414352"/>
                  </a:lnTo>
                  <a:lnTo>
                    <a:pt x="4859225" y="1198262"/>
                  </a:lnTo>
                  <a:lnTo>
                    <a:pt x="4850872" y="1156937"/>
                  </a:lnTo>
                  <a:lnTo>
                    <a:pt x="4842480" y="1114944"/>
                  </a:lnTo>
                  <a:lnTo>
                    <a:pt x="4775595" y="860442"/>
                  </a:lnTo>
                  <a:lnTo>
                    <a:pt x="4767232" y="836130"/>
                  </a:lnTo>
                  <a:lnTo>
                    <a:pt x="4758840" y="841008"/>
                  </a:lnTo>
                  <a:lnTo>
                    <a:pt x="4691956" y="884520"/>
                  </a:lnTo>
                  <a:lnTo>
                    <a:pt x="4683603" y="890647"/>
                  </a:lnTo>
                  <a:lnTo>
                    <a:pt x="4675201" y="945047"/>
                  </a:lnTo>
                  <a:lnTo>
                    <a:pt x="4608317" y="1390002"/>
                  </a:lnTo>
                  <a:lnTo>
                    <a:pt x="4599964" y="1446899"/>
                  </a:lnTo>
                  <a:lnTo>
                    <a:pt x="4591572" y="1445389"/>
                  </a:lnTo>
                  <a:lnTo>
                    <a:pt x="4524687" y="1434802"/>
                  </a:lnTo>
                  <a:lnTo>
                    <a:pt x="4516324" y="1433592"/>
                  </a:lnTo>
                  <a:lnTo>
                    <a:pt x="4507932" y="1400513"/>
                  </a:lnTo>
                  <a:lnTo>
                    <a:pt x="4441048" y="1150094"/>
                  </a:lnTo>
                  <a:lnTo>
                    <a:pt x="4432695" y="1120460"/>
                  </a:lnTo>
                  <a:lnTo>
                    <a:pt x="4424303" y="1042581"/>
                  </a:lnTo>
                  <a:lnTo>
                    <a:pt x="4357409" y="414305"/>
                  </a:lnTo>
                  <a:lnTo>
                    <a:pt x="4349055" y="335101"/>
                  </a:lnTo>
                  <a:lnTo>
                    <a:pt x="4340664" y="433884"/>
                  </a:lnTo>
                  <a:lnTo>
                    <a:pt x="4273779" y="1289148"/>
                  </a:lnTo>
                  <a:lnTo>
                    <a:pt x="4265416" y="1404935"/>
                  </a:lnTo>
                  <a:lnTo>
                    <a:pt x="4257024" y="1306046"/>
                  </a:lnTo>
                  <a:lnTo>
                    <a:pt x="4190140" y="675805"/>
                  </a:lnTo>
                  <a:lnTo>
                    <a:pt x="4181787" y="612666"/>
                  </a:lnTo>
                  <a:lnTo>
                    <a:pt x="4173394" y="670927"/>
                  </a:lnTo>
                  <a:lnTo>
                    <a:pt x="4106500" y="1383847"/>
                  </a:lnTo>
                  <a:lnTo>
                    <a:pt x="4098147" y="1523152"/>
                  </a:lnTo>
                  <a:lnTo>
                    <a:pt x="4089755" y="1475294"/>
                  </a:lnTo>
                  <a:lnTo>
                    <a:pt x="4022871" y="1225931"/>
                  </a:lnTo>
                  <a:lnTo>
                    <a:pt x="4014517" y="1205259"/>
                  </a:lnTo>
                  <a:lnTo>
                    <a:pt x="4006154" y="1234293"/>
                  </a:lnTo>
                  <a:lnTo>
                    <a:pt x="3939231" y="1497825"/>
                  </a:lnTo>
                  <a:lnTo>
                    <a:pt x="3930878" y="1535250"/>
                  </a:lnTo>
                  <a:lnTo>
                    <a:pt x="3922525" y="1512758"/>
                  </a:lnTo>
                  <a:lnTo>
                    <a:pt x="3855602" y="1312694"/>
                  </a:lnTo>
                  <a:lnTo>
                    <a:pt x="3847239" y="1284870"/>
                  </a:lnTo>
                  <a:lnTo>
                    <a:pt x="3838885" y="1281057"/>
                  </a:lnTo>
                  <a:lnTo>
                    <a:pt x="3771962" y="1253001"/>
                  </a:lnTo>
                  <a:lnTo>
                    <a:pt x="3763609" y="1249787"/>
                  </a:lnTo>
                  <a:lnTo>
                    <a:pt x="3755246" y="1219360"/>
                  </a:lnTo>
                  <a:lnTo>
                    <a:pt x="3688323" y="941950"/>
                  </a:lnTo>
                  <a:lnTo>
                    <a:pt x="3679970" y="902405"/>
                  </a:lnTo>
                  <a:lnTo>
                    <a:pt x="3671616" y="864487"/>
                  </a:lnTo>
                  <a:lnTo>
                    <a:pt x="3604693" y="637093"/>
                  </a:lnTo>
                  <a:lnTo>
                    <a:pt x="3596330" y="615617"/>
                  </a:lnTo>
                  <a:lnTo>
                    <a:pt x="3587977" y="651948"/>
                  </a:lnTo>
                  <a:lnTo>
                    <a:pt x="3521054" y="986594"/>
                  </a:lnTo>
                  <a:lnTo>
                    <a:pt x="3512701" y="1034868"/>
                  </a:lnTo>
                  <a:lnTo>
                    <a:pt x="3504347" y="969048"/>
                  </a:lnTo>
                  <a:lnTo>
                    <a:pt x="3437424" y="510514"/>
                  </a:lnTo>
                  <a:lnTo>
                    <a:pt x="3429061" y="460499"/>
                  </a:lnTo>
                  <a:lnTo>
                    <a:pt x="3420708" y="496230"/>
                  </a:lnTo>
                  <a:lnTo>
                    <a:pt x="3353785" y="1196829"/>
                  </a:lnTo>
                  <a:lnTo>
                    <a:pt x="3345432" y="1435789"/>
                  </a:lnTo>
                  <a:lnTo>
                    <a:pt x="3337069" y="1414052"/>
                  </a:lnTo>
                  <a:lnTo>
                    <a:pt x="3270146" y="1338022"/>
                  </a:lnTo>
                  <a:lnTo>
                    <a:pt x="3261792" y="1333560"/>
                  </a:lnTo>
                  <a:lnTo>
                    <a:pt x="3253439" y="1281473"/>
                  </a:lnTo>
                  <a:lnTo>
                    <a:pt x="3186516" y="950186"/>
                  </a:lnTo>
                  <a:lnTo>
                    <a:pt x="3178153" y="917068"/>
                  </a:lnTo>
                  <a:lnTo>
                    <a:pt x="3169800" y="918432"/>
                  </a:lnTo>
                  <a:lnTo>
                    <a:pt x="3102877" y="933665"/>
                  </a:lnTo>
                  <a:lnTo>
                    <a:pt x="3094523" y="936346"/>
                  </a:lnTo>
                  <a:lnTo>
                    <a:pt x="3086161" y="956651"/>
                  </a:lnTo>
                  <a:lnTo>
                    <a:pt x="3019238" y="1084168"/>
                  </a:lnTo>
                  <a:lnTo>
                    <a:pt x="3010884" y="1096759"/>
                  </a:lnTo>
                  <a:lnTo>
                    <a:pt x="3002531" y="1060766"/>
                  </a:lnTo>
                  <a:lnTo>
                    <a:pt x="2935608" y="760594"/>
                  </a:lnTo>
                  <a:lnTo>
                    <a:pt x="2927245" y="721466"/>
                  </a:lnTo>
                  <a:lnTo>
                    <a:pt x="2918892" y="742680"/>
                  </a:lnTo>
                  <a:lnTo>
                    <a:pt x="2851968" y="907699"/>
                  </a:lnTo>
                  <a:lnTo>
                    <a:pt x="2843615" y="927771"/>
                  </a:lnTo>
                  <a:lnTo>
                    <a:pt x="2835262" y="938582"/>
                  </a:lnTo>
                  <a:lnTo>
                    <a:pt x="2768329" y="1052714"/>
                  </a:lnTo>
                  <a:lnTo>
                    <a:pt x="2759976" y="1071732"/>
                  </a:lnTo>
                  <a:lnTo>
                    <a:pt x="2751623" y="1051427"/>
                  </a:lnTo>
                  <a:lnTo>
                    <a:pt x="2684699" y="914541"/>
                  </a:lnTo>
                  <a:lnTo>
                    <a:pt x="2676346" y="900054"/>
                  </a:lnTo>
                  <a:lnTo>
                    <a:pt x="2667983" y="941001"/>
                  </a:lnTo>
                  <a:lnTo>
                    <a:pt x="2601060" y="1264304"/>
                  </a:lnTo>
                  <a:lnTo>
                    <a:pt x="2592707" y="1304187"/>
                  </a:lnTo>
                  <a:lnTo>
                    <a:pt x="2584354" y="1270924"/>
                  </a:lnTo>
                  <a:lnTo>
                    <a:pt x="2517430" y="1043907"/>
                  </a:lnTo>
                  <a:lnTo>
                    <a:pt x="2509068" y="1019635"/>
                  </a:lnTo>
                  <a:lnTo>
                    <a:pt x="2500714" y="1015667"/>
                  </a:lnTo>
                  <a:lnTo>
                    <a:pt x="2433791" y="981978"/>
                  </a:lnTo>
                  <a:lnTo>
                    <a:pt x="2425438" y="977516"/>
                  </a:lnTo>
                  <a:lnTo>
                    <a:pt x="2417075" y="1009241"/>
                  </a:lnTo>
                  <a:lnTo>
                    <a:pt x="2350152" y="1276402"/>
                  </a:lnTo>
                  <a:lnTo>
                    <a:pt x="2341799" y="1311562"/>
                  </a:lnTo>
                  <a:lnTo>
                    <a:pt x="2333445" y="1303549"/>
                  </a:lnTo>
                  <a:lnTo>
                    <a:pt x="2266522" y="1225031"/>
                  </a:lnTo>
                  <a:lnTo>
                    <a:pt x="2258159" y="1212963"/>
                  </a:lnTo>
                  <a:lnTo>
                    <a:pt x="2249806" y="1198600"/>
                  </a:lnTo>
                  <a:lnTo>
                    <a:pt x="2182883" y="1102653"/>
                  </a:lnTo>
                  <a:lnTo>
                    <a:pt x="2174530" y="1092597"/>
                  </a:lnTo>
                  <a:lnTo>
                    <a:pt x="2166176" y="1033920"/>
                  </a:lnTo>
                  <a:lnTo>
                    <a:pt x="2099253" y="489155"/>
                  </a:lnTo>
                  <a:lnTo>
                    <a:pt x="2090890" y="409999"/>
                  </a:lnTo>
                  <a:lnTo>
                    <a:pt x="2082537" y="531080"/>
                  </a:lnTo>
                  <a:lnTo>
                    <a:pt x="2015614" y="1270963"/>
                  </a:lnTo>
                  <a:lnTo>
                    <a:pt x="2007260" y="1342183"/>
                  </a:lnTo>
                  <a:lnTo>
                    <a:pt x="1998898" y="1333938"/>
                  </a:lnTo>
                  <a:lnTo>
                    <a:pt x="1931975" y="1249710"/>
                  </a:lnTo>
                  <a:lnTo>
                    <a:pt x="1923621" y="1236141"/>
                  </a:lnTo>
                  <a:lnTo>
                    <a:pt x="1915268" y="1242190"/>
                  </a:lnTo>
                  <a:lnTo>
                    <a:pt x="1848345" y="1291035"/>
                  </a:lnTo>
                  <a:lnTo>
                    <a:pt x="1839982" y="1297200"/>
                  </a:lnTo>
                  <a:lnTo>
                    <a:pt x="1831629" y="1296629"/>
                  </a:lnTo>
                  <a:lnTo>
                    <a:pt x="1764706" y="1292399"/>
                  </a:lnTo>
                  <a:lnTo>
                    <a:pt x="1756352" y="1291906"/>
                  </a:lnTo>
                  <a:lnTo>
                    <a:pt x="1747989" y="1301052"/>
                  </a:lnTo>
                  <a:lnTo>
                    <a:pt x="1681066" y="1361462"/>
                  </a:lnTo>
                  <a:lnTo>
                    <a:pt x="1672713" y="1367743"/>
                  </a:lnTo>
                  <a:lnTo>
                    <a:pt x="1664360" y="1370501"/>
                  </a:lnTo>
                  <a:lnTo>
                    <a:pt x="1597437" y="1403387"/>
                  </a:lnTo>
                  <a:lnTo>
                    <a:pt x="1589074" y="1409629"/>
                  </a:lnTo>
                  <a:lnTo>
                    <a:pt x="1580720" y="1410645"/>
                  </a:lnTo>
                  <a:lnTo>
                    <a:pt x="1513797" y="1417033"/>
                  </a:lnTo>
                  <a:lnTo>
                    <a:pt x="1505444" y="1417681"/>
                  </a:lnTo>
                  <a:lnTo>
                    <a:pt x="1497091" y="1378737"/>
                  </a:lnTo>
                  <a:lnTo>
                    <a:pt x="1430158" y="1117741"/>
                  </a:lnTo>
                  <a:lnTo>
                    <a:pt x="1421805" y="1090333"/>
                  </a:lnTo>
                  <a:lnTo>
                    <a:pt x="1413451" y="1113802"/>
                  </a:lnTo>
                  <a:lnTo>
                    <a:pt x="1346528" y="1394280"/>
                  </a:lnTo>
                  <a:lnTo>
                    <a:pt x="1338175" y="1447654"/>
                  </a:lnTo>
                  <a:lnTo>
                    <a:pt x="1329812" y="1353681"/>
                  </a:lnTo>
                  <a:lnTo>
                    <a:pt x="1262889" y="890114"/>
                  </a:lnTo>
                  <a:lnTo>
                    <a:pt x="1254536" y="853483"/>
                  </a:lnTo>
                  <a:lnTo>
                    <a:pt x="1246182" y="872994"/>
                  </a:lnTo>
                  <a:lnTo>
                    <a:pt x="1179259" y="1057215"/>
                  </a:lnTo>
                  <a:lnTo>
                    <a:pt x="1170896" y="1084507"/>
                  </a:lnTo>
                  <a:lnTo>
                    <a:pt x="1162543" y="1113734"/>
                  </a:lnTo>
                  <a:lnTo>
                    <a:pt x="1095620" y="1334809"/>
                  </a:lnTo>
                  <a:lnTo>
                    <a:pt x="1087267" y="1360939"/>
                  </a:lnTo>
                  <a:lnTo>
                    <a:pt x="1078904" y="1356323"/>
                  </a:lnTo>
                  <a:lnTo>
                    <a:pt x="1011981" y="1325585"/>
                  </a:lnTo>
                  <a:lnTo>
                    <a:pt x="1003627" y="1322411"/>
                  </a:lnTo>
                  <a:lnTo>
                    <a:pt x="995274" y="1301623"/>
                  </a:lnTo>
                  <a:lnTo>
                    <a:pt x="928351" y="1086394"/>
                  </a:lnTo>
                  <a:lnTo>
                    <a:pt x="919988" y="1051311"/>
                  </a:lnTo>
                  <a:lnTo>
                    <a:pt x="911635" y="1076493"/>
                  </a:lnTo>
                  <a:lnTo>
                    <a:pt x="844712" y="1239964"/>
                  </a:lnTo>
                  <a:lnTo>
                    <a:pt x="836358" y="1256591"/>
                  </a:lnTo>
                  <a:lnTo>
                    <a:pt x="828005" y="1263927"/>
                  </a:lnTo>
                  <a:lnTo>
                    <a:pt x="761082" y="1338670"/>
                  </a:lnTo>
                  <a:lnTo>
                    <a:pt x="752719" y="1350651"/>
                  </a:lnTo>
                  <a:lnTo>
                    <a:pt x="744366" y="1327095"/>
                  </a:lnTo>
                  <a:lnTo>
                    <a:pt x="677443" y="1102014"/>
                  </a:lnTo>
                  <a:lnTo>
                    <a:pt x="669089" y="1068286"/>
                  </a:lnTo>
                  <a:lnTo>
                    <a:pt x="660727" y="1033736"/>
                  </a:lnTo>
                  <a:lnTo>
                    <a:pt x="593803" y="845392"/>
                  </a:lnTo>
                  <a:lnTo>
                    <a:pt x="585450" y="829095"/>
                  </a:lnTo>
                  <a:lnTo>
                    <a:pt x="577097" y="838550"/>
                  </a:lnTo>
                  <a:lnTo>
                    <a:pt x="510174" y="959680"/>
                  </a:lnTo>
                  <a:lnTo>
                    <a:pt x="501811" y="984591"/>
                  </a:lnTo>
                  <a:lnTo>
                    <a:pt x="493458" y="939946"/>
                  </a:lnTo>
                  <a:lnTo>
                    <a:pt x="426534" y="740144"/>
                  </a:lnTo>
                  <a:lnTo>
                    <a:pt x="418181" y="725666"/>
                  </a:lnTo>
                  <a:lnTo>
                    <a:pt x="409818" y="741276"/>
                  </a:lnTo>
                  <a:lnTo>
                    <a:pt x="342895" y="911212"/>
                  </a:lnTo>
                  <a:lnTo>
                    <a:pt x="334542" y="940430"/>
                  </a:lnTo>
                  <a:lnTo>
                    <a:pt x="326189" y="974913"/>
                  </a:lnTo>
                  <a:lnTo>
                    <a:pt x="259304" y="1293677"/>
                  </a:lnTo>
                  <a:lnTo>
                    <a:pt x="250903" y="1339802"/>
                  </a:lnTo>
                  <a:lnTo>
                    <a:pt x="242549" y="1325092"/>
                  </a:lnTo>
                  <a:lnTo>
                    <a:pt x="175665" y="1242945"/>
                  </a:lnTo>
                  <a:lnTo>
                    <a:pt x="167273" y="1235648"/>
                  </a:lnTo>
                  <a:lnTo>
                    <a:pt x="158920" y="1206236"/>
                  </a:lnTo>
                  <a:lnTo>
                    <a:pt x="92029" y="935214"/>
                  </a:lnTo>
                  <a:lnTo>
                    <a:pt x="83635" y="896086"/>
                  </a:lnTo>
                  <a:lnTo>
                    <a:pt x="75279" y="898360"/>
                  </a:lnTo>
                  <a:lnTo>
                    <a:pt x="8394" y="916197"/>
                  </a:lnTo>
                  <a:lnTo>
                    <a:pt x="0" y="918393"/>
                  </a:lnTo>
                  <a:close/>
                </a:path>
              </a:pathLst>
            </a:custGeom>
            <a:solidFill>
              <a:srgbClr val="80B1D3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02" name="Freeform: Shape 3001">
              <a:extLst>
                <a:ext uri="{FF2B5EF4-FFF2-40B4-BE49-F238E27FC236}">
                  <a16:creationId xmlns:a16="http://schemas.microsoft.com/office/drawing/2014/main" id="{2E9909DD-03E8-51AC-BC4D-78805465FD81}"/>
                </a:ext>
              </a:extLst>
            </p:cNvPr>
            <p:cNvSpPr/>
            <p:nvPr/>
          </p:nvSpPr>
          <p:spPr>
            <a:xfrm>
              <a:off x="1961705" y="3048228"/>
              <a:ext cx="8363529" cy="1421726"/>
            </a:xfrm>
            <a:custGeom>
              <a:avLst/>
              <a:gdLst>
                <a:gd name="connsiteX0" fmla="*/ 0 w 8363529"/>
                <a:gd name="connsiteY0" fmla="*/ 594897 h 1421726"/>
                <a:gd name="connsiteX1" fmla="*/ 8394 w 8363529"/>
                <a:gd name="connsiteY1" fmla="*/ 592700 h 1421726"/>
                <a:gd name="connsiteX2" fmla="*/ 75279 w 8363529"/>
                <a:gd name="connsiteY2" fmla="*/ 574863 h 1421726"/>
                <a:gd name="connsiteX3" fmla="*/ 83635 w 8363529"/>
                <a:gd name="connsiteY3" fmla="*/ 572589 h 1421726"/>
                <a:gd name="connsiteX4" fmla="*/ 92029 w 8363529"/>
                <a:gd name="connsiteY4" fmla="*/ 611717 h 1421726"/>
                <a:gd name="connsiteX5" fmla="*/ 158920 w 8363529"/>
                <a:gd name="connsiteY5" fmla="*/ 882740 h 1421726"/>
                <a:gd name="connsiteX6" fmla="*/ 167273 w 8363529"/>
                <a:gd name="connsiteY6" fmla="*/ 912151 h 1421726"/>
                <a:gd name="connsiteX7" fmla="*/ 175665 w 8363529"/>
                <a:gd name="connsiteY7" fmla="*/ 919448 h 1421726"/>
                <a:gd name="connsiteX8" fmla="*/ 242549 w 8363529"/>
                <a:gd name="connsiteY8" fmla="*/ 1001595 h 1421726"/>
                <a:gd name="connsiteX9" fmla="*/ 250903 w 8363529"/>
                <a:gd name="connsiteY9" fmla="*/ 1016306 h 1421726"/>
                <a:gd name="connsiteX10" fmla="*/ 259304 w 8363529"/>
                <a:gd name="connsiteY10" fmla="*/ 970180 h 1421726"/>
                <a:gd name="connsiteX11" fmla="*/ 326189 w 8363529"/>
                <a:gd name="connsiteY11" fmla="*/ 651416 h 1421726"/>
                <a:gd name="connsiteX12" fmla="*/ 334542 w 8363529"/>
                <a:gd name="connsiteY12" fmla="*/ 616934 h 1421726"/>
                <a:gd name="connsiteX13" fmla="*/ 342895 w 8363529"/>
                <a:gd name="connsiteY13" fmla="*/ 587716 h 1421726"/>
                <a:gd name="connsiteX14" fmla="*/ 409818 w 8363529"/>
                <a:gd name="connsiteY14" fmla="*/ 417780 h 1421726"/>
                <a:gd name="connsiteX15" fmla="*/ 418181 w 8363529"/>
                <a:gd name="connsiteY15" fmla="*/ 402169 h 1421726"/>
                <a:gd name="connsiteX16" fmla="*/ 426534 w 8363529"/>
                <a:gd name="connsiteY16" fmla="*/ 416647 h 1421726"/>
                <a:gd name="connsiteX17" fmla="*/ 493458 w 8363529"/>
                <a:gd name="connsiteY17" fmla="*/ 616449 h 1421726"/>
                <a:gd name="connsiteX18" fmla="*/ 501811 w 8363529"/>
                <a:gd name="connsiteY18" fmla="*/ 661094 h 1421726"/>
                <a:gd name="connsiteX19" fmla="*/ 510174 w 8363529"/>
                <a:gd name="connsiteY19" fmla="*/ 636183 h 1421726"/>
                <a:gd name="connsiteX20" fmla="*/ 577097 w 8363529"/>
                <a:gd name="connsiteY20" fmla="*/ 515053 h 1421726"/>
                <a:gd name="connsiteX21" fmla="*/ 585450 w 8363529"/>
                <a:gd name="connsiteY21" fmla="*/ 505598 h 1421726"/>
                <a:gd name="connsiteX22" fmla="*/ 593803 w 8363529"/>
                <a:gd name="connsiteY22" fmla="*/ 521896 h 1421726"/>
                <a:gd name="connsiteX23" fmla="*/ 660727 w 8363529"/>
                <a:gd name="connsiteY23" fmla="*/ 710239 h 1421726"/>
                <a:gd name="connsiteX24" fmla="*/ 669089 w 8363529"/>
                <a:gd name="connsiteY24" fmla="*/ 744790 h 1421726"/>
                <a:gd name="connsiteX25" fmla="*/ 677443 w 8363529"/>
                <a:gd name="connsiteY25" fmla="*/ 778517 h 1421726"/>
                <a:gd name="connsiteX26" fmla="*/ 744366 w 8363529"/>
                <a:gd name="connsiteY26" fmla="*/ 1003599 h 1421726"/>
                <a:gd name="connsiteX27" fmla="*/ 752719 w 8363529"/>
                <a:gd name="connsiteY27" fmla="*/ 1027155 h 1421726"/>
                <a:gd name="connsiteX28" fmla="*/ 761082 w 8363529"/>
                <a:gd name="connsiteY28" fmla="*/ 1015173 h 1421726"/>
                <a:gd name="connsiteX29" fmla="*/ 828005 w 8363529"/>
                <a:gd name="connsiteY29" fmla="*/ 940430 h 1421726"/>
                <a:gd name="connsiteX30" fmla="*/ 836358 w 8363529"/>
                <a:gd name="connsiteY30" fmla="*/ 933094 h 1421726"/>
                <a:gd name="connsiteX31" fmla="*/ 844712 w 8363529"/>
                <a:gd name="connsiteY31" fmla="*/ 916467 h 1421726"/>
                <a:gd name="connsiteX32" fmla="*/ 911635 w 8363529"/>
                <a:gd name="connsiteY32" fmla="*/ 752996 h 1421726"/>
                <a:gd name="connsiteX33" fmla="*/ 919988 w 8363529"/>
                <a:gd name="connsiteY33" fmla="*/ 727814 h 1421726"/>
                <a:gd name="connsiteX34" fmla="*/ 928351 w 8363529"/>
                <a:gd name="connsiteY34" fmla="*/ 762897 h 1421726"/>
                <a:gd name="connsiteX35" fmla="*/ 995274 w 8363529"/>
                <a:gd name="connsiteY35" fmla="*/ 978126 h 1421726"/>
                <a:gd name="connsiteX36" fmla="*/ 1003627 w 8363529"/>
                <a:gd name="connsiteY36" fmla="*/ 998914 h 1421726"/>
                <a:gd name="connsiteX37" fmla="*/ 1011981 w 8363529"/>
                <a:gd name="connsiteY37" fmla="*/ 1002089 h 1421726"/>
                <a:gd name="connsiteX38" fmla="*/ 1078904 w 8363529"/>
                <a:gd name="connsiteY38" fmla="*/ 1032826 h 1421726"/>
                <a:gd name="connsiteX39" fmla="*/ 1087267 w 8363529"/>
                <a:gd name="connsiteY39" fmla="*/ 1037442 h 1421726"/>
                <a:gd name="connsiteX40" fmla="*/ 1095620 w 8363529"/>
                <a:gd name="connsiteY40" fmla="*/ 1011312 h 1421726"/>
                <a:gd name="connsiteX41" fmla="*/ 1162543 w 8363529"/>
                <a:gd name="connsiteY41" fmla="*/ 790237 h 1421726"/>
                <a:gd name="connsiteX42" fmla="*/ 1170896 w 8363529"/>
                <a:gd name="connsiteY42" fmla="*/ 761010 h 1421726"/>
                <a:gd name="connsiteX43" fmla="*/ 1179259 w 8363529"/>
                <a:gd name="connsiteY43" fmla="*/ 733718 h 1421726"/>
                <a:gd name="connsiteX44" fmla="*/ 1246182 w 8363529"/>
                <a:gd name="connsiteY44" fmla="*/ 549497 h 1421726"/>
                <a:gd name="connsiteX45" fmla="*/ 1254536 w 8363529"/>
                <a:gd name="connsiteY45" fmla="*/ 529986 h 1421726"/>
                <a:gd name="connsiteX46" fmla="*/ 1262889 w 8363529"/>
                <a:gd name="connsiteY46" fmla="*/ 566618 h 1421726"/>
                <a:gd name="connsiteX47" fmla="*/ 1329812 w 8363529"/>
                <a:gd name="connsiteY47" fmla="*/ 1030184 h 1421726"/>
                <a:gd name="connsiteX48" fmla="*/ 1338175 w 8363529"/>
                <a:gd name="connsiteY48" fmla="*/ 1124157 h 1421726"/>
                <a:gd name="connsiteX49" fmla="*/ 1346528 w 8363529"/>
                <a:gd name="connsiteY49" fmla="*/ 1070783 h 1421726"/>
                <a:gd name="connsiteX50" fmla="*/ 1413451 w 8363529"/>
                <a:gd name="connsiteY50" fmla="*/ 790305 h 1421726"/>
                <a:gd name="connsiteX51" fmla="*/ 1421805 w 8363529"/>
                <a:gd name="connsiteY51" fmla="*/ 766836 h 1421726"/>
                <a:gd name="connsiteX52" fmla="*/ 1430158 w 8363529"/>
                <a:gd name="connsiteY52" fmla="*/ 794244 h 1421726"/>
                <a:gd name="connsiteX53" fmla="*/ 1497091 w 8363529"/>
                <a:gd name="connsiteY53" fmla="*/ 1055240 h 1421726"/>
                <a:gd name="connsiteX54" fmla="*/ 1505444 w 8363529"/>
                <a:gd name="connsiteY54" fmla="*/ 1094184 h 1421726"/>
                <a:gd name="connsiteX55" fmla="*/ 1513797 w 8363529"/>
                <a:gd name="connsiteY55" fmla="*/ 1093536 h 1421726"/>
                <a:gd name="connsiteX56" fmla="*/ 1580720 w 8363529"/>
                <a:gd name="connsiteY56" fmla="*/ 1087149 h 1421726"/>
                <a:gd name="connsiteX57" fmla="*/ 1589074 w 8363529"/>
                <a:gd name="connsiteY57" fmla="*/ 1086132 h 1421726"/>
                <a:gd name="connsiteX58" fmla="*/ 1597437 w 8363529"/>
                <a:gd name="connsiteY58" fmla="*/ 1079890 h 1421726"/>
                <a:gd name="connsiteX59" fmla="*/ 1664360 w 8363529"/>
                <a:gd name="connsiteY59" fmla="*/ 1047004 h 1421726"/>
                <a:gd name="connsiteX60" fmla="*/ 1672713 w 8363529"/>
                <a:gd name="connsiteY60" fmla="*/ 1044246 h 1421726"/>
                <a:gd name="connsiteX61" fmla="*/ 1681066 w 8363529"/>
                <a:gd name="connsiteY61" fmla="*/ 1037965 h 1421726"/>
                <a:gd name="connsiteX62" fmla="*/ 1747989 w 8363529"/>
                <a:gd name="connsiteY62" fmla="*/ 977555 h 1421726"/>
                <a:gd name="connsiteX63" fmla="*/ 1756352 w 8363529"/>
                <a:gd name="connsiteY63" fmla="*/ 968409 h 1421726"/>
                <a:gd name="connsiteX64" fmla="*/ 1764706 w 8363529"/>
                <a:gd name="connsiteY64" fmla="*/ 968903 h 1421726"/>
                <a:gd name="connsiteX65" fmla="*/ 1831629 w 8363529"/>
                <a:gd name="connsiteY65" fmla="*/ 973132 h 1421726"/>
                <a:gd name="connsiteX66" fmla="*/ 1839982 w 8363529"/>
                <a:gd name="connsiteY66" fmla="*/ 973703 h 1421726"/>
                <a:gd name="connsiteX67" fmla="*/ 1848345 w 8363529"/>
                <a:gd name="connsiteY67" fmla="*/ 967538 h 1421726"/>
                <a:gd name="connsiteX68" fmla="*/ 1915268 w 8363529"/>
                <a:gd name="connsiteY68" fmla="*/ 918693 h 1421726"/>
                <a:gd name="connsiteX69" fmla="*/ 1923621 w 8363529"/>
                <a:gd name="connsiteY69" fmla="*/ 912645 h 1421726"/>
                <a:gd name="connsiteX70" fmla="*/ 1931975 w 8363529"/>
                <a:gd name="connsiteY70" fmla="*/ 926213 h 1421726"/>
                <a:gd name="connsiteX71" fmla="*/ 1998898 w 8363529"/>
                <a:gd name="connsiteY71" fmla="*/ 1010441 h 1421726"/>
                <a:gd name="connsiteX72" fmla="*/ 2007260 w 8363529"/>
                <a:gd name="connsiteY72" fmla="*/ 1018686 h 1421726"/>
                <a:gd name="connsiteX73" fmla="*/ 2015614 w 8363529"/>
                <a:gd name="connsiteY73" fmla="*/ 947466 h 1421726"/>
                <a:gd name="connsiteX74" fmla="*/ 2082537 w 8363529"/>
                <a:gd name="connsiteY74" fmla="*/ 207583 h 1421726"/>
                <a:gd name="connsiteX75" fmla="*/ 2090890 w 8363529"/>
                <a:gd name="connsiteY75" fmla="*/ 86502 h 1421726"/>
                <a:gd name="connsiteX76" fmla="*/ 2099253 w 8363529"/>
                <a:gd name="connsiteY76" fmla="*/ 165658 h 1421726"/>
                <a:gd name="connsiteX77" fmla="*/ 2166176 w 8363529"/>
                <a:gd name="connsiteY77" fmla="*/ 710423 h 1421726"/>
                <a:gd name="connsiteX78" fmla="*/ 2174530 w 8363529"/>
                <a:gd name="connsiteY78" fmla="*/ 769101 h 1421726"/>
                <a:gd name="connsiteX79" fmla="*/ 2182883 w 8363529"/>
                <a:gd name="connsiteY79" fmla="*/ 779156 h 1421726"/>
                <a:gd name="connsiteX80" fmla="*/ 2249806 w 8363529"/>
                <a:gd name="connsiteY80" fmla="*/ 875104 h 1421726"/>
                <a:gd name="connsiteX81" fmla="*/ 2258159 w 8363529"/>
                <a:gd name="connsiteY81" fmla="*/ 889466 h 1421726"/>
                <a:gd name="connsiteX82" fmla="*/ 2266522 w 8363529"/>
                <a:gd name="connsiteY82" fmla="*/ 901534 h 1421726"/>
                <a:gd name="connsiteX83" fmla="*/ 2333445 w 8363529"/>
                <a:gd name="connsiteY83" fmla="*/ 980052 h 1421726"/>
                <a:gd name="connsiteX84" fmla="*/ 2341799 w 8363529"/>
                <a:gd name="connsiteY84" fmla="*/ 988065 h 1421726"/>
                <a:gd name="connsiteX85" fmla="*/ 2350152 w 8363529"/>
                <a:gd name="connsiteY85" fmla="*/ 952905 h 1421726"/>
                <a:gd name="connsiteX86" fmla="*/ 2417075 w 8363529"/>
                <a:gd name="connsiteY86" fmla="*/ 685744 h 1421726"/>
                <a:gd name="connsiteX87" fmla="*/ 2425438 w 8363529"/>
                <a:gd name="connsiteY87" fmla="*/ 654020 h 1421726"/>
                <a:gd name="connsiteX88" fmla="*/ 2433791 w 8363529"/>
                <a:gd name="connsiteY88" fmla="*/ 658481 h 1421726"/>
                <a:gd name="connsiteX89" fmla="*/ 2500714 w 8363529"/>
                <a:gd name="connsiteY89" fmla="*/ 692170 h 1421726"/>
                <a:gd name="connsiteX90" fmla="*/ 2509068 w 8363529"/>
                <a:gd name="connsiteY90" fmla="*/ 696138 h 1421726"/>
                <a:gd name="connsiteX91" fmla="*/ 2517430 w 8363529"/>
                <a:gd name="connsiteY91" fmla="*/ 720411 h 1421726"/>
                <a:gd name="connsiteX92" fmla="*/ 2584354 w 8363529"/>
                <a:gd name="connsiteY92" fmla="*/ 947427 h 1421726"/>
                <a:gd name="connsiteX93" fmla="*/ 2592707 w 8363529"/>
                <a:gd name="connsiteY93" fmla="*/ 980691 h 1421726"/>
                <a:gd name="connsiteX94" fmla="*/ 2601060 w 8363529"/>
                <a:gd name="connsiteY94" fmla="*/ 940808 h 1421726"/>
                <a:gd name="connsiteX95" fmla="*/ 2667983 w 8363529"/>
                <a:gd name="connsiteY95" fmla="*/ 617504 h 1421726"/>
                <a:gd name="connsiteX96" fmla="*/ 2676346 w 8363529"/>
                <a:gd name="connsiteY96" fmla="*/ 576557 h 1421726"/>
                <a:gd name="connsiteX97" fmla="*/ 2684699 w 8363529"/>
                <a:gd name="connsiteY97" fmla="*/ 591045 h 1421726"/>
                <a:gd name="connsiteX98" fmla="*/ 2751623 w 8363529"/>
                <a:gd name="connsiteY98" fmla="*/ 727930 h 1421726"/>
                <a:gd name="connsiteX99" fmla="*/ 2759976 w 8363529"/>
                <a:gd name="connsiteY99" fmla="*/ 748235 h 1421726"/>
                <a:gd name="connsiteX100" fmla="*/ 2768329 w 8363529"/>
                <a:gd name="connsiteY100" fmla="*/ 729218 h 1421726"/>
                <a:gd name="connsiteX101" fmla="*/ 2835262 w 8363529"/>
                <a:gd name="connsiteY101" fmla="*/ 615085 h 1421726"/>
                <a:gd name="connsiteX102" fmla="*/ 2843615 w 8363529"/>
                <a:gd name="connsiteY102" fmla="*/ 604275 h 1421726"/>
                <a:gd name="connsiteX103" fmla="*/ 2851968 w 8363529"/>
                <a:gd name="connsiteY103" fmla="*/ 584202 h 1421726"/>
                <a:gd name="connsiteX104" fmla="*/ 2918892 w 8363529"/>
                <a:gd name="connsiteY104" fmla="*/ 419183 h 1421726"/>
                <a:gd name="connsiteX105" fmla="*/ 2927245 w 8363529"/>
                <a:gd name="connsiteY105" fmla="*/ 397969 h 1421726"/>
                <a:gd name="connsiteX106" fmla="*/ 2935608 w 8363529"/>
                <a:gd name="connsiteY106" fmla="*/ 437097 h 1421726"/>
                <a:gd name="connsiteX107" fmla="*/ 3002531 w 8363529"/>
                <a:gd name="connsiteY107" fmla="*/ 737270 h 1421726"/>
                <a:gd name="connsiteX108" fmla="*/ 3010884 w 8363529"/>
                <a:gd name="connsiteY108" fmla="*/ 773262 h 1421726"/>
                <a:gd name="connsiteX109" fmla="*/ 3019238 w 8363529"/>
                <a:gd name="connsiteY109" fmla="*/ 760671 h 1421726"/>
                <a:gd name="connsiteX110" fmla="*/ 3086161 w 8363529"/>
                <a:gd name="connsiteY110" fmla="*/ 633154 h 1421726"/>
                <a:gd name="connsiteX111" fmla="*/ 3094523 w 8363529"/>
                <a:gd name="connsiteY111" fmla="*/ 612849 h 1421726"/>
                <a:gd name="connsiteX112" fmla="*/ 3102877 w 8363529"/>
                <a:gd name="connsiteY112" fmla="*/ 610169 h 1421726"/>
                <a:gd name="connsiteX113" fmla="*/ 3169800 w 8363529"/>
                <a:gd name="connsiteY113" fmla="*/ 594935 h 1421726"/>
                <a:gd name="connsiteX114" fmla="*/ 3178153 w 8363529"/>
                <a:gd name="connsiteY114" fmla="*/ 593571 h 1421726"/>
                <a:gd name="connsiteX115" fmla="*/ 3186516 w 8363529"/>
                <a:gd name="connsiteY115" fmla="*/ 626689 h 1421726"/>
                <a:gd name="connsiteX116" fmla="*/ 3253439 w 8363529"/>
                <a:gd name="connsiteY116" fmla="*/ 957976 h 1421726"/>
                <a:gd name="connsiteX117" fmla="*/ 3261792 w 8363529"/>
                <a:gd name="connsiteY117" fmla="*/ 1010063 h 1421726"/>
                <a:gd name="connsiteX118" fmla="*/ 3270146 w 8363529"/>
                <a:gd name="connsiteY118" fmla="*/ 1014525 h 1421726"/>
                <a:gd name="connsiteX119" fmla="*/ 3337069 w 8363529"/>
                <a:gd name="connsiteY119" fmla="*/ 1090555 h 1421726"/>
                <a:gd name="connsiteX120" fmla="*/ 3345432 w 8363529"/>
                <a:gd name="connsiteY120" fmla="*/ 1112292 h 1421726"/>
                <a:gd name="connsiteX121" fmla="*/ 3353785 w 8363529"/>
                <a:gd name="connsiteY121" fmla="*/ 873332 h 1421726"/>
                <a:gd name="connsiteX122" fmla="*/ 3420708 w 8363529"/>
                <a:gd name="connsiteY122" fmla="*/ 172733 h 1421726"/>
                <a:gd name="connsiteX123" fmla="*/ 3429061 w 8363529"/>
                <a:gd name="connsiteY123" fmla="*/ 137002 h 1421726"/>
                <a:gd name="connsiteX124" fmla="*/ 3437424 w 8363529"/>
                <a:gd name="connsiteY124" fmla="*/ 187018 h 1421726"/>
                <a:gd name="connsiteX125" fmla="*/ 3504347 w 8363529"/>
                <a:gd name="connsiteY125" fmla="*/ 645551 h 1421726"/>
                <a:gd name="connsiteX126" fmla="*/ 3512701 w 8363529"/>
                <a:gd name="connsiteY126" fmla="*/ 711371 h 1421726"/>
                <a:gd name="connsiteX127" fmla="*/ 3521054 w 8363529"/>
                <a:gd name="connsiteY127" fmla="*/ 663097 h 1421726"/>
                <a:gd name="connsiteX128" fmla="*/ 3587977 w 8363529"/>
                <a:gd name="connsiteY128" fmla="*/ 328452 h 1421726"/>
                <a:gd name="connsiteX129" fmla="*/ 3596330 w 8363529"/>
                <a:gd name="connsiteY129" fmla="*/ 292121 h 1421726"/>
                <a:gd name="connsiteX130" fmla="*/ 3604693 w 8363529"/>
                <a:gd name="connsiteY130" fmla="*/ 313596 h 1421726"/>
                <a:gd name="connsiteX131" fmla="*/ 3671616 w 8363529"/>
                <a:gd name="connsiteY131" fmla="*/ 540990 h 1421726"/>
                <a:gd name="connsiteX132" fmla="*/ 3679970 w 8363529"/>
                <a:gd name="connsiteY132" fmla="*/ 578909 h 1421726"/>
                <a:gd name="connsiteX133" fmla="*/ 3688323 w 8363529"/>
                <a:gd name="connsiteY133" fmla="*/ 618453 h 1421726"/>
                <a:gd name="connsiteX134" fmla="*/ 3755246 w 8363529"/>
                <a:gd name="connsiteY134" fmla="*/ 895863 h 1421726"/>
                <a:gd name="connsiteX135" fmla="*/ 3763609 w 8363529"/>
                <a:gd name="connsiteY135" fmla="*/ 926291 h 1421726"/>
                <a:gd name="connsiteX136" fmla="*/ 3771962 w 8363529"/>
                <a:gd name="connsiteY136" fmla="*/ 929504 h 1421726"/>
                <a:gd name="connsiteX137" fmla="*/ 3838885 w 8363529"/>
                <a:gd name="connsiteY137" fmla="*/ 957560 h 1421726"/>
                <a:gd name="connsiteX138" fmla="*/ 3847239 w 8363529"/>
                <a:gd name="connsiteY138" fmla="*/ 961373 h 1421726"/>
                <a:gd name="connsiteX139" fmla="*/ 3855602 w 8363529"/>
                <a:gd name="connsiteY139" fmla="*/ 989198 h 1421726"/>
                <a:gd name="connsiteX140" fmla="*/ 3922525 w 8363529"/>
                <a:gd name="connsiteY140" fmla="*/ 1189261 h 1421726"/>
                <a:gd name="connsiteX141" fmla="*/ 3930878 w 8363529"/>
                <a:gd name="connsiteY141" fmla="*/ 1211753 h 1421726"/>
                <a:gd name="connsiteX142" fmla="*/ 3939231 w 8363529"/>
                <a:gd name="connsiteY142" fmla="*/ 1174328 h 1421726"/>
                <a:gd name="connsiteX143" fmla="*/ 4006154 w 8363529"/>
                <a:gd name="connsiteY143" fmla="*/ 910796 h 1421726"/>
                <a:gd name="connsiteX144" fmla="*/ 4014517 w 8363529"/>
                <a:gd name="connsiteY144" fmla="*/ 881762 h 1421726"/>
                <a:gd name="connsiteX145" fmla="*/ 4022871 w 8363529"/>
                <a:gd name="connsiteY145" fmla="*/ 902434 h 1421726"/>
                <a:gd name="connsiteX146" fmla="*/ 4089755 w 8363529"/>
                <a:gd name="connsiteY146" fmla="*/ 1151798 h 1421726"/>
                <a:gd name="connsiteX147" fmla="*/ 4098147 w 8363529"/>
                <a:gd name="connsiteY147" fmla="*/ 1199655 h 1421726"/>
                <a:gd name="connsiteX148" fmla="*/ 4106500 w 8363529"/>
                <a:gd name="connsiteY148" fmla="*/ 1060350 h 1421726"/>
                <a:gd name="connsiteX149" fmla="*/ 4173394 w 8363529"/>
                <a:gd name="connsiteY149" fmla="*/ 347430 h 1421726"/>
                <a:gd name="connsiteX150" fmla="*/ 4181787 w 8363529"/>
                <a:gd name="connsiteY150" fmla="*/ 289169 h 1421726"/>
                <a:gd name="connsiteX151" fmla="*/ 4190140 w 8363529"/>
                <a:gd name="connsiteY151" fmla="*/ 352308 h 1421726"/>
                <a:gd name="connsiteX152" fmla="*/ 4257024 w 8363529"/>
                <a:gd name="connsiteY152" fmla="*/ 982549 h 1421726"/>
                <a:gd name="connsiteX153" fmla="*/ 4265416 w 8363529"/>
                <a:gd name="connsiteY153" fmla="*/ 1081439 h 1421726"/>
                <a:gd name="connsiteX154" fmla="*/ 4273779 w 8363529"/>
                <a:gd name="connsiteY154" fmla="*/ 965651 h 1421726"/>
                <a:gd name="connsiteX155" fmla="*/ 4340664 w 8363529"/>
                <a:gd name="connsiteY155" fmla="*/ 110387 h 1421726"/>
                <a:gd name="connsiteX156" fmla="*/ 4349055 w 8363529"/>
                <a:gd name="connsiteY156" fmla="*/ 11604 h 1421726"/>
                <a:gd name="connsiteX157" fmla="*/ 4357409 w 8363529"/>
                <a:gd name="connsiteY157" fmla="*/ 90809 h 1421726"/>
                <a:gd name="connsiteX158" fmla="*/ 4424303 w 8363529"/>
                <a:gd name="connsiteY158" fmla="*/ 719085 h 1421726"/>
                <a:gd name="connsiteX159" fmla="*/ 4432695 w 8363529"/>
                <a:gd name="connsiteY159" fmla="*/ 796964 h 1421726"/>
                <a:gd name="connsiteX160" fmla="*/ 4441048 w 8363529"/>
                <a:gd name="connsiteY160" fmla="*/ 826598 h 1421726"/>
                <a:gd name="connsiteX161" fmla="*/ 4507932 w 8363529"/>
                <a:gd name="connsiteY161" fmla="*/ 1077016 h 1421726"/>
                <a:gd name="connsiteX162" fmla="*/ 4516324 w 8363529"/>
                <a:gd name="connsiteY162" fmla="*/ 1110095 h 1421726"/>
                <a:gd name="connsiteX163" fmla="*/ 4524687 w 8363529"/>
                <a:gd name="connsiteY163" fmla="*/ 1111305 h 1421726"/>
                <a:gd name="connsiteX164" fmla="*/ 4591572 w 8363529"/>
                <a:gd name="connsiteY164" fmla="*/ 1121893 h 1421726"/>
                <a:gd name="connsiteX165" fmla="*/ 4599964 w 8363529"/>
                <a:gd name="connsiteY165" fmla="*/ 1123402 h 1421726"/>
                <a:gd name="connsiteX166" fmla="*/ 4608317 w 8363529"/>
                <a:gd name="connsiteY166" fmla="*/ 1066506 h 1421726"/>
                <a:gd name="connsiteX167" fmla="*/ 4675201 w 8363529"/>
                <a:gd name="connsiteY167" fmla="*/ 621550 h 1421726"/>
                <a:gd name="connsiteX168" fmla="*/ 4683603 w 8363529"/>
                <a:gd name="connsiteY168" fmla="*/ 567150 h 1421726"/>
                <a:gd name="connsiteX169" fmla="*/ 4691956 w 8363529"/>
                <a:gd name="connsiteY169" fmla="*/ 561024 h 1421726"/>
                <a:gd name="connsiteX170" fmla="*/ 4758840 w 8363529"/>
                <a:gd name="connsiteY170" fmla="*/ 517511 h 1421726"/>
                <a:gd name="connsiteX171" fmla="*/ 4767232 w 8363529"/>
                <a:gd name="connsiteY171" fmla="*/ 512634 h 1421726"/>
                <a:gd name="connsiteX172" fmla="*/ 4775595 w 8363529"/>
                <a:gd name="connsiteY172" fmla="*/ 536945 h 1421726"/>
                <a:gd name="connsiteX173" fmla="*/ 4842480 w 8363529"/>
                <a:gd name="connsiteY173" fmla="*/ 791447 h 1421726"/>
                <a:gd name="connsiteX174" fmla="*/ 4850872 w 8363529"/>
                <a:gd name="connsiteY174" fmla="*/ 833440 h 1421726"/>
                <a:gd name="connsiteX175" fmla="*/ 4859225 w 8363529"/>
                <a:gd name="connsiteY175" fmla="*/ 874765 h 1421726"/>
                <a:gd name="connsiteX176" fmla="*/ 4926109 w 8363529"/>
                <a:gd name="connsiteY176" fmla="*/ 1090855 h 1421726"/>
                <a:gd name="connsiteX177" fmla="*/ 4934501 w 8363529"/>
                <a:gd name="connsiteY177" fmla="*/ 1108885 h 1421726"/>
                <a:gd name="connsiteX178" fmla="*/ 4942864 w 8363529"/>
                <a:gd name="connsiteY178" fmla="*/ 1105604 h 1421726"/>
                <a:gd name="connsiteX179" fmla="*/ 5009749 w 8363529"/>
                <a:gd name="connsiteY179" fmla="*/ 1076222 h 1421726"/>
                <a:gd name="connsiteX180" fmla="*/ 5018141 w 8363529"/>
                <a:gd name="connsiteY180" fmla="*/ 1072070 h 1421726"/>
                <a:gd name="connsiteX181" fmla="*/ 5026494 w 8363529"/>
                <a:gd name="connsiteY181" fmla="*/ 1042126 h 1421726"/>
                <a:gd name="connsiteX182" fmla="*/ 5093388 w 8363529"/>
                <a:gd name="connsiteY182" fmla="*/ 757458 h 1421726"/>
                <a:gd name="connsiteX183" fmla="*/ 5101780 w 8363529"/>
                <a:gd name="connsiteY183" fmla="*/ 715039 h 1421726"/>
                <a:gd name="connsiteX184" fmla="*/ 5110134 w 8363529"/>
                <a:gd name="connsiteY184" fmla="*/ 715572 h 1421726"/>
                <a:gd name="connsiteX185" fmla="*/ 5177018 w 8363529"/>
                <a:gd name="connsiteY185" fmla="*/ 718591 h 1421726"/>
                <a:gd name="connsiteX186" fmla="*/ 5185410 w 8363529"/>
                <a:gd name="connsiteY186" fmla="*/ 718862 h 1421726"/>
                <a:gd name="connsiteX187" fmla="*/ 5193773 w 8363529"/>
                <a:gd name="connsiteY187" fmla="*/ 735528 h 1421726"/>
                <a:gd name="connsiteX188" fmla="*/ 5260657 w 8363529"/>
                <a:gd name="connsiteY188" fmla="*/ 880475 h 1421726"/>
                <a:gd name="connsiteX189" fmla="*/ 5269049 w 8363529"/>
                <a:gd name="connsiteY189" fmla="*/ 900170 h 1421726"/>
                <a:gd name="connsiteX190" fmla="*/ 5277403 w 8363529"/>
                <a:gd name="connsiteY190" fmla="*/ 881569 h 1421726"/>
                <a:gd name="connsiteX191" fmla="*/ 5344287 w 8363529"/>
                <a:gd name="connsiteY191" fmla="*/ 709484 h 1421726"/>
                <a:gd name="connsiteX192" fmla="*/ 5352650 w 8363529"/>
                <a:gd name="connsiteY192" fmla="*/ 684573 h 1421726"/>
                <a:gd name="connsiteX193" fmla="*/ 5361042 w 8363529"/>
                <a:gd name="connsiteY193" fmla="*/ 702526 h 1421726"/>
                <a:gd name="connsiteX194" fmla="*/ 5427926 w 8363529"/>
                <a:gd name="connsiteY194" fmla="*/ 1057437 h 1421726"/>
                <a:gd name="connsiteX195" fmla="*/ 5436280 w 8363529"/>
                <a:gd name="connsiteY195" fmla="*/ 1179699 h 1421726"/>
                <a:gd name="connsiteX196" fmla="*/ 5444672 w 8363529"/>
                <a:gd name="connsiteY196" fmla="*/ 1198107 h 1421726"/>
                <a:gd name="connsiteX197" fmla="*/ 5511566 w 8363529"/>
                <a:gd name="connsiteY197" fmla="*/ 1258856 h 1421726"/>
                <a:gd name="connsiteX198" fmla="*/ 5519919 w 8363529"/>
                <a:gd name="connsiteY198" fmla="*/ 1262262 h 1421726"/>
                <a:gd name="connsiteX199" fmla="*/ 5528311 w 8363529"/>
                <a:gd name="connsiteY199" fmla="*/ 1174560 h 1421726"/>
                <a:gd name="connsiteX200" fmla="*/ 5595195 w 8363529"/>
                <a:gd name="connsiteY200" fmla="*/ 688725 h 1421726"/>
                <a:gd name="connsiteX201" fmla="*/ 5603558 w 8363529"/>
                <a:gd name="connsiteY201" fmla="*/ 646045 h 1421726"/>
                <a:gd name="connsiteX202" fmla="*/ 5611950 w 8363529"/>
                <a:gd name="connsiteY202" fmla="*/ 597539 h 1421726"/>
                <a:gd name="connsiteX203" fmla="*/ 5678835 w 8363529"/>
                <a:gd name="connsiteY203" fmla="*/ 211406 h 1421726"/>
                <a:gd name="connsiteX204" fmla="*/ 5687188 w 8363529"/>
                <a:gd name="connsiteY204" fmla="*/ 163355 h 1421726"/>
                <a:gd name="connsiteX205" fmla="*/ 5695580 w 8363529"/>
                <a:gd name="connsiteY205" fmla="*/ 227394 h 1421726"/>
                <a:gd name="connsiteX206" fmla="*/ 5762474 w 8363529"/>
                <a:gd name="connsiteY206" fmla="*/ 954454 h 1421726"/>
                <a:gd name="connsiteX207" fmla="*/ 5770827 w 8363529"/>
                <a:gd name="connsiteY207" fmla="*/ 1085300 h 1421726"/>
                <a:gd name="connsiteX208" fmla="*/ 5779219 w 8363529"/>
                <a:gd name="connsiteY208" fmla="*/ 1061667 h 1421726"/>
                <a:gd name="connsiteX209" fmla="*/ 5846103 w 8363529"/>
                <a:gd name="connsiteY209" fmla="*/ 923871 h 1421726"/>
                <a:gd name="connsiteX210" fmla="*/ 5854457 w 8363529"/>
                <a:gd name="connsiteY210" fmla="*/ 911173 h 1421726"/>
                <a:gd name="connsiteX211" fmla="*/ 5862858 w 8363529"/>
                <a:gd name="connsiteY211" fmla="*/ 925120 h 1421726"/>
                <a:gd name="connsiteX212" fmla="*/ 5929743 w 8363529"/>
                <a:gd name="connsiteY212" fmla="*/ 1107414 h 1421726"/>
                <a:gd name="connsiteX213" fmla="*/ 5938096 w 8363529"/>
                <a:gd name="connsiteY213" fmla="*/ 1145633 h 1421726"/>
                <a:gd name="connsiteX214" fmla="*/ 5946488 w 8363529"/>
                <a:gd name="connsiteY214" fmla="*/ 1136826 h 1421726"/>
                <a:gd name="connsiteX215" fmla="*/ 6013372 w 8363529"/>
                <a:gd name="connsiteY215" fmla="*/ 1092520 h 1421726"/>
                <a:gd name="connsiteX216" fmla="*/ 6021735 w 8363529"/>
                <a:gd name="connsiteY216" fmla="*/ 1088968 h 1421726"/>
                <a:gd name="connsiteX217" fmla="*/ 6030127 w 8363529"/>
                <a:gd name="connsiteY217" fmla="*/ 1080839 h 1421726"/>
                <a:gd name="connsiteX218" fmla="*/ 6097011 w 8363529"/>
                <a:gd name="connsiteY218" fmla="*/ 1007199 h 1421726"/>
                <a:gd name="connsiteX219" fmla="*/ 6105365 w 8363529"/>
                <a:gd name="connsiteY219" fmla="*/ 996756 h 1421726"/>
                <a:gd name="connsiteX220" fmla="*/ 6113767 w 8363529"/>
                <a:gd name="connsiteY220" fmla="*/ 991849 h 1421726"/>
                <a:gd name="connsiteX221" fmla="*/ 6180651 w 8363529"/>
                <a:gd name="connsiteY221" fmla="*/ 958044 h 1421726"/>
                <a:gd name="connsiteX222" fmla="*/ 6189004 w 8363529"/>
                <a:gd name="connsiteY222" fmla="*/ 954386 h 1421726"/>
                <a:gd name="connsiteX223" fmla="*/ 6197396 w 8363529"/>
                <a:gd name="connsiteY223" fmla="*/ 969842 h 1421726"/>
                <a:gd name="connsiteX224" fmla="*/ 6264280 w 8363529"/>
                <a:gd name="connsiteY224" fmla="*/ 1127303 h 1421726"/>
                <a:gd name="connsiteX225" fmla="*/ 6272644 w 8363529"/>
                <a:gd name="connsiteY225" fmla="*/ 1152552 h 1421726"/>
                <a:gd name="connsiteX226" fmla="*/ 6281036 w 8363529"/>
                <a:gd name="connsiteY226" fmla="*/ 1134484 h 1421726"/>
                <a:gd name="connsiteX227" fmla="*/ 6347920 w 8363529"/>
                <a:gd name="connsiteY227" fmla="*/ 1011689 h 1421726"/>
                <a:gd name="connsiteX228" fmla="*/ 6356273 w 8363529"/>
                <a:gd name="connsiteY228" fmla="*/ 998614 h 1421726"/>
                <a:gd name="connsiteX229" fmla="*/ 6364665 w 8363529"/>
                <a:gd name="connsiteY229" fmla="*/ 1010141 h 1421726"/>
                <a:gd name="connsiteX230" fmla="*/ 6431560 w 8363529"/>
                <a:gd name="connsiteY230" fmla="*/ 1094446 h 1421726"/>
                <a:gd name="connsiteX231" fmla="*/ 6439913 w 8363529"/>
                <a:gd name="connsiteY231" fmla="*/ 1104124 h 1421726"/>
                <a:gd name="connsiteX232" fmla="*/ 6448305 w 8363529"/>
                <a:gd name="connsiteY232" fmla="*/ 1099440 h 1421726"/>
                <a:gd name="connsiteX233" fmla="*/ 6515189 w 8363529"/>
                <a:gd name="connsiteY233" fmla="*/ 1057398 h 1421726"/>
                <a:gd name="connsiteX234" fmla="*/ 6523542 w 8363529"/>
                <a:gd name="connsiteY234" fmla="*/ 1051466 h 1421726"/>
                <a:gd name="connsiteX235" fmla="*/ 6531944 w 8363529"/>
                <a:gd name="connsiteY235" fmla="*/ 1038652 h 1421726"/>
                <a:gd name="connsiteX236" fmla="*/ 6598829 w 8363529"/>
                <a:gd name="connsiteY236" fmla="*/ 924142 h 1421726"/>
                <a:gd name="connsiteX237" fmla="*/ 6607182 w 8363529"/>
                <a:gd name="connsiteY237" fmla="*/ 908106 h 1421726"/>
                <a:gd name="connsiteX238" fmla="*/ 6615535 w 8363529"/>
                <a:gd name="connsiteY238" fmla="*/ 924703 h 1421726"/>
                <a:gd name="connsiteX239" fmla="*/ 6682458 w 8363529"/>
                <a:gd name="connsiteY239" fmla="*/ 1017215 h 1421726"/>
                <a:gd name="connsiteX240" fmla="*/ 6690821 w 8363529"/>
                <a:gd name="connsiteY240" fmla="*/ 1025413 h 1421726"/>
                <a:gd name="connsiteX241" fmla="*/ 6699174 w 8363529"/>
                <a:gd name="connsiteY241" fmla="*/ 1003676 h 1421726"/>
                <a:gd name="connsiteX242" fmla="*/ 6766097 w 8363529"/>
                <a:gd name="connsiteY242" fmla="*/ 785998 h 1421726"/>
                <a:gd name="connsiteX243" fmla="*/ 6774451 w 8363529"/>
                <a:gd name="connsiteY243" fmla="*/ 751748 h 1421726"/>
                <a:gd name="connsiteX244" fmla="*/ 6782814 w 8363529"/>
                <a:gd name="connsiteY244" fmla="*/ 770804 h 1421726"/>
                <a:gd name="connsiteX245" fmla="*/ 6849737 w 8363529"/>
                <a:gd name="connsiteY245" fmla="*/ 948105 h 1421726"/>
                <a:gd name="connsiteX246" fmla="*/ 6858090 w 8363529"/>
                <a:gd name="connsiteY246" fmla="*/ 973926 h 1421726"/>
                <a:gd name="connsiteX247" fmla="*/ 6866443 w 8363529"/>
                <a:gd name="connsiteY247" fmla="*/ 925991 h 1421726"/>
                <a:gd name="connsiteX248" fmla="*/ 6933366 w 8363529"/>
                <a:gd name="connsiteY248" fmla="*/ 667675 h 1421726"/>
                <a:gd name="connsiteX249" fmla="*/ 6941729 w 8363529"/>
                <a:gd name="connsiteY249" fmla="*/ 645551 h 1421726"/>
                <a:gd name="connsiteX250" fmla="*/ 6950083 w 8363529"/>
                <a:gd name="connsiteY250" fmla="*/ 694474 h 1421726"/>
                <a:gd name="connsiteX251" fmla="*/ 7017006 w 8363529"/>
                <a:gd name="connsiteY251" fmla="*/ 1171076 h 1421726"/>
                <a:gd name="connsiteX252" fmla="*/ 7025359 w 8363529"/>
                <a:gd name="connsiteY252" fmla="*/ 1243932 h 1421726"/>
                <a:gd name="connsiteX253" fmla="*/ 7033712 w 8363529"/>
                <a:gd name="connsiteY253" fmla="*/ 1172063 h 1421726"/>
                <a:gd name="connsiteX254" fmla="*/ 7100645 w 8363529"/>
                <a:gd name="connsiteY254" fmla="*/ 557356 h 1421726"/>
                <a:gd name="connsiteX255" fmla="*/ 7108998 w 8363529"/>
                <a:gd name="connsiteY255" fmla="*/ 475170 h 1421726"/>
                <a:gd name="connsiteX256" fmla="*/ 7117351 w 8363529"/>
                <a:gd name="connsiteY256" fmla="*/ 553233 h 1421726"/>
                <a:gd name="connsiteX257" fmla="*/ 7184274 w 8363529"/>
                <a:gd name="connsiteY257" fmla="*/ 1202907 h 1421726"/>
                <a:gd name="connsiteX258" fmla="*/ 7192628 w 8363529"/>
                <a:gd name="connsiteY258" fmla="*/ 1287406 h 1421726"/>
                <a:gd name="connsiteX259" fmla="*/ 7200991 w 8363529"/>
                <a:gd name="connsiteY259" fmla="*/ 1252546 h 1421726"/>
                <a:gd name="connsiteX260" fmla="*/ 7267914 w 8363529"/>
                <a:gd name="connsiteY260" fmla="*/ 994608 h 1421726"/>
                <a:gd name="connsiteX261" fmla="*/ 7276267 w 8363529"/>
                <a:gd name="connsiteY261" fmla="*/ 964780 h 1421726"/>
                <a:gd name="connsiteX262" fmla="*/ 7284620 w 8363529"/>
                <a:gd name="connsiteY262" fmla="*/ 925352 h 1421726"/>
                <a:gd name="connsiteX263" fmla="*/ 7351543 w 8363529"/>
                <a:gd name="connsiteY263" fmla="*/ 591645 h 1421726"/>
                <a:gd name="connsiteX264" fmla="*/ 7359906 w 8363529"/>
                <a:gd name="connsiteY264" fmla="*/ 547523 h 1421726"/>
                <a:gd name="connsiteX265" fmla="*/ 7368260 w 8363529"/>
                <a:gd name="connsiteY265" fmla="*/ 528099 h 1421726"/>
                <a:gd name="connsiteX266" fmla="*/ 7435183 w 8363529"/>
                <a:gd name="connsiteY266" fmla="*/ 398501 h 1421726"/>
                <a:gd name="connsiteX267" fmla="*/ 7443536 w 8363529"/>
                <a:gd name="connsiteY267" fmla="*/ 384932 h 1421726"/>
                <a:gd name="connsiteX268" fmla="*/ 7451899 w 8363529"/>
                <a:gd name="connsiteY268" fmla="*/ 415776 h 1421726"/>
                <a:gd name="connsiteX269" fmla="*/ 7518822 w 8363529"/>
                <a:gd name="connsiteY269" fmla="*/ 712397 h 1421726"/>
                <a:gd name="connsiteX270" fmla="*/ 7527175 w 8363529"/>
                <a:gd name="connsiteY270" fmla="*/ 757158 h 1421726"/>
                <a:gd name="connsiteX271" fmla="*/ 7535528 w 8363529"/>
                <a:gd name="connsiteY271" fmla="*/ 673985 h 1421726"/>
                <a:gd name="connsiteX272" fmla="*/ 7602452 w 8363529"/>
                <a:gd name="connsiteY272" fmla="*/ 116291 h 1421726"/>
                <a:gd name="connsiteX273" fmla="*/ 7610815 w 8363529"/>
                <a:gd name="connsiteY273" fmla="*/ 57652 h 1421726"/>
                <a:gd name="connsiteX274" fmla="*/ 7619168 w 8363529"/>
                <a:gd name="connsiteY274" fmla="*/ 146757 h 1421726"/>
                <a:gd name="connsiteX275" fmla="*/ 7686091 w 8363529"/>
                <a:gd name="connsiteY275" fmla="*/ 920058 h 1421726"/>
                <a:gd name="connsiteX276" fmla="*/ 7694444 w 8363529"/>
                <a:gd name="connsiteY276" fmla="*/ 1025035 h 1421726"/>
                <a:gd name="connsiteX277" fmla="*/ 7702798 w 8363529"/>
                <a:gd name="connsiteY277" fmla="*/ 957599 h 1421726"/>
                <a:gd name="connsiteX278" fmla="*/ 7769731 w 8363529"/>
                <a:gd name="connsiteY278" fmla="*/ 292537 h 1421726"/>
                <a:gd name="connsiteX279" fmla="*/ 7778084 w 8363529"/>
                <a:gd name="connsiteY279" fmla="*/ 189553 h 1421726"/>
                <a:gd name="connsiteX280" fmla="*/ 7786437 w 8363529"/>
                <a:gd name="connsiteY280" fmla="*/ 303154 h 1421726"/>
                <a:gd name="connsiteX281" fmla="*/ 7853360 w 8363529"/>
                <a:gd name="connsiteY281" fmla="*/ 858429 h 1421726"/>
                <a:gd name="connsiteX282" fmla="*/ 7861713 w 8363529"/>
                <a:gd name="connsiteY282" fmla="*/ 901980 h 1421726"/>
                <a:gd name="connsiteX283" fmla="*/ 7870077 w 8363529"/>
                <a:gd name="connsiteY283" fmla="*/ 884065 h 1421726"/>
                <a:gd name="connsiteX284" fmla="*/ 7937000 w 8363529"/>
                <a:gd name="connsiteY284" fmla="*/ 683431 h 1421726"/>
                <a:gd name="connsiteX285" fmla="*/ 7945353 w 8363529"/>
                <a:gd name="connsiteY285" fmla="*/ 647826 h 1421726"/>
                <a:gd name="connsiteX286" fmla="*/ 7953706 w 8363529"/>
                <a:gd name="connsiteY286" fmla="*/ 684496 h 1421726"/>
                <a:gd name="connsiteX287" fmla="*/ 8020629 w 8363529"/>
                <a:gd name="connsiteY287" fmla="*/ 964248 h 1421726"/>
                <a:gd name="connsiteX288" fmla="*/ 8028992 w 8363529"/>
                <a:gd name="connsiteY288" fmla="*/ 997588 h 1421726"/>
                <a:gd name="connsiteX289" fmla="*/ 8037346 w 8363529"/>
                <a:gd name="connsiteY289" fmla="*/ 997966 h 1421726"/>
                <a:gd name="connsiteX290" fmla="*/ 8104268 w 8363529"/>
                <a:gd name="connsiteY290" fmla="*/ 1001372 h 1421726"/>
                <a:gd name="connsiteX291" fmla="*/ 8112622 w 8363529"/>
                <a:gd name="connsiteY291" fmla="*/ 1001866 h 1421726"/>
                <a:gd name="connsiteX292" fmla="*/ 8120985 w 8363529"/>
                <a:gd name="connsiteY292" fmla="*/ 1017022 h 1421726"/>
                <a:gd name="connsiteX293" fmla="*/ 8187908 w 8363529"/>
                <a:gd name="connsiteY293" fmla="*/ 1097243 h 1421726"/>
                <a:gd name="connsiteX294" fmla="*/ 8196261 w 8363529"/>
                <a:gd name="connsiteY294" fmla="*/ 1104008 h 1421726"/>
                <a:gd name="connsiteX295" fmla="*/ 8204614 w 8363529"/>
                <a:gd name="connsiteY295" fmla="*/ 1019896 h 1421726"/>
                <a:gd name="connsiteX296" fmla="*/ 8271537 w 8363529"/>
                <a:gd name="connsiteY296" fmla="*/ 143776 h 1421726"/>
                <a:gd name="connsiteX297" fmla="*/ 8279900 w 8363529"/>
                <a:gd name="connsiteY297" fmla="*/ 0 h 1421726"/>
                <a:gd name="connsiteX298" fmla="*/ 8288254 w 8363529"/>
                <a:gd name="connsiteY298" fmla="*/ 84082 h 1421726"/>
                <a:gd name="connsiteX299" fmla="*/ 8355177 w 8363529"/>
                <a:gd name="connsiteY299" fmla="*/ 763507 h 1421726"/>
                <a:gd name="connsiteX300" fmla="*/ 8363530 w 8363529"/>
                <a:gd name="connsiteY300" fmla="*/ 849283 h 1421726"/>
                <a:gd name="connsiteX301" fmla="*/ 8363530 w 8363529"/>
                <a:gd name="connsiteY301" fmla="*/ 1278628 h 1421726"/>
                <a:gd name="connsiteX302" fmla="*/ 8355177 w 8363529"/>
                <a:gd name="connsiteY302" fmla="*/ 1182119 h 1421726"/>
                <a:gd name="connsiteX303" fmla="*/ 8288254 w 8363529"/>
                <a:gd name="connsiteY303" fmla="*/ 417818 h 1421726"/>
                <a:gd name="connsiteX304" fmla="*/ 8279900 w 8363529"/>
                <a:gd name="connsiteY304" fmla="*/ 323235 h 1421726"/>
                <a:gd name="connsiteX305" fmla="*/ 8271537 w 8363529"/>
                <a:gd name="connsiteY305" fmla="*/ 435132 h 1421726"/>
                <a:gd name="connsiteX306" fmla="*/ 8204614 w 8363529"/>
                <a:gd name="connsiteY306" fmla="*/ 1117170 h 1421726"/>
                <a:gd name="connsiteX307" fmla="*/ 8196261 w 8363529"/>
                <a:gd name="connsiteY307" fmla="*/ 1182641 h 1421726"/>
                <a:gd name="connsiteX308" fmla="*/ 8187908 w 8363529"/>
                <a:gd name="connsiteY308" fmla="*/ 1198446 h 1421726"/>
                <a:gd name="connsiteX309" fmla="*/ 8120985 w 8363529"/>
                <a:gd name="connsiteY309" fmla="*/ 1386266 h 1421726"/>
                <a:gd name="connsiteX310" fmla="*/ 8112622 w 8363529"/>
                <a:gd name="connsiteY310" fmla="*/ 1421726 h 1421726"/>
                <a:gd name="connsiteX311" fmla="*/ 8104268 w 8363529"/>
                <a:gd name="connsiteY311" fmla="*/ 1384902 h 1421726"/>
                <a:gd name="connsiteX312" fmla="*/ 8037346 w 8363529"/>
                <a:gd name="connsiteY312" fmla="*/ 1128435 h 1421726"/>
                <a:gd name="connsiteX313" fmla="*/ 8028992 w 8363529"/>
                <a:gd name="connsiteY313" fmla="*/ 1100456 h 1421726"/>
                <a:gd name="connsiteX314" fmla="*/ 8020629 w 8363529"/>
                <a:gd name="connsiteY314" fmla="*/ 1064318 h 1421726"/>
                <a:gd name="connsiteX315" fmla="*/ 7953706 w 8363529"/>
                <a:gd name="connsiteY315" fmla="*/ 761349 h 1421726"/>
                <a:gd name="connsiteX316" fmla="*/ 7945353 w 8363529"/>
                <a:gd name="connsiteY316" fmla="*/ 721659 h 1421726"/>
                <a:gd name="connsiteX317" fmla="*/ 7937000 w 8363529"/>
                <a:gd name="connsiteY317" fmla="*/ 769517 h 1421726"/>
                <a:gd name="connsiteX318" fmla="*/ 7870077 w 8363529"/>
                <a:gd name="connsiteY318" fmla="*/ 1039330 h 1421726"/>
                <a:gd name="connsiteX319" fmla="*/ 7861713 w 8363529"/>
                <a:gd name="connsiteY319" fmla="*/ 1063408 h 1421726"/>
                <a:gd name="connsiteX320" fmla="*/ 7853360 w 8363529"/>
                <a:gd name="connsiteY320" fmla="*/ 1019557 h 1421726"/>
                <a:gd name="connsiteX321" fmla="*/ 7786437 w 8363529"/>
                <a:gd name="connsiteY321" fmla="*/ 460237 h 1421726"/>
                <a:gd name="connsiteX322" fmla="*/ 7778084 w 8363529"/>
                <a:gd name="connsiteY322" fmla="*/ 345804 h 1421726"/>
                <a:gd name="connsiteX323" fmla="*/ 7769731 w 8363529"/>
                <a:gd name="connsiteY323" fmla="*/ 458872 h 1421726"/>
                <a:gd name="connsiteX324" fmla="*/ 7702798 w 8363529"/>
                <a:gd name="connsiteY324" fmla="*/ 1189038 h 1421726"/>
                <a:gd name="connsiteX325" fmla="*/ 7694444 w 8363529"/>
                <a:gd name="connsiteY325" fmla="*/ 1263095 h 1421726"/>
                <a:gd name="connsiteX326" fmla="*/ 7686091 w 8363529"/>
                <a:gd name="connsiteY326" fmla="*/ 1173796 h 1421726"/>
                <a:gd name="connsiteX327" fmla="*/ 7619168 w 8363529"/>
                <a:gd name="connsiteY327" fmla="*/ 515847 h 1421726"/>
                <a:gd name="connsiteX328" fmla="*/ 7610815 w 8363529"/>
                <a:gd name="connsiteY328" fmla="*/ 440049 h 1421726"/>
                <a:gd name="connsiteX329" fmla="*/ 7602452 w 8363529"/>
                <a:gd name="connsiteY329" fmla="*/ 482313 h 1421726"/>
                <a:gd name="connsiteX330" fmla="*/ 7535528 w 8363529"/>
                <a:gd name="connsiteY330" fmla="*/ 884288 h 1421726"/>
                <a:gd name="connsiteX331" fmla="*/ 7527175 w 8363529"/>
                <a:gd name="connsiteY331" fmla="*/ 944253 h 1421726"/>
                <a:gd name="connsiteX332" fmla="*/ 7518822 w 8363529"/>
                <a:gd name="connsiteY332" fmla="*/ 900247 h 1421726"/>
                <a:gd name="connsiteX333" fmla="*/ 7451899 w 8363529"/>
                <a:gd name="connsiteY333" fmla="*/ 608504 h 1421726"/>
                <a:gd name="connsiteX334" fmla="*/ 7443536 w 8363529"/>
                <a:gd name="connsiteY334" fmla="*/ 578154 h 1421726"/>
                <a:gd name="connsiteX335" fmla="*/ 7435183 w 8363529"/>
                <a:gd name="connsiteY335" fmla="*/ 578115 h 1421726"/>
                <a:gd name="connsiteX336" fmla="*/ 7368260 w 8363529"/>
                <a:gd name="connsiteY336" fmla="*/ 577699 h 1421726"/>
                <a:gd name="connsiteX337" fmla="*/ 7359906 w 8363529"/>
                <a:gd name="connsiteY337" fmla="*/ 577621 h 1421726"/>
                <a:gd name="connsiteX338" fmla="*/ 7351543 w 8363529"/>
                <a:gd name="connsiteY338" fmla="*/ 653119 h 1421726"/>
                <a:gd name="connsiteX339" fmla="*/ 7284620 w 8363529"/>
                <a:gd name="connsiteY339" fmla="*/ 1224121 h 1421726"/>
                <a:gd name="connsiteX340" fmla="*/ 7276267 w 8363529"/>
                <a:gd name="connsiteY340" fmla="*/ 1291596 h 1421726"/>
                <a:gd name="connsiteX341" fmla="*/ 7267914 w 8363529"/>
                <a:gd name="connsiteY341" fmla="*/ 1300442 h 1421726"/>
                <a:gd name="connsiteX342" fmla="*/ 7200991 w 8363529"/>
                <a:gd name="connsiteY342" fmla="*/ 1376734 h 1421726"/>
                <a:gd name="connsiteX343" fmla="*/ 7192628 w 8363529"/>
                <a:gd name="connsiteY343" fmla="*/ 1387060 h 1421726"/>
                <a:gd name="connsiteX344" fmla="*/ 7184274 w 8363529"/>
                <a:gd name="connsiteY344" fmla="*/ 1376772 h 1421726"/>
                <a:gd name="connsiteX345" fmla="*/ 7117351 w 8363529"/>
                <a:gd name="connsiteY345" fmla="*/ 1297955 h 1421726"/>
                <a:gd name="connsiteX346" fmla="*/ 7108998 w 8363529"/>
                <a:gd name="connsiteY346" fmla="*/ 1288461 h 1421726"/>
                <a:gd name="connsiteX347" fmla="*/ 7100645 w 8363529"/>
                <a:gd name="connsiteY347" fmla="*/ 1294809 h 1421726"/>
                <a:gd name="connsiteX348" fmla="*/ 7033712 w 8363529"/>
                <a:gd name="connsiteY348" fmla="*/ 1342260 h 1421726"/>
                <a:gd name="connsiteX349" fmla="*/ 7025359 w 8363529"/>
                <a:gd name="connsiteY349" fmla="*/ 1347777 h 1421726"/>
                <a:gd name="connsiteX350" fmla="*/ 7017006 w 8363529"/>
                <a:gd name="connsiteY350" fmla="*/ 1317533 h 1421726"/>
                <a:gd name="connsiteX351" fmla="*/ 6950083 w 8363529"/>
                <a:gd name="connsiteY351" fmla="*/ 1119589 h 1421726"/>
                <a:gd name="connsiteX352" fmla="*/ 6941729 w 8363529"/>
                <a:gd name="connsiteY352" fmla="*/ 1099246 h 1421726"/>
                <a:gd name="connsiteX353" fmla="*/ 6933366 w 8363529"/>
                <a:gd name="connsiteY353" fmla="*/ 1103746 h 1421726"/>
                <a:gd name="connsiteX354" fmla="*/ 6866443 w 8363529"/>
                <a:gd name="connsiteY354" fmla="*/ 1156027 h 1421726"/>
                <a:gd name="connsiteX355" fmla="*/ 6858090 w 8363529"/>
                <a:gd name="connsiteY355" fmla="*/ 1165744 h 1421726"/>
                <a:gd name="connsiteX356" fmla="*/ 6849737 w 8363529"/>
                <a:gd name="connsiteY356" fmla="*/ 1126015 h 1421726"/>
                <a:gd name="connsiteX357" fmla="*/ 6782814 w 8363529"/>
                <a:gd name="connsiteY357" fmla="*/ 853367 h 1421726"/>
                <a:gd name="connsiteX358" fmla="*/ 6774451 w 8363529"/>
                <a:gd name="connsiteY358" fmla="*/ 824033 h 1421726"/>
                <a:gd name="connsiteX359" fmla="*/ 6766097 w 8363529"/>
                <a:gd name="connsiteY359" fmla="*/ 877184 h 1421726"/>
                <a:gd name="connsiteX360" fmla="*/ 6699174 w 8363529"/>
                <a:gd name="connsiteY360" fmla="*/ 1214588 h 1421726"/>
                <a:gd name="connsiteX361" fmla="*/ 6690821 w 8363529"/>
                <a:gd name="connsiteY361" fmla="*/ 1248239 h 1421726"/>
                <a:gd name="connsiteX362" fmla="*/ 6682458 w 8363529"/>
                <a:gd name="connsiteY362" fmla="*/ 1246419 h 1421726"/>
                <a:gd name="connsiteX363" fmla="*/ 6615535 w 8363529"/>
                <a:gd name="connsiteY363" fmla="*/ 1225854 h 1421726"/>
                <a:gd name="connsiteX364" fmla="*/ 6607182 w 8363529"/>
                <a:gd name="connsiteY364" fmla="*/ 1222156 h 1421726"/>
                <a:gd name="connsiteX365" fmla="*/ 6598829 w 8363529"/>
                <a:gd name="connsiteY365" fmla="*/ 1213456 h 1421726"/>
                <a:gd name="connsiteX366" fmla="*/ 6531944 w 8363529"/>
                <a:gd name="connsiteY366" fmla="*/ 1151043 h 1421726"/>
                <a:gd name="connsiteX367" fmla="*/ 6523542 w 8363529"/>
                <a:gd name="connsiteY367" fmla="*/ 1144046 h 1421726"/>
                <a:gd name="connsiteX368" fmla="*/ 6515189 w 8363529"/>
                <a:gd name="connsiteY368" fmla="*/ 1154788 h 1421726"/>
                <a:gd name="connsiteX369" fmla="*/ 6448305 w 8363529"/>
                <a:gd name="connsiteY369" fmla="*/ 1231070 h 1421726"/>
                <a:gd name="connsiteX370" fmla="*/ 6439913 w 8363529"/>
                <a:gd name="connsiteY370" fmla="*/ 1239538 h 1421726"/>
                <a:gd name="connsiteX371" fmla="*/ 6431560 w 8363529"/>
                <a:gd name="connsiteY371" fmla="*/ 1233306 h 1421726"/>
                <a:gd name="connsiteX372" fmla="*/ 6364665 w 8363529"/>
                <a:gd name="connsiteY372" fmla="*/ 1178983 h 1421726"/>
                <a:gd name="connsiteX373" fmla="*/ 6356273 w 8363529"/>
                <a:gd name="connsiteY373" fmla="*/ 1171570 h 1421726"/>
                <a:gd name="connsiteX374" fmla="*/ 6347920 w 8363529"/>
                <a:gd name="connsiteY374" fmla="*/ 1172518 h 1421726"/>
                <a:gd name="connsiteX375" fmla="*/ 6281036 w 8363529"/>
                <a:gd name="connsiteY375" fmla="*/ 1181509 h 1421726"/>
                <a:gd name="connsiteX376" fmla="*/ 6272644 w 8363529"/>
                <a:gd name="connsiteY376" fmla="*/ 1182874 h 1421726"/>
                <a:gd name="connsiteX377" fmla="*/ 6264280 w 8363529"/>
                <a:gd name="connsiteY377" fmla="*/ 1157391 h 1421726"/>
                <a:gd name="connsiteX378" fmla="*/ 6197396 w 8363529"/>
                <a:gd name="connsiteY378" fmla="*/ 998614 h 1421726"/>
                <a:gd name="connsiteX379" fmla="*/ 6189004 w 8363529"/>
                <a:gd name="connsiteY379" fmla="*/ 983033 h 1421726"/>
                <a:gd name="connsiteX380" fmla="*/ 6180651 w 8363529"/>
                <a:gd name="connsiteY380" fmla="*/ 988481 h 1421726"/>
                <a:gd name="connsiteX381" fmla="*/ 6113767 w 8363529"/>
                <a:gd name="connsiteY381" fmla="*/ 1038613 h 1421726"/>
                <a:gd name="connsiteX382" fmla="*/ 6105365 w 8363529"/>
                <a:gd name="connsiteY382" fmla="*/ 1045911 h 1421726"/>
                <a:gd name="connsiteX383" fmla="*/ 6097011 w 8363529"/>
                <a:gd name="connsiteY383" fmla="*/ 1067831 h 1421726"/>
                <a:gd name="connsiteX384" fmla="*/ 6030127 w 8363529"/>
                <a:gd name="connsiteY384" fmla="*/ 1222418 h 1421726"/>
                <a:gd name="connsiteX385" fmla="*/ 6021735 w 8363529"/>
                <a:gd name="connsiteY385" fmla="*/ 1239470 h 1421726"/>
                <a:gd name="connsiteX386" fmla="*/ 6013372 w 8363529"/>
                <a:gd name="connsiteY386" fmla="*/ 1236180 h 1421726"/>
                <a:gd name="connsiteX387" fmla="*/ 5946488 w 8363529"/>
                <a:gd name="connsiteY387" fmla="*/ 1195126 h 1421726"/>
                <a:gd name="connsiteX388" fmla="*/ 5938096 w 8363529"/>
                <a:gd name="connsiteY388" fmla="*/ 1186996 h 1421726"/>
                <a:gd name="connsiteX389" fmla="*/ 5929743 w 8363529"/>
                <a:gd name="connsiteY389" fmla="*/ 1171115 h 1421726"/>
                <a:gd name="connsiteX390" fmla="*/ 5862858 w 8363529"/>
                <a:gd name="connsiteY390" fmla="*/ 1095317 h 1421726"/>
                <a:gd name="connsiteX391" fmla="*/ 5854457 w 8363529"/>
                <a:gd name="connsiteY391" fmla="*/ 1089529 h 1421726"/>
                <a:gd name="connsiteX392" fmla="*/ 5846103 w 8363529"/>
                <a:gd name="connsiteY392" fmla="*/ 1104801 h 1421726"/>
                <a:gd name="connsiteX393" fmla="*/ 5779219 w 8363529"/>
                <a:gd name="connsiteY393" fmla="*/ 1270546 h 1421726"/>
                <a:gd name="connsiteX394" fmla="*/ 5770827 w 8363529"/>
                <a:gd name="connsiteY394" fmla="*/ 1298932 h 1421726"/>
                <a:gd name="connsiteX395" fmla="*/ 5762474 w 8363529"/>
                <a:gd name="connsiteY395" fmla="*/ 1153646 h 1421726"/>
                <a:gd name="connsiteX396" fmla="*/ 5695580 w 8363529"/>
                <a:gd name="connsiteY396" fmla="*/ 346298 h 1421726"/>
                <a:gd name="connsiteX397" fmla="*/ 5687188 w 8363529"/>
                <a:gd name="connsiteY397" fmla="*/ 275184 h 1421726"/>
                <a:gd name="connsiteX398" fmla="*/ 5678835 w 8363529"/>
                <a:gd name="connsiteY398" fmla="*/ 335294 h 1421726"/>
                <a:gd name="connsiteX399" fmla="*/ 5611950 w 8363529"/>
                <a:gd name="connsiteY399" fmla="*/ 818362 h 1421726"/>
                <a:gd name="connsiteX400" fmla="*/ 5603558 w 8363529"/>
                <a:gd name="connsiteY400" fmla="*/ 879033 h 1421726"/>
                <a:gd name="connsiteX401" fmla="*/ 5595195 w 8363529"/>
                <a:gd name="connsiteY401" fmla="*/ 914687 h 1421726"/>
                <a:gd name="connsiteX402" fmla="*/ 5528311 w 8363529"/>
                <a:gd name="connsiteY402" fmla="*/ 1320940 h 1421726"/>
                <a:gd name="connsiteX403" fmla="*/ 5519919 w 8363529"/>
                <a:gd name="connsiteY403" fmla="*/ 1394318 h 1421726"/>
                <a:gd name="connsiteX404" fmla="*/ 5511566 w 8363529"/>
                <a:gd name="connsiteY404" fmla="*/ 1387699 h 1421726"/>
                <a:gd name="connsiteX405" fmla="*/ 5444672 w 8363529"/>
                <a:gd name="connsiteY405" fmla="*/ 1269598 h 1421726"/>
                <a:gd name="connsiteX406" fmla="*/ 5436280 w 8363529"/>
                <a:gd name="connsiteY406" fmla="*/ 1233760 h 1421726"/>
                <a:gd name="connsiteX407" fmla="*/ 5427926 w 8363529"/>
                <a:gd name="connsiteY407" fmla="*/ 1117770 h 1421726"/>
                <a:gd name="connsiteX408" fmla="*/ 5361042 w 8363529"/>
                <a:gd name="connsiteY408" fmla="*/ 781043 h 1421726"/>
                <a:gd name="connsiteX409" fmla="*/ 5352650 w 8363529"/>
                <a:gd name="connsiteY409" fmla="*/ 764000 h 1421726"/>
                <a:gd name="connsiteX410" fmla="*/ 5344287 w 8363529"/>
                <a:gd name="connsiteY410" fmla="*/ 784750 h 1421726"/>
                <a:gd name="connsiteX411" fmla="*/ 5277403 w 8363529"/>
                <a:gd name="connsiteY411" fmla="*/ 928033 h 1421726"/>
                <a:gd name="connsiteX412" fmla="*/ 5269049 w 8363529"/>
                <a:gd name="connsiteY412" fmla="*/ 943527 h 1421726"/>
                <a:gd name="connsiteX413" fmla="*/ 5260657 w 8363529"/>
                <a:gd name="connsiteY413" fmla="*/ 955973 h 1421726"/>
                <a:gd name="connsiteX414" fmla="*/ 5193773 w 8363529"/>
                <a:gd name="connsiteY414" fmla="*/ 1047566 h 1421726"/>
                <a:gd name="connsiteX415" fmla="*/ 5185410 w 8363529"/>
                <a:gd name="connsiteY415" fmla="*/ 1058115 h 1421726"/>
                <a:gd name="connsiteX416" fmla="*/ 5177018 w 8363529"/>
                <a:gd name="connsiteY416" fmla="*/ 1034713 h 1421726"/>
                <a:gd name="connsiteX417" fmla="*/ 5110134 w 8363529"/>
                <a:gd name="connsiteY417" fmla="*/ 778624 h 1421726"/>
                <a:gd name="connsiteX418" fmla="*/ 5101780 w 8363529"/>
                <a:gd name="connsiteY418" fmla="*/ 734318 h 1421726"/>
                <a:gd name="connsiteX419" fmla="*/ 5093388 w 8363529"/>
                <a:gd name="connsiteY419" fmla="*/ 779388 h 1421726"/>
                <a:gd name="connsiteX420" fmla="*/ 5026494 w 8363529"/>
                <a:gd name="connsiteY420" fmla="*/ 1081632 h 1421726"/>
                <a:gd name="connsiteX421" fmla="*/ 5018141 w 8363529"/>
                <a:gd name="connsiteY421" fmla="*/ 1113463 h 1421726"/>
                <a:gd name="connsiteX422" fmla="*/ 5009749 w 8363529"/>
                <a:gd name="connsiteY422" fmla="*/ 1123519 h 1421726"/>
                <a:gd name="connsiteX423" fmla="*/ 4942864 w 8363529"/>
                <a:gd name="connsiteY423" fmla="*/ 1194855 h 1421726"/>
                <a:gd name="connsiteX424" fmla="*/ 4934501 w 8363529"/>
                <a:gd name="connsiteY424" fmla="*/ 1202762 h 1421726"/>
                <a:gd name="connsiteX425" fmla="*/ 4926109 w 8363529"/>
                <a:gd name="connsiteY425" fmla="*/ 1192019 h 1421726"/>
                <a:gd name="connsiteX426" fmla="*/ 4859225 w 8363529"/>
                <a:gd name="connsiteY426" fmla="*/ 1062876 h 1421726"/>
                <a:gd name="connsiteX427" fmla="*/ 4850872 w 8363529"/>
                <a:gd name="connsiteY427" fmla="*/ 1038158 h 1421726"/>
                <a:gd name="connsiteX428" fmla="*/ 4842480 w 8363529"/>
                <a:gd name="connsiteY428" fmla="*/ 1018386 h 1421726"/>
                <a:gd name="connsiteX429" fmla="*/ 4775595 w 8363529"/>
                <a:gd name="connsiteY429" fmla="*/ 898350 h 1421726"/>
                <a:gd name="connsiteX430" fmla="*/ 4767232 w 8363529"/>
                <a:gd name="connsiteY430" fmla="*/ 886901 h 1421726"/>
                <a:gd name="connsiteX431" fmla="*/ 4758840 w 8363529"/>
                <a:gd name="connsiteY431" fmla="*/ 874310 h 1421726"/>
                <a:gd name="connsiteX432" fmla="*/ 4691956 w 8363529"/>
                <a:gd name="connsiteY432" fmla="*/ 761765 h 1421726"/>
                <a:gd name="connsiteX433" fmla="*/ 4683603 w 8363529"/>
                <a:gd name="connsiteY433" fmla="*/ 745999 h 1421726"/>
                <a:gd name="connsiteX434" fmla="*/ 4675201 w 8363529"/>
                <a:gd name="connsiteY434" fmla="*/ 796702 h 1421726"/>
                <a:gd name="connsiteX435" fmla="*/ 4608317 w 8363529"/>
                <a:gd name="connsiteY435" fmla="*/ 1211491 h 1421726"/>
                <a:gd name="connsiteX436" fmla="*/ 4599964 w 8363529"/>
                <a:gd name="connsiteY436" fmla="*/ 1264488 h 1421726"/>
                <a:gd name="connsiteX437" fmla="*/ 4591572 w 8363529"/>
                <a:gd name="connsiteY437" fmla="*/ 1256436 h 1421726"/>
                <a:gd name="connsiteX438" fmla="*/ 4524687 w 8363529"/>
                <a:gd name="connsiteY438" fmla="*/ 1198716 h 1421726"/>
                <a:gd name="connsiteX439" fmla="*/ 4516324 w 8363529"/>
                <a:gd name="connsiteY439" fmla="*/ 1192252 h 1421726"/>
                <a:gd name="connsiteX440" fmla="*/ 4507932 w 8363529"/>
                <a:gd name="connsiteY440" fmla="*/ 1170660 h 1421726"/>
                <a:gd name="connsiteX441" fmla="*/ 4441048 w 8363529"/>
                <a:gd name="connsiteY441" fmla="*/ 1007082 h 1421726"/>
                <a:gd name="connsiteX442" fmla="*/ 4432695 w 8363529"/>
                <a:gd name="connsiteY442" fmla="*/ 987726 h 1421726"/>
                <a:gd name="connsiteX443" fmla="*/ 4424303 w 8363529"/>
                <a:gd name="connsiteY443" fmla="*/ 895970 h 1421726"/>
                <a:gd name="connsiteX444" fmla="*/ 4357409 w 8363529"/>
                <a:gd name="connsiteY444" fmla="*/ 155458 h 1421726"/>
                <a:gd name="connsiteX445" fmla="*/ 4349055 w 8363529"/>
                <a:gd name="connsiteY445" fmla="*/ 62075 h 1421726"/>
                <a:gd name="connsiteX446" fmla="*/ 4340664 w 8363529"/>
                <a:gd name="connsiteY446" fmla="*/ 167516 h 1421726"/>
                <a:gd name="connsiteX447" fmla="*/ 4273779 w 8363529"/>
                <a:gd name="connsiteY447" fmla="*/ 1080161 h 1421726"/>
                <a:gd name="connsiteX448" fmla="*/ 4265416 w 8363529"/>
                <a:gd name="connsiteY448" fmla="*/ 1203701 h 1421726"/>
                <a:gd name="connsiteX449" fmla="*/ 4257024 w 8363529"/>
                <a:gd name="connsiteY449" fmla="*/ 1126509 h 1421726"/>
                <a:gd name="connsiteX450" fmla="*/ 4190140 w 8363529"/>
                <a:gd name="connsiteY450" fmla="*/ 634364 h 1421726"/>
                <a:gd name="connsiteX451" fmla="*/ 4181787 w 8363529"/>
                <a:gd name="connsiteY451" fmla="*/ 585064 h 1421726"/>
                <a:gd name="connsiteX452" fmla="*/ 4173394 w 8363529"/>
                <a:gd name="connsiteY452" fmla="*/ 626882 h 1421726"/>
                <a:gd name="connsiteX453" fmla="*/ 4106500 w 8363529"/>
                <a:gd name="connsiteY453" fmla="*/ 1138606 h 1421726"/>
                <a:gd name="connsiteX454" fmla="*/ 4098147 w 8363529"/>
                <a:gd name="connsiteY454" fmla="*/ 1238599 h 1421726"/>
                <a:gd name="connsiteX455" fmla="*/ 4089755 w 8363529"/>
                <a:gd name="connsiteY455" fmla="*/ 1199239 h 1421726"/>
                <a:gd name="connsiteX456" fmla="*/ 4022871 w 8363529"/>
                <a:gd name="connsiteY456" fmla="*/ 994153 h 1421726"/>
                <a:gd name="connsiteX457" fmla="*/ 4014517 w 8363529"/>
                <a:gd name="connsiteY457" fmla="*/ 977139 h 1421726"/>
                <a:gd name="connsiteX458" fmla="*/ 4006154 w 8363529"/>
                <a:gd name="connsiteY458" fmla="*/ 999708 h 1421726"/>
                <a:gd name="connsiteX459" fmla="*/ 3939231 w 8363529"/>
                <a:gd name="connsiteY459" fmla="*/ 1204417 h 1421726"/>
                <a:gd name="connsiteX460" fmla="*/ 3930878 w 8363529"/>
                <a:gd name="connsiteY460" fmla="*/ 1233490 h 1421726"/>
                <a:gd name="connsiteX461" fmla="*/ 3922525 w 8363529"/>
                <a:gd name="connsiteY461" fmla="*/ 1216176 h 1421726"/>
                <a:gd name="connsiteX462" fmla="*/ 3855602 w 8363529"/>
                <a:gd name="connsiteY462" fmla="*/ 1062083 h 1421726"/>
                <a:gd name="connsiteX463" fmla="*/ 3847239 w 8363529"/>
                <a:gd name="connsiteY463" fmla="*/ 1040655 h 1421726"/>
                <a:gd name="connsiteX464" fmla="*/ 3838885 w 8363529"/>
                <a:gd name="connsiteY464" fmla="*/ 1036649 h 1421726"/>
                <a:gd name="connsiteX465" fmla="*/ 3771962 w 8363529"/>
                <a:gd name="connsiteY465" fmla="*/ 1007537 h 1421726"/>
                <a:gd name="connsiteX466" fmla="*/ 3763609 w 8363529"/>
                <a:gd name="connsiteY466" fmla="*/ 1004208 h 1421726"/>
                <a:gd name="connsiteX467" fmla="*/ 3755246 w 8363529"/>
                <a:gd name="connsiteY467" fmla="*/ 1011205 h 1421726"/>
                <a:gd name="connsiteX468" fmla="*/ 3688323 w 8363529"/>
                <a:gd name="connsiteY468" fmla="*/ 1074828 h 1421726"/>
                <a:gd name="connsiteX469" fmla="*/ 3679970 w 8363529"/>
                <a:gd name="connsiteY469" fmla="*/ 1083897 h 1421726"/>
                <a:gd name="connsiteX470" fmla="*/ 3671616 w 8363529"/>
                <a:gd name="connsiteY470" fmla="*/ 999824 h 1421726"/>
                <a:gd name="connsiteX471" fmla="*/ 3604693 w 8363529"/>
                <a:gd name="connsiteY471" fmla="*/ 495920 h 1421726"/>
                <a:gd name="connsiteX472" fmla="*/ 3596330 w 8363529"/>
                <a:gd name="connsiteY472" fmla="*/ 448294 h 1421726"/>
                <a:gd name="connsiteX473" fmla="*/ 3587977 w 8363529"/>
                <a:gd name="connsiteY473" fmla="*/ 490142 h 1421726"/>
                <a:gd name="connsiteX474" fmla="*/ 3521054 w 8363529"/>
                <a:gd name="connsiteY474" fmla="*/ 875781 h 1421726"/>
                <a:gd name="connsiteX475" fmla="*/ 3512701 w 8363529"/>
                <a:gd name="connsiteY475" fmla="*/ 931430 h 1421726"/>
                <a:gd name="connsiteX476" fmla="*/ 3504347 w 8363529"/>
                <a:gd name="connsiteY476" fmla="*/ 864255 h 1421726"/>
                <a:gd name="connsiteX477" fmla="*/ 3437424 w 8363529"/>
                <a:gd name="connsiteY477" fmla="*/ 396236 h 1421726"/>
                <a:gd name="connsiteX478" fmla="*/ 3429061 w 8363529"/>
                <a:gd name="connsiteY478" fmla="*/ 345156 h 1421726"/>
                <a:gd name="connsiteX479" fmla="*/ 3420708 w 8363529"/>
                <a:gd name="connsiteY479" fmla="*/ 373290 h 1421726"/>
                <a:gd name="connsiteX480" fmla="*/ 3353785 w 8363529"/>
                <a:gd name="connsiteY480" fmla="*/ 924326 h 1421726"/>
                <a:gd name="connsiteX481" fmla="*/ 3345432 w 8363529"/>
                <a:gd name="connsiteY481" fmla="*/ 1112292 h 1421726"/>
                <a:gd name="connsiteX482" fmla="*/ 3337069 w 8363529"/>
                <a:gd name="connsiteY482" fmla="*/ 1138490 h 1421726"/>
                <a:gd name="connsiteX483" fmla="*/ 3270146 w 8363529"/>
                <a:gd name="connsiteY483" fmla="*/ 1230238 h 1421726"/>
                <a:gd name="connsiteX484" fmla="*/ 3261792 w 8363529"/>
                <a:gd name="connsiteY484" fmla="*/ 1235648 h 1421726"/>
                <a:gd name="connsiteX485" fmla="*/ 3253439 w 8363529"/>
                <a:gd name="connsiteY485" fmla="*/ 1156066 h 1421726"/>
                <a:gd name="connsiteX486" fmla="*/ 3186516 w 8363529"/>
                <a:gd name="connsiteY486" fmla="*/ 650090 h 1421726"/>
                <a:gd name="connsiteX487" fmla="*/ 3178153 w 8363529"/>
                <a:gd name="connsiteY487" fmla="*/ 599513 h 1421726"/>
                <a:gd name="connsiteX488" fmla="*/ 3169800 w 8363529"/>
                <a:gd name="connsiteY488" fmla="*/ 611194 h 1421726"/>
                <a:gd name="connsiteX489" fmla="*/ 3102877 w 8363529"/>
                <a:gd name="connsiteY489" fmla="*/ 740405 h 1421726"/>
                <a:gd name="connsiteX490" fmla="*/ 3094523 w 8363529"/>
                <a:gd name="connsiteY490" fmla="*/ 763091 h 1421726"/>
                <a:gd name="connsiteX491" fmla="*/ 3086161 w 8363529"/>
                <a:gd name="connsiteY491" fmla="*/ 777453 h 1421726"/>
                <a:gd name="connsiteX492" fmla="*/ 3019238 w 8363529"/>
                <a:gd name="connsiteY492" fmla="*/ 867623 h 1421726"/>
                <a:gd name="connsiteX493" fmla="*/ 3010884 w 8363529"/>
                <a:gd name="connsiteY493" fmla="*/ 876546 h 1421726"/>
                <a:gd name="connsiteX494" fmla="*/ 3002531 w 8363529"/>
                <a:gd name="connsiteY494" fmla="*/ 835066 h 1421726"/>
                <a:gd name="connsiteX495" fmla="*/ 2935608 w 8363529"/>
                <a:gd name="connsiteY495" fmla="*/ 489232 h 1421726"/>
                <a:gd name="connsiteX496" fmla="*/ 2927245 w 8363529"/>
                <a:gd name="connsiteY496" fmla="*/ 444172 h 1421726"/>
                <a:gd name="connsiteX497" fmla="*/ 2918892 w 8363529"/>
                <a:gd name="connsiteY497" fmla="*/ 489494 h 1421726"/>
                <a:gd name="connsiteX498" fmla="*/ 2851968 w 8363529"/>
                <a:gd name="connsiteY498" fmla="*/ 842102 h 1421726"/>
                <a:gd name="connsiteX499" fmla="*/ 2843615 w 8363529"/>
                <a:gd name="connsiteY499" fmla="*/ 885014 h 1421726"/>
                <a:gd name="connsiteX500" fmla="*/ 2835262 w 8363529"/>
                <a:gd name="connsiteY500" fmla="*/ 884859 h 1421726"/>
                <a:gd name="connsiteX501" fmla="*/ 2768329 w 8363529"/>
                <a:gd name="connsiteY501" fmla="*/ 883495 h 1421726"/>
                <a:gd name="connsiteX502" fmla="*/ 2759976 w 8363529"/>
                <a:gd name="connsiteY502" fmla="*/ 883272 h 1421726"/>
                <a:gd name="connsiteX503" fmla="*/ 2751623 w 8363529"/>
                <a:gd name="connsiteY503" fmla="*/ 913361 h 1421726"/>
                <a:gd name="connsiteX504" fmla="*/ 2684699 w 8363529"/>
                <a:gd name="connsiteY504" fmla="*/ 1116260 h 1421726"/>
                <a:gd name="connsiteX505" fmla="*/ 2676346 w 8363529"/>
                <a:gd name="connsiteY505" fmla="*/ 1137697 h 1421726"/>
                <a:gd name="connsiteX506" fmla="*/ 2667983 w 8363529"/>
                <a:gd name="connsiteY506" fmla="*/ 1141626 h 1421726"/>
                <a:gd name="connsiteX507" fmla="*/ 2601060 w 8363529"/>
                <a:gd name="connsiteY507" fmla="*/ 1172586 h 1421726"/>
                <a:gd name="connsiteX508" fmla="*/ 2592707 w 8363529"/>
                <a:gd name="connsiteY508" fmla="*/ 1176409 h 1421726"/>
                <a:gd name="connsiteX509" fmla="*/ 2584354 w 8363529"/>
                <a:gd name="connsiteY509" fmla="*/ 1160489 h 1421726"/>
                <a:gd name="connsiteX510" fmla="*/ 2517430 w 8363529"/>
                <a:gd name="connsiteY510" fmla="*/ 1052027 h 1421726"/>
                <a:gd name="connsiteX511" fmla="*/ 2509068 w 8363529"/>
                <a:gd name="connsiteY511" fmla="*/ 1040462 h 1421726"/>
                <a:gd name="connsiteX512" fmla="*/ 2500714 w 8363529"/>
                <a:gd name="connsiteY512" fmla="*/ 1012676 h 1421726"/>
                <a:gd name="connsiteX513" fmla="*/ 2433791 w 8363529"/>
                <a:gd name="connsiteY513" fmla="*/ 777491 h 1421726"/>
                <a:gd name="connsiteX514" fmla="*/ 2425438 w 8363529"/>
                <a:gd name="connsiteY514" fmla="*/ 746377 h 1421726"/>
                <a:gd name="connsiteX515" fmla="*/ 2417075 w 8363529"/>
                <a:gd name="connsiteY515" fmla="*/ 776582 h 1421726"/>
                <a:gd name="connsiteX516" fmla="*/ 2350152 w 8363529"/>
                <a:gd name="connsiteY516" fmla="*/ 1031045 h 1421726"/>
                <a:gd name="connsiteX517" fmla="*/ 2341799 w 8363529"/>
                <a:gd name="connsiteY517" fmla="*/ 1064541 h 1421726"/>
                <a:gd name="connsiteX518" fmla="*/ 2333445 w 8363529"/>
                <a:gd name="connsiteY518" fmla="*/ 1058947 h 1421726"/>
                <a:gd name="connsiteX519" fmla="*/ 2266522 w 8363529"/>
                <a:gd name="connsiteY519" fmla="*/ 1004053 h 1421726"/>
                <a:gd name="connsiteX520" fmla="*/ 2258159 w 8363529"/>
                <a:gd name="connsiteY520" fmla="*/ 995624 h 1421726"/>
                <a:gd name="connsiteX521" fmla="*/ 2249806 w 8363529"/>
                <a:gd name="connsiteY521" fmla="*/ 993398 h 1421726"/>
                <a:gd name="connsiteX522" fmla="*/ 2182883 w 8363529"/>
                <a:gd name="connsiteY522" fmla="*/ 978581 h 1421726"/>
                <a:gd name="connsiteX523" fmla="*/ 2174530 w 8363529"/>
                <a:gd name="connsiteY523" fmla="*/ 977023 h 1421726"/>
                <a:gd name="connsiteX524" fmla="*/ 2166176 w 8363529"/>
                <a:gd name="connsiteY524" fmla="*/ 913477 h 1421726"/>
                <a:gd name="connsiteX525" fmla="*/ 2099253 w 8363529"/>
                <a:gd name="connsiteY525" fmla="*/ 323613 h 1421726"/>
                <a:gd name="connsiteX526" fmla="*/ 2090890 w 8363529"/>
                <a:gd name="connsiteY526" fmla="*/ 237866 h 1421726"/>
                <a:gd name="connsiteX527" fmla="*/ 2082537 w 8363529"/>
                <a:gd name="connsiteY527" fmla="*/ 357408 h 1421726"/>
                <a:gd name="connsiteX528" fmla="*/ 2015614 w 8363529"/>
                <a:gd name="connsiteY528" fmla="*/ 1087836 h 1421726"/>
                <a:gd name="connsiteX529" fmla="*/ 2007260 w 8363529"/>
                <a:gd name="connsiteY529" fmla="*/ 1158108 h 1421726"/>
                <a:gd name="connsiteX530" fmla="*/ 1998898 w 8363529"/>
                <a:gd name="connsiteY530" fmla="*/ 1156443 h 1421726"/>
                <a:gd name="connsiteX531" fmla="*/ 1931975 w 8363529"/>
                <a:gd name="connsiteY531" fmla="*/ 1139129 h 1421726"/>
                <a:gd name="connsiteX532" fmla="*/ 1923621 w 8363529"/>
                <a:gd name="connsiteY532" fmla="*/ 1136371 h 1421726"/>
                <a:gd name="connsiteX533" fmla="*/ 1915268 w 8363529"/>
                <a:gd name="connsiteY533" fmla="*/ 1134638 h 1421726"/>
                <a:gd name="connsiteX534" fmla="*/ 1848345 w 8363529"/>
                <a:gd name="connsiteY534" fmla="*/ 1120838 h 1421726"/>
                <a:gd name="connsiteX535" fmla="*/ 1839982 w 8363529"/>
                <a:gd name="connsiteY535" fmla="*/ 1119096 h 1421726"/>
                <a:gd name="connsiteX536" fmla="*/ 1831629 w 8363529"/>
                <a:gd name="connsiteY536" fmla="*/ 1123973 h 1421726"/>
                <a:gd name="connsiteX537" fmla="*/ 1764706 w 8363529"/>
                <a:gd name="connsiteY537" fmla="*/ 1160682 h 1421726"/>
                <a:gd name="connsiteX538" fmla="*/ 1756352 w 8363529"/>
                <a:gd name="connsiteY538" fmla="*/ 1164989 h 1421726"/>
                <a:gd name="connsiteX539" fmla="*/ 1747989 w 8363529"/>
                <a:gd name="connsiteY539" fmla="*/ 1169682 h 1421726"/>
                <a:gd name="connsiteX540" fmla="*/ 1681066 w 8363529"/>
                <a:gd name="connsiteY540" fmla="*/ 1200488 h 1421726"/>
                <a:gd name="connsiteX541" fmla="*/ 1672713 w 8363529"/>
                <a:gd name="connsiteY541" fmla="*/ 1203701 h 1421726"/>
                <a:gd name="connsiteX542" fmla="*/ 1664360 w 8363529"/>
                <a:gd name="connsiteY542" fmla="*/ 1205143 h 1421726"/>
                <a:gd name="connsiteX543" fmla="*/ 1597437 w 8363529"/>
                <a:gd name="connsiteY543" fmla="*/ 1222186 h 1421726"/>
                <a:gd name="connsiteX544" fmla="*/ 1589074 w 8363529"/>
                <a:gd name="connsiteY544" fmla="*/ 1225399 h 1421726"/>
                <a:gd name="connsiteX545" fmla="*/ 1580720 w 8363529"/>
                <a:gd name="connsiteY545" fmla="*/ 1227102 h 1421726"/>
                <a:gd name="connsiteX546" fmla="*/ 1513797 w 8363529"/>
                <a:gd name="connsiteY546" fmla="*/ 1237651 h 1421726"/>
                <a:gd name="connsiteX547" fmla="*/ 1505444 w 8363529"/>
                <a:gd name="connsiteY547" fmla="*/ 1238706 h 1421726"/>
                <a:gd name="connsiteX548" fmla="*/ 1497091 w 8363529"/>
                <a:gd name="connsiteY548" fmla="*/ 1209333 h 1421726"/>
                <a:gd name="connsiteX549" fmla="*/ 1430158 w 8363529"/>
                <a:gd name="connsiteY549" fmla="*/ 1012483 h 1421726"/>
                <a:gd name="connsiteX550" fmla="*/ 1421805 w 8363529"/>
                <a:gd name="connsiteY550" fmla="*/ 991811 h 1421726"/>
                <a:gd name="connsiteX551" fmla="*/ 1413451 w 8363529"/>
                <a:gd name="connsiteY551" fmla="*/ 1005989 h 1421726"/>
                <a:gd name="connsiteX552" fmla="*/ 1346528 w 8363529"/>
                <a:gd name="connsiteY552" fmla="*/ 1175538 h 1421726"/>
                <a:gd name="connsiteX553" fmla="*/ 1338175 w 8363529"/>
                <a:gd name="connsiteY553" fmla="*/ 1207785 h 1421726"/>
                <a:gd name="connsiteX554" fmla="*/ 1329812 w 8363529"/>
                <a:gd name="connsiteY554" fmla="*/ 1149494 h 1421726"/>
                <a:gd name="connsiteX555" fmla="*/ 1262889 w 8363529"/>
                <a:gd name="connsiteY555" fmla="*/ 861990 h 1421726"/>
                <a:gd name="connsiteX556" fmla="*/ 1254536 w 8363529"/>
                <a:gd name="connsiteY556" fmla="*/ 839266 h 1421726"/>
                <a:gd name="connsiteX557" fmla="*/ 1246182 w 8363529"/>
                <a:gd name="connsiteY557" fmla="*/ 848034 h 1421726"/>
                <a:gd name="connsiteX558" fmla="*/ 1179259 w 8363529"/>
                <a:gd name="connsiteY558" fmla="*/ 930830 h 1421726"/>
                <a:gd name="connsiteX559" fmla="*/ 1170896 w 8363529"/>
                <a:gd name="connsiteY559" fmla="*/ 943111 h 1421726"/>
                <a:gd name="connsiteX560" fmla="*/ 1162543 w 8363529"/>
                <a:gd name="connsiteY560" fmla="*/ 954531 h 1421726"/>
                <a:gd name="connsiteX561" fmla="*/ 1095620 w 8363529"/>
                <a:gd name="connsiteY561" fmla="*/ 1040762 h 1421726"/>
                <a:gd name="connsiteX562" fmla="*/ 1087267 w 8363529"/>
                <a:gd name="connsiteY562" fmla="*/ 1050934 h 1421726"/>
                <a:gd name="connsiteX563" fmla="*/ 1078904 w 8363529"/>
                <a:gd name="connsiteY563" fmla="*/ 1058076 h 1421726"/>
                <a:gd name="connsiteX564" fmla="*/ 1011981 w 8363529"/>
                <a:gd name="connsiteY564" fmla="*/ 1105295 h 1421726"/>
                <a:gd name="connsiteX565" fmla="*/ 1003627 w 8363529"/>
                <a:gd name="connsiteY565" fmla="*/ 1110211 h 1421726"/>
                <a:gd name="connsiteX566" fmla="*/ 995274 w 8363529"/>
                <a:gd name="connsiteY566" fmla="*/ 1094223 h 1421726"/>
                <a:gd name="connsiteX567" fmla="*/ 928351 w 8363529"/>
                <a:gd name="connsiteY567" fmla="*/ 928904 h 1421726"/>
                <a:gd name="connsiteX568" fmla="*/ 919988 w 8363529"/>
                <a:gd name="connsiteY568" fmla="*/ 901950 h 1421726"/>
                <a:gd name="connsiteX569" fmla="*/ 911635 w 8363529"/>
                <a:gd name="connsiteY569" fmla="*/ 923116 h 1421726"/>
                <a:gd name="connsiteX570" fmla="*/ 844712 w 8363529"/>
                <a:gd name="connsiteY570" fmla="*/ 1060612 h 1421726"/>
                <a:gd name="connsiteX571" fmla="*/ 836358 w 8363529"/>
                <a:gd name="connsiteY571" fmla="*/ 1074596 h 1421726"/>
                <a:gd name="connsiteX572" fmla="*/ 828005 w 8363529"/>
                <a:gd name="connsiteY572" fmla="*/ 1080229 h 1421726"/>
                <a:gd name="connsiteX573" fmla="*/ 761082 w 8363529"/>
                <a:gd name="connsiteY573" fmla="*/ 1137619 h 1421726"/>
                <a:gd name="connsiteX574" fmla="*/ 752719 w 8363529"/>
                <a:gd name="connsiteY574" fmla="*/ 1146843 h 1421726"/>
                <a:gd name="connsiteX575" fmla="*/ 744366 w 8363529"/>
                <a:gd name="connsiteY575" fmla="*/ 1142758 h 1421726"/>
                <a:gd name="connsiteX576" fmla="*/ 677443 w 8363529"/>
                <a:gd name="connsiteY576" fmla="*/ 1104008 h 1421726"/>
                <a:gd name="connsiteX577" fmla="*/ 669089 w 8363529"/>
                <a:gd name="connsiteY577" fmla="*/ 1098191 h 1421726"/>
                <a:gd name="connsiteX578" fmla="*/ 660727 w 8363529"/>
                <a:gd name="connsiteY578" fmla="*/ 1054563 h 1421726"/>
                <a:gd name="connsiteX579" fmla="*/ 593803 w 8363529"/>
                <a:gd name="connsiteY579" fmla="*/ 816736 h 1421726"/>
                <a:gd name="connsiteX580" fmla="*/ 585450 w 8363529"/>
                <a:gd name="connsiteY580" fmla="*/ 796170 h 1421726"/>
                <a:gd name="connsiteX581" fmla="*/ 577097 w 8363529"/>
                <a:gd name="connsiteY581" fmla="*/ 797680 h 1421726"/>
                <a:gd name="connsiteX582" fmla="*/ 510174 w 8363529"/>
                <a:gd name="connsiteY582" fmla="*/ 817036 h 1421726"/>
                <a:gd name="connsiteX583" fmla="*/ 501811 w 8363529"/>
                <a:gd name="connsiteY583" fmla="*/ 821042 h 1421726"/>
                <a:gd name="connsiteX584" fmla="*/ 493458 w 8363529"/>
                <a:gd name="connsiteY584" fmla="*/ 775304 h 1421726"/>
                <a:gd name="connsiteX585" fmla="*/ 426534 w 8363529"/>
                <a:gd name="connsiteY585" fmla="*/ 570586 h 1421726"/>
                <a:gd name="connsiteX586" fmla="*/ 418181 w 8363529"/>
                <a:gd name="connsiteY586" fmla="*/ 555769 h 1421726"/>
                <a:gd name="connsiteX587" fmla="*/ 409818 w 8363529"/>
                <a:gd name="connsiteY587" fmla="*/ 586690 h 1421726"/>
                <a:gd name="connsiteX588" fmla="*/ 342895 w 8363529"/>
                <a:gd name="connsiteY588" fmla="*/ 923155 h 1421726"/>
                <a:gd name="connsiteX589" fmla="*/ 334542 w 8363529"/>
                <a:gd name="connsiteY589" fmla="*/ 981000 h 1421726"/>
                <a:gd name="connsiteX590" fmla="*/ 326189 w 8363529"/>
                <a:gd name="connsiteY590" fmla="*/ 1002466 h 1421726"/>
                <a:gd name="connsiteX591" fmla="*/ 259304 w 8363529"/>
                <a:gd name="connsiteY591" fmla="*/ 1200865 h 1421726"/>
                <a:gd name="connsiteX592" fmla="*/ 250903 w 8363529"/>
                <a:gd name="connsiteY592" fmla="*/ 1229560 h 1421726"/>
                <a:gd name="connsiteX593" fmla="*/ 242549 w 8363529"/>
                <a:gd name="connsiteY593" fmla="*/ 1207069 h 1421726"/>
                <a:gd name="connsiteX594" fmla="*/ 175665 w 8363529"/>
                <a:gd name="connsiteY594" fmla="*/ 1081371 h 1421726"/>
                <a:gd name="connsiteX595" fmla="*/ 167273 w 8363529"/>
                <a:gd name="connsiteY595" fmla="*/ 1070251 h 1421726"/>
                <a:gd name="connsiteX596" fmla="*/ 158920 w 8363529"/>
                <a:gd name="connsiteY596" fmla="*/ 1052375 h 1421726"/>
                <a:gd name="connsiteX597" fmla="*/ 92029 w 8363529"/>
                <a:gd name="connsiteY597" fmla="*/ 887501 h 1421726"/>
                <a:gd name="connsiteX598" fmla="*/ 83635 w 8363529"/>
                <a:gd name="connsiteY598" fmla="*/ 863684 h 1421726"/>
                <a:gd name="connsiteX599" fmla="*/ 75279 w 8363529"/>
                <a:gd name="connsiteY599" fmla="*/ 845276 h 1421726"/>
                <a:gd name="connsiteX600" fmla="*/ 8394 w 8363529"/>
                <a:gd name="connsiteY600" fmla="*/ 699651 h 1421726"/>
                <a:gd name="connsiteX601" fmla="*/ 0 w 8363529"/>
                <a:gd name="connsiteY601" fmla="*/ 681660 h 14217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  <a:cxn ang="0">
                  <a:pos x="connsiteX466" y="connsiteY466"/>
                </a:cxn>
                <a:cxn ang="0">
                  <a:pos x="connsiteX467" y="connsiteY467"/>
                </a:cxn>
                <a:cxn ang="0">
                  <a:pos x="connsiteX468" y="connsiteY468"/>
                </a:cxn>
                <a:cxn ang="0">
                  <a:pos x="connsiteX469" y="connsiteY469"/>
                </a:cxn>
                <a:cxn ang="0">
                  <a:pos x="connsiteX470" y="connsiteY470"/>
                </a:cxn>
                <a:cxn ang="0">
                  <a:pos x="connsiteX471" y="connsiteY471"/>
                </a:cxn>
                <a:cxn ang="0">
                  <a:pos x="connsiteX472" y="connsiteY472"/>
                </a:cxn>
                <a:cxn ang="0">
                  <a:pos x="connsiteX473" y="connsiteY473"/>
                </a:cxn>
                <a:cxn ang="0">
                  <a:pos x="connsiteX474" y="connsiteY474"/>
                </a:cxn>
                <a:cxn ang="0">
                  <a:pos x="connsiteX475" y="connsiteY475"/>
                </a:cxn>
                <a:cxn ang="0">
                  <a:pos x="connsiteX476" y="connsiteY476"/>
                </a:cxn>
                <a:cxn ang="0">
                  <a:pos x="connsiteX477" y="connsiteY477"/>
                </a:cxn>
                <a:cxn ang="0">
                  <a:pos x="connsiteX478" y="connsiteY478"/>
                </a:cxn>
                <a:cxn ang="0">
                  <a:pos x="connsiteX479" y="connsiteY479"/>
                </a:cxn>
                <a:cxn ang="0">
                  <a:pos x="connsiteX480" y="connsiteY480"/>
                </a:cxn>
                <a:cxn ang="0">
                  <a:pos x="connsiteX481" y="connsiteY481"/>
                </a:cxn>
                <a:cxn ang="0">
                  <a:pos x="connsiteX482" y="connsiteY482"/>
                </a:cxn>
                <a:cxn ang="0">
                  <a:pos x="connsiteX483" y="connsiteY483"/>
                </a:cxn>
                <a:cxn ang="0">
                  <a:pos x="connsiteX484" y="connsiteY484"/>
                </a:cxn>
                <a:cxn ang="0">
                  <a:pos x="connsiteX485" y="connsiteY485"/>
                </a:cxn>
                <a:cxn ang="0">
                  <a:pos x="connsiteX486" y="connsiteY486"/>
                </a:cxn>
                <a:cxn ang="0">
                  <a:pos x="connsiteX487" y="connsiteY487"/>
                </a:cxn>
                <a:cxn ang="0">
                  <a:pos x="connsiteX488" y="connsiteY488"/>
                </a:cxn>
                <a:cxn ang="0">
                  <a:pos x="connsiteX489" y="connsiteY489"/>
                </a:cxn>
                <a:cxn ang="0">
                  <a:pos x="connsiteX490" y="connsiteY490"/>
                </a:cxn>
                <a:cxn ang="0">
                  <a:pos x="connsiteX491" y="connsiteY491"/>
                </a:cxn>
                <a:cxn ang="0">
                  <a:pos x="connsiteX492" y="connsiteY492"/>
                </a:cxn>
                <a:cxn ang="0">
                  <a:pos x="connsiteX493" y="connsiteY493"/>
                </a:cxn>
                <a:cxn ang="0">
                  <a:pos x="connsiteX494" y="connsiteY494"/>
                </a:cxn>
                <a:cxn ang="0">
                  <a:pos x="connsiteX495" y="connsiteY495"/>
                </a:cxn>
                <a:cxn ang="0">
                  <a:pos x="connsiteX496" y="connsiteY496"/>
                </a:cxn>
                <a:cxn ang="0">
                  <a:pos x="connsiteX497" y="connsiteY497"/>
                </a:cxn>
                <a:cxn ang="0">
                  <a:pos x="connsiteX498" y="connsiteY498"/>
                </a:cxn>
                <a:cxn ang="0">
                  <a:pos x="connsiteX499" y="connsiteY499"/>
                </a:cxn>
                <a:cxn ang="0">
                  <a:pos x="connsiteX500" y="connsiteY500"/>
                </a:cxn>
                <a:cxn ang="0">
                  <a:pos x="connsiteX501" y="connsiteY501"/>
                </a:cxn>
                <a:cxn ang="0">
                  <a:pos x="connsiteX502" y="connsiteY502"/>
                </a:cxn>
                <a:cxn ang="0">
                  <a:pos x="connsiteX503" y="connsiteY503"/>
                </a:cxn>
                <a:cxn ang="0">
                  <a:pos x="connsiteX504" y="connsiteY504"/>
                </a:cxn>
                <a:cxn ang="0">
                  <a:pos x="connsiteX505" y="connsiteY505"/>
                </a:cxn>
                <a:cxn ang="0">
                  <a:pos x="connsiteX506" y="connsiteY506"/>
                </a:cxn>
                <a:cxn ang="0">
                  <a:pos x="connsiteX507" y="connsiteY507"/>
                </a:cxn>
                <a:cxn ang="0">
                  <a:pos x="connsiteX508" y="connsiteY508"/>
                </a:cxn>
                <a:cxn ang="0">
                  <a:pos x="connsiteX509" y="connsiteY509"/>
                </a:cxn>
                <a:cxn ang="0">
                  <a:pos x="connsiteX510" y="connsiteY510"/>
                </a:cxn>
                <a:cxn ang="0">
                  <a:pos x="connsiteX511" y="connsiteY511"/>
                </a:cxn>
                <a:cxn ang="0">
                  <a:pos x="connsiteX512" y="connsiteY512"/>
                </a:cxn>
                <a:cxn ang="0">
                  <a:pos x="connsiteX513" y="connsiteY513"/>
                </a:cxn>
                <a:cxn ang="0">
                  <a:pos x="connsiteX514" y="connsiteY514"/>
                </a:cxn>
                <a:cxn ang="0">
                  <a:pos x="connsiteX515" y="connsiteY515"/>
                </a:cxn>
                <a:cxn ang="0">
                  <a:pos x="connsiteX516" y="connsiteY516"/>
                </a:cxn>
                <a:cxn ang="0">
                  <a:pos x="connsiteX517" y="connsiteY517"/>
                </a:cxn>
                <a:cxn ang="0">
                  <a:pos x="connsiteX518" y="connsiteY518"/>
                </a:cxn>
                <a:cxn ang="0">
                  <a:pos x="connsiteX519" y="connsiteY519"/>
                </a:cxn>
                <a:cxn ang="0">
                  <a:pos x="connsiteX520" y="connsiteY520"/>
                </a:cxn>
                <a:cxn ang="0">
                  <a:pos x="connsiteX521" y="connsiteY521"/>
                </a:cxn>
                <a:cxn ang="0">
                  <a:pos x="connsiteX522" y="connsiteY522"/>
                </a:cxn>
                <a:cxn ang="0">
                  <a:pos x="connsiteX523" y="connsiteY523"/>
                </a:cxn>
                <a:cxn ang="0">
                  <a:pos x="connsiteX524" y="connsiteY524"/>
                </a:cxn>
                <a:cxn ang="0">
                  <a:pos x="connsiteX525" y="connsiteY525"/>
                </a:cxn>
                <a:cxn ang="0">
                  <a:pos x="connsiteX526" y="connsiteY526"/>
                </a:cxn>
                <a:cxn ang="0">
                  <a:pos x="connsiteX527" y="connsiteY527"/>
                </a:cxn>
                <a:cxn ang="0">
                  <a:pos x="connsiteX528" y="connsiteY528"/>
                </a:cxn>
                <a:cxn ang="0">
                  <a:pos x="connsiteX529" y="connsiteY529"/>
                </a:cxn>
                <a:cxn ang="0">
                  <a:pos x="connsiteX530" y="connsiteY530"/>
                </a:cxn>
                <a:cxn ang="0">
                  <a:pos x="connsiteX531" y="connsiteY531"/>
                </a:cxn>
                <a:cxn ang="0">
                  <a:pos x="connsiteX532" y="connsiteY532"/>
                </a:cxn>
                <a:cxn ang="0">
                  <a:pos x="connsiteX533" y="connsiteY533"/>
                </a:cxn>
                <a:cxn ang="0">
                  <a:pos x="connsiteX534" y="connsiteY534"/>
                </a:cxn>
                <a:cxn ang="0">
                  <a:pos x="connsiteX535" y="connsiteY535"/>
                </a:cxn>
                <a:cxn ang="0">
                  <a:pos x="connsiteX536" y="connsiteY536"/>
                </a:cxn>
                <a:cxn ang="0">
                  <a:pos x="connsiteX537" y="connsiteY537"/>
                </a:cxn>
                <a:cxn ang="0">
                  <a:pos x="connsiteX538" y="connsiteY538"/>
                </a:cxn>
                <a:cxn ang="0">
                  <a:pos x="connsiteX539" y="connsiteY539"/>
                </a:cxn>
                <a:cxn ang="0">
                  <a:pos x="connsiteX540" y="connsiteY540"/>
                </a:cxn>
                <a:cxn ang="0">
                  <a:pos x="connsiteX541" y="connsiteY541"/>
                </a:cxn>
                <a:cxn ang="0">
                  <a:pos x="connsiteX542" y="connsiteY542"/>
                </a:cxn>
                <a:cxn ang="0">
                  <a:pos x="connsiteX543" y="connsiteY543"/>
                </a:cxn>
                <a:cxn ang="0">
                  <a:pos x="connsiteX544" y="connsiteY544"/>
                </a:cxn>
                <a:cxn ang="0">
                  <a:pos x="connsiteX545" y="connsiteY545"/>
                </a:cxn>
                <a:cxn ang="0">
                  <a:pos x="connsiteX546" y="connsiteY546"/>
                </a:cxn>
                <a:cxn ang="0">
                  <a:pos x="connsiteX547" y="connsiteY547"/>
                </a:cxn>
                <a:cxn ang="0">
                  <a:pos x="connsiteX548" y="connsiteY548"/>
                </a:cxn>
                <a:cxn ang="0">
                  <a:pos x="connsiteX549" y="connsiteY549"/>
                </a:cxn>
                <a:cxn ang="0">
                  <a:pos x="connsiteX550" y="connsiteY550"/>
                </a:cxn>
                <a:cxn ang="0">
                  <a:pos x="connsiteX551" y="connsiteY551"/>
                </a:cxn>
                <a:cxn ang="0">
                  <a:pos x="connsiteX552" y="connsiteY552"/>
                </a:cxn>
                <a:cxn ang="0">
                  <a:pos x="connsiteX553" y="connsiteY553"/>
                </a:cxn>
                <a:cxn ang="0">
                  <a:pos x="connsiteX554" y="connsiteY554"/>
                </a:cxn>
                <a:cxn ang="0">
                  <a:pos x="connsiteX555" y="connsiteY555"/>
                </a:cxn>
                <a:cxn ang="0">
                  <a:pos x="connsiteX556" y="connsiteY556"/>
                </a:cxn>
                <a:cxn ang="0">
                  <a:pos x="connsiteX557" y="connsiteY557"/>
                </a:cxn>
                <a:cxn ang="0">
                  <a:pos x="connsiteX558" y="connsiteY558"/>
                </a:cxn>
                <a:cxn ang="0">
                  <a:pos x="connsiteX559" y="connsiteY559"/>
                </a:cxn>
                <a:cxn ang="0">
                  <a:pos x="connsiteX560" y="connsiteY560"/>
                </a:cxn>
                <a:cxn ang="0">
                  <a:pos x="connsiteX561" y="connsiteY561"/>
                </a:cxn>
                <a:cxn ang="0">
                  <a:pos x="connsiteX562" y="connsiteY562"/>
                </a:cxn>
                <a:cxn ang="0">
                  <a:pos x="connsiteX563" y="connsiteY563"/>
                </a:cxn>
                <a:cxn ang="0">
                  <a:pos x="connsiteX564" y="connsiteY564"/>
                </a:cxn>
                <a:cxn ang="0">
                  <a:pos x="connsiteX565" y="connsiteY565"/>
                </a:cxn>
                <a:cxn ang="0">
                  <a:pos x="connsiteX566" y="connsiteY566"/>
                </a:cxn>
                <a:cxn ang="0">
                  <a:pos x="connsiteX567" y="connsiteY567"/>
                </a:cxn>
                <a:cxn ang="0">
                  <a:pos x="connsiteX568" y="connsiteY568"/>
                </a:cxn>
                <a:cxn ang="0">
                  <a:pos x="connsiteX569" y="connsiteY569"/>
                </a:cxn>
                <a:cxn ang="0">
                  <a:pos x="connsiteX570" y="connsiteY570"/>
                </a:cxn>
                <a:cxn ang="0">
                  <a:pos x="connsiteX571" y="connsiteY571"/>
                </a:cxn>
                <a:cxn ang="0">
                  <a:pos x="connsiteX572" y="connsiteY572"/>
                </a:cxn>
                <a:cxn ang="0">
                  <a:pos x="connsiteX573" y="connsiteY573"/>
                </a:cxn>
                <a:cxn ang="0">
                  <a:pos x="connsiteX574" y="connsiteY574"/>
                </a:cxn>
                <a:cxn ang="0">
                  <a:pos x="connsiteX575" y="connsiteY575"/>
                </a:cxn>
                <a:cxn ang="0">
                  <a:pos x="connsiteX576" y="connsiteY576"/>
                </a:cxn>
                <a:cxn ang="0">
                  <a:pos x="connsiteX577" y="connsiteY577"/>
                </a:cxn>
                <a:cxn ang="0">
                  <a:pos x="connsiteX578" y="connsiteY578"/>
                </a:cxn>
                <a:cxn ang="0">
                  <a:pos x="connsiteX579" y="connsiteY579"/>
                </a:cxn>
                <a:cxn ang="0">
                  <a:pos x="connsiteX580" y="connsiteY580"/>
                </a:cxn>
                <a:cxn ang="0">
                  <a:pos x="connsiteX581" y="connsiteY581"/>
                </a:cxn>
                <a:cxn ang="0">
                  <a:pos x="connsiteX582" y="connsiteY582"/>
                </a:cxn>
                <a:cxn ang="0">
                  <a:pos x="connsiteX583" y="connsiteY583"/>
                </a:cxn>
                <a:cxn ang="0">
                  <a:pos x="connsiteX584" y="connsiteY584"/>
                </a:cxn>
                <a:cxn ang="0">
                  <a:pos x="connsiteX585" y="connsiteY585"/>
                </a:cxn>
                <a:cxn ang="0">
                  <a:pos x="connsiteX586" y="connsiteY586"/>
                </a:cxn>
                <a:cxn ang="0">
                  <a:pos x="connsiteX587" y="connsiteY587"/>
                </a:cxn>
                <a:cxn ang="0">
                  <a:pos x="connsiteX588" y="connsiteY588"/>
                </a:cxn>
                <a:cxn ang="0">
                  <a:pos x="connsiteX589" y="connsiteY589"/>
                </a:cxn>
                <a:cxn ang="0">
                  <a:pos x="connsiteX590" y="connsiteY590"/>
                </a:cxn>
                <a:cxn ang="0">
                  <a:pos x="connsiteX591" y="connsiteY591"/>
                </a:cxn>
                <a:cxn ang="0">
                  <a:pos x="connsiteX592" y="connsiteY592"/>
                </a:cxn>
                <a:cxn ang="0">
                  <a:pos x="connsiteX593" y="connsiteY593"/>
                </a:cxn>
                <a:cxn ang="0">
                  <a:pos x="connsiteX594" y="connsiteY594"/>
                </a:cxn>
                <a:cxn ang="0">
                  <a:pos x="connsiteX595" y="connsiteY595"/>
                </a:cxn>
                <a:cxn ang="0">
                  <a:pos x="connsiteX596" y="connsiteY596"/>
                </a:cxn>
                <a:cxn ang="0">
                  <a:pos x="connsiteX597" y="connsiteY597"/>
                </a:cxn>
                <a:cxn ang="0">
                  <a:pos x="connsiteX598" y="connsiteY598"/>
                </a:cxn>
                <a:cxn ang="0">
                  <a:pos x="connsiteX599" y="connsiteY599"/>
                </a:cxn>
                <a:cxn ang="0">
                  <a:pos x="connsiteX600" y="connsiteY600"/>
                </a:cxn>
                <a:cxn ang="0">
                  <a:pos x="connsiteX601" y="connsiteY601"/>
                </a:cxn>
              </a:cxnLst>
              <a:rect l="l" t="t" r="r" b="b"/>
              <a:pathLst>
                <a:path w="8363529" h="1421726">
                  <a:moveTo>
                    <a:pt x="0" y="594897"/>
                  </a:moveTo>
                  <a:lnTo>
                    <a:pt x="8394" y="592700"/>
                  </a:lnTo>
                  <a:lnTo>
                    <a:pt x="75279" y="574863"/>
                  </a:lnTo>
                  <a:lnTo>
                    <a:pt x="83635" y="572589"/>
                  </a:lnTo>
                  <a:lnTo>
                    <a:pt x="92029" y="611717"/>
                  </a:lnTo>
                  <a:lnTo>
                    <a:pt x="158920" y="882740"/>
                  </a:lnTo>
                  <a:lnTo>
                    <a:pt x="167273" y="912151"/>
                  </a:lnTo>
                  <a:lnTo>
                    <a:pt x="175665" y="919448"/>
                  </a:lnTo>
                  <a:lnTo>
                    <a:pt x="242549" y="1001595"/>
                  </a:lnTo>
                  <a:lnTo>
                    <a:pt x="250903" y="1016306"/>
                  </a:lnTo>
                  <a:lnTo>
                    <a:pt x="259304" y="970180"/>
                  </a:lnTo>
                  <a:lnTo>
                    <a:pt x="326189" y="651416"/>
                  </a:lnTo>
                  <a:lnTo>
                    <a:pt x="334542" y="616934"/>
                  </a:lnTo>
                  <a:lnTo>
                    <a:pt x="342895" y="587716"/>
                  </a:lnTo>
                  <a:lnTo>
                    <a:pt x="409818" y="417780"/>
                  </a:lnTo>
                  <a:lnTo>
                    <a:pt x="418181" y="402169"/>
                  </a:lnTo>
                  <a:lnTo>
                    <a:pt x="426534" y="416647"/>
                  </a:lnTo>
                  <a:lnTo>
                    <a:pt x="493458" y="616449"/>
                  </a:lnTo>
                  <a:lnTo>
                    <a:pt x="501811" y="661094"/>
                  </a:lnTo>
                  <a:lnTo>
                    <a:pt x="510174" y="636183"/>
                  </a:lnTo>
                  <a:lnTo>
                    <a:pt x="577097" y="515053"/>
                  </a:lnTo>
                  <a:lnTo>
                    <a:pt x="585450" y="505598"/>
                  </a:lnTo>
                  <a:lnTo>
                    <a:pt x="593803" y="521896"/>
                  </a:lnTo>
                  <a:lnTo>
                    <a:pt x="660727" y="710239"/>
                  </a:lnTo>
                  <a:lnTo>
                    <a:pt x="669089" y="744790"/>
                  </a:lnTo>
                  <a:lnTo>
                    <a:pt x="677443" y="778517"/>
                  </a:lnTo>
                  <a:lnTo>
                    <a:pt x="744366" y="1003599"/>
                  </a:lnTo>
                  <a:lnTo>
                    <a:pt x="752719" y="1027155"/>
                  </a:lnTo>
                  <a:lnTo>
                    <a:pt x="761082" y="1015173"/>
                  </a:lnTo>
                  <a:lnTo>
                    <a:pt x="828005" y="940430"/>
                  </a:lnTo>
                  <a:lnTo>
                    <a:pt x="836358" y="933094"/>
                  </a:lnTo>
                  <a:lnTo>
                    <a:pt x="844712" y="916467"/>
                  </a:lnTo>
                  <a:lnTo>
                    <a:pt x="911635" y="752996"/>
                  </a:lnTo>
                  <a:lnTo>
                    <a:pt x="919988" y="727814"/>
                  </a:lnTo>
                  <a:lnTo>
                    <a:pt x="928351" y="762897"/>
                  </a:lnTo>
                  <a:lnTo>
                    <a:pt x="995274" y="978126"/>
                  </a:lnTo>
                  <a:lnTo>
                    <a:pt x="1003627" y="998914"/>
                  </a:lnTo>
                  <a:lnTo>
                    <a:pt x="1011981" y="1002089"/>
                  </a:lnTo>
                  <a:lnTo>
                    <a:pt x="1078904" y="1032826"/>
                  </a:lnTo>
                  <a:lnTo>
                    <a:pt x="1087267" y="1037442"/>
                  </a:lnTo>
                  <a:lnTo>
                    <a:pt x="1095620" y="1011312"/>
                  </a:lnTo>
                  <a:lnTo>
                    <a:pt x="1162543" y="790237"/>
                  </a:lnTo>
                  <a:lnTo>
                    <a:pt x="1170896" y="761010"/>
                  </a:lnTo>
                  <a:lnTo>
                    <a:pt x="1179259" y="733718"/>
                  </a:lnTo>
                  <a:lnTo>
                    <a:pt x="1246182" y="549497"/>
                  </a:lnTo>
                  <a:lnTo>
                    <a:pt x="1254536" y="529986"/>
                  </a:lnTo>
                  <a:lnTo>
                    <a:pt x="1262889" y="566618"/>
                  </a:lnTo>
                  <a:lnTo>
                    <a:pt x="1329812" y="1030184"/>
                  </a:lnTo>
                  <a:lnTo>
                    <a:pt x="1338175" y="1124157"/>
                  </a:lnTo>
                  <a:lnTo>
                    <a:pt x="1346528" y="1070783"/>
                  </a:lnTo>
                  <a:lnTo>
                    <a:pt x="1413451" y="790305"/>
                  </a:lnTo>
                  <a:lnTo>
                    <a:pt x="1421805" y="766836"/>
                  </a:lnTo>
                  <a:lnTo>
                    <a:pt x="1430158" y="794244"/>
                  </a:lnTo>
                  <a:lnTo>
                    <a:pt x="1497091" y="1055240"/>
                  </a:lnTo>
                  <a:lnTo>
                    <a:pt x="1505444" y="1094184"/>
                  </a:lnTo>
                  <a:lnTo>
                    <a:pt x="1513797" y="1093536"/>
                  </a:lnTo>
                  <a:lnTo>
                    <a:pt x="1580720" y="1087149"/>
                  </a:lnTo>
                  <a:lnTo>
                    <a:pt x="1589074" y="1086132"/>
                  </a:lnTo>
                  <a:lnTo>
                    <a:pt x="1597437" y="1079890"/>
                  </a:lnTo>
                  <a:lnTo>
                    <a:pt x="1664360" y="1047004"/>
                  </a:lnTo>
                  <a:lnTo>
                    <a:pt x="1672713" y="1044246"/>
                  </a:lnTo>
                  <a:lnTo>
                    <a:pt x="1681066" y="1037965"/>
                  </a:lnTo>
                  <a:lnTo>
                    <a:pt x="1747989" y="977555"/>
                  </a:lnTo>
                  <a:lnTo>
                    <a:pt x="1756352" y="968409"/>
                  </a:lnTo>
                  <a:lnTo>
                    <a:pt x="1764706" y="968903"/>
                  </a:lnTo>
                  <a:lnTo>
                    <a:pt x="1831629" y="973132"/>
                  </a:lnTo>
                  <a:lnTo>
                    <a:pt x="1839982" y="973703"/>
                  </a:lnTo>
                  <a:lnTo>
                    <a:pt x="1848345" y="967538"/>
                  </a:lnTo>
                  <a:lnTo>
                    <a:pt x="1915268" y="918693"/>
                  </a:lnTo>
                  <a:lnTo>
                    <a:pt x="1923621" y="912645"/>
                  </a:lnTo>
                  <a:lnTo>
                    <a:pt x="1931975" y="926213"/>
                  </a:lnTo>
                  <a:lnTo>
                    <a:pt x="1998898" y="1010441"/>
                  </a:lnTo>
                  <a:lnTo>
                    <a:pt x="2007260" y="1018686"/>
                  </a:lnTo>
                  <a:lnTo>
                    <a:pt x="2015614" y="947466"/>
                  </a:lnTo>
                  <a:lnTo>
                    <a:pt x="2082537" y="207583"/>
                  </a:lnTo>
                  <a:lnTo>
                    <a:pt x="2090890" y="86502"/>
                  </a:lnTo>
                  <a:lnTo>
                    <a:pt x="2099253" y="165658"/>
                  </a:lnTo>
                  <a:lnTo>
                    <a:pt x="2166176" y="710423"/>
                  </a:lnTo>
                  <a:lnTo>
                    <a:pt x="2174530" y="769101"/>
                  </a:lnTo>
                  <a:lnTo>
                    <a:pt x="2182883" y="779156"/>
                  </a:lnTo>
                  <a:lnTo>
                    <a:pt x="2249806" y="875104"/>
                  </a:lnTo>
                  <a:lnTo>
                    <a:pt x="2258159" y="889466"/>
                  </a:lnTo>
                  <a:lnTo>
                    <a:pt x="2266522" y="901534"/>
                  </a:lnTo>
                  <a:lnTo>
                    <a:pt x="2333445" y="980052"/>
                  </a:lnTo>
                  <a:lnTo>
                    <a:pt x="2341799" y="988065"/>
                  </a:lnTo>
                  <a:lnTo>
                    <a:pt x="2350152" y="952905"/>
                  </a:lnTo>
                  <a:lnTo>
                    <a:pt x="2417075" y="685744"/>
                  </a:lnTo>
                  <a:lnTo>
                    <a:pt x="2425438" y="654020"/>
                  </a:lnTo>
                  <a:lnTo>
                    <a:pt x="2433791" y="658481"/>
                  </a:lnTo>
                  <a:lnTo>
                    <a:pt x="2500714" y="692170"/>
                  </a:lnTo>
                  <a:lnTo>
                    <a:pt x="2509068" y="696138"/>
                  </a:lnTo>
                  <a:lnTo>
                    <a:pt x="2517430" y="720411"/>
                  </a:lnTo>
                  <a:lnTo>
                    <a:pt x="2584354" y="947427"/>
                  </a:lnTo>
                  <a:lnTo>
                    <a:pt x="2592707" y="980691"/>
                  </a:lnTo>
                  <a:lnTo>
                    <a:pt x="2601060" y="940808"/>
                  </a:lnTo>
                  <a:lnTo>
                    <a:pt x="2667983" y="617504"/>
                  </a:lnTo>
                  <a:lnTo>
                    <a:pt x="2676346" y="576557"/>
                  </a:lnTo>
                  <a:lnTo>
                    <a:pt x="2684699" y="591045"/>
                  </a:lnTo>
                  <a:lnTo>
                    <a:pt x="2751623" y="727930"/>
                  </a:lnTo>
                  <a:lnTo>
                    <a:pt x="2759976" y="748235"/>
                  </a:lnTo>
                  <a:lnTo>
                    <a:pt x="2768329" y="729218"/>
                  </a:lnTo>
                  <a:lnTo>
                    <a:pt x="2835262" y="615085"/>
                  </a:lnTo>
                  <a:lnTo>
                    <a:pt x="2843615" y="604275"/>
                  </a:lnTo>
                  <a:lnTo>
                    <a:pt x="2851968" y="584202"/>
                  </a:lnTo>
                  <a:lnTo>
                    <a:pt x="2918892" y="419183"/>
                  </a:lnTo>
                  <a:lnTo>
                    <a:pt x="2927245" y="397969"/>
                  </a:lnTo>
                  <a:lnTo>
                    <a:pt x="2935608" y="437097"/>
                  </a:lnTo>
                  <a:lnTo>
                    <a:pt x="3002531" y="737270"/>
                  </a:lnTo>
                  <a:lnTo>
                    <a:pt x="3010884" y="773262"/>
                  </a:lnTo>
                  <a:lnTo>
                    <a:pt x="3019238" y="760671"/>
                  </a:lnTo>
                  <a:lnTo>
                    <a:pt x="3086161" y="633154"/>
                  </a:lnTo>
                  <a:lnTo>
                    <a:pt x="3094523" y="612849"/>
                  </a:lnTo>
                  <a:lnTo>
                    <a:pt x="3102877" y="610169"/>
                  </a:lnTo>
                  <a:lnTo>
                    <a:pt x="3169800" y="594935"/>
                  </a:lnTo>
                  <a:lnTo>
                    <a:pt x="3178153" y="593571"/>
                  </a:lnTo>
                  <a:lnTo>
                    <a:pt x="3186516" y="626689"/>
                  </a:lnTo>
                  <a:lnTo>
                    <a:pt x="3253439" y="957976"/>
                  </a:lnTo>
                  <a:lnTo>
                    <a:pt x="3261792" y="1010063"/>
                  </a:lnTo>
                  <a:lnTo>
                    <a:pt x="3270146" y="1014525"/>
                  </a:lnTo>
                  <a:lnTo>
                    <a:pt x="3337069" y="1090555"/>
                  </a:lnTo>
                  <a:lnTo>
                    <a:pt x="3345432" y="1112292"/>
                  </a:lnTo>
                  <a:lnTo>
                    <a:pt x="3353785" y="873332"/>
                  </a:lnTo>
                  <a:lnTo>
                    <a:pt x="3420708" y="172733"/>
                  </a:lnTo>
                  <a:lnTo>
                    <a:pt x="3429061" y="137002"/>
                  </a:lnTo>
                  <a:lnTo>
                    <a:pt x="3437424" y="187018"/>
                  </a:lnTo>
                  <a:lnTo>
                    <a:pt x="3504347" y="645551"/>
                  </a:lnTo>
                  <a:lnTo>
                    <a:pt x="3512701" y="711371"/>
                  </a:lnTo>
                  <a:lnTo>
                    <a:pt x="3521054" y="663097"/>
                  </a:lnTo>
                  <a:lnTo>
                    <a:pt x="3587977" y="328452"/>
                  </a:lnTo>
                  <a:lnTo>
                    <a:pt x="3596330" y="292121"/>
                  </a:lnTo>
                  <a:lnTo>
                    <a:pt x="3604693" y="313596"/>
                  </a:lnTo>
                  <a:lnTo>
                    <a:pt x="3671616" y="540990"/>
                  </a:lnTo>
                  <a:lnTo>
                    <a:pt x="3679970" y="578909"/>
                  </a:lnTo>
                  <a:lnTo>
                    <a:pt x="3688323" y="618453"/>
                  </a:lnTo>
                  <a:lnTo>
                    <a:pt x="3755246" y="895863"/>
                  </a:lnTo>
                  <a:lnTo>
                    <a:pt x="3763609" y="926291"/>
                  </a:lnTo>
                  <a:lnTo>
                    <a:pt x="3771962" y="929504"/>
                  </a:lnTo>
                  <a:lnTo>
                    <a:pt x="3838885" y="957560"/>
                  </a:lnTo>
                  <a:lnTo>
                    <a:pt x="3847239" y="961373"/>
                  </a:lnTo>
                  <a:lnTo>
                    <a:pt x="3855602" y="989198"/>
                  </a:lnTo>
                  <a:lnTo>
                    <a:pt x="3922525" y="1189261"/>
                  </a:lnTo>
                  <a:lnTo>
                    <a:pt x="3930878" y="1211753"/>
                  </a:lnTo>
                  <a:lnTo>
                    <a:pt x="3939231" y="1174328"/>
                  </a:lnTo>
                  <a:lnTo>
                    <a:pt x="4006154" y="910796"/>
                  </a:lnTo>
                  <a:lnTo>
                    <a:pt x="4014517" y="881762"/>
                  </a:lnTo>
                  <a:lnTo>
                    <a:pt x="4022871" y="902434"/>
                  </a:lnTo>
                  <a:lnTo>
                    <a:pt x="4089755" y="1151798"/>
                  </a:lnTo>
                  <a:lnTo>
                    <a:pt x="4098147" y="1199655"/>
                  </a:lnTo>
                  <a:lnTo>
                    <a:pt x="4106500" y="1060350"/>
                  </a:lnTo>
                  <a:lnTo>
                    <a:pt x="4173394" y="347430"/>
                  </a:lnTo>
                  <a:lnTo>
                    <a:pt x="4181787" y="289169"/>
                  </a:lnTo>
                  <a:lnTo>
                    <a:pt x="4190140" y="352308"/>
                  </a:lnTo>
                  <a:lnTo>
                    <a:pt x="4257024" y="982549"/>
                  </a:lnTo>
                  <a:lnTo>
                    <a:pt x="4265416" y="1081439"/>
                  </a:lnTo>
                  <a:lnTo>
                    <a:pt x="4273779" y="965651"/>
                  </a:lnTo>
                  <a:lnTo>
                    <a:pt x="4340664" y="110387"/>
                  </a:lnTo>
                  <a:lnTo>
                    <a:pt x="4349055" y="11604"/>
                  </a:lnTo>
                  <a:lnTo>
                    <a:pt x="4357409" y="90809"/>
                  </a:lnTo>
                  <a:lnTo>
                    <a:pt x="4424303" y="719085"/>
                  </a:lnTo>
                  <a:lnTo>
                    <a:pt x="4432695" y="796964"/>
                  </a:lnTo>
                  <a:lnTo>
                    <a:pt x="4441048" y="826598"/>
                  </a:lnTo>
                  <a:lnTo>
                    <a:pt x="4507932" y="1077016"/>
                  </a:lnTo>
                  <a:lnTo>
                    <a:pt x="4516324" y="1110095"/>
                  </a:lnTo>
                  <a:lnTo>
                    <a:pt x="4524687" y="1111305"/>
                  </a:lnTo>
                  <a:lnTo>
                    <a:pt x="4591572" y="1121893"/>
                  </a:lnTo>
                  <a:lnTo>
                    <a:pt x="4599964" y="1123402"/>
                  </a:lnTo>
                  <a:lnTo>
                    <a:pt x="4608317" y="1066506"/>
                  </a:lnTo>
                  <a:lnTo>
                    <a:pt x="4675201" y="621550"/>
                  </a:lnTo>
                  <a:lnTo>
                    <a:pt x="4683603" y="567150"/>
                  </a:lnTo>
                  <a:lnTo>
                    <a:pt x="4691956" y="561024"/>
                  </a:lnTo>
                  <a:lnTo>
                    <a:pt x="4758840" y="517511"/>
                  </a:lnTo>
                  <a:lnTo>
                    <a:pt x="4767232" y="512634"/>
                  </a:lnTo>
                  <a:lnTo>
                    <a:pt x="4775595" y="536945"/>
                  </a:lnTo>
                  <a:lnTo>
                    <a:pt x="4842480" y="791447"/>
                  </a:lnTo>
                  <a:lnTo>
                    <a:pt x="4850872" y="833440"/>
                  </a:lnTo>
                  <a:lnTo>
                    <a:pt x="4859225" y="874765"/>
                  </a:lnTo>
                  <a:lnTo>
                    <a:pt x="4926109" y="1090855"/>
                  </a:lnTo>
                  <a:lnTo>
                    <a:pt x="4934501" y="1108885"/>
                  </a:lnTo>
                  <a:lnTo>
                    <a:pt x="4942864" y="1105604"/>
                  </a:lnTo>
                  <a:lnTo>
                    <a:pt x="5009749" y="1076222"/>
                  </a:lnTo>
                  <a:lnTo>
                    <a:pt x="5018141" y="1072070"/>
                  </a:lnTo>
                  <a:lnTo>
                    <a:pt x="5026494" y="1042126"/>
                  </a:lnTo>
                  <a:lnTo>
                    <a:pt x="5093388" y="757458"/>
                  </a:lnTo>
                  <a:lnTo>
                    <a:pt x="5101780" y="715039"/>
                  </a:lnTo>
                  <a:lnTo>
                    <a:pt x="5110134" y="715572"/>
                  </a:lnTo>
                  <a:lnTo>
                    <a:pt x="5177018" y="718591"/>
                  </a:lnTo>
                  <a:lnTo>
                    <a:pt x="5185410" y="718862"/>
                  </a:lnTo>
                  <a:lnTo>
                    <a:pt x="5193773" y="735528"/>
                  </a:lnTo>
                  <a:lnTo>
                    <a:pt x="5260657" y="880475"/>
                  </a:lnTo>
                  <a:lnTo>
                    <a:pt x="5269049" y="900170"/>
                  </a:lnTo>
                  <a:lnTo>
                    <a:pt x="5277403" y="881569"/>
                  </a:lnTo>
                  <a:lnTo>
                    <a:pt x="5344287" y="709484"/>
                  </a:lnTo>
                  <a:lnTo>
                    <a:pt x="5352650" y="684573"/>
                  </a:lnTo>
                  <a:lnTo>
                    <a:pt x="5361042" y="702526"/>
                  </a:lnTo>
                  <a:lnTo>
                    <a:pt x="5427926" y="1057437"/>
                  </a:lnTo>
                  <a:lnTo>
                    <a:pt x="5436280" y="1179699"/>
                  </a:lnTo>
                  <a:lnTo>
                    <a:pt x="5444672" y="1198107"/>
                  </a:lnTo>
                  <a:lnTo>
                    <a:pt x="5511566" y="1258856"/>
                  </a:lnTo>
                  <a:lnTo>
                    <a:pt x="5519919" y="1262262"/>
                  </a:lnTo>
                  <a:lnTo>
                    <a:pt x="5528311" y="1174560"/>
                  </a:lnTo>
                  <a:lnTo>
                    <a:pt x="5595195" y="688725"/>
                  </a:lnTo>
                  <a:lnTo>
                    <a:pt x="5603558" y="646045"/>
                  </a:lnTo>
                  <a:lnTo>
                    <a:pt x="5611950" y="597539"/>
                  </a:lnTo>
                  <a:lnTo>
                    <a:pt x="5678835" y="211406"/>
                  </a:lnTo>
                  <a:lnTo>
                    <a:pt x="5687188" y="163355"/>
                  </a:lnTo>
                  <a:lnTo>
                    <a:pt x="5695580" y="227394"/>
                  </a:lnTo>
                  <a:lnTo>
                    <a:pt x="5762474" y="954454"/>
                  </a:lnTo>
                  <a:lnTo>
                    <a:pt x="5770827" y="1085300"/>
                  </a:lnTo>
                  <a:lnTo>
                    <a:pt x="5779219" y="1061667"/>
                  </a:lnTo>
                  <a:lnTo>
                    <a:pt x="5846103" y="923871"/>
                  </a:lnTo>
                  <a:lnTo>
                    <a:pt x="5854457" y="911173"/>
                  </a:lnTo>
                  <a:lnTo>
                    <a:pt x="5862858" y="925120"/>
                  </a:lnTo>
                  <a:lnTo>
                    <a:pt x="5929743" y="1107414"/>
                  </a:lnTo>
                  <a:lnTo>
                    <a:pt x="5938096" y="1145633"/>
                  </a:lnTo>
                  <a:lnTo>
                    <a:pt x="5946488" y="1136826"/>
                  </a:lnTo>
                  <a:lnTo>
                    <a:pt x="6013372" y="1092520"/>
                  </a:lnTo>
                  <a:lnTo>
                    <a:pt x="6021735" y="1088968"/>
                  </a:lnTo>
                  <a:lnTo>
                    <a:pt x="6030127" y="1080839"/>
                  </a:lnTo>
                  <a:lnTo>
                    <a:pt x="6097011" y="1007199"/>
                  </a:lnTo>
                  <a:lnTo>
                    <a:pt x="6105365" y="996756"/>
                  </a:lnTo>
                  <a:lnTo>
                    <a:pt x="6113767" y="991849"/>
                  </a:lnTo>
                  <a:lnTo>
                    <a:pt x="6180651" y="958044"/>
                  </a:lnTo>
                  <a:lnTo>
                    <a:pt x="6189004" y="954386"/>
                  </a:lnTo>
                  <a:lnTo>
                    <a:pt x="6197396" y="969842"/>
                  </a:lnTo>
                  <a:lnTo>
                    <a:pt x="6264280" y="1127303"/>
                  </a:lnTo>
                  <a:lnTo>
                    <a:pt x="6272644" y="1152552"/>
                  </a:lnTo>
                  <a:lnTo>
                    <a:pt x="6281036" y="1134484"/>
                  </a:lnTo>
                  <a:lnTo>
                    <a:pt x="6347920" y="1011689"/>
                  </a:lnTo>
                  <a:lnTo>
                    <a:pt x="6356273" y="998614"/>
                  </a:lnTo>
                  <a:lnTo>
                    <a:pt x="6364665" y="1010141"/>
                  </a:lnTo>
                  <a:lnTo>
                    <a:pt x="6431560" y="1094446"/>
                  </a:lnTo>
                  <a:lnTo>
                    <a:pt x="6439913" y="1104124"/>
                  </a:lnTo>
                  <a:lnTo>
                    <a:pt x="6448305" y="1099440"/>
                  </a:lnTo>
                  <a:lnTo>
                    <a:pt x="6515189" y="1057398"/>
                  </a:lnTo>
                  <a:lnTo>
                    <a:pt x="6523542" y="1051466"/>
                  </a:lnTo>
                  <a:lnTo>
                    <a:pt x="6531944" y="1038652"/>
                  </a:lnTo>
                  <a:lnTo>
                    <a:pt x="6598829" y="924142"/>
                  </a:lnTo>
                  <a:lnTo>
                    <a:pt x="6607182" y="908106"/>
                  </a:lnTo>
                  <a:lnTo>
                    <a:pt x="6615535" y="924703"/>
                  </a:lnTo>
                  <a:lnTo>
                    <a:pt x="6682458" y="1017215"/>
                  </a:lnTo>
                  <a:lnTo>
                    <a:pt x="6690821" y="1025413"/>
                  </a:lnTo>
                  <a:lnTo>
                    <a:pt x="6699174" y="1003676"/>
                  </a:lnTo>
                  <a:lnTo>
                    <a:pt x="6766097" y="785998"/>
                  </a:lnTo>
                  <a:lnTo>
                    <a:pt x="6774451" y="751748"/>
                  </a:lnTo>
                  <a:lnTo>
                    <a:pt x="6782814" y="770804"/>
                  </a:lnTo>
                  <a:lnTo>
                    <a:pt x="6849737" y="948105"/>
                  </a:lnTo>
                  <a:lnTo>
                    <a:pt x="6858090" y="973926"/>
                  </a:lnTo>
                  <a:lnTo>
                    <a:pt x="6866443" y="925991"/>
                  </a:lnTo>
                  <a:lnTo>
                    <a:pt x="6933366" y="667675"/>
                  </a:lnTo>
                  <a:lnTo>
                    <a:pt x="6941729" y="645551"/>
                  </a:lnTo>
                  <a:lnTo>
                    <a:pt x="6950083" y="694474"/>
                  </a:lnTo>
                  <a:lnTo>
                    <a:pt x="7017006" y="1171076"/>
                  </a:lnTo>
                  <a:lnTo>
                    <a:pt x="7025359" y="1243932"/>
                  </a:lnTo>
                  <a:lnTo>
                    <a:pt x="7033712" y="1172063"/>
                  </a:lnTo>
                  <a:lnTo>
                    <a:pt x="7100645" y="557356"/>
                  </a:lnTo>
                  <a:lnTo>
                    <a:pt x="7108998" y="475170"/>
                  </a:lnTo>
                  <a:lnTo>
                    <a:pt x="7117351" y="553233"/>
                  </a:lnTo>
                  <a:lnTo>
                    <a:pt x="7184274" y="1202907"/>
                  </a:lnTo>
                  <a:lnTo>
                    <a:pt x="7192628" y="1287406"/>
                  </a:lnTo>
                  <a:lnTo>
                    <a:pt x="7200991" y="1252546"/>
                  </a:lnTo>
                  <a:lnTo>
                    <a:pt x="7267914" y="994608"/>
                  </a:lnTo>
                  <a:lnTo>
                    <a:pt x="7276267" y="964780"/>
                  </a:lnTo>
                  <a:lnTo>
                    <a:pt x="7284620" y="925352"/>
                  </a:lnTo>
                  <a:lnTo>
                    <a:pt x="7351543" y="591645"/>
                  </a:lnTo>
                  <a:lnTo>
                    <a:pt x="7359906" y="547523"/>
                  </a:lnTo>
                  <a:lnTo>
                    <a:pt x="7368260" y="528099"/>
                  </a:lnTo>
                  <a:lnTo>
                    <a:pt x="7435183" y="398501"/>
                  </a:lnTo>
                  <a:lnTo>
                    <a:pt x="7443536" y="384932"/>
                  </a:lnTo>
                  <a:lnTo>
                    <a:pt x="7451899" y="415776"/>
                  </a:lnTo>
                  <a:lnTo>
                    <a:pt x="7518822" y="712397"/>
                  </a:lnTo>
                  <a:lnTo>
                    <a:pt x="7527175" y="757158"/>
                  </a:lnTo>
                  <a:lnTo>
                    <a:pt x="7535528" y="673985"/>
                  </a:lnTo>
                  <a:lnTo>
                    <a:pt x="7602452" y="116291"/>
                  </a:lnTo>
                  <a:lnTo>
                    <a:pt x="7610815" y="57652"/>
                  </a:lnTo>
                  <a:lnTo>
                    <a:pt x="7619168" y="146757"/>
                  </a:lnTo>
                  <a:lnTo>
                    <a:pt x="7686091" y="920058"/>
                  </a:lnTo>
                  <a:lnTo>
                    <a:pt x="7694444" y="1025035"/>
                  </a:lnTo>
                  <a:lnTo>
                    <a:pt x="7702798" y="957599"/>
                  </a:lnTo>
                  <a:lnTo>
                    <a:pt x="7769731" y="292537"/>
                  </a:lnTo>
                  <a:lnTo>
                    <a:pt x="7778084" y="189553"/>
                  </a:lnTo>
                  <a:lnTo>
                    <a:pt x="7786437" y="303154"/>
                  </a:lnTo>
                  <a:lnTo>
                    <a:pt x="7853360" y="858429"/>
                  </a:lnTo>
                  <a:lnTo>
                    <a:pt x="7861713" y="901980"/>
                  </a:lnTo>
                  <a:lnTo>
                    <a:pt x="7870077" y="884065"/>
                  </a:lnTo>
                  <a:lnTo>
                    <a:pt x="7937000" y="683431"/>
                  </a:lnTo>
                  <a:lnTo>
                    <a:pt x="7945353" y="647826"/>
                  </a:lnTo>
                  <a:lnTo>
                    <a:pt x="7953706" y="684496"/>
                  </a:lnTo>
                  <a:lnTo>
                    <a:pt x="8020629" y="964248"/>
                  </a:lnTo>
                  <a:lnTo>
                    <a:pt x="8028992" y="997588"/>
                  </a:lnTo>
                  <a:lnTo>
                    <a:pt x="8037346" y="997966"/>
                  </a:lnTo>
                  <a:lnTo>
                    <a:pt x="8104268" y="1001372"/>
                  </a:lnTo>
                  <a:lnTo>
                    <a:pt x="8112622" y="1001866"/>
                  </a:lnTo>
                  <a:lnTo>
                    <a:pt x="8120985" y="1017022"/>
                  </a:lnTo>
                  <a:lnTo>
                    <a:pt x="8187908" y="1097243"/>
                  </a:lnTo>
                  <a:lnTo>
                    <a:pt x="8196261" y="1104008"/>
                  </a:lnTo>
                  <a:lnTo>
                    <a:pt x="8204614" y="1019896"/>
                  </a:lnTo>
                  <a:lnTo>
                    <a:pt x="8271537" y="143776"/>
                  </a:lnTo>
                  <a:lnTo>
                    <a:pt x="8279900" y="0"/>
                  </a:lnTo>
                  <a:lnTo>
                    <a:pt x="8288254" y="84082"/>
                  </a:lnTo>
                  <a:lnTo>
                    <a:pt x="8355177" y="763507"/>
                  </a:lnTo>
                  <a:lnTo>
                    <a:pt x="8363530" y="849283"/>
                  </a:lnTo>
                  <a:lnTo>
                    <a:pt x="8363530" y="1278628"/>
                  </a:lnTo>
                  <a:lnTo>
                    <a:pt x="8355177" y="1182119"/>
                  </a:lnTo>
                  <a:lnTo>
                    <a:pt x="8288254" y="417818"/>
                  </a:lnTo>
                  <a:lnTo>
                    <a:pt x="8279900" y="323235"/>
                  </a:lnTo>
                  <a:lnTo>
                    <a:pt x="8271537" y="435132"/>
                  </a:lnTo>
                  <a:lnTo>
                    <a:pt x="8204614" y="1117170"/>
                  </a:lnTo>
                  <a:lnTo>
                    <a:pt x="8196261" y="1182641"/>
                  </a:lnTo>
                  <a:lnTo>
                    <a:pt x="8187908" y="1198446"/>
                  </a:lnTo>
                  <a:lnTo>
                    <a:pt x="8120985" y="1386266"/>
                  </a:lnTo>
                  <a:lnTo>
                    <a:pt x="8112622" y="1421726"/>
                  </a:lnTo>
                  <a:lnTo>
                    <a:pt x="8104268" y="1384902"/>
                  </a:lnTo>
                  <a:lnTo>
                    <a:pt x="8037346" y="1128435"/>
                  </a:lnTo>
                  <a:lnTo>
                    <a:pt x="8028992" y="1100456"/>
                  </a:lnTo>
                  <a:lnTo>
                    <a:pt x="8020629" y="1064318"/>
                  </a:lnTo>
                  <a:lnTo>
                    <a:pt x="7953706" y="761349"/>
                  </a:lnTo>
                  <a:lnTo>
                    <a:pt x="7945353" y="721659"/>
                  </a:lnTo>
                  <a:lnTo>
                    <a:pt x="7937000" y="769517"/>
                  </a:lnTo>
                  <a:lnTo>
                    <a:pt x="7870077" y="1039330"/>
                  </a:lnTo>
                  <a:lnTo>
                    <a:pt x="7861713" y="1063408"/>
                  </a:lnTo>
                  <a:lnTo>
                    <a:pt x="7853360" y="1019557"/>
                  </a:lnTo>
                  <a:lnTo>
                    <a:pt x="7786437" y="460237"/>
                  </a:lnTo>
                  <a:lnTo>
                    <a:pt x="7778084" y="345804"/>
                  </a:lnTo>
                  <a:lnTo>
                    <a:pt x="7769731" y="458872"/>
                  </a:lnTo>
                  <a:lnTo>
                    <a:pt x="7702798" y="1189038"/>
                  </a:lnTo>
                  <a:lnTo>
                    <a:pt x="7694444" y="1263095"/>
                  </a:lnTo>
                  <a:lnTo>
                    <a:pt x="7686091" y="1173796"/>
                  </a:lnTo>
                  <a:lnTo>
                    <a:pt x="7619168" y="515847"/>
                  </a:lnTo>
                  <a:lnTo>
                    <a:pt x="7610815" y="440049"/>
                  </a:lnTo>
                  <a:lnTo>
                    <a:pt x="7602452" y="482313"/>
                  </a:lnTo>
                  <a:lnTo>
                    <a:pt x="7535528" y="884288"/>
                  </a:lnTo>
                  <a:lnTo>
                    <a:pt x="7527175" y="944253"/>
                  </a:lnTo>
                  <a:lnTo>
                    <a:pt x="7518822" y="900247"/>
                  </a:lnTo>
                  <a:lnTo>
                    <a:pt x="7451899" y="608504"/>
                  </a:lnTo>
                  <a:lnTo>
                    <a:pt x="7443536" y="578154"/>
                  </a:lnTo>
                  <a:lnTo>
                    <a:pt x="7435183" y="578115"/>
                  </a:lnTo>
                  <a:lnTo>
                    <a:pt x="7368260" y="577699"/>
                  </a:lnTo>
                  <a:lnTo>
                    <a:pt x="7359906" y="577621"/>
                  </a:lnTo>
                  <a:lnTo>
                    <a:pt x="7351543" y="653119"/>
                  </a:lnTo>
                  <a:lnTo>
                    <a:pt x="7284620" y="1224121"/>
                  </a:lnTo>
                  <a:lnTo>
                    <a:pt x="7276267" y="1291596"/>
                  </a:lnTo>
                  <a:lnTo>
                    <a:pt x="7267914" y="1300442"/>
                  </a:lnTo>
                  <a:lnTo>
                    <a:pt x="7200991" y="1376734"/>
                  </a:lnTo>
                  <a:lnTo>
                    <a:pt x="7192628" y="1387060"/>
                  </a:lnTo>
                  <a:lnTo>
                    <a:pt x="7184274" y="1376772"/>
                  </a:lnTo>
                  <a:lnTo>
                    <a:pt x="7117351" y="1297955"/>
                  </a:lnTo>
                  <a:lnTo>
                    <a:pt x="7108998" y="1288461"/>
                  </a:lnTo>
                  <a:lnTo>
                    <a:pt x="7100645" y="1294809"/>
                  </a:lnTo>
                  <a:lnTo>
                    <a:pt x="7033712" y="1342260"/>
                  </a:lnTo>
                  <a:lnTo>
                    <a:pt x="7025359" y="1347777"/>
                  </a:lnTo>
                  <a:lnTo>
                    <a:pt x="7017006" y="1317533"/>
                  </a:lnTo>
                  <a:lnTo>
                    <a:pt x="6950083" y="1119589"/>
                  </a:lnTo>
                  <a:lnTo>
                    <a:pt x="6941729" y="1099246"/>
                  </a:lnTo>
                  <a:lnTo>
                    <a:pt x="6933366" y="1103746"/>
                  </a:lnTo>
                  <a:lnTo>
                    <a:pt x="6866443" y="1156027"/>
                  </a:lnTo>
                  <a:lnTo>
                    <a:pt x="6858090" y="1165744"/>
                  </a:lnTo>
                  <a:lnTo>
                    <a:pt x="6849737" y="1126015"/>
                  </a:lnTo>
                  <a:lnTo>
                    <a:pt x="6782814" y="853367"/>
                  </a:lnTo>
                  <a:lnTo>
                    <a:pt x="6774451" y="824033"/>
                  </a:lnTo>
                  <a:lnTo>
                    <a:pt x="6766097" y="877184"/>
                  </a:lnTo>
                  <a:lnTo>
                    <a:pt x="6699174" y="1214588"/>
                  </a:lnTo>
                  <a:lnTo>
                    <a:pt x="6690821" y="1248239"/>
                  </a:lnTo>
                  <a:lnTo>
                    <a:pt x="6682458" y="1246419"/>
                  </a:lnTo>
                  <a:lnTo>
                    <a:pt x="6615535" y="1225854"/>
                  </a:lnTo>
                  <a:lnTo>
                    <a:pt x="6607182" y="1222156"/>
                  </a:lnTo>
                  <a:lnTo>
                    <a:pt x="6598829" y="1213456"/>
                  </a:lnTo>
                  <a:lnTo>
                    <a:pt x="6531944" y="1151043"/>
                  </a:lnTo>
                  <a:lnTo>
                    <a:pt x="6523542" y="1144046"/>
                  </a:lnTo>
                  <a:lnTo>
                    <a:pt x="6515189" y="1154788"/>
                  </a:lnTo>
                  <a:lnTo>
                    <a:pt x="6448305" y="1231070"/>
                  </a:lnTo>
                  <a:lnTo>
                    <a:pt x="6439913" y="1239538"/>
                  </a:lnTo>
                  <a:lnTo>
                    <a:pt x="6431560" y="1233306"/>
                  </a:lnTo>
                  <a:lnTo>
                    <a:pt x="6364665" y="1178983"/>
                  </a:lnTo>
                  <a:lnTo>
                    <a:pt x="6356273" y="1171570"/>
                  </a:lnTo>
                  <a:lnTo>
                    <a:pt x="6347920" y="1172518"/>
                  </a:lnTo>
                  <a:lnTo>
                    <a:pt x="6281036" y="1181509"/>
                  </a:lnTo>
                  <a:lnTo>
                    <a:pt x="6272644" y="1182874"/>
                  </a:lnTo>
                  <a:lnTo>
                    <a:pt x="6264280" y="1157391"/>
                  </a:lnTo>
                  <a:lnTo>
                    <a:pt x="6197396" y="998614"/>
                  </a:lnTo>
                  <a:lnTo>
                    <a:pt x="6189004" y="983033"/>
                  </a:lnTo>
                  <a:lnTo>
                    <a:pt x="6180651" y="988481"/>
                  </a:lnTo>
                  <a:lnTo>
                    <a:pt x="6113767" y="1038613"/>
                  </a:lnTo>
                  <a:lnTo>
                    <a:pt x="6105365" y="1045911"/>
                  </a:lnTo>
                  <a:lnTo>
                    <a:pt x="6097011" y="1067831"/>
                  </a:lnTo>
                  <a:lnTo>
                    <a:pt x="6030127" y="1222418"/>
                  </a:lnTo>
                  <a:lnTo>
                    <a:pt x="6021735" y="1239470"/>
                  </a:lnTo>
                  <a:lnTo>
                    <a:pt x="6013372" y="1236180"/>
                  </a:lnTo>
                  <a:lnTo>
                    <a:pt x="5946488" y="1195126"/>
                  </a:lnTo>
                  <a:lnTo>
                    <a:pt x="5938096" y="1186996"/>
                  </a:lnTo>
                  <a:lnTo>
                    <a:pt x="5929743" y="1171115"/>
                  </a:lnTo>
                  <a:lnTo>
                    <a:pt x="5862858" y="1095317"/>
                  </a:lnTo>
                  <a:lnTo>
                    <a:pt x="5854457" y="1089529"/>
                  </a:lnTo>
                  <a:lnTo>
                    <a:pt x="5846103" y="1104801"/>
                  </a:lnTo>
                  <a:lnTo>
                    <a:pt x="5779219" y="1270546"/>
                  </a:lnTo>
                  <a:lnTo>
                    <a:pt x="5770827" y="1298932"/>
                  </a:lnTo>
                  <a:lnTo>
                    <a:pt x="5762474" y="1153646"/>
                  </a:lnTo>
                  <a:lnTo>
                    <a:pt x="5695580" y="346298"/>
                  </a:lnTo>
                  <a:lnTo>
                    <a:pt x="5687188" y="275184"/>
                  </a:lnTo>
                  <a:lnTo>
                    <a:pt x="5678835" y="335294"/>
                  </a:lnTo>
                  <a:lnTo>
                    <a:pt x="5611950" y="818362"/>
                  </a:lnTo>
                  <a:lnTo>
                    <a:pt x="5603558" y="879033"/>
                  </a:lnTo>
                  <a:lnTo>
                    <a:pt x="5595195" y="914687"/>
                  </a:lnTo>
                  <a:lnTo>
                    <a:pt x="5528311" y="1320940"/>
                  </a:lnTo>
                  <a:lnTo>
                    <a:pt x="5519919" y="1394318"/>
                  </a:lnTo>
                  <a:lnTo>
                    <a:pt x="5511566" y="1387699"/>
                  </a:lnTo>
                  <a:lnTo>
                    <a:pt x="5444672" y="1269598"/>
                  </a:lnTo>
                  <a:lnTo>
                    <a:pt x="5436280" y="1233760"/>
                  </a:lnTo>
                  <a:lnTo>
                    <a:pt x="5427926" y="1117770"/>
                  </a:lnTo>
                  <a:lnTo>
                    <a:pt x="5361042" y="781043"/>
                  </a:lnTo>
                  <a:lnTo>
                    <a:pt x="5352650" y="764000"/>
                  </a:lnTo>
                  <a:lnTo>
                    <a:pt x="5344287" y="784750"/>
                  </a:lnTo>
                  <a:lnTo>
                    <a:pt x="5277403" y="928033"/>
                  </a:lnTo>
                  <a:lnTo>
                    <a:pt x="5269049" y="943527"/>
                  </a:lnTo>
                  <a:lnTo>
                    <a:pt x="5260657" y="955973"/>
                  </a:lnTo>
                  <a:lnTo>
                    <a:pt x="5193773" y="1047566"/>
                  </a:lnTo>
                  <a:lnTo>
                    <a:pt x="5185410" y="1058115"/>
                  </a:lnTo>
                  <a:lnTo>
                    <a:pt x="5177018" y="1034713"/>
                  </a:lnTo>
                  <a:lnTo>
                    <a:pt x="5110134" y="778624"/>
                  </a:lnTo>
                  <a:lnTo>
                    <a:pt x="5101780" y="734318"/>
                  </a:lnTo>
                  <a:lnTo>
                    <a:pt x="5093388" y="779388"/>
                  </a:lnTo>
                  <a:lnTo>
                    <a:pt x="5026494" y="1081632"/>
                  </a:lnTo>
                  <a:lnTo>
                    <a:pt x="5018141" y="1113463"/>
                  </a:lnTo>
                  <a:lnTo>
                    <a:pt x="5009749" y="1123519"/>
                  </a:lnTo>
                  <a:lnTo>
                    <a:pt x="4942864" y="1194855"/>
                  </a:lnTo>
                  <a:lnTo>
                    <a:pt x="4934501" y="1202762"/>
                  </a:lnTo>
                  <a:lnTo>
                    <a:pt x="4926109" y="1192019"/>
                  </a:lnTo>
                  <a:lnTo>
                    <a:pt x="4859225" y="1062876"/>
                  </a:lnTo>
                  <a:lnTo>
                    <a:pt x="4850872" y="1038158"/>
                  </a:lnTo>
                  <a:lnTo>
                    <a:pt x="4842480" y="1018386"/>
                  </a:lnTo>
                  <a:lnTo>
                    <a:pt x="4775595" y="898350"/>
                  </a:lnTo>
                  <a:lnTo>
                    <a:pt x="4767232" y="886901"/>
                  </a:lnTo>
                  <a:lnTo>
                    <a:pt x="4758840" y="874310"/>
                  </a:lnTo>
                  <a:lnTo>
                    <a:pt x="4691956" y="761765"/>
                  </a:lnTo>
                  <a:lnTo>
                    <a:pt x="4683603" y="745999"/>
                  </a:lnTo>
                  <a:lnTo>
                    <a:pt x="4675201" y="796702"/>
                  </a:lnTo>
                  <a:lnTo>
                    <a:pt x="4608317" y="1211491"/>
                  </a:lnTo>
                  <a:lnTo>
                    <a:pt x="4599964" y="1264488"/>
                  </a:lnTo>
                  <a:lnTo>
                    <a:pt x="4591572" y="1256436"/>
                  </a:lnTo>
                  <a:lnTo>
                    <a:pt x="4524687" y="1198716"/>
                  </a:lnTo>
                  <a:lnTo>
                    <a:pt x="4516324" y="1192252"/>
                  </a:lnTo>
                  <a:lnTo>
                    <a:pt x="4507932" y="1170660"/>
                  </a:lnTo>
                  <a:lnTo>
                    <a:pt x="4441048" y="1007082"/>
                  </a:lnTo>
                  <a:lnTo>
                    <a:pt x="4432695" y="987726"/>
                  </a:lnTo>
                  <a:lnTo>
                    <a:pt x="4424303" y="895970"/>
                  </a:lnTo>
                  <a:lnTo>
                    <a:pt x="4357409" y="155458"/>
                  </a:lnTo>
                  <a:lnTo>
                    <a:pt x="4349055" y="62075"/>
                  </a:lnTo>
                  <a:lnTo>
                    <a:pt x="4340664" y="167516"/>
                  </a:lnTo>
                  <a:lnTo>
                    <a:pt x="4273779" y="1080161"/>
                  </a:lnTo>
                  <a:lnTo>
                    <a:pt x="4265416" y="1203701"/>
                  </a:lnTo>
                  <a:lnTo>
                    <a:pt x="4257024" y="1126509"/>
                  </a:lnTo>
                  <a:lnTo>
                    <a:pt x="4190140" y="634364"/>
                  </a:lnTo>
                  <a:lnTo>
                    <a:pt x="4181787" y="585064"/>
                  </a:lnTo>
                  <a:lnTo>
                    <a:pt x="4173394" y="626882"/>
                  </a:lnTo>
                  <a:lnTo>
                    <a:pt x="4106500" y="1138606"/>
                  </a:lnTo>
                  <a:lnTo>
                    <a:pt x="4098147" y="1238599"/>
                  </a:lnTo>
                  <a:lnTo>
                    <a:pt x="4089755" y="1199239"/>
                  </a:lnTo>
                  <a:lnTo>
                    <a:pt x="4022871" y="994153"/>
                  </a:lnTo>
                  <a:lnTo>
                    <a:pt x="4014517" y="977139"/>
                  </a:lnTo>
                  <a:lnTo>
                    <a:pt x="4006154" y="999708"/>
                  </a:lnTo>
                  <a:lnTo>
                    <a:pt x="3939231" y="1204417"/>
                  </a:lnTo>
                  <a:lnTo>
                    <a:pt x="3930878" y="1233490"/>
                  </a:lnTo>
                  <a:lnTo>
                    <a:pt x="3922525" y="1216176"/>
                  </a:lnTo>
                  <a:lnTo>
                    <a:pt x="3855602" y="1062083"/>
                  </a:lnTo>
                  <a:lnTo>
                    <a:pt x="3847239" y="1040655"/>
                  </a:lnTo>
                  <a:lnTo>
                    <a:pt x="3838885" y="1036649"/>
                  </a:lnTo>
                  <a:lnTo>
                    <a:pt x="3771962" y="1007537"/>
                  </a:lnTo>
                  <a:lnTo>
                    <a:pt x="3763609" y="1004208"/>
                  </a:lnTo>
                  <a:lnTo>
                    <a:pt x="3755246" y="1011205"/>
                  </a:lnTo>
                  <a:lnTo>
                    <a:pt x="3688323" y="1074828"/>
                  </a:lnTo>
                  <a:lnTo>
                    <a:pt x="3679970" y="1083897"/>
                  </a:lnTo>
                  <a:lnTo>
                    <a:pt x="3671616" y="999824"/>
                  </a:lnTo>
                  <a:lnTo>
                    <a:pt x="3604693" y="495920"/>
                  </a:lnTo>
                  <a:lnTo>
                    <a:pt x="3596330" y="448294"/>
                  </a:lnTo>
                  <a:lnTo>
                    <a:pt x="3587977" y="490142"/>
                  </a:lnTo>
                  <a:lnTo>
                    <a:pt x="3521054" y="875781"/>
                  </a:lnTo>
                  <a:lnTo>
                    <a:pt x="3512701" y="931430"/>
                  </a:lnTo>
                  <a:lnTo>
                    <a:pt x="3504347" y="864255"/>
                  </a:lnTo>
                  <a:lnTo>
                    <a:pt x="3437424" y="396236"/>
                  </a:lnTo>
                  <a:lnTo>
                    <a:pt x="3429061" y="345156"/>
                  </a:lnTo>
                  <a:lnTo>
                    <a:pt x="3420708" y="373290"/>
                  </a:lnTo>
                  <a:lnTo>
                    <a:pt x="3353785" y="924326"/>
                  </a:lnTo>
                  <a:lnTo>
                    <a:pt x="3345432" y="1112292"/>
                  </a:lnTo>
                  <a:lnTo>
                    <a:pt x="3337069" y="1138490"/>
                  </a:lnTo>
                  <a:lnTo>
                    <a:pt x="3270146" y="1230238"/>
                  </a:lnTo>
                  <a:lnTo>
                    <a:pt x="3261792" y="1235648"/>
                  </a:lnTo>
                  <a:lnTo>
                    <a:pt x="3253439" y="1156066"/>
                  </a:lnTo>
                  <a:lnTo>
                    <a:pt x="3186516" y="650090"/>
                  </a:lnTo>
                  <a:lnTo>
                    <a:pt x="3178153" y="599513"/>
                  </a:lnTo>
                  <a:lnTo>
                    <a:pt x="3169800" y="611194"/>
                  </a:lnTo>
                  <a:lnTo>
                    <a:pt x="3102877" y="740405"/>
                  </a:lnTo>
                  <a:lnTo>
                    <a:pt x="3094523" y="763091"/>
                  </a:lnTo>
                  <a:lnTo>
                    <a:pt x="3086161" y="777453"/>
                  </a:lnTo>
                  <a:lnTo>
                    <a:pt x="3019238" y="867623"/>
                  </a:lnTo>
                  <a:lnTo>
                    <a:pt x="3010884" y="876546"/>
                  </a:lnTo>
                  <a:lnTo>
                    <a:pt x="3002531" y="835066"/>
                  </a:lnTo>
                  <a:lnTo>
                    <a:pt x="2935608" y="489232"/>
                  </a:lnTo>
                  <a:lnTo>
                    <a:pt x="2927245" y="444172"/>
                  </a:lnTo>
                  <a:lnTo>
                    <a:pt x="2918892" y="489494"/>
                  </a:lnTo>
                  <a:lnTo>
                    <a:pt x="2851968" y="842102"/>
                  </a:lnTo>
                  <a:lnTo>
                    <a:pt x="2843615" y="885014"/>
                  </a:lnTo>
                  <a:lnTo>
                    <a:pt x="2835262" y="884859"/>
                  </a:lnTo>
                  <a:lnTo>
                    <a:pt x="2768329" y="883495"/>
                  </a:lnTo>
                  <a:lnTo>
                    <a:pt x="2759976" y="883272"/>
                  </a:lnTo>
                  <a:lnTo>
                    <a:pt x="2751623" y="913361"/>
                  </a:lnTo>
                  <a:lnTo>
                    <a:pt x="2684699" y="1116260"/>
                  </a:lnTo>
                  <a:lnTo>
                    <a:pt x="2676346" y="1137697"/>
                  </a:lnTo>
                  <a:lnTo>
                    <a:pt x="2667983" y="1141626"/>
                  </a:lnTo>
                  <a:lnTo>
                    <a:pt x="2601060" y="1172586"/>
                  </a:lnTo>
                  <a:lnTo>
                    <a:pt x="2592707" y="1176409"/>
                  </a:lnTo>
                  <a:lnTo>
                    <a:pt x="2584354" y="1160489"/>
                  </a:lnTo>
                  <a:lnTo>
                    <a:pt x="2517430" y="1052027"/>
                  </a:lnTo>
                  <a:lnTo>
                    <a:pt x="2509068" y="1040462"/>
                  </a:lnTo>
                  <a:lnTo>
                    <a:pt x="2500714" y="1012676"/>
                  </a:lnTo>
                  <a:lnTo>
                    <a:pt x="2433791" y="777491"/>
                  </a:lnTo>
                  <a:lnTo>
                    <a:pt x="2425438" y="746377"/>
                  </a:lnTo>
                  <a:lnTo>
                    <a:pt x="2417075" y="776582"/>
                  </a:lnTo>
                  <a:lnTo>
                    <a:pt x="2350152" y="1031045"/>
                  </a:lnTo>
                  <a:lnTo>
                    <a:pt x="2341799" y="1064541"/>
                  </a:lnTo>
                  <a:lnTo>
                    <a:pt x="2333445" y="1058947"/>
                  </a:lnTo>
                  <a:lnTo>
                    <a:pt x="2266522" y="1004053"/>
                  </a:lnTo>
                  <a:lnTo>
                    <a:pt x="2258159" y="995624"/>
                  </a:lnTo>
                  <a:lnTo>
                    <a:pt x="2249806" y="993398"/>
                  </a:lnTo>
                  <a:lnTo>
                    <a:pt x="2182883" y="978581"/>
                  </a:lnTo>
                  <a:lnTo>
                    <a:pt x="2174530" y="977023"/>
                  </a:lnTo>
                  <a:lnTo>
                    <a:pt x="2166176" y="913477"/>
                  </a:lnTo>
                  <a:lnTo>
                    <a:pt x="2099253" y="323613"/>
                  </a:lnTo>
                  <a:lnTo>
                    <a:pt x="2090890" y="237866"/>
                  </a:lnTo>
                  <a:lnTo>
                    <a:pt x="2082537" y="357408"/>
                  </a:lnTo>
                  <a:lnTo>
                    <a:pt x="2015614" y="1087836"/>
                  </a:lnTo>
                  <a:lnTo>
                    <a:pt x="2007260" y="1158108"/>
                  </a:lnTo>
                  <a:lnTo>
                    <a:pt x="1998898" y="1156443"/>
                  </a:lnTo>
                  <a:lnTo>
                    <a:pt x="1931975" y="1139129"/>
                  </a:lnTo>
                  <a:lnTo>
                    <a:pt x="1923621" y="1136371"/>
                  </a:lnTo>
                  <a:lnTo>
                    <a:pt x="1915268" y="1134638"/>
                  </a:lnTo>
                  <a:lnTo>
                    <a:pt x="1848345" y="1120838"/>
                  </a:lnTo>
                  <a:lnTo>
                    <a:pt x="1839982" y="1119096"/>
                  </a:lnTo>
                  <a:lnTo>
                    <a:pt x="1831629" y="1123973"/>
                  </a:lnTo>
                  <a:lnTo>
                    <a:pt x="1764706" y="1160682"/>
                  </a:lnTo>
                  <a:lnTo>
                    <a:pt x="1756352" y="1164989"/>
                  </a:lnTo>
                  <a:lnTo>
                    <a:pt x="1747989" y="1169682"/>
                  </a:lnTo>
                  <a:lnTo>
                    <a:pt x="1681066" y="1200488"/>
                  </a:lnTo>
                  <a:lnTo>
                    <a:pt x="1672713" y="1203701"/>
                  </a:lnTo>
                  <a:lnTo>
                    <a:pt x="1664360" y="1205143"/>
                  </a:lnTo>
                  <a:lnTo>
                    <a:pt x="1597437" y="1222186"/>
                  </a:lnTo>
                  <a:lnTo>
                    <a:pt x="1589074" y="1225399"/>
                  </a:lnTo>
                  <a:lnTo>
                    <a:pt x="1580720" y="1227102"/>
                  </a:lnTo>
                  <a:lnTo>
                    <a:pt x="1513797" y="1237651"/>
                  </a:lnTo>
                  <a:lnTo>
                    <a:pt x="1505444" y="1238706"/>
                  </a:lnTo>
                  <a:lnTo>
                    <a:pt x="1497091" y="1209333"/>
                  </a:lnTo>
                  <a:lnTo>
                    <a:pt x="1430158" y="1012483"/>
                  </a:lnTo>
                  <a:lnTo>
                    <a:pt x="1421805" y="991811"/>
                  </a:lnTo>
                  <a:lnTo>
                    <a:pt x="1413451" y="1005989"/>
                  </a:lnTo>
                  <a:lnTo>
                    <a:pt x="1346528" y="1175538"/>
                  </a:lnTo>
                  <a:lnTo>
                    <a:pt x="1338175" y="1207785"/>
                  </a:lnTo>
                  <a:lnTo>
                    <a:pt x="1329812" y="1149494"/>
                  </a:lnTo>
                  <a:lnTo>
                    <a:pt x="1262889" y="861990"/>
                  </a:lnTo>
                  <a:lnTo>
                    <a:pt x="1254536" y="839266"/>
                  </a:lnTo>
                  <a:lnTo>
                    <a:pt x="1246182" y="848034"/>
                  </a:lnTo>
                  <a:lnTo>
                    <a:pt x="1179259" y="930830"/>
                  </a:lnTo>
                  <a:lnTo>
                    <a:pt x="1170896" y="943111"/>
                  </a:lnTo>
                  <a:lnTo>
                    <a:pt x="1162543" y="954531"/>
                  </a:lnTo>
                  <a:lnTo>
                    <a:pt x="1095620" y="1040762"/>
                  </a:lnTo>
                  <a:lnTo>
                    <a:pt x="1087267" y="1050934"/>
                  </a:lnTo>
                  <a:lnTo>
                    <a:pt x="1078904" y="1058076"/>
                  </a:lnTo>
                  <a:lnTo>
                    <a:pt x="1011981" y="1105295"/>
                  </a:lnTo>
                  <a:lnTo>
                    <a:pt x="1003627" y="1110211"/>
                  </a:lnTo>
                  <a:lnTo>
                    <a:pt x="995274" y="1094223"/>
                  </a:lnTo>
                  <a:lnTo>
                    <a:pt x="928351" y="928904"/>
                  </a:lnTo>
                  <a:lnTo>
                    <a:pt x="919988" y="901950"/>
                  </a:lnTo>
                  <a:lnTo>
                    <a:pt x="911635" y="923116"/>
                  </a:lnTo>
                  <a:lnTo>
                    <a:pt x="844712" y="1060612"/>
                  </a:lnTo>
                  <a:lnTo>
                    <a:pt x="836358" y="1074596"/>
                  </a:lnTo>
                  <a:lnTo>
                    <a:pt x="828005" y="1080229"/>
                  </a:lnTo>
                  <a:lnTo>
                    <a:pt x="761082" y="1137619"/>
                  </a:lnTo>
                  <a:lnTo>
                    <a:pt x="752719" y="1146843"/>
                  </a:lnTo>
                  <a:lnTo>
                    <a:pt x="744366" y="1142758"/>
                  </a:lnTo>
                  <a:lnTo>
                    <a:pt x="677443" y="1104008"/>
                  </a:lnTo>
                  <a:lnTo>
                    <a:pt x="669089" y="1098191"/>
                  </a:lnTo>
                  <a:lnTo>
                    <a:pt x="660727" y="1054563"/>
                  </a:lnTo>
                  <a:lnTo>
                    <a:pt x="593803" y="816736"/>
                  </a:lnTo>
                  <a:lnTo>
                    <a:pt x="585450" y="796170"/>
                  </a:lnTo>
                  <a:lnTo>
                    <a:pt x="577097" y="797680"/>
                  </a:lnTo>
                  <a:lnTo>
                    <a:pt x="510174" y="817036"/>
                  </a:lnTo>
                  <a:lnTo>
                    <a:pt x="501811" y="821042"/>
                  </a:lnTo>
                  <a:lnTo>
                    <a:pt x="493458" y="775304"/>
                  </a:lnTo>
                  <a:lnTo>
                    <a:pt x="426534" y="570586"/>
                  </a:lnTo>
                  <a:lnTo>
                    <a:pt x="418181" y="555769"/>
                  </a:lnTo>
                  <a:lnTo>
                    <a:pt x="409818" y="586690"/>
                  </a:lnTo>
                  <a:lnTo>
                    <a:pt x="342895" y="923155"/>
                  </a:lnTo>
                  <a:lnTo>
                    <a:pt x="334542" y="981000"/>
                  </a:lnTo>
                  <a:lnTo>
                    <a:pt x="326189" y="1002466"/>
                  </a:lnTo>
                  <a:lnTo>
                    <a:pt x="259304" y="1200865"/>
                  </a:lnTo>
                  <a:lnTo>
                    <a:pt x="250903" y="1229560"/>
                  </a:lnTo>
                  <a:lnTo>
                    <a:pt x="242549" y="1207069"/>
                  </a:lnTo>
                  <a:lnTo>
                    <a:pt x="175665" y="1081371"/>
                  </a:lnTo>
                  <a:lnTo>
                    <a:pt x="167273" y="1070251"/>
                  </a:lnTo>
                  <a:lnTo>
                    <a:pt x="158920" y="1052375"/>
                  </a:lnTo>
                  <a:lnTo>
                    <a:pt x="92029" y="887501"/>
                  </a:lnTo>
                  <a:lnTo>
                    <a:pt x="83635" y="863684"/>
                  </a:lnTo>
                  <a:lnTo>
                    <a:pt x="75279" y="845276"/>
                  </a:lnTo>
                  <a:lnTo>
                    <a:pt x="8394" y="699651"/>
                  </a:lnTo>
                  <a:lnTo>
                    <a:pt x="0" y="681660"/>
                  </a:lnTo>
                  <a:close/>
                </a:path>
              </a:pathLst>
            </a:custGeom>
            <a:solidFill>
              <a:srgbClr val="FDB462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03" name="Freeform: Shape 3002">
              <a:extLst>
                <a:ext uri="{FF2B5EF4-FFF2-40B4-BE49-F238E27FC236}">
                  <a16:creationId xmlns:a16="http://schemas.microsoft.com/office/drawing/2014/main" id="{E01E6BAB-FBB0-FCCC-7569-A8E5D672186A}"/>
                </a:ext>
              </a:extLst>
            </p:cNvPr>
            <p:cNvSpPr/>
            <p:nvPr/>
          </p:nvSpPr>
          <p:spPr>
            <a:xfrm>
              <a:off x="1961705" y="3110303"/>
              <a:ext cx="8363529" cy="1517480"/>
            </a:xfrm>
            <a:custGeom>
              <a:avLst/>
              <a:gdLst>
                <a:gd name="connsiteX0" fmla="*/ 0 w 8363529"/>
                <a:gd name="connsiteY0" fmla="*/ 619585 h 1517480"/>
                <a:gd name="connsiteX1" fmla="*/ 8394 w 8363529"/>
                <a:gd name="connsiteY1" fmla="*/ 637577 h 1517480"/>
                <a:gd name="connsiteX2" fmla="*/ 75279 w 8363529"/>
                <a:gd name="connsiteY2" fmla="*/ 783201 h 1517480"/>
                <a:gd name="connsiteX3" fmla="*/ 83635 w 8363529"/>
                <a:gd name="connsiteY3" fmla="*/ 801609 h 1517480"/>
                <a:gd name="connsiteX4" fmla="*/ 92029 w 8363529"/>
                <a:gd name="connsiteY4" fmla="*/ 825427 h 1517480"/>
                <a:gd name="connsiteX5" fmla="*/ 158920 w 8363529"/>
                <a:gd name="connsiteY5" fmla="*/ 990301 h 1517480"/>
                <a:gd name="connsiteX6" fmla="*/ 167273 w 8363529"/>
                <a:gd name="connsiteY6" fmla="*/ 1008176 h 1517480"/>
                <a:gd name="connsiteX7" fmla="*/ 175665 w 8363529"/>
                <a:gd name="connsiteY7" fmla="*/ 1019296 h 1517480"/>
                <a:gd name="connsiteX8" fmla="*/ 242549 w 8363529"/>
                <a:gd name="connsiteY8" fmla="*/ 1144994 h 1517480"/>
                <a:gd name="connsiteX9" fmla="*/ 250903 w 8363529"/>
                <a:gd name="connsiteY9" fmla="*/ 1167486 h 1517480"/>
                <a:gd name="connsiteX10" fmla="*/ 259304 w 8363529"/>
                <a:gd name="connsiteY10" fmla="*/ 1138790 h 1517480"/>
                <a:gd name="connsiteX11" fmla="*/ 326189 w 8363529"/>
                <a:gd name="connsiteY11" fmla="*/ 940391 h 1517480"/>
                <a:gd name="connsiteX12" fmla="*/ 334542 w 8363529"/>
                <a:gd name="connsiteY12" fmla="*/ 918926 h 1517480"/>
                <a:gd name="connsiteX13" fmla="*/ 342895 w 8363529"/>
                <a:gd name="connsiteY13" fmla="*/ 861080 h 1517480"/>
                <a:gd name="connsiteX14" fmla="*/ 409818 w 8363529"/>
                <a:gd name="connsiteY14" fmla="*/ 524615 h 1517480"/>
                <a:gd name="connsiteX15" fmla="*/ 418181 w 8363529"/>
                <a:gd name="connsiteY15" fmla="*/ 493694 h 1517480"/>
                <a:gd name="connsiteX16" fmla="*/ 426534 w 8363529"/>
                <a:gd name="connsiteY16" fmla="*/ 508511 h 1517480"/>
                <a:gd name="connsiteX17" fmla="*/ 493458 w 8363529"/>
                <a:gd name="connsiteY17" fmla="*/ 713229 h 1517480"/>
                <a:gd name="connsiteX18" fmla="*/ 501811 w 8363529"/>
                <a:gd name="connsiteY18" fmla="*/ 758968 h 1517480"/>
                <a:gd name="connsiteX19" fmla="*/ 510174 w 8363529"/>
                <a:gd name="connsiteY19" fmla="*/ 754961 h 1517480"/>
                <a:gd name="connsiteX20" fmla="*/ 577097 w 8363529"/>
                <a:gd name="connsiteY20" fmla="*/ 735605 h 1517480"/>
                <a:gd name="connsiteX21" fmla="*/ 585450 w 8363529"/>
                <a:gd name="connsiteY21" fmla="*/ 734095 h 1517480"/>
                <a:gd name="connsiteX22" fmla="*/ 593803 w 8363529"/>
                <a:gd name="connsiteY22" fmla="*/ 754661 h 1517480"/>
                <a:gd name="connsiteX23" fmla="*/ 660727 w 8363529"/>
                <a:gd name="connsiteY23" fmla="*/ 992488 h 1517480"/>
                <a:gd name="connsiteX24" fmla="*/ 669089 w 8363529"/>
                <a:gd name="connsiteY24" fmla="*/ 1036116 h 1517480"/>
                <a:gd name="connsiteX25" fmla="*/ 677443 w 8363529"/>
                <a:gd name="connsiteY25" fmla="*/ 1041933 h 1517480"/>
                <a:gd name="connsiteX26" fmla="*/ 744366 w 8363529"/>
                <a:gd name="connsiteY26" fmla="*/ 1080684 h 1517480"/>
                <a:gd name="connsiteX27" fmla="*/ 752719 w 8363529"/>
                <a:gd name="connsiteY27" fmla="*/ 1084768 h 1517480"/>
                <a:gd name="connsiteX28" fmla="*/ 761082 w 8363529"/>
                <a:gd name="connsiteY28" fmla="*/ 1075545 h 1517480"/>
                <a:gd name="connsiteX29" fmla="*/ 828005 w 8363529"/>
                <a:gd name="connsiteY29" fmla="*/ 1018154 h 1517480"/>
                <a:gd name="connsiteX30" fmla="*/ 836358 w 8363529"/>
                <a:gd name="connsiteY30" fmla="*/ 1012522 h 1517480"/>
                <a:gd name="connsiteX31" fmla="*/ 844712 w 8363529"/>
                <a:gd name="connsiteY31" fmla="*/ 998537 h 1517480"/>
                <a:gd name="connsiteX32" fmla="*/ 911635 w 8363529"/>
                <a:gd name="connsiteY32" fmla="*/ 861042 h 1517480"/>
                <a:gd name="connsiteX33" fmla="*/ 919988 w 8363529"/>
                <a:gd name="connsiteY33" fmla="*/ 839876 h 1517480"/>
                <a:gd name="connsiteX34" fmla="*/ 928351 w 8363529"/>
                <a:gd name="connsiteY34" fmla="*/ 866829 h 1517480"/>
                <a:gd name="connsiteX35" fmla="*/ 995274 w 8363529"/>
                <a:gd name="connsiteY35" fmla="*/ 1032148 h 1517480"/>
                <a:gd name="connsiteX36" fmla="*/ 1003627 w 8363529"/>
                <a:gd name="connsiteY36" fmla="*/ 1048137 h 1517480"/>
                <a:gd name="connsiteX37" fmla="*/ 1011981 w 8363529"/>
                <a:gd name="connsiteY37" fmla="*/ 1043220 h 1517480"/>
                <a:gd name="connsiteX38" fmla="*/ 1078904 w 8363529"/>
                <a:gd name="connsiteY38" fmla="*/ 996001 h 1517480"/>
                <a:gd name="connsiteX39" fmla="*/ 1087267 w 8363529"/>
                <a:gd name="connsiteY39" fmla="*/ 988859 h 1517480"/>
                <a:gd name="connsiteX40" fmla="*/ 1095620 w 8363529"/>
                <a:gd name="connsiteY40" fmla="*/ 978687 h 1517480"/>
                <a:gd name="connsiteX41" fmla="*/ 1162543 w 8363529"/>
                <a:gd name="connsiteY41" fmla="*/ 892456 h 1517480"/>
                <a:gd name="connsiteX42" fmla="*/ 1170896 w 8363529"/>
                <a:gd name="connsiteY42" fmla="*/ 881036 h 1517480"/>
                <a:gd name="connsiteX43" fmla="*/ 1179259 w 8363529"/>
                <a:gd name="connsiteY43" fmla="*/ 868755 h 1517480"/>
                <a:gd name="connsiteX44" fmla="*/ 1246182 w 8363529"/>
                <a:gd name="connsiteY44" fmla="*/ 785960 h 1517480"/>
                <a:gd name="connsiteX45" fmla="*/ 1254536 w 8363529"/>
                <a:gd name="connsiteY45" fmla="*/ 777191 h 1517480"/>
                <a:gd name="connsiteX46" fmla="*/ 1262889 w 8363529"/>
                <a:gd name="connsiteY46" fmla="*/ 799915 h 1517480"/>
                <a:gd name="connsiteX47" fmla="*/ 1329812 w 8363529"/>
                <a:gd name="connsiteY47" fmla="*/ 1087419 h 1517480"/>
                <a:gd name="connsiteX48" fmla="*/ 1338175 w 8363529"/>
                <a:gd name="connsiteY48" fmla="*/ 1145710 h 1517480"/>
                <a:gd name="connsiteX49" fmla="*/ 1346528 w 8363529"/>
                <a:gd name="connsiteY49" fmla="*/ 1113463 h 1517480"/>
                <a:gd name="connsiteX50" fmla="*/ 1413451 w 8363529"/>
                <a:gd name="connsiteY50" fmla="*/ 943914 h 1517480"/>
                <a:gd name="connsiteX51" fmla="*/ 1421805 w 8363529"/>
                <a:gd name="connsiteY51" fmla="*/ 929736 h 1517480"/>
                <a:gd name="connsiteX52" fmla="*/ 1430158 w 8363529"/>
                <a:gd name="connsiteY52" fmla="*/ 950408 h 1517480"/>
                <a:gd name="connsiteX53" fmla="*/ 1497091 w 8363529"/>
                <a:gd name="connsiteY53" fmla="*/ 1147259 h 1517480"/>
                <a:gd name="connsiteX54" fmla="*/ 1505444 w 8363529"/>
                <a:gd name="connsiteY54" fmla="*/ 1176631 h 1517480"/>
                <a:gd name="connsiteX55" fmla="*/ 1513797 w 8363529"/>
                <a:gd name="connsiteY55" fmla="*/ 1175576 h 1517480"/>
                <a:gd name="connsiteX56" fmla="*/ 1580720 w 8363529"/>
                <a:gd name="connsiteY56" fmla="*/ 1165027 h 1517480"/>
                <a:gd name="connsiteX57" fmla="*/ 1589074 w 8363529"/>
                <a:gd name="connsiteY57" fmla="*/ 1163324 h 1517480"/>
                <a:gd name="connsiteX58" fmla="*/ 1597437 w 8363529"/>
                <a:gd name="connsiteY58" fmla="*/ 1160111 h 1517480"/>
                <a:gd name="connsiteX59" fmla="*/ 1664360 w 8363529"/>
                <a:gd name="connsiteY59" fmla="*/ 1143068 h 1517480"/>
                <a:gd name="connsiteX60" fmla="*/ 1672713 w 8363529"/>
                <a:gd name="connsiteY60" fmla="*/ 1141626 h 1517480"/>
                <a:gd name="connsiteX61" fmla="*/ 1681066 w 8363529"/>
                <a:gd name="connsiteY61" fmla="*/ 1138413 h 1517480"/>
                <a:gd name="connsiteX62" fmla="*/ 1747989 w 8363529"/>
                <a:gd name="connsiteY62" fmla="*/ 1107608 h 1517480"/>
                <a:gd name="connsiteX63" fmla="*/ 1756352 w 8363529"/>
                <a:gd name="connsiteY63" fmla="*/ 1102914 h 1517480"/>
                <a:gd name="connsiteX64" fmla="*/ 1764706 w 8363529"/>
                <a:gd name="connsiteY64" fmla="*/ 1098607 h 1517480"/>
                <a:gd name="connsiteX65" fmla="*/ 1831629 w 8363529"/>
                <a:gd name="connsiteY65" fmla="*/ 1061899 h 1517480"/>
                <a:gd name="connsiteX66" fmla="*/ 1839982 w 8363529"/>
                <a:gd name="connsiteY66" fmla="*/ 1057021 h 1517480"/>
                <a:gd name="connsiteX67" fmla="*/ 1848345 w 8363529"/>
                <a:gd name="connsiteY67" fmla="*/ 1058763 h 1517480"/>
                <a:gd name="connsiteX68" fmla="*/ 1915268 w 8363529"/>
                <a:gd name="connsiteY68" fmla="*/ 1072564 h 1517480"/>
                <a:gd name="connsiteX69" fmla="*/ 1923621 w 8363529"/>
                <a:gd name="connsiteY69" fmla="*/ 1074296 h 1517480"/>
                <a:gd name="connsiteX70" fmla="*/ 1931975 w 8363529"/>
                <a:gd name="connsiteY70" fmla="*/ 1077054 h 1517480"/>
                <a:gd name="connsiteX71" fmla="*/ 1998898 w 8363529"/>
                <a:gd name="connsiteY71" fmla="*/ 1094368 h 1517480"/>
                <a:gd name="connsiteX72" fmla="*/ 2007260 w 8363529"/>
                <a:gd name="connsiteY72" fmla="*/ 1096033 h 1517480"/>
                <a:gd name="connsiteX73" fmla="*/ 2015614 w 8363529"/>
                <a:gd name="connsiteY73" fmla="*/ 1025761 h 1517480"/>
                <a:gd name="connsiteX74" fmla="*/ 2082537 w 8363529"/>
                <a:gd name="connsiteY74" fmla="*/ 295334 h 1517480"/>
                <a:gd name="connsiteX75" fmla="*/ 2090890 w 8363529"/>
                <a:gd name="connsiteY75" fmla="*/ 175791 h 1517480"/>
                <a:gd name="connsiteX76" fmla="*/ 2099253 w 8363529"/>
                <a:gd name="connsiteY76" fmla="*/ 261538 h 1517480"/>
                <a:gd name="connsiteX77" fmla="*/ 2166176 w 8363529"/>
                <a:gd name="connsiteY77" fmla="*/ 851402 h 1517480"/>
                <a:gd name="connsiteX78" fmla="*/ 2174530 w 8363529"/>
                <a:gd name="connsiteY78" fmla="*/ 914948 h 1517480"/>
                <a:gd name="connsiteX79" fmla="*/ 2182883 w 8363529"/>
                <a:gd name="connsiteY79" fmla="*/ 916506 h 1517480"/>
                <a:gd name="connsiteX80" fmla="*/ 2249806 w 8363529"/>
                <a:gd name="connsiteY80" fmla="*/ 931323 h 1517480"/>
                <a:gd name="connsiteX81" fmla="*/ 2258159 w 8363529"/>
                <a:gd name="connsiteY81" fmla="*/ 933549 h 1517480"/>
                <a:gd name="connsiteX82" fmla="*/ 2266522 w 8363529"/>
                <a:gd name="connsiteY82" fmla="*/ 941979 h 1517480"/>
                <a:gd name="connsiteX83" fmla="*/ 2333445 w 8363529"/>
                <a:gd name="connsiteY83" fmla="*/ 996872 h 1517480"/>
                <a:gd name="connsiteX84" fmla="*/ 2341799 w 8363529"/>
                <a:gd name="connsiteY84" fmla="*/ 1002466 h 1517480"/>
                <a:gd name="connsiteX85" fmla="*/ 2350152 w 8363529"/>
                <a:gd name="connsiteY85" fmla="*/ 968971 h 1517480"/>
                <a:gd name="connsiteX86" fmla="*/ 2417075 w 8363529"/>
                <a:gd name="connsiteY86" fmla="*/ 714507 h 1517480"/>
                <a:gd name="connsiteX87" fmla="*/ 2425438 w 8363529"/>
                <a:gd name="connsiteY87" fmla="*/ 684302 h 1517480"/>
                <a:gd name="connsiteX88" fmla="*/ 2433791 w 8363529"/>
                <a:gd name="connsiteY88" fmla="*/ 715417 h 1517480"/>
                <a:gd name="connsiteX89" fmla="*/ 2500714 w 8363529"/>
                <a:gd name="connsiteY89" fmla="*/ 950602 h 1517480"/>
                <a:gd name="connsiteX90" fmla="*/ 2509068 w 8363529"/>
                <a:gd name="connsiteY90" fmla="*/ 978387 h 1517480"/>
                <a:gd name="connsiteX91" fmla="*/ 2517430 w 8363529"/>
                <a:gd name="connsiteY91" fmla="*/ 989953 h 1517480"/>
                <a:gd name="connsiteX92" fmla="*/ 2584354 w 8363529"/>
                <a:gd name="connsiteY92" fmla="*/ 1098414 h 1517480"/>
                <a:gd name="connsiteX93" fmla="*/ 2592707 w 8363529"/>
                <a:gd name="connsiteY93" fmla="*/ 1114334 h 1517480"/>
                <a:gd name="connsiteX94" fmla="*/ 2601060 w 8363529"/>
                <a:gd name="connsiteY94" fmla="*/ 1110511 h 1517480"/>
                <a:gd name="connsiteX95" fmla="*/ 2667983 w 8363529"/>
                <a:gd name="connsiteY95" fmla="*/ 1079551 h 1517480"/>
                <a:gd name="connsiteX96" fmla="*/ 2676346 w 8363529"/>
                <a:gd name="connsiteY96" fmla="*/ 1075622 h 1517480"/>
                <a:gd name="connsiteX97" fmla="*/ 2684699 w 8363529"/>
                <a:gd name="connsiteY97" fmla="*/ 1054185 h 1517480"/>
                <a:gd name="connsiteX98" fmla="*/ 2751623 w 8363529"/>
                <a:gd name="connsiteY98" fmla="*/ 851286 h 1517480"/>
                <a:gd name="connsiteX99" fmla="*/ 2759976 w 8363529"/>
                <a:gd name="connsiteY99" fmla="*/ 821197 h 1517480"/>
                <a:gd name="connsiteX100" fmla="*/ 2768329 w 8363529"/>
                <a:gd name="connsiteY100" fmla="*/ 821420 h 1517480"/>
                <a:gd name="connsiteX101" fmla="*/ 2835262 w 8363529"/>
                <a:gd name="connsiteY101" fmla="*/ 822784 h 1517480"/>
                <a:gd name="connsiteX102" fmla="*/ 2843615 w 8363529"/>
                <a:gd name="connsiteY102" fmla="*/ 822939 h 1517480"/>
                <a:gd name="connsiteX103" fmla="*/ 2851968 w 8363529"/>
                <a:gd name="connsiteY103" fmla="*/ 780027 h 1517480"/>
                <a:gd name="connsiteX104" fmla="*/ 2918892 w 8363529"/>
                <a:gd name="connsiteY104" fmla="*/ 427419 h 1517480"/>
                <a:gd name="connsiteX105" fmla="*/ 2927245 w 8363529"/>
                <a:gd name="connsiteY105" fmla="*/ 382097 h 1517480"/>
                <a:gd name="connsiteX106" fmla="*/ 2935608 w 8363529"/>
                <a:gd name="connsiteY106" fmla="*/ 427158 h 1517480"/>
                <a:gd name="connsiteX107" fmla="*/ 3002531 w 8363529"/>
                <a:gd name="connsiteY107" fmla="*/ 772991 h 1517480"/>
                <a:gd name="connsiteX108" fmla="*/ 3010884 w 8363529"/>
                <a:gd name="connsiteY108" fmla="*/ 814471 h 1517480"/>
                <a:gd name="connsiteX109" fmla="*/ 3019238 w 8363529"/>
                <a:gd name="connsiteY109" fmla="*/ 805548 h 1517480"/>
                <a:gd name="connsiteX110" fmla="*/ 3086161 w 8363529"/>
                <a:gd name="connsiteY110" fmla="*/ 715378 h 1517480"/>
                <a:gd name="connsiteX111" fmla="*/ 3094523 w 8363529"/>
                <a:gd name="connsiteY111" fmla="*/ 701016 h 1517480"/>
                <a:gd name="connsiteX112" fmla="*/ 3102877 w 8363529"/>
                <a:gd name="connsiteY112" fmla="*/ 678331 h 1517480"/>
                <a:gd name="connsiteX113" fmla="*/ 3169800 w 8363529"/>
                <a:gd name="connsiteY113" fmla="*/ 549120 h 1517480"/>
                <a:gd name="connsiteX114" fmla="*/ 3178153 w 8363529"/>
                <a:gd name="connsiteY114" fmla="*/ 537438 h 1517480"/>
                <a:gd name="connsiteX115" fmla="*/ 3186516 w 8363529"/>
                <a:gd name="connsiteY115" fmla="*/ 588016 h 1517480"/>
                <a:gd name="connsiteX116" fmla="*/ 3253439 w 8363529"/>
                <a:gd name="connsiteY116" fmla="*/ 1093991 h 1517480"/>
                <a:gd name="connsiteX117" fmla="*/ 3261792 w 8363529"/>
                <a:gd name="connsiteY117" fmla="*/ 1173573 h 1517480"/>
                <a:gd name="connsiteX118" fmla="*/ 3270146 w 8363529"/>
                <a:gd name="connsiteY118" fmla="*/ 1168163 h 1517480"/>
                <a:gd name="connsiteX119" fmla="*/ 3337069 w 8363529"/>
                <a:gd name="connsiteY119" fmla="*/ 1076416 h 1517480"/>
                <a:gd name="connsiteX120" fmla="*/ 3345432 w 8363529"/>
                <a:gd name="connsiteY120" fmla="*/ 1050217 h 1517480"/>
                <a:gd name="connsiteX121" fmla="*/ 3353785 w 8363529"/>
                <a:gd name="connsiteY121" fmla="*/ 862251 h 1517480"/>
                <a:gd name="connsiteX122" fmla="*/ 3420708 w 8363529"/>
                <a:gd name="connsiteY122" fmla="*/ 311215 h 1517480"/>
                <a:gd name="connsiteX123" fmla="*/ 3429061 w 8363529"/>
                <a:gd name="connsiteY123" fmla="*/ 283081 h 1517480"/>
                <a:gd name="connsiteX124" fmla="*/ 3437424 w 8363529"/>
                <a:gd name="connsiteY124" fmla="*/ 334162 h 1517480"/>
                <a:gd name="connsiteX125" fmla="*/ 3504347 w 8363529"/>
                <a:gd name="connsiteY125" fmla="*/ 802180 h 1517480"/>
                <a:gd name="connsiteX126" fmla="*/ 3512701 w 8363529"/>
                <a:gd name="connsiteY126" fmla="*/ 869355 h 1517480"/>
                <a:gd name="connsiteX127" fmla="*/ 3521054 w 8363529"/>
                <a:gd name="connsiteY127" fmla="*/ 813707 h 1517480"/>
                <a:gd name="connsiteX128" fmla="*/ 3587977 w 8363529"/>
                <a:gd name="connsiteY128" fmla="*/ 428067 h 1517480"/>
                <a:gd name="connsiteX129" fmla="*/ 3596330 w 8363529"/>
                <a:gd name="connsiteY129" fmla="*/ 386220 h 1517480"/>
                <a:gd name="connsiteX130" fmla="*/ 3604693 w 8363529"/>
                <a:gd name="connsiteY130" fmla="*/ 433845 h 1517480"/>
                <a:gd name="connsiteX131" fmla="*/ 3671616 w 8363529"/>
                <a:gd name="connsiteY131" fmla="*/ 937749 h 1517480"/>
                <a:gd name="connsiteX132" fmla="*/ 3679970 w 8363529"/>
                <a:gd name="connsiteY132" fmla="*/ 1021822 h 1517480"/>
                <a:gd name="connsiteX133" fmla="*/ 3688323 w 8363529"/>
                <a:gd name="connsiteY133" fmla="*/ 1012754 h 1517480"/>
                <a:gd name="connsiteX134" fmla="*/ 3755246 w 8363529"/>
                <a:gd name="connsiteY134" fmla="*/ 949131 h 1517480"/>
                <a:gd name="connsiteX135" fmla="*/ 3763609 w 8363529"/>
                <a:gd name="connsiteY135" fmla="*/ 942133 h 1517480"/>
                <a:gd name="connsiteX136" fmla="*/ 3771962 w 8363529"/>
                <a:gd name="connsiteY136" fmla="*/ 945463 h 1517480"/>
                <a:gd name="connsiteX137" fmla="*/ 3838885 w 8363529"/>
                <a:gd name="connsiteY137" fmla="*/ 974574 h 1517480"/>
                <a:gd name="connsiteX138" fmla="*/ 3847239 w 8363529"/>
                <a:gd name="connsiteY138" fmla="*/ 978581 h 1517480"/>
                <a:gd name="connsiteX139" fmla="*/ 3855602 w 8363529"/>
                <a:gd name="connsiteY139" fmla="*/ 1000008 h 1517480"/>
                <a:gd name="connsiteX140" fmla="*/ 3922525 w 8363529"/>
                <a:gd name="connsiteY140" fmla="*/ 1154101 h 1517480"/>
                <a:gd name="connsiteX141" fmla="*/ 3930878 w 8363529"/>
                <a:gd name="connsiteY141" fmla="*/ 1171415 h 1517480"/>
                <a:gd name="connsiteX142" fmla="*/ 3939231 w 8363529"/>
                <a:gd name="connsiteY142" fmla="*/ 1142342 h 1517480"/>
                <a:gd name="connsiteX143" fmla="*/ 4006154 w 8363529"/>
                <a:gd name="connsiteY143" fmla="*/ 937633 h 1517480"/>
                <a:gd name="connsiteX144" fmla="*/ 4014517 w 8363529"/>
                <a:gd name="connsiteY144" fmla="*/ 915064 h 1517480"/>
                <a:gd name="connsiteX145" fmla="*/ 4022871 w 8363529"/>
                <a:gd name="connsiteY145" fmla="*/ 932078 h 1517480"/>
                <a:gd name="connsiteX146" fmla="*/ 4089755 w 8363529"/>
                <a:gd name="connsiteY146" fmla="*/ 1137165 h 1517480"/>
                <a:gd name="connsiteX147" fmla="*/ 4098147 w 8363529"/>
                <a:gd name="connsiteY147" fmla="*/ 1176525 h 1517480"/>
                <a:gd name="connsiteX148" fmla="*/ 4106500 w 8363529"/>
                <a:gd name="connsiteY148" fmla="*/ 1076532 h 1517480"/>
                <a:gd name="connsiteX149" fmla="*/ 4173394 w 8363529"/>
                <a:gd name="connsiteY149" fmla="*/ 564808 h 1517480"/>
                <a:gd name="connsiteX150" fmla="*/ 4181787 w 8363529"/>
                <a:gd name="connsiteY150" fmla="*/ 522989 h 1517480"/>
                <a:gd name="connsiteX151" fmla="*/ 4190140 w 8363529"/>
                <a:gd name="connsiteY151" fmla="*/ 572289 h 1517480"/>
                <a:gd name="connsiteX152" fmla="*/ 4257024 w 8363529"/>
                <a:gd name="connsiteY152" fmla="*/ 1064434 h 1517480"/>
                <a:gd name="connsiteX153" fmla="*/ 4265416 w 8363529"/>
                <a:gd name="connsiteY153" fmla="*/ 1141626 h 1517480"/>
                <a:gd name="connsiteX154" fmla="*/ 4273779 w 8363529"/>
                <a:gd name="connsiteY154" fmla="*/ 1018086 h 1517480"/>
                <a:gd name="connsiteX155" fmla="*/ 4340664 w 8363529"/>
                <a:gd name="connsiteY155" fmla="*/ 105442 h 1517480"/>
                <a:gd name="connsiteX156" fmla="*/ 4349055 w 8363529"/>
                <a:gd name="connsiteY156" fmla="*/ 0 h 1517480"/>
                <a:gd name="connsiteX157" fmla="*/ 4357409 w 8363529"/>
                <a:gd name="connsiteY157" fmla="*/ 93383 h 1517480"/>
                <a:gd name="connsiteX158" fmla="*/ 4424303 w 8363529"/>
                <a:gd name="connsiteY158" fmla="*/ 833895 h 1517480"/>
                <a:gd name="connsiteX159" fmla="*/ 4432695 w 8363529"/>
                <a:gd name="connsiteY159" fmla="*/ 925652 h 1517480"/>
                <a:gd name="connsiteX160" fmla="*/ 4441048 w 8363529"/>
                <a:gd name="connsiteY160" fmla="*/ 945008 h 1517480"/>
                <a:gd name="connsiteX161" fmla="*/ 4507932 w 8363529"/>
                <a:gd name="connsiteY161" fmla="*/ 1108585 h 1517480"/>
                <a:gd name="connsiteX162" fmla="*/ 4516324 w 8363529"/>
                <a:gd name="connsiteY162" fmla="*/ 1130177 h 1517480"/>
                <a:gd name="connsiteX163" fmla="*/ 4524687 w 8363529"/>
                <a:gd name="connsiteY163" fmla="*/ 1136642 h 1517480"/>
                <a:gd name="connsiteX164" fmla="*/ 4591572 w 8363529"/>
                <a:gd name="connsiteY164" fmla="*/ 1194361 h 1517480"/>
                <a:gd name="connsiteX165" fmla="*/ 4599964 w 8363529"/>
                <a:gd name="connsiteY165" fmla="*/ 1202414 h 1517480"/>
                <a:gd name="connsiteX166" fmla="*/ 4608317 w 8363529"/>
                <a:gd name="connsiteY166" fmla="*/ 1149417 h 1517480"/>
                <a:gd name="connsiteX167" fmla="*/ 4675201 w 8363529"/>
                <a:gd name="connsiteY167" fmla="*/ 734627 h 1517480"/>
                <a:gd name="connsiteX168" fmla="*/ 4683603 w 8363529"/>
                <a:gd name="connsiteY168" fmla="*/ 683925 h 1517480"/>
                <a:gd name="connsiteX169" fmla="*/ 4691956 w 8363529"/>
                <a:gd name="connsiteY169" fmla="*/ 699690 h 1517480"/>
                <a:gd name="connsiteX170" fmla="*/ 4758840 w 8363529"/>
                <a:gd name="connsiteY170" fmla="*/ 812235 h 1517480"/>
                <a:gd name="connsiteX171" fmla="*/ 4767232 w 8363529"/>
                <a:gd name="connsiteY171" fmla="*/ 824826 h 1517480"/>
                <a:gd name="connsiteX172" fmla="*/ 4775595 w 8363529"/>
                <a:gd name="connsiteY172" fmla="*/ 836276 h 1517480"/>
                <a:gd name="connsiteX173" fmla="*/ 4842480 w 8363529"/>
                <a:gd name="connsiteY173" fmla="*/ 956312 h 1517480"/>
                <a:gd name="connsiteX174" fmla="*/ 4850872 w 8363529"/>
                <a:gd name="connsiteY174" fmla="*/ 976084 h 1517480"/>
                <a:gd name="connsiteX175" fmla="*/ 4859225 w 8363529"/>
                <a:gd name="connsiteY175" fmla="*/ 1000802 h 1517480"/>
                <a:gd name="connsiteX176" fmla="*/ 4926109 w 8363529"/>
                <a:gd name="connsiteY176" fmla="*/ 1129945 h 1517480"/>
                <a:gd name="connsiteX177" fmla="*/ 4934501 w 8363529"/>
                <a:gd name="connsiteY177" fmla="*/ 1140687 h 1517480"/>
                <a:gd name="connsiteX178" fmla="*/ 4942864 w 8363529"/>
                <a:gd name="connsiteY178" fmla="*/ 1132780 h 1517480"/>
                <a:gd name="connsiteX179" fmla="*/ 5009749 w 8363529"/>
                <a:gd name="connsiteY179" fmla="*/ 1061444 h 1517480"/>
                <a:gd name="connsiteX180" fmla="*/ 5018141 w 8363529"/>
                <a:gd name="connsiteY180" fmla="*/ 1051388 h 1517480"/>
                <a:gd name="connsiteX181" fmla="*/ 5026494 w 8363529"/>
                <a:gd name="connsiteY181" fmla="*/ 1019557 h 1517480"/>
                <a:gd name="connsiteX182" fmla="*/ 5093388 w 8363529"/>
                <a:gd name="connsiteY182" fmla="*/ 717314 h 1517480"/>
                <a:gd name="connsiteX183" fmla="*/ 5101780 w 8363529"/>
                <a:gd name="connsiteY183" fmla="*/ 672243 h 1517480"/>
                <a:gd name="connsiteX184" fmla="*/ 5110134 w 8363529"/>
                <a:gd name="connsiteY184" fmla="*/ 716549 h 1517480"/>
                <a:gd name="connsiteX185" fmla="*/ 5177018 w 8363529"/>
                <a:gd name="connsiteY185" fmla="*/ 972639 h 1517480"/>
                <a:gd name="connsiteX186" fmla="*/ 5185410 w 8363529"/>
                <a:gd name="connsiteY186" fmla="*/ 996040 h 1517480"/>
                <a:gd name="connsiteX187" fmla="*/ 5193773 w 8363529"/>
                <a:gd name="connsiteY187" fmla="*/ 985491 h 1517480"/>
                <a:gd name="connsiteX188" fmla="*/ 5260657 w 8363529"/>
                <a:gd name="connsiteY188" fmla="*/ 893898 h 1517480"/>
                <a:gd name="connsiteX189" fmla="*/ 5269049 w 8363529"/>
                <a:gd name="connsiteY189" fmla="*/ 881453 h 1517480"/>
                <a:gd name="connsiteX190" fmla="*/ 5277403 w 8363529"/>
                <a:gd name="connsiteY190" fmla="*/ 865958 h 1517480"/>
                <a:gd name="connsiteX191" fmla="*/ 5344287 w 8363529"/>
                <a:gd name="connsiteY191" fmla="*/ 722675 h 1517480"/>
                <a:gd name="connsiteX192" fmla="*/ 5352650 w 8363529"/>
                <a:gd name="connsiteY192" fmla="*/ 701926 h 1517480"/>
                <a:gd name="connsiteX193" fmla="*/ 5361042 w 8363529"/>
                <a:gd name="connsiteY193" fmla="*/ 718969 h 1517480"/>
                <a:gd name="connsiteX194" fmla="*/ 5427926 w 8363529"/>
                <a:gd name="connsiteY194" fmla="*/ 1055695 h 1517480"/>
                <a:gd name="connsiteX195" fmla="*/ 5436280 w 8363529"/>
                <a:gd name="connsiteY195" fmla="*/ 1171686 h 1517480"/>
                <a:gd name="connsiteX196" fmla="*/ 5444672 w 8363529"/>
                <a:gd name="connsiteY196" fmla="*/ 1207523 h 1517480"/>
                <a:gd name="connsiteX197" fmla="*/ 5511566 w 8363529"/>
                <a:gd name="connsiteY197" fmla="*/ 1325624 h 1517480"/>
                <a:gd name="connsiteX198" fmla="*/ 5519919 w 8363529"/>
                <a:gd name="connsiteY198" fmla="*/ 1332244 h 1517480"/>
                <a:gd name="connsiteX199" fmla="*/ 5528311 w 8363529"/>
                <a:gd name="connsiteY199" fmla="*/ 1258865 h 1517480"/>
                <a:gd name="connsiteX200" fmla="*/ 5595195 w 8363529"/>
                <a:gd name="connsiteY200" fmla="*/ 852612 h 1517480"/>
                <a:gd name="connsiteX201" fmla="*/ 5603558 w 8363529"/>
                <a:gd name="connsiteY201" fmla="*/ 816958 h 1517480"/>
                <a:gd name="connsiteX202" fmla="*/ 5611950 w 8363529"/>
                <a:gd name="connsiteY202" fmla="*/ 756287 h 1517480"/>
                <a:gd name="connsiteX203" fmla="*/ 5678835 w 8363529"/>
                <a:gd name="connsiteY203" fmla="*/ 273219 h 1517480"/>
                <a:gd name="connsiteX204" fmla="*/ 5687188 w 8363529"/>
                <a:gd name="connsiteY204" fmla="*/ 213109 h 1517480"/>
                <a:gd name="connsiteX205" fmla="*/ 5695580 w 8363529"/>
                <a:gd name="connsiteY205" fmla="*/ 284223 h 1517480"/>
                <a:gd name="connsiteX206" fmla="*/ 5762474 w 8363529"/>
                <a:gd name="connsiteY206" fmla="*/ 1091571 h 1517480"/>
                <a:gd name="connsiteX207" fmla="*/ 5770827 w 8363529"/>
                <a:gd name="connsiteY207" fmla="*/ 1236857 h 1517480"/>
                <a:gd name="connsiteX208" fmla="*/ 5779219 w 8363529"/>
                <a:gd name="connsiteY208" fmla="*/ 1208472 h 1517480"/>
                <a:gd name="connsiteX209" fmla="*/ 5846103 w 8363529"/>
                <a:gd name="connsiteY209" fmla="*/ 1042727 h 1517480"/>
                <a:gd name="connsiteX210" fmla="*/ 5854457 w 8363529"/>
                <a:gd name="connsiteY210" fmla="*/ 1027455 h 1517480"/>
                <a:gd name="connsiteX211" fmla="*/ 5862858 w 8363529"/>
                <a:gd name="connsiteY211" fmla="*/ 1033242 h 1517480"/>
                <a:gd name="connsiteX212" fmla="*/ 5929743 w 8363529"/>
                <a:gd name="connsiteY212" fmla="*/ 1109040 h 1517480"/>
                <a:gd name="connsiteX213" fmla="*/ 5938096 w 8363529"/>
                <a:gd name="connsiteY213" fmla="*/ 1124922 h 1517480"/>
                <a:gd name="connsiteX214" fmla="*/ 5946488 w 8363529"/>
                <a:gd name="connsiteY214" fmla="*/ 1133051 h 1517480"/>
                <a:gd name="connsiteX215" fmla="*/ 6013372 w 8363529"/>
                <a:gd name="connsiteY215" fmla="*/ 1174105 h 1517480"/>
                <a:gd name="connsiteX216" fmla="*/ 6021735 w 8363529"/>
                <a:gd name="connsiteY216" fmla="*/ 1177396 h 1517480"/>
                <a:gd name="connsiteX217" fmla="*/ 6030127 w 8363529"/>
                <a:gd name="connsiteY217" fmla="*/ 1160343 h 1517480"/>
                <a:gd name="connsiteX218" fmla="*/ 6097011 w 8363529"/>
                <a:gd name="connsiteY218" fmla="*/ 1005757 h 1517480"/>
                <a:gd name="connsiteX219" fmla="*/ 6105365 w 8363529"/>
                <a:gd name="connsiteY219" fmla="*/ 983836 h 1517480"/>
                <a:gd name="connsiteX220" fmla="*/ 6113767 w 8363529"/>
                <a:gd name="connsiteY220" fmla="*/ 976539 h 1517480"/>
                <a:gd name="connsiteX221" fmla="*/ 6180651 w 8363529"/>
                <a:gd name="connsiteY221" fmla="*/ 926407 h 1517480"/>
                <a:gd name="connsiteX222" fmla="*/ 6189004 w 8363529"/>
                <a:gd name="connsiteY222" fmla="*/ 920958 h 1517480"/>
                <a:gd name="connsiteX223" fmla="*/ 6197396 w 8363529"/>
                <a:gd name="connsiteY223" fmla="*/ 936540 h 1517480"/>
                <a:gd name="connsiteX224" fmla="*/ 6264280 w 8363529"/>
                <a:gd name="connsiteY224" fmla="*/ 1095317 h 1517480"/>
                <a:gd name="connsiteX225" fmla="*/ 6272644 w 8363529"/>
                <a:gd name="connsiteY225" fmla="*/ 1120799 h 1517480"/>
                <a:gd name="connsiteX226" fmla="*/ 6281036 w 8363529"/>
                <a:gd name="connsiteY226" fmla="*/ 1119434 h 1517480"/>
                <a:gd name="connsiteX227" fmla="*/ 6347920 w 8363529"/>
                <a:gd name="connsiteY227" fmla="*/ 1110443 h 1517480"/>
                <a:gd name="connsiteX228" fmla="*/ 6356273 w 8363529"/>
                <a:gd name="connsiteY228" fmla="*/ 1109495 h 1517480"/>
                <a:gd name="connsiteX229" fmla="*/ 6364665 w 8363529"/>
                <a:gd name="connsiteY229" fmla="*/ 1116908 h 1517480"/>
                <a:gd name="connsiteX230" fmla="*/ 6431560 w 8363529"/>
                <a:gd name="connsiteY230" fmla="*/ 1171231 h 1517480"/>
                <a:gd name="connsiteX231" fmla="*/ 6439913 w 8363529"/>
                <a:gd name="connsiteY231" fmla="*/ 1177464 h 1517480"/>
                <a:gd name="connsiteX232" fmla="*/ 6448305 w 8363529"/>
                <a:gd name="connsiteY232" fmla="*/ 1168995 h 1517480"/>
                <a:gd name="connsiteX233" fmla="*/ 6515189 w 8363529"/>
                <a:gd name="connsiteY233" fmla="*/ 1092713 h 1517480"/>
                <a:gd name="connsiteX234" fmla="*/ 6523542 w 8363529"/>
                <a:gd name="connsiteY234" fmla="*/ 1081971 h 1517480"/>
                <a:gd name="connsiteX235" fmla="*/ 6531944 w 8363529"/>
                <a:gd name="connsiteY235" fmla="*/ 1088968 h 1517480"/>
                <a:gd name="connsiteX236" fmla="*/ 6598829 w 8363529"/>
                <a:gd name="connsiteY236" fmla="*/ 1151381 h 1517480"/>
                <a:gd name="connsiteX237" fmla="*/ 6607182 w 8363529"/>
                <a:gd name="connsiteY237" fmla="*/ 1160082 h 1517480"/>
                <a:gd name="connsiteX238" fmla="*/ 6615535 w 8363529"/>
                <a:gd name="connsiteY238" fmla="*/ 1163779 h 1517480"/>
                <a:gd name="connsiteX239" fmla="*/ 6682458 w 8363529"/>
                <a:gd name="connsiteY239" fmla="*/ 1184345 h 1517480"/>
                <a:gd name="connsiteX240" fmla="*/ 6690821 w 8363529"/>
                <a:gd name="connsiteY240" fmla="*/ 1186164 h 1517480"/>
                <a:gd name="connsiteX241" fmla="*/ 6699174 w 8363529"/>
                <a:gd name="connsiteY241" fmla="*/ 1152514 h 1517480"/>
                <a:gd name="connsiteX242" fmla="*/ 6766097 w 8363529"/>
                <a:gd name="connsiteY242" fmla="*/ 815110 h 1517480"/>
                <a:gd name="connsiteX243" fmla="*/ 6774451 w 8363529"/>
                <a:gd name="connsiteY243" fmla="*/ 761958 h 1517480"/>
                <a:gd name="connsiteX244" fmla="*/ 6782814 w 8363529"/>
                <a:gd name="connsiteY244" fmla="*/ 791292 h 1517480"/>
                <a:gd name="connsiteX245" fmla="*/ 6849737 w 8363529"/>
                <a:gd name="connsiteY245" fmla="*/ 1063941 h 1517480"/>
                <a:gd name="connsiteX246" fmla="*/ 6858090 w 8363529"/>
                <a:gd name="connsiteY246" fmla="*/ 1103669 h 1517480"/>
                <a:gd name="connsiteX247" fmla="*/ 6866443 w 8363529"/>
                <a:gd name="connsiteY247" fmla="*/ 1093952 h 1517480"/>
                <a:gd name="connsiteX248" fmla="*/ 6933366 w 8363529"/>
                <a:gd name="connsiteY248" fmla="*/ 1041672 h 1517480"/>
                <a:gd name="connsiteX249" fmla="*/ 6941729 w 8363529"/>
                <a:gd name="connsiteY249" fmla="*/ 1037171 h 1517480"/>
                <a:gd name="connsiteX250" fmla="*/ 6950083 w 8363529"/>
                <a:gd name="connsiteY250" fmla="*/ 1057515 h 1517480"/>
                <a:gd name="connsiteX251" fmla="*/ 7017006 w 8363529"/>
                <a:gd name="connsiteY251" fmla="*/ 1255459 h 1517480"/>
                <a:gd name="connsiteX252" fmla="*/ 7025359 w 8363529"/>
                <a:gd name="connsiteY252" fmla="*/ 1285702 h 1517480"/>
                <a:gd name="connsiteX253" fmla="*/ 7033712 w 8363529"/>
                <a:gd name="connsiteY253" fmla="*/ 1280186 h 1517480"/>
                <a:gd name="connsiteX254" fmla="*/ 7100645 w 8363529"/>
                <a:gd name="connsiteY254" fmla="*/ 1232735 h 1517480"/>
                <a:gd name="connsiteX255" fmla="*/ 7108998 w 8363529"/>
                <a:gd name="connsiteY255" fmla="*/ 1226386 h 1517480"/>
                <a:gd name="connsiteX256" fmla="*/ 7117351 w 8363529"/>
                <a:gd name="connsiteY256" fmla="*/ 1235880 h 1517480"/>
                <a:gd name="connsiteX257" fmla="*/ 7184274 w 8363529"/>
                <a:gd name="connsiteY257" fmla="*/ 1314698 h 1517480"/>
                <a:gd name="connsiteX258" fmla="*/ 7192628 w 8363529"/>
                <a:gd name="connsiteY258" fmla="*/ 1324985 h 1517480"/>
                <a:gd name="connsiteX259" fmla="*/ 7200991 w 8363529"/>
                <a:gd name="connsiteY259" fmla="*/ 1314659 h 1517480"/>
                <a:gd name="connsiteX260" fmla="*/ 7267914 w 8363529"/>
                <a:gd name="connsiteY260" fmla="*/ 1238367 h 1517480"/>
                <a:gd name="connsiteX261" fmla="*/ 7276267 w 8363529"/>
                <a:gd name="connsiteY261" fmla="*/ 1229522 h 1517480"/>
                <a:gd name="connsiteX262" fmla="*/ 7284620 w 8363529"/>
                <a:gd name="connsiteY262" fmla="*/ 1162046 h 1517480"/>
                <a:gd name="connsiteX263" fmla="*/ 7351543 w 8363529"/>
                <a:gd name="connsiteY263" fmla="*/ 591045 h 1517480"/>
                <a:gd name="connsiteX264" fmla="*/ 7359906 w 8363529"/>
                <a:gd name="connsiteY264" fmla="*/ 515547 h 1517480"/>
                <a:gd name="connsiteX265" fmla="*/ 7368260 w 8363529"/>
                <a:gd name="connsiteY265" fmla="*/ 515624 h 1517480"/>
                <a:gd name="connsiteX266" fmla="*/ 7435183 w 8363529"/>
                <a:gd name="connsiteY266" fmla="*/ 516040 h 1517480"/>
                <a:gd name="connsiteX267" fmla="*/ 7443536 w 8363529"/>
                <a:gd name="connsiteY267" fmla="*/ 516079 h 1517480"/>
                <a:gd name="connsiteX268" fmla="*/ 7451899 w 8363529"/>
                <a:gd name="connsiteY268" fmla="*/ 546429 h 1517480"/>
                <a:gd name="connsiteX269" fmla="*/ 7518822 w 8363529"/>
                <a:gd name="connsiteY269" fmla="*/ 838172 h 1517480"/>
                <a:gd name="connsiteX270" fmla="*/ 7527175 w 8363529"/>
                <a:gd name="connsiteY270" fmla="*/ 882178 h 1517480"/>
                <a:gd name="connsiteX271" fmla="*/ 7535528 w 8363529"/>
                <a:gd name="connsiteY271" fmla="*/ 822213 h 1517480"/>
                <a:gd name="connsiteX272" fmla="*/ 7602452 w 8363529"/>
                <a:gd name="connsiteY272" fmla="*/ 420238 h 1517480"/>
                <a:gd name="connsiteX273" fmla="*/ 7610815 w 8363529"/>
                <a:gd name="connsiteY273" fmla="*/ 377974 h 1517480"/>
                <a:gd name="connsiteX274" fmla="*/ 7619168 w 8363529"/>
                <a:gd name="connsiteY274" fmla="*/ 453772 h 1517480"/>
                <a:gd name="connsiteX275" fmla="*/ 7686091 w 8363529"/>
                <a:gd name="connsiteY275" fmla="*/ 1111721 h 1517480"/>
                <a:gd name="connsiteX276" fmla="*/ 7694444 w 8363529"/>
                <a:gd name="connsiteY276" fmla="*/ 1201020 h 1517480"/>
                <a:gd name="connsiteX277" fmla="*/ 7702798 w 8363529"/>
                <a:gd name="connsiteY277" fmla="*/ 1126964 h 1517480"/>
                <a:gd name="connsiteX278" fmla="*/ 7769731 w 8363529"/>
                <a:gd name="connsiteY278" fmla="*/ 396798 h 1517480"/>
                <a:gd name="connsiteX279" fmla="*/ 7778084 w 8363529"/>
                <a:gd name="connsiteY279" fmla="*/ 283730 h 1517480"/>
                <a:gd name="connsiteX280" fmla="*/ 7786437 w 8363529"/>
                <a:gd name="connsiteY280" fmla="*/ 398162 h 1517480"/>
                <a:gd name="connsiteX281" fmla="*/ 7853360 w 8363529"/>
                <a:gd name="connsiteY281" fmla="*/ 957483 h 1517480"/>
                <a:gd name="connsiteX282" fmla="*/ 7861713 w 8363529"/>
                <a:gd name="connsiteY282" fmla="*/ 1001334 h 1517480"/>
                <a:gd name="connsiteX283" fmla="*/ 7870077 w 8363529"/>
                <a:gd name="connsiteY283" fmla="*/ 977255 h 1517480"/>
                <a:gd name="connsiteX284" fmla="*/ 7937000 w 8363529"/>
                <a:gd name="connsiteY284" fmla="*/ 707442 h 1517480"/>
                <a:gd name="connsiteX285" fmla="*/ 7945353 w 8363529"/>
                <a:gd name="connsiteY285" fmla="*/ 659584 h 1517480"/>
                <a:gd name="connsiteX286" fmla="*/ 7953706 w 8363529"/>
                <a:gd name="connsiteY286" fmla="*/ 699274 h 1517480"/>
                <a:gd name="connsiteX287" fmla="*/ 8020629 w 8363529"/>
                <a:gd name="connsiteY287" fmla="*/ 1002243 h 1517480"/>
                <a:gd name="connsiteX288" fmla="*/ 8028992 w 8363529"/>
                <a:gd name="connsiteY288" fmla="*/ 1038381 h 1517480"/>
                <a:gd name="connsiteX289" fmla="*/ 8037346 w 8363529"/>
                <a:gd name="connsiteY289" fmla="*/ 1066360 h 1517480"/>
                <a:gd name="connsiteX290" fmla="*/ 8104268 w 8363529"/>
                <a:gd name="connsiteY290" fmla="*/ 1322827 h 1517480"/>
                <a:gd name="connsiteX291" fmla="*/ 8112622 w 8363529"/>
                <a:gd name="connsiteY291" fmla="*/ 1359652 h 1517480"/>
                <a:gd name="connsiteX292" fmla="*/ 8120985 w 8363529"/>
                <a:gd name="connsiteY292" fmla="*/ 1324192 h 1517480"/>
                <a:gd name="connsiteX293" fmla="*/ 8187908 w 8363529"/>
                <a:gd name="connsiteY293" fmla="*/ 1136371 h 1517480"/>
                <a:gd name="connsiteX294" fmla="*/ 8196261 w 8363529"/>
                <a:gd name="connsiteY294" fmla="*/ 1120567 h 1517480"/>
                <a:gd name="connsiteX295" fmla="*/ 8204614 w 8363529"/>
                <a:gd name="connsiteY295" fmla="*/ 1055095 h 1517480"/>
                <a:gd name="connsiteX296" fmla="*/ 8271537 w 8363529"/>
                <a:gd name="connsiteY296" fmla="*/ 373058 h 1517480"/>
                <a:gd name="connsiteX297" fmla="*/ 8279900 w 8363529"/>
                <a:gd name="connsiteY297" fmla="*/ 261161 h 1517480"/>
                <a:gd name="connsiteX298" fmla="*/ 8288254 w 8363529"/>
                <a:gd name="connsiteY298" fmla="*/ 355744 h 1517480"/>
                <a:gd name="connsiteX299" fmla="*/ 8355177 w 8363529"/>
                <a:gd name="connsiteY299" fmla="*/ 1120044 h 1517480"/>
                <a:gd name="connsiteX300" fmla="*/ 8363530 w 8363529"/>
                <a:gd name="connsiteY300" fmla="*/ 1216553 h 1517480"/>
                <a:gd name="connsiteX301" fmla="*/ 8363530 w 8363529"/>
                <a:gd name="connsiteY301" fmla="*/ 1269443 h 1517480"/>
                <a:gd name="connsiteX302" fmla="*/ 8355177 w 8363529"/>
                <a:gd name="connsiteY302" fmla="*/ 1180338 h 1517480"/>
                <a:gd name="connsiteX303" fmla="*/ 8288254 w 8363529"/>
                <a:gd name="connsiteY303" fmla="*/ 474638 h 1517480"/>
                <a:gd name="connsiteX304" fmla="*/ 8279900 w 8363529"/>
                <a:gd name="connsiteY304" fmla="*/ 387352 h 1517480"/>
                <a:gd name="connsiteX305" fmla="*/ 8271537 w 8363529"/>
                <a:gd name="connsiteY305" fmla="*/ 494371 h 1517480"/>
                <a:gd name="connsiteX306" fmla="*/ 8204614 w 8363529"/>
                <a:gd name="connsiteY306" fmla="*/ 1146804 h 1517480"/>
                <a:gd name="connsiteX307" fmla="*/ 8196261 w 8363529"/>
                <a:gd name="connsiteY307" fmla="*/ 1209449 h 1517480"/>
                <a:gd name="connsiteX308" fmla="*/ 8187908 w 8363529"/>
                <a:gd name="connsiteY308" fmla="*/ 1219350 h 1517480"/>
                <a:gd name="connsiteX309" fmla="*/ 8120985 w 8363529"/>
                <a:gd name="connsiteY309" fmla="*/ 1337344 h 1517480"/>
                <a:gd name="connsiteX310" fmla="*/ 8112622 w 8363529"/>
                <a:gd name="connsiteY310" fmla="*/ 1359652 h 1517480"/>
                <a:gd name="connsiteX311" fmla="*/ 8104268 w 8363529"/>
                <a:gd name="connsiteY311" fmla="*/ 1335980 h 1517480"/>
                <a:gd name="connsiteX312" fmla="*/ 8037346 w 8363529"/>
                <a:gd name="connsiteY312" fmla="*/ 1171037 h 1517480"/>
                <a:gd name="connsiteX313" fmla="*/ 8028992 w 8363529"/>
                <a:gd name="connsiteY313" fmla="*/ 1153046 h 1517480"/>
                <a:gd name="connsiteX314" fmla="*/ 8020629 w 8363529"/>
                <a:gd name="connsiteY314" fmla="*/ 1115282 h 1517480"/>
                <a:gd name="connsiteX315" fmla="*/ 7953706 w 8363529"/>
                <a:gd name="connsiteY315" fmla="*/ 798705 h 1517480"/>
                <a:gd name="connsiteX316" fmla="*/ 7945353 w 8363529"/>
                <a:gd name="connsiteY316" fmla="*/ 757197 h 1517480"/>
                <a:gd name="connsiteX317" fmla="*/ 7937000 w 8363529"/>
                <a:gd name="connsiteY317" fmla="*/ 831253 h 1517480"/>
                <a:gd name="connsiteX318" fmla="*/ 7870077 w 8363529"/>
                <a:gd name="connsiteY318" fmla="*/ 1248655 h 1517480"/>
                <a:gd name="connsiteX319" fmla="*/ 7861713 w 8363529"/>
                <a:gd name="connsiteY319" fmla="*/ 1285925 h 1517480"/>
                <a:gd name="connsiteX320" fmla="*/ 7853360 w 8363529"/>
                <a:gd name="connsiteY320" fmla="*/ 1229560 h 1517480"/>
                <a:gd name="connsiteX321" fmla="*/ 7786437 w 8363529"/>
                <a:gd name="connsiteY321" fmla="*/ 510853 h 1517480"/>
                <a:gd name="connsiteX322" fmla="*/ 7778084 w 8363529"/>
                <a:gd name="connsiteY322" fmla="*/ 363835 h 1517480"/>
                <a:gd name="connsiteX323" fmla="*/ 7769731 w 8363529"/>
                <a:gd name="connsiteY323" fmla="*/ 472218 h 1517480"/>
                <a:gd name="connsiteX324" fmla="*/ 7702798 w 8363529"/>
                <a:gd name="connsiteY324" fmla="*/ 1172363 h 1517480"/>
                <a:gd name="connsiteX325" fmla="*/ 7694444 w 8363529"/>
                <a:gd name="connsiteY325" fmla="*/ 1243361 h 1517480"/>
                <a:gd name="connsiteX326" fmla="*/ 7686091 w 8363529"/>
                <a:gd name="connsiteY326" fmla="*/ 1247939 h 1517480"/>
                <a:gd name="connsiteX327" fmla="*/ 7619168 w 8363529"/>
                <a:gd name="connsiteY327" fmla="*/ 1281696 h 1517480"/>
                <a:gd name="connsiteX328" fmla="*/ 7610815 w 8363529"/>
                <a:gd name="connsiteY328" fmla="*/ 1285586 h 1517480"/>
                <a:gd name="connsiteX329" fmla="*/ 7602452 w 8363529"/>
                <a:gd name="connsiteY329" fmla="*/ 1257462 h 1517480"/>
                <a:gd name="connsiteX330" fmla="*/ 7535528 w 8363529"/>
                <a:gd name="connsiteY330" fmla="*/ 989730 h 1517480"/>
                <a:gd name="connsiteX331" fmla="*/ 7527175 w 8363529"/>
                <a:gd name="connsiteY331" fmla="*/ 949808 h 1517480"/>
                <a:gd name="connsiteX332" fmla="*/ 7518822 w 8363529"/>
                <a:gd name="connsiteY332" fmla="*/ 912838 h 1517480"/>
                <a:gd name="connsiteX333" fmla="*/ 7451899 w 8363529"/>
                <a:gd name="connsiteY333" fmla="*/ 667743 h 1517480"/>
                <a:gd name="connsiteX334" fmla="*/ 7443536 w 8363529"/>
                <a:gd name="connsiteY334" fmla="*/ 642270 h 1517480"/>
                <a:gd name="connsiteX335" fmla="*/ 7435183 w 8363529"/>
                <a:gd name="connsiteY335" fmla="*/ 654097 h 1517480"/>
                <a:gd name="connsiteX336" fmla="*/ 7368260 w 8363529"/>
                <a:gd name="connsiteY336" fmla="*/ 766942 h 1517480"/>
                <a:gd name="connsiteX337" fmla="*/ 7359906 w 8363529"/>
                <a:gd name="connsiteY337" fmla="*/ 783879 h 1517480"/>
                <a:gd name="connsiteX338" fmla="*/ 7351543 w 8363529"/>
                <a:gd name="connsiteY338" fmla="*/ 834504 h 1517480"/>
                <a:gd name="connsiteX339" fmla="*/ 7284620 w 8363529"/>
                <a:gd name="connsiteY339" fmla="*/ 1217579 h 1517480"/>
                <a:gd name="connsiteX340" fmla="*/ 7276267 w 8363529"/>
                <a:gd name="connsiteY340" fmla="*/ 1262872 h 1517480"/>
                <a:gd name="connsiteX341" fmla="*/ 7267914 w 8363529"/>
                <a:gd name="connsiteY341" fmla="*/ 1274137 h 1517480"/>
                <a:gd name="connsiteX342" fmla="*/ 7200991 w 8363529"/>
                <a:gd name="connsiteY342" fmla="*/ 1371556 h 1517480"/>
                <a:gd name="connsiteX343" fmla="*/ 7192628 w 8363529"/>
                <a:gd name="connsiteY343" fmla="*/ 1384747 h 1517480"/>
                <a:gd name="connsiteX344" fmla="*/ 7184274 w 8363529"/>
                <a:gd name="connsiteY344" fmla="*/ 1368265 h 1517480"/>
                <a:gd name="connsiteX345" fmla="*/ 7117351 w 8363529"/>
                <a:gd name="connsiteY345" fmla="*/ 1241619 h 1517480"/>
                <a:gd name="connsiteX346" fmla="*/ 7108998 w 8363529"/>
                <a:gd name="connsiteY346" fmla="*/ 1226386 h 1517480"/>
                <a:gd name="connsiteX347" fmla="*/ 7100645 w 8363529"/>
                <a:gd name="connsiteY347" fmla="*/ 1245103 h 1517480"/>
                <a:gd name="connsiteX348" fmla="*/ 7033712 w 8363529"/>
                <a:gd name="connsiteY348" fmla="*/ 1385057 h 1517480"/>
                <a:gd name="connsiteX349" fmla="*/ 7025359 w 8363529"/>
                <a:gd name="connsiteY349" fmla="*/ 1401422 h 1517480"/>
                <a:gd name="connsiteX350" fmla="*/ 7017006 w 8363529"/>
                <a:gd name="connsiteY350" fmla="*/ 1364675 h 1517480"/>
                <a:gd name="connsiteX351" fmla="*/ 6950083 w 8363529"/>
                <a:gd name="connsiteY351" fmla="*/ 1124196 h 1517480"/>
                <a:gd name="connsiteX352" fmla="*/ 6941729 w 8363529"/>
                <a:gd name="connsiteY352" fmla="*/ 1099517 h 1517480"/>
                <a:gd name="connsiteX353" fmla="*/ 6933366 w 8363529"/>
                <a:gd name="connsiteY353" fmla="*/ 1121099 h 1517480"/>
                <a:gd name="connsiteX354" fmla="*/ 6866443 w 8363529"/>
                <a:gd name="connsiteY354" fmla="*/ 1372920 h 1517480"/>
                <a:gd name="connsiteX355" fmla="*/ 6858090 w 8363529"/>
                <a:gd name="connsiteY355" fmla="*/ 1419646 h 1517480"/>
                <a:gd name="connsiteX356" fmla="*/ 6849737 w 8363529"/>
                <a:gd name="connsiteY356" fmla="*/ 1367704 h 1517480"/>
                <a:gd name="connsiteX357" fmla="*/ 6782814 w 8363529"/>
                <a:gd name="connsiteY357" fmla="*/ 1011128 h 1517480"/>
                <a:gd name="connsiteX358" fmla="*/ 6774451 w 8363529"/>
                <a:gd name="connsiteY358" fmla="*/ 972793 h 1517480"/>
                <a:gd name="connsiteX359" fmla="*/ 6766097 w 8363529"/>
                <a:gd name="connsiteY359" fmla="*/ 1014080 h 1517480"/>
                <a:gd name="connsiteX360" fmla="*/ 6699174 w 8363529"/>
                <a:gd name="connsiteY360" fmla="*/ 1276440 h 1517480"/>
                <a:gd name="connsiteX361" fmla="*/ 6690821 w 8363529"/>
                <a:gd name="connsiteY361" fmla="*/ 1302639 h 1517480"/>
                <a:gd name="connsiteX362" fmla="*/ 6682458 w 8363529"/>
                <a:gd name="connsiteY362" fmla="*/ 1306113 h 1517480"/>
                <a:gd name="connsiteX363" fmla="*/ 6615535 w 8363529"/>
                <a:gd name="connsiteY363" fmla="*/ 1345474 h 1517480"/>
                <a:gd name="connsiteX364" fmla="*/ 6607182 w 8363529"/>
                <a:gd name="connsiteY364" fmla="*/ 1352539 h 1517480"/>
                <a:gd name="connsiteX365" fmla="*/ 6598829 w 8363529"/>
                <a:gd name="connsiteY365" fmla="*/ 1329515 h 1517480"/>
                <a:gd name="connsiteX366" fmla="*/ 6531944 w 8363529"/>
                <a:gd name="connsiteY366" fmla="*/ 1164989 h 1517480"/>
                <a:gd name="connsiteX367" fmla="*/ 6523542 w 8363529"/>
                <a:gd name="connsiteY367" fmla="*/ 1146581 h 1517480"/>
                <a:gd name="connsiteX368" fmla="*/ 6515189 w 8363529"/>
                <a:gd name="connsiteY368" fmla="*/ 1163101 h 1517480"/>
                <a:gd name="connsiteX369" fmla="*/ 6448305 w 8363529"/>
                <a:gd name="connsiteY369" fmla="*/ 1280525 h 1517480"/>
                <a:gd name="connsiteX370" fmla="*/ 6439913 w 8363529"/>
                <a:gd name="connsiteY370" fmla="*/ 1293561 h 1517480"/>
                <a:gd name="connsiteX371" fmla="*/ 6431560 w 8363529"/>
                <a:gd name="connsiteY371" fmla="*/ 1276741 h 1517480"/>
                <a:gd name="connsiteX372" fmla="*/ 6364665 w 8363529"/>
                <a:gd name="connsiteY372" fmla="*/ 1129567 h 1517480"/>
                <a:gd name="connsiteX373" fmla="*/ 6356273 w 8363529"/>
                <a:gd name="connsiteY373" fmla="*/ 1109495 h 1517480"/>
                <a:gd name="connsiteX374" fmla="*/ 6347920 w 8363529"/>
                <a:gd name="connsiteY374" fmla="*/ 1118147 h 1517480"/>
                <a:gd name="connsiteX375" fmla="*/ 6281036 w 8363529"/>
                <a:gd name="connsiteY375" fmla="*/ 1199471 h 1517480"/>
                <a:gd name="connsiteX376" fmla="*/ 6272644 w 8363529"/>
                <a:gd name="connsiteY376" fmla="*/ 1211414 h 1517480"/>
                <a:gd name="connsiteX377" fmla="*/ 6264280 w 8363529"/>
                <a:gd name="connsiteY377" fmla="*/ 1210582 h 1517480"/>
                <a:gd name="connsiteX378" fmla="*/ 6197396 w 8363529"/>
                <a:gd name="connsiteY378" fmla="*/ 1205288 h 1517480"/>
                <a:gd name="connsiteX379" fmla="*/ 6189004 w 8363529"/>
                <a:gd name="connsiteY379" fmla="*/ 1204765 h 1517480"/>
                <a:gd name="connsiteX380" fmla="*/ 6180651 w 8363529"/>
                <a:gd name="connsiteY380" fmla="*/ 1208501 h 1517480"/>
                <a:gd name="connsiteX381" fmla="*/ 6113767 w 8363529"/>
                <a:gd name="connsiteY381" fmla="*/ 1243061 h 1517480"/>
                <a:gd name="connsiteX382" fmla="*/ 6105365 w 8363529"/>
                <a:gd name="connsiteY382" fmla="*/ 1248045 h 1517480"/>
                <a:gd name="connsiteX383" fmla="*/ 6097011 w 8363529"/>
                <a:gd name="connsiteY383" fmla="*/ 1246381 h 1517480"/>
                <a:gd name="connsiteX384" fmla="*/ 6030127 w 8363529"/>
                <a:gd name="connsiteY384" fmla="*/ 1234738 h 1517480"/>
                <a:gd name="connsiteX385" fmla="*/ 6021735 w 8363529"/>
                <a:gd name="connsiteY385" fmla="*/ 1233460 h 1517480"/>
                <a:gd name="connsiteX386" fmla="*/ 6013372 w 8363529"/>
                <a:gd name="connsiteY386" fmla="*/ 1227102 h 1517480"/>
                <a:gd name="connsiteX387" fmla="*/ 5946488 w 8363529"/>
                <a:gd name="connsiteY387" fmla="*/ 1148468 h 1517480"/>
                <a:gd name="connsiteX388" fmla="*/ 5938096 w 8363529"/>
                <a:gd name="connsiteY388" fmla="*/ 1132896 h 1517480"/>
                <a:gd name="connsiteX389" fmla="*/ 5929743 w 8363529"/>
                <a:gd name="connsiteY389" fmla="*/ 1124235 h 1517480"/>
                <a:gd name="connsiteX390" fmla="*/ 5862858 w 8363529"/>
                <a:gd name="connsiteY390" fmla="*/ 1083065 h 1517480"/>
                <a:gd name="connsiteX391" fmla="*/ 5854457 w 8363529"/>
                <a:gd name="connsiteY391" fmla="*/ 1079890 h 1517480"/>
                <a:gd name="connsiteX392" fmla="*/ 5846103 w 8363529"/>
                <a:gd name="connsiteY392" fmla="*/ 1102498 h 1517480"/>
                <a:gd name="connsiteX393" fmla="*/ 5779219 w 8363529"/>
                <a:gd name="connsiteY393" fmla="*/ 1347700 h 1517480"/>
                <a:gd name="connsiteX394" fmla="*/ 5770827 w 8363529"/>
                <a:gd name="connsiteY394" fmla="*/ 1389741 h 1517480"/>
                <a:gd name="connsiteX395" fmla="*/ 5762474 w 8363529"/>
                <a:gd name="connsiteY395" fmla="*/ 1231041 h 1517480"/>
                <a:gd name="connsiteX396" fmla="*/ 5695580 w 8363529"/>
                <a:gd name="connsiteY396" fmla="*/ 349056 h 1517480"/>
                <a:gd name="connsiteX397" fmla="*/ 5687188 w 8363529"/>
                <a:gd name="connsiteY397" fmla="*/ 271361 h 1517480"/>
                <a:gd name="connsiteX398" fmla="*/ 5678835 w 8363529"/>
                <a:gd name="connsiteY398" fmla="*/ 358618 h 1517480"/>
                <a:gd name="connsiteX399" fmla="*/ 5611950 w 8363529"/>
                <a:gd name="connsiteY399" fmla="*/ 1059779 h 1517480"/>
                <a:gd name="connsiteX400" fmla="*/ 5603558 w 8363529"/>
                <a:gd name="connsiteY400" fmla="*/ 1147830 h 1517480"/>
                <a:gd name="connsiteX401" fmla="*/ 5595195 w 8363529"/>
                <a:gd name="connsiteY401" fmla="*/ 1161476 h 1517480"/>
                <a:gd name="connsiteX402" fmla="*/ 5528311 w 8363529"/>
                <a:gd name="connsiteY402" fmla="*/ 1317078 h 1517480"/>
                <a:gd name="connsiteX403" fmla="*/ 5519919 w 8363529"/>
                <a:gd name="connsiteY403" fmla="*/ 1345164 h 1517480"/>
                <a:gd name="connsiteX404" fmla="*/ 5511566 w 8363529"/>
                <a:gd name="connsiteY404" fmla="*/ 1340025 h 1517480"/>
                <a:gd name="connsiteX405" fmla="*/ 5444672 w 8363529"/>
                <a:gd name="connsiteY405" fmla="*/ 1247900 h 1517480"/>
                <a:gd name="connsiteX406" fmla="*/ 5436280 w 8363529"/>
                <a:gd name="connsiteY406" fmla="*/ 1219998 h 1517480"/>
                <a:gd name="connsiteX407" fmla="*/ 5427926 w 8363529"/>
                <a:gd name="connsiteY407" fmla="*/ 1199965 h 1517480"/>
                <a:gd name="connsiteX408" fmla="*/ 5361042 w 8363529"/>
                <a:gd name="connsiteY408" fmla="*/ 1141858 h 1517480"/>
                <a:gd name="connsiteX409" fmla="*/ 5352650 w 8363529"/>
                <a:gd name="connsiteY409" fmla="*/ 1138906 h 1517480"/>
                <a:gd name="connsiteX410" fmla="*/ 5344287 w 8363529"/>
                <a:gd name="connsiteY410" fmla="*/ 1119396 h 1517480"/>
                <a:gd name="connsiteX411" fmla="*/ 5277403 w 8363529"/>
                <a:gd name="connsiteY411" fmla="*/ 984629 h 1517480"/>
                <a:gd name="connsiteX412" fmla="*/ 5269049 w 8363529"/>
                <a:gd name="connsiteY412" fmla="*/ 970074 h 1517480"/>
                <a:gd name="connsiteX413" fmla="*/ 5260657 w 8363529"/>
                <a:gd name="connsiteY413" fmla="*/ 974458 h 1517480"/>
                <a:gd name="connsiteX414" fmla="*/ 5193773 w 8363529"/>
                <a:gd name="connsiteY414" fmla="*/ 1006705 h 1517480"/>
                <a:gd name="connsiteX415" fmla="*/ 5185410 w 8363529"/>
                <a:gd name="connsiteY415" fmla="*/ 1010412 h 1517480"/>
                <a:gd name="connsiteX416" fmla="*/ 5177018 w 8363529"/>
                <a:gd name="connsiteY416" fmla="*/ 1014873 h 1517480"/>
                <a:gd name="connsiteX417" fmla="*/ 5110134 w 8363529"/>
                <a:gd name="connsiteY417" fmla="*/ 1063602 h 1517480"/>
                <a:gd name="connsiteX418" fmla="*/ 5101780 w 8363529"/>
                <a:gd name="connsiteY418" fmla="*/ 1072031 h 1517480"/>
                <a:gd name="connsiteX419" fmla="*/ 5093388 w 8363529"/>
                <a:gd name="connsiteY419" fmla="*/ 1082348 h 1517480"/>
                <a:gd name="connsiteX420" fmla="*/ 5026494 w 8363529"/>
                <a:gd name="connsiteY420" fmla="*/ 1151498 h 1517480"/>
                <a:gd name="connsiteX421" fmla="*/ 5018141 w 8363529"/>
                <a:gd name="connsiteY421" fmla="*/ 1158756 h 1517480"/>
                <a:gd name="connsiteX422" fmla="*/ 5009749 w 8363529"/>
                <a:gd name="connsiteY422" fmla="*/ 1163634 h 1517480"/>
                <a:gd name="connsiteX423" fmla="*/ 4942864 w 8363529"/>
                <a:gd name="connsiteY423" fmla="*/ 1198068 h 1517480"/>
                <a:gd name="connsiteX424" fmla="*/ 4934501 w 8363529"/>
                <a:gd name="connsiteY424" fmla="*/ 1201891 h 1517480"/>
                <a:gd name="connsiteX425" fmla="*/ 4926109 w 8363529"/>
                <a:gd name="connsiteY425" fmla="*/ 1191080 h 1517480"/>
                <a:gd name="connsiteX426" fmla="*/ 4859225 w 8363529"/>
                <a:gd name="connsiteY426" fmla="*/ 1061405 h 1517480"/>
                <a:gd name="connsiteX427" fmla="*/ 4850872 w 8363529"/>
                <a:gd name="connsiteY427" fmla="*/ 1036610 h 1517480"/>
                <a:gd name="connsiteX428" fmla="*/ 4842480 w 8363529"/>
                <a:gd name="connsiteY428" fmla="*/ 1013286 h 1517480"/>
                <a:gd name="connsiteX429" fmla="*/ 4775595 w 8363529"/>
                <a:gd name="connsiteY429" fmla="*/ 871775 h 1517480"/>
                <a:gd name="connsiteX430" fmla="*/ 4767232 w 8363529"/>
                <a:gd name="connsiteY430" fmla="*/ 858283 h 1517480"/>
                <a:gd name="connsiteX431" fmla="*/ 4758840 w 8363529"/>
                <a:gd name="connsiteY431" fmla="*/ 852312 h 1517480"/>
                <a:gd name="connsiteX432" fmla="*/ 4691956 w 8363529"/>
                <a:gd name="connsiteY432" fmla="*/ 798773 h 1517480"/>
                <a:gd name="connsiteX433" fmla="*/ 4683603 w 8363529"/>
                <a:gd name="connsiteY433" fmla="*/ 791254 h 1517480"/>
                <a:gd name="connsiteX434" fmla="*/ 4675201 w 8363529"/>
                <a:gd name="connsiteY434" fmla="*/ 835869 h 1517480"/>
                <a:gd name="connsiteX435" fmla="*/ 4608317 w 8363529"/>
                <a:gd name="connsiteY435" fmla="*/ 1200604 h 1517480"/>
                <a:gd name="connsiteX436" fmla="*/ 4599964 w 8363529"/>
                <a:gd name="connsiteY436" fmla="*/ 1247213 h 1517480"/>
                <a:gd name="connsiteX437" fmla="*/ 4591572 w 8363529"/>
                <a:gd name="connsiteY437" fmla="*/ 1235948 h 1517480"/>
                <a:gd name="connsiteX438" fmla="*/ 4524687 w 8363529"/>
                <a:gd name="connsiteY438" fmla="*/ 1155204 h 1517480"/>
                <a:gd name="connsiteX439" fmla="*/ 4516324 w 8363529"/>
                <a:gd name="connsiteY439" fmla="*/ 1146126 h 1517480"/>
                <a:gd name="connsiteX440" fmla="*/ 4507932 w 8363529"/>
                <a:gd name="connsiteY440" fmla="*/ 1153085 h 1517480"/>
                <a:gd name="connsiteX441" fmla="*/ 4441048 w 8363529"/>
                <a:gd name="connsiteY441" fmla="*/ 1205704 h 1517480"/>
                <a:gd name="connsiteX442" fmla="*/ 4432695 w 8363529"/>
                <a:gd name="connsiteY442" fmla="*/ 1211908 h 1517480"/>
                <a:gd name="connsiteX443" fmla="*/ 4424303 w 8363529"/>
                <a:gd name="connsiteY443" fmla="*/ 1101065 h 1517480"/>
                <a:gd name="connsiteX444" fmla="*/ 4357409 w 8363529"/>
                <a:gd name="connsiteY444" fmla="*/ 206412 h 1517480"/>
                <a:gd name="connsiteX445" fmla="*/ 4349055 w 8363529"/>
                <a:gd name="connsiteY445" fmla="*/ 93606 h 1517480"/>
                <a:gd name="connsiteX446" fmla="*/ 4340664 w 8363529"/>
                <a:gd name="connsiteY446" fmla="*/ 213109 h 1517480"/>
                <a:gd name="connsiteX447" fmla="*/ 4273779 w 8363529"/>
                <a:gd name="connsiteY447" fmla="*/ 1247523 h 1517480"/>
                <a:gd name="connsiteX448" fmla="*/ 4265416 w 8363529"/>
                <a:gd name="connsiteY448" fmla="*/ 1387544 h 1517480"/>
                <a:gd name="connsiteX449" fmla="*/ 4257024 w 8363529"/>
                <a:gd name="connsiteY449" fmla="*/ 1310391 h 1517480"/>
                <a:gd name="connsiteX450" fmla="*/ 4190140 w 8363529"/>
                <a:gd name="connsiteY450" fmla="*/ 818546 h 1517480"/>
                <a:gd name="connsiteX451" fmla="*/ 4181787 w 8363529"/>
                <a:gd name="connsiteY451" fmla="*/ 769294 h 1517480"/>
                <a:gd name="connsiteX452" fmla="*/ 4173394 w 8363529"/>
                <a:gd name="connsiteY452" fmla="*/ 803845 h 1517480"/>
                <a:gd name="connsiteX453" fmla="*/ 4106500 w 8363529"/>
                <a:gd name="connsiteY453" fmla="*/ 1226725 h 1517480"/>
                <a:gd name="connsiteX454" fmla="*/ 4098147 w 8363529"/>
                <a:gd name="connsiteY454" fmla="*/ 1309404 h 1517480"/>
                <a:gd name="connsiteX455" fmla="*/ 4089755 w 8363529"/>
                <a:gd name="connsiteY455" fmla="*/ 1263733 h 1517480"/>
                <a:gd name="connsiteX456" fmla="*/ 4022871 w 8363529"/>
                <a:gd name="connsiteY456" fmla="*/ 1025868 h 1517480"/>
                <a:gd name="connsiteX457" fmla="*/ 4014517 w 8363529"/>
                <a:gd name="connsiteY457" fmla="*/ 1006134 h 1517480"/>
                <a:gd name="connsiteX458" fmla="*/ 4006154 w 8363529"/>
                <a:gd name="connsiteY458" fmla="*/ 1024474 h 1517480"/>
                <a:gd name="connsiteX459" fmla="*/ 3939231 w 8363529"/>
                <a:gd name="connsiteY459" fmla="*/ 1190848 h 1517480"/>
                <a:gd name="connsiteX460" fmla="*/ 3930878 w 8363529"/>
                <a:gd name="connsiteY460" fmla="*/ 1214511 h 1517480"/>
                <a:gd name="connsiteX461" fmla="*/ 3922525 w 8363529"/>
                <a:gd name="connsiteY461" fmla="*/ 1214104 h 1517480"/>
                <a:gd name="connsiteX462" fmla="*/ 3855602 w 8363529"/>
                <a:gd name="connsiteY462" fmla="*/ 1210320 h 1517480"/>
                <a:gd name="connsiteX463" fmla="*/ 3847239 w 8363529"/>
                <a:gd name="connsiteY463" fmla="*/ 1209788 h 1517480"/>
                <a:gd name="connsiteX464" fmla="*/ 3838885 w 8363529"/>
                <a:gd name="connsiteY464" fmla="*/ 1186048 h 1517480"/>
                <a:gd name="connsiteX465" fmla="*/ 3771962 w 8363529"/>
                <a:gd name="connsiteY465" fmla="*/ 1012454 h 1517480"/>
                <a:gd name="connsiteX466" fmla="*/ 3763609 w 8363529"/>
                <a:gd name="connsiteY466" fmla="*/ 992643 h 1517480"/>
                <a:gd name="connsiteX467" fmla="*/ 3755246 w 8363529"/>
                <a:gd name="connsiteY467" fmla="*/ 1011012 h 1517480"/>
                <a:gd name="connsiteX468" fmla="*/ 3688323 w 8363529"/>
                <a:gd name="connsiteY468" fmla="*/ 1178412 h 1517480"/>
                <a:gd name="connsiteX469" fmla="*/ 3679970 w 8363529"/>
                <a:gd name="connsiteY469" fmla="*/ 1202268 h 1517480"/>
                <a:gd name="connsiteX470" fmla="*/ 3671616 w 8363529"/>
                <a:gd name="connsiteY470" fmla="*/ 1118602 h 1517480"/>
                <a:gd name="connsiteX471" fmla="*/ 3604693 w 8363529"/>
                <a:gd name="connsiteY471" fmla="*/ 617166 h 1517480"/>
                <a:gd name="connsiteX472" fmla="*/ 3596330 w 8363529"/>
                <a:gd name="connsiteY472" fmla="*/ 569753 h 1517480"/>
                <a:gd name="connsiteX473" fmla="*/ 3587977 w 8363529"/>
                <a:gd name="connsiteY473" fmla="*/ 600645 h 1517480"/>
                <a:gd name="connsiteX474" fmla="*/ 3521054 w 8363529"/>
                <a:gd name="connsiteY474" fmla="*/ 885198 h 1517480"/>
                <a:gd name="connsiteX475" fmla="*/ 3512701 w 8363529"/>
                <a:gd name="connsiteY475" fmla="*/ 926252 h 1517480"/>
                <a:gd name="connsiteX476" fmla="*/ 3504347 w 8363529"/>
                <a:gd name="connsiteY476" fmla="*/ 945153 h 1517480"/>
                <a:gd name="connsiteX477" fmla="*/ 3437424 w 8363529"/>
                <a:gd name="connsiteY477" fmla="*/ 1076754 h 1517480"/>
                <a:gd name="connsiteX478" fmla="*/ 3429061 w 8363529"/>
                <a:gd name="connsiteY478" fmla="*/ 1091117 h 1517480"/>
                <a:gd name="connsiteX479" fmla="*/ 3420708 w 8363529"/>
                <a:gd name="connsiteY479" fmla="*/ 1106737 h 1517480"/>
                <a:gd name="connsiteX480" fmla="*/ 3353785 w 8363529"/>
                <a:gd name="connsiteY480" fmla="*/ 1413026 h 1517480"/>
                <a:gd name="connsiteX481" fmla="*/ 3345432 w 8363529"/>
                <a:gd name="connsiteY481" fmla="*/ 1517481 h 1517480"/>
                <a:gd name="connsiteX482" fmla="*/ 3337069 w 8363529"/>
                <a:gd name="connsiteY482" fmla="*/ 1462897 h 1517480"/>
                <a:gd name="connsiteX483" fmla="*/ 3270146 w 8363529"/>
                <a:gd name="connsiteY483" fmla="*/ 1271718 h 1517480"/>
                <a:gd name="connsiteX484" fmla="*/ 3261792 w 8363529"/>
                <a:gd name="connsiteY484" fmla="*/ 1260482 h 1517480"/>
                <a:gd name="connsiteX485" fmla="*/ 3253439 w 8363529"/>
                <a:gd name="connsiteY485" fmla="*/ 1187635 h 1517480"/>
                <a:gd name="connsiteX486" fmla="*/ 3186516 w 8363529"/>
                <a:gd name="connsiteY486" fmla="*/ 724340 h 1517480"/>
                <a:gd name="connsiteX487" fmla="*/ 3178153 w 8363529"/>
                <a:gd name="connsiteY487" fmla="*/ 678031 h 1517480"/>
                <a:gd name="connsiteX488" fmla="*/ 3169800 w 8363529"/>
                <a:gd name="connsiteY488" fmla="*/ 683363 h 1517480"/>
                <a:gd name="connsiteX489" fmla="*/ 3102877 w 8363529"/>
                <a:gd name="connsiteY489" fmla="*/ 742563 h 1517480"/>
                <a:gd name="connsiteX490" fmla="*/ 3094523 w 8363529"/>
                <a:gd name="connsiteY490" fmla="*/ 752958 h 1517480"/>
                <a:gd name="connsiteX491" fmla="*/ 3086161 w 8363529"/>
                <a:gd name="connsiteY491" fmla="*/ 795676 h 1517480"/>
                <a:gd name="connsiteX492" fmla="*/ 3019238 w 8363529"/>
                <a:gd name="connsiteY492" fmla="*/ 1063941 h 1517480"/>
                <a:gd name="connsiteX493" fmla="*/ 3010884 w 8363529"/>
                <a:gd name="connsiteY493" fmla="*/ 1090439 h 1517480"/>
                <a:gd name="connsiteX494" fmla="*/ 3002531 w 8363529"/>
                <a:gd name="connsiteY494" fmla="*/ 1031394 h 1517480"/>
                <a:gd name="connsiteX495" fmla="*/ 2935608 w 8363529"/>
                <a:gd name="connsiteY495" fmla="*/ 538871 h 1517480"/>
                <a:gd name="connsiteX496" fmla="*/ 2927245 w 8363529"/>
                <a:gd name="connsiteY496" fmla="*/ 474715 h 1517480"/>
                <a:gd name="connsiteX497" fmla="*/ 2918892 w 8363529"/>
                <a:gd name="connsiteY497" fmla="*/ 532561 h 1517480"/>
                <a:gd name="connsiteX498" fmla="*/ 2851968 w 8363529"/>
                <a:gd name="connsiteY498" fmla="*/ 983004 h 1517480"/>
                <a:gd name="connsiteX499" fmla="*/ 2843615 w 8363529"/>
                <a:gd name="connsiteY499" fmla="*/ 1037781 h 1517480"/>
                <a:gd name="connsiteX500" fmla="*/ 2835262 w 8363529"/>
                <a:gd name="connsiteY500" fmla="*/ 1047498 h 1517480"/>
                <a:gd name="connsiteX501" fmla="*/ 2768329 w 8363529"/>
                <a:gd name="connsiteY501" fmla="*/ 1149794 h 1517480"/>
                <a:gd name="connsiteX502" fmla="*/ 2759976 w 8363529"/>
                <a:gd name="connsiteY502" fmla="*/ 1166808 h 1517480"/>
                <a:gd name="connsiteX503" fmla="*/ 2751623 w 8363529"/>
                <a:gd name="connsiteY503" fmla="*/ 1186919 h 1517480"/>
                <a:gd name="connsiteX504" fmla="*/ 2684699 w 8363529"/>
                <a:gd name="connsiteY504" fmla="*/ 1322488 h 1517480"/>
                <a:gd name="connsiteX505" fmla="*/ 2676346 w 8363529"/>
                <a:gd name="connsiteY505" fmla="*/ 1336851 h 1517480"/>
                <a:gd name="connsiteX506" fmla="*/ 2667983 w 8363529"/>
                <a:gd name="connsiteY506" fmla="*/ 1323843 h 1517480"/>
                <a:gd name="connsiteX507" fmla="*/ 2601060 w 8363529"/>
                <a:gd name="connsiteY507" fmla="*/ 1221015 h 1517480"/>
                <a:gd name="connsiteX508" fmla="*/ 2592707 w 8363529"/>
                <a:gd name="connsiteY508" fmla="*/ 1208317 h 1517480"/>
                <a:gd name="connsiteX509" fmla="*/ 2584354 w 8363529"/>
                <a:gd name="connsiteY509" fmla="*/ 1208772 h 1517480"/>
                <a:gd name="connsiteX510" fmla="*/ 2517430 w 8363529"/>
                <a:gd name="connsiteY510" fmla="*/ 1211869 h 1517480"/>
                <a:gd name="connsiteX511" fmla="*/ 2509068 w 8363529"/>
                <a:gd name="connsiteY511" fmla="*/ 1212169 h 1517480"/>
                <a:gd name="connsiteX512" fmla="*/ 2500714 w 8363529"/>
                <a:gd name="connsiteY512" fmla="*/ 1182951 h 1517480"/>
                <a:gd name="connsiteX513" fmla="*/ 2433791 w 8363529"/>
                <a:gd name="connsiteY513" fmla="*/ 935446 h 1517480"/>
                <a:gd name="connsiteX514" fmla="*/ 2425438 w 8363529"/>
                <a:gd name="connsiteY514" fmla="*/ 902705 h 1517480"/>
                <a:gd name="connsiteX515" fmla="*/ 2417075 w 8363529"/>
                <a:gd name="connsiteY515" fmla="*/ 922207 h 1517480"/>
                <a:gd name="connsiteX516" fmla="*/ 2350152 w 8363529"/>
                <a:gd name="connsiteY516" fmla="*/ 1086510 h 1517480"/>
                <a:gd name="connsiteX517" fmla="*/ 2341799 w 8363529"/>
                <a:gd name="connsiteY517" fmla="*/ 1108169 h 1517480"/>
                <a:gd name="connsiteX518" fmla="*/ 2333445 w 8363529"/>
                <a:gd name="connsiteY518" fmla="*/ 1116453 h 1517480"/>
                <a:gd name="connsiteX519" fmla="*/ 2266522 w 8363529"/>
                <a:gd name="connsiteY519" fmla="*/ 1197768 h 1517480"/>
                <a:gd name="connsiteX520" fmla="*/ 2258159 w 8363529"/>
                <a:gd name="connsiteY520" fmla="*/ 1210282 h 1517480"/>
                <a:gd name="connsiteX521" fmla="*/ 2249806 w 8363529"/>
                <a:gd name="connsiteY521" fmla="*/ 1194855 h 1517480"/>
                <a:gd name="connsiteX522" fmla="*/ 2182883 w 8363529"/>
                <a:gd name="connsiteY522" fmla="*/ 1091920 h 1517480"/>
                <a:gd name="connsiteX523" fmla="*/ 2174530 w 8363529"/>
                <a:gd name="connsiteY523" fmla="*/ 1081139 h 1517480"/>
                <a:gd name="connsiteX524" fmla="*/ 2166176 w 8363529"/>
                <a:gd name="connsiteY524" fmla="*/ 1021261 h 1517480"/>
                <a:gd name="connsiteX525" fmla="*/ 2099253 w 8363529"/>
                <a:gd name="connsiteY525" fmla="*/ 465647 h 1517480"/>
                <a:gd name="connsiteX526" fmla="*/ 2090890 w 8363529"/>
                <a:gd name="connsiteY526" fmla="*/ 384894 h 1517480"/>
                <a:gd name="connsiteX527" fmla="*/ 2082537 w 8363529"/>
                <a:gd name="connsiteY527" fmla="*/ 488777 h 1517480"/>
                <a:gd name="connsiteX528" fmla="*/ 2015614 w 8363529"/>
                <a:gd name="connsiteY528" fmla="*/ 1123635 h 1517480"/>
                <a:gd name="connsiteX529" fmla="*/ 2007260 w 8363529"/>
                <a:gd name="connsiteY529" fmla="*/ 1184722 h 1517480"/>
                <a:gd name="connsiteX530" fmla="*/ 1998898 w 8363529"/>
                <a:gd name="connsiteY530" fmla="*/ 1183028 h 1517480"/>
                <a:gd name="connsiteX531" fmla="*/ 1931975 w 8363529"/>
                <a:gd name="connsiteY531" fmla="*/ 1165560 h 1517480"/>
                <a:gd name="connsiteX532" fmla="*/ 1923621 w 8363529"/>
                <a:gd name="connsiteY532" fmla="*/ 1162724 h 1517480"/>
                <a:gd name="connsiteX533" fmla="*/ 1915268 w 8363529"/>
                <a:gd name="connsiteY533" fmla="*/ 1163818 h 1517480"/>
                <a:gd name="connsiteX534" fmla="*/ 1848345 w 8363529"/>
                <a:gd name="connsiteY534" fmla="*/ 1172557 h 1517480"/>
                <a:gd name="connsiteX535" fmla="*/ 1839982 w 8363529"/>
                <a:gd name="connsiteY535" fmla="*/ 1173650 h 1517480"/>
                <a:gd name="connsiteX536" fmla="*/ 1831629 w 8363529"/>
                <a:gd name="connsiteY536" fmla="*/ 1186425 h 1517480"/>
                <a:gd name="connsiteX537" fmla="*/ 1764706 w 8363529"/>
                <a:gd name="connsiteY537" fmla="*/ 1282412 h 1517480"/>
                <a:gd name="connsiteX538" fmla="*/ 1756352 w 8363529"/>
                <a:gd name="connsiteY538" fmla="*/ 1293677 h 1517480"/>
                <a:gd name="connsiteX539" fmla="*/ 1747989 w 8363529"/>
                <a:gd name="connsiteY539" fmla="*/ 1277534 h 1517480"/>
                <a:gd name="connsiteX540" fmla="*/ 1681066 w 8363529"/>
                <a:gd name="connsiteY540" fmla="*/ 1171037 h 1517480"/>
                <a:gd name="connsiteX541" fmla="*/ 1672713 w 8363529"/>
                <a:gd name="connsiteY541" fmla="*/ 1160004 h 1517480"/>
                <a:gd name="connsiteX542" fmla="*/ 1664360 w 8363529"/>
                <a:gd name="connsiteY542" fmla="*/ 1166615 h 1517480"/>
                <a:gd name="connsiteX543" fmla="*/ 1597437 w 8363529"/>
                <a:gd name="connsiteY543" fmla="*/ 1245171 h 1517480"/>
                <a:gd name="connsiteX544" fmla="*/ 1589074 w 8363529"/>
                <a:gd name="connsiteY544" fmla="*/ 1260036 h 1517480"/>
                <a:gd name="connsiteX545" fmla="*/ 1580720 w 8363529"/>
                <a:gd name="connsiteY545" fmla="*/ 1258710 h 1517480"/>
                <a:gd name="connsiteX546" fmla="*/ 1513797 w 8363529"/>
                <a:gd name="connsiteY546" fmla="*/ 1250542 h 1517480"/>
                <a:gd name="connsiteX547" fmla="*/ 1505444 w 8363529"/>
                <a:gd name="connsiteY547" fmla="*/ 1249749 h 1517480"/>
                <a:gd name="connsiteX548" fmla="*/ 1497091 w 8363529"/>
                <a:gd name="connsiteY548" fmla="*/ 1248084 h 1517480"/>
                <a:gd name="connsiteX549" fmla="*/ 1430158 w 8363529"/>
                <a:gd name="connsiteY549" fmla="*/ 1237196 h 1517480"/>
                <a:gd name="connsiteX550" fmla="*/ 1421805 w 8363529"/>
                <a:gd name="connsiteY550" fmla="*/ 1236064 h 1517480"/>
                <a:gd name="connsiteX551" fmla="*/ 1413451 w 8363529"/>
                <a:gd name="connsiteY551" fmla="*/ 1237235 h 1517480"/>
                <a:gd name="connsiteX552" fmla="*/ 1346528 w 8363529"/>
                <a:gd name="connsiteY552" fmla="*/ 1251190 h 1517480"/>
                <a:gd name="connsiteX553" fmla="*/ 1338175 w 8363529"/>
                <a:gd name="connsiteY553" fmla="*/ 1253833 h 1517480"/>
                <a:gd name="connsiteX554" fmla="*/ 1329812 w 8363529"/>
                <a:gd name="connsiteY554" fmla="*/ 1208995 h 1517480"/>
                <a:gd name="connsiteX555" fmla="*/ 1262889 w 8363529"/>
                <a:gd name="connsiteY555" fmla="*/ 987688 h 1517480"/>
                <a:gd name="connsiteX556" fmla="*/ 1254536 w 8363529"/>
                <a:gd name="connsiteY556" fmla="*/ 970180 h 1517480"/>
                <a:gd name="connsiteX557" fmla="*/ 1246182 w 8363529"/>
                <a:gd name="connsiteY557" fmla="*/ 967345 h 1517480"/>
                <a:gd name="connsiteX558" fmla="*/ 1179259 w 8363529"/>
                <a:gd name="connsiteY558" fmla="*/ 940585 h 1517480"/>
                <a:gd name="connsiteX559" fmla="*/ 1170896 w 8363529"/>
                <a:gd name="connsiteY559" fmla="*/ 936617 h 1517480"/>
                <a:gd name="connsiteX560" fmla="*/ 1162543 w 8363529"/>
                <a:gd name="connsiteY560" fmla="*/ 953776 h 1517480"/>
                <a:gd name="connsiteX561" fmla="*/ 1095620 w 8363529"/>
                <a:gd name="connsiteY561" fmla="*/ 1083597 h 1517480"/>
                <a:gd name="connsiteX562" fmla="*/ 1087267 w 8363529"/>
                <a:gd name="connsiteY562" fmla="*/ 1098946 h 1517480"/>
                <a:gd name="connsiteX563" fmla="*/ 1078904 w 8363529"/>
                <a:gd name="connsiteY563" fmla="*/ 1105604 h 1517480"/>
                <a:gd name="connsiteX564" fmla="*/ 1011981 w 8363529"/>
                <a:gd name="connsiteY564" fmla="*/ 1149533 h 1517480"/>
                <a:gd name="connsiteX565" fmla="*/ 1003627 w 8363529"/>
                <a:gd name="connsiteY565" fmla="*/ 1154101 h 1517480"/>
                <a:gd name="connsiteX566" fmla="*/ 995274 w 8363529"/>
                <a:gd name="connsiteY566" fmla="*/ 1140339 h 1517480"/>
                <a:gd name="connsiteX567" fmla="*/ 928351 w 8363529"/>
                <a:gd name="connsiteY567" fmla="*/ 997898 h 1517480"/>
                <a:gd name="connsiteX568" fmla="*/ 919988 w 8363529"/>
                <a:gd name="connsiteY568" fmla="*/ 974681 h 1517480"/>
                <a:gd name="connsiteX569" fmla="*/ 911635 w 8363529"/>
                <a:gd name="connsiteY569" fmla="*/ 994269 h 1517480"/>
                <a:gd name="connsiteX570" fmla="*/ 844712 w 8363529"/>
                <a:gd name="connsiteY570" fmla="*/ 1121215 h 1517480"/>
                <a:gd name="connsiteX571" fmla="*/ 836358 w 8363529"/>
                <a:gd name="connsiteY571" fmla="*/ 1134145 h 1517480"/>
                <a:gd name="connsiteX572" fmla="*/ 828005 w 8363529"/>
                <a:gd name="connsiteY572" fmla="*/ 1139023 h 1517480"/>
                <a:gd name="connsiteX573" fmla="*/ 761082 w 8363529"/>
                <a:gd name="connsiteY573" fmla="*/ 1188622 h 1517480"/>
                <a:gd name="connsiteX574" fmla="*/ 752719 w 8363529"/>
                <a:gd name="connsiteY574" fmla="*/ 1196558 h 1517480"/>
                <a:gd name="connsiteX575" fmla="*/ 744366 w 8363529"/>
                <a:gd name="connsiteY575" fmla="*/ 1186803 h 1517480"/>
                <a:gd name="connsiteX576" fmla="*/ 677443 w 8363529"/>
                <a:gd name="connsiteY576" fmla="*/ 1093352 h 1517480"/>
                <a:gd name="connsiteX577" fmla="*/ 669089 w 8363529"/>
                <a:gd name="connsiteY577" fmla="*/ 1079367 h 1517480"/>
                <a:gd name="connsiteX578" fmla="*/ 660727 w 8363529"/>
                <a:gd name="connsiteY578" fmla="*/ 1055472 h 1517480"/>
                <a:gd name="connsiteX579" fmla="*/ 593803 w 8363529"/>
                <a:gd name="connsiteY579" fmla="*/ 925458 h 1517480"/>
                <a:gd name="connsiteX580" fmla="*/ 585450 w 8363529"/>
                <a:gd name="connsiteY580" fmla="*/ 914193 h 1517480"/>
                <a:gd name="connsiteX581" fmla="*/ 577097 w 8363529"/>
                <a:gd name="connsiteY581" fmla="*/ 908938 h 1517480"/>
                <a:gd name="connsiteX582" fmla="*/ 510174 w 8363529"/>
                <a:gd name="connsiteY582" fmla="*/ 841647 h 1517480"/>
                <a:gd name="connsiteX583" fmla="*/ 501811 w 8363529"/>
                <a:gd name="connsiteY583" fmla="*/ 827807 h 1517480"/>
                <a:gd name="connsiteX584" fmla="*/ 493458 w 8363529"/>
                <a:gd name="connsiteY584" fmla="*/ 826530 h 1517480"/>
                <a:gd name="connsiteX585" fmla="*/ 426534 w 8363529"/>
                <a:gd name="connsiteY585" fmla="*/ 820781 h 1517480"/>
                <a:gd name="connsiteX586" fmla="*/ 418181 w 8363529"/>
                <a:gd name="connsiteY586" fmla="*/ 820365 h 1517480"/>
                <a:gd name="connsiteX587" fmla="*/ 409818 w 8363529"/>
                <a:gd name="connsiteY587" fmla="*/ 834050 h 1517480"/>
                <a:gd name="connsiteX588" fmla="*/ 342895 w 8363529"/>
                <a:gd name="connsiteY588" fmla="*/ 982694 h 1517480"/>
                <a:gd name="connsiteX589" fmla="*/ 334542 w 8363529"/>
                <a:gd name="connsiteY589" fmla="*/ 1008254 h 1517480"/>
                <a:gd name="connsiteX590" fmla="*/ 326189 w 8363529"/>
                <a:gd name="connsiteY590" fmla="*/ 1036000 h 1517480"/>
                <a:gd name="connsiteX591" fmla="*/ 259304 w 8363529"/>
                <a:gd name="connsiteY591" fmla="*/ 1292206 h 1517480"/>
                <a:gd name="connsiteX592" fmla="*/ 250903 w 8363529"/>
                <a:gd name="connsiteY592" fmla="*/ 1329253 h 1517480"/>
                <a:gd name="connsiteX593" fmla="*/ 242549 w 8363529"/>
                <a:gd name="connsiteY593" fmla="*/ 1291935 h 1517480"/>
                <a:gd name="connsiteX594" fmla="*/ 175665 w 8363529"/>
                <a:gd name="connsiteY594" fmla="*/ 1083258 h 1517480"/>
                <a:gd name="connsiteX595" fmla="*/ 167273 w 8363529"/>
                <a:gd name="connsiteY595" fmla="*/ 1064773 h 1517480"/>
                <a:gd name="connsiteX596" fmla="*/ 158920 w 8363529"/>
                <a:gd name="connsiteY596" fmla="*/ 1060011 h 1517480"/>
                <a:gd name="connsiteX597" fmla="*/ 92029 w 8363529"/>
                <a:gd name="connsiteY597" fmla="*/ 1016267 h 1517480"/>
                <a:gd name="connsiteX598" fmla="*/ 83635 w 8363529"/>
                <a:gd name="connsiteY598" fmla="*/ 1009957 h 1517480"/>
                <a:gd name="connsiteX599" fmla="*/ 75279 w 8363529"/>
                <a:gd name="connsiteY599" fmla="*/ 980429 h 1517480"/>
                <a:gd name="connsiteX600" fmla="*/ 8394 w 8363529"/>
                <a:gd name="connsiteY600" fmla="*/ 747209 h 1517480"/>
                <a:gd name="connsiteX601" fmla="*/ 0 w 8363529"/>
                <a:gd name="connsiteY601" fmla="*/ 718446 h 1517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  <a:cxn ang="0">
                  <a:pos x="connsiteX466" y="connsiteY466"/>
                </a:cxn>
                <a:cxn ang="0">
                  <a:pos x="connsiteX467" y="connsiteY467"/>
                </a:cxn>
                <a:cxn ang="0">
                  <a:pos x="connsiteX468" y="connsiteY468"/>
                </a:cxn>
                <a:cxn ang="0">
                  <a:pos x="connsiteX469" y="connsiteY469"/>
                </a:cxn>
                <a:cxn ang="0">
                  <a:pos x="connsiteX470" y="connsiteY470"/>
                </a:cxn>
                <a:cxn ang="0">
                  <a:pos x="connsiteX471" y="connsiteY471"/>
                </a:cxn>
                <a:cxn ang="0">
                  <a:pos x="connsiteX472" y="connsiteY472"/>
                </a:cxn>
                <a:cxn ang="0">
                  <a:pos x="connsiteX473" y="connsiteY473"/>
                </a:cxn>
                <a:cxn ang="0">
                  <a:pos x="connsiteX474" y="connsiteY474"/>
                </a:cxn>
                <a:cxn ang="0">
                  <a:pos x="connsiteX475" y="connsiteY475"/>
                </a:cxn>
                <a:cxn ang="0">
                  <a:pos x="connsiteX476" y="connsiteY476"/>
                </a:cxn>
                <a:cxn ang="0">
                  <a:pos x="connsiteX477" y="connsiteY477"/>
                </a:cxn>
                <a:cxn ang="0">
                  <a:pos x="connsiteX478" y="connsiteY478"/>
                </a:cxn>
                <a:cxn ang="0">
                  <a:pos x="connsiteX479" y="connsiteY479"/>
                </a:cxn>
                <a:cxn ang="0">
                  <a:pos x="connsiteX480" y="connsiteY480"/>
                </a:cxn>
                <a:cxn ang="0">
                  <a:pos x="connsiteX481" y="connsiteY481"/>
                </a:cxn>
                <a:cxn ang="0">
                  <a:pos x="connsiteX482" y="connsiteY482"/>
                </a:cxn>
                <a:cxn ang="0">
                  <a:pos x="connsiteX483" y="connsiteY483"/>
                </a:cxn>
                <a:cxn ang="0">
                  <a:pos x="connsiteX484" y="connsiteY484"/>
                </a:cxn>
                <a:cxn ang="0">
                  <a:pos x="connsiteX485" y="connsiteY485"/>
                </a:cxn>
                <a:cxn ang="0">
                  <a:pos x="connsiteX486" y="connsiteY486"/>
                </a:cxn>
                <a:cxn ang="0">
                  <a:pos x="connsiteX487" y="connsiteY487"/>
                </a:cxn>
                <a:cxn ang="0">
                  <a:pos x="connsiteX488" y="connsiteY488"/>
                </a:cxn>
                <a:cxn ang="0">
                  <a:pos x="connsiteX489" y="connsiteY489"/>
                </a:cxn>
                <a:cxn ang="0">
                  <a:pos x="connsiteX490" y="connsiteY490"/>
                </a:cxn>
                <a:cxn ang="0">
                  <a:pos x="connsiteX491" y="connsiteY491"/>
                </a:cxn>
                <a:cxn ang="0">
                  <a:pos x="connsiteX492" y="connsiteY492"/>
                </a:cxn>
                <a:cxn ang="0">
                  <a:pos x="connsiteX493" y="connsiteY493"/>
                </a:cxn>
                <a:cxn ang="0">
                  <a:pos x="connsiteX494" y="connsiteY494"/>
                </a:cxn>
                <a:cxn ang="0">
                  <a:pos x="connsiteX495" y="connsiteY495"/>
                </a:cxn>
                <a:cxn ang="0">
                  <a:pos x="connsiteX496" y="connsiteY496"/>
                </a:cxn>
                <a:cxn ang="0">
                  <a:pos x="connsiteX497" y="connsiteY497"/>
                </a:cxn>
                <a:cxn ang="0">
                  <a:pos x="connsiteX498" y="connsiteY498"/>
                </a:cxn>
                <a:cxn ang="0">
                  <a:pos x="connsiteX499" y="connsiteY499"/>
                </a:cxn>
                <a:cxn ang="0">
                  <a:pos x="connsiteX500" y="connsiteY500"/>
                </a:cxn>
                <a:cxn ang="0">
                  <a:pos x="connsiteX501" y="connsiteY501"/>
                </a:cxn>
                <a:cxn ang="0">
                  <a:pos x="connsiteX502" y="connsiteY502"/>
                </a:cxn>
                <a:cxn ang="0">
                  <a:pos x="connsiteX503" y="connsiteY503"/>
                </a:cxn>
                <a:cxn ang="0">
                  <a:pos x="connsiteX504" y="connsiteY504"/>
                </a:cxn>
                <a:cxn ang="0">
                  <a:pos x="connsiteX505" y="connsiteY505"/>
                </a:cxn>
                <a:cxn ang="0">
                  <a:pos x="connsiteX506" y="connsiteY506"/>
                </a:cxn>
                <a:cxn ang="0">
                  <a:pos x="connsiteX507" y="connsiteY507"/>
                </a:cxn>
                <a:cxn ang="0">
                  <a:pos x="connsiteX508" y="connsiteY508"/>
                </a:cxn>
                <a:cxn ang="0">
                  <a:pos x="connsiteX509" y="connsiteY509"/>
                </a:cxn>
                <a:cxn ang="0">
                  <a:pos x="connsiteX510" y="connsiteY510"/>
                </a:cxn>
                <a:cxn ang="0">
                  <a:pos x="connsiteX511" y="connsiteY511"/>
                </a:cxn>
                <a:cxn ang="0">
                  <a:pos x="connsiteX512" y="connsiteY512"/>
                </a:cxn>
                <a:cxn ang="0">
                  <a:pos x="connsiteX513" y="connsiteY513"/>
                </a:cxn>
                <a:cxn ang="0">
                  <a:pos x="connsiteX514" y="connsiteY514"/>
                </a:cxn>
                <a:cxn ang="0">
                  <a:pos x="connsiteX515" y="connsiteY515"/>
                </a:cxn>
                <a:cxn ang="0">
                  <a:pos x="connsiteX516" y="connsiteY516"/>
                </a:cxn>
                <a:cxn ang="0">
                  <a:pos x="connsiteX517" y="connsiteY517"/>
                </a:cxn>
                <a:cxn ang="0">
                  <a:pos x="connsiteX518" y="connsiteY518"/>
                </a:cxn>
                <a:cxn ang="0">
                  <a:pos x="connsiteX519" y="connsiteY519"/>
                </a:cxn>
                <a:cxn ang="0">
                  <a:pos x="connsiteX520" y="connsiteY520"/>
                </a:cxn>
                <a:cxn ang="0">
                  <a:pos x="connsiteX521" y="connsiteY521"/>
                </a:cxn>
                <a:cxn ang="0">
                  <a:pos x="connsiteX522" y="connsiteY522"/>
                </a:cxn>
                <a:cxn ang="0">
                  <a:pos x="connsiteX523" y="connsiteY523"/>
                </a:cxn>
                <a:cxn ang="0">
                  <a:pos x="connsiteX524" y="connsiteY524"/>
                </a:cxn>
                <a:cxn ang="0">
                  <a:pos x="connsiteX525" y="connsiteY525"/>
                </a:cxn>
                <a:cxn ang="0">
                  <a:pos x="connsiteX526" y="connsiteY526"/>
                </a:cxn>
                <a:cxn ang="0">
                  <a:pos x="connsiteX527" y="connsiteY527"/>
                </a:cxn>
                <a:cxn ang="0">
                  <a:pos x="connsiteX528" y="connsiteY528"/>
                </a:cxn>
                <a:cxn ang="0">
                  <a:pos x="connsiteX529" y="connsiteY529"/>
                </a:cxn>
                <a:cxn ang="0">
                  <a:pos x="connsiteX530" y="connsiteY530"/>
                </a:cxn>
                <a:cxn ang="0">
                  <a:pos x="connsiteX531" y="connsiteY531"/>
                </a:cxn>
                <a:cxn ang="0">
                  <a:pos x="connsiteX532" y="connsiteY532"/>
                </a:cxn>
                <a:cxn ang="0">
                  <a:pos x="connsiteX533" y="connsiteY533"/>
                </a:cxn>
                <a:cxn ang="0">
                  <a:pos x="connsiteX534" y="connsiteY534"/>
                </a:cxn>
                <a:cxn ang="0">
                  <a:pos x="connsiteX535" y="connsiteY535"/>
                </a:cxn>
                <a:cxn ang="0">
                  <a:pos x="connsiteX536" y="connsiteY536"/>
                </a:cxn>
                <a:cxn ang="0">
                  <a:pos x="connsiteX537" y="connsiteY537"/>
                </a:cxn>
                <a:cxn ang="0">
                  <a:pos x="connsiteX538" y="connsiteY538"/>
                </a:cxn>
                <a:cxn ang="0">
                  <a:pos x="connsiteX539" y="connsiteY539"/>
                </a:cxn>
                <a:cxn ang="0">
                  <a:pos x="connsiteX540" y="connsiteY540"/>
                </a:cxn>
                <a:cxn ang="0">
                  <a:pos x="connsiteX541" y="connsiteY541"/>
                </a:cxn>
                <a:cxn ang="0">
                  <a:pos x="connsiteX542" y="connsiteY542"/>
                </a:cxn>
                <a:cxn ang="0">
                  <a:pos x="connsiteX543" y="connsiteY543"/>
                </a:cxn>
                <a:cxn ang="0">
                  <a:pos x="connsiteX544" y="connsiteY544"/>
                </a:cxn>
                <a:cxn ang="0">
                  <a:pos x="connsiteX545" y="connsiteY545"/>
                </a:cxn>
                <a:cxn ang="0">
                  <a:pos x="connsiteX546" y="connsiteY546"/>
                </a:cxn>
                <a:cxn ang="0">
                  <a:pos x="connsiteX547" y="connsiteY547"/>
                </a:cxn>
                <a:cxn ang="0">
                  <a:pos x="connsiteX548" y="connsiteY548"/>
                </a:cxn>
                <a:cxn ang="0">
                  <a:pos x="connsiteX549" y="connsiteY549"/>
                </a:cxn>
                <a:cxn ang="0">
                  <a:pos x="connsiteX550" y="connsiteY550"/>
                </a:cxn>
                <a:cxn ang="0">
                  <a:pos x="connsiteX551" y="connsiteY551"/>
                </a:cxn>
                <a:cxn ang="0">
                  <a:pos x="connsiteX552" y="connsiteY552"/>
                </a:cxn>
                <a:cxn ang="0">
                  <a:pos x="connsiteX553" y="connsiteY553"/>
                </a:cxn>
                <a:cxn ang="0">
                  <a:pos x="connsiteX554" y="connsiteY554"/>
                </a:cxn>
                <a:cxn ang="0">
                  <a:pos x="connsiteX555" y="connsiteY555"/>
                </a:cxn>
                <a:cxn ang="0">
                  <a:pos x="connsiteX556" y="connsiteY556"/>
                </a:cxn>
                <a:cxn ang="0">
                  <a:pos x="connsiteX557" y="connsiteY557"/>
                </a:cxn>
                <a:cxn ang="0">
                  <a:pos x="connsiteX558" y="connsiteY558"/>
                </a:cxn>
                <a:cxn ang="0">
                  <a:pos x="connsiteX559" y="connsiteY559"/>
                </a:cxn>
                <a:cxn ang="0">
                  <a:pos x="connsiteX560" y="connsiteY560"/>
                </a:cxn>
                <a:cxn ang="0">
                  <a:pos x="connsiteX561" y="connsiteY561"/>
                </a:cxn>
                <a:cxn ang="0">
                  <a:pos x="connsiteX562" y="connsiteY562"/>
                </a:cxn>
                <a:cxn ang="0">
                  <a:pos x="connsiteX563" y="connsiteY563"/>
                </a:cxn>
                <a:cxn ang="0">
                  <a:pos x="connsiteX564" y="connsiteY564"/>
                </a:cxn>
                <a:cxn ang="0">
                  <a:pos x="connsiteX565" y="connsiteY565"/>
                </a:cxn>
                <a:cxn ang="0">
                  <a:pos x="connsiteX566" y="connsiteY566"/>
                </a:cxn>
                <a:cxn ang="0">
                  <a:pos x="connsiteX567" y="connsiteY567"/>
                </a:cxn>
                <a:cxn ang="0">
                  <a:pos x="connsiteX568" y="connsiteY568"/>
                </a:cxn>
                <a:cxn ang="0">
                  <a:pos x="connsiteX569" y="connsiteY569"/>
                </a:cxn>
                <a:cxn ang="0">
                  <a:pos x="connsiteX570" y="connsiteY570"/>
                </a:cxn>
                <a:cxn ang="0">
                  <a:pos x="connsiteX571" y="connsiteY571"/>
                </a:cxn>
                <a:cxn ang="0">
                  <a:pos x="connsiteX572" y="connsiteY572"/>
                </a:cxn>
                <a:cxn ang="0">
                  <a:pos x="connsiteX573" y="connsiteY573"/>
                </a:cxn>
                <a:cxn ang="0">
                  <a:pos x="connsiteX574" y="connsiteY574"/>
                </a:cxn>
                <a:cxn ang="0">
                  <a:pos x="connsiteX575" y="connsiteY575"/>
                </a:cxn>
                <a:cxn ang="0">
                  <a:pos x="connsiteX576" y="connsiteY576"/>
                </a:cxn>
                <a:cxn ang="0">
                  <a:pos x="connsiteX577" y="connsiteY577"/>
                </a:cxn>
                <a:cxn ang="0">
                  <a:pos x="connsiteX578" y="connsiteY578"/>
                </a:cxn>
                <a:cxn ang="0">
                  <a:pos x="connsiteX579" y="connsiteY579"/>
                </a:cxn>
                <a:cxn ang="0">
                  <a:pos x="connsiteX580" y="connsiteY580"/>
                </a:cxn>
                <a:cxn ang="0">
                  <a:pos x="connsiteX581" y="connsiteY581"/>
                </a:cxn>
                <a:cxn ang="0">
                  <a:pos x="connsiteX582" y="connsiteY582"/>
                </a:cxn>
                <a:cxn ang="0">
                  <a:pos x="connsiteX583" y="connsiteY583"/>
                </a:cxn>
                <a:cxn ang="0">
                  <a:pos x="connsiteX584" y="connsiteY584"/>
                </a:cxn>
                <a:cxn ang="0">
                  <a:pos x="connsiteX585" y="connsiteY585"/>
                </a:cxn>
                <a:cxn ang="0">
                  <a:pos x="connsiteX586" y="connsiteY586"/>
                </a:cxn>
                <a:cxn ang="0">
                  <a:pos x="connsiteX587" y="connsiteY587"/>
                </a:cxn>
                <a:cxn ang="0">
                  <a:pos x="connsiteX588" y="connsiteY588"/>
                </a:cxn>
                <a:cxn ang="0">
                  <a:pos x="connsiteX589" y="connsiteY589"/>
                </a:cxn>
                <a:cxn ang="0">
                  <a:pos x="connsiteX590" y="connsiteY590"/>
                </a:cxn>
                <a:cxn ang="0">
                  <a:pos x="connsiteX591" y="connsiteY591"/>
                </a:cxn>
                <a:cxn ang="0">
                  <a:pos x="connsiteX592" y="connsiteY592"/>
                </a:cxn>
                <a:cxn ang="0">
                  <a:pos x="connsiteX593" y="connsiteY593"/>
                </a:cxn>
                <a:cxn ang="0">
                  <a:pos x="connsiteX594" y="connsiteY594"/>
                </a:cxn>
                <a:cxn ang="0">
                  <a:pos x="connsiteX595" y="connsiteY595"/>
                </a:cxn>
                <a:cxn ang="0">
                  <a:pos x="connsiteX596" y="connsiteY596"/>
                </a:cxn>
                <a:cxn ang="0">
                  <a:pos x="connsiteX597" y="connsiteY597"/>
                </a:cxn>
                <a:cxn ang="0">
                  <a:pos x="connsiteX598" y="connsiteY598"/>
                </a:cxn>
                <a:cxn ang="0">
                  <a:pos x="connsiteX599" y="connsiteY599"/>
                </a:cxn>
                <a:cxn ang="0">
                  <a:pos x="connsiteX600" y="connsiteY600"/>
                </a:cxn>
                <a:cxn ang="0">
                  <a:pos x="connsiteX601" y="connsiteY601"/>
                </a:cxn>
              </a:cxnLst>
              <a:rect l="l" t="t" r="r" b="b"/>
              <a:pathLst>
                <a:path w="8363529" h="1517480">
                  <a:moveTo>
                    <a:pt x="0" y="619585"/>
                  </a:moveTo>
                  <a:lnTo>
                    <a:pt x="8394" y="637577"/>
                  </a:lnTo>
                  <a:lnTo>
                    <a:pt x="75279" y="783201"/>
                  </a:lnTo>
                  <a:lnTo>
                    <a:pt x="83635" y="801609"/>
                  </a:lnTo>
                  <a:lnTo>
                    <a:pt x="92029" y="825427"/>
                  </a:lnTo>
                  <a:lnTo>
                    <a:pt x="158920" y="990301"/>
                  </a:lnTo>
                  <a:lnTo>
                    <a:pt x="167273" y="1008176"/>
                  </a:lnTo>
                  <a:lnTo>
                    <a:pt x="175665" y="1019296"/>
                  </a:lnTo>
                  <a:lnTo>
                    <a:pt x="242549" y="1144994"/>
                  </a:lnTo>
                  <a:lnTo>
                    <a:pt x="250903" y="1167486"/>
                  </a:lnTo>
                  <a:lnTo>
                    <a:pt x="259304" y="1138790"/>
                  </a:lnTo>
                  <a:lnTo>
                    <a:pt x="326189" y="940391"/>
                  </a:lnTo>
                  <a:lnTo>
                    <a:pt x="334542" y="918926"/>
                  </a:lnTo>
                  <a:lnTo>
                    <a:pt x="342895" y="861080"/>
                  </a:lnTo>
                  <a:lnTo>
                    <a:pt x="409818" y="524615"/>
                  </a:lnTo>
                  <a:lnTo>
                    <a:pt x="418181" y="493694"/>
                  </a:lnTo>
                  <a:lnTo>
                    <a:pt x="426534" y="508511"/>
                  </a:lnTo>
                  <a:lnTo>
                    <a:pt x="493458" y="713229"/>
                  </a:lnTo>
                  <a:lnTo>
                    <a:pt x="501811" y="758968"/>
                  </a:lnTo>
                  <a:lnTo>
                    <a:pt x="510174" y="754961"/>
                  </a:lnTo>
                  <a:lnTo>
                    <a:pt x="577097" y="735605"/>
                  </a:lnTo>
                  <a:lnTo>
                    <a:pt x="585450" y="734095"/>
                  </a:lnTo>
                  <a:lnTo>
                    <a:pt x="593803" y="754661"/>
                  </a:lnTo>
                  <a:lnTo>
                    <a:pt x="660727" y="992488"/>
                  </a:lnTo>
                  <a:lnTo>
                    <a:pt x="669089" y="1036116"/>
                  </a:lnTo>
                  <a:lnTo>
                    <a:pt x="677443" y="1041933"/>
                  </a:lnTo>
                  <a:lnTo>
                    <a:pt x="744366" y="1080684"/>
                  </a:lnTo>
                  <a:lnTo>
                    <a:pt x="752719" y="1084768"/>
                  </a:lnTo>
                  <a:lnTo>
                    <a:pt x="761082" y="1075545"/>
                  </a:lnTo>
                  <a:lnTo>
                    <a:pt x="828005" y="1018154"/>
                  </a:lnTo>
                  <a:lnTo>
                    <a:pt x="836358" y="1012522"/>
                  </a:lnTo>
                  <a:lnTo>
                    <a:pt x="844712" y="998537"/>
                  </a:lnTo>
                  <a:lnTo>
                    <a:pt x="911635" y="861042"/>
                  </a:lnTo>
                  <a:lnTo>
                    <a:pt x="919988" y="839876"/>
                  </a:lnTo>
                  <a:lnTo>
                    <a:pt x="928351" y="866829"/>
                  </a:lnTo>
                  <a:lnTo>
                    <a:pt x="995274" y="1032148"/>
                  </a:lnTo>
                  <a:lnTo>
                    <a:pt x="1003627" y="1048137"/>
                  </a:lnTo>
                  <a:lnTo>
                    <a:pt x="1011981" y="1043220"/>
                  </a:lnTo>
                  <a:lnTo>
                    <a:pt x="1078904" y="996001"/>
                  </a:lnTo>
                  <a:lnTo>
                    <a:pt x="1087267" y="988859"/>
                  </a:lnTo>
                  <a:lnTo>
                    <a:pt x="1095620" y="978687"/>
                  </a:lnTo>
                  <a:lnTo>
                    <a:pt x="1162543" y="892456"/>
                  </a:lnTo>
                  <a:lnTo>
                    <a:pt x="1170896" y="881036"/>
                  </a:lnTo>
                  <a:lnTo>
                    <a:pt x="1179259" y="868755"/>
                  </a:lnTo>
                  <a:lnTo>
                    <a:pt x="1246182" y="785960"/>
                  </a:lnTo>
                  <a:lnTo>
                    <a:pt x="1254536" y="777191"/>
                  </a:lnTo>
                  <a:lnTo>
                    <a:pt x="1262889" y="799915"/>
                  </a:lnTo>
                  <a:lnTo>
                    <a:pt x="1329812" y="1087419"/>
                  </a:lnTo>
                  <a:lnTo>
                    <a:pt x="1338175" y="1145710"/>
                  </a:lnTo>
                  <a:lnTo>
                    <a:pt x="1346528" y="1113463"/>
                  </a:lnTo>
                  <a:lnTo>
                    <a:pt x="1413451" y="943914"/>
                  </a:lnTo>
                  <a:lnTo>
                    <a:pt x="1421805" y="929736"/>
                  </a:lnTo>
                  <a:lnTo>
                    <a:pt x="1430158" y="950408"/>
                  </a:lnTo>
                  <a:lnTo>
                    <a:pt x="1497091" y="1147259"/>
                  </a:lnTo>
                  <a:lnTo>
                    <a:pt x="1505444" y="1176631"/>
                  </a:lnTo>
                  <a:lnTo>
                    <a:pt x="1513797" y="1175576"/>
                  </a:lnTo>
                  <a:lnTo>
                    <a:pt x="1580720" y="1165027"/>
                  </a:lnTo>
                  <a:lnTo>
                    <a:pt x="1589074" y="1163324"/>
                  </a:lnTo>
                  <a:lnTo>
                    <a:pt x="1597437" y="1160111"/>
                  </a:lnTo>
                  <a:lnTo>
                    <a:pt x="1664360" y="1143068"/>
                  </a:lnTo>
                  <a:lnTo>
                    <a:pt x="1672713" y="1141626"/>
                  </a:lnTo>
                  <a:lnTo>
                    <a:pt x="1681066" y="1138413"/>
                  </a:lnTo>
                  <a:lnTo>
                    <a:pt x="1747989" y="1107608"/>
                  </a:lnTo>
                  <a:lnTo>
                    <a:pt x="1756352" y="1102914"/>
                  </a:lnTo>
                  <a:lnTo>
                    <a:pt x="1764706" y="1098607"/>
                  </a:lnTo>
                  <a:lnTo>
                    <a:pt x="1831629" y="1061899"/>
                  </a:lnTo>
                  <a:lnTo>
                    <a:pt x="1839982" y="1057021"/>
                  </a:lnTo>
                  <a:lnTo>
                    <a:pt x="1848345" y="1058763"/>
                  </a:lnTo>
                  <a:lnTo>
                    <a:pt x="1915268" y="1072564"/>
                  </a:lnTo>
                  <a:lnTo>
                    <a:pt x="1923621" y="1074296"/>
                  </a:lnTo>
                  <a:lnTo>
                    <a:pt x="1931975" y="1077054"/>
                  </a:lnTo>
                  <a:lnTo>
                    <a:pt x="1998898" y="1094368"/>
                  </a:lnTo>
                  <a:lnTo>
                    <a:pt x="2007260" y="1096033"/>
                  </a:lnTo>
                  <a:lnTo>
                    <a:pt x="2015614" y="1025761"/>
                  </a:lnTo>
                  <a:lnTo>
                    <a:pt x="2082537" y="295334"/>
                  </a:lnTo>
                  <a:lnTo>
                    <a:pt x="2090890" y="175791"/>
                  </a:lnTo>
                  <a:lnTo>
                    <a:pt x="2099253" y="261538"/>
                  </a:lnTo>
                  <a:lnTo>
                    <a:pt x="2166176" y="851402"/>
                  </a:lnTo>
                  <a:lnTo>
                    <a:pt x="2174530" y="914948"/>
                  </a:lnTo>
                  <a:lnTo>
                    <a:pt x="2182883" y="916506"/>
                  </a:lnTo>
                  <a:lnTo>
                    <a:pt x="2249806" y="931323"/>
                  </a:lnTo>
                  <a:lnTo>
                    <a:pt x="2258159" y="933549"/>
                  </a:lnTo>
                  <a:lnTo>
                    <a:pt x="2266522" y="941979"/>
                  </a:lnTo>
                  <a:lnTo>
                    <a:pt x="2333445" y="996872"/>
                  </a:lnTo>
                  <a:lnTo>
                    <a:pt x="2341799" y="1002466"/>
                  </a:lnTo>
                  <a:lnTo>
                    <a:pt x="2350152" y="968971"/>
                  </a:lnTo>
                  <a:lnTo>
                    <a:pt x="2417075" y="714507"/>
                  </a:lnTo>
                  <a:lnTo>
                    <a:pt x="2425438" y="684302"/>
                  </a:lnTo>
                  <a:lnTo>
                    <a:pt x="2433791" y="715417"/>
                  </a:lnTo>
                  <a:lnTo>
                    <a:pt x="2500714" y="950602"/>
                  </a:lnTo>
                  <a:lnTo>
                    <a:pt x="2509068" y="978387"/>
                  </a:lnTo>
                  <a:lnTo>
                    <a:pt x="2517430" y="989953"/>
                  </a:lnTo>
                  <a:lnTo>
                    <a:pt x="2584354" y="1098414"/>
                  </a:lnTo>
                  <a:lnTo>
                    <a:pt x="2592707" y="1114334"/>
                  </a:lnTo>
                  <a:lnTo>
                    <a:pt x="2601060" y="1110511"/>
                  </a:lnTo>
                  <a:lnTo>
                    <a:pt x="2667983" y="1079551"/>
                  </a:lnTo>
                  <a:lnTo>
                    <a:pt x="2676346" y="1075622"/>
                  </a:lnTo>
                  <a:lnTo>
                    <a:pt x="2684699" y="1054185"/>
                  </a:lnTo>
                  <a:lnTo>
                    <a:pt x="2751623" y="851286"/>
                  </a:lnTo>
                  <a:lnTo>
                    <a:pt x="2759976" y="821197"/>
                  </a:lnTo>
                  <a:lnTo>
                    <a:pt x="2768329" y="821420"/>
                  </a:lnTo>
                  <a:lnTo>
                    <a:pt x="2835262" y="822784"/>
                  </a:lnTo>
                  <a:lnTo>
                    <a:pt x="2843615" y="822939"/>
                  </a:lnTo>
                  <a:lnTo>
                    <a:pt x="2851968" y="780027"/>
                  </a:lnTo>
                  <a:lnTo>
                    <a:pt x="2918892" y="427419"/>
                  </a:lnTo>
                  <a:lnTo>
                    <a:pt x="2927245" y="382097"/>
                  </a:lnTo>
                  <a:lnTo>
                    <a:pt x="2935608" y="427158"/>
                  </a:lnTo>
                  <a:lnTo>
                    <a:pt x="3002531" y="772991"/>
                  </a:lnTo>
                  <a:lnTo>
                    <a:pt x="3010884" y="814471"/>
                  </a:lnTo>
                  <a:lnTo>
                    <a:pt x="3019238" y="805548"/>
                  </a:lnTo>
                  <a:lnTo>
                    <a:pt x="3086161" y="715378"/>
                  </a:lnTo>
                  <a:lnTo>
                    <a:pt x="3094523" y="701016"/>
                  </a:lnTo>
                  <a:lnTo>
                    <a:pt x="3102877" y="678331"/>
                  </a:lnTo>
                  <a:lnTo>
                    <a:pt x="3169800" y="549120"/>
                  </a:lnTo>
                  <a:lnTo>
                    <a:pt x="3178153" y="537438"/>
                  </a:lnTo>
                  <a:lnTo>
                    <a:pt x="3186516" y="588016"/>
                  </a:lnTo>
                  <a:lnTo>
                    <a:pt x="3253439" y="1093991"/>
                  </a:lnTo>
                  <a:lnTo>
                    <a:pt x="3261792" y="1173573"/>
                  </a:lnTo>
                  <a:lnTo>
                    <a:pt x="3270146" y="1168163"/>
                  </a:lnTo>
                  <a:lnTo>
                    <a:pt x="3337069" y="1076416"/>
                  </a:lnTo>
                  <a:lnTo>
                    <a:pt x="3345432" y="1050217"/>
                  </a:lnTo>
                  <a:lnTo>
                    <a:pt x="3353785" y="862251"/>
                  </a:lnTo>
                  <a:lnTo>
                    <a:pt x="3420708" y="311215"/>
                  </a:lnTo>
                  <a:lnTo>
                    <a:pt x="3429061" y="283081"/>
                  </a:lnTo>
                  <a:lnTo>
                    <a:pt x="3437424" y="334162"/>
                  </a:lnTo>
                  <a:lnTo>
                    <a:pt x="3504347" y="802180"/>
                  </a:lnTo>
                  <a:lnTo>
                    <a:pt x="3512701" y="869355"/>
                  </a:lnTo>
                  <a:lnTo>
                    <a:pt x="3521054" y="813707"/>
                  </a:lnTo>
                  <a:lnTo>
                    <a:pt x="3587977" y="428067"/>
                  </a:lnTo>
                  <a:lnTo>
                    <a:pt x="3596330" y="386220"/>
                  </a:lnTo>
                  <a:lnTo>
                    <a:pt x="3604693" y="433845"/>
                  </a:lnTo>
                  <a:lnTo>
                    <a:pt x="3671616" y="937749"/>
                  </a:lnTo>
                  <a:lnTo>
                    <a:pt x="3679970" y="1021822"/>
                  </a:lnTo>
                  <a:lnTo>
                    <a:pt x="3688323" y="1012754"/>
                  </a:lnTo>
                  <a:lnTo>
                    <a:pt x="3755246" y="949131"/>
                  </a:lnTo>
                  <a:lnTo>
                    <a:pt x="3763609" y="942133"/>
                  </a:lnTo>
                  <a:lnTo>
                    <a:pt x="3771962" y="945463"/>
                  </a:lnTo>
                  <a:lnTo>
                    <a:pt x="3838885" y="974574"/>
                  </a:lnTo>
                  <a:lnTo>
                    <a:pt x="3847239" y="978581"/>
                  </a:lnTo>
                  <a:lnTo>
                    <a:pt x="3855602" y="1000008"/>
                  </a:lnTo>
                  <a:lnTo>
                    <a:pt x="3922525" y="1154101"/>
                  </a:lnTo>
                  <a:lnTo>
                    <a:pt x="3930878" y="1171415"/>
                  </a:lnTo>
                  <a:lnTo>
                    <a:pt x="3939231" y="1142342"/>
                  </a:lnTo>
                  <a:lnTo>
                    <a:pt x="4006154" y="937633"/>
                  </a:lnTo>
                  <a:lnTo>
                    <a:pt x="4014517" y="915064"/>
                  </a:lnTo>
                  <a:lnTo>
                    <a:pt x="4022871" y="932078"/>
                  </a:lnTo>
                  <a:lnTo>
                    <a:pt x="4089755" y="1137165"/>
                  </a:lnTo>
                  <a:lnTo>
                    <a:pt x="4098147" y="1176525"/>
                  </a:lnTo>
                  <a:lnTo>
                    <a:pt x="4106500" y="1076532"/>
                  </a:lnTo>
                  <a:lnTo>
                    <a:pt x="4173394" y="564808"/>
                  </a:lnTo>
                  <a:lnTo>
                    <a:pt x="4181787" y="522989"/>
                  </a:lnTo>
                  <a:lnTo>
                    <a:pt x="4190140" y="572289"/>
                  </a:lnTo>
                  <a:lnTo>
                    <a:pt x="4257024" y="1064434"/>
                  </a:lnTo>
                  <a:lnTo>
                    <a:pt x="4265416" y="1141626"/>
                  </a:lnTo>
                  <a:lnTo>
                    <a:pt x="4273779" y="1018086"/>
                  </a:lnTo>
                  <a:lnTo>
                    <a:pt x="4340664" y="105442"/>
                  </a:lnTo>
                  <a:lnTo>
                    <a:pt x="4349055" y="0"/>
                  </a:lnTo>
                  <a:lnTo>
                    <a:pt x="4357409" y="93383"/>
                  </a:lnTo>
                  <a:lnTo>
                    <a:pt x="4424303" y="833895"/>
                  </a:lnTo>
                  <a:lnTo>
                    <a:pt x="4432695" y="925652"/>
                  </a:lnTo>
                  <a:lnTo>
                    <a:pt x="4441048" y="945008"/>
                  </a:lnTo>
                  <a:lnTo>
                    <a:pt x="4507932" y="1108585"/>
                  </a:lnTo>
                  <a:lnTo>
                    <a:pt x="4516324" y="1130177"/>
                  </a:lnTo>
                  <a:lnTo>
                    <a:pt x="4524687" y="1136642"/>
                  </a:lnTo>
                  <a:lnTo>
                    <a:pt x="4591572" y="1194361"/>
                  </a:lnTo>
                  <a:lnTo>
                    <a:pt x="4599964" y="1202414"/>
                  </a:lnTo>
                  <a:lnTo>
                    <a:pt x="4608317" y="1149417"/>
                  </a:lnTo>
                  <a:lnTo>
                    <a:pt x="4675201" y="734627"/>
                  </a:lnTo>
                  <a:lnTo>
                    <a:pt x="4683603" y="683925"/>
                  </a:lnTo>
                  <a:lnTo>
                    <a:pt x="4691956" y="699690"/>
                  </a:lnTo>
                  <a:lnTo>
                    <a:pt x="4758840" y="812235"/>
                  </a:lnTo>
                  <a:lnTo>
                    <a:pt x="4767232" y="824826"/>
                  </a:lnTo>
                  <a:lnTo>
                    <a:pt x="4775595" y="836276"/>
                  </a:lnTo>
                  <a:lnTo>
                    <a:pt x="4842480" y="956312"/>
                  </a:lnTo>
                  <a:lnTo>
                    <a:pt x="4850872" y="976084"/>
                  </a:lnTo>
                  <a:lnTo>
                    <a:pt x="4859225" y="1000802"/>
                  </a:lnTo>
                  <a:lnTo>
                    <a:pt x="4926109" y="1129945"/>
                  </a:lnTo>
                  <a:lnTo>
                    <a:pt x="4934501" y="1140687"/>
                  </a:lnTo>
                  <a:lnTo>
                    <a:pt x="4942864" y="1132780"/>
                  </a:lnTo>
                  <a:lnTo>
                    <a:pt x="5009749" y="1061444"/>
                  </a:lnTo>
                  <a:lnTo>
                    <a:pt x="5018141" y="1051388"/>
                  </a:lnTo>
                  <a:lnTo>
                    <a:pt x="5026494" y="1019557"/>
                  </a:lnTo>
                  <a:lnTo>
                    <a:pt x="5093388" y="717314"/>
                  </a:lnTo>
                  <a:lnTo>
                    <a:pt x="5101780" y="672243"/>
                  </a:lnTo>
                  <a:lnTo>
                    <a:pt x="5110134" y="716549"/>
                  </a:lnTo>
                  <a:lnTo>
                    <a:pt x="5177018" y="972639"/>
                  </a:lnTo>
                  <a:lnTo>
                    <a:pt x="5185410" y="996040"/>
                  </a:lnTo>
                  <a:lnTo>
                    <a:pt x="5193773" y="985491"/>
                  </a:lnTo>
                  <a:lnTo>
                    <a:pt x="5260657" y="893898"/>
                  </a:lnTo>
                  <a:lnTo>
                    <a:pt x="5269049" y="881453"/>
                  </a:lnTo>
                  <a:lnTo>
                    <a:pt x="5277403" y="865958"/>
                  </a:lnTo>
                  <a:lnTo>
                    <a:pt x="5344287" y="722675"/>
                  </a:lnTo>
                  <a:lnTo>
                    <a:pt x="5352650" y="701926"/>
                  </a:lnTo>
                  <a:lnTo>
                    <a:pt x="5361042" y="718969"/>
                  </a:lnTo>
                  <a:lnTo>
                    <a:pt x="5427926" y="1055695"/>
                  </a:lnTo>
                  <a:lnTo>
                    <a:pt x="5436280" y="1171686"/>
                  </a:lnTo>
                  <a:lnTo>
                    <a:pt x="5444672" y="1207523"/>
                  </a:lnTo>
                  <a:lnTo>
                    <a:pt x="5511566" y="1325624"/>
                  </a:lnTo>
                  <a:lnTo>
                    <a:pt x="5519919" y="1332244"/>
                  </a:lnTo>
                  <a:lnTo>
                    <a:pt x="5528311" y="1258865"/>
                  </a:lnTo>
                  <a:lnTo>
                    <a:pt x="5595195" y="852612"/>
                  </a:lnTo>
                  <a:lnTo>
                    <a:pt x="5603558" y="816958"/>
                  </a:lnTo>
                  <a:lnTo>
                    <a:pt x="5611950" y="756287"/>
                  </a:lnTo>
                  <a:lnTo>
                    <a:pt x="5678835" y="273219"/>
                  </a:lnTo>
                  <a:lnTo>
                    <a:pt x="5687188" y="213109"/>
                  </a:lnTo>
                  <a:lnTo>
                    <a:pt x="5695580" y="284223"/>
                  </a:lnTo>
                  <a:lnTo>
                    <a:pt x="5762474" y="1091571"/>
                  </a:lnTo>
                  <a:lnTo>
                    <a:pt x="5770827" y="1236857"/>
                  </a:lnTo>
                  <a:lnTo>
                    <a:pt x="5779219" y="1208472"/>
                  </a:lnTo>
                  <a:lnTo>
                    <a:pt x="5846103" y="1042727"/>
                  </a:lnTo>
                  <a:lnTo>
                    <a:pt x="5854457" y="1027455"/>
                  </a:lnTo>
                  <a:lnTo>
                    <a:pt x="5862858" y="1033242"/>
                  </a:lnTo>
                  <a:lnTo>
                    <a:pt x="5929743" y="1109040"/>
                  </a:lnTo>
                  <a:lnTo>
                    <a:pt x="5938096" y="1124922"/>
                  </a:lnTo>
                  <a:lnTo>
                    <a:pt x="5946488" y="1133051"/>
                  </a:lnTo>
                  <a:lnTo>
                    <a:pt x="6013372" y="1174105"/>
                  </a:lnTo>
                  <a:lnTo>
                    <a:pt x="6021735" y="1177396"/>
                  </a:lnTo>
                  <a:lnTo>
                    <a:pt x="6030127" y="1160343"/>
                  </a:lnTo>
                  <a:lnTo>
                    <a:pt x="6097011" y="1005757"/>
                  </a:lnTo>
                  <a:lnTo>
                    <a:pt x="6105365" y="983836"/>
                  </a:lnTo>
                  <a:lnTo>
                    <a:pt x="6113767" y="976539"/>
                  </a:lnTo>
                  <a:lnTo>
                    <a:pt x="6180651" y="926407"/>
                  </a:lnTo>
                  <a:lnTo>
                    <a:pt x="6189004" y="920958"/>
                  </a:lnTo>
                  <a:lnTo>
                    <a:pt x="6197396" y="936540"/>
                  </a:lnTo>
                  <a:lnTo>
                    <a:pt x="6264280" y="1095317"/>
                  </a:lnTo>
                  <a:lnTo>
                    <a:pt x="6272644" y="1120799"/>
                  </a:lnTo>
                  <a:lnTo>
                    <a:pt x="6281036" y="1119434"/>
                  </a:lnTo>
                  <a:lnTo>
                    <a:pt x="6347920" y="1110443"/>
                  </a:lnTo>
                  <a:lnTo>
                    <a:pt x="6356273" y="1109495"/>
                  </a:lnTo>
                  <a:lnTo>
                    <a:pt x="6364665" y="1116908"/>
                  </a:lnTo>
                  <a:lnTo>
                    <a:pt x="6431560" y="1171231"/>
                  </a:lnTo>
                  <a:lnTo>
                    <a:pt x="6439913" y="1177464"/>
                  </a:lnTo>
                  <a:lnTo>
                    <a:pt x="6448305" y="1168995"/>
                  </a:lnTo>
                  <a:lnTo>
                    <a:pt x="6515189" y="1092713"/>
                  </a:lnTo>
                  <a:lnTo>
                    <a:pt x="6523542" y="1081971"/>
                  </a:lnTo>
                  <a:lnTo>
                    <a:pt x="6531944" y="1088968"/>
                  </a:lnTo>
                  <a:lnTo>
                    <a:pt x="6598829" y="1151381"/>
                  </a:lnTo>
                  <a:lnTo>
                    <a:pt x="6607182" y="1160082"/>
                  </a:lnTo>
                  <a:lnTo>
                    <a:pt x="6615535" y="1163779"/>
                  </a:lnTo>
                  <a:lnTo>
                    <a:pt x="6682458" y="1184345"/>
                  </a:lnTo>
                  <a:lnTo>
                    <a:pt x="6690821" y="1186164"/>
                  </a:lnTo>
                  <a:lnTo>
                    <a:pt x="6699174" y="1152514"/>
                  </a:lnTo>
                  <a:lnTo>
                    <a:pt x="6766097" y="815110"/>
                  </a:lnTo>
                  <a:lnTo>
                    <a:pt x="6774451" y="761958"/>
                  </a:lnTo>
                  <a:lnTo>
                    <a:pt x="6782814" y="791292"/>
                  </a:lnTo>
                  <a:lnTo>
                    <a:pt x="6849737" y="1063941"/>
                  </a:lnTo>
                  <a:lnTo>
                    <a:pt x="6858090" y="1103669"/>
                  </a:lnTo>
                  <a:lnTo>
                    <a:pt x="6866443" y="1093952"/>
                  </a:lnTo>
                  <a:lnTo>
                    <a:pt x="6933366" y="1041672"/>
                  </a:lnTo>
                  <a:lnTo>
                    <a:pt x="6941729" y="1037171"/>
                  </a:lnTo>
                  <a:lnTo>
                    <a:pt x="6950083" y="1057515"/>
                  </a:lnTo>
                  <a:lnTo>
                    <a:pt x="7017006" y="1255459"/>
                  </a:lnTo>
                  <a:lnTo>
                    <a:pt x="7025359" y="1285702"/>
                  </a:lnTo>
                  <a:lnTo>
                    <a:pt x="7033712" y="1280186"/>
                  </a:lnTo>
                  <a:lnTo>
                    <a:pt x="7100645" y="1232735"/>
                  </a:lnTo>
                  <a:lnTo>
                    <a:pt x="7108998" y="1226386"/>
                  </a:lnTo>
                  <a:lnTo>
                    <a:pt x="7117351" y="1235880"/>
                  </a:lnTo>
                  <a:lnTo>
                    <a:pt x="7184274" y="1314698"/>
                  </a:lnTo>
                  <a:lnTo>
                    <a:pt x="7192628" y="1324985"/>
                  </a:lnTo>
                  <a:lnTo>
                    <a:pt x="7200991" y="1314659"/>
                  </a:lnTo>
                  <a:lnTo>
                    <a:pt x="7267914" y="1238367"/>
                  </a:lnTo>
                  <a:lnTo>
                    <a:pt x="7276267" y="1229522"/>
                  </a:lnTo>
                  <a:lnTo>
                    <a:pt x="7284620" y="1162046"/>
                  </a:lnTo>
                  <a:lnTo>
                    <a:pt x="7351543" y="591045"/>
                  </a:lnTo>
                  <a:lnTo>
                    <a:pt x="7359906" y="515547"/>
                  </a:lnTo>
                  <a:lnTo>
                    <a:pt x="7368260" y="515624"/>
                  </a:lnTo>
                  <a:lnTo>
                    <a:pt x="7435183" y="516040"/>
                  </a:lnTo>
                  <a:lnTo>
                    <a:pt x="7443536" y="516079"/>
                  </a:lnTo>
                  <a:lnTo>
                    <a:pt x="7451899" y="546429"/>
                  </a:lnTo>
                  <a:lnTo>
                    <a:pt x="7518822" y="838172"/>
                  </a:lnTo>
                  <a:lnTo>
                    <a:pt x="7527175" y="882178"/>
                  </a:lnTo>
                  <a:lnTo>
                    <a:pt x="7535528" y="822213"/>
                  </a:lnTo>
                  <a:lnTo>
                    <a:pt x="7602452" y="420238"/>
                  </a:lnTo>
                  <a:lnTo>
                    <a:pt x="7610815" y="377974"/>
                  </a:lnTo>
                  <a:lnTo>
                    <a:pt x="7619168" y="453772"/>
                  </a:lnTo>
                  <a:lnTo>
                    <a:pt x="7686091" y="1111721"/>
                  </a:lnTo>
                  <a:lnTo>
                    <a:pt x="7694444" y="1201020"/>
                  </a:lnTo>
                  <a:lnTo>
                    <a:pt x="7702798" y="1126964"/>
                  </a:lnTo>
                  <a:lnTo>
                    <a:pt x="7769731" y="396798"/>
                  </a:lnTo>
                  <a:lnTo>
                    <a:pt x="7778084" y="283730"/>
                  </a:lnTo>
                  <a:lnTo>
                    <a:pt x="7786437" y="398162"/>
                  </a:lnTo>
                  <a:lnTo>
                    <a:pt x="7853360" y="957483"/>
                  </a:lnTo>
                  <a:lnTo>
                    <a:pt x="7861713" y="1001334"/>
                  </a:lnTo>
                  <a:lnTo>
                    <a:pt x="7870077" y="977255"/>
                  </a:lnTo>
                  <a:lnTo>
                    <a:pt x="7937000" y="707442"/>
                  </a:lnTo>
                  <a:lnTo>
                    <a:pt x="7945353" y="659584"/>
                  </a:lnTo>
                  <a:lnTo>
                    <a:pt x="7953706" y="699274"/>
                  </a:lnTo>
                  <a:lnTo>
                    <a:pt x="8020629" y="1002243"/>
                  </a:lnTo>
                  <a:lnTo>
                    <a:pt x="8028992" y="1038381"/>
                  </a:lnTo>
                  <a:lnTo>
                    <a:pt x="8037346" y="1066360"/>
                  </a:lnTo>
                  <a:lnTo>
                    <a:pt x="8104268" y="1322827"/>
                  </a:lnTo>
                  <a:lnTo>
                    <a:pt x="8112622" y="1359652"/>
                  </a:lnTo>
                  <a:lnTo>
                    <a:pt x="8120985" y="1324192"/>
                  </a:lnTo>
                  <a:lnTo>
                    <a:pt x="8187908" y="1136371"/>
                  </a:lnTo>
                  <a:lnTo>
                    <a:pt x="8196261" y="1120567"/>
                  </a:lnTo>
                  <a:lnTo>
                    <a:pt x="8204614" y="1055095"/>
                  </a:lnTo>
                  <a:lnTo>
                    <a:pt x="8271537" y="373058"/>
                  </a:lnTo>
                  <a:lnTo>
                    <a:pt x="8279900" y="261161"/>
                  </a:lnTo>
                  <a:lnTo>
                    <a:pt x="8288254" y="355744"/>
                  </a:lnTo>
                  <a:lnTo>
                    <a:pt x="8355177" y="1120044"/>
                  </a:lnTo>
                  <a:lnTo>
                    <a:pt x="8363530" y="1216553"/>
                  </a:lnTo>
                  <a:lnTo>
                    <a:pt x="8363530" y="1269443"/>
                  </a:lnTo>
                  <a:lnTo>
                    <a:pt x="8355177" y="1180338"/>
                  </a:lnTo>
                  <a:lnTo>
                    <a:pt x="8288254" y="474638"/>
                  </a:lnTo>
                  <a:lnTo>
                    <a:pt x="8279900" y="387352"/>
                  </a:lnTo>
                  <a:lnTo>
                    <a:pt x="8271537" y="494371"/>
                  </a:lnTo>
                  <a:lnTo>
                    <a:pt x="8204614" y="1146804"/>
                  </a:lnTo>
                  <a:lnTo>
                    <a:pt x="8196261" y="1209449"/>
                  </a:lnTo>
                  <a:lnTo>
                    <a:pt x="8187908" y="1219350"/>
                  </a:lnTo>
                  <a:lnTo>
                    <a:pt x="8120985" y="1337344"/>
                  </a:lnTo>
                  <a:lnTo>
                    <a:pt x="8112622" y="1359652"/>
                  </a:lnTo>
                  <a:lnTo>
                    <a:pt x="8104268" y="1335980"/>
                  </a:lnTo>
                  <a:lnTo>
                    <a:pt x="8037346" y="1171037"/>
                  </a:lnTo>
                  <a:lnTo>
                    <a:pt x="8028992" y="1153046"/>
                  </a:lnTo>
                  <a:lnTo>
                    <a:pt x="8020629" y="1115282"/>
                  </a:lnTo>
                  <a:lnTo>
                    <a:pt x="7953706" y="798705"/>
                  </a:lnTo>
                  <a:lnTo>
                    <a:pt x="7945353" y="757197"/>
                  </a:lnTo>
                  <a:lnTo>
                    <a:pt x="7937000" y="831253"/>
                  </a:lnTo>
                  <a:lnTo>
                    <a:pt x="7870077" y="1248655"/>
                  </a:lnTo>
                  <a:lnTo>
                    <a:pt x="7861713" y="1285925"/>
                  </a:lnTo>
                  <a:lnTo>
                    <a:pt x="7853360" y="1229560"/>
                  </a:lnTo>
                  <a:lnTo>
                    <a:pt x="7786437" y="510853"/>
                  </a:lnTo>
                  <a:lnTo>
                    <a:pt x="7778084" y="363835"/>
                  </a:lnTo>
                  <a:lnTo>
                    <a:pt x="7769731" y="472218"/>
                  </a:lnTo>
                  <a:lnTo>
                    <a:pt x="7702798" y="1172363"/>
                  </a:lnTo>
                  <a:lnTo>
                    <a:pt x="7694444" y="1243361"/>
                  </a:lnTo>
                  <a:lnTo>
                    <a:pt x="7686091" y="1247939"/>
                  </a:lnTo>
                  <a:lnTo>
                    <a:pt x="7619168" y="1281696"/>
                  </a:lnTo>
                  <a:lnTo>
                    <a:pt x="7610815" y="1285586"/>
                  </a:lnTo>
                  <a:lnTo>
                    <a:pt x="7602452" y="1257462"/>
                  </a:lnTo>
                  <a:lnTo>
                    <a:pt x="7535528" y="989730"/>
                  </a:lnTo>
                  <a:lnTo>
                    <a:pt x="7527175" y="949808"/>
                  </a:lnTo>
                  <a:lnTo>
                    <a:pt x="7518822" y="912838"/>
                  </a:lnTo>
                  <a:lnTo>
                    <a:pt x="7451899" y="667743"/>
                  </a:lnTo>
                  <a:lnTo>
                    <a:pt x="7443536" y="642270"/>
                  </a:lnTo>
                  <a:lnTo>
                    <a:pt x="7435183" y="654097"/>
                  </a:lnTo>
                  <a:lnTo>
                    <a:pt x="7368260" y="766942"/>
                  </a:lnTo>
                  <a:lnTo>
                    <a:pt x="7359906" y="783879"/>
                  </a:lnTo>
                  <a:lnTo>
                    <a:pt x="7351543" y="834504"/>
                  </a:lnTo>
                  <a:lnTo>
                    <a:pt x="7284620" y="1217579"/>
                  </a:lnTo>
                  <a:lnTo>
                    <a:pt x="7276267" y="1262872"/>
                  </a:lnTo>
                  <a:lnTo>
                    <a:pt x="7267914" y="1274137"/>
                  </a:lnTo>
                  <a:lnTo>
                    <a:pt x="7200991" y="1371556"/>
                  </a:lnTo>
                  <a:lnTo>
                    <a:pt x="7192628" y="1384747"/>
                  </a:lnTo>
                  <a:lnTo>
                    <a:pt x="7184274" y="1368265"/>
                  </a:lnTo>
                  <a:lnTo>
                    <a:pt x="7117351" y="1241619"/>
                  </a:lnTo>
                  <a:lnTo>
                    <a:pt x="7108998" y="1226386"/>
                  </a:lnTo>
                  <a:lnTo>
                    <a:pt x="7100645" y="1245103"/>
                  </a:lnTo>
                  <a:lnTo>
                    <a:pt x="7033712" y="1385057"/>
                  </a:lnTo>
                  <a:lnTo>
                    <a:pt x="7025359" y="1401422"/>
                  </a:lnTo>
                  <a:lnTo>
                    <a:pt x="7017006" y="1364675"/>
                  </a:lnTo>
                  <a:lnTo>
                    <a:pt x="6950083" y="1124196"/>
                  </a:lnTo>
                  <a:lnTo>
                    <a:pt x="6941729" y="1099517"/>
                  </a:lnTo>
                  <a:lnTo>
                    <a:pt x="6933366" y="1121099"/>
                  </a:lnTo>
                  <a:lnTo>
                    <a:pt x="6866443" y="1372920"/>
                  </a:lnTo>
                  <a:lnTo>
                    <a:pt x="6858090" y="1419646"/>
                  </a:lnTo>
                  <a:lnTo>
                    <a:pt x="6849737" y="1367704"/>
                  </a:lnTo>
                  <a:lnTo>
                    <a:pt x="6782814" y="1011128"/>
                  </a:lnTo>
                  <a:lnTo>
                    <a:pt x="6774451" y="972793"/>
                  </a:lnTo>
                  <a:lnTo>
                    <a:pt x="6766097" y="1014080"/>
                  </a:lnTo>
                  <a:lnTo>
                    <a:pt x="6699174" y="1276440"/>
                  </a:lnTo>
                  <a:lnTo>
                    <a:pt x="6690821" y="1302639"/>
                  </a:lnTo>
                  <a:lnTo>
                    <a:pt x="6682458" y="1306113"/>
                  </a:lnTo>
                  <a:lnTo>
                    <a:pt x="6615535" y="1345474"/>
                  </a:lnTo>
                  <a:lnTo>
                    <a:pt x="6607182" y="1352539"/>
                  </a:lnTo>
                  <a:lnTo>
                    <a:pt x="6598829" y="1329515"/>
                  </a:lnTo>
                  <a:lnTo>
                    <a:pt x="6531944" y="1164989"/>
                  </a:lnTo>
                  <a:lnTo>
                    <a:pt x="6523542" y="1146581"/>
                  </a:lnTo>
                  <a:lnTo>
                    <a:pt x="6515189" y="1163101"/>
                  </a:lnTo>
                  <a:lnTo>
                    <a:pt x="6448305" y="1280525"/>
                  </a:lnTo>
                  <a:lnTo>
                    <a:pt x="6439913" y="1293561"/>
                  </a:lnTo>
                  <a:lnTo>
                    <a:pt x="6431560" y="1276741"/>
                  </a:lnTo>
                  <a:lnTo>
                    <a:pt x="6364665" y="1129567"/>
                  </a:lnTo>
                  <a:lnTo>
                    <a:pt x="6356273" y="1109495"/>
                  </a:lnTo>
                  <a:lnTo>
                    <a:pt x="6347920" y="1118147"/>
                  </a:lnTo>
                  <a:lnTo>
                    <a:pt x="6281036" y="1199471"/>
                  </a:lnTo>
                  <a:lnTo>
                    <a:pt x="6272644" y="1211414"/>
                  </a:lnTo>
                  <a:lnTo>
                    <a:pt x="6264280" y="1210582"/>
                  </a:lnTo>
                  <a:lnTo>
                    <a:pt x="6197396" y="1205288"/>
                  </a:lnTo>
                  <a:lnTo>
                    <a:pt x="6189004" y="1204765"/>
                  </a:lnTo>
                  <a:lnTo>
                    <a:pt x="6180651" y="1208501"/>
                  </a:lnTo>
                  <a:lnTo>
                    <a:pt x="6113767" y="1243061"/>
                  </a:lnTo>
                  <a:lnTo>
                    <a:pt x="6105365" y="1248045"/>
                  </a:lnTo>
                  <a:lnTo>
                    <a:pt x="6097011" y="1246381"/>
                  </a:lnTo>
                  <a:lnTo>
                    <a:pt x="6030127" y="1234738"/>
                  </a:lnTo>
                  <a:lnTo>
                    <a:pt x="6021735" y="1233460"/>
                  </a:lnTo>
                  <a:lnTo>
                    <a:pt x="6013372" y="1227102"/>
                  </a:lnTo>
                  <a:lnTo>
                    <a:pt x="5946488" y="1148468"/>
                  </a:lnTo>
                  <a:lnTo>
                    <a:pt x="5938096" y="1132896"/>
                  </a:lnTo>
                  <a:lnTo>
                    <a:pt x="5929743" y="1124235"/>
                  </a:lnTo>
                  <a:lnTo>
                    <a:pt x="5862858" y="1083065"/>
                  </a:lnTo>
                  <a:lnTo>
                    <a:pt x="5854457" y="1079890"/>
                  </a:lnTo>
                  <a:lnTo>
                    <a:pt x="5846103" y="1102498"/>
                  </a:lnTo>
                  <a:lnTo>
                    <a:pt x="5779219" y="1347700"/>
                  </a:lnTo>
                  <a:lnTo>
                    <a:pt x="5770827" y="1389741"/>
                  </a:lnTo>
                  <a:lnTo>
                    <a:pt x="5762474" y="1231041"/>
                  </a:lnTo>
                  <a:lnTo>
                    <a:pt x="5695580" y="349056"/>
                  </a:lnTo>
                  <a:lnTo>
                    <a:pt x="5687188" y="271361"/>
                  </a:lnTo>
                  <a:lnTo>
                    <a:pt x="5678835" y="358618"/>
                  </a:lnTo>
                  <a:lnTo>
                    <a:pt x="5611950" y="1059779"/>
                  </a:lnTo>
                  <a:lnTo>
                    <a:pt x="5603558" y="1147830"/>
                  </a:lnTo>
                  <a:lnTo>
                    <a:pt x="5595195" y="1161476"/>
                  </a:lnTo>
                  <a:lnTo>
                    <a:pt x="5528311" y="1317078"/>
                  </a:lnTo>
                  <a:lnTo>
                    <a:pt x="5519919" y="1345164"/>
                  </a:lnTo>
                  <a:lnTo>
                    <a:pt x="5511566" y="1340025"/>
                  </a:lnTo>
                  <a:lnTo>
                    <a:pt x="5444672" y="1247900"/>
                  </a:lnTo>
                  <a:lnTo>
                    <a:pt x="5436280" y="1219998"/>
                  </a:lnTo>
                  <a:lnTo>
                    <a:pt x="5427926" y="1199965"/>
                  </a:lnTo>
                  <a:lnTo>
                    <a:pt x="5361042" y="1141858"/>
                  </a:lnTo>
                  <a:lnTo>
                    <a:pt x="5352650" y="1138906"/>
                  </a:lnTo>
                  <a:lnTo>
                    <a:pt x="5344287" y="1119396"/>
                  </a:lnTo>
                  <a:lnTo>
                    <a:pt x="5277403" y="984629"/>
                  </a:lnTo>
                  <a:lnTo>
                    <a:pt x="5269049" y="970074"/>
                  </a:lnTo>
                  <a:lnTo>
                    <a:pt x="5260657" y="974458"/>
                  </a:lnTo>
                  <a:lnTo>
                    <a:pt x="5193773" y="1006705"/>
                  </a:lnTo>
                  <a:lnTo>
                    <a:pt x="5185410" y="1010412"/>
                  </a:lnTo>
                  <a:lnTo>
                    <a:pt x="5177018" y="1014873"/>
                  </a:lnTo>
                  <a:lnTo>
                    <a:pt x="5110134" y="1063602"/>
                  </a:lnTo>
                  <a:lnTo>
                    <a:pt x="5101780" y="1072031"/>
                  </a:lnTo>
                  <a:lnTo>
                    <a:pt x="5093388" y="1082348"/>
                  </a:lnTo>
                  <a:lnTo>
                    <a:pt x="5026494" y="1151498"/>
                  </a:lnTo>
                  <a:lnTo>
                    <a:pt x="5018141" y="1158756"/>
                  </a:lnTo>
                  <a:lnTo>
                    <a:pt x="5009749" y="1163634"/>
                  </a:lnTo>
                  <a:lnTo>
                    <a:pt x="4942864" y="1198068"/>
                  </a:lnTo>
                  <a:lnTo>
                    <a:pt x="4934501" y="1201891"/>
                  </a:lnTo>
                  <a:lnTo>
                    <a:pt x="4926109" y="1191080"/>
                  </a:lnTo>
                  <a:lnTo>
                    <a:pt x="4859225" y="1061405"/>
                  </a:lnTo>
                  <a:lnTo>
                    <a:pt x="4850872" y="1036610"/>
                  </a:lnTo>
                  <a:lnTo>
                    <a:pt x="4842480" y="1013286"/>
                  </a:lnTo>
                  <a:lnTo>
                    <a:pt x="4775595" y="871775"/>
                  </a:lnTo>
                  <a:lnTo>
                    <a:pt x="4767232" y="858283"/>
                  </a:lnTo>
                  <a:lnTo>
                    <a:pt x="4758840" y="852312"/>
                  </a:lnTo>
                  <a:lnTo>
                    <a:pt x="4691956" y="798773"/>
                  </a:lnTo>
                  <a:lnTo>
                    <a:pt x="4683603" y="791254"/>
                  </a:lnTo>
                  <a:lnTo>
                    <a:pt x="4675201" y="835869"/>
                  </a:lnTo>
                  <a:lnTo>
                    <a:pt x="4608317" y="1200604"/>
                  </a:lnTo>
                  <a:lnTo>
                    <a:pt x="4599964" y="1247213"/>
                  </a:lnTo>
                  <a:lnTo>
                    <a:pt x="4591572" y="1235948"/>
                  </a:lnTo>
                  <a:lnTo>
                    <a:pt x="4524687" y="1155204"/>
                  </a:lnTo>
                  <a:lnTo>
                    <a:pt x="4516324" y="1146126"/>
                  </a:lnTo>
                  <a:lnTo>
                    <a:pt x="4507932" y="1153085"/>
                  </a:lnTo>
                  <a:lnTo>
                    <a:pt x="4441048" y="1205704"/>
                  </a:lnTo>
                  <a:lnTo>
                    <a:pt x="4432695" y="1211908"/>
                  </a:lnTo>
                  <a:lnTo>
                    <a:pt x="4424303" y="1101065"/>
                  </a:lnTo>
                  <a:lnTo>
                    <a:pt x="4357409" y="206412"/>
                  </a:lnTo>
                  <a:lnTo>
                    <a:pt x="4349055" y="93606"/>
                  </a:lnTo>
                  <a:lnTo>
                    <a:pt x="4340664" y="213109"/>
                  </a:lnTo>
                  <a:lnTo>
                    <a:pt x="4273779" y="1247523"/>
                  </a:lnTo>
                  <a:lnTo>
                    <a:pt x="4265416" y="1387544"/>
                  </a:lnTo>
                  <a:lnTo>
                    <a:pt x="4257024" y="1310391"/>
                  </a:lnTo>
                  <a:lnTo>
                    <a:pt x="4190140" y="818546"/>
                  </a:lnTo>
                  <a:lnTo>
                    <a:pt x="4181787" y="769294"/>
                  </a:lnTo>
                  <a:lnTo>
                    <a:pt x="4173394" y="803845"/>
                  </a:lnTo>
                  <a:lnTo>
                    <a:pt x="4106500" y="1226725"/>
                  </a:lnTo>
                  <a:lnTo>
                    <a:pt x="4098147" y="1309404"/>
                  </a:lnTo>
                  <a:lnTo>
                    <a:pt x="4089755" y="1263733"/>
                  </a:lnTo>
                  <a:lnTo>
                    <a:pt x="4022871" y="1025868"/>
                  </a:lnTo>
                  <a:lnTo>
                    <a:pt x="4014517" y="1006134"/>
                  </a:lnTo>
                  <a:lnTo>
                    <a:pt x="4006154" y="1024474"/>
                  </a:lnTo>
                  <a:lnTo>
                    <a:pt x="3939231" y="1190848"/>
                  </a:lnTo>
                  <a:lnTo>
                    <a:pt x="3930878" y="1214511"/>
                  </a:lnTo>
                  <a:lnTo>
                    <a:pt x="3922525" y="1214104"/>
                  </a:lnTo>
                  <a:lnTo>
                    <a:pt x="3855602" y="1210320"/>
                  </a:lnTo>
                  <a:lnTo>
                    <a:pt x="3847239" y="1209788"/>
                  </a:lnTo>
                  <a:lnTo>
                    <a:pt x="3838885" y="1186048"/>
                  </a:lnTo>
                  <a:lnTo>
                    <a:pt x="3771962" y="1012454"/>
                  </a:lnTo>
                  <a:lnTo>
                    <a:pt x="3763609" y="992643"/>
                  </a:lnTo>
                  <a:lnTo>
                    <a:pt x="3755246" y="1011012"/>
                  </a:lnTo>
                  <a:lnTo>
                    <a:pt x="3688323" y="1178412"/>
                  </a:lnTo>
                  <a:lnTo>
                    <a:pt x="3679970" y="1202268"/>
                  </a:lnTo>
                  <a:lnTo>
                    <a:pt x="3671616" y="1118602"/>
                  </a:lnTo>
                  <a:lnTo>
                    <a:pt x="3604693" y="617166"/>
                  </a:lnTo>
                  <a:lnTo>
                    <a:pt x="3596330" y="569753"/>
                  </a:lnTo>
                  <a:lnTo>
                    <a:pt x="3587977" y="600645"/>
                  </a:lnTo>
                  <a:lnTo>
                    <a:pt x="3521054" y="885198"/>
                  </a:lnTo>
                  <a:lnTo>
                    <a:pt x="3512701" y="926252"/>
                  </a:lnTo>
                  <a:lnTo>
                    <a:pt x="3504347" y="945153"/>
                  </a:lnTo>
                  <a:lnTo>
                    <a:pt x="3437424" y="1076754"/>
                  </a:lnTo>
                  <a:lnTo>
                    <a:pt x="3429061" y="1091117"/>
                  </a:lnTo>
                  <a:lnTo>
                    <a:pt x="3420708" y="1106737"/>
                  </a:lnTo>
                  <a:lnTo>
                    <a:pt x="3353785" y="1413026"/>
                  </a:lnTo>
                  <a:lnTo>
                    <a:pt x="3345432" y="1517481"/>
                  </a:lnTo>
                  <a:lnTo>
                    <a:pt x="3337069" y="1462897"/>
                  </a:lnTo>
                  <a:lnTo>
                    <a:pt x="3270146" y="1271718"/>
                  </a:lnTo>
                  <a:lnTo>
                    <a:pt x="3261792" y="1260482"/>
                  </a:lnTo>
                  <a:lnTo>
                    <a:pt x="3253439" y="1187635"/>
                  </a:lnTo>
                  <a:lnTo>
                    <a:pt x="3186516" y="724340"/>
                  </a:lnTo>
                  <a:lnTo>
                    <a:pt x="3178153" y="678031"/>
                  </a:lnTo>
                  <a:lnTo>
                    <a:pt x="3169800" y="683363"/>
                  </a:lnTo>
                  <a:lnTo>
                    <a:pt x="3102877" y="742563"/>
                  </a:lnTo>
                  <a:lnTo>
                    <a:pt x="3094523" y="752958"/>
                  </a:lnTo>
                  <a:lnTo>
                    <a:pt x="3086161" y="795676"/>
                  </a:lnTo>
                  <a:lnTo>
                    <a:pt x="3019238" y="1063941"/>
                  </a:lnTo>
                  <a:lnTo>
                    <a:pt x="3010884" y="1090439"/>
                  </a:lnTo>
                  <a:lnTo>
                    <a:pt x="3002531" y="1031394"/>
                  </a:lnTo>
                  <a:lnTo>
                    <a:pt x="2935608" y="538871"/>
                  </a:lnTo>
                  <a:lnTo>
                    <a:pt x="2927245" y="474715"/>
                  </a:lnTo>
                  <a:lnTo>
                    <a:pt x="2918892" y="532561"/>
                  </a:lnTo>
                  <a:lnTo>
                    <a:pt x="2851968" y="983004"/>
                  </a:lnTo>
                  <a:lnTo>
                    <a:pt x="2843615" y="1037781"/>
                  </a:lnTo>
                  <a:lnTo>
                    <a:pt x="2835262" y="1047498"/>
                  </a:lnTo>
                  <a:lnTo>
                    <a:pt x="2768329" y="1149794"/>
                  </a:lnTo>
                  <a:lnTo>
                    <a:pt x="2759976" y="1166808"/>
                  </a:lnTo>
                  <a:lnTo>
                    <a:pt x="2751623" y="1186919"/>
                  </a:lnTo>
                  <a:lnTo>
                    <a:pt x="2684699" y="1322488"/>
                  </a:lnTo>
                  <a:lnTo>
                    <a:pt x="2676346" y="1336851"/>
                  </a:lnTo>
                  <a:lnTo>
                    <a:pt x="2667983" y="1323843"/>
                  </a:lnTo>
                  <a:lnTo>
                    <a:pt x="2601060" y="1221015"/>
                  </a:lnTo>
                  <a:lnTo>
                    <a:pt x="2592707" y="1208317"/>
                  </a:lnTo>
                  <a:lnTo>
                    <a:pt x="2584354" y="1208772"/>
                  </a:lnTo>
                  <a:lnTo>
                    <a:pt x="2517430" y="1211869"/>
                  </a:lnTo>
                  <a:lnTo>
                    <a:pt x="2509068" y="1212169"/>
                  </a:lnTo>
                  <a:lnTo>
                    <a:pt x="2500714" y="1182951"/>
                  </a:lnTo>
                  <a:lnTo>
                    <a:pt x="2433791" y="935446"/>
                  </a:lnTo>
                  <a:lnTo>
                    <a:pt x="2425438" y="902705"/>
                  </a:lnTo>
                  <a:lnTo>
                    <a:pt x="2417075" y="922207"/>
                  </a:lnTo>
                  <a:lnTo>
                    <a:pt x="2350152" y="1086510"/>
                  </a:lnTo>
                  <a:lnTo>
                    <a:pt x="2341799" y="1108169"/>
                  </a:lnTo>
                  <a:lnTo>
                    <a:pt x="2333445" y="1116453"/>
                  </a:lnTo>
                  <a:lnTo>
                    <a:pt x="2266522" y="1197768"/>
                  </a:lnTo>
                  <a:lnTo>
                    <a:pt x="2258159" y="1210282"/>
                  </a:lnTo>
                  <a:lnTo>
                    <a:pt x="2249806" y="1194855"/>
                  </a:lnTo>
                  <a:lnTo>
                    <a:pt x="2182883" y="1091920"/>
                  </a:lnTo>
                  <a:lnTo>
                    <a:pt x="2174530" y="1081139"/>
                  </a:lnTo>
                  <a:lnTo>
                    <a:pt x="2166176" y="1021261"/>
                  </a:lnTo>
                  <a:lnTo>
                    <a:pt x="2099253" y="465647"/>
                  </a:lnTo>
                  <a:lnTo>
                    <a:pt x="2090890" y="384894"/>
                  </a:lnTo>
                  <a:lnTo>
                    <a:pt x="2082537" y="488777"/>
                  </a:lnTo>
                  <a:lnTo>
                    <a:pt x="2015614" y="1123635"/>
                  </a:lnTo>
                  <a:lnTo>
                    <a:pt x="2007260" y="1184722"/>
                  </a:lnTo>
                  <a:lnTo>
                    <a:pt x="1998898" y="1183028"/>
                  </a:lnTo>
                  <a:lnTo>
                    <a:pt x="1931975" y="1165560"/>
                  </a:lnTo>
                  <a:lnTo>
                    <a:pt x="1923621" y="1162724"/>
                  </a:lnTo>
                  <a:lnTo>
                    <a:pt x="1915268" y="1163818"/>
                  </a:lnTo>
                  <a:lnTo>
                    <a:pt x="1848345" y="1172557"/>
                  </a:lnTo>
                  <a:lnTo>
                    <a:pt x="1839982" y="1173650"/>
                  </a:lnTo>
                  <a:lnTo>
                    <a:pt x="1831629" y="1186425"/>
                  </a:lnTo>
                  <a:lnTo>
                    <a:pt x="1764706" y="1282412"/>
                  </a:lnTo>
                  <a:lnTo>
                    <a:pt x="1756352" y="1293677"/>
                  </a:lnTo>
                  <a:lnTo>
                    <a:pt x="1747989" y="1277534"/>
                  </a:lnTo>
                  <a:lnTo>
                    <a:pt x="1681066" y="1171037"/>
                  </a:lnTo>
                  <a:lnTo>
                    <a:pt x="1672713" y="1160004"/>
                  </a:lnTo>
                  <a:lnTo>
                    <a:pt x="1664360" y="1166615"/>
                  </a:lnTo>
                  <a:lnTo>
                    <a:pt x="1597437" y="1245171"/>
                  </a:lnTo>
                  <a:lnTo>
                    <a:pt x="1589074" y="1260036"/>
                  </a:lnTo>
                  <a:lnTo>
                    <a:pt x="1580720" y="1258710"/>
                  </a:lnTo>
                  <a:lnTo>
                    <a:pt x="1513797" y="1250542"/>
                  </a:lnTo>
                  <a:lnTo>
                    <a:pt x="1505444" y="1249749"/>
                  </a:lnTo>
                  <a:lnTo>
                    <a:pt x="1497091" y="1248084"/>
                  </a:lnTo>
                  <a:lnTo>
                    <a:pt x="1430158" y="1237196"/>
                  </a:lnTo>
                  <a:lnTo>
                    <a:pt x="1421805" y="1236064"/>
                  </a:lnTo>
                  <a:lnTo>
                    <a:pt x="1413451" y="1237235"/>
                  </a:lnTo>
                  <a:lnTo>
                    <a:pt x="1346528" y="1251190"/>
                  </a:lnTo>
                  <a:lnTo>
                    <a:pt x="1338175" y="1253833"/>
                  </a:lnTo>
                  <a:lnTo>
                    <a:pt x="1329812" y="1208995"/>
                  </a:lnTo>
                  <a:lnTo>
                    <a:pt x="1262889" y="987688"/>
                  </a:lnTo>
                  <a:lnTo>
                    <a:pt x="1254536" y="970180"/>
                  </a:lnTo>
                  <a:lnTo>
                    <a:pt x="1246182" y="967345"/>
                  </a:lnTo>
                  <a:lnTo>
                    <a:pt x="1179259" y="940585"/>
                  </a:lnTo>
                  <a:lnTo>
                    <a:pt x="1170896" y="936617"/>
                  </a:lnTo>
                  <a:lnTo>
                    <a:pt x="1162543" y="953776"/>
                  </a:lnTo>
                  <a:lnTo>
                    <a:pt x="1095620" y="1083597"/>
                  </a:lnTo>
                  <a:lnTo>
                    <a:pt x="1087267" y="1098946"/>
                  </a:lnTo>
                  <a:lnTo>
                    <a:pt x="1078904" y="1105604"/>
                  </a:lnTo>
                  <a:lnTo>
                    <a:pt x="1011981" y="1149533"/>
                  </a:lnTo>
                  <a:lnTo>
                    <a:pt x="1003627" y="1154101"/>
                  </a:lnTo>
                  <a:lnTo>
                    <a:pt x="995274" y="1140339"/>
                  </a:lnTo>
                  <a:lnTo>
                    <a:pt x="928351" y="997898"/>
                  </a:lnTo>
                  <a:lnTo>
                    <a:pt x="919988" y="974681"/>
                  </a:lnTo>
                  <a:lnTo>
                    <a:pt x="911635" y="994269"/>
                  </a:lnTo>
                  <a:lnTo>
                    <a:pt x="844712" y="1121215"/>
                  </a:lnTo>
                  <a:lnTo>
                    <a:pt x="836358" y="1134145"/>
                  </a:lnTo>
                  <a:lnTo>
                    <a:pt x="828005" y="1139023"/>
                  </a:lnTo>
                  <a:lnTo>
                    <a:pt x="761082" y="1188622"/>
                  </a:lnTo>
                  <a:lnTo>
                    <a:pt x="752719" y="1196558"/>
                  </a:lnTo>
                  <a:lnTo>
                    <a:pt x="744366" y="1186803"/>
                  </a:lnTo>
                  <a:lnTo>
                    <a:pt x="677443" y="1093352"/>
                  </a:lnTo>
                  <a:lnTo>
                    <a:pt x="669089" y="1079367"/>
                  </a:lnTo>
                  <a:lnTo>
                    <a:pt x="660727" y="1055472"/>
                  </a:lnTo>
                  <a:lnTo>
                    <a:pt x="593803" y="925458"/>
                  </a:lnTo>
                  <a:lnTo>
                    <a:pt x="585450" y="914193"/>
                  </a:lnTo>
                  <a:lnTo>
                    <a:pt x="577097" y="908938"/>
                  </a:lnTo>
                  <a:lnTo>
                    <a:pt x="510174" y="841647"/>
                  </a:lnTo>
                  <a:lnTo>
                    <a:pt x="501811" y="827807"/>
                  </a:lnTo>
                  <a:lnTo>
                    <a:pt x="493458" y="826530"/>
                  </a:lnTo>
                  <a:lnTo>
                    <a:pt x="426534" y="820781"/>
                  </a:lnTo>
                  <a:lnTo>
                    <a:pt x="418181" y="820365"/>
                  </a:lnTo>
                  <a:lnTo>
                    <a:pt x="409818" y="834050"/>
                  </a:lnTo>
                  <a:lnTo>
                    <a:pt x="342895" y="982694"/>
                  </a:lnTo>
                  <a:lnTo>
                    <a:pt x="334542" y="1008254"/>
                  </a:lnTo>
                  <a:lnTo>
                    <a:pt x="326189" y="1036000"/>
                  </a:lnTo>
                  <a:lnTo>
                    <a:pt x="259304" y="1292206"/>
                  </a:lnTo>
                  <a:lnTo>
                    <a:pt x="250903" y="1329253"/>
                  </a:lnTo>
                  <a:lnTo>
                    <a:pt x="242549" y="1291935"/>
                  </a:lnTo>
                  <a:lnTo>
                    <a:pt x="175665" y="1083258"/>
                  </a:lnTo>
                  <a:lnTo>
                    <a:pt x="167273" y="1064773"/>
                  </a:lnTo>
                  <a:lnTo>
                    <a:pt x="158920" y="1060011"/>
                  </a:lnTo>
                  <a:lnTo>
                    <a:pt x="92029" y="1016267"/>
                  </a:lnTo>
                  <a:lnTo>
                    <a:pt x="83635" y="1009957"/>
                  </a:lnTo>
                  <a:lnTo>
                    <a:pt x="75279" y="980429"/>
                  </a:lnTo>
                  <a:lnTo>
                    <a:pt x="8394" y="747209"/>
                  </a:lnTo>
                  <a:lnTo>
                    <a:pt x="0" y="718446"/>
                  </a:lnTo>
                  <a:close/>
                </a:path>
              </a:pathLst>
            </a:custGeom>
            <a:solidFill>
              <a:srgbClr val="B3DE69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04" name="Freeform: Shape 3003">
              <a:extLst>
                <a:ext uri="{FF2B5EF4-FFF2-40B4-BE49-F238E27FC236}">
                  <a16:creationId xmlns:a16="http://schemas.microsoft.com/office/drawing/2014/main" id="{131B5AFA-BAB4-A8D6-8830-2F06093E7397}"/>
                </a:ext>
              </a:extLst>
            </p:cNvPr>
            <p:cNvSpPr/>
            <p:nvPr/>
          </p:nvSpPr>
          <p:spPr>
            <a:xfrm>
              <a:off x="1961705" y="3203908"/>
              <a:ext cx="8363529" cy="1423875"/>
            </a:xfrm>
            <a:custGeom>
              <a:avLst/>
              <a:gdLst>
                <a:gd name="connsiteX0" fmla="*/ 0 w 8363529"/>
                <a:gd name="connsiteY0" fmla="*/ 624840 h 1423875"/>
                <a:gd name="connsiteX1" fmla="*/ 8394 w 8363529"/>
                <a:gd name="connsiteY1" fmla="*/ 653603 h 1423875"/>
                <a:gd name="connsiteX2" fmla="*/ 75279 w 8363529"/>
                <a:gd name="connsiteY2" fmla="*/ 886824 h 1423875"/>
                <a:gd name="connsiteX3" fmla="*/ 83635 w 8363529"/>
                <a:gd name="connsiteY3" fmla="*/ 916351 h 1423875"/>
                <a:gd name="connsiteX4" fmla="*/ 92029 w 8363529"/>
                <a:gd name="connsiteY4" fmla="*/ 922661 h 1423875"/>
                <a:gd name="connsiteX5" fmla="*/ 158920 w 8363529"/>
                <a:gd name="connsiteY5" fmla="*/ 966406 h 1423875"/>
                <a:gd name="connsiteX6" fmla="*/ 167273 w 8363529"/>
                <a:gd name="connsiteY6" fmla="*/ 971167 h 1423875"/>
                <a:gd name="connsiteX7" fmla="*/ 175665 w 8363529"/>
                <a:gd name="connsiteY7" fmla="*/ 989652 h 1423875"/>
                <a:gd name="connsiteX8" fmla="*/ 242549 w 8363529"/>
                <a:gd name="connsiteY8" fmla="*/ 1198330 h 1423875"/>
                <a:gd name="connsiteX9" fmla="*/ 250903 w 8363529"/>
                <a:gd name="connsiteY9" fmla="*/ 1235648 h 1423875"/>
                <a:gd name="connsiteX10" fmla="*/ 259304 w 8363529"/>
                <a:gd name="connsiteY10" fmla="*/ 1198600 h 1423875"/>
                <a:gd name="connsiteX11" fmla="*/ 326189 w 8363529"/>
                <a:gd name="connsiteY11" fmla="*/ 942395 h 1423875"/>
                <a:gd name="connsiteX12" fmla="*/ 334542 w 8363529"/>
                <a:gd name="connsiteY12" fmla="*/ 914648 h 1423875"/>
                <a:gd name="connsiteX13" fmla="*/ 342895 w 8363529"/>
                <a:gd name="connsiteY13" fmla="*/ 889088 h 1423875"/>
                <a:gd name="connsiteX14" fmla="*/ 409818 w 8363529"/>
                <a:gd name="connsiteY14" fmla="*/ 740444 h 1423875"/>
                <a:gd name="connsiteX15" fmla="*/ 418181 w 8363529"/>
                <a:gd name="connsiteY15" fmla="*/ 726759 h 1423875"/>
                <a:gd name="connsiteX16" fmla="*/ 426534 w 8363529"/>
                <a:gd name="connsiteY16" fmla="*/ 727176 h 1423875"/>
                <a:gd name="connsiteX17" fmla="*/ 493458 w 8363529"/>
                <a:gd name="connsiteY17" fmla="*/ 732924 h 1423875"/>
                <a:gd name="connsiteX18" fmla="*/ 501811 w 8363529"/>
                <a:gd name="connsiteY18" fmla="*/ 734202 h 1423875"/>
                <a:gd name="connsiteX19" fmla="*/ 510174 w 8363529"/>
                <a:gd name="connsiteY19" fmla="*/ 748041 h 1423875"/>
                <a:gd name="connsiteX20" fmla="*/ 577097 w 8363529"/>
                <a:gd name="connsiteY20" fmla="*/ 815332 h 1423875"/>
                <a:gd name="connsiteX21" fmla="*/ 585450 w 8363529"/>
                <a:gd name="connsiteY21" fmla="*/ 820588 h 1423875"/>
                <a:gd name="connsiteX22" fmla="*/ 593803 w 8363529"/>
                <a:gd name="connsiteY22" fmla="*/ 831853 h 1423875"/>
                <a:gd name="connsiteX23" fmla="*/ 660727 w 8363529"/>
                <a:gd name="connsiteY23" fmla="*/ 961867 h 1423875"/>
                <a:gd name="connsiteX24" fmla="*/ 669089 w 8363529"/>
                <a:gd name="connsiteY24" fmla="*/ 985762 h 1423875"/>
                <a:gd name="connsiteX25" fmla="*/ 677443 w 8363529"/>
                <a:gd name="connsiteY25" fmla="*/ 999747 h 1423875"/>
                <a:gd name="connsiteX26" fmla="*/ 744366 w 8363529"/>
                <a:gd name="connsiteY26" fmla="*/ 1093197 h 1423875"/>
                <a:gd name="connsiteX27" fmla="*/ 752719 w 8363529"/>
                <a:gd name="connsiteY27" fmla="*/ 1102953 h 1423875"/>
                <a:gd name="connsiteX28" fmla="*/ 761082 w 8363529"/>
                <a:gd name="connsiteY28" fmla="*/ 1095017 h 1423875"/>
                <a:gd name="connsiteX29" fmla="*/ 828005 w 8363529"/>
                <a:gd name="connsiteY29" fmla="*/ 1045417 h 1423875"/>
                <a:gd name="connsiteX30" fmla="*/ 836358 w 8363529"/>
                <a:gd name="connsiteY30" fmla="*/ 1040539 h 1423875"/>
                <a:gd name="connsiteX31" fmla="*/ 844712 w 8363529"/>
                <a:gd name="connsiteY31" fmla="*/ 1027610 h 1423875"/>
                <a:gd name="connsiteX32" fmla="*/ 911635 w 8363529"/>
                <a:gd name="connsiteY32" fmla="*/ 900663 h 1423875"/>
                <a:gd name="connsiteX33" fmla="*/ 919988 w 8363529"/>
                <a:gd name="connsiteY33" fmla="*/ 881075 h 1423875"/>
                <a:gd name="connsiteX34" fmla="*/ 928351 w 8363529"/>
                <a:gd name="connsiteY34" fmla="*/ 904292 h 1423875"/>
                <a:gd name="connsiteX35" fmla="*/ 995274 w 8363529"/>
                <a:gd name="connsiteY35" fmla="*/ 1046733 h 1423875"/>
                <a:gd name="connsiteX36" fmla="*/ 1003627 w 8363529"/>
                <a:gd name="connsiteY36" fmla="*/ 1060495 h 1423875"/>
                <a:gd name="connsiteX37" fmla="*/ 1011981 w 8363529"/>
                <a:gd name="connsiteY37" fmla="*/ 1055927 h 1423875"/>
                <a:gd name="connsiteX38" fmla="*/ 1078904 w 8363529"/>
                <a:gd name="connsiteY38" fmla="*/ 1011999 h 1423875"/>
                <a:gd name="connsiteX39" fmla="*/ 1087267 w 8363529"/>
                <a:gd name="connsiteY39" fmla="*/ 1005340 h 1423875"/>
                <a:gd name="connsiteX40" fmla="*/ 1095620 w 8363529"/>
                <a:gd name="connsiteY40" fmla="*/ 989991 h 1423875"/>
                <a:gd name="connsiteX41" fmla="*/ 1162543 w 8363529"/>
                <a:gd name="connsiteY41" fmla="*/ 860171 h 1423875"/>
                <a:gd name="connsiteX42" fmla="*/ 1170896 w 8363529"/>
                <a:gd name="connsiteY42" fmla="*/ 843011 h 1423875"/>
                <a:gd name="connsiteX43" fmla="*/ 1179259 w 8363529"/>
                <a:gd name="connsiteY43" fmla="*/ 846979 h 1423875"/>
                <a:gd name="connsiteX44" fmla="*/ 1246182 w 8363529"/>
                <a:gd name="connsiteY44" fmla="*/ 873739 h 1423875"/>
                <a:gd name="connsiteX45" fmla="*/ 1254536 w 8363529"/>
                <a:gd name="connsiteY45" fmla="*/ 876575 h 1423875"/>
                <a:gd name="connsiteX46" fmla="*/ 1262889 w 8363529"/>
                <a:gd name="connsiteY46" fmla="*/ 894082 h 1423875"/>
                <a:gd name="connsiteX47" fmla="*/ 1329812 w 8363529"/>
                <a:gd name="connsiteY47" fmla="*/ 1115389 h 1423875"/>
                <a:gd name="connsiteX48" fmla="*/ 1338175 w 8363529"/>
                <a:gd name="connsiteY48" fmla="*/ 1160227 h 1423875"/>
                <a:gd name="connsiteX49" fmla="*/ 1346528 w 8363529"/>
                <a:gd name="connsiteY49" fmla="*/ 1157585 h 1423875"/>
                <a:gd name="connsiteX50" fmla="*/ 1413451 w 8363529"/>
                <a:gd name="connsiteY50" fmla="*/ 1143629 h 1423875"/>
                <a:gd name="connsiteX51" fmla="*/ 1421805 w 8363529"/>
                <a:gd name="connsiteY51" fmla="*/ 1142458 h 1423875"/>
                <a:gd name="connsiteX52" fmla="*/ 1430158 w 8363529"/>
                <a:gd name="connsiteY52" fmla="*/ 1143591 h 1423875"/>
                <a:gd name="connsiteX53" fmla="*/ 1497091 w 8363529"/>
                <a:gd name="connsiteY53" fmla="*/ 1154478 h 1423875"/>
                <a:gd name="connsiteX54" fmla="*/ 1505444 w 8363529"/>
                <a:gd name="connsiteY54" fmla="*/ 1156143 h 1423875"/>
                <a:gd name="connsiteX55" fmla="*/ 1513797 w 8363529"/>
                <a:gd name="connsiteY55" fmla="*/ 1156937 h 1423875"/>
                <a:gd name="connsiteX56" fmla="*/ 1580720 w 8363529"/>
                <a:gd name="connsiteY56" fmla="*/ 1165105 h 1423875"/>
                <a:gd name="connsiteX57" fmla="*/ 1589074 w 8363529"/>
                <a:gd name="connsiteY57" fmla="*/ 1166431 h 1423875"/>
                <a:gd name="connsiteX58" fmla="*/ 1597437 w 8363529"/>
                <a:gd name="connsiteY58" fmla="*/ 1151565 h 1423875"/>
                <a:gd name="connsiteX59" fmla="*/ 1664360 w 8363529"/>
                <a:gd name="connsiteY59" fmla="*/ 1073009 h 1423875"/>
                <a:gd name="connsiteX60" fmla="*/ 1672713 w 8363529"/>
                <a:gd name="connsiteY60" fmla="*/ 1066399 h 1423875"/>
                <a:gd name="connsiteX61" fmla="*/ 1681066 w 8363529"/>
                <a:gd name="connsiteY61" fmla="*/ 1077432 h 1423875"/>
                <a:gd name="connsiteX62" fmla="*/ 1747989 w 8363529"/>
                <a:gd name="connsiteY62" fmla="*/ 1183929 h 1423875"/>
                <a:gd name="connsiteX63" fmla="*/ 1756352 w 8363529"/>
                <a:gd name="connsiteY63" fmla="*/ 1200071 h 1423875"/>
                <a:gd name="connsiteX64" fmla="*/ 1764706 w 8363529"/>
                <a:gd name="connsiteY64" fmla="*/ 1188806 h 1423875"/>
                <a:gd name="connsiteX65" fmla="*/ 1831629 w 8363529"/>
                <a:gd name="connsiteY65" fmla="*/ 1092820 h 1423875"/>
                <a:gd name="connsiteX66" fmla="*/ 1839982 w 8363529"/>
                <a:gd name="connsiteY66" fmla="*/ 1080045 h 1423875"/>
                <a:gd name="connsiteX67" fmla="*/ 1848345 w 8363529"/>
                <a:gd name="connsiteY67" fmla="*/ 1078951 h 1423875"/>
                <a:gd name="connsiteX68" fmla="*/ 1915268 w 8363529"/>
                <a:gd name="connsiteY68" fmla="*/ 1070212 h 1423875"/>
                <a:gd name="connsiteX69" fmla="*/ 1923621 w 8363529"/>
                <a:gd name="connsiteY69" fmla="*/ 1069118 h 1423875"/>
                <a:gd name="connsiteX70" fmla="*/ 1931975 w 8363529"/>
                <a:gd name="connsiteY70" fmla="*/ 1071954 h 1423875"/>
                <a:gd name="connsiteX71" fmla="*/ 1998898 w 8363529"/>
                <a:gd name="connsiteY71" fmla="*/ 1089423 h 1423875"/>
                <a:gd name="connsiteX72" fmla="*/ 2007260 w 8363529"/>
                <a:gd name="connsiteY72" fmla="*/ 1091117 h 1423875"/>
                <a:gd name="connsiteX73" fmla="*/ 2015614 w 8363529"/>
                <a:gd name="connsiteY73" fmla="*/ 1030029 h 1423875"/>
                <a:gd name="connsiteX74" fmla="*/ 2082537 w 8363529"/>
                <a:gd name="connsiteY74" fmla="*/ 395172 h 1423875"/>
                <a:gd name="connsiteX75" fmla="*/ 2090890 w 8363529"/>
                <a:gd name="connsiteY75" fmla="*/ 291288 h 1423875"/>
                <a:gd name="connsiteX76" fmla="*/ 2099253 w 8363529"/>
                <a:gd name="connsiteY76" fmla="*/ 372041 h 1423875"/>
                <a:gd name="connsiteX77" fmla="*/ 2166176 w 8363529"/>
                <a:gd name="connsiteY77" fmla="*/ 927655 h 1423875"/>
                <a:gd name="connsiteX78" fmla="*/ 2174530 w 8363529"/>
                <a:gd name="connsiteY78" fmla="*/ 987533 h 1423875"/>
                <a:gd name="connsiteX79" fmla="*/ 2182883 w 8363529"/>
                <a:gd name="connsiteY79" fmla="*/ 998314 h 1423875"/>
                <a:gd name="connsiteX80" fmla="*/ 2249806 w 8363529"/>
                <a:gd name="connsiteY80" fmla="*/ 1101249 h 1423875"/>
                <a:gd name="connsiteX81" fmla="*/ 2258159 w 8363529"/>
                <a:gd name="connsiteY81" fmla="*/ 1116676 h 1423875"/>
                <a:gd name="connsiteX82" fmla="*/ 2266522 w 8363529"/>
                <a:gd name="connsiteY82" fmla="*/ 1104163 h 1423875"/>
                <a:gd name="connsiteX83" fmla="*/ 2333445 w 8363529"/>
                <a:gd name="connsiteY83" fmla="*/ 1022848 h 1423875"/>
                <a:gd name="connsiteX84" fmla="*/ 2341799 w 8363529"/>
                <a:gd name="connsiteY84" fmla="*/ 1014564 h 1423875"/>
                <a:gd name="connsiteX85" fmla="*/ 2350152 w 8363529"/>
                <a:gd name="connsiteY85" fmla="*/ 992904 h 1423875"/>
                <a:gd name="connsiteX86" fmla="*/ 2417075 w 8363529"/>
                <a:gd name="connsiteY86" fmla="*/ 828601 h 1423875"/>
                <a:gd name="connsiteX87" fmla="*/ 2425438 w 8363529"/>
                <a:gd name="connsiteY87" fmla="*/ 809100 h 1423875"/>
                <a:gd name="connsiteX88" fmla="*/ 2433791 w 8363529"/>
                <a:gd name="connsiteY88" fmla="*/ 841840 h 1423875"/>
                <a:gd name="connsiteX89" fmla="*/ 2500714 w 8363529"/>
                <a:gd name="connsiteY89" fmla="*/ 1089345 h 1423875"/>
                <a:gd name="connsiteX90" fmla="*/ 2509068 w 8363529"/>
                <a:gd name="connsiteY90" fmla="*/ 1118563 h 1423875"/>
                <a:gd name="connsiteX91" fmla="*/ 2517430 w 8363529"/>
                <a:gd name="connsiteY91" fmla="*/ 1118263 h 1423875"/>
                <a:gd name="connsiteX92" fmla="*/ 2584354 w 8363529"/>
                <a:gd name="connsiteY92" fmla="*/ 1115166 h 1423875"/>
                <a:gd name="connsiteX93" fmla="*/ 2592707 w 8363529"/>
                <a:gd name="connsiteY93" fmla="*/ 1114711 h 1423875"/>
                <a:gd name="connsiteX94" fmla="*/ 2601060 w 8363529"/>
                <a:gd name="connsiteY94" fmla="*/ 1127409 h 1423875"/>
                <a:gd name="connsiteX95" fmla="*/ 2667983 w 8363529"/>
                <a:gd name="connsiteY95" fmla="*/ 1230238 h 1423875"/>
                <a:gd name="connsiteX96" fmla="*/ 2676346 w 8363529"/>
                <a:gd name="connsiteY96" fmla="*/ 1243245 h 1423875"/>
                <a:gd name="connsiteX97" fmla="*/ 2684699 w 8363529"/>
                <a:gd name="connsiteY97" fmla="*/ 1228883 h 1423875"/>
                <a:gd name="connsiteX98" fmla="*/ 2751623 w 8363529"/>
                <a:gd name="connsiteY98" fmla="*/ 1093313 h 1423875"/>
                <a:gd name="connsiteX99" fmla="*/ 2759976 w 8363529"/>
                <a:gd name="connsiteY99" fmla="*/ 1073203 h 1423875"/>
                <a:gd name="connsiteX100" fmla="*/ 2768329 w 8363529"/>
                <a:gd name="connsiteY100" fmla="*/ 1056189 h 1423875"/>
                <a:gd name="connsiteX101" fmla="*/ 2835262 w 8363529"/>
                <a:gd name="connsiteY101" fmla="*/ 953892 h 1423875"/>
                <a:gd name="connsiteX102" fmla="*/ 2843615 w 8363529"/>
                <a:gd name="connsiteY102" fmla="*/ 944175 h 1423875"/>
                <a:gd name="connsiteX103" fmla="*/ 2851968 w 8363529"/>
                <a:gd name="connsiteY103" fmla="*/ 889398 h 1423875"/>
                <a:gd name="connsiteX104" fmla="*/ 2918892 w 8363529"/>
                <a:gd name="connsiteY104" fmla="*/ 438955 h 1423875"/>
                <a:gd name="connsiteX105" fmla="*/ 2927245 w 8363529"/>
                <a:gd name="connsiteY105" fmla="*/ 381110 h 1423875"/>
                <a:gd name="connsiteX106" fmla="*/ 2935608 w 8363529"/>
                <a:gd name="connsiteY106" fmla="*/ 445265 h 1423875"/>
                <a:gd name="connsiteX107" fmla="*/ 3002531 w 8363529"/>
                <a:gd name="connsiteY107" fmla="*/ 937788 h 1423875"/>
                <a:gd name="connsiteX108" fmla="*/ 3010884 w 8363529"/>
                <a:gd name="connsiteY108" fmla="*/ 996834 h 1423875"/>
                <a:gd name="connsiteX109" fmla="*/ 3019238 w 8363529"/>
                <a:gd name="connsiteY109" fmla="*/ 970335 h 1423875"/>
                <a:gd name="connsiteX110" fmla="*/ 3086161 w 8363529"/>
                <a:gd name="connsiteY110" fmla="*/ 702071 h 1423875"/>
                <a:gd name="connsiteX111" fmla="*/ 3094523 w 8363529"/>
                <a:gd name="connsiteY111" fmla="*/ 659352 h 1423875"/>
                <a:gd name="connsiteX112" fmla="*/ 3102877 w 8363529"/>
                <a:gd name="connsiteY112" fmla="*/ 648958 h 1423875"/>
                <a:gd name="connsiteX113" fmla="*/ 3169800 w 8363529"/>
                <a:gd name="connsiteY113" fmla="*/ 589758 h 1423875"/>
                <a:gd name="connsiteX114" fmla="*/ 3178153 w 8363529"/>
                <a:gd name="connsiteY114" fmla="*/ 584425 h 1423875"/>
                <a:gd name="connsiteX115" fmla="*/ 3186516 w 8363529"/>
                <a:gd name="connsiteY115" fmla="*/ 630734 h 1423875"/>
                <a:gd name="connsiteX116" fmla="*/ 3253439 w 8363529"/>
                <a:gd name="connsiteY116" fmla="*/ 1094030 h 1423875"/>
                <a:gd name="connsiteX117" fmla="*/ 3261792 w 8363529"/>
                <a:gd name="connsiteY117" fmla="*/ 1166876 h 1423875"/>
                <a:gd name="connsiteX118" fmla="*/ 3270146 w 8363529"/>
                <a:gd name="connsiteY118" fmla="*/ 1178112 h 1423875"/>
                <a:gd name="connsiteX119" fmla="*/ 3337069 w 8363529"/>
                <a:gd name="connsiteY119" fmla="*/ 1369291 h 1423875"/>
                <a:gd name="connsiteX120" fmla="*/ 3345432 w 8363529"/>
                <a:gd name="connsiteY120" fmla="*/ 1423875 h 1423875"/>
                <a:gd name="connsiteX121" fmla="*/ 3353785 w 8363529"/>
                <a:gd name="connsiteY121" fmla="*/ 1319421 h 1423875"/>
                <a:gd name="connsiteX122" fmla="*/ 3420708 w 8363529"/>
                <a:gd name="connsiteY122" fmla="*/ 1013131 h 1423875"/>
                <a:gd name="connsiteX123" fmla="*/ 3429061 w 8363529"/>
                <a:gd name="connsiteY123" fmla="*/ 997511 h 1423875"/>
                <a:gd name="connsiteX124" fmla="*/ 3437424 w 8363529"/>
                <a:gd name="connsiteY124" fmla="*/ 983149 h 1423875"/>
                <a:gd name="connsiteX125" fmla="*/ 3504347 w 8363529"/>
                <a:gd name="connsiteY125" fmla="*/ 851548 h 1423875"/>
                <a:gd name="connsiteX126" fmla="*/ 3512701 w 8363529"/>
                <a:gd name="connsiteY126" fmla="*/ 832646 h 1423875"/>
                <a:gd name="connsiteX127" fmla="*/ 3521054 w 8363529"/>
                <a:gd name="connsiteY127" fmla="*/ 791592 h 1423875"/>
                <a:gd name="connsiteX128" fmla="*/ 3587977 w 8363529"/>
                <a:gd name="connsiteY128" fmla="*/ 507040 h 1423875"/>
                <a:gd name="connsiteX129" fmla="*/ 3596330 w 8363529"/>
                <a:gd name="connsiteY129" fmla="*/ 476148 h 1423875"/>
                <a:gd name="connsiteX130" fmla="*/ 3604693 w 8363529"/>
                <a:gd name="connsiteY130" fmla="*/ 523560 h 1423875"/>
                <a:gd name="connsiteX131" fmla="*/ 3671616 w 8363529"/>
                <a:gd name="connsiteY131" fmla="*/ 1024997 h 1423875"/>
                <a:gd name="connsiteX132" fmla="*/ 3679970 w 8363529"/>
                <a:gd name="connsiteY132" fmla="*/ 1108663 h 1423875"/>
                <a:gd name="connsiteX133" fmla="*/ 3688323 w 8363529"/>
                <a:gd name="connsiteY133" fmla="*/ 1084807 h 1423875"/>
                <a:gd name="connsiteX134" fmla="*/ 3755246 w 8363529"/>
                <a:gd name="connsiteY134" fmla="*/ 917406 h 1423875"/>
                <a:gd name="connsiteX135" fmla="*/ 3763609 w 8363529"/>
                <a:gd name="connsiteY135" fmla="*/ 899037 h 1423875"/>
                <a:gd name="connsiteX136" fmla="*/ 3771962 w 8363529"/>
                <a:gd name="connsiteY136" fmla="*/ 918848 h 1423875"/>
                <a:gd name="connsiteX137" fmla="*/ 3838885 w 8363529"/>
                <a:gd name="connsiteY137" fmla="*/ 1092442 h 1423875"/>
                <a:gd name="connsiteX138" fmla="*/ 3847239 w 8363529"/>
                <a:gd name="connsiteY138" fmla="*/ 1116183 h 1423875"/>
                <a:gd name="connsiteX139" fmla="*/ 3855602 w 8363529"/>
                <a:gd name="connsiteY139" fmla="*/ 1116715 h 1423875"/>
                <a:gd name="connsiteX140" fmla="*/ 3922525 w 8363529"/>
                <a:gd name="connsiteY140" fmla="*/ 1120499 h 1423875"/>
                <a:gd name="connsiteX141" fmla="*/ 3930878 w 8363529"/>
                <a:gd name="connsiteY141" fmla="*/ 1120906 h 1423875"/>
                <a:gd name="connsiteX142" fmla="*/ 3939231 w 8363529"/>
                <a:gd name="connsiteY142" fmla="*/ 1097243 h 1423875"/>
                <a:gd name="connsiteX143" fmla="*/ 4006154 w 8363529"/>
                <a:gd name="connsiteY143" fmla="*/ 930868 h 1423875"/>
                <a:gd name="connsiteX144" fmla="*/ 4014517 w 8363529"/>
                <a:gd name="connsiteY144" fmla="*/ 912529 h 1423875"/>
                <a:gd name="connsiteX145" fmla="*/ 4022871 w 8363529"/>
                <a:gd name="connsiteY145" fmla="*/ 932262 h 1423875"/>
                <a:gd name="connsiteX146" fmla="*/ 4089755 w 8363529"/>
                <a:gd name="connsiteY146" fmla="*/ 1170128 h 1423875"/>
                <a:gd name="connsiteX147" fmla="*/ 4098147 w 8363529"/>
                <a:gd name="connsiteY147" fmla="*/ 1215798 h 1423875"/>
                <a:gd name="connsiteX148" fmla="*/ 4106500 w 8363529"/>
                <a:gd name="connsiteY148" fmla="*/ 1133119 h 1423875"/>
                <a:gd name="connsiteX149" fmla="*/ 4173394 w 8363529"/>
                <a:gd name="connsiteY149" fmla="*/ 710239 h 1423875"/>
                <a:gd name="connsiteX150" fmla="*/ 4181787 w 8363529"/>
                <a:gd name="connsiteY150" fmla="*/ 675688 h 1423875"/>
                <a:gd name="connsiteX151" fmla="*/ 4190140 w 8363529"/>
                <a:gd name="connsiteY151" fmla="*/ 724940 h 1423875"/>
                <a:gd name="connsiteX152" fmla="*/ 4257024 w 8363529"/>
                <a:gd name="connsiteY152" fmla="*/ 1216785 h 1423875"/>
                <a:gd name="connsiteX153" fmla="*/ 4265416 w 8363529"/>
                <a:gd name="connsiteY153" fmla="*/ 1293938 h 1423875"/>
                <a:gd name="connsiteX154" fmla="*/ 4273779 w 8363529"/>
                <a:gd name="connsiteY154" fmla="*/ 1153917 h 1423875"/>
                <a:gd name="connsiteX155" fmla="*/ 4340664 w 8363529"/>
                <a:gd name="connsiteY155" fmla="*/ 119504 h 1423875"/>
                <a:gd name="connsiteX156" fmla="*/ 4349055 w 8363529"/>
                <a:gd name="connsiteY156" fmla="*/ 0 h 1423875"/>
                <a:gd name="connsiteX157" fmla="*/ 4357409 w 8363529"/>
                <a:gd name="connsiteY157" fmla="*/ 112807 h 1423875"/>
                <a:gd name="connsiteX158" fmla="*/ 4424303 w 8363529"/>
                <a:gd name="connsiteY158" fmla="*/ 1007460 h 1423875"/>
                <a:gd name="connsiteX159" fmla="*/ 4432695 w 8363529"/>
                <a:gd name="connsiteY159" fmla="*/ 1118302 h 1423875"/>
                <a:gd name="connsiteX160" fmla="*/ 4441048 w 8363529"/>
                <a:gd name="connsiteY160" fmla="*/ 1112099 h 1423875"/>
                <a:gd name="connsiteX161" fmla="*/ 4507932 w 8363529"/>
                <a:gd name="connsiteY161" fmla="*/ 1059479 h 1423875"/>
                <a:gd name="connsiteX162" fmla="*/ 4516324 w 8363529"/>
                <a:gd name="connsiteY162" fmla="*/ 1052521 h 1423875"/>
                <a:gd name="connsiteX163" fmla="*/ 4524687 w 8363529"/>
                <a:gd name="connsiteY163" fmla="*/ 1061599 h 1423875"/>
                <a:gd name="connsiteX164" fmla="*/ 4591572 w 8363529"/>
                <a:gd name="connsiteY164" fmla="*/ 1142342 h 1423875"/>
                <a:gd name="connsiteX165" fmla="*/ 4599964 w 8363529"/>
                <a:gd name="connsiteY165" fmla="*/ 1153607 h 1423875"/>
                <a:gd name="connsiteX166" fmla="*/ 4608317 w 8363529"/>
                <a:gd name="connsiteY166" fmla="*/ 1106998 h 1423875"/>
                <a:gd name="connsiteX167" fmla="*/ 4675201 w 8363529"/>
                <a:gd name="connsiteY167" fmla="*/ 742263 h 1423875"/>
                <a:gd name="connsiteX168" fmla="*/ 4683603 w 8363529"/>
                <a:gd name="connsiteY168" fmla="*/ 697648 h 1423875"/>
                <a:gd name="connsiteX169" fmla="*/ 4691956 w 8363529"/>
                <a:gd name="connsiteY169" fmla="*/ 705168 h 1423875"/>
                <a:gd name="connsiteX170" fmla="*/ 4758840 w 8363529"/>
                <a:gd name="connsiteY170" fmla="*/ 758706 h 1423875"/>
                <a:gd name="connsiteX171" fmla="*/ 4767232 w 8363529"/>
                <a:gd name="connsiteY171" fmla="*/ 764678 h 1423875"/>
                <a:gd name="connsiteX172" fmla="*/ 4775595 w 8363529"/>
                <a:gd name="connsiteY172" fmla="*/ 778169 h 1423875"/>
                <a:gd name="connsiteX173" fmla="*/ 4842480 w 8363529"/>
                <a:gd name="connsiteY173" fmla="*/ 919680 h 1423875"/>
                <a:gd name="connsiteX174" fmla="*/ 4850872 w 8363529"/>
                <a:gd name="connsiteY174" fmla="*/ 943004 h 1423875"/>
                <a:gd name="connsiteX175" fmla="*/ 4859225 w 8363529"/>
                <a:gd name="connsiteY175" fmla="*/ 967800 h 1423875"/>
                <a:gd name="connsiteX176" fmla="*/ 4926109 w 8363529"/>
                <a:gd name="connsiteY176" fmla="*/ 1097475 h 1423875"/>
                <a:gd name="connsiteX177" fmla="*/ 4934501 w 8363529"/>
                <a:gd name="connsiteY177" fmla="*/ 1108285 h 1423875"/>
                <a:gd name="connsiteX178" fmla="*/ 4942864 w 8363529"/>
                <a:gd name="connsiteY178" fmla="*/ 1104463 h 1423875"/>
                <a:gd name="connsiteX179" fmla="*/ 5009749 w 8363529"/>
                <a:gd name="connsiteY179" fmla="*/ 1070028 h 1423875"/>
                <a:gd name="connsiteX180" fmla="*/ 5018141 w 8363529"/>
                <a:gd name="connsiteY180" fmla="*/ 1065150 h 1423875"/>
                <a:gd name="connsiteX181" fmla="*/ 5026494 w 8363529"/>
                <a:gd name="connsiteY181" fmla="*/ 1057892 h 1423875"/>
                <a:gd name="connsiteX182" fmla="*/ 5093388 w 8363529"/>
                <a:gd name="connsiteY182" fmla="*/ 988743 h 1423875"/>
                <a:gd name="connsiteX183" fmla="*/ 5101780 w 8363529"/>
                <a:gd name="connsiteY183" fmla="*/ 978426 h 1423875"/>
                <a:gd name="connsiteX184" fmla="*/ 5110134 w 8363529"/>
                <a:gd name="connsiteY184" fmla="*/ 969996 h 1423875"/>
                <a:gd name="connsiteX185" fmla="*/ 5177018 w 8363529"/>
                <a:gd name="connsiteY185" fmla="*/ 921268 h 1423875"/>
                <a:gd name="connsiteX186" fmla="*/ 5185410 w 8363529"/>
                <a:gd name="connsiteY186" fmla="*/ 916806 h 1423875"/>
                <a:gd name="connsiteX187" fmla="*/ 5193773 w 8363529"/>
                <a:gd name="connsiteY187" fmla="*/ 913099 h 1423875"/>
                <a:gd name="connsiteX188" fmla="*/ 5260657 w 8363529"/>
                <a:gd name="connsiteY188" fmla="*/ 880852 h 1423875"/>
                <a:gd name="connsiteX189" fmla="*/ 5269049 w 8363529"/>
                <a:gd name="connsiteY189" fmla="*/ 876468 h 1423875"/>
                <a:gd name="connsiteX190" fmla="*/ 5277403 w 8363529"/>
                <a:gd name="connsiteY190" fmla="*/ 891024 h 1423875"/>
                <a:gd name="connsiteX191" fmla="*/ 5344287 w 8363529"/>
                <a:gd name="connsiteY191" fmla="*/ 1025790 h 1423875"/>
                <a:gd name="connsiteX192" fmla="*/ 5352650 w 8363529"/>
                <a:gd name="connsiteY192" fmla="*/ 1045301 h 1423875"/>
                <a:gd name="connsiteX193" fmla="*/ 5361042 w 8363529"/>
                <a:gd name="connsiteY193" fmla="*/ 1048253 h 1423875"/>
                <a:gd name="connsiteX194" fmla="*/ 5427926 w 8363529"/>
                <a:gd name="connsiteY194" fmla="*/ 1106359 h 1423875"/>
                <a:gd name="connsiteX195" fmla="*/ 5436280 w 8363529"/>
                <a:gd name="connsiteY195" fmla="*/ 1126393 h 1423875"/>
                <a:gd name="connsiteX196" fmla="*/ 5444672 w 8363529"/>
                <a:gd name="connsiteY196" fmla="*/ 1154294 h 1423875"/>
                <a:gd name="connsiteX197" fmla="*/ 5511566 w 8363529"/>
                <a:gd name="connsiteY197" fmla="*/ 1246419 h 1423875"/>
                <a:gd name="connsiteX198" fmla="*/ 5519919 w 8363529"/>
                <a:gd name="connsiteY198" fmla="*/ 1251558 h 1423875"/>
                <a:gd name="connsiteX199" fmla="*/ 5528311 w 8363529"/>
                <a:gd name="connsiteY199" fmla="*/ 1223473 h 1423875"/>
                <a:gd name="connsiteX200" fmla="*/ 5595195 w 8363529"/>
                <a:gd name="connsiteY200" fmla="*/ 1067870 h 1423875"/>
                <a:gd name="connsiteX201" fmla="*/ 5603558 w 8363529"/>
                <a:gd name="connsiteY201" fmla="*/ 1054224 h 1423875"/>
                <a:gd name="connsiteX202" fmla="*/ 5611950 w 8363529"/>
                <a:gd name="connsiteY202" fmla="*/ 966174 h 1423875"/>
                <a:gd name="connsiteX203" fmla="*/ 5678835 w 8363529"/>
                <a:gd name="connsiteY203" fmla="*/ 265013 h 1423875"/>
                <a:gd name="connsiteX204" fmla="*/ 5687188 w 8363529"/>
                <a:gd name="connsiteY204" fmla="*/ 177756 h 1423875"/>
                <a:gd name="connsiteX205" fmla="*/ 5695580 w 8363529"/>
                <a:gd name="connsiteY205" fmla="*/ 255451 h 1423875"/>
                <a:gd name="connsiteX206" fmla="*/ 5762474 w 8363529"/>
                <a:gd name="connsiteY206" fmla="*/ 1137435 h 1423875"/>
                <a:gd name="connsiteX207" fmla="*/ 5770827 w 8363529"/>
                <a:gd name="connsiteY207" fmla="*/ 1296135 h 1423875"/>
                <a:gd name="connsiteX208" fmla="*/ 5779219 w 8363529"/>
                <a:gd name="connsiteY208" fmla="*/ 1254094 h 1423875"/>
                <a:gd name="connsiteX209" fmla="*/ 5846103 w 8363529"/>
                <a:gd name="connsiteY209" fmla="*/ 1008892 h 1423875"/>
                <a:gd name="connsiteX210" fmla="*/ 5854457 w 8363529"/>
                <a:gd name="connsiteY210" fmla="*/ 986285 h 1423875"/>
                <a:gd name="connsiteX211" fmla="*/ 5862858 w 8363529"/>
                <a:gd name="connsiteY211" fmla="*/ 989459 h 1423875"/>
                <a:gd name="connsiteX212" fmla="*/ 5929743 w 8363529"/>
                <a:gd name="connsiteY212" fmla="*/ 1030629 h 1423875"/>
                <a:gd name="connsiteX213" fmla="*/ 5938096 w 8363529"/>
                <a:gd name="connsiteY213" fmla="*/ 1039291 h 1423875"/>
                <a:gd name="connsiteX214" fmla="*/ 5946488 w 8363529"/>
                <a:gd name="connsiteY214" fmla="*/ 1054863 h 1423875"/>
                <a:gd name="connsiteX215" fmla="*/ 6013372 w 8363529"/>
                <a:gd name="connsiteY215" fmla="*/ 1133497 h 1423875"/>
                <a:gd name="connsiteX216" fmla="*/ 6021735 w 8363529"/>
                <a:gd name="connsiteY216" fmla="*/ 1139855 h 1423875"/>
                <a:gd name="connsiteX217" fmla="*/ 6030127 w 8363529"/>
                <a:gd name="connsiteY217" fmla="*/ 1141133 h 1423875"/>
                <a:gd name="connsiteX218" fmla="*/ 6097011 w 8363529"/>
                <a:gd name="connsiteY218" fmla="*/ 1152775 h 1423875"/>
                <a:gd name="connsiteX219" fmla="*/ 6105365 w 8363529"/>
                <a:gd name="connsiteY219" fmla="*/ 1154440 h 1423875"/>
                <a:gd name="connsiteX220" fmla="*/ 6113767 w 8363529"/>
                <a:gd name="connsiteY220" fmla="*/ 1149455 h 1423875"/>
                <a:gd name="connsiteX221" fmla="*/ 6180651 w 8363529"/>
                <a:gd name="connsiteY221" fmla="*/ 1114895 h 1423875"/>
                <a:gd name="connsiteX222" fmla="*/ 6189004 w 8363529"/>
                <a:gd name="connsiteY222" fmla="*/ 1111160 h 1423875"/>
                <a:gd name="connsiteX223" fmla="*/ 6197396 w 8363529"/>
                <a:gd name="connsiteY223" fmla="*/ 1111682 h 1423875"/>
                <a:gd name="connsiteX224" fmla="*/ 6264280 w 8363529"/>
                <a:gd name="connsiteY224" fmla="*/ 1116976 h 1423875"/>
                <a:gd name="connsiteX225" fmla="*/ 6272644 w 8363529"/>
                <a:gd name="connsiteY225" fmla="*/ 1117809 h 1423875"/>
                <a:gd name="connsiteX226" fmla="*/ 6281036 w 8363529"/>
                <a:gd name="connsiteY226" fmla="*/ 1105866 h 1423875"/>
                <a:gd name="connsiteX227" fmla="*/ 6347920 w 8363529"/>
                <a:gd name="connsiteY227" fmla="*/ 1024542 h 1423875"/>
                <a:gd name="connsiteX228" fmla="*/ 6356273 w 8363529"/>
                <a:gd name="connsiteY228" fmla="*/ 1015889 h 1423875"/>
                <a:gd name="connsiteX229" fmla="*/ 6364665 w 8363529"/>
                <a:gd name="connsiteY229" fmla="*/ 1035962 h 1423875"/>
                <a:gd name="connsiteX230" fmla="*/ 6431560 w 8363529"/>
                <a:gd name="connsiteY230" fmla="*/ 1183135 h 1423875"/>
                <a:gd name="connsiteX231" fmla="*/ 6439913 w 8363529"/>
                <a:gd name="connsiteY231" fmla="*/ 1199955 h 1423875"/>
                <a:gd name="connsiteX232" fmla="*/ 6448305 w 8363529"/>
                <a:gd name="connsiteY232" fmla="*/ 1186919 h 1423875"/>
                <a:gd name="connsiteX233" fmla="*/ 6515189 w 8363529"/>
                <a:gd name="connsiteY233" fmla="*/ 1069496 h 1423875"/>
                <a:gd name="connsiteX234" fmla="*/ 6523542 w 8363529"/>
                <a:gd name="connsiteY234" fmla="*/ 1052976 h 1423875"/>
                <a:gd name="connsiteX235" fmla="*/ 6531944 w 8363529"/>
                <a:gd name="connsiteY235" fmla="*/ 1071383 h 1423875"/>
                <a:gd name="connsiteX236" fmla="*/ 6598829 w 8363529"/>
                <a:gd name="connsiteY236" fmla="*/ 1235909 h 1423875"/>
                <a:gd name="connsiteX237" fmla="*/ 6607182 w 8363529"/>
                <a:gd name="connsiteY237" fmla="*/ 1258933 h 1423875"/>
                <a:gd name="connsiteX238" fmla="*/ 6615535 w 8363529"/>
                <a:gd name="connsiteY238" fmla="*/ 1251868 h 1423875"/>
                <a:gd name="connsiteX239" fmla="*/ 6682458 w 8363529"/>
                <a:gd name="connsiteY239" fmla="*/ 1212508 h 1423875"/>
                <a:gd name="connsiteX240" fmla="*/ 6690821 w 8363529"/>
                <a:gd name="connsiteY240" fmla="*/ 1209033 h 1423875"/>
                <a:gd name="connsiteX241" fmla="*/ 6699174 w 8363529"/>
                <a:gd name="connsiteY241" fmla="*/ 1182835 h 1423875"/>
                <a:gd name="connsiteX242" fmla="*/ 6766097 w 8363529"/>
                <a:gd name="connsiteY242" fmla="*/ 920474 h 1423875"/>
                <a:gd name="connsiteX243" fmla="*/ 6774451 w 8363529"/>
                <a:gd name="connsiteY243" fmla="*/ 879188 h 1423875"/>
                <a:gd name="connsiteX244" fmla="*/ 6782814 w 8363529"/>
                <a:gd name="connsiteY244" fmla="*/ 917522 h 1423875"/>
                <a:gd name="connsiteX245" fmla="*/ 6849737 w 8363529"/>
                <a:gd name="connsiteY245" fmla="*/ 1274098 h 1423875"/>
                <a:gd name="connsiteX246" fmla="*/ 6858090 w 8363529"/>
                <a:gd name="connsiteY246" fmla="*/ 1326040 h 1423875"/>
                <a:gd name="connsiteX247" fmla="*/ 6866443 w 8363529"/>
                <a:gd name="connsiteY247" fmla="*/ 1279315 h 1423875"/>
                <a:gd name="connsiteX248" fmla="*/ 6933366 w 8363529"/>
                <a:gd name="connsiteY248" fmla="*/ 1027493 h 1423875"/>
                <a:gd name="connsiteX249" fmla="*/ 6941729 w 8363529"/>
                <a:gd name="connsiteY249" fmla="*/ 1005911 h 1423875"/>
                <a:gd name="connsiteX250" fmla="*/ 6950083 w 8363529"/>
                <a:gd name="connsiteY250" fmla="*/ 1030590 h 1423875"/>
                <a:gd name="connsiteX251" fmla="*/ 7017006 w 8363529"/>
                <a:gd name="connsiteY251" fmla="*/ 1271069 h 1423875"/>
                <a:gd name="connsiteX252" fmla="*/ 7025359 w 8363529"/>
                <a:gd name="connsiteY252" fmla="*/ 1307817 h 1423875"/>
                <a:gd name="connsiteX253" fmla="*/ 7033712 w 8363529"/>
                <a:gd name="connsiteY253" fmla="*/ 1291451 h 1423875"/>
                <a:gd name="connsiteX254" fmla="*/ 7100645 w 8363529"/>
                <a:gd name="connsiteY254" fmla="*/ 1151498 h 1423875"/>
                <a:gd name="connsiteX255" fmla="*/ 7108998 w 8363529"/>
                <a:gd name="connsiteY255" fmla="*/ 1132780 h 1423875"/>
                <a:gd name="connsiteX256" fmla="*/ 7117351 w 8363529"/>
                <a:gd name="connsiteY256" fmla="*/ 1148014 h 1423875"/>
                <a:gd name="connsiteX257" fmla="*/ 7184274 w 8363529"/>
                <a:gd name="connsiteY257" fmla="*/ 1274660 h 1423875"/>
                <a:gd name="connsiteX258" fmla="*/ 7192628 w 8363529"/>
                <a:gd name="connsiteY258" fmla="*/ 1291141 h 1423875"/>
                <a:gd name="connsiteX259" fmla="*/ 7200991 w 8363529"/>
                <a:gd name="connsiteY259" fmla="*/ 1277950 h 1423875"/>
                <a:gd name="connsiteX260" fmla="*/ 7267914 w 8363529"/>
                <a:gd name="connsiteY260" fmla="*/ 1180531 h 1423875"/>
                <a:gd name="connsiteX261" fmla="*/ 7276267 w 8363529"/>
                <a:gd name="connsiteY261" fmla="*/ 1169266 h 1423875"/>
                <a:gd name="connsiteX262" fmla="*/ 7284620 w 8363529"/>
                <a:gd name="connsiteY262" fmla="*/ 1123973 h 1423875"/>
                <a:gd name="connsiteX263" fmla="*/ 7351543 w 8363529"/>
                <a:gd name="connsiteY263" fmla="*/ 740899 h 1423875"/>
                <a:gd name="connsiteX264" fmla="*/ 7359906 w 8363529"/>
                <a:gd name="connsiteY264" fmla="*/ 690273 h 1423875"/>
                <a:gd name="connsiteX265" fmla="*/ 7368260 w 8363529"/>
                <a:gd name="connsiteY265" fmla="*/ 673337 h 1423875"/>
                <a:gd name="connsiteX266" fmla="*/ 7435183 w 8363529"/>
                <a:gd name="connsiteY266" fmla="*/ 560491 h 1423875"/>
                <a:gd name="connsiteX267" fmla="*/ 7443536 w 8363529"/>
                <a:gd name="connsiteY267" fmla="*/ 548665 h 1423875"/>
                <a:gd name="connsiteX268" fmla="*/ 7451899 w 8363529"/>
                <a:gd name="connsiteY268" fmla="*/ 574137 h 1423875"/>
                <a:gd name="connsiteX269" fmla="*/ 7518822 w 8363529"/>
                <a:gd name="connsiteY269" fmla="*/ 819233 h 1423875"/>
                <a:gd name="connsiteX270" fmla="*/ 7527175 w 8363529"/>
                <a:gd name="connsiteY270" fmla="*/ 856203 h 1423875"/>
                <a:gd name="connsiteX271" fmla="*/ 7535528 w 8363529"/>
                <a:gd name="connsiteY271" fmla="*/ 896124 h 1423875"/>
                <a:gd name="connsiteX272" fmla="*/ 7602452 w 8363529"/>
                <a:gd name="connsiteY272" fmla="*/ 1163856 h 1423875"/>
                <a:gd name="connsiteX273" fmla="*/ 7610815 w 8363529"/>
                <a:gd name="connsiteY273" fmla="*/ 1191981 h 1423875"/>
                <a:gd name="connsiteX274" fmla="*/ 7619168 w 8363529"/>
                <a:gd name="connsiteY274" fmla="*/ 1188090 h 1423875"/>
                <a:gd name="connsiteX275" fmla="*/ 7686091 w 8363529"/>
                <a:gd name="connsiteY275" fmla="*/ 1154333 h 1423875"/>
                <a:gd name="connsiteX276" fmla="*/ 7694444 w 8363529"/>
                <a:gd name="connsiteY276" fmla="*/ 1149756 h 1423875"/>
                <a:gd name="connsiteX277" fmla="*/ 7702798 w 8363529"/>
                <a:gd name="connsiteY277" fmla="*/ 1078758 h 1423875"/>
                <a:gd name="connsiteX278" fmla="*/ 7769731 w 8363529"/>
                <a:gd name="connsiteY278" fmla="*/ 378613 h 1423875"/>
                <a:gd name="connsiteX279" fmla="*/ 7778084 w 8363529"/>
                <a:gd name="connsiteY279" fmla="*/ 270229 h 1423875"/>
                <a:gd name="connsiteX280" fmla="*/ 7786437 w 8363529"/>
                <a:gd name="connsiteY280" fmla="*/ 417247 h 1423875"/>
                <a:gd name="connsiteX281" fmla="*/ 7853360 w 8363529"/>
                <a:gd name="connsiteY281" fmla="*/ 1135955 h 1423875"/>
                <a:gd name="connsiteX282" fmla="*/ 7861713 w 8363529"/>
                <a:gd name="connsiteY282" fmla="*/ 1192319 h 1423875"/>
                <a:gd name="connsiteX283" fmla="*/ 7870077 w 8363529"/>
                <a:gd name="connsiteY283" fmla="*/ 1155049 h 1423875"/>
                <a:gd name="connsiteX284" fmla="*/ 7937000 w 8363529"/>
                <a:gd name="connsiteY284" fmla="*/ 737647 h 1423875"/>
                <a:gd name="connsiteX285" fmla="*/ 7945353 w 8363529"/>
                <a:gd name="connsiteY285" fmla="*/ 663591 h 1423875"/>
                <a:gd name="connsiteX286" fmla="*/ 7953706 w 8363529"/>
                <a:gd name="connsiteY286" fmla="*/ 705100 h 1423875"/>
                <a:gd name="connsiteX287" fmla="*/ 8020629 w 8363529"/>
                <a:gd name="connsiteY287" fmla="*/ 1021677 h 1423875"/>
                <a:gd name="connsiteX288" fmla="*/ 8028992 w 8363529"/>
                <a:gd name="connsiteY288" fmla="*/ 1059440 h 1423875"/>
                <a:gd name="connsiteX289" fmla="*/ 8037346 w 8363529"/>
                <a:gd name="connsiteY289" fmla="*/ 1077432 h 1423875"/>
                <a:gd name="connsiteX290" fmla="*/ 8104268 w 8363529"/>
                <a:gd name="connsiteY290" fmla="*/ 1242374 h 1423875"/>
                <a:gd name="connsiteX291" fmla="*/ 8112622 w 8363529"/>
                <a:gd name="connsiteY291" fmla="*/ 1266046 h 1423875"/>
                <a:gd name="connsiteX292" fmla="*/ 8120985 w 8363529"/>
                <a:gd name="connsiteY292" fmla="*/ 1243739 h 1423875"/>
                <a:gd name="connsiteX293" fmla="*/ 8187908 w 8363529"/>
                <a:gd name="connsiteY293" fmla="*/ 1125745 h 1423875"/>
                <a:gd name="connsiteX294" fmla="*/ 8196261 w 8363529"/>
                <a:gd name="connsiteY294" fmla="*/ 1115844 h 1423875"/>
                <a:gd name="connsiteX295" fmla="*/ 8204614 w 8363529"/>
                <a:gd name="connsiteY295" fmla="*/ 1053198 h 1423875"/>
                <a:gd name="connsiteX296" fmla="*/ 8271537 w 8363529"/>
                <a:gd name="connsiteY296" fmla="*/ 400766 h 1423875"/>
                <a:gd name="connsiteX297" fmla="*/ 8279900 w 8363529"/>
                <a:gd name="connsiteY297" fmla="*/ 293746 h 1423875"/>
                <a:gd name="connsiteX298" fmla="*/ 8288254 w 8363529"/>
                <a:gd name="connsiteY298" fmla="*/ 381032 h 1423875"/>
                <a:gd name="connsiteX299" fmla="*/ 8355177 w 8363529"/>
                <a:gd name="connsiteY299" fmla="*/ 1086732 h 1423875"/>
                <a:gd name="connsiteX300" fmla="*/ 8363530 w 8363529"/>
                <a:gd name="connsiteY300" fmla="*/ 1175838 h 1423875"/>
                <a:gd name="connsiteX301" fmla="*/ 8363530 w 8363529"/>
                <a:gd name="connsiteY301" fmla="*/ 1250765 h 1423875"/>
                <a:gd name="connsiteX302" fmla="*/ 8355177 w 8363529"/>
                <a:gd name="connsiteY302" fmla="*/ 1181780 h 1423875"/>
                <a:gd name="connsiteX303" fmla="*/ 8288254 w 8363529"/>
                <a:gd name="connsiteY303" fmla="*/ 635312 h 1423875"/>
                <a:gd name="connsiteX304" fmla="*/ 8279900 w 8363529"/>
                <a:gd name="connsiteY304" fmla="*/ 567673 h 1423875"/>
                <a:gd name="connsiteX305" fmla="*/ 8271537 w 8363529"/>
                <a:gd name="connsiteY305" fmla="*/ 647709 h 1423875"/>
                <a:gd name="connsiteX306" fmla="*/ 8204614 w 8363529"/>
                <a:gd name="connsiteY306" fmla="*/ 1135316 h 1423875"/>
                <a:gd name="connsiteX307" fmla="*/ 8196261 w 8363529"/>
                <a:gd name="connsiteY307" fmla="*/ 1182119 h 1423875"/>
                <a:gd name="connsiteX308" fmla="*/ 8187908 w 8363529"/>
                <a:gd name="connsiteY308" fmla="*/ 1191758 h 1423875"/>
                <a:gd name="connsiteX309" fmla="*/ 8120985 w 8363529"/>
                <a:gd name="connsiteY309" fmla="*/ 1306413 h 1423875"/>
                <a:gd name="connsiteX310" fmla="*/ 8112622 w 8363529"/>
                <a:gd name="connsiteY310" fmla="*/ 1328082 h 1423875"/>
                <a:gd name="connsiteX311" fmla="*/ 8104268 w 8363529"/>
                <a:gd name="connsiteY311" fmla="*/ 1315453 h 1423875"/>
                <a:gd name="connsiteX312" fmla="*/ 8037346 w 8363529"/>
                <a:gd name="connsiteY312" fmla="*/ 1227712 h 1423875"/>
                <a:gd name="connsiteX313" fmla="*/ 8028992 w 8363529"/>
                <a:gd name="connsiteY313" fmla="*/ 1218140 h 1423875"/>
                <a:gd name="connsiteX314" fmla="*/ 8020629 w 8363529"/>
                <a:gd name="connsiteY314" fmla="*/ 1184083 h 1423875"/>
                <a:gd name="connsiteX315" fmla="*/ 7953706 w 8363529"/>
                <a:gd name="connsiteY315" fmla="*/ 898582 h 1423875"/>
                <a:gd name="connsiteX316" fmla="*/ 7945353 w 8363529"/>
                <a:gd name="connsiteY316" fmla="*/ 861158 h 1423875"/>
                <a:gd name="connsiteX317" fmla="*/ 7937000 w 8363529"/>
                <a:gd name="connsiteY317" fmla="*/ 929504 h 1423875"/>
                <a:gd name="connsiteX318" fmla="*/ 7870077 w 8363529"/>
                <a:gd name="connsiteY318" fmla="*/ 1314882 h 1423875"/>
                <a:gd name="connsiteX319" fmla="*/ 7861713 w 8363529"/>
                <a:gd name="connsiteY319" fmla="*/ 1349287 h 1423875"/>
                <a:gd name="connsiteX320" fmla="*/ 7853360 w 8363529"/>
                <a:gd name="connsiteY320" fmla="*/ 1302978 h 1423875"/>
                <a:gd name="connsiteX321" fmla="*/ 7786437 w 8363529"/>
                <a:gd name="connsiteY321" fmla="*/ 712165 h 1423875"/>
                <a:gd name="connsiteX322" fmla="*/ 7778084 w 8363529"/>
                <a:gd name="connsiteY322" fmla="*/ 591306 h 1423875"/>
                <a:gd name="connsiteX323" fmla="*/ 7769731 w 8363529"/>
                <a:gd name="connsiteY323" fmla="*/ 668159 h 1423875"/>
                <a:gd name="connsiteX324" fmla="*/ 7702798 w 8363529"/>
                <a:gd name="connsiteY324" fmla="*/ 1164457 h 1423875"/>
                <a:gd name="connsiteX325" fmla="*/ 7694444 w 8363529"/>
                <a:gd name="connsiteY325" fmla="*/ 1214782 h 1423875"/>
                <a:gd name="connsiteX326" fmla="*/ 7686091 w 8363529"/>
                <a:gd name="connsiteY326" fmla="*/ 1233567 h 1423875"/>
                <a:gd name="connsiteX327" fmla="*/ 7619168 w 8363529"/>
                <a:gd name="connsiteY327" fmla="*/ 1371779 h 1423875"/>
                <a:gd name="connsiteX328" fmla="*/ 7610815 w 8363529"/>
                <a:gd name="connsiteY328" fmla="*/ 1387699 h 1423875"/>
                <a:gd name="connsiteX329" fmla="*/ 7602452 w 8363529"/>
                <a:gd name="connsiteY329" fmla="*/ 1351251 h 1423875"/>
                <a:gd name="connsiteX330" fmla="*/ 7535528 w 8363529"/>
                <a:gd name="connsiteY330" fmla="*/ 1004586 h 1423875"/>
                <a:gd name="connsiteX331" fmla="*/ 7527175 w 8363529"/>
                <a:gd name="connsiteY331" fmla="*/ 952866 h 1423875"/>
                <a:gd name="connsiteX332" fmla="*/ 7518822 w 8363529"/>
                <a:gd name="connsiteY332" fmla="*/ 926145 h 1423875"/>
                <a:gd name="connsiteX333" fmla="*/ 7451899 w 8363529"/>
                <a:gd name="connsiteY333" fmla="*/ 748951 h 1423875"/>
                <a:gd name="connsiteX334" fmla="*/ 7443536 w 8363529"/>
                <a:gd name="connsiteY334" fmla="*/ 730543 h 1423875"/>
                <a:gd name="connsiteX335" fmla="*/ 7435183 w 8363529"/>
                <a:gd name="connsiteY335" fmla="*/ 777569 h 1423875"/>
                <a:gd name="connsiteX336" fmla="*/ 7368260 w 8363529"/>
                <a:gd name="connsiteY336" fmla="*/ 1226841 h 1423875"/>
                <a:gd name="connsiteX337" fmla="*/ 7359906 w 8363529"/>
                <a:gd name="connsiteY337" fmla="*/ 1294171 h 1423875"/>
                <a:gd name="connsiteX338" fmla="*/ 7351543 w 8363529"/>
                <a:gd name="connsiteY338" fmla="*/ 1290657 h 1423875"/>
                <a:gd name="connsiteX339" fmla="*/ 7284620 w 8363529"/>
                <a:gd name="connsiteY339" fmla="*/ 1263966 h 1423875"/>
                <a:gd name="connsiteX340" fmla="*/ 7276267 w 8363529"/>
                <a:gd name="connsiteY340" fmla="*/ 1260791 h 1423875"/>
                <a:gd name="connsiteX341" fmla="*/ 7267914 w 8363529"/>
                <a:gd name="connsiteY341" fmla="*/ 1270092 h 1423875"/>
                <a:gd name="connsiteX342" fmla="*/ 7200991 w 8363529"/>
                <a:gd name="connsiteY342" fmla="*/ 1350535 h 1423875"/>
                <a:gd name="connsiteX343" fmla="*/ 7192628 w 8363529"/>
                <a:gd name="connsiteY343" fmla="*/ 1361423 h 1423875"/>
                <a:gd name="connsiteX344" fmla="*/ 7184274 w 8363529"/>
                <a:gd name="connsiteY344" fmla="*/ 1356052 h 1423875"/>
                <a:gd name="connsiteX345" fmla="*/ 7117351 w 8363529"/>
                <a:gd name="connsiteY345" fmla="*/ 1314775 h 1423875"/>
                <a:gd name="connsiteX346" fmla="*/ 7108998 w 8363529"/>
                <a:gd name="connsiteY346" fmla="*/ 1309820 h 1423875"/>
                <a:gd name="connsiteX347" fmla="*/ 7100645 w 8363529"/>
                <a:gd name="connsiteY347" fmla="*/ 1317988 h 1423875"/>
                <a:gd name="connsiteX348" fmla="*/ 7033712 w 8363529"/>
                <a:gd name="connsiteY348" fmla="*/ 1379037 h 1423875"/>
                <a:gd name="connsiteX349" fmla="*/ 7025359 w 8363529"/>
                <a:gd name="connsiteY349" fmla="*/ 1386189 h 1423875"/>
                <a:gd name="connsiteX350" fmla="*/ 7017006 w 8363529"/>
                <a:gd name="connsiteY350" fmla="*/ 1347245 h 1423875"/>
                <a:gd name="connsiteX351" fmla="*/ 6950083 w 8363529"/>
                <a:gd name="connsiteY351" fmla="*/ 1092559 h 1423875"/>
                <a:gd name="connsiteX352" fmla="*/ 6941729 w 8363529"/>
                <a:gd name="connsiteY352" fmla="*/ 1066399 h 1423875"/>
                <a:gd name="connsiteX353" fmla="*/ 6933366 w 8363529"/>
                <a:gd name="connsiteY353" fmla="*/ 1089007 h 1423875"/>
                <a:gd name="connsiteX354" fmla="*/ 6866443 w 8363529"/>
                <a:gd name="connsiteY354" fmla="*/ 1353032 h 1423875"/>
                <a:gd name="connsiteX355" fmla="*/ 6858090 w 8363529"/>
                <a:gd name="connsiteY355" fmla="*/ 1402022 h 1423875"/>
                <a:gd name="connsiteX356" fmla="*/ 6849737 w 8363529"/>
                <a:gd name="connsiteY356" fmla="*/ 1354958 h 1423875"/>
                <a:gd name="connsiteX357" fmla="*/ 6782814 w 8363529"/>
                <a:gd name="connsiteY357" fmla="*/ 1031955 h 1423875"/>
                <a:gd name="connsiteX358" fmla="*/ 6774451 w 8363529"/>
                <a:gd name="connsiteY358" fmla="*/ 997250 h 1423875"/>
                <a:gd name="connsiteX359" fmla="*/ 6766097 w 8363529"/>
                <a:gd name="connsiteY359" fmla="*/ 1028026 h 1423875"/>
                <a:gd name="connsiteX360" fmla="*/ 6699174 w 8363529"/>
                <a:gd name="connsiteY360" fmla="*/ 1223589 h 1423875"/>
                <a:gd name="connsiteX361" fmla="*/ 6690821 w 8363529"/>
                <a:gd name="connsiteY361" fmla="*/ 1243129 h 1423875"/>
                <a:gd name="connsiteX362" fmla="*/ 6682458 w 8363529"/>
                <a:gd name="connsiteY362" fmla="*/ 1249332 h 1423875"/>
                <a:gd name="connsiteX363" fmla="*/ 6615535 w 8363529"/>
                <a:gd name="connsiteY363" fmla="*/ 1319498 h 1423875"/>
                <a:gd name="connsiteX364" fmla="*/ 6607182 w 8363529"/>
                <a:gd name="connsiteY364" fmla="*/ 1332089 h 1423875"/>
                <a:gd name="connsiteX365" fmla="*/ 6598829 w 8363529"/>
                <a:gd name="connsiteY365" fmla="*/ 1321201 h 1423875"/>
                <a:gd name="connsiteX366" fmla="*/ 6531944 w 8363529"/>
                <a:gd name="connsiteY366" fmla="*/ 1243400 h 1423875"/>
                <a:gd name="connsiteX367" fmla="*/ 6523542 w 8363529"/>
                <a:gd name="connsiteY367" fmla="*/ 1234661 h 1423875"/>
                <a:gd name="connsiteX368" fmla="*/ 6515189 w 8363529"/>
                <a:gd name="connsiteY368" fmla="*/ 1238783 h 1423875"/>
                <a:gd name="connsiteX369" fmla="*/ 6448305 w 8363529"/>
                <a:gd name="connsiteY369" fmla="*/ 1268050 h 1423875"/>
                <a:gd name="connsiteX370" fmla="*/ 6439913 w 8363529"/>
                <a:gd name="connsiteY370" fmla="*/ 1271301 h 1423875"/>
                <a:gd name="connsiteX371" fmla="*/ 6431560 w 8363529"/>
                <a:gd name="connsiteY371" fmla="*/ 1269859 h 1423875"/>
                <a:gd name="connsiteX372" fmla="*/ 6364665 w 8363529"/>
                <a:gd name="connsiteY372" fmla="*/ 1257268 h 1423875"/>
                <a:gd name="connsiteX373" fmla="*/ 6356273 w 8363529"/>
                <a:gd name="connsiteY373" fmla="*/ 1255536 h 1423875"/>
                <a:gd name="connsiteX374" fmla="*/ 6347920 w 8363529"/>
                <a:gd name="connsiteY374" fmla="*/ 1247445 h 1423875"/>
                <a:gd name="connsiteX375" fmla="*/ 6281036 w 8363529"/>
                <a:gd name="connsiteY375" fmla="*/ 1171270 h 1423875"/>
                <a:gd name="connsiteX376" fmla="*/ 6272644 w 8363529"/>
                <a:gd name="connsiteY376" fmla="*/ 1160034 h 1423875"/>
                <a:gd name="connsiteX377" fmla="*/ 6264280 w 8363529"/>
                <a:gd name="connsiteY377" fmla="*/ 1171647 h 1423875"/>
                <a:gd name="connsiteX378" fmla="*/ 6197396 w 8363529"/>
                <a:gd name="connsiteY378" fmla="*/ 1243816 h 1423875"/>
                <a:gd name="connsiteX379" fmla="*/ 6189004 w 8363529"/>
                <a:gd name="connsiteY379" fmla="*/ 1250881 h 1423875"/>
                <a:gd name="connsiteX380" fmla="*/ 6180651 w 8363529"/>
                <a:gd name="connsiteY380" fmla="*/ 1247106 h 1423875"/>
                <a:gd name="connsiteX381" fmla="*/ 6113767 w 8363529"/>
                <a:gd name="connsiteY381" fmla="*/ 1212092 h 1423875"/>
                <a:gd name="connsiteX382" fmla="*/ 6105365 w 8363529"/>
                <a:gd name="connsiteY382" fmla="*/ 1206991 h 1423875"/>
                <a:gd name="connsiteX383" fmla="*/ 6097011 w 8363529"/>
                <a:gd name="connsiteY383" fmla="*/ 1224344 h 1423875"/>
                <a:gd name="connsiteX384" fmla="*/ 6030127 w 8363529"/>
                <a:gd name="connsiteY384" fmla="*/ 1346306 h 1423875"/>
                <a:gd name="connsiteX385" fmla="*/ 6021735 w 8363529"/>
                <a:gd name="connsiteY385" fmla="*/ 1359758 h 1423875"/>
                <a:gd name="connsiteX386" fmla="*/ 6013372 w 8363529"/>
                <a:gd name="connsiteY386" fmla="*/ 1343993 h 1423875"/>
                <a:gd name="connsiteX387" fmla="*/ 5946488 w 8363529"/>
                <a:gd name="connsiteY387" fmla="*/ 1148284 h 1423875"/>
                <a:gd name="connsiteX388" fmla="*/ 5938096 w 8363529"/>
                <a:gd name="connsiteY388" fmla="*/ 1109456 h 1423875"/>
                <a:gd name="connsiteX389" fmla="*/ 5929743 w 8363529"/>
                <a:gd name="connsiteY389" fmla="*/ 1111305 h 1423875"/>
                <a:gd name="connsiteX390" fmla="*/ 5862858 w 8363529"/>
                <a:gd name="connsiteY390" fmla="*/ 1120112 h 1423875"/>
                <a:gd name="connsiteX391" fmla="*/ 5854457 w 8363529"/>
                <a:gd name="connsiteY391" fmla="*/ 1120760 h 1423875"/>
                <a:gd name="connsiteX392" fmla="*/ 5846103 w 8363529"/>
                <a:gd name="connsiteY392" fmla="*/ 1138713 h 1423875"/>
                <a:gd name="connsiteX393" fmla="*/ 5779219 w 8363529"/>
                <a:gd name="connsiteY393" fmla="*/ 1333183 h 1423875"/>
                <a:gd name="connsiteX394" fmla="*/ 5770827 w 8363529"/>
                <a:gd name="connsiteY394" fmla="*/ 1366523 h 1423875"/>
                <a:gd name="connsiteX395" fmla="*/ 5762474 w 8363529"/>
                <a:gd name="connsiteY395" fmla="*/ 1215760 h 1423875"/>
                <a:gd name="connsiteX396" fmla="*/ 5695580 w 8363529"/>
                <a:gd name="connsiteY396" fmla="*/ 378119 h 1423875"/>
                <a:gd name="connsiteX397" fmla="*/ 5687188 w 8363529"/>
                <a:gd name="connsiteY397" fmla="*/ 304363 h 1423875"/>
                <a:gd name="connsiteX398" fmla="*/ 5678835 w 8363529"/>
                <a:gd name="connsiteY398" fmla="*/ 403979 h 1423875"/>
                <a:gd name="connsiteX399" fmla="*/ 5611950 w 8363529"/>
                <a:gd name="connsiteY399" fmla="*/ 1204649 h 1423875"/>
                <a:gd name="connsiteX400" fmla="*/ 5603558 w 8363529"/>
                <a:gd name="connsiteY400" fmla="*/ 1305204 h 1423875"/>
                <a:gd name="connsiteX401" fmla="*/ 5595195 w 8363529"/>
                <a:gd name="connsiteY401" fmla="*/ 1303849 h 1423875"/>
                <a:gd name="connsiteX402" fmla="*/ 5528311 w 8363529"/>
                <a:gd name="connsiteY402" fmla="*/ 1288267 h 1423875"/>
                <a:gd name="connsiteX403" fmla="*/ 5519919 w 8363529"/>
                <a:gd name="connsiteY403" fmla="*/ 1285470 h 1423875"/>
                <a:gd name="connsiteX404" fmla="*/ 5511566 w 8363529"/>
                <a:gd name="connsiteY404" fmla="*/ 1278899 h 1423875"/>
                <a:gd name="connsiteX405" fmla="*/ 5444672 w 8363529"/>
                <a:gd name="connsiteY405" fmla="*/ 1161853 h 1423875"/>
                <a:gd name="connsiteX406" fmla="*/ 5436280 w 8363529"/>
                <a:gd name="connsiteY406" fmla="*/ 1126393 h 1423875"/>
                <a:gd name="connsiteX407" fmla="*/ 5427926 w 8363529"/>
                <a:gd name="connsiteY407" fmla="*/ 1146049 h 1423875"/>
                <a:gd name="connsiteX408" fmla="*/ 5361042 w 8363529"/>
                <a:gd name="connsiteY408" fmla="*/ 1203207 h 1423875"/>
                <a:gd name="connsiteX409" fmla="*/ 5352650 w 8363529"/>
                <a:gd name="connsiteY409" fmla="*/ 1206082 h 1423875"/>
                <a:gd name="connsiteX410" fmla="*/ 5344287 w 8363529"/>
                <a:gd name="connsiteY410" fmla="*/ 1178828 h 1423875"/>
                <a:gd name="connsiteX411" fmla="*/ 5277403 w 8363529"/>
                <a:gd name="connsiteY411" fmla="*/ 990601 h 1423875"/>
                <a:gd name="connsiteX412" fmla="*/ 5269049 w 8363529"/>
                <a:gd name="connsiteY412" fmla="*/ 970258 h 1423875"/>
                <a:gd name="connsiteX413" fmla="*/ 5260657 w 8363529"/>
                <a:gd name="connsiteY413" fmla="*/ 972455 h 1423875"/>
                <a:gd name="connsiteX414" fmla="*/ 5193773 w 8363529"/>
                <a:gd name="connsiteY414" fmla="*/ 988665 h 1423875"/>
                <a:gd name="connsiteX415" fmla="*/ 5185410 w 8363529"/>
                <a:gd name="connsiteY415" fmla="*/ 990523 h 1423875"/>
                <a:gd name="connsiteX416" fmla="*/ 5177018 w 8363529"/>
                <a:gd name="connsiteY416" fmla="*/ 1011273 h 1423875"/>
                <a:gd name="connsiteX417" fmla="*/ 5110134 w 8363529"/>
                <a:gd name="connsiteY417" fmla="*/ 1238522 h 1423875"/>
                <a:gd name="connsiteX418" fmla="*/ 5101780 w 8363529"/>
                <a:gd name="connsiteY418" fmla="*/ 1277834 h 1423875"/>
                <a:gd name="connsiteX419" fmla="*/ 5093388 w 8363529"/>
                <a:gd name="connsiteY419" fmla="*/ 1277728 h 1423875"/>
                <a:gd name="connsiteX420" fmla="*/ 5026494 w 8363529"/>
                <a:gd name="connsiteY420" fmla="*/ 1277002 h 1423875"/>
                <a:gd name="connsiteX421" fmla="*/ 5018141 w 8363529"/>
                <a:gd name="connsiteY421" fmla="*/ 1276934 h 1423875"/>
                <a:gd name="connsiteX422" fmla="*/ 5009749 w 8363529"/>
                <a:gd name="connsiteY422" fmla="*/ 1268805 h 1423875"/>
                <a:gd name="connsiteX423" fmla="*/ 4942864 w 8363529"/>
                <a:gd name="connsiteY423" fmla="*/ 1211037 h 1423875"/>
                <a:gd name="connsiteX424" fmla="*/ 4934501 w 8363529"/>
                <a:gd name="connsiteY424" fmla="*/ 1204610 h 1423875"/>
                <a:gd name="connsiteX425" fmla="*/ 4926109 w 8363529"/>
                <a:gd name="connsiteY425" fmla="*/ 1192736 h 1423875"/>
                <a:gd name="connsiteX426" fmla="*/ 4859225 w 8363529"/>
                <a:gd name="connsiteY426" fmla="*/ 1050140 h 1423875"/>
                <a:gd name="connsiteX427" fmla="*/ 4850872 w 8363529"/>
                <a:gd name="connsiteY427" fmla="*/ 1022848 h 1423875"/>
                <a:gd name="connsiteX428" fmla="*/ 4842480 w 8363529"/>
                <a:gd name="connsiteY428" fmla="*/ 1027571 h 1423875"/>
                <a:gd name="connsiteX429" fmla="*/ 4775595 w 8363529"/>
                <a:gd name="connsiteY429" fmla="*/ 1056227 h 1423875"/>
                <a:gd name="connsiteX430" fmla="*/ 4767232 w 8363529"/>
                <a:gd name="connsiteY430" fmla="*/ 1058986 h 1423875"/>
                <a:gd name="connsiteX431" fmla="*/ 4758840 w 8363529"/>
                <a:gd name="connsiteY431" fmla="*/ 1029042 h 1423875"/>
                <a:gd name="connsiteX432" fmla="*/ 4691956 w 8363529"/>
                <a:gd name="connsiteY432" fmla="*/ 760932 h 1423875"/>
                <a:gd name="connsiteX433" fmla="*/ 4683603 w 8363529"/>
                <a:gd name="connsiteY433" fmla="*/ 723353 h 1423875"/>
                <a:gd name="connsiteX434" fmla="*/ 4675201 w 8363529"/>
                <a:gd name="connsiteY434" fmla="*/ 776204 h 1423875"/>
                <a:gd name="connsiteX435" fmla="*/ 4608317 w 8363529"/>
                <a:gd name="connsiteY435" fmla="*/ 1208617 h 1423875"/>
                <a:gd name="connsiteX436" fmla="*/ 4599964 w 8363529"/>
                <a:gd name="connsiteY436" fmla="*/ 1263888 h 1423875"/>
                <a:gd name="connsiteX437" fmla="*/ 4591572 w 8363529"/>
                <a:gd name="connsiteY437" fmla="*/ 1242906 h 1423875"/>
                <a:gd name="connsiteX438" fmla="*/ 4524687 w 8363529"/>
                <a:gd name="connsiteY438" fmla="*/ 1092326 h 1423875"/>
                <a:gd name="connsiteX439" fmla="*/ 4516324 w 8363529"/>
                <a:gd name="connsiteY439" fmla="*/ 1075429 h 1423875"/>
                <a:gd name="connsiteX440" fmla="*/ 4507932 w 8363529"/>
                <a:gd name="connsiteY440" fmla="*/ 1093768 h 1423875"/>
                <a:gd name="connsiteX441" fmla="*/ 4441048 w 8363529"/>
                <a:gd name="connsiteY441" fmla="*/ 1232396 h 1423875"/>
                <a:gd name="connsiteX442" fmla="*/ 4432695 w 8363529"/>
                <a:gd name="connsiteY442" fmla="*/ 1248800 h 1423875"/>
                <a:gd name="connsiteX443" fmla="*/ 4424303 w 8363529"/>
                <a:gd name="connsiteY443" fmla="*/ 1133913 h 1423875"/>
                <a:gd name="connsiteX444" fmla="*/ 4357409 w 8363529"/>
                <a:gd name="connsiteY444" fmla="*/ 207099 h 1423875"/>
                <a:gd name="connsiteX445" fmla="*/ 4349055 w 8363529"/>
                <a:gd name="connsiteY445" fmla="*/ 90238 h 1423875"/>
                <a:gd name="connsiteX446" fmla="*/ 4340664 w 8363529"/>
                <a:gd name="connsiteY446" fmla="*/ 207583 h 1423875"/>
                <a:gd name="connsiteX447" fmla="*/ 4273779 w 8363529"/>
                <a:gd name="connsiteY447" fmla="*/ 1223744 h 1423875"/>
                <a:gd name="connsiteX448" fmla="*/ 4265416 w 8363529"/>
                <a:gd name="connsiteY448" fmla="*/ 1361268 h 1423875"/>
                <a:gd name="connsiteX449" fmla="*/ 4257024 w 8363529"/>
                <a:gd name="connsiteY449" fmla="*/ 1316962 h 1423875"/>
                <a:gd name="connsiteX450" fmla="*/ 4190140 w 8363529"/>
                <a:gd name="connsiteY450" fmla="*/ 1034529 h 1423875"/>
                <a:gd name="connsiteX451" fmla="*/ 4181787 w 8363529"/>
                <a:gd name="connsiteY451" fmla="*/ 1006250 h 1423875"/>
                <a:gd name="connsiteX452" fmla="*/ 4173394 w 8363529"/>
                <a:gd name="connsiteY452" fmla="*/ 1026400 h 1423875"/>
                <a:gd name="connsiteX453" fmla="*/ 4106500 w 8363529"/>
                <a:gd name="connsiteY453" fmla="*/ 1273073 h 1423875"/>
                <a:gd name="connsiteX454" fmla="*/ 4098147 w 8363529"/>
                <a:gd name="connsiteY454" fmla="*/ 1321317 h 1423875"/>
                <a:gd name="connsiteX455" fmla="*/ 4089755 w 8363529"/>
                <a:gd name="connsiteY455" fmla="*/ 1284831 h 1423875"/>
                <a:gd name="connsiteX456" fmla="*/ 4022871 w 8363529"/>
                <a:gd name="connsiteY456" fmla="*/ 1094823 h 1423875"/>
                <a:gd name="connsiteX457" fmla="*/ 4014517 w 8363529"/>
                <a:gd name="connsiteY457" fmla="*/ 1079058 h 1423875"/>
                <a:gd name="connsiteX458" fmla="*/ 4006154 w 8363529"/>
                <a:gd name="connsiteY458" fmla="*/ 1093120 h 1423875"/>
                <a:gd name="connsiteX459" fmla="*/ 3939231 w 8363529"/>
                <a:gd name="connsiteY459" fmla="*/ 1220831 h 1423875"/>
                <a:gd name="connsiteX460" fmla="*/ 3930878 w 8363529"/>
                <a:gd name="connsiteY460" fmla="*/ 1238977 h 1423875"/>
                <a:gd name="connsiteX461" fmla="*/ 3922525 w 8363529"/>
                <a:gd name="connsiteY461" fmla="*/ 1235193 h 1423875"/>
                <a:gd name="connsiteX462" fmla="*/ 3855602 w 8363529"/>
                <a:gd name="connsiteY462" fmla="*/ 1201513 h 1423875"/>
                <a:gd name="connsiteX463" fmla="*/ 3847239 w 8363529"/>
                <a:gd name="connsiteY463" fmla="*/ 1196820 h 1423875"/>
                <a:gd name="connsiteX464" fmla="*/ 3838885 w 8363529"/>
                <a:gd name="connsiteY464" fmla="*/ 1170544 h 1423875"/>
                <a:gd name="connsiteX465" fmla="*/ 3771962 w 8363529"/>
                <a:gd name="connsiteY465" fmla="*/ 978958 h 1423875"/>
                <a:gd name="connsiteX466" fmla="*/ 3763609 w 8363529"/>
                <a:gd name="connsiteY466" fmla="*/ 957067 h 1423875"/>
                <a:gd name="connsiteX467" fmla="*/ 3755246 w 8363529"/>
                <a:gd name="connsiteY467" fmla="*/ 974119 h 1423875"/>
                <a:gd name="connsiteX468" fmla="*/ 3688323 w 8363529"/>
                <a:gd name="connsiteY468" fmla="*/ 1129267 h 1423875"/>
                <a:gd name="connsiteX469" fmla="*/ 3679970 w 8363529"/>
                <a:gd name="connsiteY469" fmla="*/ 1151381 h 1423875"/>
                <a:gd name="connsiteX470" fmla="*/ 3671616 w 8363529"/>
                <a:gd name="connsiteY470" fmla="*/ 1093091 h 1423875"/>
                <a:gd name="connsiteX471" fmla="*/ 3604693 w 8363529"/>
                <a:gd name="connsiteY471" fmla="*/ 743541 h 1423875"/>
                <a:gd name="connsiteX472" fmla="*/ 3596330 w 8363529"/>
                <a:gd name="connsiteY472" fmla="*/ 710539 h 1423875"/>
                <a:gd name="connsiteX473" fmla="*/ 3587977 w 8363529"/>
                <a:gd name="connsiteY473" fmla="*/ 731066 h 1423875"/>
                <a:gd name="connsiteX474" fmla="*/ 3521054 w 8363529"/>
                <a:gd name="connsiteY474" fmla="*/ 920203 h 1423875"/>
                <a:gd name="connsiteX475" fmla="*/ 3512701 w 8363529"/>
                <a:gd name="connsiteY475" fmla="*/ 947505 h 1423875"/>
                <a:gd name="connsiteX476" fmla="*/ 3504347 w 8363529"/>
                <a:gd name="connsiteY476" fmla="*/ 992904 h 1423875"/>
                <a:gd name="connsiteX477" fmla="*/ 3437424 w 8363529"/>
                <a:gd name="connsiteY477" fmla="*/ 1309442 h 1423875"/>
                <a:gd name="connsiteX478" fmla="*/ 3429061 w 8363529"/>
                <a:gd name="connsiteY478" fmla="*/ 1343993 h 1423875"/>
                <a:gd name="connsiteX479" fmla="*/ 3420708 w 8363529"/>
                <a:gd name="connsiteY479" fmla="*/ 1346906 h 1423875"/>
                <a:gd name="connsiteX480" fmla="*/ 3353785 w 8363529"/>
                <a:gd name="connsiteY480" fmla="*/ 1404335 h 1423875"/>
                <a:gd name="connsiteX481" fmla="*/ 3345432 w 8363529"/>
                <a:gd name="connsiteY481" fmla="*/ 1423875 h 1423875"/>
                <a:gd name="connsiteX482" fmla="*/ 3337069 w 8363529"/>
                <a:gd name="connsiteY482" fmla="*/ 1384902 h 1423875"/>
                <a:gd name="connsiteX483" fmla="*/ 3270146 w 8363529"/>
                <a:gd name="connsiteY483" fmla="*/ 1248384 h 1423875"/>
                <a:gd name="connsiteX484" fmla="*/ 3261792 w 8363529"/>
                <a:gd name="connsiteY484" fmla="*/ 1240332 h 1423875"/>
                <a:gd name="connsiteX485" fmla="*/ 3253439 w 8363529"/>
                <a:gd name="connsiteY485" fmla="*/ 1174551 h 1423875"/>
                <a:gd name="connsiteX486" fmla="*/ 3186516 w 8363529"/>
                <a:gd name="connsiteY486" fmla="*/ 756209 h 1423875"/>
                <a:gd name="connsiteX487" fmla="*/ 3178153 w 8363529"/>
                <a:gd name="connsiteY487" fmla="*/ 714400 h 1423875"/>
                <a:gd name="connsiteX488" fmla="*/ 3169800 w 8363529"/>
                <a:gd name="connsiteY488" fmla="*/ 734511 h 1423875"/>
                <a:gd name="connsiteX489" fmla="*/ 3102877 w 8363529"/>
                <a:gd name="connsiteY489" fmla="*/ 957560 h 1423875"/>
                <a:gd name="connsiteX490" fmla="*/ 3094523 w 8363529"/>
                <a:gd name="connsiteY490" fmla="*/ 996688 h 1423875"/>
                <a:gd name="connsiteX491" fmla="*/ 3086161 w 8363529"/>
                <a:gd name="connsiteY491" fmla="*/ 1015773 h 1423875"/>
                <a:gd name="connsiteX492" fmla="*/ 3019238 w 8363529"/>
                <a:gd name="connsiteY492" fmla="*/ 1135916 h 1423875"/>
                <a:gd name="connsiteX493" fmla="*/ 3010884 w 8363529"/>
                <a:gd name="connsiteY493" fmla="*/ 1147791 h 1423875"/>
                <a:gd name="connsiteX494" fmla="*/ 3002531 w 8363529"/>
                <a:gd name="connsiteY494" fmla="*/ 1080839 h 1423875"/>
                <a:gd name="connsiteX495" fmla="*/ 2935608 w 8363529"/>
                <a:gd name="connsiteY495" fmla="*/ 522496 h 1423875"/>
                <a:gd name="connsiteX496" fmla="*/ 2927245 w 8363529"/>
                <a:gd name="connsiteY496" fmla="*/ 449765 h 1423875"/>
                <a:gd name="connsiteX497" fmla="*/ 2918892 w 8363529"/>
                <a:gd name="connsiteY497" fmla="*/ 514182 h 1423875"/>
                <a:gd name="connsiteX498" fmla="*/ 2851968 w 8363529"/>
                <a:gd name="connsiteY498" fmla="*/ 1015512 h 1423875"/>
                <a:gd name="connsiteX499" fmla="*/ 2843615 w 8363529"/>
                <a:gd name="connsiteY499" fmla="*/ 1076493 h 1423875"/>
                <a:gd name="connsiteX500" fmla="*/ 2835262 w 8363529"/>
                <a:gd name="connsiteY500" fmla="*/ 1087797 h 1423875"/>
                <a:gd name="connsiteX501" fmla="*/ 2768329 w 8363529"/>
                <a:gd name="connsiteY501" fmla="*/ 1207030 h 1423875"/>
                <a:gd name="connsiteX502" fmla="*/ 2759976 w 8363529"/>
                <a:gd name="connsiteY502" fmla="*/ 1226879 h 1423875"/>
                <a:gd name="connsiteX503" fmla="*/ 2751623 w 8363529"/>
                <a:gd name="connsiteY503" fmla="*/ 1237651 h 1423875"/>
                <a:gd name="connsiteX504" fmla="*/ 2684699 w 8363529"/>
                <a:gd name="connsiteY504" fmla="*/ 1310275 h 1423875"/>
                <a:gd name="connsiteX505" fmla="*/ 2676346 w 8363529"/>
                <a:gd name="connsiteY505" fmla="*/ 1317949 h 1423875"/>
                <a:gd name="connsiteX506" fmla="*/ 2667983 w 8363529"/>
                <a:gd name="connsiteY506" fmla="*/ 1307855 h 1423875"/>
                <a:gd name="connsiteX507" fmla="*/ 2601060 w 8363529"/>
                <a:gd name="connsiteY507" fmla="*/ 1227934 h 1423875"/>
                <a:gd name="connsiteX508" fmla="*/ 2592707 w 8363529"/>
                <a:gd name="connsiteY508" fmla="*/ 1218072 h 1423875"/>
                <a:gd name="connsiteX509" fmla="*/ 2584354 w 8363529"/>
                <a:gd name="connsiteY509" fmla="*/ 1223705 h 1423875"/>
                <a:gd name="connsiteX510" fmla="*/ 2517430 w 8363529"/>
                <a:gd name="connsiteY510" fmla="*/ 1262107 h 1423875"/>
                <a:gd name="connsiteX511" fmla="*/ 2509068 w 8363529"/>
                <a:gd name="connsiteY511" fmla="*/ 1266230 h 1423875"/>
                <a:gd name="connsiteX512" fmla="*/ 2500714 w 8363529"/>
                <a:gd name="connsiteY512" fmla="*/ 1237728 h 1423875"/>
                <a:gd name="connsiteX513" fmla="*/ 2433791 w 8363529"/>
                <a:gd name="connsiteY513" fmla="*/ 996650 h 1423875"/>
                <a:gd name="connsiteX514" fmla="*/ 2425438 w 8363529"/>
                <a:gd name="connsiteY514" fmla="*/ 964741 h 1423875"/>
                <a:gd name="connsiteX515" fmla="*/ 2417075 w 8363529"/>
                <a:gd name="connsiteY515" fmla="*/ 986323 h 1423875"/>
                <a:gd name="connsiteX516" fmla="*/ 2350152 w 8363529"/>
                <a:gd name="connsiteY516" fmla="*/ 1168163 h 1423875"/>
                <a:gd name="connsiteX517" fmla="*/ 2341799 w 8363529"/>
                <a:gd name="connsiteY517" fmla="*/ 1192097 h 1423875"/>
                <a:gd name="connsiteX518" fmla="*/ 2333445 w 8363529"/>
                <a:gd name="connsiteY518" fmla="*/ 1194177 h 1423875"/>
                <a:gd name="connsiteX519" fmla="*/ 2266522 w 8363529"/>
                <a:gd name="connsiteY519" fmla="*/ 1214404 h 1423875"/>
                <a:gd name="connsiteX520" fmla="*/ 2258159 w 8363529"/>
                <a:gd name="connsiteY520" fmla="*/ 1217502 h 1423875"/>
                <a:gd name="connsiteX521" fmla="*/ 2249806 w 8363529"/>
                <a:gd name="connsiteY521" fmla="*/ 1209788 h 1423875"/>
                <a:gd name="connsiteX522" fmla="*/ 2182883 w 8363529"/>
                <a:gd name="connsiteY522" fmla="*/ 1158146 h 1423875"/>
                <a:gd name="connsiteX523" fmla="*/ 2174530 w 8363529"/>
                <a:gd name="connsiteY523" fmla="*/ 1152707 h 1423875"/>
                <a:gd name="connsiteX524" fmla="*/ 2166176 w 8363529"/>
                <a:gd name="connsiteY524" fmla="*/ 1100194 h 1423875"/>
                <a:gd name="connsiteX525" fmla="*/ 2099253 w 8363529"/>
                <a:gd name="connsiteY525" fmla="*/ 612782 h 1423875"/>
                <a:gd name="connsiteX526" fmla="*/ 2090890 w 8363529"/>
                <a:gd name="connsiteY526" fmla="*/ 541968 h 1423875"/>
                <a:gd name="connsiteX527" fmla="*/ 2082537 w 8363529"/>
                <a:gd name="connsiteY527" fmla="*/ 619508 h 1423875"/>
                <a:gd name="connsiteX528" fmla="*/ 2015614 w 8363529"/>
                <a:gd name="connsiteY528" fmla="*/ 1093313 h 1423875"/>
                <a:gd name="connsiteX529" fmla="*/ 2007260 w 8363529"/>
                <a:gd name="connsiteY529" fmla="*/ 1138906 h 1423875"/>
                <a:gd name="connsiteX530" fmla="*/ 1998898 w 8363529"/>
                <a:gd name="connsiteY530" fmla="*/ 1146349 h 1423875"/>
                <a:gd name="connsiteX531" fmla="*/ 1931975 w 8363529"/>
                <a:gd name="connsiteY531" fmla="*/ 1222495 h 1423875"/>
                <a:gd name="connsiteX532" fmla="*/ 1923621 w 8363529"/>
                <a:gd name="connsiteY532" fmla="*/ 1234738 h 1423875"/>
                <a:gd name="connsiteX533" fmla="*/ 1915268 w 8363529"/>
                <a:gd name="connsiteY533" fmla="*/ 1237119 h 1423875"/>
                <a:gd name="connsiteX534" fmla="*/ 1848345 w 8363529"/>
                <a:gd name="connsiteY534" fmla="*/ 1256213 h 1423875"/>
                <a:gd name="connsiteX535" fmla="*/ 1839982 w 8363529"/>
                <a:gd name="connsiteY535" fmla="*/ 1258594 h 1423875"/>
                <a:gd name="connsiteX536" fmla="*/ 1831629 w 8363529"/>
                <a:gd name="connsiteY536" fmla="*/ 1257839 h 1423875"/>
                <a:gd name="connsiteX537" fmla="*/ 1764706 w 8363529"/>
                <a:gd name="connsiteY537" fmla="*/ 1252207 h 1423875"/>
                <a:gd name="connsiteX538" fmla="*/ 1756352 w 8363529"/>
                <a:gd name="connsiteY538" fmla="*/ 1251558 h 1423875"/>
                <a:gd name="connsiteX539" fmla="*/ 1747989 w 8363529"/>
                <a:gd name="connsiteY539" fmla="*/ 1236219 h 1423875"/>
                <a:gd name="connsiteX540" fmla="*/ 1681066 w 8363529"/>
                <a:gd name="connsiteY540" fmla="*/ 1134977 h 1423875"/>
                <a:gd name="connsiteX541" fmla="*/ 1672713 w 8363529"/>
                <a:gd name="connsiteY541" fmla="*/ 1124506 h 1423875"/>
                <a:gd name="connsiteX542" fmla="*/ 1664360 w 8363529"/>
                <a:gd name="connsiteY542" fmla="*/ 1132142 h 1423875"/>
                <a:gd name="connsiteX543" fmla="*/ 1597437 w 8363529"/>
                <a:gd name="connsiteY543" fmla="*/ 1222911 h 1423875"/>
                <a:gd name="connsiteX544" fmla="*/ 1589074 w 8363529"/>
                <a:gd name="connsiteY544" fmla="*/ 1240032 h 1423875"/>
                <a:gd name="connsiteX545" fmla="*/ 1580720 w 8363529"/>
                <a:gd name="connsiteY545" fmla="*/ 1239054 h 1423875"/>
                <a:gd name="connsiteX546" fmla="*/ 1513797 w 8363529"/>
                <a:gd name="connsiteY546" fmla="*/ 1232773 h 1423875"/>
                <a:gd name="connsiteX547" fmla="*/ 1505444 w 8363529"/>
                <a:gd name="connsiteY547" fmla="*/ 1232173 h 1423875"/>
                <a:gd name="connsiteX548" fmla="*/ 1497091 w 8363529"/>
                <a:gd name="connsiteY548" fmla="*/ 1238900 h 1423875"/>
                <a:gd name="connsiteX549" fmla="*/ 1430158 w 8363529"/>
                <a:gd name="connsiteY549" fmla="*/ 1284231 h 1423875"/>
                <a:gd name="connsiteX550" fmla="*/ 1421805 w 8363529"/>
                <a:gd name="connsiteY550" fmla="*/ 1288993 h 1423875"/>
                <a:gd name="connsiteX551" fmla="*/ 1413451 w 8363529"/>
                <a:gd name="connsiteY551" fmla="*/ 1282189 h 1423875"/>
                <a:gd name="connsiteX552" fmla="*/ 1346528 w 8363529"/>
                <a:gd name="connsiteY552" fmla="*/ 1200788 h 1423875"/>
                <a:gd name="connsiteX553" fmla="*/ 1338175 w 8363529"/>
                <a:gd name="connsiteY553" fmla="*/ 1185293 h 1423875"/>
                <a:gd name="connsiteX554" fmla="*/ 1329812 w 8363529"/>
                <a:gd name="connsiteY554" fmla="*/ 1157469 h 1423875"/>
                <a:gd name="connsiteX555" fmla="*/ 1262889 w 8363529"/>
                <a:gd name="connsiteY555" fmla="*/ 1020158 h 1423875"/>
                <a:gd name="connsiteX556" fmla="*/ 1254536 w 8363529"/>
                <a:gd name="connsiteY556" fmla="*/ 1009308 h 1423875"/>
                <a:gd name="connsiteX557" fmla="*/ 1246182 w 8363529"/>
                <a:gd name="connsiteY557" fmla="*/ 1000956 h 1423875"/>
                <a:gd name="connsiteX558" fmla="*/ 1179259 w 8363529"/>
                <a:gd name="connsiteY558" fmla="*/ 922129 h 1423875"/>
                <a:gd name="connsiteX559" fmla="*/ 1170896 w 8363529"/>
                <a:gd name="connsiteY559" fmla="*/ 910448 h 1423875"/>
                <a:gd name="connsiteX560" fmla="*/ 1162543 w 8363529"/>
                <a:gd name="connsiteY560" fmla="*/ 933404 h 1423875"/>
                <a:gd name="connsiteX561" fmla="*/ 1095620 w 8363529"/>
                <a:gd name="connsiteY561" fmla="*/ 1106805 h 1423875"/>
                <a:gd name="connsiteX562" fmla="*/ 1087267 w 8363529"/>
                <a:gd name="connsiteY562" fmla="*/ 1127303 h 1423875"/>
                <a:gd name="connsiteX563" fmla="*/ 1078904 w 8363529"/>
                <a:gd name="connsiteY563" fmla="*/ 1129906 h 1423875"/>
                <a:gd name="connsiteX564" fmla="*/ 1011981 w 8363529"/>
                <a:gd name="connsiteY564" fmla="*/ 1147143 h 1423875"/>
                <a:gd name="connsiteX565" fmla="*/ 1003627 w 8363529"/>
                <a:gd name="connsiteY565" fmla="*/ 1148923 h 1423875"/>
                <a:gd name="connsiteX566" fmla="*/ 995274 w 8363529"/>
                <a:gd name="connsiteY566" fmla="*/ 1131909 h 1423875"/>
                <a:gd name="connsiteX567" fmla="*/ 928351 w 8363529"/>
                <a:gd name="connsiteY567" fmla="*/ 955663 h 1423875"/>
                <a:gd name="connsiteX568" fmla="*/ 919988 w 8363529"/>
                <a:gd name="connsiteY568" fmla="*/ 926939 h 1423875"/>
                <a:gd name="connsiteX569" fmla="*/ 911635 w 8363529"/>
                <a:gd name="connsiteY569" fmla="*/ 946556 h 1423875"/>
                <a:gd name="connsiteX570" fmla="*/ 844712 w 8363529"/>
                <a:gd name="connsiteY570" fmla="*/ 1073764 h 1423875"/>
                <a:gd name="connsiteX571" fmla="*/ 836358 w 8363529"/>
                <a:gd name="connsiteY571" fmla="*/ 1086732 h 1423875"/>
                <a:gd name="connsiteX572" fmla="*/ 828005 w 8363529"/>
                <a:gd name="connsiteY572" fmla="*/ 1095888 h 1423875"/>
                <a:gd name="connsiteX573" fmla="*/ 761082 w 8363529"/>
                <a:gd name="connsiteY573" fmla="*/ 1189068 h 1423875"/>
                <a:gd name="connsiteX574" fmla="*/ 752719 w 8363529"/>
                <a:gd name="connsiteY574" fmla="*/ 1204001 h 1423875"/>
                <a:gd name="connsiteX575" fmla="*/ 744366 w 8363529"/>
                <a:gd name="connsiteY575" fmla="*/ 1193307 h 1423875"/>
                <a:gd name="connsiteX576" fmla="*/ 677443 w 8363529"/>
                <a:gd name="connsiteY576" fmla="*/ 1090817 h 1423875"/>
                <a:gd name="connsiteX577" fmla="*/ 669089 w 8363529"/>
                <a:gd name="connsiteY577" fmla="*/ 1075467 h 1423875"/>
                <a:gd name="connsiteX578" fmla="*/ 660727 w 8363529"/>
                <a:gd name="connsiteY578" fmla="*/ 1059857 h 1423875"/>
                <a:gd name="connsiteX579" fmla="*/ 593803 w 8363529"/>
                <a:gd name="connsiteY579" fmla="*/ 974642 h 1423875"/>
                <a:gd name="connsiteX580" fmla="*/ 585450 w 8363529"/>
                <a:gd name="connsiteY580" fmla="*/ 967277 h 1423875"/>
                <a:gd name="connsiteX581" fmla="*/ 577097 w 8363529"/>
                <a:gd name="connsiteY581" fmla="*/ 963231 h 1423875"/>
                <a:gd name="connsiteX582" fmla="*/ 510174 w 8363529"/>
                <a:gd name="connsiteY582" fmla="*/ 911396 h 1423875"/>
                <a:gd name="connsiteX583" fmla="*/ 501811 w 8363529"/>
                <a:gd name="connsiteY583" fmla="*/ 900731 h 1423875"/>
                <a:gd name="connsiteX584" fmla="*/ 493458 w 8363529"/>
                <a:gd name="connsiteY584" fmla="*/ 935930 h 1423875"/>
                <a:gd name="connsiteX585" fmla="*/ 426534 w 8363529"/>
                <a:gd name="connsiteY585" fmla="*/ 1093497 h 1423875"/>
                <a:gd name="connsiteX586" fmla="*/ 418181 w 8363529"/>
                <a:gd name="connsiteY586" fmla="*/ 1104917 h 1423875"/>
                <a:gd name="connsiteX587" fmla="*/ 409818 w 8363529"/>
                <a:gd name="connsiteY587" fmla="*/ 1095356 h 1423875"/>
                <a:gd name="connsiteX588" fmla="*/ 342895 w 8363529"/>
                <a:gd name="connsiteY588" fmla="*/ 991056 h 1423875"/>
                <a:gd name="connsiteX589" fmla="*/ 334542 w 8363529"/>
                <a:gd name="connsiteY589" fmla="*/ 973132 h 1423875"/>
                <a:gd name="connsiteX590" fmla="*/ 326189 w 8363529"/>
                <a:gd name="connsiteY590" fmla="*/ 1005534 h 1423875"/>
                <a:gd name="connsiteX591" fmla="*/ 259304 w 8363529"/>
                <a:gd name="connsiteY591" fmla="*/ 1304720 h 1423875"/>
                <a:gd name="connsiteX592" fmla="*/ 250903 w 8363529"/>
                <a:gd name="connsiteY592" fmla="*/ 1348000 h 1423875"/>
                <a:gd name="connsiteX593" fmla="*/ 242549 w 8363529"/>
                <a:gd name="connsiteY593" fmla="*/ 1299155 h 1423875"/>
                <a:gd name="connsiteX594" fmla="*/ 175665 w 8363529"/>
                <a:gd name="connsiteY594" fmla="*/ 1026206 h 1423875"/>
                <a:gd name="connsiteX595" fmla="*/ 167273 w 8363529"/>
                <a:gd name="connsiteY595" fmla="*/ 1002011 h 1423875"/>
                <a:gd name="connsiteX596" fmla="*/ 158920 w 8363529"/>
                <a:gd name="connsiteY596" fmla="*/ 1002737 h 1423875"/>
                <a:gd name="connsiteX597" fmla="*/ 92029 w 8363529"/>
                <a:gd name="connsiteY597" fmla="*/ 1009386 h 1423875"/>
                <a:gd name="connsiteX598" fmla="*/ 83635 w 8363529"/>
                <a:gd name="connsiteY598" fmla="*/ 1010373 h 1423875"/>
                <a:gd name="connsiteX599" fmla="*/ 75279 w 8363529"/>
                <a:gd name="connsiteY599" fmla="*/ 981262 h 1423875"/>
                <a:gd name="connsiteX600" fmla="*/ 8394 w 8363529"/>
                <a:gd name="connsiteY600" fmla="*/ 751448 h 1423875"/>
                <a:gd name="connsiteX601" fmla="*/ 0 w 8363529"/>
                <a:gd name="connsiteY601" fmla="*/ 723091 h 14238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  <a:cxn ang="0">
                  <a:pos x="connsiteX466" y="connsiteY466"/>
                </a:cxn>
                <a:cxn ang="0">
                  <a:pos x="connsiteX467" y="connsiteY467"/>
                </a:cxn>
                <a:cxn ang="0">
                  <a:pos x="connsiteX468" y="connsiteY468"/>
                </a:cxn>
                <a:cxn ang="0">
                  <a:pos x="connsiteX469" y="connsiteY469"/>
                </a:cxn>
                <a:cxn ang="0">
                  <a:pos x="connsiteX470" y="connsiteY470"/>
                </a:cxn>
                <a:cxn ang="0">
                  <a:pos x="connsiteX471" y="connsiteY471"/>
                </a:cxn>
                <a:cxn ang="0">
                  <a:pos x="connsiteX472" y="connsiteY472"/>
                </a:cxn>
                <a:cxn ang="0">
                  <a:pos x="connsiteX473" y="connsiteY473"/>
                </a:cxn>
                <a:cxn ang="0">
                  <a:pos x="connsiteX474" y="connsiteY474"/>
                </a:cxn>
                <a:cxn ang="0">
                  <a:pos x="connsiteX475" y="connsiteY475"/>
                </a:cxn>
                <a:cxn ang="0">
                  <a:pos x="connsiteX476" y="connsiteY476"/>
                </a:cxn>
                <a:cxn ang="0">
                  <a:pos x="connsiteX477" y="connsiteY477"/>
                </a:cxn>
                <a:cxn ang="0">
                  <a:pos x="connsiteX478" y="connsiteY478"/>
                </a:cxn>
                <a:cxn ang="0">
                  <a:pos x="connsiteX479" y="connsiteY479"/>
                </a:cxn>
                <a:cxn ang="0">
                  <a:pos x="connsiteX480" y="connsiteY480"/>
                </a:cxn>
                <a:cxn ang="0">
                  <a:pos x="connsiteX481" y="connsiteY481"/>
                </a:cxn>
                <a:cxn ang="0">
                  <a:pos x="connsiteX482" y="connsiteY482"/>
                </a:cxn>
                <a:cxn ang="0">
                  <a:pos x="connsiteX483" y="connsiteY483"/>
                </a:cxn>
                <a:cxn ang="0">
                  <a:pos x="connsiteX484" y="connsiteY484"/>
                </a:cxn>
                <a:cxn ang="0">
                  <a:pos x="connsiteX485" y="connsiteY485"/>
                </a:cxn>
                <a:cxn ang="0">
                  <a:pos x="connsiteX486" y="connsiteY486"/>
                </a:cxn>
                <a:cxn ang="0">
                  <a:pos x="connsiteX487" y="connsiteY487"/>
                </a:cxn>
                <a:cxn ang="0">
                  <a:pos x="connsiteX488" y="connsiteY488"/>
                </a:cxn>
                <a:cxn ang="0">
                  <a:pos x="connsiteX489" y="connsiteY489"/>
                </a:cxn>
                <a:cxn ang="0">
                  <a:pos x="connsiteX490" y="connsiteY490"/>
                </a:cxn>
                <a:cxn ang="0">
                  <a:pos x="connsiteX491" y="connsiteY491"/>
                </a:cxn>
                <a:cxn ang="0">
                  <a:pos x="connsiteX492" y="connsiteY492"/>
                </a:cxn>
                <a:cxn ang="0">
                  <a:pos x="connsiteX493" y="connsiteY493"/>
                </a:cxn>
                <a:cxn ang="0">
                  <a:pos x="connsiteX494" y="connsiteY494"/>
                </a:cxn>
                <a:cxn ang="0">
                  <a:pos x="connsiteX495" y="connsiteY495"/>
                </a:cxn>
                <a:cxn ang="0">
                  <a:pos x="connsiteX496" y="connsiteY496"/>
                </a:cxn>
                <a:cxn ang="0">
                  <a:pos x="connsiteX497" y="connsiteY497"/>
                </a:cxn>
                <a:cxn ang="0">
                  <a:pos x="connsiteX498" y="connsiteY498"/>
                </a:cxn>
                <a:cxn ang="0">
                  <a:pos x="connsiteX499" y="connsiteY499"/>
                </a:cxn>
                <a:cxn ang="0">
                  <a:pos x="connsiteX500" y="connsiteY500"/>
                </a:cxn>
                <a:cxn ang="0">
                  <a:pos x="connsiteX501" y="connsiteY501"/>
                </a:cxn>
                <a:cxn ang="0">
                  <a:pos x="connsiteX502" y="connsiteY502"/>
                </a:cxn>
                <a:cxn ang="0">
                  <a:pos x="connsiteX503" y="connsiteY503"/>
                </a:cxn>
                <a:cxn ang="0">
                  <a:pos x="connsiteX504" y="connsiteY504"/>
                </a:cxn>
                <a:cxn ang="0">
                  <a:pos x="connsiteX505" y="connsiteY505"/>
                </a:cxn>
                <a:cxn ang="0">
                  <a:pos x="connsiteX506" y="connsiteY506"/>
                </a:cxn>
                <a:cxn ang="0">
                  <a:pos x="connsiteX507" y="connsiteY507"/>
                </a:cxn>
                <a:cxn ang="0">
                  <a:pos x="connsiteX508" y="connsiteY508"/>
                </a:cxn>
                <a:cxn ang="0">
                  <a:pos x="connsiteX509" y="connsiteY509"/>
                </a:cxn>
                <a:cxn ang="0">
                  <a:pos x="connsiteX510" y="connsiteY510"/>
                </a:cxn>
                <a:cxn ang="0">
                  <a:pos x="connsiteX511" y="connsiteY511"/>
                </a:cxn>
                <a:cxn ang="0">
                  <a:pos x="connsiteX512" y="connsiteY512"/>
                </a:cxn>
                <a:cxn ang="0">
                  <a:pos x="connsiteX513" y="connsiteY513"/>
                </a:cxn>
                <a:cxn ang="0">
                  <a:pos x="connsiteX514" y="connsiteY514"/>
                </a:cxn>
                <a:cxn ang="0">
                  <a:pos x="connsiteX515" y="connsiteY515"/>
                </a:cxn>
                <a:cxn ang="0">
                  <a:pos x="connsiteX516" y="connsiteY516"/>
                </a:cxn>
                <a:cxn ang="0">
                  <a:pos x="connsiteX517" y="connsiteY517"/>
                </a:cxn>
                <a:cxn ang="0">
                  <a:pos x="connsiteX518" y="connsiteY518"/>
                </a:cxn>
                <a:cxn ang="0">
                  <a:pos x="connsiteX519" y="connsiteY519"/>
                </a:cxn>
                <a:cxn ang="0">
                  <a:pos x="connsiteX520" y="connsiteY520"/>
                </a:cxn>
                <a:cxn ang="0">
                  <a:pos x="connsiteX521" y="connsiteY521"/>
                </a:cxn>
                <a:cxn ang="0">
                  <a:pos x="connsiteX522" y="connsiteY522"/>
                </a:cxn>
                <a:cxn ang="0">
                  <a:pos x="connsiteX523" y="connsiteY523"/>
                </a:cxn>
                <a:cxn ang="0">
                  <a:pos x="connsiteX524" y="connsiteY524"/>
                </a:cxn>
                <a:cxn ang="0">
                  <a:pos x="connsiteX525" y="connsiteY525"/>
                </a:cxn>
                <a:cxn ang="0">
                  <a:pos x="connsiteX526" y="connsiteY526"/>
                </a:cxn>
                <a:cxn ang="0">
                  <a:pos x="connsiteX527" y="connsiteY527"/>
                </a:cxn>
                <a:cxn ang="0">
                  <a:pos x="connsiteX528" y="connsiteY528"/>
                </a:cxn>
                <a:cxn ang="0">
                  <a:pos x="connsiteX529" y="connsiteY529"/>
                </a:cxn>
                <a:cxn ang="0">
                  <a:pos x="connsiteX530" y="connsiteY530"/>
                </a:cxn>
                <a:cxn ang="0">
                  <a:pos x="connsiteX531" y="connsiteY531"/>
                </a:cxn>
                <a:cxn ang="0">
                  <a:pos x="connsiteX532" y="connsiteY532"/>
                </a:cxn>
                <a:cxn ang="0">
                  <a:pos x="connsiteX533" y="connsiteY533"/>
                </a:cxn>
                <a:cxn ang="0">
                  <a:pos x="connsiteX534" y="connsiteY534"/>
                </a:cxn>
                <a:cxn ang="0">
                  <a:pos x="connsiteX535" y="connsiteY535"/>
                </a:cxn>
                <a:cxn ang="0">
                  <a:pos x="connsiteX536" y="connsiteY536"/>
                </a:cxn>
                <a:cxn ang="0">
                  <a:pos x="connsiteX537" y="connsiteY537"/>
                </a:cxn>
                <a:cxn ang="0">
                  <a:pos x="connsiteX538" y="connsiteY538"/>
                </a:cxn>
                <a:cxn ang="0">
                  <a:pos x="connsiteX539" y="connsiteY539"/>
                </a:cxn>
                <a:cxn ang="0">
                  <a:pos x="connsiteX540" y="connsiteY540"/>
                </a:cxn>
                <a:cxn ang="0">
                  <a:pos x="connsiteX541" y="connsiteY541"/>
                </a:cxn>
                <a:cxn ang="0">
                  <a:pos x="connsiteX542" y="connsiteY542"/>
                </a:cxn>
                <a:cxn ang="0">
                  <a:pos x="connsiteX543" y="connsiteY543"/>
                </a:cxn>
                <a:cxn ang="0">
                  <a:pos x="connsiteX544" y="connsiteY544"/>
                </a:cxn>
                <a:cxn ang="0">
                  <a:pos x="connsiteX545" y="connsiteY545"/>
                </a:cxn>
                <a:cxn ang="0">
                  <a:pos x="connsiteX546" y="connsiteY546"/>
                </a:cxn>
                <a:cxn ang="0">
                  <a:pos x="connsiteX547" y="connsiteY547"/>
                </a:cxn>
                <a:cxn ang="0">
                  <a:pos x="connsiteX548" y="connsiteY548"/>
                </a:cxn>
                <a:cxn ang="0">
                  <a:pos x="connsiteX549" y="connsiteY549"/>
                </a:cxn>
                <a:cxn ang="0">
                  <a:pos x="connsiteX550" y="connsiteY550"/>
                </a:cxn>
                <a:cxn ang="0">
                  <a:pos x="connsiteX551" y="connsiteY551"/>
                </a:cxn>
                <a:cxn ang="0">
                  <a:pos x="connsiteX552" y="connsiteY552"/>
                </a:cxn>
                <a:cxn ang="0">
                  <a:pos x="connsiteX553" y="connsiteY553"/>
                </a:cxn>
                <a:cxn ang="0">
                  <a:pos x="connsiteX554" y="connsiteY554"/>
                </a:cxn>
                <a:cxn ang="0">
                  <a:pos x="connsiteX555" y="connsiteY555"/>
                </a:cxn>
                <a:cxn ang="0">
                  <a:pos x="connsiteX556" y="connsiteY556"/>
                </a:cxn>
                <a:cxn ang="0">
                  <a:pos x="connsiteX557" y="connsiteY557"/>
                </a:cxn>
                <a:cxn ang="0">
                  <a:pos x="connsiteX558" y="connsiteY558"/>
                </a:cxn>
                <a:cxn ang="0">
                  <a:pos x="connsiteX559" y="connsiteY559"/>
                </a:cxn>
                <a:cxn ang="0">
                  <a:pos x="connsiteX560" y="connsiteY560"/>
                </a:cxn>
                <a:cxn ang="0">
                  <a:pos x="connsiteX561" y="connsiteY561"/>
                </a:cxn>
                <a:cxn ang="0">
                  <a:pos x="connsiteX562" y="connsiteY562"/>
                </a:cxn>
                <a:cxn ang="0">
                  <a:pos x="connsiteX563" y="connsiteY563"/>
                </a:cxn>
                <a:cxn ang="0">
                  <a:pos x="connsiteX564" y="connsiteY564"/>
                </a:cxn>
                <a:cxn ang="0">
                  <a:pos x="connsiteX565" y="connsiteY565"/>
                </a:cxn>
                <a:cxn ang="0">
                  <a:pos x="connsiteX566" y="connsiteY566"/>
                </a:cxn>
                <a:cxn ang="0">
                  <a:pos x="connsiteX567" y="connsiteY567"/>
                </a:cxn>
                <a:cxn ang="0">
                  <a:pos x="connsiteX568" y="connsiteY568"/>
                </a:cxn>
                <a:cxn ang="0">
                  <a:pos x="connsiteX569" y="connsiteY569"/>
                </a:cxn>
                <a:cxn ang="0">
                  <a:pos x="connsiteX570" y="connsiteY570"/>
                </a:cxn>
                <a:cxn ang="0">
                  <a:pos x="connsiteX571" y="connsiteY571"/>
                </a:cxn>
                <a:cxn ang="0">
                  <a:pos x="connsiteX572" y="connsiteY572"/>
                </a:cxn>
                <a:cxn ang="0">
                  <a:pos x="connsiteX573" y="connsiteY573"/>
                </a:cxn>
                <a:cxn ang="0">
                  <a:pos x="connsiteX574" y="connsiteY574"/>
                </a:cxn>
                <a:cxn ang="0">
                  <a:pos x="connsiteX575" y="connsiteY575"/>
                </a:cxn>
                <a:cxn ang="0">
                  <a:pos x="connsiteX576" y="connsiteY576"/>
                </a:cxn>
                <a:cxn ang="0">
                  <a:pos x="connsiteX577" y="connsiteY577"/>
                </a:cxn>
                <a:cxn ang="0">
                  <a:pos x="connsiteX578" y="connsiteY578"/>
                </a:cxn>
                <a:cxn ang="0">
                  <a:pos x="connsiteX579" y="connsiteY579"/>
                </a:cxn>
                <a:cxn ang="0">
                  <a:pos x="connsiteX580" y="connsiteY580"/>
                </a:cxn>
                <a:cxn ang="0">
                  <a:pos x="connsiteX581" y="connsiteY581"/>
                </a:cxn>
                <a:cxn ang="0">
                  <a:pos x="connsiteX582" y="connsiteY582"/>
                </a:cxn>
                <a:cxn ang="0">
                  <a:pos x="connsiteX583" y="connsiteY583"/>
                </a:cxn>
                <a:cxn ang="0">
                  <a:pos x="connsiteX584" y="connsiteY584"/>
                </a:cxn>
                <a:cxn ang="0">
                  <a:pos x="connsiteX585" y="connsiteY585"/>
                </a:cxn>
                <a:cxn ang="0">
                  <a:pos x="connsiteX586" y="connsiteY586"/>
                </a:cxn>
                <a:cxn ang="0">
                  <a:pos x="connsiteX587" y="connsiteY587"/>
                </a:cxn>
                <a:cxn ang="0">
                  <a:pos x="connsiteX588" y="connsiteY588"/>
                </a:cxn>
                <a:cxn ang="0">
                  <a:pos x="connsiteX589" y="connsiteY589"/>
                </a:cxn>
                <a:cxn ang="0">
                  <a:pos x="connsiteX590" y="connsiteY590"/>
                </a:cxn>
                <a:cxn ang="0">
                  <a:pos x="connsiteX591" y="connsiteY591"/>
                </a:cxn>
                <a:cxn ang="0">
                  <a:pos x="connsiteX592" y="connsiteY592"/>
                </a:cxn>
                <a:cxn ang="0">
                  <a:pos x="connsiteX593" y="connsiteY593"/>
                </a:cxn>
                <a:cxn ang="0">
                  <a:pos x="connsiteX594" y="connsiteY594"/>
                </a:cxn>
                <a:cxn ang="0">
                  <a:pos x="connsiteX595" y="connsiteY595"/>
                </a:cxn>
                <a:cxn ang="0">
                  <a:pos x="connsiteX596" y="connsiteY596"/>
                </a:cxn>
                <a:cxn ang="0">
                  <a:pos x="connsiteX597" y="connsiteY597"/>
                </a:cxn>
                <a:cxn ang="0">
                  <a:pos x="connsiteX598" y="connsiteY598"/>
                </a:cxn>
                <a:cxn ang="0">
                  <a:pos x="connsiteX599" y="connsiteY599"/>
                </a:cxn>
                <a:cxn ang="0">
                  <a:pos x="connsiteX600" y="connsiteY600"/>
                </a:cxn>
                <a:cxn ang="0">
                  <a:pos x="connsiteX601" y="connsiteY601"/>
                </a:cxn>
              </a:cxnLst>
              <a:rect l="l" t="t" r="r" b="b"/>
              <a:pathLst>
                <a:path w="8363529" h="1423875">
                  <a:moveTo>
                    <a:pt x="0" y="624840"/>
                  </a:moveTo>
                  <a:lnTo>
                    <a:pt x="8394" y="653603"/>
                  </a:lnTo>
                  <a:lnTo>
                    <a:pt x="75279" y="886824"/>
                  </a:lnTo>
                  <a:lnTo>
                    <a:pt x="83635" y="916351"/>
                  </a:lnTo>
                  <a:lnTo>
                    <a:pt x="92029" y="922661"/>
                  </a:lnTo>
                  <a:lnTo>
                    <a:pt x="158920" y="966406"/>
                  </a:lnTo>
                  <a:lnTo>
                    <a:pt x="167273" y="971167"/>
                  </a:lnTo>
                  <a:lnTo>
                    <a:pt x="175665" y="989652"/>
                  </a:lnTo>
                  <a:lnTo>
                    <a:pt x="242549" y="1198330"/>
                  </a:lnTo>
                  <a:lnTo>
                    <a:pt x="250903" y="1235648"/>
                  </a:lnTo>
                  <a:lnTo>
                    <a:pt x="259304" y="1198600"/>
                  </a:lnTo>
                  <a:lnTo>
                    <a:pt x="326189" y="942395"/>
                  </a:lnTo>
                  <a:lnTo>
                    <a:pt x="334542" y="914648"/>
                  </a:lnTo>
                  <a:lnTo>
                    <a:pt x="342895" y="889088"/>
                  </a:lnTo>
                  <a:lnTo>
                    <a:pt x="409818" y="740444"/>
                  </a:lnTo>
                  <a:lnTo>
                    <a:pt x="418181" y="726759"/>
                  </a:lnTo>
                  <a:lnTo>
                    <a:pt x="426534" y="727176"/>
                  </a:lnTo>
                  <a:lnTo>
                    <a:pt x="493458" y="732924"/>
                  </a:lnTo>
                  <a:lnTo>
                    <a:pt x="501811" y="734202"/>
                  </a:lnTo>
                  <a:lnTo>
                    <a:pt x="510174" y="748041"/>
                  </a:lnTo>
                  <a:lnTo>
                    <a:pt x="577097" y="815332"/>
                  </a:lnTo>
                  <a:lnTo>
                    <a:pt x="585450" y="820588"/>
                  </a:lnTo>
                  <a:lnTo>
                    <a:pt x="593803" y="831853"/>
                  </a:lnTo>
                  <a:lnTo>
                    <a:pt x="660727" y="961867"/>
                  </a:lnTo>
                  <a:lnTo>
                    <a:pt x="669089" y="985762"/>
                  </a:lnTo>
                  <a:lnTo>
                    <a:pt x="677443" y="999747"/>
                  </a:lnTo>
                  <a:lnTo>
                    <a:pt x="744366" y="1093197"/>
                  </a:lnTo>
                  <a:lnTo>
                    <a:pt x="752719" y="1102953"/>
                  </a:lnTo>
                  <a:lnTo>
                    <a:pt x="761082" y="1095017"/>
                  </a:lnTo>
                  <a:lnTo>
                    <a:pt x="828005" y="1045417"/>
                  </a:lnTo>
                  <a:lnTo>
                    <a:pt x="836358" y="1040539"/>
                  </a:lnTo>
                  <a:lnTo>
                    <a:pt x="844712" y="1027610"/>
                  </a:lnTo>
                  <a:lnTo>
                    <a:pt x="911635" y="900663"/>
                  </a:lnTo>
                  <a:lnTo>
                    <a:pt x="919988" y="881075"/>
                  </a:lnTo>
                  <a:lnTo>
                    <a:pt x="928351" y="904292"/>
                  </a:lnTo>
                  <a:lnTo>
                    <a:pt x="995274" y="1046733"/>
                  </a:lnTo>
                  <a:lnTo>
                    <a:pt x="1003627" y="1060495"/>
                  </a:lnTo>
                  <a:lnTo>
                    <a:pt x="1011981" y="1055927"/>
                  </a:lnTo>
                  <a:lnTo>
                    <a:pt x="1078904" y="1011999"/>
                  </a:lnTo>
                  <a:lnTo>
                    <a:pt x="1087267" y="1005340"/>
                  </a:lnTo>
                  <a:lnTo>
                    <a:pt x="1095620" y="989991"/>
                  </a:lnTo>
                  <a:lnTo>
                    <a:pt x="1162543" y="860171"/>
                  </a:lnTo>
                  <a:lnTo>
                    <a:pt x="1170896" y="843011"/>
                  </a:lnTo>
                  <a:lnTo>
                    <a:pt x="1179259" y="846979"/>
                  </a:lnTo>
                  <a:lnTo>
                    <a:pt x="1246182" y="873739"/>
                  </a:lnTo>
                  <a:lnTo>
                    <a:pt x="1254536" y="876575"/>
                  </a:lnTo>
                  <a:lnTo>
                    <a:pt x="1262889" y="894082"/>
                  </a:lnTo>
                  <a:lnTo>
                    <a:pt x="1329812" y="1115389"/>
                  </a:lnTo>
                  <a:lnTo>
                    <a:pt x="1338175" y="1160227"/>
                  </a:lnTo>
                  <a:lnTo>
                    <a:pt x="1346528" y="1157585"/>
                  </a:lnTo>
                  <a:lnTo>
                    <a:pt x="1413451" y="1143629"/>
                  </a:lnTo>
                  <a:lnTo>
                    <a:pt x="1421805" y="1142458"/>
                  </a:lnTo>
                  <a:lnTo>
                    <a:pt x="1430158" y="1143591"/>
                  </a:lnTo>
                  <a:lnTo>
                    <a:pt x="1497091" y="1154478"/>
                  </a:lnTo>
                  <a:lnTo>
                    <a:pt x="1505444" y="1156143"/>
                  </a:lnTo>
                  <a:lnTo>
                    <a:pt x="1513797" y="1156937"/>
                  </a:lnTo>
                  <a:lnTo>
                    <a:pt x="1580720" y="1165105"/>
                  </a:lnTo>
                  <a:lnTo>
                    <a:pt x="1589074" y="1166431"/>
                  </a:lnTo>
                  <a:lnTo>
                    <a:pt x="1597437" y="1151565"/>
                  </a:lnTo>
                  <a:lnTo>
                    <a:pt x="1664360" y="1073009"/>
                  </a:lnTo>
                  <a:lnTo>
                    <a:pt x="1672713" y="1066399"/>
                  </a:lnTo>
                  <a:lnTo>
                    <a:pt x="1681066" y="1077432"/>
                  </a:lnTo>
                  <a:lnTo>
                    <a:pt x="1747989" y="1183929"/>
                  </a:lnTo>
                  <a:lnTo>
                    <a:pt x="1756352" y="1200071"/>
                  </a:lnTo>
                  <a:lnTo>
                    <a:pt x="1764706" y="1188806"/>
                  </a:lnTo>
                  <a:lnTo>
                    <a:pt x="1831629" y="1092820"/>
                  </a:lnTo>
                  <a:lnTo>
                    <a:pt x="1839982" y="1080045"/>
                  </a:lnTo>
                  <a:lnTo>
                    <a:pt x="1848345" y="1078951"/>
                  </a:lnTo>
                  <a:lnTo>
                    <a:pt x="1915268" y="1070212"/>
                  </a:lnTo>
                  <a:lnTo>
                    <a:pt x="1923621" y="1069118"/>
                  </a:lnTo>
                  <a:lnTo>
                    <a:pt x="1931975" y="1071954"/>
                  </a:lnTo>
                  <a:lnTo>
                    <a:pt x="1998898" y="1089423"/>
                  </a:lnTo>
                  <a:lnTo>
                    <a:pt x="2007260" y="1091117"/>
                  </a:lnTo>
                  <a:lnTo>
                    <a:pt x="2015614" y="1030029"/>
                  </a:lnTo>
                  <a:lnTo>
                    <a:pt x="2082537" y="395172"/>
                  </a:lnTo>
                  <a:lnTo>
                    <a:pt x="2090890" y="291288"/>
                  </a:lnTo>
                  <a:lnTo>
                    <a:pt x="2099253" y="372041"/>
                  </a:lnTo>
                  <a:lnTo>
                    <a:pt x="2166176" y="927655"/>
                  </a:lnTo>
                  <a:lnTo>
                    <a:pt x="2174530" y="987533"/>
                  </a:lnTo>
                  <a:lnTo>
                    <a:pt x="2182883" y="998314"/>
                  </a:lnTo>
                  <a:lnTo>
                    <a:pt x="2249806" y="1101249"/>
                  </a:lnTo>
                  <a:lnTo>
                    <a:pt x="2258159" y="1116676"/>
                  </a:lnTo>
                  <a:lnTo>
                    <a:pt x="2266522" y="1104163"/>
                  </a:lnTo>
                  <a:lnTo>
                    <a:pt x="2333445" y="1022848"/>
                  </a:lnTo>
                  <a:lnTo>
                    <a:pt x="2341799" y="1014564"/>
                  </a:lnTo>
                  <a:lnTo>
                    <a:pt x="2350152" y="992904"/>
                  </a:lnTo>
                  <a:lnTo>
                    <a:pt x="2417075" y="828601"/>
                  </a:lnTo>
                  <a:lnTo>
                    <a:pt x="2425438" y="809100"/>
                  </a:lnTo>
                  <a:lnTo>
                    <a:pt x="2433791" y="841840"/>
                  </a:lnTo>
                  <a:lnTo>
                    <a:pt x="2500714" y="1089345"/>
                  </a:lnTo>
                  <a:lnTo>
                    <a:pt x="2509068" y="1118563"/>
                  </a:lnTo>
                  <a:lnTo>
                    <a:pt x="2517430" y="1118263"/>
                  </a:lnTo>
                  <a:lnTo>
                    <a:pt x="2584354" y="1115166"/>
                  </a:lnTo>
                  <a:lnTo>
                    <a:pt x="2592707" y="1114711"/>
                  </a:lnTo>
                  <a:lnTo>
                    <a:pt x="2601060" y="1127409"/>
                  </a:lnTo>
                  <a:lnTo>
                    <a:pt x="2667983" y="1230238"/>
                  </a:lnTo>
                  <a:lnTo>
                    <a:pt x="2676346" y="1243245"/>
                  </a:lnTo>
                  <a:lnTo>
                    <a:pt x="2684699" y="1228883"/>
                  </a:lnTo>
                  <a:lnTo>
                    <a:pt x="2751623" y="1093313"/>
                  </a:lnTo>
                  <a:lnTo>
                    <a:pt x="2759976" y="1073203"/>
                  </a:lnTo>
                  <a:lnTo>
                    <a:pt x="2768329" y="1056189"/>
                  </a:lnTo>
                  <a:lnTo>
                    <a:pt x="2835262" y="953892"/>
                  </a:lnTo>
                  <a:lnTo>
                    <a:pt x="2843615" y="944175"/>
                  </a:lnTo>
                  <a:lnTo>
                    <a:pt x="2851968" y="889398"/>
                  </a:lnTo>
                  <a:lnTo>
                    <a:pt x="2918892" y="438955"/>
                  </a:lnTo>
                  <a:lnTo>
                    <a:pt x="2927245" y="381110"/>
                  </a:lnTo>
                  <a:lnTo>
                    <a:pt x="2935608" y="445265"/>
                  </a:lnTo>
                  <a:lnTo>
                    <a:pt x="3002531" y="937788"/>
                  </a:lnTo>
                  <a:lnTo>
                    <a:pt x="3010884" y="996834"/>
                  </a:lnTo>
                  <a:lnTo>
                    <a:pt x="3019238" y="970335"/>
                  </a:lnTo>
                  <a:lnTo>
                    <a:pt x="3086161" y="702071"/>
                  </a:lnTo>
                  <a:lnTo>
                    <a:pt x="3094523" y="659352"/>
                  </a:lnTo>
                  <a:lnTo>
                    <a:pt x="3102877" y="648958"/>
                  </a:lnTo>
                  <a:lnTo>
                    <a:pt x="3169800" y="589758"/>
                  </a:lnTo>
                  <a:lnTo>
                    <a:pt x="3178153" y="584425"/>
                  </a:lnTo>
                  <a:lnTo>
                    <a:pt x="3186516" y="630734"/>
                  </a:lnTo>
                  <a:lnTo>
                    <a:pt x="3253439" y="1094030"/>
                  </a:lnTo>
                  <a:lnTo>
                    <a:pt x="3261792" y="1166876"/>
                  </a:lnTo>
                  <a:lnTo>
                    <a:pt x="3270146" y="1178112"/>
                  </a:lnTo>
                  <a:lnTo>
                    <a:pt x="3337069" y="1369291"/>
                  </a:lnTo>
                  <a:lnTo>
                    <a:pt x="3345432" y="1423875"/>
                  </a:lnTo>
                  <a:lnTo>
                    <a:pt x="3353785" y="1319421"/>
                  </a:lnTo>
                  <a:lnTo>
                    <a:pt x="3420708" y="1013131"/>
                  </a:lnTo>
                  <a:lnTo>
                    <a:pt x="3429061" y="997511"/>
                  </a:lnTo>
                  <a:lnTo>
                    <a:pt x="3437424" y="983149"/>
                  </a:lnTo>
                  <a:lnTo>
                    <a:pt x="3504347" y="851548"/>
                  </a:lnTo>
                  <a:lnTo>
                    <a:pt x="3512701" y="832646"/>
                  </a:lnTo>
                  <a:lnTo>
                    <a:pt x="3521054" y="791592"/>
                  </a:lnTo>
                  <a:lnTo>
                    <a:pt x="3587977" y="507040"/>
                  </a:lnTo>
                  <a:lnTo>
                    <a:pt x="3596330" y="476148"/>
                  </a:lnTo>
                  <a:lnTo>
                    <a:pt x="3604693" y="523560"/>
                  </a:lnTo>
                  <a:lnTo>
                    <a:pt x="3671616" y="1024997"/>
                  </a:lnTo>
                  <a:lnTo>
                    <a:pt x="3679970" y="1108663"/>
                  </a:lnTo>
                  <a:lnTo>
                    <a:pt x="3688323" y="1084807"/>
                  </a:lnTo>
                  <a:lnTo>
                    <a:pt x="3755246" y="917406"/>
                  </a:lnTo>
                  <a:lnTo>
                    <a:pt x="3763609" y="899037"/>
                  </a:lnTo>
                  <a:lnTo>
                    <a:pt x="3771962" y="918848"/>
                  </a:lnTo>
                  <a:lnTo>
                    <a:pt x="3838885" y="1092442"/>
                  </a:lnTo>
                  <a:lnTo>
                    <a:pt x="3847239" y="1116183"/>
                  </a:lnTo>
                  <a:lnTo>
                    <a:pt x="3855602" y="1116715"/>
                  </a:lnTo>
                  <a:lnTo>
                    <a:pt x="3922525" y="1120499"/>
                  </a:lnTo>
                  <a:lnTo>
                    <a:pt x="3930878" y="1120906"/>
                  </a:lnTo>
                  <a:lnTo>
                    <a:pt x="3939231" y="1097243"/>
                  </a:lnTo>
                  <a:lnTo>
                    <a:pt x="4006154" y="930868"/>
                  </a:lnTo>
                  <a:lnTo>
                    <a:pt x="4014517" y="912529"/>
                  </a:lnTo>
                  <a:lnTo>
                    <a:pt x="4022871" y="932262"/>
                  </a:lnTo>
                  <a:lnTo>
                    <a:pt x="4089755" y="1170128"/>
                  </a:lnTo>
                  <a:lnTo>
                    <a:pt x="4098147" y="1215798"/>
                  </a:lnTo>
                  <a:lnTo>
                    <a:pt x="4106500" y="1133119"/>
                  </a:lnTo>
                  <a:lnTo>
                    <a:pt x="4173394" y="710239"/>
                  </a:lnTo>
                  <a:lnTo>
                    <a:pt x="4181787" y="675688"/>
                  </a:lnTo>
                  <a:lnTo>
                    <a:pt x="4190140" y="724940"/>
                  </a:lnTo>
                  <a:lnTo>
                    <a:pt x="4257024" y="1216785"/>
                  </a:lnTo>
                  <a:lnTo>
                    <a:pt x="4265416" y="1293938"/>
                  </a:lnTo>
                  <a:lnTo>
                    <a:pt x="4273779" y="1153917"/>
                  </a:lnTo>
                  <a:lnTo>
                    <a:pt x="4340664" y="119504"/>
                  </a:lnTo>
                  <a:lnTo>
                    <a:pt x="4349055" y="0"/>
                  </a:lnTo>
                  <a:lnTo>
                    <a:pt x="4357409" y="112807"/>
                  </a:lnTo>
                  <a:lnTo>
                    <a:pt x="4424303" y="1007460"/>
                  </a:lnTo>
                  <a:lnTo>
                    <a:pt x="4432695" y="1118302"/>
                  </a:lnTo>
                  <a:lnTo>
                    <a:pt x="4441048" y="1112099"/>
                  </a:lnTo>
                  <a:lnTo>
                    <a:pt x="4507932" y="1059479"/>
                  </a:lnTo>
                  <a:lnTo>
                    <a:pt x="4516324" y="1052521"/>
                  </a:lnTo>
                  <a:lnTo>
                    <a:pt x="4524687" y="1061599"/>
                  </a:lnTo>
                  <a:lnTo>
                    <a:pt x="4591572" y="1142342"/>
                  </a:lnTo>
                  <a:lnTo>
                    <a:pt x="4599964" y="1153607"/>
                  </a:lnTo>
                  <a:lnTo>
                    <a:pt x="4608317" y="1106998"/>
                  </a:lnTo>
                  <a:lnTo>
                    <a:pt x="4675201" y="742263"/>
                  </a:lnTo>
                  <a:lnTo>
                    <a:pt x="4683603" y="697648"/>
                  </a:lnTo>
                  <a:lnTo>
                    <a:pt x="4691956" y="705168"/>
                  </a:lnTo>
                  <a:lnTo>
                    <a:pt x="4758840" y="758706"/>
                  </a:lnTo>
                  <a:lnTo>
                    <a:pt x="4767232" y="764678"/>
                  </a:lnTo>
                  <a:lnTo>
                    <a:pt x="4775595" y="778169"/>
                  </a:lnTo>
                  <a:lnTo>
                    <a:pt x="4842480" y="919680"/>
                  </a:lnTo>
                  <a:lnTo>
                    <a:pt x="4850872" y="943004"/>
                  </a:lnTo>
                  <a:lnTo>
                    <a:pt x="4859225" y="967800"/>
                  </a:lnTo>
                  <a:lnTo>
                    <a:pt x="4926109" y="1097475"/>
                  </a:lnTo>
                  <a:lnTo>
                    <a:pt x="4934501" y="1108285"/>
                  </a:lnTo>
                  <a:lnTo>
                    <a:pt x="4942864" y="1104463"/>
                  </a:lnTo>
                  <a:lnTo>
                    <a:pt x="5009749" y="1070028"/>
                  </a:lnTo>
                  <a:lnTo>
                    <a:pt x="5018141" y="1065150"/>
                  </a:lnTo>
                  <a:lnTo>
                    <a:pt x="5026494" y="1057892"/>
                  </a:lnTo>
                  <a:lnTo>
                    <a:pt x="5093388" y="988743"/>
                  </a:lnTo>
                  <a:lnTo>
                    <a:pt x="5101780" y="978426"/>
                  </a:lnTo>
                  <a:lnTo>
                    <a:pt x="5110134" y="969996"/>
                  </a:lnTo>
                  <a:lnTo>
                    <a:pt x="5177018" y="921268"/>
                  </a:lnTo>
                  <a:lnTo>
                    <a:pt x="5185410" y="916806"/>
                  </a:lnTo>
                  <a:lnTo>
                    <a:pt x="5193773" y="913099"/>
                  </a:lnTo>
                  <a:lnTo>
                    <a:pt x="5260657" y="880852"/>
                  </a:lnTo>
                  <a:lnTo>
                    <a:pt x="5269049" y="876468"/>
                  </a:lnTo>
                  <a:lnTo>
                    <a:pt x="5277403" y="891024"/>
                  </a:lnTo>
                  <a:lnTo>
                    <a:pt x="5344287" y="1025790"/>
                  </a:lnTo>
                  <a:lnTo>
                    <a:pt x="5352650" y="1045301"/>
                  </a:lnTo>
                  <a:lnTo>
                    <a:pt x="5361042" y="1048253"/>
                  </a:lnTo>
                  <a:lnTo>
                    <a:pt x="5427926" y="1106359"/>
                  </a:lnTo>
                  <a:lnTo>
                    <a:pt x="5436280" y="1126393"/>
                  </a:lnTo>
                  <a:lnTo>
                    <a:pt x="5444672" y="1154294"/>
                  </a:lnTo>
                  <a:lnTo>
                    <a:pt x="5511566" y="1246419"/>
                  </a:lnTo>
                  <a:lnTo>
                    <a:pt x="5519919" y="1251558"/>
                  </a:lnTo>
                  <a:lnTo>
                    <a:pt x="5528311" y="1223473"/>
                  </a:lnTo>
                  <a:lnTo>
                    <a:pt x="5595195" y="1067870"/>
                  </a:lnTo>
                  <a:lnTo>
                    <a:pt x="5603558" y="1054224"/>
                  </a:lnTo>
                  <a:lnTo>
                    <a:pt x="5611950" y="966174"/>
                  </a:lnTo>
                  <a:lnTo>
                    <a:pt x="5678835" y="265013"/>
                  </a:lnTo>
                  <a:lnTo>
                    <a:pt x="5687188" y="177756"/>
                  </a:lnTo>
                  <a:lnTo>
                    <a:pt x="5695580" y="255451"/>
                  </a:lnTo>
                  <a:lnTo>
                    <a:pt x="5762474" y="1137435"/>
                  </a:lnTo>
                  <a:lnTo>
                    <a:pt x="5770827" y="1296135"/>
                  </a:lnTo>
                  <a:lnTo>
                    <a:pt x="5779219" y="1254094"/>
                  </a:lnTo>
                  <a:lnTo>
                    <a:pt x="5846103" y="1008892"/>
                  </a:lnTo>
                  <a:lnTo>
                    <a:pt x="5854457" y="986285"/>
                  </a:lnTo>
                  <a:lnTo>
                    <a:pt x="5862858" y="989459"/>
                  </a:lnTo>
                  <a:lnTo>
                    <a:pt x="5929743" y="1030629"/>
                  </a:lnTo>
                  <a:lnTo>
                    <a:pt x="5938096" y="1039291"/>
                  </a:lnTo>
                  <a:lnTo>
                    <a:pt x="5946488" y="1054863"/>
                  </a:lnTo>
                  <a:lnTo>
                    <a:pt x="6013372" y="1133497"/>
                  </a:lnTo>
                  <a:lnTo>
                    <a:pt x="6021735" y="1139855"/>
                  </a:lnTo>
                  <a:lnTo>
                    <a:pt x="6030127" y="1141133"/>
                  </a:lnTo>
                  <a:lnTo>
                    <a:pt x="6097011" y="1152775"/>
                  </a:lnTo>
                  <a:lnTo>
                    <a:pt x="6105365" y="1154440"/>
                  </a:lnTo>
                  <a:lnTo>
                    <a:pt x="6113767" y="1149455"/>
                  </a:lnTo>
                  <a:lnTo>
                    <a:pt x="6180651" y="1114895"/>
                  </a:lnTo>
                  <a:lnTo>
                    <a:pt x="6189004" y="1111160"/>
                  </a:lnTo>
                  <a:lnTo>
                    <a:pt x="6197396" y="1111682"/>
                  </a:lnTo>
                  <a:lnTo>
                    <a:pt x="6264280" y="1116976"/>
                  </a:lnTo>
                  <a:lnTo>
                    <a:pt x="6272644" y="1117809"/>
                  </a:lnTo>
                  <a:lnTo>
                    <a:pt x="6281036" y="1105866"/>
                  </a:lnTo>
                  <a:lnTo>
                    <a:pt x="6347920" y="1024542"/>
                  </a:lnTo>
                  <a:lnTo>
                    <a:pt x="6356273" y="1015889"/>
                  </a:lnTo>
                  <a:lnTo>
                    <a:pt x="6364665" y="1035962"/>
                  </a:lnTo>
                  <a:lnTo>
                    <a:pt x="6431560" y="1183135"/>
                  </a:lnTo>
                  <a:lnTo>
                    <a:pt x="6439913" y="1199955"/>
                  </a:lnTo>
                  <a:lnTo>
                    <a:pt x="6448305" y="1186919"/>
                  </a:lnTo>
                  <a:lnTo>
                    <a:pt x="6515189" y="1069496"/>
                  </a:lnTo>
                  <a:lnTo>
                    <a:pt x="6523542" y="1052976"/>
                  </a:lnTo>
                  <a:lnTo>
                    <a:pt x="6531944" y="1071383"/>
                  </a:lnTo>
                  <a:lnTo>
                    <a:pt x="6598829" y="1235909"/>
                  </a:lnTo>
                  <a:lnTo>
                    <a:pt x="6607182" y="1258933"/>
                  </a:lnTo>
                  <a:lnTo>
                    <a:pt x="6615535" y="1251868"/>
                  </a:lnTo>
                  <a:lnTo>
                    <a:pt x="6682458" y="1212508"/>
                  </a:lnTo>
                  <a:lnTo>
                    <a:pt x="6690821" y="1209033"/>
                  </a:lnTo>
                  <a:lnTo>
                    <a:pt x="6699174" y="1182835"/>
                  </a:lnTo>
                  <a:lnTo>
                    <a:pt x="6766097" y="920474"/>
                  </a:lnTo>
                  <a:lnTo>
                    <a:pt x="6774451" y="879188"/>
                  </a:lnTo>
                  <a:lnTo>
                    <a:pt x="6782814" y="917522"/>
                  </a:lnTo>
                  <a:lnTo>
                    <a:pt x="6849737" y="1274098"/>
                  </a:lnTo>
                  <a:lnTo>
                    <a:pt x="6858090" y="1326040"/>
                  </a:lnTo>
                  <a:lnTo>
                    <a:pt x="6866443" y="1279315"/>
                  </a:lnTo>
                  <a:lnTo>
                    <a:pt x="6933366" y="1027493"/>
                  </a:lnTo>
                  <a:lnTo>
                    <a:pt x="6941729" y="1005911"/>
                  </a:lnTo>
                  <a:lnTo>
                    <a:pt x="6950083" y="1030590"/>
                  </a:lnTo>
                  <a:lnTo>
                    <a:pt x="7017006" y="1271069"/>
                  </a:lnTo>
                  <a:lnTo>
                    <a:pt x="7025359" y="1307817"/>
                  </a:lnTo>
                  <a:lnTo>
                    <a:pt x="7033712" y="1291451"/>
                  </a:lnTo>
                  <a:lnTo>
                    <a:pt x="7100645" y="1151498"/>
                  </a:lnTo>
                  <a:lnTo>
                    <a:pt x="7108998" y="1132780"/>
                  </a:lnTo>
                  <a:lnTo>
                    <a:pt x="7117351" y="1148014"/>
                  </a:lnTo>
                  <a:lnTo>
                    <a:pt x="7184274" y="1274660"/>
                  </a:lnTo>
                  <a:lnTo>
                    <a:pt x="7192628" y="1291141"/>
                  </a:lnTo>
                  <a:lnTo>
                    <a:pt x="7200991" y="1277950"/>
                  </a:lnTo>
                  <a:lnTo>
                    <a:pt x="7267914" y="1180531"/>
                  </a:lnTo>
                  <a:lnTo>
                    <a:pt x="7276267" y="1169266"/>
                  </a:lnTo>
                  <a:lnTo>
                    <a:pt x="7284620" y="1123973"/>
                  </a:lnTo>
                  <a:lnTo>
                    <a:pt x="7351543" y="740899"/>
                  </a:lnTo>
                  <a:lnTo>
                    <a:pt x="7359906" y="690273"/>
                  </a:lnTo>
                  <a:lnTo>
                    <a:pt x="7368260" y="673337"/>
                  </a:lnTo>
                  <a:lnTo>
                    <a:pt x="7435183" y="560491"/>
                  </a:lnTo>
                  <a:lnTo>
                    <a:pt x="7443536" y="548665"/>
                  </a:lnTo>
                  <a:lnTo>
                    <a:pt x="7451899" y="574137"/>
                  </a:lnTo>
                  <a:lnTo>
                    <a:pt x="7518822" y="819233"/>
                  </a:lnTo>
                  <a:lnTo>
                    <a:pt x="7527175" y="856203"/>
                  </a:lnTo>
                  <a:lnTo>
                    <a:pt x="7535528" y="896124"/>
                  </a:lnTo>
                  <a:lnTo>
                    <a:pt x="7602452" y="1163856"/>
                  </a:lnTo>
                  <a:lnTo>
                    <a:pt x="7610815" y="1191981"/>
                  </a:lnTo>
                  <a:lnTo>
                    <a:pt x="7619168" y="1188090"/>
                  </a:lnTo>
                  <a:lnTo>
                    <a:pt x="7686091" y="1154333"/>
                  </a:lnTo>
                  <a:lnTo>
                    <a:pt x="7694444" y="1149756"/>
                  </a:lnTo>
                  <a:lnTo>
                    <a:pt x="7702798" y="1078758"/>
                  </a:lnTo>
                  <a:lnTo>
                    <a:pt x="7769731" y="378613"/>
                  </a:lnTo>
                  <a:lnTo>
                    <a:pt x="7778084" y="270229"/>
                  </a:lnTo>
                  <a:lnTo>
                    <a:pt x="7786437" y="417247"/>
                  </a:lnTo>
                  <a:lnTo>
                    <a:pt x="7853360" y="1135955"/>
                  </a:lnTo>
                  <a:lnTo>
                    <a:pt x="7861713" y="1192319"/>
                  </a:lnTo>
                  <a:lnTo>
                    <a:pt x="7870077" y="1155049"/>
                  </a:lnTo>
                  <a:lnTo>
                    <a:pt x="7937000" y="737647"/>
                  </a:lnTo>
                  <a:lnTo>
                    <a:pt x="7945353" y="663591"/>
                  </a:lnTo>
                  <a:lnTo>
                    <a:pt x="7953706" y="705100"/>
                  </a:lnTo>
                  <a:lnTo>
                    <a:pt x="8020629" y="1021677"/>
                  </a:lnTo>
                  <a:lnTo>
                    <a:pt x="8028992" y="1059440"/>
                  </a:lnTo>
                  <a:lnTo>
                    <a:pt x="8037346" y="1077432"/>
                  </a:lnTo>
                  <a:lnTo>
                    <a:pt x="8104268" y="1242374"/>
                  </a:lnTo>
                  <a:lnTo>
                    <a:pt x="8112622" y="1266046"/>
                  </a:lnTo>
                  <a:lnTo>
                    <a:pt x="8120985" y="1243739"/>
                  </a:lnTo>
                  <a:lnTo>
                    <a:pt x="8187908" y="1125745"/>
                  </a:lnTo>
                  <a:lnTo>
                    <a:pt x="8196261" y="1115844"/>
                  </a:lnTo>
                  <a:lnTo>
                    <a:pt x="8204614" y="1053198"/>
                  </a:lnTo>
                  <a:lnTo>
                    <a:pt x="8271537" y="400766"/>
                  </a:lnTo>
                  <a:lnTo>
                    <a:pt x="8279900" y="293746"/>
                  </a:lnTo>
                  <a:lnTo>
                    <a:pt x="8288254" y="381032"/>
                  </a:lnTo>
                  <a:lnTo>
                    <a:pt x="8355177" y="1086732"/>
                  </a:lnTo>
                  <a:lnTo>
                    <a:pt x="8363530" y="1175838"/>
                  </a:lnTo>
                  <a:lnTo>
                    <a:pt x="8363530" y="1250765"/>
                  </a:lnTo>
                  <a:lnTo>
                    <a:pt x="8355177" y="1181780"/>
                  </a:lnTo>
                  <a:lnTo>
                    <a:pt x="8288254" y="635312"/>
                  </a:lnTo>
                  <a:lnTo>
                    <a:pt x="8279900" y="567673"/>
                  </a:lnTo>
                  <a:lnTo>
                    <a:pt x="8271537" y="647709"/>
                  </a:lnTo>
                  <a:lnTo>
                    <a:pt x="8204614" y="1135316"/>
                  </a:lnTo>
                  <a:lnTo>
                    <a:pt x="8196261" y="1182119"/>
                  </a:lnTo>
                  <a:lnTo>
                    <a:pt x="8187908" y="1191758"/>
                  </a:lnTo>
                  <a:lnTo>
                    <a:pt x="8120985" y="1306413"/>
                  </a:lnTo>
                  <a:lnTo>
                    <a:pt x="8112622" y="1328082"/>
                  </a:lnTo>
                  <a:lnTo>
                    <a:pt x="8104268" y="1315453"/>
                  </a:lnTo>
                  <a:lnTo>
                    <a:pt x="8037346" y="1227712"/>
                  </a:lnTo>
                  <a:lnTo>
                    <a:pt x="8028992" y="1218140"/>
                  </a:lnTo>
                  <a:lnTo>
                    <a:pt x="8020629" y="1184083"/>
                  </a:lnTo>
                  <a:lnTo>
                    <a:pt x="7953706" y="898582"/>
                  </a:lnTo>
                  <a:lnTo>
                    <a:pt x="7945353" y="861158"/>
                  </a:lnTo>
                  <a:lnTo>
                    <a:pt x="7937000" y="929504"/>
                  </a:lnTo>
                  <a:lnTo>
                    <a:pt x="7870077" y="1314882"/>
                  </a:lnTo>
                  <a:lnTo>
                    <a:pt x="7861713" y="1349287"/>
                  </a:lnTo>
                  <a:lnTo>
                    <a:pt x="7853360" y="1302978"/>
                  </a:lnTo>
                  <a:lnTo>
                    <a:pt x="7786437" y="712165"/>
                  </a:lnTo>
                  <a:lnTo>
                    <a:pt x="7778084" y="591306"/>
                  </a:lnTo>
                  <a:lnTo>
                    <a:pt x="7769731" y="668159"/>
                  </a:lnTo>
                  <a:lnTo>
                    <a:pt x="7702798" y="1164457"/>
                  </a:lnTo>
                  <a:lnTo>
                    <a:pt x="7694444" y="1214782"/>
                  </a:lnTo>
                  <a:lnTo>
                    <a:pt x="7686091" y="1233567"/>
                  </a:lnTo>
                  <a:lnTo>
                    <a:pt x="7619168" y="1371779"/>
                  </a:lnTo>
                  <a:lnTo>
                    <a:pt x="7610815" y="1387699"/>
                  </a:lnTo>
                  <a:lnTo>
                    <a:pt x="7602452" y="1351251"/>
                  </a:lnTo>
                  <a:lnTo>
                    <a:pt x="7535528" y="1004586"/>
                  </a:lnTo>
                  <a:lnTo>
                    <a:pt x="7527175" y="952866"/>
                  </a:lnTo>
                  <a:lnTo>
                    <a:pt x="7518822" y="926145"/>
                  </a:lnTo>
                  <a:lnTo>
                    <a:pt x="7451899" y="748951"/>
                  </a:lnTo>
                  <a:lnTo>
                    <a:pt x="7443536" y="730543"/>
                  </a:lnTo>
                  <a:lnTo>
                    <a:pt x="7435183" y="777569"/>
                  </a:lnTo>
                  <a:lnTo>
                    <a:pt x="7368260" y="1226841"/>
                  </a:lnTo>
                  <a:lnTo>
                    <a:pt x="7359906" y="1294171"/>
                  </a:lnTo>
                  <a:lnTo>
                    <a:pt x="7351543" y="1290657"/>
                  </a:lnTo>
                  <a:lnTo>
                    <a:pt x="7284620" y="1263966"/>
                  </a:lnTo>
                  <a:lnTo>
                    <a:pt x="7276267" y="1260791"/>
                  </a:lnTo>
                  <a:lnTo>
                    <a:pt x="7267914" y="1270092"/>
                  </a:lnTo>
                  <a:lnTo>
                    <a:pt x="7200991" y="1350535"/>
                  </a:lnTo>
                  <a:lnTo>
                    <a:pt x="7192628" y="1361423"/>
                  </a:lnTo>
                  <a:lnTo>
                    <a:pt x="7184274" y="1356052"/>
                  </a:lnTo>
                  <a:lnTo>
                    <a:pt x="7117351" y="1314775"/>
                  </a:lnTo>
                  <a:lnTo>
                    <a:pt x="7108998" y="1309820"/>
                  </a:lnTo>
                  <a:lnTo>
                    <a:pt x="7100645" y="1317988"/>
                  </a:lnTo>
                  <a:lnTo>
                    <a:pt x="7033712" y="1379037"/>
                  </a:lnTo>
                  <a:lnTo>
                    <a:pt x="7025359" y="1386189"/>
                  </a:lnTo>
                  <a:lnTo>
                    <a:pt x="7017006" y="1347245"/>
                  </a:lnTo>
                  <a:lnTo>
                    <a:pt x="6950083" y="1092559"/>
                  </a:lnTo>
                  <a:lnTo>
                    <a:pt x="6941729" y="1066399"/>
                  </a:lnTo>
                  <a:lnTo>
                    <a:pt x="6933366" y="1089007"/>
                  </a:lnTo>
                  <a:lnTo>
                    <a:pt x="6866443" y="1353032"/>
                  </a:lnTo>
                  <a:lnTo>
                    <a:pt x="6858090" y="1402022"/>
                  </a:lnTo>
                  <a:lnTo>
                    <a:pt x="6849737" y="1354958"/>
                  </a:lnTo>
                  <a:lnTo>
                    <a:pt x="6782814" y="1031955"/>
                  </a:lnTo>
                  <a:lnTo>
                    <a:pt x="6774451" y="997250"/>
                  </a:lnTo>
                  <a:lnTo>
                    <a:pt x="6766097" y="1028026"/>
                  </a:lnTo>
                  <a:lnTo>
                    <a:pt x="6699174" y="1223589"/>
                  </a:lnTo>
                  <a:lnTo>
                    <a:pt x="6690821" y="1243129"/>
                  </a:lnTo>
                  <a:lnTo>
                    <a:pt x="6682458" y="1249332"/>
                  </a:lnTo>
                  <a:lnTo>
                    <a:pt x="6615535" y="1319498"/>
                  </a:lnTo>
                  <a:lnTo>
                    <a:pt x="6607182" y="1332089"/>
                  </a:lnTo>
                  <a:lnTo>
                    <a:pt x="6598829" y="1321201"/>
                  </a:lnTo>
                  <a:lnTo>
                    <a:pt x="6531944" y="1243400"/>
                  </a:lnTo>
                  <a:lnTo>
                    <a:pt x="6523542" y="1234661"/>
                  </a:lnTo>
                  <a:lnTo>
                    <a:pt x="6515189" y="1238783"/>
                  </a:lnTo>
                  <a:lnTo>
                    <a:pt x="6448305" y="1268050"/>
                  </a:lnTo>
                  <a:lnTo>
                    <a:pt x="6439913" y="1271301"/>
                  </a:lnTo>
                  <a:lnTo>
                    <a:pt x="6431560" y="1269859"/>
                  </a:lnTo>
                  <a:lnTo>
                    <a:pt x="6364665" y="1257268"/>
                  </a:lnTo>
                  <a:lnTo>
                    <a:pt x="6356273" y="1255536"/>
                  </a:lnTo>
                  <a:lnTo>
                    <a:pt x="6347920" y="1247445"/>
                  </a:lnTo>
                  <a:lnTo>
                    <a:pt x="6281036" y="1171270"/>
                  </a:lnTo>
                  <a:lnTo>
                    <a:pt x="6272644" y="1160034"/>
                  </a:lnTo>
                  <a:lnTo>
                    <a:pt x="6264280" y="1171647"/>
                  </a:lnTo>
                  <a:lnTo>
                    <a:pt x="6197396" y="1243816"/>
                  </a:lnTo>
                  <a:lnTo>
                    <a:pt x="6189004" y="1250881"/>
                  </a:lnTo>
                  <a:lnTo>
                    <a:pt x="6180651" y="1247106"/>
                  </a:lnTo>
                  <a:lnTo>
                    <a:pt x="6113767" y="1212092"/>
                  </a:lnTo>
                  <a:lnTo>
                    <a:pt x="6105365" y="1206991"/>
                  </a:lnTo>
                  <a:lnTo>
                    <a:pt x="6097011" y="1224344"/>
                  </a:lnTo>
                  <a:lnTo>
                    <a:pt x="6030127" y="1346306"/>
                  </a:lnTo>
                  <a:lnTo>
                    <a:pt x="6021735" y="1359758"/>
                  </a:lnTo>
                  <a:lnTo>
                    <a:pt x="6013372" y="1343993"/>
                  </a:lnTo>
                  <a:lnTo>
                    <a:pt x="5946488" y="1148284"/>
                  </a:lnTo>
                  <a:lnTo>
                    <a:pt x="5938096" y="1109456"/>
                  </a:lnTo>
                  <a:lnTo>
                    <a:pt x="5929743" y="1111305"/>
                  </a:lnTo>
                  <a:lnTo>
                    <a:pt x="5862858" y="1120112"/>
                  </a:lnTo>
                  <a:lnTo>
                    <a:pt x="5854457" y="1120760"/>
                  </a:lnTo>
                  <a:lnTo>
                    <a:pt x="5846103" y="1138713"/>
                  </a:lnTo>
                  <a:lnTo>
                    <a:pt x="5779219" y="1333183"/>
                  </a:lnTo>
                  <a:lnTo>
                    <a:pt x="5770827" y="1366523"/>
                  </a:lnTo>
                  <a:lnTo>
                    <a:pt x="5762474" y="1215760"/>
                  </a:lnTo>
                  <a:lnTo>
                    <a:pt x="5695580" y="378119"/>
                  </a:lnTo>
                  <a:lnTo>
                    <a:pt x="5687188" y="304363"/>
                  </a:lnTo>
                  <a:lnTo>
                    <a:pt x="5678835" y="403979"/>
                  </a:lnTo>
                  <a:lnTo>
                    <a:pt x="5611950" y="1204649"/>
                  </a:lnTo>
                  <a:lnTo>
                    <a:pt x="5603558" y="1305204"/>
                  </a:lnTo>
                  <a:lnTo>
                    <a:pt x="5595195" y="1303849"/>
                  </a:lnTo>
                  <a:lnTo>
                    <a:pt x="5528311" y="1288267"/>
                  </a:lnTo>
                  <a:lnTo>
                    <a:pt x="5519919" y="1285470"/>
                  </a:lnTo>
                  <a:lnTo>
                    <a:pt x="5511566" y="1278899"/>
                  </a:lnTo>
                  <a:lnTo>
                    <a:pt x="5444672" y="1161853"/>
                  </a:lnTo>
                  <a:lnTo>
                    <a:pt x="5436280" y="1126393"/>
                  </a:lnTo>
                  <a:lnTo>
                    <a:pt x="5427926" y="1146049"/>
                  </a:lnTo>
                  <a:lnTo>
                    <a:pt x="5361042" y="1203207"/>
                  </a:lnTo>
                  <a:lnTo>
                    <a:pt x="5352650" y="1206082"/>
                  </a:lnTo>
                  <a:lnTo>
                    <a:pt x="5344287" y="1178828"/>
                  </a:lnTo>
                  <a:lnTo>
                    <a:pt x="5277403" y="990601"/>
                  </a:lnTo>
                  <a:lnTo>
                    <a:pt x="5269049" y="970258"/>
                  </a:lnTo>
                  <a:lnTo>
                    <a:pt x="5260657" y="972455"/>
                  </a:lnTo>
                  <a:lnTo>
                    <a:pt x="5193773" y="988665"/>
                  </a:lnTo>
                  <a:lnTo>
                    <a:pt x="5185410" y="990523"/>
                  </a:lnTo>
                  <a:lnTo>
                    <a:pt x="5177018" y="1011273"/>
                  </a:lnTo>
                  <a:lnTo>
                    <a:pt x="5110134" y="1238522"/>
                  </a:lnTo>
                  <a:lnTo>
                    <a:pt x="5101780" y="1277834"/>
                  </a:lnTo>
                  <a:lnTo>
                    <a:pt x="5093388" y="1277728"/>
                  </a:lnTo>
                  <a:lnTo>
                    <a:pt x="5026494" y="1277002"/>
                  </a:lnTo>
                  <a:lnTo>
                    <a:pt x="5018141" y="1276934"/>
                  </a:lnTo>
                  <a:lnTo>
                    <a:pt x="5009749" y="1268805"/>
                  </a:lnTo>
                  <a:lnTo>
                    <a:pt x="4942864" y="1211037"/>
                  </a:lnTo>
                  <a:lnTo>
                    <a:pt x="4934501" y="1204610"/>
                  </a:lnTo>
                  <a:lnTo>
                    <a:pt x="4926109" y="1192736"/>
                  </a:lnTo>
                  <a:lnTo>
                    <a:pt x="4859225" y="1050140"/>
                  </a:lnTo>
                  <a:lnTo>
                    <a:pt x="4850872" y="1022848"/>
                  </a:lnTo>
                  <a:lnTo>
                    <a:pt x="4842480" y="1027571"/>
                  </a:lnTo>
                  <a:lnTo>
                    <a:pt x="4775595" y="1056227"/>
                  </a:lnTo>
                  <a:lnTo>
                    <a:pt x="4767232" y="1058986"/>
                  </a:lnTo>
                  <a:lnTo>
                    <a:pt x="4758840" y="1029042"/>
                  </a:lnTo>
                  <a:lnTo>
                    <a:pt x="4691956" y="760932"/>
                  </a:lnTo>
                  <a:lnTo>
                    <a:pt x="4683603" y="723353"/>
                  </a:lnTo>
                  <a:lnTo>
                    <a:pt x="4675201" y="776204"/>
                  </a:lnTo>
                  <a:lnTo>
                    <a:pt x="4608317" y="1208617"/>
                  </a:lnTo>
                  <a:lnTo>
                    <a:pt x="4599964" y="1263888"/>
                  </a:lnTo>
                  <a:lnTo>
                    <a:pt x="4591572" y="1242906"/>
                  </a:lnTo>
                  <a:lnTo>
                    <a:pt x="4524687" y="1092326"/>
                  </a:lnTo>
                  <a:lnTo>
                    <a:pt x="4516324" y="1075429"/>
                  </a:lnTo>
                  <a:lnTo>
                    <a:pt x="4507932" y="1093768"/>
                  </a:lnTo>
                  <a:lnTo>
                    <a:pt x="4441048" y="1232396"/>
                  </a:lnTo>
                  <a:lnTo>
                    <a:pt x="4432695" y="1248800"/>
                  </a:lnTo>
                  <a:lnTo>
                    <a:pt x="4424303" y="1133913"/>
                  </a:lnTo>
                  <a:lnTo>
                    <a:pt x="4357409" y="207099"/>
                  </a:lnTo>
                  <a:lnTo>
                    <a:pt x="4349055" y="90238"/>
                  </a:lnTo>
                  <a:lnTo>
                    <a:pt x="4340664" y="207583"/>
                  </a:lnTo>
                  <a:lnTo>
                    <a:pt x="4273779" y="1223744"/>
                  </a:lnTo>
                  <a:lnTo>
                    <a:pt x="4265416" y="1361268"/>
                  </a:lnTo>
                  <a:lnTo>
                    <a:pt x="4257024" y="1316962"/>
                  </a:lnTo>
                  <a:lnTo>
                    <a:pt x="4190140" y="1034529"/>
                  </a:lnTo>
                  <a:lnTo>
                    <a:pt x="4181787" y="1006250"/>
                  </a:lnTo>
                  <a:lnTo>
                    <a:pt x="4173394" y="1026400"/>
                  </a:lnTo>
                  <a:lnTo>
                    <a:pt x="4106500" y="1273073"/>
                  </a:lnTo>
                  <a:lnTo>
                    <a:pt x="4098147" y="1321317"/>
                  </a:lnTo>
                  <a:lnTo>
                    <a:pt x="4089755" y="1284831"/>
                  </a:lnTo>
                  <a:lnTo>
                    <a:pt x="4022871" y="1094823"/>
                  </a:lnTo>
                  <a:lnTo>
                    <a:pt x="4014517" y="1079058"/>
                  </a:lnTo>
                  <a:lnTo>
                    <a:pt x="4006154" y="1093120"/>
                  </a:lnTo>
                  <a:lnTo>
                    <a:pt x="3939231" y="1220831"/>
                  </a:lnTo>
                  <a:lnTo>
                    <a:pt x="3930878" y="1238977"/>
                  </a:lnTo>
                  <a:lnTo>
                    <a:pt x="3922525" y="1235193"/>
                  </a:lnTo>
                  <a:lnTo>
                    <a:pt x="3855602" y="1201513"/>
                  </a:lnTo>
                  <a:lnTo>
                    <a:pt x="3847239" y="1196820"/>
                  </a:lnTo>
                  <a:lnTo>
                    <a:pt x="3838885" y="1170544"/>
                  </a:lnTo>
                  <a:lnTo>
                    <a:pt x="3771962" y="978958"/>
                  </a:lnTo>
                  <a:lnTo>
                    <a:pt x="3763609" y="957067"/>
                  </a:lnTo>
                  <a:lnTo>
                    <a:pt x="3755246" y="974119"/>
                  </a:lnTo>
                  <a:lnTo>
                    <a:pt x="3688323" y="1129267"/>
                  </a:lnTo>
                  <a:lnTo>
                    <a:pt x="3679970" y="1151381"/>
                  </a:lnTo>
                  <a:lnTo>
                    <a:pt x="3671616" y="1093091"/>
                  </a:lnTo>
                  <a:lnTo>
                    <a:pt x="3604693" y="743541"/>
                  </a:lnTo>
                  <a:lnTo>
                    <a:pt x="3596330" y="710539"/>
                  </a:lnTo>
                  <a:lnTo>
                    <a:pt x="3587977" y="731066"/>
                  </a:lnTo>
                  <a:lnTo>
                    <a:pt x="3521054" y="920203"/>
                  </a:lnTo>
                  <a:lnTo>
                    <a:pt x="3512701" y="947505"/>
                  </a:lnTo>
                  <a:lnTo>
                    <a:pt x="3504347" y="992904"/>
                  </a:lnTo>
                  <a:lnTo>
                    <a:pt x="3437424" y="1309442"/>
                  </a:lnTo>
                  <a:lnTo>
                    <a:pt x="3429061" y="1343993"/>
                  </a:lnTo>
                  <a:lnTo>
                    <a:pt x="3420708" y="1346906"/>
                  </a:lnTo>
                  <a:lnTo>
                    <a:pt x="3353785" y="1404335"/>
                  </a:lnTo>
                  <a:lnTo>
                    <a:pt x="3345432" y="1423875"/>
                  </a:lnTo>
                  <a:lnTo>
                    <a:pt x="3337069" y="1384902"/>
                  </a:lnTo>
                  <a:lnTo>
                    <a:pt x="3270146" y="1248384"/>
                  </a:lnTo>
                  <a:lnTo>
                    <a:pt x="3261792" y="1240332"/>
                  </a:lnTo>
                  <a:lnTo>
                    <a:pt x="3253439" y="1174551"/>
                  </a:lnTo>
                  <a:lnTo>
                    <a:pt x="3186516" y="756209"/>
                  </a:lnTo>
                  <a:lnTo>
                    <a:pt x="3178153" y="714400"/>
                  </a:lnTo>
                  <a:lnTo>
                    <a:pt x="3169800" y="734511"/>
                  </a:lnTo>
                  <a:lnTo>
                    <a:pt x="3102877" y="957560"/>
                  </a:lnTo>
                  <a:lnTo>
                    <a:pt x="3094523" y="996688"/>
                  </a:lnTo>
                  <a:lnTo>
                    <a:pt x="3086161" y="1015773"/>
                  </a:lnTo>
                  <a:lnTo>
                    <a:pt x="3019238" y="1135916"/>
                  </a:lnTo>
                  <a:lnTo>
                    <a:pt x="3010884" y="1147791"/>
                  </a:lnTo>
                  <a:lnTo>
                    <a:pt x="3002531" y="1080839"/>
                  </a:lnTo>
                  <a:lnTo>
                    <a:pt x="2935608" y="522496"/>
                  </a:lnTo>
                  <a:lnTo>
                    <a:pt x="2927245" y="449765"/>
                  </a:lnTo>
                  <a:lnTo>
                    <a:pt x="2918892" y="514182"/>
                  </a:lnTo>
                  <a:lnTo>
                    <a:pt x="2851968" y="1015512"/>
                  </a:lnTo>
                  <a:lnTo>
                    <a:pt x="2843615" y="1076493"/>
                  </a:lnTo>
                  <a:lnTo>
                    <a:pt x="2835262" y="1087797"/>
                  </a:lnTo>
                  <a:lnTo>
                    <a:pt x="2768329" y="1207030"/>
                  </a:lnTo>
                  <a:lnTo>
                    <a:pt x="2759976" y="1226879"/>
                  </a:lnTo>
                  <a:lnTo>
                    <a:pt x="2751623" y="1237651"/>
                  </a:lnTo>
                  <a:lnTo>
                    <a:pt x="2684699" y="1310275"/>
                  </a:lnTo>
                  <a:lnTo>
                    <a:pt x="2676346" y="1317949"/>
                  </a:lnTo>
                  <a:lnTo>
                    <a:pt x="2667983" y="1307855"/>
                  </a:lnTo>
                  <a:lnTo>
                    <a:pt x="2601060" y="1227934"/>
                  </a:lnTo>
                  <a:lnTo>
                    <a:pt x="2592707" y="1218072"/>
                  </a:lnTo>
                  <a:lnTo>
                    <a:pt x="2584354" y="1223705"/>
                  </a:lnTo>
                  <a:lnTo>
                    <a:pt x="2517430" y="1262107"/>
                  </a:lnTo>
                  <a:lnTo>
                    <a:pt x="2509068" y="1266230"/>
                  </a:lnTo>
                  <a:lnTo>
                    <a:pt x="2500714" y="1237728"/>
                  </a:lnTo>
                  <a:lnTo>
                    <a:pt x="2433791" y="996650"/>
                  </a:lnTo>
                  <a:lnTo>
                    <a:pt x="2425438" y="964741"/>
                  </a:lnTo>
                  <a:lnTo>
                    <a:pt x="2417075" y="986323"/>
                  </a:lnTo>
                  <a:lnTo>
                    <a:pt x="2350152" y="1168163"/>
                  </a:lnTo>
                  <a:lnTo>
                    <a:pt x="2341799" y="1192097"/>
                  </a:lnTo>
                  <a:lnTo>
                    <a:pt x="2333445" y="1194177"/>
                  </a:lnTo>
                  <a:lnTo>
                    <a:pt x="2266522" y="1214404"/>
                  </a:lnTo>
                  <a:lnTo>
                    <a:pt x="2258159" y="1217502"/>
                  </a:lnTo>
                  <a:lnTo>
                    <a:pt x="2249806" y="1209788"/>
                  </a:lnTo>
                  <a:lnTo>
                    <a:pt x="2182883" y="1158146"/>
                  </a:lnTo>
                  <a:lnTo>
                    <a:pt x="2174530" y="1152707"/>
                  </a:lnTo>
                  <a:lnTo>
                    <a:pt x="2166176" y="1100194"/>
                  </a:lnTo>
                  <a:lnTo>
                    <a:pt x="2099253" y="612782"/>
                  </a:lnTo>
                  <a:lnTo>
                    <a:pt x="2090890" y="541968"/>
                  </a:lnTo>
                  <a:lnTo>
                    <a:pt x="2082537" y="619508"/>
                  </a:lnTo>
                  <a:lnTo>
                    <a:pt x="2015614" y="1093313"/>
                  </a:lnTo>
                  <a:lnTo>
                    <a:pt x="2007260" y="1138906"/>
                  </a:lnTo>
                  <a:lnTo>
                    <a:pt x="1998898" y="1146349"/>
                  </a:lnTo>
                  <a:lnTo>
                    <a:pt x="1931975" y="1222495"/>
                  </a:lnTo>
                  <a:lnTo>
                    <a:pt x="1923621" y="1234738"/>
                  </a:lnTo>
                  <a:lnTo>
                    <a:pt x="1915268" y="1237119"/>
                  </a:lnTo>
                  <a:lnTo>
                    <a:pt x="1848345" y="1256213"/>
                  </a:lnTo>
                  <a:lnTo>
                    <a:pt x="1839982" y="1258594"/>
                  </a:lnTo>
                  <a:lnTo>
                    <a:pt x="1831629" y="1257839"/>
                  </a:lnTo>
                  <a:lnTo>
                    <a:pt x="1764706" y="1252207"/>
                  </a:lnTo>
                  <a:lnTo>
                    <a:pt x="1756352" y="1251558"/>
                  </a:lnTo>
                  <a:lnTo>
                    <a:pt x="1747989" y="1236219"/>
                  </a:lnTo>
                  <a:lnTo>
                    <a:pt x="1681066" y="1134977"/>
                  </a:lnTo>
                  <a:lnTo>
                    <a:pt x="1672713" y="1124506"/>
                  </a:lnTo>
                  <a:lnTo>
                    <a:pt x="1664360" y="1132142"/>
                  </a:lnTo>
                  <a:lnTo>
                    <a:pt x="1597437" y="1222911"/>
                  </a:lnTo>
                  <a:lnTo>
                    <a:pt x="1589074" y="1240032"/>
                  </a:lnTo>
                  <a:lnTo>
                    <a:pt x="1580720" y="1239054"/>
                  </a:lnTo>
                  <a:lnTo>
                    <a:pt x="1513797" y="1232773"/>
                  </a:lnTo>
                  <a:lnTo>
                    <a:pt x="1505444" y="1232173"/>
                  </a:lnTo>
                  <a:lnTo>
                    <a:pt x="1497091" y="1238900"/>
                  </a:lnTo>
                  <a:lnTo>
                    <a:pt x="1430158" y="1284231"/>
                  </a:lnTo>
                  <a:lnTo>
                    <a:pt x="1421805" y="1288993"/>
                  </a:lnTo>
                  <a:lnTo>
                    <a:pt x="1413451" y="1282189"/>
                  </a:lnTo>
                  <a:lnTo>
                    <a:pt x="1346528" y="1200788"/>
                  </a:lnTo>
                  <a:lnTo>
                    <a:pt x="1338175" y="1185293"/>
                  </a:lnTo>
                  <a:lnTo>
                    <a:pt x="1329812" y="1157469"/>
                  </a:lnTo>
                  <a:lnTo>
                    <a:pt x="1262889" y="1020158"/>
                  </a:lnTo>
                  <a:lnTo>
                    <a:pt x="1254536" y="1009308"/>
                  </a:lnTo>
                  <a:lnTo>
                    <a:pt x="1246182" y="1000956"/>
                  </a:lnTo>
                  <a:lnTo>
                    <a:pt x="1179259" y="922129"/>
                  </a:lnTo>
                  <a:lnTo>
                    <a:pt x="1170896" y="910448"/>
                  </a:lnTo>
                  <a:lnTo>
                    <a:pt x="1162543" y="933404"/>
                  </a:lnTo>
                  <a:lnTo>
                    <a:pt x="1095620" y="1106805"/>
                  </a:lnTo>
                  <a:lnTo>
                    <a:pt x="1087267" y="1127303"/>
                  </a:lnTo>
                  <a:lnTo>
                    <a:pt x="1078904" y="1129906"/>
                  </a:lnTo>
                  <a:lnTo>
                    <a:pt x="1011981" y="1147143"/>
                  </a:lnTo>
                  <a:lnTo>
                    <a:pt x="1003627" y="1148923"/>
                  </a:lnTo>
                  <a:lnTo>
                    <a:pt x="995274" y="1131909"/>
                  </a:lnTo>
                  <a:lnTo>
                    <a:pt x="928351" y="955663"/>
                  </a:lnTo>
                  <a:lnTo>
                    <a:pt x="919988" y="926939"/>
                  </a:lnTo>
                  <a:lnTo>
                    <a:pt x="911635" y="946556"/>
                  </a:lnTo>
                  <a:lnTo>
                    <a:pt x="844712" y="1073764"/>
                  </a:lnTo>
                  <a:lnTo>
                    <a:pt x="836358" y="1086732"/>
                  </a:lnTo>
                  <a:lnTo>
                    <a:pt x="828005" y="1095888"/>
                  </a:lnTo>
                  <a:lnTo>
                    <a:pt x="761082" y="1189068"/>
                  </a:lnTo>
                  <a:lnTo>
                    <a:pt x="752719" y="1204001"/>
                  </a:lnTo>
                  <a:lnTo>
                    <a:pt x="744366" y="1193307"/>
                  </a:lnTo>
                  <a:lnTo>
                    <a:pt x="677443" y="1090817"/>
                  </a:lnTo>
                  <a:lnTo>
                    <a:pt x="669089" y="1075467"/>
                  </a:lnTo>
                  <a:lnTo>
                    <a:pt x="660727" y="1059857"/>
                  </a:lnTo>
                  <a:lnTo>
                    <a:pt x="593803" y="974642"/>
                  </a:lnTo>
                  <a:lnTo>
                    <a:pt x="585450" y="967277"/>
                  </a:lnTo>
                  <a:lnTo>
                    <a:pt x="577097" y="963231"/>
                  </a:lnTo>
                  <a:lnTo>
                    <a:pt x="510174" y="911396"/>
                  </a:lnTo>
                  <a:lnTo>
                    <a:pt x="501811" y="900731"/>
                  </a:lnTo>
                  <a:lnTo>
                    <a:pt x="493458" y="935930"/>
                  </a:lnTo>
                  <a:lnTo>
                    <a:pt x="426534" y="1093497"/>
                  </a:lnTo>
                  <a:lnTo>
                    <a:pt x="418181" y="1104917"/>
                  </a:lnTo>
                  <a:lnTo>
                    <a:pt x="409818" y="1095356"/>
                  </a:lnTo>
                  <a:lnTo>
                    <a:pt x="342895" y="991056"/>
                  </a:lnTo>
                  <a:lnTo>
                    <a:pt x="334542" y="973132"/>
                  </a:lnTo>
                  <a:lnTo>
                    <a:pt x="326189" y="1005534"/>
                  </a:lnTo>
                  <a:lnTo>
                    <a:pt x="259304" y="1304720"/>
                  </a:lnTo>
                  <a:lnTo>
                    <a:pt x="250903" y="1348000"/>
                  </a:lnTo>
                  <a:lnTo>
                    <a:pt x="242549" y="1299155"/>
                  </a:lnTo>
                  <a:lnTo>
                    <a:pt x="175665" y="1026206"/>
                  </a:lnTo>
                  <a:lnTo>
                    <a:pt x="167273" y="1002011"/>
                  </a:lnTo>
                  <a:lnTo>
                    <a:pt x="158920" y="1002737"/>
                  </a:lnTo>
                  <a:lnTo>
                    <a:pt x="92029" y="1009386"/>
                  </a:lnTo>
                  <a:lnTo>
                    <a:pt x="83635" y="1010373"/>
                  </a:lnTo>
                  <a:lnTo>
                    <a:pt x="75279" y="981262"/>
                  </a:lnTo>
                  <a:lnTo>
                    <a:pt x="8394" y="751448"/>
                  </a:lnTo>
                  <a:lnTo>
                    <a:pt x="0" y="723091"/>
                  </a:lnTo>
                  <a:close/>
                </a:path>
              </a:pathLst>
            </a:custGeom>
            <a:solidFill>
              <a:srgbClr val="FCCDE5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05" name="Freeform: Shape 3004">
              <a:extLst>
                <a:ext uri="{FF2B5EF4-FFF2-40B4-BE49-F238E27FC236}">
                  <a16:creationId xmlns:a16="http://schemas.microsoft.com/office/drawing/2014/main" id="{2CCDA9FC-DF0E-7FE9-81F2-C54EF55C5CA1}"/>
                </a:ext>
              </a:extLst>
            </p:cNvPr>
            <p:cNvSpPr/>
            <p:nvPr/>
          </p:nvSpPr>
          <p:spPr>
            <a:xfrm>
              <a:off x="1961705" y="3294146"/>
              <a:ext cx="8363529" cy="1338553"/>
            </a:xfrm>
            <a:custGeom>
              <a:avLst/>
              <a:gdLst>
                <a:gd name="connsiteX0" fmla="*/ 0 w 8363529"/>
                <a:gd name="connsiteY0" fmla="*/ 632854 h 1338553"/>
                <a:gd name="connsiteX1" fmla="*/ 8394 w 8363529"/>
                <a:gd name="connsiteY1" fmla="*/ 661210 h 1338553"/>
                <a:gd name="connsiteX2" fmla="*/ 75279 w 8363529"/>
                <a:gd name="connsiteY2" fmla="*/ 891024 h 1338553"/>
                <a:gd name="connsiteX3" fmla="*/ 83635 w 8363529"/>
                <a:gd name="connsiteY3" fmla="*/ 920135 h 1338553"/>
                <a:gd name="connsiteX4" fmla="*/ 92029 w 8363529"/>
                <a:gd name="connsiteY4" fmla="*/ 919148 h 1338553"/>
                <a:gd name="connsiteX5" fmla="*/ 158920 w 8363529"/>
                <a:gd name="connsiteY5" fmla="*/ 912499 h 1338553"/>
                <a:gd name="connsiteX6" fmla="*/ 167273 w 8363529"/>
                <a:gd name="connsiteY6" fmla="*/ 911774 h 1338553"/>
                <a:gd name="connsiteX7" fmla="*/ 175665 w 8363529"/>
                <a:gd name="connsiteY7" fmla="*/ 935969 h 1338553"/>
                <a:gd name="connsiteX8" fmla="*/ 242549 w 8363529"/>
                <a:gd name="connsiteY8" fmla="*/ 1208917 h 1338553"/>
                <a:gd name="connsiteX9" fmla="*/ 250903 w 8363529"/>
                <a:gd name="connsiteY9" fmla="*/ 1257762 h 1338553"/>
                <a:gd name="connsiteX10" fmla="*/ 259304 w 8363529"/>
                <a:gd name="connsiteY10" fmla="*/ 1214482 h 1338553"/>
                <a:gd name="connsiteX11" fmla="*/ 326189 w 8363529"/>
                <a:gd name="connsiteY11" fmla="*/ 915296 h 1338553"/>
                <a:gd name="connsiteX12" fmla="*/ 334542 w 8363529"/>
                <a:gd name="connsiteY12" fmla="*/ 882894 h 1338553"/>
                <a:gd name="connsiteX13" fmla="*/ 342895 w 8363529"/>
                <a:gd name="connsiteY13" fmla="*/ 900818 h 1338553"/>
                <a:gd name="connsiteX14" fmla="*/ 409818 w 8363529"/>
                <a:gd name="connsiteY14" fmla="*/ 1005118 h 1338553"/>
                <a:gd name="connsiteX15" fmla="*/ 418181 w 8363529"/>
                <a:gd name="connsiteY15" fmla="*/ 1014680 h 1338553"/>
                <a:gd name="connsiteX16" fmla="*/ 426534 w 8363529"/>
                <a:gd name="connsiteY16" fmla="*/ 1003260 h 1338553"/>
                <a:gd name="connsiteX17" fmla="*/ 493458 w 8363529"/>
                <a:gd name="connsiteY17" fmla="*/ 845692 h 1338553"/>
                <a:gd name="connsiteX18" fmla="*/ 501811 w 8363529"/>
                <a:gd name="connsiteY18" fmla="*/ 810493 h 1338553"/>
                <a:gd name="connsiteX19" fmla="*/ 510174 w 8363529"/>
                <a:gd name="connsiteY19" fmla="*/ 821158 h 1338553"/>
                <a:gd name="connsiteX20" fmla="*/ 577097 w 8363529"/>
                <a:gd name="connsiteY20" fmla="*/ 872994 h 1338553"/>
                <a:gd name="connsiteX21" fmla="*/ 585450 w 8363529"/>
                <a:gd name="connsiteY21" fmla="*/ 877039 h 1338553"/>
                <a:gd name="connsiteX22" fmla="*/ 593803 w 8363529"/>
                <a:gd name="connsiteY22" fmla="*/ 884404 h 1338553"/>
                <a:gd name="connsiteX23" fmla="*/ 660727 w 8363529"/>
                <a:gd name="connsiteY23" fmla="*/ 969619 h 1338553"/>
                <a:gd name="connsiteX24" fmla="*/ 669089 w 8363529"/>
                <a:gd name="connsiteY24" fmla="*/ 985230 h 1338553"/>
                <a:gd name="connsiteX25" fmla="*/ 677443 w 8363529"/>
                <a:gd name="connsiteY25" fmla="*/ 1000579 h 1338553"/>
                <a:gd name="connsiteX26" fmla="*/ 744366 w 8363529"/>
                <a:gd name="connsiteY26" fmla="*/ 1103069 h 1338553"/>
                <a:gd name="connsiteX27" fmla="*/ 752719 w 8363529"/>
                <a:gd name="connsiteY27" fmla="*/ 1113763 h 1338553"/>
                <a:gd name="connsiteX28" fmla="*/ 761082 w 8363529"/>
                <a:gd name="connsiteY28" fmla="*/ 1098830 h 1338553"/>
                <a:gd name="connsiteX29" fmla="*/ 828005 w 8363529"/>
                <a:gd name="connsiteY29" fmla="*/ 1005650 h 1338553"/>
                <a:gd name="connsiteX30" fmla="*/ 836358 w 8363529"/>
                <a:gd name="connsiteY30" fmla="*/ 996495 h 1338553"/>
                <a:gd name="connsiteX31" fmla="*/ 844712 w 8363529"/>
                <a:gd name="connsiteY31" fmla="*/ 983526 h 1338553"/>
                <a:gd name="connsiteX32" fmla="*/ 911635 w 8363529"/>
                <a:gd name="connsiteY32" fmla="*/ 856319 h 1338553"/>
                <a:gd name="connsiteX33" fmla="*/ 919988 w 8363529"/>
                <a:gd name="connsiteY33" fmla="*/ 836701 h 1338553"/>
                <a:gd name="connsiteX34" fmla="*/ 928351 w 8363529"/>
                <a:gd name="connsiteY34" fmla="*/ 865426 h 1338553"/>
                <a:gd name="connsiteX35" fmla="*/ 995274 w 8363529"/>
                <a:gd name="connsiteY35" fmla="*/ 1041672 h 1338553"/>
                <a:gd name="connsiteX36" fmla="*/ 1003627 w 8363529"/>
                <a:gd name="connsiteY36" fmla="*/ 1058686 h 1338553"/>
                <a:gd name="connsiteX37" fmla="*/ 1011981 w 8363529"/>
                <a:gd name="connsiteY37" fmla="*/ 1056905 h 1338553"/>
                <a:gd name="connsiteX38" fmla="*/ 1078904 w 8363529"/>
                <a:gd name="connsiteY38" fmla="*/ 1039668 h 1338553"/>
                <a:gd name="connsiteX39" fmla="*/ 1087267 w 8363529"/>
                <a:gd name="connsiteY39" fmla="*/ 1037065 h 1338553"/>
                <a:gd name="connsiteX40" fmla="*/ 1095620 w 8363529"/>
                <a:gd name="connsiteY40" fmla="*/ 1016567 h 1338553"/>
                <a:gd name="connsiteX41" fmla="*/ 1162543 w 8363529"/>
                <a:gd name="connsiteY41" fmla="*/ 843166 h 1338553"/>
                <a:gd name="connsiteX42" fmla="*/ 1170896 w 8363529"/>
                <a:gd name="connsiteY42" fmla="*/ 820210 h 1338553"/>
                <a:gd name="connsiteX43" fmla="*/ 1179259 w 8363529"/>
                <a:gd name="connsiteY43" fmla="*/ 831891 h 1338553"/>
                <a:gd name="connsiteX44" fmla="*/ 1246182 w 8363529"/>
                <a:gd name="connsiteY44" fmla="*/ 910719 h 1338553"/>
                <a:gd name="connsiteX45" fmla="*/ 1254536 w 8363529"/>
                <a:gd name="connsiteY45" fmla="*/ 919071 h 1338553"/>
                <a:gd name="connsiteX46" fmla="*/ 1262889 w 8363529"/>
                <a:gd name="connsiteY46" fmla="*/ 929920 h 1338553"/>
                <a:gd name="connsiteX47" fmla="*/ 1329812 w 8363529"/>
                <a:gd name="connsiteY47" fmla="*/ 1067231 h 1338553"/>
                <a:gd name="connsiteX48" fmla="*/ 1338175 w 8363529"/>
                <a:gd name="connsiteY48" fmla="*/ 1095055 h 1338553"/>
                <a:gd name="connsiteX49" fmla="*/ 1346528 w 8363529"/>
                <a:gd name="connsiteY49" fmla="*/ 1110550 h 1338553"/>
                <a:gd name="connsiteX50" fmla="*/ 1413451 w 8363529"/>
                <a:gd name="connsiteY50" fmla="*/ 1191951 h 1338553"/>
                <a:gd name="connsiteX51" fmla="*/ 1421805 w 8363529"/>
                <a:gd name="connsiteY51" fmla="*/ 1198755 h 1338553"/>
                <a:gd name="connsiteX52" fmla="*/ 1430158 w 8363529"/>
                <a:gd name="connsiteY52" fmla="*/ 1193993 h 1338553"/>
                <a:gd name="connsiteX53" fmla="*/ 1497091 w 8363529"/>
                <a:gd name="connsiteY53" fmla="*/ 1148662 h 1338553"/>
                <a:gd name="connsiteX54" fmla="*/ 1505444 w 8363529"/>
                <a:gd name="connsiteY54" fmla="*/ 1141936 h 1338553"/>
                <a:gd name="connsiteX55" fmla="*/ 1513797 w 8363529"/>
                <a:gd name="connsiteY55" fmla="*/ 1142536 h 1338553"/>
                <a:gd name="connsiteX56" fmla="*/ 1580720 w 8363529"/>
                <a:gd name="connsiteY56" fmla="*/ 1148817 h 1338553"/>
                <a:gd name="connsiteX57" fmla="*/ 1589074 w 8363529"/>
                <a:gd name="connsiteY57" fmla="*/ 1149794 h 1338553"/>
                <a:gd name="connsiteX58" fmla="*/ 1597437 w 8363529"/>
                <a:gd name="connsiteY58" fmla="*/ 1132674 h 1338553"/>
                <a:gd name="connsiteX59" fmla="*/ 1664360 w 8363529"/>
                <a:gd name="connsiteY59" fmla="*/ 1041904 h 1338553"/>
                <a:gd name="connsiteX60" fmla="*/ 1672713 w 8363529"/>
                <a:gd name="connsiteY60" fmla="*/ 1034268 h 1338553"/>
                <a:gd name="connsiteX61" fmla="*/ 1681066 w 8363529"/>
                <a:gd name="connsiteY61" fmla="*/ 1044739 h 1338553"/>
                <a:gd name="connsiteX62" fmla="*/ 1747989 w 8363529"/>
                <a:gd name="connsiteY62" fmla="*/ 1145981 h 1338553"/>
                <a:gd name="connsiteX63" fmla="*/ 1756352 w 8363529"/>
                <a:gd name="connsiteY63" fmla="*/ 1161321 h 1338553"/>
                <a:gd name="connsiteX64" fmla="*/ 1764706 w 8363529"/>
                <a:gd name="connsiteY64" fmla="*/ 1161969 h 1338553"/>
                <a:gd name="connsiteX65" fmla="*/ 1831629 w 8363529"/>
                <a:gd name="connsiteY65" fmla="*/ 1167602 h 1338553"/>
                <a:gd name="connsiteX66" fmla="*/ 1839982 w 8363529"/>
                <a:gd name="connsiteY66" fmla="*/ 1168357 h 1338553"/>
                <a:gd name="connsiteX67" fmla="*/ 1848345 w 8363529"/>
                <a:gd name="connsiteY67" fmla="*/ 1165976 h 1338553"/>
                <a:gd name="connsiteX68" fmla="*/ 1915268 w 8363529"/>
                <a:gd name="connsiteY68" fmla="*/ 1146881 h 1338553"/>
                <a:gd name="connsiteX69" fmla="*/ 1923621 w 8363529"/>
                <a:gd name="connsiteY69" fmla="*/ 1144500 h 1338553"/>
                <a:gd name="connsiteX70" fmla="*/ 1931975 w 8363529"/>
                <a:gd name="connsiteY70" fmla="*/ 1132258 h 1338553"/>
                <a:gd name="connsiteX71" fmla="*/ 1998898 w 8363529"/>
                <a:gd name="connsiteY71" fmla="*/ 1056111 h 1338553"/>
                <a:gd name="connsiteX72" fmla="*/ 2007260 w 8363529"/>
                <a:gd name="connsiteY72" fmla="*/ 1048669 h 1338553"/>
                <a:gd name="connsiteX73" fmla="*/ 2015614 w 8363529"/>
                <a:gd name="connsiteY73" fmla="*/ 1003076 h 1338553"/>
                <a:gd name="connsiteX74" fmla="*/ 2082537 w 8363529"/>
                <a:gd name="connsiteY74" fmla="*/ 529270 h 1338553"/>
                <a:gd name="connsiteX75" fmla="*/ 2090890 w 8363529"/>
                <a:gd name="connsiteY75" fmla="*/ 451730 h 1338553"/>
                <a:gd name="connsiteX76" fmla="*/ 2099253 w 8363529"/>
                <a:gd name="connsiteY76" fmla="*/ 522544 h 1338553"/>
                <a:gd name="connsiteX77" fmla="*/ 2166176 w 8363529"/>
                <a:gd name="connsiteY77" fmla="*/ 1009957 h 1338553"/>
                <a:gd name="connsiteX78" fmla="*/ 2174530 w 8363529"/>
                <a:gd name="connsiteY78" fmla="*/ 1062470 h 1338553"/>
                <a:gd name="connsiteX79" fmla="*/ 2182883 w 8363529"/>
                <a:gd name="connsiteY79" fmla="*/ 1067909 h 1338553"/>
                <a:gd name="connsiteX80" fmla="*/ 2249806 w 8363529"/>
                <a:gd name="connsiteY80" fmla="*/ 1119550 h 1338553"/>
                <a:gd name="connsiteX81" fmla="*/ 2258159 w 8363529"/>
                <a:gd name="connsiteY81" fmla="*/ 1127264 h 1338553"/>
                <a:gd name="connsiteX82" fmla="*/ 2266522 w 8363529"/>
                <a:gd name="connsiteY82" fmla="*/ 1124167 h 1338553"/>
                <a:gd name="connsiteX83" fmla="*/ 2333445 w 8363529"/>
                <a:gd name="connsiteY83" fmla="*/ 1103940 h 1338553"/>
                <a:gd name="connsiteX84" fmla="*/ 2341799 w 8363529"/>
                <a:gd name="connsiteY84" fmla="*/ 1101859 h 1338553"/>
                <a:gd name="connsiteX85" fmla="*/ 2350152 w 8363529"/>
                <a:gd name="connsiteY85" fmla="*/ 1077925 h 1338553"/>
                <a:gd name="connsiteX86" fmla="*/ 2417075 w 8363529"/>
                <a:gd name="connsiteY86" fmla="*/ 896086 h 1338553"/>
                <a:gd name="connsiteX87" fmla="*/ 2425438 w 8363529"/>
                <a:gd name="connsiteY87" fmla="*/ 874504 h 1338553"/>
                <a:gd name="connsiteX88" fmla="*/ 2433791 w 8363529"/>
                <a:gd name="connsiteY88" fmla="*/ 906412 h 1338553"/>
                <a:gd name="connsiteX89" fmla="*/ 2500714 w 8363529"/>
                <a:gd name="connsiteY89" fmla="*/ 1147491 h 1338553"/>
                <a:gd name="connsiteX90" fmla="*/ 2509068 w 8363529"/>
                <a:gd name="connsiteY90" fmla="*/ 1175993 h 1338553"/>
                <a:gd name="connsiteX91" fmla="*/ 2517430 w 8363529"/>
                <a:gd name="connsiteY91" fmla="*/ 1171870 h 1338553"/>
                <a:gd name="connsiteX92" fmla="*/ 2584354 w 8363529"/>
                <a:gd name="connsiteY92" fmla="*/ 1133467 h 1338553"/>
                <a:gd name="connsiteX93" fmla="*/ 2592707 w 8363529"/>
                <a:gd name="connsiteY93" fmla="*/ 1127835 h 1338553"/>
                <a:gd name="connsiteX94" fmla="*/ 2601060 w 8363529"/>
                <a:gd name="connsiteY94" fmla="*/ 1137697 h 1338553"/>
                <a:gd name="connsiteX95" fmla="*/ 2667983 w 8363529"/>
                <a:gd name="connsiteY95" fmla="*/ 1217618 h 1338553"/>
                <a:gd name="connsiteX96" fmla="*/ 2676346 w 8363529"/>
                <a:gd name="connsiteY96" fmla="*/ 1227712 h 1338553"/>
                <a:gd name="connsiteX97" fmla="*/ 2684699 w 8363529"/>
                <a:gd name="connsiteY97" fmla="*/ 1220037 h 1338553"/>
                <a:gd name="connsiteX98" fmla="*/ 2751623 w 8363529"/>
                <a:gd name="connsiteY98" fmla="*/ 1147413 h 1338553"/>
                <a:gd name="connsiteX99" fmla="*/ 2759976 w 8363529"/>
                <a:gd name="connsiteY99" fmla="*/ 1136642 h 1338553"/>
                <a:gd name="connsiteX100" fmla="*/ 2768329 w 8363529"/>
                <a:gd name="connsiteY100" fmla="*/ 1116792 h 1338553"/>
                <a:gd name="connsiteX101" fmla="*/ 2835262 w 8363529"/>
                <a:gd name="connsiteY101" fmla="*/ 997559 h 1338553"/>
                <a:gd name="connsiteX102" fmla="*/ 2843615 w 8363529"/>
                <a:gd name="connsiteY102" fmla="*/ 986255 h 1338553"/>
                <a:gd name="connsiteX103" fmla="*/ 2851968 w 8363529"/>
                <a:gd name="connsiteY103" fmla="*/ 925274 h 1338553"/>
                <a:gd name="connsiteX104" fmla="*/ 2918892 w 8363529"/>
                <a:gd name="connsiteY104" fmla="*/ 423945 h 1338553"/>
                <a:gd name="connsiteX105" fmla="*/ 2927245 w 8363529"/>
                <a:gd name="connsiteY105" fmla="*/ 359528 h 1338553"/>
                <a:gd name="connsiteX106" fmla="*/ 2935608 w 8363529"/>
                <a:gd name="connsiteY106" fmla="*/ 432258 h 1338553"/>
                <a:gd name="connsiteX107" fmla="*/ 3002531 w 8363529"/>
                <a:gd name="connsiteY107" fmla="*/ 990601 h 1338553"/>
                <a:gd name="connsiteX108" fmla="*/ 3010884 w 8363529"/>
                <a:gd name="connsiteY108" fmla="*/ 1057553 h 1338553"/>
                <a:gd name="connsiteX109" fmla="*/ 3019238 w 8363529"/>
                <a:gd name="connsiteY109" fmla="*/ 1045678 h 1338553"/>
                <a:gd name="connsiteX110" fmla="*/ 3086161 w 8363529"/>
                <a:gd name="connsiteY110" fmla="*/ 925536 h 1338553"/>
                <a:gd name="connsiteX111" fmla="*/ 3094523 w 8363529"/>
                <a:gd name="connsiteY111" fmla="*/ 906451 h 1338553"/>
                <a:gd name="connsiteX112" fmla="*/ 3102877 w 8363529"/>
                <a:gd name="connsiteY112" fmla="*/ 867322 h 1338553"/>
                <a:gd name="connsiteX113" fmla="*/ 3169800 w 8363529"/>
                <a:gd name="connsiteY113" fmla="*/ 644274 h 1338553"/>
                <a:gd name="connsiteX114" fmla="*/ 3178153 w 8363529"/>
                <a:gd name="connsiteY114" fmla="*/ 624163 h 1338553"/>
                <a:gd name="connsiteX115" fmla="*/ 3186516 w 8363529"/>
                <a:gd name="connsiteY115" fmla="*/ 665972 h 1338553"/>
                <a:gd name="connsiteX116" fmla="*/ 3253439 w 8363529"/>
                <a:gd name="connsiteY116" fmla="*/ 1084313 h 1338553"/>
                <a:gd name="connsiteX117" fmla="*/ 3261792 w 8363529"/>
                <a:gd name="connsiteY117" fmla="*/ 1150094 h 1338553"/>
                <a:gd name="connsiteX118" fmla="*/ 3270146 w 8363529"/>
                <a:gd name="connsiteY118" fmla="*/ 1158146 h 1338553"/>
                <a:gd name="connsiteX119" fmla="*/ 3337069 w 8363529"/>
                <a:gd name="connsiteY119" fmla="*/ 1294664 h 1338553"/>
                <a:gd name="connsiteX120" fmla="*/ 3345432 w 8363529"/>
                <a:gd name="connsiteY120" fmla="*/ 1333637 h 1338553"/>
                <a:gd name="connsiteX121" fmla="*/ 3353785 w 8363529"/>
                <a:gd name="connsiteY121" fmla="*/ 1314097 h 1338553"/>
                <a:gd name="connsiteX122" fmla="*/ 3420708 w 8363529"/>
                <a:gd name="connsiteY122" fmla="*/ 1256668 h 1338553"/>
                <a:gd name="connsiteX123" fmla="*/ 3429061 w 8363529"/>
                <a:gd name="connsiteY123" fmla="*/ 1253755 h 1338553"/>
                <a:gd name="connsiteX124" fmla="*/ 3437424 w 8363529"/>
                <a:gd name="connsiteY124" fmla="*/ 1219205 h 1338553"/>
                <a:gd name="connsiteX125" fmla="*/ 3504347 w 8363529"/>
                <a:gd name="connsiteY125" fmla="*/ 902667 h 1338553"/>
                <a:gd name="connsiteX126" fmla="*/ 3512701 w 8363529"/>
                <a:gd name="connsiteY126" fmla="*/ 857267 h 1338553"/>
                <a:gd name="connsiteX127" fmla="*/ 3521054 w 8363529"/>
                <a:gd name="connsiteY127" fmla="*/ 829966 h 1338553"/>
                <a:gd name="connsiteX128" fmla="*/ 3587977 w 8363529"/>
                <a:gd name="connsiteY128" fmla="*/ 640828 h 1338553"/>
                <a:gd name="connsiteX129" fmla="*/ 3596330 w 8363529"/>
                <a:gd name="connsiteY129" fmla="*/ 620301 h 1338553"/>
                <a:gd name="connsiteX130" fmla="*/ 3604693 w 8363529"/>
                <a:gd name="connsiteY130" fmla="*/ 653303 h 1338553"/>
                <a:gd name="connsiteX131" fmla="*/ 3671616 w 8363529"/>
                <a:gd name="connsiteY131" fmla="*/ 1002853 h 1338553"/>
                <a:gd name="connsiteX132" fmla="*/ 3679970 w 8363529"/>
                <a:gd name="connsiteY132" fmla="*/ 1061144 h 1338553"/>
                <a:gd name="connsiteX133" fmla="*/ 3688323 w 8363529"/>
                <a:gd name="connsiteY133" fmla="*/ 1039029 h 1338553"/>
                <a:gd name="connsiteX134" fmla="*/ 3755246 w 8363529"/>
                <a:gd name="connsiteY134" fmla="*/ 883881 h 1338553"/>
                <a:gd name="connsiteX135" fmla="*/ 3763609 w 8363529"/>
                <a:gd name="connsiteY135" fmla="*/ 866829 h 1338553"/>
                <a:gd name="connsiteX136" fmla="*/ 3771962 w 8363529"/>
                <a:gd name="connsiteY136" fmla="*/ 888720 h 1338553"/>
                <a:gd name="connsiteX137" fmla="*/ 3838885 w 8363529"/>
                <a:gd name="connsiteY137" fmla="*/ 1080306 h 1338553"/>
                <a:gd name="connsiteX138" fmla="*/ 3847239 w 8363529"/>
                <a:gd name="connsiteY138" fmla="*/ 1106582 h 1338553"/>
                <a:gd name="connsiteX139" fmla="*/ 3855602 w 8363529"/>
                <a:gd name="connsiteY139" fmla="*/ 1111276 h 1338553"/>
                <a:gd name="connsiteX140" fmla="*/ 3922525 w 8363529"/>
                <a:gd name="connsiteY140" fmla="*/ 1144955 h 1338553"/>
                <a:gd name="connsiteX141" fmla="*/ 3930878 w 8363529"/>
                <a:gd name="connsiteY141" fmla="*/ 1148739 h 1338553"/>
                <a:gd name="connsiteX142" fmla="*/ 3939231 w 8363529"/>
                <a:gd name="connsiteY142" fmla="*/ 1130593 h 1338553"/>
                <a:gd name="connsiteX143" fmla="*/ 4006154 w 8363529"/>
                <a:gd name="connsiteY143" fmla="*/ 1002882 h 1338553"/>
                <a:gd name="connsiteX144" fmla="*/ 4014517 w 8363529"/>
                <a:gd name="connsiteY144" fmla="*/ 988820 h 1338553"/>
                <a:gd name="connsiteX145" fmla="*/ 4022871 w 8363529"/>
                <a:gd name="connsiteY145" fmla="*/ 1004586 h 1338553"/>
                <a:gd name="connsiteX146" fmla="*/ 4089755 w 8363529"/>
                <a:gd name="connsiteY146" fmla="*/ 1194594 h 1338553"/>
                <a:gd name="connsiteX147" fmla="*/ 4098147 w 8363529"/>
                <a:gd name="connsiteY147" fmla="*/ 1231080 h 1338553"/>
                <a:gd name="connsiteX148" fmla="*/ 4106500 w 8363529"/>
                <a:gd name="connsiteY148" fmla="*/ 1182835 h 1338553"/>
                <a:gd name="connsiteX149" fmla="*/ 4173394 w 8363529"/>
                <a:gd name="connsiteY149" fmla="*/ 936162 h 1338553"/>
                <a:gd name="connsiteX150" fmla="*/ 4181787 w 8363529"/>
                <a:gd name="connsiteY150" fmla="*/ 916012 h 1338553"/>
                <a:gd name="connsiteX151" fmla="*/ 4190140 w 8363529"/>
                <a:gd name="connsiteY151" fmla="*/ 944292 h 1338553"/>
                <a:gd name="connsiteX152" fmla="*/ 4257024 w 8363529"/>
                <a:gd name="connsiteY152" fmla="*/ 1226725 h 1338553"/>
                <a:gd name="connsiteX153" fmla="*/ 4265416 w 8363529"/>
                <a:gd name="connsiteY153" fmla="*/ 1271031 h 1338553"/>
                <a:gd name="connsiteX154" fmla="*/ 4273779 w 8363529"/>
                <a:gd name="connsiteY154" fmla="*/ 1133506 h 1338553"/>
                <a:gd name="connsiteX155" fmla="*/ 4340664 w 8363529"/>
                <a:gd name="connsiteY155" fmla="*/ 117346 h 1338553"/>
                <a:gd name="connsiteX156" fmla="*/ 4349055 w 8363529"/>
                <a:gd name="connsiteY156" fmla="*/ 0 h 1338553"/>
                <a:gd name="connsiteX157" fmla="*/ 4357409 w 8363529"/>
                <a:gd name="connsiteY157" fmla="*/ 116862 h 1338553"/>
                <a:gd name="connsiteX158" fmla="*/ 4424303 w 8363529"/>
                <a:gd name="connsiteY158" fmla="*/ 1043675 h 1338553"/>
                <a:gd name="connsiteX159" fmla="*/ 4432695 w 8363529"/>
                <a:gd name="connsiteY159" fmla="*/ 1158563 h 1338553"/>
                <a:gd name="connsiteX160" fmla="*/ 4441048 w 8363529"/>
                <a:gd name="connsiteY160" fmla="*/ 1142158 h 1338553"/>
                <a:gd name="connsiteX161" fmla="*/ 4507932 w 8363529"/>
                <a:gd name="connsiteY161" fmla="*/ 1003531 h 1338553"/>
                <a:gd name="connsiteX162" fmla="*/ 4516324 w 8363529"/>
                <a:gd name="connsiteY162" fmla="*/ 985191 h 1338553"/>
                <a:gd name="connsiteX163" fmla="*/ 4524687 w 8363529"/>
                <a:gd name="connsiteY163" fmla="*/ 1002089 h 1338553"/>
                <a:gd name="connsiteX164" fmla="*/ 4591572 w 8363529"/>
                <a:gd name="connsiteY164" fmla="*/ 1152669 h 1338553"/>
                <a:gd name="connsiteX165" fmla="*/ 4599964 w 8363529"/>
                <a:gd name="connsiteY165" fmla="*/ 1173650 h 1338553"/>
                <a:gd name="connsiteX166" fmla="*/ 4608317 w 8363529"/>
                <a:gd name="connsiteY166" fmla="*/ 1118379 h 1338553"/>
                <a:gd name="connsiteX167" fmla="*/ 4675201 w 8363529"/>
                <a:gd name="connsiteY167" fmla="*/ 685967 h 1338553"/>
                <a:gd name="connsiteX168" fmla="*/ 4683603 w 8363529"/>
                <a:gd name="connsiteY168" fmla="*/ 633115 h 1338553"/>
                <a:gd name="connsiteX169" fmla="*/ 4691956 w 8363529"/>
                <a:gd name="connsiteY169" fmla="*/ 670695 h 1338553"/>
                <a:gd name="connsiteX170" fmla="*/ 4758840 w 8363529"/>
                <a:gd name="connsiteY170" fmla="*/ 938804 h 1338553"/>
                <a:gd name="connsiteX171" fmla="*/ 4767232 w 8363529"/>
                <a:gd name="connsiteY171" fmla="*/ 968748 h 1338553"/>
                <a:gd name="connsiteX172" fmla="*/ 4775595 w 8363529"/>
                <a:gd name="connsiteY172" fmla="*/ 965990 h 1338553"/>
                <a:gd name="connsiteX173" fmla="*/ 4842480 w 8363529"/>
                <a:gd name="connsiteY173" fmla="*/ 937333 h 1338553"/>
                <a:gd name="connsiteX174" fmla="*/ 4850872 w 8363529"/>
                <a:gd name="connsiteY174" fmla="*/ 932610 h 1338553"/>
                <a:gd name="connsiteX175" fmla="*/ 4859225 w 8363529"/>
                <a:gd name="connsiteY175" fmla="*/ 959902 h 1338553"/>
                <a:gd name="connsiteX176" fmla="*/ 4926109 w 8363529"/>
                <a:gd name="connsiteY176" fmla="*/ 1102498 h 1338553"/>
                <a:gd name="connsiteX177" fmla="*/ 4934501 w 8363529"/>
                <a:gd name="connsiteY177" fmla="*/ 1114373 h 1338553"/>
                <a:gd name="connsiteX178" fmla="*/ 4942864 w 8363529"/>
                <a:gd name="connsiteY178" fmla="*/ 1120799 h 1338553"/>
                <a:gd name="connsiteX179" fmla="*/ 5009749 w 8363529"/>
                <a:gd name="connsiteY179" fmla="*/ 1178567 h 1338553"/>
                <a:gd name="connsiteX180" fmla="*/ 5018141 w 8363529"/>
                <a:gd name="connsiteY180" fmla="*/ 1186696 h 1338553"/>
                <a:gd name="connsiteX181" fmla="*/ 5026494 w 8363529"/>
                <a:gd name="connsiteY181" fmla="*/ 1186764 h 1338553"/>
                <a:gd name="connsiteX182" fmla="*/ 5093388 w 8363529"/>
                <a:gd name="connsiteY182" fmla="*/ 1187490 h 1338553"/>
                <a:gd name="connsiteX183" fmla="*/ 5101780 w 8363529"/>
                <a:gd name="connsiteY183" fmla="*/ 1187597 h 1338553"/>
                <a:gd name="connsiteX184" fmla="*/ 5110134 w 8363529"/>
                <a:gd name="connsiteY184" fmla="*/ 1148284 h 1338553"/>
                <a:gd name="connsiteX185" fmla="*/ 5177018 w 8363529"/>
                <a:gd name="connsiteY185" fmla="*/ 921035 h 1338553"/>
                <a:gd name="connsiteX186" fmla="*/ 5185410 w 8363529"/>
                <a:gd name="connsiteY186" fmla="*/ 900286 h 1338553"/>
                <a:gd name="connsiteX187" fmla="*/ 5193773 w 8363529"/>
                <a:gd name="connsiteY187" fmla="*/ 898428 h 1338553"/>
                <a:gd name="connsiteX188" fmla="*/ 5260657 w 8363529"/>
                <a:gd name="connsiteY188" fmla="*/ 882217 h 1338553"/>
                <a:gd name="connsiteX189" fmla="*/ 5269049 w 8363529"/>
                <a:gd name="connsiteY189" fmla="*/ 880020 h 1338553"/>
                <a:gd name="connsiteX190" fmla="*/ 5277403 w 8363529"/>
                <a:gd name="connsiteY190" fmla="*/ 900363 h 1338553"/>
                <a:gd name="connsiteX191" fmla="*/ 5344287 w 8363529"/>
                <a:gd name="connsiteY191" fmla="*/ 1088591 h 1338553"/>
                <a:gd name="connsiteX192" fmla="*/ 5352650 w 8363529"/>
                <a:gd name="connsiteY192" fmla="*/ 1115844 h 1338553"/>
                <a:gd name="connsiteX193" fmla="*/ 5361042 w 8363529"/>
                <a:gd name="connsiteY193" fmla="*/ 1112970 h 1338553"/>
                <a:gd name="connsiteX194" fmla="*/ 5427926 w 8363529"/>
                <a:gd name="connsiteY194" fmla="*/ 1055811 h 1338553"/>
                <a:gd name="connsiteX195" fmla="*/ 5436280 w 8363529"/>
                <a:gd name="connsiteY195" fmla="*/ 1036155 h 1338553"/>
                <a:gd name="connsiteX196" fmla="*/ 5444672 w 8363529"/>
                <a:gd name="connsiteY196" fmla="*/ 1071615 h 1338553"/>
                <a:gd name="connsiteX197" fmla="*/ 5511566 w 8363529"/>
                <a:gd name="connsiteY197" fmla="*/ 1188661 h 1338553"/>
                <a:gd name="connsiteX198" fmla="*/ 5519919 w 8363529"/>
                <a:gd name="connsiteY198" fmla="*/ 1195232 h 1338553"/>
                <a:gd name="connsiteX199" fmla="*/ 5528311 w 8363529"/>
                <a:gd name="connsiteY199" fmla="*/ 1198029 h 1338553"/>
                <a:gd name="connsiteX200" fmla="*/ 5595195 w 8363529"/>
                <a:gd name="connsiteY200" fmla="*/ 1213611 h 1338553"/>
                <a:gd name="connsiteX201" fmla="*/ 5603558 w 8363529"/>
                <a:gd name="connsiteY201" fmla="*/ 1214966 h 1338553"/>
                <a:gd name="connsiteX202" fmla="*/ 5611950 w 8363529"/>
                <a:gd name="connsiteY202" fmla="*/ 1114411 h 1338553"/>
                <a:gd name="connsiteX203" fmla="*/ 5678835 w 8363529"/>
                <a:gd name="connsiteY203" fmla="*/ 313741 h 1338553"/>
                <a:gd name="connsiteX204" fmla="*/ 5687188 w 8363529"/>
                <a:gd name="connsiteY204" fmla="*/ 214126 h 1338553"/>
                <a:gd name="connsiteX205" fmla="*/ 5695580 w 8363529"/>
                <a:gd name="connsiteY205" fmla="*/ 287882 h 1338553"/>
                <a:gd name="connsiteX206" fmla="*/ 5762474 w 8363529"/>
                <a:gd name="connsiteY206" fmla="*/ 1125522 h 1338553"/>
                <a:gd name="connsiteX207" fmla="*/ 5770827 w 8363529"/>
                <a:gd name="connsiteY207" fmla="*/ 1276286 h 1338553"/>
                <a:gd name="connsiteX208" fmla="*/ 5779219 w 8363529"/>
                <a:gd name="connsiteY208" fmla="*/ 1242945 h 1338553"/>
                <a:gd name="connsiteX209" fmla="*/ 5846103 w 8363529"/>
                <a:gd name="connsiteY209" fmla="*/ 1048475 h 1338553"/>
                <a:gd name="connsiteX210" fmla="*/ 5854457 w 8363529"/>
                <a:gd name="connsiteY210" fmla="*/ 1030523 h 1338553"/>
                <a:gd name="connsiteX211" fmla="*/ 5862858 w 8363529"/>
                <a:gd name="connsiteY211" fmla="*/ 1029874 h 1338553"/>
                <a:gd name="connsiteX212" fmla="*/ 5929743 w 8363529"/>
                <a:gd name="connsiteY212" fmla="*/ 1021067 h 1338553"/>
                <a:gd name="connsiteX213" fmla="*/ 5938096 w 8363529"/>
                <a:gd name="connsiteY213" fmla="*/ 1019219 h 1338553"/>
                <a:gd name="connsiteX214" fmla="*/ 5946488 w 8363529"/>
                <a:gd name="connsiteY214" fmla="*/ 1058047 h 1338553"/>
                <a:gd name="connsiteX215" fmla="*/ 6013372 w 8363529"/>
                <a:gd name="connsiteY215" fmla="*/ 1253755 h 1338553"/>
                <a:gd name="connsiteX216" fmla="*/ 6021735 w 8363529"/>
                <a:gd name="connsiteY216" fmla="*/ 1269521 h 1338553"/>
                <a:gd name="connsiteX217" fmla="*/ 6030127 w 8363529"/>
                <a:gd name="connsiteY217" fmla="*/ 1256068 h 1338553"/>
                <a:gd name="connsiteX218" fmla="*/ 6097011 w 8363529"/>
                <a:gd name="connsiteY218" fmla="*/ 1134106 h 1338553"/>
                <a:gd name="connsiteX219" fmla="*/ 6105365 w 8363529"/>
                <a:gd name="connsiteY219" fmla="*/ 1116754 h 1338553"/>
                <a:gd name="connsiteX220" fmla="*/ 6113767 w 8363529"/>
                <a:gd name="connsiteY220" fmla="*/ 1121854 h 1338553"/>
                <a:gd name="connsiteX221" fmla="*/ 6180651 w 8363529"/>
                <a:gd name="connsiteY221" fmla="*/ 1156869 h 1338553"/>
                <a:gd name="connsiteX222" fmla="*/ 6189004 w 8363529"/>
                <a:gd name="connsiteY222" fmla="*/ 1160643 h 1338553"/>
                <a:gd name="connsiteX223" fmla="*/ 6197396 w 8363529"/>
                <a:gd name="connsiteY223" fmla="*/ 1153578 h 1338553"/>
                <a:gd name="connsiteX224" fmla="*/ 6264280 w 8363529"/>
                <a:gd name="connsiteY224" fmla="*/ 1081409 h 1338553"/>
                <a:gd name="connsiteX225" fmla="*/ 6272644 w 8363529"/>
                <a:gd name="connsiteY225" fmla="*/ 1069796 h 1338553"/>
                <a:gd name="connsiteX226" fmla="*/ 6281036 w 8363529"/>
                <a:gd name="connsiteY226" fmla="*/ 1081032 h 1338553"/>
                <a:gd name="connsiteX227" fmla="*/ 6347920 w 8363529"/>
                <a:gd name="connsiteY227" fmla="*/ 1157207 h 1338553"/>
                <a:gd name="connsiteX228" fmla="*/ 6356273 w 8363529"/>
                <a:gd name="connsiteY228" fmla="*/ 1165298 h 1338553"/>
                <a:gd name="connsiteX229" fmla="*/ 6364665 w 8363529"/>
                <a:gd name="connsiteY229" fmla="*/ 1167031 h 1338553"/>
                <a:gd name="connsiteX230" fmla="*/ 6431560 w 8363529"/>
                <a:gd name="connsiteY230" fmla="*/ 1179622 h 1338553"/>
                <a:gd name="connsiteX231" fmla="*/ 6439913 w 8363529"/>
                <a:gd name="connsiteY231" fmla="*/ 1181064 h 1338553"/>
                <a:gd name="connsiteX232" fmla="*/ 6448305 w 8363529"/>
                <a:gd name="connsiteY232" fmla="*/ 1177812 h 1338553"/>
                <a:gd name="connsiteX233" fmla="*/ 6515189 w 8363529"/>
                <a:gd name="connsiteY233" fmla="*/ 1148546 h 1338553"/>
                <a:gd name="connsiteX234" fmla="*/ 6523542 w 8363529"/>
                <a:gd name="connsiteY234" fmla="*/ 1144423 h 1338553"/>
                <a:gd name="connsiteX235" fmla="*/ 6531944 w 8363529"/>
                <a:gd name="connsiteY235" fmla="*/ 1153162 h 1338553"/>
                <a:gd name="connsiteX236" fmla="*/ 6598829 w 8363529"/>
                <a:gd name="connsiteY236" fmla="*/ 1230964 h 1338553"/>
                <a:gd name="connsiteX237" fmla="*/ 6607182 w 8363529"/>
                <a:gd name="connsiteY237" fmla="*/ 1241851 h 1338553"/>
                <a:gd name="connsiteX238" fmla="*/ 6615535 w 8363529"/>
                <a:gd name="connsiteY238" fmla="*/ 1229260 h 1338553"/>
                <a:gd name="connsiteX239" fmla="*/ 6682458 w 8363529"/>
                <a:gd name="connsiteY239" fmla="*/ 1159095 h 1338553"/>
                <a:gd name="connsiteX240" fmla="*/ 6690821 w 8363529"/>
                <a:gd name="connsiteY240" fmla="*/ 1152891 h 1338553"/>
                <a:gd name="connsiteX241" fmla="*/ 6699174 w 8363529"/>
                <a:gd name="connsiteY241" fmla="*/ 1133351 h 1338553"/>
                <a:gd name="connsiteX242" fmla="*/ 6766097 w 8363529"/>
                <a:gd name="connsiteY242" fmla="*/ 937788 h 1338553"/>
                <a:gd name="connsiteX243" fmla="*/ 6774451 w 8363529"/>
                <a:gd name="connsiteY243" fmla="*/ 907012 h 1338553"/>
                <a:gd name="connsiteX244" fmla="*/ 6782814 w 8363529"/>
                <a:gd name="connsiteY244" fmla="*/ 941717 h 1338553"/>
                <a:gd name="connsiteX245" fmla="*/ 6849737 w 8363529"/>
                <a:gd name="connsiteY245" fmla="*/ 1264720 h 1338553"/>
                <a:gd name="connsiteX246" fmla="*/ 6858090 w 8363529"/>
                <a:gd name="connsiteY246" fmla="*/ 1311785 h 1338553"/>
                <a:gd name="connsiteX247" fmla="*/ 6866443 w 8363529"/>
                <a:gd name="connsiteY247" fmla="*/ 1262794 h 1338553"/>
                <a:gd name="connsiteX248" fmla="*/ 6933366 w 8363529"/>
                <a:gd name="connsiteY248" fmla="*/ 998769 h 1338553"/>
                <a:gd name="connsiteX249" fmla="*/ 6941729 w 8363529"/>
                <a:gd name="connsiteY249" fmla="*/ 976161 h 1338553"/>
                <a:gd name="connsiteX250" fmla="*/ 6950083 w 8363529"/>
                <a:gd name="connsiteY250" fmla="*/ 1002321 h 1338553"/>
                <a:gd name="connsiteX251" fmla="*/ 7017006 w 8363529"/>
                <a:gd name="connsiteY251" fmla="*/ 1257007 h 1338553"/>
                <a:gd name="connsiteX252" fmla="*/ 7025359 w 8363529"/>
                <a:gd name="connsiteY252" fmla="*/ 1295951 h 1338553"/>
                <a:gd name="connsiteX253" fmla="*/ 7033712 w 8363529"/>
                <a:gd name="connsiteY253" fmla="*/ 1288799 h 1338553"/>
                <a:gd name="connsiteX254" fmla="*/ 7100645 w 8363529"/>
                <a:gd name="connsiteY254" fmla="*/ 1227750 h 1338553"/>
                <a:gd name="connsiteX255" fmla="*/ 7108998 w 8363529"/>
                <a:gd name="connsiteY255" fmla="*/ 1219582 h 1338553"/>
                <a:gd name="connsiteX256" fmla="*/ 7117351 w 8363529"/>
                <a:gd name="connsiteY256" fmla="*/ 1224537 h 1338553"/>
                <a:gd name="connsiteX257" fmla="*/ 7184274 w 8363529"/>
                <a:gd name="connsiteY257" fmla="*/ 1265814 h 1338553"/>
                <a:gd name="connsiteX258" fmla="*/ 7192628 w 8363529"/>
                <a:gd name="connsiteY258" fmla="*/ 1271185 h 1338553"/>
                <a:gd name="connsiteX259" fmla="*/ 7200991 w 8363529"/>
                <a:gd name="connsiteY259" fmla="*/ 1260298 h 1338553"/>
                <a:gd name="connsiteX260" fmla="*/ 7267914 w 8363529"/>
                <a:gd name="connsiteY260" fmla="*/ 1179854 h 1338553"/>
                <a:gd name="connsiteX261" fmla="*/ 7276267 w 8363529"/>
                <a:gd name="connsiteY261" fmla="*/ 1170553 h 1338553"/>
                <a:gd name="connsiteX262" fmla="*/ 7284620 w 8363529"/>
                <a:gd name="connsiteY262" fmla="*/ 1173728 h 1338553"/>
                <a:gd name="connsiteX263" fmla="*/ 7351543 w 8363529"/>
                <a:gd name="connsiteY263" fmla="*/ 1200420 h 1338553"/>
                <a:gd name="connsiteX264" fmla="*/ 7359906 w 8363529"/>
                <a:gd name="connsiteY264" fmla="*/ 1203933 h 1338553"/>
                <a:gd name="connsiteX265" fmla="*/ 7368260 w 8363529"/>
                <a:gd name="connsiteY265" fmla="*/ 1136603 h 1338553"/>
                <a:gd name="connsiteX266" fmla="*/ 7435183 w 8363529"/>
                <a:gd name="connsiteY266" fmla="*/ 687331 h 1338553"/>
                <a:gd name="connsiteX267" fmla="*/ 7443536 w 8363529"/>
                <a:gd name="connsiteY267" fmla="*/ 640306 h 1338553"/>
                <a:gd name="connsiteX268" fmla="*/ 7451899 w 8363529"/>
                <a:gd name="connsiteY268" fmla="*/ 658713 h 1338553"/>
                <a:gd name="connsiteX269" fmla="*/ 7518822 w 8363529"/>
                <a:gd name="connsiteY269" fmla="*/ 835908 h 1338553"/>
                <a:gd name="connsiteX270" fmla="*/ 7527175 w 8363529"/>
                <a:gd name="connsiteY270" fmla="*/ 862629 h 1338553"/>
                <a:gd name="connsiteX271" fmla="*/ 7535528 w 8363529"/>
                <a:gd name="connsiteY271" fmla="*/ 914348 h 1338553"/>
                <a:gd name="connsiteX272" fmla="*/ 7602452 w 8363529"/>
                <a:gd name="connsiteY272" fmla="*/ 1261014 h 1338553"/>
                <a:gd name="connsiteX273" fmla="*/ 7610815 w 8363529"/>
                <a:gd name="connsiteY273" fmla="*/ 1297461 h 1338553"/>
                <a:gd name="connsiteX274" fmla="*/ 7619168 w 8363529"/>
                <a:gd name="connsiteY274" fmla="*/ 1281541 h 1338553"/>
                <a:gd name="connsiteX275" fmla="*/ 7686091 w 8363529"/>
                <a:gd name="connsiteY275" fmla="*/ 1143329 h 1338553"/>
                <a:gd name="connsiteX276" fmla="*/ 7694444 w 8363529"/>
                <a:gd name="connsiteY276" fmla="*/ 1124544 h 1338553"/>
                <a:gd name="connsiteX277" fmla="*/ 7702798 w 8363529"/>
                <a:gd name="connsiteY277" fmla="*/ 1074219 h 1338553"/>
                <a:gd name="connsiteX278" fmla="*/ 7769731 w 8363529"/>
                <a:gd name="connsiteY278" fmla="*/ 577921 h 1338553"/>
                <a:gd name="connsiteX279" fmla="*/ 7778084 w 8363529"/>
                <a:gd name="connsiteY279" fmla="*/ 501068 h 1338553"/>
                <a:gd name="connsiteX280" fmla="*/ 7786437 w 8363529"/>
                <a:gd name="connsiteY280" fmla="*/ 621927 h 1338553"/>
                <a:gd name="connsiteX281" fmla="*/ 7853360 w 8363529"/>
                <a:gd name="connsiteY281" fmla="*/ 1212740 h 1338553"/>
                <a:gd name="connsiteX282" fmla="*/ 7861713 w 8363529"/>
                <a:gd name="connsiteY282" fmla="*/ 1259049 h 1338553"/>
                <a:gd name="connsiteX283" fmla="*/ 7870077 w 8363529"/>
                <a:gd name="connsiteY283" fmla="*/ 1224644 h 1338553"/>
                <a:gd name="connsiteX284" fmla="*/ 7937000 w 8363529"/>
                <a:gd name="connsiteY284" fmla="*/ 839266 h 1338553"/>
                <a:gd name="connsiteX285" fmla="*/ 7945353 w 8363529"/>
                <a:gd name="connsiteY285" fmla="*/ 770920 h 1338553"/>
                <a:gd name="connsiteX286" fmla="*/ 7953706 w 8363529"/>
                <a:gd name="connsiteY286" fmla="*/ 808345 h 1338553"/>
                <a:gd name="connsiteX287" fmla="*/ 8020629 w 8363529"/>
                <a:gd name="connsiteY287" fmla="*/ 1093846 h 1338553"/>
                <a:gd name="connsiteX288" fmla="*/ 8028992 w 8363529"/>
                <a:gd name="connsiteY288" fmla="*/ 1127903 h 1338553"/>
                <a:gd name="connsiteX289" fmla="*/ 8037346 w 8363529"/>
                <a:gd name="connsiteY289" fmla="*/ 1137474 h 1338553"/>
                <a:gd name="connsiteX290" fmla="*/ 8104268 w 8363529"/>
                <a:gd name="connsiteY290" fmla="*/ 1225215 h 1338553"/>
                <a:gd name="connsiteX291" fmla="*/ 8112622 w 8363529"/>
                <a:gd name="connsiteY291" fmla="*/ 1237845 h 1338553"/>
                <a:gd name="connsiteX292" fmla="*/ 8120985 w 8363529"/>
                <a:gd name="connsiteY292" fmla="*/ 1216176 h 1338553"/>
                <a:gd name="connsiteX293" fmla="*/ 8187908 w 8363529"/>
                <a:gd name="connsiteY293" fmla="*/ 1101520 h 1338553"/>
                <a:gd name="connsiteX294" fmla="*/ 8196261 w 8363529"/>
                <a:gd name="connsiteY294" fmla="*/ 1091881 h 1338553"/>
                <a:gd name="connsiteX295" fmla="*/ 8204614 w 8363529"/>
                <a:gd name="connsiteY295" fmla="*/ 1045078 h 1338553"/>
                <a:gd name="connsiteX296" fmla="*/ 8271537 w 8363529"/>
                <a:gd name="connsiteY296" fmla="*/ 557472 h 1338553"/>
                <a:gd name="connsiteX297" fmla="*/ 8279900 w 8363529"/>
                <a:gd name="connsiteY297" fmla="*/ 477435 h 1338553"/>
                <a:gd name="connsiteX298" fmla="*/ 8288254 w 8363529"/>
                <a:gd name="connsiteY298" fmla="*/ 545074 h 1338553"/>
                <a:gd name="connsiteX299" fmla="*/ 8355177 w 8363529"/>
                <a:gd name="connsiteY299" fmla="*/ 1091542 h 1338553"/>
                <a:gd name="connsiteX300" fmla="*/ 8363530 w 8363529"/>
                <a:gd name="connsiteY300" fmla="*/ 1160527 h 1338553"/>
                <a:gd name="connsiteX301" fmla="*/ 8363530 w 8363529"/>
                <a:gd name="connsiteY301" fmla="*/ 1263017 h 1338553"/>
                <a:gd name="connsiteX302" fmla="*/ 8355177 w 8363529"/>
                <a:gd name="connsiteY302" fmla="*/ 1198716 h 1338553"/>
                <a:gd name="connsiteX303" fmla="*/ 8288254 w 8363529"/>
                <a:gd name="connsiteY303" fmla="*/ 689635 h 1338553"/>
                <a:gd name="connsiteX304" fmla="*/ 8279900 w 8363529"/>
                <a:gd name="connsiteY304" fmla="*/ 626650 h 1338553"/>
                <a:gd name="connsiteX305" fmla="*/ 8271537 w 8363529"/>
                <a:gd name="connsiteY305" fmla="*/ 718630 h 1338553"/>
                <a:gd name="connsiteX306" fmla="*/ 8204614 w 8363529"/>
                <a:gd name="connsiteY306" fmla="*/ 1279276 h 1338553"/>
                <a:gd name="connsiteX307" fmla="*/ 8196261 w 8363529"/>
                <a:gd name="connsiteY307" fmla="*/ 1333105 h 1338553"/>
                <a:gd name="connsiteX308" fmla="*/ 8187908 w 8363529"/>
                <a:gd name="connsiteY308" fmla="*/ 1327211 h 1338553"/>
                <a:gd name="connsiteX309" fmla="*/ 8120985 w 8363529"/>
                <a:gd name="connsiteY309" fmla="*/ 1257539 h 1338553"/>
                <a:gd name="connsiteX310" fmla="*/ 8112622 w 8363529"/>
                <a:gd name="connsiteY310" fmla="*/ 1244348 h 1338553"/>
                <a:gd name="connsiteX311" fmla="*/ 8104268 w 8363529"/>
                <a:gd name="connsiteY311" fmla="*/ 1243739 h 1338553"/>
                <a:gd name="connsiteX312" fmla="*/ 8037346 w 8363529"/>
                <a:gd name="connsiteY312" fmla="*/ 1239432 h 1338553"/>
                <a:gd name="connsiteX313" fmla="*/ 8028992 w 8363529"/>
                <a:gd name="connsiteY313" fmla="*/ 1238938 h 1338553"/>
                <a:gd name="connsiteX314" fmla="*/ 8020629 w 8363529"/>
                <a:gd name="connsiteY314" fmla="*/ 1211724 h 1338553"/>
                <a:gd name="connsiteX315" fmla="*/ 7953706 w 8363529"/>
                <a:gd name="connsiteY315" fmla="*/ 983458 h 1338553"/>
                <a:gd name="connsiteX316" fmla="*/ 7945353 w 8363529"/>
                <a:gd name="connsiteY316" fmla="*/ 953553 h 1338553"/>
                <a:gd name="connsiteX317" fmla="*/ 7937000 w 8363529"/>
                <a:gd name="connsiteY317" fmla="*/ 1000918 h 1338553"/>
                <a:gd name="connsiteX318" fmla="*/ 7870077 w 8363529"/>
                <a:gd name="connsiteY318" fmla="*/ 1268127 h 1338553"/>
                <a:gd name="connsiteX319" fmla="*/ 7861713 w 8363529"/>
                <a:gd name="connsiteY319" fmla="*/ 1291974 h 1338553"/>
                <a:gd name="connsiteX320" fmla="*/ 7853360 w 8363529"/>
                <a:gd name="connsiteY320" fmla="*/ 1249332 h 1338553"/>
                <a:gd name="connsiteX321" fmla="*/ 7786437 w 8363529"/>
                <a:gd name="connsiteY321" fmla="*/ 705255 h 1338553"/>
                <a:gd name="connsiteX322" fmla="*/ 7778084 w 8363529"/>
                <a:gd name="connsiteY322" fmla="*/ 593919 h 1338553"/>
                <a:gd name="connsiteX323" fmla="*/ 7769731 w 8363529"/>
                <a:gd name="connsiteY323" fmla="*/ 678708 h 1338553"/>
                <a:gd name="connsiteX324" fmla="*/ 7702798 w 8363529"/>
                <a:gd name="connsiteY324" fmla="*/ 1226309 h 1338553"/>
                <a:gd name="connsiteX325" fmla="*/ 7694444 w 8363529"/>
                <a:gd name="connsiteY325" fmla="*/ 1281850 h 1338553"/>
                <a:gd name="connsiteX326" fmla="*/ 7686091 w 8363529"/>
                <a:gd name="connsiteY326" fmla="*/ 1285247 h 1338553"/>
                <a:gd name="connsiteX327" fmla="*/ 7619168 w 8363529"/>
                <a:gd name="connsiteY327" fmla="*/ 1310197 h 1338553"/>
                <a:gd name="connsiteX328" fmla="*/ 7610815 w 8363529"/>
                <a:gd name="connsiteY328" fmla="*/ 1313072 h 1338553"/>
                <a:gd name="connsiteX329" fmla="*/ 7602452 w 8363529"/>
                <a:gd name="connsiteY329" fmla="*/ 1283321 h 1338553"/>
                <a:gd name="connsiteX330" fmla="*/ 7535528 w 8363529"/>
                <a:gd name="connsiteY330" fmla="*/ 1000240 h 1338553"/>
                <a:gd name="connsiteX331" fmla="*/ 7527175 w 8363529"/>
                <a:gd name="connsiteY331" fmla="*/ 958015 h 1338553"/>
                <a:gd name="connsiteX332" fmla="*/ 7518822 w 8363529"/>
                <a:gd name="connsiteY332" fmla="*/ 933927 h 1338553"/>
                <a:gd name="connsiteX333" fmla="*/ 7451899 w 8363529"/>
                <a:gd name="connsiteY333" fmla="*/ 774317 h 1338553"/>
                <a:gd name="connsiteX334" fmla="*/ 7443536 w 8363529"/>
                <a:gd name="connsiteY334" fmla="*/ 757719 h 1338553"/>
                <a:gd name="connsiteX335" fmla="*/ 7435183 w 8363529"/>
                <a:gd name="connsiteY335" fmla="*/ 803312 h 1338553"/>
                <a:gd name="connsiteX336" fmla="*/ 7368260 w 8363529"/>
                <a:gd name="connsiteY336" fmla="*/ 1238677 h 1338553"/>
                <a:gd name="connsiteX337" fmla="*/ 7359906 w 8363529"/>
                <a:gd name="connsiteY337" fmla="*/ 1303887 h 1338553"/>
                <a:gd name="connsiteX338" fmla="*/ 7351543 w 8363529"/>
                <a:gd name="connsiteY338" fmla="*/ 1300829 h 1338553"/>
                <a:gd name="connsiteX339" fmla="*/ 7284620 w 8363529"/>
                <a:gd name="connsiteY339" fmla="*/ 1277689 h 1338553"/>
                <a:gd name="connsiteX340" fmla="*/ 7276267 w 8363529"/>
                <a:gd name="connsiteY340" fmla="*/ 1274969 h 1338553"/>
                <a:gd name="connsiteX341" fmla="*/ 7267914 w 8363529"/>
                <a:gd name="connsiteY341" fmla="*/ 1277989 h 1338553"/>
                <a:gd name="connsiteX342" fmla="*/ 7200991 w 8363529"/>
                <a:gd name="connsiteY342" fmla="*/ 1304187 h 1338553"/>
                <a:gd name="connsiteX343" fmla="*/ 7192628 w 8363529"/>
                <a:gd name="connsiteY343" fmla="*/ 1307739 h 1338553"/>
                <a:gd name="connsiteX344" fmla="*/ 7184274 w 8363529"/>
                <a:gd name="connsiteY344" fmla="*/ 1305968 h 1338553"/>
                <a:gd name="connsiteX345" fmla="*/ 7117351 w 8363529"/>
                <a:gd name="connsiteY345" fmla="*/ 1292283 h 1338553"/>
                <a:gd name="connsiteX346" fmla="*/ 7108998 w 8363529"/>
                <a:gd name="connsiteY346" fmla="*/ 1290619 h 1338553"/>
                <a:gd name="connsiteX347" fmla="*/ 7100645 w 8363529"/>
                <a:gd name="connsiteY347" fmla="*/ 1294587 h 1338553"/>
                <a:gd name="connsiteX348" fmla="*/ 7033712 w 8363529"/>
                <a:gd name="connsiteY348" fmla="*/ 1324192 h 1338553"/>
                <a:gd name="connsiteX349" fmla="*/ 7025359 w 8363529"/>
                <a:gd name="connsiteY349" fmla="*/ 1327666 h 1338553"/>
                <a:gd name="connsiteX350" fmla="*/ 7017006 w 8363529"/>
                <a:gd name="connsiteY350" fmla="*/ 1322788 h 1338553"/>
                <a:gd name="connsiteX351" fmla="*/ 6950083 w 8363529"/>
                <a:gd name="connsiteY351" fmla="*/ 1291112 h 1338553"/>
                <a:gd name="connsiteX352" fmla="*/ 6941729 w 8363529"/>
                <a:gd name="connsiteY352" fmla="*/ 1287860 h 1338553"/>
                <a:gd name="connsiteX353" fmla="*/ 6933366 w 8363529"/>
                <a:gd name="connsiteY353" fmla="*/ 1290280 h 1338553"/>
                <a:gd name="connsiteX354" fmla="*/ 6866443 w 8363529"/>
                <a:gd name="connsiteY354" fmla="*/ 1318327 h 1338553"/>
                <a:gd name="connsiteX355" fmla="*/ 6858090 w 8363529"/>
                <a:gd name="connsiteY355" fmla="*/ 1323543 h 1338553"/>
                <a:gd name="connsiteX356" fmla="*/ 6849737 w 8363529"/>
                <a:gd name="connsiteY356" fmla="*/ 1305852 h 1338553"/>
                <a:gd name="connsiteX357" fmla="*/ 6782814 w 8363529"/>
                <a:gd name="connsiteY357" fmla="*/ 1184345 h 1338553"/>
                <a:gd name="connsiteX358" fmla="*/ 6774451 w 8363529"/>
                <a:gd name="connsiteY358" fmla="*/ 1171270 h 1338553"/>
                <a:gd name="connsiteX359" fmla="*/ 6766097 w 8363529"/>
                <a:gd name="connsiteY359" fmla="*/ 1191264 h 1338553"/>
                <a:gd name="connsiteX360" fmla="*/ 6699174 w 8363529"/>
                <a:gd name="connsiteY360" fmla="*/ 1318143 h 1338553"/>
                <a:gd name="connsiteX361" fmla="*/ 6690821 w 8363529"/>
                <a:gd name="connsiteY361" fmla="*/ 1330802 h 1338553"/>
                <a:gd name="connsiteX362" fmla="*/ 6682458 w 8363529"/>
                <a:gd name="connsiteY362" fmla="*/ 1324869 h 1338553"/>
                <a:gd name="connsiteX363" fmla="*/ 6615535 w 8363529"/>
                <a:gd name="connsiteY363" fmla="*/ 1257839 h 1338553"/>
                <a:gd name="connsiteX364" fmla="*/ 6607182 w 8363529"/>
                <a:gd name="connsiteY364" fmla="*/ 1245819 h 1338553"/>
                <a:gd name="connsiteX365" fmla="*/ 6598829 w 8363529"/>
                <a:gd name="connsiteY365" fmla="*/ 1255420 h 1338553"/>
                <a:gd name="connsiteX366" fmla="*/ 6531944 w 8363529"/>
                <a:gd name="connsiteY366" fmla="*/ 1324192 h 1338553"/>
                <a:gd name="connsiteX367" fmla="*/ 6523542 w 8363529"/>
                <a:gd name="connsiteY367" fmla="*/ 1331905 h 1338553"/>
                <a:gd name="connsiteX368" fmla="*/ 6515189 w 8363529"/>
                <a:gd name="connsiteY368" fmla="*/ 1327027 h 1338553"/>
                <a:gd name="connsiteX369" fmla="*/ 6448305 w 8363529"/>
                <a:gd name="connsiteY369" fmla="*/ 1292506 h 1338553"/>
                <a:gd name="connsiteX370" fmla="*/ 6439913 w 8363529"/>
                <a:gd name="connsiteY370" fmla="*/ 1288693 h 1338553"/>
                <a:gd name="connsiteX371" fmla="*/ 6431560 w 8363529"/>
                <a:gd name="connsiteY371" fmla="*/ 1286796 h 1338553"/>
                <a:gd name="connsiteX372" fmla="*/ 6364665 w 8363529"/>
                <a:gd name="connsiteY372" fmla="*/ 1270508 h 1338553"/>
                <a:gd name="connsiteX373" fmla="*/ 6356273 w 8363529"/>
                <a:gd name="connsiteY373" fmla="*/ 1268311 h 1338553"/>
                <a:gd name="connsiteX374" fmla="*/ 6347920 w 8363529"/>
                <a:gd name="connsiteY374" fmla="*/ 1262417 h 1338553"/>
                <a:gd name="connsiteX375" fmla="*/ 6281036 w 8363529"/>
                <a:gd name="connsiteY375" fmla="*/ 1207223 h 1338553"/>
                <a:gd name="connsiteX376" fmla="*/ 6272644 w 8363529"/>
                <a:gd name="connsiteY376" fmla="*/ 1199133 h 1338553"/>
                <a:gd name="connsiteX377" fmla="*/ 6264280 w 8363529"/>
                <a:gd name="connsiteY377" fmla="*/ 1202152 h 1338553"/>
                <a:gd name="connsiteX378" fmla="*/ 6197396 w 8363529"/>
                <a:gd name="connsiteY378" fmla="*/ 1221208 h 1338553"/>
                <a:gd name="connsiteX379" fmla="*/ 6189004 w 8363529"/>
                <a:gd name="connsiteY379" fmla="*/ 1223057 h 1338553"/>
                <a:gd name="connsiteX380" fmla="*/ 6180651 w 8363529"/>
                <a:gd name="connsiteY380" fmla="*/ 1213911 h 1338553"/>
                <a:gd name="connsiteX381" fmla="*/ 6113767 w 8363529"/>
                <a:gd name="connsiteY381" fmla="*/ 1129074 h 1338553"/>
                <a:gd name="connsiteX382" fmla="*/ 6105365 w 8363529"/>
                <a:gd name="connsiteY382" fmla="*/ 1116754 h 1338553"/>
                <a:gd name="connsiteX383" fmla="*/ 6097011 w 8363529"/>
                <a:gd name="connsiteY383" fmla="*/ 1138606 h 1338553"/>
                <a:gd name="connsiteX384" fmla="*/ 6030127 w 8363529"/>
                <a:gd name="connsiteY384" fmla="*/ 1292467 h 1338553"/>
                <a:gd name="connsiteX385" fmla="*/ 6021735 w 8363529"/>
                <a:gd name="connsiteY385" fmla="*/ 1309442 h 1338553"/>
                <a:gd name="connsiteX386" fmla="*/ 6013372 w 8363529"/>
                <a:gd name="connsiteY386" fmla="*/ 1303132 h 1338553"/>
                <a:gd name="connsiteX387" fmla="*/ 5946488 w 8363529"/>
                <a:gd name="connsiteY387" fmla="*/ 1225060 h 1338553"/>
                <a:gd name="connsiteX388" fmla="*/ 5938096 w 8363529"/>
                <a:gd name="connsiteY388" fmla="*/ 1209565 h 1338553"/>
                <a:gd name="connsiteX389" fmla="*/ 5929743 w 8363529"/>
                <a:gd name="connsiteY389" fmla="*/ 1222989 h 1338553"/>
                <a:gd name="connsiteX390" fmla="*/ 5862858 w 8363529"/>
                <a:gd name="connsiteY390" fmla="*/ 1286873 h 1338553"/>
                <a:gd name="connsiteX391" fmla="*/ 5854457 w 8363529"/>
                <a:gd name="connsiteY391" fmla="*/ 1291790 h 1338553"/>
                <a:gd name="connsiteX392" fmla="*/ 5846103 w 8363529"/>
                <a:gd name="connsiteY392" fmla="*/ 1291258 h 1338553"/>
                <a:gd name="connsiteX393" fmla="*/ 5779219 w 8363529"/>
                <a:gd name="connsiteY393" fmla="*/ 1285625 h 1338553"/>
                <a:gd name="connsiteX394" fmla="*/ 5770827 w 8363529"/>
                <a:gd name="connsiteY394" fmla="*/ 1284686 h 1338553"/>
                <a:gd name="connsiteX395" fmla="*/ 5762474 w 8363529"/>
                <a:gd name="connsiteY395" fmla="*/ 1162501 h 1338553"/>
                <a:gd name="connsiteX396" fmla="*/ 5695580 w 8363529"/>
                <a:gd name="connsiteY396" fmla="*/ 483638 h 1338553"/>
                <a:gd name="connsiteX397" fmla="*/ 5687188 w 8363529"/>
                <a:gd name="connsiteY397" fmla="*/ 423828 h 1338553"/>
                <a:gd name="connsiteX398" fmla="*/ 5678835 w 8363529"/>
                <a:gd name="connsiteY398" fmla="*/ 514908 h 1338553"/>
                <a:gd name="connsiteX399" fmla="*/ 5611950 w 8363529"/>
                <a:gd name="connsiteY399" fmla="*/ 1246652 h 1338553"/>
                <a:gd name="connsiteX400" fmla="*/ 5603558 w 8363529"/>
                <a:gd name="connsiteY400" fmla="*/ 1338554 h 1338553"/>
                <a:gd name="connsiteX401" fmla="*/ 5595195 w 8363529"/>
                <a:gd name="connsiteY401" fmla="*/ 1328992 h 1338553"/>
                <a:gd name="connsiteX402" fmla="*/ 5528311 w 8363529"/>
                <a:gd name="connsiteY402" fmla="*/ 1220337 h 1338553"/>
                <a:gd name="connsiteX403" fmla="*/ 5519919 w 8363529"/>
                <a:gd name="connsiteY403" fmla="*/ 1200720 h 1338553"/>
                <a:gd name="connsiteX404" fmla="*/ 5511566 w 8363529"/>
                <a:gd name="connsiteY404" fmla="*/ 1201736 h 1338553"/>
                <a:gd name="connsiteX405" fmla="*/ 5444672 w 8363529"/>
                <a:gd name="connsiteY405" fmla="*/ 1220376 h 1338553"/>
                <a:gd name="connsiteX406" fmla="*/ 5436280 w 8363529"/>
                <a:gd name="connsiteY406" fmla="*/ 1226047 h 1338553"/>
                <a:gd name="connsiteX407" fmla="*/ 5427926 w 8363529"/>
                <a:gd name="connsiteY407" fmla="*/ 1212963 h 1338553"/>
                <a:gd name="connsiteX408" fmla="*/ 5361042 w 8363529"/>
                <a:gd name="connsiteY408" fmla="*/ 1174938 h 1338553"/>
                <a:gd name="connsiteX409" fmla="*/ 5352650 w 8363529"/>
                <a:gd name="connsiteY409" fmla="*/ 1173041 h 1338553"/>
                <a:gd name="connsiteX410" fmla="*/ 5344287 w 8363529"/>
                <a:gd name="connsiteY410" fmla="*/ 1143368 h 1338553"/>
                <a:gd name="connsiteX411" fmla="*/ 5277403 w 8363529"/>
                <a:gd name="connsiteY411" fmla="*/ 938659 h 1338553"/>
                <a:gd name="connsiteX412" fmla="*/ 5269049 w 8363529"/>
                <a:gd name="connsiteY412" fmla="*/ 916506 h 1338553"/>
                <a:gd name="connsiteX413" fmla="*/ 5260657 w 8363529"/>
                <a:gd name="connsiteY413" fmla="*/ 952982 h 1338553"/>
                <a:gd name="connsiteX414" fmla="*/ 5193773 w 8363529"/>
                <a:gd name="connsiteY414" fmla="*/ 1221624 h 1338553"/>
                <a:gd name="connsiteX415" fmla="*/ 5185410 w 8363529"/>
                <a:gd name="connsiteY415" fmla="*/ 1252546 h 1338553"/>
                <a:gd name="connsiteX416" fmla="*/ 5177018 w 8363529"/>
                <a:gd name="connsiteY416" fmla="*/ 1251297 h 1338553"/>
                <a:gd name="connsiteX417" fmla="*/ 5110134 w 8363529"/>
                <a:gd name="connsiteY417" fmla="*/ 1237506 h 1338553"/>
                <a:gd name="connsiteX418" fmla="*/ 5101780 w 8363529"/>
                <a:gd name="connsiteY418" fmla="*/ 1235125 h 1338553"/>
                <a:gd name="connsiteX419" fmla="*/ 5093388 w 8363529"/>
                <a:gd name="connsiteY419" fmla="*/ 1244232 h 1338553"/>
                <a:gd name="connsiteX420" fmla="*/ 5026494 w 8363529"/>
                <a:gd name="connsiteY420" fmla="*/ 1305358 h 1338553"/>
                <a:gd name="connsiteX421" fmla="*/ 5018141 w 8363529"/>
                <a:gd name="connsiteY421" fmla="*/ 1311785 h 1338553"/>
                <a:gd name="connsiteX422" fmla="*/ 5009749 w 8363529"/>
                <a:gd name="connsiteY422" fmla="*/ 1294471 h 1338553"/>
                <a:gd name="connsiteX423" fmla="*/ 4942864 w 8363529"/>
                <a:gd name="connsiteY423" fmla="*/ 1171947 h 1338553"/>
                <a:gd name="connsiteX424" fmla="*/ 4934501 w 8363529"/>
                <a:gd name="connsiteY424" fmla="*/ 1158379 h 1338553"/>
                <a:gd name="connsiteX425" fmla="*/ 4926109 w 8363529"/>
                <a:gd name="connsiteY425" fmla="*/ 1153956 h 1338553"/>
                <a:gd name="connsiteX426" fmla="*/ 4859225 w 8363529"/>
                <a:gd name="connsiteY426" fmla="*/ 1100833 h 1338553"/>
                <a:gd name="connsiteX427" fmla="*/ 4850872 w 8363529"/>
                <a:gd name="connsiteY427" fmla="*/ 1090671 h 1338553"/>
                <a:gd name="connsiteX428" fmla="*/ 4842480 w 8363529"/>
                <a:gd name="connsiteY428" fmla="*/ 1084584 h 1338553"/>
                <a:gd name="connsiteX429" fmla="*/ 4775595 w 8363529"/>
                <a:gd name="connsiteY429" fmla="*/ 1047720 h 1338553"/>
                <a:gd name="connsiteX430" fmla="*/ 4767232 w 8363529"/>
                <a:gd name="connsiteY430" fmla="*/ 1044207 h 1338553"/>
                <a:gd name="connsiteX431" fmla="*/ 4758840 w 8363529"/>
                <a:gd name="connsiteY431" fmla="*/ 1014680 h 1338553"/>
                <a:gd name="connsiteX432" fmla="*/ 4691956 w 8363529"/>
                <a:gd name="connsiteY432" fmla="*/ 750238 h 1338553"/>
                <a:gd name="connsiteX433" fmla="*/ 4683603 w 8363529"/>
                <a:gd name="connsiteY433" fmla="*/ 713152 h 1338553"/>
                <a:gd name="connsiteX434" fmla="*/ 4675201 w 8363529"/>
                <a:gd name="connsiteY434" fmla="*/ 768423 h 1338553"/>
                <a:gd name="connsiteX435" fmla="*/ 4608317 w 8363529"/>
                <a:gd name="connsiteY435" fmla="*/ 1220260 h 1338553"/>
                <a:gd name="connsiteX436" fmla="*/ 4599964 w 8363529"/>
                <a:gd name="connsiteY436" fmla="*/ 1277989 h 1338553"/>
                <a:gd name="connsiteX437" fmla="*/ 4591572 w 8363529"/>
                <a:gd name="connsiteY437" fmla="*/ 1261430 h 1338553"/>
                <a:gd name="connsiteX438" fmla="*/ 4524687 w 8363529"/>
                <a:gd name="connsiteY438" fmla="*/ 1142836 h 1338553"/>
                <a:gd name="connsiteX439" fmla="*/ 4516324 w 8363529"/>
                <a:gd name="connsiteY439" fmla="*/ 1129529 h 1338553"/>
                <a:gd name="connsiteX440" fmla="*/ 4507932 w 8363529"/>
                <a:gd name="connsiteY440" fmla="*/ 1147713 h 1338553"/>
                <a:gd name="connsiteX441" fmla="*/ 4441048 w 8363529"/>
                <a:gd name="connsiteY441" fmla="*/ 1285402 h 1338553"/>
                <a:gd name="connsiteX442" fmla="*/ 4432695 w 8363529"/>
                <a:gd name="connsiteY442" fmla="*/ 1301690 h 1338553"/>
                <a:gd name="connsiteX443" fmla="*/ 4424303 w 8363529"/>
                <a:gd name="connsiteY443" fmla="*/ 1177696 h 1338553"/>
                <a:gd name="connsiteX444" fmla="*/ 4357409 w 8363529"/>
                <a:gd name="connsiteY444" fmla="*/ 177233 h 1338553"/>
                <a:gd name="connsiteX445" fmla="*/ 4349055 w 8363529"/>
                <a:gd name="connsiteY445" fmla="*/ 51080 h 1338553"/>
                <a:gd name="connsiteX446" fmla="*/ 4340664 w 8363529"/>
                <a:gd name="connsiteY446" fmla="*/ 165436 h 1338553"/>
                <a:gd name="connsiteX447" fmla="*/ 4273779 w 8363529"/>
                <a:gd name="connsiteY447" fmla="*/ 1155543 h 1338553"/>
                <a:gd name="connsiteX448" fmla="*/ 4265416 w 8363529"/>
                <a:gd name="connsiteY448" fmla="*/ 1289593 h 1338553"/>
                <a:gd name="connsiteX449" fmla="*/ 4257024 w 8363529"/>
                <a:gd name="connsiteY449" fmla="*/ 1256029 h 1338553"/>
                <a:gd name="connsiteX450" fmla="*/ 4190140 w 8363529"/>
                <a:gd name="connsiteY450" fmla="*/ 1042243 h 1338553"/>
                <a:gd name="connsiteX451" fmla="*/ 4181787 w 8363529"/>
                <a:gd name="connsiteY451" fmla="*/ 1020806 h 1338553"/>
                <a:gd name="connsiteX452" fmla="*/ 4173394 w 8363529"/>
                <a:gd name="connsiteY452" fmla="*/ 1037481 h 1338553"/>
                <a:gd name="connsiteX453" fmla="*/ 4106500 w 8363529"/>
                <a:gd name="connsiteY453" fmla="*/ 1241474 h 1338553"/>
                <a:gd name="connsiteX454" fmla="*/ 4098147 w 8363529"/>
                <a:gd name="connsiteY454" fmla="*/ 1281318 h 1338553"/>
                <a:gd name="connsiteX455" fmla="*/ 4089755 w 8363529"/>
                <a:gd name="connsiteY455" fmla="*/ 1289593 h 1338553"/>
                <a:gd name="connsiteX456" fmla="*/ 4022871 w 8363529"/>
                <a:gd name="connsiteY456" fmla="*/ 1332699 h 1338553"/>
                <a:gd name="connsiteX457" fmla="*/ 4014517 w 8363529"/>
                <a:gd name="connsiteY457" fmla="*/ 1336289 h 1338553"/>
                <a:gd name="connsiteX458" fmla="*/ 4006154 w 8363529"/>
                <a:gd name="connsiteY458" fmla="*/ 1327743 h 1338553"/>
                <a:gd name="connsiteX459" fmla="*/ 3939231 w 8363529"/>
                <a:gd name="connsiteY459" fmla="*/ 1250281 h 1338553"/>
                <a:gd name="connsiteX460" fmla="*/ 3930878 w 8363529"/>
                <a:gd name="connsiteY460" fmla="*/ 1239277 h 1338553"/>
                <a:gd name="connsiteX461" fmla="*/ 3922525 w 8363529"/>
                <a:gd name="connsiteY461" fmla="*/ 1233528 h 1338553"/>
                <a:gd name="connsiteX462" fmla="*/ 3855602 w 8363529"/>
                <a:gd name="connsiteY462" fmla="*/ 1182196 h 1338553"/>
                <a:gd name="connsiteX463" fmla="*/ 3847239 w 8363529"/>
                <a:gd name="connsiteY463" fmla="*/ 1175044 h 1338553"/>
                <a:gd name="connsiteX464" fmla="*/ 3838885 w 8363529"/>
                <a:gd name="connsiteY464" fmla="*/ 1143484 h 1338553"/>
                <a:gd name="connsiteX465" fmla="*/ 3771962 w 8363529"/>
                <a:gd name="connsiteY465" fmla="*/ 913216 h 1338553"/>
                <a:gd name="connsiteX466" fmla="*/ 3763609 w 8363529"/>
                <a:gd name="connsiteY466" fmla="*/ 886901 h 1338553"/>
                <a:gd name="connsiteX467" fmla="*/ 3755246 w 8363529"/>
                <a:gd name="connsiteY467" fmla="*/ 910641 h 1338553"/>
                <a:gd name="connsiteX468" fmla="*/ 3688323 w 8363529"/>
                <a:gd name="connsiteY468" fmla="*/ 1126770 h 1338553"/>
                <a:gd name="connsiteX469" fmla="*/ 3679970 w 8363529"/>
                <a:gd name="connsiteY469" fmla="*/ 1157585 h 1338553"/>
                <a:gd name="connsiteX470" fmla="*/ 3671616 w 8363529"/>
                <a:gd name="connsiteY470" fmla="*/ 1117586 h 1338553"/>
                <a:gd name="connsiteX471" fmla="*/ 3604693 w 8363529"/>
                <a:gd name="connsiteY471" fmla="*/ 877833 h 1338553"/>
                <a:gd name="connsiteX472" fmla="*/ 3596330 w 8363529"/>
                <a:gd name="connsiteY472" fmla="*/ 855148 h 1338553"/>
                <a:gd name="connsiteX473" fmla="*/ 3587977 w 8363529"/>
                <a:gd name="connsiteY473" fmla="*/ 890269 h 1338553"/>
                <a:gd name="connsiteX474" fmla="*/ 3521054 w 8363529"/>
                <a:gd name="connsiteY474" fmla="*/ 1213572 h 1338553"/>
                <a:gd name="connsiteX475" fmla="*/ 3512701 w 8363529"/>
                <a:gd name="connsiteY475" fmla="*/ 1260220 h 1338553"/>
                <a:gd name="connsiteX476" fmla="*/ 3504347 w 8363529"/>
                <a:gd name="connsiteY476" fmla="*/ 1260259 h 1338553"/>
                <a:gd name="connsiteX477" fmla="*/ 3437424 w 8363529"/>
                <a:gd name="connsiteY477" fmla="*/ 1260452 h 1338553"/>
                <a:gd name="connsiteX478" fmla="*/ 3429061 w 8363529"/>
                <a:gd name="connsiteY478" fmla="*/ 1260452 h 1338553"/>
                <a:gd name="connsiteX479" fmla="*/ 3420708 w 8363529"/>
                <a:gd name="connsiteY479" fmla="*/ 1263133 h 1338553"/>
                <a:gd name="connsiteX480" fmla="*/ 3353785 w 8363529"/>
                <a:gd name="connsiteY480" fmla="*/ 1315723 h 1338553"/>
                <a:gd name="connsiteX481" fmla="*/ 3345432 w 8363529"/>
                <a:gd name="connsiteY481" fmla="*/ 1333637 h 1338553"/>
                <a:gd name="connsiteX482" fmla="*/ 3337069 w 8363529"/>
                <a:gd name="connsiteY482" fmla="*/ 1317872 h 1338553"/>
                <a:gd name="connsiteX483" fmla="*/ 3270146 w 8363529"/>
                <a:gd name="connsiteY483" fmla="*/ 1262640 h 1338553"/>
                <a:gd name="connsiteX484" fmla="*/ 3261792 w 8363529"/>
                <a:gd name="connsiteY484" fmla="*/ 1259388 h 1338553"/>
                <a:gd name="connsiteX485" fmla="*/ 3253439 w 8363529"/>
                <a:gd name="connsiteY485" fmla="*/ 1185293 h 1338553"/>
                <a:gd name="connsiteX486" fmla="*/ 3186516 w 8363529"/>
                <a:gd name="connsiteY486" fmla="*/ 714062 h 1338553"/>
                <a:gd name="connsiteX487" fmla="*/ 3178153 w 8363529"/>
                <a:gd name="connsiteY487" fmla="*/ 666949 h 1338553"/>
                <a:gd name="connsiteX488" fmla="*/ 3169800 w 8363529"/>
                <a:gd name="connsiteY488" fmla="*/ 699845 h 1338553"/>
                <a:gd name="connsiteX489" fmla="*/ 3102877 w 8363529"/>
                <a:gd name="connsiteY489" fmla="*/ 1064473 h 1338553"/>
                <a:gd name="connsiteX490" fmla="*/ 3094523 w 8363529"/>
                <a:gd name="connsiteY490" fmla="*/ 1128435 h 1338553"/>
                <a:gd name="connsiteX491" fmla="*/ 3086161 w 8363529"/>
                <a:gd name="connsiteY491" fmla="*/ 1144162 h 1338553"/>
                <a:gd name="connsiteX492" fmla="*/ 3019238 w 8363529"/>
                <a:gd name="connsiteY492" fmla="*/ 1243061 h 1338553"/>
                <a:gd name="connsiteX493" fmla="*/ 3010884 w 8363529"/>
                <a:gd name="connsiteY493" fmla="*/ 1252816 h 1338553"/>
                <a:gd name="connsiteX494" fmla="*/ 3002531 w 8363529"/>
                <a:gd name="connsiteY494" fmla="*/ 1192552 h 1338553"/>
                <a:gd name="connsiteX495" fmla="*/ 2935608 w 8363529"/>
                <a:gd name="connsiteY495" fmla="*/ 689935 h 1338553"/>
                <a:gd name="connsiteX496" fmla="*/ 2927245 w 8363529"/>
                <a:gd name="connsiteY496" fmla="*/ 624424 h 1338553"/>
                <a:gd name="connsiteX497" fmla="*/ 2918892 w 8363529"/>
                <a:gd name="connsiteY497" fmla="*/ 676937 h 1338553"/>
                <a:gd name="connsiteX498" fmla="*/ 2851968 w 8363529"/>
                <a:gd name="connsiteY498" fmla="*/ 1085716 h 1338553"/>
                <a:gd name="connsiteX499" fmla="*/ 2843615 w 8363529"/>
                <a:gd name="connsiteY499" fmla="*/ 1135432 h 1338553"/>
                <a:gd name="connsiteX500" fmla="*/ 2835262 w 8363529"/>
                <a:gd name="connsiteY500" fmla="*/ 1139816 h 1338553"/>
                <a:gd name="connsiteX501" fmla="*/ 2768329 w 8363529"/>
                <a:gd name="connsiteY501" fmla="*/ 1186048 h 1338553"/>
                <a:gd name="connsiteX502" fmla="*/ 2759976 w 8363529"/>
                <a:gd name="connsiteY502" fmla="*/ 1193761 h 1338553"/>
                <a:gd name="connsiteX503" fmla="*/ 2751623 w 8363529"/>
                <a:gd name="connsiteY503" fmla="*/ 1202191 h 1338553"/>
                <a:gd name="connsiteX504" fmla="*/ 2684699 w 8363529"/>
                <a:gd name="connsiteY504" fmla="*/ 1259165 h 1338553"/>
                <a:gd name="connsiteX505" fmla="*/ 2676346 w 8363529"/>
                <a:gd name="connsiteY505" fmla="*/ 1265175 h 1338553"/>
                <a:gd name="connsiteX506" fmla="*/ 2667983 w 8363529"/>
                <a:gd name="connsiteY506" fmla="*/ 1266646 h 1338553"/>
                <a:gd name="connsiteX507" fmla="*/ 2601060 w 8363529"/>
                <a:gd name="connsiteY507" fmla="*/ 1278066 h 1338553"/>
                <a:gd name="connsiteX508" fmla="*/ 2592707 w 8363529"/>
                <a:gd name="connsiteY508" fmla="*/ 1279470 h 1338553"/>
                <a:gd name="connsiteX509" fmla="*/ 2584354 w 8363529"/>
                <a:gd name="connsiteY509" fmla="*/ 1275531 h 1338553"/>
                <a:gd name="connsiteX510" fmla="*/ 2517430 w 8363529"/>
                <a:gd name="connsiteY510" fmla="*/ 1248655 h 1338553"/>
                <a:gd name="connsiteX511" fmla="*/ 2509068 w 8363529"/>
                <a:gd name="connsiteY511" fmla="*/ 1245781 h 1338553"/>
                <a:gd name="connsiteX512" fmla="*/ 2500714 w 8363529"/>
                <a:gd name="connsiteY512" fmla="*/ 1217317 h 1338553"/>
                <a:gd name="connsiteX513" fmla="*/ 2433791 w 8363529"/>
                <a:gd name="connsiteY513" fmla="*/ 976084 h 1338553"/>
                <a:gd name="connsiteX514" fmla="*/ 2425438 w 8363529"/>
                <a:gd name="connsiteY514" fmla="*/ 944137 h 1338553"/>
                <a:gd name="connsiteX515" fmla="*/ 2417075 w 8363529"/>
                <a:gd name="connsiteY515" fmla="*/ 978803 h 1338553"/>
                <a:gd name="connsiteX516" fmla="*/ 2350152 w 8363529"/>
                <a:gd name="connsiteY516" fmla="*/ 1270924 h 1338553"/>
                <a:gd name="connsiteX517" fmla="*/ 2341799 w 8363529"/>
                <a:gd name="connsiteY517" fmla="*/ 1309365 h 1338553"/>
                <a:gd name="connsiteX518" fmla="*/ 2333445 w 8363529"/>
                <a:gd name="connsiteY518" fmla="*/ 1309713 h 1338553"/>
                <a:gd name="connsiteX519" fmla="*/ 2266522 w 8363529"/>
                <a:gd name="connsiteY519" fmla="*/ 1313033 h 1338553"/>
                <a:gd name="connsiteX520" fmla="*/ 2258159 w 8363529"/>
                <a:gd name="connsiteY520" fmla="*/ 1313527 h 1338553"/>
                <a:gd name="connsiteX521" fmla="*/ 2249806 w 8363529"/>
                <a:gd name="connsiteY521" fmla="*/ 1307971 h 1338553"/>
                <a:gd name="connsiteX522" fmla="*/ 2182883 w 8363529"/>
                <a:gd name="connsiteY522" fmla="*/ 1270924 h 1338553"/>
                <a:gd name="connsiteX523" fmla="*/ 2174530 w 8363529"/>
                <a:gd name="connsiteY523" fmla="*/ 1267024 h 1338553"/>
                <a:gd name="connsiteX524" fmla="*/ 2166176 w 8363529"/>
                <a:gd name="connsiteY524" fmla="*/ 1211453 h 1338553"/>
                <a:gd name="connsiteX525" fmla="*/ 2099253 w 8363529"/>
                <a:gd name="connsiteY525" fmla="*/ 695799 h 1338553"/>
                <a:gd name="connsiteX526" fmla="*/ 2090890 w 8363529"/>
                <a:gd name="connsiteY526" fmla="*/ 620872 h 1338553"/>
                <a:gd name="connsiteX527" fmla="*/ 2082537 w 8363529"/>
                <a:gd name="connsiteY527" fmla="*/ 698935 h 1338553"/>
                <a:gd name="connsiteX528" fmla="*/ 2015614 w 8363529"/>
                <a:gd name="connsiteY528" fmla="*/ 1175954 h 1338553"/>
                <a:gd name="connsiteX529" fmla="*/ 2007260 w 8363529"/>
                <a:gd name="connsiteY529" fmla="*/ 1221847 h 1338553"/>
                <a:gd name="connsiteX530" fmla="*/ 1998898 w 8363529"/>
                <a:gd name="connsiteY530" fmla="*/ 1222989 h 1338553"/>
                <a:gd name="connsiteX531" fmla="*/ 1931975 w 8363529"/>
                <a:gd name="connsiteY531" fmla="*/ 1234515 h 1338553"/>
                <a:gd name="connsiteX532" fmla="*/ 1923621 w 8363529"/>
                <a:gd name="connsiteY532" fmla="*/ 1236403 h 1338553"/>
                <a:gd name="connsiteX533" fmla="*/ 1915268 w 8363529"/>
                <a:gd name="connsiteY533" fmla="*/ 1237428 h 1338553"/>
                <a:gd name="connsiteX534" fmla="*/ 1848345 w 8363529"/>
                <a:gd name="connsiteY534" fmla="*/ 1245703 h 1338553"/>
                <a:gd name="connsiteX535" fmla="*/ 1839982 w 8363529"/>
                <a:gd name="connsiteY535" fmla="*/ 1246729 h 1338553"/>
                <a:gd name="connsiteX536" fmla="*/ 1831629 w 8363529"/>
                <a:gd name="connsiteY536" fmla="*/ 1240409 h 1338553"/>
                <a:gd name="connsiteX537" fmla="*/ 1764706 w 8363529"/>
                <a:gd name="connsiteY537" fmla="*/ 1192852 h 1338553"/>
                <a:gd name="connsiteX538" fmla="*/ 1756352 w 8363529"/>
                <a:gd name="connsiteY538" fmla="*/ 1187258 h 1338553"/>
                <a:gd name="connsiteX539" fmla="*/ 1747989 w 8363529"/>
                <a:gd name="connsiteY539" fmla="*/ 1190326 h 1338553"/>
                <a:gd name="connsiteX540" fmla="*/ 1681066 w 8363529"/>
                <a:gd name="connsiteY540" fmla="*/ 1210543 h 1338553"/>
                <a:gd name="connsiteX541" fmla="*/ 1672713 w 8363529"/>
                <a:gd name="connsiteY541" fmla="*/ 1212624 h 1338553"/>
                <a:gd name="connsiteX542" fmla="*/ 1664360 w 8363529"/>
                <a:gd name="connsiteY542" fmla="*/ 1209565 h 1338553"/>
                <a:gd name="connsiteX543" fmla="*/ 1597437 w 8363529"/>
                <a:gd name="connsiteY543" fmla="*/ 1173418 h 1338553"/>
                <a:gd name="connsiteX544" fmla="*/ 1589074 w 8363529"/>
                <a:gd name="connsiteY544" fmla="*/ 1166576 h 1338553"/>
                <a:gd name="connsiteX545" fmla="*/ 1580720 w 8363529"/>
                <a:gd name="connsiteY545" fmla="*/ 1183483 h 1338553"/>
                <a:gd name="connsiteX546" fmla="*/ 1513797 w 8363529"/>
                <a:gd name="connsiteY546" fmla="*/ 1289070 h 1338553"/>
                <a:gd name="connsiteX547" fmla="*/ 1505444 w 8363529"/>
                <a:gd name="connsiteY547" fmla="*/ 1299426 h 1338553"/>
                <a:gd name="connsiteX548" fmla="*/ 1497091 w 8363529"/>
                <a:gd name="connsiteY548" fmla="*/ 1297084 h 1338553"/>
                <a:gd name="connsiteX549" fmla="*/ 1430158 w 8363529"/>
                <a:gd name="connsiteY549" fmla="*/ 1281434 h 1338553"/>
                <a:gd name="connsiteX550" fmla="*/ 1421805 w 8363529"/>
                <a:gd name="connsiteY550" fmla="*/ 1279770 h 1338553"/>
                <a:gd name="connsiteX551" fmla="*/ 1413451 w 8363529"/>
                <a:gd name="connsiteY551" fmla="*/ 1271824 h 1338553"/>
                <a:gd name="connsiteX552" fmla="*/ 1346528 w 8363529"/>
                <a:gd name="connsiteY552" fmla="*/ 1177086 h 1338553"/>
                <a:gd name="connsiteX553" fmla="*/ 1338175 w 8363529"/>
                <a:gd name="connsiteY553" fmla="*/ 1159056 h 1338553"/>
                <a:gd name="connsiteX554" fmla="*/ 1329812 w 8363529"/>
                <a:gd name="connsiteY554" fmla="*/ 1135655 h 1338553"/>
                <a:gd name="connsiteX555" fmla="*/ 1262889 w 8363529"/>
                <a:gd name="connsiteY555" fmla="*/ 1020167 h 1338553"/>
                <a:gd name="connsiteX556" fmla="*/ 1254536 w 8363529"/>
                <a:gd name="connsiteY556" fmla="*/ 1011050 h 1338553"/>
                <a:gd name="connsiteX557" fmla="*/ 1246182 w 8363529"/>
                <a:gd name="connsiteY557" fmla="*/ 1017554 h 1338553"/>
                <a:gd name="connsiteX558" fmla="*/ 1179259 w 8363529"/>
                <a:gd name="connsiteY558" fmla="*/ 1079097 h 1338553"/>
                <a:gd name="connsiteX559" fmla="*/ 1170896 w 8363529"/>
                <a:gd name="connsiteY559" fmla="*/ 1088213 h 1338553"/>
                <a:gd name="connsiteX560" fmla="*/ 1162543 w 8363529"/>
                <a:gd name="connsiteY560" fmla="*/ 1088552 h 1338553"/>
                <a:gd name="connsiteX561" fmla="*/ 1095620 w 8363529"/>
                <a:gd name="connsiteY561" fmla="*/ 1091155 h 1338553"/>
                <a:gd name="connsiteX562" fmla="*/ 1087267 w 8363529"/>
                <a:gd name="connsiteY562" fmla="*/ 1091465 h 1338553"/>
                <a:gd name="connsiteX563" fmla="*/ 1078904 w 8363529"/>
                <a:gd name="connsiteY563" fmla="*/ 1113841 h 1338553"/>
                <a:gd name="connsiteX564" fmla="*/ 1011981 w 8363529"/>
                <a:gd name="connsiteY564" fmla="*/ 1262040 h 1338553"/>
                <a:gd name="connsiteX565" fmla="*/ 1003627 w 8363529"/>
                <a:gd name="connsiteY565" fmla="*/ 1277457 h 1338553"/>
                <a:gd name="connsiteX566" fmla="*/ 995274 w 8363529"/>
                <a:gd name="connsiteY566" fmla="*/ 1250920 h 1338553"/>
                <a:gd name="connsiteX567" fmla="*/ 928351 w 8363529"/>
                <a:gd name="connsiteY567" fmla="*/ 976006 h 1338553"/>
                <a:gd name="connsiteX568" fmla="*/ 919988 w 8363529"/>
                <a:gd name="connsiteY568" fmla="*/ 931207 h 1338553"/>
                <a:gd name="connsiteX569" fmla="*/ 911635 w 8363529"/>
                <a:gd name="connsiteY569" fmla="*/ 950224 h 1338553"/>
                <a:gd name="connsiteX570" fmla="*/ 844712 w 8363529"/>
                <a:gd name="connsiteY570" fmla="*/ 1073541 h 1338553"/>
                <a:gd name="connsiteX571" fmla="*/ 836358 w 8363529"/>
                <a:gd name="connsiteY571" fmla="*/ 1086094 h 1338553"/>
                <a:gd name="connsiteX572" fmla="*/ 828005 w 8363529"/>
                <a:gd name="connsiteY572" fmla="*/ 1099662 h 1338553"/>
                <a:gd name="connsiteX573" fmla="*/ 761082 w 8363529"/>
                <a:gd name="connsiteY573" fmla="*/ 1237845 h 1338553"/>
                <a:gd name="connsiteX574" fmla="*/ 752719 w 8363529"/>
                <a:gd name="connsiteY574" fmla="*/ 1259959 h 1338553"/>
                <a:gd name="connsiteX575" fmla="*/ 744366 w 8363529"/>
                <a:gd name="connsiteY575" fmla="*/ 1253910 h 1338553"/>
                <a:gd name="connsiteX576" fmla="*/ 677443 w 8363529"/>
                <a:gd name="connsiteY576" fmla="*/ 1195919 h 1338553"/>
                <a:gd name="connsiteX577" fmla="*/ 669089 w 8363529"/>
                <a:gd name="connsiteY577" fmla="*/ 1187219 h 1338553"/>
                <a:gd name="connsiteX578" fmla="*/ 660727 w 8363529"/>
                <a:gd name="connsiteY578" fmla="*/ 1168695 h 1338553"/>
                <a:gd name="connsiteX579" fmla="*/ 593803 w 8363529"/>
                <a:gd name="connsiteY579" fmla="*/ 1067725 h 1338553"/>
                <a:gd name="connsiteX580" fmla="*/ 585450 w 8363529"/>
                <a:gd name="connsiteY580" fmla="*/ 1058986 h 1338553"/>
                <a:gd name="connsiteX581" fmla="*/ 577097 w 8363529"/>
                <a:gd name="connsiteY581" fmla="*/ 1046365 h 1338553"/>
                <a:gd name="connsiteX582" fmla="*/ 510174 w 8363529"/>
                <a:gd name="connsiteY582" fmla="*/ 884598 h 1338553"/>
                <a:gd name="connsiteX583" fmla="*/ 501811 w 8363529"/>
                <a:gd name="connsiteY583" fmla="*/ 851325 h 1338553"/>
                <a:gd name="connsiteX584" fmla="*/ 493458 w 8363529"/>
                <a:gd name="connsiteY584" fmla="*/ 912267 h 1338553"/>
                <a:gd name="connsiteX585" fmla="*/ 426534 w 8363529"/>
                <a:gd name="connsiteY585" fmla="*/ 1184916 h 1338553"/>
                <a:gd name="connsiteX586" fmla="*/ 418181 w 8363529"/>
                <a:gd name="connsiteY586" fmla="*/ 1204688 h 1338553"/>
                <a:gd name="connsiteX587" fmla="*/ 409818 w 8363529"/>
                <a:gd name="connsiteY587" fmla="*/ 1192929 h 1338553"/>
                <a:gd name="connsiteX588" fmla="*/ 342895 w 8363529"/>
                <a:gd name="connsiteY588" fmla="*/ 1064812 h 1338553"/>
                <a:gd name="connsiteX589" fmla="*/ 334542 w 8363529"/>
                <a:gd name="connsiteY589" fmla="*/ 1042804 h 1338553"/>
                <a:gd name="connsiteX590" fmla="*/ 326189 w 8363529"/>
                <a:gd name="connsiteY590" fmla="*/ 1067647 h 1338553"/>
                <a:gd name="connsiteX591" fmla="*/ 259304 w 8363529"/>
                <a:gd name="connsiteY591" fmla="*/ 1297084 h 1338553"/>
                <a:gd name="connsiteX592" fmla="*/ 250903 w 8363529"/>
                <a:gd name="connsiteY592" fmla="*/ 1330279 h 1338553"/>
                <a:gd name="connsiteX593" fmla="*/ 242549 w 8363529"/>
                <a:gd name="connsiteY593" fmla="*/ 1287028 h 1338553"/>
                <a:gd name="connsiteX594" fmla="*/ 175665 w 8363529"/>
                <a:gd name="connsiteY594" fmla="*/ 1045340 h 1338553"/>
                <a:gd name="connsiteX595" fmla="*/ 167273 w 8363529"/>
                <a:gd name="connsiteY595" fmla="*/ 1023942 h 1338553"/>
                <a:gd name="connsiteX596" fmla="*/ 158920 w 8363529"/>
                <a:gd name="connsiteY596" fmla="*/ 1016644 h 1338553"/>
                <a:gd name="connsiteX597" fmla="*/ 92029 w 8363529"/>
                <a:gd name="connsiteY597" fmla="*/ 949508 h 1338553"/>
                <a:gd name="connsiteX598" fmla="*/ 83635 w 8363529"/>
                <a:gd name="connsiteY598" fmla="*/ 939830 h 1338553"/>
                <a:gd name="connsiteX599" fmla="*/ 75279 w 8363529"/>
                <a:gd name="connsiteY599" fmla="*/ 919264 h 1338553"/>
                <a:gd name="connsiteX600" fmla="*/ 8394 w 8363529"/>
                <a:gd name="connsiteY600" fmla="*/ 757080 h 1338553"/>
                <a:gd name="connsiteX601" fmla="*/ 0 w 8363529"/>
                <a:gd name="connsiteY601" fmla="*/ 737047 h 13385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  <a:cxn ang="0">
                  <a:pos x="connsiteX466" y="connsiteY466"/>
                </a:cxn>
                <a:cxn ang="0">
                  <a:pos x="connsiteX467" y="connsiteY467"/>
                </a:cxn>
                <a:cxn ang="0">
                  <a:pos x="connsiteX468" y="connsiteY468"/>
                </a:cxn>
                <a:cxn ang="0">
                  <a:pos x="connsiteX469" y="connsiteY469"/>
                </a:cxn>
                <a:cxn ang="0">
                  <a:pos x="connsiteX470" y="connsiteY470"/>
                </a:cxn>
                <a:cxn ang="0">
                  <a:pos x="connsiteX471" y="connsiteY471"/>
                </a:cxn>
                <a:cxn ang="0">
                  <a:pos x="connsiteX472" y="connsiteY472"/>
                </a:cxn>
                <a:cxn ang="0">
                  <a:pos x="connsiteX473" y="connsiteY473"/>
                </a:cxn>
                <a:cxn ang="0">
                  <a:pos x="connsiteX474" y="connsiteY474"/>
                </a:cxn>
                <a:cxn ang="0">
                  <a:pos x="connsiteX475" y="connsiteY475"/>
                </a:cxn>
                <a:cxn ang="0">
                  <a:pos x="connsiteX476" y="connsiteY476"/>
                </a:cxn>
                <a:cxn ang="0">
                  <a:pos x="connsiteX477" y="connsiteY477"/>
                </a:cxn>
                <a:cxn ang="0">
                  <a:pos x="connsiteX478" y="connsiteY478"/>
                </a:cxn>
                <a:cxn ang="0">
                  <a:pos x="connsiteX479" y="connsiteY479"/>
                </a:cxn>
                <a:cxn ang="0">
                  <a:pos x="connsiteX480" y="connsiteY480"/>
                </a:cxn>
                <a:cxn ang="0">
                  <a:pos x="connsiteX481" y="connsiteY481"/>
                </a:cxn>
                <a:cxn ang="0">
                  <a:pos x="connsiteX482" y="connsiteY482"/>
                </a:cxn>
                <a:cxn ang="0">
                  <a:pos x="connsiteX483" y="connsiteY483"/>
                </a:cxn>
                <a:cxn ang="0">
                  <a:pos x="connsiteX484" y="connsiteY484"/>
                </a:cxn>
                <a:cxn ang="0">
                  <a:pos x="connsiteX485" y="connsiteY485"/>
                </a:cxn>
                <a:cxn ang="0">
                  <a:pos x="connsiteX486" y="connsiteY486"/>
                </a:cxn>
                <a:cxn ang="0">
                  <a:pos x="connsiteX487" y="connsiteY487"/>
                </a:cxn>
                <a:cxn ang="0">
                  <a:pos x="connsiteX488" y="connsiteY488"/>
                </a:cxn>
                <a:cxn ang="0">
                  <a:pos x="connsiteX489" y="connsiteY489"/>
                </a:cxn>
                <a:cxn ang="0">
                  <a:pos x="connsiteX490" y="connsiteY490"/>
                </a:cxn>
                <a:cxn ang="0">
                  <a:pos x="connsiteX491" y="connsiteY491"/>
                </a:cxn>
                <a:cxn ang="0">
                  <a:pos x="connsiteX492" y="connsiteY492"/>
                </a:cxn>
                <a:cxn ang="0">
                  <a:pos x="connsiteX493" y="connsiteY493"/>
                </a:cxn>
                <a:cxn ang="0">
                  <a:pos x="connsiteX494" y="connsiteY494"/>
                </a:cxn>
                <a:cxn ang="0">
                  <a:pos x="connsiteX495" y="connsiteY495"/>
                </a:cxn>
                <a:cxn ang="0">
                  <a:pos x="connsiteX496" y="connsiteY496"/>
                </a:cxn>
                <a:cxn ang="0">
                  <a:pos x="connsiteX497" y="connsiteY497"/>
                </a:cxn>
                <a:cxn ang="0">
                  <a:pos x="connsiteX498" y="connsiteY498"/>
                </a:cxn>
                <a:cxn ang="0">
                  <a:pos x="connsiteX499" y="connsiteY499"/>
                </a:cxn>
                <a:cxn ang="0">
                  <a:pos x="connsiteX500" y="connsiteY500"/>
                </a:cxn>
                <a:cxn ang="0">
                  <a:pos x="connsiteX501" y="connsiteY501"/>
                </a:cxn>
                <a:cxn ang="0">
                  <a:pos x="connsiteX502" y="connsiteY502"/>
                </a:cxn>
                <a:cxn ang="0">
                  <a:pos x="connsiteX503" y="connsiteY503"/>
                </a:cxn>
                <a:cxn ang="0">
                  <a:pos x="connsiteX504" y="connsiteY504"/>
                </a:cxn>
                <a:cxn ang="0">
                  <a:pos x="connsiteX505" y="connsiteY505"/>
                </a:cxn>
                <a:cxn ang="0">
                  <a:pos x="connsiteX506" y="connsiteY506"/>
                </a:cxn>
                <a:cxn ang="0">
                  <a:pos x="connsiteX507" y="connsiteY507"/>
                </a:cxn>
                <a:cxn ang="0">
                  <a:pos x="connsiteX508" y="connsiteY508"/>
                </a:cxn>
                <a:cxn ang="0">
                  <a:pos x="connsiteX509" y="connsiteY509"/>
                </a:cxn>
                <a:cxn ang="0">
                  <a:pos x="connsiteX510" y="connsiteY510"/>
                </a:cxn>
                <a:cxn ang="0">
                  <a:pos x="connsiteX511" y="connsiteY511"/>
                </a:cxn>
                <a:cxn ang="0">
                  <a:pos x="connsiteX512" y="connsiteY512"/>
                </a:cxn>
                <a:cxn ang="0">
                  <a:pos x="connsiteX513" y="connsiteY513"/>
                </a:cxn>
                <a:cxn ang="0">
                  <a:pos x="connsiteX514" y="connsiteY514"/>
                </a:cxn>
                <a:cxn ang="0">
                  <a:pos x="connsiteX515" y="connsiteY515"/>
                </a:cxn>
                <a:cxn ang="0">
                  <a:pos x="connsiteX516" y="connsiteY516"/>
                </a:cxn>
                <a:cxn ang="0">
                  <a:pos x="connsiteX517" y="connsiteY517"/>
                </a:cxn>
                <a:cxn ang="0">
                  <a:pos x="connsiteX518" y="connsiteY518"/>
                </a:cxn>
                <a:cxn ang="0">
                  <a:pos x="connsiteX519" y="connsiteY519"/>
                </a:cxn>
                <a:cxn ang="0">
                  <a:pos x="connsiteX520" y="connsiteY520"/>
                </a:cxn>
                <a:cxn ang="0">
                  <a:pos x="connsiteX521" y="connsiteY521"/>
                </a:cxn>
                <a:cxn ang="0">
                  <a:pos x="connsiteX522" y="connsiteY522"/>
                </a:cxn>
                <a:cxn ang="0">
                  <a:pos x="connsiteX523" y="connsiteY523"/>
                </a:cxn>
                <a:cxn ang="0">
                  <a:pos x="connsiteX524" y="connsiteY524"/>
                </a:cxn>
                <a:cxn ang="0">
                  <a:pos x="connsiteX525" y="connsiteY525"/>
                </a:cxn>
                <a:cxn ang="0">
                  <a:pos x="connsiteX526" y="connsiteY526"/>
                </a:cxn>
                <a:cxn ang="0">
                  <a:pos x="connsiteX527" y="connsiteY527"/>
                </a:cxn>
                <a:cxn ang="0">
                  <a:pos x="connsiteX528" y="connsiteY528"/>
                </a:cxn>
                <a:cxn ang="0">
                  <a:pos x="connsiteX529" y="connsiteY529"/>
                </a:cxn>
                <a:cxn ang="0">
                  <a:pos x="connsiteX530" y="connsiteY530"/>
                </a:cxn>
                <a:cxn ang="0">
                  <a:pos x="connsiteX531" y="connsiteY531"/>
                </a:cxn>
                <a:cxn ang="0">
                  <a:pos x="connsiteX532" y="connsiteY532"/>
                </a:cxn>
                <a:cxn ang="0">
                  <a:pos x="connsiteX533" y="connsiteY533"/>
                </a:cxn>
                <a:cxn ang="0">
                  <a:pos x="connsiteX534" y="connsiteY534"/>
                </a:cxn>
                <a:cxn ang="0">
                  <a:pos x="connsiteX535" y="connsiteY535"/>
                </a:cxn>
                <a:cxn ang="0">
                  <a:pos x="connsiteX536" y="connsiteY536"/>
                </a:cxn>
                <a:cxn ang="0">
                  <a:pos x="connsiteX537" y="connsiteY537"/>
                </a:cxn>
                <a:cxn ang="0">
                  <a:pos x="connsiteX538" y="connsiteY538"/>
                </a:cxn>
                <a:cxn ang="0">
                  <a:pos x="connsiteX539" y="connsiteY539"/>
                </a:cxn>
                <a:cxn ang="0">
                  <a:pos x="connsiteX540" y="connsiteY540"/>
                </a:cxn>
                <a:cxn ang="0">
                  <a:pos x="connsiteX541" y="connsiteY541"/>
                </a:cxn>
                <a:cxn ang="0">
                  <a:pos x="connsiteX542" y="connsiteY542"/>
                </a:cxn>
                <a:cxn ang="0">
                  <a:pos x="connsiteX543" y="connsiteY543"/>
                </a:cxn>
                <a:cxn ang="0">
                  <a:pos x="connsiteX544" y="connsiteY544"/>
                </a:cxn>
                <a:cxn ang="0">
                  <a:pos x="connsiteX545" y="connsiteY545"/>
                </a:cxn>
                <a:cxn ang="0">
                  <a:pos x="connsiteX546" y="connsiteY546"/>
                </a:cxn>
                <a:cxn ang="0">
                  <a:pos x="connsiteX547" y="connsiteY547"/>
                </a:cxn>
                <a:cxn ang="0">
                  <a:pos x="connsiteX548" y="connsiteY548"/>
                </a:cxn>
                <a:cxn ang="0">
                  <a:pos x="connsiteX549" y="connsiteY549"/>
                </a:cxn>
                <a:cxn ang="0">
                  <a:pos x="connsiteX550" y="connsiteY550"/>
                </a:cxn>
                <a:cxn ang="0">
                  <a:pos x="connsiteX551" y="connsiteY551"/>
                </a:cxn>
                <a:cxn ang="0">
                  <a:pos x="connsiteX552" y="connsiteY552"/>
                </a:cxn>
                <a:cxn ang="0">
                  <a:pos x="connsiteX553" y="connsiteY553"/>
                </a:cxn>
                <a:cxn ang="0">
                  <a:pos x="connsiteX554" y="connsiteY554"/>
                </a:cxn>
                <a:cxn ang="0">
                  <a:pos x="connsiteX555" y="connsiteY555"/>
                </a:cxn>
                <a:cxn ang="0">
                  <a:pos x="connsiteX556" y="connsiteY556"/>
                </a:cxn>
                <a:cxn ang="0">
                  <a:pos x="connsiteX557" y="connsiteY557"/>
                </a:cxn>
                <a:cxn ang="0">
                  <a:pos x="connsiteX558" y="connsiteY558"/>
                </a:cxn>
                <a:cxn ang="0">
                  <a:pos x="connsiteX559" y="connsiteY559"/>
                </a:cxn>
                <a:cxn ang="0">
                  <a:pos x="connsiteX560" y="connsiteY560"/>
                </a:cxn>
                <a:cxn ang="0">
                  <a:pos x="connsiteX561" y="connsiteY561"/>
                </a:cxn>
                <a:cxn ang="0">
                  <a:pos x="connsiteX562" y="connsiteY562"/>
                </a:cxn>
                <a:cxn ang="0">
                  <a:pos x="connsiteX563" y="connsiteY563"/>
                </a:cxn>
                <a:cxn ang="0">
                  <a:pos x="connsiteX564" y="connsiteY564"/>
                </a:cxn>
                <a:cxn ang="0">
                  <a:pos x="connsiteX565" y="connsiteY565"/>
                </a:cxn>
                <a:cxn ang="0">
                  <a:pos x="connsiteX566" y="connsiteY566"/>
                </a:cxn>
                <a:cxn ang="0">
                  <a:pos x="connsiteX567" y="connsiteY567"/>
                </a:cxn>
                <a:cxn ang="0">
                  <a:pos x="connsiteX568" y="connsiteY568"/>
                </a:cxn>
                <a:cxn ang="0">
                  <a:pos x="connsiteX569" y="connsiteY569"/>
                </a:cxn>
                <a:cxn ang="0">
                  <a:pos x="connsiteX570" y="connsiteY570"/>
                </a:cxn>
                <a:cxn ang="0">
                  <a:pos x="connsiteX571" y="connsiteY571"/>
                </a:cxn>
                <a:cxn ang="0">
                  <a:pos x="connsiteX572" y="connsiteY572"/>
                </a:cxn>
                <a:cxn ang="0">
                  <a:pos x="connsiteX573" y="connsiteY573"/>
                </a:cxn>
                <a:cxn ang="0">
                  <a:pos x="connsiteX574" y="connsiteY574"/>
                </a:cxn>
                <a:cxn ang="0">
                  <a:pos x="connsiteX575" y="connsiteY575"/>
                </a:cxn>
                <a:cxn ang="0">
                  <a:pos x="connsiteX576" y="connsiteY576"/>
                </a:cxn>
                <a:cxn ang="0">
                  <a:pos x="connsiteX577" y="connsiteY577"/>
                </a:cxn>
                <a:cxn ang="0">
                  <a:pos x="connsiteX578" y="connsiteY578"/>
                </a:cxn>
                <a:cxn ang="0">
                  <a:pos x="connsiteX579" y="connsiteY579"/>
                </a:cxn>
                <a:cxn ang="0">
                  <a:pos x="connsiteX580" y="connsiteY580"/>
                </a:cxn>
                <a:cxn ang="0">
                  <a:pos x="connsiteX581" y="connsiteY581"/>
                </a:cxn>
                <a:cxn ang="0">
                  <a:pos x="connsiteX582" y="connsiteY582"/>
                </a:cxn>
                <a:cxn ang="0">
                  <a:pos x="connsiteX583" y="connsiteY583"/>
                </a:cxn>
                <a:cxn ang="0">
                  <a:pos x="connsiteX584" y="connsiteY584"/>
                </a:cxn>
                <a:cxn ang="0">
                  <a:pos x="connsiteX585" y="connsiteY585"/>
                </a:cxn>
                <a:cxn ang="0">
                  <a:pos x="connsiteX586" y="connsiteY586"/>
                </a:cxn>
                <a:cxn ang="0">
                  <a:pos x="connsiteX587" y="connsiteY587"/>
                </a:cxn>
                <a:cxn ang="0">
                  <a:pos x="connsiteX588" y="connsiteY588"/>
                </a:cxn>
                <a:cxn ang="0">
                  <a:pos x="connsiteX589" y="connsiteY589"/>
                </a:cxn>
                <a:cxn ang="0">
                  <a:pos x="connsiteX590" y="connsiteY590"/>
                </a:cxn>
                <a:cxn ang="0">
                  <a:pos x="connsiteX591" y="connsiteY591"/>
                </a:cxn>
                <a:cxn ang="0">
                  <a:pos x="connsiteX592" y="connsiteY592"/>
                </a:cxn>
                <a:cxn ang="0">
                  <a:pos x="connsiteX593" y="connsiteY593"/>
                </a:cxn>
                <a:cxn ang="0">
                  <a:pos x="connsiteX594" y="connsiteY594"/>
                </a:cxn>
                <a:cxn ang="0">
                  <a:pos x="connsiteX595" y="connsiteY595"/>
                </a:cxn>
                <a:cxn ang="0">
                  <a:pos x="connsiteX596" y="connsiteY596"/>
                </a:cxn>
                <a:cxn ang="0">
                  <a:pos x="connsiteX597" y="connsiteY597"/>
                </a:cxn>
                <a:cxn ang="0">
                  <a:pos x="connsiteX598" y="connsiteY598"/>
                </a:cxn>
                <a:cxn ang="0">
                  <a:pos x="connsiteX599" y="connsiteY599"/>
                </a:cxn>
                <a:cxn ang="0">
                  <a:pos x="connsiteX600" y="connsiteY600"/>
                </a:cxn>
                <a:cxn ang="0">
                  <a:pos x="connsiteX601" y="connsiteY601"/>
                </a:cxn>
              </a:cxnLst>
              <a:rect l="l" t="t" r="r" b="b"/>
              <a:pathLst>
                <a:path w="8363529" h="1338553">
                  <a:moveTo>
                    <a:pt x="0" y="632854"/>
                  </a:moveTo>
                  <a:lnTo>
                    <a:pt x="8394" y="661210"/>
                  </a:lnTo>
                  <a:lnTo>
                    <a:pt x="75279" y="891024"/>
                  </a:lnTo>
                  <a:lnTo>
                    <a:pt x="83635" y="920135"/>
                  </a:lnTo>
                  <a:lnTo>
                    <a:pt x="92029" y="919148"/>
                  </a:lnTo>
                  <a:lnTo>
                    <a:pt x="158920" y="912499"/>
                  </a:lnTo>
                  <a:lnTo>
                    <a:pt x="167273" y="911774"/>
                  </a:lnTo>
                  <a:lnTo>
                    <a:pt x="175665" y="935969"/>
                  </a:lnTo>
                  <a:lnTo>
                    <a:pt x="242549" y="1208917"/>
                  </a:lnTo>
                  <a:lnTo>
                    <a:pt x="250903" y="1257762"/>
                  </a:lnTo>
                  <a:lnTo>
                    <a:pt x="259304" y="1214482"/>
                  </a:lnTo>
                  <a:lnTo>
                    <a:pt x="326189" y="915296"/>
                  </a:lnTo>
                  <a:lnTo>
                    <a:pt x="334542" y="882894"/>
                  </a:lnTo>
                  <a:lnTo>
                    <a:pt x="342895" y="900818"/>
                  </a:lnTo>
                  <a:lnTo>
                    <a:pt x="409818" y="1005118"/>
                  </a:lnTo>
                  <a:lnTo>
                    <a:pt x="418181" y="1014680"/>
                  </a:lnTo>
                  <a:lnTo>
                    <a:pt x="426534" y="1003260"/>
                  </a:lnTo>
                  <a:lnTo>
                    <a:pt x="493458" y="845692"/>
                  </a:lnTo>
                  <a:lnTo>
                    <a:pt x="501811" y="810493"/>
                  </a:lnTo>
                  <a:lnTo>
                    <a:pt x="510174" y="821158"/>
                  </a:lnTo>
                  <a:lnTo>
                    <a:pt x="577097" y="872994"/>
                  </a:lnTo>
                  <a:lnTo>
                    <a:pt x="585450" y="877039"/>
                  </a:lnTo>
                  <a:lnTo>
                    <a:pt x="593803" y="884404"/>
                  </a:lnTo>
                  <a:lnTo>
                    <a:pt x="660727" y="969619"/>
                  </a:lnTo>
                  <a:lnTo>
                    <a:pt x="669089" y="985230"/>
                  </a:lnTo>
                  <a:lnTo>
                    <a:pt x="677443" y="1000579"/>
                  </a:lnTo>
                  <a:lnTo>
                    <a:pt x="744366" y="1103069"/>
                  </a:lnTo>
                  <a:lnTo>
                    <a:pt x="752719" y="1113763"/>
                  </a:lnTo>
                  <a:lnTo>
                    <a:pt x="761082" y="1098830"/>
                  </a:lnTo>
                  <a:lnTo>
                    <a:pt x="828005" y="1005650"/>
                  </a:lnTo>
                  <a:lnTo>
                    <a:pt x="836358" y="996495"/>
                  </a:lnTo>
                  <a:lnTo>
                    <a:pt x="844712" y="983526"/>
                  </a:lnTo>
                  <a:lnTo>
                    <a:pt x="911635" y="856319"/>
                  </a:lnTo>
                  <a:lnTo>
                    <a:pt x="919988" y="836701"/>
                  </a:lnTo>
                  <a:lnTo>
                    <a:pt x="928351" y="865426"/>
                  </a:lnTo>
                  <a:lnTo>
                    <a:pt x="995274" y="1041672"/>
                  </a:lnTo>
                  <a:lnTo>
                    <a:pt x="1003627" y="1058686"/>
                  </a:lnTo>
                  <a:lnTo>
                    <a:pt x="1011981" y="1056905"/>
                  </a:lnTo>
                  <a:lnTo>
                    <a:pt x="1078904" y="1039668"/>
                  </a:lnTo>
                  <a:lnTo>
                    <a:pt x="1087267" y="1037065"/>
                  </a:lnTo>
                  <a:lnTo>
                    <a:pt x="1095620" y="1016567"/>
                  </a:lnTo>
                  <a:lnTo>
                    <a:pt x="1162543" y="843166"/>
                  </a:lnTo>
                  <a:lnTo>
                    <a:pt x="1170896" y="820210"/>
                  </a:lnTo>
                  <a:lnTo>
                    <a:pt x="1179259" y="831891"/>
                  </a:lnTo>
                  <a:lnTo>
                    <a:pt x="1246182" y="910719"/>
                  </a:lnTo>
                  <a:lnTo>
                    <a:pt x="1254536" y="919071"/>
                  </a:lnTo>
                  <a:lnTo>
                    <a:pt x="1262889" y="929920"/>
                  </a:lnTo>
                  <a:lnTo>
                    <a:pt x="1329812" y="1067231"/>
                  </a:lnTo>
                  <a:lnTo>
                    <a:pt x="1338175" y="1095055"/>
                  </a:lnTo>
                  <a:lnTo>
                    <a:pt x="1346528" y="1110550"/>
                  </a:lnTo>
                  <a:lnTo>
                    <a:pt x="1413451" y="1191951"/>
                  </a:lnTo>
                  <a:lnTo>
                    <a:pt x="1421805" y="1198755"/>
                  </a:lnTo>
                  <a:lnTo>
                    <a:pt x="1430158" y="1193993"/>
                  </a:lnTo>
                  <a:lnTo>
                    <a:pt x="1497091" y="1148662"/>
                  </a:lnTo>
                  <a:lnTo>
                    <a:pt x="1505444" y="1141936"/>
                  </a:lnTo>
                  <a:lnTo>
                    <a:pt x="1513797" y="1142536"/>
                  </a:lnTo>
                  <a:lnTo>
                    <a:pt x="1580720" y="1148817"/>
                  </a:lnTo>
                  <a:lnTo>
                    <a:pt x="1589074" y="1149794"/>
                  </a:lnTo>
                  <a:lnTo>
                    <a:pt x="1597437" y="1132674"/>
                  </a:lnTo>
                  <a:lnTo>
                    <a:pt x="1664360" y="1041904"/>
                  </a:lnTo>
                  <a:lnTo>
                    <a:pt x="1672713" y="1034268"/>
                  </a:lnTo>
                  <a:lnTo>
                    <a:pt x="1681066" y="1044739"/>
                  </a:lnTo>
                  <a:lnTo>
                    <a:pt x="1747989" y="1145981"/>
                  </a:lnTo>
                  <a:lnTo>
                    <a:pt x="1756352" y="1161321"/>
                  </a:lnTo>
                  <a:lnTo>
                    <a:pt x="1764706" y="1161969"/>
                  </a:lnTo>
                  <a:lnTo>
                    <a:pt x="1831629" y="1167602"/>
                  </a:lnTo>
                  <a:lnTo>
                    <a:pt x="1839982" y="1168357"/>
                  </a:lnTo>
                  <a:lnTo>
                    <a:pt x="1848345" y="1165976"/>
                  </a:lnTo>
                  <a:lnTo>
                    <a:pt x="1915268" y="1146881"/>
                  </a:lnTo>
                  <a:lnTo>
                    <a:pt x="1923621" y="1144500"/>
                  </a:lnTo>
                  <a:lnTo>
                    <a:pt x="1931975" y="1132258"/>
                  </a:lnTo>
                  <a:lnTo>
                    <a:pt x="1998898" y="1056111"/>
                  </a:lnTo>
                  <a:lnTo>
                    <a:pt x="2007260" y="1048669"/>
                  </a:lnTo>
                  <a:lnTo>
                    <a:pt x="2015614" y="1003076"/>
                  </a:lnTo>
                  <a:lnTo>
                    <a:pt x="2082537" y="529270"/>
                  </a:lnTo>
                  <a:lnTo>
                    <a:pt x="2090890" y="451730"/>
                  </a:lnTo>
                  <a:lnTo>
                    <a:pt x="2099253" y="522544"/>
                  </a:lnTo>
                  <a:lnTo>
                    <a:pt x="2166176" y="1009957"/>
                  </a:lnTo>
                  <a:lnTo>
                    <a:pt x="2174530" y="1062470"/>
                  </a:lnTo>
                  <a:lnTo>
                    <a:pt x="2182883" y="1067909"/>
                  </a:lnTo>
                  <a:lnTo>
                    <a:pt x="2249806" y="1119550"/>
                  </a:lnTo>
                  <a:lnTo>
                    <a:pt x="2258159" y="1127264"/>
                  </a:lnTo>
                  <a:lnTo>
                    <a:pt x="2266522" y="1124167"/>
                  </a:lnTo>
                  <a:lnTo>
                    <a:pt x="2333445" y="1103940"/>
                  </a:lnTo>
                  <a:lnTo>
                    <a:pt x="2341799" y="1101859"/>
                  </a:lnTo>
                  <a:lnTo>
                    <a:pt x="2350152" y="1077925"/>
                  </a:lnTo>
                  <a:lnTo>
                    <a:pt x="2417075" y="896086"/>
                  </a:lnTo>
                  <a:lnTo>
                    <a:pt x="2425438" y="874504"/>
                  </a:lnTo>
                  <a:lnTo>
                    <a:pt x="2433791" y="906412"/>
                  </a:lnTo>
                  <a:lnTo>
                    <a:pt x="2500714" y="1147491"/>
                  </a:lnTo>
                  <a:lnTo>
                    <a:pt x="2509068" y="1175993"/>
                  </a:lnTo>
                  <a:lnTo>
                    <a:pt x="2517430" y="1171870"/>
                  </a:lnTo>
                  <a:lnTo>
                    <a:pt x="2584354" y="1133467"/>
                  </a:lnTo>
                  <a:lnTo>
                    <a:pt x="2592707" y="1127835"/>
                  </a:lnTo>
                  <a:lnTo>
                    <a:pt x="2601060" y="1137697"/>
                  </a:lnTo>
                  <a:lnTo>
                    <a:pt x="2667983" y="1217618"/>
                  </a:lnTo>
                  <a:lnTo>
                    <a:pt x="2676346" y="1227712"/>
                  </a:lnTo>
                  <a:lnTo>
                    <a:pt x="2684699" y="1220037"/>
                  </a:lnTo>
                  <a:lnTo>
                    <a:pt x="2751623" y="1147413"/>
                  </a:lnTo>
                  <a:lnTo>
                    <a:pt x="2759976" y="1136642"/>
                  </a:lnTo>
                  <a:lnTo>
                    <a:pt x="2768329" y="1116792"/>
                  </a:lnTo>
                  <a:lnTo>
                    <a:pt x="2835262" y="997559"/>
                  </a:lnTo>
                  <a:lnTo>
                    <a:pt x="2843615" y="986255"/>
                  </a:lnTo>
                  <a:lnTo>
                    <a:pt x="2851968" y="925274"/>
                  </a:lnTo>
                  <a:lnTo>
                    <a:pt x="2918892" y="423945"/>
                  </a:lnTo>
                  <a:lnTo>
                    <a:pt x="2927245" y="359528"/>
                  </a:lnTo>
                  <a:lnTo>
                    <a:pt x="2935608" y="432258"/>
                  </a:lnTo>
                  <a:lnTo>
                    <a:pt x="3002531" y="990601"/>
                  </a:lnTo>
                  <a:lnTo>
                    <a:pt x="3010884" y="1057553"/>
                  </a:lnTo>
                  <a:lnTo>
                    <a:pt x="3019238" y="1045678"/>
                  </a:lnTo>
                  <a:lnTo>
                    <a:pt x="3086161" y="925536"/>
                  </a:lnTo>
                  <a:lnTo>
                    <a:pt x="3094523" y="906451"/>
                  </a:lnTo>
                  <a:lnTo>
                    <a:pt x="3102877" y="867322"/>
                  </a:lnTo>
                  <a:lnTo>
                    <a:pt x="3169800" y="644274"/>
                  </a:lnTo>
                  <a:lnTo>
                    <a:pt x="3178153" y="624163"/>
                  </a:lnTo>
                  <a:lnTo>
                    <a:pt x="3186516" y="665972"/>
                  </a:lnTo>
                  <a:lnTo>
                    <a:pt x="3253439" y="1084313"/>
                  </a:lnTo>
                  <a:lnTo>
                    <a:pt x="3261792" y="1150094"/>
                  </a:lnTo>
                  <a:lnTo>
                    <a:pt x="3270146" y="1158146"/>
                  </a:lnTo>
                  <a:lnTo>
                    <a:pt x="3337069" y="1294664"/>
                  </a:lnTo>
                  <a:lnTo>
                    <a:pt x="3345432" y="1333637"/>
                  </a:lnTo>
                  <a:lnTo>
                    <a:pt x="3353785" y="1314097"/>
                  </a:lnTo>
                  <a:lnTo>
                    <a:pt x="3420708" y="1256668"/>
                  </a:lnTo>
                  <a:lnTo>
                    <a:pt x="3429061" y="1253755"/>
                  </a:lnTo>
                  <a:lnTo>
                    <a:pt x="3437424" y="1219205"/>
                  </a:lnTo>
                  <a:lnTo>
                    <a:pt x="3504347" y="902667"/>
                  </a:lnTo>
                  <a:lnTo>
                    <a:pt x="3512701" y="857267"/>
                  </a:lnTo>
                  <a:lnTo>
                    <a:pt x="3521054" y="829966"/>
                  </a:lnTo>
                  <a:lnTo>
                    <a:pt x="3587977" y="640828"/>
                  </a:lnTo>
                  <a:lnTo>
                    <a:pt x="3596330" y="620301"/>
                  </a:lnTo>
                  <a:lnTo>
                    <a:pt x="3604693" y="653303"/>
                  </a:lnTo>
                  <a:lnTo>
                    <a:pt x="3671616" y="1002853"/>
                  </a:lnTo>
                  <a:lnTo>
                    <a:pt x="3679970" y="1061144"/>
                  </a:lnTo>
                  <a:lnTo>
                    <a:pt x="3688323" y="1039029"/>
                  </a:lnTo>
                  <a:lnTo>
                    <a:pt x="3755246" y="883881"/>
                  </a:lnTo>
                  <a:lnTo>
                    <a:pt x="3763609" y="866829"/>
                  </a:lnTo>
                  <a:lnTo>
                    <a:pt x="3771962" y="888720"/>
                  </a:lnTo>
                  <a:lnTo>
                    <a:pt x="3838885" y="1080306"/>
                  </a:lnTo>
                  <a:lnTo>
                    <a:pt x="3847239" y="1106582"/>
                  </a:lnTo>
                  <a:lnTo>
                    <a:pt x="3855602" y="1111276"/>
                  </a:lnTo>
                  <a:lnTo>
                    <a:pt x="3922525" y="1144955"/>
                  </a:lnTo>
                  <a:lnTo>
                    <a:pt x="3930878" y="1148739"/>
                  </a:lnTo>
                  <a:lnTo>
                    <a:pt x="3939231" y="1130593"/>
                  </a:lnTo>
                  <a:lnTo>
                    <a:pt x="4006154" y="1002882"/>
                  </a:lnTo>
                  <a:lnTo>
                    <a:pt x="4014517" y="988820"/>
                  </a:lnTo>
                  <a:lnTo>
                    <a:pt x="4022871" y="1004586"/>
                  </a:lnTo>
                  <a:lnTo>
                    <a:pt x="4089755" y="1194594"/>
                  </a:lnTo>
                  <a:lnTo>
                    <a:pt x="4098147" y="1231080"/>
                  </a:lnTo>
                  <a:lnTo>
                    <a:pt x="4106500" y="1182835"/>
                  </a:lnTo>
                  <a:lnTo>
                    <a:pt x="4173394" y="936162"/>
                  </a:lnTo>
                  <a:lnTo>
                    <a:pt x="4181787" y="916012"/>
                  </a:lnTo>
                  <a:lnTo>
                    <a:pt x="4190140" y="944292"/>
                  </a:lnTo>
                  <a:lnTo>
                    <a:pt x="4257024" y="1226725"/>
                  </a:lnTo>
                  <a:lnTo>
                    <a:pt x="4265416" y="1271031"/>
                  </a:lnTo>
                  <a:lnTo>
                    <a:pt x="4273779" y="1133506"/>
                  </a:lnTo>
                  <a:lnTo>
                    <a:pt x="4340664" y="117346"/>
                  </a:lnTo>
                  <a:lnTo>
                    <a:pt x="4349055" y="0"/>
                  </a:lnTo>
                  <a:lnTo>
                    <a:pt x="4357409" y="116862"/>
                  </a:lnTo>
                  <a:lnTo>
                    <a:pt x="4424303" y="1043675"/>
                  </a:lnTo>
                  <a:lnTo>
                    <a:pt x="4432695" y="1158563"/>
                  </a:lnTo>
                  <a:lnTo>
                    <a:pt x="4441048" y="1142158"/>
                  </a:lnTo>
                  <a:lnTo>
                    <a:pt x="4507932" y="1003531"/>
                  </a:lnTo>
                  <a:lnTo>
                    <a:pt x="4516324" y="985191"/>
                  </a:lnTo>
                  <a:lnTo>
                    <a:pt x="4524687" y="1002089"/>
                  </a:lnTo>
                  <a:lnTo>
                    <a:pt x="4591572" y="1152669"/>
                  </a:lnTo>
                  <a:lnTo>
                    <a:pt x="4599964" y="1173650"/>
                  </a:lnTo>
                  <a:lnTo>
                    <a:pt x="4608317" y="1118379"/>
                  </a:lnTo>
                  <a:lnTo>
                    <a:pt x="4675201" y="685967"/>
                  </a:lnTo>
                  <a:lnTo>
                    <a:pt x="4683603" y="633115"/>
                  </a:lnTo>
                  <a:lnTo>
                    <a:pt x="4691956" y="670695"/>
                  </a:lnTo>
                  <a:lnTo>
                    <a:pt x="4758840" y="938804"/>
                  </a:lnTo>
                  <a:lnTo>
                    <a:pt x="4767232" y="968748"/>
                  </a:lnTo>
                  <a:lnTo>
                    <a:pt x="4775595" y="965990"/>
                  </a:lnTo>
                  <a:lnTo>
                    <a:pt x="4842480" y="937333"/>
                  </a:lnTo>
                  <a:lnTo>
                    <a:pt x="4850872" y="932610"/>
                  </a:lnTo>
                  <a:lnTo>
                    <a:pt x="4859225" y="959902"/>
                  </a:lnTo>
                  <a:lnTo>
                    <a:pt x="4926109" y="1102498"/>
                  </a:lnTo>
                  <a:lnTo>
                    <a:pt x="4934501" y="1114373"/>
                  </a:lnTo>
                  <a:lnTo>
                    <a:pt x="4942864" y="1120799"/>
                  </a:lnTo>
                  <a:lnTo>
                    <a:pt x="5009749" y="1178567"/>
                  </a:lnTo>
                  <a:lnTo>
                    <a:pt x="5018141" y="1186696"/>
                  </a:lnTo>
                  <a:lnTo>
                    <a:pt x="5026494" y="1186764"/>
                  </a:lnTo>
                  <a:lnTo>
                    <a:pt x="5093388" y="1187490"/>
                  </a:lnTo>
                  <a:lnTo>
                    <a:pt x="5101780" y="1187597"/>
                  </a:lnTo>
                  <a:lnTo>
                    <a:pt x="5110134" y="1148284"/>
                  </a:lnTo>
                  <a:lnTo>
                    <a:pt x="5177018" y="921035"/>
                  </a:lnTo>
                  <a:lnTo>
                    <a:pt x="5185410" y="900286"/>
                  </a:lnTo>
                  <a:lnTo>
                    <a:pt x="5193773" y="898428"/>
                  </a:lnTo>
                  <a:lnTo>
                    <a:pt x="5260657" y="882217"/>
                  </a:lnTo>
                  <a:lnTo>
                    <a:pt x="5269049" y="880020"/>
                  </a:lnTo>
                  <a:lnTo>
                    <a:pt x="5277403" y="900363"/>
                  </a:lnTo>
                  <a:lnTo>
                    <a:pt x="5344287" y="1088591"/>
                  </a:lnTo>
                  <a:lnTo>
                    <a:pt x="5352650" y="1115844"/>
                  </a:lnTo>
                  <a:lnTo>
                    <a:pt x="5361042" y="1112970"/>
                  </a:lnTo>
                  <a:lnTo>
                    <a:pt x="5427926" y="1055811"/>
                  </a:lnTo>
                  <a:lnTo>
                    <a:pt x="5436280" y="1036155"/>
                  </a:lnTo>
                  <a:lnTo>
                    <a:pt x="5444672" y="1071615"/>
                  </a:lnTo>
                  <a:lnTo>
                    <a:pt x="5511566" y="1188661"/>
                  </a:lnTo>
                  <a:lnTo>
                    <a:pt x="5519919" y="1195232"/>
                  </a:lnTo>
                  <a:lnTo>
                    <a:pt x="5528311" y="1198029"/>
                  </a:lnTo>
                  <a:lnTo>
                    <a:pt x="5595195" y="1213611"/>
                  </a:lnTo>
                  <a:lnTo>
                    <a:pt x="5603558" y="1214966"/>
                  </a:lnTo>
                  <a:lnTo>
                    <a:pt x="5611950" y="1114411"/>
                  </a:lnTo>
                  <a:lnTo>
                    <a:pt x="5678835" y="313741"/>
                  </a:lnTo>
                  <a:lnTo>
                    <a:pt x="5687188" y="214126"/>
                  </a:lnTo>
                  <a:lnTo>
                    <a:pt x="5695580" y="287882"/>
                  </a:lnTo>
                  <a:lnTo>
                    <a:pt x="5762474" y="1125522"/>
                  </a:lnTo>
                  <a:lnTo>
                    <a:pt x="5770827" y="1276286"/>
                  </a:lnTo>
                  <a:lnTo>
                    <a:pt x="5779219" y="1242945"/>
                  </a:lnTo>
                  <a:lnTo>
                    <a:pt x="5846103" y="1048475"/>
                  </a:lnTo>
                  <a:lnTo>
                    <a:pt x="5854457" y="1030523"/>
                  </a:lnTo>
                  <a:lnTo>
                    <a:pt x="5862858" y="1029874"/>
                  </a:lnTo>
                  <a:lnTo>
                    <a:pt x="5929743" y="1021067"/>
                  </a:lnTo>
                  <a:lnTo>
                    <a:pt x="5938096" y="1019219"/>
                  </a:lnTo>
                  <a:lnTo>
                    <a:pt x="5946488" y="1058047"/>
                  </a:lnTo>
                  <a:lnTo>
                    <a:pt x="6013372" y="1253755"/>
                  </a:lnTo>
                  <a:lnTo>
                    <a:pt x="6021735" y="1269521"/>
                  </a:lnTo>
                  <a:lnTo>
                    <a:pt x="6030127" y="1256068"/>
                  </a:lnTo>
                  <a:lnTo>
                    <a:pt x="6097011" y="1134106"/>
                  </a:lnTo>
                  <a:lnTo>
                    <a:pt x="6105365" y="1116754"/>
                  </a:lnTo>
                  <a:lnTo>
                    <a:pt x="6113767" y="1121854"/>
                  </a:lnTo>
                  <a:lnTo>
                    <a:pt x="6180651" y="1156869"/>
                  </a:lnTo>
                  <a:lnTo>
                    <a:pt x="6189004" y="1160643"/>
                  </a:lnTo>
                  <a:lnTo>
                    <a:pt x="6197396" y="1153578"/>
                  </a:lnTo>
                  <a:lnTo>
                    <a:pt x="6264280" y="1081409"/>
                  </a:lnTo>
                  <a:lnTo>
                    <a:pt x="6272644" y="1069796"/>
                  </a:lnTo>
                  <a:lnTo>
                    <a:pt x="6281036" y="1081032"/>
                  </a:lnTo>
                  <a:lnTo>
                    <a:pt x="6347920" y="1157207"/>
                  </a:lnTo>
                  <a:lnTo>
                    <a:pt x="6356273" y="1165298"/>
                  </a:lnTo>
                  <a:lnTo>
                    <a:pt x="6364665" y="1167031"/>
                  </a:lnTo>
                  <a:lnTo>
                    <a:pt x="6431560" y="1179622"/>
                  </a:lnTo>
                  <a:lnTo>
                    <a:pt x="6439913" y="1181064"/>
                  </a:lnTo>
                  <a:lnTo>
                    <a:pt x="6448305" y="1177812"/>
                  </a:lnTo>
                  <a:lnTo>
                    <a:pt x="6515189" y="1148546"/>
                  </a:lnTo>
                  <a:lnTo>
                    <a:pt x="6523542" y="1144423"/>
                  </a:lnTo>
                  <a:lnTo>
                    <a:pt x="6531944" y="1153162"/>
                  </a:lnTo>
                  <a:lnTo>
                    <a:pt x="6598829" y="1230964"/>
                  </a:lnTo>
                  <a:lnTo>
                    <a:pt x="6607182" y="1241851"/>
                  </a:lnTo>
                  <a:lnTo>
                    <a:pt x="6615535" y="1229260"/>
                  </a:lnTo>
                  <a:lnTo>
                    <a:pt x="6682458" y="1159095"/>
                  </a:lnTo>
                  <a:lnTo>
                    <a:pt x="6690821" y="1152891"/>
                  </a:lnTo>
                  <a:lnTo>
                    <a:pt x="6699174" y="1133351"/>
                  </a:lnTo>
                  <a:lnTo>
                    <a:pt x="6766097" y="937788"/>
                  </a:lnTo>
                  <a:lnTo>
                    <a:pt x="6774451" y="907012"/>
                  </a:lnTo>
                  <a:lnTo>
                    <a:pt x="6782814" y="941717"/>
                  </a:lnTo>
                  <a:lnTo>
                    <a:pt x="6849737" y="1264720"/>
                  </a:lnTo>
                  <a:lnTo>
                    <a:pt x="6858090" y="1311785"/>
                  </a:lnTo>
                  <a:lnTo>
                    <a:pt x="6866443" y="1262794"/>
                  </a:lnTo>
                  <a:lnTo>
                    <a:pt x="6933366" y="998769"/>
                  </a:lnTo>
                  <a:lnTo>
                    <a:pt x="6941729" y="976161"/>
                  </a:lnTo>
                  <a:lnTo>
                    <a:pt x="6950083" y="1002321"/>
                  </a:lnTo>
                  <a:lnTo>
                    <a:pt x="7017006" y="1257007"/>
                  </a:lnTo>
                  <a:lnTo>
                    <a:pt x="7025359" y="1295951"/>
                  </a:lnTo>
                  <a:lnTo>
                    <a:pt x="7033712" y="1288799"/>
                  </a:lnTo>
                  <a:lnTo>
                    <a:pt x="7100645" y="1227750"/>
                  </a:lnTo>
                  <a:lnTo>
                    <a:pt x="7108998" y="1219582"/>
                  </a:lnTo>
                  <a:lnTo>
                    <a:pt x="7117351" y="1224537"/>
                  </a:lnTo>
                  <a:lnTo>
                    <a:pt x="7184274" y="1265814"/>
                  </a:lnTo>
                  <a:lnTo>
                    <a:pt x="7192628" y="1271185"/>
                  </a:lnTo>
                  <a:lnTo>
                    <a:pt x="7200991" y="1260298"/>
                  </a:lnTo>
                  <a:lnTo>
                    <a:pt x="7267914" y="1179854"/>
                  </a:lnTo>
                  <a:lnTo>
                    <a:pt x="7276267" y="1170553"/>
                  </a:lnTo>
                  <a:lnTo>
                    <a:pt x="7284620" y="1173728"/>
                  </a:lnTo>
                  <a:lnTo>
                    <a:pt x="7351543" y="1200420"/>
                  </a:lnTo>
                  <a:lnTo>
                    <a:pt x="7359906" y="1203933"/>
                  </a:lnTo>
                  <a:lnTo>
                    <a:pt x="7368260" y="1136603"/>
                  </a:lnTo>
                  <a:lnTo>
                    <a:pt x="7435183" y="687331"/>
                  </a:lnTo>
                  <a:lnTo>
                    <a:pt x="7443536" y="640306"/>
                  </a:lnTo>
                  <a:lnTo>
                    <a:pt x="7451899" y="658713"/>
                  </a:lnTo>
                  <a:lnTo>
                    <a:pt x="7518822" y="835908"/>
                  </a:lnTo>
                  <a:lnTo>
                    <a:pt x="7527175" y="862629"/>
                  </a:lnTo>
                  <a:lnTo>
                    <a:pt x="7535528" y="914348"/>
                  </a:lnTo>
                  <a:lnTo>
                    <a:pt x="7602452" y="1261014"/>
                  </a:lnTo>
                  <a:lnTo>
                    <a:pt x="7610815" y="1297461"/>
                  </a:lnTo>
                  <a:lnTo>
                    <a:pt x="7619168" y="1281541"/>
                  </a:lnTo>
                  <a:lnTo>
                    <a:pt x="7686091" y="1143329"/>
                  </a:lnTo>
                  <a:lnTo>
                    <a:pt x="7694444" y="1124544"/>
                  </a:lnTo>
                  <a:lnTo>
                    <a:pt x="7702798" y="1074219"/>
                  </a:lnTo>
                  <a:lnTo>
                    <a:pt x="7769731" y="577921"/>
                  </a:lnTo>
                  <a:lnTo>
                    <a:pt x="7778084" y="501068"/>
                  </a:lnTo>
                  <a:lnTo>
                    <a:pt x="7786437" y="621927"/>
                  </a:lnTo>
                  <a:lnTo>
                    <a:pt x="7853360" y="1212740"/>
                  </a:lnTo>
                  <a:lnTo>
                    <a:pt x="7861713" y="1259049"/>
                  </a:lnTo>
                  <a:lnTo>
                    <a:pt x="7870077" y="1224644"/>
                  </a:lnTo>
                  <a:lnTo>
                    <a:pt x="7937000" y="839266"/>
                  </a:lnTo>
                  <a:lnTo>
                    <a:pt x="7945353" y="770920"/>
                  </a:lnTo>
                  <a:lnTo>
                    <a:pt x="7953706" y="808345"/>
                  </a:lnTo>
                  <a:lnTo>
                    <a:pt x="8020629" y="1093846"/>
                  </a:lnTo>
                  <a:lnTo>
                    <a:pt x="8028992" y="1127903"/>
                  </a:lnTo>
                  <a:lnTo>
                    <a:pt x="8037346" y="1137474"/>
                  </a:lnTo>
                  <a:lnTo>
                    <a:pt x="8104268" y="1225215"/>
                  </a:lnTo>
                  <a:lnTo>
                    <a:pt x="8112622" y="1237845"/>
                  </a:lnTo>
                  <a:lnTo>
                    <a:pt x="8120985" y="1216176"/>
                  </a:lnTo>
                  <a:lnTo>
                    <a:pt x="8187908" y="1101520"/>
                  </a:lnTo>
                  <a:lnTo>
                    <a:pt x="8196261" y="1091881"/>
                  </a:lnTo>
                  <a:lnTo>
                    <a:pt x="8204614" y="1045078"/>
                  </a:lnTo>
                  <a:lnTo>
                    <a:pt x="8271537" y="557472"/>
                  </a:lnTo>
                  <a:lnTo>
                    <a:pt x="8279900" y="477435"/>
                  </a:lnTo>
                  <a:lnTo>
                    <a:pt x="8288254" y="545074"/>
                  </a:lnTo>
                  <a:lnTo>
                    <a:pt x="8355177" y="1091542"/>
                  </a:lnTo>
                  <a:lnTo>
                    <a:pt x="8363530" y="1160527"/>
                  </a:lnTo>
                  <a:lnTo>
                    <a:pt x="8363530" y="1263017"/>
                  </a:lnTo>
                  <a:lnTo>
                    <a:pt x="8355177" y="1198716"/>
                  </a:lnTo>
                  <a:lnTo>
                    <a:pt x="8288254" y="689635"/>
                  </a:lnTo>
                  <a:lnTo>
                    <a:pt x="8279900" y="626650"/>
                  </a:lnTo>
                  <a:lnTo>
                    <a:pt x="8271537" y="718630"/>
                  </a:lnTo>
                  <a:lnTo>
                    <a:pt x="8204614" y="1279276"/>
                  </a:lnTo>
                  <a:lnTo>
                    <a:pt x="8196261" y="1333105"/>
                  </a:lnTo>
                  <a:lnTo>
                    <a:pt x="8187908" y="1327211"/>
                  </a:lnTo>
                  <a:lnTo>
                    <a:pt x="8120985" y="1257539"/>
                  </a:lnTo>
                  <a:lnTo>
                    <a:pt x="8112622" y="1244348"/>
                  </a:lnTo>
                  <a:lnTo>
                    <a:pt x="8104268" y="1243739"/>
                  </a:lnTo>
                  <a:lnTo>
                    <a:pt x="8037346" y="1239432"/>
                  </a:lnTo>
                  <a:lnTo>
                    <a:pt x="8028992" y="1238938"/>
                  </a:lnTo>
                  <a:lnTo>
                    <a:pt x="8020629" y="1211724"/>
                  </a:lnTo>
                  <a:lnTo>
                    <a:pt x="7953706" y="983458"/>
                  </a:lnTo>
                  <a:lnTo>
                    <a:pt x="7945353" y="953553"/>
                  </a:lnTo>
                  <a:lnTo>
                    <a:pt x="7937000" y="1000918"/>
                  </a:lnTo>
                  <a:lnTo>
                    <a:pt x="7870077" y="1268127"/>
                  </a:lnTo>
                  <a:lnTo>
                    <a:pt x="7861713" y="1291974"/>
                  </a:lnTo>
                  <a:lnTo>
                    <a:pt x="7853360" y="1249332"/>
                  </a:lnTo>
                  <a:lnTo>
                    <a:pt x="7786437" y="705255"/>
                  </a:lnTo>
                  <a:lnTo>
                    <a:pt x="7778084" y="593919"/>
                  </a:lnTo>
                  <a:lnTo>
                    <a:pt x="7769731" y="678708"/>
                  </a:lnTo>
                  <a:lnTo>
                    <a:pt x="7702798" y="1226309"/>
                  </a:lnTo>
                  <a:lnTo>
                    <a:pt x="7694444" y="1281850"/>
                  </a:lnTo>
                  <a:lnTo>
                    <a:pt x="7686091" y="1285247"/>
                  </a:lnTo>
                  <a:lnTo>
                    <a:pt x="7619168" y="1310197"/>
                  </a:lnTo>
                  <a:lnTo>
                    <a:pt x="7610815" y="1313072"/>
                  </a:lnTo>
                  <a:lnTo>
                    <a:pt x="7602452" y="1283321"/>
                  </a:lnTo>
                  <a:lnTo>
                    <a:pt x="7535528" y="1000240"/>
                  </a:lnTo>
                  <a:lnTo>
                    <a:pt x="7527175" y="958015"/>
                  </a:lnTo>
                  <a:lnTo>
                    <a:pt x="7518822" y="933927"/>
                  </a:lnTo>
                  <a:lnTo>
                    <a:pt x="7451899" y="774317"/>
                  </a:lnTo>
                  <a:lnTo>
                    <a:pt x="7443536" y="757719"/>
                  </a:lnTo>
                  <a:lnTo>
                    <a:pt x="7435183" y="803312"/>
                  </a:lnTo>
                  <a:lnTo>
                    <a:pt x="7368260" y="1238677"/>
                  </a:lnTo>
                  <a:lnTo>
                    <a:pt x="7359906" y="1303887"/>
                  </a:lnTo>
                  <a:lnTo>
                    <a:pt x="7351543" y="1300829"/>
                  </a:lnTo>
                  <a:lnTo>
                    <a:pt x="7284620" y="1277689"/>
                  </a:lnTo>
                  <a:lnTo>
                    <a:pt x="7276267" y="1274969"/>
                  </a:lnTo>
                  <a:lnTo>
                    <a:pt x="7267914" y="1277989"/>
                  </a:lnTo>
                  <a:lnTo>
                    <a:pt x="7200991" y="1304187"/>
                  </a:lnTo>
                  <a:lnTo>
                    <a:pt x="7192628" y="1307739"/>
                  </a:lnTo>
                  <a:lnTo>
                    <a:pt x="7184274" y="1305968"/>
                  </a:lnTo>
                  <a:lnTo>
                    <a:pt x="7117351" y="1292283"/>
                  </a:lnTo>
                  <a:lnTo>
                    <a:pt x="7108998" y="1290619"/>
                  </a:lnTo>
                  <a:lnTo>
                    <a:pt x="7100645" y="1294587"/>
                  </a:lnTo>
                  <a:lnTo>
                    <a:pt x="7033712" y="1324192"/>
                  </a:lnTo>
                  <a:lnTo>
                    <a:pt x="7025359" y="1327666"/>
                  </a:lnTo>
                  <a:lnTo>
                    <a:pt x="7017006" y="1322788"/>
                  </a:lnTo>
                  <a:lnTo>
                    <a:pt x="6950083" y="1291112"/>
                  </a:lnTo>
                  <a:lnTo>
                    <a:pt x="6941729" y="1287860"/>
                  </a:lnTo>
                  <a:lnTo>
                    <a:pt x="6933366" y="1290280"/>
                  </a:lnTo>
                  <a:lnTo>
                    <a:pt x="6866443" y="1318327"/>
                  </a:lnTo>
                  <a:lnTo>
                    <a:pt x="6858090" y="1323543"/>
                  </a:lnTo>
                  <a:lnTo>
                    <a:pt x="6849737" y="1305852"/>
                  </a:lnTo>
                  <a:lnTo>
                    <a:pt x="6782814" y="1184345"/>
                  </a:lnTo>
                  <a:lnTo>
                    <a:pt x="6774451" y="1171270"/>
                  </a:lnTo>
                  <a:lnTo>
                    <a:pt x="6766097" y="1191264"/>
                  </a:lnTo>
                  <a:lnTo>
                    <a:pt x="6699174" y="1318143"/>
                  </a:lnTo>
                  <a:lnTo>
                    <a:pt x="6690821" y="1330802"/>
                  </a:lnTo>
                  <a:lnTo>
                    <a:pt x="6682458" y="1324869"/>
                  </a:lnTo>
                  <a:lnTo>
                    <a:pt x="6615535" y="1257839"/>
                  </a:lnTo>
                  <a:lnTo>
                    <a:pt x="6607182" y="1245819"/>
                  </a:lnTo>
                  <a:lnTo>
                    <a:pt x="6598829" y="1255420"/>
                  </a:lnTo>
                  <a:lnTo>
                    <a:pt x="6531944" y="1324192"/>
                  </a:lnTo>
                  <a:lnTo>
                    <a:pt x="6523542" y="1331905"/>
                  </a:lnTo>
                  <a:lnTo>
                    <a:pt x="6515189" y="1327027"/>
                  </a:lnTo>
                  <a:lnTo>
                    <a:pt x="6448305" y="1292506"/>
                  </a:lnTo>
                  <a:lnTo>
                    <a:pt x="6439913" y="1288693"/>
                  </a:lnTo>
                  <a:lnTo>
                    <a:pt x="6431560" y="1286796"/>
                  </a:lnTo>
                  <a:lnTo>
                    <a:pt x="6364665" y="1270508"/>
                  </a:lnTo>
                  <a:lnTo>
                    <a:pt x="6356273" y="1268311"/>
                  </a:lnTo>
                  <a:lnTo>
                    <a:pt x="6347920" y="1262417"/>
                  </a:lnTo>
                  <a:lnTo>
                    <a:pt x="6281036" y="1207223"/>
                  </a:lnTo>
                  <a:lnTo>
                    <a:pt x="6272644" y="1199133"/>
                  </a:lnTo>
                  <a:lnTo>
                    <a:pt x="6264280" y="1202152"/>
                  </a:lnTo>
                  <a:lnTo>
                    <a:pt x="6197396" y="1221208"/>
                  </a:lnTo>
                  <a:lnTo>
                    <a:pt x="6189004" y="1223057"/>
                  </a:lnTo>
                  <a:lnTo>
                    <a:pt x="6180651" y="1213911"/>
                  </a:lnTo>
                  <a:lnTo>
                    <a:pt x="6113767" y="1129074"/>
                  </a:lnTo>
                  <a:lnTo>
                    <a:pt x="6105365" y="1116754"/>
                  </a:lnTo>
                  <a:lnTo>
                    <a:pt x="6097011" y="1138606"/>
                  </a:lnTo>
                  <a:lnTo>
                    <a:pt x="6030127" y="1292467"/>
                  </a:lnTo>
                  <a:lnTo>
                    <a:pt x="6021735" y="1309442"/>
                  </a:lnTo>
                  <a:lnTo>
                    <a:pt x="6013372" y="1303132"/>
                  </a:lnTo>
                  <a:lnTo>
                    <a:pt x="5946488" y="1225060"/>
                  </a:lnTo>
                  <a:lnTo>
                    <a:pt x="5938096" y="1209565"/>
                  </a:lnTo>
                  <a:lnTo>
                    <a:pt x="5929743" y="1222989"/>
                  </a:lnTo>
                  <a:lnTo>
                    <a:pt x="5862858" y="1286873"/>
                  </a:lnTo>
                  <a:lnTo>
                    <a:pt x="5854457" y="1291790"/>
                  </a:lnTo>
                  <a:lnTo>
                    <a:pt x="5846103" y="1291258"/>
                  </a:lnTo>
                  <a:lnTo>
                    <a:pt x="5779219" y="1285625"/>
                  </a:lnTo>
                  <a:lnTo>
                    <a:pt x="5770827" y="1284686"/>
                  </a:lnTo>
                  <a:lnTo>
                    <a:pt x="5762474" y="1162501"/>
                  </a:lnTo>
                  <a:lnTo>
                    <a:pt x="5695580" y="483638"/>
                  </a:lnTo>
                  <a:lnTo>
                    <a:pt x="5687188" y="423828"/>
                  </a:lnTo>
                  <a:lnTo>
                    <a:pt x="5678835" y="514908"/>
                  </a:lnTo>
                  <a:lnTo>
                    <a:pt x="5611950" y="1246652"/>
                  </a:lnTo>
                  <a:lnTo>
                    <a:pt x="5603558" y="1338554"/>
                  </a:lnTo>
                  <a:lnTo>
                    <a:pt x="5595195" y="1328992"/>
                  </a:lnTo>
                  <a:lnTo>
                    <a:pt x="5528311" y="1220337"/>
                  </a:lnTo>
                  <a:lnTo>
                    <a:pt x="5519919" y="1200720"/>
                  </a:lnTo>
                  <a:lnTo>
                    <a:pt x="5511566" y="1201736"/>
                  </a:lnTo>
                  <a:lnTo>
                    <a:pt x="5444672" y="1220376"/>
                  </a:lnTo>
                  <a:lnTo>
                    <a:pt x="5436280" y="1226047"/>
                  </a:lnTo>
                  <a:lnTo>
                    <a:pt x="5427926" y="1212963"/>
                  </a:lnTo>
                  <a:lnTo>
                    <a:pt x="5361042" y="1174938"/>
                  </a:lnTo>
                  <a:lnTo>
                    <a:pt x="5352650" y="1173041"/>
                  </a:lnTo>
                  <a:lnTo>
                    <a:pt x="5344287" y="1143368"/>
                  </a:lnTo>
                  <a:lnTo>
                    <a:pt x="5277403" y="938659"/>
                  </a:lnTo>
                  <a:lnTo>
                    <a:pt x="5269049" y="916506"/>
                  </a:lnTo>
                  <a:lnTo>
                    <a:pt x="5260657" y="952982"/>
                  </a:lnTo>
                  <a:lnTo>
                    <a:pt x="5193773" y="1221624"/>
                  </a:lnTo>
                  <a:lnTo>
                    <a:pt x="5185410" y="1252546"/>
                  </a:lnTo>
                  <a:lnTo>
                    <a:pt x="5177018" y="1251297"/>
                  </a:lnTo>
                  <a:lnTo>
                    <a:pt x="5110134" y="1237506"/>
                  </a:lnTo>
                  <a:lnTo>
                    <a:pt x="5101780" y="1235125"/>
                  </a:lnTo>
                  <a:lnTo>
                    <a:pt x="5093388" y="1244232"/>
                  </a:lnTo>
                  <a:lnTo>
                    <a:pt x="5026494" y="1305358"/>
                  </a:lnTo>
                  <a:lnTo>
                    <a:pt x="5018141" y="1311785"/>
                  </a:lnTo>
                  <a:lnTo>
                    <a:pt x="5009749" y="1294471"/>
                  </a:lnTo>
                  <a:lnTo>
                    <a:pt x="4942864" y="1171947"/>
                  </a:lnTo>
                  <a:lnTo>
                    <a:pt x="4934501" y="1158379"/>
                  </a:lnTo>
                  <a:lnTo>
                    <a:pt x="4926109" y="1153956"/>
                  </a:lnTo>
                  <a:lnTo>
                    <a:pt x="4859225" y="1100833"/>
                  </a:lnTo>
                  <a:lnTo>
                    <a:pt x="4850872" y="1090671"/>
                  </a:lnTo>
                  <a:lnTo>
                    <a:pt x="4842480" y="1084584"/>
                  </a:lnTo>
                  <a:lnTo>
                    <a:pt x="4775595" y="1047720"/>
                  </a:lnTo>
                  <a:lnTo>
                    <a:pt x="4767232" y="1044207"/>
                  </a:lnTo>
                  <a:lnTo>
                    <a:pt x="4758840" y="1014680"/>
                  </a:lnTo>
                  <a:lnTo>
                    <a:pt x="4691956" y="750238"/>
                  </a:lnTo>
                  <a:lnTo>
                    <a:pt x="4683603" y="713152"/>
                  </a:lnTo>
                  <a:lnTo>
                    <a:pt x="4675201" y="768423"/>
                  </a:lnTo>
                  <a:lnTo>
                    <a:pt x="4608317" y="1220260"/>
                  </a:lnTo>
                  <a:lnTo>
                    <a:pt x="4599964" y="1277989"/>
                  </a:lnTo>
                  <a:lnTo>
                    <a:pt x="4591572" y="1261430"/>
                  </a:lnTo>
                  <a:lnTo>
                    <a:pt x="4524687" y="1142836"/>
                  </a:lnTo>
                  <a:lnTo>
                    <a:pt x="4516324" y="1129529"/>
                  </a:lnTo>
                  <a:lnTo>
                    <a:pt x="4507932" y="1147713"/>
                  </a:lnTo>
                  <a:lnTo>
                    <a:pt x="4441048" y="1285402"/>
                  </a:lnTo>
                  <a:lnTo>
                    <a:pt x="4432695" y="1301690"/>
                  </a:lnTo>
                  <a:lnTo>
                    <a:pt x="4424303" y="1177696"/>
                  </a:lnTo>
                  <a:lnTo>
                    <a:pt x="4357409" y="177233"/>
                  </a:lnTo>
                  <a:lnTo>
                    <a:pt x="4349055" y="51080"/>
                  </a:lnTo>
                  <a:lnTo>
                    <a:pt x="4340664" y="165436"/>
                  </a:lnTo>
                  <a:lnTo>
                    <a:pt x="4273779" y="1155543"/>
                  </a:lnTo>
                  <a:lnTo>
                    <a:pt x="4265416" y="1289593"/>
                  </a:lnTo>
                  <a:lnTo>
                    <a:pt x="4257024" y="1256029"/>
                  </a:lnTo>
                  <a:lnTo>
                    <a:pt x="4190140" y="1042243"/>
                  </a:lnTo>
                  <a:lnTo>
                    <a:pt x="4181787" y="1020806"/>
                  </a:lnTo>
                  <a:lnTo>
                    <a:pt x="4173394" y="1037481"/>
                  </a:lnTo>
                  <a:lnTo>
                    <a:pt x="4106500" y="1241474"/>
                  </a:lnTo>
                  <a:lnTo>
                    <a:pt x="4098147" y="1281318"/>
                  </a:lnTo>
                  <a:lnTo>
                    <a:pt x="4089755" y="1289593"/>
                  </a:lnTo>
                  <a:lnTo>
                    <a:pt x="4022871" y="1332699"/>
                  </a:lnTo>
                  <a:lnTo>
                    <a:pt x="4014517" y="1336289"/>
                  </a:lnTo>
                  <a:lnTo>
                    <a:pt x="4006154" y="1327743"/>
                  </a:lnTo>
                  <a:lnTo>
                    <a:pt x="3939231" y="1250281"/>
                  </a:lnTo>
                  <a:lnTo>
                    <a:pt x="3930878" y="1239277"/>
                  </a:lnTo>
                  <a:lnTo>
                    <a:pt x="3922525" y="1233528"/>
                  </a:lnTo>
                  <a:lnTo>
                    <a:pt x="3855602" y="1182196"/>
                  </a:lnTo>
                  <a:lnTo>
                    <a:pt x="3847239" y="1175044"/>
                  </a:lnTo>
                  <a:lnTo>
                    <a:pt x="3838885" y="1143484"/>
                  </a:lnTo>
                  <a:lnTo>
                    <a:pt x="3771962" y="913216"/>
                  </a:lnTo>
                  <a:lnTo>
                    <a:pt x="3763609" y="886901"/>
                  </a:lnTo>
                  <a:lnTo>
                    <a:pt x="3755246" y="910641"/>
                  </a:lnTo>
                  <a:lnTo>
                    <a:pt x="3688323" y="1126770"/>
                  </a:lnTo>
                  <a:lnTo>
                    <a:pt x="3679970" y="1157585"/>
                  </a:lnTo>
                  <a:lnTo>
                    <a:pt x="3671616" y="1117586"/>
                  </a:lnTo>
                  <a:lnTo>
                    <a:pt x="3604693" y="877833"/>
                  </a:lnTo>
                  <a:lnTo>
                    <a:pt x="3596330" y="855148"/>
                  </a:lnTo>
                  <a:lnTo>
                    <a:pt x="3587977" y="890269"/>
                  </a:lnTo>
                  <a:lnTo>
                    <a:pt x="3521054" y="1213572"/>
                  </a:lnTo>
                  <a:lnTo>
                    <a:pt x="3512701" y="1260220"/>
                  </a:lnTo>
                  <a:lnTo>
                    <a:pt x="3504347" y="1260259"/>
                  </a:lnTo>
                  <a:lnTo>
                    <a:pt x="3437424" y="1260452"/>
                  </a:lnTo>
                  <a:lnTo>
                    <a:pt x="3429061" y="1260452"/>
                  </a:lnTo>
                  <a:lnTo>
                    <a:pt x="3420708" y="1263133"/>
                  </a:lnTo>
                  <a:lnTo>
                    <a:pt x="3353785" y="1315723"/>
                  </a:lnTo>
                  <a:lnTo>
                    <a:pt x="3345432" y="1333637"/>
                  </a:lnTo>
                  <a:lnTo>
                    <a:pt x="3337069" y="1317872"/>
                  </a:lnTo>
                  <a:lnTo>
                    <a:pt x="3270146" y="1262640"/>
                  </a:lnTo>
                  <a:lnTo>
                    <a:pt x="3261792" y="1259388"/>
                  </a:lnTo>
                  <a:lnTo>
                    <a:pt x="3253439" y="1185293"/>
                  </a:lnTo>
                  <a:lnTo>
                    <a:pt x="3186516" y="714062"/>
                  </a:lnTo>
                  <a:lnTo>
                    <a:pt x="3178153" y="666949"/>
                  </a:lnTo>
                  <a:lnTo>
                    <a:pt x="3169800" y="699845"/>
                  </a:lnTo>
                  <a:lnTo>
                    <a:pt x="3102877" y="1064473"/>
                  </a:lnTo>
                  <a:lnTo>
                    <a:pt x="3094523" y="1128435"/>
                  </a:lnTo>
                  <a:lnTo>
                    <a:pt x="3086161" y="1144162"/>
                  </a:lnTo>
                  <a:lnTo>
                    <a:pt x="3019238" y="1243061"/>
                  </a:lnTo>
                  <a:lnTo>
                    <a:pt x="3010884" y="1252816"/>
                  </a:lnTo>
                  <a:lnTo>
                    <a:pt x="3002531" y="1192552"/>
                  </a:lnTo>
                  <a:lnTo>
                    <a:pt x="2935608" y="689935"/>
                  </a:lnTo>
                  <a:lnTo>
                    <a:pt x="2927245" y="624424"/>
                  </a:lnTo>
                  <a:lnTo>
                    <a:pt x="2918892" y="676937"/>
                  </a:lnTo>
                  <a:lnTo>
                    <a:pt x="2851968" y="1085716"/>
                  </a:lnTo>
                  <a:lnTo>
                    <a:pt x="2843615" y="1135432"/>
                  </a:lnTo>
                  <a:lnTo>
                    <a:pt x="2835262" y="1139816"/>
                  </a:lnTo>
                  <a:lnTo>
                    <a:pt x="2768329" y="1186048"/>
                  </a:lnTo>
                  <a:lnTo>
                    <a:pt x="2759976" y="1193761"/>
                  </a:lnTo>
                  <a:lnTo>
                    <a:pt x="2751623" y="1202191"/>
                  </a:lnTo>
                  <a:lnTo>
                    <a:pt x="2684699" y="1259165"/>
                  </a:lnTo>
                  <a:lnTo>
                    <a:pt x="2676346" y="1265175"/>
                  </a:lnTo>
                  <a:lnTo>
                    <a:pt x="2667983" y="1266646"/>
                  </a:lnTo>
                  <a:lnTo>
                    <a:pt x="2601060" y="1278066"/>
                  </a:lnTo>
                  <a:lnTo>
                    <a:pt x="2592707" y="1279470"/>
                  </a:lnTo>
                  <a:lnTo>
                    <a:pt x="2584354" y="1275531"/>
                  </a:lnTo>
                  <a:lnTo>
                    <a:pt x="2517430" y="1248655"/>
                  </a:lnTo>
                  <a:lnTo>
                    <a:pt x="2509068" y="1245781"/>
                  </a:lnTo>
                  <a:lnTo>
                    <a:pt x="2500714" y="1217317"/>
                  </a:lnTo>
                  <a:lnTo>
                    <a:pt x="2433791" y="976084"/>
                  </a:lnTo>
                  <a:lnTo>
                    <a:pt x="2425438" y="944137"/>
                  </a:lnTo>
                  <a:lnTo>
                    <a:pt x="2417075" y="978803"/>
                  </a:lnTo>
                  <a:lnTo>
                    <a:pt x="2350152" y="1270924"/>
                  </a:lnTo>
                  <a:lnTo>
                    <a:pt x="2341799" y="1309365"/>
                  </a:lnTo>
                  <a:lnTo>
                    <a:pt x="2333445" y="1309713"/>
                  </a:lnTo>
                  <a:lnTo>
                    <a:pt x="2266522" y="1313033"/>
                  </a:lnTo>
                  <a:lnTo>
                    <a:pt x="2258159" y="1313527"/>
                  </a:lnTo>
                  <a:lnTo>
                    <a:pt x="2249806" y="1307971"/>
                  </a:lnTo>
                  <a:lnTo>
                    <a:pt x="2182883" y="1270924"/>
                  </a:lnTo>
                  <a:lnTo>
                    <a:pt x="2174530" y="1267024"/>
                  </a:lnTo>
                  <a:lnTo>
                    <a:pt x="2166176" y="1211453"/>
                  </a:lnTo>
                  <a:lnTo>
                    <a:pt x="2099253" y="695799"/>
                  </a:lnTo>
                  <a:lnTo>
                    <a:pt x="2090890" y="620872"/>
                  </a:lnTo>
                  <a:lnTo>
                    <a:pt x="2082537" y="698935"/>
                  </a:lnTo>
                  <a:lnTo>
                    <a:pt x="2015614" y="1175954"/>
                  </a:lnTo>
                  <a:lnTo>
                    <a:pt x="2007260" y="1221847"/>
                  </a:lnTo>
                  <a:lnTo>
                    <a:pt x="1998898" y="1222989"/>
                  </a:lnTo>
                  <a:lnTo>
                    <a:pt x="1931975" y="1234515"/>
                  </a:lnTo>
                  <a:lnTo>
                    <a:pt x="1923621" y="1236403"/>
                  </a:lnTo>
                  <a:lnTo>
                    <a:pt x="1915268" y="1237428"/>
                  </a:lnTo>
                  <a:lnTo>
                    <a:pt x="1848345" y="1245703"/>
                  </a:lnTo>
                  <a:lnTo>
                    <a:pt x="1839982" y="1246729"/>
                  </a:lnTo>
                  <a:lnTo>
                    <a:pt x="1831629" y="1240409"/>
                  </a:lnTo>
                  <a:lnTo>
                    <a:pt x="1764706" y="1192852"/>
                  </a:lnTo>
                  <a:lnTo>
                    <a:pt x="1756352" y="1187258"/>
                  </a:lnTo>
                  <a:lnTo>
                    <a:pt x="1747989" y="1190326"/>
                  </a:lnTo>
                  <a:lnTo>
                    <a:pt x="1681066" y="1210543"/>
                  </a:lnTo>
                  <a:lnTo>
                    <a:pt x="1672713" y="1212624"/>
                  </a:lnTo>
                  <a:lnTo>
                    <a:pt x="1664360" y="1209565"/>
                  </a:lnTo>
                  <a:lnTo>
                    <a:pt x="1597437" y="1173418"/>
                  </a:lnTo>
                  <a:lnTo>
                    <a:pt x="1589074" y="1166576"/>
                  </a:lnTo>
                  <a:lnTo>
                    <a:pt x="1580720" y="1183483"/>
                  </a:lnTo>
                  <a:lnTo>
                    <a:pt x="1513797" y="1289070"/>
                  </a:lnTo>
                  <a:lnTo>
                    <a:pt x="1505444" y="1299426"/>
                  </a:lnTo>
                  <a:lnTo>
                    <a:pt x="1497091" y="1297084"/>
                  </a:lnTo>
                  <a:lnTo>
                    <a:pt x="1430158" y="1281434"/>
                  </a:lnTo>
                  <a:lnTo>
                    <a:pt x="1421805" y="1279770"/>
                  </a:lnTo>
                  <a:lnTo>
                    <a:pt x="1413451" y="1271824"/>
                  </a:lnTo>
                  <a:lnTo>
                    <a:pt x="1346528" y="1177086"/>
                  </a:lnTo>
                  <a:lnTo>
                    <a:pt x="1338175" y="1159056"/>
                  </a:lnTo>
                  <a:lnTo>
                    <a:pt x="1329812" y="1135655"/>
                  </a:lnTo>
                  <a:lnTo>
                    <a:pt x="1262889" y="1020167"/>
                  </a:lnTo>
                  <a:lnTo>
                    <a:pt x="1254536" y="1011050"/>
                  </a:lnTo>
                  <a:lnTo>
                    <a:pt x="1246182" y="1017554"/>
                  </a:lnTo>
                  <a:lnTo>
                    <a:pt x="1179259" y="1079097"/>
                  </a:lnTo>
                  <a:lnTo>
                    <a:pt x="1170896" y="1088213"/>
                  </a:lnTo>
                  <a:lnTo>
                    <a:pt x="1162543" y="1088552"/>
                  </a:lnTo>
                  <a:lnTo>
                    <a:pt x="1095620" y="1091155"/>
                  </a:lnTo>
                  <a:lnTo>
                    <a:pt x="1087267" y="1091465"/>
                  </a:lnTo>
                  <a:lnTo>
                    <a:pt x="1078904" y="1113841"/>
                  </a:lnTo>
                  <a:lnTo>
                    <a:pt x="1011981" y="1262040"/>
                  </a:lnTo>
                  <a:lnTo>
                    <a:pt x="1003627" y="1277457"/>
                  </a:lnTo>
                  <a:lnTo>
                    <a:pt x="995274" y="1250920"/>
                  </a:lnTo>
                  <a:lnTo>
                    <a:pt x="928351" y="976006"/>
                  </a:lnTo>
                  <a:lnTo>
                    <a:pt x="919988" y="931207"/>
                  </a:lnTo>
                  <a:lnTo>
                    <a:pt x="911635" y="950224"/>
                  </a:lnTo>
                  <a:lnTo>
                    <a:pt x="844712" y="1073541"/>
                  </a:lnTo>
                  <a:lnTo>
                    <a:pt x="836358" y="1086094"/>
                  </a:lnTo>
                  <a:lnTo>
                    <a:pt x="828005" y="1099662"/>
                  </a:lnTo>
                  <a:lnTo>
                    <a:pt x="761082" y="1237845"/>
                  </a:lnTo>
                  <a:lnTo>
                    <a:pt x="752719" y="1259959"/>
                  </a:lnTo>
                  <a:lnTo>
                    <a:pt x="744366" y="1253910"/>
                  </a:lnTo>
                  <a:lnTo>
                    <a:pt x="677443" y="1195919"/>
                  </a:lnTo>
                  <a:lnTo>
                    <a:pt x="669089" y="1187219"/>
                  </a:lnTo>
                  <a:lnTo>
                    <a:pt x="660727" y="1168695"/>
                  </a:lnTo>
                  <a:lnTo>
                    <a:pt x="593803" y="1067725"/>
                  </a:lnTo>
                  <a:lnTo>
                    <a:pt x="585450" y="1058986"/>
                  </a:lnTo>
                  <a:lnTo>
                    <a:pt x="577097" y="1046365"/>
                  </a:lnTo>
                  <a:lnTo>
                    <a:pt x="510174" y="884598"/>
                  </a:lnTo>
                  <a:lnTo>
                    <a:pt x="501811" y="851325"/>
                  </a:lnTo>
                  <a:lnTo>
                    <a:pt x="493458" y="912267"/>
                  </a:lnTo>
                  <a:lnTo>
                    <a:pt x="426534" y="1184916"/>
                  </a:lnTo>
                  <a:lnTo>
                    <a:pt x="418181" y="1204688"/>
                  </a:lnTo>
                  <a:lnTo>
                    <a:pt x="409818" y="1192929"/>
                  </a:lnTo>
                  <a:lnTo>
                    <a:pt x="342895" y="1064812"/>
                  </a:lnTo>
                  <a:lnTo>
                    <a:pt x="334542" y="1042804"/>
                  </a:lnTo>
                  <a:lnTo>
                    <a:pt x="326189" y="1067647"/>
                  </a:lnTo>
                  <a:lnTo>
                    <a:pt x="259304" y="1297084"/>
                  </a:lnTo>
                  <a:lnTo>
                    <a:pt x="250903" y="1330279"/>
                  </a:lnTo>
                  <a:lnTo>
                    <a:pt x="242549" y="1287028"/>
                  </a:lnTo>
                  <a:lnTo>
                    <a:pt x="175665" y="1045340"/>
                  </a:lnTo>
                  <a:lnTo>
                    <a:pt x="167273" y="1023942"/>
                  </a:lnTo>
                  <a:lnTo>
                    <a:pt x="158920" y="1016644"/>
                  </a:lnTo>
                  <a:lnTo>
                    <a:pt x="92029" y="949508"/>
                  </a:lnTo>
                  <a:lnTo>
                    <a:pt x="83635" y="939830"/>
                  </a:lnTo>
                  <a:lnTo>
                    <a:pt x="75279" y="919264"/>
                  </a:lnTo>
                  <a:lnTo>
                    <a:pt x="8394" y="757080"/>
                  </a:lnTo>
                  <a:lnTo>
                    <a:pt x="0" y="737047"/>
                  </a:lnTo>
                  <a:close/>
                </a:path>
              </a:pathLst>
            </a:custGeom>
            <a:solidFill>
              <a:srgbClr val="D9D9D9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06" name="Freeform: Shape 3005">
              <a:extLst>
                <a:ext uri="{FF2B5EF4-FFF2-40B4-BE49-F238E27FC236}">
                  <a16:creationId xmlns:a16="http://schemas.microsoft.com/office/drawing/2014/main" id="{7DA1B6D5-2CE1-B092-A310-89A8F8F0C2C3}"/>
                </a:ext>
              </a:extLst>
            </p:cNvPr>
            <p:cNvSpPr/>
            <p:nvPr/>
          </p:nvSpPr>
          <p:spPr>
            <a:xfrm>
              <a:off x="1961705" y="3345226"/>
              <a:ext cx="8363529" cy="1292118"/>
            </a:xfrm>
            <a:custGeom>
              <a:avLst/>
              <a:gdLst>
                <a:gd name="connsiteX0" fmla="*/ 0 w 8363529"/>
                <a:gd name="connsiteY0" fmla="*/ 685967 h 1292118"/>
                <a:gd name="connsiteX1" fmla="*/ 8394 w 8363529"/>
                <a:gd name="connsiteY1" fmla="*/ 706000 h 1292118"/>
                <a:gd name="connsiteX2" fmla="*/ 75279 w 8363529"/>
                <a:gd name="connsiteY2" fmla="*/ 868184 h 1292118"/>
                <a:gd name="connsiteX3" fmla="*/ 83635 w 8363529"/>
                <a:gd name="connsiteY3" fmla="*/ 888750 h 1292118"/>
                <a:gd name="connsiteX4" fmla="*/ 92029 w 8363529"/>
                <a:gd name="connsiteY4" fmla="*/ 898428 h 1292118"/>
                <a:gd name="connsiteX5" fmla="*/ 158920 w 8363529"/>
                <a:gd name="connsiteY5" fmla="*/ 965564 h 1292118"/>
                <a:gd name="connsiteX6" fmla="*/ 167273 w 8363529"/>
                <a:gd name="connsiteY6" fmla="*/ 972861 h 1292118"/>
                <a:gd name="connsiteX7" fmla="*/ 175665 w 8363529"/>
                <a:gd name="connsiteY7" fmla="*/ 994259 h 1292118"/>
                <a:gd name="connsiteX8" fmla="*/ 242549 w 8363529"/>
                <a:gd name="connsiteY8" fmla="*/ 1235948 h 1292118"/>
                <a:gd name="connsiteX9" fmla="*/ 250903 w 8363529"/>
                <a:gd name="connsiteY9" fmla="*/ 1279199 h 1292118"/>
                <a:gd name="connsiteX10" fmla="*/ 259304 w 8363529"/>
                <a:gd name="connsiteY10" fmla="*/ 1246003 h 1292118"/>
                <a:gd name="connsiteX11" fmla="*/ 326189 w 8363529"/>
                <a:gd name="connsiteY11" fmla="*/ 1016567 h 1292118"/>
                <a:gd name="connsiteX12" fmla="*/ 334542 w 8363529"/>
                <a:gd name="connsiteY12" fmla="*/ 991724 h 1292118"/>
                <a:gd name="connsiteX13" fmla="*/ 342895 w 8363529"/>
                <a:gd name="connsiteY13" fmla="*/ 1013731 h 1292118"/>
                <a:gd name="connsiteX14" fmla="*/ 409818 w 8363529"/>
                <a:gd name="connsiteY14" fmla="*/ 1141849 h 1292118"/>
                <a:gd name="connsiteX15" fmla="*/ 418181 w 8363529"/>
                <a:gd name="connsiteY15" fmla="*/ 1153607 h 1292118"/>
                <a:gd name="connsiteX16" fmla="*/ 426534 w 8363529"/>
                <a:gd name="connsiteY16" fmla="*/ 1133835 h 1292118"/>
                <a:gd name="connsiteX17" fmla="*/ 493458 w 8363529"/>
                <a:gd name="connsiteY17" fmla="*/ 861187 h 1292118"/>
                <a:gd name="connsiteX18" fmla="*/ 501811 w 8363529"/>
                <a:gd name="connsiteY18" fmla="*/ 800245 h 1292118"/>
                <a:gd name="connsiteX19" fmla="*/ 510174 w 8363529"/>
                <a:gd name="connsiteY19" fmla="*/ 833517 h 1292118"/>
                <a:gd name="connsiteX20" fmla="*/ 577097 w 8363529"/>
                <a:gd name="connsiteY20" fmla="*/ 995285 h 1292118"/>
                <a:gd name="connsiteX21" fmla="*/ 585450 w 8363529"/>
                <a:gd name="connsiteY21" fmla="*/ 1007905 h 1292118"/>
                <a:gd name="connsiteX22" fmla="*/ 593803 w 8363529"/>
                <a:gd name="connsiteY22" fmla="*/ 1016644 h 1292118"/>
                <a:gd name="connsiteX23" fmla="*/ 660727 w 8363529"/>
                <a:gd name="connsiteY23" fmla="*/ 1117615 h 1292118"/>
                <a:gd name="connsiteX24" fmla="*/ 669089 w 8363529"/>
                <a:gd name="connsiteY24" fmla="*/ 1136139 h 1292118"/>
                <a:gd name="connsiteX25" fmla="*/ 677443 w 8363529"/>
                <a:gd name="connsiteY25" fmla="*/ 1144839 h 1292118"/>
                <a:gd name="connsiteX26" fmla="*/ 744366 w 8363529"/>
                <a:gd name="connsiteY26" fmla="*/ 1202830 h 1292118"/>
                <a:gd name="connsiteX27" fmla="*/ 752719 w 8363529"/>
                <a:gd name="connsiteY27" fmla="*/ 1208878 h 1292118"/>
                <a:gd name="connsiteX28" fmla="*/ 761082 w 8363529"/>
                <a:gd name="connsiteY28" fmla="*/ 1186764 h 1292118"/>
                <a:gd name="connsiteX29" fmla="*/ 828005 w 8363529"/>
                <a:gd name="connsiteY29" fmla="*/ 1048582 h 1292118"/>
                <a:gd name="connsiteX30" fmla="*/ 836358 w 8363529"/>
                <a:gd name="connsiteY30" fmla="*/ 1035013 h 1292118"/>
                <a:gd name="connsiteX31" fmla="*/ 844712 w 8363529"/>
                <a:gd name="connsiteY31" fmla="*/ 1022461 h 1292118"/>
                <a:gd name="connsiteX32" fmla="*/ 911635 w 8363529"/>
                <a:gd name="connsiteY32" fmla="*/ 899144 h 1292118"/>
                <a:gd name="connsiteX33" fmla="*/ 919988 w 8363529"/>
                <a:gd name="connsiteY33" fmla="*/ 880127 h 1292118"/>
                <a:gd name="connsiteX34" fmla="*/ 928351 w 8363529"/>
                <a:gd name="connsiteY34" fmla="*/ 924926 h 1292118"/>
                <a:gd name="connsiteX35" fmla="*/ 995274 w 8363529"/>
                <a:gd name="connsiteY35" fmla="*/ 1199839 h 1292118"/>
                <a:gd name="connsiteX36" fmla="*/ 1003627 w 8363529"/>
                <a:gd name="connsiteY36" fmla="*/ 1226376 h 1292118"/>
                <a:gd name="connsiteX37" fmla="*/ 1011981 w 8363529"/>
                <a:gd name="connsiteY37" fmla="*/ 1210959 h 1292118"/>
                <a:gd name="connsiteX38" fmla="*/ 1078904 w 8363529"/>
                <a:gd name="connsiteY38" fmla="*/ 1062760 h 1292118"/>
                <a:gd name="connsiteX39" fmla="*/ 1087267 w 8363529"/>
                <a:gd name="connsiteY39" fmla="*/ 1040385 h 1292118"/>
                <a:gd name="connsiteX40" fmla="*/ 1095620 w 8363529"/>
                <a:gd name="connsiteY40" fmla="*/ 1040075 h 1292118"/>
                <a:gd name="connsiteX41" fmla="*/ 1162543 w 8363529"/>
                <a:gd name="connsiteY41" fmla="*/ 1037472 h 1292118"/>
                <a:gd name="connsiteX42" fmla="*/ 1170896 w 8363529"/>
                <a:gd name="connsiteY42" fmla="*/ 1037133 h 1292118"/>
                <a:gd name="connsiteX43" fmla="*/ 1179259 w 8363529"/>
                <a:gd name="connsiteY43" fmla="*/ 1028016 h 1292118"/>
                <a:gd name="connsiteX44" fmla="*/ 1246182 w 8363529"/>
                <a:gd name="connsiteY44" fmla="*/ 966474 h 1292118"/>
                <a:gd name="connsiteX45" fmla="*/ 1254536 w 8363529"/>
                <a:gd name="connsiteY45" fmla="*/ 959970 h 1292118"/>
                <a:gd name="connsiteX46" fmla="*/ 1262889 w 8363529"/>
                <a:gd name="connsiteY46" fmla="*/ 969087 h 1292118"/>
                <a:gd name="connsiteX47" fmla="*/ 1329812 w 8363529"/>
                <a:gd name="connsiteY47" fmla="*/ 1084574 h 1292118"/>
                <a:gd name="connsiteX48" fmla="*/ 1338175 w 8363529"/>
                <a:gd name="connsiteY48" fmla="*/ 1107976 h 1292118"/>
                <a:gd name="connsiteX49" fmla="*/ 1346528 w 8363529"/>
                <a:gd name="connsiteY49" fmla="*/ 1126006 h 1292118"/>
                <a:gd name="connsiteX50" fmla="*/ 1413451 w 8363529"/>
                <a:gd name="connsiteY50" fmla="*/ 1220744 h 1292118"/>
                <a:gd name="connsiteX51" fmla="*/ 1421805 w 8363529"/>
                <a:gd name="connsiteY51" fmla="*/ 1228689 h 1292118"/>
                <a:gd name="connsiteX52" fmla="*/ 1430158 w 8363529"/>
                <a:gd name="connsiteY52" fmla="*/ 1230354 h 1292118"/>
                <a:gd name="connsiteX53" fmla="*/ 1497091 w 8363529"/>
                <a:gd name="connsiteY53" fmla="*/ 1246003 h 1292118"/>
                <a:gd name="connsiteX54" fmla="*/ 1505444 w 8363529"/>
                <a:gd name="connsiteY54" fmla="*/ 1248345 h 1292118"/>
                <a:gd name="connsiteX55" fmla="*/ 1513797 w 8363529"/>
                <a:gd name="connsiteY55" fmla="*/ 1237990 h 1292118"/>
                <a:gd name="connsiteX56" fmla="*/ 1580720 w 8363529"/>
                <a:gd name="connsiteY56" fmla="*/ 1132403 h 1292118"/>
                <a:gd name="connsiteX57" fmla="*/ 1589074 w 8363529"/>
                <a:gd name="connsiteY57" fmla="*/ 1115496 h 1292118"/>
                <a:gd name="connsiteX58" fmla="*/ 1597437 w 8363529"/>
                <a:gd name="connsiteY58" fmla="*/ 1122338 h 1292118"/>
                <a:gd name="connsiteX59" fmla="*/ 1664360 w 8363529"/>
                <a:gd name="connsiteY59" fmla="*/ 1158485 h 1292118"/>
                <a:gd name="connsiteX60" fmla="*/ 1672713 w 8363529"/>
                <a:gd name="connsiteY60" fmla="*/ 1161544 h 1292118"/>
                <a:gd name="connsiteX61" fmla="*/ 1681066 w 8363529"/>
                <a:gd name="connsiteY61" fmla="*/ 1159463 h 1292118"/>
                <a:gd name="connsiteX62" fmla="*/ 1747989 w 8363529"/>
                <a:gd name="connsiteY62" fmla="*/ 1139245 h 1292118"/>
                <a:gd name="connsiteX63" fmla="*/ 1756352 w 8363529"/>
                <a:gd name="connsiteY63" fmla="*/ 1136177 h 1292118"/>
                <a:gd name="connsiteX64" fmla="*/ 1764706 w 8363529"/>
                <a:gd name="connsiteY64" fmla="*/ 1141771 h 1292118"/>
                <a:gd name="connsiteX65" fmla="*/ 1831629 w 8363529"/>
                <a:gd name="connsiteY65" fmla="*/ 1189329 h 1292118"/>
                <a:gd name="connsiteX66" fmla="*/ 1839982 w 8363529"/>
                <a:gd name="connsiteY66" fmla="*/ 1195649 h 1292118"/>
                <a:gd name="connsiteX67" fmla="*/ 1848345 w 8363529"/>
                <a:gd name="connsiteY67" fmla="*/ 1194623 h 1292118"/>
                <a:gd name="connsiteX68" fmla="*/ 1915268 w 8363529"/>
                <a:gd name="connsiteY68" fmla="*/ 1186348 h 1292118"/>
                <a:gd name="connsiteX69" fmla="*/ 1923621 w 8363529"/>
                <a:gd name="connsiteY69" fmla="*/ 1185322 h 1292118"/>
                <a:gd name="connsiteX70" fmla="*/ 1931975 w 8363529"/>
                <a:gd name="connsiteY70" fmla="*/ 1183435 h 1292118"/>
                <a:gd name="connsiteX71" fmla="*/ 1998898 w 8363529"/>
                <a:gd name="connsiteY71" fmla="*/ 1171908 h 1292118"/>
                <a:gd name="connsiteX72" fmla="*/ 2007260 w 8363529"/>
                <a:gd name="connsiteY72" fmla="*/ 1170767 h 1292118"/>
                <a:gd name="connsiteX73" fmla="*/ 2015614 w 8363529"/>
                <a:gd name="connsiteY73" fmla="*/ 1124874 h 1292118"/>
                <a:gd name="connsiteX74" fmla="*/ 2082537 w 8363529"/>
                <a:gd name="connsiteY74" fmla="*/ 647855 h 1292118"/>
                <a:gd name="connsiteX75" fmla="*/ 2090890 w 8363529"/>
                <a:gd name="connsiteY75" fmla="*/ 569792 h 1292118"/>
                <a:gd name="connsiteX76" fmla="*/ 2099253 w 8363529"/>
                <a:gd name="connsiteY76" fmla="*/ 644719 h 1292118"/>
                <a:gd name="connsiteX77" fmla="*/ 2166176 w 8363529"/>
                <a:gd name="connsiteY77" fmla="*/ 1160372 h 1292118"/>
                <a:gd name="connsiteX78" fmla="*/ 2174530 w 8363529"/>
                <a:gd name="connsiteY78" fmla="*/ 1215944 h 1292118"/>
                <a:gd name="connsiteX79" fmla="*/ 2182883 w 8363529"/>
                <a:gd name="connsiteY79" fmla="*/ 1219844 h 1292118"/>
                <a:gd name="connsiteX80" fmla="*/ 2249806 w 8363529"/>
                <a:gd name="connsiteY80" fmla="*/ 1256891 h 1292118"/>
                <a:gd name="connsiteX81" fmla="*/ 2258159 w 8363529"/>
                <a:gd name="connsiteY81" fmla="*/ 1262446 h 1292118"/>
                <a:gd name="connsiteX82" fmla="*/ 2266522 w 8363529"/>
                <a:gd name="connsiteY82" fmla="*/ 1261953 h 1292118"/>
                <a:gd name="connsiteX83" fmla="*/ 2333445 w 8363529"/>
                <a:gd name="connsiteY83" fmla="*/ 1258633 h 1292118"/>
                <a:gd name="connsiteX84" fmla="*/ 2341799 w 8363529"/>
                <a:gd name="connsiteY84" fmla="*/ 1258285 h 1292118"/>
                <a:gd name="connsiteX85" fmla="*/ 2350152 w 8363529"/>
                <a:gd name="connsiteY85" fmla="*/ 1219844 h 1292118"/>
                <a:gd name="connsiteX86" fmla="*/ 2417075 w 8363529"/>
                <a:gd name="connsiteY86" fmla="*/ 927723 h 1292118"/>
                <a:gd name="connsiteX87" fmla="*/ 2425438 w 8363529"/>
                <a:gd name="connsiteY87" fmla="*/ 893056 h 1292118"/>
                <a:gd name="connsiteX88" fmla="*/ 2433791 w 8363529"/>
                <a:gd name="connsiteY88" fmla="*/ 925003 h 1292118"/>
                <a:gd name="connsiteX89" fmla="*/ 2500714 w 8363529"/>
                <a:gd name="connsiteY89" fmla="*/ 1166237 h 1292118"/>
                <a:gd name="connsiteX90" fmla="*/ 2509068 w 8363529"/>
                <a:gd name="connsiteY90" fmla="*/ 1194700 h 1292118"/>
                <a:gd name="connsiteX91" fmla="*/ 2517430 w 8363529"/>
                <a:gd name="connsiteY91" fmla="*/ 1197575 h 1292118"/>
                <a:gd name="connsiteX92" fmla="*/ 2584354 w 8363529"/>
                <a:gd name="connsiteY92" fmla="*/ 1224450 h 1292118"/>
                <a:gd name="connsiteX93" fmla="*/ 2592707 w 8363529"/>
                <a:gd name="connsiteY93" fmla="*/ 1228389 h 1292118"/>
                <a:gd name="connsiteX94" fmla="*/ 2601060 w 8363529"/>
                <a:gd name="connsiteY94" fmla="*/ 1226986 h 1292118"/>
                <a:gd name="connsiteX95" fmla="*/ 2667983 w 8363529"/>
                <a:gd name="connsiteY95" fmla="*/ 1215566 h 1292118"/>
                <a:gd name="connsiteX96" fmla="*/ 2676346 w 8363529"/>
                <a:gd name="connsiteY96" fmla="*/ 1214095 h 1292118"/>
                <a:gd name="connsiteX97" fmla="*/ 2684699 w 8363529"/>
                <a:gd name="connsiteY97" fmla="*/ 1208085 h 1292118"/>
                <a:gd name="connsiteX98" fmla="*/ 2751623 w 8363529"/>
                <a:gd name="connsiteY98" fmla="*/ 1151111 h 1292118"/>
                <a:gd name="connsiteX99" fmla="*/ 2759976 w 8363529"/>
                <a:gd name="connsiteY99" fmla="*/ 1142681 h 1292118"/>
                <a:gd name="connsiteX100" fmla="*/ 2768329 w 8363529"/>
                <a:gd name="connsiteY100" fmla="*/ 1134968 h 1292118"/>
                <a:gd name="connsiteX101" fmla="*/ 2835262 w 8363529"/>
                <a:gd name="connsiteY101" fmla="*/ 1088736 h 1292118"/>
                <a:gd name="connsiteX102" fmla="*/ 2843615 w 8363529"/>
                <a:gd name="connsiteY102" fmla="*/ 1084352 h 1292118"/>
                <a:gd name="connsiteX103" fmla="*/ 2851968 w 8363529"/>
                <a:gd name="connsiteY103" fmla="*/ 1034636 h 1292118"/>
                <a:gd name="connsiteX104" fmla="*/ 2918892 w 8363529"/>
                <a:gd name="connsiteY104" fmla="*/ 625857 h 1292118"/>
                <a:gd name="connsiteX105" fmla="*/ 2927245 w 8363529"/>
                <a:gd name="connsiteY105" fmla="*/ 573344 h 1292118"/>
                <a:gd name="connsiteX106" fmla="*/ 2935608 w 8363529"/>
                <a:gd name="connsiteY106" fmla="*/ 638854 h 1292118"/>
                <a:gd name="connsiteX107" fmla="*/ 3002531 w 8363529"/>
                <a:gd name="connsiteY107" fmla="*/ 1141471 h 1292118"/>
                <a:gd name="connsiteX108" fmla="*/ 3010884 w 8363529"/>
                <a:gd name="connsiteY108" fmla="*/ 1201736 h 1292118"/>
                <a:gd name="connsiteX109" fmla="*/ 3019238 w 8363529"/>
                <a:gd name="connsiteY109" fmla="*/ 1191981 h 1292118"/>
                <a:gd name="connsiteX110" fmla="*/ 3086161 w 8363529"/>
                <a:gd name="connsiteY110" fmla="*/ 1093081 h 1292118"/>
                <a:gd name="connsiteX111" fmla="*/ 3094523 w 8363529"/>
                <a:gd name="connsiteY111" fmla="*/ 1077355 h 1292118"/>
                <a:gd name="connsiteX112" fmla="*/ 3102877 w 8363529"/>
                <a:gd name="connsiteY112" fmla="*/ 1013393 h 1292118"/>
                <a:gd name="connsiteX113" fmla="*/ 3169800 w 8363529"/>
                <a:gd name="connsiteY113" fmla="*/ 648764 h 1292118"/>
                <a:gd name="connsiteX114" fmla="*/ 3178153 w 8363529"/>
                <a:gd name="connsiteY114" fmla="*/ 615869 h 1292118"/>
                <a:gd name="connsiteX115" fmla="*/ 3186516 w 8363529"/>
                <a:gd name="connsiteY115" fmla="*/ 662981 h 1292118"/>
                <a:gd name="connsiteX116" fmla="*/ 3253439 w 8363529"/>
                <a:gd name="connsiteY116" fmla="*/ 1134213 h 1292118"/>
                <a:gd name="connsiteX117" fmla="*/ 3261792 w 8363529"/>
                <a:gd name="connsiteY117" fmla="*/ 1208308 h 1292118"/>
                <a:gd name="connsiteX118" fmla="*/ 3270146 w 8363529"/>
                <a:gd name="connsiteY118" fmla="*/ 1211559 h 1292118"/>
                <a:gd name="connsiteX119" fmla="*/ 3337069 w 8363529"/>
                <a:gd name="connsiteY119" fmla="*/ 1266792 h 1292118"/>
                <a:gd name="connsiteX120" fmla="*/ 3345432 w 8363529"/>
                <a:gd name="connsiteY120" fmla="*/ 1282557 h 1292118"/>
                <a:gd name="connsiteX121" fmla="*/ 3353785 w 8363529"/>
                <a:gd name="connsiteY121" fmla="*/ 1264643 h 1292118"/>
                <a:gd name="connsiteX122" fmla="*/ 3420708 w 8363529"/>
                <a:gd name="connsiteY122" fmla="*/ 1212053 h 1292118"/>
                <a:gd name="connsiteX123" fmla="*/ 3429061 w 8363529"/>
                <a:gd name="connsiteY123" fmla="*/ 1209372 h 1292118"/>
                <a:gd name="connsiteX124" fmla="*/ 3437424 w 8363529"/>
                <a:gd name="connsiteY124" fmla="*/ 1209372 h 1292118"/>
                <a:gd name="connsiteX125" fmla="*/ 3504347 w 8363529"/>
                <a:gd name="connsiteY125" fmla="*/ 1209179 h 1292118"/>
                <a:gd name="connsiteX126" fmla="*/ 3512701 w 8363529"/>
                <a:gd name="connsiteY126" fmla="*/ 1209140 h 1292118"/>
                <a:gd name="connsiteX127" fmla="*/ 3521054 w 8363529"/>
                <a:gd name="connsiteY127" fmla="*/ 1162492 h 1292118"/>
                <a:gd name="connsiteX128" fmla="*/ 3587977 w 8363529"/>
                <a:gd name="connsiteY128" fmla="*/ 839189 h 1292118"/>
                <a:gd name="connsiteX129" fmla="*/ 3596330 w 8363529"/>
                <a:gd name="connsiteY129" fmla="*/ 804067 h 1292118"/>
                <a:gd name="connsiteX130" fmla="*/ 3604693 w 8363529"/>
                <a:gd name="connsiteY130" fmla="*/ 826752 h 1292118"/>
                <a:gd name="connsiteX131" fmla="*/ 3671616 w 8363529"/>
                <a:gd name="connsiteY131" fmla="*/ 1066506 h 1292118"/>
                <a:gd name="connsiteX132" fmla="*/ 3679970 w 8363529"/>
                <a:gd name="connsiteY132" fmla="*/ 1106505 h 1292118"/>
                <a:gd name="connsiteX133" fmla="*/ 3688323 w 8363529"/>
                <a:gd name="connsiteY133" fmla="*/ 1075690 h 1292118"/>
                <a:gd name="connsiteX134" fmla="*/ 3755246 w 8363529"/>
                <a:gd name="connsiteY134" fmla="*/ 859561 h 1292118"/>
                <a:gd name="connsiteX135" fmla="*/ 3763609 w 8363529"/>
                <a:gd name="connsiteY135" fmla="*/ 835821 h 1292118"/>
                <a:gd name="connsiteX136" fmla="*/ 3771962 w 8363529"/>
                <a:gd name="connsiteY136" fmla="*/ 862135 h 1292118"/>
                <a:gd name="connsiteX137" fmla="*/ 3838885 w 8363529"/>
                <a:gd name="connsiteY137" fmla="*/ 1092404 h 1292118"/>
                <a:gd name="connsiteX138" fmla="*/ 3847239 w 8363529"/>
                <a:gd name="connsiteY138" fmla="*/ 1123964 h 1292118"/>
                <a:gd name="connsiteX139" fmla="*/ 3855602 w 8363529"/>
                <a:gd name="connsiteY139" fmla="*/ 1131116 h 1292118"/>
                <a:gd name="connsiteX140" fmla="*/ 3922525 w 8363529"/>
                <a:gd name="connsiteY140" fmla="*/ 1182448 h 1292118"/>
                <a:gd name="connsiteX141" fmla="*/ 3930878 w 8363529"/>
                <a:gd name="connsiteY141" fmla="*/ 1188197 h 1292118"/>
                <a:gd name="connsiteX142" fmla="*/ 3939231 w 8363529"/>
                <a:gd name="connsiteY142" fmla="*/ 1199200 h 1292118"/>
                <a:gd name="connsiteX143" fmla="*/ 4006154 w 8363529"/>
                <a:gd name="connsiteY143" fmla="*/ 1276663 h 1292118"/>
                <a:gd name="connsiteX144" fmla="*/ 4014517 w 8363529"/>
                <a:gd name="connsiteY144" fmla="*/ 1285209 h 1292118"/>
                <a:gd name="connsiteX145" fmla="*/ 4022871 w 8363529"/>
                <a:gd name="connsiteY145" fmla="*/ 1281618 h 1292118"/>
                <a:gd name="connsiteX146" fmla="*/ 4089755 w 8363529"/>
                <a:gd name="connsiteY146" fmla="*/ 1238513 h 1292118"/>
                <a:gd name="connsiteX147" fmla="*/ 4098147 w 8363529"/>
                <a:gd name="connsiteY147" fmla="*/ 1230238 h 1292118"/>
                <a:gd name="connsiteX148" fmla="*/ 4106500 w 8363529"/>
                <a:gd name="connsiteY148" fmla="*/ 1190393 h 1292118"/>
                <a:gd name="connsiteX149" fmla="*/ 4173394 w 8363529"/>
                <a:gd name="connsiteY149" fmla="*/ 986401 h 1292118"/>
                <a:gd name="connsiteX150" fmla="*/ 4181787 w 8363529"/>
                <a:gd name="connsiteY150" fmla="*/ 969726 h 1292118"/>
                <a:gd name="connsiteX151" fmla="*/ 4190140 w 8363529"/>
                <a:gd name="connsiteY151" fmla="*/ 991162 h 1292118"/>
                <a:gd name="connsiteX152" fmla="*/ 4257024 w 8363529"/>
                <a:gd name="connsiteY152" fmla="*/ 1204949 h 1292118"/>
                <a:gd name="connsiteX153" fmla="*/ 4265416 w 8363529"/>
                <a:gd name="connsiteY153" fmla="*/ 1238513 h 1292118"/>
                <a:gd name="connsiteX154" fmla="*/ 4273779 w 8363529"/>
                <a:gd name="connsiteY154" fmla="*/ 1104463 h 1292118"/>
                <a:gd name="connsiteX155" fmla="*/ 4340664 w 8363529"/>
                <a:gd name="connsiteY155" fmla="*/ 114355 h 1292118"/>
                <a:gd name="connsiteX156" fmla="*/ 4349055 w 8363529"/>
                <a:gd name="connsiteY156" fmla="*/ 0 h 1292118"/>
                <a:gd name="connsiteX157" fmla="*/ 4357409 w 8363529"/>
                <a:gd name="connsiteY157" fmla="*/ 126153 h 1292118"/>
                <a:gd name="connsiteX158" fmla="*/ 4424303 w 8363529"/>
                <a:gd name="connsiteY158" fmla="*/ 1126616 h 1292118"/>
                <a:gd name="connsiteX159" fmla="*/ 4432695 w 8363529"/>
                <a:gd name="connsiteY159" fmla="*/ 1250610 h 1292118"/>
                <a:gd name="connsiteX160" fmla="*/ 4441048 w 8363529"/>
                <a:gd name="connsiteY160" fmla="*/ 1234322 h 1292118"/>
                <a:gd name="connsiteX161" fmla="*/ 4507932 w 8363529"/>
                <a:gd name="connsiteY161" fmla="*/ 1096633 h 1292118"/>
                <a:gd name="connsiteX162" fmla="*/ 4516324 w 8363529"/>
                <a:gd name="connsiteY162" fmla="*/ 1078448 h 1292118"/>
                <a:gd name="connsiteX163" fmla="*/ 4524687 w 8363529"/>
                <a:gd name="connsiteY163" fmla="*/ 1091755 h 1292118"/>
                <a:gd name="connsiteX164" fmla="*/ 4591572 w 8363529"/>
                <a:gd name="connsiteY164" fmla="*/ 1210350 h 1292118"/>
                <a:gd name="connsiteX165" fmla="*/ 4599964 w 8363529"/>
                <a:gd name="connsiteY165" fmla="*/ 1226909 h 1292118"/>
                <a:gd name="connsiteX166" fmla="*/ 4608317 w 8363529"/>
                <a:gd name="connsiteY166" fmla="*/ 1169179 h 1292118"/>
                <a:gd name="connsiteX167" fmla="*/ 4675201 w 8363529"/>
                <a:gd name="connsiteY167" fmla="*/ 717343 h 1292118"/>
                <a:gd name="connsiteX168" fmla="*/ 4683603 w 8363529"/>
                <a:gd name="connsiteY168" fmla="*/ 662072 h 1292118"/>
                <a:gd name="connsiteX169" fmla="*/ 4691956 w 8363529"/>
                <a:gd name="connsiteY169" fmla="*/ 699158 h 1292118"/>
                <a:gd name="connsiteX170" fmla="*/ 4758840 w 8363529"/>
                <a:gd name="connsiteY170" fmla="*/ 963599 h 1292118"/>
                <a:gd name="connsiteX171" fmla="*/ 4767232 w 8363529"/>
                <a:gd name="connsiteY171" fmla="*/ 993127 h 1292118"/>
                <a:gd name="connsiteX172" fmla="*/ 4775595 w 8363529"/>
                <a:gd name="connsiteY172" fmla="*/ 996640 h 1292118"/>
                <a:gd name="connsiteX173" fmla="*/ 4842480 w 8363529"/>
                <a:gd name="connsiteY173" fmla="*/ 1033503 h 1292118"/>
                <a:gd name="connsiteX174" fmla="*/ 4850872 w 8363529"/>
                <a:gd name="connsiteY174" fmla="*/ 1039591 h 1292118"/>
                <a:gd name="connsiteX175" fmla="*/ 4859225 w 8363529"/>
                <a:gd name="connsiteY175" fmla="*/ 1049753 h 1292118"/>
                <a:gd name="connsiteX176" fmla="*/ 4926109 w 8363529"/>
                <a:gd name="connsiteY176" fmla="*/ 1102875 h 1292118"/>
                <a:gd name="connsiteX177" fmla="*/ 4934501 w 8363529"/>
                <a:gd name="connsiteY177" fmla="*/ 1107298 h 1292118"/>
                <a:gd name="connsiteX178" fmla="*/ 4942864 w 8363529"/>
                <a:gd name="connsiteY178" fmla="*/ 1120867 h 1292118"/>
                <a:gd name="connsiteX179" fmla="*/ 5009749 w 8363529"/>
                <a:gd name="connsiteY179" fmla="*/ 1243390 h 1292118"/>
                <a:gd name="connsiteX180" fmla="*/ 5018141 w 8363529"/>
                <a:gd name="connsiteY180" fmla="*/ 1260704 h 1292118"/>
                <a:gd name="connsiteX181" fmla="*/ 5026494 w 8363529"/>
                <a:gd name="connsiteY181" fmla="*/ 1254278 h 1292118"/>
                <a:gd name="connsiteX182" fmla="*/ 5093388 w 8363529"/>
                <a:gd name="connsiteY182" fmla="*/ 1193152 h 1292118"/>
                <a:gd name="connsiteX183" fmla="*/ 5101780 w 8363529"/>
                <a:gd name="connsiteY183" fmla="*/ 1184045 h 1292118"/>
                <a:gd name="connsiteX184" fmla="*/ 5110134 w 8363529"/>
                <a:gd name="connsiteY184" fmla="*/ 1186425 h 1292118"/>
                <a:gd name="connsiteX185" fmla="*/ 5177018 w 8363529"/>
                <a:gd name="connsiteY185" fmla="*/ 1200217 h 1292118"/>
                <a:gd name="connsiteX186" fmla="*/ 5185410 w 8363529"/>
                <a:gd name="connsiteY186" fmla="*/ 1201465 h 1292118"/>
                <a:gd name="connsiteX187" fmla="*/ 5193773 w 8363529"/>
                <a:gd name="connsiteY187" fmla="*/ 1170544 h 1292118"/>
                <a:gd name="connsiteX188" fmla="*/ 5260657 w 8363529"/>
                <a:gd name="connsiteY188" fmla="*/ 901902 h 1292118"/>
                <a:gd name="connsiteX189" fmla="*/ 5269049 w 8363529"/>
                <a:gd name="connsiteY189" fmla="*/ 865426 h 1292118"/>
                <a:gd name="connsiteX190" fmla="*/ 5277403 w 8363529"/>
                <a:gd name="connsiteY190" fmla="*/ 887579 h 1292118"/>
                <a:gd name="connsiteX191" fmla="*/ 5344287 w 8363529"/>
                <a:gd name="connsiteY191" fmla="*/ 1092288 h 1292118"/>
                <a:gd name="connsiteX192" fmla="*/ 5352650 w 8363529"/>
                <a:gd name="connsiteY192" fmla="*/ 1121961 h 1292118"/>
                <a:gd name="connsiteX193" fmla="*/ 5361042 w 8363529"/>
                <a:gd name="connsiteY193" fmla="*/ 1123857 h 1292118"/>
                <a:gd name="connsiteX194" fmla="*/ 5427926 w 8363529"/>
                <a:gd name="connsiteY194" fmla="*/ 1161882 h 1292118"/>
                <a:gd name="connsiteX195" fmla="*/ 5436280 w 8363529"/>
                <a:gd name="connsiteY195" fmla="*/ 1174967 h 1292118"/>
                <a:gd name="connsiteX196" fmla="*/ 5444672 w 8363529"/>
                <a:gd name="connsiteY196" fmla="*/ 1169296 h 1292118"/>
                <a:gd name="connsiteX197" fmla="*/ 5511566 w 8363529"/>
                <a:gd name="connsiteY197" fmla="*/ 1150656 h 1292118"/>
                <a:gd name="connsiteX198" fmla="*/ 5519919 w 8363529"/>
                <a:gd name="connsiteY198" fmla="*/ 1149639 h 1292118"/>
                <a:gd name="connsiteX199" fmla="*/ 5528311 w 8363529"/>
                <a:gd name="connsiteY199" fmla="*/ 1169257 h 1292118"/>
                <a:gd name="connsiteX200" fmla="*/ 5595195 w 8363529"/>
                <a:gd name="connsiteY200" fmla="*/ 1277912 h 1292118"/>
                <a:gd name="connsiteX201" fmla="*/ 5603558 w 8363529"/>
                <a:gd name="connsiteY201" fmla="*/ 1287474 h 1292118"/>
                <a:gd name="connsiteX202" fmla="*/ 5611950 w 8363529"/>
                <a:gd name="connsiteY202" fmla="*/ 1195571 h 1292118"/>
                <a:gd name="connsiteX203" fmla="*/ 5678835 w 8363529"/>
                <a:gd name="connsiteY203" fmla="*/ 463828 h 1292118"/>
                <a:gd name="connsiteX204" fmla="*/ 5687188 w 8363529"/>
                <a:gd name="connsiteY204" fmla="*/ 372748 h 1292118"/>
                <a:gd name="connsiteX205" fmla="*/ 5695580 w 8363529"/>
                <a:gd name="connsiteY205" fmla="*/ 432558 h 1292118"/>
                <a:gd name="connsiteX206" fmla="*/ 5762474 w 8363529"/>
                <a:gd name="connsiteY206" fmla="*/ 1111421 h 1292118"/>
                <a:gd name="connsiteX207" fmla="*/ 5770827 w 8363529"/>
                <a:gd name="connsiteY207" fmla="*/ 1233606 h 1292118"/>
                <a:gd name="connsiteX208" fmla="*/ 5779219 w 8363529"/>
                <a:gd name="connsiteY208" fmla="*/ 1234545 h 1292118"/>
                <a:gd name="connsiteX209" fmla="*/ 5846103 w 8363529"/>
                <a:gd name="connsiteY209" fmla="*/ 1240177 h 1292118"/>
                <a:gd name="connsiteX210" fmla="*/ 5854457 w 8363529"/>
                <a:gd name="connsiteY210" fmla="*/ 1240709 h 1292118"/>
                <a:gd name="connsiteX211" fmla="*/ 5862858 w 8363529"/>
                <a:gd name="connsiteY211" fmla="*/ 1235793 h 1292118"/>
                <a:gd name="connsiteX212" fmla="*/ 5929743 w 8363529"/>
                <a:gd name="connsiteY212" fmla="*/ 1171908 h 1292118"/>
                <a:gd name="connsiteX213" fmla="*/ 5938096 w 8363529"/>
                <a:gd name="connsiteY213" fmla="*/ 1158485 h 1292118"/>
                <a:gd name="connsiteX214" fmla="*/ 5946488 w 8363529"/>
                <a:gd name="connsiteY214" fmla="*/ 1173980 h 1292118"/>
                <a:gd name="connsiteX215" fmla="*/ 6013372 w 8363529"/>
                <a:gd name="connsiteY215" fmla="*/ 1252052 h 1292118"/>
                <a:gd name="connsiteX216" fmla="*/ 6021735 w 8363529"/>
                <a:gd name="connsiteY216" fmla="*/ 1258362 h 1292118"/>
                <a:gd name="connsiteX217" fmla="*/ 6030127 w 8363529"/>
                <a:gd name="connsiteY217" fmla="*/ 1241387 h 1292118"/>
                <a:gd name="connsiteX218" fmla="*/ 6097011 w 8363529"/>
                <a:gd name="connsiteY218" fmla="*/ 1087526 h 1292118"/>
                <a:gd name="connsiteX219" fmla="*/ 6105365 w 8363529"/>
                <a:gd name="connsiteY219" fmla="*/ 1065673 h 1292118"/>
                <a:gd name="connsiteX220" fmla="*/ 6113767 w 8363529"/>
                <a:gd name="connsiteY220" fmla="*/ 1077993 h 1292118"/>
                <a:gd name="connsiteX221" fmla="*/ 6180651 w 8363529"/>
                <a:gd name="connsiteY221" fmla="*/ 1162831 h 1292118"/>
                <a:gd name="connsiteX222" fmla="*/ 6189004 w 8363529"/>
                <a:gd name="connsiteY222" fmla="*/ 1171976 h 1292118"/>
                <a:gd name="connsiteX223" fmla="*/ 6197396 w 8363529"/>
                <a:gd name="connsiteY223" fmla="*/ 1170128 h 1292118"/>
                <a:gd name="connsiteX224" fmla="*/ 6264280 w 8363529"/>
                <a:gd name="connsiteY224" fmla="*/ 1151072 h 1292118"/>
                <a:gd name="connsiteX225" fmla="*/ 6272644 w 8363529"/>
                <a:gd name="connsiteY225" fmla="*/ 1148052 h 1292118"/>
                <a:gd name="connsiteX226" fmla="*/ 6281036 w 8363529"/>
                <a:gd name="connsiteY226" fmla="*/ 1156143 h 1292118"/>
                <a:gd name="connsiteX227" fmla="*/ 6347920 w 8363529"/>
                <a:gd name="connsiteY227" fmla="*/ 1211337 h 1292118"/>
                <a:gd name="connsiteX228" fmla="*/ 6356273 w 8363529"/>
                <a:gd name="connsiteY228" fmla="*/ 1217231 h 1292118"/>
                <a:gd name="connsiteX229" fmla="*/ 6364665 w 8363529"/>
                <a:gd name="connsiteY229" fmla="*/ 1219427 h 1292118"/>
                <a:gd name="connsiteX230" fmla="*/ 6431560 w 8363529"/>
                <a:gd name="connsiteY230" fmla="*/ 1235716 h 1292118"/>
                <a:gd name="connsiteX231" fmla="*/ 6439913 w 8363529"/>
                <a:gd name="connsiteY231" fmla="*/ 1237612 h 1292118"/>
                <a:gd name="connsiteX232" fmla="*/ 6448305 w 8363529"/>
                <a:gd name="connsiteY232" fmla="*/ 1241426 h 1292118"/>
                <a:gd name="connsiteX233" fmla="*/ 6515189 w 8363529"/>
                <a:gd name="connsiteY233" fmla="*/ 1275947 h 1292118"/>
                <a:gd name="connsiteX234" fmla="*/ 6523542 w 8363529"/>
                <a:gd name="connsiteY234" fmla="*/ 1280825 h 1292118"/>
                <a:gd name="connsiteX235" fmla="*/ 6531944 w 8363529"/>
                <a:gd name="connsiteY235" fmla="*/ 1273111 h 1292118"/>
                <a:gd name="connsiteX236" fmla="*/ 6598829 w 8363529"/>
                <a:gd name="connsiteY236" fmla="*/ 1204340 h 1292118"/>
                <a:gd name="connsiteX237" fmla="*/ 6607182 w 8363529"/>
                <a:gd name="connsiteY237" fmla="*/ 1194739 h 1292118"/>
                <a:gd name="connsiteX238" fmla="*/ 6615535 w 8363529"/>
                <a:gd name="connsiteY238" fmla="*/ 1206759 h 1292118"/>
                <a:gd name="connsiteX239" fmla="*/ 6682458 w 8363529"/>
                <a:gd name="connsiteY239" fmla="*/ 1273789 h 1292118"/>
                <a:gd name="connsiteX240" fmla="*/ 6690821 w 8363529"/>
                <a:gd name="connsiteY240" fmla="*/ 1279721 h 1292118"/>
                <a:gd name="connsiteX241" fmla="*/ 6699174 w 8363529"/>
                <a:gd name="connsiteY241" fmla="*/ 1267063 h 1292118"/>
                <a:gd name="connsiteX242" fmla="*/ 6766097 w 8363529"/>
                <a:gd name="connsiteY242" fmla="*/ 1140184 h 1292118"/>
                <a:gd name="connsiteX243" fmla="*/ 6774451 w 8363529"/>
                <a:gd name="connsiteY243" fmla="*/ 1120189 h 1292118"/>
                <a:gd name="connsiteX244" fmla="*/ 6782814 w 8363529"/>
                <a:gd name="connsiteY244" fmla="*/ 1133264 h 1292118"/>
                <a:gd name="connsiteX245" fmla="*/ 6849737 w 8363529"/>
                <a:gd name="connsiteY245" fmla="*/ 1254772 h 1292118"/>
                <a:gd name="connsiteX246" fmla="*/ 6858090 w 8363529"/>
                <a:gd name="connsiteY246" fmla="*/ 1272463 h 1292118"/>
                <a:gd name="connsiteX247" fmla="*/ 6866443 w 8363529"/>
                <a:gd name="connsiteY247" fmla="*/ 1267247 h 1292118"/>
                <a:gd name="connsiteX248" fmla="*/ 6933366 w 8363529"/>
                <a:gd name="connsiteY248" fmla="*/ 1239200 h 1292118"/>
                <a:gd name="connsiteX249" fmla="*/ 6941729 w 8363529"/>
                <a:gd name="connsiteY249" fmla="*/ 1236780 h 1292118"/>
                <a:gd name="connsiteX250" fmla="*/ 6950083 w 8363529"/>
                <a:gd name="connsiteY250" fmla="*/ 1240032 h 1292118"/>
                <a:gd name="connsiteX251" fmla="*/ 7017006 w 8363529"/>
                <a:gd name="connsiteY251" fmla="*/ 1271708 h 1292118"/>
                <a:gd name="connsiteX252" fmla="*/ 7025359 w 8363529"/>
                <a:gd name="connsiteY252" fmla="*/ 1276586 h 1292118"/>
                <a:gd name="connsiteX253" fmla="*/ 7033712 w 8363529"/>
                <a:gd name="connsiteY253" fmla="*/ 1273111 h 1292118"/>
                <a:gd name="connsiteX254" fmla="*/ 7100645 w 8363529"/>
                <a:gd name="connsiteY254" fmla="*/ 1243506 h 1292118"/>
                <a:gd name="connsiteX255" fmla="*/ 7108998 w 8363529"/>
                <a:gd name="connsiteY255" fmla="*/ 1239538 h 1292118"/>
                <a:gd name="connsiteX256" fmla="*/ 7117351 w 8363529"/>
                <a:gd name="connsiteY256" fmla="*/ 1241203 h 1292118"/>
                <a:gd name="connsiteX257" fmla="*/ 7184274 w 8363529"/>
                <a:gd name="connsiteY257" fmla="*/ 1254888 h 1292118"/>
                <a:gd name="connsiteX258" fmla="*/ 7192628 w 8363529"/>
                <a:gd name="connsiteY258" fmla="*/ 1256659 h 1292118"/>
                <a:gd name="connsiteX259" fmla="*/ 7200991 w 8363529"/>
                <a:gd name="connsiteY259" fmla="*/ 1253107 h 1292118"/>
                <a:gd name="connsiteX260" fmla="*/ 7267914 w 8363529"/>
                <a:gd name="connsiteY260" fmla="*/ 1226909 h 1292118"/>
                <a:gd name="connsiteX261" fmla="*/ 7276267 w 8363529"/>
                <a:gd name="connsiteY261" fmla="*/ 1223889 h 1292118"/>
                <a:gd name="connsiteX262" fmla="*/ 7284620 w 8363529"/>
                <a:gd name="connsiteY262" fmla="*/ 1226609 h 1292118"/>
                <a:gd name="connsiteX263" fmla="*/ 7351543 w 8363529"/>
                <a:gd name="connsiteY263" fmla="*/ 1249749 h 1292118"/>
                <a:gd name="connsiteX264" fmla="*/ 7359906 w 8363529"/>
                <a:gd name="connsiteY264" fmla="*/ 1252807 h 1292118"/>
                <a:gd name="connsiteX265" fmla="*/ 7368260 w 8363529"/>
                <a:gd name="connsiteY265" fmla="*/ 1187597 h 1292118"/>
                <a:gd name="connsiteX266" fmla="*/ 7435183 w 8363529"/>
                <a:gd name="connsiteY266" fmla="*/ 752232 h 1292118"/>
                <a:gd name="connsiteX267" fmla="*/ 7443536 w 8363529"/>
                <a:gd name="connsiteY267" fmla="*/ 706639 h 1292118"/>
                <a:gd name="connsiteX268" fmla="*/ 7451899 w 8363529"/>
                <a:gd name="connsiteY268" fmla="*/ 723237 h 1292118"/>
                <a:gd name="connsiteX269" fmla="*/ 7518822 w 8363529"/>
                <a:gd name="connsiteY269" fmla="*/ 882846 h 1292118"/>
                <a:gd name="connsiteX270" fmla="*/ 7527175 w 8363529"/>
                <a:gd name="connsiteY270" fmla="*/ 906935 h 1292118"/>
                <a:gd name="connsiteX271" fmla="*/ 7535528 w 8363529"/>
                <a:gd name="connsiteY271" fmla="*/ 949160 h 1292118"/>
                <a:gd name="connsiteX272" fmla="*/ 7602452 w 8363529"/>
                <a:gd name="connsiteY272" fmla="*/ 1232241 h 1292118"/>
                <a:gd name="connsiteX273" fmla="*/ 7610815 w 8363529"/>
                <a:gd name="connsiteY273" fmla="*/ 1261991 h 1292118"/>
                <a:gd name="connsiteX274" fmla="*/ 7619168 w 8363529"/>
                <a:gd name="connsiteY274" fmla="*/ 1259117 h 1292118"/>
                <a:gd name="connsiteX275" fmla="*/ 7686091 w 8363529"/>
                <a:gd name="connsiteY275" fmla="*/ 1234167 h 1292118"/>
                <a:gd name="connsiteX276" fmla="*/ 7694444 w 8363529"/>
                <a:gd name="connsiteY276" fmla="*/ 1230770 h 1292118"/>
                <a:gd name="connsiteX277" fmla="*/ 7702798 w 8363529"/>
                <a:gd name="connsiteY277" fmla="*/ 1175228 h 1292118"/>
                <a:gd name="connsiteX278" fmla="*/ 7769731 w 8363529"/>
                <a:gd name="connsiteY278" fmla="*/ 627628 h 1292118"/>
                <a:gd name="connsiteX279" fmla="*/ 7778084 w 8363529"/>
                <a:gd name="connsiteY279" fmla="*/ 542839 h 1292118"/>
                <a:gd name="connsiteX280" fmla="*/ 7786437 w 8363529"/>
                <a:gd name="connsiteY280" fmla="*/ 654174 h 1292118"/>
                <a:gd name="connsiteX281" fmla="*/ 7853360 w 8363529"/>
                <a:gd name="connsiteY281" fmla="*/ 1198252 h 1292118"/>
                <a:gd name="connsiteX282" fmla="*/ 7861713 w 8363529"/>
                <a:gd name="connsiteY282" fmla="*/ 1240893 h 1292118"/>
                <a:gd name="connsiteX283" fmla="*/ 7870077 w 8363529"/>
                <a:gd name="connsiteY283" fmla="*/ 1217047 h 1292118"/>
                <a:gd name="connsiteX284" fmla="*/ 7937000 w 8363529"/>
                <a:gd name="connsiteY284" fmla="*/ 949837 h 1292118"/>
                <a:gd name="connsiteX285" fmla="*/ 7945353 w 8363529"/>
                <a:gd name="connsiteY285" fmla="*/ 902473 h 1292118"/>
                <a:gd name="connsiteX286" fmla="*/ 7953706 w 8363529"/>
                <a:gd name="connsiteY286" fmla="*/ 932378 h 1292118"/>
                <a:gd name="connsiteX287" fmla="*/ 8020629 w 8363529"/>
                <a:gd name="connsiteY287" fmla="*/ 1160643 h 1292118"/>
                <a:gd name="connsiteX288" fmla="*/ 8028992 w 8363529"/>
                <a:gd name="connsiteY288" fmla="*/ 1187858 h 1292118"/>
                <a:gd name="connsiteX289" fmla="*/ 8037346 w 8363529"/>
                <a:gd name="connsiteY289" fmla="*/ 1188351 h 1292118"/>
                <a:gd name="connsiteX290" fmla="*/ 8104268 w 8363529"/>
                <a:gd name="connsiteY290" fmla="*/ 1192658 h 1292118"/>
                <a:gd name="connsiteX291" fmla="*/ 8112622 w 8363529"/>
                <a:gd name="connsiteY291" fmla="*/ 1193268 h 1292118"/>
                <a:gd name="connsiteX292" fmla="*/ 8120985 w 8363529"/>
                <a:gd name="connsiteY292" fmla="*/ 1206459 h 1292118"/>
                <a:gd name="connsiteX293" fmla="*/ 8187908 w 8363529"/>
                <a:gd name="connsiteY293" fmla="*/ 1276131 h 1292118"/>
                <a:gd name="connsiteX294" fmla="*/ 8196261 w 8363529"/>
                <a:gd name="connsiteY294" fmla="*/ 1282025 h 1292118"/>
                <a:gd name="connsiteX295" fmla="*/ 8204614 w 8363529"/>
                <a:gd name="connsiteY295" fmla="*/ 1228196 h 1292118"/>
                <a:gd name="connsiteX296" fmla="*/ 8271537 w 8363529"/>
                <a:gd name="connsiteY296" fmla="*/ 667550 h 1292118"/>
                <a:gd name="connsiteX297" fmla="*/ 8279900 w 8363529"/>
                <a:gd name="connsiteY297" fmla="*/ 575570 h 1292118"/>
                <a:gd name="connsiteX298" fmla="*/ 8288254 w 8363529"/>
                <a:gd name="connsiteY298" fmla="*/ 638554 h 1292118"/>
                <a:gd name="connsiteX299" fmla="*/ 8355177 w 8363529"/>
                <a:gd name="connsiteY299" fmla="*/ 1147636 h 1292118"/>
                <a:gd name="connsiteX300" fmla="*/ 8363530 w 8363529"/>
                <a:gd name="connsiteY300" fmla="*/ 1211937 h 1292118"/>
                <a:gd name="connsiteX301" fmla="*/ 8363530 w 8363529"/>
                <a:gd name="connsiteY301" fmla="*/ 1239277 h 1292118"/>
                <a:gd name="connsiteX302" fmla="*/ 8355177 w 8363529"/>
                <a:gd name="connsiteY302" fmla="*/ 1173457 h 1292118"/>
                <a:gd name="connsiteX303" fmla="*/ 8288254 w 8363529"/>
                <a:gd name="connsiteY303" fmla="*/ 652278 h 1292118"/>
                <a:gd name="connsiteX304" fmla="*/ 8279900 w 8363529"/>
                <a:gd name="connsiteY304" fmla="*/ 587783 h 1292118"/>
                <a:gd name="connsiteX305" fmla="*/ 8271537 w 8363529"/>
                <a:gd name="connsiteY305" fmla="*/ 679502 h 1292118"/>
                <a:gd name="connsiteX306" fmla="*/ 8204614 w 8363529"/>
                <a:gd name="connsiteY306" fmla="*/ 1238474 h 1292118"/>
                <a:gd name="connsiteX307" fmla="*/ 8196261 w 8363529"/>
                <a:gd name="connsiteY307" fmla="*/ 1292119 h 1292118"/>
                <a:gd name="connsiteX308" fmla="*/ 8028992 w 8363529"/>
                <a:gd name="connsiteY308" fmla="*/ 1292119 h 1292118"/>
                <a:gd name="connsiteX309" fmla="*/ 8020629 w 8363529"/>
                <a:gd name="connsiteY309" fmla="*/ 1264982 h 1292118"/>
                <a:gd name="connsiteX310" fmla="*/ 7953706 w 8363529"/>
                <a:gd name="connsiteY310" fmla="*/ 1037278 h 1292118"/>
                <a:gd name="connsiteX311" fmla="*/ 7945353 w 8363529"/>
                <a:gd name="connsiteY311" fmla="*/ 1007450 h 1292118"/>
                <a:gd name="connsiteX312" fmla="*/ 7937000 w 8363529"/>
                <a:gd name="connsiteY312" fmla="*/ 1047333 h 1292118"/>
                <a:gd name="connsiteX313" fmla="*/ 7870077 w 8363529"/>
                <a:gd name="connsiteY313" fmla="*/ 1272047 h 1292118"/>
                <a:gd name="connsiteX314" fmla="*/ 7861713 w 8363529"/>
                <a:gd name="connsiteY314" fmla="*/ 1292119 h 1292118"/>
                <a:gd name="connsiteX315" fmla="*/ 7853360 w 8363529"/>
                <a:gd name="connsiteY315" fmla="*/ 1246681 h 1292118"/>
                <a:gd name="connsiteX316" fmla="*/ 7786437 w 8363529"/>
                <a:gd name="connsiteY316" fmla="*/ 667095 h 1292118"/>
                <a:gd name="connsiteX317" fmla="*/ 7778084 w 8363529"/>
                <a:gd name="connsiteY317" fmla="*/ 548510 h 1292118"/>
                <a:gd name="connsiteX318" fmla="*/ 7769731 w 8363529"/>
                <a:gd name="connsiteY318" fmla="*/ 640141 h 1292118"/>
                <a:gd name="connsiteX319" fmla="*/ 7702798 w 8363529"/>
                <a:gd name="connsiteY319" fmla="*/ 1232086 h 1292118"/>
                <a:gd name="connsiteX320" fmla="*/ 7694444 w 8363529"/>
                <a:gd name="connsiteY320" fmla="*/ 1292119 h 1292118"/>
                <a:gd name="connsiteX321" fmla="*/ 7610815 w 8363529"/>
                <a:gd name="connsiteY321" fmla="*/ 1292119 h 1292118"/>
                <a:gd name="connsiteX322" fmla="*/ 7602452 w 8363529"/>
                <a:gd name="connsiteY322" fmla="*/ 1264866 h 1292118"/>
                <a:gd name="connsiteX323" fmla="*/ 7535528 w 8363529"/>
                <a:gd name="connsiteY323" fmla="*/ 1005679 h 1292118"/>
                <a:gd name="connsiteX324" fmla="*/ 7527175 w 8363529"/>
                <a:gd name="connsiteY324" fmla="*/ 967006 h 1292118"/>
                <a:gd name="connsiteX325" fmla="*/ 7518822 w 8363529"/>
                <a:gd name="connsiteY325" fmla="*/ 945376 h 1292118"/>
                <a:gd name="connsiteX326" fmla="*/ 7451899 w 8363529"/>
                <a:gd name="connsiteY326" fmla="*/ 802064 h 1292118"/>
                <a:gd name="connsiteX327" fmla="*/ 7443536 w 8363529"/>
                <a:gd name="connsiteY327" fmla="*/ 787169 h 1292118"/>
                <a:gd name="connsiteX328" fmla="*/ 7435183 w 8363529"/>
                <a:gd name="connsiteY328" fmla="*/ 827159 h 1292118"/>
                <a:gd name="connsiteX329" fmla="*/ 7368260 w 8363529"/>
                <a:gd name="connsiteY329" fmla="*/ 1209256 h 1292118"/>
                <a:gd name="connsiteX330" fmla="*/ 7359906 w 8363529"/>
                <a:gd name="connsiteY330" fmla="*/ 1266492 h 1292118"/>
                <a:gd name="connsiteX331" fmla="*/ 7351543 w 8363529"/>
                <a:gd name="connsiteY331" fmla="*/ 1269211 h 1292118"/>
                <a:gd name="connsiteX332" fmla="*/ 7284620 w 8363529"/>
                <a:gd name="connsiteY332" fmla="*/ 1289700 h 1292118"/>
                <a:gd name="connsiteX333" fmla="*/ 7276267 w 8363529"/>
                <a:gd name="connsiteY333" fmla="*/ 1292119 h 1292118"/>
                <a:gd name="connsiteX334" fmla="*/ 6356273 w 8363529"/>
                <a:gd name="connsiteY334" fmla="*/ 1292119 h 1292118"/>
                <a:gd name="connsiteX335" fmla="*/ 6347920 w 8363529"/>
                <a:gd name="connsiteY335" fmla="*/ 1288683 h 1292118"/>
                <a:gd name="connsiteX336" fmla="*/ 6281036 w 8363529"/>
                <a:gd name="connsiteY336" fmla="*/ 1256320 h 1292118"/>
                <a:gd name="connsiteX337" fmla="*/ 6272644 w 8363529"/>
                <a:gd name="connsiteY337" fmla="*/ 1251558 h 1292118"/>
                <a:gd name="connsiteX338" fmla="*/ 6264280 w 8363529"/>
                <a:gd name="connsiteY338" fmla="*/ 1256736 h 1292118"/>
                <a:gd name="connsiteX339" fmla="*/ 6197396 w 8363529"/>
                <a:gd name="connsiteY339" fmla="*/ 1288945 h 1292118"/>
                <a:gd name="connsiteX340" fmla="*/ 6189004 w 8363529"/>
                <a:gd name="connsiteY340" fmla="*/ 1292119 h 1292118"/>
                <a:gd name="connsiteX341" fmla="*/ 6021735 w 8363529"/>
                <a:gd name="connsiteY341" fmla="*/ 1292119 h 1292118"/>
                <a:gd name="connsiteX342" fmla="*/ 6013372 w 8363529"/>
                <a:gd name="connsiteY342" fmla="*/ 1291596 h 1292118"/>
                <a:gd name="connsiteX343" fmla="*/ 5946488 w 8363529"/>
                <a:gd name="connsiteY343" fmla="*/ 1284861 h 1292118"/>
                <a:gd name="connsiteX344" fmla="*/ 5938096 w 8363529"/>
                <a:gd name="connsiteY344" fmla="*/ 1283544 h 1292118"/>
                <a:gd name="connsiteX345" fmla="*/ 5929743 w 8363529"/>
                <a:gd name="connsiteY345" fmla="*/ 1284938 h 1292118"/>
                <a:gd name="connsiteX346" fmla="*/ 5862858 w 8363529"/>
                <a:gd name="connsiteY346" fmla="*/ 1291596 h 1292118"/>
                <a:gd name="connsiteX347" fmla="*/ 5854457 w 8363529"/>
                <a:gd name="connsiteY347" fmla="*/ 1292119 h 1292118"/>
                <a:gd name="connsiteX348" fmla="*/ 5770827 w 8363529"/>
                <a:gd name="connsiteY348" fmla="*/ 1292119 h 1292118"/>
                <a:gd name="connsiteX349" fmla="*/ 5762474 w 8363529"/>
                <a:gd name="connsiteY349" fmla="*/ 1161660 h 1292118"/>
                <a:gd name="connsiteX350" fmla="*/ 5695580 w 8363529"/>
                <a:gd name="connsiteY350" fmla="*/ 436603 h 1292118"/>
                <a:gd name="connsiteX351" fmla="*/ 5687188 w 8363529"/>
                <a:gd name="connsiteY351" fmla="*/ 372748 h 1292118"/>
                <a:gd name="connsiteX352" fmla="*/ 5678835 w 8363529"/>
                <a:gd name="connsiteY352" fmla="*/ 464273 h 1292118"/>
                <a:gd name="connsiteX353" fmla="*/ 5611950 w 8363529"/>
                <a:gd name="connsiteY353" fmla="*/ 1199762 h 1292118"/>
                <a:gd name="connsiteX354" fmla="*/ 5603558 w 8363529"/>
                <a:gd name="connsiteY354" fmla="*/ 1292119 h 1292118"/>
                <a:gd name="connsiteX355" fmla="*/ 5436280 w 8363529"/>
                <a:gd name="connsiteY355" fmla="*/ 1292119 h 1292118"/>
                <a:gd name="connsiteX356" fmla="*/ 5427926 w 8363529"/>
                <a:gd name="connsiteY356" fmla="*/ 1289970 h 1292118"/>
                <a:gd name="connsiteX357" fmla="*/ 5361042 w 8363529"/>
                <a:gd name="connsiteY357" fmla="*/ 1283728 h 1292118"/>
                <a:gd name="connsiteX358" fmla="*/ 5352650 w 8363529"/>
                <a:gd name="connsiteY358" fmla="*/ 1283389 h 1292118"/>
                <a:gd name="connsiteX359" fmla="*/ 5344287 w 8363529"/>
                <a:gd name="connsiteY359" fmla="*/ 1238629 h 1292118"/>
                <a:gd name="connsiteX360" fmla="*/ 5277403 w 8363529"/>
                <a:gd name="connsiteY360" fmla="*/ 929610 h 1292118"/>
                <a:gd name="connsiteX361" fmla="*/ 5269049 w 8363529"/>
                <a:gd name="connsiteY361" fmla="*/ 896192 h 1292118"/>
                <a:gd name="connsiteX362" fmla="*/ 5260657 w 8363529"/>
                <a:gd name="connsiteY362" fmla="*/ 939182 h 1292118"/>
                <a:gd name="connsiteX363" fmla="*/ 5193773 w 8363529"/>
                <a:gd name="connsiteY363" fmla="*/ 1255681 h 1292118"/>
                <a:gd name="connsiteX364" fmla="*/ 5185410 w 8363529"/>
                <a:gd name="connsiteY364" fmla="*/ 1292119 h 1292118"/>
                <a:gd name="connsiteX365" fmla="*/ 5177018 w 8363529"/>
                <a:gd name="connsiteY365" fmla="*/ 1291442 h 1292118"/>
                <a:gd name="connsiteX366" fmla="*/ 5110134 w 8363529"/>
                <a:gd name="connsiteY366" fmla="*/ 1283806 h 1292118"/>
                <a:gd name="connsiteX367" fmla="*/ 5101780 w 8363529"/>
                <a:gd name="connsiteY367" fmla="*/ 1282480 h 1292118"/>
                <a:gd name="connsiteX368" fmla="*/ 5093388 w 8363529"/>
                <a:gd name="connsiteY368" fmla="*/ 1283622 h 1292118"/>
                <a:gd name="connsiteX369" fmla="*/ 5026494 w 8363529"/>
                <a:gd name="connsiteY369" fmla="*/ 1291325 h 1292118"/>
                <a:gd name="connsiteX370" fmla="*/ 5018141 w 8363529"/>
                <a:gd name="connsiteY370" fmla="*/ 1292119 h 1292118"/>
                <a:gd name="connsiteX371" fmla="*/ 5009749 w 8363529"/>
                <a:gd name="connsiteY371" fmla="*/ 1277118 h 1292118"/>
                <a:gd name="connsiteX372" fmla="*/ 4942864 w 8363529"/>
                <a:gd name="connsiteY372" fmla="*/ 1170728 h 1292118"/>
                <a:gd name="connsiteX373" fmla="*/ 4934501 w 8363529"/>
                <a:gd name="connsiteY373" fmla="*/ 1158940 h 1292118"/>
                <a:gd name="connsiteX374" fmla="*/ 4926109 w 8363529"/>
                <a:gd name="connsiteY374" fmla="*/ 1159279 h 1292118"/>
                <a:gd name="connsiteX375" fmla="*/ 4859225 w 8363529"/>
                <a:gd name="connsiteY375" fmla="*/ 1163169 h 1292118"/>
                <a:gd name="connsiteX376" fmla="*/ 4850872 w 8363529"/>
                <a:gd name="connsiteY376" fmla="*/ 1163924 h 1292118"/>
                <a:gd name="connsiteX377" fmla="*/ 4842480 w 8363529"/>
                <a:gd name="connsiteY377" fmla="*/ 1163131 h 1292118"/>
                <a:gd name="connsiteX378" fmla="*/ 4775595 w 8363529"/>
                <a:gd name="connsiteY378" fmla="*/ 1158369 h 1292118"/>
                <a:gd name="connsiteX379" fmla="*/ 4767232 w 8363529"/>
                <a:gd name="connsiteY379" fmla="*/ 1157914 h 1292118"/>
                <a:gd name="connsiteX380" fmla="*/ 4758840 w 8363529"/>
                <a:gd name="connsiteY380" fmla="*/ 1169905 h 1292118"/>
                <a:gd name="connsiteX381" fmla="*/ 4691956 w 8363529"/>
                <a:gd name="connsiteY381" fmla="*/ 1277118 h 1292118"/>
                <a:gd name="connsiteX382" fmla="*/ 4683603 w 8363529"/>
                <a:gd name="connsiteY382" fmla="*/ 1292119 h 1292118"/>
                <a:gd name="connsiteX383" fmla="*/ 4432695 w 8363529"/>
                <a:gd name="connsiteY383" fmla="*/ 1292119 h 1292118"/>
                <a:gd name="connsiteX384" fmla="*/ 4424303 w 8363529"/>
                <a:gd name="connsiteY384" fmla="*/ 1187935 h 1292118"/>
                <a:gd name="connsiteX385" fmla="*/ 4357409 w 8363529"/>
                <a:gd name="connsiteY385" fmla="*/ 347305 h 1292118"/>
                <a:gd name="connsiteX386" fmla="*/ 4349055 w 8363529"/>
                <a:gd name="connsiteY386" fmla="*/ 241302 h 1292118"/>
                <a:gd name="connsiteX387" fmla="*/ 4340664 w 8363529"/>
                <a:gd name="connsiteY387" fmla="*/ 338352 h 1292118"/>
                <a:gd name="connsiteX388" fmla="*/ 4273779 w 8363529"/>
                <a:gd name="connsiteY388" fmla="*/ 1178403 h 1292118"/>
                <a:gd name="connsiteX389" fmla="*/ 4265416 w 8363529"/>
                <a:gd name="connsiteY389" fmla="*/ 1292119 h 1292118"/>
                <a:gd name="connsiteX390" fmla="*/ 4257024 w 8363529"/>
                <a:gd name="connsiteY390" fmla="*/ 1254549 h 1292118"/>
                <a:gd name="connsiteX391" fmla="*/ 4190140 w 8363529"/>
                <a:gd name="connsiteY391" fmla="*/ 1015125 h 1292118"/>
                <a:gd name="connsiteX392" fmla="*/ 4181787 w 8363529"/>
                <a:gd name="connsiteY392" fmla="*/ 991124 h 1292118"/>
                <a:gd name="connsiteX393" fmla="*/ 4173394 w 8363529"/>
                <a:gd name="connsiteY393" fmla="*/ 1010402 h 1292118"/>
                <a:gd name="connsiteX394" fmla="*/ 4106500 w 8363529"/>
                <a:gd name="connsiteY394" fmla="*/ 1246081 h 1292118"/>
                <a:gd name="connsiteX395" fmla="*/ 4098147 w 8363529"/>
                <a:gd name="connsiteY395" fmla="*/ 1292119 h 1292118"/>
                <a:gd name="connsiteX396" fmla="*/ 3763609 w 8363529"/>
                <a:gd name="connsiteY396" fmla="*/ 1292119 h 1292118"/>
                <a:gd name="connsiteX397" fmla="*/ 3755246 w 8363529"/>
                <a:gd name="connsiteY397" fmla="*/ 1290503 h 1292118"/>
                <a:gd name="connsiteX398" fmla="*/ 3688323 w 8363529"/>
                <a:gd name="connsiteY398" fmla="*/ 1275492 h 1292118"/>
                <a:gd name="connsiteX399" fmla="*/ 3679970 w 8363529"/>
                <a:gd name="connsiteY399" fmla="*/ 1273334 h 1292118"/>
                <a:gd name="connsiteX400" fmla="*/ 3671616 w 8363529"/>
                <a:gd name="connsiteY400" fmla="*/ 1216253 h 1292118"/>
                <a:gd name="connsiteX401" fmla="*/ 3604693 w 8363529"/>
                <a:gd name="connsiteY401" fmla="*/ 873894 h 1292118"/>
                <a:gd name="connsiteX402" fmla="*/ 3596330 w 8363529"/>
                <a:gd name="connsiteY402" fmla="*/ 841531 h 1292118"/>
                <a:gd name="connsiteX403" fmla="*/ 3587977 w 8363529"/>
                <a:gd name="connsiteY403" fmla="*/ 880582 h 1292118"/>
                <a:gd name="connsiteX404" fmla="*/ 3521054 w 8363529"/>
                <a:gd name="connsiteY404" fmla="*/ 1240216 h 1292118"/>
                <a:gd name="connsiteX405" fmla="*/ 3512701 w 8363529"/>
                <a:gd name="connsiteY405" fmla="*/ 1292119 h 1292118"/>
                <a:gd name="connsiteX406" fmla="*/ 3261792 w 8363529"/>
                <a:gd name="connsiteY406" fmla="*/ 1292119 h 1292118"/>
                <a:gd name="connsiteX407" fmla="*/ 3253439 w 8363529"/>
                <a:gd name="connsiteY407" fmla="*/ 1215721 h 1292118"/>
                <a:gd name="connsiteX408" fmla="*/ 3186516 w 8363529"/>
                <a:gd name="connsiteY408" fmla="*/ 729895 h 1292118"/>
                <a:gd name="connsiteX409" fmla="*/ 3178153 w 8363529"/>
                <a:gd name="connsiteY409" fmla="*/ 681350 h 1292118"/>
                <a:gd name="connsiteX410" fmla="*/ 3169800 w 8363529"/>
                <a:gd name="connsiteY410" fmla="*/ 721533 h 1292118"/>
                <a:gd name="connsiteX411" fmla="*/ 3102877 w 8363529"/>
                <a:gd name="connsiteY411" fmla="*/ 1167331 h 1292118"/>
                <a:gd name="connsiteX412" fmla="*/ 3094523 w 8363529"/>
                <a:gd name="connsiteY412" fmla="*/ 1245548 h 1292118"/>
                <a:gd name="connsiteX413" fmla="*/ 3086161 w 8363529"/>
                <a:gd name="connsiteY413" fmla="*/ 1247891 h 1292118"/>
                <a:gd name="connsiteX414" fmla="*/ 3019238 w 8363529"/>
                <a:gd name="connsiteY414" fmla="*/ 1262785 h 1292118"/>
                <a:gd name="connsiteX415" fmla="*/ 3010884 w 8363529"/>
                <a:gd name="connsiteY415" fmla="*/ 1264266 h 1292118"/>
                <a:gd name="connsiteX416" fmla="*/ 3002531 w 8363529"/>
                <a:gd name="connsiteY416" fmla="*/ 1202152 h 1292118"/>
                <a:gd name="connsiteX417" fmla="*/ 2935608 w 8363529"/>
                <a:gd name="connsiteY417" fmla="*/ 684263 h 1292118"/>
                <a:gd name="connsiteX418" fmla="*/ 2927245 w 8363529"/>
                <a:gd name="connsiteY418" fmla="*/ 616740 h 1292118"/>
                <a:gd name="connsiteX419" fmla="*/ 2918892 w 8363529"/>
                <a:gd name="connsiteY419" fmla="*/ 686151 h 1292118"/>
                <a:gd name="connsiteX420" fmla="*/ 2851968 w 8363529"/>
                <a:gd name="connsiteY420" fmla="*/ 1226415 h 1292118"/>
                <a:gd name="connsiteX421" fmla="*/ 2843615 w 8363529"/>
                <a:gd name="connsiteY421" fmla="*/ 1292119 h 1292118"/>
                <a:gd name="connsiteX422" fmla="*/ 2509068 w 8363529"/>
                <a:gd name="connsiteY422" fmla="*/ 1292119 h 1292118"/>
                <a:gd name="connsiteX423" fmla="*/ 2500714 w 8363529"/>
                <a:gd name="connsiteY423" fmla="*/ 1260249 h 1292118"/>
                <a:gd name="connsiteX424" fmla="*/ 2433791 w 8363529"/>
                <a:gd name="connsiteY424" fmla="*/ 990291 h 1292118"/>
                <a:gd name="connsiteX425" fmla="*/ 2425438 w 8363529"/>
                <a:gd name="connsiteY425" fmla="*/ 954570 h 1292118"/>
                <a:gd name="connsiteX426" fmla="*/ 2417075 w 8363529"/>
                <a:gd name="connsiteY426" fmla="*/ 986585 h 1292118"/>
                <a:gd name="connsiteX427" fmla="*/ 2350152 w 8363529"/>
                <a:gd name="connsiteY427" fmla="*/ 1256591 h 1292118"/>
                <a:gd name="connsiteX428" fmla="*/ 2341799 w 8363529"/>
                <a:gd name="connsiteY428" fmla="*/ 1292119 h 1292118"/>
                <a:gd name="connsiteX429" fmla="*/ 2174530 w 8363529"/>
                <a:gd name="connsiteY429" fmla="*/ 1292119 h 1292118"/>
                <a:gd name="connsiteX430" fmla="*/ 2166176 w 8363529"/>
                <a:gd name="connsiteY430" fmla="*/ 1234051 h 1292118"/>
                <a:gd name="connsiteX431" fmla="*/ 2099253 w 8363529"/>
                <a:gd name="connsiteY431" fmla="*/ 695267 h 1292118"/>
                <a:gd name="connsiteX432" fmla="*/ 2090890 w 8363529"/>
                <a:gd name="connsiteY432" fmla="*/ 616972 h 1292118"/>
                <a:gd name="connsiteX433" fmla="*/ 2082537 w 8363529"/>
                <a:gd name="connsiteY433" fmla="*/ 704674 h 1292118"/>
                <a:gd name="connsiteX434" fmla="*/ 2015614 w 8363529"/>
                <a:gd name="connsiteY434" fmla="*/ 1240555 h 1292118"/>
                <a:gd name="connsiteX435" fmla="*/ 2007260 w 8363529"/>
                <a:gd name="connsiteY435" fmla="*/ 1292119 h 1292118"/>
                <a:gd name="connsiteX436" fmla="*/ 1672713 w 8363529"/>
                <a:gd name="connsiteY436" fmla="*/ 1292119 h 1292118"/>
                <a:gd name="connsiteX437" fmla="*/ 1664360 w 8363529"/>
                <a:gd name="connsiteY437" fmla="*/ 1291219 h 1292118"/>
                <a:gd name="connsiteX438" fmla="*/ 1597437 w 8363529"/>
                <a:gd name="connsiteY438" fmla="*/ 1280176 h 1292118"/>
                <a:gd name="connsiteX439" fmla="*/ 1589074 w 8363529"/>
                <a:gd name="connsiteY439" fmla="*/ 1278096 h 1292118"/>
                <a:gd name="connsiteX440" fmla="*/ 1580720 w 8363529"/>
                <a:gd name="connsiteY440" fmla="*/ 1279915 h 1292118"/>
                <a:gd name="connsiteX441" fmla="*/ 1513797 w 8363529"/>
                <a:gd name="connsiteY441" fmla="*/ 1291025 h 1292118"/>
                <a:gd name="connsiteX442" fmla="*/ 1505444 w 8363529"/>
                <a:gd name="connsiteY442" fmla="*/ 1292119 h 1292118"/>
                <a:gd name="connsiteX443" fmla="*/ 752719 w 8363529"/>
                <a:gd name="connsiteY443" fmla="*/ 1292119 h 1292118"/>
                <a:gd name="connsiteX444" fmla="*/ 744366 w 8363529"/>
                <a:gd name="connsiteY444" fmla="*/ 1279838 h 1292118"/>
                <a:gd name="connsiteX445" fmla="*/ 677443 w 8363529"/>
                <a:gd name="connsiteY445" fmla="*/ 1162337 h 1292118"/>
                <a:gd name="connsiteX446" fmla="*/ 669089 w 8363529"/>
                <a:gd name="connsiteY446" fmla="*/ 1144762 h 1292118"/>
                <a:gd name="connsiteX447" fmla="*/ 660727 w 8363529"/>
                <a:gd name="connsiteY447" fmla="*/ 1166044 h 1292118"/>
                <a:gd name="connsiteX448" fmla="*/ 593803 w 8363529"/>
                <a:gd name="connsiteY448" fmla="*/ 1282064 h 1292118"/>
                <a:gd name="connsiteX449" fmla="*/ 585450 w 8363529"/>
                <a:gd name="connsiteY449" fmla="*/ 1292119 h 1292118"/>
                <a:gd name="connsiteX450" fmla="*/ 577097 w 8363529"/>
                <a:gd name="connsiteY450" fmla="*/ 1262708 h 1292118"/>
                <a:gd name="connsiteX451" fmla="*/ 510174 w 8363529"/>
                <a:gd name="connsiteY451" fmla="*/ 885798 h 1292118"/>
                <a:gd name="connsiteX452" fmla="*/ 501811 w 8363529"/>
                <a:gd name="connsiteY452" fmla="*/ 808258 h 1292118"/>
                <a:gd name="connsiteX453" fmla="*/ 493458 w 8363529"/>
                <a:gd name="connsiteY453" fmla="*/ 880388 h 1292118"/>
                <a:gd name="connsiteX454" fmla="*/ 426534 w 8363529"/>
                <a:gd name="connsiteY454" fmla="*/ 1203362 h 1292118"/>
                <a:gd name="connsiteX455" fmla="*/ 418181 w 8363529"/>
                <a:gd name="connsiteY455" fmla="*/ 1226763 h 1292118"/>
                <a:gd name="connsiteX456" fmla="*/ 409818 w 8363529"/>
                <a:gd name="connsiteY456" fmla="*/ 1214434 h 1292118"/>
                <a:gd name="connsiteX457" fmla="*/ 342895 w 8363529"/>
                <a:gd name="connsiteY457" fmla="*/ 1080568 h 1292118"/>
                <a:gd name="connsiteX458" fmla="*/ 334542 w 8363529"/>
                <a:gd name="connsiteY458" fmla="*/ 1057544 h 1292118"/>
                <a:gd name="connsiteX459" fmla="*/ 326189 w 8363529"/>
                <a:gd name="connsiteY459" fmla="*/ 1077809 h 1292118"/>
                <a:gd name="connsiteX460" fmla="*/ 259304 w 8363529"/>
                <a:gd name="connsiteY460" fmla="*/ 1265020 h 1292118"/>
                <a:gd name="connsiteX461" fmla="*/ 250903 w 8363529"/>
                <a:gd name="connsiteY461" fmla="*/ 1292119 h 1292118"/>
                <a:gd name="connsiteX462" fmla="*/ 83635 w 8363529"/>
                <a:gd name="connsiteY462" fmla="*/ 1292119 h 1292118"/>
                <a:gd name="connsiteX463" fmla="*/ 75279 w 8363529"/>
                <a:gd name="connsiteY463" fmla="*/ 1238367 h 1292118"/>
                <a:gd name="connsiteX464" fmla="*/ 8394 w 8363529"/>
                <a:gd name="connsiteY464" fmla="*/ 813668 h 1292118"/>
                <a:gd name="connsiteX465" fmla="*/ 0 w 8363529"/>
                <a:gd name="connsiteY465" fmla="*/ 761232 h 12921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</a:cxnLst>
              <a:rect l="l" t="t" r="r" b="b"/>
              <a:pathLst>
                <a:path w="8363529" h="1292118">
                  <a:moveTo>
                    <a:pt x="0" y="685967"/>
                  </a:moveTo>
                  <a:lnTo>
                    <a:pt x="8394" y="706000"/>
                  </a:lnTo>
                  <a:lnTo>
                    <a:pt x="75279" y="868184"/>
                  </a:lnTo>
                  <a:lnTo>
                    <a:pt x="83635" y="888750"/>
                  </a:lnTo>
                  <a:lnTo>
                    <a:pt x="92029" y="898428"/>
                  </a:lnTo>
                  <a:lnTo>
                    <a:pt x="158920" y="965564"/>
                  </a:lnTo>
                  <a:lnTo>
                    <a:pt x="167273" y="972861"/>
                  </a:lnTo>
                  <a:lnTo>
                    <a:pt x="175665" y="994259"/>
                  </a:lnTo>
                  <a:lnTo>
                    <a:pt x="242549" y="1235948"/>
                  </a:lnTo>
                  <a:lnTo>
                    <a:pt x="250903" y="1279199"/>
                  </a:lnTo>
                  <a:lnTo>
                    <a:pt x="259304" y="1246003"/>
                  </a:lnTo>
                  <a:lnTo>
                    <a:pt x="326189" y="1016567"/>
                  </a:lnTo>
                  <a:lnTo>
                    <a:pt x="334542" y="991724"/>
                  </a:lnTo>
                  <a:lnTo>
                    <a:pt x="342895" y="1013731"/>
                  </a:lnTo>
                  <a:lnTo>
                    <a:pt x="409818" y="1141849"/>
                  </a:lnTo>
                  <a:lnTo>
                    <a:pt x="418181" y="1153607"/>
                  </a:lnTo>
                  <a:lnTo>
                    <a:pt x="426534" y="1133835"/>
                  </a:lnTo>
                  <a:lnTo>
                    <a:pt x="493458" y="861187"/>
                  </a:lnTo>
                  <a:lnTo>
                    <a:pt x="501811" y="800245"/>
                  </a:lnTo>
                  <a:lnTo>
                    <a:pt x="510174" y="833517"/>
                  </a:lnTo>
                  <a:lnTo>
                    <a:pt x="577097" y="995285"/>
                  </a:lnTo>
                  <a:lnTo>
                    <a:pt x="585450" y="1007905"/>
                  </a:lnTo>
                  <a:lnTo>
                    <a:pt x="593803" y="1016644"/>
                  </a:lnTo>
                  <a:lnTo>
                    <a:pt x="660727" y="1117615"/>
                  </a:lnTo>
                  <a:lnTo>
                    <a:pt x="669089" y="1136139"/>
                  </a:lnTo>
                  <a:lnTo>
                    <a:pt x="677443" y="1144839"/>
                  </a:lnTo>
                  <a:lnTo>
                    <a:pt x="744366" y="1202830"/>
                  </a:lnTo>
                  <a:lnTo>
                    <a:pt x="752719" y="1208878"/>
                  </a:lnTo>
                  <a:lnTo>
                    <a:pt x="761082" y="1186764"/>
                  </a:lnTo>
                  <a:lnTo>
                    <a:pt x="828005" y="1048582"/>
                  </a:lnTo>
                  <a:lnTo>
                    <a:pt x="836358" y="1035013"/>
                  </a:lnTo>
                  <a:lnTo>
                    <a:pt x="844712" y="1022461"/>
                  </a:lnTo>
                  <a:lnTo>
                    <a:pt x="911635" y="899144"/>
                  </a:lnTo>
                  <a:lnTo>
                    <a:pt x="919988" y="880127"/>
                  </a:lnTo>
                  <a:lnTo>
                    <a:pt x="928351" y="924926"/>
                  </a:lnTo>
                  <a:lnTo>
                    <a:pt x="995274" y="1199839"/>
                  </a:lnTo>
                  <a:lnTo>
                    <a:pt x="1003627" y="1226376"/>
                  </a:lnTo>
                  <a:lnTo>
                    <a:pt x="1011981" y="1210959"/>
                  </a:lnTo>
                  <a:lnTo>
                    <a:pt x="1078904" y="1062760"/>
                  </a:lnTo>
                  <a:lnTo>
                    <a:pt x="1087267" y="1040385"/>
                  </a:lnTo>
                  <a:lnTo>
                    <a:pt x="1095620" y="1040075"/>
                  </a:lnTo>
                  <a:lnTo>
                    <a:pt x="1162543" y="1037472"/>
                  </a:lnTo>
                  <a:lnTo>
                    <a:pt x="1170896" y="1037133"/>
                  </a:lnTo>
                  <a:lnTo>
                    <a:pt x="1179259" y="1028016"/>
                  </a:lnTo>
                  <a:lnTo>
                    <a:pt x="1246182" y="966474"/>
                  </a:lnTo>
                  <a:lnTo>
                    <a:pt x="1254536" y="959970"/>
                  </a:lnTo>
                  <a:lnTo>
                    <a:pt x="1262889" y="969087"/>
                  </a:lnTo>
                  <a:lnTo>
                    <a:pt x="1329812" y="1084574"/>
                  </a:lnTo>
                  <a:lnTo>
                    <a:pt x="1338175" y="1107976"/>
                  </a:lnTo>
                  <a:lnTo>
                    <a:pt x="1346528" y="1126006"/>
                  </a:lnTo>
                  <a:lnTo>
                    <a:pt x="1413451" y="1220744"/>
                  </a:lnTo>
                  <a:lnTo>
                    <a:pt x="1421805" y="1228689"/>
                  </a:lnTo>
                  <a:lnTo>
                    <a:pt x="1430158" y="1230354"/>
                  </a:lnTo>
                  <a:lnTo>
                    <a:pt x="1497091" y="1246003"/>
                  </a:lnTo>
                  <a:lnTo>
                    <a:pt x="1505444" y="1248345"/>
                  </a:lnTo>
                  <a:lnTo>
                    <a:pt x="1513797" y="1237990"/>
                  </a:lnTo>
                  <a:lnTo>
                    <a:pt x="1580720" y="1132403"/>
                  </a:lnTo>
                  <a:lnTo>
                    <a:pt x="1589074" y="1115496"/>
                  </a:lnTo>
                  <a:lnTo>
                    <a:pt x="1597437" y="1122338"/>
                  </a:lnTo>
                  <a:lnTo>
                    <a:pt x="1664360" y="1158485"/>
                  </a:lnTo>
                  <a:lnTo>
                    <a:pt x="1672713" y="1161544"/>
                  </a:lnTo>
                  <a:lnTo>
                    <a:pt x="1681066" y="1159463"/>
                  </a:lnTo>
                  <a:lnTo>
                    <a:pt x="1747989" y="1139245"/>
                  </a:lnTo>
                  <a:lnTo>
                    <a:pt x="1756352" y="1136177"/>
                  </a:lnTo>
                  <a:lnTo>
                    <a:pt x="1764706" y="1141771"/>
                  </a:lnTo>
                  <a:lnTo>
                    <a:pt x="1831629" y="1189329"/>
                  </a:lnTo>
                  <a:lnTo>
                    <a:pt x="1839982" y="1195649"/>
                  </a:lnTo>
                  <a:lnTo>
                    <a:pt x="1848345" y="1194623"/>
                  </a:lnTo>
                  <a:lnTo>
                    <a:pt x="1915268" y="1186348"/>
                  </a:lnTo>
                  <a:lnTo>
                    <a:pt x="1923621" y="1185322"/>
                  </a:lnTo>
                  <a:lnTo>
                    <a:pt x="1931975" y="1183435"/>
                  </a:lnTo>
                  <a:lnTo>
                    <a:pt x="1998898" y="1171908"/>
                  </a:lnTo>
                  <a:lnTo>
                    <a:pt x="2007260" y="1170767"/>
                  </a:lnTo>
                  <a:lnTo>
                    <a:pt x="2015614" y="1124874"/>
                  </a:lnTo>
                  <a:lnTo>
                    <a:pt x="2082537" y="647855"/>
                  </a:lnTo>
                  <a:lnTo>
                    <a:pt x="2090890" y="569792"/>
                  </a:lnTo>
                  <a:lnTo>
                    <a:pt x="2099253" y="644719"/>
                  </a:lnTo>
                  <a:lnTo>
                    <a:pt x="2166176" y="1160372"/>
                  </a:lnTo>
                  <a:lnTo>
                    <a:pt x="2174530" y="1215944"/>
                  </a:lnTo>
                  <a:lnTo>
                    <a:pt x="2182883" y="1219844"/>
                  </a:lnTo>
                  <a:lnTo>
                    <a:pt x="2249806" y="1256891"/>
                  </a:lnTo>
                  <a:lnTo>
                    <a:pt x="2258159" y="1262446"/>
                  </a:lnTo>
                  <a:lnTo>
                    <a:pt x="2266522" y="1261953"/>
                  </a:lnTo>
                  <a:lnTo>
                    <a:pt x="2333445" y="1258633"/>
                  </a:lnTo>
                  <a:lnTo>
                    <a:pt x="2341799" y="1258285"/>
                  </a:lnTo>
                  <a:lnTo>
                    <a:pt x="2350152" y="1219844"/>
                  </a:lnTo>
                  <a:lnTo>
                    <a:pt x="2417075" y="927723"/>
                  </a:lnTo>
                  <a:lnTo>
                    <a:pt x="2425438" y="893056"/>
                  </a:lnTo>
                  <a:lnTo>
                    <a:pt x="2433791" y="925003"/>
                  </a:lnTo>
                  <a:lnTo>
                    <a:pt x="2500714" y="1166237"/>
                  </a:lnTo>
                  <a:lnTo>
                    <a:pt x="2509068" y="1194700"/>
                  </a:lnTo>
                  <a:lnTo>
                    <a:pt x="2517430" y="1197575"/>
                  </a:lnTo>
                  <a:lnTo>
                    <a:pt x="2584354" y="1224450"/>
                  </a:lnTo>
                  <a:lnTo>
                    <a:pt x="2592707" y="1228389"/>
                  </a:lnTo>
                  <a:lnTo>
                    <a:pt x="2601060" y="1226986"/>
                  </a:lnTo>
                  <a:lnTo>
                    <a:pt x="2667983" y="1215566"/>
                  </a:lnTo>
                  <a:lnTo>
                    <a:pt x="2676346" y="1214095"/>
                  </a:lnTo>
                  <a:lnTo>
                    <a:pt x="2684699" y="1208085"/>
                  </a:lnTo>
                  <a:lnTo>
                    <a:pt x="2751623" y="1151111"/>
                  </a:lnTo>
                  <a:lnTo>
                    <a:pt x="2759976" y="1142681"/>
                  </a:lnTo>
                  <a:lnTo>
                    <a:pt x="2768329" y="1134968"/>
                  </a:lnTo>
                  <a:lnTo>
                    <a:pt x="2835262" y="1088736"/>
                  </a:lnTo>
                  <a:lnTo>
                    <a:pt x="2843615" y="1084352"/>
                  </a:lnTo>
                  <a:lnTo>
                    <a:pt x="2851968" y="1034636"/>
                  </a:lnTo>
                  <a:lnTo>
                    <a:pt x="2918892" y="625857"/>
                  </a:lnTo>
                  <a:lnTo>
                    <a:pt x="2927245" y="573344"/>
                  </a:lnTo>
                  <a:lnTo>
                    <a:pt x="2935608" y="638854"/>
                  </a:lnTo>
                  <a:lnTo>
                    <a:pt x="3002531" y="1141471"/>
                  </a:lnTo>
                  <a:lnTo>
                    <a:pt x="3010884" y="1201736"/>
                  </a:lnTo>
                  <a:lnTo>
                    <a:pt x="3019238" y="1191981"/>
                  </a:lnTo>
                  <a:lnTo>
                    <a:pt x="3086161" y="1093081"/>
                  </a:lnTo>
                  <a:lnTo>
                    <a:pt x="3094523" y="1077355"/>
                  </a:lnTo>
                  <a:lnTo>
                    <a:pt x="3102877" y="1013393"/>
                  </a:lnTo>
                  <a:lnTo>
                    <a:pt x="3169800" y="648764"/>
                  </a:lnTo>
                  <a:lnTo>
                    <a:pt x="3178153" y="615869"/>
                  </a:lnTo>
                  <a:lnTo>
                    <a:pt x="3186516" y="662981"/>
                  </a:lnTo>
                  <a:lnTo>
                    <a:pt x="3253439" y="1134213"/>
                  </a:lnTo>
                  <a:lnTo>
                    <a:pt x="3261792" y="1208308"/>
                  </a:lnTo>
                  <a:lnTo>
                    <a:pt x="3270146" y="1211559"/>
                  </a:lnTo>
                  <a:lnTo>
                    <a:pt x="3337069" y="1266792"/>
                  </a:lnTo>
                  <a:lnTo>
                    <a:pt x="3345432" y="1282557"/>
                  </a:lnTo>
                  <a:lnTo>
                    <a:pt x="3353785" y="1264643"/>
                  </a:lnTo>
                  <a:lnTo>
                    <a:pt x="3420708" y="1212053"/>
                  </a:lnTo>
                  <a:lnTo>
                    <a:pt x="3429061" y="1209372"/>
                  </a:lnTo>
                  <a:lnTo>
                    <a:pt x="3437424" y="1209372"/>
                  </a:lnTo>
                  <a:lnTo>
                    <a:pt x="3504347" y="1209179"/>
                  </a:lnTo>
                  <a:lnTo>
                    <a:pt x="3512701" y="1209140"/>
                  </a:lnTo>
                  <a:lnTo>
                    <a:pt x="3521054" y="1162492"/>
                  </a:lnTo>
                  <a:lnTo>
                    <a:pt x="3587977" y="839189"/>
                  </a:lnTo>
                  <a:lnTo>
                    <a:pt x="3596330" y="804067"/>
                  </a:lnTo>
                  <a:lnTo>
                    <a:pt x="3604693" y="826752"/>
                  </a:lnTo>
                  <a:lnTo>
                    <a:pt x="3671616" y="1066506"/>
                  </a:lnTo>
                  <a:lnTo>
                    <a:pt x="3679970" y="1106505"/>
                  </a:lnTo>
                  <a:lnTo>
                    <a:pt x="3688323" y="1075690"/>
                  </a:lnTo>
                  <a:lnTo>
                    <a:pt x="3755246" y="859561"/>
                  </a:lnTo>
                  <a:lnTo>
                    <a:pt x="3763609" y="835821"/>
                  </a:lnTo>
                  <a:lnTo>
                    <a:pt x="3771962" y="862135"/>
                  </a:lnTo>
                  <a:lnTo>
                    <a:pt x="3838885" y="1092404"/>
                  </a:lnTo>
                  <a:lnTo>
                    <a:pt x="3847239" y="1123964"/>
                  </a:lnTo>
                  <a:lnTo>
                    <a:pt x="3855602" y="1131116"/>
                  </a:lnTo>
                  <a:lnTo>
                    <a:pt x="3922525" y="1182448"/>
                  </a:lnTo>
                  <a:lnTo>
                    <a:pt x="3930878" y="1188197"/>
                  </a:lnTo>
                  <a:lnTo>
                    <a:pt x="3939231" y="1199200"/>
                  </a:lnTo>
                  <a:lnTo>
                    <a:pt x="4006154" y="1276663"/>
                  </a:lnTo>
                  <a:lnTo>
                    <a:pt x="4014517" y="1285209"/>
                  </a:lnTo>
                  <a:lnTo>
                    <a:pt x="4022871" y="1281618"/>
                  </a:lnTo>
                  <a:lnTo>
                    <a:pt x="4089755" y="1238513"/>
                  </a:lnTo>
                  <a:lnTo>
                    <a:pt x="4098147" y="1230238"/>
                  </a:lnTo>
                  <a:lnTo>
                    <a:pt x="4106500" y="1190393"/>
                  </a:lnTo>
                  <a:lnTo>
                    <a:pt x="4173394" y="986401"/>
                  </a:lnTo>
                  <a:lnTo>
                    <a:pt x="4181787" y="969726"/>
                  </a:lnTo>
                  <a:lnTo>
                    <a:pt x="4190140" y="991162"/>
                  </a:lnTo>
                  <a:lnTo>
                    <a:pt x="4257024" y="1204949"/>
                  </a:lnTo>
                  <a:lnTo>
                    <a:pt x="4265416" y="1238513"/>
                  </a:lnTo>
                  <a:lnTo>
                    <a:pt x="4273779" y="1104463"/>
                  </a:lnTo>
                  <a:lnTo>
                    <a:pt x="4340664" y="114355"/>
                  </a:lnTo>
                  <a:lnTo>
                    <a:pt x="4349055" y="0"/>
                  </a:lnTo>
                  <a:lnTo>
                    <a:pt x="4357409" y="126153"/>
                  </a:lnTo>
                  <a:lnTo>
                    <a:pt x="4424303" y="1126616"/>
                  </a:lnTo>
                  <a:lnTo>
                    <a:pt x="4432695" y="1250610"/>
                  </a:lnTo>
                  <a:lnTo>
                    <a:pt x="4441048" y="1234322"/>
                  </a:lnTo>
                  <a:lnTo>
                    <a:pt x="4507932" y="1096633"/>
                  </a:lnTo>
                  <a:lnTo>
                    <a:pt x="4516324" y="1078448"/>
                  </a:lnTo>
                  <a:lnTo>
                    <a:pt x="4524687" y="1091755"/>
                  </a:lnTo>
                  <a:lnTo>
                    <a:pt x="4591572" y="1210350"/>
                  </a:lnTo>
                  <a:lnTo>
                    <a:pt x="4599964" y="1226909"/>
                  </a:lnTo>
                  <a:lnTo>
                    <a:pt x="4608317" y="1169179"/>
                  </a:lnTo>
                  <a:lnTo>
                    <a:pt x="4675201" y="717343"/>
                  </a:lnTo>
                  <a:lnTo>
                    <a:pt x="4683603" y="662072"/>
                  </a:lnTo>
                  <a:lnTo>
                    <a:pt x="4691956" y="699158"/>
                  </a:lnTo>
                  <a:lnTo>
                    <a:pt x="4758840" y="963599"/>
                  </a:lnTo>
                  <a:lnTo>
                    <a:pt x="4767232" y="993127"/>
                  </a:lnTo>
                  <a:lnTo>
                    <a:pt x="4775595" y="996640"/>
                  </a:lnTo>
                  <a:lnTo>
                    <a:pt x="4842480" y="1033503"/>
                  </a:lnTo>
                  <a:lnTo>
                    <a:pt x="4850872" y="1039591"/>
                  </a:lnTo>
                  <a:lnTo>
                    <a:pt x="4859225" y="1049753"/>
                  </a:lnTo>
                  <a:lnTo>
                    <a:pt x="4926109" y="1102875"/>
                  </a:lnTo>
                  <a:lnTo>
                    <a:pt x="4934501" y="1107298"/>
                  </a:lnTo>
                  <a:lnTo>
                    <a:pt x="4942864" y="1120867"/>
                  </a:lnTo>
                  <a:lnTo>
                    <a:pt x="5009749" y="1243390"/>
                  </a:lnTo>
                  <a:lnTo>
                    <a:pt x="5018141" y="1260704"/>
                  </a:lnTo>
                  <a:lnTo>
                    <a:pt x="5026494" y="1254278"/>
                  </a:lnTo>
                  <a:lnTo>
                    <a:pt x="5093388" y="1193152"/>
                  </a:lnTo>
                  <a:lnTo>
                    <a:pt x="5101780" y="1184045"/>
                  </a:lnTo>
                  <a:lnTo>
                    <a:pt x="5110134" y="1186425"/>
                  </a:lnTo>
                  <a:lnTo>
                    <a:pt x="5177018" y="1200217"/>
                  </a:lnTo>
                  <a:lnTo>
                    <a:pt x="5185410" y="1201465"/>
                  </a:lnTo>
                  <a:lnTo>
                    <a:pt x="5193773" y="1170544"/>
                  </a:lnTo>
                  <a:lnTo>
                    <a:pt x="5260657" y="901902"/>
                  </a:lnTo>
                  <a:lnTo>
                    <a:pt x="5269049" y="865426"/>
                  </a:lnTo>
                  <a:lnTo>
                    <a:pt x="5277403" y="887579"/>
                  </a:lnTo>
                  <a:lnTo>
                    <a:pt x="5344287" y="1092288"/>
                  </a:lnTo>
                  <a:lnTo>
                    <a:pt x="5352650" y="1121961"/>
                  </a:lnTo>
                  <a:lnTo>
                    <a:pt x="5361042" y="1123857"/>
                  </a:lnTo>
                  <a:lnTo>
                    <a:pt x="5427926" y="1161882"/>
                  </a:lnTo>
                  <a:lnTo>
                    <a:pt x="5436280" y="1174967"/>
                  </a:lnTo>
                  <a:lnTo>
                    <a:pt x="5444672" y="1169296"/>
                  </a:lnTo>
                  <a:lnTo>
                    <a:pt x="5511566" y="1150656"/>
                  </a:lnTo>
                  <a:lnTo>
                    <a:pt x="5519919" y="1149639"/>
                  </a:lnTo>
                  <a:lnTo>
                    <a:pt x="5528311" y="1169257"/>
                  </a:lnTo>
                  <a:lnTo>
                    <a:pt x="5595195" y="1277912"/>
                  </a:lnTo>
                  <a:lnTo>
                    <a:pt x="5603558" y="1287474"/>
                  </a:lnTo>
                  <a:lnTo>
                    <a:pt x="5611950" y="1195571"/>
                  </a:lnTo>
                  <a:lnTo>
                    <a:pt x="5678835" y="463828"/>
                  </a:lnTo>
                  <a:lnTo>
                    <a:pt x="5687188" y="372748"/>
                  </a:lnTo>
                  <a:lnTo>
                    <a:pt x="5695580" y="432558"/>
                  </a:lnTo>
                  <a:lnTo>
                    <a:pt x="5762474" y="1111421"/>
                  </a:lnTo>
                  <a:lnTo>
                    <a:pt x="5770827" y="1233606"/>
                  </a:lnTo>
                  <a:lnTo>
                    <a:pt x="5779219" y="1234545"/>
                  </a:lnTo>
                  <a:lnTo>
                    <a:pt x="5846103" y="1240177"/>
                  </a:lnTo>
                  <a:lnTo>
                    <a:pt x="5854457" y="1240709"/>
                  </a:lnTo>
                  <a:lnTo>
                    <a:pt x="5862858" y="1235793"/>
                  </a:lnTo>
                  <a:lnTo>
                    <a:pt x="5929743" y="1171908"/>
                  </a:lnTo>
                  <a:lnTo>
                    <a:pt x="5938096" y="1158485"/>
                  </a:lnTo>
                  <a:lnTo>
                    <a:pt x="5946488" y="1173980"/>
                  </a:lnTo>
                  <a:lnTo>
                    <a:pt x="6013372" y="1252052"/>
                  </a:lnTo>
                  <a:lnTo>
                    <a:pt x="6021735" y="1258362"/>
                  </a:lnTo>
                  <a:lnTo>
                    <a:pt x="6030127" y="1241387"/>
                  </a:lnTo>
                  <a:lnTo>
                    <a:pt x="6097011" y="1087526"/>
                  </a:lnTo>
                  <a:lnTo>
                    <a:pt x="6105365" y="1065673"/>
                  </a:lnTo>
                  <a:lnTo>
                    <a:pt x="6113767" y="1077993"/>
                  </a:lnTo>
                  <a:lnTo>
                    <a:pt x="6180651" y="1162831"/>
                  </a:lnTo>
                  <a:lnTo>
                    <a:pt x="6189004" y="1171976"/>
                  </a:lnTo>
                  <a:lnTo>
                    <a:pt x="6197396" y="1170128"/>
                  </a:lnTo>
                  <a:lnTo>
                    <a:pt x="6264280" y="1151072"/>
                  </a:lnTo>
                  <a:lnTo>
                    <a:pt x="6272644" y="1148052"/>
                  </a:lnTo>
                  <a:lnTo>
                    <a:pt x="6281036" y="1156143"/>
                  </a:lnTo>
                  <a:lnTo>
                    <a:pt x="6347920" y="1211337"/>
                  </a:lnTo>
                  <a:lnTo>
                    <a:pt x="6356273" y="1217231"/>
                  </a:lnTo>
                  <a:lnTo>
                    <a:pt x="6364665" y="1219427"/>
                  </a:lnTo>
                  <a:lnTo>
                    <a:pt x="6431560" y="1235716"/>
                  </a:lnTo>
                  <a:lnTo>
                    <a:pt x="6439913" y="1237612"/>
                  </a:lnTo>
                  <a:lnTo>
                    <a:pt x="6448305" y="1241426"/>
                  </a:lnTo>
                  <a:lnTo>
                    <a:pt x="6515189" y="1275947"/>
                  </a:lnTo>
                  <a:lnTo>
                    <a:pt x="6523542" y="1280825"/>
                  </a:lnTo>
                  <a:lnTo>
                    <a:pt x="6531944" y="1273111"/>
                  </a:lnTo>
                  <a:lnTo>
                    <a:pt x="6598829" y="1204340"/>
                  </a:lnTo>
                  <a:lnTo>
                    <a:pt x="6607182" y="1194739"/>
                  </a:lnTo>
                  <a:lnTo>
                    <a:pt x="6615535" y="1206759"/>
                  </a:lnTo>
                  <a:lnTo>
                    <a:pt x="6682458" y="1273789"/>
                  </a:lnTo>
                  <a:lnTo>
                    <a:pt x="6690821" y="1279721"/>
                  </a:lnTo>
                  <a:lnTo>
                    <a:pt x="6699174" y="1267063"/>
                  </a:lnTo>
                  <a:lnTo>
                    <a:pt x="6766097" y="1140184"/>
                  </a:lnTo>
                  <a:lnTo>
                    <a:pt x="6774451" y="1120189"/>
                  </a:lnTo>
                  <a:lnTo>
                    <a:pt x="6782814" y="1133264"/>
                  </a:lnTo>
                  <a:lnTo>
                    <a:pt x="6849737" y="1254772"/>
                  </a:lnTo>
                  <a:lnTo>
                    <a:pt x="6858090" y="1272463"/>
                  </a:lnTo>
                  <a:lnTo>
                    <a:pt x="6866443" y="1267247"/>
                  </a:lnTo>
                  <a:lnTo>
                    <a:pt x="6933366" y="1239200"/>
                  </a:lnTo>
                  <a:lnTo>
                    <a:pt x="6941729" y="1236780"/>
                  </a:lnTo>
                  <a:lnTo>
                    <a:pt x="6950083" y="1240032"/>
                  </a:lnTo>
                  <a:lnTo>
                    <a:pt x="7017006" y="1271708"/>
                  </a:lnTo>
                  <a:lnTo>
                    <a:pt x="7025359" y="1276586"/>
                  </a:lnTo>
                  <a:lnTo>
                    <a:pt x="7033712" y="1273111"/>
                  </a:lnTo>
                  <a:lnTo>
                    <a:pt x="7100645" y="1243506"/>
                  </a:lnTo>
                  <a:lnTo>
                    <a:pt x="7108998" y="1239538"/>
                  </a:lnTo>
                  <a:lnTo>
                    <a:pt x="7117351" y="1241203"/>
                  </a:lnTo>
                  <a:lnTo>
                    <a:pt x="7184274" y="1254888"/>
                  </a:lnTo>
                  <a:lnTo>
                    <a:pt x="7192628" y="1256659"/>
                  </a:lnTo>
                  <a:lnTo>
                    <a:pt x="7200991" y="1253107"/>
                  </a:lnTo>
                  <a:lnTo>
                    <a:pt x="7267914" y="1226909"/>
                  </a:lnTo>
                  <a:lnTo>
                    <a:pt x="7276267" y="1223889"/>
                  </a:lnTo>
                  <a:lnTo>
                    <a:pt x="7284620" y="1226609"/>
                  </a:lnTo>
                  <a:lnTo>
                    <a:pt x="7351543" y="1249749"/>
                  </a:lnTo>
                  <a:lnTo>
                    <a:pt x="7359906" y="1252807"/>
                  </a:lnTo>
                  <a:lnTo>
                    <a:pt x="7368260" y="1187597"/>
                  </a:lnTo>
                  <a:lnTo>
                    <a:pt x="7435183" y="752232"/>
                  </a:lnTo>
                  <a:lnTo>
                    <a:pt x="7443536" y="706639"/>
                  </a:lnTo>
                  <a:lnTo>
                    <a:pt x="7451899" y="723237"/>
                  </a:lnTo>
                  <a:lnTo>
                    <a:pt x="7518822" y="882846"/>
                  </a:lnTo>
                  <a:lnTo>
                    <a:pt x="7527175" y="906935"/>
                  </a:lnTo>
                  <a:lnTo>
                    <a:pt x="7535528" y="949160"/>
                  </a:lnTo>
                  <a:lnTo>
                    <a:pt x="7602452" y="1232241"/>
                  </a:lnTo>
                  <a:lnTo>
                    <a:pt x="7610815" y="1261991"/>
                  </a:lnTo>
                  <a:lnTo>
                    <a:pt x="7619168" y="1259117"/>
                  </a:lnTo>
                  <a:lnTo>
                    <a:pt x="7686091" y="1234167"/>
                  </a:lnTo>
                  <a:lnTo>
                    <a:pt x="7694444" y="1230770"/>
                  </a:lnTo>
                  <a:lnTo>
                    <a:pt x="7702798" y="1175228"/>
                  </a:lnTo>
                  <a:lnTo>
                    <a:pt x="7769731" y="627628"/>
                  </a:lnTo>
                  <a:lnTo>
                    <a:pt x="7778084" y="542839"/>
                  </a:lnTo>
                  <a:lnTo>
                    <a:pt x="7786437" y="654174"/>
                  </a:lnTo>
                  <a:lnTo>
                    <a:pt x="7853360" y="1198252"/>
                  </a:lnTo>
                  <a:lnTo>
                    <a:pt x="7861713" y="1240893"/>
                  </a:lnTo>
                  <a:lnTo>
                    <a:pt x="7870077" y="1217047"/>
                  </a:lnTo>
                  <a:lnTo>
                    <a:pt x="7937000" y="949837"/>
                  </a:lnTo>
                  <a:lnTo>
                    <a:pt x="7945353" y="902473"/>
                  </a:lnTo>
                  <a:lnTo>
                    <a:pt x="7953706" y="932378"/>
                  </a:lnTo>
                  <a:lnTo>
                    <a:pt x="8020629" y="1160643"/>
                  </a:lnTo>
                  <a:lnTo>
                    <a:pt x="8028992" y="1187858"/>
                  </a:lnTo>
                  <a:lnTo>
                    <a:pt x="8037346" y="1188351"/>
                  </a:lnTo>
                  <a:lnTo>
                    <a:pt x="8104268" y="1192658"/>
                  </a:lnTo>
                  <a:lnTo>
                    <a:pt x="8112622" y="1193268"/>
                  </a:lnTo>
                  <a:lnTo>
                    <a:pt x="8120985" y="1206459"/>
                  </a:lnTo>
                  <a:lnTo>
                    <a:pt x="8187908" y="1276131"/>
                  </a:lnTo>
                  <a:lnTo>
                    <a:pt x="8196261" y="1282025"/>
                  </a:lnTo>
                  <a:lnTo>
                    <a:pt x="8204614" y="1228196"/>
                  </a:lnTo>
                  <a:lnTo>
                    <a:pt x="8271537" y="667550"/>
                  </a:lnTo>
                  <a:lnTo>
                    <a:pt x="8279900" y="575570"/>
                  </a:lnTo>
                  <a:lnTo>
                    <a:pt x="8288254" y="638554"/>
                  </a:lnTo>
                  <a:lnTo>
                    <a:pt x="8355177" y="1147636"/>
                  </a:lnTo>
                  <a:lnTo>
                    <a:pt x="8363530" y="1211937"/>
                  </a:lnTo>
                  <a:lnTo>
                    <a:pt x="8363530" y="1239277"/>
                  </a:lnTo>
                  <a:lnTo>
                    <a:pt x="8355177" y="1173457"/>
                  </a:lnTo>
                  <a:lnTo>
                    <a:pt x="8288254" y="652278"/>
                  </a:lnTo>
                  <a:lnTo>
                    <a:pt x="8279900" y="587783"/>
                  </a:lnTo>
                  <a:lnTo>
                    <a:pt x="8271537" y="679502"/>
                  </a:lnTo>
                  <a:lnTo>
                    <a:pt x="8204614" y="1238474"/>
                  </a:lnTo>
                  <a:lnTo>
                    <a:pt x="8196261" y="1292119"/>
                  </a:lnTo>
                  <a:lnTo>
                    <a:pt x="8028992" y="1292119"/>
                  </a:lnTo>
                  <a:lnTo>
                    <a:pt x="8020629" y="1264982"/>
                  </a:lnTo>
                  <a:lnTo>
                    <a:pt x="7953706" y="1037278"/>
                  </a:lnTo>
                  <a:lnTo>
                    <a:pt x="7945353" y="1007450"/>
                  </a:lnTo>
                  <a:lnTo>
                    <a:pt x="7937000" y="1047333"/>
                  </a:lnTo>
                  <a:lnTo>
                    <a:pt x="7870077" y="1272047"/>
                  </a:lnTo>
                  <a:lnTo>
                    <a:pt x="7861713" y="1292119"/>
                  </a:lnTo>
                  <a:lnTo>
                    <a:pt x="7853360" y="1246681"/>
                  </a:lnTo>
                  <a:lnTo>
                    <a:pt x="7786437" y="667095"/>
                  </a:lnTo>
                  <a:lnTo>
                    <a:pt x="7778084" y="548510"/>
                  </a:lnTo>
                  <a:lnTo>
                    <a:pt x="7769731" y="640141"/>
                  </a:lnTo>
                  <a:lnTo>
                    <a:pt x="7702798" y="1232086"/>
                  </a:lnTo>
                  <a:lnTo>
                    <a:pt x="7694444" y="1292119"/>
                  </a:lnTo>
                  <a:lnTo>
                    <a:pt x="7610815" y="1292119"/>
                  </a:lnTo>
                  <a:lnTo>
                    <a:pt x="7602452" y="1264866"/>
                  </a:lnTo>
                  <a:lnTo>
                    <a:pt x="7535528" y="1005679"/>
                  </a:lnTo>
                  <a:lnTo>
                    <a:pt x="7527175" y="967006"/>
                  </a:lnTo>
                  <a:lnTo>
                    <a:pt x="7518822" y="945376"/>
                  </a:lnTo>
                  <a:lnTo>
                    <a:pt x="7451899" y="802064"/>
                  </a:lnTo>
                  <a:lnTo>
                    <a:pt x="7443536" y="787169"/>
                  </a:lnTo>
                  <a:lnTo>
                    <a:pt x="7435183" y="827159"/>
                  </a:lnTo>
                  <a:lnTo>
                    <a:pt x="7368260" y="1209256"/>
                  </a:lnTo>
                  <a:lnTo>
                    <a:pt x="7359906" y="1266492"/>
                  </a:lnTo>
                  <a:lnTo>
                    <a:pt x="7351543" y="1269211"/>
                  </a:lnTo>
                  <a:lnTo>
                    <a:pt x="7284620" y="1289700"/>
                  </a:lnTo>
                  <a:lnTo>
                    <a:pt x="7276267" y="1292119"/>
                  </a:lnTo>
                  <a:lnTo>
                    <a:pt x="6356273" y="1292119"/>
                  </a:lnTo>
                  <a:lnTo>
                    <a:pt x="6347920" y="1288683"/>
                  </a:lnTo>
                  <a:lnTo>
                    <a:pt x="6281036" y="1256320"/>
                  </a:lnTo>
                  <a:lnTo>
                    <a:pt x="6272644" y="1251558"/>
                  </a:lnTo>
                  <a:lnTo>
                    <a:pt x="6264280" y="1256736"/>
                  </a:lnTo>
                  <a:lnTo>
                    <a:pt x="6197396" y="1288945"/>
                  </a:lnTo>
                  <a:lnTo>
                    <a:pt x="6189004" y="1292119"/>
                  </a:lnTo>
                  <a:lnTo>
                    <a:pt x="6021735" y="1292119"/>
                  </a:lnTo>
                  <a:lnTo>
                    <a:pt x="6013372" y="1291596"/>
                  </a:lnTo>
                  <a:lnTo>
                    <a:pt x="5946488" y="1284861"/>
                  </a:lnTo>
                  <a:lnTo>
                    <a:pt x="5938096" y="1283544"/>
                  </a:lnTo>
                  <a:lnTo>
                    <a:pt x="5929743" y="1284938"/>
                  </a:lnTo>
                  <a:lnTo>
                    <a:pt x="5862858" y="1291596"/>
                  </a:lnTo>
                  <a:lnTo>
                    <a:pt x="5854457" y="1292119"/>
                  </a:lnTo>
                  <a:lnTo>
                    <a:pt x="5770827" y="1292119"/>
                  </a:lnTo>
                  <a:lnTo>
                    <a:pt x="5762474" y="1161660"/>
                  </a:lnTo>
                  <a:lnTo>
                    <a:pt x="5695580" y="436603"/>
                  </a:lnTo>
                  <a:lnTo>
                    <a:pt x="5687188" y="372748"/>
                  </a:lnTo>
                  <a:lnTo>
                    <a:pt x="5678835" y="464273"/>
                  </a:lnTo>
                  <a:lnTo>
                    <a:pt x="5611950" y="1199762"/>
                  </a:lnTo>
                  <a:lnTo>
                    <a:pt x="5603558" y="1292119"/>
                  </a:lnTo>
                  <a:lnTo>
                    <a:pt x="5436280" y="1292119"/>
                  </a:lnTo>
                  <a:lnTo>
                    <a:pt x="5427926" y="1289970"/>
                  </a:lnTo>
                  <a:lnTo>
                    <a:pt x="5361042" y="1283728"/>
                  </a:lnTo>
                  <a:lnTo>
                    <a:pt x="5352650" y="1283389"/>
                  </a:lnTo>
                  <a:lnTo>
                    <a:pt x="5344287" y="1238629"/>
                  </a:lnTo>
                  <a:lnTo>
                    <a:pt x="5277403" y="929610"/>
                  </a:lnTo>
                  <a:lnTo>
                    <a:pt x="5269049" y="896192"/>
                  </a:lnTo>
                  <a:lnTo>
                    <a:pt x="5260657" y="939182"/>
                  </a:lnTo>
                  <a:lnTo>
                    <a:pt x="5193773" y="1255681"/>
                  </a:lnTo>
                  <a:lnTo>
                    <a:pt x="5185410" y="1292119"/>
                  </a:lnTo>
                  <a:lnTo>
                    <a:pt x="5177018" y="1291442"/>
                  </a:lnTo>
                  <a:lnTo>
                    <a:pt x="5110134" y="1283806"/>
                  </a:lnTo>
                  <a:lnTo>
                    <a:pt x="5101780" y="1282480"/>
                  </a:lnTo>
                  <a:lnTo>
                    <a:pt x="5093388" y="1283622"/>
                  </a:lnTo>
                  <a:lnTo>
                    <a:pt x="5026494" y="1291325"/>
                  </a:lnTo>
                  <a:lnTo>
                    <a:pt x="5018141" y="1292119"/>
                  </a:lnTo>
                  <a:lnTo>
                    <a:pt x="5009749" y="1277118"/>
                  </a:lnTo>
                  <a:lnTo>
                    <a:pt x="4942864" y="1170728"/>
                  </a:lnTo>
                  <a:lnTo>
                    <a:pt x="4934501" y="1158940"/>
                  </a:lnTo>
                  <a:lnTo>
                    <a:pt x="4926109" y="1159279"/>
                  </a:lnTo>
                  <a:lnTo>
                    <a:pt x="4859225" y="1163169"/>
                  </a:lnTo>
                  <a:lnTo>
                    <a:pt x="4850872" y="1163924"/>
                  </a:lnTo>
                  <a:lnTo>
                    <a:pt x="4842480" y="1163131"/>
                  </a:lnTo>
                  <a:lnTo>
                    <a:pt x="4775595" y="1158369"/>
                  </a:lnTo>
                  <a:lnTo>
                    <a:pt x="4767232" y="1157914"/>
                  </a:lnTo>
                  <a:lnTo>
                    <a:pt x="4758840" y="1169905"/>
                  </a:lnTo>
                  <a:lnTo>
                    <a:pt x="4691956" y="1277118"/>
                  </a:lnTo>
                  <a:lnTo>
                    <a:pt x="4683603" y="1292119"/>
                  </a:lnTo>
                  <a:lnTo>
                    <a:pt x="4432695" y="1292119"/>
                  </a:lnTo>
                  <a:lnTo>
                    <a:pt x="4424303" y="1187935"/>
                  </a:lnTo>
                  <a:lnTo>
                    <a:pt x="4357409" y="347305"/>
                  </a:lnTo>
                  <a:lnTo>
                    <a:pt x="4349055" y="241302"/>
                  </a:lnTo>
                  <a:lnTo>
                    <a:pt x="4340664" y="338352"/>
                  </a:lnTo>
                  <a:lnTo>
                    <a:pt x="4273779" y="1178403"/>
                  </a:lnTo>
                  <a:lnTo>
                    <a:pt x="4265416" y="1292119"/>
                  </a:lnTo>
                  <a:lnTo>
                    <a:pt x="4257024" y="1254549"/>
                  </a:lnTo>
                  <a:lnTo>
                    <a:pt x="4190140" y="1015125"/>
                  </a:lnTo>
                  <a:lnTo>
                    <a:pt x="4181787" y="991124"/>
                  </a:lnTo>
                  <a:lnTo>
                    <a:pt x="4173394" y="1010402"/>
                  </a:lnTo>
                  <a:lnTo>
                    <a:pt x="4106500" y="1246081"/>
                  </a:lnTo>
                  <a:lnTo>
                    <a:pt x="4098147" y="1292119"/>
                  </a:lnTo>
                  <a:lnTo>
                    <a:pt x="3763609" y="1292119"/>
                  </a:lnTo>
                  <a:lnTo>
                    <a:pt x="3755246" y="1290503"/>
                  </a:lnTo>
                  <a:lnTo>
                    <a:pt x="3688323" y="1275492"/>
                  </a:lnTo>
                  <a:lnTo>
                    <a:pt x="3679970" y="1273334"/>
                  </a:lnTo>
                  <a:lnTo>
                    <a:pt x="3671616" y="1216253"/>
                  </a:lnTo>
                  <a:lnTo>
                    <a:pt x="3604693" y="873894"/>
                  </a:lnTo>
                  <a:lnTo>
                    <a:pt x="3596330" y="841531"/>
                  </a:lnTo>
                  <a:lnTo>
                    <a:pt x="3587977" y="880582"/>
                  </a:lnTo>
                  <a:lnTo>
                    <a:pt x="3521054" y="1240216"/>
                  </a:lnTo>
                  <a:lnTo>
                    <a:pt x="3512701" y="1292119"/>
                  </a:lnTo>
                  <a:lnTo>
                    <a:pt x="3261792" y="1292119"/>
                  </a:lnTo>
                  <a:lnTo>
                    <a:pt x="3253439" y="1215721"/>
                  </a:lnTo>
                  <a:lnTo>
                    <a:pt x="3186516" y="729895"/>
                  </a:lnTo>
                  <a:lnTo>
                    <a:pt x="3178153" y="681350"/>
                  </a:lnTo>
                  <a:lnTo>
                    <a:pt x="3169800" y="721533"/>
                  </a:lnTo>
                  <a:lnTo>
                    <a:pt x="3102877" y="1167331"/>
                  </a:lnTo>
                  <a:lnTo>
                    <a:pt x="3094523" y="1245548"/>
                  </a:lnTo>
                  <a:lnTo>
                    <a:pt x="3086161" y="1247891"/>
                  </a:lnTo>
                  <a:lnTo>
                    <a:pt x="3019238" y="1262785"/>
                  </a:lnTo>
                  <a:lnTo>
                    <a:pt x="3010884" y="1264266"/>
                  </a:lnTo>
                  <a:lnTo>
                    <a:pt x="3002531" y="1202152"/>
                  </a:lnTo>
                  <a:lnTo>
                    <a:pt x="2935608" y="684263"/>
                  </a:lnTo>
                  <a:lnTo>
                    <a:pt x="2927245" y="616740"/>
                  </a:lnTo>
                  <a:lnTo>
                    <a:pt x="2918892" y="686151"/>
                  </a:lnTo>
                  <a:lnTo>
                    <a:pt x="2851968" y="1226415"/>
                  </a:lnTo>
                  <a:lnTo>
                    <a:pt x="2843615" y="1292119"/>
                  </a:lnTo>
                  <a:lnTo>
                    <a:pt x="2509068" y="1292119"/>
                  </a:lnTo>
                  <a:lnTo>
                    <a:pt x="2500714" y="1260249"/>
                  </a:lnTo>
                  <a:lnTo>
                    <a:pt x="2433791" y="990291"/>
                  </a:lnTo>
                  <a:lnTo>
                    <a:pt x="2425438" y="954570"/>
                  </a:lnTo>
                  <a:lnTo>
                    <a:pt x="2417075" y="986585"/>
                  </a:lnTo>
                  <a:lnTo>
                    <a:pt x="2350152" y="1256591"/>
                  </a:lnTo>
                  <a:lnTo>
                    <a:pt x="2341799" y="1292119"/>
                  </a:lnTo>
                  <a:lnTo>
                    <a:pt x="2174530" y="1292119"/>
                  </a:lnTo>
                  <a:lnTo>
                    <a:pt x="2166176" y="1234051"/>
                  </a:lnTo>
                  <a:lnTo>
                    <a:pt x="2099253" y="695267"/>
                  </a:lnTo>
                  <a:lnTo>
                    <a:pt x="2090890" y="616972"/>
                  </a:lnTo>
                  <a:lnTo>
                    <a:pt x="2082537" y="704674"/>
                  </a:lnTo>
                  <a:lnTo>
                    <a:pt x="2015614" y="1240555"/>
                  </a:lnTo>
                  <a:lnTo>
                    <a:pt x="2007260" y="1292119"/>
                  </a:lnTo>
                  <a:lnTo>
                    <a:pt x="1672713" y="1292119"/>
                  </a:lnTo>
                  <a:lnTo>
                    <a:pt x="1664360" y="1291219"/>
                  </a:lnTo>
                  <a:lnTo>
                    <a:pt x="1597437" y="1280176"/>
                  </a:lnTo>
                  <a:lnTo>
                    <a:pt x="1589074" y="1278096"/>
                  </a:lnTo>
                  <a:lnTo>
                    <a:pt x="1580720" y="1279915"/>
                  </a:lnTo>
                  <a:lnTo>
                    <a:pt x="1513797" y="1291025"/>
                  </a:lnTo>
                  <a:lnTo>
                    <a:pt x="1505444" y="1292119"/>
                  </a:lnTo>
                  <a:lnTo>
                    <a:pt x="752719" y="1292119"/>
                  </a:lnTo>
                  <a:lnTo>
                    <a:pt x="744366" y="1279838"/>
                  </a:lnTo>
                  <a:lnTo>
                    <a:pt x="677443" y="1162337"/>
                  </a:lnTo>
                  <a:lnTo>
                    <a:pt x="669089" y="1144762"/>
                  </a:lnTo>
                  <a:lnTo>
                    <a:pt x="660727" y="1166044"/>
                  </a:lnTo>
                  <a:lnTo>
                    <a:pt x="593803" y="1282064"/>
                  </a:lnTo>
                  <a:lnTo>
                    <a:pt x="585450" y="1292119"/>
                  </a:lnTo>
                  <a:lnTo>
                    <a:pt x="577097" y="1262708"/>
                  </a:lnTo>
                  <a:lnTo>
                    <a:pt x="510174" y="885798"/>
                  </a:lnTo>
                  <a:lnTo>
                    <a:pt x="501811" y="808258"/>
                  </a:lnTo>
                  <a:lnTo>
                    <a:pt x="493458" y="880388"/>
                  </a:lnTo>
                  <a:lnTo>
                    <a:pt x="426534" y="1203362"/>
                  </a:lnTo>
                  <a:lnTo>
                    <a:pt x="418181" y="1226763"/>
                  </a:lnTo>
                  <a:lnTo>
                    <a:pt x="409818" y="1214434"/>
                  </a:lnTo>
                  <a:lnTo>
                    <a:pt x="342895" y="1080568"/>
                  </a:lnTo>
                  <a:lnTo>
                    <a:pt x="334542" y="1057544"/>
                  </a:lnTo>
                  <a:lnTo>
                    <a:pt x="326189" y="1077809"/>
                  </a:lnTo>
                  <a:lnTo>
                    <a:pt x="259304" y="1265020"/>
                  </a:lnTo>
                  <a:lnTo>
                    <a:pt x="250903" y="1292119"/>
                  </a:lnTo>
                  <a:lnTo>
                    <a:pt x="83635" y="1292119"/>
                  </a:lnTo>
                  <a:lnTo>
                    <a:pt x="75279" y="1238367"/>
                  </a:lnTo>
                  <a:lnTo>
                    <a:pt x="8394" y="813668"/>
                  </a:lnTo>
                  <a:lnTo>
                    <a:pt x="0" y="761232"/>
                  </a:lnTo>
                  <a:close/>
                </a:path>
              </a:pathLst>
            </a:custGeom>
            <a:solidFill>
              <a:srgbClr val="BC80BD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07" name="Freeform: Shape 3006">
              <a:extLst>
                <a:ext uri="{FF2B5EF4-FFF2-40B4-BE49-F238E27FC236}">
                  <a16:creationId xmlns:a16="http://schemas.microsoft.com/office/drawing/2014/main" id="{75F3DD6F-AD1A-7DCB-3D16-406727F5B43E}"/>
                </a:ext>
              </a:extLst>
            </p:cNvPr>
            <p:cNvSpPr/>
            <p:nvPr/>
          </p:nvSpPr>
          <p:spPr>
            <a:xfrm>
              <a:off x="1961705" y="3586528"/>
              <a:ext cx="8363529" cy="1050817"/>
            </a:xfrm>
            <a:custGeom>
              <a:avLst/>
              <a:gdLst>
                <a:gd name="connsiteX0" fmla="*/ 0 w 8363529"/>
                <a:gd name="connsiteY0" fmla="*/ 519931 h 1050817"/>
                <a:gd name="connsiteX1" fmla="*/ 8394 w 8363529"/>
                <a:gd name="connsiteY1" fmla="*/ 572366 h 1050817"/>
                <a:gd name="connsiteX2" fmla="*/ 75279 w 8363529"/>
                <a:gd name="connsiteY2" fmla="*/ 997066 h 1050817"/>
                <a:gd name="connsiteX3" fmla="*/ 83635 w 8363529"/>
                <a:gd name="connsiteY3" fmla="*/ 1050817 h 1050817"/>
                <a:gd name="connsiteX4" fmla="*/ 250903 w 8363529"/>
                <a:gd name="connsiteY4" fmla="*/ 1050817 h 1050817"/>
                <a:gd name="connsiteX5" fmla="*/ 259304 w 8363529"/>
                <a:gd name="connsiteY5" fmla="*/ 1023719 h 1050817"/>
                <a:gd name="connsiteX6" fmla="*/ 326189 w 8363529"/>
                <a:gd name="connsiteY6" fmla="*/ 836508 h 1050817"/>
                <a:gd name="connsiteX7" fmla="*/ 334542 w 8363529"/>
                <a:gd name="connsiteY7" fmla="*/ 816242 h 1050817"/>
                <a:gd name="connsiteX8" fmla="*/ 342895 w 8363529"/>
                <a:gd name="connsiteY8" fmla="*/ 839266 h 1050817"/>
                <a:gd name="connsiteX9" fmla="*/ 409818 w 8363529"/>
                <a:gd name="connsiteY9" fmla="*/ 973132 h 1050817"/>
                <a:gd name="connsiteX10" fmla="*/ 418181 w 8363529"/>
                <a:gd name="connsiteY10" fmla="*/ 985462 h 1050817"/>
                <a:gd name="connsiteX11" fmla="*/ 426534 w 8363529"/>
                <a:gd name="connsiteY11" fmla="*/ 962060 h 1050817"/>
                <a:gd name="connsiteX12" fmla="*/ 493458 w 8363529"/>
                <a:gd name="connsiteY12" fmla="*/ 639086 h 1050817"/>
                <a:gd name="connsiteX13" fmla="*/ 501811 w 8363529"/>
                <a:gd name="connsiteY13" fmla="*/ 566956 h 1050817"/>
                <a:gd name="connsiteX14" fmla="*/ 510174 w 8363529"/>
                <a:gd name="connsiteY14" fmla="*/ 644496 h 1050817"/>
                <a:gd name="connsiteX15" fmla="*/ 577097 w 8363529"/>
                <a:gd name="connsiteY15" fmla="*/ 1021406 h 1050817"/>
                <a:gd name="connsiteX16" fmla="*/ 585450 w 8363529"/>
                <a:gd name="connsiteY16" fmla="*/ 1050817 h 1050817"/>
                <a:gd name="connsiteX17" fmla="*/ 593803 w 8363529"/>
                <a:gd name="connsiteY17" fmla="*/ 1040762 h 1050817"/>
                <a:gd name="connsiteX18" fmla="*/ 660727 w 8363529"/>
                <a:gd name="connsiteY18" fmla="*/ 924742 h 1050817"/>
                <a:gd name="connsiteX19" fmla="*/ 669089 w 8363529"/>
                <a:gd name="connsiteY19" fmla="*/ 903460 h 1050817"/>
                <a:gd name="connsiteX20" fmla="*/ 677443 w 8363529"/>
                <a:gd name="connsiteY20" fmla="*/ 921035 h 1050817"/>
                <a:gd name="connsiteX21" fmla="*/ 744366 w 8363529"/>
                <a:gd name="connsiteY21" fmla="*/ 1038536 h 1050817"/>
                <a:gd name="connsiteX22" fmla="*/ 752719 w 8363529"/>
                <a:gd name="connsiteY22" fmla="*/ 1050817 h 1050817"/>
                <a:gd name="connsiteX23" fmla="*/ 1505444 w 8363529"/>
                <a:gd name="connsiteY23" fmla="*/ 1050817 h 1050817"/>
                <a:gd name="connsiteX24" fmla="*/ 1513797 w 8363529"/>
                <a:gd name="connsiteY24" fmla="*/ 1049724 h 1050817"/>
                <a:gd name="connsiteX25" fmla="*/ 1580720 w 8363529"/>
                <a:gd name="connsiteY25" fmla="*/ 1038613 h 1050817"/>
                <a:gd name="connsiteX26" fmla="*/ 1589074 w 8363529"/>
                <a:gd name="connsiteY26" fmla="*/ 1036794 h 1050817"/>
                <a:gd name="connsiteX27" fmla="*/ 1597437 w 8363529"/>
                <a:gd name="connsiteY27" fmla="*/ 1038875 h 1050817"/>
                <a:gd name="connsiteX28" fmla="*/ 1664360 w 8363529"/>
                <a:gd name="connsiteY28" fmla="*/ 1049917 h 1050817"/>
                <a:gd name="connsiteX29" fmla="*/ 1672713 w 8363529"/>
                <a:gd name="connsiteY29" fmla="*/ 1050817 h 1050817"/>
                <a:gd name="connsiteX30" fmla="*/ 2007260 w 8363529"/>
                <a:gd name="connsiteY30" fmla="*/ 1050817 h 1050817"/>
                <a:gd name="connsiteX31" fmla="*/ 2015614 w 8363529"/>
                <a:gd name="connsiteY31" fmla="*/ 999253 h 1050817"/>
                <a:gd name="connsiteX32" fmla="*/ 2082537 w 8363529"/>
                <a:gd name="connsiteY32" fmla="*/ 463373 h 1050817"/>
                <a:gd name="connsiteX33" fmla="*/ 2090890 w 8363529"/>
                <a:gd name="connsiteY33" fmla="*/ 375671 h 1050817"/>
                <a:gd name="connsiteX34" fmla="*/ 2099253 w 8363529"/>
                <a:gd name="connsiteY34" fmla="*/ 453966 h 1050817"/>
                <a:gd name="connsiteX35" fmla="*/ 2166176 w 8363529"/>
                <a:gd name="connsiteY35" fmla="*/ 992749 h 1050817"/>
                <a:gd name="connsiteX36" fmla="*/ 2174530 w 8363529"/>
                <a:gd name="connsiteY36" fmla="*/ 1050817 h 1050817"/>
                <a:gd name="connsiteX37" fmla="*/ 2341799 w 8363529"/>
                <a:gd name="connsiteY37" fmla="*/ 1050817 h 1050817"/>
                <a:gd name="connsiteX38" fmla="*/ 2350152 w 8363529"/>
                <a:gd name="connsiteY38" fmla="*/ 1015289 h 1050817"/>
                <a:gd name="connsiteX39" fmla="*/ 2417075 w 8363529"/>
                <a:gd name="connsiteY39" fmla="*/ 745283 h 1050817"/>
                <a:gd name="connsiteX40" fmla="*/ 2425438 w 8363529"/>
                <a:gd name="connsiteY40" fmla="*/ 713268 h 1050817"/>
                <a:gd name="connsiteX41" fmla="*/ 2433791 w 8363529"/>
                <a:gd name="connsiteY41" fmla="*/ 748990 h 1050817"/>
                <a:gd name="connsiteX42" fmla="*/ 2500714 w 8363529"/>
                <a:gd name="connsiteY42" fmla="*/ 1018948 h 1050817"/>
                <a:gd name="connsiteX43" fmla="*/ 2509068 w 8363529"/>
                <a:gd name="connsiteY43" fmla="*/ 1050817 h 1050817"/>
                <a:gd name="connsiteX44" fmla="*/ 2843615 w 8363529"/>
                <a:gd name="connsiteY44" fmla="*/ 1050817 h 1050817"/>
                <a:gd name="connsiteX45" fmla="*/ 2851968 w 8363529"/>
                <a:gd name="connsiteY45" fmla="*/ 985114 h 1050817"/>
                <a:gd name="connsiteX46" fmla="*/ 2918892 w 8363529"/>
                <a:gd name="connsiteY46" fmla="*/ 444849 h 1050817"/>
                <a:gd name="connsiteX47" fmla="*/ 2927245 w 8363529"/>
                <a:gd name="connsiteY47" fmla="*/ 375438 h 1050817"/>
                <a:gd name="connsiteX48" fmla="*/ 2935608 w 8363529"/>
                <a:gd name="connsiteY48" fmla="*/ 442962 h 1050817"/>
                <a:gd name="connsiteX49" fmla="*/ 3002531 w 8363529"/>
                <a:gd name="connsiteY49" fmla="*/ 960851 h 1050817"/>
                <a:gd name="connsiteX50" fmla="*/ 3010884 w 8363529"/>
                <a:gd name="connsiteY50" fmla="*/ 1022964 h 1050817"/>
                <a:gd name="connsiteX51" fmla="*/ 3019238 w 8363529"/>
                <a:gd name="connsiteY51" fmla="*/ 1021483 h 1050817"/>
                <a:gd name="connsiteX52" fmla="*/ 3086161 w 8363529"/>
                <a:gd name="connsiteY52" fmla="*/ 1006589 h 1050817"/>
                <a:gd name="connsiteX53" fmla="*/ 3094523 w 8363529"/>
                <a:gd name="connsiteY53" fmla="*/ 1004247 h 1050817"/>
                <a:gd name="connsiteX54" fmla="*/ 3102877 w 8363529"/>
                <a:gd name="connsiteY54" fmla="*/ 926029 h 1050817"/>
                <a:gd name="connsiteX55" fmla="*/ 3169800 w 8363529"/>
                <a:gd name="connsiteY55" fmla="*/ 480232 h 1050817"/>
                <a:gd name="connsiteX56" fmla="*/ 3178153 w 8363529"/>
                <a:gd name="connsiteY56" fmla="*/ 440049 h 1050817"/>
                <a:gd name="connsiteX57" fmla="*/ 3186516 w 8363529"/>
                <a:gd name="connsiteY57" fmla="*/ 488593 h 1050817"/>
                <a:gd name="connsiteX58" fmla="*/ 3253439 w 8363529"/>
                <a:gd name="connsiteY58" fmla="*/ 974419 h 1050817"/>
                <a:gd name="connsiteX59" fmla="*/ 3261792 w 8363529"/>
                <a:gd name="connsiteY59" fmla="*/ 1050817 h 1050817"/>
                <a:gd name="connsiteX60" fmla="*/ 3512701 w 8363529"/>
                <a:gd name="connsiteY60" fmla="*/ 1050817 h 1050817"/>
                <a:gd name="connsiteX61" fmla="*/ 3521054 w 8363529"/>
                <a:gd name="connsiteY61" fmla="*/ 998914 h 1050817"/>
                <a:gd name="connsiteX62" fmla="*/ 3587977 w 8363529"/>
                <a:gd name="connsiteY62" fmla="*/ 639280 h 1050817"/>
                <a:gd name="connsiteX63" fmla="*/ 3596330 w 8363529"/>
                <a:gd name="connsiteY63" fmla="*/ 600229 h 1050817"/>
                <a:gd name="connsiteX64" fmla="*/ 3604693 w 8363529"/>
                <a:gd name="connsiteY64" fmla="*/ 632592 h 1050817"/>
                <a:gd name="connsiteX65" fmla="*/ 3671616 w 8363529"/>
                <a:gd name="connsiteY65" fmla="*/ 974951 h 1050817"/>
                <a:gd name="connsiteX66" fmla="*/ 3679970 w 8363529"/>
                <a:gd name="connsiteY66" fmla="*/ 1032032 h 1050817"/>
                <a:gd name="connsiteX67" fmla="*/ 3688323 w 8363529"/>
                <a:gd name="connsiteY67" fmla="*/ 1034190 h 1050817"/>
                <a:gd name="connsiteX68" fmla="*/ 3755246 w 8363529"/>
                <a:gd name="connsiteY68" fmla="*/ 1049201 h 1050817"/>
                <a:gd name="connsiteX69" fmla="*/ 3763609 w 8363529"/>
                <a:gd name="connsiteY69" fmla="*/ 1050817 h 1050817"/>
                <a:gd name="connsiteX70" fmla="*/ 4098147 w 8363529"/>
                <a:gd name="connsiteY70" fmla="*/ 1050817 h 1050817"/>
                <a:gd name="connsiteX71" fmla="*/ 4106500 w 8363529"/>
                <a:gd name="connsiteY71" fmla="*/ 1004779 h 1050817"/>
                <a:gd name="connsiteX72" fmla="*/ 4173394 w 8363529"/>
                <a:gd name="connsiteY72" fmla="*/ 769101 h 1050817"/>
                <a:gd name="connsiteX73" fmla="*/ 4181787 w 8363529"/>
                <a:gd name="connsiteY73" fmla="*/ 749822 h 1050817"/>
                <a:gd name="connsiteX74" fmla="*/ 4190140 w 8363529"/>
                <a:gd name="connsiteY74" fmla="*/ 773824 h 1050817"/>
                <a:gd name="connsiteX75" fmla="*/ 4257024 w 8363529"/>
                <a:gd name="connsiteY75" fmla="*/ 1013247 h 1050817"/>
                <a:gd name="connsiteX76" fmla="*/ 4265416 w 8363529"/>
                <a:gd name="connsiteY76" fmla="*/ 1050817 h 1050817"/>
                <a:gd name="connsiteX77" fmla="*/ 4273779 w 8363529"/>
                <a:gd name="connsiteY77" fmla="*/ 937101 h 1050817"/>
                <a:gd name="connsiteX78" fmla="*/ 4340664 w 8363529"/>
                <a:gd name="connsiteY78" fmla="*/ 97051 h 1050817"/>
                <a:gd name="connsiteX79" fmla="*/ 4349055 w 8363529"/>
                <a:gd name="connsiteY79" fmla="*/ 0 h 1050817"/>
                <a:gd name="connsiteX80" fmla="*/ 4357409 w 8363529"/>
                <a:gd name="connsiteY80" fmla="*/ 106003 h 1050817"/>
                <a:gd name="connsiteX81" fmla="*/ 4424303 w 8363529"/>
                <a:gd name="connsiteY81" fmla="*/ 946634 h 1050817"/>
                <a:gd name="connsiteX82" fmla="*/ 4432695 w 8363529"/>
                <a:gd name="connsiteY82" fmla="*/ 1050817 h 1050817"/>
                <a:gd name="connsiteX83" fmla="*/ 4683603 w 8363529"/>
                <a:gd name="connsiteY83" fmla="*/ 1050817 h 1050817"/>
                <a:gd name="connsiteX84" fmla="*/ 4691956 w 8363529"/>
                <a:gd name="connsiteY84" fmla="*/ 1035816 h 1050817"/>
                <a:gd name="connsiteX85" fmla="*/ 4758840 w 8363529"/>
                <a:gd name="connsiteY85" fmla="*/ 928604 h 1050817"/>
                <a:gd name="connsiteX86" fmla="*/ 4767232 w 8363529"/>
                <a:gd name="connsiteY86" fmla="*/ 916613 h 1050817"/>
                <a:gd name="connsiteX87" fmla="*/ 4775595 w 8363529"/>
                <a:gd name="connsiteY87" fmla="*/ 917067 h 1050817"/>
                <a:gd name="connsiteX88" fmla="*/ 4842480 w 8363529"/>
                <a:gd name="connsiteY88" fmla="*/ 921829 h 1050817"/>
                <a:gd name="connsiteX89" fmla="*/ 4850872 w 8363529"/>
                <a:gd name="connsiteY89" fmla="*/ 922623 h 1050817"/>
                <a:gd name="connsiteX90" fmla="*/ 4859225 w 8363529"/>
                <a:gd name="connsiteY90" fmla="*/ 921868 h 1050817"/>
                <a:gd name="connsiteX91" fmla="*/ 4926109 w 8363529"/>
                <a:gd name="connsiteY91" fmla="*/ 917977 h 1050817"/>
                <a:gd name="connsiteX92" fmla="*/ 4934501 w 8363529"/>
                <a:gd name="connsiteY92" fmla="*/ 917638 h 1050817"/>
                <a:gd name="connsiteX93" fmla="*/ 4942864 w 8363529"/>
                <a:gd name="connsiteY93" fmla="*/ 929426 h 1050817"/>
                <a:gd name="connsiteX94" fmla="*/ 5009749 w 8363529"/>
                <a:gd name="connsiteY94" fmla="*/ 1035816 h 1050817"/>
                <a:gd name="connsiteX95" fmla="*/ 5018141 w 8363529"/>
                <a:gd name="connsiteY95" fmla="*/ 1050817 h 1050817"/>
                <a:gd name="connsiteX96" fmla="*/ 5026494 w 8363529"/>
                <a:gd name="connsiteY96" fmla="*/ 1050024 h 1050817"/>
                <a:gd name="connsiteX97" fmla="*/ 5093388 w 8363529"/>
                <a:gd name="connsiteY97" fmla="*/ 1042320 h 1050817"/>
                <a:gd name="connsiteX98" fmla="*/ 5101780 w 8363529"/>
                <a:gd name="connsiteY98" fmla="*/ 1041178 h 1050817"/>
                <a:gd name="connsiteX99" fmla="*/ 5110134 w 8363529"/>
                <a:gd name="connsiteY99" fmla="*/ 1042504 h 1050817"/>
                <a:gd name="connsiteX100" fmla="*/ 5177018 w 8363529"/>
                <a:gd name="connsiteY100" fmla="*/ 1050140 h 1050817"/>
                <a:gd name="connsiteX101" fmla="*/ 5185410 w 8363529"/>
                <a:gd name="connsiteY101" fmla="*/ 1050817 h 1050817"/>
                <a:gd name="connsiteX102" fmla="*/ 5193773 w 8363529"/>
                <a:gd name="connsiteY102" fmla="*/ 1014380 h 1050817"/>
                <a:gd name="connsiteX103" fmla="*/ 5260657 w 8363529"/>
                <a:gd name="connsiteY103" fmla="*/ 697880 h 1050817"/>
                <a:gd name="connsiteX104" fmla="*/ 5269049 w 8363529"/>
                <a:gd name="connsiteY104" fmla="*/ 654891 h 1050817"/>
                <a:gd name="connsiteX105" fmla="*/ 5277403 w 8363529"/>
                <a:gd name="connsiteY105" fmla="*/ 688309 h 1050817"/>
                <a:gd name="connsiteX106" fmla="*/ 5344287 w 8363529"/>
                <a:gd name="connsiteY106" fmla="*/ 997327 h 1050817"/>
                <a:gd name="connsiteX107" fmla="*/ 5352650 w 8363529"/>
                <a:gd name="connsiteY107" fmla="*/ 1042088 h 1050817"/>
                <a:gd name="connsiteX108" fmla="*/ 5361042 w 8363529"/>
                <a:gd name="connsiteY108" fmla="*/ 1042427 h 1050817"/>
                <a:gd name="connsiteX109" fmla="*/ 5427926 w 8363529"/>
                <a:gd name="connsiteY109" fmla="*/ 1048669 h 1050817"/>
                <a:gd name="connsiteX110" fmla="*/ 5436280 w 8363529"/>
                <a:gd name="connsiteY110" fmla="*/ 1050817 h 1050817"/>
                <a:gd name="connsiteX111" fmla="*/ 5603558 w 8363529"/>
                <a:gd name="connsiteY111" fmla="*/ 1050817 h 1050817"/>
                <a:gd name="connsiteX112" fmla="*/ 5611950 w 8363529"/>
                <a:gd name="connsiteY112" fmla="*/ 958460 h 1050817"/>
                <a:gd name="connsiteX113" fmla="*/ 5678835 w 8363529"/>
                <a:gd name="connsiteY113" fmla="*/ 222971 h 1050817"/>
                <a:gd name="connsiteX114" fmla="*/ 5687188 w 8363529"/>
                <a:gd name="connsiteY114" fmla="*/ 131447 h 1050817"/>
                <a:gd name="connsiteX115" fmla="*/ 5695580 w 8363529"/>
                <a:gd name="connsiteY115" fmla="*/ 195302 h 1050817"/>
                <a:gd name="connsiteX116" fmla="*/ 5762474 w 8363529"/>
                <a:gd name="connsiteY116" fmla="*/ 920358 h 1050817"/>
                <a:gd name="connsiteX117" fmla="*/ 5770827 w 8363529"/>
                <a:gd name="connsiteY117" fmla="*/ 1050817 h 1050817"/>
                <a:gd name="connsiteX118" fmla="*/ 5854457 w 8363529"/>
                <a:gd name="connsiteY118" fmla="*/ 1050817 h 1050817"/>
                <a:gd name="connsiteX119" fmla="*/ 5862858 w 8363529"/>
                <a:gd name="connsiteY119" fmla="*/ 1050295 h 1050817"/>
                <a:gd name="connsiteX120" fmla="*/ 5929743 w 8363529"/>
                <a:gd name="connsiteY120" fmla="*/ 1043636 h 1050817"/>
                <a:gd name="connsiteX121" fmla="*/ 5938096 w 8363529"/>
                <a:gd name="connsiteY121" fmla="*/ 1042243 h 1050817"/>
                <a:gd name="connsiteX122" fmla="*/ 5946488 w 8363529"/>
                <a:gd name="connsiteY122" fmla="*/ 1043559 h 1050817"/>
                <a:gd name="connsiteX123" fmla="*/ 6013372 w 8363529"/>
                <a:gd name="connsiteY123" fmla="*/ 1050295 h 1050817"/>
                <a:gd name="connsiteX124" fmla="*/ 6021735 w 8363529"/>
                <a:gd name="connsiteY124" fmla="*/ 1050817 h 1050817"/>
                <a:gd name="connsiteX125" fmla="*/ 6189004 w 8363529"/>
                <a:gd name="connsiteY125" fmla="*/ 1050817 h 1050817"/>
                <a:gd name="connsiteX126" fmla="*/ 6197396 w 8363529"/>
                <a:gd name="connsiteY126" fmla="*/ 1047643 h 1050817"/>
                <a:gd name="connsiteX127" fmla="*/ 6264280 w 8363529"/>
                <a:gd name="connsiteY127" fmla="*/ 1015435 h 1050817"/>
                <a:gd name="connsiteX128" fmla="*/ 6272644 w 8363529"/>
                <a:gd name="connsiteY128" fmla="*/ 1010257 h 1050817"/>
                <a:gd name="connsiteX129" fmla="*/ 6281036 w 8363529"/>
                <a:gd name="connsiteY129" fmla="*/ 1015018 h 1050817"/>
                <a:gd name="connsiteX130" fmla="*/ 6347920 w 8363529"/>
                <a:gd name="connsiteY130" fmla="*/ 1047382 h 1050817"/>
                <a:gd name="connsiteX131" fmla="*/ 6356273 w 8363529"/>
                <a:gd name="connsiteY131" fmla="*/ 1050817 h 1050817"/>
                <a:gd name="connsiteX132" fmla="*/ 7276267 w 8363529"/>
                <a:gd name="connsiteY132" fmla="*/ 1050817 h 1050817"/>
                <a:gd name="connsiteX133" fmla="*/ 7284620 w 8363529"/>
                <a:gd name="connsiteY133" fmla="*/ 1048398 h 1050817"/>
                <a:gd name="connsiteX134" fmla="*/ 7351543 w 8363529"/>
                <a:gd name="connsiteY134" fmla="*/ 1027910 h 1050817"/>
                <a:gd name="connsiteX135" fmla="*/ 7359906 w 8363529"/>
                <a:gd name="connsiteY135" fmla="*/ 1025190 h 1050817"/>
                <a:gd name="connsiteX136" fmla="*/ 7368260 w 8363529"/>
                <a:gd name="connsiteY136" fmla="*/ 967954 h 1050817"/>
                <a:gd name="connsiteX137" fmla="*/ 7435183 w 8363529"/>
                <a:gd name="connsiteY137" fmla="*/ 585858 h 1050817"/>
                <a:gd name="connsiteX138" fmla="*/ 7443536 w 8363529"/>
                <a:gd name="connsiteY138" fmla="*/ 545868 h 1050817"/>
                <a:gd name="connsiteX139" fmla="*/ 7451899 w 8363529"/>
                <a:gd name="connsiteY139" fmla="*/ 560762 h 1050817"/>
                <a:gd name="connsiteX140" fmla="*/ 7518822 w 8363529"/>
                <a:gd name="connsiteY140" fmla="*/ 704074 h 1050817"/>
                <a:gd name="connsiteX141" fmla="*/ 7527175 w 8363529"/>
                <a:gd name="connsiteY141" fmla="*/ 725704 h 1050817"/>
                <a:gd name="connsiteX142" fmla="*/ 7535528 w 8363529"/>
                <a:gd name="connsiteY142" fmla="*/ 764378 h 1050817"/>
                <a:gd name="connsiteX143" fmla="*/ 7602452 w 8363529"/>
                <a:gd name="connsiteY143" fmla="*/ 1023564 h 1050817"/>
                <a:gd name="connsiteX144" fmla="*/ 7610815 w 8363529"/>
                <a:gd name="connsiteY144" fmla="*/ 1050817 h 1050817"/>
                <a:gd name="connsiteX145" fmla="*/ 7694444 w 8363529"/>
                <a:gd name="connsiteY145" fmla="*/ 1050817 h 1050817"/>
                <a:gd name="connsiteX146" fmla="*/ 7702798 w 8363529"/>
                <a:gd name="connsiteY146" fmla="*/ 990785 h 1050817"/>
                <a:gd name="connsiteX147" fmla="*/ 7769731 w 8363529"/>
                <a:gd name="connsiteY147" fmla="*/ 398840 h 1050817"/>
                <a:gd name="connsiteX148" fmla="*/ 7778084 w 8363529"/>
                <a:gd name="connsiteY148" fmla="*/ 307208 h 1050817"/>
                <a:gd name="connsiteX149" fmla="*/ 7786437 w 8363529"/>
                <a:gd name="connsiteY149" fmla="*/ 425793 h 1050817"/>
                <a:gd name="connsiteX150" fmla="*/ 7853360 w 8363529"/>
                <a:gd name="connsiteY150" fmla="*/ 1005379 h 1050817"/>
                <a:gd name="connsiteX151" fmla="*/ 7861713 w 8363529"/>
                <a:gd name="connsiteY151" fmla="*/ 1050817 h 1050817"/>
                <a:gd name="connsiteX152" fmla="*/ 7870077 w 8363529"/>
                <a:gd name="connsiteY152" fmla="*/ 1030745 h 1050817"/>
                <a:gd name="connsiteX153" fmla="*/ 7937000 w 8363529"/>
                <a:gd name="connsiteY153" fmla="*/ 806032 h 1050817"/>
                <a:gd name="connsiteX154" fmla="*/ 7945353 w 8363529"/>
                <a:gd name="connsiteY154" fmla="*/ 766149 h 1050817"/>
                <a:gd name="connsiteX155" fmla="*/ 7953706 w 8363529"/>
                <a:gd name="connsiteY155" fmla="*/ 795976 h 1050817"/>
                <a:gd name="connsiteX156" fmla="*/ 8020629 w 8363529"/>
                <a:gd name="connsiteY156" fmla="*/ 1023680 h 1050817"/>
                <a:gd name="connsiteX157" fmla="*/ 8028992 w 8363529"/>
                <a:gd name="connsiteY157" fmla="*/ 1050817 h 1050817"/>
                <a:gd name="connsiteX158" fmla="*/ 8196261 w 8363529"/>
                <a:gd name="connsiteY158" fmla="*/ 1050817 h 1050817"/>
                <a:gd name="connsiteX159" fmla="*/ 8204614 w 8363529"/>
                <a:gd name="connsiteY159" fmla="*/ 997172 h 1050817"/>
                <a:gd name="connsiteX160" fmla="*/ 8271537 w 8363529"/>
                <a:gd name="connsiteY160" fmla="*/ 438200 h 1050817"/>
                <a:gd name="connsiteX161" fmla="*/ 8279900 w 8363529"/>
                <a:gd name="connsiteY161" fmla="*/ 346482 h 1050817"/>
                <a:gd name="connsiteX162" fmla="*/ 8288254 w 8363529"/>
                <a:gd name="connsiteY162" fmla="*/ 410976 h 1050817"/>
                <a:gd name="connsiteX163" fmla="*/ 8355177 w 8363529"/>
                <a:gd name="connsiteY163" fmla="*/ 932155 h 1050817"/>
                <a:gd name="connsiteX164" fmla="*/ 8363530 w 8363529"/>
                <a:gd name="connsiteY164" fmla="*/ 997975 h 1050817"/>
                <a:gd name="connsiteX165" fmla="*/ 8363530 w 8363529"/>
                <a:gd name="connsiteY165" fmla="*/ 1050817 h 1050817"/>
                <a:gd name="connsiteX166" fmla="*/ 0 w 8363529"/>
                <a:gd name="connsiteY166" fmla="*/ 1050817 h 105081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</a:cxnLst>
              <a:rect l="l" t="t" r="r" b="b"/>
              <a:pathLst>
                <a:path w="8363529" h="1050817">
                  <a:moveTo>
                    <a:pt x="0" y="519931"/>
                  </a:moveTo>
                  <a:lnTo>
                    <a:pt x="8394" y="572366"/>
                  </a:lnTo>
                  <a:lnTo>
                    <a:pt x="75279" y="997066"/>
                  </a:lnTo>
                  <a:lnTo>
                    <a:pt x="83635" y="1050817"/>
                  </a:lnTo>
                  <a:lnTo>
                    <a:pt x="250903" y="1050817"/>
                  </a:lnTo>
                  <a:lnTo>
                    <a:pt x="259304" y="1023719"/>
                  </a:lnTo>
                  <a:lnTo>
                    <a:pt x="326189" y="836508"/>
                  </a:lnTo>
                  <a:lnTo>
                    <a:pt x="334542" y="816242"/>
                  </a:lnTo>
                  <a:lnTo>
                    <a:pt x="342895" y="839266"/>
                  </a:lnTo>
                  <a:lnTo>
                    <a:pt x="409818" y="973132"/>
                  </a:lnTo>
                  <a:lnTo>
                    <a:pt x="418181" y="985462"/>
                  </a:lnTo>
                  <a:lnTo>
                    <a:pt x="426534" y="962060"/>
                  </a:lnTo>
                  <a:lnTo>
                    <a:pt x="493458" y="639086"/>
                  </a:lnTo>
                  <a:lnTo>
                    <a:pt x="501811" y="566956"/>
                  </a:lnTo>
                  <a:lnTo>
                    <a:pt x="510174" y="644496"/>
                  </a:lnTo>
                  <a:lnTo>
                    <a:pt x="577097" y="1021406"/>
                  </a:lnTo>
                  <a:lnTo>
                    <a:pt x="585450" y="1050817"/>
                  </a:lnTo>
                  <a:lnTo>
                    <a:pt x="593803" y="1040762"/>
                  </a:lnTo>
                  <a:lnTo>
                    <a:pt x="660727" y="924742"/>
                  </a:lnTo>
                  <a:lnTo>
                    <a:pt x="669089" y="903460"/>
                  </a:lnTo>
                  <a:lnTo>
                    <a:pt x="677443" y="921035"/>
                  </a:lnTo>
                  <a:lnTo>
                    <a:pt x="744366" y="1038536"/>
                  </a:lnTo>
                  <a:lnTo>
                    <a:pt x="752719" y="1050817"/>
                  </a:lnTo>
                  <a:lnTo>
                    <a:pt x="1505444" y="1050817"/>
                  </a:lnTo>
                  <a:lnTo>
                    <a:pt x="1513797" y="1049724"/>
                  </a:lnTo>
                  <a:lnTo>
                    <a:pt x="1580720" y="1038613"/>
                  </a:lnTo>
                  <a:lnTo>
                    <a:pt x="1589074" y="1036794"/>
                  </a:lnTo>
                  <a:lnTo>
                    <a:pt x="1597437" y="1038875"/>
                  </a:lnTo>
                  <a:lnTo>
                    <a:pt x="1664360" y="1049917"/>
                  </a:lnTo>
                  <a:lnTo>
                    <a:pt x="1672713" y="1050817"/>
                  </a:lnTo>
                  <a:lnTo>
                    <a:pt x="2007260" y="1050817"/>
                  </a:lnTo>
                  <a:lnTo>
                    <a:pt x="2015614" y="999253"/>
                  </a:lnTo>
                  <a:lnTo>
                    <a:pt x="2082537" y="463373"/>
                  </a:lnTo>
                  <a:lnTo>
                    <a:pt x="2090890" y="375671"/>
                  </a:lnTo>
                  <a:lnTo>
                    <a:pt x="2099253" y="453966"/>
                  </a:lnTo>
                  <a:lnTo>
                    <a:pt x="2166176" y="992749"/>
                  </a:lnTo>
                  <a:lnTo>
                    <a:pt x="2174530" y="1050817"/>
                  </a:lnTo>
                  <a:lnTo>
                    <a:pt x="2341799" y="1050817"/>
                  </a:lnTo>
                  <a:lnTo>
                    <a:pt x="2350152" y="1015289"/>
                  </a:lnTo>
                  <a:lnTo>
                    <a:pt x="2417075" y="745283"/>
                  </a:lnTo>
                  <a:lnTo>
                    <a:pt x="2425438" y="713268"/>
                  </a:lnTo>
                  <a:lnTo>
                    <a:pt x="2433791" y="748990"/>
                  </a:lnTo>
                  <a:lnTo>
                    <a:pt x="2500714" y="1018948"/>
                  </a:lnTo>
                  <a:lnTo>
                    <a:pt x="2509068" y="1050817"/>
                  </a:lnTo>
                  <a:lnTo>
                    <a:pt x="2843615" y="1050817"/>
                  </a:lnTo>
                  <a:lnTo>
                    <a:pt x="2851968" y="985114"/>
                  </a:lnTo>
                  <a:lnTo>
                    <a:pt x="2918892" y="444849"/>
                  </a:lnTo>
                  <a:lnTo>
                    <a:pt x="2927245" y="375438"/>
                  </a:lnTo>
                  <a:lnTo>
                    <a:pt x="2935608" y="442962"/>
                  </a:lnTo>
                  <a:lnTo>
                    <a:pt x="3002531" y="960851"/>
                  </a:lnTo>
                  <a:lnTo>
                    <a:pt x="3010884" y="1022964"/>
                  </a:lnTo>
                  <a:lnTo>
                    <a:pt x="3019238" y="1021483"/>
                  </a:lnTo>
                  <a:lnTo>
                    <a:pt x="3086161" y="1006589"/>
                  </a:lnTo>
                  <a:lnTo>
                    <a:pt x="3094523" y="1004247"/>
                  </a:lnTo>
                  <a:lnTo>
                    <a:pt x="3102877" y="926029"/>
                  </a:lnTo>
                  <a:lnTo>
                    <a:pt x="3169800" y="480232"/>
                  </a:lnTo>
                  <a:lnTo>
                    <a:pt x="3178153" y="440049"/>
                  </a:lnTo>
                  <a:lnTo>
                    <a:pt x="3186516" y="488593"/>
                  </a:lnTo>
                  <a:lnTo>
                    <a:pt x="3253439" y="974419"/>
                  </a:lnTo>
                  <a:lnTo>
                    <a:pt x="3261792" y="1050817"/>
                  </a:lnTo>
                  <a:lnTo>
                    <a:pt x="3512701" y="1050817"/>
                  </a:lnTo>
                  <a:lnTo>
                    <a:pt x="3521054" y="998914"/>
                  </a:lnTo>
                  <a:lnTo>
                    <a:pt x="3587977" y="639280"/>
                  </a:lnTo>
                  <a:lnTo>
                    <a:pt x="3596330" y="600229"/>
                  </a:lnTo>
                  <a:lnTo>
                    <a:pt x="3604693" y="632592"/>
                  </a:lnTo>
                  <a:lnTo>
                    <a:pt x="3671616" y="974951"/>
                  </a:lnTo>
                  <a:lnTo>
                    <a:pt x="3679970" y="1032032"/>
                  </a:lnTo>
                  <a:lnTo>
                    <a:pt x="3688323" y="1034190"/>
                  </a:lnTo>
                  <a:lnTo>
                    <a:pt x="3755246" y="1049201"/>
                  </a:lnTo>
                  <a:lnTo>
                    <a:pt x="3763609" y="1050817"/>
                  </a:lnTo>
                  <a:lnTo>
                    <a:pt x="4098147" y="1050817"/>
                  </a:lnTo>
                  <a:lnTo>
                    <a:pt x="4106500" y="1004779"/>
                  </a:lnTo>
                  <a:lnTo>
                    <a:pt x="4173394" y="769101"/>
                  </a:lnTo>
                  <a:lnTo>
                    <a:pt x="4181787" y="749822"/>
                  </a:lnTo>
                  <a:lnTo>
                    <a:pt x="4190140" y="773824"/>
                  </a:lnTo>
                  <a:lnTo>
                    <a:pt x="4257024" y="1013247"/>
                  </a:lnTo>
                  <a:lnTo>
                    <a:pt x="4265416" y="1050817"/>
                  </a:lnTo>
                  <a:lnTo>
                    <a:pt x="4273779" y="937101"/>
                  </a:lnTo>
                  <a:lnTo>
                    <a:pt x="4340664" y="97051"/>
                  </a:lnTo>
                  <a:lnTo>
                    <a:pt x="4349055" y="0"/>
                  </a:lnTo>
                  <a:lnTo>
                    <a:pt x="4357409" y="106003"/>
                  </a:lnTo>
                  <a:lnTo>
                    <a:pt x="4424303" y="946634"/>
                  </a:lnTo>
                  <a:lnTo>
                    <a:pt x="4432695" y="1050817"/>
                  </a:lnTo>
                  <a:lnTo>
                    <a:pt x="4683603" y="1050817"/>
                  </a:lnTo>
                  <a:lnTo>
                    <a:pt x="4691956" y="1035816"/>
                  </a:lnTo>
                  <a:lnTo>
                    <a:pt x="4758840" y="928604"/>
                  </a:lnTo>
                  <a:lnTo>
                    <a:pt x="4767232" y="916613"/>
                  </a:lnTo>
                  <a:lnTo>
                    <a:pt x="4775595" y="917067"/>
                  </a:lnTo>
                  <a:lnTo>
                    <a:pt x="4842480" y="921829"/>
                  </a:lnTo>
                  <a:lnTo>
                    <a:pt x="4850872" y="922623"/>
                  </a:lnTo>
                  <a:lnTo>
                    <a:pt x="4859225" y="921868"/>
                  </a:lnTo>
                  <a:lnTo>
                    <a:pt x="4926109" y="917977"/>
                  </a:lnTo>
                  <a:lnTo>
                    <a:pt x="4934501" y="917638"/>
                  </a:lnTo>
                  <a:lnTo>
                    <a:pt x="4942864" y="929426"/>
                  </a:lnTo>
                  <a:lnTo>
                    <a:pt x="5009749" y="1035816"/>
                  </a:lnTo>
                  <a:lnTo>
                    <a:pt x="5018141" y="1050817"/>
                  </a:lnTo>
                  <a:lnTo>
                    <a:pt x="5026494" y="1050024"/>
                  </a:lnTo>
                  <a:lnTo>
                    <a:pt x="5093388" y="1042320"/>
                  </a:lnTo>
                  <a:lnTo>
                    <a:pt x="5101780" y="1041178"/>
                  </a:lnTo>
                  <a:lnTo>
                    <a:pt x="5110134" y="1042504"/>
                  </a:lnTo>
                  <a:lnTo>
                    <a:pt x="5177018" y="1050140"/>
                  </a:lnTo>
                  <a:lnTo>
                    <a:pt x="5185410" y="1050817"/>
                  </a:lnTo>
                  <a:lnTo>
                    <a:pt x="5193773" y="1014380"/>
                  </a:lnTo>
                  <a:lnTo>
                    <a:pt x="5260657" y="697880"/>
                  </a:lnTo>
                  <a:lnTo>
                    <a:pt x="5269049" y="654891"/>
                  </a:lnTo>
                  <a:lnTo>
                    <a:pt x="5277403" y="688309"/>
                  </a:lnTo>
                  <a:lnTo>
                    <a:pt x="5344287" y="997327"/>
                  </a:lnTo>
                  <a:lnTo>
                    <a:pt x="5352650" y="1042088"/>
                  </a:lnTo>
                  <a:lnTo>
                    <a:pt x="5361042" y="1042427"/>
                  </a:lnTo>
                  <a:lnTo>
                    <a:pt x="5427926" y="1048669"/>
                  </a:lnTo>
                  <a:lnTo>
                    <a:pt x="5436280" y="1050817"/>
                  </a:lnTo>
                  <a:lnTo>
                    <a:pt x="5603558" y="1050817"/>
                  </a:lnTo>
                  <a:lnTo>
                    <a:pt x="5611950" y="958460"/>
                  </a:lnTo>
                  <a:lnTo>
                    <a:pt x="5678835" y="222971"/>
                  </a:lnTo>
                  <a:lnTo>
                    <a:pt x="5687188" y="131447"/>
                  </a:lnTo>
                  <a:lnTo>
                    <a:pt x="5695580" y="195302"/>
                  </a:lnTo>
                  <a:lnTo>
                    <a:pt x="5762474" y="920358"/>
                  </a:lnTo>
                  <a:lnTo>
                    <a:pt x="5770827" y="1050817"/>
                  </a:lnTo>
                  <a:lnTo>
                    <a:pt x="5854457" y="1050817"/>
                  </a:lnTo>
                  <a:lnTo>
                    <a:pt x="5862858" y="1050295"/>
                  </a:lnTo>
                  <a:lnTo>
                    <a:pt x="5929743" y="1043636"/>
                  </a:lnTo>
                  <a:lnTo>
                    <a:pt x="5938096" y="1042243"/>
                  </a:lnTo>
                  <a:lnTo>
                    <a:pt x="5946488" y="1043559"/>
                  </a:lnTo>
                  <a:lnTo>
                    <a:pt x="6013372" y="1050295"/>
                  </a:lnTo>
                  <a:lnTo>
                    <a:pt x="6021735" y="1050817"/>
                  </a:lnTo>
                  <a:lnTo>
                    <a:pt x="6189004" y="1050817"/>
                  </a:lnTo>
                  <a:lnTo>
                    <a:pt x="6197396" y="1047643"/>
                  </a:lnTo>
                  <a:lnTo>
                    <a:pt x="6264280" y="1015435"/>
                  </a:lnTo>
                  <a:lnTo>
                    <a:pt x="6272644" y="1010257"/>
                  </a:lnTo>
                  <a:lnTo>
                    <a:pt x="6281036" y="1015018"/>
                  </a:lnTo>
                  <a:lnTo>
                    <a:pt x="6347920" y="1047382"/>
                  </a:lnTo>
                  <a:lnTo>
                    <a:pt x="6356273" y="1050817"/>
                  </a:lnTo>
                  <a:lnTo>
                    <a:pt x="7276267" y="1050817"/>
                  </a:lnTo>
                  <a:lnTo>
                    <a:pt x="7284620" y="1048398"/>
                  </a:lnTo>
                  <a:lnTo>
                    <a:pt x="7351543" y="1027910"/>
                  </a:lnTo>
                  <a:lnTo>
                    <a:pt x="7359906" y="1025190"/>
                  </a:lnTo>
                  <a:lnTo>
                    <a:pt x="7368260" y="967954"/>
                  </a:lnTo>
                  <a:lnTo>
                    <a:pt x="7435183" y="585858"/>
                  </a:lnTo>
                  <a:lnTo>
                    <a:pt x="7443536" y="545868"/>
                  </a:lnTo>
                  <a:lnTo>
                    <a:pt x="7451899" y="560762"/>
                  </a:lnTo>
                  <a:lnTo>
                    <a:pt x="7518822" y="704074"/>
                  </a:lnTo>
                  <a:lnTo>
                    <a:pt x="7527175" y="725704"/>
                  </a:lnTo>
                  <a:lnTo>
                    <a:pt x="7535528" y="764378"/>
                  </a:lnTo>
                  <a:lnTo>
                    <a:pt x="7602452" y="1023564"/>
                  </a:lnTo>
                  <a:lnTo>
                    <a:pt x="7610815" y="1050817"/>
                  </a:lnTo>
                  <a:lnTo>
                    <a:pt x="7694444" y="1050817"/>
                  </a:lnTo>
                  <a:lnTo>
                    <a:pt x="7702798" y="990785"/>
                  </a:lnTo>
                  <a:lnTo>
                    <a:pt x="7769731" y="398840"/>
                  </a:lnTo>
                  <a:lnTo>
                    <a:pt x="7778084" y="307208"/>
                  </a:lnTo>
                  <a:lnTo>
                    <a:pt x="7786437" y="425793"/>
                  </a:lnTo>
                  <a:lnTo>
                    <a:pt x="7853360" y="1005379"/>
                  </a:lnTo>
                  <a:lnTo>
                    <a:pt x="7861713" y="1050817"/>
                  </a:lnTo>
                  <a:lnTo>
                    <a:pt x="7870077" y="1030745"/>
                  </a:lnTo>
                  <a:lnTo>
                    <a:pt x="7937000" y="806032"/>
                  </a:lnTo>
                  <a:lnTo>
                    <a:pt x="7945353" y="766149"/>
                  </a:lnTo>
                  <a:lnTo>
                    <a:pt x="7953706" y="795976"/>
                  </a:lnTo>
                  <a:lnTo>
                    <a:pt x="8020629" y="1023680"/>
                  </a:lnTo>
                  <a:lnTo>
                    <a:pt x="8028992" y="1050817"/>
                  </a:lnTo>
                  <a:lnTo>
                    <a:pt x="8196261" y="1050817"/>
                  </a:lnTo>
                  <a:lnTo>
                    <a:pt x="8204614" y="997172"/>
                  </a:lnTo>
                  <a:lnTo>
                    <a:pt x="8271537" y="438200"/>
                  </a:lnTo>
                  <a:lnTo>
                    <a:pt x="8279900" y="346482"/>
                  </a:lnTo>
                  <a:lnTo>
                    <a:pt x="8288254" y="410976"/>
                  </a:lnTo>
                  <a:lnTo>
                    <a:pt x="8355177" y="932155"/>
                  </a:lnTo>
                  <a:lnTo>
                    <a:pt x="8363530" y="997975"/>
                  </a:lnTo>
                  <a:lnTo>
                    <a:pt x="8363530" y="1050817"/>
                  </a:lnTo>
                  <a:lnTo>
                    <a:pt x="0" y="1050817"/>
                  </a:lnTo>
                  <a:close/>
                </a:path>
              </a:pathLst>
            </a:custGeom>
            <a:solidFill>
              <a:srgbClr val="CCEBC5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08" name="Freeform: Shape 3007">
              <a:extLst>
                <a:ext uri="{FF2B5EF4-FFF2-40B4-BE49-F238E27FC236}">
                  <a16:creationId xmlns:a16="http://schemas.microsoft.com/office/drawing/2014/main" id="{E0E970E6-035F-14CC-4FC7-362A33B1D6C4}"/>
                </a:ext>
              </a:extLst>
            </p:cNvPr>
            <p:cNvSpPr/>
            <p:nvPr/>
          </p:nvSpPr>
          <p:spPr>
            <a:xfrm>
              <a:off x="1534338" y="385080"/>
              <a:ext cx="9218269" cy="4454747"/>
            </a:xfrm>
            <a:custGeom>
              <a:avLst/>
              <a:gdLst>
                <a:gd name="connsiteX0" fmla="*/ 0 w 9218269"/>
                <a:gd name="connsiteY0" fmla="*/ 0 h 4454747"/>
                <a:gd name="connsiteX1" fmla="*/ 9218269 w 9218269"/>
                <a:gd name="connsiteY1" fmla="*/ 0 h 4454747"/>
                <a:gd name="connsiteX2" fmla="*/ 9218269 w 9218269"/>
                <a:gd name="connsiteY2" fmla="*/ 4454748 h 4454747"/>
                <a:gd name="connsiteX3" fmla="*/ 0 w 9218269"/>
                <a:gd name="connsiteY3" fmla="*/ 4454748 h 445474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9218269" h="4454747">
                  <a:moveTo>
                    <a:pt x="0" y="0"/>
                  </a:moveTo>
                  <a:lnTo>
                    <a:pt x="9218269" y="0"/>
                  </a:lnTo>
                  <a:lnTo>
                    <a:pt x="9218269" y="4454748"/>
                  </a:lnTo>
                  <a:lnTo>
                    <a:pt x="0" y="4454748"/>
                  </a:lnTo>
                  <a:close/>
                </a:path>
              </a:pathLst>
            </a:custGeom>
            <a:noFill/>
            <a:ln w="13767" cap="rnd">
              <a:solidFill>
                <a:srgbClr val="333333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grpSp>
          <p:nvGrpSpPr>
            <p:cNvPr id="3009" name="Content Placeholder 4">
              <a:extLst>
                <a:ext uri="{FF2B5EF4-FFF2-40B4-BE49-F238E27FC236}">
                  <a16:creationId xmlns:a16="http://schemas.microsoft.com/office/drawing/2014/main" id="{0A29CA77-1BFF-80E7-5425-3CA82B4DA910}"/>
                </a:ext>
              </a:extLst>
            </p:cNvPr>
            <p:cNvGrpSpPr/>
            <p:nvPr/>
          </p:nvGrpSpPr>
          <p:grpSpPr>
            <a:xfrm>
              <a:off x="1314948" y="4605559"/>
              <a:ext cx="168179" cy="63663"/>
              <a:chOff x="1314948" y="4605559"/>
              <a:chExt cx="168179" cy="63663"/>
            </a:xfrm>
          </p:grpSpPr>
          <p:sp>
            <p:nvSpPr>
              <p:cNvPr id="3093" name="Freeform: Shape 3092">
                <a:extLst>
                  <a:ext uri="{FF2B5EF4-FFF2-40B4-BE49-F238E27FC236}">
                    <a16:creationId xmlns:a16="http://schemas.microsoft.com/office/drawing/2014/main" id="{63426A9D-31FD-BB65-BE68-E66F5FE1234E}"/>
                  </a:ext>
                </a:extLst>
              </p:cNvPr>
              <p:cNvSpPr/>
              <p:nvPr/>
            </p:nvSpPr>
            <p:spPr>
              <a:xfrm>
                <a:off x="1314948" y="4605559"/>
                <a:ext cx="43103" cy="63663"/>
              </a:xfrm>
              <a:custGeom>
                <a:avLst/>
                <a:gdLst>
                  <a:gd name="connsiteX0" fmla="*/ 43123 w 43103"/>
                  <a:gd name="connsiteY0" fmla="*/ 32204 h 63663"/>
                  <a:gd name="connsiteX1" fmla="*/ 37527 w 43103"/>
                  <a:gd name="connsiteY1" fmla="*/ 55945 h 63663"/>
                  <a:gd name="connsiteX2" fmla="*/ 21344 w 43103"/>
                  <a:gd name="connsiteY2" fmla="*/ 64111 h 63663"/>
                  <a:gd name="connsiteX3" fmla="*/ 5313 w 43103"/>
                  <a:gd name="connsiteY3" fmla="*/ 55945 h 63663"/>
                  <a:gd name="connsiteX4" fmla="*/ 19 w 43103"/>
                  <a:gd name="connsiteY4" fmla="*/ 32204 h 63663"/>
                  <a:gd name="connsiteX5" fmla="*/ 5161 w 43103"/>
                  <a:gd name="connsiteY5" fmla="*/ 8463 h 63663"/>
                  <a:gd name="connsiteX6" fmla="*/ 21646 w 43103"/>
                  <a:gd name="connsiteY6" fmla="*/ 448 h 63663"/>
                  <a:gd name="connsiteX7" fmla="*/ 37829 w 43103"/>
                  <a:gd name="connsiteY7" fmla="*/ 8463 h 63663"/>
                  <a:gd name="connsiteX8" fmla="*/ 43123 w 43103"/>
                  <a:gd name="connsiteY8" fmla="*/ 32204 h 63663"/>
                  <a:gd name="connsiteX9" fmla="*/ 35107 w 43103"/>
                  <a:gd name="connsiteY9" fmla="*/ 32204 h 63663"/>
                  <a:gd name="connsiteX10" fmla="*/ 31931 w 43103"/>
                  <a:gd name="connsiteY10" fmla="*/ 12848 h 63663"/>
                  <a:gd name="connsiteX11" fmla="*/ 21646 w 43103"/>
                  <a:gd name="connsiteY11" fmla="*/ 6799 h 63663"/>
                  <a:gd name="connsiteX12" fmla="*/ 11211 w 43103"/>
                  <a:gd name="connsiteY12" fmla="*/ 12697 h 63663"/>
                  <a:gd name="connsiteX13" fmla="*/ 8035 w 43103"/>
                  <a:gd name="connsiteY13" fmla="*/ 32204 h 63663"/>
                  <a:gd name="connsiteX14" fmla="*/ 11211 w 43103"/>
                  <a:gd name="connsiteY14" fmla="*/ 51560 h 63663"/>
                  <a:gd name="connsiteX15" fmla="*/ 21495 w 43103"/>
                  <a:gd name="connsiteY15" fmla="*/ 57609 h 63663"/>
                  <a:gd name="connsiteX16" fmla="*/ 31779 w 43103"/>
                  <a:gd name="connsiteY16" fmla="*/ 51409 h 63663"/>
                  <a:gd name="connsiteX17" fmla="*/ 35107 w 43103"/>
                  <a:gd name="connsiteY17" fmla="*/ 32204 h 636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3103" h="63663">
                    <a:moveTo>
                      <a:pt x="43123" y="32204"/>
                    </a:moveTo>
                    <a:cubicBezTo>
                      <a:pt x="43123" y="42600"/>
                      <a:pt x="41232" y="50501"/>
                      <a:pt x="37527" y="55945"/>
                    </a:cubicBezTo>
                    <a:cubicBezTo>
                      <a:pt x="33897" y="61389"/>
                      <a:pt x="28490" y="64111"/>
                      <a:pt x="21344" y="64111"/>
                    </a:cubicBezTo>
                    <a:cubicBezTo>
                      <a:pt x="14273" y="64111"/>
                      <a:pt x="8942" y="61389"/>
                      <a:pt x="5313" y="55945"/>
                    </a:cubicBezTo>
                    <a:cubicBezTo>
                      <a:pt x="1758" y="50501"/>
                      <a:pt x="19" y="42600"/>
                      <a:pt x="19" y="32204"/>
                    </a:cubicBezTo>
                    <a:cubicBezTo>
                      <a:pt x="19" y="21619"/>
                      <a:pt x="1721" y="13718"/>
                      <a:pt x="5161" y="8463"/>
                    </a:cubicBezTo>
                    <a:cubicBezTo>
                      <a:pt x="8678" y="3132"/>
                      <a:pt x="14160" y="448"/>
                      <a:pt x="21646" y="448"/>
                    </a:cubicBezTo>
                    <a:cubicBezTo>
                      <a:pt x="28982" y="448"/>
                      <a:pt x="34388" y="3132"/>
                      <a:pt x="37829" y="8463"/>
                    </a:cubicBezTo>
                    <a:cubicBezTo>
                      <a:pt x="41345" y="13831"/>
                      <a:pt x="43123" y="21732"/>
                      <a:pt x="43123" y="32204"/>
                    </a:cubicBezTo>
                    <a:close/>
                    <a:moveTo>
                      <a:pt x="35107" y="32204"/>
                    </a:moveTo>
                    <a:cubicBezTo>
                      <a:pt x="35107" y="23358"/>
                      <a:pt x="34048" y="16893"/>
                      <a:pt x="31931" y="12848"/>
                    </a:cubicBezTo>
                    <a:cubicBezTo>
                      <a:pt x="29889" y="8841"/>
                      <a:pt x="26486" y="6799"/>
                      <a:pt x="21646" y="6799"/>
                    </a:cubicBezTo>
                    <a:cubicBezTo>
                      <a:pt x="16807" y="6799"/>
                      <a:pt x="13328" y="8765"/>
                      <a:pt x="11211" y="12697"/>
                    </a:cubicBezTo>
                    <a:cubicBezTo>
                      <a:pt x="9094" y="16629"/>
                      <a:pt x="8035" y="23131"/>
                      <a:pt x="8035" y="32204"/>
                    </a:cubicBezTo>
                    <a:cubicBezTo>
                      <a:pt x="8035" y="40975"/>
                      <a:pt x="9094" y="47439"/>
                      <a:pt x="11211" y="51560"/>
                    </a:cubicBezTo>
                    <a:cubicBezTo>
                      <a:pt x="13404" y="55605"/>
                      <a:pt x="16845" y="57609"/>
                      <a:pt x="21495" y="57609"/>
                    </a:cubicBezTo>
                    <a:cubicBezTo>
                      <a:pt x="26221" y="57609"/>
                      <a:pt x="29662" y="55567"/>
                      <a:pt x="31779" y="51409"/>
                    </a:cubicBezTo>
                    <a:cubicBezTo>
                      <a:pt x="33973" y="47288"/>
                      <a:pt x="35107" y="40899"/>
                      <a:pt x="35107" y="32204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94" name="Freeform: Shape 3093">
                <a:extLst>
                  <a:ext uri="{FF2B5EF4-FFF2-40B4-BE49-F238E27FC236}">
                    <a16:creationId xmlns:a16="http://schemas.microsoft.com/office/drawing/2014/main" id="{DE10085E-1762-11F2-1A28-4BDAF5714956}"/>
                  </a:ext>
                </a:extLst>
              </p:cNvPr>
              <p:cNvSpPr/>
              <p:nvPr/>
            </p:nvSpPr>
            <p:spPr>
              <a:xfrm>
                <a:off x="1369697" y="4658637"/>
                <a:ext cx="8620" cy="9677"/>
              </a:xfrm>
              <a:custGeom>
                <a:avLst/>
                <a:gdLst>
                  <a:gd name="connsiteX0" fmla="*/ 24 w 8620"/>
                  <a:gd name="connsiteY0" fmla="*/ 10126 h 9677"/>
                  <a:gd name="connsiteX1" fmla="*/ 24 w 8620"/>
                  <a:gd name="connsiteY1" fmla="*/ 448 h 9677"/>
                  <a:gd name="connsiteX2" fmla="*/ 8645 w 8620"/>
                  <a:gd name="connsiteY2" fmla="*/ 448 h 9677"/>
                  <a:gd name="connsiteX3" fmla="*/ 8645 w 8620"/>
                  <a:gd name="connsiteY3" fmla="*/ 10126 h 96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8620" h="9677">
                    <a:moveTo>
                      <a:pt x="24" y="10126"/>
                    </a:moveTo>
                    <a:lnTo>
                      <a:pt x="24" y="448"/>
                    </a:lnTo>
                    <a:lnTo>
                      <a:pt x="8645" y="448"/>
                    </a:lnTo>
                    <a:lnTo>
                      <a:pt x="8645" y="10126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95" name="Freeform: Shape 3094">
                <a:extLst>
                  <a:ext uri="{FF2B5EF4-FFF2-40B4-BE49-F238E27FC236}">
                    <a16:creationId xmlns:a16="http://schemas.microsoft.com/office/drawing/2014/main" id="{8E645BE5-27CB-BBAE-5143-236F900A3713}"/>
                  </a:ext>
                </a:extLst>
              </p:cNvPr>
              <p:cNvSpPr/>
              <p:nvPr/>
            </p:nvSpPr>
            <p:spPr>
              <a:xfrm>
                <a:off x="1389963" y="4605559"/>
                <a:ext cx="43103" cy="63663"/>
              </a:xfrm>
              <a:custGeom>
                <a:avLst/>
                <a:gdLst>
                  <a:gd name="connsiteX0" fmla="*/ 43130 w 43103"/>
                  <a:gd name="connsiteY0" fmla="*/ 32204 h 63663"/>
                  <a:gd name="connsiteX1" fmla="*/ 37534 w 43103"/>
                  <a:gd name="connsiteY1" fmla="*/ 55945 h 63663"/>
                  <a:gd name="connsiteX2" fmla="*/ 21352 w 43103"/>
                  <a:gd name="connsiteY2" fmla="*/ 64111 h 63663"/>
                  <a:gd name="connsiteX3" fmla="*/ 5320 w 43103"/>
                  <a:gd name="connsiteY3" fmla="*/ 55945 h 63663"/>
                  <a:gd name="connsiteX4" fmla="*/ 27 w 43103"/>
                  <a:gd name="connsiteY4" fmla="*/ 32204 h 63663"/>
                  <a:gd name="connsiteX5" fmla="*/ 5169 w 43103"/>
                  <a:gd name="connsiteY5" fmla="*/ 8463 h 63663"/>
                  <a:gd name="connsiteX6" fmla="*/ 21654 w 43103"/>
                  <a:gd name="connsiteY6" fmla="*/ 448 h 63663"/>
                  <a:gd name="connsiteX7" fmla="*/ 37837 w 43103"/>
                  <a:gd name="connsiteY7" fmla="*/ 8463 h 63663"/>
                  <a:gd name="connsiteX8" fmla="*/ 43130 w 43103"/>
                  <a:gd name="connsiteY8" fmla="*/ 32204 h 63663"/>
                  <a:gd name="connsiteX9" fmla="*/ 35115 w 43103"/>
                  <a:gd name="connsiteY9" fmla="*/ 32204 h 63663"/>
                  <a:gd name="connsiteX10" fmla="*/ 31939 w 43103"/>
                  <a:gd name="connsiteY10" fmla="*/ 12848 h 63663"/>
                  <a:gd name="connsiteX11" fmla="*/ 21654 w 43103"/>
                  <a:gd name="connsiteY11" fmla="*/ 6799 h 63663"/>
                  <a:gd name="connsiteX12" fmla="*/ 11219 w 43103"/>
                  <a:gd name="connsiteY12" fmla="*/ 12697 h 63663"/>
                  <a:gd name="connsiteX13" fmla="*/ 8043 w 43103"/>
                  <a:gd name="connsiteY13" fmla="*/ 32204 h 63663"/>
                  <a:gd name="connsiteX14" fmla="*/ 11219 w 43103"/>
                  <a:gd name="connsiteY14" fmla="*/ 51560 h 63663"/>
                  <a:gd name="connsiteX15" fmla="*/ 21503 w 43103"/>
                  <a:gd name="connsiteY15" fmla="*/ 57609 h 63663"/>
                  <a:gd name="connsiteX16" fmla="*/ 31787 w 43103"/>
                  <a:gd name="connsiteY16" fmla="*/ 51409 h 63663"/>
                  <a:gd name="connsiteX17" fmla="*/ 35115 w 43103"/>
                  <a:gd name="connsiteY17" fmla="*/ 32204 h 636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3103" h="63663">
                    <a:moveTo>
                      <a:pt x="43130" y="32204"/>
                    </a:moveTo>
                    <a:cubicBezTo>
                      <a:pt x="43130" y="42600"/>
                      <a:pt x="41240" y="50501"/>
                      <a:pt x="37534" y="55945"/>
                    </a:cubicBezTo>
                    <a:cubicBezTo>
                      <a:pt x="33905" y="61389"/>
                      <a:pt x="28498" y="64111"/>
                      <a:pt x="21352" y="64111"/>
                    </a:cubicBezTo>
                    <a:cubicBezTo>
                      <a:pt x="14281" y="64111"/>
                      <a:pt x="8950" y="61389"/>
                      <a:pt x="5320" y="55945"/>
                    </a:cubicBezTo>
                    <a:cubicBezTo>
                      <a:pt x="1766" y="50501"/>
                      <a:pt x="27" y="42600"/>
                      <a:pt x="27" y="32204"/>
                    </a:cubicBezTo>
                    <a:cubicBezTo>
                      <a:pt x="27" y="21619"/>
                      <a:pt x="1728" y="13718"/>
                      <a:pt x="5169" y="8463"/>
                    </a:cubicBezTo>
                    <a:cubicBezTo>
                      <a:pt x="8685" y="3132"/>
                      <a:pt x="14168" y="448"/>
                      <a:pt x="21654" y="448"/>
                    </a:cubicBezTo>
                    <a:cubicBezTo>
                      <a:pt x="28989" y="448"/>
                      <a:pt x="34396" y="3132"/>
                      <a:pt x="37837" y="8463"/>
                    </a:cubicBezTo>
                    <a:cubicBezTo>
                      <a:pt x="41353" y="13831"/>
                      <a:pt x="43130" y="21732"/>
                      <a:pt x="43130" y="32204"/>
                    </a:cubicBezTo>
                    <a:close/>
                    <a:moveTo>
                      <a:pt x="35115" y="32204"/>
                    </a:moveTo>
                    <a:cubicBezTo>
                      <a:pt x="35115" y="23358"/>
                      <a:pt x="34056" y="16893"/>
                      <a:pt x="31939" y="12848"/>
                    </a:cubicBezTo>
                    <a:cubicBezTo>
                      <a:pt x="29897" y="8841"/>
                      <a:pt x="26494" y="6799"/>
                      <a:pt x="21654" y="6799"/>
                    </a:cubicBezTo>
                    <a:cubicBezTo>
                      <a:pt x="16815" y="6799"/>
                      <a:pt x="13336" y="8765"/>
                      <a:pt x="11219" y="12697"/>
                    </a:cubicBezTo>
                    <a:cubicBezTo>
                      <a:pt x="9101" y="16629"/>
                      <a:pt x="8043" y="23131"/>
                      <a:pt x="8043" y="32204"/>
                    </a:cubicBezTo>
                    <a:cubicBezTo>
                      <a:pt x="8043" y="40975"/>
                      <a:pt x="9101" y="47439"/>
                      <a:pt x="11219" y="51560"/>
                    </a:cubicBezTo>
                    <a:cubicBezTo>
                      <a:pt x="13412" y="55605"/>
                      <a:pt x="16852" y="57609"/>
                      <a:pt x="21503" y="57609"/>
                    </a:cubicBezTo>
                    <a:cubicBezTo>
                      <a:pt x="26229" y="57609"/>
                      <a:pt x="29670" y="55567"/>
                      <a:pt x="31787" y="51409"/>
                    </a:cubicBezTo>
                    <a:cubicBezTo>
                      <a:pt x="33980" y="47288"/>
                      <a:pt x="35115" y="40899"/>
                      <a:pt x="35115" y="32204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96" name="Freeform: Shape 3095">
                <a:extLst>
                  <a:ext uri="{FF2B5EF4-FFF2-40B4-BE49-F238E27FC236}">
                    <a16:creationId xmlns:a16="http://schemas.microsoft.com/office/drawing/2014/main" id="{7FE3EBE2-5DB5-AE2B-883F-462034DAF1D1}"/>
                  </a:ext>
                </a:extLst>
              </p:cNvPr>
              <p:cNvSpPr/>
              <p:nvPr/>
            </p:nvSpPr>
            <p:spPr>
              <a:xfrm>
                <a:off x="1440023" y="4605559"/>
                <a:ext cx="43103" cy="63663"/>
              </a:xfrm>
              <a:custGeom>
                <a:avLst/>
                <a:gdLst>
                  <a:gd name="connsiteX0" fmla="*/ 43135 w 43103"/>
                  <a:gd name="connsiteY0" fmla="*/ 32204 h 63663"/>
                  <a:gd name="connsiteX1" fmla="*/ 37540 w 43103"/>
                  <a:gd name="connsiteY1" fmla="*/ 55945 h 63663"/>
                  <a:gd name="connsiteX2" fmla="*/ 21357 w 43103"/>
                  <a:gd name="connsiteY2" fmla="*/ 64111 h 63663"/>
                  <a:gd name="connsiteX3" fmla="*/ 5325 w 43103"/>
                  <a:gd name="connsiteY3" fmla="*/ 55945 h 63663"/>
                  <a:gd name="connsiteX4" fmla="*/ 32 w 43103"/>
                  <a:gd name="connsiteY4" fmla="*/ 32204 h 63663"/>
                  <a:gd name="connsiteX5" fmla="*/ 5174 w 43103"/>
                  <a:gd name="connsiteY5" fmla="*/ 8463 h 63663"/>
                  <a:gd name="connsiteX6" fmla="*/ 21659 w 43103"/>
                  <a:gd name="connsiteY6" fmla="*/ 448 h 63663"/>
                  <a:gd name="connsiteX7" fmla="*/ 37842 w 43103"/>
                  <a:gd name="connsiteY7" fmla="*/ 8463 h 63663"/>
                  <a:gd name="connsiteX8" fmla="*/ 43135 w 43103"/>
                  <a:gd name="connsiteY8" fmla="*/ 32204 h 63663"/>
                  <a:gd name="connsiteX9" fmla="*/ 35120 w 43103"/>
                  <a:gd name="connsiteY9" fmla="*/ 32204 h 63663"/>
                  <a:gd name="connsiteX10" fmla="*/ 31944 w 43103"/>
                  <a:gd name="connsiteY10" fmla="*/ 12848 h 63663"/>
                  <a:gd name="connsiteX11" fmla="*/ 21659 w 43103"/>
                  <a:gd name="connsiteY11" fmla="*/ 6799 h 63663"/>
                  <a:gd name="connsiteX12" fmla="*/ 11224 w 43103"/>
                  <a:gd name="connsiteY12" fmla="*/ 12697 h 63663"/>
                  <a:gd name="connsiteX13" fmla="*/ 8048 w 43103"/>
                  <a:gd name="connsiteY13" fmla="*/ 32204 h 63663"/>
                  <a:gd name="connsiteX14" fmla="*/ 11224 w 43103"/>
                  <a:gd name="connsiteY14" fmla="*/ 51560 h 63663"/>
                  <a:gd name="connsiteX15" fmla="*/ 21508 w 43103"/>
                  <a:gd name="connsiteY15" fmla="*/ 57609 h 63663"/>
                  <a:gd name="connsiteX16" fmla="*/ 31792 w 43103"/>
                  <a:gd name="connsiteY16" fmla="*/ 51409 h 63663"/>
                  <a:gd name="connsiteX17" fmla="*/ 35120 w 43103"/>
                  <a:gd name="connsiteY17" fmla="*/ 32204 h 636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3103" h="63663">
                    <a:moveTo>
                      <a:pt x="43135" y="32204"/>
                    </a:moveTo>
                    <a:cubicBezTo>
                      <a:pt x="43135" y="42600"/>
                      <a:pt x="41245" y="50501"/>
                      <a:pt x="37540" y="55945"/>
                    </a:cubicBezTo>
                    <a:cubicBezTo>
                      <a:pt x="33910" y="61389"/>
                      <a:pt x="28503" y="64111"/>
                      <a:pt x="21357" y="64111"/>
                    </a:cubicBezTo>
                    <a:cubicBezTo>
                      <a:pt x="14286" y="64111"/>
                      <a:pt x="8955" y="61389"/>
                      <a:pt x="5325" y="55945"/>
                    </a:cubicBezTo>
                    <a:cubicBezTo>
                      <a:pt x="1771" y="50501"/>
                      <a:pt x="32" y="42600"/>
                      <a:pt x="32" y="32204"/>
                    </a:cubicBezTo>
                    <a:cubicBezTo>
                      <a:pt x="32" y="21619"/>
                      <a:pt x="1734" y="13718"/>
                      <a:pt x="5174" y="8463"/>
                    </a:cubicBezTo>
                    <a:cubicBezTo>
                      <a:pt x="8691" y="3132"/>
                      <a:pt x="14173" y="448"/>
                      <a:pt x="21659" y="448"/>
                    </a:cubicBezTo>
                    <a:cubicBezTo>
                      <a:pt x="28994" y="448"/>
                      <a:pt x="34401" y="3132"/>
                      <a:pt x="37842" y="8463"/>
                    </a:cubicBezTo>
                    <a:cubicBezTo>
                      <a:pt x="41358" y="13831"/>
                      <a:pt x="43135" y="21732"/>
                      <a:pt x="43135" y="32204"/>
                    </a:cubicBezTo>
                    <a:close/>
                    <a:moveTo>
                      <a:pt x="35120" y="32204"/>
                    </a:moveTo>
                    <a:cubicBezTo>
                      <a:pt x="35120" y="23358"/>
                      <a:pt x="34061" y="16893"/>
                      <a:pt x="31944" y="12848"/>
                    </a:cubicBezTo>
                    <a:cubicBezTo>
                      <a:pt x="29902" y="8841"/>
                      <a:pt x="26499" y="6799"/>
                      <a:pt x="21659" y="6799"/>
                    </a:cubicBezTo>
                    <a:cubicBezTo>
                      <a:pt x="16820" y="6799"/>
                      <a:pt x="13341" y="8765"/>
                      <a:pt x="11224" y="12697"/>
                    </a:cubicBezTo>
                    <a:cubicBezTo>
                      <a:pt x="9106" y="16629"/>
                      <a:pt x="8048" y="23131"/>
                      <a:pt x="8048" y="32204"/>
                    </a:cubicBezTo>
                    <a:cubicBezTo>
                      <a:pt x="8048" y="40975"/>
                      <a:pt x="9106" y="47439"/>
                      <a:pt x="11224" y="51560"/>
                    </a:cubicBezTo>
                    <a:cubicBezTo>
                      <a:pt x="13417" y="55605"/>
                      <a:pt x="16858" y="57609"/>
                      <a:pt x="21508" y="57609"/>
                    </a:cubicBezTo>
                    <a:cubicBezTo>
                      <a:pt x="26234" y="57609"/>
                      <a:pt x="29675" y="55567"/>
                      <a:pt x="31792" y="51409"/>
                    </a:cubicBezTo>
                    <a:cubicBezTo>
                      <a:pt x="33985" y="47288"/>
                      <a:pt x="35120" y="40899"/>
                      <a:pt x="35120" y="32204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</p:grpSp>
        <p:grpSp>
          <p:nvGrpSpPr>
            <p:cNvPr id="3010" name="Content Placeholder 4">
              <a:extLst>
                <a:ext uri="{FF2B5EF4-FFF2-40B4-BE49-F238E27FC236}">
                  <a16:creationId xmlns:a16="http://schemas.microsoft.com/office/drawing/2014/main" id="{6F49F02B-6F16-75BE-DF1B-98F969D1F126}"/>
                </a:ext>
              </a:extLst>
            </p:cNvPr>
            <p:cNvGrpSpPr/>
            <p:nvPr/>
          </p:nvGrpSpPr>
          <p:grpSpPr>
            <a:xfrm>
              <a:off x="1314948" y="3593105"/>
              <a:ext cx="167876" cy="63663"/>
              <a:chOff x="1314948" y="3593105"/>
              <a:chExt cx="167876" cy="63663"/>
            </a:xfrm>
          </p:grpSpPr>
          <p:sp>
            <p:nvSpPr>
              <p:cNvPr id="3089" name="Freeform: Shape 3088">
                <a:extLst>
                  <a:ext uri="{FF2B5EF4-FFF2-40B4-BE49-F238E27FC236}">
                    <a16:creationId xmlns:a16="http://schemas.microsoft.com/office/drawing/2014/main" id="{9EC5FAB7-B4A4-C58D-576E-6E06A7AA4559}"/>
                  </a:ext>
                </a:extLst>
              </p:cNvPr>
              <p:cNvSpPr/>
              <p:nvPr/>
            </p:nvSpPr>
            <p:spPr>
              <a:xfrm>
                <a:off x="1314948" y="3593105"/>
                <a:ext cx="43103" cy="63663"/>
              </a:xfrm>
              <a:custGeom>
                <a:avLst/>
                <a:gdLst>
                  <a:gd name="connsiteX0" fmla="*/ 43123 w 43103"/>
                  <a:gd name="connsiteY0" fmla="*/ 32099 h 63663"/>
                  <a:gd name="connsiteX1" fmla="*/ 37527 w 43103"/>
                  <a:gd name="connsiteY1" fmla="*/ 55841 h 63663"/>
                  <a:gd name="connsiteX2" fmla="*/ 21344 w 43103"/>
                  <a:gd name="connsiteY2" fmla="*/ 64007 h 63663"/>
                  <a:gd name="connsiteX3" fmla="*/ 5313 w 43103"/>
                  <a:gd name="connsiteY3" fmla="*/ 55841 h 63663"/>
                  <a:gd name="connsiteX4" fmla="*/ 19 w 43103"/>
                  <a:gd name="connsiteY4" fmla="*/ 32099 h 63663"/>
                  <a:gd name="connsiteX5" fmla="*/ 5161 w 43103"/>
                  <a:gd name="connsiteY5" fmla="*/ 8358 h 63663"/>
                  <a:gd name="connsiteX6" fmla="*/ 21646 w 43103"/>
                  <a:gd name="connsiteY6" fmla="*/ 343 h 63663"/>
                  <a:gd name="connsiteX7" fmla="*/ 37829 w 43103"/>
                  <a:gd name="connsiteY7" fmla="*/ 8358 h 63663"/>
                  <a:gd name="connsiteX8" fmla="*/ 43123 w 43103"/>
                  <a:gd name="connsiteY8" fmla="*/ 32099 h 63663"/>
                  <a:gd name="connsiteX9" fmla="*/ 35107 w 43103"/>
                  <a:gd name="connsiteY9" fmla="*/ 32099 h 63663"/>
                  <a:gd name="connsiteX10" fmla="*/ 31931 w 43103"/>
                  <a:gd name="connsiteY10" fmla="*/ 12743 h 63663"/>
                  <a:gd name="connsiteX11" fmla="*/ 21646 w 43103"/>
                  <a:gd name="connsiteY11" fmla="*/ 6695 h 63663"/>
                  <a:gd name="connsiteX12" fmla="*/ 11211 w 43103"/>
                  <a:gd name="connsiteY12" fmla="*/ 12592 h 63663"/>
                  <a:gd name="connsiteX13" fmla="*/ 8035 w 43103"/>
                  <a:gd name="connsiteY13" fmla="*/ 32099 h 63663"/>
                  <a:gd name="connsiteX14" fmla="*/ 11211 w 43103"/>
                  <a:gd name="connsiteY14" fmla="*/ 51455 h 63663"/>
                  <a:gd name="connsiteX15" fmla="*/ 21495 w 43103"/>
                  <a:gd name="connsiteY15" fmla="*/ 57504 h 63663"/>
                  <a:gd name="connsiteX16" fmla="*/ 31779 w 43103"/>
                  <a:gd name="connsiteY16" fmla="*/ 51304 h 63663"/>
                  <a:gd name="connsiteX17" fmla="*/ 35107 w 43103"/>
                  <a:gd name="connsiteY17" fmla="*/ 32099 h 636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3103" h="63663">
                    <a:moveTo>
                      <a:pt x="43123" y="32099"/>
                    </a:moveTo>
                    <a:cubicBezTo>
                      <a:pt x="43123" y="42496"/>
                      <a:pt x="41232" y="50397"/>
                      <a:pt x="37527" y="55841"/>
                    </a:cubicBezTo>
                    <a:cubicBezTo>
                      <a:pt x="33897" y="61285"/>
                      <a:pt x="28490" y="64007"/>
                      <a:pt x="21344" y="64007"/>
                    </a:cubicBezTo>
                    <a:cubicBezTo>
                      <a:pt x="14273" y="64007"/>
                      <a:pt x="8942" y="61285"/>
                      <a:pt x="5313" y="55841"/>
                    </a:cubicBezTo>
                    <a:cubicBezTo>
                      <a:pt x="1758" y="50397"/>
                      <a:pt x="19" y="42496"/>
                      <a:pt x="19" y="32099"/>
                    </a:cubicBezTo>
                    <a:cubicBezTo>
                      <a:pt x="19" y="21514"/>
                      <a:pt x="1721" y="13613"/>
                      <a:pt x="5161" y="8358"/>
                    </a:cubicBezTo>
                    <a:cubicBezTo>
                      <a:pt x="8678" y="3028"/>
                      <a:pt x="14160" y="343"/>
                      <a:pt x="21646" y="343"/>
                    </a:cubicBezTo>
                    <a:cubicBezTo>
                      <a:pt x="28982" y="343"/>
                      <a:pt x="34388" y="3028"/>
                      <a:pt x="37829" y="8358"/>
                    </a:cubicBezTo>
                    <a:cubicBezTo>
                      <a:pt x="41345" y="13726"/>
                      <a:pt x="43123" y="21627"/>
                      <a:pt x="43123" y="32099"/>
                    </a:cubicBezTo>
                    <a:close/>
                    <a:moveTo>
                      <a:pt x="35107" y="32099"/>
                    </a:moveTo>
                    <a:cubicBezTo>
                      <a:pt x="35107" y="23253"/>
                      <a:pt x="34048" y="16788"/>
                      <a:pt x="31931" y="12743"/>
                    </a:cubicBezTo>
                    <a:cubicBezTo>
                      <a:pt x="29889" y="8736"/>
                      <a:pt x="26486" y="6695"/>
                      <a:pt x="21646" y="6695"/>
                    </a:cubicBezTo>
                    <a:cubicBezTo>
                      <a:pt x="16807" y="6695"/>
                      <a:pt x="13328" y="8661"/>
                      <a:pt x="11211" y="12592"/>
                    </a:cubicBezTo>
                    <a:cubicBezTo>
                      <a:pt x="9094" y="16524"/>
                      <a:pt x="8035" y="23026"/>
                      <a:pt x="8035" y="32099"/>
                    </a:cubicBezTo>
                    <a:cubicBezTo>
                      <a:pt x="8035" y="40870"/>
                      <a:pt x="9094" y="47335"/>
                      <a:pt x="11211" y="51455"/>
                    </a:cubicBezTo>
                    <a:cubicBezTo>
                      <a:pt x="13404" y="55501"/>
                      <a:pt x="16845" y="57504"/>
                      <a:pt x="21495" y="57504"/>
                    </a:cubicBezTo>
                    <a:cubicBezTo>
                      <a:pt x="26221" y="57504"/>
                      <a:pt x="29662" y="55463"/>
                      <a:pt x="31779" y="51304"/>
                    </a:cubicBezTo>
                    <a:cubicBezTo>
                      <a:pt x="33973" y="47183"/>
                      <a:pt x="35107" y="40794"/>
                      <a:pt x="35107" y="32099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90" name="Freeform: Shape 3089">
                <a:extLst>
                  <a:ext uri="{FF2B5EF4-FFF2-40B4-BE49-F238E27FC236}">
                    <a16:creationId xmlns:a16="http://schemas.microsoft.com/office/drawing/2014/main" id="{C4081AD8-BC35-ADF5-DD6F-35F375C5CC3B}"/>
                  </a:ext>
                </a:extLst>
              </p:cNvPr>
              <p:cNvSpPr/>
              <p:nvPr/>
            </p:nvSpPr>
            <p:spPr>
              <a:xfrm>
                <a:off x="1369697" y="3646183"/>
                <a:ext cx="8620" cy="9677"/>
              </a:xfrm>
              <a:custGeom>
                <a:avLst/>
                <a:gdLst>
                  <a:gd name="connsiteX0" fmla="*/ 24 w 8620"/>
                  <a:gd name="connsiteY0" fmla="*/ 10021 h 9677"/>
                  <a:gd name="connsiteX1" fmla="*/ 24 w 8620"/>
                  <a:gd name="connsiteY1" fmla="*/ 343 h 9677"/>
                  <a:gd name="connsiteX2" fmla="*/ 8645 w 8620"/>
                  <a:gd name="connsiteY2" fmla="*/ 343 h 9677"/>
                  <a:gd name="connsiteX3" fmla="*/ 8645 w 8620"/>
                  <a:gd name="connsiteY3" fmla="*/ 10021 h 96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8620" h="9677">
                    <a:moveTo>
                      <a:pt x="24" y="10021"/>
                    </a:moveTo>
                    <a:lnTo>
                      <a:pt x="24" y="343"/>
                    </a:lnTo>
                    <a:lnTo>
                      <a:pt x="8645" y="343"/>
                    </a:lnTo>
                    <a:lnTo>
                      <a:pt x="8645" y="10021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91" name="Freeform: Shape 3090">
                <a:extLst>
                  <a:ext uri="{FF2B5EF4-FFF2-40B4-BE49-F238E27FC236}">
                    <a16:creationId xmlns:a16="http://schemas.microsoft.com/office/drawing/2014/main" id="{561DB20C-C4CC-A1B3-45AC-99CAEC609FA7}"/>
                  </a:ext>
                </a:extLst>
              </p:cNvPr>
              <p:cNvSpPr/>
              <p:nvPr/>
            </p:nvSpPr>
            <p:spPr>
              <a:xfrm>
                <a:off x="1391021" y="3593105"/>
                <a:ext cx="40985" cy="62755"/>
              </a:xfrm>
              <a:custGeom>
                <a:avLst/>
                <a:gdLst>
                  <a:gd name="connsiteX0" fmla="*/ 27 w 40985"/>
                  <a:gd name="connsiteY0" fmla="*/ 63099 h 62755"/>
                  <a:gd name="connsiteX1" fmla="*/ 27 w 40985"/>
                  <a:gd name="connsiteY1" fmla="*/ 57504 h 62755"/>
                  <a:gd name="connsiteX2" fmla="*/ 5472 w 40985"/>
                  <a:gd name="connsiteY2" fmla="*/ 48431 h 62755"/>
                  <a:gd name="connsiteX3" fmla="*/ 12277 w 40985"/>
                  <a:gd name="connsiteY3" fmla="*/ 41324 h 62755"/>
                  <a:gd name="connsiteX4" fmla="*/ 19386 w 40985"/>
                  <a:gd name="connsiteY4" fmla="*/ 35426 h 62755"/>
                  <a:gd name="connsiteX5" fmla="*/ 25586 w 40985"/>
                  <a:gd name="connsiteY5" fmla="*/ 29982 h 62755"/>
                  <a:gd name="connsiteX6" fmla="*/ 30124 w 40985"/>
                  <a:gd name="connsiteY6" fmla="*/ 24236 h 62755"/>
                  <a:gd name="connsiteX7" fmla="*/ 31938 w 40985"/>
                  <a:gd name="connsiteY7" fmla="*/ 17431 h 62755"/>
                  <a:gd name="connsiteX8" fmla="*/ 28914 w 40985"/>
                  <a:gd name="connsiteY8" fmla="*/ 9719 h 62755"/>
                  <a:gd name="connsiteX9" fmla="*/ 20596 w 40985"/>
                  <a:gd name="connsiteY9" fmla="*/ 6846 h 62755"/>
                  <a:gd name="connsiteX10" fmla="*/ 12277 w 40985"/>
                  <a:gd name="connsiteY10" fmla="*/ 9568 h 62755"/>
                  <a:gd name="connsiteX11" fmla="*/ 8496 w 40985"/>
                  <a:gd name="connsiteY11" fmla="*/ 17280 h 62755"/>
                  <a:gd name="connsiteX12" fmla="*/ 329 w 40985"/>
                  <a:gd name="connsiteY12" fmla="*/ 16524 h 62755"/>
                  <a:gd name="connsiteX13" fmla="*/ 6681 w 40985"/>
                  <a:gd name="connsiteY13" fmla="*/ 4729 h 62755"/>
                  <a:gd name="connsiteX14" fmla="*/ 20596 w 40985"/>
                  <a:gd name="connsiteY14" fmla="*/ 343 h 62755"/>
                  <a:gd name="connsiteX15" fmla="*/ 34963 w 40985"/>
                  <a:gd name="connsiteY15" fmla="*/ 4729 h 62755"/>
                  <a:gd name="connsiteX16" fmla="*/ 40106 w 40985"/>
                  <a:gd name="connsiteY16" fmla="*/ 17280 h 62755"/>
                  <a:gd name="connsiteX17" fmla="*/ 38442 w 40985"/>
                  <a:gd name="connsiteY17" fmla="*/ 24538 h 62755"/>
                  <a:gd name="connsiteX18" fmla="*/ 33451 w 40985"/>
                  <a:gd name="connsiteY18" fmla="*/ 31646 h 62755"/>
                  <a:gd name="connsiteX19" fmla="*/ 21049 w 40985"/>
                  <a:gd name="connsiteY19" fmla="*/ 42533 h 62755"/>
                  <a:gd name="connsiteX20" fmla="*/ 13034 w 40985"/>
                  <a:gd name="connsiteY20" fmla="*/ 49943 h 62755"/>
                  <a:gd name="connsiteX21" fmla="*/ 8648 w 40985"/>
                  <a:gd name="connsiteY21" fmla="*/ 56446 h 62755"/>
                  <a:gd name="connsiteX22" fmla="*/ 41013 w 40985"/>
                  <a:gd name="connsiteY22" fmla="*/ 56446 h 62755"/>
                  <a:gd name="connsiteX23" fmla="*/ 41013 w 40985"/>
                  <a:gd name="connsiteY23" fmla="*/ 63099 h 627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40985" h="62755">
                    <a:moveTo>
                      <a:pt x="27" y="63099"/>
                    </a:moveTo>
                    <a:lnTo>
                      <a:pt x="27" y="57504"/>
                    </a:lnTo>
                    <a:cubicBezTo>
                      <a:pt x="1539" y="54102"/>
                      <a:pt x="3354" y="51077"/>
                      <a:pt x="5472" y="48431"/>
                    </a:cubicBezTo>
                    <a:cubicBezTo>
                      <a:pt x="7589" y="45822"/>
                      <a:pt x="9858" y="43441"/>
                      <a:pt x="12277" y="41324"/>
                    </a:cubicBezTo>
                    <a:cubicBezTo>
                      <a:pt x="14697" y="39207"/>
                      <a:pt x="17041" y="37241"/>
                      <a:pt x="19386" y="35426"/>
                    </a:cubicBezTo>
                    <a:cubicBezTo>
                      <a:pt x="21692" y="33612"/>
                      <a:pt x="23772" y="31797"/>
                      <a:pt x="25586" y="29982"/>
                    </a:cubicBezTo>
                    <a:cubicBezTo>
                      <a:pt x="27477" y="28168"/>
                      <a:pt x="28989" y="26277"/>
                      <a:pt x="30124" y="24236"/>
                    </a:cubicBezTo>
                    <a:cubicBezTo>
                      <a:pt x="31334" y="22232"/>
                      <a:pt x="31938" y="19964"/>
                      <a:pt x="31938" y="17431"/>
                    </a:cubicBezTo>
                    <a:cubicBezTo>
                      <a:pt x="31938" y="14104"/>
                      <a:pt x="30918" y="11534"/>
                      <a:pt x="28914" y="9719"/>
                    </a:cubicBezTo>
                    <a:cubicBezTo>
                      <a:pt x="26872" y="7829"/>
                      <a:pt x="24112" y="6846"/>
                      <a:pt x="20596" y="6846"/>
                    </a:cubicBezTo>
                    <a:cubicBezTo>
                      <a:pt x="17268" y="6846"/>
                      <a:pt x="14470" y="7753"/>
                      <a:pt x="12277" y="9568"/>
                    </a:cubicBezTo>
                    <a:cubicBezTo>
                      <a:pt x="10047" y="11382"/>
                      <a:pt x="8799" y="13953"/>
                      <a:pt x="8496" y="17280"/>
                    </a:cubicBezTo>
                    <a:lnTo>
                      <a:pt x="329" y="16524"/>
                    </a:lnTo>
                    <a:cubicBezTo>
                      <a:pt x="934" y="11609"/>
                      <a:pt x="3052" y="7678"/>
                      <a:pt x="6681" y="4729"/>
                    </a:cubicBezTo>
                    <a:cubicBezTo>
                      <a:pt x="10311" y="1818"/>
                      <a:pt x="14924" y="343"/>
                      <a:pt x="20596" y="343"/>
                    </a:cubicBezTo>
                    <a:cubicBezTo>
                      <a:pt x="26834" y="343"/>
                      <a:pt x="31636" y="1818"/>
                      <a:pt x="34963" y="4729"/>
                    </a:cubicBezTo>
                    <a:cubicBezTo>
                      <a:pt x="38366" y="7678"/>
                      <a:pt x="40106" y="11836"/>
                      <a:pt x="40106" y="17280"/>
                    </a:cubicBezTo>
                    <a:cubicBezTo>
                      <a:pt x="40106" y="19699"/>
                      <a:pt x="39538" y="22119"/>
                      <a:pt x="38442" y="24538"/>
                    </a:cubicBezTo>
                    <a:cubicBezTo>
                      <a:pt x="37308" y="26882"/>
                      <a:pt x="35644" y="29226"/>
                      <a:pt x="33451" y="31646"/>
                    </a:cubicBezTo>
                    <a:cubicBezTo>
                      <a:pt x="31334" y="33990"/>
                      <a:pt x="27174" y="37619"/>
                      <a:pt x="21049" y="42533"/>
                    </a:cubicBezTo>
                    <a:cubicBezTo>
                      <a:pt x="17722" y="45255"/>
                      <a:pt x="15037" y="47751"/>
                      <a:pt x="13034" y="49943"/>
                    </a:cubicBezTo>
                    <a:cubicBezTo>
                      <a:pt x="10992" y="52174"/>
                      <a:pt x="9555" y="54329"/>
                      <a:pt x="8648" y="56446"/>
                    </a:cubicBezTo>
                    <a:lnTo>
                      <a:pt x="41013" y="56446"/>
                    </a:lnTo>
                    <a:lnTo>
                      <a:pt x="41013" y="63099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92" name="Freeform: Shape 3091">
                <a:extLst>
                  <a:ext uri="{FF2B5EF4-FFF2-40B4-BE49-F238E27FC236}">
                    <a16:creationId xmlns:a16="http://schemas.microsoft.com/office/drawing/2014/main" id="{0620E133-40D7-9895-DAE2-E57139E15B3A}"/>
                  </a:ext>
                </a:extLst>
              </p:cNvPr>
              <p:cNvSpPr/>
              <p:nvPr/>
            </p:nvSpPr>
            <p:spPr>
              <a:xfrm>
                <a:off x="1440175" y="3594012"/>
                <a:ext cx="42649" cy="62755"/>
              </a:xfrm>
              <a:custGeom>
                <a:avLst/>
                <a:gdLst>
                  <a:gd name="connsiteX0" fmla="*/ 42682 w 42649"/>
                  <a:gd name="connsiteY0" fmla="*/ 42080 h 62755"/>
                  <a:gd name="connsiteX1" fmla="*/ 36783 w 42649"/>
                  <a:gd name="connsiteY1" fmla="*/ 57504 h 62755"/>
                  <a:gd name="connsiteX2" fmla="*/ 20752 w 42649"/>
                  <a:gd name="connsiteY2" fmla="*/ 63099 h 62755"/>
                  <a:gd name="connsiteX3" fmla="*/ 6687 w 42649"/>
                  <a:gd name="connsiteY3" fmla="*/ 59319 h 62755"/>
                  <a:gd name="connsiteX4" fmla="*/ 32 w 42649"/>
                  <a:gd name="connsiteY4" fmla="*/ 48280 h 62755"/>
                  <a:gd name="connsiteX5" fmla="*/ 8048 w 42649"/>
                  <a:gd name="connsiteY5" fmla="*/ 47372 h 62755"/>
                  <a:gd name="connsiteX6" fmla="*/ 20903 w 42649"/>
                  <a:gd name="connsiteY6" fmla="*/ 56597 h 62755"/>
                  <a:gd name="connsiteX7" fmla="*/ 30885 w 42649"/>
                  <a:gd name="connsiteY7" fmla="*/ 52816 h 62755"/>
                  <a:gd name="connsiteX8" fmla="*/ 34515 w 42649"/>
                  <a:gd name="connsiteY8" fmla="*/ 42231 h 62755"/>
                  <a:gd name="connsiteX9" fmla="*/ 30885 w 42649"/>
                  <a:gd name="connsiteY9" fmla="*/ 32855 h 62755"/>
                  <a:gd name="connsiteX10" fmla="*/ 21054 w 42649"/>
                  <a:gd name="connsiteY10" fmla="*/ 29226 h 62755"/>
                  <a:gd name="connsiteX11" fmla="*/ 15005 w 42649"/>
                  <a:gd name="connsiteY11" fmla="*/ 30285 h 62755"/>
                  <a:gd name="connsiteX12" fmla="*/ 9560 w 42649"/>
                  <a:gd name="connsiteY12" fmla="*/ 33612 h 62755"/>
                  <a:gd name="connsiteX13" fmla="*/ 1847 w 42649"/>
                  <a:gd name="connsiteY13" fmla="*/ 33612 h 62755"/>
                  <a:gd name="connsiteX14" fmla="*/ 3813 w 42649"/>
                  <a:gd name="connsiteY14" fmla="*/ 343 h 62755"/>
                  <a:gd name="connsiteX15" fmla="*/ 39052 w 42649"/>
                  <a:gd name="connsiteY15" fmla="*/ 343 h 62755"/>
                  <a:gd name="connsiteX16" fmla="*/ 39052 w 42649"/>
                  <a:gd name="connsiteY16" fmla="*/ 6997 h 62755"/>
                  <a:gd name="connsiteX17" fmla="*/ 11073 w 42649"/>
                  <a:gd name="connsiteY17" fmla="*/ 6997 h 62755"/>
                  <a:gd name="connsiteX18" fmla="*/ 9863 w 42649"/>
                  <a:gd name="connsiteY18" fmla="*/ 26655 h 62755"/>
                  <a:gd name="connsiteX19" fmla="*/ 22718 w 42649"/>
                  <a:gd name="connsiteY19" fmla="*/ 22724 h 62755"/>
                  <a:gd name="connsiteX20" fmla="*/ 37237 w 42649"/>
                  <a:gd name="connsiteY20" fmla="*/ 28168 h 62755"/>
                  <a:gd name="connsiteX21" fmla="*/ 42682 w 42649"/>
                  <a:gd name="connsiteY21" fmla="*/ 42080 h 627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42649" h="62755">
                    <a:moveTo>
                      <a:pt x="42682" y="42080"/>
                    </a:moveTo>
                    <a:cubicBezTo>
                      <a:pt x="42682" y="48544"/>
                      <a:pt x="40716" y="53686"/>
                      <a:pt x="36783" y="57504"/>
                    </a:cubicBezTo>
                    <a:cubicBezTo>
                      <a:pt x="32927" y="61247"/>
                      <a:pt x="27596" y="63099"/>
                      <a:pt x="20752" y="63099"/>
                    </a:cubicBezTo>
                    <a:cubicBezTo>
                      <a:pt x="14891" y="63099"/>
                      <a:pt x="10203" y="61852"/>
                      <a:pt x="6687" y="59319"/>
                    </a:cubicBezTo>
                    <a:cubicBezTo>
                      <a:pt x="3132" y="56824"/>
                      <a:pt x="939" y="53119"/>
                      <a:pt x="32" y="48280"/>
                    </a:cubicBezTo>
                    <a:lnTo>
                      <a:pt x="8048" y="47372"/>
                    </a:lnTo>
                    <a:cubicBezTo>
                      <a:pt x="9636" y="53535"/>
                      <a:pt x="13946" y="56597"/>
                      <a:pt x="20903" y="56597"/>
                    </a:cubicBezTo>
                    <a:cubicBezTo>
                      <a:pt x="25138" y="56597"/>
                      <a:pt x="28465" y="55349"/>
                      <a:pt x="30885" y="52816"/>
                    </a:cubicBezTo>
                    <a:cubicBezTo>
                      <a:pt x="33305" y="50208"/>
                      <a:pt x="34515" y="46692"/>
                      <a:pt x="34515" y="42231"/>
                    </a:cubicBezTo>
                    <a:cubicBezTo>
                      <a:pt x="34515" y="38299"/>
                      <a:pt x="33305" y="35199"/>
                      <a:pt x="30885" y="32855"/>
                    </a:cubicBezTo>
                    <a:cubicBezTo>
                      <a:pt x="28465" y="30436"/>
                      <a:pt x="25176" y="29226"/>
                      <a:pt x="21054" y="29226"/>
                    </a:cubicBezTo>
                    <a:cubicBezTo>
                      <a:pt x="18937" y="29226"/>
                      <a:pt x="16895" y="29604"/>
                      <a:pt x="15005" y="30285"/>
                    </a:cubicBezTo>
                    <a:cubicBezTo>
                      <a:pt x="13190" y="30890"/>
                      <a:pt x="11375" y="32024"/>
                      <a:pt x="9560" y="33612"/>
                    </a:cubicBezTo>
                    <a:lnTo>
                      <a:pt x="1847" y="33612"/>
                    </a:lnTo>
                    <a:lnTo>
                      <a:pt x="3813" y="343"/>
                    </a:lnTo>
                    <a:lnTo>
                      <a:pt x="39052" y="343"/>
                    </a:lnTo>
                    <a:lnTo>
                      <a:pt x="39052" y="6997"/>
                    </a:lnTo>
                    <a:lnTo>
                      <a:pt x="11073" y="6997"/>
                    </a:lnTo>
                    <a:lnTo>
                      <a:pt x="9863" y="26655"/>
                    </a:lnTo>
                    <a:cubicBezTo>
                      <a:pt x="13266" y="24047"/>
                      <a:pt x="17576" y="22724"/>
                      <a:pt x="22718" y="22724"/>
                    </a:cubicBezTo>
                    <a:cubicBezTo>
                      <a:pt x="28768" y="22724"/>
                      <a:pt x="33607" y="24538"/>
                      <a:pt x="37237" y="28168"/>
                    </a:cubicBezTo>
                    <a:cubicBezTo>
                      <a:pt x="40867" y="31721"/>
                      <a:pt x="42682" y="36333"/>
                      <a:pt x="42682" y="42080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</p:grpSp>
        <p:grpSp>
          <p:nvGrpSpPr>
            <p:cNvPr id="3011" name="Content Placeholder 4">
              <a:extLst>
                <a:ext uri="{FF2B5EF4-FFF2-40B4-BE49-F238E27FC236}">
                  <a16:creationId xmlns:a16="http://schemas.microsoft.com/office/drawing/2014/main" id="{5EAF5E7D-83C8-C9EC-BB01-AF91EFD9EAD9}"/>
                </a:ext>
              </a:extLst>
            </p:cNvPr>
            <p:cNvGrpSpPr/>
            <p:nvPr/>
          </p:nvGrpSpPr>
          <p:grpSpPr>
            <a:xfrm>
              <a:off x="1314948" y="2580661"/>
              <a:ext cx="168179" cy="63663"/>
              <a:chOff x="1314948" y="2580661"/>
              <a:chExt cx="168179" cy="63663"/>
            </a:xfrm>
          </p:grpSpPr>
          <p:sp>
            <p:nvSpPr>
              <p:cNvPr id="3085" name="Freeform: Shape 3084">
                <a:extLst>
                  <a:ext uri="{FF2B5EF4-FFF2-40B4-BE49-F238E27FC236}">
                    <a16:creationId xmlns:a16="http://schemas.microsoft.com/office/drawing/2014/main" id="{3AC721C0-9A2F-9B7A-D41A-56A92B5359B4}"/>
                  </a:ext>
                </a:extLst>
              </p:cNvPr>
              <p:cNvSpPr/>
              <p:nvPr/>
            </p:nvSpPr>
            <p:spPr>
              <a:xfrm>
                <a:off x="1314948" y="2580661"/>
                <a:ext cx="43103" cy="63663"/>
              </a:xfrm>
              <a:custGeom>
                <a:avLst/>
                <a:gdLst>
                  <a:gd name="connsiteX0" fmla="*/ 43123 w 43103"/>
                  <a:gd name="connsiteY0" fmla="*/ 31995 h 63663"/>
                  <a:gd name="connsiteX1" fmla="*/ 37527 w 43103"/>
                  <a:gd name="connsiteY1" fmla="*/ 55736 h 63663"/>
                  <a:gd name="connsiteX2" fmla="*/ 21344 w 43103"/>
                  <a:gd name="connsiteY2" fmla="*/ 63902 h 63663"/>
                  <a:gd name="connsiteX3" fmla="*/ 5313 w 43103"/>
                  <a:gd name="connsiteY3" fmla="*/ 55736 h 63663"/>
                  <a:gd name="connsiteX4" fmla="*/ 19 w 43103"/>
                  <a:gd name="connsiteY4" fmla="*/ 31995 h 63663"/>
                  <a:gd name="connsiteX5" fmla="*/ 5161 w 43103"/>
                  <a:gd name="connsiteY5" fmla="*/ 8253 h 63663"/>
                  <a:gd name="connsiteX6" fmla="*/ 21646 w 43103"/>
                  <a:gd name="connsiteY6" fmla="*/ 239 h 63663"/>
                  <a:gd name="connsiteX7" fmla="*/ 37829 w 43103"/>
                  <a:gd name="connsiteY7" fmla="*/ 8253 h 63663"/>
                  <a:gd name="connsiteX8" fmla="*/ 43123 w 43103"/>
                  <a:gd name="connsiteY8" fmla="*/ 31995 h 63663"/>
                  <a:gd name="connsiteX9" fmla="*/ 35107 w 43103"/>
                  <a:gd name="connsiteY9" fmla="*/ 31995 h 63663"/>
                  <a:gd name="connsiteX10" fmla="*/ 31931 w 43103"/>
                  <a:gd name="connsiteY10" fmla="*/ 12639 h 63663"/>
                  <a:gd name="connsiteX11" fmla="*/ 21646 w 43103"/>
                  <a:gd name="connsiteY11" fmla="*/ 6590 h 63663"/>
                  <a:gd name="connsiteX12" fmla="*/ 11211 w 43103"/>
                  <a:gd name="connsiteY12" fmla="*/ 12488 h 63663"/>
                  <a:gd name="connsiteX13" fmla="*/ 8035 w 43103"/>
                  <a:gd name="connsiteY13" fmla="*/ 31995 h 63663"/>
                  <a:gd name="connsiteX14" fmla="*/ 11211 w 43103"/>
                  <a:gd name="connsiteY14" fmla="*/ 51351 h 63663"/>
                  <a:gd name="connsiteX15" fmla="*/ 21495 w 43103"/>
                  <a:gd name="connsiteY15" fmla="*/ 57400 h 63663"/>
                  <a:gd name="connsiteX16" fmla="*/ 31779 w 43103"/>
                  <a:gd name="connsiteY16" fmla="*/ 51200 h 63663"/>
                  <a:gd name="connsiteX17" fmla="*/ 35107 w 43103"/>
                  <a:gd name="connsiteY17" fmla="*/ 31995 h 636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3103" h="63663">
                    <a:moveTo>
                      <a:pt x="43123" y="31995"/>
                    </a:moveTo>
                    <a:cubicBezTo>
                      <a:pt x="43123" y="42391"/>
                      <a:pt x="41232" y="50292"/>
                      <a:pt x="37527" y="55736"/>
                    </a:cubicBezTo>
                    <a:cubicBezTo>
                      <a:pt x="33897" y="61180"/>
                      <a:pt x="28490" y="63902"/>
                      <a:pt x="21344" y="63902"/>
                    </a:cubicBezTo>
                    <a:cubicBezTo>
                      <a:pt x="14273" y="63902"/>
                      <a:pt x="8942" y="61180"/>
                      <a:pt x="5313" y="55736"/>
                    </a:cubicBezTo>
                    <a:cubicBezTo>
                      <a:pt x="1758" y="50292"/>
                      <a:pt x="19" y="42391"/>
                      <a:pt x="19" y="31995"/>
                    </a:cubicBezTo>
                    <a:cubicBezTo>
                      <a:pt x="19" y="21409"/>
                      <a:pt x="1721" y="13508"/>
                      <a:pt x="5161" y="8253"/>
                    </a:cubicBezTo>
                    <a:cubicBezTo>
                      <a:pt x="8678" y="2923"/>
                      <a:pt x="14160" y="239"/>
                      <a:pt x="21646" y="239"/>
                    </a:cubicBezTo>
                    <a:cubicBezTo>
                      <a:pt x="28982" y="239"/>
                      <a:pt x="34388" y="2923"/>
                      <a:pt x="37829" y="8253"/>
                    </a:cubicBezTo>
                    <a:cubicBezTo>
                      <a:pt x="41345" y="13622"/>
                      <a:pt x="43123" y="21523"/>
                      <a:pt x="43123" y="31995"/>
                    </a:cubicBezTo>
                    <a:close/>
                    <a:moveTo>
                      <a:pt x="35107" y="31995"/>
                    </a:moveTo>
                    <a:cubicBezTo>
                      <a:pt x="35107" y="23148"/>
                      <a:pt x="34048" y="16684"/>
                      <a:pt x="31931" y="12639"/>
                    </a:cubicBezTo>
                    <a:cubicBezTo>
                      <a:pt x="29889" y="8631"/>
                      <a:pt x="26486" y="6590"/>
                      <a:pt x="21646" y="6590"/>
                    </a:cubicBezTo>
                    <a:cubicBezTo>
                      <a:pt x="16807" y="6590"/>
                      <a:pt x="13328" y="8556"/>
                      <a:pt x="11211" y="12488"/>
                    </a:cubicBezTo>
                    <a:cubicBezTo>
                      <a:pt x="9094" y="16419"/>
                      <a:pt x="8035" y="22922"/>
                      <a:pt x="8035" y="31995"/>
                    </a:cubicBezTo>
                    <a:cubicBezTo>
                      <a:pt x="8035" y="40765"/>
                      <a:pt x="9094" y="47230"/>
                      <a:pt x="11211" y="51351"/>
                    </a:cubicBezTo>
                    <a:cubicBezTo>
                      <a:pt x="13404" y="55396"/>
                      <a:pt x="16845" y="57400"/>
                      <a:pt x="21495" y="57400"/>
                    </a:cubicBezTo>
                    <a:cubicBezTo>
                      <a:pt x="26221" y="57400"/>
                      <a:pt x="29662" y="55358"/>
                      <a:pt x="31779" y="51200"/>
                    </a:cubicBezTo>
                    <a:cubicBezTo>
                      <a:pt x="33973" y="47079"/>
                      <a:pt x="35107" y="40690"/>
                      <a:pt x="35107" y="31995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86" name="Freeform: Shape 3085">
                <a:extLst>
                  <a:ext uri="{FF2B5EF4-FFF2-40B4-BE49-F238E27FC236}">
                    <a16:creationId xmlns:a16="http://schemas.microsoft.com/office/drawing/2014/main" id="{298F5FE2-458A-5022-327C-3E9B469C92E9}"/>
                  </a:ext>
                </a:extLst>
              </p:cNvPr>
              <p:cNvSpPr/>
              <p:nvPr/>
            </p:nvSpPr>
            <p:spPr>
              <a:xfrm>
                <a:off x="1369697" y="2633739"/>
                <a:ext cx="8620" cy="9677"/>
              </a:xfrm>
              <a:custGeom>
                <a:avLst/>
                <a:gdLst>
                  <a:gd name="connsiteX0" fmla="*/ 24 w 8620"/>
                  <a:gd name="connsiteY0" fmla="*/ 9917 h 9677"/>
                  <a:gd name="connsiteX1" fmla="*/ 24 w 8620"/>
                  <a:gd name="connsiteY1" fmla="*/ 239 h 9677"/>
                  <a:gd name="connsiteX2" fmla="*/ 8645 w 8620"/>
                  <a:gd name="connsiteY2" fmla="*/ 239 h 9677"/>
                  <a:gd name="connsiteX3" fmla="*/ 8645 w 8620"/>
                  <a:gd name="connsiteY3" fmla="*/ 9917 h 96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8620" h="9677">
                    <a:moveTo>
                      <a:pt x="24" y="9917"/>
                    </a:moveTo>
                    <a:lnTo>
                      <a:pt x="24" y="239"/>
                    </a:lnTo>
                    <a:lnTo>
                      <a:pt x="8645" y="239"/>
                    </a:lnTo>
                    <a:lnTo>
                      <a:pt x="8645" y="9917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87" name="Freeform: Shape 3086">
                <a:extLst>
                  <a:ext uri="{FF2B5EF4-FFF2-40B4-BE49-F238E27FC236}">
                    <a16:creationId xmlns:a16="http://schemas.microsoft.com/office/drawing/2014/main" id="{312EC247-3536-EA19-7543-8ECB8C7D942F}"/>
                  </a:ext>
                </a:extLst>
              </p:cNvPr>
              <p:cNvSpPr/>
              <p:nvPr/>
            </p:nvSpPr>
            <p:spPr>
              <a:xfrm>
                <a:off x="1390114" y="2581568"/>
                <a:ext cx="42649" cy="62755"/>
              </a:xfrm>
              <a:custGeom>
                <a:avLst/>
                <a:gdLst>
                  <a:gd name="connsiteX0" fmla="*/ 42677 w 42649"/>
                  <a:gd name="connsiteY0" fmla="*/ 41975 h 62755"/>
                  <a:gd name="connsiteX1" fmla="*/ 36778 w 42649"/>
                  <a:gd name="connsiteY1" fmla="*/ 57399 h 62755"/>
                  <a:gd name="connsiteX2" fmla="*/ 20747 w 42649"/>
                  <a:gd name="connsiteY2" fmla="*/ 62995 h 62755"/>
                  <a:gd name="connsiteX3" fmla="*/ 6681 w 42649"/>
                  <a:gd name="connsiteY3" fmla="*/ 59214 h 62755"/>
                  <a:gd name="connsiteX4" fmla="*/ 27 w 42649"/>
                  <a:gd name="connsiteY4" fmla="*/ 48175 h 62755"/>
                  <a:gd name="connsiteX5" fmla="*/ 8043 w 42649"/>
                  <a:gd name="connsiteY5" fmla="*/ 47268 h 62755"/>
                  <a:gd name="connsiteX6" fmla="*/ 20898 w 42649"/>
                  <a:gd name="connsiteY6" fmla="*/ 56492 h 62755"/>
                  <a:gd name="connsiteX7" fmla="*/ 30880 w 42649"/>
                  <a:gd name="connsiteY7" fmla="*/ 52712 h 62755"/>
                  <a:gd name="connsiteX8" fmla="*/ 34510 w 42649"/>
                  <a:gd name="connsiteY8" fmla="*/ 42126 h 62755"/>
                  <a:gd name="connsiteX9" fmla="*/ 30880 w 42649"/>
                  <a:gd name="connsiteY9" fmla="*/ 32751 h 62755"/>
                  <a:gd name="connsiteX10" fmla="*/ 21049 w 42649"/>
                  <a:gd name="connsiteY10" fmla="*/ 29122 h 62755"/>
                  <a:gd name="connsiteX11" fmla="*/ 15000 w 42649"/>
                  <a:gd name="connsiteY11" fmla="*/ 30180 h 62755"/>
                  <a:gd name="connsiteX12" fmla="*/ 9555 w 42649"/>
                  <a:gd name="connsiteY12" fmla="*/ 33507 h 62755"/>
                  <a:gd name="connsiteX13" fmla="*/ 1842 w 42649"/>
                  <a:gd name="connsiteY13" fmla="*/ 33507 h 62755"/>
                  <a:gd name="connsiteX14" fmla="*/ 3808 w 42649"/>
                  <a:gd name="connsiteY14" fmla="*/ 239 h 62755"/>
                  <a:gd name="connsiteX15" fmla="*/ 39047 w 42649"/>
                  <a:gd name="connsiteY15" fmla="*/ 239 h 62755"/>
                  <a:gd name="connsiteX16" fmla="*/ 39047 w 42649"/>
                  <a:gd name="connsiteY16" fmla="*/ 6892 h 62755"/>
                  <a:gd name="connsiteX17" fmla="*/ 11067 w 42649"/>
                  <a:gd name="connsiteY17" fmla="*/ 6892 h 62755"/>
                  <a:gd name="connsiteX18" fmla="*/ 9857 w 42649"/>
                  <a:gd name="connsiteY18" fmla="*/ 26551 h 62755"/>
                  <a:gd name="connsiteX19" fmla="*/ 22713 w 42649"/>
                  <a:gd name="connsiteY19" fmla="*/ 22619 h 62755"/>
                  <a:gd name="connsiteX20" fmla="*/ 37232 w 42649"/>
                  <a:gd name="connsiteY20" fmla="*/ 28063 h 62755"/>
                  <a:gd name="connsiteX21" fmla="*/ 42677 w 42649"/>
                  <a:gd name="connsiteY21" fmla="*/ 41975 h 627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42649" h="62755">
                    <a:moveTo>
                      <a:pt x="42677" y="41975"/>
                    </a:moveTo>
                    <a:cubicBezTo>
                      <a:pt x="42677" y="48440"/>
                      <a:pt x="40710" y="53581"/>
                      <a:pt x="36778" y="57399"/>
                    </a:cubicBezTo>
                    <a:cubicBezTo>
                      <a:pt x="32922" y="61142"/>
                      <a:pt x="27590" y="62995"/>
                      <a:pt x="20747" y="62995"/>
                    </a:cubicBezTo>
                    <a:cubicBezTo>
                      <a:pt x="14886" y="62995"/>
                      <a:pt x="10198" y="61747"/>
                      <a:pt x="6681" y="59214"/>
                    </a:cubicBezTo>
                    <a:cubicBezTo>
                      <a:pt x="3127" y="56719"/>
                      <a:pt x="934" y="53014"/>
                      <a:pt x="27" y="48175"/>
                    </a:cubicBezTo>
                    <a:lnTo>
                      <a:pt x="8043" y="47268"/>
                    </a:lnTo>
                    <a:cubicBezTo>
                      <a:pt x="9631" y="53430"/>
                      <a:pt x="13941" y="56492"/>
                      <a:pt x="20898" y="56492"/>
                    </a:cubicBezTo>
                    <a:cubicBezTo>
                      <a:pt x="25133" y="56492"/>
                      <a:pt x="28460" y="55245"/>
                      <a:pt x="30880" y="52712"/>
                    </a:cubicBezTo>
                    <a:cubicBezTo>
                      <a:pt x="33300" y="50103"/>
                      <a:pt x="34510" y="46587"/>
                      <a:pt x="34510" y="42126"/>
                    </a:cubicBezTo>
                    <a:cubicBezTo>
                      <a:pt x="34510" y="38195"/>
                      <a:pt x="33300" y="35095"/>
                      <a:pt x="30880" y="32751"/>
                    </a:cubicBezTo>
                    <a:cubicBezTo>
                      <a:pt x="28460" y="30331"/>
                      <a:pt x="25171" y="29122"/>
                      <a:pt x="21049" y="29122"/>
                    </a:cubicBezTo>
                    <a:cubicBezTo>
                      <a:pt x="18932" y="29122"/>
                      <a:pt x="16890" y="29500"/>
                      <a:pt x="15000" y="30180"/>
                    </a:cubicBezTo>
                    <a:cubicBezTo>
                      <a:pt x="13185" y="30785"/>
                      <a:pt x="11370" y="31919"/>
                      <a:pt x="9555" y="33507"/>
                    </a:cubicBezTo>
                    <a:lnTo>
                      <a:pt x="1842" y="33507"/>
                    </a:lnTo>
                    <a:lnTo>
                      <a:pt x="3808" y="239"/>
                    </a:lnTo>
                    <a:lnTo>
                      <a:pt x="39047" y="239"/>
                    </a:lnTo>
                    <a:lnTo>
                      <a:pt x="39047" y="6892"/>
                    </a:lnTo>
                    <a:lnTo>
                      <a:pt x="11067" y="6892"/>
                    </a:lnTo>
                    <a:lnTo>
                      <a:pt x="9857" y="26551"/>
                    </a:lnTo>
                    <a:cubicBezTo>
                      <a:pt x="13260" y="23942"/>
                      <a:pt x="17571" y="22619"/>
                      <a:pt x="22713" y="22619"/>
                    </a:cubicBezTo>
                    <a:cubicBezTo>
                      <a:pt x="28762" y="22619"/>
                      <a:pt x="33602" y="24434"/>
                      <a:pt x="37232" y="28063"/>
                    </a:cubicBezTo>
                    <a:cubicBezTo>
                      <a:pt x="40862" y="31617"/>
                      <a:pt x="42677" y="36229"/>
                      <a:pt x="42677" y="41975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88" name="Freeform: Shape 3087">
                <a:extLst>
                  <a:ext uri="{FF2B5EF4-FFF2-40B4-BE49-F238E27FC236}">
                    <a16:creationId xmlns:a16="http://schemas.microsoft.com/office/drawing/2014/main" id="{42D25BB1-0C7D-E6FF-FBF1-F40E8C5F4583}"/>
                  </a:ext>
                </a:extLst>
              </p:cNvPr>
              <p:cNvSpPr/>
              <p:nvPr/>
            </p:nvSpPr>
            <p:spPr>
              <a:xfrm>
                <a:off x="1440023" y="2580661"/>
                <a:ext cx="43103" cy="63663"/>
              </a:xfrm>
              <a:custGeom>
                <a:avLst/>
                <a:gdLst>
                  <a:gd name="connsiteX0" fmla="*/ 43135 w 43103"/>
                  <a:gd name="connsiteY0" fmla="*/ 31995 h 63663"/>
                  <a:gd name="connsiteX1" fmla="*/ 37540 w 43103"/>
                  <a:gd name="connsiteY1" fmla="*/ 55736 h 63663"/>
                  <a:gd name="connsiteX2" fmla="*/ 21357 w 43103"/>
                  <a:gd name="connsiteY2" fmla="*/ 63902 h 63663"/>
                  <a:gd name="connsiteX3" fmla="*/ 5325 w 43103"/>
                  <a:gd name="connsiteY3" fmla="*/ 55736 h 63663"/>
                  <a:gd name="connsiteX4" fmla="*/ 32 w 43103"/>
                  <a:gd name="connsiteY4" fmla="*/ 31995 h 63663"/>
                  <a:gd name="connsiteX5" fmla="*/ 5174 w 43103"/>
                  <a:gd name="connsiteY5" fmla="*/ 8253 h 63663"/>
                  <a:gd name="connsiteX6" fmla="*/ 21659 w 43103"/>
                  <a:gd name="connsiteY6" fmla="*/ 239 h 63663"/>
                  <a:gd name="connsiteX7" fmla="*/ 37842 w 43103"/>
                  <a:gd name="connsiteY7" fmla="*/ 8253 h 63663"/>
                  <a:gd name="connsiteX8" fmla="*/ 43135 w 43103"/>
                  <a:gd name="connsiteY8" fmla="*/ 31995 h 63663"/>
                  <a:gd name="connsiteX9" fmla="*/ 35120 w 43103"/>
                  <a:gd name="connsiteY9" fmla="*/ 31995 h 63663"/>
                  <a:gd name="connsiteX10" fmla="*/ 31944 w 43103"/>
                  <a:gd name="connsiteY10" fmla="*/ 12639 h 63663"/>
                  <a:gd name="connsiteX11" fmla="*/ 21659 w 43103"/>
                  <a:gd name="connsiteY11" fmla="*/ 6590 h 63663"/>
                  <a:gd name="connsiteX12" fmla="*/ 11224 w 43103"/>
                  <a:gd name="connsiteY12" fmla="*/ 12488 h 63663"/>
                  <a:gd name="connsiteX13" fmla="*/ 8048 w 43103"/>
                  <a:gd name="connsiteY13" fmla="*/ 31995 h 63663"/>
                  <a:gd name="connsiteX14" fmla="*/ 11224 w 43103"/>
                  <a:gd name="connsiteY14" fmla="*/ 51351 h 63663"/>
                  <a:gd name="connsiteX15" fmla="*/ 21508 w 43103"/>
                  <a:gd name="connsiteY15" fmla="*/ 57400 h 63663"/>
                  <a:gd name="connsiteX16" fmla="*/ 31792 w 43103"/>
                  <a:gd name="connsiteY16" fmla="*/ 51200 h 63663"/>
                  <a:gd name="connsiteX17" fmla="*/ 35120 w 43103"/>
                  <a:gd name="connsiteY17" fmla="*/ 31995 h 636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3103" h="63663">
                    <a:moveTo>
                      <a:pt x="43135" y="31995"/>
                    </a:moveTo>
                    <a:cubicBezTo>
                      <a:pt x="43135" y="42391"/>
                      <a:pt x="41245" y="50292"/>
                      <a:pt x="37540" y="55736"/>
                    </a:cubicBezTo>
                    <a:cubicBezTo>
                      <a:pt x="33910" y="61180"/>
                      <a:pt x="28503" y="63902"/>
                      <a:pt x="21357" y="63902"/>
                    </a:cubicBezTo>
                    <a:cubicBezTo>
                      <a:pt x="14286" y="63902"/>
                      <a:pt x="8955" y="61180"/>
                      <a:pt x="5325" y="55736"/>
                    </a:cubicBezTo>
                    <a:cubicBezTo>
                      <a:pt x="1771" y="50292"/>
                      <a:pt x="32" y="42391"/>
                      <a:pt x="32" y="31995"/>
                    </a:cubicBezTo>
                    <a:cubicBezTo>
                      <a:pt x="32" y="21409"/>
                      <a:pt x="1734" y="13508"/>
                      <a:pt x="5174" y="8253"/>
                    </a:cubicBezTo>
                    <a:cubicBezTo>
                      <a:pt x="8691" y="2923"/>
                      <a:pt x="14173" y="239"/>
                      <a:pt x="21659" y="239"/>
                    </a:cubicBezTo>
                    <a:cubicBezTo>
                      <a:pt x="28994" y="239"/>
                      <a:pt x="34401" y="2923"/>
                      <a:pt x="37842" y="8253"/>
                    </a:cubicBezTo>
                    <a:cubicBezTo>
                      <a:pt x="41358" y="13622"/>
                      <a:pt x="43135" y="21523"/>
                      <a:pt x="43135" y="31995"/>
                    </a:cubicBezTo>
                    <a:close/>
                    <a:moveTo>
                      <a:pt x="35120" y="31995"/>
                    </a:moveTo>
                    <a:cubicBezTo>
                      <a:pt x="35120" y="23148"/>
                      <a:pt x="34061" y="16684"/>
                      <a:pt x="31944" y="12639"/>
                    </a:cubicBezTo>
                    <a:cubicBezTo>
                      <a:pt x="29902" y="8631"/>
                      <a:pt x="26499" y="6590"/>
                      <a:pt x="21659" y="6590"/>
                    </a:cubicBezTo>
                    <a:cubicBezTo>
                      <a:pt x="16820" y="6590"/>
                      <a:pt x="13341" y="8556"/>
                      <a:pt x="11224" y="12488"/>
                    </a:cubicBezTo>
                    <a:cubicBezTo>
                      <a:pt x="9106" y="16419"/>
                      <a:pt x="8048" y="22922"/>
                      <a:pt x="8048" y="31995"/>
                    </a:cubicBezTo>
                    <a:cubicBezTo>
                      <a:pt x="8048" y="40765"/>
                      <a:pt x="9106" y="47230"/>
                      <a:pt x="11224" y="51351"/>
                    </a:cubicBezTo>
                    <a:cubicBezTo>
                      <a:pt x="13417" y="55396"/>
                      <a:pt x="16858" y="57400"/>
                      <a:pt x="21508" y="57400"/>
                    </a:cubicBezTo>
                    <a:cubicBezTo>
                      <a:pt x="26234" y="57400"/>
                      <a:pt x="29675" y="55358"/>
                      <a:pt x="31792" y="51200"/>
                    </a:cubicBezTo>
                    <a:cubicBezTo>
                      <a:pt x="33985" y="47079"/>
                      <a:pt x="35120" y="40690"/>
                      <a:pt x="35120" y="31995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</p:grpSp>
        <p:grpSp>
          <p:nvGrpSpPr>
            <p:cNvPr id="3012" name="Content Placeholder 4">
              <a:extLst>
                <a:ext uri="{FF2B5EF4-FFF2-40B4-BE49-F238E27FC236}">
                  <a16:creationId xmlns:a16="http://schemas.microsoft.com/office/drawing/2014/main" id="{0F7D5A64-C7D7-89FE-7291-0D5C4C011015}"/>
                </a:ext>
              </a:extLst>
            </p:cNvPr>
            <p:cNvGrpSpPr/>
            <p:nvPr/>
          </p:nvGrpSpPr>
          <p:grpSpPr>
            <a:xfrm>
              <a:off x="1314948" y="1568217"/>
              <a:ext cx="167876" cy="63663"/>
              <a:chOff x="1314948" y="1568217"/>
              <a:chExt cx="167876" cy="63663"/>
            </a:xfrm>
          </p:grpSpPr>
          <p:sp>
            <p:nvSpPr>
              <p:cNvPr id="3081" name="Freeform: Shape 3080">
                <a:extLst>
                  <a:ext uri="{FF2B5EF4-FFF2-40B4-BE49-F238E27FC236}">
                    <a16:creationId xmlns:a16="http://schemas.microsoft.com/office/drawing/2014/main" id="{64FEB350-EBCC-699B-E0D2-3ACD0AF72400}"/>
                  </a:ext>
                </a:extLst>
              </p:cNvPr>
              <p:cNvSpPr/>
              <p:nvPr/>
            </p:nvSpPr>
            <p:spPr>
              <a:xfrm>
                <a:off x="1314948" y="1568217"/>
                <a:ext cx="43103" cy="63663"/>
              </a:xfrm>
              <a:custGeom>
                <a:avLst/>
                <a:gdLst>
                  <a:gd name="connsiteX0" fmla="*/ 43123 w 43103"/>
                  <a:gd name="connsiteY0" fmla="*/ 31890 h 63663"/>
                  <a:gd name="connsiteX1" fmla="*/ 37527 w 43103"/>
                  <a:gd name="connsiteY1" fmla="*/ 55632 h 63663"/>
                  <a:gd name="connsiteX2" fmla="*/ 21344 w 43103"/>
                  <a:gd name="connsiteY2" fmla="*/ 63797 h 63663"/>
                  <a:gd name="connsiteX3" fmla="*/ 5313 w 43103"/>
                  <a:gd name="connsiteY3" fmla="*/ 55632 h 63663"/>
                  <a:gd name="connsiteX4" fmla="*/ 19 w 43103"/>
                  <a:gd name="connsiteY4" fmla="*/ 31890 h 63663"/>
                  <a:gd name="connsiteX5" fmla="*/ 5161 w 43103"/>
                  <a:gd name="connsiteY5" fmla="*/ 8149 h 63663"/>
                  <a:gd name="connsiteX6" fmla="*/ 21646 w 43103"/>
                  <a:gd name="connsiteY6" fmla="*/ 134 h 63663"/>
                  <a:gd name="connsiteX7" fmla="*/ 37829 w 43103"/>
                  <a:gd name="connsiteY7" fmla="*/ 8149 h 63663"/>
                  <a:gd name="connsiteX8" fmla="*/ 43123 w 43103"/>
                  <a:gd name="connsiteY8" fmla="*/ 31890 h 63663"/>
                  <a:gd name="connsiteX9" fmla="*/ 35107 w 43103"/>
                  <a:gd name="connsiteY9" fmla="*/ 31890 h 63663"/>
                  <a:gd name="connsiteX10" fmla="*/ 31931 w 43103"/>
                  <a:gd name="connsiteY10" fmla="*/ 12534 h 63663"/>
                  <a:gd name="connsiteX11" fmla="*/ 21646 w 43103"/>
                  <a:gd name="connsiteY11" fmla="*/ 6485 h 63663"/>
                  <a:gd name="connsiteX12" fmla="*/ 11211 w 43103"/>
                  <a:gd name="connsiteY12" fmla="*/ 12383 h 63663"/>
                  <a:gd name="connsiteX13" fmla="*/ 8035 w 43103"/>
                  <a:gd name="connsiteY13" fmla="*/ 31890 h 63663"/>
                  <a:gd name="connsiteX14" fmla="*/ 11211 w 43103"/>
                  <a:gd name="connsiteY14" fmla="*/ 51246 h 63663"/>
                  <a:gd name="connsiteX15" fmla="*/ 21495 w 43103"/>
                  <a:gd name="connsiteY15" fmla="*/ 57295 h 63663"/>
                  <a:gd name="connsiteX16" fmla="*/ 31779 w 43103"/>
                  <a:gd name="connsiteY16" fmla="*/ 51095 h 63663"/>
                  <a:gd name="connsiteX17" fmla="*/ 35107 w 43103"/>
                  <a:gd name="connsiteY17" fmla="*/ 31890 h 636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3103" h="63663">
                    <a:moveTo>
                      <a:pt x="43123" y="31890"/>
                    </a:moveTo>
                    <a:cubicBezTo>
                      <a:pt x="43123" y="42286"/>
                      <a:pt x="41232" y="50188"/>
                      <a:pt x="37527" y="55632"/>
                    </a:cubicBezTo>
                    <a:cubicBezTo>
                      <a:pt x="33897" y="61075"/>
                      <a:pt x="28490" y="63797"/>
                      <a:pt x="21344" y="63797"/>
                    </a:cubicBezTo>
                    <a:cubicBezTo>
                      <a:pt x="14273" y="63797"/>
                      <a:pt x="8942" y="61075"/>
                      <a:pt x="5313" y="55632"/>
                    </a:cubicBezTo>
                    <a:cubicBezTo>
                      <a:pt x="1758" y="50188"/>
                      <a:pt x="19" y="42286"/>
                      <a:pt x="19" y="31890"/>
                    </a:cubicBezTo>
                    <a:cubicBezTo>
                      <a:pt x="19" y="21305"/>
                      <a:pt x="1721" y="13404"/>
                      <a:pt x="5161" y="8149"/>
                    </a:cubicBezTo>
                    <a:cubicBezTo>
                      <a:pt x="8678" y="2818"/>
                      <a:pt x="14160" y="134"/>
                      <a:pt x="21646" y="134"/>
                    </a:cubicBezTo>
                    <a:cubicBezTo>
                      <a:pt x="28982" y="134"/>
                      <a:pt x="34388" y="2818"/>
                      <a:pt x="37829" y="8149"/>
                    </a:cubicBezTo>
                    <a:cubicBezTo>
                      <a:pt x="41345" y="13517"/>
                      <a:pt x="43123" y="21418"/>
                      <a:pt x="43123" y="31890"/>
                    </a:cubicBezTo>
                    <a:close/>
                    <a:moveTo>
                      <a:pt x="35107" y="31890"/>
                    </a:moveTo>
                    <a:cubicBezTo>
                      <a:pt x="35107" y="23044"/>
                      <a:pt x="34048" y="16579"/>
                      <a:pt x="31931" y="12534"/>
                    </a:cubicBezTo>
                    <a:cubicBezTo>
                      <a:pt x="29889" y="8527"/>
                      <a:pt x="26486" y="6485"/>
                      <a:pt x="21646" y="6485"/>
                    </a:cubicBezTo>
                    <a:cubicBezTo>
                      <a:pt x="16807" y="6485"/>
                      <a:pt x="13328" y="8451"/>
                      <a:pt x="11211" y="12383"/>
                    </a:cubicBezTo>
                    <a:cubicBezTo>
                      <a:pt x="9094" y="16315"/>
                      <a:pt x="8035" y="22817"/>
                      <a:pt x="8035" y="31890"/>
                    </a:cubicBezTo>
                    <a:cubicBezTo>
                      <a:pt x="8035" y="40661"/>
                      <a:pt x="9094" y="47125"/>
                      <a:pt x="11211" y="51246"/>
                    </a:cubicBezTo>
                    <a:cubicBezTo>
                      <a:pt x="13404" y="55291"/>
                      <a:pt x="16845" y="57295"/>
                      <a:pt x="21495" y="57295"/>
                    </a:cubicBezTo>
                    <a:cubicBezTo>
                      <a:pt x="26221" y="57295"/>
                      <a:pt x="29662" y="55253"/>
                      <a:pt x="31779" y="51095"/>
                    </a:cubicBezTo>
                    <a:cubicBezTo>
                      <a:pt x="33973" y="46974"/>
                      <a:pt x="35107" y="40585"/>
                      <a:pt x="35107" y="31890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82" name="Freeform: Shape 3081">
                <a:extLst>
                  <a:ext uri="{FF2B5EF4-FFF2-40B4-BE49-F238E27FC236}">
                    <a16:creationId xmlns:a16="http://schemas.microsoft.com/office/drawing/2014/main" id="{28DB95C1-44F9-0CD1-3B6E-275F4CA7D394}"/>
                  </a:ext>
                </a:extLst>
              </p:cNvPr>
              <p:cNvSpPr/>
              <p:nvPr/>
            </p:nvSpPr>
            <p:spPr>
              <a:xfrm>
                <a:off x="1369697" y="1621295"/>
                <a:ext cx="8620" cy="9677"/>
              </a:xfrm>
              <a:custGeom>
                <a:avLst/>
                <a:gdLst>
                  <a:gd name="connsiteX0" fmla="*/ 24 w 8620"/>
                  <a:gd name="connsiteY0" fmla="*/ 9812 h 9677"/>
                  <a:gd name="connsiteX1" fmla="*/ 24 w 8620"/>
                  <a:gd name="connsiteY1" fmla="*/ 134 h 9677"/>
                  <a:gd name="connsiteX2" fmla="*/ 8645 w 8620"/>
                  <a:gd name="connsiteY2" fmla="*/ 134 h 9677"/>
                  <a:gd name="connsiteX3" fmla="*/ 8645 w 8620"/>
                  <a:gd name="connsiteY3" fmla="*/ 9812 h 96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8620" h="9677">
                    <a:moveTo>
                      <a:pt x="24" y="9812"/>
                    </a:moveTo>
                    <a:lnTo>
                      <a:pt x="24" y="134"/>
                    </a:lnTo>
                    <a:lnTo>
                      <a:pt x="8645" y="134"/>
                    </a:lnTo>
                    <a:lnTo>
                      <a:pt x="8645" y="9812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83" name="Freeform: Shape 3082">
                <a:extLst>
                  <a:ext uri="{FF2B5EF4-FFF2-40B4-BE49-F238E27FC236}">
                    <a16:creationId xmlns:a16="http://schemas.microsoft.com/office/drawing/2014/main" id="{CC3CE6DC-EF50-EB98-FA03-63CBAD8AA662}"/>
                  </a:ext>
                </a:extLst>
              </p:cNvPr>
              <p:cNvSpPr/>
              <p:nvPr/>
            </p:nvSpPr>
            <p:spPr>
              <a:xfrm>
                <a:off x="1391173" y="1569124"/>
                <a:ext cx="40834" cy="61848"/>
              </a:xfrm>
              <a:custGeom>
                <a:avLst/>
                <a:gdLst>
                  <a:gd name="connsiteX0" fmla="*/ 40862 w 40834"/>
                  <a:gd name="connsiteY0" fmla="*/ 6485 h 61848"/>
                  <a:gd name="connsiteX1" fmla="*/ 27401 w 40834"/>
                  <a:gd name="connsiteY1" fmla="*/ 29319 h 61848"/>
                  <a:gd name="connsiteX2" fmla="*/ 21654 w 40834"/>
                  <a:gd name="connsiteY2" fmla="*/ 45500 h 61848"/>
                  <a:gd name="connsiteX3" fmla="*/ 19688 w 40834"/>
                  <a:gd name="connsiteY3" fmla="*/ 61983 h 61848"/>
                  <a:gd name="connsiteX4" fmla="*/ 11370 w 40834"/>
                  <a:gd name="connsiteY4" fmla="*/ 61983 h 61848"/>
                  <a:gd name="connsiteX5" fmla="*/ 16361 w 40834"/>
                  <a:gd name="connsiteY5" fmla="*/ 37032 h 61848"/>
                  <a:gd name="connsiteX6" fmla="*/ 33148 w 40834"/>
                  <a:gd name="connsiteY6" fmla="*/ 6788 h 61848"/>
                  <a:gd name="connsiteX7" fmla="*/ 27 w 40834"/>
                  <a:gd name="connsiteY7" fmla="*/ 6788 h 61848"/>
                  <a:gd name="connsiteX8" fmla="*/ 27 w 40834"/>
                  <a:gd name="connsiteY8" fmla="*/ 134 h 61848"/>
                  <a:gd name="connsiteX9" fmla="*/ 40862 w 40834"/>
                  <a:gd name="connsiteY9" fmla="*/ 134 h 6184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40834" h="61848">
                    <a:moveTo>
                      <a:pt x="40862" y="6485"/>
                    </a:moveTo>
                    <a:cubicBezTo>
                      <a:pt x="34510" y="16163"/>
                      <a:pt x="30010" y="23800"/>
                      <a:pt x="27401" y="29319"/>
                    </a:cubicBezTo>
                    <a:cubicBezTo>
                      <a:pt x="24868" y="34763"/>
                      <a:pt x="22940" y="40169"/>
                      <a:pt x="21654" y="45500"/>
                    </a:cubicBezTo>
                    <a:cubicBezTo>
                      <a:pt x="20331" y="50755"/>
                      <a:pt x="19688" y="56236"/>
                      <a:pt x="19688" y="61983"/>
                    </a:cubicBezTo>
                    <a:lnTo>
                      <a:pt x="11370" y="61983"/>
                    </a:lnTo>
                    <a:cubicBezTo>
                      <a:pt x="11370" y="54119"/>
                      <a:pt x="13033" y="45802"/>
                      <a:pt x="16361" y="37032"/>
                    </a:cubicBezTo>
                    <a:cubicBezTo>
                      <a:pt x="19764" y="28261"/>
                      <a:pt x="25360" y="18205"/>
                      <a:pt x="33148" y="6788"/>
                    </a:cubicBezTo>
                    <a:lnTo>
                      <a:pt x="27" y="6788"/>
                    </a:lnTo>
                    <a:lnTo>
                      <a:pt x="27" y="134"/>
                    </a:lnTo>
                    <a:lnTo>
                      <a:pt x="40862" y="134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84" name="Freeform: Shape 3083">
                <a:extLst>
                  <a:ext uri="{FF2B5EF4-FFF2-40B4-BE49-F238E27FC236}">
                    <a16:creationId xmlns:a16="http://schemas.microsoft.com/office/drawing/2014/main" id="{77F28F02-BE8B-DEA0-BF83-CA74FF5F6869}"/>
                  </a:ext>
                </a:extLst>
              </p:cNvPr>
              <p:cNvSpPr/>
              <p:nvPr/>
            </p:nvSpPr>
            <p:spPr>
              <a:xfrm>
                <a:off x="1440175" y="1569124"/>
                <a:ext cx="42649" cy="62755"/>
              </a:xfrm>
              <a:custGeom>
                <a:avLst/>
                <a:gdLst>
                  <a:gd name="connsiteX0" fmla="*/ 42682 w 42649"/>
                  <a:gd name="connsiteY0" fmla="*/ 41871 h 62755"/>
                  <a:gd name="connsiteX1" fmla="*/ 36783 w 42649"/>
                  <a:gd name="connsiteY1" fmla="*/ 57295 h 62755"/>
                  <a:gd name="connsiteX2" fmla="*/ 20752 w 42649"/>
                  <a:gd name="connsiteY2" fmla="*/ 62890 h 62755"/>
                  <a:gd name="connsiteX3" fmla="*/ 6687 w 42649"/>
                  <a:gd name="connsiteY3" fmla="*/ 59109 h 62755"/>
                  <a:gd name="connsiteX4" fmla="*/ 32 w 42649"/>
                  <a:gd name="connsiteY4" fmla="*/ 48070 h 62755"/>
                  <a:gd name="connsiteX5" fmla="*/ 8048 w 42649"/>
                  <a:gd name="connsiteY5" fmla="*/ 47163 h 62755"/>
                  <a:gd name="connsiteX6" fmla="*/ 20903 w 42649"/>
                  <a:gd name="connsiteY6" fmla="*/ 56388 h 62755"/>
                  <a:gd name="connsiteX7" fmla="*/ 30885 w 42649"/>
                  <a:gd name="connsiteY7" fmla="*/ 52607 h 62755"/>
                  <a:gd name="connsiteX8" fmla="*/ 34515 w 42649"/>
                  <a:gd name="connsiteY8" fmla="*/ 42022 h 62755"/>
                  <a:gd name="connsiteX9" fmla="*/ 30885 w 42649"/>
                  <a:gd name="connsiteY9" fmla="*/ 32646 h 62755"/>
                  <a:gd name="connsiteX10" fmla="*/ 21054 w 42649"/>
                  <a:gd name="connsiteY10" fmla="*/ 29017 h 62755"/>
                  <a:gd name="connsiteX11" fmla="*/ 15005 w 42649"/>
                  <a:gd name="connsiteY11" fmla="*/ 30075 h 62755"/>
                  <a:gd name="connsiteX12" fmla="*/ 9560 w 42649"/>
                  <a:gd name="connsiteY12" fmla="*/ 33402 h 62755"/>
                  <a:gd name="connsiteX13" fmla="*/ 1847 w 42649"/>
                  <a:gd name="connsiteY13" fmla="*/ 33402 h 62755"/>
                  <a:gd name="connsiteX14" fmla="*/ 3813 w 42649"/>
                  <a:gd name="connsiteY14" fmla="*/ 134 h 62755"/>
                  <a:gd name="connsiteX15" fmla="*/ 39052 w 42649"/>
                  <a:gd name="connsiteY15" fmla="*/ 134 h 62755"/>
                  <a:gd name="connsiteX16" fmla="*/ 39052 w 42649"/>
                  <a:gd name="connsiteY16" fmla="*/ 6788 h 62755"/>
                  <a:gd name="connsiteX17" fmla="*/ 11073 w 42649"/>
                  <a:gd name="connsiteY17" fmla="*/ 6788 h 62755"/>
                  <a:gd name="connsiteX18" fmla="*/ 9863 w 42649"/>
                  <a:gd name="connsiteY18" fmla="*/ 26446 h 62755"/>
                  <a:gd name="connsiteX19" fmla="*/ 22718 w 42649"/>
                  <a:gd name="connsiteY19" fmla="*/ 22515 h 62755"/>
                  <a:gd name="connsiteX20" fmla="*/ 37237 w 42649"/>
                  <a:gd name="connsiteY20" fmla="*/ 27958 h 62755"/>
                  <a:gd name="connsiteX21" fmla="*/ 42682 w 42649"/>
                  <a:gd name="connsiteY21" fmla="*/ 41871 h 627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42649" h="62755">
                    <a:moveTo>
                      <a:pt x="42682" y="41871"/>
                    </a:moveTo>
                    <a:cubicBezTo>
                      <a:pt x="42682" y="48335"/>
                      <a:pt x="40716" y="53477"/>
                      <a:pt x="36783" y="57295"/>
                    </a:cubicBezTo>
                    <a:cubicBezTo>
                      <a:pt x="32927" y="61037"/>
                      <a:pt x="27596" y="62890"/>
                      <a:pt x="20752" y="62890"/>
                    </a:cubicBezTo>
                    <a:cubicBezTo>
                      <a:pt x="14891" y="62890"/>
                      <a:pt x="10203" y="61642"/>
                      <a:pt x="6687" y="59109"/>
                    </a:cubicBezTo>
                    <a:cubicBezTo>
                      <a:pt x="3132" y="56614"/>
                      <a:pt x="939" y="52909"/>
                      <a:pt x="32" y="48070"/>
                    </a:cubicBezTo>
                    <a:lnTo>
                      <a:pt x="8048" y="47163"/>
                    </a:lnTo>
                    <a:cubicBezTo>
                      <a:pt x="9636" y="53325"/>
                      <a:pt x="13946" y="56388"/>
                      <a:pt x="20903" y="56388"/>
                    </a:cubicBezTo>
                    <a:cubicBezTo>
                      <a:pt x="25138" y="56388"/>
                      <a:pt x="28465" y="55140"/>
                      <a:pt x="30885" y="52607"/>
                    </a:cubicBezTo>
                    <a:cubicBezTo>
                      <a:pt x="33305" y="49999"/>
                      <a:pt x="34515" y="46483"/>
                      <a:pt x="34515" y="42022"/>
                    </a:cubicBezTo>
                    <a:cubicBezTo>
                      <a:pt x="34515" y="38090"/>
                      <a:pt x="33305" y="34990"/>
                      <a:pt x="30885" y="32646"/>
                    </a:cubicBezTo>
                    <a:cubicBezTo>
                      <a:pt x="28465" y="30227"/>
                      <a:pt x="25176" y="29017"/>
                      <a:pt x="21054" y="29017"/>
                    </a:cubicBezTo>
                    <a:cubicBezTo>
                      <a:pt x="18937" y="29017"/>
                      <a:pt x="16895" y="29395"/>
                      <a:pt x="15005" y="30075"/>
                    </a:cubicBezTo>
                    <a:cubicBezTo>
                      <a:pt x="13190" y="30680"/>
                      <a:pt x="11375" y="31814"/>
                      <a:pt x="9560" y="33402"/>
                    </a:cubicBezTo>
                    <a:lnTo>
                      <a:pt x="1847" y="33402"/>
                    </a:lnTo>
                    <a:lnTo>
                      <a:pt x="3813" y="134"/>
                    </a:lnTo>
                    <a:lnTo>
                      <a:pt x="39052" y="134"/>
                    </a:lnTo>
                    <a:lnTo>
                      <a:pt x="39052" y="6788"/>
                    </a:lnTo>
                    <a:lnTo>
                      <a:pt x="11073" y="6788"/>
                    </a:lnTo>
                    <a:lnTo>
                      <a:pt x="9863" y="26446"/>
                    </a:lnTo>
                    <a:cubicBezTo>
                      <a:pt x="13266" y="23838"/>
                      <a:pt x="17576" y="22515"/>
                      <a:pt x="22718" y="22515"/>
                    </a:cubicBezTo>
                    <a:cubicBezTo>
                      <a:pt x="28768" y="22515"/>
                      <a:pt x="33607" y="24329"/>
                      <a:pt x="37237" y="27958"/>
                    </a:cubicBezTo>
                    <a:cubicBezTo>
                      <a:pt x="40867" y="31512"/>
                      <a:pt x="42682" y="36124"/>
                      <a:pt x="42682" y="41871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</p:grpSp>
        <p:grpSp>
          <p:nvGrpSpPr>
            <p:cNvPr id="3013" name="Content Placeholder 4">
              <a:extLst>
                <a:ext uri="{FF2B5EF4-FFF2-40B4-BE49-F238E27FC236}">
                  <a16:creationId xmlns:a16="http://schemas.microsoft.com/office/drawing/2014/main" id="{1E568E1A-AEFD-0259-E249-DFA97804D956}"/>
                </a:ext>
              </a:extLst>
            </p:cNvPr>
            <p:cNvGrpSpPr/>
            <p:nvPr/>
          </p:nvGrpSpPr>
          <p:grpSpPr>
            <a:xfrm>
              <a:off x="1318275" y="555766"/>
              <a:ext cx="164851" cy="63663"/>
              <a:chOff x="1318275" y="555766"/>
              <a:chExt cx="164851" cy="63663"/>
            </a:xfrm>
          </p:grpSpPr>
          <p:sp>
            <p:nvSpPr>
              <p:cNvPr id="3077" name="Freeform: Shape 3076">
                <a:extLst>
                  <a:ext uri="{FF2B5EF4-FFF2-40B4-BE49-F238E27FC236}">
                    <a16:creationId xmlns:a16="http://schemas.microsoft.com/office/drawing/2014/main" id="{414B300F-81A8-866B-E437-03A283CA152A}"/>
                  </a:ext>
                </a:extLst>
              </p:cNvPr>
              <p:cNvSpPr/>
              <p:nvPr/>
            </p:nvSpPr>
            <p:spPr>
              <a:xfrm>
                <a:off x="1318275" y="556673"/>
                <a:ext cx="38868" cy="61848"/>
              </a:xfrm>
              <a:custGeom>
                <a:avLst/>
                <a:gdLst>
                  <a:gd name="connsiteX0" fmla="*/ 19 w 38868"/>
                  <a:gd name="connsiteY0" fmla="*/ 61878 h 61848"/>
                  <a:gd name="connsiteX1" fmla="*/ 19 w 38868"/>
                  <a:gd name="connsiteY1" fmla="*/ 55224 h 61848"/>
                  <a:gd name="connsiteX2" fmla="*/ 15899 w 38868"/>
                  <a:gd name="connsiteY2" fmla="*/ 55224 h 61848"/>
                  <a:gd name="connsiteX3" fmla="*/ 15899 w 38868"/>
                  <a:gd name="connsiteY3" fmla="*/ 7590 h 61848"/>
                  <a:gd name="connsiteX4" fmla="*/ 1834 w 38868"/>
                  <a:gd name="connsiteY4" fmla="*/ 17571 h 61848"/>
                  <a:gd name="connsiteX5" fmla="*/ 1834 w 38868"/>
                  <a:gd name="connsiteY5" fmla="*/ 10010 h 61848"/>
                  <a:gd name="connsiteX6" fmla="*/ 16504 w 38868"/>
                  <a:gd name="connsiteY6" fmla="*/ 30 h 61848"/>
                  <a:gd name="connsiteX7" fmla="*/ 23764 w 38868"/>
                  <a:gd name="connsiteY7" fmla="*/ 30 h 61848"/>
                  <a:gd name="connsiteX8" fmla="*/ 23764 w 38868"/>
                  <a:gd name="connsiteY8" fmla="*/ 55224 h 61848"/>
                  <a:gd name="connsiteX9" fmla="*/ 38888 w 38868"/>
                  <a:gd name="connsiteY9" fmla="*/ 55224 h 61848"/>
                  <a:gd name="connsiteX10" fmla="*/ 38888 w 38868"/>
                  <a:gd name="connsiteY10" fmla="*/ 61878 h 6184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38868" h="61848">
                    <a:moveTo>
                      <a:pt x="19" y="61878"/>
                    </a:moveTo>
                    <a:lnTo>
                      <a:pt x="19" y="55224"/>
                    </a:lnTo>
                    <a:lnTo>
                      <a:pt x="15899" y="55224"/>
                    </a:lnTo>
                    <a:lnTo>
                      <a:pt x="15899" y="7590"/>
                    </a:lnTo>
                    <a:lnTo>
                      <a:pt x="1834" y="17571"/>
                    </a:lnTo>
                    <a:lnTo>
                      <a:pt x="1834" y="10010"/>
                    </a:lnTo>
                    <a:lnTo>
                      <a:pt x="16504" y="30"/>
                    </a:lnTo>
                    <a:lnTo>
                      <a:pt x="23764" y="30"/>
                    </a:lnTo>
                    <a:lnTo>
                      <a:pt x="23764" y="55224"/>
                    </a:lnTo>
                    <a:lnTo>
                      <a:pt x="38888" y="55224"/>
                    </a:lnTo>
                    <a:lnTo>
                      <a:pt x="38888" y="61878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78" name="Freeform: Shape 3077">
                <a:extLst>
                  <a:ext uri="{FF2B5EF4-FFF2-40B4-BE49-F238E27FC236}">
                    <a16:creationId xmlns:a16="http://schemas.microsoft.com/office/drawing/2014/main" id="{648F3143-6B71-F1E8-AD04-B26E46122D7C}"/>
                  </a:ext>
                </a:extLst>
              </p:cNvPr>
              <p:cNvSpPr/>
              <p:nvPr/>
            </p:nvSpPr>
            <p:spPr>
              <a:xfrm>
                <a:off x="1369697" y="608844"/>
                <a:ext cx="8620" cy="9677"/>
              </a:xfrm>
              <a:custGeom>
                <a:avLst/>
                <a:gdLst>
                  <a:gd name="connsiteX0" fmla="*/ 24 w 8620"/>
                  <a:gd name="connsiteY0" fmla="*/ 9708 h 9677"/>
                  <a:gd name="connsiteX1" fmla="*/ 24 w 8620"/>
                  <a:gd name="connsiteY1" fmla="*/ 30 h 9677"/>
                  <a:gd name="connsiteX2" fmla="*/ 8645 w 8620"/>
                  <a:gd name="connsiteY2" fmla="*/ 30 h 9677"/>
                  <a:gd name="connsiteX3" fmla="*/ 8645 w 8620"/>
                  <a:gd name="connsiteY3" fmla="*/ 9708 h 96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8620" h="9677">
                    <a:moveTo>
                      <a:pt x="24" y="9708"/>
                    </a:moveTo>
                    <a:lnTo>
                      <a:pt x="24" y="30"/>
                    </a:lnTo>
                    <a:lnTo>
                      <a:pt x="8645" y="30"/>
                    </a:lnTo>
                    <a:lnTo>
                      <a:pt x="8645" y="9708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79" name="Freeform: Shape 3078">
                <a:extLst>
                  <a:ext uri="{FF2B5EF4-FFF2-40B4-BE49-F238E27FC236}">
                    <a16:creationId xmlns:a16="http://schemas.microsoft.com/office/drawing/2014/main" id="{D9FBA819-75F5-519D-5C4F-9B49E72F4D62}"/>
                  </a:ext>
                </a:extLst>
              </p:cNvPr>
              <p:cNvSpPr/>
              <p:nvPr/>
            </p:nvSpPr>
            <p:spPr>
              <a:xfrm>
                <a:off x="1389963" y="555766"/>
                <a:ext cx="43103" cy="63663"/>
              </a:xfrm>
              <a:custGeom>
                <a:avLst/>
                <a:gdLst>
                  <a:gd name="connsiteX0" fmla="*/ 43130 w 43103"/>
                  <a:gd name="connsiteY0" fmla="*/ 31786 h 63663"/>
                  <a:gd name="connsiteX1" fmla="*/ 37534 w 43103"/>
                  <a:gd name="connsiteY1" fmla="*/ 55527 h 63663"/>
                  <a:gd name="connsiteX2" fmla="*/ 21352 w 43103"/>
                  <a:gd name="connsiteY2" fmla="*/ 63693 h 63663"/>
                  <a:gd name="connsiteX3" fmla="*/ 5320 w 43103"/>
                  <a:gd name="connsiteY3" fmla="*/ 55527 h 63663"/>
                  <a:gd name="connsiteX4" fmla="*/ 27 w 43103"/>
                  <a:gd name="connsiteY4" fmla="*/ 31786 h 63663"/>
                  <a:gd name="connsiteX5" fmla="*/ 5169 w 43103"/>
                  <a:gd name="connsiteY5" fmla="*/ 8044 h 63663"/>
                  <a:gd name="connsiteX6" fmla="*/ 21654 w 43103"/>
                  <a:gd name="connsiteY6" fmla="*/ 30 h 63663"/>
                  <a:gd name="connsiteX7" fmla="*/ 37837 w 43103"/>
                  <a:gd name="connsiteY7" fmla="*/ 8044 h 63663"/>
                  <a:gd name="connsiteX8" fmla="*/ 43130 w 43103"/>
                  <a:gd name="connsiteY8" fmla="*/ 31786 h 63663"/>
                  <a:gd name="connsiteX9" fmla="*/ 35115 w 43103"/>
                  <a:gd name="connsiteY9" fmla="*/ 31786 h 63663"/>
                  <a:gd name="connsiteX10" fmla="*/ 31939 w 43103"/>
                  <a:gd name="connsiteY10" fmla="*/ 12430 h 63663"/>
                  <a:gd name="connsiteX11" fmla="*/ 21654 w 43103"/>
                  <a:gd name="connsiteY11" fmla="*/ 6381 h 63663"/>
                  <a:gd name="connsiteX12" fmla="*/ 11219 w 43103"/>
                  <a:gd name="connsiteY12" fmla="*/ 12278 h 63663"/>
                  <a:gd name="connsiteX13" fmla="*/ 8043 w 43103"/>
                  <a:gd name="connsiteY13" fmla="*/ 31786 h 63663"/>
                  <a:gd name="connsiteX14" fmla="*/ 11219 w 43103"/>
                  <a:gd name="connsiteY14" fmla="*/ 51142 h 63663"/>
                  <a:gd name="connsiteX15" fmla="*/ 21503 w 43103"/>
                  <a:gd name="connsiteY15" fmla="*/ 57190 h 63663"/>
                  <a:gd name="connsiteX16" fmla="*/ 31787 w 43103"/>
                  <a:gd name="connsiteY16" fmla="*/ 50990 h 63663"/>
                  <a:gd name="connsiteX17" fmla="*/ 35115 w 43103"/>
                  <a:gd name="connsiteY17" fmla="*/ 31786 h 636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3103" h="63663">
                    <a:moveTo>
                      <a:pt x="43130" y="31786"/>
                    </a:moveTo>
                    <a:cubicBezTo>
                      <a:pt x="43130" y="42182"/>
                      <a:pt x="41240" y="50083"/>
                      <a:pt x="37534" y="55527"/>
                    </a:cubicBezTo>
                    <a:cubicBezTo>
                      <a:pt x="33905" y="60971"/>
                      <a:pt x="28498" y="63693"/>
                      <a:pt x="21352" y="63693"/>
                    </a:cubicBezTo>
                    <a:cubicBezTo>
                      <a:pt x="14281" y="63693"/>
                      <a:pt x="8950" y="60971"/>
                      <a:pt x="5320" y="55527"/>
                    </a:cubicBezTo>
                    <a:cubicBezTo>
                      <a:pt x="1766" y="50083"/>
                      <a:pt x="27" y="42182"/>
                      <a:pt x="27" y="31786"/>
                    </a:cubicBezTo>
                    <a:cubicBezTo>
                      <a:pt x="27" y="21200"/>
                      <a:pt x="1728" y="13299"/>
                      <a:pt x="5169" y="8044"/>
                    </a:cubicBezTo>
                    <a:cubicBezTo>
                      <a:pt x="8685" y="2714"/>
                      <a:pt x="14168" y="30"/>
                      <a:pt x="21654" y="30"/>
                    </a:cubicBezTo>
                    <a:cubicBezTo>
                      <a:pt x="28989" y="30"/>
                      <a:pt x="34396" y="2714"/>
                      <a:pt x="37837" y="8044"/>
                    </a:cubicBezTo>
                    <a:cubicBezTo>
                      <a:pt x="41353" y="13413"/>
                      <a:pt x="43130" y="21314"/>
                      <a:pt x="43130" y="31786"/>
                    </a:cubicBezTo>
                    <a:close/>
                    <a:moveTo>
                      <a:pt x="35115" y="31786"/>
                    </a:moveTo>
                    <a:cubicBezTo>
                      <a:pt x="35115" y="22939"/>
                      <a:pt x="34056" y="16475"/>
                      <a:pt x="31939" y="12430"/>
                    </a:cubicBezTo>
                    <a:cubicBezTo>
                      <a:pt x="29897" y="8422"/>
                      <a:pt x="26494" y="6381"/>
                      <a:pt x="21654" y="6381"/>
                    </a:cubicBezTo>
                    <a:cubicBezTo>
                      <a:pt x="16815" y="6381"/>
                      <a:pt x="13336" y="8347"/>
                      <a:pt x="11219" y="12278"/>
                    </a:cubicBezTo>
                    <a:cubicBezTo>
                      <a:pt x="9101" y="16210"/>
                      <a:pt x="8043" y="22712"/>
                      <a:pt x="8043" y="31786"/>
                    </a:cubicBezTo>
                    <a:cubicBezTo>
                      <a:pt x="8043" y="40556"/>
                      <a:pt x="9101" y="47021"/>
                      <a:pt x="11219" y="51142"/>
                    </a:cubicBezTo>
                    <a:cubicBezTo>
                      <a:pt x="13412" y="55187"/>
                      <a:pt x="16852" y="57190"/>
                      <a:pt x="21503" y="57190"/>
                    </a:cubicBezTo>
                    <a:cubicBezTo>
                      <a:pt x="26229" y="57190"/>
                      <a:pt x="29670" y="55149"/>
                      <a:pt x="31787" y="50990"/>
                    </a:cubicBezTo>
                    <a:cubicBezTo>
                      <a:pt x="33980" y="46870"/>
                      <a:pt x="35115" y="40481"/>
                      <a:pt x="35115" y="31786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80" name="Freeform: Shape 3079">
                <a:extLst>
                  <a:ext uri="{FF2B5EF4-FFF2-40B4-BE49-F238E27FC236}">
                    <a16:creationId xmlns:a16="http://schemas.microsoft.com/office/drawing/2014/main" id="{0D46FBF3-37EF-0B83-EA51-4E0161BB8138}"/>
                  </a:ext>
                </a:extLst>
              </p:cNvPr>
              <p:cNvSpPr/>
              <p:nvPr/>
            </p:nvSpPr>
            <p:spPr>
              <a:xfrm>
                <a:off x="1440023" y="555766"/>
                <a:ext cx="43103" cy="63663"/>
              </a:xfrm>
              <a:custGeom>
                <a:avLst/>
                <a:gdLst>
                  <a:gd name="connsiteX0" fmla="*/ 43135 w 43103"/>
                  <a:gd name="connsiteY0" fmla="*/ 31786 h 63663"/>
                  <a:gd name="connsiteX1" fmla="*/ 37540 w 43103"/>
                  <a:gd name="connsiteY1" fmla="*/ 55527 h 63663"/>
                  <a:gd name="connsiteX2" fmla="*/ 21357 w 43103"/>
                  <a:gd name="connsiteY2" fmla="*/ 63693 h 63663"/>
                  <a:gd name="connsiteX3" fmla="*/ 5325 w 43103"/>
                  <a:gd name="connsiteY3" fmla="*/ 55527 h 63663"/>
                  <a:gd name="connsiteX4" fmla="*/ 32 w 43103"/>
                  <a:gd name="connsiteY4" fmla="*/ 31786 h 63663"/>
                  <a:gd name="connsiteX5" fmla="*/ 5174 w 43103"/>
                  <a:gd name="connsiteY5" fmla="*/ 8044 h 63663"/>
                  <a:gd name="connsiteX6" fmla="*/ 21659 w 43103"/>
                  <a:gd name="connsiteY6" fmla="*/ 30 h 63663"/>
                  <a:gd name="connsiteX7" fmla="*/ 37842 w 43103"/>
                  <a:gd name="connsiteY7" fmla="*/ 8044 h 63663"/>
                  <a:gd name="connsiteX8" fmla="*/ 43135 w 43103"/>
                  <a:gd name="connsiteY8" fmla="*/ 31786 h 63663"/>
                  <a:gd name="connsiteX9" fmla="*/ 35120 w 43103"/>
                  <a:gd name="connsiteY9" fmla="*/ 31786 h 63663"/>
                  <a:gd name="connsiteX10" fmla="*/ 31944 w 43103"/>
                  <a:gd name="connsiteY10" fmla="*/ 12430 h 63663"/>
                  <a:gd name="connsiteX11" fmla="*/ 21659 w 43103"/>
                  <a:gd name="connsiteY11" fmla="*/ 6381 h 63663"/>
                  <a:gd name="connsiteX12" fmla="*/ 11224 w 43103"/>
                  <a:gd name="connsiteY12" fmla="*/ 12278 h 63663"/>
                  <a:gd name="connsiteX13" fmla="*/ 8048 w 43103"/>
                  <a:gd name="connsiteY13" fmla="*/ 31786 h 63663"/>
                  <a:gd name="connsiteX14" fmla="*/ 11224 w 43103"/>
                  <a:gd name="connsiteY14" fmla="*/ 51142 h 63663"/>
                  <a:gd name="connsiteX15" fmla="*/ 21508 w 43103"/>
                  <a:gd name="connsiteY15" fmla="*/ 57190 h 63663"/>
                  <a:gd name="connsiteX16" fmla="*/ 31792 w 43103"/>
                  <a:gd name="connsiteY16" fmla="*/ 50990 h 63663"/>
                  <a:gd name="connsiteX17" fmla="*/ 35120 w 43103"/>
                  <a:gd name="connsiteY17" fmla="*/ 31786 h 636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43103" h="63663">
                    <a:moveTo>
                      <a:pt x="43135" y="31786"/>
                    </a:moveTo>
                    <a:cubicBezTo>
                      <a:pt x="43135" y="42182"/>
                      <a:pt x="41245" y="50083"/>
                      <a:pt x="37540" y="55527"/>
                    </a:cubicBezTo>
                    <a:cubicBezTo>
                      <a:pt x="33910" y="60971"/>
                      <a:pt x="28503" y="63693"/>
                      <a:pt x="21357" y="63693"/>
                    </a:cubicBezTo>
                    <a:cubicBezTo>
                      <a:pt x="14286" y="63693"/>
                      <a:pt x="8955" y="60971"/>
                      <a:pt x="5325" y="55527"/>
                    </a:cubicBezTo>
                    <a:cubicBezTo>
                      <a:pt x="1771" y="50083"/>
                      <a:pt x="32" y="42182"/>
                      <a:pt x="32" y="31786"/>
                    </a:cubicBezTo>
                    <a:cubicBezTo>
                      <a:pt x="32" y="21200"/>
                      <a:pt x="1734" y="13299"/>
                      <a:pt x="5174" y="8044"/>
                    </a:cubicBezTo>
                    <a:cubicBezTo>
                      <a:pt x="8691" y="2714"/>
                      <a:pt x="14173" y="30"/>
                      <a:pt x="21659" y="30"/>
                    </a:cubicBezTo>
                    <a:cubicBezTo>
                      <a:pt x="28994" y="30"/>
                      <a:pt x="34401" y="2714"/>
                      <a:pt x="37842" y="8044"/>
                    </a:cubicBezTo>
                    <a:cubicBezTo>
                      <a:pt x="41358" y="13413"/>
                      <a:pt x="43135" y="21314"/>
                      <a:pt x="43135" y="31786"/>
                    </a:cubicBezTo>
                    <a:close/>
                    <a:moveTo>
                      <a:pt x="35120" y="31786"/>
                    </a:moveTo>
                    <a:cubicBezTo>
                      <a:pt x="35120" y="22939"/>
                      <a:pt x="34061" y="16475"/>
                      <a:pt x="31944" y="12430"/>
                    </a:cubicBezTo>
                    <a:cubicBezTo>
                      <a:pt x="29902" y="8422"/>
                      <a:pt x="26499" y="6381"/>
                      <a:pt x="21659" y="6381"/>
                    </a:cubicBezTo>
                    <a:cubicBezTo>
                      <a:pt x="16820" y="6381"/>
                      <a:pt x="13341" y="8347"/>
                      <a:pt x="11224" y="12278"/>
                    </a:cubicBezTo>
                    <a:cubicBezTo>
                      <a:pt x="9106" y="16210"/>
                      <a:pt x="8048" y="22712"/>
                      <a:pt x="8048" y="31786"/>
                    </a:cubicBezTo>
                    <a:cubicBezTo>
                      <a:pt x="8048" y="40556"/>
                      <a:pt x="9106" y="47021"/>
                      <a:pt x="11224" y="51142"/>
                    </a:cubicBezTo>
                    <a:cubicBezTo>
                      <a:pt x="13417" y="55187"/>
                      <a:pt x="16858" y="57190"/>
                      <a:pt x="21508" y="57190"/>
                    </a:cubicBezTo>
                    <a:cubicBezTo>
                      <a:pt x="26234" y="57190"/>
                      <a:pt x="29675" y="55149"/>
                      <a:pt x="31792" y="50990"/>
                    </a:cubicBezTo>
                    <a:cubicBezTo>
                      <a:pt x="33985" y="46870"/>
                      <a:pt x="35120" y="40481"/>
                      <a:pt x="35120" y="31786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</p:grpSp>
        <p:sp>
          <p:nvSpPr>
            <p:cNvPr id="3014" name="Freeform: Shape 3013">
              <a:extLst>
                <a:ext uri="{FF2B5EF4-FFF2-40B4-BE49-F238E27FC236}">
                  <a16:creationId xmlns:a16="http://schemas.microsoft.com/office/drawing/2014/main" id="{B66BB595-AE89-586F-3523-7183181635A9}"/>
                </a:ext>
              </a:extLst>
            </p:cNvPr>
            <p:cNvSpPr/>
            <p:nvPr/>
          </p:nvSpPr>
          <p:spPr>
            <a:xfrm>
              <a:off x="1507834" y="4637345"/>
              <a:ext cx="26504" cy="9677"/>
            </a:xfrm>
            <a:custGeom>
              <a:avLst/>
              <a:gdLst>
                <a:gd name="connsiteX0" fmla="*/ 0 w 26504"/>
                <a:gd name="connsiteY0" fmla="*/ 0 h 9677"/>
                <a:gd name="connsiteX1" fmla="*/ 26504 w 26504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504" h="9677">
                  <a:moveTo>
                    <a:pt x="0" y="0"/>
                  </a:moveTo>
                  <a:lnTo>
                    <a:pt x="26504" y="0"/>
                  </a:lnTo>
                </a:path>
              </a:pathLst>
            </a:custGeom>
            <a:noFill/>
            <a:ln w="13767" cap="flat">
              <a:solidFill>
                <a:srgbClr val="333333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15" name="Freeform: Shape 3014">
              <a:extLst>
                <a:ext uri="{FF2B5EF4-FFF2-40B4-BE49-F238E27FC236}">
                  <a16:creationId xmlns:a16="http://schemas.microsoft.com/office/drawing/2014/main" id="{89896688-3096-FC3C-5B28-47DD3D0E7A15}"/>
                </a:ext>
              </a:extLst>
            </p:cNvPr>
            <p:cNvSpPr/>
            <p:nvPr/>
          </p:nvSpPr>
          <p:spPr>
            <a:xfrm>
              <a:off x="1507834" y="3624901"/>
              <a:ext cx="26504" cy="9677"/>
            </a:xfrm>
            <a:custGeom>
              <a:avLst/>
              <a:gdLst>
                <a:gd name="connsiteX0" fmla="*/ 0 w 26504"/>
                <a:gd name="connsiteY0" fmla="*/ 0 h 9677"/>
                <a:gd name="connsiteX1" fmla="*/ 26504 w 26504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504" h="9677">
                  <a:moveTo>
                    <a:pt x="0" y="0"/>
                  </a:moveTo>
                  <a:lnTo>
                    <a:pt x="26504" y="0"/>
                  </a:lnTo>
                </a:path>
              </a:pathLst>
            </a:custGeom>
            <a:noFill/>
            <a:ln w="13767" cap="flat">
              <a:solidFill>
                <a:srgbClr val="333333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16" name="Freeform: Shape 3015">
              <a:extLst>
                <a:ext uri="{FF2B5EF4-FFF2-40B4-BE49-F238E27FC236}">
                  <a16:creationId xmlns:a16="http://schemas.microsoft.com/office/drawing/2014/main" id="{929BBF1F-5138-5F45-24FD-808760450D2E}"/>
                </a:ext>
              </a:extLst>
            </p:cNvPr>
            <p:cNvSpPr/>
            <p:nvPr/>
          </p:nvSpPr>
          <p:spPr>
            <a:xfrm>
              <a:off x="1507834" y="2612457"/>
              <a:ext cx="26504" cy="9677"/>
            </a:xfrm>
            <a:custGeom>
              <a:avLst/>
              <a:gdLst>
                <a:gd name="connsiteX0" fmla="*/ 0 w 26504"/>
                <a:gd name="connsiteY0" fmla="*/ 0 h 9677"/>
                <a:gd name="connsiteX1" fmla="*/ 26504 w 26504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504" h="9677">
                  <a:moveTo>
                    <a:pt x="0" y="0"/>
                  </a:moveTo>
                  <a:lnTo>
                    <a:pt x="26504" y="0"/>
                  </a:lnTo>
                </a:path>
              </a:pathLst>
            </a:custGeom>
            <a:noFill/>
            <a:ln w="13767" cap="flat">
              <a:solidFill>
                <a:srgbClr val="333333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17" name="Freeform: Shape 3016">
              <a:extLst>
                <a:ext uri="{FF2B5EF4-FFF2-40B4-BE49-F238E27FC236}">
                  <a16:creationId xmlns:a16="http://schemas.microsoft.com/office/drawing/2014/main" id="{7EA695B7-E5AF-0CE4-7DC3-283DFC10C261}"/>
                </a:ext>
              </a:extLst>
            </p:cNvPr>
            <p:cNvSpPr/>
            <p:nvPr/>
          </p:nvSpPr>
          <p:spPr>
            <a:xfrm>
              <a:off x="1507834" y="1600013"/>
              <a:ext cx="26504" cy="9677"/>
            </a:xfrm>
            <a:custGeom>
              <a:avLst/>
              <a:gdLst>
                <a:gd name="connsiteX0" fmla="*/ 0 w 26504"/>
                <a:gd name="connsiteY0" fmla="*/ 0 h 9677"/>
                <a:gd name="connsiteX1" fmla="*/ 26504 w 26504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504" h="9677">
                  <a:moveTo>
                    <a:pt x="0" y="0"/>
                  </a:moveTo>
                  <a:lnTo>
                    <a:pt x="26504" y="0"/>
                  </a:lnTo>
                </a:path>
              </a:pathLst>
            </a:custGeom>
            <a:noFill/>
            <a:ln w="13767" cap="flat">
              <a:solidFill>
                <a:srgbClr val="333333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18" name="Freeform: Shape 3017">
              <a:extLst>
                <a:ext uri="{FF2B5EF4-FFF2-40B4-BE49-F238E27FC236}">
                  <a16:creationId xmlns:a16="http://schemas.microsoft.com/office/drawing/2014/main" id="{CD0CB6EF-C646-44D9-3788-B7D155B48E31}"/>
                </a:ext>
              </a:extLst>
            </p:cNvPr>
            <p:cNvSpPr/>
            <p:nvPr/>
          </p:nvSpPr>
          <p:spPr>
            <a:xfrm>
              <a:off x="1507834" y="587562"/>
              <a:ext cx="26504" cy="9677"/>
            </a:xfrm>
            <a:custGeom>
              <a:avLst/>
              <a:gdLst>
                <a:gd name="connsiteX0" fmla="*/ 0 w 26504"/>
                <a:gd name="connsiteY0" fmla="*/ 0 h 9677"/>
                <a:gd name="connsiteX1" fmla="*/ 26504 w 26504"/>
                <a:gd name="connsiteY1" fmla="*/ 0 h 9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26504" h="9677">
                  <a:moveTo>
                    <a:pt x="0" y="0"/>
                  </a:moveTo>
                  <a:lnTo>
                    <a:pt x="26504" y="0"/>
                  </a:lnTo>
                </a:path>
              </a:pathLst>
            </a:custGeom>
            <a:noFill/>
            <a:ln w="13767" cap="flat">
              <a:solidFill>
                <a:srgbClr val="333333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en-GB"/>
            </a:p>
          </p:txBody>
        </p:sp>
        <p:grpSp>
          <p:nvGrpSpPr>
            <p:cNvPr id="3019" name="Content Placeholder 4">
              <a:extLst>
                <a:ext uri="{FF2B5EF4-FFF2-40B4-BE49-F238E27FC236}">
                  <a16:creationId xmlns:a16="http://schemas.microsoft.com/office/drawing/2014/main" id="{08FAB395-CEAE-CAB8-CE03-D224882C5EBD}"/>
                </a:ext>
              </a:extLst>
            </p:cNvPr>
            <p:cNvGrpSpPr/>
            <p:nvPr/>
          </p:nvGrpSpPr>
          <p:grpSpPr>
            <a:xfrm>
              <a:off x="1175302" y="2125628"/>
              <a:ext cx="81669" cy="969465"/>
              <a:chOff x="1175302" y="2125628"/>
              <a:chExt cx="81669" cy="969465"/>
            </a:xfrm>
            <a:solidFill>
              <a:srgbClr val="000000"/>
            </a:solidFill>
          </p:grpSpPr>
          <p:sp>
            <p:nvSpPr>
              <p:cNvPr id="3059" name="Freeform: Shape 3058">
                <a:extLst>
                  <a:ext uri="{FF2B5EF4-FFF2-40B4-BE49-F238E27FC236}">
                    <a16:creationId xmlns:a16="http://schemas.microsoft.com/office/drawing/2014/main" id="{D0025083-C954-447C-227A-9F4D901F83D3}"/>
                  </a:ext>
                </a:extLst>
              </p:cNvPr>
              <p:cNvSpPr/>
              <p:nvPr/>
            </p:nvSpPr>
            <p:spPr>
              <a:xfrm>
                <a:off x="1179385" y="3029011"/>
                <a:ext cx="76527" cy="66082"/>
              </a:xfrm>
              <a:custGeom>
                <a:avLst/>
                <a:gdLst>
                  <a:gd name="connsiteX0" fmla="*/ 76541 w 76527"/>
                  <a:gd name="connsiteY0" fmla="*/ 12233 h 66082"/>
                  <a:gd name="connsiteX1" fmla="*/ 44780 w 76527"/>
                  <a:gd name="connsiteY1" fmla="*/ 32042 h 66082"/>
                  <a:gd name="connsiteX2" fmla="*/ 44780 w 76527"/>
                  <a:gd name="connsiteY2" fmla="*/ 55935 h 66082"/>
                  <a:gd name="connsiteX3" fmla="*/ 76541 w 76527"/>
                  <a:gd name="connsiteY3" fmla="*/ 55935 h 66082"/>
                  <a:gd name="connsiteX4" fmla="*/ 76541 w 76527"/>
                  <a:gd name="connsiteY4" fmla="*/ 66369 h 66082"/>
                  <a:gd name="connsiteX5" fmla="*/ 13 w 76527"/>
                  <a:gd name="connsiteY5" fmla="*/ 66369 h 66082"/>
                  <a:gd name="connsiteX6" fmla="*/ 13 w 76527"/>
                  <a:gd name="connsiteY6" fmla="*/ 30228 h 66082"/>
                  <a:gd name="connsiteX7" fmla="*/ 5761 w 76527"/>
                  <a:gd name="connsiteY7" fmla="*/ 10418 h 66082"/>
                  <a:gd name="connsiteX8" fmla="*/ 21792 w 76527"/>
                  <a:gd name="connsiteY8" fmla="*/ 3311 h 66082"/>
                  <a:gd name="connsiteX9" fmla="*/ 36311 w 76527"/>
                  <a:gd name="connsiteY9" fmla="*/ 8301 h 66082"/>
                  <a:gd name="connsiteX10" fmla="*/ 43570 w 76527"/>
                  <a:gd name="connsiteY10" fmla="*/ 21911 h 66082"/>
                  <a:gd name="connsiteX11" fmla="*/ 76541 w 76527"/>
                  <a:gd name="connsiteY11" fmla="*/ 286 h 66082"/>
                  <a:gd name="connsiteX12" fmla="*/ 21943 w 76527"/>
                  <a:gd name="connsiteY12" fmla="*/ 13745 h 66082"/>
                  <a:gd name="connsiteX13" fmla="*/ 11810 w 76527"/>
                  <a:gd name="connsiteY13" fmla="*/ 18281 h 66082"/>
                  <a:gd name="connsiteX14" fmla="*/ 8332 w 76527"/>
                  <a:gd name="connsiteY14" fmla="*/ 31286 h 66082"/>
                  <a:gd name="connsiteX15" fmla="*/ 8332 w 76527"/>
                  <a:gd name="connsiteY15" fmla="*/ 55935 h 66082"/>
                  <a:gd name="connsiteX16" fmla="*/ 36462 w 76527"/>
                  <a:gd name="connsiteY16" fmla="*/ 55935 h 66082"/>
                  <a:gd name="connsiteX17" fmla="*/ 36462 w 76527"/>
                  <a:gd name="connsiteY17" fmla="*/ 30833 h 66082"/>
                  <a:gd name="connsiteX18" fmla="*/ 32681 w 76527"/>
                  <a:gd name="connsiteY18" fmla="*/ 18281 h 66082"/>
                  <a:gd name="connsiteX19" fmla="*/ 21943 w 76527"/>
                  <a:gd name="connsiteY19" fmla="*/ 13745 h 660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</a:cxnLst>
                <a:rect l="l" t="t" r="r" b="b"/>
                <a:pathLst>
                  <a:path w="76527" h="66082">
                    <a:moveTo>
                      <a:pt x="76541" y="12233"/>
                    </a:moveTo>
                    <a:lnTo>
                      <a:pt x="44780" y="32042"/>
                    </a:lnTo>
                    <a:lnTo>
                      <a:pt x="44780" y="55935"/>
                    </a:lnTo>
                    <a:lnTo>
                      <a:pt x="76541" y="55935"/>
                    </a:lnTo>
                    <a:lnTo>
                      <a:pt x="76541" y="66369"/>
                    </a:lnTo>
                    <a:lnTo>
                      <a:pt x="13" y="66369"/>
                    </a:lnTo>
                    <a:lnTo>
                      <a:pt x="13" y="30228"/>
                    </a:lnTo>
                    <a:cubicBezTo>
                      <a:pt x="13" y="21684"/>
                      <a:pt x="1942" y="15068"/>
                      <a:pt x="5761" y="10418"/>
                    </a:cubicBezTo>
                    <a:cubicBezTo>
                      <a:pt x="9617" y="5692"/>
                      <a:pt x="14948" y="3311"/>
                      <a:pt x="21792" y="3311"/>
                    </a:cubicBezTo>
                    <a:cubicBezTo>
                      <a:pt x="27539" y="3311"/>
                      <a:pt x="32379" y="4974"/>
                      <a:pt x="36311" y="8301"/>
                    </a:cubicBezTo>
                    <a:cubicBezTo>
                      <a:pt x="40168" y="11628"/>
                      <a:pt x="42587" y="16164"/>
                      <a:pt x="43570" y="21911"/>
                    </a:cubicBezTo>
                    <a:lnTo>
                      <a:pt x="76541" y="286"/>
                    </a:lnTo>
                    <a:close/>
                    <a:moveTo>
                      <a:pt x="21943" y="13745"/>
                    </a:moveTo>
                    <a:cubicBezTo>
                      <a:pt x="17519" y="13745"/>
                      <a:pt x="14154" y="15257"/>
                      <a:pt x="11810" y="18281"/>
                    </a:cubicBezTo>
                    <a:cubicBezTo>
                      <a:pt x="9504" y="21306"/>
                      <a:pt x="8332" y="25653"/>
                      <a:pt x="8332" y="31286"/>
                    </a:cubicBezTo>
                    <a:lnTo>
                      <a:pt x="8332" y="55935"/>
                    </a:lnTo>
                    <a:lnTo>
                      <a:pt x="36462" y="55935"/>
                    </a:lnTo>
                    <a:lnTo>
                      <a:pt x="36462" y="30833"/>
                    </a:lnTo>
                    <a:cubicBezTo>
                      <a:pt x="36462" y="25389"/>
                      <a:pt x="35215" y="21230"/>
                      <a:pt x="32681" y="18281"/>
                    </a:cubicBezTo>
                    <a:cubicBezTo>
                      <a:pt x="30186" y="15257"/>
                      <a:pt x="26594" y="13745"/>
                      <a:pt x="21943" y="13745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60" name="Freeform: Shape 3059">
                <a:extLst>
                  <a:ext uri="{FF2B5EF4-FFF2-40B4-BE49-F238E27FC236}">
                    <a16:creationId xmlns:a16="http://schemas.microsoft.com/office/drawing/2014/main" id="{7CF916FD-6969-0A64-6885-406203287786}"/>
                  </a:ext>
                </a:extLst>
              </p:cNvPr>
              <p:cNvSpPr/>
              <p:nvPr/>
            </p:nvSpPr>
            <p:spPr>
              <a:xfrm>
                <a:off x="1196022" y="2966714"/>
                <a:ext cx="60949" cy="52321"/>
              </a:xfrm>
              <a:custGeom>
                <a:avLst/>
                <a:gdLst>
                  <a:gd name="connsiteX0" fmla="*/ 32530 w 60949"/>
                  <a:gd name="connsiteY0" fmla="*/ 42317 h 52321"/>
                  <a:gd name="connsiteX1" fmla="*/ 48259 w 60949"/>
                  <a:gd name="connsiteY1" fmla="*/ 38083 h 52321"/>
                  <a:gd name="connsiteX2" fmla="*/ 53704 w 60949"/>
                  <a:gd name="connsiteY2" fmla="*/ 25834 h 52321"/>
                  <a:gd name="connsiteX3" fmla="*/ 51132 w 60949"/>
                  <a:gd name="connsiteY3" fmla="*/ 15702 h 52321"/>
                  <a:gd name="connsiteX4" fmla="*/ 44629 w 60949"/>
                  <a:gd name="connsiteY4" fmla="*/ 10561 h 52321"/>
                  <a:gd name="connsiteX5" fmla="*/ 47049 w 60949"/>
                  <a:gd name="connsiteY5" fmla="*/ 1941 h 52321"/>
                  <a:gd name="connsiteX6" fmla="*/ 60963 w 60949"/>
                  <a:gd name="connsiteY6" fmla="*/ 25834 h 52321"/>
                  <a:gd name="connsiteX7" fmla="*/ 53250 w 60949"/>
                  <a:gd name="connsiteY7" fmla="*/ 45795 h 52321"/>
                  <a:gd name="connsiteX8" fmla="*/ 30110 w 60949"/>
                  <a:gd name="connsiteY8" fmla="*/ 52600 h 52321"/>
                  <a:gd name="connsiteX9" fmla="*/ 7878 w 60949"/>
                  <a:gd name="connsiteY9" fmla="*/ 45795 h 52321"/>
                  <a:gd name="connsiteX10" fmla="*/ 13 w 60949"/>
                  <a:gd name="connsiteY10" fmla="*/ 26288 h 52321"/>
                  <a:gd name="connsiteX11" fmla="*/ 31320 w 60949"/>
                  <a:gd name="connsiteY11" fmla="*/ 278 h 52321"/>
                  <a:gd name="connsiteX12" fmla="*/ 32530 w 60949"/>
                  <a:gd name="connsiteY12" fmla="*/ 278 h 52321"/>
                  <a:gd name="connsiteX13" fmla="*/ 25119 w 60949"/>
                  <a:gd name="connsiteY13" fmla="*/ 10410 h 52321"/>
                  <a:gd name="connsiteX14" fmla="*/ 11508 w 60949"/>
                  <a:gd name="connsiteY14" fmla="*/ 15249 h 52321"/>
                  <a:gd name="connsiteX15" fmla="*/ 7273 w 60949"/>
                  <a:gd name="connsiteY15" fmla="*/ 26439 h 52321"/>
                  <a:gd name="connsiteX16" fmla="*/ 12113 w 60949"/>
                  <a:gd name="connsiteY16" fmla="*/ 37780 h 52321"/>
                  <a:gd name="connsiteX17" fmla="*/ 25119 w 60949"/>
                  <a:gd name="connsiteY17" fmla="*/ 42166 h 5232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60949" h="52321">
                    <a:moveTo>
                      <a:pt x="32530" y="42317"/>
                    </a:moveTo>
                    <a:cubicBezTo>
                      <a:pt x="39298" y="42317"/>
                      <a:pt x="44554" y="40918"/>
                      <a:pt x="48259" y="38083"/>
                    </a:cubicBezTo>
                    <a:cubicBezTo>
                      <a:pt x="51889" y="35285"/>
                      <a:pt x="53704" y="31202"/>
                      <a:pt x="53704" y="25834"/>
                    </a:cubicBezTo>
                    <a:cubicBezTo>
                      <a:pt x="53704" y="21600"/>
                      <a:pt x="52872" y="18235"/>
                      <a:pt x="51132" y="15702"/>
                    </a:cubicBezTo>
                    <a:cubicBezTo>
                      <a:pt x="49431" y="13207"/>
                      <a:pt x="47276" y="11468"/>
                      <a:pt x="44629" y="10561"/>
                    </a:cubicBezTo>
                    <a:lnTo>
                      <a:pt x="47049" y="1941"/>
                    </a:lnTo>
                    <a:cubicBezTo>
                      <a:pt x="56350" y="5495"/>
                      <a:pt x="60963" y="13434"/>
                      <a:pt x="60963" y="25834"/>
                    </a:cubicBezTo>
                    <a:cubicBezTo>
                      <a:pt x="60963" y="34605"/>
                      <a:pt x="58392" y="41258"/>
                      <a:pt x="53250" y="45795"/>
                    </a:cubicBezTo>
                    <a:cubicBezTo>
                      <a:pt x="48032" y="50331"/>
                      <a:pt x="40319" y="52600"/>
                      <a:pt x="30110" y="52600"/>
                    </a:cubicBezTo>
                    <a:cubicBezTo>
                      <a:pt x="20431" y="52600"/>
                      <a:pt x="13020" y="50331"/>
                      <a:pt x="7878" y="45795"/>
                    </a:cubicBezTo>
                    <a:cubicBezTo>
                      <a:pt x="2660" y="41258"/>
                      <a:pt x="13" y="34756"/>
                      <a:pt x="13" y="26288"/>
                    </a:cubicBezTo>
                    <a:cubicBezTo>
                      <a:pt x="13" y="8973"/>
                      <a:pt x="10449" y="278"/>
                      <a:pt x="31320" y="278"/>
                    </a:cubicBezTo>
                    <a:lnTo>
                      <a:pt x="32530" y="278"/>
                    </a:lnTo>
                    <a:close/>
                    <a:moveTo>
                      <a:pt x="25119" y="10410"/>
                    </a:moveTo>
                    <a:cubicBezTo>
                      <a:pt x="18881" y="11015"/>
                      <a:pt x="14343" y="12640"/>
                      <a:pt x="11508" y="15249"/>
                    </a:cubicBezTo>
                    <a:cubicBezTo>
                      <a:pt x="8710" y="17782"/>
                      <a:pt x="7273" y="21524"/>
                      <a:pt x="7273" y="26439"/>
                    </a:cubicBezTo>
                    <a:cubicBezTo>
                      <a:pt x="7273" y="31202"/>
                      <a:pt x="8899" y="34983"/>
                      <a:pt x="12113" y="37780"/>
                    </a:cubicBezTo>
                    <a:cubicBezTo>
                      <a:pt x="15251" y="40502"/>
                      <a:pt x="19599" y="41977"/>
                      <a:pt x="25119" y="42166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61" name="Freeform: Shape 3060">
                <a:extLst>
                  <a:ext uri="{FF2B5EF4-FFF2-40B4-BE49-F238E27FC236}">
                    <a16:creationId xmlns:a16="http://schemas.microsoft.com/office/drawing/2014/main" id="{4EB51ED1-14B4-FD2B-ABBA-91B5AED6EE22}"/>
                  </a:ext>
                </a:extLst>
              </p:cNvPr>
              <p:cNvSpPr/>
              <p:nvPr/>
            </p:nvSpPr>
            <p:spPr>
              <a:xfrm>
                <a:off x="1175302" y="2944632"/>
                <a:ext cx="80610" cy="9677"/>
              </a:xfrm>
              <a:custGeom>
                <a:avLst/>
                <a:gdLst>
                  <a:gd name="connsiteX0" fmla="*/ 80624 w 80610"/>
                  <a:gd name="connsiteY0" fmla="*/ 9950 h 9677"/>
                  <a:gd name="connsiteX1" fmla="*/ 13 w 80610"/>
                  <a:gd name="connsiteY1" fmla="*/ 9950 h 9677"/>
                  <a:gd name="connsiteX2" fmla="*/ 13 w 80610"/>
                  <a:gd name="connsiteY2" fmla="*/ 272 h 9677"/>
                  <a:gd name="connsiteX3" fmla="*/ 80624 w 80610"/>
                  <a:gd name="connsiteY3" fmla="*/ 272 h 967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80610" h="9677">
                    <a:moveTo>
                      <a:pt x="80624" y="9950"/>
                    </a:moveTo>
                    <a:lnTo>
                      <a:pt x="13" y="9950"/>
                    </a:lnTo>
                    <a:lnTo>
                      <a:pt x="13" y="272"/>
                    </a:lnTo>
                    <a:lnTo>
                      <a:pt x="80624" y="272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62" name="Freeform: Shape 3061">
                <a:extLst>
                  <a:ext uri="{FF2B5EF4-FFF2-40B4-BE49-F238E27FC236}">
                    <a16:creationId xmlns:a16="http://schemas.microsoft.com/office/drawing/2014/main" id="{E6CF794F-7E88-EB69-9ADE-89C6C3A392C7}"/>
                  </a:ext>
                </a:extLst>
              </p:cNvPr>
              <p:cNvSpPr/>
              <p:nvPr/>
            </p:nvSpPr>
            <p:spPr>
              <a:xfrm>
                <a:off x="1196022" y="2875218"/>
                <a:ext cx="60949" cy="57160"/>
              </a:xfrm>
              <a:custGeom>
                <a:avLst/>
                <a:gdLst>
                  <a:gd name="connsiteX0" fmla="*/ 60963 w 60949"/>
                  <a:gd name="connsiteY0" fmla="*/ 39586 h 57160"/>
                  <a:gd name="connsiteX1" fmla="*/ 56275 w 60949"/>
                  <a:gd name="connsiteY1" fmla="*/ 53044 h 57160"/>
                  <a:gd name="connsiteX2" fmla="*/ 43419 w 60949"/>
                  <a:gd name="connsiteY2" fmla="*/ 57430 h 57160"/>
                  <a:gd name="connsiteX3" fmla="*/ 29505 w 60949"/>
                  <a:gd name="connsiteY3" fmla="*/ 51381 h 57160"/>
                  <a:gd name="connsiteX4" fmla="*/ 24212 w 60949"/>
                  <a:gd name="connsiteY4" fmla="*/ 32025 h 57160"/>
                  <a:gd name="connsiteX5" fmla="*/ 24061 w 60949"/>
                  <a:gd name="connsiteY5" fmla="*/ 18869 h 57160"/>
                  <a:gd name="connsiteX6" fmla="*/ 20885 w 60949"/>
                  <a:gd name="connsiteY6" fmla="*/ 18869 h 57160"/>
                  <a:gd name="connsiteX7" fmla="*/ 10600 w 60949"/>
                  <a:gd name="connsiteY7" fmla="*/ 21893 h 57160"/>
                  <a:gd name="connsiteX8" fmla="*/ 7424 w 60949"/>
                  <a:gd name="connsiteY8" fmla="*/ 31420 h 57160"/>
                  <a:gd name="connsiteX9" fmla="*/ 9693 w 60949"/>
                  <a:gd name="connsiteY9" fmla="*/ 40947 h 57160"/>
                  <a:gd name="connsiteX10" fmla="*/ 16801 w 60949"/>
                  <a:gd name="connsiteY10" fmla="*/ 44576 h 57160"/>
                  <a:gd name="connsiteX11" fmla="*/ 15894 w 60949"/>
                  <a:gd name="connsiteY11" fmla="*/ 54708 h 57160"/>
                  <a:gd name="connsiteX12" fmla="*/ 13 w 60949"/>
                  <a:gd name="connsiteY12" fmla="*/ 31269 h 57160"/>
                  <a:gd name="connsiteX13" fmla="*/ 5156 w 60949"/>
                  <a:gd name="connsiteY13" fmla="*/ 14484 h 57160"/>
                  <a:gd name="connsiteX14" fmla="*/ 19826 w 60949"/>
                  <a:gd name="connsiteY14" fmla="*/ 8889 h 57160"/>
                  <a:gd name="connsiteX15" fmla="*/ 45083 w 60949"/>
                  <a:gd name="connsiteY15" fmla="*/ 8889 h 57160"/>
                  <a:gd name="connsiteX16" fmla="*/ 51737 w 60949"/>
                  <a:gd name="connsiteY16" fmla="*/ 7830 h 57160"/>
                  <a:gd name="connsiteX17" fmla="*/ 53855 w 60949"/>
                  <a:gd name="connsiteY17" fmla="*/ 3445 h 57160"/>
                  <a:gd name="connsiteX18" fmla="*/ 53552 w 60949"/>
                  <a:gd name="connsiteY18" fmla="*/ 269 h 57160"/>
                  <a:gd name="connsiteX19" fmla="*/ 59602 w 60949"/>
                  <a:gd name="connsiteY19" fmla="*/ 269 h 57160"/>
                  <a:gd name="connsiteX20" fmla="*/ 60509 w 60949"/>
                  <a:gd name="connsiteY20" fmla="*/ 7830 h 57160"/>
                  <a:gd name="connsiteX21" fmla="*/ 57636 w 60949"/>
                  <a:gd name="connsiteY21" fmla="*/ 15693 h 57160"/>
                  <a:gd name="connsiteX22" fmla="*/ 48713 w 60949"/>
                  <a:gd name="connsiteY22" fmla="*/ 18415 h 57160"/>
                  <a:gd name="connsiteX23" fmla="*/ 48713 w 60949"/>
                  <a:gd name="connsiteY23" fmla="*/ 18869 h 57160"/>
                  <a:gd name="connsiteX24" fmla="*/ 58241 w 60949"/>
                  <a:gd name="connsiteY24" fmla="*/ 27489 h 57160"/>
                  <a:gd name="connsiteX25" fmla="*/ 60963 w 60949"/>
                  <a:gd name="connsiteY25" fmla="*/ 39586 h 57160"/>
                  <a:gd name="connsiteX26" fmla="*/ 53704 w 60949"/>
                  <a:gd name="connsiteY26" fmla="*/ 37318 h 57160"/>
                  <a:gd name="connsiteX27" fmla="*/ 51284 w 60949"/>
                  <a:gd name="connsiteY27" fmla="*/ 27942 h 57160"/>
                  <a:gd name="connsiteX28" fmla="*/ 44478 w 60949"/>
                  <a:gd name="connsiteY28" fmla="*/ 21289 h 57160"/>
                  <a:gd name="connsiteX29" fmla="*/ 35706 w 60949"/>
                  <a:gd name="connsiteY29" fmla="*/ 18869 h 57160"/>
                  <a:gd name="connsiteX30" fmla="*/ 30866 w 60949"/>
                  <a:gd name="connsiteY30" fmla="*/ 18869 h 57160"/>
                  <a:gd name="connsiteX31" fmla="*/ 31169 w 60949"/>
                  <a:gd name="connsiteY31" fmla="*/ 29454 h 57160"/>
                  <a:gd name="connsiteX32" fmla="*/ 32530 w 60949"/>
                  <a:gd name="connsiteY32" fmla="*/ 40040 h 57160"/>
                  <a:gd name="connsiteX33" fmla="*/ 36462 w 60949"/>
                  <a:gd name="connsiteY33" fmla="*/ 45484 h 57160"/>
                  <a:gd name="connsiteX34" fmla="*/ 43722 w 60949"/>
                  <a:gd name="connsiteY34" fmla="*/ 47298 h 57160"/>
                  <a:gd name="connsiteX35" fmla="*/ 51132 w 60949"/>
                  <a:gd name="connsiteY35" fmla="*/ 44727 h 57160"/>
                  <a:gd name="connsiteX36" fmla="*/ 53704 w 60949"/>
                  <a:gd name="connsiteY36" fmla="*/ 37318 h 571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</a:cxnLst>
                <a:rect l="l" t="t" r="r" b="b"/>
                <a:pathLst>
                  <a:path w="60949" h="57160">
                    <a:moveTo>
                      <a:pt x="60963" y="39586"/>
                    </a:moveTo>
                    <a:cubicBezTo>
                      <a:pt x="60963" y="45559"/>
                      <a:pt x="59413" y="50020"/>
                      <a:pt x="56275" y="53044"/>
                    </a:cubicBezTo>
                    <a:cubicBezTo>
                      <a:pt x="53174" y="55993"/>
                      <a:pt x="48864" y="57430"/>
                      <a:pt x="43419" y="57430"/>
                    </a:cubicBezTo>
                    <a:cubicBezTo>
                      <a:pt x="37370" y="57430"/>
                      <a:pt x="32757" y="55426"/>
                      <a:pt x="29505" y="51381"/>
                    </a:cubicBezTo>
                    <a:cubicBezTo>
                      <a:pt x="26178" y="47374"/>
                      <a:pt x="24439" y="40909"/>
                      <a:pt x="24212" y="32025"/>
                    </a:cubicBezTo>
                    <a:lnTo>
                      <a:pt x="24061" y="18869"/>
                    </a:lnTo>
                    <a:lnTo>
                      <a:pt x="20885" y="18869"/>
                    </a:lnTo>
                    <a:cubicBezTo>
                      <a:pt x="16045" y="18869"/>
                      <a:pt x="12642" y="19890"/>
                      <a:pt x="10600" y="21893"/>
                    </a:cubicBezTo>
                    <a:cubicBezTo>
                      <a:pt x="8483" y="23935"/>
                      <a:pt x="7424" y="27110"/>
                      <a:pt x="7424" y="31420"/>
                    </a:cubicBezTo>
                    <a:cubicBezTo>
                      <a:pt x="7424" y="35768"/>
                      <a:pt x="8180" y="38943"/>
                      <a:pt x="9693" y="40947"/>
                    </a:cubicBezTo>
                    <a:cubicBezTo>
                      <a:pt x="11205" y="42988"/>
                      <a:pt x="13587" y="44198"/>
                      <a:pt x="16801" y="44576"/>
                    </a:cubicBezTo>
                    <a:lnTo>
                      <a:pt x="15894" y="54708"/>
                    </a:lnTo>
                    <a:cubicBezTo>
                      <a:pt x="5307" y="53120"/>
                      <a:pt x="13" y="45294"/>
                      <a:pt x="13" y="31269"/>
                    </a:cubicBezTo>
                    <a:cubicBezTo>
                      <a:pt x="13" y="23821"/>
                      <a:pt x="1753" y="18226"/>
                      <a:pt x="5156" y="14484"/>
                    </a:cubicBezTo>
                    <a:cubicBezTo>
                      <a:pt x="8483" y="10779"/>
                      <a:pt x="13398" y="8889"/>
                      <a:pt x="19826" y="8889"/>
                    </a:cubicBezTo>
                    <a:lnTo>
                      <a:pt x="45083" y="8889"/>
                    </a:lnTo>
                    <a:cubicBezTo>
                      <a:pt x="48032" y="8889"/>
                      <a:pt x="50225" y="8548"/>
                      <a:pt x="51737" y="7830"/>
                    </a:cubicBezTo>
                    <a:cubicBezTo>
                      <a:pt x="53174" y="7036"/>
                      <a:pt x="53855" y="5562"/>
                      <a:pt x="53855" y="3445"/>
                    </a:cubicBezTo>
                    <a:cubicBezTo>
                      <a:pt x="53855" y="2537"/>
                      <a:pt x="53779" y="1479"/>
                      <a:pt x="53552" y="269"/>
                    </a:cubicBezTo>
                    <a:lnTo>
                      <a:pt x="59602" y="269"/>
                    </a:lnTo>
                    <a:cubicBezTo>
                      <a:pt x="60207" y="2689"/>
                      <a:pt x="60509" y="5221"/>
                      <a:pt x="60509" y="7830"/>
                    </a:cubicBezTo>
                    <a:cubicBezTo>
                      <a:pt x="60509" y="11459"/>
                      <a:pt x="59564" y="14106"/>
                      <a:pt x="57636" y="15693"/>
                    </a:cubicBezTo>
                    <a:cubicBezTo>
                      <a:pt x="55745" y="17319"/>
                      <a:pt x="52758" y="18226"/>
                      <a:pt x="48713" y="18415"/>
                    </a:cubicBezTo>
                    <a:lnTo>
                      <a:pt x="48713" y="18869"/>
                    </a:lnTo>
                    <a:cubicBezTo>
                      <a:pt x="53174" y="21289"/>
                      <a:pt x="56350" y="24162"/>
                      <a:pt x="58241" y="27489"/>
                    </a:cubicBezTo>
                    <a:cubicBezTo>
                      <a:pt x="60056" y="30815"/>
                      <a:pt x="60963" y="34860"/>
                      <a:pt x="60963" y="39586"/>
                    </a:cubicBezTo>
                    <a:close/>
                    <a:moveTo>
                      <a:pt x="53704" y="37318"/>
                    </a:moveTo>
                    <a:cubicBezTo>
                      <a:pt x="53704" y="33802"/>
                      <a:pt x="52910" y="30664"/>
                      <a:pt x="51284" y="27942"/>
                    </a:cubicBezTo>
                    <a:cubicBezTo>
                      <a:pt x="49582" y="25145"/>
                      <a:pt x="47314" y="22914"/>
                      <a:pt x="44478" y="21289"/>
                    </a:cubicBezTo>
                    <a:cubicBezTo>
                      <a:pt x="41680" y="19701"/>
                      <a:pt x="38731" y="18869"/>
                      <a:pt x="35706" y="18869"/>
                    </a:cubicBezTo>
                    <a:lnTo>
                      <a:pt x="30866" y="18869"/>
                    </a:lnTo>
                    <a:lnTo>
                      <a:pt x="31169" y="29454"/>
                    </a:lnTo>
                    <a:cubicBezTo>
                      <a:pt x="31169" y="34104"/>
                      <a:pt x="31622" y="37620"/>
                      <a:pt x="32530" y="40040"/>
                    </a:cubicBezTo>
                    <a:cubicBezTo>
                      <a:pt x="33362" y="42384"/>
                      <a:pt x="34647" y="44198"/>
                      <a:pt x="36462" y="45484"/>
                    </a:cubicBezTo>
                    <a:cubicBezTo>
                      <a:pt x="38277" y="46693"/>
                      <a:pt x="40697" y="47298"/>
                      <a:pt x="43722" y="47298"/>
                    </a:cubicBezTo>
                    <a:cubicBezTo>
                      <a:pt x="46860" y="47298"/>
                      <a:pt x="49318" y="46466"/>
                      <a:pt x="51132" y="44727"/>
                    </a:cubicBezTo>
                    <a:cubicBezTo>
                      <a:pt x="52872" y="43026"/>
                      <a:pt x="53704" y="40569"/>
                      <a:pt x="53704" y="37318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63" name="Freeform: Shape 3062">
                <a:extLst>
                  <a:ext uri="{FF2B5EF4-FFF2-40B4-BE49-F238E27FC236}">
                    <a16:creationId xmlns:a16="http://schemas.microsoft.com/office/drawing/2014/main" id="{FD6F6CAE-D6A7-B3D8-6EAF-7F2757D54CB7}"/>
                  </a:ext>
                </a:extLst>
              </p:cNvPr>
              <p:cNvSpPr/>
              <p:nvPr/>
            </p:nvSpPr>
            <p:spPr>
              <a:xfrm>
                <a:off x="1183922" y="2845132"/>
                <a:ext cx="72897" cy="28429"/>
              </a:xfrm>
              <a:custGeom>
                <a:avLst/>
                <a:gdLst>
                  <a:gd name="connsiteX0" fmla="*/ 71550 w 72897"/>
                  <a:gd name="connsiteY0" fmla="*/ 263 h 28429"/>
                  <a:gd name="connsiteX1" fmla="*/ 72911 w 72897"/>
                  <a:gd name="connsiteY1" fmla="*/ 10092 h 28429"/>
                  <a:gd name="connsiteX2" fmla="*/ 59602 w 72897"/>
                  <a:gd name="connsiteY2" fmla="*/ 21887 h 28429"/>
                  <a:gd name="connsiteX3" fmla="*/ 20280 w 72897"/>
                  <a:gd name="connsiteY3" fmla="*/ 21887 h 28429"/>
                  <a:gd name="connsiteX4" fmla="*/ 20280 w 72897"/>
                  <a:gd name="connsiteY4" fmla="*/ 28692 h 28429"/>
                  <a:gd name="connsiteX5" fmla="*/ 13171 w 72897"/>
                  <a:gd name="connsiteY5" fmla="*/ 28692 h 28429"/>
                  <a:gd name="connsiteX6" fmla="*/ 13171 w 72897"/>
                  <a:gd name="connsiteY6" fmla="*/ 21433 h 28429"/>
                  <a:gd name="connsiteX7" fmla="*/ 13 w 72897"/>
                  <a:gd name="connsiteY7" fmla="*/ 18560 h 28429"/>
                  <a:gd name="connsiteX8" fmla="*/ 13 w 72897"/>
                  <a:gd name="connsiteY8" fmla="*/ 12058 h 28429"/>
                  <a:gd name="connsiteX9" fmla="*/ 13171 w 72897"/>
                  <a:gd name="connsiteY9" fmla="*/ 12058 h 28429"/>
                  <a:gd name="connsiteX10" fmla="*/ 13171 w 72897"/>
                  <a:gd name="connsiteY10" fmla="*/ 1170 h 28429"/>
                  <a:gd name="connsiteX11" fmla="*/ 20280 w 72897"/>
                  <a:gd name="connsiteY11" fmla="*/ 1170 h 28429"/>
                  <a:gd name="connsiteX12" fmla="*/ 20280 w 72897"/>
                  <a:gd name="connsiteY12" fmla="*/ 12058 h 28429"/>
                  <a:gd name="connsiteX13" fmla="*/ 57485 w 72897"/>
                  <a:gd name="connsiteY13" fmla="*/ 12058 h 28429"/>
                  <a:gd name="connsiteX14" fmla="*/ 63383 w 72897"/>
                  <a:gd name="connsiteY14" fmla="*/ 10697 h 28429"/>
                  <a:gd name="connsiteX15" fmla="*/ 65047 w 72897"/>
                  <a:gd name="connsiteY15" fmla="*/ 5858 h 28429"/>
                  <a:gd name="connsiteX16" fmla="*/ 64290 w 72897"/>
                  <a:gd name="connsiteY16" fmla="*/ 263 h 284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</a:cxnLst>
                <a:rect l="l" t="t" r="r" b="b"/>
                <a:pathLst>
                  <a:path w="72897" h="28429">
                    <a:moveTo>
                      <a:pt x="71550" y="263"/>
                    </a:moveTo>
                    <a:cubicBezTo>
                      <a:pt x="72457" y="3514"/>
                      <a:pt x="72911" y="6765"/>
                      <a:pt x="72911" y="10092"/>
                    </a:cubicBezTo>
                    <a:cubicBezTo>
                      <a:pt x="72911" y="17955"/>
                      <a:pt x="68487" y="21887"/>
                      <a:pt x="59602" y="21887"/>
                    </a:cubicBezTo>
                    <a:lnTo>
                      <a:pt x="20280" y="21887"/>
                    </a:lnTo>
                    <a:lnTo>
                      <a:pt x="20280" y="28692"/>
                    </a:lnTo>
                    <a:lnTo>
                      <a:pt x="13171" y="28692"/>
                    </a:lnTo>
                    <a:lnTo>
                      <a:pt x="13171" y="21433"/>
                    </a:lnTo>
                    <a:lnTo>
                      <a:pt x="13" y="18560"/>
                    </a:lnTo>
                    <a:lnTo>
                      <a:pt x="13" y="12058"/>
                    </a:lnTo>
                    <a:lnTo>
                      <a:pt x="13171" y="12058"/>
                    </a:lnTo>
                    <a:lnTo>
                      <a:pt x="13171" y="1170"/>
                    </a:lnTo>
                    <a:lnTo>
                      <a:pt x="20280" y="1170"/>
                    </a:lnTo>
                    <a:lnTo>
                      <a:pt x="20280" y="12058"/>
                    </a:lnTo>
                    <a:lnTo>
                      <a:pt x="57485" y="12058"/>
                    </a:lnTo>
                    <a:cubicBezTo>
                      <a:pt x="60320" y="12058"/>
                      <a:pt x="62286" y="11604"/>
                      <a:pt x="63383" y="10697"/>
                    </a:cubicBezTo>
                    <a:cubicBezTo>
                      <a:pt x="64517" y="9790"/>
                      <a:pt x="65047" y="8202"/>
                      <a:pt x="65047" y="5858"/>
                    </a:cubicBezTo>
                    <a:cubicBezTo>
                      <a:pt x="65047" y="4573"/>
                      <a:pt x="64820" y="2682"/>
                      <a:pt x="64290" y="263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64" name="Freeform: Shape 3063">
                <a:extLst>
                  <a:ext uri="{FF2B5EF4-FFF2-40B4-BE49-F238E27FC236}">
                    <a16:creationId xmlns:a16="http://schemas.microsoft.com/office/drawing/2014/main" id="{2EC73200-62AC-DE40-4201-140907E8F0CC}"/>
                  </a:ext>
                </a:extLst>
              </p:cNvPr>
              <p:cNvSpPr/>
              <p:nvPr/>
            </p:nvSpPr>
            <p:spPr>
              <a:xfrm>
                <a:off x="1175302" y="2827132"/>
                <a:ext cx="80610" cy="9829"/>
              </a:xfrm>
              <a:custGeom>
                <a:avLst/>
                <a:gdLst>
                  <a:gd name="connsiteX0" fmla="*/ 80624 w 80610"/>
                  <a:gd name="connsiteY0" fmla="*/ 10089 h 9829"/>
                  <a:gd name="connsiteX1" fmla="*/ 21792 w 80610"/>
                  <a:gd name="connsiteY1" fmla="*/ 10089 h 9829"/>
                  <a:gd name="connsiteX2" fmla="*/ 21792 w 80610"/>
                  <a:gd name="connsiteY2" fmla="*/ 260 h 9829"/>
                  <a:gd name="connsiteX3" fmla="*/ 80624 w 80610"/>
                  <a:gd name="connsiteY3" fmla="*/ 260 h 9829"/>
                  <a:gd name="connsiteX4" fmla="*/ 9239 w 80610"/>
                  <a:gd name="connsiteY4" fmla="*/ 10089 h 9829"/>
                  <a:gd name="connsiteX5" fmla="*/ 13 w 80610"/>
                  <a:gd name="connsiteY5" fmla="*/ 10089 h 9829"/>
                  <a:gd name="connsiteX6" fmla="*/ 13 w 80610"/>
                  <a:gd name="connsiteY6" fmla="*/ 260 h 9829"/>
                  <a:gd name="connsiteX7" fmla="*/ 9239 w 80610"/>
                  <a:gd name="connsiteY7" fmla="*/ 260 h 98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80610" h="9829">
                    <a:moveTo>
                      <a:pt x="80624" y="10089"/>
                    </a:moveTo>
                    <a:lnTo>
                      <a:pt x="21792" y="10089"/>
                    </a:lnTo>
                    <a:lnTo>
                      <a:pt x="21792" y="260"/>
                    </a:lnTo>
                    <a:lnTo>
                      <a:pt x="80624" y="260"/>
                    </a:lnTo>
                    <a:close/>
                    <a:moveTo>
                      <a:pt x="9239" y="10089"/>
                    </a:moveTo>
                    <a:lnTo>
                      <a:pt x="13" y="10089"/>
                    </a:lnTo>
                    <a:lnTo>
                      <a:pt x="13" y="260"/>
                    </a:lnTo>
                    <a:lnTo>
                      <a:pt x="9239" y="260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65" name="Freeform: Shape 3064">
                <a:extLst>
                  <a:ext uri="{FF2B5EF4-FFF2-40B4-BE49-F238E27FC236}">
                    <a16:creationId xmlns:a16="http://schemas.microsoft.com/office/drawing/2014/main" id="{B515BEAE-4DE1-E42E-1042-D35DBB347B09}"/>
                  </a:ext>
                </a:extLst>
              </p:cNvPr>
              <p:cNvSpPr/>
              <p:nvPr/>
            </p:nvSpPr>
            <p:spPr>
              <a:xfrm>
                <a:off x="1197080" y="2764381"/>
                <a:ext cx="58832" cy="54741"/>
              </a:xfrm>
              <a:custGeom>
                <a:avLst/>
                <a:gdLst>
                  <a:gd name="connsiteX0" fmla="*/ 58846 w 58832"/>
                  <a:gd name="connsiteY0" fmla="*/ 22184 h 54741"/>
                  <a:gd name="connsiteX1" fmla="*/ 58846 w 58832"/>
                  <a:gd name="connsiteY1" fmla="*/ 33676 h 54741"/>
                  <a:gd name="connsiteX2" fmla="*/ 13 w 58832"/>
                  <a:gd name="connsiteY2" fmla="*/ 54998 h 54741"/>
                  <a:gd name="connsiteX3" fmla="*/ 13 w 58832"/>
                  <a:gd name="connsiteY3" fmla="*/ 44564 h 54741"/>
                  <a:gd name="connsiteX4" fmla="*/ 38277 w 58832"/>
                  <a:gd name="connsiteY4" fmla="*/ 31711 h 54741"/>
                  <a:gd name="connsiteX5" fmla="*/ 51132 w 58832"/>
                  <a:gd name="connsiteY5" fmla="*/ 27930 h 54741"/>
                  <a:gd name="connsiteX6" fmla="*/ 44780 w 58832"/>
                  <a:gd name="connsiteY6" fmla="*/ 26115 h 54741"/>
                  <a:gd name="connsiteX7" fmla="*/ 38428 w 58832"/>
                  <a:gd name="connsiteY7" fmla="*/ 23998 h 54741"/>
                  <a:gd name="connsiteX8" fmla="*/ 13 w 58832"/>
                  <a:gd name="connsiteY8" fmla="*/ 10540 h 54741"/>
                  <a:gd name="connsiteX9" fmla="*/ 13 w 58832"/>
                  <a:gd name="connsiteY9" fmla="*/ 257 h 5474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58832" h="54741">
                    <a:moveTo>
                      <a:pt x="58846" y="22184"/>
                    </a:moveTo>
                    <a:lnTo>
                      <a:pt x="58846" y="33676"/>
                    </a:lnTo>
                    <a:lnTo>
                      <a:pt x="13" y="54998"/>
                    </a:lnTo>
                    <a:lnTo>
                      <a:pt x="13" y="44564"/>
                    </a:lnTo>
                    <a:lnTo>
                      <a:pt x="38277" y="31711"/>
                    </a:lnTo>
                    <a:cubicBezTo>
                      <a:pt x="39789" y="31219"/>
                      <a:pt x="44100" y="29971"/>
                      <a:pt x="51132" y="27930"/>
                    </a:cubicBezTo>
                    <a:lnTo>
                      <a:pt x="44780" y="26115"/>
                    </a:lnTo>
                    <a:lnTo>
                      <a:pt x="38428" y="23998"/>
                    </a:lnTo>
                    <a:lnTo>
                      <a:pt x="13" y="10540"/>
                    </a:lnTo>
                    <a:lnTo>
                      <a:pt x="13" y="257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66" name="Freeform: Shape 3065">
                <a:extLst>
                  <a:ext uri="{FF2B5EF4-FFF2-40B4-BE49-F238E27FC236}">
                    <a16:creationId xmlns:a16="http://schemas.microsoft.com/office/drawing/2014/main" id="{EB0C6853-297A-4CC0-A492-455CFC116BD0}"/>
                  </a:ext>
                </a:extLst>
              </p:cNvPr>
              <p:cNvSpPr/>
              <p:nvPr/>
            </p:nvSpPr>
            <p:spPr>
              <a:xfrm>
                <a:off x="1196022" y="2706918"/>
                <a:ext cx="60949" cy="52321"/>
              </a:xfrm>
              <a:custGeom>
                <a:avLst/>
                <a:gdLst>
                  <a:gd name="connsiteX0" fmla="*/ 32530 w 60949"/>
                  <a:gd name="connsiteY0" fmla="*/ 42290 h 52321"/>
                  <a:gd name="connsiteX1" fmla="*/ 48259 w 60949"/>
                  <a:gd name="connsiteY1" fmla="*/ 38056 h 52321"/>
                  <a:gd name="connsiteX2" fmla="*/ 53704 w 60949"/>
                  <a:gd name="connsiteY2" fmla="*/ 25807 h 52321"/>
                  <a:gd name="connsiteX3" fmla="*/ 51132 w 60949"/>
                  <a:gd name="connsiteY3" fmla="*/ 15675 h 52321"/>
                  <a:gd name="connsiteX4" fmla="*/ 44629 w 60949"/>
                  <a:gd name="connsiteY4" fmla="*/ 10534 h 52321"/>
                  <a:gd name="connsiteX5" fmla="*/ 47049 w 60949"/>
                  <a:gd name="connsiteY5" fmla="*/ 1915 h 52321"/>
                  <a:gd name="connsiteX6" fmla="*/ 60963 w 60949"/>
                  <a:gd name="connsiteY6" fmla="*/ 25807 h 52321"/>
                  <a:gd name="connsiteX7" fmla="*/ 53250 w 60949"/>
                  <a:gd name="connsiteY7" fmla="*/ 45768 h 52321"/>
                  <a:gd name="connsiteX8" fmla="*/ 30110 w 60949"/>
                  <a:gd name="connsiteY8" fmla="*/ 52573 h 52321"/>
                  <a:gd name="connsiteX9" fmla="*/ 7878 w 60949"/>
                  <a:gd name="connsiteY9" fmla="*/ 45768 h 52321"/>
                  <a:gd name="connsiteX10" fmla="*/ 13 w 60949"/>
                  <a:gd name="connsiteY10" fmla="*/ 26261 h 52321"/>
                  <a:gd name="connsiteX11" fmla="*/ 31320 w 60949"/>
                  <a:gd name="connsiteY11" fmla="*/ 251 h 52321"/>
                  <a:gd name="connsiteX12" fmla="*/ 32530 w 60949"/>
                  <a:gd name="connsiteY12" fmla="*/ 251 h 52321"/>
                  <a:gd name="connsiteX13" fmla="*/ 25119 w 60949"/>
                  <a:gd name="connsiteY13" fmla="*/ 10383 h 52321"/>
                  <a:gd name="connsiteX14" fmla="*/ 11508 w 60949"/>
                  <a:gd name="connsiteY14" fmla="*/ 15222 h 52321"/>
                  <a:gd name="connsiteX15" fmla="*/ 7273 w 60949"/>
                  <a:gd name="connsiteY15" fmla="*/ 26412 h 52321"/>
                  <a:gd name="connsiteX16" fmla="*/ 12113 w 60949"/>
                  <a:gd name="connsiteY16" fmla="*/ 37754 h 52321"/>
                  <a:gd name="connsiteX17" fmla="*/ 25119 w 60949"/>
                  <a:gd name="connsiteY17" fmla="*/ 42139 h 5232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60949" h="52321">
                    <a:moveTo>
                      <a:pt x="32530" y="42290"/>
                    </a:moveTo>
                    <a:cubicBezTo>
                      <a:pt x="39298" y="42290"/>
                      <a:pt x="44554" y="40891"/>
                      <a:pt x="48259" y="38056"/>
                    </a:cubicBezTo>
                    <a:cubicBezTo>
                      <a:pt x="51889" y="35258"/>
                      <a:pt x="53704" y="31175"/>
                      <a:pt x="53704" y="25807"/>
                    </a:cubicBezTo>
                    <a:cubicBezTo>
                      <a:pt x="53704" y="21573"/>
                      <a:pt x="52872" y="18208"/>
                      <a:pt x="51132" y="15675"/>
                    </a:cubicBezTo>
                    <a:cubicBezTo>
                      <a:pt x="49431" y="13180"/>
                      <a:pt x="47276" y="11441"/>
                      <a:pt x="44629" y="10534"/>
                    </a:cubicBezTo>
                    <a:lnTo>
                      <a:pt x="47049" y="1915"/>
                    </a:lnTo>
                    <a:cubicBezTo>
                      <a:pt x="56350" y="5468"/>
                      <a:pt x="60963" y="13407"/>
                      <a:pt x="60963" y="25807"/>
                    </a:cubicBezTo>
                    <a:cubicBezTo>
                      <a:pt x="60963" y="34578"/>
                      <a:pt x="58392" y="41231"/>
                      <a:pt x="53250" y="45768"/>
                    </a:cubicBezTo>
                    <a:cubicBezTo>
                      <a:pt x="48032" y="50305"/>
                      <a:pt x="40319" y="52573"/>
                      <a:pt x="30110" y="52573"/>
                    </a:cubicBezTo>
                    <a:cubicBezTo>
                      <a:pt x="20431" y="52573"/>
                      <a:pt x="13020" y="50305"/>
                      <a:pt x="7878" y="45768"/>
                    </a:cubicBezTo>
                    <a:cubicBezTo>
                      <a:pt x="2660" y="41231"/>
                      <a:pt x="13" y="34729"/>
                      <a:pt x="13" y="26261"/>
                    </a:cubicBezTo>
                    <a:cubicBezTo>
                      <a:pt x="13" y="8946"/>
                      <a:pt x="10449" y="251"/>
                      <a:pt x="31320" y="251"/>
                    </a:cubicBezTo>
                    <a:lnTo>
                      <a:pt x="32530" y="251"/>
                    </a:lnTo>
                    <a:close/>
                    <a:moveTo>
                      <a:pt x="25119" y="10383"/>
                    </a:moveTo>
                    <a:cubicBezTo>
                      <a:pt x="18881" y="10988"/>
                      <a:pt x="14343" y="12613"/>
                      <a:pt x="11508" y="15222"/>
                    </a:cubicBezTo>
                    <a:cubicBezTo>
                      <a:pt x="8710" y="17755"/>
                      <a:pt x="7273" y="21497"/>
                      <a:pt x="7273" y="26412"/>
                    </a:cubicBezTo>
                    <a:cubicBezTo>
                      <a:pt x="7273" y="31175"/>
                      <a:pt x="8899" y="34956"/>
                      <a:pt x="12113" y="37754"/>
                    </a:cubicBezTo>
                    <a:cubicBezTo>
                      <a:pt x="15251" y="40475"/>
                      <a:pt x="19599" y="41950"/>
                      <a:pt x="25119" y="42139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67" name="Freeform: Shape 3066">
                <a:extLst>
                  <a:ext uri="{FF2B5EF4-FFF2-40B4-BE49-F238E27FC236}">
                    <a16:creationId xmlns:a16="http://schemas.microsoft.com/office/drawing/2014/main" id="{3D00F076-2A2E-FB81-507B-0871B923BDC3}"/>
                  </a:ext>
                </a:extLst>
              </p:cNvPr>
              <p:cNvSpPr/>
              <p:nvPr/>
            </p:nvSpPr>
            <p:spPr>
              <a:xfrm>
                <a:off x="1255913" y="2702075"/>
                <a:ext cx="9679" cy="9677"/>
              </a:xfrm>
              <a:custGeom>
                <a:avLst/>
                <a:gdLst/>
                <a:ahLst/>
                <a:cxnLst/>
                <a:rect l="l" t="t" r="r" b="b"/>
                <a:pathLst>
                  <a:path w="9679" h="9677"/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68" name="Freeform: Shape 3067">
                <a:extLst>
                  <a:ext uri="{FF2B5EF4-FFF2-40B4-BE49-F238E27FC236}">
                    <a16:creationId xmlns:a16="http://schemas.microsoft.com/office/drawing/2014/main" id="{53C5C8E2-4997-22C7-9BDF-866B72D47FB7}"/>
                  </a:ext>
                </a:extLst>
              </p:cNvPr>
              <p:cNvSpPr/>
              <p:nvPr/>
            </p:nvSpPr>
            <p:spPr>
              <a:xfrm>
                <a:off x="1196022" y="2609383"/>
                <a:ext cx="60949" cy="57160"/>
              </a:xfrm>
              <a:custGeom>
                <a:avLst/>
                <a:gdLst>
                  <a:gd name="connsiteX0" fmla="*/ 60963 w 60949"/>
                  <a:gd name="connsiteY0" fmla="*/ 39559 h 57160"/>
                  <a:gd name="connsiteX1" fmla="*/ 56275 w 60949"/>
                  <a:gd name="connsiteY1" fmla="*/ 53017 h 57160"/>
                  <a:gd name="connsiteX2" fmla="*/ 43419 w 60949"/>
                  <a:gd name="connsiteY2" fmla="*/ 57402 h 57160"/>
                  <a:gd name="connsiteX3" fmla="*/ 29505 w 60949"/>
                  <a:gd name="connsiteY3" fmla="*/ 51354 h 57160"/>
                  <a:gd name="connsiteX4" fmla="*/ 24212 w 60949"/>
                  <a:gd name="connsiteY4" fmla="*/ 31998 h 57160"/>
                  <a:gd name="connsiteX5" fmla="*/ 24061 w 60949"/>
                  <a:gd name="connsiteY5" fmla="*/ 18842 h 57160"/>
                  <a:gd name="connsiteX6" fmla="*/ 20885 w 60949"/>
                  <a:gd name="connsiteY6" fmla="*/ 18842 h 57160"/>
                  <a:gd name="connsiteX7" fmla="*/ 10600 w 60949"/>
                  <a:gd name="connsiteY7" fmla="*/ 21866 h 57160"/>
                  <a:gd name="connsiteX8" fmla="*/ 7424 w 60949"/>
                  <a:gd name="connsiteY8" fmla="*/ 31393 h 57160"/>
                  <a:gd name="connsiteX9" fmla="*/ 9693 w 60949"/>
                  <a:gd name="connsiteY9" fmla="*/ 40919 h 57160"/>
                  <a:gd name="connsiteX10" fmla="*/ 16801 w 60949"/>
                  <a:gd name="connsiteY10" fmla="*/ 44549 h 57160"/>
                  <a:gd name="connsiteX11" fmla="*/ 15894 w 60949"/>
                  <a:gd name="connsiteY11" fmla="*/ 54680 h 57160"/>
                  <a:gd name="connsiteX12" fmla="*/ 13 w 60949"/>
                  <a:gd name="connsiteY12" fmla="*/ 31241 h 57160"/>
                  <a:gd name="connsiteX13" fmla="*/ 5156 w 60949"/>
                  <a:gd name="connsiteY13" fmla="*/ 14456 h 57160"/>
                  <a:gd name="connsiteX14" fmla="*/ 19826 w 60949"/>
                  <a:gd name="connsiteY14" fmla="*/ 8861 h 57160"/>
                  <a:gd name="connsiteX15" fmla="*/ 45083 w 60949"/>
                  <a:gd name="connsiteY15" fmla="*/ 8861 h 57160"/>
                  <a:gd name="connsiteX16" fmla="*/ 51737 w 60949"/>
                  <a:gd name="connsiteY16" fmla="*/ 7803 h 57160"/>
                  <a:gd name="connsiteX17" fmla="*/ 53855 w 60949"/>
                  <a:gd name="connsiteY17" fmla="*/ 3417 h 57160"/>
                  <a:gd name="connsiteX18" fmla="*/ 53552 w 60949"/>
                  <a:gd name="connsiteY18" fmla="*/ 242 h 57160"/>
                  <a:gd name="connsiteX19" fmla="*/ 59602 w 60949"/>
                  <a:gd name="connsiteY19" fmla="*/ 242 h 57160"/>
                  <a:gd name="connsiteX20" fmla="*/ 60509 w 60949"/>
                  <a:gd name="connsiteY20" fmla="*/ 7803 h 57160"/>
                  <a:gd name="connsiteX21" fmla="*/ 57636 w 60949"/>
                  <a:gd name="connsiteY21" fmla="*/ 15666 h 57160"/>
                  <a:gd name="connsiteX22" fmla="*/ 48713 w 60949"/>
                  <a:gd name="connsiteY22" fmla="*/ 18388 h 57160"/>
                  <a:gd name="connsiteX23" fmla="*/ 48713 w 60949"/>
                  <a:gd name="connsiteY23" fmla="*/ 18842 h 57160"/>
                  <a:gd name="connsiteX24" fmla="*/ 58241 w 60949"/>
                  <a:gd name="connsiteY24" fmla="*/ 27461 h 57160"/>
                  <a:gd name="connsiteX25" fmla="*/ 60963 w 60949"/>
                  <a:gd name="connsiteY25" fmla="*/ 39559 h 57160"/>
                  <a:gd name="connsiteX26" fmla="*/ 53704 w 60949"/>
                  <a:gd name="connsiteY26" fmla="*/ 37290 h 57160"/>
                  <a:gd name="connsiteX27" fmla="*/ 51284 w 60949"/>
                  <a:gd name="connsiteY27" fmla="*/ 27915 h 57160"/>
                  <a:gd name="connsiteX28" fmla="*/ 44478 w 60949"/>
                  <a:gd name="connsiteY28" fmla="*/ 21261 h 57160"/>
                  <a:gd name="connsiteX29" fmla="*/ 35706 w 60949"/>
                  <a:gd name="connsiteY29" fmla="*/ 18842 h 57160"/>
                  <a:gd name="connsiteX30" fmla="*/ 30866 w 60949"/>
                  <a:gd name="connsiteY30" fmla="*/ 18842 h 57160"/>
                  <a:gd name="connsiteX31" fmla="*/ 31169 w 60949"/>
                  <a:gd name="connsiteY31" fmla="*/ 29427 h 57160"/>
                  <a:gd name="connsiteX32" fmla="*/ 32530 w 60949"/>
                  <a:gd name="connsiteY32" fmla="*/ 40012 h 57160"/>
                  <a:gd name="connsiteX33" fmla="*/ 36462 w 60949"/>
                  <a:gd name="connsiteY33" fmla="*/ 45456 h 57160"/>
                  <a:gd name="connsiteX34" fmla="*/ 43722 w 60949"/>
                  <a:gd name="connsiteY34" fmla="*/ 47271 h 57160"/>
                  <a:gd name="connsiteX35" fmla="*/ 51132 w 60949"/>
                  <a:gd name="connsiteY35" fmla="*/ 44700 h 57160"/>
                  <a:gd name="connsiteX36" fmla="*/ 53704 w 60949"/>
                  <a:gd name="connsiteY36" fmla="*/ 37290 h 571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</a:cxnLst>
                <a:rect l="l" t="t" r="r" b="b"/>
                <a:pathLst>
                  <a:path w="60949" h="57160">
                    <a:moveTo>
                      <a:pt x="60963" y="39559"/>
                    </a:moveTo>
                    <a:cubicBezTo>
                      <a:pt x="60963" y="45532"/>
                      <a:pt x="59413" y="49993"/>
                      <a:pt x="56275" y="53017"/>
                    </a:cubicBezTo>
                    <a:cubicBezTo>
                      <a:pt x="53174" y="55966"/>
                      <a:pt x="48864" y="57402"/>
                      <a:pt x="43419" y="57402"/>
                    </a:cubicBezTo>
                    <a:cubicBezTo>
                      <a:pt x="37370" y="57402"/>
                      <a:pt x="32757" y="55399"/>
                      <a:pt x="29505" y="51354"/>
                    </a:cubicBezTo>
                    <a:cubicBezTo>
                      <a:pt x="26178" y="47346"/>
                      <a:pt x="24439" y="40882"/>
                      <a:pt x="24212" y="31998"/>
                    </a:cubicBezTo>
                    <a:lnTo>
                      <a:pt x="24061" y="18842"/>
                    </a:lnTo>
                    <a:lnTo>
                      <a:pt x="20885" y="18842"/>
                    </a:lnTo>
                    <a:cubicBezTo>
                      <a:pt x="16045" y="18842"/>
                      <a:pt x="12642" y="19862"/>
                      <a:pt x="10600" y="21866"/>
                    </a:cubicBezTo>
                    <a:cubicBezTo>
                      <a:pt x="8483" y="23907"/>
                      <a:pt x="7424" y="27083"/>
                      <a:pt x="7424" y="31393"/>
                    </a:cubicBezTo>
                    <a:cubicBezTo>
                      <a:pt x="7424" y="35740"/>
                      <a:pt x="8180" y="38916"/>
                      <a:pt x="9693" y="40919"/>
                    </a:cubicBezTo>
                    <a:cubicBezTo>
                      <a:pt x="11205" y="42961"/>
                      <a:pt x="13587" y="44171"/>
                      <a:pt x="16801" y="44549"/>
                    </a:cubicBezTo>
                    <a:lnTo>
                      <a:pt x="15894" y="54680"/>
                    </a:lnTo>
                    <a:cubicBezTo>
                      <a:pt x="5307" y="53093"/>
                      <a:pt x="13" y="45267"/>
                      <a:pt x="13" y="31241"/>
                    </a:cubicBezTo>
                    <a:cubicBezTo>
                      <a:pt x="13" y="23794"/>
                      <a:pt x="1753" y="18199"/>
                      <a:pt x="5156" y="14456"/>
                    </a:cubicBezTo>
                    <a:cubicBezTo>
                      <a:pt x="8483" y="10751"/>
                      <a:pt x="13398" y="8861"/>
                      <a:pt x="19826" y="8861"/>
                    </a:cubicBezTo>
                    <a:lnTo>
                      <a:pt x="45083" y="8861"/>
                    </a:lnTo>
                    <a:cubicBezTo>
                      <a:pt x="48032" y="8861"/>
                      <a:pt x="50225" y="8521"/>
                      <a:pt x="51737" y="7803"/>
                    </a:cubicBezTo>
                    <a:cubicBezTo>
                      <a:pt x="53174" y="7009"/>
                      <a:pt x="53855" y="5534"/>
                      <a:pt x="53855" y="3417"/>
                    </a:cubicBezTo>
                    <a:cubicBezTo>
                      <a:pt x="53855" y="2510"/>
                      <a:pt x="53779" y="1451"/>
                      <a:pt x="53552" y="242"/>
                    </a:cubicBezTo>
                    <a:lnTo>
                      <a:pt x="59602" y="242"/>
                    </a:lnTo>
                    <a:cubicBezTo>
                      <a:pt x="60207" y="2661"/>
                      <a:pt x="60509" y="5194"/>
                      <a:pt x="60509" y="7803"/>
                    </a:cubicBezTo>
                    <a:cubicBezTo>
                      <a:pt x="60509" y="11432"/>
                      <a:pt x="59564" y="14078"/>
                      <a:pt x="57636" y="15666"/>
                    </a:cubicBezTo>
                    <a:cubicBezTo>
                      <a:pt x="55745" y="17292"/>
                      <a:pt x="52758" y="18199"/>
                      <a:pt x="48713" y="18388"/>
                    </a:cubicBezTo>
                    <a:lnTo>
                      <a:pt x="48713" y="18842"/>
                    </a:lnTo>
                    <a:cubicBezTo>
                      <a:pt x="53174" y="21261"/>
                      <a:pt x="56350" y="24134"/>
                      <a:pt x="58241" y="27461"/>
                    </a:cubicBezTo>
                    <a:cubicBezTo>
                      <a:pt x="60056" y="30788"/>
                      <a:pt x="60963" y="34833"/>
                      <a:pt x="60963" y="39559"/>
                    </a:cubicBezTo>
                    <a:close/>
                    <a:moveTo>
                      <a:pt x="53704" y="37290"/>
                    </a:moveTo>
                    <a:cubicBezTo>
                      <a:pt x="53704" y="33774"/>
                      <a:pt x="52910" y="30637"/>
                      <a:pt x="51284" y="27915"/>
                    </a:cubicBezTo>
                    <a:cubicBezTo>
                      <a:pt x="49582" y="25117"/>
                      <a:pt x="47314" y="22887"/>
                      <a:pt x="44478" y="21261"/>
                    </a:cubicBezTo>
                    <a:cubicBezTo>
                      <a:pt x="41680" y="19673"/>
                      <a:pt x="38731" y="18842"/>
                      <a:pt x="35706" y="18842"/>
                    </a:cubicBezTo>
                    <a:lnTo>
                      <a:pt x="30866" y="18842"/>
                    </a:lnTo>
                    <a:lnTo>
                      <a:pt x="31169" y="29427"/>
                    </a:lnTo>
                    <a:cubicBezTo>
                      <a:pt x="31169" y="34077"/>
                      <a:pt x="31622" y="37593"/>
                      <a:pt x="32530" y="40012"/>
                    </a:cubicBezTo>
                    <a:cubicBezTo>
                      <a:pt x="33362" y="42356"/>
                      <a:pt x="34647" y="44171"/>
                      <a:pt x="36462" y="45456"/>
                    </a:cubicBezTo>
                    <a:cubicBezTo>
                      <a:pt x="38277" y="46666"/>
                      <a:pt x="40697" y="47271"/>
                      <a:pt x="43722" y="47271"/>
                    </a:cubicBezTo>
                    <a:cubicBezTo>
                      <a:pt x="46860" y="47271"/>
                      <a:pt x="49318" y="46439"/>
                      <a:pt x="51132" y="44700"/>
                    </a:cubicBezTo>
                    <a:cubicBezTo>
                      <a:pt x="52872" y="42999"/>
                      <a:pt x="53704" y="40541"/>
                      <a:pt x="53704" y="37290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69" name="Freeform: Shape 3068">
                <a:extLst>
                  <a:ext uri="{FF2B5EF4-FFF2-40B4-BE49-F238E27FC236}">
                    <a16:creationId xmlns:a16="http://schemas.microsoft.com/office/drawing/2014/main" id="{A10CA434-61DE-504E-6235-12D54341A038}"/>
                  </a:ext>
                </a:extLst>
              </p:cNvPr>
              <p:cNvSpPr/>
              <p:nvPr/>
            </p:nvSpPr>
            <p:spPr>
              <a:xfrm>
                <a:off x="1175302" y="2552219"/>
                <a:ext cx="81669" cy="50053"/>
              </a:xfrm>
              <a:custGeom>
                <a:avLst/>
                <a:gdLst>
                  <a:gd name="connsiteX0" fmla="*/ 50981 w 81669"/>
                  <a:gd name="connsiteY0" fmla="*/ 235 h 50053"/>
                  <a:gd name="connsiteX1" fmla="*/ 81683 w 81669"/>
                  <a:gd name="connsiteY1" fmla="*/ 21860 h 50053"/>
                  <a:gd name="connsiteX2" fmla="*/ 79263 w 81669"/>
                  <a:gd name="connsiteY2" fmla="*/ 32899 h 50053"/>
                  <a:gd name="connsiteX3" fmla="*/ 71550 w 81669"/>
                  <a:gd name="connsiteY3" fmla="*/ 40157 h 50053"/>
                  <a:gd name="connsiteX4" fmla="*/ 76692 w 81669"/>
                  <a:gd name="connsiteY4" fmla="*/ 40459 h 50053"/>
                  <a:gd name="connsiteX5" fmla="*/ 80624 w 81669"/>
                  <a:gd name="connsiteY5" fmla="*/ 40762 h 50053"/>
                  <a:gd name="connsiteX6" fmla="*/ 80624 w 81669"/>
                  <a:gd name="connsiteY6" fmla="*/ 50289 h 50053"/>
                  <a:gd name="connsiteX7" fmla="*/ 68525 w 81669"/>
                  <a:gd name="connsiteY7" fmla="*/ 49835 h 50053"/>
                  <a:gd name="connsiteX8" fmla="*/ 13 w 81669"/>
                  <a:gd name="connsiteY8" fmla="*/ 49835 h 50053"/>
                  <a:gd name="connsiteX9" fmla="*/ 13 w 81669"/>
                  <a:gd name="connsiteY9" fmla="*/ 40157 h 50053"/>
                  <a:gd name="connsiteX10" fmla="*/ 23002 w 81669"/>
                  <a:gd name="connsiteY10" fmla="*/ 40157 h 50053"/>
                  <a:gd name="connsiteX11" fmla="*/ 31320 w 81669"/>
                  <a:gd name="connsiteY11" fmla="*/ 40308 h 50053"/>
                  <a:gd name="connsiteX12" fmla="*/ 31320 w 81669"/>
                  <a:gd name="connsiteY12" fmla="*/ 40157 h 50053"/>
                  <a:gd name="connsiteX13" fmla="*/ 23153 w 81669"/>
                  <a:gd name="connsiteY13" fmla="*/ 32899 h 50053"/>
                  <a:gd name="connsiteX14" fmla="*/ 20733 w 81669"/>
                  <a:gd name="connsiteY14" fmla="*/ 21860 h 50053"/>
                  <a:gd name="connsiteX15" fmla="*/ 28295 w 81669"/>
                  <a:gd name="connsiteY15" fmla="*/ 5528 h 50053"/>
                  <a:gd name="connsiteX16" fmla="*/ 50981 w 81669"/>
                  <a:gd name="connsiteY16" fmla="*/ 235 h 50053"/>
                  <a:gd name="connsiteX17" fmla="*/ 51284 w 81669"/>
                  <a:gd name="connsiteY17" fmla="*/ 10367 h 50053"/>
                  <a:gd name="connsiteX18" fmla="*/ 33589 w 81669"/>
                  <a:gd name="connsiteY18" fmla="*/ 13694 h 50053"/>
                  <a:gd name="connsiteX19" fmla="*/ 28295 w 81669"/>
                  <a:gd name="connsiteY19" fmla="*/ 24279 h 50053"/>
                  <a:gd name="connsiteX20" fmla="*/ 34042 w 81669"/>
                  <a:gd name="connsiteY20" fmla="*/ 36377 h 50053"/>
                  <a:gd name="connsiteX21" fmla="*/ 51889 w 81669"/>
                  <a:gd name="connsiteY21" fmla="*/ 40157 h 50053"/>
                  <a:gd name="connsiteX22" fmla="*/ 68979 w 81669"/>
                  <a:gd name="connsiteY22" fmla="*/ 36528 h 50053"/>
                  <a:gd name="connsiteX23" fmla="*/ 74423 w 81669"/>
                  <a:gd name="connsiteY23" fmla="*/ 24430 h 50053"/>
                  <a:gd name="connsiteX24" fmla="*/ 68979 w 81669"/>
                  <a:gd name="connsiteY24" fmla="*/ 13694 h 50053"/>
                  <a:gd name="connsiteX25" fmla="*/ 51284 w 81669"/>
                  <a:gd name="connsiteY25" fmla="*/ 10367 h 500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</a:cxnLst>
                <a:rect l="l" t="t" r="r" b="b"/>
                <a:pathLst>
                  <a:path w="81669" h="50053">
                    <a:moveTo>
                      <a:pt x="50981" y="235"/>
                    </a:moveTo>
                    <a:cubicBezTo>
                      <a:pt x="71474" y="235"/>
                      <a:pt x="81683" y="7456"/>
                      <a:pt x="81683" y="21860"/>
                    </a:cubicBezTo>
                    <a:cubicBezTo>
                      <a:pt x="81683" y="26321"/>
                      <a:pt x="80851" y="29988"/>
                      <a:pt x="79263" y="32899"/>
                    </a:cubicBezTo>
                    <a:cubicBezTo>
                      <a:pt x="77675" y="35847"/>
                      <a:pt x="75104" y="38267"/>
                      <a:pt x="71550" y="40157"/>
                    </a:cubicBezTo>
                    <a:cubicBezTo>
                      <a:pt x="72684" y="40157"/>
                      <a:pt x="74386" y="40270"/>
                      <a:pt x="76692" y="40459"/>
                    </a:cubicBezTo>
                    <a:cubicBezTo>
                      <a:pt x="78923" y="40573"/>
                      <a:pt x="80246" y="40686"/>
                      <a:pt x="80624" y="40762"/>
                    </a:cubicBezTo>
                    <a:lnTo>
                      <a:pt x="80624" y="50289"/>
                    </a:lnTo>
                    <a:cubicBezTo>
                      <a:pt x="78734" y="49986"/>
                      <a:pt x="74688" y="49835"/>
                      <a:pt x="68525" y="49835"/>
                    </a:cubicBezTo>
                    <a:lnTo>
                      <a:pt x="13" y="49835"/>
                    </a:lnTo>
                    <a:lnTo>
                      <a:pt x="13" y="40157"/>
                    </a:lnTo>
                    <a:lnTo>
                      <a:pt x="23002" y="40157"/>
                    </a:lnTo>
                    <a:cubicBezTo>
                      <a:pt x="25346" y="40157"/>
                      <a:pt x="28106" y="40233"/>
                      <a:pt x="31320" y="40308"/>
                    </a:cubicBezTo>
                    <a:lnTo>
                      <a:pt x="31320" y="40157"/>
                    </a:lnTo>
                    <a:cubicBezTo>
                      <a:pt x="27501" y="38342"/>
                      <a:pt x="24779" y="35923"/>
                      <a:pt x="23153" y="32899"/>
                    </a:cubicBezTo>
                    <a:cubicBezTo>
                      <a:pt x="21565" y="29874"/>
                      <a:pt x="20733" y="26207"/>
                      <a:pt x="20733" y="21860"/>
                    </a:cubicBezTo>
                    <a:cubicBezTo>
                      <a:pt x="20733" y="14412"/>
                      <a:pt x="23267" y="8968"/>
                      <a:pt x="28295" y="5528"/>
                    </a:cubicBezTo>
                    <a:cubicBezTo>
                      <a:pt x="33248" y="2012"/>
                      <a:pt x="40810" y="235"/>
                      <a:pt x="50981" y="235"/>
                    </a:cubicBezTo>
                    <a:close/>
                    <a:moveTo>
                      <a:pt x="51284" y="10367"/>
                    </a:moveTo>
                    <a:cubicBezTo>
                      <a:pt x="43041" y="10367"/>
                      <a:pt x="37143" y="11501"/>
                      <a:pt x="33589" y="13694"/>
                    </a:cubicBezTo>
                    <a:cubicBezTo>
                      <a:pt x="30072" y="15924"/>
                      <a:pt x="28295" y="19440"/>
                      <a:pt x="28295" y="24279"/>
                    </a:cubicBezTo>
                    <a:cubicBezTo>
                      <a:pt x="28295" y="29836"/>
                      <a:pt x="30224" y="33881"/>
                      <a:pt x="34042" y="36377"/>
                    </a:cubicBezTo>
                    <a:cubicBezTo>
                      <a:pt x="37786" y="38909"/>
                      <a:pt x="43722" y="40157"/>
                      <a:pt x="51889" y="40157"/>
                    </a:cubicBezTo>
                    <a:cubicBezTo>
                      <a:pt x="59564" y="40157"/>
                      <a:pt x="65273" y="38947"/>
                      <a:pt x="68979" y="36528"/>
                    </a:cubicBezTo>
                    <a:cubicBezTo>
                      <a:pt x="72609" y="34033"/>
                      <a:pt x="74423" y="29988"/>
                      <a:pt x="74423" y="24430"/>
                    </a:cubicBezTo>
                    <a:cubicBezTo>
                      <a:pt x="74423" y="19516"/>
                      <a:pt x="72609" y="15924"/>
                      <a:pt x="68979" y="13694"/>
                    </a:cubicBezTo>
                    <a:cubicBezTo>
                      <a:pt x="65349" y="11501"/>
                      <a:pt x="59451" y="10367"/>
                      <a:pt x="51284" y="10367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70" name="Freeform: Shape 3069">
                <a:extLst>
                  <a:ext uri="{FF2B5EF4-FFF2-40B4-BE49-F238E27FC236}">
                    <a16:creationId xmlns:a16="http://schemas.microsoft.com/office/drawing/2014/main" id="{6E8ECF34-8764-CAA3-76D8-DEA33905E95E}"/>
                  </a:ext>
                </a:extLst>
              </p:cNvPr>
              <p:cNvSpPr/>
              <p:nvPr/>
            </p:nvSpPr>
            <p:spPr>
              <a:xfrm>
                <a:off x="1197080" y="2493088"/>
                <a:ext cx="59890" cy="47180"/>
              </a:xfrm>
              <a:custGeom>
                <a:avLst/>
                <a:gdLst>
                  <a:gd name="connsiteX0" fmla="*/ 13 w 59890"/>
                  <a:gd name="connsiteY0" fmla="*/ 37580 h 47180"/>
                  <a:gd name="connsiteX1" fmla="*/ 37370 w 59890"/>
                  <a:gd name="connsiteY1" fmla="*/ 37580 h 47180"/>
                  <a:gd name="connsiteX2" fmla="*/ 46444 w 59890"/>
                  <a:gd name="connsiteY2" fmla="*/ 36521 h 47180"/>
                  <a:gd name="connsiteX3" fmla="*/ 50981 w 59890"/>
                  <a:gd name="connsiteY3" fmla="*/ 32892 h 47180"/>
                  <a:gd name="connsiteX4" fmla="*/ 52342 w 59890"/>
                  <a:gd name="connsiteY4" fmla="*/ 25482 h 47180"/>
                  <a:gd name="connsiteX5" fmla="*/ 47503 w 59890"/>
                  <a:gd name="connsiteY5" fmla="*/ 14292 h 47180"/>
                  <a:gd name="connsiteX6" fmla="*/ 34042 w 59890"/>
                  <a:gd name="connsiteY6" fmla="*/ 10209 h 47180"/>
                  <a:gd name="connsiteX7" fmla="*/ 13 w 59890"/>
                  <a:gd name="connsiteY7" fmla="*/ 10209 h 47180"/>
                  <a:gd name="connsiteX8" fmla="*/ 13 w 59890"/>
                  <a:gd name="connsiteY8" fmla="*/ 531 h 47180"/>
                  <a:gd name="connsiteX9" fmla="*/ 46293 w 59890"/>
                  <a:gd name="connsiteY9" fmla="*/ 531 h 47180"/>
                  <a:gd name="connsiteX10" fmla="*/ 58846 w 59890"/>
                  <a:gd name="connsiteY10" fmla="*/ 229 h 47180"/>
                  <a:gd name="connsiteX11" fmla="*/ 58846 w 59890"/>
                  <a:gd name="connsiteY11" fmla="*/ 9453 h 47180"/>
                  <a:gd name="connsiteX12" fmla="*/ 57333 w 59890"/>
                  <a:gd name="connsiteY12" fmla="*/ 9604 h 47180"/>
                  <a:gd name="connsiteX13" fmla="*/ 54611 w 59890"/>
                  <a:gd name="connsiteY13" fmla="*/ 9756 h 47180"/>
                  <a:gd name="connsiteX14" fmla="*/ 48864 w 59890"/>
                  <a:gd name="connsiteY14" fmla="*/ 9907 h 47180"/>
                  <a:gd name="connsiteX15" fmla="*/ 48864 w 59890"/>
                  <a:gd name="connsiteY15" fmla="*/ 10058 h 47180"/>
                  <a:gd name="connsiteX16" fmla="*/ 57485 w 59890"/>
                  <a:gd name="connsiteY16" fmla="*/ 17770 h 47180"/>
                  <a:gd name="connsiteX17" fmla="*/ 59904 w 59890"/>
                  <a:gd name="connsiteY17" fmla="*/ 28809 h 47180"/>
                  <a:gd name="connsiteX18" fmla="*/ 55216 w 59890"/>
                  <a:gd name="connsiteY18" fmla="*/ 43024 h 47180"/>
                  <a:gd name="connsiteX19" fmla="*/ 39184 w 59890"/>
                  <a:gd name="connsiteY19" fmla="*/ 47409 h 47180"/>
                  <a:gd name="connsiteX20" fmla="*/ 13 w 59890"/>
                  <a:gd name="connsiteY20" fmla="*/ 47409 h 471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59890" h="47180">
                    <a:moveTo>
                      <a:pt x="13" y="37580"/>
                    </a:moveTo>
                    <a:lnTo>
                      <a:pt x="37370" y="37580"/>
                    </a:lnTo>
                    <a:cubicBezTo>
                      <a:pt x="41226" y="37580"/>
                      <a:pt x="44251" y="37240"/>
                      <a:pt x="46444" y="36521"/>
                    </a:cubicBezTo>
                    <a:cubicBezTo>
                      <a:pt x="48561" y="35728"/>
                      <a:pt x="50074" y="34518"/>
                      <a:pt x="50981" y="32892"/>
                    </a:cubicBezTo>
                    <a:cubicBezTo>
                      <a:pt x="51889" y="31191"/>
                      <a:pt x="52342" y="28734"/>
                      <a:pt x="52342" y="25482"/>
                    </a:cubicBezTo>
                    <a:cubicBezTo>
                      <a:pt x="52342" y="20757"/>
                      <a:pt x="50754" y="17014"/>
                      <a:pt x="47503" y="14292"/>
                    </a:cubicBezTo>
                    <a:cubicBezTo>
                      <a:pt x="44289" y="11570"/>
                      <a:pt x="39789" y="10209"/>
                      <a:pt x="34042" y="10209"/>
                    </a:cubicBezTo>
                    <a:lnTo>
                      <a:pt x="13" y="10209"/>
                    </a:lnTo>
                    <a:lnTo>
                      <a:pt x="13" y="531"/>
                    </a:lnTo>
                    <a:lnTo>
                      <a:pt x="46293" y="531"/>
                    </a:lnTo>
                    <a:cubicBezTo>
                      <a:pt x="53174" y="531"/>
                      <a:pt x="57333" y="456"/>
                      <a:pt x="58846" y="229"/>
                    </a:cubicBezTo>
                    <a:lnTo>
                      <a:pt x="58846" y="9453"/>
                    </a:lnTo>
                    <a:cubicBezTo>
                      <a:pt x="58657" y="9453"/>
                      <a:pt x="58165" y="9529"/>
                      <a:pt x="57333" y="9604"/>
                    </a:cubicBezTo>
                    <a:cubicBezTo>
                      <a:pt x="56539" y="9604"/>
                      <a:pt x="55632" y="9680"/>
                      <a:pt x="54611" y="9756"/>
                    </a:cubicBezTo>
                    <a:cubicBezTo>
                      <a:pt x="53628" y="9756"/>
                      <a:pt x="51700" y="9831"/>
                      <a:pt x="48864" y="9907"/>
                    </a:cubicBezTo>
                    <a:lnTo>
                      <a:pt x="48864" y="10058"/>
                    </a:lnTo>
                    <a:cubicBezTo>
                      <a:pt x="52910" y="12289"/>
                      <a:pt x="55783" y="14859"/>
                      <a:pt x="57485" y="17770"/>
                    </a:cubicBezTo>
                    <a:cubicBezTo>
                      <a:pt x="59073" y="20719"/>
                      <a:pt x="59904" y="24386"/>
                      <a:pt x="59904" y="28809"/>
                    </a:cubicBezTo>
                    <a:cubicBezTo>
                      <a:pt x="59904" y="35274"/>
                      <a:pt x="58354" y="39999"/>
                      <a:pt x="55216" y="43024"/>
                    </a:cubicBezTo>
                    <a:cubicBezTo>
                      <a:pt x="52002" y="45973"/>
                      <a:pt x="46671" y="47409"/>
                      <a:pt x="39184" y="47409"/>
                    </a:cubicBezTo>
                    <a:lnTo>
                      <a:pt x="13" y="47409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71" name="Freeform: Shape 3070">
                <a:extLst>
                  <a:ext uri="{FF2B5EF4-FFF2-40B4-BE49-F238E27FC236}">
                    <a16:creationId xmlns:a16="http://schemas.microsoft.com/office/drawing/2014/main" id="{AFC34680-5803-CF9A-ACFD-55D303534D18}"/>
                  </a:ext>
                </a:extLst>
              </p:cNvPr>
              <p:cNvSpPr/>
              <p:nvPr/>
            </p:nvSpPr>
            <p:spPr>
              <a:xfrm>
                <a:off x="1196022" y="2430944"/>
                <a:ext cx="59891" cy="47331"/>
              </a:xfrm>
              <a:custGeom>
                <a:avLst/>
                <a:gdLst>
                  <a:gd name="connsiteX0" fmla="*/ 59904 w 59891"/>
                  <a:gd name="connsiteY0" fmla="*/ 10203 h 47331"/>
                  <a:gd name="connsiteX1" fmla="*/ 22548 w 59891"/>
                  <a:gd name="connsiteY1" fmla="*/ 10203 h 47331"/>
                  <a:gd name="connsiteX2" fmla="*/ 13625 w 59891"/>
                  <a:gd name="connsiteY2" fmla="*/ 11413 h 47331"/>
                  <a:gd name="connsiteX3" fmla="*/ 9088 w 59891"/>
                  <a:gd name="connsiteY3" fmla="*/ 15042 h 47331"/>
                  <a:gd name="connsiteX4" fmla="*/ 7575 w 59891"/>
                  <a:gd name="connsiteY4" fmla="*/ 22300 h 47331"/>
                  <a:gd name="connsiteX5" fmla="*/ 12415 w 59891"/>
                  <a:gd name="connsiteY5" fmla="*/ 33339 h 47331"/>
                  <a:gd name="connsiteX6" fmla="*/ 25875 w 59891"/>
                  <a:gd name="connsiteY6" fmla="*/ 37422 h 47331"/>
                  <a:gd name="connsiteX7" fmla="*/ 59904 w 59891"/>
                  <a:gd name="connsiteY7" fmla="*/ 37422 h 47331"/>
                  <a:gd name="connsiteX8" fmla="*/ 59904 w 59891"/>
                  <a:gd name="connsiteY8" fmla="*/ 47252 h 47331"/>
                  <a:gd name="connsiteX9" fmla="*/ 13625 w 59891"/>
                  <a:gd name="connsiteY9" fmla="*/ 47252 h 47331"/>
                  <a:gd name="connsiteX10" fmla="*/ 1072 w 59891"/>
                  <a:gd name="connsiteY10" fmla="*/ 47554 h 47331"/>
                  <a:gd name="connsiteX11" fmla="*/ 1072 w 59891"/>
                  <a:gd name="connsiteY11" fmla="*/ 38330 h 47331"/>
                  <a:gd name="connsiteX12" fmla="*/ 2584 w 59891"/>
                  <a:gd name="connsiteY12" fmla="*/ 38330 h 47331"/>
                  <a:gd name="connsiteX13" fmla="*/ 5307 w 59891"/>
                  <a:gd name="connsiteY13" fmla="*/ 38178 h 47331"/>
                  <a:gd name="connsiteX14" fmla="*/ 11205 w 59891"/>
                  <a:gd name="connsiteY14" fmla="*/ 37876 h 47331"/>
                  <a:gd name="connsiteX15" fmla="*/ 11205 w 59891"/>
                  <a:gd name="connsiteY15" fmla="*/ 37725 h 47331"/>
                  <a:gd name="connsiteX16" fmla="*/ 2584 w 59891"/>
                  <a:gd name="connsiteY16" fmla="*/ 30013 h 47331"/>
                  <a:gd name="connsiteX17" fmla="*/ 13 w 59891"/>
                  <a:gd name="connsiteY17" fmla="*/ 18974 h 47331"/>
                  <a:gd name="connsiteX18" fmla="*/ 4853 w 59891"/>
                  <a:gd name="connsiteY18" fmla="*/ 4759 h 47331"/>
                  <a:gd name="connsiteX19" fmla="*/ 20733 w 59891"/>
                  <a:gd name="connsiteY19" fmla="*/ 223 h 47331"/>
                  <a:gd name="connsiteX20" fmla="*/ 59904 w 59891"/>
                  <a:gd name="connsiteY20" fmla="*/ 223 h 473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59891" h="47331">
                    <a:moveTo>
                      <a:pt x="59904" y="10203"/>
                    </a:moveTo>
                    <a:lnTo>
                      <a:pt x="22548" y="10203"/>
                    </a:lnTo>
                    <a:cubicBezTo>
                      <a:pt x="18729" y="10203"/>
                      <a:pt x="15742" y="10619"/>
                      <a:pt x="13625" y="11413"/>
                    </a:cubicBezTo>
                    <a:cubicBezTo>
                      <a:pt x="11508" y="12131"/>
                      <a:pt x="9995" y="13341"/>
                      <a:pt x="9088" y="15042"/>
                    </a:cubicBezTo>
                    <a:cubicBezTo>
                      <a:pt x="8105" y="16668"/>
                      <a:pt x="7575" y="19087"/>
                      <a:pt x="7575" y="22300"/>
                    </a:cubicBezTo>
                    <a:cubicBezTo>
                      <a:pt x="7575" y="26950"/>
                      <a:pt x="9201" y="30618"/>
                      <a:pt x="12415" y="33339"/>
                    </a:cubicBezTo>
                    <a:cubicBezTo>
                      <a:pt x="15667" y="36061"/>
                      <a:pt x="20128" y="37422"/>
                      <a:pt x="25875" y="37422"/>
                    </a:cubicBezTo>
                    <a:lnTo>
                      <a:pt x="59904" y="37422"/>
                    </a:lnTo>
                    <a:lnTo>
                      <a:pt x="59904" y="47252"/>
                    </a:lnTo>
                    <a:lnTo>
                      <a:pt x="13625" y="47252"/>
                    </a:lnTo>
                    <a:cubicBezTo>
                      <a:pt x="6781" y="47252"/>
                      <a:pt x="2584" y="47365"/>
                      <a:pt x="1072" y="47554"/>
                    </a:cubicBezTo>
                    <a:lnTo>
                      <a:pt x="1072" y="38330"/>
                    </a:lnTo>
                    <a:cubicBezTo>
                      <a:pt x="1299" y="38330"/>
                      <a:pt x="1790" y="38330"/>
                      <a:pt x="2584" y="38330"/>
                    </a:cubicBezTo>
                    <a:cubicBezTo>
                      <a:pt x="3416" y="38254"/>
                      <a:pt x="4324" y="38178"/>
                      <a:pt x="5307" y="38178"/>
                    </a:cubicBezTo>
                    <a:cubicBezTo>
                      <a:pt x="6328" y="38103"/>
                      <a:pt x="8294" y="37989"/>
                      <a:pt x="11205" y="37876"/>
                    </a:cubicBezTo>
                    <a:lnTo>
                      <a:pt x="11205" y="37725"/>
                    </a:lnTo>
                    <a:cubicBezTo>
                      <a:pt x="7084" y="35532"/>
                      <a:pt x="4210" y="32961"/>
                      <a:pt x="2584" y="30013"/>
                    </a:cubicBezTo>
                    <a:cubicBezTo>
                      <a:pt x="883" y="26988"/>
                      <a:pt x="13" y="23321"/>
                      <a:pt x="13" y="18974"/>
                    </a:cubicBezTo>
                    <a:cubicBezTo>
                      <a:pt x="13" y="12547"/>
                      <a:pt x="1639" y="7783"/>
                      <a:pt x="4853" y="4759"/>
                    </a:cubicBezTo>
                    <a:cubicBezTo>
                      <a:pt x="8105" y="1735"/>
                      <a:pt x="13398" y="223"/>
                      <a:pt x="20733" y="223"/>
                    </a:cubicBezTo>
                    <a:lnTo>
                      <a:pt x="59904" y="223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72" name="Freeform: Shape 3071">
                <a:extLst>
                  <a:ext uri="{FF2B5EF4-FFF2-40B4-BE49-F238E27FC236}">
                    <a16:creationId xmlns:a16="http://schemas.microsoft.com/office/drawing/2014/main" id="{010DA1E6-BCE3-23C7-800B-546A612F4F34}"/>
                  </a:ext>
                </a:extLst>
              </p:cNvPr>
              <p:cNvSpPr/>
              <p:nvPr/>
            </p:nvSpPr>
            <p:spPr>
              <a:xfrm>
                <a:off x="1175302" y="2369092"/>
                <a:ext cx="81669" cy="50053"/>
              </a:xfrm>
              <a:custGeom>
                <a:avLst/>
                <a:gdLst>
                  <a:gd name="connsiteX0" fmla="*/ 71096 w 81669"/>
                  <a:gd name="connsiteY0" fmla="*/ 10348 h 50053"/>
                  <a:gd name="connsiteX1" fmla="*/ 79263 w 81669"/>
                  <a:gd name="connsiteY1" fmla="*/ 17606 h 50053"/>
                  <a:gd name="connsiteX2" fmla="*/ 81683 w 81669"/>
                  <a:gd name="connsiteY2" fmla="*/ 28645 h 50053"/>
                  <a:gd name="connsiteX3" fmla="*/ 74272 w 81669"/>
                  <a:gd name="connsiteY3" fmla="*/ 45128 h 50053"/>
                  <a:gd name="connsiteX4" fmla="*/ 51435 w 81669"/>
                  <a:gd name="connsiteY4" fmla="*/ 50270 h 50053"/>
                  <a:gd name="connsiteX5" fmla="*/ 20733 w 81669"/>
                  <a:gd name="connsiteY5" fmla="*/ 28645 h 50053"/>
                  <a:gd name="connsiteX6" fmla="*/ 23153 w 81669"/>
                  <a:gd name="connsiteY6" fmla="*/ 17606 h 50053"/>
                  <a:gd name="connsiteX7" fmla="*/ 31018 w 81669"/>
                  <a:gd name="connsiteY7" fmla="*/ 10348 h 50053"/>
                  <a:gd name="connsiteX8" fmla="*/ 31018 w 81669"/>
                  <a:gd name="connsiteY8" fmla="*/ 10197 h 50053"/>
                  <a:gd name="connsiteX9" fmla="*/ 24363 w 81669"/>
                  <a:gd name="connsiteY9" fmla="*/ 10348 h 50053"/>
                  <a:gd name="connsiteX10" fmla="*/ 13 w 81669"/>
                  <a:gd name="connsiteY10" fmla="*/ 10348 h 50053"/>
                  <a:gd name="connsiteX11" fmla="*/ 13 w 81669"/>
                  <a:gd name="connsiteY11" fmla="*/ 519 h 50053"/>
                  <a:gd name="connsiteX12" fmla="*/ 68525 w 81669"/>
                  <a:gd name="connsiteY12" fmla="*/ 519 h 50053"/>
                  <a:gd name="connsiteX13" fmla="*/ 80624 w 81669"/>
                  <a:gd name="connsiteY13" fmla="*/ 216 h 50053"/>
                  <a:gd name="connsiteX14" fmla="*/ 80624 w 81669"/>
                  <a:gd name="connsiteY14" fmla="*/ 9592 h 50053"/>
                  <a:gd name="connsiteX15" fmla="*/ 76692 w 81669"/>
                  <a:gd name="connsiteY15" fmla="*/ 10045 h 50053"/>
                  <a:gd name="connsiteX16" fmla="*/ 71096 w 81669"/>
                  <a:gd name="connsiteY16" fmla="*/ 10197 h 50053"/>
                  <a:gd name="connsiteX17" fmla="*/ 51132 w 81669"/>
                  <a:gd name="connsiteY17" fmla="*/ 39987 h 50053"/>
                  <a:gd name="connsiteX18" fmla="*/ 68828 w 81669"/>
                  <a:gd name="connsiteY18" fmla="*/ 36811 h 50053"/>
                  <a:gd name="connsiteX19" fmla="*/ 74121 w 81669"/>
                  <a:gd name="connsiteY19" fmla="*/ 26226 h 50053"/>
                  <a:gd name="connsiteX20" fmla="*/ 68374 w 81669"/>
                  <a:gd name="connsiteY20" fmla="*/ 14128 h 50053"/>
                  <a:gd name="connsiteX21" fmla="*/ 50527 w 81669"/>
                  <a:gd name="connsiteY21" fmla="*/ 10348 h 50053"/>
                  <a:gd name="connsiteX22" fmla="*/ 33437 w 81669"/>
                  <a:gd name="connsiteY22" fmla="*/ 14128 h 50053"/>
                  <a:gd name="connsiteX23" fmla="*/ 27993 w 81669"/>
                  <a:gd name="connsiteY23" fmla="*/ 26074 h 50053"/>
                  <a:gd name="connsiteX24" fmla="*/ 33437 w 81669"/>
                  <a:gd name="connsiteY24" fmla="*/ 36811 h 50053"/>
                  <a:gd name="connsiteX25" fmla="*/ 51132 w 81669"/>
                  <a:gd name="connsiteY25" fmla="*/ 39987 h 500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</a:cxnLst>
                <a:rect l="l" t="t" r="r" b="b"/>
                <a:pathLst>
                  <a:path w="81669" h="50053">
                    <a:moveTo>
                      <a:pt x="71096" y="10348"/>
                    </a:moveTo>
                    <a:cubicBezTo>
                      <a:pt x="74953" y="12162"/>
                      <a:pt x="77675" y="14582"/>
                      <a:pt x="79263" y="17606"/>
                    </a:cubicBezTo>
                    <a:cubicBezTo>
                      <a:pt x="80851" y="20555"/>
                      <a:pt x="81683" y="24222"/>
                      <a:pt x="81683" y="28645"/>
                    </a:cubicBezTo>
                    <a:cubicBezTo>
                      <a:pt x="81683" y="36131"/>
                      <a:pt x="79225" y="41612"/>
                      <a:pt x="74272" y="45128"/>
                    </a:cubicBezTo>
                    <a:cubicBezTo>
                      <a:pt x="69243" y="48568"/>
                      <a:pt x="61644" y="50270"/>
                      <a:pt x="51435" y="50270"/>
                    </a:cubicBezTo>
                    <a:cubicBezTo>
                      <a:pt x="30980" y="50270"/>
                      <a:pt x="20733" y="43087"/>
                      <a:pt x="20733" y="28645"/>
                    </a:cubicBezTo>
                    <a:cubicBezTo>
                      <a:pt x="20733" y="24222"/>
                      <a:pt x="21565" y="20555"/>
                      <a:pt x="23153" y="17606"/>
                    </a:cubicBezTo>
                    <a:cubicBezTo>
                      <a:pt x="24779" y="14582"/>
                      <a:pt x="27388" y="12162"/>
                      <a:pt x="31018" y="10348"/>
                    </a:cubicBezTo>
                    <a:lnTo>
                      <a:pt x="31018" y="10197"/>
                    </a:lnTo>
                    <a:lnTo>
                      <a:pt x="24363" y="10348"/>
                    </a:lnTo>
                    <a:lnTo>
                      <a:pt x="13" y="10348"/>
                    </a:lnTo>
                    <a:lnTo>
                      <a:pt x="13" y="519"/>
                    </a:lnTo>
                    <a:lnTo>
                      <a:pt x="68525" y="519"/>
                    </a:lnTo>
                    <a:cubicBezTo>
                      <a:pt x="74688" y="519"/>
                      <a:pt x="78734" y="443"/>
                      <a:pt x="80624" y="216"/>
                    </a:cubicBezTo>
                    <a:lnTo>
                      <a:pt x="80624" y="9592"/>
                    </a:lnTo>
                    <a:cubicBezTo>
                      <a:pt x="80019" y="9705"/>
                      <a:pt x="78734" y="9856"/>
                      <a:pt x="76692" y="10045"/>
                    </a:cubicBezTo>
                    <a:cubicBezTo>
                      <a:pt x="74575" y="10159"/>
                      <a:pt x="72722" y="10197"/>
                      <a:pt x="71096" y="10197"/>
                    </a:cubicBezTo>
                    <a:close/>
                    <a:moveTo>
                      <a:pt x="51132" y="39987"/>
                    </a:moveTo>
                    <a:cubicBezTo>
                      <a:pt x="59413" y="39987"/>
                      <a:pt x="65311" y="38928"/>
                      <a:pt x="68828" y="36811"/>
                    </a:cubicBezTo>
                    <a:cubicBezTo>
                      <a:pt x="72382" y="34618"/>
                      <a:pt x="74121" y="31065"/>
                      <a:pt x="74121" y="26226"/>
                    </a:cubicBezTo>
                    <a:cubicBezTo>
                      <a:pt x="74121" y="20706"/>
                      <a:pt x="72230" y="16661"/>
                      <a:pt x="68374" y="14128"/>
                    </a:cubicBezTo>
                    <a:cubicBezTo>
                      <a:pt x="64555" y="11633"/>
                      <a:pt x="58619" y="10348"/>
                      <a:pt x="50527" y="10348"/>
                    </a:cubicBezTo>
                    <a:cubicBezTo>
                      <a:pt x="42776" y="10348"/>
                      <a:pt x="37067" y="11633"/>
                      <a:pt x="33437" y="14128"/>
                    </a:cubicBezTo>
                    <a:cubicBezTo>
                      <a:pt x="29808" y="16661"/>
                      <a:pt x="27993" y="20631"/>
                      <a:pt x="27993" y="26074"/>
                    </a:cubicBezTo>
                    <a:cubicBezTo>
                      <a:pt x="27993" y="31027"/>
                      <a:pt x="29808" y="34618"/>
                      <a:pt x="33437" y="36811"/>
                    </a:cubicBezTo>
                    <a:cubicBezTo>
                      <a:pt x="37067" y="38928"/>
                      <a:pt x="42966" y="39987"/>
                      <a:pt x="51132" y="39987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73" name="Freeform: Shape 3072">
                <a:extLst>
                  <a:ext uri="{FF2B5EF4-FFF2-40B4-BE49-F238E27FC236}">
                    <a16:creationId xmlns:a16="http://schemas.microsoft.com/office/drawing/2014/main" id="{B372E553-6AB0-F6D0-717C-E23E01A95736}"/>
                  </a:ext>
                </a:extLst>
              </p:cNvPr>
              <p:cNvSpPr/>
              <p:nvPr/>
            </p:nvSpPr>
            <p:spPr>
              <a:xfrm>
                <a:off x="1196022" y="2300142"/>
                <a:ext cx="60949" cy="57160"/>
              </a:xfrm>
              <a:custGeom>
                <a:avLst/>
                <a:gdLst>
                  <a:gd name="connsiteX0" fmla="*/ 60963 w 60949"/>
                  <a:gd name="connsiteY0" fmla="*/ 39527 h 57160"/>
                  <a:gd name="connsiteX1" fmla="*/ 56275 w 60949"/>
                  <a:gd name="connsiteY1" fmla="*/ 52985 h 57160"/>
                  <a:gd name="connsiteX2" fmla="*/ 43419 w 60949"/>
                  <a:gd name="connsiteY2" fmla="*/ 57370 h 57160"/>
                  <a:gd name="connsiteX3" fmla="*/ 29505 w 60949"/>
                  <a:gd name="connsiteY3" fmla="*/ 51322 h 57160"/>
                  <a:gd name="connsiteX4" fmla="*/ 24212 w 60949"/>
                  <a:gd name="connsiteY4" fmla="*/ 31966 h 57160"/>
                  <a:gd name="connsiteX5" fmla="*/ 24061 w 60949"/>
                  <a:gd name="connsiteY5" fmla="*/ 18810 h 57160"/>
                  <a:gd name="connsiteX6" fmla="*/ 20885 w 60949"/>
                  <a:gd name="connsiteY6" fmla="*/ 18810 h 57160"/>
                  <a:gd name="connsiteX7" fmla="*/ 10600 w 60949"/>
                  <a:gd name="connsiteY7" fmla="*/ 21834 h 57160"/>
                  <a:gd name="connsiteX8" fmla="*/ 7424 w 60949"/>
                  <a:gd name="connsiteY8" fmla="*/ 31361 h 57160"/>
                  <a:gd name="connsiteX9" fmla="*/ 9693 w 60949"/>
                  <a:gd name="connsiteY9" fmla="*/ 40888 h 57160"/>
                  <a:gd name="connsiteX10" fmla="*/ 16801 w 60949"/>
                  <a:gd name="connsiteY10" fmla="*/ 44517 h 57160"/>
                  <a:gd name="connsiteX11" fmla="*/ 15894 w 60949"/>
                  <a:gd name="connsiteY11" fmla="*/ 54648 h 57160"/>
                  <a:gd name="connsiteX12" fmla="*/ 13 w 60949"/>
                  <a:gd name="connsiteY12" fmla="*/ 31210 h 57160"/>
                  <a:gd name="connsiteX13" fmla="*/ 5156 w 60949"/>
                  <a:gd name="connsiteY13" fmla="*/ 14424 h 57160"/>
                  <a:gd name="connsiteX14" fmla="*/ 19826 w 60949"/>
                  <a:gd name="connsiteY14" fmla="*/ 8829 h 57160"/>
                  <a:gd name="connsiteX15" fmla="*/ 45083 w 60949"/>
                  <a:gd name="connsiteY15" fmla="*/ 8829 h 57160"/>
                  <a:gd name="connsiteX16" fmla="*/ 51737 w 60949"/>
                  <a:gd name="connsiteY16" fmla="*/ 7771 h 57160"/>
                  <a:gd name="connsiteX17" fmla="*/ 53855 w 60949"/>
                  <a:gd name="connsiteY17" fmla="*/ 3385 h 57160"/>
                  <a:gd name="connsiteX18" fmla="*/ 53552 w 60949"/>
                  <a:gd name="connsiteY18" fmla="*/ 210 h 57160"/>
                  <a:gd name="connsiteX19" fmla="*/ 59602 w 60949"/>
                  <a:gd name="connsiteY19" fmla="*/ 210 h 57160"/>
                  <a:gd name="connsiteX20" fmla="*/ 60509 w 60949"/>
                  <a:gd name="connsiteY20" fmla="*/ 7771 h 57160"/>
                  <a:gd name="connsiteX21" fmla="*/ 57636 w 60949"/>
                  <a:gd name="connsiteY21" fmla="*/ 15634 h 57160"/>
                  <a:gd name="connsiteX22" fmla="*/ 48713 w 60949"/>
                  <a:gd name="connsiteY22" fmla="*/ 18356 h 57160"/>
                  <a:gd name="connsiteX23" fmla="*/ 48713 w 60949"/>
                  <a:gd name="connsiteY23" fmla="*/ 18810 h 57160"/>
                  <a:gd name="connsiteX24" fmla="*/ 58241 w 60949"/>
                  <a:gd name="connsiteY24" fmla="*/ 27429 h 57160"/>
                  <a:gd name="connsiteX25" fmla="*/ 60963 w 60949"/>
                  <a:gd name="connsiteY25" fmla="*/ 39527 h 57160"/>
                  <a:gd name="connsiteX26" fmla="*/ 53704 w 60949"/>
                  <a:gd name="connsiteY26" fmla="*/ 37258 h 57160"/>
                  <a:gd name="connsiteX27" fmla="*/ 51284 w 60949"/>
                  <a:gd name="connsiteY27" fmla="*/ 27883 h 57160"/>
                  <a:gd name="connsiteX28" fmla="*/ 44478 w 60949"/>
                  <a:gd name="connsiteY28" fmla="*/ 21229 h 57160"/>
                  <a:gd name="connsiteX29" fmla="*/ 35706 w 60949"/>
                  <a:gd name="connsiteY29" fmla="*/ 18810 h 57160"/>
                  <a:gd name="connsiteX30" fmla="*/ 30866 w 60949"/>
                  <a:gd name="connsiteY30" fmla="*/ 18810 h 57160"/>
                  <a:gd name="connsiteX31" fmla="*/ 31169 w 60949"/>
                  <a:gd name="connsiteY31" fmla="*/ 29395 h 57160"/>
                  <a:gd name="connsiteX32" fmla="*/ 32530 w 60949"/>
                  <a:gd name="connsiteY32" fmla="*/ 39980 h 57160"/>
                  <a:gd name="connsiteX33" fmla="*/ 36462 w 60949"/>
                  <a:gd name="connsiteY33" fmla="*/ 45424 h 57160"/>
                  <a:gd name="connsiteX34" fmla="*/ 43722 w 60949"/>
                  <a:gd name="connsiteY34" fmla="*/ 47239 h 57160"/>
                  <a:gd name="connsiteX35" fmla="*/ 51132 w 60949"/>
                  <a:gd name="connsiteY35" fmla="*/ 44668 h 57160"/>
                  <a:gd name="connsiteX36" fmla="*/ 53704 w 60949"/>
                  <a:gd name="connsiteY36" fmla="*/ 37258 h 571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</a:cxnLst>
                <a:rect l="l" t="t" r="r" b="b"/>
                <a:pathLst>
                  <a:path w="60949" h="57160">
                    <a:moveTo>
                      <a:pt x="60963" y="39527"/>
                    </a:moveTo>
                    <a:cubicBezTo>
                      <a:pt x="60963" y="45500"/>
                      <a:pt x="59413" y="49961"/>
                      <a:pt x="56275" y="52985"/>
                    </a:cubicBezTo>
                    <a:cubicBezTo>
                      <a:pt x="53174" y="55934"/>
                      <a:pt x="48864" y="57370"/>
                      <a:pt x="43419" y="57370"/>
                    </a:cubicBezTo>
                    <a:cubicBezTo>
                      <a:pt x="37370" y="57370"/>
                      <a:pt x="32757" y="55367"/>
                      <a:pt x="29505" y="51322"/>
                    </a:cubicBezTo>
                    <a:cubicBezTo>
                      <a:pt x="26178" y="47314"/>
                      <a:pt x="24439" y="40850"/>
                      <a:pt x="24212" y="31966"/>
                    </a:cubicBezTo>
                    <a:lnTo>
                      <a:pt x="24061" y="18810"/>
                    </a:lnTo>
                    <a:lnTo>
                      <a:pt x="20885" y="18810"/>
                    </a:lnTo>
                    <a:cubicBezTo>
                      <a:pt x="16045" y="18810"/>
                      <a:pt x="12642" y="19830"/>
                      <a:pt x="10600" y="21834"/>
                    </a:cubicBezTo>
                    <a:cubicBezTo>
                      <a:pt x="8483" y="23875"/>
                      <a:pt x="7424" y="27051"/>
                      <a:pt x="7424" y="31361"/>
                    </a:cubicBezTo>
                    <a:cubicBezTo>
                      <a:pt x="7424" y="35708"/>
                      <a:pt x="8180" y="38884"/>
                      <a:pt x="9693" y="40888"/>
                    </a:cubicBezTo>
                    <a:cubicBezTo>
                      <a:pt x="11205" y="42929"/>
                      <a:pt x="13587" y="44139"/>
                      <a:pt x="16801" y="44517"/>
                    </a:cubicBezTo>
                    <a:lnTo>
                      <a:pt x="15894" y="54648"/>
                    </a:lnTo>
                    <a:cubicBezTo>
                      <a:pt x="5307" y="53061"/>
                      <a:pt x="13" y="45235"/>
                      <a:pt x="13" y="31210"/>
                    </a:cubicBezTo>
                    <a:cubicBezTo>
                      <a:pt x="13" y="23762"/>
                      <a:pt x="1753" y="18167"/>
                      <a:pt x="5156" y="14424"/>
                    </a:cubicBezTo>
                    <a:cubicBezTo>
                      <a:pt x="8483" y="10719"/>
                      <a:pt x="13398" y="8829"/>
                      <a:pt x="19826" y="8829"/>
                    </a:cubicBezTo>
                    <a:lnTo>
                      <a:pt x="45083" y="8829"/>
                    </a:lnTo>
                    <a:cubicBezTo>
                      <a:pt x="48032" y="8829"/>
                      <a:pt x="50225" y="8489"/>
                      <a:pt x="51737" y="7771"/>
                    </a:cubicBezTo>
                    <a:cubicBezTo>
                      <a:pt x="53174" y="6977"/>
                      <a:pt x="53855" y="5502"/>
                      <a:pt x="53855" y="3385"/>
                    </a:cubicBezTo>
                    <a:cubicBezTo>
                      <a:pt x="53855" y="2478"/>
                      <a:pt x="53779" y="1419"/>
                      <a:pt x="53552" y="210"/>
                    </a:cubicBezTo>
                    <a:lnTo>
                      <a:pt x="59602" y="210"/>
                    </a:lnTo>
                    <a:cubicBezTo>
                      <a:pt x="60207" y="2629"/>
                      <a:pt x="60509" y="5162"/>
                      <a:pt x="60509" y="7771"/>
                    </a:cubicBezTo>
                    <a:cubicBezTo>
                      <a:pt x="60509" y="11400"/>
                      <a:pt x="59564" y="14046"/>
                      <a:pt x="57636" y="15634"/>
                    </a:cubicBezTo>
                    <a:cubicBezTo>
                      <a:pt x="55745" y="17260"/>
                      <a:pt x="52758" y="18167"/>
                      <a:pt x="48713" y="18356"/>
                    </a:cubicBezTo>
                    <a:lnTo>
                      <a:pt x="48713" y="18810"/>
                    </a:lnTo>
                    <a:cubicBezTo>
                      <a:pt x="53174" y="21229"/>
                      <a:pt x="56350" y="24102"/>
                      <a:pt x="58241" y="27429"/>
                    </a:cubicBezTo>
                    <a:cubicBezTo>
                      <a:pt x="60056" y="30756"/>
                      <a:pt x="60963" y="34801"/>
                      <a:pt x="60963" y="39527"/>
                    </a:cubicBezTo>
                    <a:close/>
                    <a:moveTo>
                      <a:pt x="53704" y="37258"/>
                    </a:moveTo>
                    <a:cubicBezTo>
                      <a:pt x="53704" y="33742"/>
                      <a:pt x="52910" y="30605"/>
                      <a:pt x="51284" y="27883"/>
                    </a:cubicBezTo>
                    <a:cubicBezTo>
                      <a:pt x="49582" y="25085"/>
                      <a:pt x="47314" y="22855"/>
                      <a:pt x="44478" y="21229"/>
                    </a:cubicBezTo>
                    <a:cubicBezTo>
                      <a:pt x="41680" y="19641"/>
                      <a:pt x="38731" y="18810"/>
                      <a:pt x="35706" y="18810"/>
                    </a:cubicBezTo>
                    <a:lnTo>
                      <a:pt x="30866" y="18810"/>
                    </a:lnTo>
                    <a:lnTo>
                      <a:pt x="31169" y="29395"/>
                    </a:lnTo>
                    <a:cubicBezTo>
                      <a:pt x="31169" y="34045"/>
                      <a:pt x="31622" y="37561"/>
                      <a:pt x="32530" y="39980"/>
                    </a:cubicBezTo>
                    <a:cubicBezTo>
                      <a:pt x="33362" y="42324"/>
                      <a:pt x="34647" y="44139"/>
                      <a:pt x="36462" y="45424"/>
                    </a:cubicBezTo>
                    <a:cubicBezTo>
                      <a:pt x="38277" y="46634"/>
                      <a:pt x="40697" y="47239"/>
                      <a:pt x="43722" y="47239"/>
                    </a:cubicBezTo>
                    <a:cubicBezTo>
                      <a:pt x="46860" y="47239"/>
                      <a:pt x="49318" y="46407"/>
                      <a:pt x="51132" y="44668"/>
                    </a:cubicBezTo>
                    <a:cubicBezTo>
                      <a:pt x="52872" y="42967"/>
                      <a:pt x="53704" y="40510"/>
                      <a:pt x="53704" y="37258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74" name="Freeform: Shape 3073">
                <a:extLst>
                  <a:ext uri="{FF2B5EF4-FFF2-40B4-BE49-F238E27FC236}">
                    <a16:creationId xmlns:a16="http://schemas.microsoft.com/office/drawing/2014/main" id="{B8C9669F-E6CA-DC7A-EC80-4FFB138D6890}"/>
                  </a:ext>
                </a:extLst>
              </p:cNvPr>
              <p:cNvSpPr/>
              <p:nvPr/>
            </p:nvSpPr>
            <p:spPr>
              <a:xfrm>
                <a:off x="1196022" y="2245397"/>
                <a:ext cx="59891" cy="47331"/>
              </a:xfrm>
              <a:custGeom>
                <a:avLst/>
                <a:gdLst>
                  <a:gd name="connsiteX0" fmla="*/ 59904 w 59891"/>
                  <a:gd name="connsiteY0" fmla="*/ 10184 h 47331"/>
                  <a:gd name="connsiteX1" fmla="*/ 22548 w 59891"/>
                  <a:gd name="connsiteY1" fmla="*/ 10184 h 47331"/>
                  <a:gd name="connsiteX2" fmla="*/ 13625 w 59891"/>
                  <a:gd name="connsiteY2" fmla="*/ 11394 h 47331"/>
                  <a:gd name="connsiteX3" fmla="*/ 9088 w 59891"/>
                  <a:gd name="connsiteY3" fmla="*/ 15023 h 47331"/>
                  <a:gd name="connsiteX4" fmla="*/ 7575 w 59891"/>
                  <a:gd name="connsiteY4" fmla="*/ 22281 h 47331"/>
                  <a:gd name="connsiteX5" fmla="*/ 12415 w 59891"/>
                  <a:gd name="connsiteY5" fmla="*/ 33320 h 47331"/>
                  <a:gd name="connsiteX6" fmla="*/ 25875 w 59891"/>
                  <a:gd name="connsiteY6" fmla="*/ 37403 h 47331"/>
                  <a:gd name="connsiteX7" fmla="*/ 59904 w 59891"/>
                  <a:gd name="connsiteY7" fmla="*/ 37403 h 47331"/>
                  <a:gd name="connsiteX8" fmla="*/ 59904 w 59891"/>
                  <a:gd name="connsiteY8" fmla="*/ 47232 h 47331"/>
                  <a:gd name="connsiteX9" fmla="*/ 13625 w 59891"/>
                  <a:gd name="connsiteY9" fmla="*/ 47232 h 47331"/>
                  <a:gd name="connsiteX10" fmla="*/ 1072 w 59891"/>
                  <a:gd name="connsiteY10" fmla="*/ 47535 h 47331"/>
                  <a:gd name="connsiteX11" fmla="*/ 1072 w 59891"/>
                  <a:gd name="connsiteY11" fmla="*/ 38310 h 47331"/>
                  <a:gd name="connsiteX12" fmla="*/ 2584 w 59891"/>
                  <a:gd name="connsiteY12" fmla="*/ 38310 h 47331"/>
                  <a:gd name="connsiteX13" fmla="*/ 5307 w 59891"/>
                  <a:gd name="connsiteY13" fmla="*/ 38159 h 47331"/>
                  <a:gd name="connsiteX14" fmla="*/ 11205 w 59891"/>
                  <a:gd name="connsiteY14" fmla="*/ 37857 h 47331"/>
                  <a:gd name="connsiteX15" fmla="*/ 11205 w 59891"/>
                  <a:gd name="connsiteY15" fmla="*/ 37706 h 47331"/>
                  <a:gd name="connsiteX16" fmla="*/ 2584 w 59891"/>
                  <a:gd name="connsiteY16" fmla="*/ 29993 h 47331"/>
                  <a:gd name="connsiteX17" fmla="*/ 13 w 59891"/>
                  <a:gd name="connsiteY17" fmla="*/ 18954 h 47331"/>
                  <a:gd name="connsiteX18" fmla="*/ 4853 w 59891"/>
                  <a:gd name="connsiteY18" fmla="*/ 4740 h 47331"/>
                  <a:gd name="connsiteX19" fmla="*/ 20733 w 59891"/>
                  <a:gd name="connsiteY19" fmla="*/ 203 h 47331"/>
                  <a:gd name="connsiteX20" fmla="*/ 59904 w 59891"/>
                  <a:gd name="connsiteY20" fmla="*/ 203 h 473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59891" h="47331">
                    <a:moveTo>
                      <a:pt x="59904" y="10184"/>
                    </a:moveTo>
                    <a:lnTo>
                      <a:pt x="22548" y="10184"/>
                    </a:lnTo>
                    <a:cubicBezTo>
                      <a:pt x="18729" y="10184"/>
                      <a:pt x="15742" y="10600"/>
                      <a:pt x="13625" y="11394"/>
                    </a:cubicBezTo>
                    <a:cubicBezTo>
                      <a:pt x="11508" y="12112"/>
                      <a:pt x="9995" y="13322"/>
                      <a:pt x="9088" y="15023"/>
                    </a:cubicBezTo>
                    <a:cubicBezTo>
                      <a:pt x="8105" y="16648"/>
                      <a:pt x="7575" y="19068"/>
                      <a:pt x="7575" y="22281"/>
                    </a:cubicBezTo>
                    <a:cubicBezTo>
                      <a:pt x="7575" y="26931"/>
                      <a:pt x="9201" y="30598"/>
                      <a:pt x="12415" y="33320"/>
                    </a:cubicBezTo>
                    <a:cubicBezTo>
                      <a:pt x="15667" y="36042"/>
                      <a:pt x="20128" y="37403"/>
                      <a:pt x="25875" y="37403"/>
                    </a:cubicBezTo>
                    <a:lnTo>
                      <a:pt x="59904" y="37403"/>
                    </a:lnTo>
                    <a:lnTo>
                      <a:pt x="59904" y="47232"/>
                    </a:lnTo>
                    <a:lnTo>
                      <a:pt x="13625" y="47232"/>
                    </a:lnTo>
                    <a:cubicBezTo>
                      <a:pt x="6781" y="47232"/>
                      <a:pt x="2584" y="47346"/>
                      <a:pt x="1072" y="47535"/>
                    </a:cubicBezTo>
                    <a:lnTo>
                      <a:pt x="1072" y="38310"/>
                    </a:lnTo>
                    <a:cubicBezTo>
                      <a:pt x="1299" y="38310"/>
                      <a:pt x="1790" y="38310"/>
                      <a:pt x="2584" y="38310"/>
                    </a:cubicBezTo>
                    <a:cubicBezTo>
                      <a:pt x="3416" y="38235"/>
                      <a:pt x="4324" y="38159"/>
                      <a:pt x="5307" y="38159"/>
                    </a:cubicBezTo>
                    <a:cubicBezTo>
                      <a:pt x="6328" y="38084"/>
                      <a:pt x="8294" y="37970"/>
                      <a:pt x="11205" y="37857"/>
                    </a:cubicBezTo>
                    <a:lnTo>
                      <a:pt x="11205" y="37706"/>
                    </a:lnTo>
                    <a:cubicBezTo>
                      <a:pt x="7084" y="35513"/>
                      <a:pt x="4210" y="32942"/>
                      <a:pt x="2584" y="29993"/>
                    </a:cubicBezTo>
                    <a:cubicBezTo>
                      <a:pt x="883" y="26969"/>
                      <a:pt x="13" y="23302"/>
                      <a:pt x="13" y="18954"/>
                    </a:cubicBezTo>
                    <a:cubicBezTo>
                      <a:pt x="13" y="12528"/>
                      <a:pt x="1639" y="7764"/>
                      <a:pt x="4853" y="4740"/>
                    </a:cubicBezTo>
                    <a:cubicBezTo>
                      <a:pt x="8105" y="1716"/>
                      <a:pt x="13398" y="203"/>
                      <a:pt x="20733" y="203"/>
                    </a:cubicBezTo>
                    <a:lnTo>
                      <a:pt x="59904" y="203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75" name="Freeform: Shape 3074">
                <a:extLst>
                  <a:ext uri="{FF2B5EF4-FFF2-40B4-BE49-F238E27FC236}">
                    <a16:creationId xmlns:a16="http://schemas.microsoft.com/office/drawing/2014/main" id="{2746E458-4141-B73D-1853-8CC92613767C}"/>
                  </a:ext>
                </a:extLst>
              </p:cNvPr>
              <p:cNvSpPr/>
              <p:nvPr/>
            </p:nvSpPr>
            <p:spPr>
              <a:xfrm>
                <a:off x="1196022" y="2185511"/>
                <a:ext cx="60949" cy="48087"/>
              </a:xfrm>
              <a:custGeom>
                <a:avLst/>
                <a:gdLst>
                  <a:gd name="connsiteX0" fmla="*/ 30261 w 60949"/>
                  <a:gd name="connsiteY0" fmla="*/ 38002 h 48087"/>
                  <a:gd name="connsiteX1" fmla="*/ 47654 w 60949"/>
                  <a:gd name="connsiteY1" fmla="*/ 34372 h 48087"/>
                  <a:gd name="connsiteX2" fmla="*/ 53250 w 60949"/>
                  <a:gd name="connsiteY2" fmla="*/ 23182 h 48087"/>
                  <a:gd name="connsiteX3" fmla="*/ 50528 w 60949"/>
                  <a:gd name="connsiteY3" fmla="*/ 14563 h 48087"/>
                  <a:gd name="connsiteX4" fmla="*/ 41756 w 60949"/>
                  <a:gd name="connsiteY4" fmla="*/ 10177 h 48087"/>
                  <a:gd name="connsiteX5" fmla="*/ 42361 w 60949"/>
                  <a:gd name="connsiteY5" fmla="*/ 197 h 48087"/>
                  <a:gd name="connsiteX6" fmla="*/ 55972 w 60949"/>
                  <a:gd name="connsiteY6" fmla="*/ 7455 h 48087"/>
                  <a:gd name="connsiteX7" fmla="*/ 60963 w 60949"/>
                  <a:gd name="connsiteY7" fmla="*/ 22880 h 48087"/>
                  <a:gd name="connsiteX8" fmla="*/ 53250 w 60949"/>
                  <a:gd name="connsiteY8" fmla="*/ 41782 h 48087"/>
                  <a:gd name="connsiteX9" fmla="*/ 30413 w 60949"/>
                  <a:gd name="connsiteY9" fmla="*/ 48284 h 48087"/>
                  <a:gd name="connsiteX10" fmla="*/ 7878 w 60949"/>
                  <a:gd name="connsiteY10" fmla="*/ 41782 h 48087"/>
                  <a:gd name="connsiteX11" fmla="*/ 13 w 60949"/>
                  <a:gd name="connsiteY11" fmla="*/ 23031 h 48087"/>
                  <a:gd name="connsiteX12" fmla="*/ 4702 w 60949"/>
                  <a:gd name="connsiteY12" fmla="*/ 8060 h 48087"/>
                  <a:gd name="connsiteX13" fmla="*/ 17557 w 60949"/>
                  <a:gd name="connsiteY13" fmla="*/ 651 h 48087"/>
                  <a:gd name="connsiteX14" fmla="*/ 18313 w 60949"/>
                  <a:gd name="connsiteY14" fmla="*/ 10631 h 48087"/>
                  <a:gd name="connsiteX15" fmla="*/ 10600 w 60949"/>
                  <a:gd name="connsiteY15" fmla="*/ 14563 h 48087"/>
                  <a:gd name="connsiteX16" fmla="*/ 7727 w 60949"/>
                  <a:gd name="connsiteY16" fmla="*/ 23333 h 48087"/>
                  <a:gd name="connsiteX17" fmla="*/ 12869 w 60949"/>
                  <a:gd name="connsiteY17" fmla="*/ 34524 h 48087"/>
                  <a:gd name="connsiteX18" fmla="*/ 30261 w 60949"/>
                  <a:gd name="connsiteY18" fmla="*/ 38002 h 4808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</a:cxnLst>
                <a:rect l="l" t="t" r="r" b="b"/>
                <a:pathLst>
                  <a:path w="60949" h="48087">
                    <a:moveTo>
                      <a:pt x="30261" y="38002"/>
                    </a:moveTo>
                    <a:cubicBezTo>
                      <a:pt x="38050" y="38002"/>
                      <a:pt x="43835" y="36792"/>
                      <a:pt x="47654" y="34372"/>
                    </a:cubicBezTo>
                    <a:cubicBezTo>
                      <a:pt x="51397" y="31877"/>
                      <a:pt x="53250" y="28135"/>
                      <a:pt x="53250" y="23182"/>
                    </a:cubicBezTo>
                    <a:cubicBezTo>
                      <a:pt x="53250" y="19780"/>
                      <a:pt x="52342" y="16907"/>
                      <a:pt x="50528" y="14563"/>
                    </a:cubicBezTo>
                    <a:cubicBezTo>
                      <a:pt x="48637" y="12143"/>
                      <a:pt x="45688" y="10707"/>
                      <a:pt x="41756" y="10177"/>
                    </a:cubicBezTo>
                    <a:lnTo>
                      <a:pt x="42361" y="197"/>
                    </a:lnTo>
                    <a:cubicBezTo>
                      <a:pt x="48032" y="1029"/>
                      <a:pt x="52569" y="3448"/>
                      <a:pt x="55972" y="7455"/>
                    </a:cubicBezTo>
                    <a:cubicBezTo>
                      <a:pt x="59299" y="11500"/>
                      <a:pt x="60963" y="16642"/>
                      <a:pt x="60963" y="22880"/>
                    </a:cubicBezTo>
                    <a:cubicBezTo>
                      <a:pt x="60963" y="31159"/>
                      <a:pt x="58392" y="37472"/>
                      <a:pt x="53250" y="41782"/>
                    </a:cubicBezTo>
                    <a:cubicBezTo>
                      <a:pt x="48032" y="46130"/>
                      <a:pt x="40395" y="48284"/>
                      <a:pt x="30413" y="48284"/>
                    </a:cubicBezTo>
                    <a:cubicBezTo>
                      <a:pt x="20544" y="48284"/>
                      <a:pt x="13020" y="46130"/>
                      <a:pt x="7878" y="41782"/>
                    </a:cubicBezTo>
                    <a:cubicBezTo>
                      <a:pt x="2660" y="37359"/>
                      <a:pt x="13" y="31121"/>
                      <a:pt x="13" y="23031"/>
                    </a:cubicBezTo>
                    <a:cubicBezTo>
                      <a:pt x="13" y="16982"/>
                      <a:pt x="1601" y="11992"/>
                      <a:pt x="4702" y="8060"/>
                    </a:cubicBezTo>
                    <a:cubicBezTo>
                      <a:pt x="7840" y="4129"/>
                      <a:pt x="12113" y="1671"/>
                      <a:pt x="17557" y="651"/>
                    </a:cubicBezTo>
                    <a:lnTo>
                      <a:pt x="18313" y="10631"/>
                    </a:lnTo>
                    <a:cubicBezTo>
                      <a:pt x="15100" y="11160"/>
                      <a:pt x="12529" y="12446"/>
                      <a:pt x="10600" y="14563"/>
                    </a:cubicBezTo>
                    <a:cubicBezTo>
                      <a:pt x="8710" y="16604"/>
                      <a:pt x="7727" y="19515"/>
                      <a:pt x="7727" y="23333"/>
                    </a:cubicBezTo>
                    <a:cubicBezTo>
                      <a:pt x="7727" y="28475"/>
                      <a:pt x="9466" y="32217"/>
                      <a:pt x="12869" y="34524"/>
                    </a:cubicBezTo>
                    <a:cubicBezTo>
                      <a:pt x="16309" y="36867"/>
                      <a:pt x="22094" y="38002"/>
                      <a:pt x="30261" y="38002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76" name="Freeform: Shape 3075">
                <a:extLst>
                  <a:ext uri="{FF2B5EF4-FFF2-40B4-BE49-F238E27FC236}">
                    <a16:creationId xmlns:a16="http://schemas.microsoft.com/office/drawing/2014/main" id="{D2029A1C-FCEE-6B81-8382-3C2A81B02683}"/>
                  </a:ext>
                </a:extLst>
              </p:cNvPr>
              <p:cNvSpPr/>
              <p:nvPr/>
            </p:nvSpPr>
            <p:spPr>
              <a:xfrm>
                <a:off x="1196022" y="2125628"/>
                <a:ext cx="60949" cy="52321"/>
              </a:xfrm>
              <a:custGeom>
                <a:avLst/>
                <a:gdLst>
                  <a:gd name="connsiteX0" fmla="*/ 32530 w 60949"/>
                  <a:gd name="connsiteY0" fmla="*/ 42230 h 52321"/>
                  <a:gd name="connsiteX1" fmla="*/ 48259 w 60949"/>
                  <a:gd name="connsiteY1" fmla="*/ 37996 h 52321"/>
                  <a:gd name="connsiteX2" fmla="*/ 53704 w 60949"/>
                  <a:gd name="connsiteY2" fmla="*/ 25747 h 52321"/>
                  <a:gd name="connsiteX3" fmla="*/ 51132 w 60949"/>
                  <a:gd name="connsiteY3" fmla="*/ 15615 h 52321"/>
                  <a:gd name="connsiteX4" fmla="*/ 44629 w 60949"/>
                  <a:gd name="connsiteY4" fmla="*/ 10474 h 52321"/>
                  <a:gd name="connsiteX5" fmla="*/ 47049 w 60949"/>
                  <a:gd name="connsiteY5" fmla="*/ 1855 h 52321"/>
                  <a:gd name="connsiteX6" fmla="*/ 60963 w 60949"/>
                  <a:gd name="connsiteY6" fmla="*/ 25747 h 52321"/>
                  <a:gd name="connsiteX7" fmla="*/ 53250 w 60949"/>
                  <a:gd name="connsiteY7" fmla="*/ 45708 h 52321"/>
                  <a:gd name="connsiteX8" fmla="*/ 30110 w 60949"/>
                  <a:gd name="connsiteY8" fmla="*/ 52513 h 52321"/>
                  <a:gd name="connsiteX9" fmla="*/ 7878 w 60949"/>
                  <a:gd name="connsiteY9" fmla="*/ 45708 h 52321"/>
                  <a:gd name="connsiteX10" fmla="*/ 13 w 60949"/>
                  <a:gd name="connsiteY10" fmla="*/ 26201 h 52321"/>
                  <a:gd name="connsiteX11" fmla="*/ 31320 w 60949"/>
                  <a:gd name="connsiteY11" fmla="*/ 191 h 52321"/>
                  <a:gd name="connsiteX12" fmla="*/ 32530 w 60949"/>
                  <a:gd name="connsiteY12" fmla="*/ 191 h 52321"/>
                  <a:gd name="connsiteX13" fmla="*/ 25119 w 60949"/>
                  <a:gd name="connsiteY13" fmla="*/ 10323 h 52321"/>
                  <a:gd name="connsiteX14" fmla="*/ 11508 w 60949"/>
                  <a:gd name="connsiteY14" fmla="*/ 15162 h 52321"/>
                  <a:gd name="connsiteX15" fmla="*/ 7273 w 60949"/>
                  <a:gd name="connsiteY15" fmla="*/ 26352 h 52321"/>
                  <a:gd name="connsiteX16" fmla="*/ 12113 w 60949"/>
                  <a:gd name="connsiteY16" fmla="*/ 37693 h 52321"/>
                  <a:gd name="connsiteX17" fmla="*/ 25119 w 60949"/>
                  <a:gd name="connsiteY17" fmla="*/ 42079 h 5232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60949" h="52321">
                    <a:moveTo>
                      <a:pt x="32530" y="42230"/>
                    </a:moveTo>
                    <a:cubicBezTo>
                      <a:pt x="39298" y="42230"/>
                      <a:pt x="44554" y="40831"/>
                      <a:pt x="48259" y="37996"/>
                    </a:cubicBezTo>
                    <a:cubicBezTo>
                      <a:pt x="51889" y="35198"/>
                      <a:pt x="53704" y="31115"/>
                      <a:pt x="53704" y="25747"/>
                    </a:cubicBezTo>
                    <a:cubicBezTo>
                      <a:pt x="53704" y="21513"/>
                      <a:pt x="52872" y="18148"/>
                      <a:pt x="51132" y="15615"/>
                    </a:cubicBezTo>
                    <a:cubicBezTo>
                      <a:pt x="49431" y="13120"/>
                      <a:pt x="47276" y="11381"/>
                      <a:pt x="44629" y="10474"/>
                    </a:cubicBezTo>
                    <a:lnTo>
                      <a:pt x="47049" y="1855"/>
                    </a:lnTo>
                    <a:cubicBezTo>
                      <a:pt x="56350" y="5408"/>
                      <a:pt x="60963" y="13347"/>
                      <a:pt x="60963" y="25747"/>
                    </a:cubicBezTo>
                    <a:cubicBezTo>
                      <a:pt x="60963" y="34518"/>
                      <a:pt x="58392" y="41171"/>
                      <a:pt x="53250" y="45708"/>
                    </a:cubicBezTo>
                    <a:cubicBezTo>
                      <a:pt x="48032" y="50245"/>
                      <a:pt x="40319" y="52513"/>
                      <a:pt x="30110" y="52513"/>
                    </a:cubicBezTo>
                    <a:cubicBezTo>
                      <a:pt x="20431" y="52513"/>
                      <a:pt x="13020" y="50245"/>
                      <a:pt x="7878" y="45708"/>
                    </a:cubicBezTo>
                    <a:cubicBezTo>
                      <a:pt x="2660" y="41171"/>
                      <a:pt x="13" y="34669"/>
                      <a:pt x="13" y="26201"/>
                    </a:cubicBezTo>
                    <a:cubicBezTo>
                      <a:pt x="13" y="8886"/>
                      <a:pt x="10449" y="191"/>
                      <a:pt x="31320" y="191"/>
                    </a:cubicBezTo>
                    <a:lnTo>
                      <a:pt x="32530" y="191"/>
                    </a:lnTo>
                    <a:close/>
                    <a:moveTo>
                      <a:pt x="25119" y="10323"/>
                    </a:moveTo>
                    <a:cubicBezTo>
                      <a:pt x="18881" y="10928"/>
                      <a:pt x="14343" y="12553"/>
                      <a:pt x="11508" y="15162"/>
                    </a:cubicBezTo>
                    <a:cubicBezTo>
                      <a:pt x="8710" y="17695"/>
                      <a:pt x="7273" y="21437"/>
                      <a:pt x="7273" y="26352"/>
                    </a:cubicBezTo>
                    <a:cubicBezTo>
                      <a:pt x="7273" y="31115"/>
                      <a:pt x="8899" y="34896"/>
                      <a:pt x="12113" y="37693"/>
                    </a:cubicBezTo>
                    <a:cubicBezTo>
                      <a:pt x="15251" y="40415"/>
                      <a:pt x="19599" y="41890"/>
                      <a:pt x="25119" y="42079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</p:grpSp>
        <p:grpSp>
          <p:nvGrpSpPr>
            <p:cNvPr id="3020" name="Content Placeholder 4">
              <a:extLst>
                <a:ext uri="{FF2B5EF4-FFF2-40B4-BE49-F238E27FC236}">
                  <a16:creationId xmlns:a16="http://schemas.microsoft.com/office/drawing/2014/main" id="{7FB5DAD4-B591-D53A-E3E9-2AD93FCA537C}"/>
                </a:ext>
              </a:extLst>
            </p:cNvPr>
            <p:cNvGrpSpPr/>
            <p:nvPr/>
          </p:nvGrpSpPr>
          <p:grpSpPr>
            <a:xfrm>
              <a:off x="3941443" y="5319494"/>
              <a:ext cx="318053" cy="78784"/>
              <a:chOff x="4012563" y="6076577"/>
              <a:chExt cx="318053" cy="78784"/>
            </a:xfrm>
            <a:solidFill>
              <a:srgbClr val="000000"/>
            </a:solidFill>
          </p:grpSpPr>
          <p:sp>
            <p:nvSpPr>
              <p:cNvPr id="3054" name="Freeform: Shape 3053">
                <a:extLst>
                  <a:ext uri="{FF2B5EF4-FFF2-40B4-BE49-F238E27FC236}">
                    <a16:creationId xmlns:a16="http://schemas.microsoft.com/office/drawing/2014/main" id="{022E28B4-4E2A-6E70-5161-66A350E4C5BA}"/>
                  </a:ext>
                </a:extLst>
              </p:cNvPr>
              <p:cNvSpPr/>
              <p:nvPr/>
            </p:nvSpPr>
            <p:spPr>
              <a:xfrm>
                <a:off x="4012563" y="6076577"/>
                <a:ext cx="72746" cy="78784"/>
              </a:xfrm>
              <a:custGeom>
                <a:avLst/>
                <a:gdLst>
                  <a:gd name="connsiteX0" fmla="*/ 298 w 72746"/>
                  <a:gd name="connsiteY0" fmla="*/ 39616 h 78784"/>
                  <a:gd name="connsiteX1" fmla="*/ 10279 w 72746"/>
                  <a:gd name="connsiteY1" fmla="*/ 10884 h 78784"/>
                  <a:gd name="connsiteX2" fmla="*/ 38410 w 72746"/>
                  <a:gd name="connsiteY2" fmla="*/ 602 h 78784"/>
                  <a:gd name="connsiteX3" fmla="*/ 58979 w 72746"/>
                  <a:gd name="connsiteY3" fmla="*/ 4987 h 78784"/>
                  <a:gd name="connsiteX4" fmla="*/ 71229 w 72746"/>
                  <a:gd name="connsiteY4" fmla="*/ 18597 h 78784"/>
                  <a:gd name="connsiteX5" fmla="*/ 61399 w 72746"/>
                  <a:gd name="connsiteY5" fmla="*/ 21621 h 78784"/>
                  <a:gd name="connsiteX6" fmla="*/ 52324 w 72746"/>
                  <a:gd name="connsiteY6" fmla="*/ 12094 h 78784"/>
                  <a:gd name="connsiteX7" fmla="*/ 38108 w 72746"/>
                  <a:gd name="connsiteY7" fmla="*/ 9070 h 78784"/>
                  <a:gd name="connsiteX8" fmla="*/ 17841 w 72746"/>
                  <a:gd name="connsiteY8" fmla="*/ 17084 h 78784"/>
                  <a:gd name="connsiteX9" fmla="*/ 10884 w 72746"/>
                  <a:gd name="connsiteY9" fmla="*/ 39616 h 78784"/>
                  <a:gd name="connsiteX10" fmla="*/ 18295 w 72746"/>
                  <a:gd name="connsiteY10" fmla="*/ 62601 h 78784"/>
                  <a:gd name="connsiteX11" fmla="*/ 38864 w 72746"/>
                  <a:gd name="connsiteY11" fmla="*/ 70918 h 78784"/>
                  <a:gd name="connsiteX12" fmla="*/ 52929 w 72746"/>
                  <a:gd name="connsiteY12" fmla="*/ 68650 h 78784"/>
                  <a:gd name="connsiteX13" fmla="*/ 63365 w 72746"/>
                  <a:gd name="connsiteY13" fmla="*/ 62450 h 78784"/>
                  <a:gd name="connsiteX14" fmla="*/ 63365 w 72746"/>
                  <a:gd name="connsiteY14" fmla="*/ 48689 h 78784"/>
                  <a:gd name="connsiteX15" fmla="*/ 40527 w 72746"/>
                  <a:gd name="connsiteY15" fmla="*/ 48689 h 78784"/>
                  <a:gd name="connsiteX16" fmla="*/ 40527 w 72746"/>
                  <a:gd name="connsiteY16" fmla="*/ 40070 h 78784"/>
                  <a:gd name="connsiteX17" fmla="*/ 73044 w 72746"/>
                  <a:gd name="connsiteY17" fmla="*/ 40070 h 78784"/>
                  <a:gd name="connsiteX18" fmla="*/ 73044 w 72746"/>
                  <a:gd name="connsiteY18" fmla="*/ 66382 h 78784"/>
                  <a:gd name="connsiteX19" fmla="*/ 57920 w 72746"/>
                  <a:gd name="connsiteY19" fmla="*/ 76060 h 78784"/>
                  <a:gd name="connsiteX20" fmla="*/ 38864 w 72746"/>
                  <a:gd name="connsiteY20" fmla="*/ 79387 h 78784"/>
                  <a:gd name="connsiteX21" fmla="*/ 18144 w 72746"/>
                  <a:gd name="connsiteY21" fmla="*/ 74699 h 78784"/>
                  <a:gd name="connsiteX22" fmla="*/ 4835 w 72746"/>
                  <a:gd name="connsiteY22" fmla="*/ 60938 h 78784"/>
                  <a:gd name="connsiteX23" fmla="*/ 298 w 72746"/>
                  <a:gd name="connsiteY23" fmla="*/ 39616 h 787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72746" h="78784">
                    <a:moveTo>
                      <a:pt x="298" y="39616"/>
                    </a:moveTo>
                    <a:cubicBezTo>
                      <a:pt x="298" y="27216"/>
                      <a:pt x="3625" y="17652"/>
                      <a:pt x="10279" y="10884"/>
                    </a:cubicBezTo>
                    <a:cubicBezTo>
                      <a:pt x="16934" y="4042"/>
                      <a:pt x="26311" y="602"/>
                      <a:pt x="38410" y="602"/>
                    </a:cubicBezTo>
                    <a:cubicBezTo>
                      <a:pt x="46879" y="602"/>
                      <a:pt x="53723" y="2076"/>
                      <a:pt x="58979" y="4987"/>
                    </a:cubicBezTo>
                    <a:cubicBezTo>
                      <a:pt x="64310" y="7822"/>
                      <a:pt x="68393" y="12359"/>
                      <a:pt x="71229" y="18597"/>
                    </a:cubicBezTo>
                    <a:lnTo>
                      <a:pt x="61399" y="21621"/>
                    </a:lnTo>
                    <a:cubicBezTo>
                      <a:pt x="59168" y="17311"/>
                      <a:pt x="56143" y="14136"/>
                      <a:pt x="52324" y="12094"/>
                    </a:cubicBezTo>
                    <a:cubicBezTo>
                      <a:pt x="48581" y="10091"/>
                      <a:pt x="43855" y="9070"/>
                      <a:pt x="38108" y="9070"/>
                    </a:cubicBezTo>
                    <a:cubicBezTo>
                      <a:pt x="29222" y="9070"/>
                      <a:pt x="22454" y="11754"/>
                      <a:pt x="17841" y="17084"/>
                    </a:cubicBezTo>
                    <a:cubicBezTo>
                      <a:pt x="13191" y="22453"/>
                      <a:pt x="10884" y="29938"/>
                      <a:pt x="10884" y="39616"/>
                    </a:cubicBezTo>
                    <a:cubicBezTo>
                      <a:pt x="10884" y="49294"/>
                      <a:pt x="13342" y="56968"/>
                      <a:pt x="18295" y="62601"/>
                    </a:cubicBezTo>
                    <a:cubicBezTo>
                      <a:pt x="23210" y="68159"/>
                      <a:pt x="30092" y="70918"/>
                      <a:pt x="38864" y="70918"/>
                    </a:cubicBezTo>
                    <a:cubicBezTo>
                      <a:pt x="43893" y="70918"/>
                      <a:pt x="48581" y="70162"/>
                      <a:pt x="52929" y="68650"/>
                    </a:cubicBezTo>
                    <a:cubicBezTo>
                      <a:pt x="57239" y="67138"/>
                      <a:pt x="60718" y="65096"/>
                      <a:pt x="63365" y="62450"/>
                    </a:cubicBezTo>
                    <a:lnTo>
                      <a:pt x="63365" y="48689"/>
                    </a:lnTo>
                    <a:lnTo>
                      <a:pt x="40527" y="48689"/>
                    </a:lnTo>
                    <a:lnTo>
                      <a:pt x="40527" y="40070"/>
                    </a:lnTo>
                    <a:lnTo>
                      <a:pt x="73044" y="40070"/>
                    </a:lnTo>
                    <a:lnTo>
                      <a:pt x="73044" y="66382"/>
                    </a:lnTo>
                    <a:cubicBezTo>
                      <a:pt x="68885" y="70540"/>
                      <a:pt x="63856" y="73754"/>
                      <a:pt x="57920" y="76060"/>
                    </a:cubicBezTo>
                    <a:cubicBezTo>
                      <a:pt x="52059" y="78290"/>
                      <a:pt x="45707" y="79387"/>
                      <a:pt x="38864" y="79387"/>
                    </a:cubicBezTo>
                    <a:cubicBezTo>
                      <a:pt x="30886" y="79387"/>
                      <a:pt x="23967" y="77837"/>
                      <a:pt x="18144" y="74699"/>
                    </a:cubicBezTo>
                    <a:cubicBezTo>
                      <a:pt x="12397" y="71485"/>
                      <a:pt x="7935" y="66911"/>
                      <a:pt x="4835" y="60938"/>
                    </a:cubicBezTo>
                    <a:cubicBezTo>
                      <a:pt x="1810" y="54889"/>
                      <a:pt x="298" y="47782"/>
                      <a:pt x="298" y="39616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55" name="Freeform: Shape 3054">
                <a:extLst>
                  <a:ext uri="{FF2B5EF4-FFF2-40B4-BE49-F238E27FC236}">
                    <a16:creationId xmlns:a16="http://schemas.microsoft.com/office/drawing/2014/main" id="{BF666713-5A2E-BC0D-0845-AB407D8E0596}"/>
                  </a:ext>
                </a:extLst>
              </p:cNvPr>
              <p:cNvSpPr/>
              <p:nvPr/>
            </p:nvSpPr>
            <p:spPr>
              <a:xfrm>
                <a:off x="4098160" y="6094421"/>
                <a:ext cx="52328" cy="60941"/>
              </a:xfrm>
              <a:custGeom>
                <a:avLst/>
                <a:gdLst>
                  <a:gd name="connsiteX0" fmla="*/ 10591 w 52328"/>
                  <a:gd name="connsiteY0" fmla="*/ 33114 h 60941"/>
                  <a:gd name="connsiteX1" fmla="*/ 14826 w 52328"/>
                  <a:gd name="connsiteY1" fmla="*/ 48840 h 60941"/>
                  <a:gd name="connsiteX2" fmla="*/ 27076 w 52328"/>
                  <a:gd name="connsiteY2" fmla="*/ 54284 h 60941"/>
                  <a:gd name="connsiteX3" fmla="*/ 37209 w 52328"/>
                  <a:gd name="connsiteY3" fmla="*/ 51714 h 60941"/>
                  <a:gd name="connsiteX4" fmla="*/ 42351 w 52328"/>
                  <a:gd name="connsiteY4" fmla="*/ 45211 h 60941"/>
                  <a:gd name="connsiteX5" fmla="*/ 50972 w 52328"/>
                  <a:gd name="connsiteY5" fmla="*/ 47631 h 60941"/>
                  <a:gd name="connsiteX6" fmla="*/ 27076 w 52328"/>
                  <a:gd name="connsiteY6" fmla="*/ 61543 h 60941"/>
                  <a:gd name="connsiteX7" fmla="*/ 7112 w 52328"/>
                  <a:gd name="connsiteY7" fmla="*/ 53831 h 60941"/>
                  <a:gd name="connsiteX8" fmla="*/ 307 w 52328"/>
                  <a:gd name="connsiteY8" fmla="*/ 30694 h 60941"/>
                  <a:gd name="connsiteX9" fmla="*/ 7112 w 52328"/>
                  <a:gd name="connsiteY9" fmla="*/ 8465 h 60941"/>
                  <a:gd name="connsiteX10" fmla="*/ 26622 w 52328"/>
                  <a:gd name="connsiteY10" fmla="*/ 602 h 60941"/>
                  <a:gd name="connsiteX11" fmla="*/ 52636 w 52328"/>
                  <a:gd name="connsiteY11" fmla="*/ 31904 h 60941"/>
                  <a:gd name="connsiteX12" fmla="*/ 52636 w 52328"/>
                  <a:gd name="connsiteY12" fmla="*/ 33114 h 60941"/>
                  <a:gd name="connsiteX13" fmla="*/ 42502 w 52328"/>
                  <a:gd name="connsiteY13" fmla="*/ 25704 h 60941"/>
                  <a:gd name="connsiteX14" fmla="*/ 37663 w 52328"/>
                  <a:gd name="connsiteY14" fmla="*/ 12094 h 60941"/>
                  <a:gd name="connsiteX15" fmla="*/ 26471 w 52328"/>
                  <a:gd name="connsiteY15" fmla="*/ 7860 h 60941"/>
                  <a:gd name="connsiteX16" fmla="*/ 15128 w 52328"/>
                  <a:gd name="connsiteY16" fmla="*/ 12699 h 60941"/>
                  <a:gd name="connsiteX17" fmla="*/ 10742 w 52328"/>
                  <a:gd name="connsiteY17" fmla="*/ 25704 h 6094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</a:cxnLst>
                <a:rect l="l" t="t" r="r" b="b"/>
                <a:pathLst>
                  <a:path w="52328" h="60941">
                    <a:moveTo>
                      <a:pt x="10591" y="33114"/>
                    </a:moveTo>
                    <a:cubicBezTo>
                      <a:pt x="10591" y="39881"/>
                      <a:pt x="11990" y="45135"/>
                      <a:pt x="14826" y="48840"/>
                    </a:cubicBezTo>
                    <a:cubicBezTo>
                      <a:pt x="17624" y="52470"/>
                      <a:pt x="21707" y="54284"/>
                      <a:pt x="27076" y="54284"/>
                    </a:cubicBezTo>
                    <a:cubicBezTo>
                      <a:pt x="31311" y="54284"/>
                      <a:pt x="34676" y="53453"/>
                      <a:pt x="37209" y="51714"/>
                    </a:cubicBezTo>
                    <a:cubicBezTo>
                      <a:pt x="39705" y="50012"/>
                      <a:pt x="41444" y="47857"/>
                      <a:pt x="42351" y="45211"/>
                    </a:cubicBezTo>
                    <a:lnTo>
                      <a:pt x="50972" y="47631"/>
                    </a:lnTo>
                    <a:cubicBezTo>
                      <a:pt x="47418" y="56931"/>
                      <a:pt x="39478" y="61543"/>
                      <a:pt x="27076" y="61543"/>
                    </a:cubicBezTo>
                    <a:cubicBezTo>
                      <a:pt x="18304" y="61543"/>
                      <a:pt x="11650" y="58972"/>
                      <a:pt x="7112" y="53831"/>
                    </a:cubicBezTo>
                    <a:cubicBezTo>
                      <a:pt x="2575" y="48614"/>
                      <a:pt x="307" y="40901"/>
                      <a:pt x="307" y="30694"/>
                    </a:cubicBezTo>
                    <a:cubicBezTo>
                      <a:pt x="307" y="21016"/>
                      <a:pt x="2575" y="13606"/>
                      <a:pt x="7112" y="8465"/>
                    </a:cubicBezTo>
                    <a:cubicBezTo>
                      <a:pt x="11650" y="3248"/>
                      <a:pt x="18153" y="602"/>
                      <a:pt x="26622" y="602"/>
                    </a:cubicBezTo>
                    <a:cubicBezTo>
                      <a:pt x="43939" y="602"/>
                      <a:pt x="52636" y="11036"/>
                      <a:pt x="52636" y="31904"/>
                    </a:cubicBezTo>
                    <a:lnTo>
                      <a:pt x="52636" y="33114"/>
                    </a:lnTo>
                    <a:close/>
                    <a:moveTo>
                      <a:pt x="42502" y="25704"/>
                    </a:moveTo>
                    <a:cubicBezTo>
                      <a:pt x="41898" y="19466"/>
                      <a:pt x="40272" y="14930"/>
                      <a:pt x="37663" y="12094"/>
                    </a:cubicBezTo>
                    <a:cubicBezTo>
                      <a:pt x="35130" y="9297"/>
                      <a:pt x="31386" y="7860"/>
                      <a:pt x="26471" y="7860"/>
                    </a:cubicBezTo>
                    <a:cubicBezTo>
                      <a:pt x="21707" y="7860"/>
                      <a:pt x="17926" y="9486"/>
                      <a:pt x="15128" y="12699"/>
                    </a:cubicBezTo>
                    <a:cubicBezTo>
                      <a:pt x="12406" y="15837"/>
                      <a:pt x="10931" y="20184"/>
                      <a:pt x="10742" y="25704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56" name="Freeform: Shape 3055">
                <a:extLst>
                  <a:ext uri="{FF2B5EF4-FFF2-40B4-BE49-F238E27FC236}">
                    <a16:creationId xmlns:a16="http://schemas.microsoft.com/office/drawing/2014/main" id="{89CEE607-AE74-9915-6D45-39C41B7C0BAB}"/>
                  </a:ext>
                </a:extLst>
              </p:cNvPr>
              <p:cNvSpPr/>
              <p:nvPr/>
            </p:nvSpPr>
            <p:spPr>
              <a:xfrm>
                <a:off x="4162743" y="6094421"/>
                <a:ext cx="47338" cy="59882"/>
              </a:xfrm>
              <a:custGeom>
                <a:avLst/>
                <a:gdLst>
                  <a:gd name="connsiteX0" fmla="*/ 37669 w 47338"/>
                  <a:gd name="connsiteY0" fmla="*/ 60484 h 59882"/>
                  <a:gd name="connsiteX1" fmla="*/ 37669 w 47338"/>
                  <a:gd name="connsiteY1" fmla="*/ 23133 h 59882"/>
                  <a:gd name="connsiteX2" fmla="*/ 36459 w 47338"/>
                  <a:gd name="connsiteY2" fmla="*/ 14211 h 59882"/>
                  <a:gd name="connsiteX3" fmla="*/ 32830 w 47338"/>
                  <a:gd name="connsiteY3" fmla="*/ 9675 h 59882"/>
                  <a:gd name="connsiteX4" fmla="*/ 25570 w 47338"/>
                  <a:gd name="connsiteY4" fmla="*/ 8163 h 59882"/>
                  <a:gd name="connsiteX5" fmla="*/ 14530 w 47338"/>
                  <a:gd name="connsiteY5" fmla="*/ 13002 h 59882"/>
                  <a:gd name="connsiteX6" fmla="*/ 10446 w 47338"/>
                  <a:gd name="connsiteY6" fmla="*/ 26460 h 59882"/>
                  <a:gd name="connsiteX7" fmla="*/ 10446 w 47338"/>
                  <a:gd name="connsiteY7" fmla="*/ 60484 h 59882"/>
                  <a:gd name="connsiteX8" fmla="*/ 615 w 47338"/>
                  <a:gd name="connsiteY8" fmla="*/ 60484 h 59882"/>
                  <a:gd name="connsiteX9" fmla="*/ 615 w 47338"/>
                  <a:gd name="connsiteY9" fmla="*/ 14211 h 59882"/>
                  <a:gd name="connsiteX10" fmla="*/ 313 w 47338"/>
                  <a:gd name="connsiteY10" fmla="*/ 1660 h 59882"/>
                  <a:gd name="connsiteX11" fmla="*/ 9539 w 47338"/>
                  <a:gd name="connsiteY11" fmla="*/ 1660 h 59882"/>
                  <a:gd name="connsiteX12" fmla="*/ 9539 w 47338"/>
                  <a:gd name="connsiteY12" fmla="*/ 3172 h 59882"/>
                  <a:gd name="connsiteX13" fmla="*/ 9690 w 47338"/>
                  <a:gd name="connsiteY13" fmla="*/ 5894 h 59882"/>
                  <a:gd name="connsiteX14" fmla="*/ 9992 w 47338"/>
                  <a:gd name="connsiteY14" fmla="*/ 11792 h 59882"/>
                  <a:gd name="connsiteX15" fmla="*/ 10144 w 47338"/>
                  <a:gd name="connsiteY15" fmla="*/ 11792 h 59882"/>
                  <a:gd name="connsiteX16" fmla="*/ 17857 w 47338"/>
                  <a:gd name="connsiteY16" fmla="*/ 3172 h 59882"/>
                  <a:gd name="connsiteX17" fmla="*/ 28897 w 47338"/>
                  <a:gd name="connsiteY17" fmla="*/ 602 h 59882"/>
                  <a:gd name="connsiteX18" fmla="*/ 43114 w 47338"/>
                  <a:gd name="connsiteY18" fmla="*/ 5441 h 59882"/>
                  <a:gd name="connsiteX19" fmla="*/ 47651 w 47338"/>
                  <a:gd name="connsiteY19" fmla="*/ 21319 h 59882"/>
                  <a:gd name="connsiteX20" fmla="*/ 47651 w 47338"/>
                  <a:gd name="connsiteY20" fmla="*/ 60484 h 598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7338" h="59882">
                    <a:moveTo>
                      <a:pt x="37669" y="60484"/>
                    </a:moveTo>
                    <a:lnTo>
                      <a:pt x="37669" y="23133"/>
                    </a:lnTo>
                    <a:cubicBezTo>
                      <a:pt x="37669" y="19315"/>
                      <a:pt x="37253" y="16328"/>
                      <a:pt x="36459" y="14211"/>
                    </a:cubicBezTo>
                    <a:cubicBezTo>
                      <a:pt x="35741" y="12094"/>
                      <a:pt x="34531" y="10582"/>
                      <a:pt x="32830" y="9675"/>
                    </a:cubicBezTo>
                    <a:cubicBezTo>
                      <a:pt x="31204" y="8692"/>
                      <a:pt x="28784" y="8163"/>
                      <a:pt x="25570" y="8163"/>
                    </a:cubicBezTo>
                    <a:cubicBezTo>
                      <a:pt x="20919" y="8163"/>
                      <a:pt x="17252" y="9788"/>
                      <a:pt x="14530" y="13002"/>
                    </a:cubicBezTo>
                    <a:cubicBezTo>
                      <a:pt x="11807" y="16253"/>
                      <a:pt x="10446" y="20714"/>
                      <a:pt x="10446" y="26460"/>
                    </a:cubicBezTo>
                    <a:lnTo>
                      <a:pt x="10446" y="60484"/>
                    </a:lnTo>
                    <a:lnTo>
                      <a:pt x="615" y="60484"/>
                    </a:lnTo>
                    <a:lnTo>
                      <a:pt x="615" y="14211"/>
                    </a:lnTo>
                    <a:cubicBezTo>
                      <a:pt x="615" y="7369"/>
                      <a:pt x="502" y="3172"/>
                      <a:pt x="313" y="1660"/>
                    </a:cubicBezTo>
                    <a:lnTo>
                      <a:pt x="9539" y="1660"/>
                    </a:lnTo>
                    <a:cubicBezTo>
                      <a:pt x="9539" y="1887"/>
                      <a:pt x="9539" y="2378"/>
                      <a:pt x="9539" y="3172"/>
                    </a:cubicBezTo>
                    <a:cubicBezTo>
                      <a:pt x="9614" y="4004"/>
                      <a:pt x="9690" y="4911"/>
                      <a:pt x="9690" y="5894"/>
                    </a:cubicBezTo>
                    <a:cubicBezTo>
                      <a:pt x="9765" y="6915"/>
                      <a:pt x="9879" y="8881"/>
                      <a:pt x="9992" y="11792"/>
                    </a:cubicBezTo>
                    <a:lnTo>
                      <a:pt x="10144" y="11792"/>
                    </a:lnTo>
                    <a:cubicBezTo>
                      <a:pt x="12336" y="7671"/>
                      <a:pt x="14908" y="4798"/>
                      <a:pt x="17857" y="3172"/>
                    </a:cubicBezTo>
                    <a:cubicBezTo>
                      <a:pt x="20882" y="1471"/>
                      <a:pt x="24549" y="602"/>
                      <a:pt x="28897" y="602"/>
                    </a:cubicBezTo>
                    <a:cubicBezTo>
                      <a:pt x="35325" y="602"/>
                      <a:pt x="40089" y="2227"/>
                      <a:pt x="43114" y="5441"/>
                    </a:cubicBezTo>
                    <a:cubicBezTo>
                      <a:pt x="46139" y="8692"/>
                      <a:pt x="47651" y="13984"/>
                      <a:pt x="47651" y="21319"/>
                    </a:cubicBezTo>
                    <a:lnTo>
                      <a:pt x="47651" y="60484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57" name="Freeform: Shape 3056">
                <a:extLst>
                  <a:ext uri="{FF2B5EF4-FFF2-40B4-BE49-F238E27FC236}">
                    <a16:creationId xmlns:a16="http://schemas.microsoft.com/office/drawing/2014/main" id="{6F48BFEB-9754-C130-8C40-414854020CBB}"/>
                  </a:ext>
                </a:extLst>
              </p:cNvPr>
              <p:cNvSpPr/>
              <p:nvPr/>
            </p:nvSpPr>
            <p:spPr>
              <a:xfrm>
                <a:off x="4224452" y="6095479"/>
                <a:ext cx="47186" cy="59882"/>
              </a:xfrm>
              <a:custGeom>
                <a:avLst/>
                <a:gdLst>
                  <a:gd name="connsiteX0" fmla="*/ 10150 w 47186"/>
                  <a:gd name="connsiteY0" fmla="*/ 602 h 59882"/>
                  <a:gd name="connsiteX1" fmla="*/ 10150 w 47186"/>
                  <a:gd name="connsiteY1" fmla="*/ 37953 h 59882"/>
                  <a:gd name="connsiteX2" fmla="*/ 11209 w 47186"/>
                  <a:gd name="connsiteY2" fmla="*/ 47026 h 59882"/>
                  <a:gd name="connsiteX3" fmla="*/ 14838 w 47186"/>
                  <a:gd name="connsiteY3" fmla="*/ 51562 h 59882"/>
                  <a:gd name="connsiteX4" fmla="*/ 22249 w 47186"/>
                  <a:gd name="connsiteY4" fmla="*/ 52923 h 59882"/>
                  <a:gd name="connsiteX5" fmla="*/ 33441 w 47186"/>
                  <a:gd name="connsiteY5" fmla="*/ 48084 h 59882"/>
                  <a:gd name="connsiteX6" fmla="*/ 37524 w 47186"/>
                  <a:gd name="connsiteY6" fmla="*/ 34626 h 59882"/>
                  <a:gd name="connsiteX7" fmla="*/ 37524 w 47186"/>
                  <a:gd name="connsiteY7" fmla="*/ 602 h 59882"/>
                  <a:gd name="connsiteX8" fmla="*/ 47204 w 47186"/>
                  <a:gd name="connsiteY8" fmla="*/ 602 h 59882"/>
                  <a:gd name="connsiteX9" fmla="*/ 47204 w 47186"/>
                  <a:gd name="connsiteY9" fmla="*/ 46874 h 59882"/>
                  <a:gd name="connsiteX10" fmla="*/ 47506 w 47186"/>
                  <a:gd name="connsiteY10" fmla="*/ 59426 h 59882"/>
                  <a:gd name="connsiteX11" fmla="*/ 38281 w 47186"/>
                  <a:gd name="connsiteY11" fmla="*/ 59426 h 59882"/>
                  <a:gd name="connsiteX12" fmla="*/ 38129 w 47186"/>
                  <a:gd name="connsiteY12" fmla="*/ 57913 h 59882"/>
                  <a:gd name="connsiteX13" fmla="*/ 37978 w 47186"/>
                  <a:gd name="connsiteY13" fmla="*/ 55191 h 59882"/>
                  <a:gd name="connsiteX14" fmla="*/ 37827 w 47186"/>
                  <a:gd name="connsiteY14" fmla="*/ 49445 h 59882"/>
                  <a:gd name="connsiteX15" fmla="*/ 37676 w 47186"/>
                  <a:gd name="connsiteY15" fmla="*/ 49445 h 59882"/>
                  <a:gd name="connsiteX16" fmla="*/ 29962 w 47186"/>
                  <a:gd name="connsiteY16" fmla="*/ 58065 h 59882"/>
                  <a:gd name="connsiteX17" fmla="*/ 18922 w 47186"/>
                  <a:gd name="connsiteY17" fmla="*/ 60484 h 59882"/>
                  <a:gd name="connsiteX18" fmla="*/ 4705 w 47186"/>
                  <a:gd name="connsiteY18" fmla="*/ 55796 h 59882"/>
                  <a:gd name="connsiteX19" fmla="*/ 319 w 47186"/>
                  <a:gd name="connsiteY19" fmla="*/ 39767 h 59882"/>
                  <a:gd name="connsiteX20" fmla="*/ 319 w 47186"/>
                  <a:gd name="connsiteY20" fmla="*/ 602 h 598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47186" h="59882">
                    <a:moveTo>
                      <a:pt x="10150" y="602"/>
                    </a:moveTo>
                    <a:lnTo>
                      <a:pt x="10150" y="37953"/>
                    </a:lnTo>
                    <a:cubicBezTo>
                      <a:pt x="10150" y="41809"/>
                      <a:pt x="10490" y="44833"/>
                      <a:pt x="11209" y="47026"/>
                    </a:cubicBezTo>
                    <a:cubicBezTo>
                      <a:pt x="12003" y="49143"/>
                      <a:pt x="13213" y="50655"/>
                      <a:pt x="14838" y="51562"/>
                    </a:cubicBezTo>
                    <a:cubicBezTo>
                      <a:pt x="16540" y="52470"/>
                      <a:pt x="18997" y="52923"/>
                      <a:pt x="22249" y="52923"/>
                    </a:cubicBezTo>
                    <a:cubicBezTo>
                      <a:pt x="26975" y="52923"/>
                      <a:pt x="30719" y="51335"/>
                      <a:pt x="33441" y="48084"/>
                    </a:cubicBezTo>
                    <a:cubicBezTo>
                      <a:pt x="36163" y="44871"/>
                      <a:pt x="37524" y="40372"/>
                      <a:pt x="37524" y="34626"/>
                    </a:cubicBezTo>
                    <a:lnTo>
                      <a:pt x="37524" y="602"/>
                    </a:lnTo>
                    <a:lnTo>
                      <a:pt x="47204" y="602"/>
                    </a:lnTo>
                    <a:lnTo>
                      <a:pt x="47204" y="46874"/>
                    </a:lnTo>
                    <a:cubicBezTo>
                      <a:pt x="47204" y="53755"/>
                      <a:pt x="47279" y="57913"/>
                      <a:pt x="47506" y="59426"/>
                    </a:cubicBezTo>
                    <a:lnTo>
                      <a:pt x="38281" y="59426"/>
                    </a:lnTo>
                    <a:cubicBezTo>
                      <a:pt x="38281" y="59237"/>
                      <a:pt x="38205" y="58745"/>
                      <a:pt x="38129" y="57913"/>
                    </a:cubicBezTo>
                    <a:cubicBezTo>
                      <a:pt x="38129" y="57120"/>
                      <a:pt x="38054" y="56212"/>
                      <a:pt x="37978" y="55191"/>
                    </a:cubicBezTo>
                    <a:cubicBezTo>
                      <a:pt x="37978" y="54209"/>
                      <a:pt x="37902" y="52281"/>
                      <a:pt x="37827" y="49445"/>
                    </a:cubicBezTo>
                    <a:lnTo>
                      <a:pt x="37676" y="49445"/>
                    </a:lnTo>
                    <a:cubicBezTo>
                      <a:pt x="35445" y="53490"/>
                      <a:pt x="32874" y="56363"/>
                      <a:pt x="29962" y="58065"/>
                    </a:cubicBezTo>
                    <a:cubicBezTo>
                      <a:pt x="27013" y="59652"/>
                      <a:pt x="23346" y="60484"/>
                      <a:pt x="18922" y="60484"/>
                    </a:cubicBezTo>
                    <a:cubicBezTo>
                      <a:pt x="12456" y="60484"/>
                      <a:pt x="7730" y="58934"/>
                      <a:pt x="4705" y="55796"/>
                    </a:cubicBezTo>
                    <a:cubicBezTo>
                      <a:pt x="1756" y="52583"/>
                      <a:pt x="319" y="47253"/>
                      <a:pt x="319" y="39767"/>
                    </a:cubicBezTo>
                    <a:lnTo>
                      <a:pt x="319" y="602"/>
                    </a:ln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  <p:sp>
            <p:nvSpPr>
              <p:cNvPr id="3058" name="Freeform: Shape 3057">
                <a:extLst>
                  <a:ext uri="{FF2B5EF4-FFF2-40B4-BE49-F238E27FC236}">
                    <a16:creationId xmlns:a16="http://schemas.microsoft.com/office/drawing/2014/main" id="{29FD21E7-51AE-455F-881B-BD6CC9709BCD}"/>
                  </a:ext>
                </a:extLst>
              </p:cNvPr>
              <p:cNvSpPr/>
              <p:nvPr/>
            </p:nvSpPr>
            <p:spPr>
              <a:xfrm>
                <a:off x="4282069" y="6094572"/>
                <a:ext cx="48547" cy="60789"/>
              </a:xfrm>
              <a:custGeom>
                <a:avLst/>
                <a:gdLst>
                  <a:gd name="connsiteX0" fmla="*/ 48874 w 48547"/>
                  <a:gd name="connsiteY0" fmla="*/ 44153 h 60789"/>
                  <a:gd name="connsiteX1" fmla="*/ 42522 w 48547"/>
                  <a:gd name="connsiteY1" fmla="*/ 57006 h 60789"/>
                  <a:gd name="connsiteX2" fmla="*/ 25129 w 48547"/>
                  <a:gd name="connsiteY2" fmla="*/ 61392 h 60789"/>
                  <a:gd name="connsiteX3" fmla="*/ 8039 w 48547"/>
                  <a:gd name="connsiteY3" fmla="*/ 57762 h 60789"/>
                  <a:gd name="connsiteX4" fmla="*/ 326 w 48547"/>
                  <a:gd name="connsiteY4" fmla="*/ 46572 h 60789"/>
                  <a:gd name="connsiteX5" fmla="*/ 9098 w 48547"/>
                  <a:gd name="connsiteY5" fmla="*/ 44909 h 60789"/>
                  <a:gd name="connsiteX6" fmla="*/ 14240 w 48547"/>
                  <a:gd name="connsiteY6" fmla="*/ 51865 h 60789"/>
                  <a:gd name="connsiteX7" fmla="*/ 25129 w 48547"/>
                  <a:gd name="connsiteY7" fmla="*/ 53982 h 60789"/>
                  <a:gd name="connsiteX8" fmla="*/ 36018 w 48547"/>
                  <a:gd name="connsiteY8" fmla="*/ 51714 h 60789"/>
                  <a:gd name="connsiteX9" fmla="*/ 39497 w 48547"/>
                  <a:gd name="connsiteY9" fmla="*/ 44909 h 60789"/>
                  <a:gd name="connsiteX10" fmla="*/ 37077 w 48547"/>
                  <a:gd name="connsiteY10" fmla="*/ 39314 h 60789"/>
                  <a:gd name="connsiteX11" fmla="*/ 29364 w 48547"/>
                  <a:gd name="connsiteY11" fmla="*/ 35533 h 60789"/>
                  <a:gd name="connsiteX12" fmla="*/ 22255 w 48547"/>
                  <a:gd name="connsiteY12" fmla="*/ 33719 h 60789"/>
                  <a:gd name="connsiteX13" fmla="*/ 10308 w 48547"/>
                  <a:gd name="connsiteY13" fmla="*/ 29484 h 60789"/>
                  <a:gd name="connsiteX14" fmla="*/ 4712 w 48547"/>
                  <a:gd name="connsiteY14" fmla="*/ 24494 h 60789"/>
                  <a:gd name="connsiteX15" fmla="*/ 2746 w 48547"/>
                  <a:gd name="connsiteY15" fmla="*/ 17084 h 60789"/>
                  <a:gd name="connsiteX16" fmla="*/ 8493 w 48547"/>
                  <a:gd name="connsiteY16" fmla="*/ 4836 h 60789"/>
                  <a:gd name="connsiteX17" fmla="*/ 25129 w 48547"/>
                  <a:gd name="connsiteY17" fmla="*/ 602 h 60789"/>
                  <a:gd name="connsiteX18" fmla="*/ 40707 w 48547"/>
                  <a:gd name="connsiteY18" fmla="*/ 4080 h 60789"/>
                  <a:gd name="connsiteX19" fmla="*/ 47966 w 48547"/>
                  <a:gd name="connsiteY19" fmla="*/ 14967 h 60789"/>
                  <a:gd name="connsiteX20" fmla="*/ 39043 w 48547"/>
                  <a:gd name="connsiteY20" fmla="*/ 16026 h 60789"/>
                  <a:gd name="connsiteX21" fmla="*/ 34657 w 48547"/>
                  <a:gd name="connsiteY21" fmla="*/ 10128 h 60789"/>
                  <a:gd name="connsiteX22" fmla="*/ 25129 w 48547"/>
                  <a:gd name="connsiteY22" fmla="*/ 8011 h 60789"/>
                  <a:gd name="connsiteX23" fmla="*/ 15450 w 48547"/>
                  <a:gd name="connsiteY23" fmla="*/ 10128 h 60789"/>
                  <a:gd name="connsiteX24" fmla="*/ 12274 w 48547"/>
                  <a:gd name="connsiteY24" fmla="*/ 16026 h 60789"/>
                  <a:gd name="connsiteX25" fmla="*/ 13484 w 48547"/>
                  <a:gd name="connsiteY25" fmla="*/ 20260 h 60789"/>
                  <a:gd name="connsiteX26" fmla="*/ 17416 w 48547"/>
                  <a:gd name="connsiteY26" fmla="*/ 23133 h 60789"/>
                  <a:gd name="connsiteX27" fmla="*/ 28154 w 48547"/>
                  <a:gd name="connsiteY27" fmla="*/ 26158 h 60789"/>
                  <a:gd name="connsiteX28" fmla="*/ 39346 w 48547"/>
                  <a:gd name="connsiteY28" fmla="*/ 29787 h 60789"/>
                  <a:gd name="connsiteX29" fmla="*/ 44790 w 48547"/>
                  <a:gd name="connsiteY29" fmla="*/ 33416 h 60789"/>
                  <a:gd name="connsiteX30" fmla="*/ 47815 w 48547"/>
                  <a:gd name="connsiteY30" fmla="*/ 38104 h 60789"/>
                  <a:gd name="connsiteX31" fmla="*/ 48874 w 48547"/>
                  <a:gd name="connsiteY31" fmla="*/ 44153 h 6078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</a:cxnLst>
                <a:rect l="l" t="t" r="r" b="b"/>
                <a:pathLst>
                  <a:path w="48547" h="60789">
                    <a:moveTo>
                      <a:pt x="48874" y="44153"/>
                    </a:moveTo>
                    <a:cubicBezTo>
                      <a:pt x="48874" y="49710"/>
                      <a:pt x="46756" y="53982"/>
                      <a:pt x="42522" y="57006"/>
                    </a:cubicBezTo>
                    <a:cubicBezTo>
                      <a:pt x="38363" y="59955"/>
                      <a:pt x="32578" y="61392"/>
                      <a:pt x="25129" y="61392"/>
                    </a:cubicBezTo>
                    <a:cubicBezTo>
                      <a:pt x="17756" y="61392"/>
                      <a:pt x="12047" y="60182"/>
                      <a:pt x="8039" y="57762"/>
                    </a:cubicBezTo>
                    <a:cubicBezTo>
                      <a:pt x="4107" y="55343"/>
                      <a:pt x="1536" y="51638"/>
                      <a:pt x="326" y="46572"/>
                    </a:cubicBezTo>
                    <a:lnTo>
                      <a:pt x="9098" y="44909"/>
                    </a:lnTo>
                    <a:cubicBezTo>
                      <a:pt x="9892" y="48047"/>
                      <a:pt x="11593" y="50353"/>
                      <a:pt x="14240" y="51865"/>
                    </a:cubicBezTo>
                    <a:cubicBezTo>
                      <a:pt x="16849" y="53301"/>
                      <a:pt x="20478" y="53982"/>
                      <a:pt x="25129" y="53982"/>
                    </a:cubicBezTo>
                    <a:cubicBezTo>
                      <a:pt x="30044" y="53982"/>
                      <a:pt x="33674" y="53226"/>
                      <a:pt x="36018" y="51714"/>
                    </a:cubicBezTo>
                    <a:cubicBezTo>
                      <a:pt x="38325" y="50201"/>
                      <a:pt x="39497" y="47933"/>
                      <a:pt x="39497" y="44909"/>
                    </a:cubicBezTo>
                    <a:cubicBezTo>
                      <a:pt x="39497" y="42603"/>
                      <a:pt x="38665" y="40750"/>
                      <a:pt x="37077" y="39314"/>
                    </a:cubicBezTo>
                    <a:cubicBezTo>
                      <a:pt x="35451" y="37801"/>
                      <a:pt x="32880" y="36554"/>
                      <a:pt x="29364" y="35533"/>
                    </a:cubicBezTo>
                    <a:lnTo>
                      <a:pt x="22255" y="33719"/>
                    </a:lnTo>
                    <a:cubicBezTo>
                      <a:pt x="16697" y="32320"/>
                      <a:pt x="12727" y="30921"/>
                      <a:pt x="10308" y="29484"/>
                    </a:cubicBezTo>
                    <a:cubicBezTo>
                      <a:pt x="7963" y="28086"/>
                      <a:pt x="6111" y="26422"/>
                      <a:pt x="4712" y="24494"/>
                    </a:cubicBezTo>
                    <a:cubicBezTo>
                      <a:pt x="3388" y="22491"/>
                      <a:pt x="2746" y="20033"/>
                      <a:pt x="2746" y="17084"/>
                    </a:cubicBezTo>
                    <a:cubicBezTo>
                      <a:pt x="2746" y="11754"/>
                      <a:pt x="4636" y="7671"/>
                      <a:pt x="8493" y="4836"/>
                    </a:cubicBezTo>
                    <a:cubicBezTo>
                      <a:pt x="12311" y="2038"/>
                      <a:pt x="17870" y="602"/>
                      <a:pt x="25129" y="602"/>
                    </a:cubicBezTo>
                    <a:cubicBezTo>
                      <a:pt x="31670" y="602"/>
                      <a:pt x="36850" y="1774"/>
                      <a:pt x="40707" y="4080"/>
                    </a:cubicBezTo>
                    <a:cubicBezTo>
                      <a:pt x="44526" y="6310"/>
                      <a:pt x="46945" y="9939"/>
                      <a:pt x="47966" y="14967"/>
                    </a:cubicBezTo>
                    <a:lnTo>
                      <a:pt x="39043" y="16026"/>
                    </a:lnTo>
                    <a:cubicBezTo>
                      <a:pt x="38514" y="13531"/>
                      <a:pt x="37077" y="11565"/>
                      <a:pt x="34657" y="10128"/>
                    </a:cubicBezTo>
                    <a:cubicBezTo>
                      <a:pt x="32313" y="8730"/>
                      <a:pt x="29137" y="8011"/>
                      <a:pt x="25129" y="8011"/>
                    </a:cubicBezTo>
                    <a:cubicBezTo>
                      <a:pt x="20781" y="8011"/>
                      <a:pt x="17567" y="8730"/>
                      <a:pt x="15450" y="10128"/>
                    </a:cubicBezTo>
                    <a:cubicBezTo>
                      <a:pt x="13332" y="11452"/>
                      <a:pt x="12274" y="13417"/>
                      <a:pt x="12274" y="16026"/>
                    </a:cubicBezTo>
                    <a:cubicBezTo>
                      <a:pt x="12274" y="17765"/>
                      <a:pt x="12652" y="19164"/>
                      <a:pt x="13484" y="20260"/>
                    </a:cubicBezTo>
                    <a:cubicBezTo>
                      <a:pt x="14391" y="21394"/>
                      <a:pt x="15677" y="22339"/>
                      <a:pt x="17416" y="23133"/>
                    </a:cubicBezTo>
                    <a:cubicBezTo>
                      <a:pt x="19117" y="23852"/>
                      <a:pt x="22709" y="24872"/>
                      <a:pt x="28154" y="26158"/>
                    </a:cubicBezTo>
                    <a:cubicBezTo>
                      <a:pt x="33372" y="27481"/>
                      <a:pt x="37115" y="28691"/>
                      <a:pt x="39346" y="29787"/>
                    </a:cubicBezTo>
                    <a:cubicBezTo>
                      <a:pt x="41652" y="30921"/>
                      <a:pt x="43467" y="32131"/>
                      <a:pt x="44790" y="33416"/>
                    </a:cubicBezTo>
                    <a:cubicBezTo>
                      <a:pt x="46076" y="34739"/>
                      <a:pt x="47097" y="36289"/>
                      <a:pt x="47815" y="38104"/>
                    </a:cubicBezTo>
                    <a:cubicBezTo>
                      <a:pt x="48496" y="39843"/>
                      <a:pt x="48874" y="41847"/>
                      <a:pt x="48874" y="44153"/>
                    </a:cubicBezTo>
                    <a:close/>
                  </a:path>
                </a:pathLst>
              </a:custGeom>
              <a:solidFill>
                <a:srgbClr val="000000"/>
              </a:solidFill>
              <a:ln w="9677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GB"/>
              </a:p>
            </p:txBody>
          </p:sp>
        </p:grpSp>
        <p:sp>
          <p:nvSpPr>
            <p:cNvPr id="3021" name="Freeform: Shape 3020">
              <a:extLst>
                <a:ext uri="{FF2B5EF4-FFF2-40B4-BE49-F238E27FC236}">
                  <a16:creationId xmlns:a16="http://schemas.microsoft.com/office/drawing/2014/main" id="{A8103FCC-E628-542A-2BC6-129F9B658B60}"/>
                </a:ext>
              </a:extLst>
            </p:cNvPr>
            <p:cNvSpPr/>
            <p:nvPr/>
          </p:nvSpPr>
          <p:spPr>
            <a:xfrm>
              <a:off x="4332387" y="5055045"/>
              <a:ext cx="167278" cy="167245"/>
            </a:xfrm>
            <a:custGeom>
              <a:avLst/>
              <a:gdLst>
                <a:gd name="connsiteX0" fmla="*/ 0 w 167278"/>
                <a:gd name="connsiteY0" fmla="*/ 0 h 167245"/>
                <a:gd name="connsiteX1" fmla="*/ 167278 w 167278"/>
                <a:gd name="connsiteY1" fmla="*/ 0 h 167245"/>
                <a:gd name="connsiteX2" fmla="*/ 167278 w 167278"/>
                <a:gd name="connsiteY2" fmla="*/ 167246 h 167245"/>
                <a:gd name="connsiteX3" fmla="*/ 0 w 167278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78" h="167245">
                  <a:moveTo>
                    <a:pt x="0" y="0"/>
                  </a:moveTo>
                  <a:lnTo>
                    <a:pt x="167278" y="0"/>
                  </a:lnTo>
                  <a:lnTo>
                    <a:pt x="167278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22" name="Freeform: Shape 3021">
              <a:extLst>
                <a:ext uri="{FF2B5EF4-FFF2-40B4-BE49-F238E27FC236}">
                  <a16:creationId xmlns:a16="http://schemas.microsoft.com/office/drawing/2014/main" id="{397BDDF3-63FD-A2C0-2F57-5757C40D6C12}"/>
                </a:ext>
              </a:extLst>
            </p:cNvPr>
            <p:cNvSpPr/>
            <p:nvPr/>
          </p:nvSpPr>
          <p:spPr>
            <a:xfrm>
              <a:off x="4339269" y="5061887"/>
              <a:ext cx="153553" cy="153522"/>
            </a:xfrm>
            <a:custGeom>
              <a:avLst/>
              <a:gdLst>
                <a:gd name="connsiteX0" fmla="*/ 0 w 153553"/>
                <a:gd name="connsiteY0" fmla="*/ 0 h 153522"/>
                <a:gd name="connsiteX1" fmla="*/ 153553 w 153553"/>
                <a:gd name="connsiteY1" fmla="*/ 0 h 153522"/>
                <a:gd name="connsiteX2" fmla="*/ 153553 w 153553"/>
                <a:gd name="connsiteY2" fmla="*/ 153522 h 153522"/>
                <a:gd name="connsiteX3" fmla="*/ 0 w 153553"/>
                <a:gd name="connsiteY3" fmla="*/ 153522 h 1535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53" h="153522">
                  <a:moveTo>
                    <a:pt x="0" y="0"/>
                  </a:moveTo>
                  <a:lnTo>
                    <a:pt x="153553" y="0"/>
                  </a:lnTo>
                  <a:lnTo>
                    <a:pt x="15355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8DD3C7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23" name="Freeform: Shape 3022">
              <a:extLst>
                <a:ext uri="{FF2B5EF4-FFF2-40B4-BE49-F238E27FC236}">
                  <a16:creationId xmlns:a16="http://schemas.microsoft.com/office/drawing/2014/main" id="{6C6C8E14-A950-0FF0-C8AE-A9B5F91961EE}"/>
                </a:ext>
              </a:extLst>
            </p:cNvPr>
            <p:cNvSpPr/>
            <p:nvPr/>
          </p:nvSpPr>
          <p:spPr>
            <a:xfrm>
              <a:off x="4332387" y="5275297"/>
              <a:ext cx="167278" cy="167245"/>
            </a:xfrm>
            <a:custGeom>
              <a:avLst/>
              <a:gdLst>
                <a:gd name="connsiteX0" fmla="*/ 0 w 167278"/>
                <a:gd name="connsiteY0" fmla="*/ 0 h 167245"/>
                <a:gd name="connsiteX1" fmla="*/ 167278 w 167278"/>
                <a:gd name="connsiteY1" fmla="*/ 0 h 167245"/>
                <a:gd name="connsiteX2" fmla="*/ 167278 w 167278"/>
                <a:gd name="connsiteY2" fmla="*/ 167246 h 167245"/>
                <a:gd name="connsiteX3" fmla="*/ 0 w 167278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78" h="167245">
                  <a:moveTo>
                    <a:pt x="0" y="0"/>
                  </a:moveTo>
                  <a:lnTo>
                    <a:pt x="167278" y="0"/>
                  </a:lnTo>
                  <a:lnTo>
                    <a:pt x="167278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24" name="Freeform: Shape 3023">
              <a:extLst>
                <a:ext uri="{FF2B5EF4-FFF2-40B4-BE49-F238E27FC236}">
                  <a16:creationId xmlns:a16="http://schemas.microsoft.com/office/drawing/2014/main" id="{13492A49-527B-1C22-D953-142837335F80}"/>
                </a:ext>
              </a:extLst>
            </p:cNvPr>
            <p:cNvSpPr/>
            <p:nvPr/>
          </p:nvSpPr>
          <p:spPr>
            <a:xfrm>
              <a:off x="4339269" y="5282178"/>
              <a:ext cx="153553" cy="153521"/>
            </a:xfrm>
            <a:custGeom>
              <a:avLst/>
              <a:gdLst>
                <a:gd name="connsiteX0" fmla="*/ 0 w 153553"/>
                <a:gd name="connsiteY0" fmla="*/ 0 h 153521"/>
                <a:gd name="connsiteX1" fmla="*/ 153553 w 153553"/>
                <a:gd name="connsiteY1" fmla="*/ 0 h 153521"/>
                <a:gd name="connsiteX2" fmla="*/ 153553 w 153553"/>
                <a:gd name="connsiteY2" fmla="*/ 153522 h 153521"/>
                <a:gd name="connsiteX3" fmla="*/ 0 w 153553"/>
                <a:gd name="connsiteY3" fmla="*/ 153522 h 1535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53" h="153521">
                  <a:moveTo>
                    <a:pt x="0" y="0"/>
                  </a:moveTo>
                  <a:lnTo>
                    <a:pt x="153553" y="0"/>
                  </a:lnTo>
                  <a:lnTo>
                    <a:pt x="15355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FFFFB3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25" name="Freeform: Shape 3024">
              <a:extLst>
                <a:ext uri="{FF2B5EF4-FFF2-40B4-BE49-F238E27FC236}">
                  <a16:creationId xmlns:a16="http://schemas.microsoft.com/office/drawing/2014/main" id="{3162F51A-B00B-1E48-C804-3E8D4FC71DD5}"/>
                </a:ext>
              </a:extLst>
            </p:cNvPr>
            <p:cNvSpPr/>
            <p:nvPr/>
          </p:nvSpPr>
          <p:spPr>
            <a:xfrm>
              <a:off x="4332387" y="5495587"/>
              <a:ext cx="167278" cy="167245"/>
            </a:xfrm>
            <a:custGeom>
              <a:avLst/>
              <a:gdLst>
                <a:gd name="connsiteX0" fmla="*/ 0 w 167278"/>
                <a:gd name="connsiteY0" fmla="*/ 0 h 167245"/>
                <a:gd name="connsiteX1" fmla="*/ 167278 w 167278"/>
                <a:gd name="connsiteY1" fmla="*/ 0 h 167245"/>
                <a:gd name="connsiteX2" fmla="*/ 167278 w 167278"/>
                <a:gd name="connsiteY2" fmla="*/ 167246 h 167245"/>
                <a:gd name="connsiteX3" fmla="*/ 0 w 167278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78" h="167245">
                  <a:moveTo>
                    <a:pt x="0" y="0"/>
                  </a:moveTo>
                  <a:lnTo>
                    <a:pt x="167278" y="0"/>
                  </a:lnTo>
                  <a:lnTo>
                    <a:pt x="167278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26" name="Freeform: Shape 3025">
              <a:extLst>
                <a:ext uri="{FF2B5EF4-FFF2-40B4-BE49-F238E27FC236}">
                  <a16:creationId xmlns:a16="http://schemas.microsoft.com/office/drawing/2014/main" id="{CC78E0A6-4F44-610C-59C0-1C4244FFD06A}"/>
                </a:ext>
              </a:extLst>
            </p:cNvPr>
            <p:cNvSpPr/>
            <p:nvPr/>
          </p:nvSpPr>
          <p:spPr>
            <a:xfrm>
              <a:off x="4339269" y="5502430"/>
              <a:ext cx="153553" cy="153521"/>
            </a:xfrm>
            <a:custGeom>
              <a:avLst/>
              <a:gdLst>
                <a:gd name="connsiteX0" fmla="*/ 0 w 153553"/>
                <a:gd name="connsiteY0" fmla="*/ 0 h 153521"/>
                <a:gd name="connsiteX1" fmla="*/ 153553 w 153553"/>
                <a:gd name="connsiteY1" fmla="*/ 0 h 153521"/>
                <a:gd name="connsiteX2" fmla="*/ 153553 w 153553"/>
                <a:gd name="connsiteY2" fmla="*/ 153522 h 153521"/>
                <a:gd name="connsiteX3" fmla="*/ 0 w 153553"/>
                <a:gd name="connsiteY3" fmla="*/ 153522 h 1535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53" h="153521">
                  <a:moveTo>
                    <a:pt x="0" y="0"/>
                  </a:moveTo>
                  <a:lnTo>
                    <a:pt x="153553" y="0"/>
                  </a:lnTo>
                  <a:lnTo>
                    <a:pt x="15355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BEBADA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27" name="Freeform: Shape 3026">
              <a:extLst>
                <a:ext uri="{FF2B5EF4-FFF2-40B4-BE49-F238E27FC236}">
                  <a16:creationId xmlns:a16="http://schemas.microsoft.com/office/drawing/2014/main" id="{18069A6E-101A-7D16-3FA0-731732373EC9}"/>
                </a:ext>
              </a:extLst>
            </p:cNvPr>
            <p:cNvSpPr/>
            <p:nvPr/>
          </p:nvSpPr>
          <p:spPr>
            <a:xfrm>
              <a:off x="5441167" y="5055045"/>
              <a:ext cx="167269" cy="167245"/>
            </a:xfrm>
            <a:custGeom>
              <a:avLst/>
              <a:gdLst>
                <a:gd name="connsiteX0" fmla="*/ 0 w 167269"/>
                <a:gd name="connsiteY0" fmla="*/ 0 h 167245"/>
                <a:gd name="connsiteX1" fmla="*/ 167269 w 167269"/>
                <a:gd name="connsiteY1" fmla="*/ 0 h 167245"/>
                <a:gd name="connsiteX2" fmla="*/ 167269 w 167269"/>
                <a:gd name="connsiteY2" fmla="*/ 167246 h 167245"/>
                <a:gd name="connsiteX3" fmla="*/ 0 w 167269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69" h="167245">
                  <a:moveTo>
                    <a:pt x="0" y="0"/>
                  </a:moveTo>
                  <a:lnTo>
                    <a:pt x="167269" y="0"/>
                  </a:lnTo>
                  <a:lnTo>
                    <a:pt x="167269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28" name="Freeform: Shape 3027">
              <a:extLst>
                <a:ext uri="{FF2B5EF4-FFF2-40B4-BE49-F238E27FC236}">
                  <a16:creationId xmlns:a16="http://schemas.microsoft.com/office/drawing/2014/main" id="{CC4D5FE5-CDEF-7155-6FB6-263C8B7C05C1}"/>
                </a:ext>
              </a:extLst>
            </p:cNvPr>
            <p:cNvSpPr/>
            <p:nvPr/>
          </p:nvSpPr>
          <p:spPr>
            <a:xfrm>
              <a:off x="5448010" y="5061887"/>
              <a:ext cx="153553" cy="153522"/>
            </a:xfrm>
            <a:custGeom>
              <a:avLst/>
              <a:gdLst>
                <a:gd name="connsiteX0" fmla="*/ 0 w 153553"/>
                <a:gd name="connsiteY0" fmla="*/ 0 h 153522"/>
                <a:gd name="connsiteX1" fmla="*/ 153553 w 153553"/>
                <a:gd name="connsiteY1" fmla="*/ 0 h 153522"/>
                <a:gd name="connsiteX2" fmla="*/ 153553 w 153553"/>
                <a:gd name="connsiteY2" fmla="*/ 153522 h 153522"/>
                <a:gd name="connsiteX3" fmla="*/ 0 w 153553"/>
                <a:gd name="connsiteY3" fmla="*/ 153522 h 1535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53" h="153522">
                  <a:moveTo>
                    <a:pt x="0" y="0"/>
                  </a:moveTo>
                  <a:lnTo>
                    <a:pt x="153553" y="0"/>
                  </a:lnTo>
                  <a:lnTo>
                    <a:pt x="15355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FB8072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29" name="Freeform: Shape 3028">
              <a:extLst>
                <a:ext uri="{FF2B5EF4-FFF2-40B4-BE49-F238E27FC236}">
                  <a16:creationId xmlns:a16="http://schemas.microsoft.com/office/drawing/2014/main" id="{2E89187F-A347-70BF-2F34-DCF5786B8BEE}"/>
                </a:ext>
              </a:extLst>
            </p:cNvPr>
            <p:cNvSpPr/>
            <p:nvPr/>
          </p:nvSpPr>
          <p:spPr>
            <a:xfrm>
              <a:off x="5441167" y="5275297"/>
              <a:ext cx="167269" cy="167245"/>
            </a:xfrm>
            <a:custGeom>
              <a:avLst/>
              <a:gdLst>
                <a:gd name="connsiteX0" fmla="*/ 0 w 167269"/>
                <a:gd name="connsiteY0" fmla="*/ 0 h 167245"/>
                <a:gd name="connsiteX1" fmla="*/ 167269 w 167269"/>
                <a:gd name="connsiteY1" fmla="*/ 0 h 167245"/>
                <a:gd name="connsiteX2" fmla="*/ 167269 w 167269"/>
                <a:gd name="connsiteY2" fmla="*/ 167246 h 167245"/>
                <a:gd name="connsiteX3" fmla="*/ 0 w 167269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69" h="167245">
                  <a:moveTo>
                    <a:pt x="0" y="0"/>
                  </a:moveTo>
                  <a:lnTo>
                    <a:pt x="167269" y="0"/>
                  </a:lnTo>
                  <a:lnTo>
                    <a:pt x="167269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30" name="Freeform: Shape 3029">
              <a:extLst>
                <a:ext uri="{FF2B5EF4-FFF2-40B4-BE49-F238E27FC236}">
                  <a16:creationId xmlns:a16="http://schemas.microsoft.com/office/drawing/2014/main" id="{76650A18-DFCC-CB1E-EB8A-D6547E5CC6A3}"/>
                </a:ext>
              </a:extLst>
            </p:cNvPr>
            <p:cNvSpPr/>
            <p:nvPr/>
          </p:nvSpPr>
          <p:spPr>
            <a:xfrm>
              <a:off x="5448010" y="5282178"/>
              <a:ext cx="153553" cy="153521"/>
            </a:xfrm>
            <a:custGeom>
              <a:avLst/>
              <a:gdLst>
                <a:gd name="connsiteX0" fmla="*/ 0 w 153553"/>
                <a:gd name="connsiteY0" fmla="*/ 0 h 153521"/>
                <a:gd name="connsiteX1" fmla="*/ 153553 w 153553"/>
                <a:gd name="connsiteY1" fmla="*/ 0 h 153521"/>
                <a:gd name="connsiteX2" fmla="*/ 153553 w 153553"/>
                <a:gd name="connsiteY2" fmla="*/ 153522 h 153521"/>
                <a:gd name="connsiteX3" fmla="*/ 0 w 153553"/>
                <a:gd name="connsiteY3" fmla="*/ 153522 h 1535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53" h="153521">
                  <a:moveTo>
                    <a:pt x="0" y="0"/>
                  </a:moveTo>
                  <a:lnTo>
                    <a:pt x="153553" y="0"/>
                  </a:lnTo>
                  <a:lnTo>
                    <a:pt x="15355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80B1D3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31" name="Freeform: Shape 3030">
              <a:extLst>
                <a:ext uri="{FF2B5EF4-FFF2-40B4-BE49-F238E27FC236}">
                  <a16:creationId xmlns:a16="http://schemas.microsoft.com/office/drawing/2014/main" id="{F5FE530F-9319-8EE9-8418-80C791E8134F}"/>
                </a:ext>
              </a:extLst>
            </p:cNvPr>
            <p:cNvSpPr/>
            <p:nvPr/>
          </p:nvSpPr>
          <p:spPr>
            <a:xfrm>
              <a:off x="5441167" y="5495587"/>
              <a:ext cx="167269" cy="167245"/>
            </a:xfrm>
            <a:custGeom>
              <a:avLst/>
              <a:gdLst>
                <a:gd name="connsiteX0" fmla="*/ 0 w 167269"/>
                <a:gd name="connsiteY0" fmla="*/ 0 h 167245"/>
                <a:gd name="connsiteX1" fmla="*/ 167269 w 167269"/>
                <a:gd name="connsiteY1" fmla="*/ 0 h 167245"/>
                <a:gd name="connsiteX2" fmla="*/ 167269 w 167269"/>
                <a:gd name="connsiteY2" fmla="*/ 167246 h 167245"/>
                <a:gd name="connsiteX3" fmla="*/ 0 w 167269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69" h="167245">
                  <a:moveTo>
                    <a:pt x="0" y="0"/>
                  </a:moveTo>
                  <a:lnTo>
                    <a:pt x="167269" y="0"/>
                  </a:lnTo>
                  <a:lnTo>
                    <a:pt x="167269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32" name="Freeform: Shape 3031">
              <a:extLst>
                <a:ext uri="{FF2B5EF4-FFF2-40B4-BE49-F238E27FC236}">
                  <a16:creationId xmlns:a16="http://schemas.microsoft.com/office/drawing/2014/main" id="{5F223A30-E2DF-AF89-A1F1-B75AA44C661B}"/>
                </a:ext>
              </a:extLst>
            </p:cNvPr>
            <p:cNvSpPr/>
            <p:nvPr/>
          </p:nvSpPr>
          <p:spPr>
            <a:xfrm>
              <a:off x="5448010" y="5502430"/>
              <a:ext cx="153553" cy="153521"/>
            </a:xfrm>
            <a:custGeom>
              <a:avLst/>
              <a:gdLst>
                <a:gd name="connsiteX0" fmla="*/ 0 w 153553"/>
                <a:gd name="connsiteY0" fmla="*/ 0 h 153521"/>
                <a:gd name="connsiteX1" fmla="*/ 153553 w 153553"/>
                <a:gd name="connsiteY1" fmla="*/ 0 h 153521"/>
                <a:gd name="connsiteX2" fmla="*/ 153553 w 153553"/>
                <a:gd name="connsiteY2" fmla="*/ 153522 h 153521"/>
                <a:gd name="connsiteX3" fmla="*/ 0 w 153553"/>
                <a:gd name="connsiteY3" fmla="*/ 153522 h 1535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53" h="153521">
                  <a:moveTo>
                    <a:pt x="0" y="0"/>
                  </a:moveTo>
                  <a:lnTo>
                    <a:pt x="153553" y="0"/>
                  </a:lnTo>
                  <a:lnTo>
                    <a:pt x="15355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FDB462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33" name="Freeform: Shape 3032">
              <a:extLst>
                <a:ext uri="{FF2B5EF4-FFF2-40B4-BE49-F238E27FC236}">
                  <a16:creationId xmlns:a16="http://schemas.microsoft.com/office/drawing/2014/main" id="{23DE27BE-E3DC-CEA3-A7DD-44B750E1E677}"/>
                </a:ext>
              </a:extLst>
            </p:cNvPr>
            <p:cNvSpPr/>
            <p:nvPr/>
          </p:nvSpPr>
          <p:spPr>
            <a:xfrm>
              <a:off x="6455196" y="5055045"/>
              <a:ext cx="167268" cy="167245"/>
            </a:xfrm>
            <a:custGeom>
              <a:avLst/>
              <a:gdLst>
                <a:gd name="connsiteX0" fmla="*/ 0 w 167268"/>
                <a:gd name="connsiteY0" fmla="*/ 0 h 167245"/>
                <a:gd name="connsiteX1" fmla="*/ 167268 w 167268"/>
                <a:gd name="connsiteY1" fmla="*/ 0 h 167245"/>
                <a:gd name="connsiteX2" fmla="*/ 167268 w 167268"/>
                <a:gd name="connsiteY2" fmla="*/ 167246 h 167245"/>
                <a:gd name="connsiteX3" fmla="*/ 0 w 167268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68" h="167245">
                  <a:moveTo>
                    <a:pt x="0" y="0"/>
                  </a:moveTo>
                  <a:lnTo>
                    <a:pt x="167268" y="0"/>
                  </a:lnTo>
                  <a:lnTo>
                    <a:pt x="167268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34" name="Freeform: Shape 3033">
              <a:extLst>
                <a:ext uri="{FF2B5EF4-FFF2-40B4-BE49-F238E27FC236}">
                  <a16:creationId xmlns:a16="http://schemas.microsoft.com/office/drawing/2014/main" id="{487C15AC-9E14-74B1-B7D0-112F2A24F744}"/>
                </a:ext>
              </a:extLst>
            </p:cNvPr>
            <p:cNvSpPr/>
            <p:nvPr/>
          </p:nvSpPr>
          <p:spPr>
            <a:xfrm>
              <a:off x="6462039" y="5061887"/>
              <a:ext cx="153543" cy="153522"/>
            </a:xfrm>
            <a:custGeom>
              <a:avLst/>
              <a:gdLst>
                <a:gd name="connsiteX0" fmla="*/ 0 w 153543"/>
                <a:gd name="connsiteY0" fmla="*/ 0 h 153522"/>
                <a:gd name="connsiteX1" fmla="*/ 153543 w 153543"/>
                <a:gd name="connsiteY1" fmla="*/ 0 h 153522"/>
                <a:gd name="connsiteX2" fmla="*/ 153543 w 153543"/>
                <a:gd name="connsiteY2" fmla="*/ 153522 h 153522"/>
                <a:gd name="connsiteX3" fmla="*/ 0 w 153543"/>
                <a:gd name="connsiteY3" fmla="*/ 153522 h 1535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43" h="153522">
                  <a:moveTo>
                    <a:pt x="0" y="0"/>
                  </a:moveTo>
                  <a:lnTo>
                    <a:pt x="153543" y="0"/>
                  </a:lnTo>
                  <a:lnTo>
                    <a:pt x="15354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B3DE69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35" name="Freeform: Shape 3034">
              <a:extLst>
                <a:ext uri="{FF2B5EF4-FFF2-40B4-BE49-F238E27FC236}">
                  <a16:creationId xmlns:a16="http://schemas.microsoft.com/office/drawing/2014/main" id="{7DF27FA0-264D-4898-61A3-8AAAE6CA8D49}"/>
                </a:ext>
              </a:extLst>
            </p:cNvPr>
            <p:cNvSpPr/>
            <p:nvPr/>
          </p:nvSpPr>
          <p:spPr>
            <a:xfrm>
              <a:off x="6455196" y="5275297"/>
              <a:ext cx="167268" cy="167245"/>
            </a:xfrm>
            <a:custGeom>
              <a:avLst/>
              <a:gdLst>
                <a:gd name="connsiteX0" fmla="*/ 0 w 167268"/>
                <a:gd name="connsiteY0" fmla="*/ 0 h 167245"/>
                <a:gd name="connsiteX1" fmla="*/ 167268 w 167268"/>
                <a:gd name="connsiteY1" fmla="*/ 0 h 167245"/>
                <a:gd name="connsiteX2" fmla="*/ 167268 w 167268"/>
                <a:gd name="connsiteY2" fmla="*/ 167246 h 167245"/>
                <a:gd name="connsiteX3" fmla="*/ 0 w 167268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68" h="167245">
                  <a:moveTo>
                    <a:pt x="0" y="0"/>
                  </a:moveTo>
                  <a:lnTo>
                    <a:pt x="167268" y="0"/>
                  </a:lnTo>
                  <a:lnTo>
                    <a:pt x="167268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36" name="Freeform: Shape 3035">
              <a:extLst>
                <a:ext uri="{FF2B5EF4-FFF2-40B4-BE49-F238E27FC236}">
                  <a16:creationId xmlns:a16="http://schemas.microsoft.com/office/drawing/2014/main" id="{CB45F62C-5989-6F7F-2D4D-8C1B2891F259}"/>
                </a:ext>
              </a:extLst>
            </p:cNvPr>
            <p:cNvSpPr/>
            <p:nvPr/>
          </p:nvSpPr>
          <p:spPr>
            <a:xfrm>
              <a:off x="6462039" y="5282178"/>
              <a:ext cx="153543" cy="153521"/>
            </a:xfrm>
            <a:custGeom>
              <a:avLst/>
              <a:gdLst>
                <a:gd name="connsiteX0" fmla="*/ 0 w 153543"/>
                <a:gd name="connsiteY0" fmla="*/ 0 h 153521"/>
                <a:gd name="connsiteX1" fmla="*/ 153543 w 153543"/>
                <a:gd name="connsiteY1" fmla="*/ 0 h 153521"/>
                <a:gd name="connsiteX2" fmla="*/ 153543 w 153543"/>
                <a:gd name="connsiteY2" fmla="*/ 153522 h 153521"/>
                <a:gd name="connsiteX3" fmla="*/ 0 w 153543"/>
                <a:gd name="connsiteY3" fmla="*/ 153522 h 1535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43" h="153521">
                  <a:moveTo>
                    <a:pt x="0" y="0"/>
                  </a:moveTo>
                  <a:lnTo>
                    <a:pt x="153543" y="0"/>
                  </a:lnTo>
                  <a:lnTo>
                    <a:pt x="15354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FCCDE5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37" name="Freeform: Shape 3036">
              <a:extLst>
                <a:ext uri="{FF2B5EF4-FFF2-40B4-BE49-F238E27FC236}">
                  <a16:creationId xmlns:a16="http://schemas.microsoft.com/office/drawing/2014/main" id="{1C6494EE-52FB-C4A6-F894-BB85C61BA850}"/>
                </a:ext>
              </a:extLst>
            </p:cNvPr>
            <p:cNvSpPr/>
            <p:nvPr/>
          </p:nvSpPr>
          <p:spPr>
            <a:xfrm>
              <a:off x="6455196" y="5495587"/>
              <a:ext cx="167268" cy="167245"/>
            </a:xfrm>
            <a:custGeom>
              <a:avLst/>
              <a:gdLst>
                <a:gd name="connsiteX0" fmla="*/ 0 w 167268"/>
                <a:gd name="connsiteY0" fmla="*/ 0 h 167245"/>
                <a:gd name="connsiteX1" fmla="*/ 167268 w 167268"/>
                <a:gd name="connsiteY1" fmla="*/ 0 h 167245"/>
                <a:gd name="connsiteX2" fmla="*/ 167268 w 167268"/>
                <a:gd name="connsiteY2" fmla="*/ 167246 h 167245"/>
                <a:gd name="connsiteX3" fmla="*/ 0 w 167268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68" h="167245">
                  <a:moveTo>
                    <a:pt x="0" y="0"/>
                  </a:moveTo>
                  <a:lnTo>
                    <a:pt x="167268" y="0"/>
                  </a:lnTo>
                  <a:lnTo>
                    <a:pt x="167268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38" name="Freeform: Shape 3037">
              <a:extLst>
                <a:ext uri="{FF2B5EF4-FFF2-40B4-BE49-F238E27FC236}">
                  <a16:creationId xmlns:a16="http://schemas.microsoft.com/office/drawing/2014/main" id="{604D16E3-7B6A-21BF-AE7A-B437AC7A14B9}"/>
                </a:ext>
              </a:extLst>
            </p:cNvPr>
            <p:cNvSpPr/>
            <p:nvPr/>
          </p:nvSpPr>
          <p:spPr>
            <a:xfrm>
              <a:off x="6462039" y="5502430"/>
              <a:ext cx="153543" cy="153521"/>
            </a:xfrm>
            <a:custGeom>
              <a:avLst/>
              <a:gdLst>
                <a:gd name="connsiteX0" fmla="*/ 0 w 153543"/>
                <a:gd name="connsiteY0" fmla="*/ 0 h 153521"/>
                <a:gd name="connsiteX1" fmla="*/ 153543 w 153543"/>
                <a:gd name="connsiteY1" fmla="*/ 0 h 153521"/>
                <a:gd name="connsiteX2" fmla="*/ 153543 w 153543"/>
                <a:gd name="connsiteY2" fmla="*/ 153522 h 153521"/>
                <a:gd name="connsiteX3" fmla="*/ 0 w 153543"/>
                <a:gd name="connsiteY3" fmla="*/ 153522 h 1535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43" h="153521">
                  <a:moveTo>
                    <a:pt x="0" y="0"/>
                  </a:moveTo>
                  <a:lnTo>
                    <a:pt x="153543" y="0"/>
                  </a:lnTo>
                  <a:lnTo>
                    <a:pt x="15354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D9D9D9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39" name="Freeform: Shape 3038">
              <a:extLst>
                <a:ext uri="{FF2B5EF4-FFF2-40B4-BE49-F238E27FC236}">
                  <a16:creationId xmlns:a16="http://schemas.microsoft.com/office/drawing/2014/main" id="{3DB7C70F-174D-0309-0A26-923E12846310}"/>
                </a:ext>
              </a:extLst>
            </p:cNvPr>
            <p:cNvSpPr/>
            <p:nvPr/>
          </p:nvSpPr>
          <p:spPr>
            <a:xfrm>
              <a:off x="7289024" y="5055045"/>
              <a:ext cx="167269" cy="167245"/>
            </a:xfrm>
            <a:custGeom>
              <a:avLst/>
              <a:gdLst>
                <a:gd name="connsiteX0" fmla="*/ 0 w 167269"/>
                <a:gd name="connsiteY0" fmla="*/ 0 h 167245"/>
                <a:gd name="connsiteX1" fmla="*/ 167269 w 167269"/>
                <a:gd name="connsiteY1" fmla="*/ 0 h 167245"/>
                <a:gd name="connsiteX2" fmla="*/ 167269 w 167269"/>
                <a:gd name="connsiteY2" fmla="*/ 167246 h 167245"/>
                <a:gd name="connsiteX3" fmla="*/ 0 w 167269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69" h="167245">
                  <a:moveTo>
                    <a:pt x="0" y="0"/>
                  </a:moveTo>
                  <a:lnTo>
                    <a:pt x="167269" y="0"/>
                  </a:lnTo>
                  <a:lnTo>
                    <a:pt x="167269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40" name="Freeform: Shape 3039">
              <a:extLst>
                <a:ext uri="{FF2B5EF4-FFF2-40B4-BE49-F238E27FC236}">
                  <a16:creationId xmlns:a16="http://schemas.microsoft.com/office/drawing/2014/main" id="{9A241EE0-BD81-925E-DB1B-51AC84CDFADA}"/>
                </a:ext>
              </a:extLst>
            </p:cNvPr>
            <p:cNvSpPr/>
            <p:nvPr/>
          </p:nvSpPr>
          <p:spPr>
            <a:xfrm>
              <a:off x="7295896" y="5061887"/>
              <a:ext cx="153553" cy="153522"/>
            </a:xfrm>
            <a:custGeom>
              <a:avLst/>
              <a:gdLst>
                <a:gd name="connsiteX0" fmla="*/ 0 w 153553"/>
                <a:gd name="connsiteY0" fmla="*/ 0 h 153522"/>
                <a:gd name="connsiteX1" fmla="*/ 153553 w 153553"/>
                <a:gd name="connsiteY1" fmla="*/ 0 h 153522"/>
                <a:gd name="connsiteX2" fmla="*/ 153553 w 153553"/>
                <a:gd name="connsiteY2" fmla="*/ 153522 h 153522"/>
                <a:gd name="connsiteX3" fmla="*/ 0 w 153553"/>
                <a:gd name="connsiteY3" fmla="*/ 153522 h 1535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53" h="153522">
                  <a:moveTo>
                    <a:pt x="0" y="0"/>
                  </a:moveTo>
                  <a:lnTo>
                    <a:pt x="153553" y="0"/>
                  </a:lnTo>
                  <a:lnTo>
                    <a:pt x="15355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BC80BD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41" name="Freeform: Shape 3040">
              <a:extLst>
                <a:ext uri="{FF2B5EF4-FFF2-40B4-BE49-F238E27FC236}">
                  <a16:creationId xmlns:a16="http://schemas.microsoft.com/office/drawing/2014/main" id="{D97928E2-BAAE-524A-60C6-1D75C901409D}"/>
                </a:ext>
              </a:extLst>
            </p:cNvPr>
            <p:cNvSpPr/>
            <p:nvPr/>
          </p:nvSpPr>
          <p:spPr>
            <a:xfrm>
              <a:off x="7289024" y="5275297"/>
              <a:ext cx="167269" cy="167245"/>
            </a:xfrm>
            <a:custGeom>
              <a:avLst/>
              <a:gdLst>
                <a:gd name="connsiteX0" fmla="*/ 0 w 167269"/>
                <a:gd name="connsiteY0" fmla="*/ 0 h 167245"/>
                <a:gd name="connsiteX1" fmla="*/ 167269 w 167269"/>
                <a:gd name="connsiteY1" fmla="*/ 0 h 167245"/>
                <a:gd name="connsiteX2" fmla="*/ 167269 w 167269"/>
                <a:gd name="connsiteY2" fmla="*/ 167246 h 167245"/>
                <a:gd name="connsiteX3" fmla="*/ 0 w 167269"/>
                <a:gd name="connsiteY3" fmla="*/ 167246 h 16724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67269" h="167245">
                  <a:moveTo>
                    <a:pt x="0" y="0"/>
                  </a:moveTo>
                  <a:lnTo>
                    <a:pt x="167269" y="0"/>
                  </a:lnTo>
                  <a:lnTo>
                    <a:pt x="167269" y="167246"/>
                  </a:lnTo>
                  <a:lnTo>
                    <a:pt x="0" y="167246"/>
                  </a:lnTo>
                  <a:close/>
                </a:path>
              </a:pathLst>
            </a:custGeom>
            <a:solidFill>
              <a:srgbClr val="FFFFFF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42" name="Freeform: Shape 3041">
              <a:extLst>
                <a:ext uri="{FF2B5EF4-FFF2-40B4-BE49-F238E27FC236}">
                  <a16:creationId xmlns:a16="http://schemas.microsoft.com/office/drawing/2014/main" id="{665166B7-0A4E-E039-763A-48F3DD6FFDE6}"/>
                </a:ext>
              </a:extLst>
            </p:cNvPr>
            <p:cNvSpPr/>
            <p:nvPr/>
          </p:nvSpPr>
          <p:spPr>
            <a:xfrm>
              <a:off x="7295896" y="5282178"/>
              <a:ext cx="153553" cy="153521"/>
            </a:xfrm>
            <a:custGeom>
              <a:avLst/>
              <a:gdLst>
                <a:gd name="connsiteX0" fmla="*/ 0 w 153553"/>
                <a:gd name="connsiteY0" fmla="*/ 0 h 153521"/>
                <a:gd name="connsiteX1" fmla="*/ 153553 w 153553"/>
                <a:gd name="connsiteY1" fmla="*/ 0 h 153521"/>
                <a:gd name="connsiteX2" fmla="*/ 153553 w 153553"/>
                <a:gd name="connsiteY2" fmla="*/ 153522 h 153521"/>
                <a:gd name="connsiteX3" fmla="*/ 0 w 153553"/>
                <a:gd name="connsiteY3" fmla="*/ 153522 h 1535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53553" h="153521">
                  <a:moveTo>
                    <a:pt x="0" y="0"/>
                  </a:moveTo>
                  <a:lnTo>
                    <a:pt x="153553" y="0"/>
                  </a:lnTo>
                  <a:lnTo>
                    <a:pt x="153553" y="153522"/>
                  </a:lnTo>
                  <a:lnTo>
                    <a:pt x="0" y="153522"/>
                  </a:lnTo>
                  <a:close/>
                </a:path>
              </a:pathLst>
            </a:custGeom>
            <a:solidFill>
              <a:srgbClr val="CCEBC5"/>
            </a:solidFill>
            <a:ln w="9677" cap="flat">
              <a:noFill/>
              <a:prstDash val="solid"/>
              <a:miter/>
            </a:ln>
          </p:spPr>
          <p:txBody>
            <a:bodyPr rtlCol="0" anchor="ctr"/>
            <a:lstStyle/>
            <a:p>
              <a:endParaRPr lang="en-GB"/>
            </a:p>
          </p:txBody>
        </p:sp>
        <p:sp>
          <p:nvSpPr>
            <p:cNvPr id="3043" name="TextBox 3042">
              <a:extLst>
                <a:ext uri="{FF2B5EF4-FFF2-40B4-BE49-F238E27FC236}">
                  <a16:creationId xmlns:a16="http://schemas.microsoft.com/office/drawing/2014/main" id="{7A4B1317-1E85-B8DC-F1CA-973F7ADF1721}"/>
                </a:ext>
              </a:extLst>
            </p:cNvPr>
            <p:cNvSpPr txBox="1"/>
            <p:nvPr/>
          </p:nvSpPr>
          <p:spPr>
            <a:xfrm>
              <a:off x="4427456" y="5241890"/>
              <a:ext cx="10583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/>
                <a:t>Faecalibacterium</a:t>
              </a:r>
              <a:endParaRPr lang="en-GB" sz="900" dirty="0"/>
            </a:p>
          </p:txBody>
        </p:sp>
        <p:sp>
          <p:nvSpPr>
            <p:cNvPr id="3044" name="TextBox 3043">
              <a:extLst>
                <a:ext uri="{FF2B5EF4-FFF2-40B4-BE49-F238E27FC236}">
                  <a16:creationId xmlns:a16="http://schemas.microsoft.com/office/drawing/2014/main" id="{648F93B7-2563-1943-A905-65554A3A1473}"/>
                </a:ext>
              </a:extLst>
            </p:cNvPr>
            <p:cNvSpPr txBox="1"/>
            <p:nvPr/>
          </p:nvSpPr>
          <p:spPr>
            <a:xfrm>
              <a:off x="4440394" y="5470543"/>
              <a:ext cx="83708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Not assigned</a:t>
              </a:r>
            </a:p>
          </p:txBody>
        </p:sp>
        <p:sp>
          <p:nvSpPr>
            <p:cNvPr id="3045" name="TextBox 3044">
              <a:extLst>
                <a:ext uri="{FF2B5EF4-FFF2-40B4-BE49-F238E27FC236}">
                  <a16:creationId xmlns:a16="http://schemas.microsoft.com/office/drawing/2014/main" id="{2754FFBC-8321-83AC-E849-E0CF9CDDDAD1}"/>
                </a:ext>
              </a:extLst>
            </p:cNvPr>
            <p:cNvSpPr txBox="1"/>
            <p:nvPr/>
          </p:nvSpPr>
          <p:spPr>
            <a:xfrm>
              <a:off x="5566217" y="5023361"/>
              <a:ext cx="86273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/>
                <a:t>Coprococcus</a:t>
              </a:r>
              <a:endParaRPr lang="en-GB" sz="900" dirty="0"/>
            </a:p>
          </p:txBody>
        </p:sp>
        <p:sp>
          <p:nvSpPr>
            <p:cNvPr id="3046" name="TextBox 3045">
              <a:extLst>
                <a:ext uri="{FF2B5EF4-FFF2-40B4-BE49-F238E27FC236}">
                  <a16:creationId xmlns:a16="http://schemas.microsoft.com/office/drawing/2014/main" id="{C04C1EEE-7253-8693-3F60-DD890556DA0C}"/>
                </a:ext>
              </a:extLst>
            </p:cNvPr>
            <p:cNvSpPr txBox="1"/>
            <p:nvPr/>
          </p:nvSpPr>
          <p:spPr>
            <a:xfrm>
              <a:off x="5565122" y="5244970"/>
              <a:ext cx="78418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Bacteroides</a:t>
              </a:r>
            </a:p>
          </p:txBody>
        </p:sp>
        <p:sp>
          <p:nvSpPr>
            <p:cNvPr id="3047" name="TextBox 3046">
              <a:extLst>
                <a:ext uri="{FF2B5EF4-FFF2-40B4-BE49-F238E27FC236}">
                  <a16:creationId xmlns:a16="http://schemas.microsoft.com/office/drawing/2014/main" id="{1812F7A3-01DC-8E75-1CB4-C2B946E709ED}"/>
                </a:ext>
              </a:extLst>
            </p:cNvPr>
            <p:cNvSpPr txBox="1"/>
            <p:nvPr/>
          </p:nvSpPr>
          <p:spPr>
            <a:xfrm>
              <a:off x="5564805" y="5475802"/>
              <a:ext cx="93968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/>
                <a:t>Ruminococcus</a:t>
              </a:r>
              <a:endParaRPr lang="en-GB" sz="900" dirty="0"/>
            </a:p>
          </p:txBody>
        </p:sp>
        <p:sp>
          <p:nvSpPr>
            <p:cNvPr id="3048" name="TextBox 3047">
              <a:extLst>
                <a:ext uri="{FF2B5EF4-FFF2-40B4-BE49-F238E27FC236}">
                  <a16:creationId xmlns:a16="http://schemas.microsoft.com/office/drawing/2014/main" id="{F51D2376-AD02-970D-2B6A-91B8A066A61F}"/>
                </a:ext>
              </a:extLst>
            </p:cNvPr>
            <p:cNvSpPr txBox="1"/>
            <p:nvPr/>
          </p:nvSpPr>
          <p:spPr>
            <a:xfrm>
              <a:off x="6571993" y="5029593"/>
              <a:ext cx="72006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/>
                <a:t>Collinsella</a:t>
              </a:r>
              <a:endParaRPr lang="en-GB" sz="900" dirty="0"/>
            </a:p>
          </p:txBody>
        </p:sp>
        <p:sp>
          <p:nvSpPr>
            <p:cNvPr id="3049" name="TextBox 3048">
              <a:extLst>
                <a:ext uri="{FF2B5EF4-FFF2-40B4-BE49-F238E27FC236}">
                  <a16:creationId xmlns:a16="http://schemas.microsoft.com/office/drawing/2014/main" id="{A5E371F9-CA1E-BCF2-18A0-2F7F53FE8FFD}"/>
                </a:ext>
              </a:extLst>
            </p:cNvPr>
            <p:cNvSpPr txBox="1"/>
            <p:nvPr/>
          </p:nvSpPr>
          <p:spPr>
            <a:xfrm>
              <a:off x="6574278" y="5250282"/>
              <a:ext cx="4876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/>
                <a:t>Dorea</a:t>
              </a:r>
              <a:endParaRPr lang="en-GB" sz="900" dirty="0"/>
            </a:p>
          </p:txBody>
        </p:sp>
        <p:sp>
          <p:nvSpPr>
            <p:cNvPr id="3050" name="TextBox 3049">
              <a:extLst>
                <a:ext uri="{FF2B5EF4-FFF2-40B4-BE49-F238E27FC236}">
                  <a16:creationId xmlns:a16="http://schemas.microsoft.com/office/drawing/2014/main" id="{7B735D1D-A6F3-A4ED-A323-8E80AF1776D2}"/>
                </a:ext>
              </a:extLst>
            </p:cNvPr>
            <p:cNvSpPr txBox="1"/>
            <p:nvPr/>
          </p:nvSpPr>
          <p:spPr>
            <a:xfrm>
              <a:off x="6571348" y="5454415"/>
              <a:ext cx="6912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/>
                <a:t>Roseburia</a:t>
              </a:r>
              <a:endParaRPr lang="en-GB" sz="900" dirty="0"/>
            </a:p>
          </p:txBody>
        </p:sp>
        <p:sp>
          <p:nvSpPr>
            <p:cNvPr id="3051" name="TextBox 3050">
              <a:extLst>
                <a:ext uri="{FF2B5EF4-FFF2-40B4-BE49-F238E27FC236}">
                  <a16:creationId xmlns:a16="http://schemas.microsoft.com/office/drawing/2014/main" id="{EDF78D85-2E1F-63E1-1FF4-62F0743E7B10}"/>
                </a:ext>
              </a:extLst>
            </p:cNvPr>
            <p:cNvSpPr txBox="1"/>
            <p:nvPr/>
          </p:nvSpPr>
          <p:spPr>
            <a:xfrm>
              <a:off x="7407664" y="5024335"/>
              <a:ext cx="6110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/>
                <a:t>Alistipes</a:t>
              </a:r>
              <a:endParaRPr lang="en-GB" sz="900" dirty="0"/>
            </a:p>
          </p:txBody>
        </p:sp>
        <p:sp>
          <p:nvSpPr>
            <p:cNvPr id="3052" name="TextBox 3051">
              <a:extLst>
                <a:ext uri="{FF2B5EF4-FFF2-40B4-BE49-F238E27FC236}">
                  <a16:creationId xmlns:a16="http://schemas.microsoft.com/office/drawing/2014/main" id="{004A72B2-4FB8-0679-AF61-97E16AE8BEBD}"/>
                </a:ext>
              </a:extLst>
            </p:cNvPr>
            <p:cNvSpPr txBox="1"/>
            <p:nvPr/>
          </p:nvSpPr>
          <p:spPr>
            <a:xfrm>
              <a:off x="7394295" y="5239553"/>
              <a:ext cx="68800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err="1"/>
                <a:t>Prevotella</a:t>
              </a:r>
              <a:endParaRPr lang="en-GB" sz="900" dirty="0"/>
            </a:p>
          </p:txBody>
        </p:sp>
        <p:sp>
          <p:nvSpPr>
            <p:cNvPr id="3053" name="TextBox 3052">
              <a:extLst>
                <a:ext uri="{FF2B5EF4-FFF2-40B4-BE49-F238E27FC236}">
                  <a16:creationId xmlns:a16="http://schemas.microsoft.com/office/drawing/2014/main" id="{1306C76D-FD0A-19CB-0A63-E2AD97B75223}"/>
                </a:ext>
              </a:extLst>
            </p:cNvPr>
            <p:cNvSpPr txBox="1"/>
            <p:nvPr/>
          </p:nvSpPr>
          <p:spPr>
            <a:xfrm>
              <a:off x="4444604" y="5037584"/>
              <a:ext cx="5261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/>
                <a:t>Other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49539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ernandes Ramos, Ana Catarina 2020 (PGR)</dc:creator>
  <cp:lastModifiedBy>Fernandes Ramos, Ana Catarina 2020 (PGR)</cp:lastModifiedBy>
  <cp:revision>7</cp:revision>
  <dcterms:created xsi:type="dcterms:W3CDTF">2026-03-21T15:59:04Z</dcterms:created>
  <dcterms:modified xsi:type="dcterms:W3CDTF">2026-03-21T16:11:09Z</dcterms:modified>
</cp:coreProperties>
</file>